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2" r:id="rId5"/>
    <p:sldId id="261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0" y="7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wt_r032_aug16_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aux1_ro02_aug15%20final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wt_r071_aug15_fina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aux1_ro01_aug15%20fina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aux1_ro02_aug15%20fina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wt_r072_aug15%20final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wt_r072_aug15%20final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aux1_ro01_aug15%20final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wt_r071_aug15_final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botanik.w2k3agp.biologie.privat\Group%20William$\Projects\Millet\Final%20volumes\ODS\wt_r072_aug15%20final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373985829581462E-2"/>
          <c:y val="3.1452647976556634E-2"/>
          <c:w val="0.89185783299186849"/>
          <c:h val="0.94233681204297948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volume sorted'!$T$2:$T$194</c:f>
              <c:numCache>
                <c:formatCode>General</c:formatCode>
                <c:ptCount val="193"/>
                <c:pt idx="0">
                  <c:v>102.53100000000001</c:v>
                </c:pt>
                <c:pt idx="1">
                  <c:v>111.65600000000001</c:v>
                </c:pt>
                <c:pt idx="2">
                  <c:v>120.952</c:v>
                </c:pt>
                <c:pt idx="3">
                  <c:v>132.19999999999999</c:v>
                </c:pt>
                <c:pt idx="4">
                  <c:v>142.77600000000001</c:v>
                </c:pt>
                <c:pt idx="5">
                  <c:v>153.02600000000001</c:v>
                </c:pt>
                <c:pt idx="6">
                  <c:v>163.268</c:v>
                </c:pt>
                <c:pt idx="7">
                  <c:v>172.79499999999999</c:v>
                </c:pt>
                <c:pt idx="8">
                  <c:v>180.69300000000001</c:v>
                </c:pt>
                <c:pt idx="9">
                  <c:v>186.279</c:v>
                </c:pt>
                <c:pt idx="10">
                  <c:v>191.613</c:v>
                </c:pt>
                <c:pt idx="11">
                  <c:v>196.935</c:v>
                </c:pt>
                <c:pt idx="12">
                  <c:v>202.49100000000001</c:v>
                </c:pt>
                <c:pt idx="13">
                  <c:v>208.16499999999999</c:v>
                </c:pt>
                <c:pt idx="14">
                  <c:v>213.82599999999999</c:v>
                </c:pt>
                <c:pt idx="15">
                  <c:v>219.661</c:v>
                </c:pt>
                <c:pt idx="16">
                  <c:v>227.60599999999999</c:v>
                </c:pt>
                <c:pt idx="17">
                  <c:v>234.01400000000001</c:v>
                </c:pt>
                <c:pt idx="18">
                  <c:v>240.12299999999999</c:v>
                </c:pt>
                <c:pt idx="19">
                  <c:v>246.34100000000001</c:v>
                </c:pt>
                <c:pt idx="20">
                  <c:v>251.84899999999999</c:v>
                </c:pt>
                <c:pt idx="21">
                  <c:v>257.39600000000002</c:v>
                </c:pt>
                <c:pt idx="22">
                  <c:v>265.16300000000001</c:v>
                </c:pt>
                <c:pt idx="23">
                  <c:v>273.35199999999998</c:v>
                </c:pt>
                <c:pt idx="24">
                  <c:v>281.19600000000003</c:v>
                </c:pt>
                <c:pt idx="25">
                  <c:v>288.13200000000001</c:v>
                </c:pt>
                <c:pt idx="26">
                  <c:v>295.553</c:v>
                </c:pt>
                <c:pt idx="27">
                  <c:v>301.42599999999999</c:v>
                </c:pt>
                <c:pt idx="28">
                  <c:v>308.20100000000002</c:v>
                </c:pt>
                <c:pt idx="29">
                  <c:v>315.50200000000001</c:v>
                </c:pt>
                <c:pt idx="30">
                  <c:v>322.49</c:v>
                </c:pt>
                <c:pt idx="31">
                  <c:v>330.23899999999998</c:v>
                </c:pt>
                <c:pt idx="32">
                  <c:v>337.315</c:v>
                </c:pt>
                <c:pt idx="33">
                  <c:v>344.52499999999998</c:v>
                </c:pt>
                <c:pt idx="34">
                  <c:v>351.34500000000003</c:v>
                </c:pt>
                <c:pt idx="35">
                  <c:v>357.55099999999999</c:v>
                </c:pt>
                <c:pt idx="36">
                  <c:v>363.74900000000002</c:v>
                </c:pt>
                <c:pt idx="37">
                  <c:v>370.267</c:v>
                </c:pt>
                <c:pt idx="38">
                  <c:v>379.86799999999999</c:v>
                </c:pt>
                <c:pt idx="39">
                  <c:v>388.471</c:v>
                </c:pt>
                <c:pt idx="40">
                  <c:v>394.87099999999998</c:v>
                </c:pt>
                <c:pt idx="41">
                  <c:v>402.05200000000002</c:v>
                </c:pt>
                <c:pt idx="42">
                  <c:v>409.05500000000001</c:v>
                </c:pt>
                <c:pt idx="43">
                  <c:v>416.584</c:v>
                </c:pt>
                <c:pt idx="44">
                  <c:v>424.65499999999997</c:v>
                </c:pt>
                <c:pt idx="45">
                  <c:v>433.50200000000001</c:v>
                </c:pt>
                <c:pt idx="46">
                  <c:v>442.80900000000003</c:v>
                </c:pt>
                <c:pt idx="47">
                  <c:v>451.15800000000002</c:v>
                </c:pt>
                <c:pt idx="48">
                  <c:v>460.36</c:v>
                </c:pt>
                <c:pt idx="49">
                  <c:v>470.54199999999997</c:v>
                </c:pt>
                <c:pt idx="50">
                  <c:v>480.56400000000002</c:v>
                </c:pt>
                <c:pt idx="51">
                  <c:v>491.75700000000001</c:v>
                </c:pt>
                <c:pt idx="52">
                  <c:v>503.38299999999998</c:v>
                </c:pt>
                <c:pt idx="53">
                  <c:v>515.79</c:v>
                </c:pt>
                <c:pt idx="54">
                  <c:v>528.11400000000003</c:v>
                </c:pt>
                <c:pt idx="55">
                  <c:v>541.22299999999996</c:v>
                </c:pt>
                <c:pt idx="56">
                  <c:v>554.66999999999996</c:v>
                </c:pt>
                <c:pt idx="57">
                  <c:v>568.60299999999995</c:v>
                </c:pt>
                <c:pt idx="58">
                  <c:v>583.03700000000003</c:v>
                </c:pt>
                <c:pt idx="59">
                  <c:v>596.654</c:v>
                </c:pt>
                <c:pt idx="60">
                  <c:v>613.72699999999998</c:v>
                </c:pt>
                <c:pt idx="61">
                  <c:v>632.38</c:v>
                </c:pt>
                <c:pt idx="62">
                  <c:v>651.93100000000004</c:v>
                </c:pt>
                <c:pt idx="63">
                  <c:v>670.71500000000003</c:v>
                </c:pt>
                <c:pt idx="64">
                  <c:v>695.14800000000002</c:v>
                </c:pt>
                <c:pt idx="65">
                  <c:v>724.56200000000001</c:v>
                </c:pt>
                <c:pt idx="66">
                  <c:v>752.08799999999997</c:v>
                </c:pt>
                <c:pt idx="67">
                  <c:v>784.06399999999996</c:v>
                </c:pt>
                <c:pt idx="68">
                  <c:v>106.664</c:v>
                </c:pt>
                <c:pt idx="69">
                  <c:v>118.238</c:v>
                </c:pt>
                <c:pt idx="70">
                  <c:v>127.428</c:v>
                </c:pt>
                <c:pt idx="71">
                  <c:v>138.661</c:v>
                </c:pt>
                <c:pt idx="72">
                  <c:v>146.399</c:v>
                </c:pt>
                <c:pt idx="73">
                  <c:v>154.08500000000001</c:v>
                </c:pt>
                <c:pt idx="74">
                  <c:v>161.94200000000001</c:v>
                </c:pt>
                <c:pt idx="75">
                  <c:v>170.809</c:v>
                </c:pt>
                <c:pt idx="76">
                  <c:v>180.535</c:v>
                </c:pt>
                <c:pt idx="77">
                  <c:v>189.381</c:v>
                </c:pt>
                <c:pt idx="78">
                  <c:v>197.69399999999999</c:v>
                </c:pt>
                <c:pt idx="79">
                  <c:v>221.64</c:v>
                </c:pt>
                <c:pt idx="80">
                  <c:v>229.11</c:v>
                </c:pt>
                <c:pt idx="81">
                  <c:v>234.572</c:v>
                </c:pt>
                <c:pt idx="82">
                  <c:v>239.90600000000001</c:v>
                </c:pt>
                <c:pt idx="83">
                  <c:v>245.072</c:v>
                </c:pt>
                <c:pt idx="84">
                  <c:v>252.602</c:v>
                </c:pt>
                <c:pt idx="85">
                  <c:v>259.91199999999998</c:v>
                </c:pt>
                <c:pt idx="86">
                  <c:v>265.22199999999998</c:v>
                </c:pt>
                <c:pt idx="87">
                  <c:v>273.50099999999998</c:v>
                </c:pt>
                <c:pt idx="88">
                  <c:v>283.053</c:v>
                </c:pt>
                <c:pt idx="89">
                  <c:v>291.81599999999997</c:v>
                </c:pt>
                <c:pt idx="90">
                  <c:v>300.85700000000003</c:v>
                </c:pt>
                <c:pt idx="91">
                  <c:v>309.541</c:v>
                </c:pt>
                <c:pt idx="92">
                  <c:v>316.21199999999999</c:v>
                </c:pt>
                <c:pt idx="93">
                  <c:v>322.02699999999999</c:v>
                </c:pt>
                <c:pt idx="94">
                  <c:v>327.714</c:v>
                </c:pt>
                <c:pt idx="95">
                  <c:v>336.7</c:v>
                </c:pt>
                <c:pt idx="96">
                  <c:v>344.93099999999998</c:v>
                </c:pt>
                <c:pt idx="97">
                  <c:v>351.06900000000002</c:v>
                </c:pt>
                <c:pt idx="98">
                  <c:v>360.65499999999997</c:v>
                </c:pt>
                <c:pt idx="99">
                  <c:v>369.92200000000003</c:v>
                </c:pt>
                <c:pt idx="100">
                  <c:v>376.48899999999998</c:v>
                </c:pt>
                <c:pt idx="101">
                  <c:v>385.06</c:v>
                </c:pt>
                <c:pt idx="102">
                  <c:v>393.66199999999998</c:v>
                </c:pt>
                <c:pt idx="103">
                  <c:v>399.15899999999999</c:v>
                </c:pt>
                <c:pt idx="104">
                  <c:v>408.41899999999998</c:v>
                </c:pt>
                <c:pt idx="105">
                  <c:v>420.738</c:v>
                </c:pt>
                <c:pt idx="106">
                  <c:v>466.38400000000001</c:v>
                </c:pt>
                <c:pt idx="107">
                  <c:v>481.04700000000003</c:v>
                </c:pt>
                <c:pt idx="108">
                  <c:v>495.851</c:v>
                </c:pt>
                <c:pt idx="109">
                  <c:v>511.56400000000002</c:v>
                </c:pt>
                <c:pt idx="110">
                  <c:v>525.96699999999998</c:v>
                </c:pt>
                <c:pt idx="111">
                  <c:v>538.72400000000005</c:v>
                </c:pt>
                <c:pt idx="112">
                  <c:v>550.80899999999997</c:v>
                </c:pt>
                <c:pt idx="113">
                  <c:v>564.15700000000004</c:v>
                </c:pt>
                <c:pt idx="114">
                  <c:v>581.56600000000003</c:v>
                </c:pt>
                <c:pt idx="115">
                  <c:v>600.33100000000002</c:v>
                </c:pt>
                <c:pt idx="116">
                  <c:v>621.14099999999996</c:v>
                </c:pt>
                <c:pt idx="117">
                  <c:v>644.43200000000002</c:v>
                </c:pt>
                <c:pt idx="118">
                  <c:v>666.38699999999994</c:v>
                </c:pt>
                <c:pt idx="119">
                  <c:v>689.35299999999995</c:v>
                </c:pt>
                <c:pt idx="120">
                  <c:v>716.48</c:v>
                </c:pt>
                <c:pt idx="121">
                  <c:v>752.79899999999998</c:v>
                </c:pt>
                <c:pt idx="122">
                  <c:v>101.354</c:v>
                </c:pt>
                <c:pt idx="123">
                  <c:v>110.285</c:v>
                </c:pt>
                <c:pt idx="124">
                  <c:v>119.23099999999999</c:v>
                </c:pt>
                <c:pt idx="125">
                  <c:v>128.25299999999999</c:v>
                </c:pt>
                <c:pt idx="126">
                  <c:v>134.98599999999999</c:v>
                </c:pt>
                <c:pt idx="127">
                  <c:v>142.226</c:v>
                </c:pt>
                <c:pt idx="128">
                  <c:v>147.11799999999999</c:v>
                </c:pt>
                <c:pt idx="129">
                  <c:v>154.01400000000001</c:v>
                </c:pt>
                <c:pt idx="130">
                  <c:v>162.316</c:v>
                </c:pt>
                <c:pt idx="131">
                  <c:v>168.44499999999999</c:v>
                </c:pt>
                <c:pt idx="132">
                  <c:v>177.22800000000001</c:v>
                </c:pt>
                <c:pt idx="133">
                  <c:v>185.773</c:v>
                </c:pt>
                <c:pt idx="134">
                  <c:v>194.59</c:v>
                </c:pt>
                <c:pt idx="135">
                  <c:v>202.149</c:v>
                </c:pt>
                <c:pt idx="136">
                  <c:v>209.37299999999999</c:v>
                </c:pt>
                <c:pt idx="137">
                  <c:v>216.471</c:v>
                </c:pt>
                <c:pt idx="138">
                  <c:v>224.09299999999999</c:v>
                </c:pt>
                <c:pt idx="139">
                  <c:v>232.02500000000001</c:v>
                </c:pt>
                <c:pt idx="140">
                  <c:v>240.33099999999999</c:v>
                </c:pt>
                <c:pt idx="141">
                  <c:v>246.81700000000001</c:v>
                </c:pt>
                <c:pt idx="142">
                  <c:v>253.31899999999999</c:v>
                </c:pt>
                <c:pt idx="143">
                  <c:v>258.72000000000003</c:v>
                </c:pt>
                <c:pt idx="144">
                  <c:v>264.06</c:v>
                </c:pt>
                <c:pt idx="145">
                  <c:v>269.81599999999997</c:v>
                </c:pt>
                <c:pt idx="146">
                  <c:v>275.27100000000002</c:v>
                </c:pt>
                <c:pt idx="147">
                  <c:v>280.22699999999998</c:v>
                </c:pt>
                <c:pt idx="148">
                  <c:v>285.351</c:v>
                </c:pt>
                <c:pt idx="149">
                  <c:v>291.036</c:v>
                </c:pt>
                <c:pt idx="150">
                  <c:v>297.25200000000001</c:v>
                </c:pt>
                <c:pt idx="151">
                  <c:v>303.54899999999998</c:v>
                </c:pt>
                <c:pt idx="152">
                  <c:v>309.29500000000002</c:v>
                </c:pt>
                <c:pt idx="153">
                  <c:v>316.05</c:v>
                </c:pt>
                <c:pt idx="154">
                  <c:v>323.80700000000002</c:v>
                </c:pt>
                <c:pt idx="155">
                  <c:v>331.15199999999999</c:v>
                </c:pt>
                <c:pt idx="156">
                  <c:v>338.815</c:v>
                </c:pt>
                <c:pt idx="157">
                  <c:v>346.66399999999999</c:v>
                </c:pt>
                <c:pt idx="158">
                  <c:v>353.05599999999998</c:v>
                </c:pt>
                <c:pt idx="159">
                  <c:v>359.30200000000002</c:v>
                </c:pt>
                <c:pt idx="160">
                  <c:v>370.262</c:v>
                </c:pt>
                <c:pt idx="161">
                  <c:v>381.73200000000003</c:v>
                </c:pt>
                <c:pt idx="162">
                  <c:v>390.05</c:v>
                </c:pt>
                <c:pt idx="163">
                  <c:v>397.58199999999999</c:v>
                </c:pt>
                <c:pt idx="164">
                  <c:v>399.233</c:v>
                </c:pt>
                <c:pt idx="165">
                  <c:v>406.04500000000002</c:v>
                </c:pt>
                <c:pt idx="166">
                  <c:v>413.32600000000002</c:v>
                </c:pt>
                <c:pt idx="167">
                  <c:v>420.68700000000001</c:v>
                </c:pt>
                <c:pt idx="168">
                  <c:v>428.298</c:v>
                </c:pt>
                <c:pt idx="169">
                  <c:v>436.714</c:v>
                </c:pt>
                <c:pt idx="170">
                  <c:v>444.64800000000002</c:v>
                </c:pt>
                <c:pt idx="171">
                  <c:v>452.44200000000001</c:v>
                </c:pt>
                <c:pt idx="172">
                  <c:v>458.15699999999998</c:v>
                </c:pt>
                <c:pt idx="173">
                  <c:v>468.74299999999999</c:v>
                </c:pt>
                <c:pt idx="174">
                  <c:v>490.65499999999997</c:v>
                </c:pt>
                <c:pt idx="175">
                  <c:v>501.18299999999999</c:v>
                </c:pt>
                <c:pt idx="176">
                  <c:v>512.32100000000003</c:v>
                </c:pt>
                <c:pt idx="177">
                  <c:v>520.39099999999996</c:v>
                </c:pt>
                <c:pt idx="178">
                  <c:v>531.51199999999994</c:v>
                </c:pt>
                <c:pt idx="179">
                  <c:v>546.05899999999997</c:v>
                </c:pt>
                <c:pt idx="180">
                  <c:v>562.09299999999996</c:v>
                </c:pt>
                <c:pt idx="181">
                  <c:v>579.35599999999999</c:v>
                </c:pt>
                <c:pt idx="182">
                  <c:v>595.88900000000001</c:v>
                </c:pt>
                <c:pt idx="183">
                  <c:v>612.31899999999996</c:v>
                </c:pt>
                <c:pt idx="184">
                  <c:v>629.10799999999995</c:v>
                </c:pt>
                <c:pt idx="185">
                  <c:v>647.048</c:v>
                </c:pt>
                <c:pt idx="186">
                  <c:v>663.798</c:v>
                </c:pt>
                <c:pt idx="187">
                  <c:v>678.41899999999998</c:v>
                </c:pt>
                <c:pt idx="188">
                  <c:v>696.51400000000001</c:v>
                </c:pt>
                <c:pt idx="189">
                  <c:v>717.91099999999994</c:v>
                </c:pt>
                <c:pt idx="190">
                  <c:v>737.125</c:v>
                </c:pt>
                <c:pt idx="191">
                  <c:v>758.40599999999995</c:v>
                </c:pt>
                <c:pt idx="192">
                  <c:v>781.81500000000005</c:v>
                </c:pt>
              </c:numCache>
            </c:numRef>
          </c:xVal>
          <c:yVal>
            <c:numRef>
              <c:f>'volume sorted'!$X$2:$X$194</c:f>
              <c:numCache>
                <c:formatCode>General</c:formatCode>
                <c:ptCount val="193"/>
                <c:pt idx="0">
                  <c:v>-608.327</c:v>
                </c:pt>
                <c:pt idx="1">
                  <c:v>-1046.8049999999998</c:v>
                </c:pt>
                <c:pt idx="2">
                  <c:v>-626.25700000000006</c:v>
                </c:pt>
                <c:pt idx="3">
                  <c:v>-807.47699999999998</c:v>
                </c:pt>
                <c:pt idx="4">
                  <c:v>-446.53700000000003</c:v>
                </c:pt>
                <c:pt idx="5">
                  <c:v>-299.44699999999989</c:v>
                </c:pt>
                <c:pt idx="6">
                  <c:v>-403.12699999999995</c:v>
                </c:pt>
                <c:pt idx="7">
                  <c:v>-486.7170000000001</c:v>
                </c:pt>
                <c:pt idx="8">
                  <c:v>-976.60500000000002</c:v>
                </c:pt>
                <c:pt idx="9">
                  <c:v>-1004.253</c:v>
                </c:pt>
                <c:pt idx="10">
                  <c:v>-1039.893</c:v>
                </c:pt>
                <c:pt idx="11">
                  <c:v>-1021.749</c:v>
                </c:pt>
                <c:pt idx="12">
                  <c:v>-1029.309</c:v>
                </c:pt>
                <c:pt idx="13">
                  <c:v>-846.14099999999996</c:v>
                </c:pt>
                <c:pt idx="14">
                  <c:v>-981.35699999999997</c:v>
                </c:pt>
                <c:pt idx="15">
                  <c:v>-618.69699999999989</c:v>
                </c:pt>
                <c:pt idx="16">
                  <c:v>-372.45699999999988</c:v>
                </c:pt>
                <c:pt idx="17">
                  <c:v>-708.98099999999999</c:v>
                </c:pt>
                <c:pt idx="18">
                  <c:v>-852.18899999999996</c:v>
                </c:pt>
                <c:pt idx="19">
                  <c:v>-812.87699999999995</c:v>
                </c:pt>
                <c:pt idx="20">
                  <c:v>-1110.741</c:v>
                </c:pt>
                <c:pt idx="21">
                  <c:v>-942.04499999999996</c:v>
                </c:pt>
                <c:pt idx="22">
                  <c:v>-459.49700000000007</c:v>
                </c:pt>
                <c:pt idx="23">
                  <c:v>-702.06899999999996</c:v>
                </c:pt>
                <c:pt idx="24">
                  <c:v>-1422.645</c:v>
                </c:pt>
                <c:pt idx="25">
                  <c:v>-370.077</c:v>
                </c:pt>
                <c:pt idx="26">
                  <c:v>-1031.4690000000001</c:v>
                </c:pt>
                <c:pt idx="27">
                  <c:v>-870.33299999999997</c:v>
                </c:pt>
                <c:pt idx="28">
                  <c:v>-851.97299999999996</c:v>
                </c:pt>
                <c:pt idx="29">
                  <c:v>-757.149</c:v>
                </c:pt>
                <c:pt idx="30">
                  <c:v>-725.39699999999993</c:v>
                </c:pt>
                <c:pt idx="31">
                  <c:v>-439.84699999999998</c:v>
                </c:pt>
                <c:pt idx="32">
                  <c:v>-588.45699999999988</c:v>
                </c:pt>
                <c:pt idx="33">
                  <c:v>-731.44499999999994</c:v>
                </c:pt>
                <c:pt idx="34">
                  <c:v>-653.6869999999999</c:v>
                </c:pt>
                <c:pt idx="35">
                  <c:v>-631.65699999999993</c:v>
                </c:pt>
                <c:pt idx="36">
                  <c:v>-833.18100000000004</c:v>
                </c:pt>
                <c:pt idx="37">
                  <c:v>-373.74700000000007</c:v>
                </c:pt>
                <c:pt idx="38">
                  <c:v>308.16300000000001</c:v>
                </c:pt>
                <c:pt idx="39">
                  <c:v>-778.31700000000001</c:v>
                </c:pt>
                <c:pt idx="40">
                  <c:v>-421.26700000000005</c:v>
                </c:pt>
                <c:pt idx="41">
                  <c:v>-479.58699999999999</c:v>
                </c:pt>
                <c:pt idx="42">
                  <c:v>-792.35699999999997</c:v>
                </c:pt>
                <c:pt idx="43">
                  <c:v>-275.25700000000006</c:v>
                </c:pt>
                <c:pt idx="44">
                  <c:v>-253.00700000000006</c:v>
                </c:pt>
                <c:pt idx="45">
                  <c:v>202.75299999999993</c:v>
                </c:pt>
                <c:pt idx="46">
                  <c:v>33.843000000000075</c:v>
                </c:pt>
                <c:pt idx="47">
                  <c:v>56.952999999999975</c:v>
                </c:pt>
                <c:pt idx="48">
                  <c:v>292.61300000000006</c:v>
                </c:pt>
                <c:pt idx="49">
                  <c:v>222.19299999999998</c:v>
                </c:pt>
                <c:pt idx="50">
                  <c:v>183.96299999999997</c:v>
                </c:pt>
                <c:pt idx="51">
                  <c:v>317.45299999999997</c:v>
                </c:pt>
                <c:pt idx="52">
                  <c:v>251.7829999999999</c:v>
                </c:pt>
                <c:pt idx="53">
                  <c:v>861.12300000000005</c:v>
                </c:pt>
                <c:pt idx="54">
                  <c:v>717.26299999999992</c:v>
                </c:pt>
                <c:pt idx="55">
                  <c:v>875.59299999999985</c:v>
                </c:pt>
                <c:pt idx="56">
                  <c:v>870.84299999999985</c:v>
                </c:pt>
                <c:pt idx="57">
                  <c:v>895.0329999999999</c:v>
                </c:pt>
                <c:pt idx="58">
                  <c:v>1175.183</c:v>
                </c:pt>
                <c:pt idx="59">
                  <c:v>843.41300000000001</c:v>
                </c:pt>
                <c:pt idx="60">
                  <c:v>2335.973</c:v>
                </c:pt>
                <c:pt idx="61">
                  <c:v>1152.2930000000001</c:v>
                </c:pt>
                <c:pt idx="62">
                  <c:v>2155.6129999999998</c:v>
                </c:pt>
                <c:pt idx="63">
                  <c:v>1432.0129999999999</c:v>
                </c:pt>
                <c:pt idx="64">
                  <c:v>4686.0529999999999</c:v>
                </c:pt>
                <c:pt idx="65">
                  <c:v>3154.6129999999998</c:v>
                </c:pt>
                <c:pt idx="66">
                  <c:v>3814.2729999999997</c:v>
                </c:pt>
                <c:pt idx="67">
                  <c:v>4645.442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726-48F4-840E-A195F1119E1D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volume sorted'!$T$2:$T$194</c:f>
              <c:numCache>
                <c:formatCode>General</c:formatCode>
                <c:ptCount val="193"/>
                <c:pt idx="0">
                  <c:v>102.53100000000001</c:v>
                </c:pt>
                <c:pt idx="1">
                  <c:v>111.65600000000001</c:v>
                </c:pt>
                <c:pt idx="2">
                  <c:v>120.952</c:v>
                </c:pt>
                <c:pt idx="3">
                  <c:v>132.19999999999999</c:v>
                </c:pt>
                <c:pt idx="4">
                  <c:v>142.77600000000001</c:v>
                </c:pt>
                <c:pt idx="5">
                  <c:v>153.02600000000001</c:v>
                </c:pt>
                <c:pt idx="6">
                  <c:v>163.268</c:v>
                </c:pt>
                <c:pt idx="7">
                  <c:v>172.79499999999999</c:v>
                </c:pt>
                <c:pt idx="8">
                  <c:v>180.69300000000001</c:v>
                </c:pt>
                <c:pt idx="9">
                  <c:v>186.279</c:v>
                </c:pt>
                <c:pt idx="10">
                  <c:v>191.613</c:v>
                </c:pt>
                <c:pt idx="11">
                  <c:v>196.935</c:v>
                </c:pt>
                <c:pt idx="12">
                  <c:v>202.49100000000001</c:v>
                </c:pt>
                <c:pt idx="13">
                  <c:v>208.16499999999999</c:v>
                </c:pt>
                <c:pt idx="14">
                  <c:v>213.82599999999999</c:v>
                </c:pt>
                <c:pt idx="15">
                  <c:v>219.661</c:v>
                </c:pt>
                <c:pt idx="16">
                  <c:v>227.60599999999999</c:v>
                </c:pt>
                <c:pt idx="17">
                  <c:v>234.01400000000001</c:v>
                </c:pt>
                <c:pt idx="18">
                  <c:v>240.12299999999999</c:v>
                </c:pt>
                <c:pt idx="19">
                  <c:v>246.34100000000001</c:v>
                </c:pt>
                <c:pt idx="20">
                  <c:v>251.84899999999999</c:v>
                </c:pt>
                <c:pt idx="21">
                  <c:v>257.39600000000002</c:v>
                </c:pt>
                <c:pt idx="22">
                  <c:v>265.16300000000001</c:v>
                </c:pt>
                <c:pt idx="23">
                  <c:v>273.35199999999998</c:v>
                </c:pt>
                <c:pt idx="24">
                  <c:v>281.19600000000003</c:v>
                </c:pt>
                <c:pt idx="25">
                  <c:v>288.13200000000001</c:v>
                </c:pt>
                <c:pt idx="26">
                  <c:v>295.553</c:v>
                </c:pt>
                <c:pt idx="27">
                  <c:v>301.42599999999999</c:v>
                </c:pt>
                <c:pt idx="28">
                  <c:v>308.20100000000002</c:v>
                </c:pt>
                <c:pt idx="29">
                  <c:v>315.50200000000001</c:v>
                </c:pt>
                <c:pt idx="30">
                  <c:v>322.49</c:v>
                </c:pt>
                <c:pt idx="31">
                  <c:v>330.23899999999998</c:v>
                </c:pt>
                <c:pt idx="32">
                  <c:v>337.315</c:v>
                </c:pt>
                <c:pt idx="33">
                  <c:v>344.52499999999998</c:v>
                </c:pt>
                <c:pt idx="34">
                  <c:v>351.34500000000003</c:v>
                </c:pt>
                <c:pt idx="35">
                  <c:v>357.55099999999999</c:v>
                </c:pt>
                <c:pt idx="36">
                  <c:v>363.74900000000002</c:v>
                </c:pt>
                <c:pt idx="37">
                  <c:v>370.267</c:v>
                </c:pt>
                <c:pt idx="38">
                  <c:v>379.86799999999999</c:v>
                </c:pt>
                <c:pt idx="39">
                  <c:v>388.471</c:v>
                </c:pt>
                <c:pt idx="40">
                  <c:v>394.87099999999998</c:v>
                </c:pt>
                <c:pt idx="41">
                  <c:v>402.05200000000002</c:v>
                </c:pt>
                <c:pt idx="42">
                  <c:v>409.05500000000001</c:v>
                </c:pt>
                <c:pt idx="43">
                  <c:v>416.584</c:v>
                </c:pt>
                <c:pt idx="44">
                  <c:v>424.65499999999997</c:v>
                </c:pt>
                <c:pt idx="45">
                  <c:v>433.50200000000001</c:v>
                </c:pt>
                <c:pt idx="46">
                  <c:v>442.80900000000003</c:v>
                </c:pt>
                <c:pt idx="47">
                  <c:v>451.15800000000002</c:v>
                </c:pt>
                <c:pt idx="48">
                  <c:v>460.36</c:v>
                </c:pt>
                <c:pt idx="49">
                  <c:v>470.54199999999997</c:v>
                </c:pt>
                <c:pt idx="50">
                  <c:v>480.56400000000002</c:v>
                </c:pt>
                <c:pt idx="51">
                  <c:v>491.75700000000001</c:v>
                </c:pt>
                <c:pt idx="52">
                  <c:v>503.38299999999998</c:v>
                </c:pt>
                <c:pt idx="53">
                  <c:v>515.79</c:v>
                </c:pt>
                <c:pt idx="54">
                  <c:v>528.11400000000003</c:v>
                </c:pt>
                <c:pt idx="55">
                  <c:v>541.22299999999996</c:v>
                </c:pt>
                <c:pt idx="56">
                  <c:v>554.66999999999996</c:v>
                </c:pt>
                <c:pt idx="57">
                  <c:v>568.60299999999995</c:v>
                </c:pt>
                <c:pt idx="58">
                  <c:v>583.03700000000003</c:v>
                </c:pt>
                <c:pt idx="59">
                  <c:v>596.654</c:v>
                </c:pt>
                <c:pt idx="60">
                  <c:v>613.72699999999998</c:v>
                </c:pt>
                <c:pt idx="61">
                  <c:v>632.38</c:v>
                </c:pt>
                <c:pt idx="62">
                  <c:v>651.93100000000004</c:v>
                </c:pt>
                <c:pt idx="63">
                  <c:v>670.71500000000003</c:v>
                </c:pt>
                <c:pt idx="64">
                  <c:v>695.14800000000002</c:v>
                </c:pt>
                <c:pt idx="65">
                  <c:v>724.56200000000001</c:v>
                </c:pt>
                <c:pt idx="66">
                  <c:v>752.08799999999997</c:v>
                </c:pt>
                <c:pt idx="67">
                  <c:v>784.06399999999996</c:v>
                </c:pt>
                <c:pt idx="68">
                  <c:v>106.664</c:v>
                </c:pt>
                <c:pt idx="69">
                  <c:v>118.238</c:v>
                </c:pt>
                <c:pt idx="70">
                  <c:v>127.428</c:v>
                </c:pt>
                <c:pt idx="71">
                  <c:v>138.661</c:v>
                </c:pt>
                <c:pt idx="72">
                  <c:v>146.399</c:v>
                </c:pt>
                <c:pt idx="73">
                  <c:v>154.08500000000001</c:v>
                </c:pt>
                <c:pt idx="74">
                  <c:v>161.94200000000001</c:v>
                </c:pt>
                <c:pt idx="75">
                  <c:v>170.809</c:v>
                </c:pt>
                <c:pt idx="76">
                  <c:v>180.535</c:v>
                </c:pt>
                <c:pt idx="77">
                  <c:v>189.381</c:v>
                </c:pt>
                <c:pt idx="78">
                  <c:v>197.69399999999999</c:v>
                </c:pt>
                <c:pt idx="79">
                  <c:v>221.64</c:v>
                </c:pt>
                <c:pt idx="80">
                  <c:v>229.11</c:v>
                </c:pt>
                <c:pt idx="81">
                  <c:v>234.572</c:v>
                </c:pt>
                <c:pt idx="82">
                  <c:v>239.90600000000001</c:v>
                </c:pt>
                <c:pt idx="83">
                  <c:v>245.072</c:v>
                </c:pt>
                <c:pt idx="84">
                  <c:v>252.602</c:v>
                </c:pt>
                <c:pt idx="85">
                  <c:v>259.91199999999998</c:v>
                </c:pt>
                <c:pt idx="86">
                  <c:v>265.22199999999998</c:v>
                </c:pt>
                <c:pt idx="87">
                  <c:v>273.50099999999998</c:v>
                </c:pt>
                <c:pt idx="88">
                  <c:v>283.053</c:v>
                </c:pt>
                <c:pt idx="89">
                  <c:v>291.81599999999997</c:v>
                </c:pt>
                <c:pt idx="90">
                  <c:v>300.85700000000003</c:v>
                </c:pt>
                <c:pt idx="91">
                  <c:v>309.541</c:v>
                </c:pt>
                <c:pt idx="92">
                  <c:v>316.21199999999999</c:v>
                </c:pt>
                <c:pt idx="93">
                  <c:v>322.02699999999999</c:v>
                </c:pt>
                <c:pt idx="94">
                  <c:v>327.714</c:v>
                </c:pt>
                <c:pt idx="95">
                  <c:v>336.7</c:v>
                </c:pt>
                <c:pt idx="96">
                  <c:v>344.93099999999998</c:v>
                </c:pt>
                <c:pt idx="97">
                  <c:v>351.06900000000002</c:v>
                </c:pt>
                <c:pt idx="98">
                  <c:v>360.65499999999997</c:v>
                </c:pt>
                <c:pt idx="99">
                  <c:v>369.92200000000003</c:v>
                </c:pt>
                <c:pt idx="100">
                  <c:v>376.48899999999998</c:v>
                </c:pt>
                <c:pt idx="101">
                  <c:v>385.06</c:v>
                </c:pt>
                <c:pt idx="102">
                  <c:v>393.66199999999998</c:v>
                </c:pt>
                <c:pt idx="103">
                  <c:v>399.15899999999999</c:v>
                </c:pt>
                <c:pt idx="104">
                  <c:v>408.41899999999998</c:v>
                </c:pt>
                <c:pt idx="105">
                  <c:v>420.738</c:v>
                </c:pt>
                <c:pt idx="106">
                  <c:v>466.38400000000001</c:v>
                </c:pt>
                <c:pt idx="107">
                  <c:v>481.04700000000003</c:v>
                </c:pt>
                <c:pt idx="108">
                  <c:v>495.851</c:v>
                </c:pt>
                <c:pt idx="109">
                  <c:v>511.56400000000002</c:v>
                </c:pt>
                <c:pt idx="110">
                  <c:v>525.96699999999998</c:v>
                </c:pt>
                <c:pt idx="111">
                  <c:v>538.72400000000005</c:v>
                </c:pt>
                <c:pt idx="112">
                  <c:v>550.80899999999997</c:v>
                </c:pt>
                <c:pt idx="113">
                  <c:v>564.15700000000004</c:v>
                </c:pt>
                <c:pt idx="114">
                  <c:v>581.56600000000003</c:v>
                </c:pt>
                <c:pt idx="115">
                  <c:v>600.33100000000002</c:v>
                </c:pt>
                <c:pt idx="116">
                  <c:v>621.14099999999996</c:v>
                </c:pt>
                <c:pt idx="117">
                  <c:v>644.43200000000002</c:v>
                </c:pt>
                <c:pt idx="118">
                  <c:v>666.38699999999994</c:v>
                </c:pt>
                <c:pt idx="119">
                  <c:v>689.35299999999995</c:v>
                </c:pt>
                <c:pt idx="120">
                  <c:v>716.48</c:v>
                </c:pt>
                <c:pt idx="121">
                  <c:v>752.79899999999998</c:v>
                </c:pt>
                <c:pt idx="122">
                  <c:v>101.354</c:v>
                </c:pt>
                <c:pt idx="123">
                  <c:v>110.285</c:v>
                </c:pt>
                <c:pt idx="124">
                  <c:v>119.23099999999999</c:v>
                </c:pt>
                <c:pt idx="125">
                  <c:v>128.25299999999999</c:v>
                </c:pt>
                <c:pt idx="126">
                  <c:v>134.98599999999999</c:v>
                </c:pt>
                <c:pt idx="127">
                  <c:v>142.226</c:v>
                </c:pt>
                <c:pt idx="128">
                  <c:v>147.11799999999999</c:v>
                </c:pt>
                <c:pt idx="129">
                  <c:v>154.01400000000001</c:v>
                </c:pt>
                <c:pt idx="130">
                  <c:v>162.316</c:v>
                </c:pt>
                <c:pt idx="131">
                  <c:v>168.44499999999999</c:v>
                </c:pt>
                <c:pt idx="132">
                  <c:v>177.22800000000001</c:v>
                </c:pt>
                <c:pt idx="133">
                  <c:v>185.773</c:v>
                </c:pt>
                <c:pt idx="134">
                  <c:v>194.59</c:v>
                </c:pt>
                <c:pt idx="135">
                  <c:v>202.149</c:v>
                </c:pt>
                <c:pt idx="136">
                  <c:v>209.37299999999999</c:v>
                </c:pt>
                <c:pt idx="137">
                  <c:v>216.471</c:v>
                </c:pt>
                <c:pt idx="138">
                  <c:v>224.09299999999999</c:v>
                </c:pt>
                <c:pt idx="139">
                  <c:v>232.02500000000001</c:v>
                </c:pt>
                <c:pt idx="140">
                  <c:v>240.33099999999999</c:v>
                </c:pt>
                <c:pt idx="141">
                  <c:v>246.81700000000001</c:v>
                </c:pt>
                <c:pt idx="142">
                  <c:v>253.31899999999999</c:v>
                </c:pt>
                <c:pt idx="143">
                  <c:v>258.72000000000003</c:v>
                </c:pt>
                <c:pt idx="144">
                  <c:v>264.06</c:v>
                </c:pt>
                <c:pt idx="145">
                  <c:v>269.81599999999997</c:v>
                </c:pt>
                <c:pt idx="146">
                  <c:v>275.27100000000002</c:v>
                </c:pt>
                <c:pt idx="147">
                  <c:v>280.22699999999998</c:v>
                </c:pt>
                <c:pt idx="148">
                  <c:v>285.351</c:v>
                </c:pt>
                <c:pt idx="149">
                  <c:v>291.036</c:v>
                </c:pt>
                <c:pt idx="150">
                  <c:v>297.25200000000001</c:v>
                </c:pt>
                <c:pt idx="151">
                  <c:v>303.54899999999998</c:v>
                </c:pt>
                <c:pt idx="152">
                  <c:v>309.29500000000002</c:v>
                </c:pt>
                <c:pt idx="153">
                  <c:v>316.05</c:v>
                </c:pt>
                <c:pt idx="154">
                  <c:v>323.80700000000002</c:v>
                </c:pt>
                <c:pt idx="155">
                  <c:v>331.15199999999999</c:v>
                </c:pt>
                <c:pt idx="156">
                  <c:v>338.815</c:v>
                </c:pt>
                <c:pt idx="157">
                  <c:v>346.66399999999999</c:v>
                </c:pt>
                <c:pt idx="158">
                  <c:v>353.05599999999998</c:v>
                </c:pt>
                <c:pt idx="159">
                  <c:v>359.30200000000002</c:v>
                </c:pt>
                <c:pt idx="160">
                  <c:v>370.262</c:v>
                </c:pt>
                <c:pt idx="161">
                  <c:v>381.73200000000003</c:v>
                </c:pt>
                <c:pt idx="162">
                  <c:v>390.05</c:v>
                </c:pt>
                <c:pt idx="163">
                  <c:v>397.58199999999999</c:v>
                </c:pt>
                <c:pt idx="164">
                  <c:v>399.233</c:v>
                </c:pt>
                <c:pt idx="165">
                  <c:v>406.04500000000002</c:v>
                </c:pt>
                <c:pt idx="166">
                  <c:v>413.32600000000002</c:v>
                </c:pt>
                <c:pt idx="167">
                  <c:v>420.68700000000001</c:v>
                </c:pt>
                <c:pt idx="168">
                  <c:v>428.298</c:v>
                </c:pt>
                <c:pt idx="169">
                  <c:v>436.714</c:v>
                </c:pt>
                <c:pt idx="170">
                  <c:v>444.64800000000002</c:v>
                </c:pt>
                <c:pt idx="171">
                  <c:v>452.44200000000001</c:v>
                </c:pt>
                <c:pt idx="172">
                  <c:v>458.15699999999998</c:v>
                </c:pt>
                <c:pt idx="173">
                  <c:v>468.74299999999999</c:v>
                </c:pt>
                <c:pt idx="174">
                  <c:v>490.65499999999997</c:v>
                </c:pt>
                <c:pt idx="175">
                  <c:v>501.18299999999999</c:v>
                </c:pt>
                <c:pt idx="176">
                  <c:v>512.32100000000003</c:v>
                </c:pt>
                <c:pt idx="177">
                  <c:v>520.39099999999996</c:v>
                </c:pt>
                <c:pt idx="178">
                  <c:v>531.51199999999994</c:v>
                </c:pt>
                <c:pt idx="179">
                  <c:v>546.05899999999997</c:v>
                </c:pt>
                <c:pt idx="180">
                  <c:v>562.09299999999996</c:v>
                </c:pt>
                <c:pt idx="181">
                  <c:v>579.35599999999999</c:v>
                </c:pt>
                <c:pt idx="182">
                  <c:v>595.88900000000001</c:v>
                </c:pt>
                <c:pt idx="183">
                  <c:v>612.31899999999996</c:v>
                </c:pt>
                <c:pt idx="184">
                  <c:v>629.10799999999995</c:v>
                </c:pt>
                <c:pt idx="185">
                  <c:v>647.048</c:v>
                </c:pt>
                <c:pt idx="186">
                  <c:v>663.798</c:v>
                </c:pt>
                <c:pt idx="187">
                  <c:v>678.41899999999998</c:v>
                </c:pt>
                <c:pt idx="188">
                  <c:v>696.51400000000001</c:v>
                </c:pt>
                <c:pt idx="189">
                  <c:v>717.91099999999994</c:v>
                </c:pt>
                <c:pt idx="190">
                  <c:v>737.125</c:v>
                </c:pt>
                <c:pt idx="191">
                  <c:v>758.40599999999995</c:v>
                </c:pt>
                <c:pt idx="192">
                  <c:v>781.81500000000005</c:v>
                </c:pt>
              </c:numCache>
            </c:numRef>
          </c:xVal>
          <c:yVal>
            <c:numRef>
              <c:f>'volume sorted'!$Y$2:$Y$194</c:f>
              <c:numCache>
                <c:formatCode>General</c:formatCode>
                <c:ptCount val="193"/>
                <c:pt idx="68">
                  <c:v>-609.26599999999985</c:v>
                </c:pt>
                <c:pt idx="69">
                  <c:v>-763.05600000000004</c:v>
                </c:pt>
                <c:pt idx="70">
                  <c:v>-499.32600000000002</c:v>
                </c:pt>
                <c:pt idx="71">
                  <c:v>-1075.1759999999999</c:v>
                </c:pt>
                <c:pt idx="72">
                  <c:v>-1217.7399999999998</c:v>
                </c:pt>
                <c:pt idx="73">
                  <c:v>-916.2059999999999</c:v>
                </c:pt>
                <c:pt idx="74">
                  <c:v>-1198.732</c:v>
                </c:pt>
                <c:pt idx="75">
                  <c:v>-691.56600000000003</c:v>
                </c:pt>
                <c:pt idx="76">
                  <c:v>-533.88599999999997</c:v>
                </c:pt>
                <c:pt idx="77">
                  <c:v>-1128.3159999999998</c:v>
                </c:pt>
                <c:pt idx="78">
                  <c:v>-656.35599999999999</c:v>
                </c:pt>
                <c:pt idx="79">
                  <c:v>-417.4559999999999</c:v>
                </c:pt>
                <c:pt idx="80">
                  <c:v>-1098.9359999999999</c:v>
                </c:pt>
                <c:pt idx="81">
                  <c:v>-1277.356</c:v>
                </c:pt>
                <c:pt idx="82">
                  <c:v>-1384.06</c:v>
                </c:pt>
                <c:pt idx="83">
                  <c:v>-1303.7080000000001</c:v>
                </c:pt>
                <c:pt idx="84">
                  <c:v>-640.37599999999998</c:v>
                </c:pt>
                <c:pt idx="85">
                  <c:v>-1314.076</c:v>
                </c:pt>
                <c:pt idx="86">
                  <c:v>-1373.9079999999999</c:v>
                </c:pt>
                <c:pt idx="87">
                  <c:v>-576.86599999999999</c:v>
                </c:pt>
                <c:pt idx="88">
                  <c:v>-724.82600000000002</c:v>
                </c:pt>
                <c:pt idx="89">
                  <c:v>-504.93599999999992</c:v>
                </c:pt>
                <c:pt idx="90">
                  <c:v>-161.71599999999989</c:v>
                </c:pt>
                <c:pt idx="91">
                  <c:v>-1074.9659999999999</c:v>
                </c:pt>
                <c:pt idx="92">
                  <c:v>-1024.2059999999999</c:v>
                </c:pt>
                <c:pt idx="93">
                  <c:v>-1266.556</c:v>
                </c:pt>
                <c:pt idx="94">
                  <c:v>-1161.58</c:v>
                </c:pt>
                <c:pt idx="95">
                  <c:v>-5.1159999999999854</c:v>
                </c:pt>
                <c:pt idx="96">
                  <c:v>-1335.46</c:v>
                </c:pt>
                <c:pt idx="97">
                  <c:v>-993.53600000000006</c:v>
                </c:pt>
                <c:pt idx="98">
                  <c:v>310.02399999999989</c:v>
                </c:pt>
                <c:pt idx="99">
                  <c:v>-956.16599999999994</c:v>
                </c:pt>
                <c:pt idx="100">
                  <c:v>-1039.5360000000001</c:v>
                </c:pt>
                <c:pt idx="101">
                  <c:v>-29.956000000000131</c:v>
                </c:pt>
                <c:pt idx="102">
                  <c:v>-1364.404</c:v>
                </c:pt>
                <c:pt idx="103">
                  <c:v>-1044.5059999999999</c:v>
                </c:pt>
                <c:pt idx="104">
                  <c:v>200.08399999999983</c:v>
                </c:pt>
                <c:pt idx="105">
                  <c:v>324.50399999999991</c:v>
                </c:pt>
                <c:pt idx="106">
                  <c:v>863.63400000000001</c:v>
                </c:pt>
                <c:pt idx="107">
                  <c:v>530.56399999999985</c:v>
                </c:pt>
                <c:pt idx="108">
                  <c:v>502.48399999999992</c:v>
                </c:pt>
                <c:pt idx="109">
                  <c:v>547.84400000000005</c:v>
                </c:pt>
                <c:pt idx="110">
                  <c:v>40.463999999999942</c:v>
                </c:pt>
                <c:pt idx="111">
                  <c:v>66.594000000000051</c:v>
                </c:pt>
                <c:pt idx="112">
                  <c:v>305.49400000000014</c:v>
                </c:pt>
                <c:pt idx="113">
                  <c:v>878.32400000000007</c:v>
                </c:pt>
                <c:pt idx="114">
                  <c:v>902.73399999999992</c:v>
                </c:pt>
                <c:pt idx="115">
                  <c:v>1847.3040000000001</c:v>
                </c:pt>
                <c:pt idx="116">
                  <c:v>2263.5339999999997</c:v>
                </c:pt>
                <c:pt idx="117">
                  <c:v>3800.1540000000005</c:v>
                </c:pt>
                <c:pt idx="118">
                  <c:v>1968.0439999999999</c:v>
                </c:pt>
                <c:pt idx="119">
                  <c:v>4001.2539999999999</c:v>
                </c:pt>
                <c:pt idx="120">
                  <c:v>3465.5739999999996</c:v>
                </c:pt>
                <c:pt idx="121">
                  <c:v>8545.24399999999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726-48F4-840E-A195F1119E1D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volume sorted'!$T$2:$T$194</c:f>
              <c:numCache>
                <c:formatCode>General</c:formatCode>
                <c:ptCount val="193"/>
                <c:pt idx="0">
                  <c:v>102.53100000000001</c:v>
                </c:pt>
                <c:pt idx="1">
                  <c:v>111.65600000000001</c:v>
                </c:pt>
                <c:pt idx="2">
                  <c:v>120.952</c:v>
                </c:pt>
                <c:pt idx="3">
                  <c:v>132.19999999999999</c:v>
                </c:pt>
                <c:pt idx="4">
                  <c:v>142.77600000000001</c:v>
                </c:pt>
                <c:pt idx="5">
                  <c:v>153.02600000000001</c:v>
                </c:pt>
                <c:pt idx="6">
                  <c:v>163.268</c:v>
                </c:pt>
                <c:pt idx="7">
                  <c:v>172.79499999999999</c:v>
                </c:pt>
                <c:pt idx="8">
                  <c:v>180.69300000000001</c:v>
                </c:pt>
                <c:pt idx="9">
                  <c:v>186.279</c:v>
                </c:pt>
                <c:pt idx="10">
                  <c:v>191.613</c:v>
                </c:pt>
                <c:pt idx="11">
                  <c:v>196.935</c:v>
                </c:pt>
                <c:pt idx="12">
                  <c:v>202.49100000000001</c:v>
                </c:pt>
                <c:pt idx="13">
                  <c:v>208.16499999999999</c:v>
                </c:pt>
                <c:pt idx="14">
                  <c:v>213.82599999999999</c:v>
                </c:pt>
                <c:pt idx="15">
                  <c:v>219.661</c:v>
                </c:pt>
                <c:pt idx="16">
                  <c:v>227.60599999999999</c:v>
                </c:pt>
                <c:pt idx="17">
                  <c:v>234.01400000000001</c:v>
                </c:pt>
                <c:pt idx="18">
                  <c:v>240.12299999999999</c:v>
                </c:pt>
                <c:pt idx="19">
                  <c:v>246.34100000000001</c:v>
                </c:pt>
                <c:pt idx="20">
                  <c:v>251.84899999999999</c:v>
                </c:pt>
                <c:pt idx="21">
                  <c:v>257.39600000000002</c:v>
                </c:pt>
                <c:pt idx="22">
                  <c:v>265.16300000000001</c:v>
                </c:pt>
                <c:pt idx="23">
                  <c:v>273.35199999999998</c:v>
                </c:pt>
                <c:pt idx="24">
                  <c:v>281.19600000000003</c:v>
                </c:pt>
                <c:pt idx="25">
                  <c:v>288.13200000000001</c:v>
                </c:pt>
                <c:pt idx="26">
                  <c:v>295.553</c:v>
                </c:pt>
                <c:pt idx="27">
                  <c:v>301.42599999999999</c:v>
                </c:pt>
                <c:pt idx="28">
                  <c:v>308.20100000000002</c:v>
                </c:pt>
                <c:pt idx="29">
                  <c:v>315.50200000000001</c:v>
                </c:pt>
                <c:pt idx="30">
                  <c:v>322.49</c:v>
                </c:pt>
                <c:pt idx="31">
                  <c:v>330.23899999999998</c:v>
                </c:pt>
                <c:pt idx="32">
                  <c:v>337.315</c:v>
                </c:pt>
                <c:pt idx="33">
                  <c:v>344.52499999999998</c:v>
                </c:pt>
                <c:pt idx="34">
                  <c:v>351.34500000000003</c:v>
                </c:pt>
                <c:pt idx="35">
                  <c:v>357.55099999999999</c:v>
                </c:pt>
                <c:pt idx="36">
                  <c:v>363.74900000000002</c:v>
                </c:pt>
                <c:pt idx="37">
                  <c:v>370.267</c:v>
                </c:pt>
                <c:pt idx="38">
                  <c:v>379.86799999999999</c:v>
                </c:pt>
                <c:pt idx="39">
                  <c:v>388.471</c:v>
                </c:pt>
                <c:pt idx="40">
                  <c:v>394.87099999999998</c:v>
                </c:pt>
                <c:pt idx="41">
                  <c:v>402.05200000000002</c:v>
                </c:pt>
                <c:pt idx="42">
                  <c:v>409.05500000000001</c:v>
                </c:pt>
                <c:pt idx="43">
                  <c:v>416.584</c:v>
                </c:pt>
                <c:pt idx="44">
                  <c:v>424.65499999999997</c:v>
                </c:pt>
                <c:pt idx="45">
                  <c:v>433.50200000000001</c:v>
                </c:pt>
                <c:pt idx="46">
                  <c:v>442.80900000000003</c:v>
                </c:pt>
                <c:pt idx="47">
                  <c:v>451.15800000000002</c:v>
                </c:pt>
                <c:pt idx="48">
                  <c:v>460.36</c:v>
                </c:pt>
                <c:pt idx="49">
                  <c:v>470.54199999999997</c:v>
                </c:pt>
                <c:pt idx="50">
                  <c:v>480.56400000000002</c:v>
                </c:pt>
                <c:pt idx="51">
                  <c:v>491.75700000000001</c:v>
                </c:pt>
                <c:pt idx="52">
                  <c:v>503.38299999999998</c:v>
                </c:pt>
                <c:pt idx="53">
                  <c:v>515.79</c:v>
                </c:pt>
                <c:pt idx="54">
                  <c:v>528.11400000000003</c:v>
                </c:pt>
                <c:pt idx="55">
                  <c:v>541.22299999999996</c:v>
                </c:pt>
                <c:pt idx="56">
                  <c:v>554.66999999999996</c:v>
                </c:pt>
                <c:pt idx="57">
                  <c:v>568.60299999999995</c:v>
                </c:pt>
                <c:pt idx="58">
                  <c:v>583.03700000000003</c:v>
                </c:pt>
                <c:pt idx="59">
                  <c:v>596.654</c:v>
                </c:pt>
                <c:pt idx="60">
                  <c:v>613.72699999999998</c:v>
                </c:pt>
                <c:pt idx="61">
                  <c:v>632.38</c:v>
                </c:pt>
                <c:pt idx="62">
                  <c:v>651.93100000000004</c:v>
                </c:pt>
                <c:pt idx="63">
                  <c:v>670.71500000000003</c:v>
                </c:pt>
                <c:pt idx="64">
                  <c:v>695.14800000000002</c:v>
                </c:pt>
                <c:pt idx="65">
                  <c:v>724.56200000000001</c:v>
                </c:pt>
                <c:pt idx="66">
                  <c:v>752.08799999999997</c:v>
                </c:pt>
                <c:pt idx="67">
                  <c:v>784.06399999999996</c:v>
                </c:pt>
                <c:pt idx="68">
                  <c:v>106.664</c:v>
                </c:pt>
                <c:pt idx="69">
                  <c:v>118.238</c:v>
                </c:pt>
                <c:pt idx="70">
                  <c:v>127.428</c:v>
                </c:pt>
                <c:pt idx="71">
                  <c:v>138.661</c:v>
                </c:pt>
                <c:pt idx="72">
                  <c:v>146.399</c:v>
                </c:pt>
                <c:pt idx="73">
                  <c:v>154.08500000000001</c:v>
                </c:pt>
                <c:pt idx="74">
                  <c:v>161.94200000000001</c:v>
                </c:pt>
                <c:pt idx="75">
                  <c:v>170.809</c:v>
                </c:pt>
                <c:pt idx="76">
                  <c:v>180.535</c:v>
                </c:pt>
                <c:pt idx="77">
                  <c:v>189.381</c:v>
                </c:pt>
                <c:pt idx="78">
                  <c:v>197.69399999999999</c:v>
                </c:pt>
                <c:pt idx="79">
                  <c:v>221.64</c:v>
                </c:pt>
                <c:pt idx="80">
                  <c:v>229.11</c:v>
                </c:pt>
                <c:pt idx="81">
                  <c:v>234.572</c:v>
                </c:pt>
                <c:pt idx="82">
                  <c:v>239.90600000000001</c:v>
                </c:pt>
                <c:pt idx="83">
                  <c:v>245.072</c:v>
                </c:pt>
                <c:pt idx="84">
                  <c:v>252.602</c:v>
                </c:pt>
                <c:pt idx="85">
                  <c:v>259.91199999999998</c:v>
                </c:pt>
                <c:pt idx="86">
                  <c:v>265.22199999999998</c:v>
                </c:pt>
                <c:pt idx="87">
                  <c:v>273.50099999999998</c:v>
                </c:pt>
                <c:pt idx="88">
                  <c:v>283.053</c:v>
                </c:pt>
                <c:pt idx="89">
                  <c:v>291.81599999999997</c:v>
                </c:pt>
                <c:pt idx="90">
                  <c:v>300.85700000000003</c:v>
                </c:pt>
                <c:pt idx="91">
                  <c:v>309.541</c:v>
                </c:pt>
                <c:pt idx="92">
                  <c:v>316.21199999999999</c:v>
                </c:pt>
                <c:pt idx="93">
                  <c:v>322.02699999999999</c:v>
                </c:pt>
                <c:pt idx="94">
                  <c:v>327.714</c:v>
                </c:pt>
                <c:pt idx="95">
                  <c:v>336.7</c:v>
                </c:pt>
                <c:pt idx="96">
                  <c:v>344.93099999999998</c:v>
                </c:pt>
                <c:pt idx="97">
                  <c:v>351.06900000000002</c:v>
                </c:pt>
                <c:pt idx="98">
                  <c:v>360.65499999999997</c:v>
                </c:pt>
                <c:pt idx="99">
                  <c:v>369.92200000000003</c:v>
                </c:pt>
                <c:pt idx="100">
                  <c:v>376.48899999999998</c:v>
                </c:pt>
                <c:pt idx="101">
                  <c:v>385.06</c:v>
                </c:pt>
                <c:pt idx="102">
                  <c:v>393.66199999999998</c:v>
                </c:pt>
                <c:pt idx="103">
                  <c:v>399.15899999999999</c:v>
                </c:pt>
                <c:pt idx="104">
                  <c:v>408.41899999999998</c:v>
                </c:pt>
                <c:pt idx="105">
                  <c:v>420.738</c:v>
                </c:pt>
                <c:pt idx="106">
                  <c:v>466.38400000000001</c:v>
                </c:pt>
                <c:pt idx="107">
                  <c:v>481.04700000000003</c:v>
                </c:pt>
                <c:pt idx="108">
                  <c:v>495.851</c:v>
                </c:pt>
                <c:pt idx="109">
                  <c:v>511.56400000000002</c:v>
                </c:pt>
                <c:pt idx="110">
                  <c:v>525.96699999999998</c:v>
                </c:pt>
                <c:pt idx="111">
                  <c:v>538.72400000000005</c:v>
                </c:pt>
                <c:pt idx="112">
                  <c:v>550.80899999999997</c:v>
                </c:pt>
                <c:pt idx="113">
                  <c:v>564.15700000000004</c:v>
                </c:pt>
                <c:pt idx="114">
                  <c:v>581.56600000000003</c:v>
                </c:pt>
                <c:pt idx="115">
                  <c:v>600.33100000000002</c:v>
                </c:pt>
                <c:pt idx="116">
                  <c:v>621.14099999999996</c:v>
                </c:pt>
                <c:pt idx="117">
                  <c:v>644.43200000000002</c:v>
                </c:pt>
                <c:pt idx="118">
                  <c:v>666.38699999999994</c:v>
                </c:pt>
                <c:pt idx="119">
                  <c:v>689.35299999999995</c:v>
                </c:pt>
                <c:pt idx="120">
                  <c:v>716.48</c:v>
                </c:pt>
                <c:pt idx="121">
                  <c:v>752.79899999999998</c:v>
                </c:pt>
                <c:pt idx="122">
                  <c:v>101.354</c:v>
                </c:pt>
                <c:pt idx="123">
                  <c:v>110.285</c:v>
                </c:pt>
                <c:pt idx="124">
                  <c:v>119.23099999999999</c:v>
                </c:pt>
                <c:pt idx="125">
                  <c:v>128.25299999999999</c:v>
                </c:pt>
                <c:pt idx="126">
                  <c:v>134.98599999999999</c:v>
                </c:pt>
                <c:pt idx="127">
                  <c:v>142.226</c:v>
                </c:pt>
                <c:pt idx="128">
                  <c:v>147.11799999999999</c:v>
                </c:pt>
                <c:pt idx="129">
                  <c:v>154.01400000000001</c:v>
                </c:pt>
                <c:pt idx="130">
                  <c:v>162.316</c:v>
                </c:pt>
                <c:pt idx="131">
                  <c:v>168.44499999999999</c:v>
                </c:pt>
                <c:pt idx="132">
                  <c:v>177.22800000000001</c:v>
                </c:pt>
                <c:pt idx="133">
                  <c:v>185.773</c:v>
                </c:pt>
                <c:pt idx="134">
                  <c:v>194.59</c:v>
                </c:pt>
                <c:pt idx="135">
                  <c:v>202.149</c:v>
                </c:pt>
                <c:pt idx="136">
                  <c:v>209.37299999999999</c:v>
                </c:pt>
                <c:pt idx="137">
                  <c:v>216.471</c:v>
                </c:pt>
                <c:pt idx="138">
                  <c:v>224.09299999999999</c:v>
                </c:pt>
                <c:pt idx="139">
                  <c:v>232.02500000000001</c:v>
                </c:pt>
                <c:pt idx="140">
                  <c:v>240.33099999999999</c:v>
                </c:pt>
                <c:pt idx="141">
                  <c:v>246.81700000000001</c:v>
                </c:pt>
                <c:pt idx="142">
                  <c:v>253.31899999999999</c:v>
                </c:pt>
                <c:pt idx="143">
                  <c:v>258.72000000000003</c:v>
                </c:pt>
                <c:pt idx="144">
                  <c:v>264.06</c:v>
                </c:pt>
                <c:pt idx="145">
                  <c:v>269.81599999999997</c:v>
                </c:pt>
                <c:pt idx="146">
                  <c:v>275.27100000000002</c:v>
                </c:pt>
                <c:pt idx="147">
                  <c:v>280.22699999999998</c:v>
                </c:pt>
                <c:pt idx="148">
                  <c:v>285.351</c:v>
                </c:pt>
                <c:pt idx="149">
                  <c:v>291.036</c:v>
                </c:pt>
                <c:pt idx="150">
                  <c:v>297.25200000000001</c:v>
                </c:pt>
                <c:pt idx="151">
                  <c:v>303.54899999999998</c:v>
                </c:pt>
                <c:pt idx="152">
                  <c:v>309.29500000000002</c:v>
                </c:pt>
                <c:pt idx="153">
                  <c:v>316.05</c:v>
                </c:pt>
                <c:pt idx="154">
                  <c:v>323.80700000000002</c:v>
                </c:pt>
                <c:pt idx="155">
                  <c:v>331.15199999999999</c:v>
                </c:pt>
                <c:pt idx="156">
                  <c:v>338.815</c:v>
                </c:pt>
                <c:pt idx="157">
                  <c:v>346.66399999999999</c:v>
                </c:pt>
                <c:pt idx="158">
                  <c:v>353.05599999999998</c:v>
                </c:pt>
                <c:pt idx="159">
                  <c:v>359.30200000000002</c:v>
                </c:pt>
                <c:pt idx="160">
                  <c:v>370.262</c:v>
                </c:pt>
                <c:pt idx="161">
                  <c:v>381.73200000000003</c:v>
                </c:pt>
                <c:pt idx="162">
                  <c:v>390.05</c:v>
                </c:pt>
                <c:pt idx="163">
                  <c:v>397.58199999999999</c:v>
                </c:pt>
                <c:pt idx="164">
                  <c:v>399.233</c:v>
                </c:pt>
                <c:pt idx="165">
                  <c:v>406.04500000000002</c:v>
                </c:pt>
                <c:pt idx="166">
                  <c:v>413.32600000000002</c:v>
                </c:pt>
                <c:pt idx="167">
                  <c:v>420.68700000000001</c:v>
                </c:pt>
                <c:pt idx="168">
                  <c:v>428.298</c:v>
                </c:pt>
                <c:pt idx="169">
                  <c:v>436.714</c:v>
                </c:pt>
                <c:pt idx="170">
                  <c:v>444.64800000000002</c:v>
                </c:pt>
                <c:pt idx="171">
                  <c:v>452.44200000000001</c:v>
                </c:pt>
                <c:pt idx="172">
                  <c:v>458.15699999999998</c:v>
                </c:pt>
                <c:pt idx="173">
                  <c:v>468.74299999999999</c:v>
                </c:pt>
                <c:pt idx="174">
                  <c:v>490.65499999999997</c:v>
                </c:pt>
                <c:pt idx="175">
                  <c:v>501.18299999999999</c:v>
                </c:pt>
                <c:pt idx="176">
                  <c:v>512.32100000000003</c:v>
                </c:pt>
                <c:pt idx="177">
                  <c:v>520.39099999999996</c:v>
                </c:pt>
                <c:pt idx="178">
                  <c:v>531.51199999999994</c:v>
                </c:pt>
                <c:pt idx="179">
                  <c:v>546.05899999999997</c:v>
                </c:pt>
                <c:pt idx="180">
                  <c:v>562.09299999999996</c:v>
                </c:pt>
                <c:pt idx="181">
                  <c:v>579.35599999999999</c:v>
                </c:pt>
                <c:pt idx="182">
                  <c:v>595.88900000000001</c:v>
                </c:pt>
                <c:pt idx="183">
                  <c:v>612.31899999999996</c:v>
                </c:pt>
                <c:pt idx="184">
                  <c:v>629.10799999999995</c:v>
                </c:pt>
                <c:pt idx="185">
                  <c:v>647.048</c:v>
                </c:pt>
                <c:pt idx="186">
                  <c:v>663.798</c:v>
                </c:pt>
                <c:pt idx="187">
                  <c:v>678.41899999999998</c:v>
                </c:pt>
                <c:pt idx="188">
                  <c:v>696.51400000000001</c:v>
                </c:pt>
                <c:pt idx="189">
                  <c:v>717.91099999999994</c:v>
                </c:pt>
                <c:pt idx="190">
                  <c:v>737.125</c:v>
                </c:pt>
                <c:pt idx="191">
                  <c:v>758.40599999999995</c:v>
                </c:pt>
                <c:pt idx="192">
                  <c:v>781.81500000000005</c:v>
                </c:pt>
              </c:numCache>
            </c:numRef>
          </c:xVal>
          <c:yVal>
            <c:numRef>
              <c:f>'volume sorted'!$Z$2:$Z$194</c:f>
              <c:numCache>
                <c:formatCode>General</c:formatCode>
                <c:ptCount val="193"/>
                <c:pt idx="122">
                  <c:v>-666.15499999999997</c:v>
                </c:pt>
                <c:pt idx="123">
                  <c:v>-709.79500000000007</c:v>
                </c:pt>
                <c:pt idx="124">
                  <c:v>-638.72499999999991</c:v>
                </c:pt>
                <c:pt idx="125">
                  <c:v>-731.60500000000002</c:v>
                </c:pt>
                <c:pt idx="126">
                  <c:v>-589.47499999999991</c:v>
                </c:pt>
                <c:pt idx="127">
                  <c:v>-854.94499999999994</c:v>
                </c:pt>
                <c:pt idx="128">
                  <c:v>-1159.5029999999999</c:v>
                </c:pt>
                <c:pt idx="129">
                  <c:v>-260.51499999999987</c:v>
                </c:pt>
                <c:pt idx="130">
                  <c:v>-910.88499999999999</c:v>
                </c:pt>
                <c:pt idx="131">
                  <c:v>-579.97499999999991</c:v>
                </c:pt>
                <c:pt idx="132">
                  <c:v>-667.45499999999993</c:v>
                </c:pt>
                <c:pt idx="133">
                  <c:v>-716.27499999999986</c:v>
                </c:pt>
                <c:pt idx="134">
                  <c:v>-354.47499999999991</c:v>
                </c:pt>
                <c:pt idx="135">
                  <c:v>-703.95499999999993</c:v>
                </c:pt>
                <c:pt idx="136">
                  <c:v>-620.15499999999997</c:v>
                </c:pt>
                <c:pt idx="137">
                  <c:v>-840.68499999999995</c:v>
                </c:pt>
                <c:pt idx="138">
                  <c:v>-465.92499999999995</c:v>
                </c:pt>
                <c:pt idx="139">
                  <c:v>-1120.623</c:v>
                </c:pt>
                <c:pt idx="140">
                  <c:v>-401.125</c:v>
                </c:pt>
                <c:pt idx="141">
                  <c:v>-799.86500000000001</c:v>
                </c:pt>
                <c:pt idx="142">
                  <c:v>-968.12699999999995</c:v>
                </c:pt>
                <c:pt idx="143">
                  <c:v>-1088.0070000000001</c:v>
                </c:pt>
                <c:pt idx="144">
                  <c:v>-929.24699999999996</c:v>
                </c:pt>
                <c:pt idx="145">
                  <c:v>-715.625</c:v>
                </c:pt>
                <c:pt idx="146">
                  <c:v>-1035.519</c:v>
                </c:pt>
                <c:pt idx="147">
                  <c:v>-975.471</c:v>
                </c:pt>
                <c:pt idx="148">
                  <c:v>-1053.663</c:v>
                </c:pt>
                <c:pt idx="149">
                  <c:v>-441.7349999999999</c:v>
                </c:pt>
                <c:pt idx="150">
                  <c:v>-666.375</c:v>
                </c:pt>
                <c:pt idx="151">
                  <c:v>-665.72499999999991</c:v>
                </c:pt>
                <c:pt idx="152">
                  <c:v>-808.50499999999988</c:v>
                </c:pt>
                <c:pt idx="153">
                  <c:v>-337.40499999999997</c:v>
                </c:pt>
                <c:pt idx="154">
                  <c:v>-316.67499999999995</c:v>
                </c:pt>
                <c:pt idx="155">
                  <c:v>-615.61500000000001</c:v>
                </c:pt>
                <c:pt idx="156">
                  <c:v>-260.72499999999991</c:v>
                </c:pt>
                <c:pt idx="157">
                  <c:v>-483.20499999999993</c:v>
                </c:pt>
                <c:pt idx="158">
                  <c:v>-859.91499999999996</c:v>
                </c:pt>
                <c:pt idx="159">
                  <c:v>-613.02499999999986</c:v>
                </c:pt>
                <c:pt idx="160">
                  <c:v>1069.1850000000002</c:v>
                </c:pt>
                <c:pt idx="161">
                  <c:v>-479.10500000000002</c:v>
                </c:pt>
                <c:pt idx="162">
                  <c:v>-250.14499999999998</c:v>
                </c:pt>
                <c:pt idx="163">
                  <c:v>-1266.6390000000001</c:v>
                </c:pt>
                <c:pt idx="164">
                  <c:v>-1054.7429999999999</c:v>
                </c:pt>
                <c:pt idx="165">
                  <c:v>-605.03500000000008</c:v>
                </c:pt>
                <c:pt idx="166">
                  <c:v>-542.17499999999995</c:v>
                </c:pt>
                <c:pt idx="167">
                  <c:v>-506.75499999999988</c:v>
                </c:pt>
                <c:pt idx="168">
                  <c:v>-462.68499999999995</c:v>
                </c:pt>
                <c:pt idx="169">
                  <c:v>-334.38499999999999</c:v>
                </c:pt>
                <c:pt idx="170">
                  <c:v>-600.27499999999986</c:v>
                </c:pt>
                <c:pt idx="171">
                  <c:v>-252.95499999999993</c:v>
                </c:pt>
                <c:pt idx="172">
                  <c:v>2090.6450000000004</c:v>
                </c:pt>
                <c:pt idx="173">
                  <c:v>-465.06500000000005</c:v>
                </c:pt>
                <c:pt idx="174">
                  <c:v>-439.79500000000007</c:v>
                </c:pt>
                <c:pt idx="175">
                  <c:v>1120.3750000000002</c:v>
                </c:pt>
                <c:pt idx="176">
                  <c:v>-374.55500000000006</c:v>
                </c:pt>
                <c:pt idx="177">
                  <c:v>-95.055000000000064</c:v>
                </c:pt>
                <c:pt idx="178">
                  <c:v>660.08499999999981</c:v>
                </c:pt>
                <c:pt idx="179">
                  <c:v>1600.325</c:v>
                </c:pt>
                <c:pt idx="180">
                  <c:v>1348.4750000000001</c:v>
                </c:pt>
                <c:pt idx="181">
                  <c:v>1987.1850000000002</c:v>
                </c:pt>
                <c:pt idx="182">
                  <c:v>1485.4150000000002</c:v>
                </c:pt>
                <c:pt idx="183">
                  <c:v>2267.5550000000003</c:v>
                </c:pt>
                <c:pt idx="184">
                  <c:v>1692.345</c:v>
                </c:pt>
                <c:pt idx="185">
                  <c:v>2932.1850000000004</c:v>
                </c:pt>
                <c:pt idx="186">
                  <c:v>1221.4649999999999</c:v>
                </c:pt>
                <c:pt idx="187">
                  <c:v>1776.8050000000001</c:v>
                </c:pt>
                <c:pt idx="188">
                  <c:v>2426.9650000000001</c:v>
                </c:pt>
                <c:pt idx="189">
                  <c:v>3228.1050000000005</c:v>
                </c:pt>
                <c:pt idx="190">
                  <c:v>1305.0550000000001</c:v>
                </c:pt>
                <c:pt idx="191">
                  <c:v>4153.665</c:v>
                </c:pt>
                <c:pt idx="192">
                  <c:v>1990.205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726-48F4-840E-A195F1119E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0986856"/>
        <c:axId val="750988168"/>
      </c:scatterChart>
      <c:valAx>
        <c:axId val="750986856"/>
        <c:scaling>
          <c:orientation val="minMax"/>
          <c:max val="1000"/>
        </c:scaling>
        <c:delete val="1"/>
        <c:axPos val="b"/>
        <c:numFmt formatCode="General" sourceLinked="1"/>
        <c:majorTickMark val="none"/>
        <c:minorTickMark val="none"/>
        <c:tickLblPos val="nextTo"/>
        <c:crossAx val="750988168"/>
        <c:crosses val="autoZero"/>
        <c:crossBetween val="midCat"/>
      </c:valAx>
      <c:valAx>
        <c:axId val="75098816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7509868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V$1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U$2:$U$3663</c:f>
              <c:numCache>
                <c:formatCode>General</c:formatCode>
                <c:ptCount val="3662"/>
                <c:pt idx="0">
                  <c:v>12.165000000000006</c:v>
                </c:pt>
                <c:pt idx="1">
                  <c:v>12.239999999999995</c:v>
                </c:pt>
                <c:pt idx="2">
                  <c:v>10.543000000000006</c:v>
                </c:pt>
                <c:pt idx="3">
                  <c:v>13.01400000000001</c:v>
                </c:pt>
                <c:pt idx="4">
                  <c:v>10.697999999999979</c:v>
                </c:pt>
                <c:pt idx="5">
                  <c:v>7.5960000000000036</c:v>
                </c:pt>
                <c:pt idx="6">
                  <c:v>8.4749999999999943</c:v>
                </c:pt>
                <c:pt idx="7">
                  <c:v>8.5790000000000077</c:v>
                </c:pt>
                <c:pt idx="8">
                  <c:v>12.994</c:v>
                </c:pt>
                <c:pt idx="9">
                  <c:v>15.272999999999996</c:v>
                </c:pt>
                <c:pt idx="11">
                  <c:v>11.354000000000013</c:v>
                </c:pt>
                <c:pt idx="12">
                  <c:v>9.4380000000000166</c:v>
                </c:pt>
                <c:pt idx="13">
                  <c:v>6.3069999999999595</c:v>
                </c:pt>
                <c:pt idx="14">
                  <c:v>5.3670000000000186</c:v>
                </c:pt>
                <c:pt idx="15">
                  <c:v>5.7010000000000218</c:v>
                </c:pt>
                <c:pt idx="16">
                  <c:v>6.5019999999999527</c:v>
                </c:pt>
                <c:pt idx="17">
                  <c:v>6.5080000000000382</c:v>
                </c:pt>
                <c:pt idx="18">
                  <c:v>6.8709999999999809</c:v>
                </c:pt>
                <c:pt idx="19">
                  <c:v>6.4890000000000327</c:v>
                </c:pt>
                <c:pt idx="20">
                  <c:v>8.7789999999999964</c:v>
                </c:pt>
                <c:pt idx="21">
                  <c:v>10.334000000000003</c:v>
                </c:pt>
                <c:pt idx="22">
                  <c:v>9.72199999999998</c:v>
                </c:pt>
                <c:pt idx="23">
                  <c:v>9.4710000000000036</c:v>
                </c:pt>
                <c:pt idx="24">
                  <c:v>10.034999999999968</c:v>
                </c:pt>
                <c:pt idx="25">
                  <c:v>10.451000000000022</c:v>
                </c:pt>
                <c:pt idx="26">
                  <c:v>8.5860000000000127</c:v>
                </c:pt>
                <c:pt idx="27">
                  <c:v>6.4110000000000014</c:v>
                </c:pt>
                <c:pt idx="28">
                  <c:v>6.4279999999999973</c:v>
                </c:pt>
                <c:pt idx="29">
                  <c:v>7.0260000000000105</c:v>
                </c:pt>
                <c:pt idx="30">
                  <c:v>7.1359999999999673</c:v>
                </c:pt>
                <c:pt idx="31">
                  <c:v>7.2560000000000286</c:v>
                </c:pt>
                <c:pt idx="32">
                  <c:v>14.86099999999999</c:v>
                </c:pt>
                <c:pt idx="33">
                  <c:v>14.055000000000007</c:v>
                </c:pt>
                <c:pt idx="34">
                  <c:v>14.224999999999966</c:v>
                </c:pt>
                <c:pt idx="35">
                  <c:v>7.4180000000000064</c:v>
                </c:pt>
                <c:pt idx="36">
                  <c:v>8.1899999999999977</c:v>
                </c:pt>
                <c:pt idx="37">
                  <c:v>16.503000000000043</c:v>
                </c:pt>
                <c:pt idx="38">
                  <c:v>8.7139999999999986</c:v>
                </c:pt>
                <c:pt idx="39">
                  <c:v>10.31699999999995</c:v>
                </c:pt>
                <c:pt idx="40">
                  <c:v>10.718000000000075</c:v>
                </c:pt>
                <c:pt idx="41">
                  <c:v>11.774000000000001</c:v>
                </c:pt>
                <c:pt idx="42">
                  <c:v>12.674999999999955</c:v>
                </c:pt>
                <c:pt idx="43">
                  <c:v>14.119000000000028</c:v>
                </c:pt>
                <c:pt idx="44">
                  <c:v>15.370999999999981</c:v>
                </c:pt>
                <c:pt idx="45">
                  <c:v>18.002999999999929</c:v>
                </c:pt>
                <c:pt idx="46">
                  <c:v>16.240000000000009</c:v>
                </c:pt>
                <c:pt idx="47">
                  <c:v>14.516000000000076</c:v>
                </c:pt>
                <c:pt idx="48">
                  <c:v>16.719999999999914</c:v>
                </c:pt>
                <c:pt idx="49">
                  <c:v>20.597000000000094</c:v>
                </c:pt>
                <c:pt idx="50">
                  <c:v>21.225999999999999</c:v>
                </c:pt>
                <c:pt idx="51">
                  <c:v>22.375</c:v>
                </c:pt>
                <c:pt idx="52">
                  <c:v>29.009999999999991</c:v>
                </c:pt>
                <c:pt idx="53">
                  <c:v>29.569999999999936</c:v>
                </c:pt>
                <c:pt idx="54">
                  <c:v>34.696000000000026</c:v>
                </c:pt>
                <c:pt idx="55">
                  <c:v>17.384</c:v>
                </c:pt>
                <c:pt idx="56">
                  <c:v>13.947000000000003</c:v>
                </c:pt>
                <c:pt idx="57">
                  <c:v>14.829000000000008</c:v>
                </c:pt>
                <c:pt idx="58">
                  <c:v>13.451999999999998</c:v>
                </c:pt>
                <c:pt idx="59">
                  <c:v>13.945999999999998</c:v>
                </c:pt>
                <c:pt idx="60">
                  <c:v>10.775999999999982</c:v>
                </c:pt>
                <c:pt idx="61">
                  <c:v>7.9780000000000086</c:v>
                </c:pt>
                <c:pt idx="62">
                  <c:v>8.8629999999999995</c:v>
                </c:pt>
                <c:pt idx="63">
                  <c:v>9.3220000000000027</c:v>
                </c:pt>
                <c:pt idx="64">
                  <c:v>7.0550000000000068</c:v>
                </c:pt>
                <c:pt idx="65">
                  <c:v>12.312999999999988</c:v>
                </c:pt>
                <c:pt idx="66">
                  <c:v>10.363</c:v>
                </c:pt>
                <c:pt idx="67">
                  <c:v>10.078000000000031</c:v>
                </c:pt>
                <c:pt idx="68">
                  <c:v>10.129999999999995</c:v>
                </c:pt>
                <c:pt idx="69">
                  <c:v>10.54299999999995</c:v>
                </c:pt>
                <c:pt idx="70">
                  <c:v>11.711000000000013</c:v>
                </c:pt>
                <c:pt idx="71">
                  <c:v>9.1720000000000255</c:v>
                </c:pt>
                <c:pt idx="72">
                  <c:v>8.1649999999999636</c:v>
                </c:pt>
                <c:pt idx="73">
                  <c:v>9.0400000000000205</c:v>
                </c:pt>
                <c:pt idx="74">
                  <c:v>9.103999999999985</c:v>
                </c:pt>
                <c:pt idx="75">
                  <c:v>9.0400000000000205</c:v>
                </c:pt>
                <c:pt idx="76">
                  <c:v>9.9359999999999786</c:v>
                </c:pt>
                <c:pt idx="77">
                  <c:v>12.661000000000001</c:v>
                </c:pt>
                <c:pt idx="78">
                  <c:v>9.1140000000000327</c:v>
                </c:pt>
                <c:pt idx="79">
                  <c:v>6.5649999999999977</c:v>
                </c:pt>
                <c:pt idx="80">
                  <c:v>9.4909999999999854</c:v>
                </c:pt>
                <c:pt idx="81">
                  <c:v>12.15100000000001</c:v>
                </c:pt>
                <c:pt idx="82">
                  <c:v>13.671999999999969</c:v>
                </c:pt>
                <c:pt idx="83">
                  <c:v>10.594000000000051</c:v>
                </c:pt>
                <c:pt idx="84">
                  <c:v>7.9849999999999568</c:v>
                </c:pt>
                <c:pt idx="85">
                  <c:v>13.350000000000023</c:v>
                </c:pt>
                <c:pt idx="86">
                  <c:v>13.024000000000001</c:v>
                </c:pt>
                <c:pt idx="87">
                  <c:v>10.134000000000015</c:v>
                </c:pt>
                <c:pt idx="88">
                  <c:v>15.088999999999999</c:v>
                </c:pt>
                <c:pt idx="89">
                  <c:v>12.996999999999957</c:v>
                </c:pt>
                <c:pt idx="90">
                  <c:v>9.6160000000000423</c:v>
                </c:pt>
                <c:pt idx="91">
                  <c:v>24.150000000000034</c:v>
                </c:pt>
                <c:pt idx="92">
                  <c:v>12.74899999999991</c:v>
                </c:pt>
                <c:pt idx="93">
                  <c:v>15.430000000000064</c:v>
                </c:pt>
                <c:pt idx="94">
                  <c:v>15.972999999999956</c:v>
                </c:pt>
                <c:pt idx="95">
                  <c:v>17.092999999999961</c:v>
                </c:pt>
                <c:pt idx="96">
                  <c:v>18.068000000000097</c:v>
                </c:pt>
                <c:pt idx="97">
                  <c:v>11.491999999999962</c:v>
                </c:pt>
                <c:pt idx="98">
                  <c:v>7.79200000000003</c:v>
                </c:pt>
                <c:pt idx="99">
                  <c:v>12.584999999999923</c:v>
                </c:pt>
                <c:pt idx="100">
                  <c:v>18.496000000000095</c:v>
                </c:pt>
                <c:pt idx="101">
                  <c:v>22.138999999999896</c:v>
                </c:pt>
                <c:pt idx="102">
                  <c:v>32.480000000000018</c:v>
                </c:pt>
                <c:pt idx="103">
                  <c:v>40.993000000000052</c:v>
                </c:pt>
                <c:pt idx="104">
                  <c:v>17.798000000000002</c:v>
                </c:pt>
                <c:pt idx="105">
                  <c:v>11.585999999999999</c:v>
                </c:pt>
                <c:pt idx="106">
                  <c:v>8.6479999999999961</c:v>
                </c:pt>
                <c:pt idx="107">
                  <c:v>15.899000000000001</c:v>
                </c:pt>
                <c:pt idx="108">
                  <c:v>18.751000000000005</c:v>
                </c:pt>
                <c:pt idx="109">
                  <c:v>15.324000000000012</c:v>
                </c:pt>
                <c:pt idx="110">
                  <c:v>13.685999999999979</c:v>
                </c:pt>
                <c:pt idx="111">
                  <c:v>9.0630000000000166</c:v>
                </c:pt>
                <c:pt idx="112">
                  <c:v>8.0889999999999986</c:v>
                </c:pt>
                <c:pt idx="113">
                  <c:v>8.186000000000007</c:v>
                </c:pt>
                <c:pt idx="114">
                  <c:v>8.0839999999999748</c:v>
                </c:pt>
                <c:pt idx="115">
                  <c:v>6.8880000000000052</c:v>
                </c:pt>
                <c:pt idx="116">
                  <c:v>8.2350000000000136</c:v>
                </c:pt>
                <c:pt idx="117">
                  <c:v>9.6670000000000016</c:v>
                </c:pt>
                <c:pt idx="118">
                  <c:v>9.3519999999999754</c:v>
                </c:pt>
                <c:pt idx="119">
                  <c:v>9.0160000000000196</c:v>
                </c:pt>
                <c:pt idx="120">
                  <c:v>10.213999999999999</c:v>
                </c:pt>
                <c:pt idx="121">
                  <c:v>9.9019999999999868</c:v>
                </c:pt>
                <c:pt idx="122">
                  <c:v>9.5970000000000368</c:v>
                </c:pt>
                <c:pt idx="123">
                  <c:v>10.375</c:v>
                </c:pt>
                <c:pt idx="124">
                  <c:v>10.385999999999967</c:v>
                </c:pt>
                <c:pt idx="125">
                  <c:v>10.61099999999999</c:v>
                </c:pt>
                <c:pt idx="126">
                  <c:v>12.579000000000008</c:v>
                </c:pt>
                <c:pt idx="127">
                  <c:v>11.420000000000016</c:v>
                </c:pt>
                <c:pt idx="128">
                  <c:v>9.5559999999999832</c:v>
                </c:pt>
                <c:pt idx="129">
                  <c:v>9.2870000000000346</c:v>
                </c:pt>
                <c:pt idx="130">
                  <c:v>8.7109999999999559</c:v>
                </c:pt>
                <c:pt idx="132">
                  <c:v>6.06899999999996</c:v>
                </c:pt>
                <c:pt idx="133">
                  <c:v>7.1920000000000073</c:v>
                </c:pt>
                <c:pt idx="134">
                  <c:v>7.9370000000000118</c:v>
                </c:pt>
                <c:pt idx="135">
                  <c:v>10.451000000000022</c:v>
                </c:pt>
                <c:pt idx="136">
                  <c:v>10.488</c:v>
                </c:pt>
                <c:pt idx="137">
                  <c:v>8.1100000000000136</c:v>
                </c:pt>
                <c:pt idx="138">
                  <c:v>7.9349999999999454</c:v>
                </c:pt>
                <c:pt idx="139">
                  <c:v>9.1910000000000309</c:v>
                </c:pt>
                <c:pt idx="140">
                  <c:v>9.1689999999999827</c:v>
                </c:pt>
                <c:pt idx="141">
                  <c:v>9.1440000000000055</c:v>
                </c:pt>
                <c:pt idx="142">
                  <c:v>9.3589999999999804</c:v>
                </c:pt>
                <c:pt idx="143">
                  <c:v>9.8490000000000464</c:v>
                </c:pt>
                <c:pt idx="144">
                  <c:v>9.9869999999999663</c:v>
                </c:pt>
                <c:pt idx="145">
                  <c:v>10.74799999999999</c:v>
                </c:pt>
                <c:pt idx="146">
                  <c:v>12.710000000000036</c:v>
                </c:pt>
                <c:pt idx="147">
                  <c:v>14.309999999999945</c:v>
                </c:pt>
                <c:pt idx="148">
                  <c:v>16.221000000000004</c:v>
                </c:pt>
                <c:pt idx="149">
                  <c:v>15.798000000000002</c:v>
                </c:pt>
                <c:pt idx="150">
                  <c:v>17.548000000000002</c:v>
                </c:pt>
                <c:pt idx="151">
                  <c:v>19.968000000000075</c:v>
                </c:pt>
                <c:pt idx="152">
                  <c:v>19.334999999999923</c:v>
                </c:pt>
                <c:pt idx="153">
                  <c:v>35.594000000000051</c:v>
                </c:pt>
                <c:pt idx="154">
                  <c:v>35.782000000000039</c:v>
                </c:pt>
                <c:pt idx="155">
                  <c:v>37.406999999999925</c:v>
                </c:pt>
                <c:pt idx="156">
                  <c:v>38.081999999999994</c:v>
                </c:pt>
              </c:numCache>
            </c:numRef>
          </c:xVal>
          <c:yVal>
            <c:numRef>
              <c:f>Sheet1!$V$2:$V$3663</c:f>
              <c:numCache>
                <c:formatCode>General</c:formatCode>
                <c:ptCount val="3662"/>
                <c:pt idx="0">
                  <c:v>108.48699999999999</c:v>
                </c:pt>
                <c:pt idx="1">
                  <c:v>120.652</c:v>
                </c:pt>
                <c:pt idx="2">
                  <c:v>132.892</c:v>
                </c:pt>
                <c:pt idx="3">
                  <c:v>143.435</c:v>
                </c:pt>
                <c:pt idx="4">
                  <c:v>156.44900000000001</c:v>
                </c:pt>
                <c:pt idx="5">
                  <c:v>167.14699999999999</c:v>
                </c:pt>
                <c:pt idx="6">
                  <c:v>174.74299999999999</c:v>
                </c:pt>
                <c:pt idx="7">
                  <c:v>183.21799999999999</c:v>
                </c:pt>
                <c:pt idx="8">
                  <c:v>191.797</c:v>
                </c:pt>
                <c:pt idx="9">
                  <c:v>204.791</c:v>
                </c:pt>
                <c:pt idx="11">
                  <c:v>242.57</c:v>
                </c:pt>
                <c:pt idx="12">
                  <c:v>253.92400000000001</c:v>
                </c:pt>
                <c:pt idx="13">
                  <c:v>263.36200000000002</c:v>
                </c:pt>
                <c:pt idx="14">
                  <c:v>269.66899999999998</c:v>
                </c:pt>
                <c:pt idx="15">
                  <c:v>275.036</c:v>
                </c:pt>
                <c:pt idx="16">
                  <c:v>280.73700000000002</c:v>
                </c:pt>
                <c:pt idx="17">
                  <c:v>287.23899999999998</c:v>
                </c:pt>
                <c:pt idx="18">
                  <c:v>293.74700000000001</c:v>
                </c:pt>
                <c:pt idx="19">
                  <c:v>300.61799999999999</c:v>
                </c:pt>
                <c:pt idx="20">
                  <c:v>307.10700000000003</c:v>
                </c:pt>
                <c:pt idx="21">
                  <c:v>315.88600000000002</c:v>
                </c:pt>
                <c:pt idx="22">
                  <c:v>326.22000000000003</c:v>
                </c:pt>
                <c:pt idx="23">
                  <c:v>335.94200000000001</c:v>
                </c:pt>
                <c:pt idx="24">
                  <c:v>345.41300000000001</c:v>
                </c:pt>
                <c:pt idx="25">
                  <c:v>355.44799999999998</c:v>
                </c:pt>
                <c:pt idx="26">
                  <c:v>365.899</c:v>
                </c:pt>
                <c:pt idx="27">
                  <c:v>374.48500000000001</c:v>
                </c:pt>
                <c:pt idx="28">
                  <c:v>380.89600000000002</c:v>
                </c:pt>
                <c:pt idx="29">
                  <c:v>387.32400000000001</c:v>
                </c:pt>
                <c:pt idx="30">
                  <c:v>394.35</c:v>
                </c:pt>
                <c:pt idx="31">
                  <c:v>401.48599999999999</c:v>
                </c:pt>
                <c:pt idx="32">
                  <c:v>408.74200000000002</c:v>
                </c:pt>
                <c:pt idx="33">
                  <c:v>423.60300000000001</c:v>
                </c:pt>
                <c:pt idx="34">
                  <c:v>437.65800000000002</c:v>
                </c:pt>
                <c:pt idx="35">
                  <c:v>451.88299999999998</c:v>
                </c:pt>
                <c:pt idx="36">
                  <c:v>459.30099999999999</c:v>
                </c:pt>
                <c:pt idx="37">
                  <c:v>467.49099999999999</c:v>
                </c:pt>
                <c:pt idx="38">
                  <c:v>483.99400000000003</c:v>
                </c:pt>
                <c:pt idx="39">
                  <c:v>492.70800000000003</c:v>
                </c:pt>
                <c:pt idx="40">
                  <c:v>503.02499999999998</c:v>
                </c:pt>
                <c:pt idx="41">
                  <c:v>513.74300000000005</c:v>
                </c:pt>
                <c:pt idx="42">
                  <c:v>525.51700000000005</c:v>
                </c:pt>
                <c:pt idx="43">
                  <c:v>538.19200000000001</c:v>
                </c:pt>
                <c:pt idx="44">
                  <c:v>552.31100000000004</c:v>
                </c:pt>
                <c:pt idx="45">
                  <c:v>567.68200000000002</c:v>
                </c:pt>
                <c:pt idx="46">
                  <c:v>585.68499999999995</c:v>
                </c:pt>
                <c:pt idx="47">
                  <c:v>601.92499999999995</c:v>
                </c:pt>
                <c:pt idx="48">
                  <c:v>616.44100000000003</c:v>
                </c:pt>
                <c:pt idx="49">
                  <c:v>633.16099999999994</c:v>
                </c:pt>
                <c:pt idx="50">
                  <c:v>653.75800000000004</c:v>
                </c:pt>
                <c:pt idx="51">
                  <c:v>674.98400000000004</c:v>
                </c:pt>
                <c:pt idx="52">
                  <c:v>697.35900000000004</c:v>
                </c:pt>
                <c:pt idx="53">
                  <c:v>726.36900000000003</c:v>
                </c:pt>
                <c:pt idx="54">
                  <c:v>755.938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3D3-4032-A1FA-3106AD67BE96}"/>
            </c:ext>
          </c:extLst>
        </c:ser>
        <c:ser>
          <c:idx val="1"/>
          <c:order val="1"/>
          <c:tx>
            <c:strRef>
              <c:f>Sheet1!$W$1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U$2:$U$3663</c:f>
              <c:numCache>
                <c:formatCode>General</c:formatCode>
                <c:ptCount val="3662"/>
                <c:pt idx="0">
                  <c:v>12.165000000000006</c:v>
                </c:pt>
                <c:pt idx="1">
                  <c:v>12.239999999999995</c:v>
                </c:pt>
                <c:pt idx="2">
                  <c:v>10.543000000000006</c:v>
                </c:pt>
                <c:pt idx="3">
                  <c:v>13.01400000000001</c:v>
                </c:pt>
                <c:pt idx="4">
                  <c:v>10.697999999999979</c:v>
                </c:pt>
                <c:pt idx="5">
                  <c:v>7.5960000000000036</c:v>
                </c:pt>
                <c:pt idx="6">
                  <c:v>8.4749999999999943</c:v>
                </c:pt>
                <c:pt idx="7">
                  <c:v>8.5790000000000077</c:v>
                </c:pt>
                <c:pt idx="8">
                  <c:v>12.994</c:v>
                </c:pt>
                <c:pt idx="9">
                  <c:v>15.272999999999996</c:v>
                </c:pt>
                <c:pt idx="11">
                  <c:v>11.354000000000013</c:v>
                </c:pt>
                <c:pt idx="12">
                  <c:v>9.4380000000000166</c:v>
                </c:pt>
                <c:pt idx="13">
                  <c:v>6.3069999999999595</c:v>
                </c:pt>
                <c:pt idx="14">
                  <c:v>5.3670000000000186</c:v>
                </c:pt>
                <c:pt idx="15">
                  <c:v>5.7010000000000218</c:v>
                </c:pt>
                <c:pt idx="16">
                  <c:v>6.5019999999999527</c:v>
                </c:pt>
                <c:pt idx="17">
                  <c:v>6.5080000000000382</c:v>
                </c:pt>
                <c:pt idx="18">
                  <c:v>6.8709999999999809</c:v>
                </c:pt>
                <c:pt idx="19">
                  <c:v>6.4890000000000327</c:v>
                </c:pt>
                <c:pt idx="20">
                  <c:v>8.7789999999999964</c:v>
                </c:pt>
                <c:pt idx="21">
                  <c:v>10.334000000000003</c:v>
                </c:pt>
                <c:pt idx="22">
                  <c:v>9.72199999999998</c:v>
                </c:pt>
                <c:pt idx="23">
                  <c:v>9.4710000000000036</c:v>
                </c:pt>
                <c:pt idx="24">
                  <c:v>10.034999999999968</c:v>
                </c:pt>
                <c:pt idx="25">
                  <c:v>10.451000000000022</c:v>
                </c:pt>
                <c:pt idx="26">
                  <c:v>8.5860000000000127</c:v>
                </c:pt>
                <c:pt idx="27">
                  <c:v>6.4110000000000014</c:v>
                </c:pt>
                <c:pt idx="28">
                  <c:v>6.4279999999999973</c:v>
                </c:pt>
                <c:pt idx="29">
                  <c:v>7.0260000000000105</c:v>
                </c:pt>
                <c:pt idx="30">
                  <c:v>7.1359999999999673</c:v>
                </c:pt>
                <c:pt idx="31">
                  <c:v>7.2560000000000286</c:v>
                </c:pt>
                <c:pt idx="32">
                  <c:v>14.86099999999999</c:v>
                </c:pt>
                <c:pt idx="33">
                  <c:v>14.055000000000007</c:v>
                </c:pt>
                <c:pt idx="34">
                  <c:v>14.224999999999966</c:v>
                </c:pt>
                <c:pt idx="35">
                  <c:v>7.4180000000000064</c:v>
                </c:pt>
                <c:pt idx="36">
                  <c:v>8.1899999999999977</c:v>
                </c:pt>
                <c:pt idx="37">
                  <c:v>16.503000000000043</c:v>
                </c:pt>
                <c:pt idx="38">
                  <c:v>8.7139999999999986</c:v>
                </c:pt>
                <c:pt idx="39">
                  <c:v>10.31699999999995</c:v>
                </c:pt>
                <c:pt idx="40">
                  <c:v>10.718000000000075</c:v>
                </c:pt>
                <c:pt idx="41">
                  <c:v>11.774000000000001</c:v>
                </c:pt>
                <c:pt idx="42">
                  <c:v>12.674999999999955</c:v>
                </c:pt>
                <c:pt idx="43">
                  <c:v>14.119000000000028</c:v>
                </c:pt>
                <c:pt idx="44">
                  <c:v>15.370999999999981</c:v>
                </c:pt>
                <c:pt idx="45">
                  <c:v>18.002999999999929</c:v>
                </c:pt>
                <c:pt idx="46">
                  <c:v>16.240000000000009</c:v>
                </c:pt>
                <c:pt idx="47">
                  <c:v>14.516000000000076</c:v>
                </c:pt>
                <c:pt idx="48">
                  <c:v>16.719999999999914</c:v>
                </c:pt>
                <c:pt idx="49">
                  <c:v>20.597000000000094</c:v>
                </c:pt>
                <c:pt idx="50">
                  <c:v>21.225999999999999</c:v>
                </c:pt>
                <c:pt idx="51">
                  <c:v>22.375</c:v>
                </c:pt>
                <c:pt idx="52">
                  <c:v>29.009999999999991</c:v>
                </c:pt>
                <c:pt idx="53">
                  <c:v>29.569999999999936</c:v>
                </c:pt>
                <c:pt idx="54">
                  <c:v>34.696000000000026</c:v>
                </c:pt>
                <c:pt idx="55">
                  <c:v>17.384</c:v>
                </c:pt>
                <c:pt idx="56">
                  <c:v>13.947000000000003</c:v>
                </c:pt>
                <c:pt idx="57">
                  <c:v>14.829000000000008</c:v>
                </c:pt>
                <c:pt idx="58">
                  <c:v>13.451999999999998</c:v>
                </c:pt>
                <c:pt idx="59">
                  <c:v>13.945999999999998</c:v>
                </c:pt>
                <c:pt idx="60">
                  <c:v>10.775999999999982</c:v>
                </c:pt>
                <c:pt idx="61">
                  <c:v>7.9780000000000086</c:v>
                </c:pt>
                <c:pt idx="62">
                  <c:v>8.8629999999999995</c:v>
                </c:pt>
                <c:pt idx="63">
                  <c:v>9.3220000000000027</c:v>
                </c:pt>
                <c:pt idx="64">
                  <c:v>7.0550000000000068</c:v>
                </c:pt>
                <c:pt idx="65">
                  <c:v>12.312999999999988</c:v>
                </c:pt>
                <c:pt idx="66">
                  <c:v>10.363</c:v>
                </c:pt>
                <c:pt idx="67">
                  <c:v>10.078000000000031</c:v>
                </c:pt>
                <c:pt idx="68">
                  <c:v>10.129999999999995</c:v>
                </c:pt>
                <c:pt idx="69">
                  <c:v>10.54299999999995</c:v>
                </c:pt>
                <c:pt idx="70">
                  <c:v>11.711000000000013</c:v>
                </c:pt>
                <c:pt idx="71">
                  <c:v>9.1720000000000255</c:v>
                </c:pt>
                <c:pt idx="72">
                  <c:v>8.1649999999999636</c:v>
                </c:pt>
                <c:pt idx="73">
                  <c:v>9.0400000000000205</c:v>
                </c:pt>
                <c:pt idx="74">
                  <c:v>9.103999999999985</c:v>
                </c:pt>
                <c:pt idx="75">
                  <c:v>9.0400000000000205</c:v>
                </c:pt>
                <c:pt idx="76">
                  <c:v>9.9359999999999786</c:v>
                </c:pt>
                <c:pt idx="77">
                  <c:v>12.661000000000001</c:v>
                </c:pt>
                <c:pt idx="78">
                  <c:v>9.1140000000000327</c:v>
                </c:pt>
                <c:pt idx="79">
                  <c:v>6.5649999999999977</c:v>
                </c:pt>
                <c:pt idx="80">
                  <c:v>9.4909999999999854</c:v>
                </c:pt>
                <c:pt idx="81">
                  <c:v>12.15100000000001</c:v>
                </c:pt>
                <c:pt idx="82">
                  <c:v>13.671999999999969</c:v>
                </c:pt>
                <c:pt idx="83">
                  <c:v>10.594000000000051</c:v>
                </c:pt>
                <c:pt idx="84">
                  <c:v>7.9849999999999568</c:v>
                </c:pt>
                <c:pt idx="85">
                  <c:v>13.350000000000023</c:v>
                </c:pt>
                <c:pt idx="86">
                  <c:v>13.024000000000001</c:v>
                </c:pt>
                <c:pt idx="87">
                  <c:v>10.134000000000015</c:v>
                </c:pt>
                <c:pt idx="88">
                  <c:v>15.088999999999999</c:v>
                </c:pt>
                <c:pt idx="89">
                  <c:v>12.996999999999957</c:v>
                </c:pt>
                <c:pt idx="90">
                  <c:v>9.6160000000000423</c:v>
                </c:pt>
                <c:pt idx="91">
                  <c:v>24.150000000000034</c:v>
                </c:pt>
                <c:pt idx="92">
                  <c:v>12.74899999999991</c:v>
                </c:pt>
                <c:pt idx="93">
                  <c:v>15.430000000000064</c:v>
                </c:pt>
                <c:pt idx="94">
                  <c:v>15.972999999999956</c:v>
                </c:pt>
                <c:pt idx="95">
                  <c:v>17.092999999999961</c:v>
                </c:pt>
                <c:pt idx="96">
                  <c:v>18.068000000000097</c:v>
                </c:pt>
                <c:pt idx="97">
                  <c:v>11.491999999999962</c:v>
                </c:pt>
                <c:pt idx="98">
                  <c:v>7.79200000000003</c:v>
                </c:pt>
                <c:pt idx="99">
                  <c:v>12.584999999999923</c:v>
                </c:pt>
                <c:pt idx="100">
                  <c:v>18.496000000000095</c:v>
                </c:pt>
                <c:pt idx="101">
                  <c:v>22.138999999999896</c:v>
                </c:pt>
                <c:pt idx="102">
                  <c:v>32.480000000000018</c:v>
                </c:pt>
                <c:pt idx="103">
                  <c:v>40.993000000000052</c:v>
                </c:pt>
                <c:pt idx="104">
                  <c:v>17.798000000000002</c:v>
                </c:pt>
                <c:pt idx="105">
                  <c:v>11.585999999999999</c:v>
                </c:pt>
                <c:pt idx="106">
                  <c:v>8.6479999999999961</c:v>
                </c:pt>
                <c:pt idx="107">
                  <c:v>15.899000000000001</c:v>
                </c:pt>
                <c:pt idx="108">
                  <c:v>18.751000000000005</c:v>
                </c:pt>
                <c:pt idx="109">
                  <c:v>15.324000000000012</c:v>
                </c:pt>
                <c:pt idx="110">
                  <c:v>13.685999999999979</c:v>
                </c:pt>
                <c:pt idx="111">
                  <c:v>9.0630000000000166</c:v>
                </c:pt>
                <c:pt idx="112">
                  <c:v>8.0889999999999986</c:v>
                </c:pt>
                <c:pt idx="113">
                  <c:v>8.186000000000007</c:v>
                </c:pt>
                <c:pt idx="114">
                  <c:v>8.0839999999999748</c:v>
                </c:pt>
                <c:pt idx="115">
                  <c:v>6.8880000000000052</c:v>
                </c:pt>
                <c:pt idx="116">
                  <c:v>8.2350000000000136</c:v>
                </c:pt>
                <c:pt idx="117">
                  <c:v>9.6670000000000016</c:v>
                </c:pt>
                <c:pt idx="118">
                  <c:v>9.3519999999999754</c:v>
                </c:pt>
                <c:pt idx="119">
                  <c:v>9.0160000000000196</c:v>
                </c:pt>
                <c:pt idx="120">
                  <c:v>10.213999999999999</c:v>
                </c:pt>
                <c:pt idx="121">
                  <c:v>9.9019999999999868</c:v>
                </c:pt>
                <c:pt idx="122">
                  <c:v>9.5970000000000368</c:v>
                </c:pt>
                <c:pt idx="123">
                  <c:v>10.375</c:v>
                </c:pt>
                <c:pt idx="124">
                  <c:v>10.385999999999967</c:v>
                </c:pt>
                <c:pt idx="125">
                  <c:v>10.61099999999999</c:v>
                </c:pt>
                <c:pt idx="126">
                  <c:v>12.579000000000008</c:v>
                </c:pt>
                <c:pt idx="127">
                  <c:v>11.420000000000016</c:v>
                </c:pt>
                <c:pt idx="128">
                  <c:v>9.5559999999999832</c:v>
                </c:pt>
                <c:pt idx="129">
                  <c:v>9.2870000000000346</c:v>
                </c:pt>
                <c:pt idx="130">
                  <c:v>8.7109999999999559</c:v>
                </c:pt>
                <c:pt idx="132">
                  <c:v>6.06899999999996</c:v>
                </c:pt>
                <c:pt idx="133">
                  <c:v>7.1920000000000073</c:v>
                </c:pt>
                <c:pt idx="134">
                  <c:v>7.9370000000000118</c:v>
                </c:pt>
                <c:pt idx="135">
                  <c:v>10.451000000000022</c:v>
                </c:pt>
                <c:pt idx="136">
                  <c:v>10.488</c:v>
                </c:pt>
                <c:pt idx="137">
                  <c:v>8.1100000000000136</c:v>
                </c:pt>
                <c:pt idx="138">
                  <c:v>7.9349999999999454</c:v>
                </c:pt>
                <c:pt idx="139">
                  <c:v>9.1910000000000309</c:v>
                </c:pt>
                <c:pt idx="140">
                  <c:v>9.1689999999999827</c:v>
                </c:pt>
                <c:pt idx="141">
                  <c:v>9.1440000000000055</c:v>
                </c:pt>
                <c:pt idx="142">
                  <c:v>9.3589999999999804</c:v>
                </c:pt>
                <c:pt idx="143">
                  <c:v>9.8490000000000464</c:v>
                </c:pt>
                <c:pt idx="144">
                  <c:v>9.9869999999999663</c:v>
                </c:pt>
                <c:pt idx="145">
                  <c:v>10.74799999999999</c:v>
                </c:pt>
                <c:pt idx="146">
                  <c:v>12.710000000000036</c:v>
                </c:pt>
                <c:pt idx="147">
                  <c:v>14.309999999999945</c:v>
                </c:pt>
                <c:pt idx="148">
                  <c:v>16.221000000000004</c:v>
                </c:pt>
                <c:pt idx="149">
                  <c:v>15.798000000000002</c:v>
                </c:pt>
                <c:pt idx="150">
                  <c:v>17.548000000000002</c:v>
                </c:pt>
                <c:pt idx="151">
                  <c:v>19.968000000000075</c:v>
                </c:pt>
                <c:pt idx="152">
                  <c:v>19.334999999999923</c:v>
                </c:pt>
                <c:pt idx="153">
                  <c:v>35.594000000000051</c:v>
                </c:pt>
                <c:pt idx="154">
                  <c:v>35.782000000000039</c:v>
                </c:pt>
                <c:pt idx="155">
                  <c:v>37.406999999999925</c:v>
                </c:pt>
                <c:pt idx="156">
                  <c:v>38.081999999999994</c:v>
                </c:pt>
              </c:numCache>
            </c:numRef>
          </c:xVal>
          <c:yVal>
            <c:numRef>
              <c:f>Sheet1!$W$2:$W$3663</c:f>
              <c:numCache>
                <c:formatCode>General</c:formatCode>
                <c:ptCount val="3662"/>
                <c:pt idx="55">
                  <c:v>115.402</c:v>
                </c:pt>
                <c:pt idx="56">
                  <c:v>132.786</c:v>
                </c:pt>
                <c:pt idx="57">
                  <c:v>146.733</c:v>
                </c:pt>
                <c:pt idx="58">
                  <c:v>161.56200000000001</c:v>
                </c:pt>
                <c:pt idx="59">
                  <c:v>175.01400000000001</c:v>
                </c:pt>
                <c:pt idx="60">
                  <c:v>188.96</c:v>
                </c:pt>
                <c:pt idx="61">
                  <c:v>199.73599999999999</c:v>
                </c:pt>
                <c:pt idx="62">
                  <c:v>207.714</c:v>
                </c:pt>
                <c:pt idx="63">
                  <c:v>216.577</c:v>
                </c:pt>
                <c:pt idx="64">
                  <c:v>225.899</c:v>
                </c:pt>
                <c:pt idx="65">
                  <c:v>232.95400000000001</c:v>
                </c:pt>
                <c:pt idx="66">
                  <c:v>245.267</c:v>
                </c:pt>
                <c:pt idx="67">
                  <c:v>255.63</c:v>
                </c:pt>
                <c:pt idx="68">
                  <c:v>265.70800000000003</c:v>
                </c:pt>
                <c:pt idx="69">
                  <c:v>275.83800000000002</c:v>
                </c:pt>
                <c:pt idx="70">
                  <c:v>286.38099999999997</c:v>
                </c:pt>
                <c:pt idx="71">
                  <c:v>298.09199999999998</c:v>
                </c:pt>
                <c:pt idx="72">
                  <c:v>307.26400000000001</c:v>
                </c:pt>
                <c:pt idx="73">
                  <c:v>315.42899999999997</c:v>
                </c:pt>
                <c:pt idx="74">
                  <c:v>324.46899999999999</c:v>
                </c:pt>
                <c:pt idx="75">
                  <c:v>333.57299999999998</c:v>
                </c:pt>
                <c:pt idx="76">
                  <c:v>342.613</c:v>
                </c:pt>
                <c:pt idx="77">
                  <c:v>352.54899999999998</c:v>
                </c:pt>
                <c:pt idx="78">
                  <c:v>365.21</c:v>
                </c:pt>
                <c:pt idx="79">
                  <c:v>374.32400000000001</c:v>
                </c:pt>
                <c:pt idx="80">
                  <c:v>380.88900000000001</c:v>
                </c:pt>
                <c:pt idx="81">
                  <c:v>390.38</c:v>
                </c:pt>
                <c:pt idx="82">
                  <c:v>402.53100000000001</c:v>
                </c:pt>
                <c:pt idx="83">
                  <c:v>416.20299999999997</c:v>
                </c:pt>
                <c:pt idx="84">
                  <c:v>426.79700000000003</c:v>
                </c:pt>
                <c:pt idx="85">
                  <c:v>434.78199999999998</c:v>
                </c:pt>
                <c:pt idx="86">
                  <c:v>448.13200000000001</c:v>
                </c:pt>
                <c:pt idx="87">
                  <c:v>461.15600000000001</c:v>
                </c:pt>
                <c:pt idx="88">
                  <c:v>471.29</c:v>
                </c:pt>
                <c:pt idx="89">
                  <c:v>486.37900000000002</c:v>
                </c:pt>
                <c:pt idx="90">
                  <c:v>499.37599999999998</c:v>
                </c:pt>
                <c:pt idx="91">
                  <c:v>508.99200000000002</c:v>
                </c:pt>
                <c:pt idx="92">
                  <c:v>533.14200000000005</c:v>
                </c:pt>
                <c:pt idx="93">
                  <c:v>545.89099999999996</c:v>
                </c:pt>
                <c:pt idx="94">
                  <c:v>561.32100000000003</c:v>
                </c:pt>
                <c:pt idx="95">
                  <c:v>577.29399999999998</c:v>
                </c:pt>
                <c:pt idx="96">
                  <c:v>594.38699999999994</c:v>
                </c:pt>
                <c:pt idx="97">
                  <c:v>612.45500000000004</c:v>
                </c:pt>
                <c:pt idx="98">
                  <c:v>623.947</c:v>
                </c:pt>
                <c:pt idx="99">
                  <c:v>631.73900000000003</c:v>
                </c:pt>
                <c:pt idx="100">
                  <c:v>644.32399999999996</c:v>
                </c:pt>
                <c:pt idx="101">
                  <c:v>662.82</c:v>
                </c:pt>
                <c:pt idx="102">
                  <c:v>684.95899999999995</c:v>
                </c:pt>
                <c:pt idx="103">
                  <c:v>717.438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3D3-4032-A1FA-3106AD67BE96}"/>
            </c:ext>
          </c:extLst>
        </c:ser>
        <c:ser>
          <c:idx val="2"/>
          <c:order val="2"/>
          <c:tx>
            <c:strRef>
              <c:f>Sheet1!$X$1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1!$U$2:$U$3663</c:f>
              <c:numCache>
                <c:formatCode>General</c:formatCode>
                <c:ptCount val="3662"/>
                <c:pt idx="0">
                  <c:v>12.165000000000006</c:v>
                </c:pt>
                <c:pt idx="1">
                  <c:v>12.239999999999995</c:v>
                </c:pt>
                <c:pt idx="2">
                  <c:v>10.543000000000006</c:v>
                </c:pt>
                <c:pt idx="3">
                  <c:v>13.01400000000001</c:v>
                </c:pt>
                <c:pt idx="4">
                  <c:v>10.697999999999979</c:v>
                </c:pt>
                <c:pt idx="5">
                  <c:v>7.5960000000000036</c:v>
                </c:pt>
                <c:pt idx="6">
                  <c:v>8.4749999999999943</c:v>
                </c:pt>
                <c:pt idx="7">
                  <c:v>8.5790000000000077</c:v>
                </c:pt>
                <c:pt idx="8">
                  <c:v>12.994</c:v>
                </c:pt>
                <c:pt idx="9">
                  <c:v>15.272999999999996</c:v>
                </c:pt>
                <c:pt idx="11">
                  <c:v>11.354000000000013</c:v>
                </c:pt>
                <c:pt idx="12">
                  <c:v>9.4380000000000166</c:v>
                </c:pt>
                <c:pt idx="13">
                  <c:v>6.3069999999999595</c:v>
                </c:pt>
                <c:pt idx="14">
                  <c:v>5.3670000000000186</c:v>
                </c:pt>
                <c:pt idx="15">
                  <c:v>5.7010000000000218</c:v>
                </c:pt>
                <c:pt idx="16">
                  <c:v>6.5019999999999527</c:v>
                </c:pt>
                <c:pt idx="17">
                  <c:v>6.5080000000000382</c:v>
                </c:pt>
                <c:pt idx="18">
                  <c:v>6.8709999999999809</c:v>
                </c:pt>
                <c:pt idx="19">
                  <c:v>6.4890000000000327</c:v>
                </c:pt>
                <c:pt idx="20">
                  <c:v>8.7789999999999964</c:v>
                </c:pt>
                <c:pt idx="21">
                  <c:v>10.334000000000003</c:v>
                </c:pt>
                <c:pt idx="22">
                  <c:v>9.72199999999998</c:v>
                </c:pt>
                <c:pt idx="23">
                  <c:v>9.4710000000000036</c:v>
                </c:pt>
                <c:pt idx="24">
                  <c:v>10.034999999999968</c:v>
                </c:pt>
                <c:pt idx="25">
                  <c:v>10.451000000000022</c:v>
                </c:pt>
                <c:pt idx="26">
                  <c:v>8.5860000000000127</c:v>
                </c:pt>
                <c:pt idx="27">
                  <c:v>6.4110000000000014</c:v>
                </c:pt>
                <c:pt idx="28">
                  <c:v>6.4279999999999973</c:v>
                </c:pt>
                <c:pt idx="29">
                  <c:v>7.0260000000000105</c:v>
                </c:pt>
                <c:pt idx="30">
                  <c:v>7.1359999999999673</c:v>
                </c:pt>
                <c:pt idx="31">
                  <c:v>7.2560000000000286</c:v>
                </c:pt>
                <c:pt idx="32">
                  <c:v>14.86099999999999</c:v>
                </c:pt>
                <c:pt idx="33">
                  <c:v>14.055000000000007</c:v>
                </c:pt>
                <c:pt idx="34">
                  <c:v>14.224999999999966</c:v>
                </c:pt>
                <c:pt idx="35">
                  <c:v>7.4180000000000064</c:v>
                </c:pt>
                <c:pt idx="36">
                  <c:v>8.1899999999999977</c:v>
                </c:pt>
                <c:pt idx="37">
                  <c:v>16.503000000000043</c:v>
                </c:pt>
                <c:pt idx="38">
                  <c:v>8.7139999999999986</c:v>
                </c:pt>
                <c:pt idx="39">
                  <c:v>10.31699999999995</c:v>
                </c:pt>
                <c:pt idx="40">
                  <c:v>10.718000000000075</c:v>
                </c:pt>
                <c:pt idx="41">
                  <c:v>11.774000000000001</c:v>
                </c:pt>
                <c:pt idx="42">
                  <c:v>12.674999999999955</c:v>
                </c:pt>
                <c:pt idx="43">
                  <c:v>14.119000000000028</c:v>
                </c:pt>
                <c:pt idx="44">
                  <c:v>15.370999999999981</c:v>
                </c:pt>
                <c:pt idx="45">
                  <c:v>18.002999999999929</c:v>
                </c:pt>
                <c:pt idx="46">
                  <c:v>16.240000000000009</c:v>
                </c:pt>
                <c:pt idx="47">
                  <c:v>14.516000000000076</c:v>
                </c:pt>
                <c:pt idx="48">
                  <c:v>16.719999999999914</c:v>
                </c:pt>
                <c:pt idx="49">
                  <c:v>20.597000000000094</c:v>
                </c:pt>
                <c:pt idx="50">
                  <c:v>21.225999999999999</c:v>
                </c:pt>
                <c:pt idx="51">
                  <c:v>22.375</c:v>
                </c:pt>
                <c:pt idx="52">
                  <c:v>29.009999999999991</c:v>
                </c:pt>
                <c:pt idx="53">
                  <c:v>29.569999999999936</c:v>
                </c:pt>
                <c:pt idx="54">
                  <c:v>34.696000000000026</c:v>
                </c:pt>
                <c:pt idx="55">
                  <c:v>17.384</c:v>
                </c:pt>
                <c:pt idx="56">
                  <c:v>13.947000000000003</c:v>
                </c:pt>
                <c:pt idx="57">
                  <c:v>14.829000000000008</c:v>
                </c:pt>
                <c:pt idx="58">
                  <c:v>13.451999999999998</c:v>
                </c:pt>
                <c:pt idx="59">
                  <c:v>13.945999999999998</c:v>
                </c:pt>
                <c:pt idx="60">
                  <c:v>10.775999999999982</c:v>
                </c:pt>
                <c:pt idx="61">
                  <c:v>7.9780000000000086</c:v>
                </c:pt>
                <c:pt idx="62">
                  <c:v>8.8629999999999995</c:v>
                </c:pt>
                <c:pt idx="63">
                  <c:v>9.3220000000000027</c:v>
                </c:pt>
                <c:pt idx="64">
                  <c:v>7.0550000000000068</c:v>
                </c:pt>
                <c:pt idx="65">
                  <c:v>12.312999999999988</c:v>
                </c:pt>
                <c:pt idx="66">
                  <c:v>10.363</c:v>
                </c:pt>
                <c:pt idx="67">
                  <c:v>10.078000000000031</c:v>
                </c:pt>
                <c:pt idx="68">
                  <c:v>10.129999999999995</c:v>
                </c:pt>
                <c:pt idx="69">
                  <c:v>10.54299999999995</c:v>
                </c:pt>
                <c:pt idx="70">
                  <c:v>11.711000000000013</c:v>
                </c:pt>
                <c:pt idx="71">
                  <c:v>9.1720000000000255</c:v>
                </c:pt>
                <c:pt idx="72">
                  <c:v>8.1649999999999636</c:v>
                </c:pt>
                <c:pt idx="73">
                  <c:v>9.0400000000000205</c:v>
                </c:pt>
                <c:pt idx="74">
                  <c:v>9.103999999999985</c:v>
                </c:pt>
                <c:pt idx="75">
                  <c:v>9.0400000000000205</c:v>
                </c:pt>
                <c:pt idx="76">
                  <c:v>9.9359999999999786</c:v>
                </c:pt>
                <c:pt idx="77">
                  <c:v>12.661000000000001</c:v>
                </c:pt>
                <c:pt idx="78">
                  <c:v>9.1140000000000327</c:v>
                </c:pt>
                <c:pt idx="79">
                  <c:v>6.5649999999999977</c:v>
                </c:pt>
                <c:pt idx="80">
                  <c:v>9.4909999999999854</c:v>
                </c:pt>
                <c:pt idx="81">
                  <c:v>12.15100000000001</c:v>
                </c:pt>
                <c:pt idx="82">
                  <c:v>13.671999999999969</c:v>
                </c:pt>
                <c:pt idx="83">
                  <c:v>10.594000000000051</c:v>
                </c:pt>
                <c:pt idx="84">
                  <c:v>7.9849999999999568</c:v>
                </c:pt>
                <c:pt idx="85">
                  <c:v>13.350000000000023</c:v>
                </c:pt>
                <c:pt idx="86">
                  <c:v>13.024000000000001</c:v>
                </c:pt>
                <c:pt idx="87">
                  <c:v>10.134000000000015</c:v>
                </c:pt>
                <c:pt idx="88">
                  <c:v>15.088999999999999</c:v>
                </c:pt>
                <c:pt idx="89">
                  <c:v>12.996999999999957</c:v>
                </c:pt>
                <c:pt idx="90">
                  <c:v>9.6160000000000423</c:v>
                </c:pt>
                <c:pt idx="91">
                  <c:v>24.150000000000034</c:v>
                </c:pt>
                <c:pt idx="92">
                  <c:v>12.74899999999991</c:v>
                </c:pt>
                <c:pt idx="93">
                  <c:v>15.430000000000064</c:v>
                </c:pt>
                <c:pt idx="94">
                  <c:v>15.972999999999956</c:v>
                </c:pt>
                <c:pt idx="95">
                  <c:v>17.092999999999961</c:v>
                </c:pt>
                <c:pt idx="96">
                  <c:v>18.068000000000097</c:v>
                </c:pt>
                <c:pt idx="97">
                  <c:v>11.491999999999962</c:v>
                </c:pt>
                <c:pt idx="98">
                  <c:v>7.79200000000003</c:v>
                </c:pt>
                <c:pt idx="99">
                  <c:v>12.584999999999923</c:v>
                </c:pt>
                <c:pt idx="100">
                  <c:v>18.496000000000095</c:v>
                </c:pt>
                <c:pt idx="101">
                  <c:v>22.138999999999896</c:v>
                </c:pt>
                <c:pt idx="102">
                  <c:v>32.480000000000018</c:v>
                </c:pt>
                <c:pt idx="103">
                  <c:v>40.993000000000052</c:v>
                </c:pt>
                <c:pt idx="104">
                  <c:v>17.798000000000002</c:v>
                </c:pt>
                <c:pt idx="105">
                  <c:v>11.585999999999999</c:v>
                </c:pt>
                <c:pt idx="106">
                  <c:v>8.6479999999999961</c:v>
                </c:pt>
                <c:pt idx="107">
                  <c:v>15.899000000000001</c:v>
                </c:pt>
                <c:pt idx="108">
                  <c:v>18.751000000000005</c:v>
                </c:pt>
                <c:pt idx="109">
                  <c:v>15.324000000000012</c:v>
                </c:pt>
                <c:pt idx="110">
                  <c:v>13.685999999999979</c:v>
                </c:pt>
                <c:pt idx="111">
                  <c:v>9.0630000000000166</c:v>
                </c:pt>
                <c:pt idx="112">
                  <c:v>8.0889999999999986</c:v>
                </c:pt>
                <c:pt idx="113">
                  <c:v>8.186000000000007</c:v>
                </c:pt>
                <c:pt idx="114">
                  <c:v>8.0839999999999748</c:v>
                </c:pt>
                <c:pt idx="115">
                  <c:v>6.8880000000000052</c:v>
                </c:pt>
                <c:pt idx="116">
                  <c:v>8.2350000000000136</c:v>
                </c:pt>
                <c:pt idx="117">
                  <c:v>9.6670000000000016</c:v>
                </c:pt>
                <c:pt idx="118">
                  <c:v>9.3519999999999754</c:v>
                </c:pt>
                <c:pt idx="119">
                  <c:v>9.0160000000000196</c:v>
                </c:pt>
                <c:pt idx="120">
                  <c:v>10.213999999999999</c:v>
                </c:pt>
                <c:pt idx="121">
                  <c:v>9.9019999999999868</c:v>
                </c:pt>
                <c:pt idx="122">
                  <c:v>9.5970000000000368</c:v>
                </c:pt>
                <c:pt idx="123">
                  <c:v>10.375</c:v>
                </c:pt>
                <c:pt idx="124">
                  <c:v>10.385999999999967</c:v>
                </c:pt>
                <c:pt idx="125">
                  <c:v>10.61099999999999</c:v>
                </c:pt>
                <c:pt idx="126">
                  <c:v>12.579000000000008</c:v>
                </c:pt>
                <c:pt idx="127">
                  <c:v>11.420000000000016</c:v>
                </c:pt>
                <c:pt idx="128">
                  <c:v>9.5559999999999832</c:v>
                </c:pt>
                <c:pt idx="129">
                  <c:v>9.2870000000000346</c:v>
                </c:pt>
                <c:pt idx="130">
                  <c:v>8.7109999999999559</c:v>
                </c:pt>
                <c:pt idx="132">
                  <c:v>6.06899999999996</c:v>
                </c:pt>
                <c:pt idx="133">
                  <c:v>7.1920000000000073</c:v>
                </c:pt>
                <c:pt idx="134">
                  <c:v>7.9370000000000118</c:v>
                </c:pt>
                <c:pt idx="135">
                  <c:v>10.451000000000022</c:v>
                </c:pt>
                <c:pt idx="136">
                  <c:v>10.488</c:v>
                </c:pt>
                <c:pt idx="137">
                  <c:v>8.1100000000000136</c:v>
                </c:pt>
                <c:pt idx="138">
                  <c:v>7.9349999999999454</c:v>
                </c:pt>
                <c:pt idx="139">
                  <c:v>9.1910000000000309</c:v>
                </c:pt>
                <c:pt idx="140">
                  <c:v>9.1689999999999827</c:v>
                </c:pt>
                <c:pt idx="141">
                  <c:v>9.1440000000000055</c:v>
                </c:pt>
                <c:pt idx="142">
                  <c:v>9.3589999999999804</c:v>
                </c:pt>
                <c:pt idx="143">
                  <c:v>9.8490000000000464</c:v>
                </c:pt>
                <c:pt idx="144">
                  <c:v>9.9869999999999663</c:v>
                </c:pt>
                <c:pt idx="145">
                  <c:v>10.74799999999999</c:v>
                </c:pt>
                <c:pt idx="146">
                  <c:v>12.710000000000036</c:v>
                </c:pt>
                <c:pt idx="147">
                  <c:v>14.309999999999945</c:v>
                </c:pt>
                <c:pt idx="148">
                  <c:v>16.221000000000004</c:v>
                </c:pt>
                <c:pt idx="149">
                  <c:v>15.798000000000002</c:v>
                </c:pt>
                <c:pt idx="150">
                  <c:v>17.548000000000002</c:v>
                </c:pt>
                <c:pt idx="151">
                  <c:v>19.968000000000075</c:v>
                </c:pt>
                <c:pt idx="152">
                  <c:v>19.334999999999923</c:v>
                </c:pt>
                <c:pt idx="153">
                  <c:v>35.594000000000051</c:v>
                </c:pt>
                <c:pt idx="154">
                  <c:v>35.782000000000039</c:v>
                </c:pt>
                <c:pt idx="155">
                  <c:v>37.406999999999925</c:v>
                </c:pt>
                <c:pt idx="156">
                  <c:v>38.081999999999994</c:v>
                </c:pt>
              </c:numCache>
            </c:numRef>
          </c:xVal>
          <c:yVal>
            <c:numRef>
              <c:f>Sheet1!$X$2:$X$3663</c:f>
              <c:numCache>
                <c:formatCode>General</c:formatCode>
                <c:ptCount val="3662"/>
                <c:pt idx="104">
                  <c:v>103.937</c:v>
                </c:pt>
                <c:pt idx="105">
                  <c:v>121.735</c:v>
                </c:pt>
                <c:pt idx="106">
                  <c:v>133.321</c:v>
                </c:pt>
                <c:pt idx="107">
                  <c:v>141.96899999999999</c:v>
                </c:pt>
                <c:pt idx="108">
                  <c:v>157.86799999999999</c:v>
                </c:pt>
                <c:pt idx="109">
                  <c:v>176.619</c:v>
                </c:pt>
                <c:pt idx="110">
                  <c:v>191.94300000000001</c:v>
                </c:pt>
                <c:pt idx="111">
                  <c:v>205.62899999999999</c:v>
                </c:pt>
                <c:pt idx="112">
                  <c:v>214.69200000000001</c:v>
                </c:pt>
                <c:pt idx="113">
                  <c:v>222.78100000000001</c:v>
                </c:pt>
                <c:pt idx="114">
                  <c:v>230.96700000000001</c:v>
                </c:pt>
                <c:pt idx="115">
                  <c:v>239.05099999999999</c:v>
                </c:pt>
                <c:pt idx="116">
                  <c:v>245.93899999999999</c:v>
                </c:pt>
                <c:pt idx="117">
                  <c:v>254.17400000000001</c:v>
                </c:pt>
                <c:pt idx="118">
                  <c:v>263.84100000000001</c:v>
                </c:pt>
                <c:pt idx="119">
                  <c:v>273.19299999999998</c:v>
                </c:pt>
                <c:pt idx="120">
                  <c:v>282.209</c:v>
                </c:pt>
                <c:pt idx="121">
                  <c:v>292.423</c:v>
                </c:pt>
                <c:pt idx="122">
                  <c:v>302.32499999999999</c:v>
                </c:pt>
                <c:pt idx="123">
                  <c:v>311.92200000000003</c:v>
                </c:pt>
                <c:pt idx="124">
                  <c:v>322.29700000000003</c:v>
                </c:pt>
                <c:pt idx="125">
                  <c:v>332.68299999999999</c:v>
                </c:pt>
                <c:pt idx="126">
                  <c:v>343.29399999999998</c:v>
                </c:pt>
                <c:pt idx="127">
                  <c:v>355.87299999999999</c:v>
                </c:pt>
                <c:pt idx="128">
                  <c:v>367.29300000000001</c:v>
                </c:pt>
                <c:pt idx="129">
                  <c:v>376.84899999999999</c:v>
                </c:pt>
                <c:pt idx="130">
                  <c:v>386.13600000000002</c:v>
                </c:pt>
                <c:pt idx="132">
                  <c:v>395.47300000000001</c:v>
                </c:pt>
                <c:pt idx="133">
                  <c:v>401.54199999999997</c:v>
                </c:pt>
                <c:pt idx="134">
                  <c:v>408.73399999999998</c:v>
                </c:pt>
                <c:pt idx="135">
                  <c:v>416.67099999999999</c:v>
                </c:pt>
                <c:pt idx="136">
                  <c:v>427.12200000000001</c:v>
                </c:pt>
                <c:pt idx="137">
                  <c:v>437.61</c:v>
                </c:pt>
                <c:pt idx="138">
                  <c:v>445.72</c:v>
                </c:pt>
                <c:pt idx="139">
                  <c:v>453.65499999999997</c:v>
                </c:pt>
                <c:pt idx="140">
                  <c:v>462.846</c:v>
                </c:pt>
                <c:pt idx="141">
                  <c:v>472.01499999999999</c:v>
                </c:pt>
                <c:pt idx="142">
                  <c:v>481.15899999999999</c:v>
                </c:pt>
                <c:pt idx="143">
                  <c:v>490.51799999999997</c:v>
                </c:pt>
                <c:pt idx="144">
                  <c:v>500.36700000000002</c:v>
                </c:pt>
                <c:pt idx="145">
                  <c:v>510.35399999999998</c:v>
                </c:pt>
                <c:pt idx="146">
                  <c:v>521.10199999999998</c:v>
                </c:pt>
                <c:pt idx="147">
                  <c:v>533.81200000000001</c:v>
                </c:pt>
                <c:pt idx="148">
                  <c:v>548.12199999999996</c:v>
                </c:pt>
                <c:pt idx="149">
                  <c:v>564.34299999999996</c:v>
                </c:pt>
                <c:pt idx="150">
                  <c:v>580.14099999999996</c:v>
                </c:pt>
                <c:pt idx="151">
                  <c:v>597.68899999999996</c:v>
                </c:pt>
                <c:pt idx="152">
                  <c:v>617.65700000000004</c:v>
                </c:pt>
                <c:pt idx="153">
                  <c:v>636.99199999999996</c:v>
                </c:pt>
                <c:pt idx="154">
                  <c:v>672.58600000000001</c:v>
                </c:pt>
                <c:pt idx="155">
                  <c:v>708.36800000000005</c:v>
                </c:pt>
                <c:pt idx="156">
                  <c:v>745.774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3D3-4032-A1FA-3106AD67B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9202832"/>
        <c:axId val="769203816"/>
      </c:scatterChart>
      <c:valAx>
        <c:axId val="769202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69203816"/>
        <c:crosses val="autoZero"/>
        <c:crossBetween val="midCat"/>
      </c:valAx>
      <c:valAx>
        <c:axId val="7692038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692028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Volumes sorted'!$S$24:$S$218</c:f>
              <c:numCache>
                <c:formatCode>General</c:formatCode>
                <c:ptCount val="195"/>
                <c:pt idx="0">
                  <c:v>106.636</c:v>
                </c:pt>
                <c:pt idx="1">
                  <c:v>114.559</c:v>
                </c:pt>
                <c:pt idx="2">
                  <c:v>121.80500000000001</c:v>
                </c:pt>
                <c:pt idx="3">
                  <c:v>129.15</c:v>
                </c:pt>
                <c:pt idx="4">
                  <c:v>136.876</c:v>
                </c:pt>
                <c:pt idx="5">
                  <c:v>143.899</c:v>
                </c:pt>
                <c:pt idx="6">
                  <c:v>151.238</c:v>
                </c:pt>
                <c:pt idx="7">
                  <c:v>158.98400000000001</c:v>
                </c:pt>
                <c:pt idx="8">
                  <c:v>168.15100000000001</c:v>
                </c:pt>
                <c:pt idx="9">
                  <c:v>177.63300000000001</c:v>
                </c:pt>
                <c:pt idx="10">
                  <c:v>186.50200000000001</c:v>
                </c:pt>
                <c:pt idx="11">
                  <c:v>195.38900000000001</c:v>
                </c:pt>
                <c:pt idx="12">
                  <c:v>204.36699999999999</c:v>
                </c:pt>
                <c:pt idx="13">
                  <c:v>214.68100000000001</c:v>
                </c:pt>
                <c:pt idx="14">
                  <c:v>223.435</c:v>
                </c:pt>
                <c:pt idx="15">
                  <c:v>228.93299999999999</c:v>
                </c:pt>
                <c:pt idx="16">
                  <c:v>234.953</c:v>
                </c:pt>
                <c:pt idx="17">
                  <c:v>241.471</c:v>
                </c:pt>
                <c:pt idx="18">
                  <c:v>247.178</c:v>
                </c:pt>
                <c:pt idx="19">
                  <c:v>255.14400000000001</c:v>
                </c:pt>
                <c:pt idx="20">
                  <c:v>263.33800000000002</c:v>
                </c:pt>
                <c:pt idx="21">
                  <c:v>269.02999999999997</c:v>
                </c:pt>
                <c:pt idx="22">
                  <c:v>274.40100000000001</c:v>
                </c:pt>
                <c:pt idx="23">
                  <c:v>279.17899999999997</c:v>
                </c:pt>
                <c:pt idx="24">
                  <c:v>284.65800000000002</c:v>
                </c:pt>
                <c:pt idx="25">
                  <c:v>290.798</c:v>
                </c:pt>
                <c:pt idx="26">
                  <c:v>296.61500000000001</c:v>
                </c:pt>
                <c:pt idx="27">
                  <c:v>302.82299999999998</c:v>
                </c:pt>
                <c:pt idx="28">
                  <c:v>311.29300000000001</c:v>
                </c:pt>
                <c:pt idx="29">
                  <c:v>321.99799999999999</c:v>
                </c:pt>
                <c:pt idx="30">
                  <c:v>330.30599999999998</c:v>
                </c:pt>
                <c:pt idx="31">
                  <c:v>336.42099999999999</c:v>
                </c:pt>
                <c:pt idx="32">
                  <c:v>342.75900000000001</c:v>
                </c:pt>
                <c:pt idx="33">
                  <c:v>349.565</c:v>
                </c:pt>
                <c:pt idx="34">
                  <c:v>357.108</c:v>
                </c:pt>
                <c:pt idx="35">
                  <c:v>364.76900000000001</c:v>
                </c:pt>
                <c:pt idx="36">
                  <c:v>372.03199999999998</c:v>
                </c:pt>
                <c:pt idx="37">
                  <c:v>379.65899999999999</c:v>
                </c:pt>
                <c:pt idx="38">
                  <c:v>387.21100000000001</c:v>
                </c:pt>
                <c:pt idx="39">
                  <c:v>394.59</c:v>
                </c:pt>
                <c:pt idx="40">
                  <c:v>402.73500000000001</c:v>
                </c:pt>
                <c:pt idx="41">
                  <c:v>411.68</c:v>
                </c:pt>
                <c:pt idx="42">
                  <c:v>420.29399999999998</c:v>
                </c:pt>
                <c:pt idx="43">
                  <c:v>429.077</c:v>
                </c:pt>
                <c:pt idx="44">
                  <c:v>438.392</c:v>
                </c:pt>
                <c:pt idx="45">
                  <c:v>447.55200000000002</c:v>
                </c:pt>
                <c:pt idx="46">
                  <c:v>457.255</c:v>
                </c:pt>
                <c:pt idx="47">
                  <c:v>464.80799999999999</c:v>
                </c:pt>
                <c:pt idx="48">
                  <c:v>470.42500000000001</c:v>
                </c:pt>
                <c:pt idx="49">
                  <c:v>478.48899999999998</c:v>
                </c:pt>
                <c:pt idx="50">
                  <c:v>489.048</c:v>
                </c:pt>
                <c:pt idx="51">
                  <c:v>498.62400000000002</c:v>
                </c:pt>
                <c:pt idx="52">
                  <c:v>508.40699999999998</c:v>
                </c:pt>
                <c:pt idx="53">
                  <c:v>521.19000000000005</c:v>
                </c:pt>
                <c:pt idx="54">
                  <c:v>535.75800000000004</c:v>
                </c:pt>
                <c:pt idx="55">
                  <c:v>561.74800000000005</c:v>
                </c:pt>
                <c:pt idx="56">
                  <c:v>570.68600000000004</c:v>
                </c:pt>
                <c:pt idx="57">
                  <c:v>581.37400000000002</c:v>
                </c:pt>
                <c:pt idx="58">
                  <c:v>592.46</c:v>
                </c:pt>
                <c:pt idx="59">
                  <c:v>603.47500000000002</c:v>
                </c:pt>
                <c:pt idx="60">
                  <c:v>633.51700000000005</c:v>
                </c:pt>
                <c:pt idx="61">
                  <c:v>651.57500000000005</c:v>
                </c:pt>
                <c:pt idx="62">
                  <c:v>670.48199999999997</c:v>
                </c:pt>
                <c:pt idx="63">
                  <c:v>718.40800000000002</c:v>
                </c:pt>
                <c:pt idx="64">
                  <c:v>737.67700000000002</c:v>
                </c:pt>
                <c:pt idx="65">
                  <c:v>761.10599999999999</c:v>
                </c:pt>
                <c:pt idx="66">
                  <c:v>791.37199999999996</c:v>
                </c:pt>
                <c:pt idx="67">
                  <c:v>103.489</c:v>
                </c:pt>
                <c:pt idx="68">
                  <c:v>117.10599999999999</c:v>
                </c:pt>
                <c:pt idx="69">
                  <c:v>125.401</c:v>
                </c:pt>
                <c:pt idx="70">
                  <c:v>136.10300000000001</c:v>
                </c:pt>
                <c:pt idx="71">
                  <c:v>146.49299999999999</c:v>
                </c:pt>
                <c:pt idx="72">
                  <c:v>157.34700000000001</c:v>
                </c:pt>
                <c:pt idx="73">
                  <c:v>165.90899999999999</c:v>
                </c:pt>
                <c:pt idx="74">
                  <c:v>172.28100000000001</c:v>
                </c:pt>
                <c:pt idx="75">
                  <c:v>181.05199999999999</c:v>
                </c:pt>
                <c:pt idx="76">
                  <c:v>189.58799999999999</c:v>
                </c:pt>
                <c:pt idx="77">
                  <c:v>197.095</c:v>
                </c:pt>
                <c:pt idx="78">
                  <c:v>203.89699999999999</c:v>
                </c:pt>
                <c:pt idx="79">
                  <c:v>209.23</c:v>
                </c:pt>
                <c:pt idx="80">
                  <c:v>215.13800000000001</c:v>
                </c:pt>
                <c:pt idx="81">
                  <c:v>221.63800000000001</c:v>
                </c:pt>
                <c:pt idx="82">
                  <c:v>229.08799999999999</c:v>
                </c:pt>
                <c:pt idx="83">
                  <c:v>236.2</c:v>
                </c:pt>
                <c:pt idx="84">
                  <c:v>243.51900000000001</c:v>
                </c:pt>
                <c:pt idx="85">
                  <c:v>251.44399999999999</c:v>
                </c:pt>
                <c:pt idx="86">
                  <c:v>259.36</c:v>
                </c:pt>
                <c:pt idx="87">
                  <c:v>267.637</c:v>
                </c:pt>
                <c:pt idx="88">
                  <c:v>275.07799999999997</c:v>
                </c:pt>
                <c:pt idx="89">
                  <c:v>281.91500000000002</c:v>
                </c:pt>
                <c:pt idx="90">
                  <c:v>289.86099999999999</c:v>
                </c:pt>
                <c:pt idx="91">
                  <c:v>298.66800000000001</c:v>
                </c:pt>
                <c:pt idx="92">
                  <c:v>307.452</c:v>
                </c:pt>
                <c:pt idx="93">
                  <c:v>314.18900000000002</c:v>
                </c:pt>
                <c:pt idx="94">
                  <c:v>319.35399999999998</c:v>
                </c:pt>
                <c:pt idx="95">
                  <c:v>324.48599999999999</c:v>
                </c:pt>
                <c:pt idx="96">
                  <c:v>329.19400000000002</c:v>
                </c:pt>
                <c:pt idx="97">
                  <c:v>333.86099999999999</c:v>
                </c:pt>
                <c:pt idx="98">
                  <c:v>339.00799999999998</c:v>
                </c:pt>
                <c:pt idx="99">
                  <c:v>346.613</c:v>
                </c:pt>
                <c:pt idx="100">
                  <c:v>355.697</c:v>
                </c:pt>
                <c:pt idx="101">
                  <c:v>362.90800000000002</c:v>
                </c:pt>
                <c:pt idx="102">
                  <c:v>370.32299999999998</c:v>
                </c:pt>
                <c:pt idx="103">
                  <c:v>377.779</c:v>
                </c:pt>
                <c:pt idx="104">
                  <c:v>385.44499999999999</c:v>
                </c:pt>
                <c:pt idx="105">
                  <c:v>393.524</c:v>
                </c:pt>
                <c:pt idx="106">
                  <c:v>401.80900000000003</c:v>
                </c:pt>
                <c:pt idx="107">
                  <c:v>409.858</c:v>
                </c:pt>
                <c:pt idx="108">
                  <c:v>417.82299999999998</c:v>
                </c:pt>
                <c:pt idx="109">
                  <c:v>426.36900000000003</c:v>
                </c:pt>
                <c:pt idx="110">
                  <c:v>437.54199999999997</c:v>
                </c:pt>
                <c:pt idx="111">
                  <c:v>446.363</c:v>
                </c:pt>
                <c:pt idx="112">
                  <c:v>453.58</c:v>
                </c:pt>
                <c:pt idx="113">
                  <c:v>463.84500000000003</c:v>
                </c:pt>
                <c:pt idx="114">
                  <c:v>473.52199999999999</c:v>
                </c:pt>
                <c:pt idx="115">
                  <c:v>480.23</c:v>
                </c:pt>
                <c:pt idx="116">
                  <c:v>488.68099999999998</c:v>
                </c:pt>
                <c:pt idx="117">
                  <c:v>500.19200000000001</c:v>
                </c:pt>
                <c:pt idx="118">
                  <c:v>511.98500000000001</c:v>
                </c:pt>
                <c:pt idx="119">
                  <c:v>521.65</c:v>
                </c:pt>
                <c:pt idx="120">
                  <c:v>530.93100000000004</c:v>
                </c:pt>
                <c:pt idx="121">
                  <c:v>549.173</c:v>
                </c:pt>
                <c:pt idx="122">
                  <c:v>563.24099999999999</c:v>
                </c:pt>
                <c:pt idx="123">
                  <c:v>580.79</c:v>
                </c:pt>
                <c:pt idx="124">
                  <c:v>602.15800000000002</c:v>
                </c:pt>
                <c:pt idx="125">
                  <c:v>621.94100000000003</c:v>
                </c:pt>
                <c:pt idx="126">
                  <c:v>640.68100000000004</c:v>
                </c:pt>
                <c:pt idx="127">
                  <c:v>660.24900000000002</c:v>
                </c:pt>
                <c:pt idx="128">
                  <c:v>687.20899999999995</c:v>
                </c:pt>
                <c:pt idx="129">
                  <c:v>721.154</c:v>
                </c:pt>
                <c:pt idx="130">
                  <c:v>755.505</c:v>
                </c:pt>
                <c:pt idx="131">
                  <c:v>795.83900000000006</c:v>
                </c:pt>
                <c:pt idx="132">
                  <c:v>106.074</c:v>
                </c:pt>
                <c:pt idx="133">
                  <c:v>112.851</c:v>
                </c:pt>
                <c:pt idx="134">
                  <c:v>120.158</c:v>
                </c:pt>
                <c:pt idx="135">
                  <c:v>127.75</c:v>
                </c:pt>
                <c:pt idx="136">
                  <c:v>135.358</c:v>
                </c:pt>
                <c:pt idx="137">
                  <c:v>143.767</c:v>
                </c:pt>
                <c:pt idx="138">
                  <c:v>154.56700000000001</c:v>
                </c:pt>
                <c:pt idx="139">
                  <c:v>165.78800000000001</c:v>
                </c:pt>
                <c:pt idx="140">
                  <c:v>176.53800000000001</c:v>
                </c:pt>
                <c:pt idx="141">
                  <c:v>185.05600000000001</c:v>
                </c:pt>
                <c:pt idx="142">
                  <c:v>191.57499999999999</c:v>
                </c:pt>
                <c:pt idx="143">
                  <c:v>200.57300000000001</c:v>
                </c:pt>
                <c:pt idx="144">
                  <c:v>208.839</c:v>
                </c:pt>
                <c:pt idx="145">
                  <c:v>214.57499999999999</c:v>
                </c:pt>
                <c:pt idx="146">
                  <c:v>220.56700000000001</c:v>
                </c:pt>
                <c:pt idx="147">
                  <c:v>229.86699999999999</c:v>
                </c:pt>
                <c:pt idx="148">
                  <c:v>240.07599999999999</c:v>
                </c:pt>
                <c:pt idx="149">
                  <c:v>249.49600000000001</c:v>
                </c:pt>
                <c:pt idx="150">
                  <c:v>262.72800000000001</c:v>
                </c:pt>
                <c:pt idx="151">
                  <c:v>273.35500000000002</c:v>
                </c:pt>
                <c:pt idx="152">
                  <c:v>279.67700000000002</c:v>
                </c:pt>
                <c:pt idx="153">
                  <c:v>286.38600000000002</c:v>
                </c:pt>
                <c:pt idx="154">
                  <c:v>293.887</c:v>
                </c:pt>
                <c:pt idx="155">
                  <c:v>302.73899999999998</c:v>
                </c:pt>
                <c:pt idx="156">
                  <c:v>311.74200000000002</c:v>
                </c:pt>
                <c:pt idx="157">
                  <c:v>318.483</c:v>
                </c:pt>
                <c:pt idx="158">
                  <c:v>323.53199999999998</c:v>
                </c:pt>
                <c:pt idx="159">
                  <c:v>328.899</c:v>
                </c:pt>
                <c:pt idx="160">
                  <c:v>334.83600000000001</c:v>
                </c:pt>
                <c:pt idx="161">
                  <c:v>342.142</c:v>
                </c:pt>
                <c:pt idx="162">
                  <c:v>351.73399999999998</c:v>
                </c:pt>
                <c:pt idx="163">
                  <c:v>360.74400000000003</c:v>
                </c:pt>
                <c:pt idx="164">
                  <c:v>367.60199999999998</c:v>
                </c:pt>
                <c:pt idx="165">
                  <c:v>373.68700000000001</c:v>
                </c:pt>
                <c:pt idx="166">
                  <c:v>381.49700000000001</c:v>
                </c:pt>
                <c:pt idx="167">
                  <c:v>389.334</c:v>
                </c:pt>
                <c:pt idx="168">
                  <c:v>397.995</c:v>
                </c:pt>
                <c:pt idx="169">
                  <c:v>406.61700000000002</c:v>
                </c:pt>
                <c:pt idx="170">
                  <c:v>414.90800000000002</c:v>
                </c:pt>
                <c:pt idx="171">
                  <c:v>422.74400000000003</c:v>
                </c:pt>
                <c:pt idx="172">
                  <c:v>431.32499999999999</c:v>
                </c:pt>
                <c:pt idx="173">
                  <c:v>440.42200000000003</c:v>
                </c:pt>
                <c:pt idx="174">
                  <c:v>450.23200000000003</c:v>
                </c:pt>
                <c:pt idx="175">
                  <c:v>458.56900000000002</c:v>
                </c:pt>
                <c:pt idx="176">
                  <c:v>469.78500000000003</c:v>
                </c:pt>
                <c:pt idx="177">
                  <c:v>480.29399999999998</c:v>
                </c:pt>
                <c:pt idx="178">
                  <c:v>489.78500000000003</c:v>
                </c:pt>
                <c:pt idx="179">
                  <c:v>497.56099999999998</c:v>
                </c:pt>
                <c:pt idx="180">
                  <c:v>506.66699999999997</c:v>
                </c:pt>
                <c:pt idx="181">
                  <c:v>520.45100000000002</c:v>
                </c:pt>
                <c:pt idx="182">
                  <c:v>536.24599999999998</c:v>
                </c:pt>
                <c:pt idx="183">
                  <c:v>549.78599999999994</c:v>
                </c:pt>
                <c:pt idx="184">
                  <c:v>563.16099999999994</c:v>
                </c:pt>
                <c:pt idx="185">
                  <c:v>578.39300000000003</c:v>
                </c:pt>
                <c:pt idx="186">
                  <c:v>594.34500000000003</c:v>
                </c:pt>
                <c:pt idx="187">
                  <c:v>610.346</c:v>
                </c:pt>
                <c:pt idx="188">
                  <c:v>626.60199999999998</c:v>
                </c:pt>
                <c:pt idx="189">
                  <c:v>645.02700000000004</c:v>
                </c:pt>
                <c:pt idx="190">
                  <c:v>666.54600000000005</c:v>
                </c:pt>
                <c:pt idx="191">
                  <c:v>692.952</c:v>
                </c:pt>
                <c:pt idx="192">
                  <c:v>717.85199999999998</c:v>
                </c:pt>
                <c:pt idx="193">
                  <c:v>745.92399999999998</c:v>
                </c:pt>
                <c:pt idx="194">
                  <c:v>776.904</c:v>
                </c:pt>
              </c:numCache>
            </c:numRef>
          </c:xVal>
          <c:yVal>
            <c:numRef>
              <c:f>'Volumes sorted'!$X$24:$X$218</c:f>
              <c:numCache>
                <c:formatCode>General</c:formatCode>
                <c:ptCount val="195"/>
                <c:pt idx="0">
                  <c:v>-845.50800000000004</c:v>
                </c:pt>
                <c:pt idx="1">
                  <c:v>-959.34</c:v>
                </c:pt>
                <c:pt idx="2">
                  <c:v>-893.89199999999994</c:v>
                </c:pt>
                <c:pt idx="3">
                  <c:v>-673.57400000000007</c:v>
                </c:pt>
                <c:pt idx="4">
                  <c:v>-741.18</c:v>
                </c:pt>
                <c:pt idx="5">
                  <c:v>-584.7940000000001</c:v>
                </c:pt>
                <c:pt idx="6">
                  <c:v>-578.31400000000008</c:v>
                </c:pt>
                <c:pt idx="7">
                  <c:v>-560.38400000000001</c:v>
                </c:pt>
                <c:pt idx="8">
                  <c:v>-228.39400000000001</c:v>
                </c:pt>
                <c:pt idx="9">
                  <c:v>-176.12400000000002</c:v>
                </c:pt>
                <c:pt idx="10">
                  <c:v>-330.99399999999991</c:v>
                </c:pt>
                <c:pt idx="11">
                  <c:v>-115.42399999999998</c:v>
                </c:pt>
                <c:pt idx="12">
                  <c:v>-305.2940000000001</c:v>
                </c:pt>
                <c:pt idx="13">
                  <c:v>374.4559999999999</c:v>
                </c:pt>
                <c:pt idx="14">
                  <c:v>-995.41200000000003</c:v>
                </c:pt>
                <c:pt idx="15">
                  <c:v>-894.75599999999997</c:v>
                </c:pt>
                <c:pt idx="16">
                  <c:v>-784.38</c:v>
                </c:pt>
                <c:pt idx="17">
                  <c:v>-729.94799999999998</c:v>
                </c:pt>
                <c:pt idx="18">
                  <c:v>-940.11599999999999</c:v>
                </c:pt>
                <c:pt idx="19">
                  <c:v>80.486000000000104</c:v>
                </c:pt>
                <c:pt idx="20">
                  <c:v>-913.98</c:v>
                </c:pt>
                <c:pt idx="21">
                  <c:v>-834.06</c:v>
                </c:pt>
                <c:pt idx="22">
                  <c:v>-937.524</c:v>
                </c:pt>
                <c:pt idx="23">
                  <c:v>-973.81200000000001</c:v>
                </c:pt>
                <c:pt idx="24">
                  <c:v>-543.10400000000004</c:v>
                </c:pt>
                <c:pt idx="25">
                  <c:v>-536.84400000000005</c:v>
                </c:pt>
                <c:pt idx="26">
                  <c:v>-696.03399999999988</c:v>
                </c:pt>
                <c:pt idx="27">
                  <c:v>-464.91399999999999</c:v>
                </c:pt>
                <c:pt idx="28">
                  <c:v>38.365999999999985</c:v>
                </c:pt>
                <c:pt idx="29">
                  <c:v>320.02600000000007</c:v>
                </c:pt>
                <c:pt idx="30">
                  <c:v>-753.49199999999996</c:v>
                </c:pt>
                <c:pt idx="31">
                  <c:v>-489.75399999999991</c:v>
                </c:pt>
                <c:pt idx="32">
                  <c:v>-570.10400000000004</c:v>
                </c:pt>
                <c:pt idx="33">
                  <c:v>-276.34400000000005</c:v>
                </c:pt>
                <c:pt idx="34">
                  <c:v>-214.57400000000007</c:v>
                </c:pt>
                <c:pt idx="35">
                  <c:v>-145.02399999999989</c:v>
                </c:pt>
                <c:pt idx="36">
                  <c:v>-294.27399999999989</c:v>
                </c:pt>
                <c:pt idx="37">
                  <c:v>86.096000000000004</c:v>
                </c:pt>
                <c:pt idx="38">
                  <c:v>-348.92399999999998</c:v>
                </c:pt>
                <c:pt idx="39">
                  <c:v>-51.923999999999978</c:v>
                </c:pt>
                <c:pt idx="40">
                  <c:v>-21.033999999999878</c:v>
                </c:pt>
                <c:pt idx="41">
                  <c:v>300.80600000000004</c:v>
                </c:pt>
                <c:pt idx="42">
                  <c:v>-143.94399999999996</c:v>
                </c:pt>
                <c:pt idx="43">
                  <c:v>199.49600000000009</c:v>
                </c:pt>
                <c:pt idx="44">
                  <c:v>44.195999999999913</c:v>
                </c:pt>
                <c:pt idx="45">
                  <c:v>246.37599999999998</c:v>
                </c:pt>
                <c:pt idx="46">
                  <c:v>425.65600000000018</c:v>
                </c:pt>
                <c:pt idx="47">
                  <c:v>-572.2639999999999</c:v>
                </c:pt>
                <c:pt idx="48">
                  <c:v>-533.38400000000001</c:v>
                </c:pt>
                <c:pt idx="49">
                  <c:v>614.21600000000012</c:v>
                </c:pt>
                <c:pt idx="50">
                  <c:v>693.92600000000016</c:v>
                </c:pt>
                <c:pt idx="51">
                  <c:v>183.94599999999991</c:v>
                </c:pt>
                <c:pt idx="52">
                  <c:v>729.34600000000023</c:v>
                </c:pt>
                <c:pt idx="53">
                  <c:v>1565.0559999999998</c:v>
                </c:pt>
                <c:pt idx="54">
                  <c:v>-530.58400000000006</c:v>
                </c:pt>
                <c:pt idx="55">
                  <c:v>-936.22799999999995</c:v>
                </c:pt>
                <c:pt idx="56">
                  <c:v>-571.404</c:v>
                </c:pt>
                <c:pt idx="57">
                  <c:v>-339.42399999999998</c:v>
                </c:pt>
                <c:pt idx="58">
                  <c:v>-390.39400000000001</c:v>
                </c:pt>
                <c:pt idx="59">
                  <c:v>-231.42399999999998</c:v>
                </c:pt>
                <c:pt idx="60">
                  <c:v>1540.2160000000001</c:v>
                </c:pt>
                <c:pt idx="61">
                  <c:v>1166.5359999999998</c:v>
                </c:pt>
                <c:pt idx="62">
                  <c:v>2504.6559999999999</c:v>
                </c:pt>
                <c:pt idx="63">
                  <c:v>1809.7760000000001</c:v>
                </c:pt>
                <c:pt idx="64">
                  <c:v>2845.9360000000006</c:v>
                </c:pt>
                <c:pt idx="65">
                  <c:v>3027.1559999999999</c:v>
                </c:pt>
                <c:pt idx="66">
                  <c:v>5855.896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5B3-407C-BB55-EF3604C208A5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Volumes sorted'!$S$24:$S$218</c:f>
              <c:numCache>
                <c:formatCode>General</c:formatCode>
                <c:ptCount val="195"/>
                <c:pt idx="0">
                  <c:v>106.636</c:v>
                </c:pt>
                <c:pt idx="1">
                  <c:v>114.559</c:v>
                </c:pt>
                <c:pt idx="2">
                  <c:v>121.80500000000001</c:v>
                </c:pt>
                <c:pt idx="3">
                  <c:v>129.15</c:v>
                </c:pt>
                <c:pt idx="4">
                  <c:v>136.876</c:v>
                </c:pt>
                <c:pt idx="5">
                  <c:v>143.899</c:v>
                </c:pt>
                <c:pt idx="6">
                  <c:v>151.238</c:v>
                </c:pt>
                <c:pt idx="7">
                  <c:v>158.98400000000001</c:v>
                </c:pt>
                <c:pt idx="8">
                  <c:v>168.15100000000001</c:v>
                </c:pt>
                <c:pt idx="9">
                  <c:v>177.63300000000001</c:v>
                </c:pt>
                <c:pt idx="10">
                  <c:v>186.50200000000001</c:v>
                </c:pt>
                <c:pt idx="11">
                  <c:v>195.38900000000001</c:v>
                </c:pt>
                <c:pt idx="12">
                  <c:v>204.36699999999999</c:v>
                </c:pt>
                <c:pt idx="13">
                  <c:v>214.68100000000001</c:v>
                </c:pt>
                <c:pt idx="14">
                  <c:v>223.435</c:v>
                </c:pt>
                <c:pt idx="15">
                  <c:v>228.93299999999999</c:v>
                </c:pt>
                <c:pt idx="16">
                  <c:v>234.953</c:v>
                </c:pt>
                <c:pt idx="17">
                  <c:v>241.471</c:v>
                </c:pt>
                <c:pt idx="18">
                  <c:v>247.178</c:v>
                </c:pt>
                <c:pt idx="19">
                  <c:v>255.14400000000001</c:v>
                </c:pt>
                <c:pt idx="20">
                  <c:v>263.33800000000002</c:v>
                </c:pt>
                <c:pt idx="21">
                  <c:v>269.02999999999997</c:v>
                </c:pt>
                <c:pt idx="22">
                  <c:v>274.40100000000001</c:v>
                </c:pt>
                <c:pt idx="23">
                  <c:v>279.17899999999997</c:v>
                </c:pt>
                <c:pt idx="24">
                  <c:v>284.65800000000002</c:v>
                </c:pt>
                <c:pt idx="25">
                  <c:v>290.798</c:v>
                </c:pt>
                <c:pt idx="26">
                  <c:v>296.61500000000001</c:v>
                </c:pt>
                <c:pt idx="27">
                  <c:v>302.82299999999998</c:v>
                </c:pt>
                <c:pt idx="28">
                  <c:v>311.29300000000001</c:v>
                </c:pt>
                <c:pt idx="29">
                  <c:v>321.99799999999999</c:v>
                </c:pt>
                <c:pt idx="30">
                  <c:v>330.30599999999998</c:v>
                </c:pt>
                <c:pt idx="31">
                  <c:v>336.42099999999999</c:v>
                </c:pt>
                <c:pt idx="32">
                  <c:v>342.75900000000001</c:v>
                </c:pt>
                <c:pt idx="33">
                  <c:v>349.565</c:v>
                </c:pt>
                <c:pt idx="34">
                  <c:v>357.108</c:v>
                </c:pt>
                <c:pt idx="35">
                  <c:v>364.76900000000001</c:v>
                </c:pt>
                <c:pt idx="36">
                  <c:v>372.03199999999998</c:v>
                </c:pt>
                <c:pt idx="37">
                  <c:v>379.65899999999999</c:v>
                </c:pt>
                <c:pt idx="38">
                  <c:v>387.21100000000001</c:v>
                </c:pt>
                <c:pt idx="39">
                  <c:v>394.59</c:v>
                </c:pt>
                <c:pt idx="40">
                  <c:v>402.73500000000001</c:v>
                </c:pt>
                <c:pt idx="41">
                  <c:v>411.68</c:v>
                </c:pt>
                <c:pt idx="42">
                  <c:v>420.29399999999998</c:v>
                </c:pt>
                <c:pt idx="43">
                  <c:v>429.077</c:v>
                </c:pt>
                <c:pt idx="44">
                  <c:v>438.392</c:v>
                </c:pt>
                <c:pt idx="45">
                  <c:v>447.55200000000002</c:v>
                </c:pt>
                <c:pt idx="46">
                  <c:v>457.255</c:v>
                </c:pt>
                <c:pt idx="47">
                  <c:v>464.80799999999999</c:v>
                </c:pt>
                <c:pt idx="48">
                  <c:v>470.42500000000001</c:v>
                </c:pt>
                <c:pt idx="49">
                  <c:v>478.48899999999998</c:v>
                </c:pt>
                <c:pt idx="50">
                  <c:v>489.048</c:v>
                </c:pt>
                <c:pt idx="51">
                  <c:v>498.62400000000002</c:v>
                </c:pt>
                <c:pt idx="52">
                  <c:v>508.40699999999998</c:v>
                </c:pt>
                <c:pt idx="53">
                  <c:v>521.19000000000005</c:v>
                </c:pt>
                <c:pt idx="54">
                  <c:v>535.75800000000004</c:v>
                </c:pt>
                <c:pt idx="55">
                  <c:v>561.74800000000005</c:v>
                </c:pt>
                <c:pt idx="56">
                  <c:v>570.68600000000004</c:v>
                </c:pt>
                <c:pt idx="57">
                  <c:v>581.37400000000002</c:v>
                </c:pt>
                <c:pt idx="58">
                  <c:v>592.46</c:v>
                </c:pt>
                <c:pt idx="59">
                  <c:v>603.47500000000002</c:v>
                </c:pt>
                <c:pt idx="60">
                  <c:v>633.51700000000005</c:v>
                </c:pt>
                <c:pt idx="61">
                  <c:v>651.57500000000005</c:v>
                </c:pt>
                <c:pt idx="62">
                  <c:v>670.48199999999997</c:v>
                </c:pt>
                <c:pt idx="63">
                  <c:v>718.40800000000002</c:v>
                </c:pt>
                <c:pt idx="64">
                  <c:v>737.67700000000002</c:v>
                </c:pt>
                <c:pt idx="65">
                  <c:v>761.10599999999999</c:v>
                </c:pt>
                <c:pt idx="66">
                  <c:v>791.37199999999996</c:v>
                </c:pt>
                <c:pt idx="67">
                  <c:v>103.489</c:v>
                </c:pt>
                <c:pt idx="68">
                  <c:v>117.10599999999999</c:v>
                </c:pt>
                <c:pt idx="69">
                  <c:v>125.401</c:v>
                </c:pt>
                <c:pt idx="70">
                  <c:v>136.10300000000001</c:v>
                </c:pt>
                <c:pt idx="71">
                  <c:v>146.49299999999999</c:v>
                </c:pt>
                <c:pt idx="72">
                  <c:v>157.34700000000001</c:v>
                </c:pt>
                <c:pt idx="73">
                  <c:v>165.90899999999999</c:v>
                </c:pt>
                <c:pt idx="74">
                  <c:v>172.28100000000001</c:v>
                </c:pt>
                <c:pt idx="75">
                  <c:v>181.05199999999999</c:v>
                </c:pt>
                <c:pt idx="76">
                  <c:v>189.58799999999999</c:v>
                </c:pt>
                <c:pt idx="77">
                  <c:v>197.095</c:v>
                </c:pt>
                <c:pt idx="78">
                  <c:v>203.89699999999999</c:v>
                </c:pt>
                <c:pt idx="79">
                  <c:v>209.23</c:v>
                </c:pt>
                <c:pt idx="80">
                  <c:v>215.13800000000001</c:v>
                </c:pt>
                <c:pt idx="81">
                  <c:v>221.63800000000001</c:v>
                </c:pt>
                <c:pt idx="82">
                  <c:v>229.08799999999999</c:v>
                </c:pt>
                <c:pt idx="83">
                  <c:v>236.2</c:v>
                </c:pt>
                <c:pt idx="84">
                  <c:v>243.51900000000001</c:v>
                </c:pt>
                <c:pt idx="85">
                  <c:v>251.44399999999999</c:v>
                </c:pt>
                <c:pt idx="86">
                  <c:v>259.36</c:v>
                </c:pt>
                <c:pt idx="87">
                  <c:v>267.637</c:v>
                </c:pt>
                <c:pt idx="88">
                  <c:v>275.07799999999997</c:v>
                </c:pt>
                <c:pt idx="89">
                  <c:v>281.91500000000002</c:v>
                </c:pt>
                <c:pt idx="90">
                  <c:v>289.86099999999999</c:v>
                </c:pt>
                <c:pt idx="91">
                  <c:v>298.66800000000001</c:v>
                </c:pt>
                <c:pt idx="92">
                  <c:v>307.452</c:v>
                </c:pt>
                <c:pt idx="93">
                  <c:v>314.18900000000002</c:v>
                </c:pt>
                <c:pt idx="94">
                  <c:v>319.35399999999998</c:v>
                </c:pt>
                <c:pt idx="95">
                  <c:v>324.48599999999999</c:v>
                </c:pt>
                <c:pt idx="96">
                  <c:v>329.19400000000002</c:v>
                </c:pt>
                <c:pt idx="97">
                  <c:v>333.86099999999999</c:v>
                </c:pt>
                <c:pt idx="98">
                  <c:v>339.00799999999998</c:v>
                </c:pt>
                <c:pt idx="99">
                  <c:v>346.613</c:v>
                </c:pt>
                <c:pt idx="100">
                  <c:v>355.697</c:v>
                </c:pt>
                <c:pt idx="101">
                  <c:v>362.90800000000002</c:v>
                </c:pt>
                <c:pt idx="102">
                  <c:v>370.32299999999998</c:v>
                </c:pt>
                <c:pt idx="103">
                  <c:v>377.779</c:v>
                </c:pt>
                <c:pt idx="104">
                  <c:v>385.44499999999999</c:v>
                </c:pt>
                <c:pt idx="105">
                  <c:v>393.524</c:v>
                </c:pt>
                <c:pt idx="106">
                  <c:v>401.80900000000003</c:v>
                </c:pt>
                <c:pt idx="107">
                  <c:v>409.858</c:v>
                </c:pt>
                <c:pt idx="108">
                  <c:v>417.82299999999998</c:v>
                </c:pt>
                <c:pt idx="109">
                  <c:v>426.36900000000003</c:v>
                </c:pt>
                <c:pt idx="110">
                  <c:v>437.54199999999997</c:v>
                </c:pt>
                <c:pt idx="111">
                  <c:v>446.363</c:v>
                </c:pt>
                <c:pt idx="112">
                  <c:v>453.58</c:v>
                </c:pt>
                <c:pt idx="113">
                  <c:v>463.84500000000003</c:v>
                </c:pt>
                <c:pt idx="114">
                  <c:v>473.52199999999999</c:v>
                </c:pt>
                <c:pt idx="115">
                  <c:v>480.23</c:v>
                </c:pt>
                <c:pt idx="116">
                  <c:v>488.68099999999998</c:v>
                </c:pt>
                <c:pt idx="117">
                  <c:v>500.19200000000001</c:v>
                </c:pt>
                <c:pt idx="118">
                  <c:v>511.98500000000001</c:v>
                </c:pt>
                <c:pt idx="119">
                  <c:v>521.65</c:v>
                </c:pt>
                <c:pt idx="120">
                  <c:v>530.93100000000004</c:v>
                </c:pt>
                <c:pt idx="121">
                  <c:v>549.173</c:v>
                </c:pt>
                <c:pt idx="122">
                  <c:v>563.24099999999999</c:v>
                </c:pt>
                <c:pt idx="123">
                  <c:v>580.79</c:v>
                </c:pt>
                <c:pt idx="124">
                  <c:v>602.15800000000002</c:v>
                </c:pt>
                <c:pt idx="125">
                  <c:v>621.94100000000003</c:v>
                </c:pt>
                <c:pt idx="126">
                  <c:v>640.68100000000004</c:v>
                </c:pt>
                <c:pt idx="127">
                  <c:v>660.24900000000002</c:v>
                </c:pt>
                <c:pt idx="128">
                  <c:v>687.20899999999995</c:v>
                </c:pt>
                <c:pt idx="129">
                  <c:v>721.154</c:v>
                </c:pt>
                <c:pt idx="130">
                  <c:v>755.505</c:v>
                </c:pt>
                <c:pt idx="131">
                  <c:v>795.83900000000006</c:v>
                </c:pt>
                <c:pt idx="132">
                  <c:v>106.074</c:v>
                </c:pt>
                <c:pt idx="133">
                  <c:v>112.851</c:v>
                </c:pt>
                <c:pt idx="134">
                  <c:v>120.158</c:v>
                </c:pt>
                <c:pt idx="135">
                  <c:v>127.75</c:v>
                </c:pt>
                <c:pt idx="136">
                  <c:v>135.358</c:v>
                </c:pt>
                <c:pt idx="137">
                  <c:v>143.767</c:v>
                </c:pt>
                <c:pt idx="138">
                  <c:v>154.56700000000001</c:v>
                </c:pt>
                <c:pt idx="139">
                  <c:v>165.78800000000001</c:v>
                </c:pt>
                <c:pt idx="140">
                  <c:v>176.53800000000001</c:v>
                </c:pt>
                <c:pt idx="141">
                  <c:v>185.05600000000001</c:v>
                </c:pt>
                <c:pt idx="142">
                  <c:v>191.57499999999999</c:v>
                </c:pt>
                <c:pt idx="143">
                  <c:v>200.57300000000001</c:v>
                </c:pt>
                <c:pt idx="144">
                  <c:v>208.839</c:v>
                </c:pt>
                <c:pt idx="145">
                  <c:v>214.57499999999999</c:v>
                </c:pt>
                <c:pt idx="146">
                  <c:v>220.56700000000001</c:v>
                </c:pt>
                <c:pt idx="147">
                  <c:v>229.86699999999999</c:v>
                </c:pt>
                <c:pt idx="148">
                  <c:v>240.07599999999999</c:v>
                </c:pt>
                <c:pt idx="149">
                  <c:v>249.49600000000001</c:v>
                </c:pt>
                <c:pt idx="150">
                  <c:v>262.72800000000001</c:v>
                </c:pt>
                <c:pt idx="151">
                  <c:v>273.35500000000002</c:v>
                </c:pt>
                <c:pt idx="152">
                  <c:v>279.67700000000002</c:v>
                </c:pt>
                <c:pt idx="153">
                  <c:v>286.38600000000002</c:v>
                </c:pt>
                <c:pt idx="154">
                  <c:v>293.887</c:v>
                </c:pt>
                <c:pt idx="155">
                  <c:v>302.73899999999998</c:v>
                </c:pt>
                <c:pt idx="156">
                  <c:v>311.74200000000002</c:v>
                </c:pt>
                <c:pt idx="157">
                  <c:v>318.483</c:v>
                </c:pt>
                <c:pt idx="158">
                  <c:v>323.53199999999998</c:v>
                </c:pt>
                <c:pt idx="159">
                  <c:v>328.899</c:v>
                </c:pt>
                <c:pt idx="160">
                  <c:v>334.83600000000001</c:v>
                </c:pt>
                <c:pt idx="161">
                  <c:v>342.142</c:v>
                </c:pt>
                <c:pt idx="162">
                  <c:v>351.73399999999998</c:v>
                </c:pt>
                <c:pt idx="163">
                  <c:v>360.74400000000003</c:v>
                </c:pt>
                <c:pt idx="164">
                  <c:v>367.60199999999998</c:v>
                </c:pt>
                <c:pt idx="165">
                  <c:v>373.68700000000001</c:v>
                </c:pt>
                <c:pt idx="166">
                  <c:v>381.49700000000001</c:v>
                </c:pt>
                <c:pt idx="167">
                  <c:v>389.334</c:v>
                </c:pt>
                <c:pt idx="168">
                  <c:v>397.995</c:v>
                </c:pt>
                <c:pt idx="169">
                  <c:v>406.61700000000002</c:v>
                </c:pt>
                <c:pt idx="170">
                  <c:v>414.90800000000002</c:v>
                </c:pt>
                <c:pt idx="171">
                  <c:v>422.74400000000003</c:v>
                </c:pt>
                <c:pt idx="172">
                  <c:v>431.32499999999999</c:v>
                </c:pt>
                <c:pt idx="173">
                  <c:v>440.42200000000003</c:v>
                </c:pt>
                <c:pt idx="174">
                  <c:v>450.23200000000003</c:v>
                </c:pt>
                <c:pt idx="175">
                  <c:v>458.56900000000002</c:v>
                </c:pt>
                <c:pt idx="176">
                  <c:v>469.78500000000003</c:v>
                </c:pt>
                <c:pt idx="177">
                  <c:v>480.29399999999998</c:v>
                </c:pt>
                <c:pt idx="178">
                  <c:v>489.78500000000003</c:v>
                </c:pt>
                <c:pt idx="179">
                  <c:v>497.56099999999998</c:v>
                </c:pt>
                <c:pt idx="180">
                  <c:v>506.66699999999997</c:v>
                </c:pt>
                <c:pt idx="181">
                  <c:v>520.45100000000002</c:v>
                </c:pt>
                <c:pt idx="182">
                  <c:v>536.24599999999998</c:v>
                </c:pt>
                <c:pt idx="183">
                  <c:v>549.78599999999994</c:v>
                </c:pt>
                <c:pt idx="184">
                  <c:v>563.16099999999994</c:v>
                </c:pt>
                <c:pt idx="185">
                  <c:v>578.39300000000003</c:v>
                </c:pt>
                <c:pt idx="186">
                  <c:v>594.34500000000003</c:v>
                </c:pt>
                <c:pt idx="187">
                  <c:v>610.346</c:v>
                </c:pt>
                <c:pt idx="188">
                  <c:v>626.60199999999998</c:v>
                </c:pt>
                <c:pt idx="189">
                  <c:v>645.02700000000004</c:v>
                </c:pt>
                <c:pt idx="190">
                  <c:v>666.54600000000005</c:v>
                </c:pt>
                <c:pt idx="191">
                  <c:v>692.952</c:v>
                </c:pt>
                <c:pt idx="192">
                  <c:v>717.85199999999998</c:v>
                </c:pt>
                <c:pt idx="193">
                  <c:v>745.92399999999998</c:v>
                </c:pt>
                <c:pt idx="194">
                  <c:v>776.904</c:v>
                </c:pt>
              </c:numCache>
            </c:numRef>
          </c:xVal>
          <c:yVal>
            <c:numRef>
              <c:f>'Volumes sorted'!$Y$24:$Y$218</c:f>
              <c:numCache>
                <c:formatCode>General</c:formatCode>
                <c:ptCount val="195"/>
                <c:pt idx="67">
                  <c:v>-685.62800000000004</c:v>
                </c:pt>
                <c:pt idx="68">
                  <c:v>-437.65999999999997</c:v>
                </c:pt>
                <c:pt idx="69">
                  <c:v>-287.5440000000001</c:v>
                </c:pt>
                <c:pt idx="70">
                  <c:v>-228.14400000000001</c:v>
                </c:pt>
                <c:pt idx="71">
                  <c:v>-86.013999999999896</c:v>
                </c:pt>
                <c:pt idx="72">
                  <c:v>12.91599999999994</c:v>
                </c:pt>
                <c:pt idx="73">
                  <c:v>-710.46799999999996</c:v>
                </c:pt>
                <c:pt idx="74">
                  <c:v>-484.31600000000003</c:v>
                </c:pt>
                <c:pt idx="75">
                  <c:v>293.93599999999992</c:v>
                </c:pt>
                <c:pt idx="76">
                  <c:v>-361.84400000000005</c:v>
                </c:pt>
                <c:pt idx="77">
                  <c:v>-204.16399999999999</c:v>
                </c:pt>
                <c:pt idx="78">
                  <c:v>-695.34799999999996</c:v>
                </c:pt>
                <c:pt idx="79">
                  <c:v>-597.93200000000002</c:v>
                </c:pt>
                <c:pt idx="80">
                  <c:v>-554.51599999999996</c:v>
                </c:pt>
                <c:pt idx="81">
                  <c:v>-524.92399999999998</c:v>
                </c:pt>
                <c:pt idx="82">
                  <c:v>-355.7940000000001</c:v>
                </c:pt>
                <c:pt idx="83">
                  <c:v>-388.62400000000002</c:v>
                </c:pt>
                <c:pt idx="84">
                  <c:v>-140.44399999999996</c:v>
                </c:pt>
                <c:pt idx="85">
                  <c:v>-220.7940000000001</c:v>
                </c:pt>
                <c:pt idx="86">
                  <c:v>-194.66399999999999</c:v>
                </c:pt>
                <c:pt idx="87">
                  <c:v>-142.60400000000004</c:v>
                </c:pt>
                <c:pt idx="88">
                  <c:v>-443.05999999999995</c:v>
                </c:pt>
                <c:pt idx="89">
                  <c:v>-381.50399999999991</c:v>
                </c:pt>
                <c:pt idx="90">
                  <c:v>-75.644000000000005</c:v>
                </c:pt>
                <c:pt idx="91">
                  <c:v>196.08600000000001</c:v>
                </c:pt>
                <c:pt idx="92">
                  <c:v>7.5160000000000764</c:v>
                </c:pt>
                <c:pt idx="93">
                  <c:v>-598.36400000000003</c:v>
                </c:pt>
                <c:pt idx="94">
                  <c:v>-497.27599999999995</c:v>
                </c:pt>
                <c:pt idx="95">
                  <c:v>-586.70000000000005</c:v>
                </c:pt>
                <c:pt idx="96">
                  <c:v>-653.66</c:v>
                </c:pt>
                <c:pt idx="97">
                  <c:v>-552.572</c:v>
                </c:pt>
                <c:pt idx="98">
                  <c:v>-630.11599999999999</c:v>
                </c:pt>
                <c:pt idx="99">
                  <c:v>141.00600000000009</c:v>
                </c:pt>
                <c:pt idx="100">
                  <c:v>-617.37199999999996</c:v>
                </c:pt>
                <c:pt idx="101">
                  <c:v>-629.25199999999995</c:v>
                </c:pt>
                <c:pt idx="102">
                  <c:v>-585.83600000000001</c:v>
                </c:pt>
                <c:pt idx="103">
                  <c:v>-160.96399999999994</c:v>
                </c:pt>
                <c:pt idx="104">
                  <c:v>-338.73399999999992</c:v>
                </c:pt>
                <c:pt idx="105">
                  <c:v>-67.223999999999933</c:v>
                </c:pt>
                <c:pt idx="106">
                  <c:v>-382.14400000000001</c:v>
                </c:pt>
                <c:pt idx="107">
                  <c:v>-145.62400000000002</c:v>
                </c:pt>
                <c:pt idx="108">
                  <c:v>-423.18799999999999</c:v>
                </c:pt>
                <c:pt idx="109">
                  <c:v>-57.503999999999905</c:v>
                </c:pt>
                <c:pt idx="110">
                  <c:v>158.93599999999992</c:v>
                </c:pt>
                <c:pt idx="111">
                  <c:v>-484.31600000000003</c:v>
                </c:pt>
                <c:pt idx="112">
                  <c:v>-241.74399999999991</c:v>
                </c:pt>
                <c:pt idx="113">
                  <c:v>489.19599999999991</c:v>
                </c:pt>
                <c:pt idx="114">
                  <c:v>-425.99599999999998</c:v>
                </c:pt>
                <c:pt idx="115">
                  <c:v>-456.66800000000001</c:v>
                </c:pt>
                <c:pt idx="116">
                  <c:v>244.25600000000009</c:v>
                </c:pt>
                <c:pt idx="117">
                  <c:v>704.97600000000011</c:v>
                </c:pt>
                <c:pt idx="118">
                  <c:v>492.65599999999995</c:v>
                </c:pt>
                <c:pt idx="119">
                  <c:v>-293.80400000000009</c:v>
                </c:pt>
                <c:pt idx="120">
                  <c:v>-502.24400000000003</c:v>
                </c:pt>
                <c:pt idx="121">
                  <c:v>-953.68399999999997</c:v>
                </c:pt>
                <c:pt idx="122">
                  <c:v>-854.75599999999997</c:v>
                </c:pt>
                <c:pt idx="123">
                  <c:v>-262.91399999999999</c:v>
                </c:pt>
                <c:pt idx="124">
                  <c:v>-91.413999999999987</c:v>
                </c:pt>
                <c:pt idx="125">
                  <c:v>5.3559999999999945</c:v>
                </c:pt>
                <c:pt idx="126">
                  <c:v>434.33600000000001</c:v>
                </c:pt>
                <c:pt idx="127">
                  <c:v>839.11599999999999</c:v>
                </c:pt>
                <c:pt idx="128">
                  <c:v>2179.616</c:v>
                </c:pt>
                <c:pt idx="129">
                  <c:v>3876.2959999999998</c:v>
                </c:pt>
                <c:pt idx="130">
                  <c:v>4360.7759999999998</c:v>
                </c:pt>
                <c:pt idx="131">
                  <c:v>5258.695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5B3-407C-BB55-EF3604C208A5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Volumes sorted'!$S$24:$S$218</c:f>
              <c:numCache>
                <c:formatCode>General</c:formatCode>
                <c:ptCount val="195"/>
                <c:pt idx="0">
                  <c:v>106.636</c:v>
                </c:pt>
                <c:pt idx="1">
                  <c:v>114.559</c:v>
                </c:pt>
                <c:pt idx="2">
                  <c:v>121.80500000000001</c:v>
                </c:pt>
                <c:pt idx="3">
                  <c:v>129.15</c:v>
                </c:pt>
                <c:pt idx="4">
                  <c:v>136.876</c:v>
                </c:pt>
                <c:pt idx="5">
                  <c:v>143.899</c:v>
                </c:pt>
                <c:pt idx="6">
                  <c:v>151.238</c:v>
                </c:pt>
                <c:pt idx="7">
                  <c:v>158.98400000000001</c:v>
                </c:pt>
                <c:pt idx="8">
                  <c:v>168.15100000000001</c:v>
                </c:pt>
                <c:pt idx="9">
                  <c:v>177.63300000000001</c:v>
                </c:pt>
                <c:pt idx="10">
                  <c:v>186.50200000000001</c:v>
                </c:pt>
                <c:pt idx="11">
                  <c:v>195.38900000000001</c:v>
                </c:pt>
                <c:pt idx="12">
                  <c:v>204.36699999999999</c:v>
                </c:pt>
                <c:pt idx="13">
                  <c:v>214.68100000000001</c:v>
                </c:pt>
                <c:pt idx="14">
                  <c:v>223.435</c:v>
                </c:pt>
                <c:pt idx="15">
                  <c:v>228.93299999999999</c:v>
                </c:pt>
                <c:pt idx="16">
                  <c:v>234.953</c:v>
                </c:pt>
                <c:pt idx="17">
                  <c:v>241.471</c:v>
                </c:pt>
                <c:pt idx="18">
                  <c:v>247.178</c:v>
                </c:pt>
                <c:pt idx="19">
                  <c:v>255.14400000000001</c:v>
                </c:pt>
                <c:pt idx="20">
                  <c:v>263.33800000000002</c:v>
                </c:pt>
                <c:pt idx="21">
                  <c:v>269.02999999999997</c:v>
                </c:pt>
                <c:pt idx="22">
                  <c:v>274.40100000000001</c:v>
                </c:pt>
                <c:pt idx="23">
                  <c:v>279.17899999999997</c:v>
                </c:pt>
                <c:pt idx="24">
                  <c:v>284.65800000000002</c:v>
                </c:pt>
                <c:pt idx="25">
                  <c:v>290.798</c:v>
                </c:pt>
                <c:pt idx="26">
                  <c:v>296.61500000000001</c:v>
                </c:pt>
                <c:pt idx="27">
                  <c:v>302.82299999999998</c:v>
                </c:pt>
                <c:pt idx="28">
                  <c:v>311.29300000000001</c:v>
                </c:pt>
                <c:pt idx="29">
                  <c:v>321.99799999999999</c:v>
                </c:pt>
                <c:pt idx="30">
                  <c:v>330.30599999999998</c:v>
                </c:pt>
                <c:pt idx="31">
                  <c:v>336.42099999999999</c:v>
                </c:pt>
                <c:pt idx="32">
                  <c:v>342.75900000000001</c:v>
                </c:pt>
                <c:pt idx="33">
                  <c:v>349.565</c:v>
                </c:pt>
                <c:pt idx="34">
                  <c:v>357.108</c:v>
                </c:pt>
                <c:pt idx="35">
                  <c:v>364.76900000000001</c:v>
                </c:pt>
                <c:pt idx="36">
                  <c:v>372.03199999999998</c:v>
                </c:pt>
                <c:pt idx="37">
                  <c:v>379.65899999999999</c:v>
                </c:pt>
                <c:pt idx="38">
                  <c:v>387.21100000000001</c:v>
                </c:pt>
                <c:pt idx="39">
                  <c:v>394.59</c:v>
                </c:pt>
                <c:pt idx="40">
                  <c:v>402.73500000000001</c:v>
                </c:pt>
                <c:pt idx="41">
                  <c:v>411.68</c:v>
                </c:pt>
                <c:pt idx="42">
                  <c:v>420.29399999999998</c:v>
                </c:pt>
                <c:pt idx="43">
                  <c:v>429.077</c:v>
                </c:pt>
                <c:pt idx="44">
                  <c:v>438.392</c:v>
                </c:pt>
                <c:pt idx="45">
                  <c:v>447.55200000000002</c:v>
                </c:pt>
                <c:pt idx="46">
                  <c:v>457.255</c:v>
                </c:pt>
                <c:pt idx="47">
                  <c:v>464.80799999999999</c:v>
                </c:pt>
                <c:pt idx="48">
                  <c:v>470.42500000000001</c:v>
                </c:pt>
                <c:pt idx="49">
                  <c:v>478.48899999999998</c:v>
                </c:pt>
                <c:pt idx="50">
                  <c:v>489.048</c:v>
                </c:pt>
                <c:pt idx="51">
                  <c:v>498.62400000000002</c:v>
                </c:pt>
                <c:pt idx="52">
                  <c:v>508.40699999999998</c:v>
                </c:pt>
                <c:pt idx="53">
                  <c:v>521.19000000000005</c:v>
                </c:pt>
                <c:pt idx="54">
                  <c:v>535.75800000000004</c:v>
                </c:pt>
                <c:pt idx="55">
                  <c:v>561.74800000000005</c:v>
                </c:pt>
                <c:pt idx="56">
                  <c:v>570.68600000000004</c:v>
                </c:pt>
                <c:pt idx="57">
                  <c:v>581.37400000000002</c:v>
                </c:pt>
                <c:pt idx="58">
                  <c:v>592.46</c:v>
                </c:pt>
                <c:pt idx="59">
                  <c:v>603.47500000000002</c:v>
                </c:pt>
                <c:pt idx="60">
                  <c:v>633.51700000000005</c:v>
                </c:pt>
                <c:pt idx="61">
                  <c:v>651.57500000000005</c:v>
                </c:pt>
                <c:pt idx="62">
                  <c:v>670.48199999999997</c:v>
                </c:pt>
                <c:pt idx="63">
                  <c:v>718.40800000000002</c:v>
                </c:pt>
                <c:pt idx="64">
                  <c:v>737.67700000000002</c:v>
                </c:pt>
                <c:pt idx="65">
                  <c:v>761.10599999999999</c:v>
                </c:pt>
                <c:pt idx="66">
                  <c:v>791.37199999999996</c:v>
                </c:pt>
                <c:pt idx="67">
                  <c:v>103.489</c:v>
                </c:pt>
                <c:pt idx="68">
                  <c:v>117.10599999999999</c:v>
                </c:pt>
                <c:pt idx="69">
                  <c:v>125.401</c:v>
                </c:pt>
                <c:pt idx="70">
                  <c:v>136.10300000000001</c:v>
                </c:pt>
                <c:pt idx="71">
                  <c:v>146.49299999999999</c:v>
                </c:pt>
                <c:pt idx="72">
                  <c:v>157.34700000000001</c:v>
                </c:pt>
                <c:pt idx="73">
                  <c:v>165.90899999999999</c:v>
                </c:pt>
                <c:pt idx="74">
                  <c:v>172.28100000000001</c:v>
                </c:pt>
                <c:pt idx="75">
                  <c:v>181.05199999999999</c:v>
                </c:pt>
                <c:pt idx="76">
                  <c:v>189.58799999999999</c:v>
                </c:pt>
                <c:pt idx="77">
                  <c:v>197.095</c:v>
                </c:pt>
                <c:pt idx="78">
                  <c:v>203.89699999999999</c:v>
                </c:pt>
                <c:pt idx="79">
                  <c:v>209.23</c:v>
                </c:pt>
                <c:pt idx="80">
                  <c:v>215.13800000000001</c:v>
                </c:pt>
                <c:pt idx="81">
                  <c:v>221.63800000000001</c:v>
                </c:pt>
                <c:pt idx="82">
                  <c:v>229.08799999999999</c:v>
                </c:pt>
                <c:pt idx="83">
                  <c:v>236.2</c:v>
                </c:pt>
                <c:pt idx="84">
                  <c:v>243.51900000000001</c:v>
                </c:pt>
                <c:pt idx="85">
                  <c:v>251.44399999999999</c:v>
                </c:pt>
                <c:pt idx="86">
                  <c:v>259.36</c:v>
                </c:pt>
                <c:pt idx="87">
                  <c:v>267.637</c:v>
                </c:pt>
                <c:pt idx="88">
                  <c:v>275.07799999999997</c:v>
                </c:pt>
                <c:pt idx="89">
                  <c:v>281.91500000000002</c:v>
                </c:pt>
                <c:pt idx="90">
                  <c:v>289.86099999999999</c:v>
                </c:pt>
                <c:pt idx="91">
                  <c:v>298.66800000000001</c:v>
                </c:pt>
                <c:pt idx="92">
                  <c:v>307.452</c:v>
                </c:pt>
                <c:pt idx="93">
                  <c:v>314.18900000000002</c:v>
                </c:pt>
                <c:pt idx="94">
                  <c:v>319.35399999999998</c:v>
                </c:pt>
                <c:pt idx="95">
                  <c:v>324.48599999999999</c:v>
                </c:pt>
                <c:pt idx="96">
                  <c:v>329.19400000000002</c:v>
                </c:pt>
                <c:pt idx="97">
                  <c:v>333.86099999999999</c:v>
                </c:pt>
                <c:pt idx="98">
                  <c:v>339.00799999999998</c:v>
                </c:pt>
                <c:pt idx="99">
                  <c:v>346.613</c:v>
                </c:pt>
                <c:pt idx="100">
                  <c:v>355.697</c:v>
                </c:pt>
                <c:pt idx="101">
                  <c:v>362.90800000000002</c:v>
                </c:pt>
                <c:pt idx="102">
                  <c:v>370.32299999999998</c:v>
                </c:pt>
                <c:pt idx="103">
                  <c:v>377.779</c:v>
                </c:pt>
                <c:pt idx="104">
                  <c:v>385.44499999999999</c:v>
                </c:pt>
                <c:pt idx="105">
                  <c:v>393.524</c:v>
                </c:pt>
                <c:pt idx="106">
                  <c:v>401.80900000000003</c:v>
                </c:pt>
                <c:pt idx="107">
                  <c:v>409.858</c:v>
                </c:pt>
                <c:pt idx="108">
                  <c:v>417.82299999999998</c:v>
                </c:pt>
                <c:pt idx="109">
                  <c:v>426.36900000000003</c:v>
                </c:pt>
                <c:pt idx="110">
                  <c:v>437.54199999999997</c:v>
                </c:pt>
                <c:pt idx="111">
                  <c:v>446.363</c:v>
                </c:pt>
                <c:pt idx="112">
                  <c:v>453.58</c:v>
                </c:pt>
                <c:pt idx="113">
                  <c:v>463.84500000000003</c:v>
                </c:pt>
                <c:pt idx="114">
                  <c:v>473.52199999999999</c:v>
                </c:pt>
                <c:pt idx="115">
                  <c:v>480.23</c:v>
                </c:pt>
                <c:pt idx="116">
                  <c:v>488.68099999999998</c:v>
                </c:pt>
                <c:pt idx="117">
                  <c:v>500.19200000000001</c:v>
                </c:pt>
                <c:pt idx="118">
                  <c:v>511.98500000000001</c:v>
                </c:pt>
                <c:pt idx="119">
                  <c:v>521.65</c:v>
                </c:pt>
                <c:pt idx="120">
                  <c:v>530.93100000000004</c:v>
                </c:pt>
                <c:pt idx="121">
                  <c:v>549.173</c:v>
                </c:pt>
                <c:pt idx="122">
                  <c:v>563.24099999999999</c:v>
                </c:pt>
                <c:pt idx="123">
                  <c:v>580.79</c:v>
                </c:pt>
                <c:pt idx="124">
                  <c:v>602.15800000000002</c:v>
                </c:pt>
                <c:pt idx="125">
                  <c:v>621.94100000000003</c:v>
                </c:pt>
                <c:pt idx="126">
                  <c:v>640.68100000000004</c:v>
                </c:pt>
                <c:pt idx="127">
                  <c:v>660.24900000000002</c:v>
                </c:pt>
                <c:pt idx="128">
                  <c:v>687.20899999999995</c:v>
                </c:pt>
                <c:pt idx="129">
                  <c:v>721.154</c:v>
                </c:pt>
                <c:pt idx="130">
                  <c:v>755.505</c:v>
                </c:pt>
                <c:pt idx="131">
                  <c:v>795.83900000000006</c:v>
                </c:pt>
                <c:pt idx="132">
                  <c:v>106.074</c:v>
                </c:pt>
                <c:pt idx="133">
                  <c:v>112.851</c:v>
                </c:pt>
                <c:pt idx="134">
                  <c:v>120.158</c:v>
                </c:pt>
                <c:pt idx="135">
                  <c:v>127.75</c:v>
                </c:pt>
                <c:pt idx="136">
                  <c:v>135.358</c:v>
                </c:pt>
                <c:pt idx="137">
                  <c:v>143.767</c:v>
                </c:pt>
                <c:pt idx="138">
                  <c:v>154.56700000000001</c:v>
                </c:pt>
                <c:pt idx="139">
                  <c:v>165.78800000000001</c:v>
                </c:pt>
                <c:pt idx="140">
                  <c:v>176.53800000000001</c:v>
                </c:pt>
                <c:pt idx="141">
                  <c:v>185.05600000000001</c:v>
                </c:pt>
                <c:pt idx="142">
                  <c:v>191.57499999999999</c:v>
                </c:pt>
                <c:pt idx="143">
                  <c:v>200.57300000000001</c:v>
                </c:pt>
                <c:pt idx="144">
                  <c:v>208.839</c:v>
                </c:pt>
                <c:pt idx="145">
                  <c:v>214.57499999999999</c:v>
                </c:pt>
                <c:pt idx="146">
                  <c:v>220.56700000000001</c:v>
                </c:pt>
                <c:pt idx="147">
                  <c:v>229.86699999999999</c:v>
                </c:pt>
                <c:pt idx="148">
                  <c:v>240.07599999999999</c:v>
                </c:pt>
                <c:pt idx="149">
                  <c:v>249.49600000000001</c:v>
                </c:pt>
                <c:pt idx="150">
                  <c:v>262.72800000000001</c:v>
                </c:pt>
                <c:pt idx="151">
                  <c:v>273.35500000000002</c:v>
                </c:pt>
                <c:pt idx="152">
                  <c:v>279.67700000000002</c:v>
                </c:pt>
                <c:pt idx="153">
                  <c:v>286.38600000000002</c:v>
                </c:pt>
                <c:pt idx="154">
                  <c:v>293.887</c:v>
                </c:pt>
                <c:pt idx="155">
                  <c:v>302.73899999999998</c:v>
                </c:pt>
                <c:pt idx="156">
                  <c:v>311.74200000000002</c:v>
                </c:pt>
                <c:pt idx="157">
                  <c:v>318.483</c:v>
                </c:pt>
                <c:pt idx="158">
                  <c:v>323.53199999999998</c:v>
                </c:pt>
                <c:pt idx="159">
                  <c:v>328.899</c:v>
                </c:pt>
                <c:pt idx="160">
                  <c:v>334.83600000000001</c:v>
                </c:pt>
                <c:pt idx="161">
                  <c:v>342.142</c:v>
                </c:pt>
                <c:pt idx="162">
                  <c:v>351.73399999999998</c:v>
                </c:pt>
                <c:pt idx="163">
                  <c:v>360.74400000000003</c:v>
                </c:pt>
                <c:pt idx="164">
                  <c:v>367.60199999999998</c:v>
                </c:pt>
                <c:pt idx="165">
                  <c:v>373.68700000000001</c:v>
                </c:pt>
                <c:pt idx="166">
                  <c:v>381.49700000000001</c:v>
                </c:pt>
                <c:pt idx="167">
                  <c:v>389.334</c:v>
                </c:pt>
                <c:pt idx="168">
                  <c:v>397.995</c:v>
                </c:pt>
                <c:pt idx="169">
                  <c:v>406.61700000000002</c:v>
                </c:pt>
                <c:pt idx="170">
                  <c:v>414.90800000000002</c:v>
                </c:pt>
                <c:pt idx="171">
                  <c:v>422.74400000000003</c:v>
                </c:pt>
                <c:pt idx="172">
                  <c:v>431.32499999999999</c:v>
                </c:pt>
                <c:pt idx="173">
                  <c:v>440.42200000000003</c:v>
                </c:pt>
                <c:pt idx="174">
                  <c:v>450.23200000000003</c:v>
                </c:pt>
                <c:pt idx="175">
                  <c:v>458.56900000000002</c:v>
                </c:pt>
                <c:pt idx="176">
                  <c:v>469.78500000000003</c:v>
                </c:pt>
                <c:pt idx="177">
                  <c:v>480.29399999999998</c:v>
                </c:pt>
                <c:pt idx="178">
                  <c:v>489.78500000000003</c:v>
                </c:pt>
                <c:pt idx="179">
                  <c:v>497.56099999999998</c:v>
                </c:pt>
                <c:pt idx="180">
                  <c:v>506.66699999999997</c:v>
                </c:pt>
                <c:pt idx="181">
                  <c:v>520.45100000000002</c:v>
                </c:pt>
                <c:pt idx="182">
                  <c:v>536.24599999999998</c:v>
                </c:pt>
                <c:pt idx="183">
                  <c:v>549.78599999999994</c:v>
                </c:pt>
                <c:pt idx="184">
                  <c:v>563.16099999999994</c:v>
                </c:pt>
                <c:pt idx="185">
                  <c:v>578.39300000000003</c:v>
                </c:pt>
                <c:pt idx="186">
                  <c:v>594.34500000000003</c:v>
                </c:pt>
                <c:pt idx="187">
                  <c:v>610.346</c:v>
                </c:pt>
                <c:pt idx="188">
                  <c:v>626.60199999999998</c:v>
                </c:pt>
                <c:pt idx="189">
                  <c:v>645.02700000000004</c:v>
                </c:pt>
                <c:pt idx="190">
                  <c:v>666.54600000000005</c:v>
                </c:pt>
                <c:pt idx="191">
                  <c:v>692.952</c:v>
                </c:pt>
                <c:pt idx="192">
                  <c:v>717.85199999999998</c:v>
                </c:pt>
                <c:pt idx="193">
                  <c:v>745.92399999999998</c:v>
                </c:pt>
                <c:pt idx="194">
                  <c:v>776.904</c:v>
                </c:pt>
              </c:numCache>
            </c:numRef>
          </c:xVal>
          <c:yVal>
            <c:numRef>
              <c:f>'Volumes sorted'!$Z$24:$Z$218</c:f>
              <c:numCache>
                <c:formatCode>General</c:formatCode>
                <c:ptCount val="195"/>
                <c:pt idx="132">
                  <c:v>-681.97399999999993</c:v>
                </c:pt>
                <c:pt idx="133">
                  <c:v>-699.68599999999992</c:v>
                </c:pt>
                <c:pt idx="134">
                  <c:v>-496.64199999999983</c:v>
                </c:pt>
                <c:pt idx="135">
                  <c:v>-430.76199999999994</c:v>
                </c:pt>
                <c:pt idx="136">
                  <c:v>-529.91199999999981</c:v>
                </c:pt>
                <c:pt idx="137">
                  <c:v>-428.1719999999998</c:v>
                </c:pt>
                <c:pt idx="138">
                  <c:v>-154.72199999999998</c:v>
                </c:pt>
                <c:pt idx="139">
                  <c:v>126.94800000000009</c:v>
                </c:pt>
                <c:pt idx="140">
                  <c:v>-98.771999999999935</c:v>
                </c:pt>
                <c:pt idx="141">
                  <c:v>-690.61399999999992</c:v>
                </c:pt>
                <c:pt idx="142">
                  <c:v>-772.69399999999996</c:v>
                </c:pt>
                <c:pt idx="143">
                  <c:v>159.77800000000002</c:v>
                </c:pt>
                <c:pt idx="144">
                  <c:v>-732.51799999999992</c:v>
                </c:pt>
                <c:pt idx="145">
                  <c:v>-692.9899999999999</c:v>
                </c:pt>
                <c:pt idx="146">
                  <c:v>-662.75199999999995</c:v>
                </c:pt>
                <c:pt idx="147">
                  <c:v>619.42800000000011</c:v>
                </c:pt>
                <c:pt idx="148">
                  <c:v>-428.39199999999983</c:v>
                </c:pt>
                <c:pt idx="149">
                  <c:v>119.16800000000012</c:v>
                </c:pt>
                <c:pt idx="150">
                  <c:v>1052.7180000000001</c:v>
                </c:pt>
                <c:pt idx="151">
                  <c:v>-615.01199999999994</c:v>
                </c:pt>
                <c:pt idx="152">
                  <c:v>-465.76199999999994</c:v>
                </c:pt>
                <c:pt idx="153">
                  <c:v>-448.69200000000001</c:v>
                </c:pt>
                <c:pt idx="154">
                  <c:v>-240.25199999999995</c:v>
                </c:pt>
                <c:pt idx="155">
                  <c:v>-154.93200000000002</c:v>
                </c:pt>
                <c:pt idx="156">
                  <c:v>-99.201999999999998</c:v>
                </c:pt>
                <c:pt idx="157">
                  <c:v>-922.59799999999996</c:v>
                </c:pt>
                <c:pt idx="158">
                  <c:v>-795.58999999999992</c:v>
                </c:pt>
                <c:pt idx="159">
                  <c:v>-769.23799999999994</c:v>
                </c:pt>
                <c:pt idx="160">
                  <c:v>-694.93399999999986</c:v>
                </c:pt>
                <c:pt idx="161">
                  <c:v>-183.66199999999981</c:v>
                </c:pt>
                <c:pt idx="162">
                  <c:v>-35.481999999999971</c:v>
                </c:pt>
                <c:pt idx="163">
                  <c:v>-321.90199999999982</c:v>
                </c:pt>
                <c:pt idx="164">
                  <c:v>-856.71799999999996</c:v>
                </c:pt>
                <c:pt idx="165">
                  <c:v>-767.72599999999989</c:v>
                </c:pt>
                <c:pt idx="166">
                  <c:v>-631.86199999999985</c:v>
                </c:pt>
                <c:pt idx="167">
                  <c:v>-550.21199999999999</c:v>
                </c:pt>
                <c:pt idx="168">
                  <c:v>-339.40199999999982</c:v>
                </c:pt>
                <c:pt idx="169">
                  <c:v>-579.80199999999991</c:v>
                </c:pt>
                <c:pt idx="170">
                  <c:v>-515.22199999999998</c:v>
                </c:pt>
                <c:pt idx="171">
                  <c:v>-547.40199999999982</c:v>
                </c:pt>
                <c:pt idx="172">
                  <c:v>-188.41199999999981</c:v>
                </c:pt>
                <c:pt idx="173">
                  <c:v>-67.241999999999962</c:v>
                </c:pt>
                <c:pt idx="174">
                  <c:v>152.86800000000017</c:v>
                </c:pt>
                <c:pt idx="175">
                  <c:v>668.45800000000031</c:v>
                </c:pt>
                <c:pt idx="176">
                  <c:v>28.448000000000093</c:v>
                </c:pt>
                <c:pt idx="177">
                  <c:v>395.64799999999991</c:v>
                </c:pt>
                <c:pt idx="178">
                  <c:v>-466.19200000000001</c:v>
                </c:pt>
                <c:pt idx="179">
                  <c:v>-422.99199999999996</c:v>
                </c:pt>
                <c:pt idx="180">
                  <c:v>-228.80199999999991</c:v>
                </c:pt>
                <c:pt idx="181">
                  <c:v>848.16799999999989</c:v>
                </c:pt>
                <c:pt idx="182">
                  <c:v>-667.07199999999989</c:v>
                </c:pt>
                <c:pt idx="183">
                  <c:v>-580.6719999999998</c:v>
                </c:pt>
                <c:pt idx="184">
                  <c:v>-401.82199999999989</c:v>
                </c:pt>
                <c:pt idx="185">
                  <c:v>124.13800000000015</c:v>
                </c:pt>
                <c:pt idx="186">
                  <c:v>-19.932000000000016</c:v>
                </c:pt>
                <c:pt idx="187">
                  <c:v>385.71800000000007</c:v>
                </c:pt>
                <c:pt idx="188">
                  <c:v>291.10800000000017</c:v>
                </c:pt>
                <c:pt idx="189">
                  <c:v>1152.7280000000003</c:v>
                </c:pt>
                <c:pt idx="190">
                  <c:v>1760.1180000000002</c:v>
                </c:pt>
                <c:pt idx="191">
                  <c:v>3799.598</c:v>
                </c:pt>
                <c:pt idx="192">
                  <c:v>2079.7979999999998</c:v>
                </c:pt>
                <c:pt idx="193">
                  <c:v>4464.6580000000004</c:v>
                </c:pt>
                <c:pt idx="194">
                  <c:v>2849.838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5B3-407C-BB55-EF3604C208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0036392"/>
        <c:axId val="780044920"/>
      </c:scatterChart>
      <c:valAx>
        <c:axId val="780036392"/>
        <c:scaling>
          <c:orientation val="minMax"/>
          <c:max val="1000"/>
        </c:scaling>
        <c:delete val="1"/>
        <c:axPos val="b"/>
        <c:numFmt formatCode="General" sourceLinked="1"/>
        <c:majorTickMark val="none"/>
        <c:minorTickMark val="none"/>
        <c:tickLblPos val="nextTo"/>
        <c:crossAx val="780044920"/>
        <c:crosses val="autoZero"/>
        <c:crossBetween val="midCat"/>
      </c:valAx>
      <c:valAx>
        <c:axId val="780044920"/>
        <c:scaling>
          <c:orientation val="minMax"/>
          <c:max val="10000"/>
        </c:scaling>
        <c:delete val="1"/>
        <c:axPos val="l"/>
        <c:numFmt formatCode="General" sourceLinked="1"/>
        <c:majorTickMark val="none"/>
        <c:minorTickMark val="none"/>
        <c:tickLblPos val="nextTo"/>
        <c:crossAx val="780036392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872466112126458E-2"/>
          <c:y val="6.4814731043150053E-2"/>
          <c:w val="0.84895598793468885"/>
          <c:h val="0.86590555028157912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volumes sorted'!$S$2:$S$190</c:f>
              <c:numCache>
                <c:formatCode>General</c:formatCode>
                <c:ptCount val="189"/>
                <c:pt idx="0">
                  <c:v>101.995</c:v>
                </c:pt>
                <c:pt idx="1">
                  <c:v>109.54300000000001</c:v>
                </c:pt>
                <c:pt idx="2">
                  <c:v>118.727</c:v>
                </c:pt>
                <c:pt idx="3">
                  <c:v>127.505</c:v>
                </c:pt>
                <c:pt idx="4">
                  <c:v>134.214</c:v>
                </c:pt>
                <c:pt idx="5">
                  <c:v>138.87799999999999</c:v>
                </c:pt>
                <c:pt idx="6">
                  <c:v>145.03100000000001</c:v>
                </c:pt>
                <c:pt idx="7">
                  <c:v>151.03700000000001</c:v>
                </c:pt>
                <c:pt idx="8">
                  <c:v>156.89699999999999</c:v>
                </c:pt>
                <c:pt idx="9">
                  <c:v>162.54499999999999</c:v>
                </c:pt>
                <c:pt idx="10">
                  <c:v>170.167</c:v>
                </c:pt>
                <c:pt idx="11">
                  <c:v>178.66</c:v>
                </c:pt>
                <c:pt idx="12">
                  <c:v>184.631</c:v>
                </c:pt>
                <c:pt idx="13">
                  <c:v>191.51400000000001</c:v>
                </c:pt>
                <c:pt idx="14">
                  <c:v>198.851</c:v>
                </c:pt>
                <c:pt idx="15">
                  <c:v>206.63399999999999</c:v>
                </c:pt>
                <c:pt idx="16">
                  <c:v>214.26599999999999</c:v>
                </c:pt>
                <c:pt idx="17">
                  <c:v>222.64099999999999</c:v>
                </c:pt>
                <c:pt idx="18">
                  <c:v>231.346</c:v>
                </c:pt>
                <c:pt idx="19">
                  <c:v>249.68899999999999</c:v>
                </c:pt>
                <c:pt idx="20">
                  <c:v>258.29500000000002</c:v>
                </c:pt>
                <c:pt idx="21">
                  <c:v>265.327</c:v>
                </c:pt>
                <c:pt idx="22">
                  <c:v>271.85199999999998</c:v>
                </c:pt>
                <c:pt idx="23">
                  <c:v>278.86900000000003</c:v>
                </c:pt>
                <c:pt idx="24">
                  <c:v>286.23099999999999</c:v>
                </c:pt>
                <c:pt idx="25">
                  <c:v>293.38900000000001</c:v>
                </c:pt>
                <c:pt idx="26">
                  <c:v>309.286</c:v>
                </c:pt>
                <c:pt idx="27">
                  <c:v>314.70600000000002</c:v>
                </c:pt>
                <c:pt idx="28">
                  <c:v>321.18400000000003</c:v>
                </c:pt>
                <c:pt idx="29">
                  <c:v>328.19200000000001</c:v>
                </c:pt>
                <c:pt idx="30">
                  <c:v>335.36799999999999</c:v>
                </c:pt>
                <c:pt idx="31">
                  <c:v>343.46100000000001</c:v>
                </c:pt>
                <c:pt idx="32">
                  <c:v>352.42599999999999</c:v>
                </c:pt>
                <c:pt idx="33">
                  <c:v>360.82299999999998</c:v>
                </c:pt>
                <c:pt idx="34">
                  <c:v>369.48</c:v>
                </c:pt>
                <c:pt idx="35">
                  <c:v>379.411</c:v>
                </c:pt>
                <c:pt idx="36">
                  <c:v>388.94900000000001</c:v>
                </c:pt>
                <c:pt idx="37">
                  <c:v>397.26299999999998</c:v>
                </c:pt>
                <c:pt idx="38">
                  <c:v>405.779</c:v>
                </c:pt>
                <c:pt idx="39">
                  <c:v>414.69099999999997</c:v>
                </c:pt>
                <c:pt idx="40">
                  <c:v>424.22399999999999</c:v>
                </c:pt>
                <c:pt idx="41">
                  <c:v>434.92899999999997</c:v>
                </c:pt>
                <c:pt idx="42">
                  <c:v>446.30200000000002</c:v>
                </c:pt>
                <c:pt idx="43">
                  <c:v>455.154</c:v>
                </c:pt>
                <c:pt idx="44">
                  <c:v>462.36799999999999</c:v>
                </c:pt>
                <c:pt idx="45">
                  <c:v>470.57400000000001</c:v>
                </c:pt>
                <c:pt idx="46">
                  <c:v>479.09699999999998</c:v>
                </c:pt>
                <c:pt idx="47">
                  <c:v>488.41399999999999</c:v>
                </c:pt>
                <c:pt idx="48">
                  <c:v>498.68900000000002</c:v>
                </c:pt>
                <c:pt idx="49">
                  <c:v>512.64800000000002</c:v>
                </c:pt>
                <c:pt idx="50">
                  <c:v>526.55100000000004</c:v>
                </c:pt>
                <c:pt idx="51">
                  <c:v>537.47299999999996</c:v>
                </c:pt>
                <c:pt idx="52">
                  <c:v>553.43700000000001</c:v>
                </c:pt>
                <c:pt idx="53">
                  <c:v>568.94000000000005</c:v>
                </c:pt>
                <c:pt idx="54">
                  <c:v>580.68899999999996</c:v>
                </c:pt>
                <c:pt idx="55">
                  <c:v>596.70299999999997</c:v>
                </c:pt>
                <c:pt idx="56">
                  <c:v>612.78200000000004</c:v>
                </c:pt>
                <c:pt idx="57">
                  <c:v>624.96699999999998</c:v>
                </c:pt>
                <c:pt idx="58">
                  <c:v>640.00699999999995</c:v>
                </c:pt>
                <c:pt idx="59">
                  <c:v>661.11699999999996</c:v>
                </c:pt>
                <c:pt idx="60">
                  <c:v>688.45600000000002</c:v>
                </c:pt>
                <c:pt idx="61">
                  <c:v>712.87400000000002</c:v>
                </c:pt>
                <c:pt idx="62">
                  <c:v>732.88599999999997</c:v>
                </c:pt>
                <c:pt idx="63">
                  <c:v>761.00400000000002</c:v>
                </c:pt>
                <c:pt idx="64">
                  <c:v>101.88</c:v>
                </c:pt>
                <c:pt idx="65">
                  <c:v>110.768</c:v>
                </c:pt>
                <c:pt idx="66">
                  <c:v>119.89100000000001</c:v>
                </c:pt>
                <c:pt idx="67">
                  <c:v>130.036</c:v>
                </c:pt>
                <c:pt idx="68">
                  <c:v>140.733</c:v>
                </c:pt>
                <c:pt idx="69">
                  <c:v>147.768</c:v>
                </c:pt>
                <c:pt idx="70">
                  <c:v>154.191</c:v>
                </c:pt>
                <c:pt idx="71">
                  <c:v>160.99799999999999</c:v>
                </c:pt>
                <c:pt idx="72">
                  <c:v>168.21700000000001</c:v>
                </c:pt>
                <c:pt idx="73">
                  <c:v>175.191</c:v>
                </c:pt>
                <c:pt idx="74">
                  <c:v>182.226</c:v>
                </c:pt>
                <c:pt idx="75">
                  <c:v>189.148</c:v>
                </c:pt>
                <c:pt idx="76">
                  <c:v>197.24199999999999</c:v>
                </c:pt>
                <c:pt idx="77">
                  <c:v>206.636</c:v>
                </c:pt>
                <c:pt idx="78">
                  <c:v>216.071</c:v>
                </c:pt>
                <c:pt idx="79">
                  <c:v>224.386</c:v>
                </c:pt>
                <c:pt idx="80">
                  <c:v>232.82</c:v>
                </c:pt>
                <c:pt idx="81">
                  <c:v>241.958</c:v>
                </c:pt>
                <c:pt idx="82">
                  <c:v>256.88499999999999</c:v>
                </c:pt>
                <c:pt idx="83">
                  <c:v>273.517</c:v>
                </c:pt>
                <c:pt idx="84">
                  <c:v>282.97500000000002</c:v>
                </c:pt>
                <c:pt idx="85">
                  <c:v>294.56900000000002</c:v>
                </c:pt>
                <c:pt idx="86">
                  <c:v>306.17599999999999</c:v>
                </c:pt>
                <c:pt idx="87">
                  <c:v>315.75200000000001</c:v>
                </c:pt>
                <c:pt idx="88">
                  <c:v>324.57600000000002</c:v>
                </c:pt>
                <c:pt idx="89">
                  <c:v>333.846</c:v>
                </c:pt>
                <c:pt idx="90">
                  <c:v>344.04399999999998</c:v>
                </c:pt>
                <c:pt idx="91">
                  <c:v>352.36</c:v>
                </c:pt>
                <c:pt idx="92">
                  <c:v>359.71800000000002</c:v>
                </c:pt>
                <c:pt idx="93">
                  <c:v>367.66899999999998</c:v>
                </c:pt>
                <c:pt idx="94">
                  <c:v>377.33499999999998</c:v>
                </c:pt>
                <c:pt idx="95">
                  <c:v>388.86599999999999</c:v>
                </c:pt>
                <c:pt idx="96">
                  <c:v>401.13099999999997</c:v>
                </c:pt>
                <c:pt idx="97">
                  <c:v>410.64100000000002</c:v>
                </c:pt>
                <c:pt idx="98">
                  <c:v>420.59100000000001</c:v>
                </c:pt>
                <c:pt idx="99">
                  <c:v>430.286</c:v>
                </c:pt>
                <c:pt idx="100">
                  <c:v>437.00400000000002</c:v>
                </c:pt>
                <c:pt idx="101">
                  <c:v>443.971</c:v>
                </c:pt>
                <c:pt idx="102">
                  <c:v>450.82299999999998</c:v>
                </c:pt>
                <c:pt idx="103">
                  <c:v>457.9</c:v>
                </c:pt>
                <c:pt idx="104">
                  <c:v>465.565</c:v>
                </c:pt>
                <c:pt idx="105">
                  <c:v>473.96100000000001</c:v>
                </c:pt>
                <c:pt idx="106">
                  <c:v>485.12599999999998</c:v>
                </c:pt>
                <c:pt idx="107">
                  <c:v>498.75099999999998</c:v>
                </c:pt>
                <c:pt idx="108">
                  <c:v>513.077</c:v>
                </c:pt>
                <c:pt idx="109">
                  <c:v>524.95399999999995</c:v>
                </c:pt>
                <c:pt idx="110">
                  <c:v>533.26599999999996</c:v>
                </c:pt>
                <c:pt idx="111">
                  <c:v>545.98199999999997</c:v>
                </c:pt>
                <c:pt idx="112">
                  <c:v>559.91399999999999</c:v>
                </c:pt>
                <c:pt idx="113">
                  <c:v>569.71199999999999</c:v>
                </c:pt>
                <c:pt idx="114">
                  <c:v>583.22199999999998</c:v>
                </c:pt>
                <c:pt idx="115">
                  <c:v>598.34100000000001</c:v>
                </c:pt>
                <c:pt idx="116">
                  <c:v>611.04600000000005</c:v>
                </c:pt>
                <c:pt idx="117">
                  <c:v>624.45100000000002</c:v>
                </c:pt>
                <c:pt idx="118">
                  <c:v>638.202</c:v>
                </c:pt>
                <c:pt idx="119">
                  <c:v>653.11199999999997</c:v>
                </c:pt>
                <c:pt idx="120">
                  <c:v>670.62900000000002</c:v>
                </c:pt>
                <c:pt idx="121">
                  <c:v>695.97500000000002</c:v>
                </c:pt>
                <c:pt idx="122">
                  <c:v>721.08699999999999</c:v>
                </c:pt>
                <c:pt idx="123">
                  <c:v>744.18</c:v>
                </c:pt>
                <c:pt idx="124">
                  <c:v>772.61500000000001</c:v>
                </c:pt>
                <c:pt idx="125">
                  <c:v>111.398</c:v>
                </c:pt>
                <c:pt idx="126">
                  <c:v>122.568</c:v>
                </c:pt>
                <c:pt idx="127">
                  <c:v>131.74199999999999</c:v>
                </c:pt>
                <c:pt idx="128">
                  <c:v>138.702</c:v>
                </c:pt>
                <c:pt idx="129">
                  <c:v>145.51499999999999</c:v>
                </c:pt>
                <c:pt idx="130">
                  <c:v>152.60499999999999</c:v>
                </c:pt>
                <c:pt idx="131">
                  <c:v>163.09299999999999</c:v>
                </c:pt>
                <c:pt idx="132">
                  <c:v>172.834</c:v>
                </c:pt>
                <c:pt idx="133">
                  <c:v>182.5</c:v>
                </c:pt>
                <c:pt idx="134">
                  <c:v>190.672</c:v>
                </c:pt>
                <c:pt idx="135">
                  <c:v>197.92099999999999</c:v>
                </c:pt>
                <c:pt idx="136">
                  <c:v>205.33699999999999</c:v>
                </c:pt>
                <c:pt idx="137">
                  <c:v>213.24</c:v>
                </c:pt>
                <c:pt idx="138">
                  <c:v>220.97499999999999</c:v>
                </c:pt>
                <c:pt idx="139">
                  <c:v>229.071</c:v>
                </c:pt>
                <c:pt idx="140">
                  <c:v>239.47800000000001</c:v>
                </c:pt>
                <c:pt idx="141">
                  <c:v>249.56800000000001</c:v>
                </c:pt>
                <c:pt idx="142">
                  <c:v>258.31700000000001</c:v>
                </c:pt>
                <c:pt idx="143">
                  <c:v>268.50700000000001</c:v>
                </c:pt>
                <c:pt idx="144">
                  <c:v>278.06400000000002</c:v>
                </c:pt>
                <c:pt idx="145">
                  <c:v>287.62</c:v>
                </c:pt>
                <c:pt idx="146">
                  <c:v>299.65499999999997</c:v>
                </c:pt>
                <c:pt idx="147">
                  <c:v>310.00799999999998</c:v>
                </c:pt>
                <c:pt idx="148">
                  <c:v>319.08699999999999</c:v>
                </c:pt>
                <c:pt idx="149">
                  <c:v>328.35399999999998</c:v>
                </c:pt>
                <c:pt idx="150">
                  <c:v>336.52100000000002</c:v>
                </c:pt>
                <c:pt idx="151">
                  <c:v>342.33699999999999</c:v>
                </c:pt>
                <c:pt idx="152">
                  <c:v>347.63499999999999</c:v>
                </c:pt>
                <c:pt idx="153">
                  <c:v>353.04700000000003</c:v>
                </c:pt>
                <c:pt idx="154">
                  <c:v>358.48399999999998</c:v>
                </c:pt>
                <c:pt idx="155">
                  <c:v>364.37</c:v>
                </c:pt>
                <c:pt idx="156">
                  <c:v>370.08800000000002</c:v>
                </c:pt>
                <c:pt idx="157">
                  <c:v>375.56299999999999</c:v>
                </c:pt>
                <c:pt idx="158">
                  <c:v>384.85599999999999</c:v>
                </c:pt>
                <c:pt idx="159">
                  <c:v>393.90499999999997</c:v>
                </c:pt>
                <c:pt idx="160">
                  <c:v>399.81</c:v>
                </c:pt>
                <c:pt idx="161">
                  <c:v>407.86900000000003</c:v>
                </c:pt>
                <c:pt idx="162">
                  <c:v>416.09399999999999</c:v>
                </c:pt>
                <c:pt idx="163">
                  <c:v>422.99700000000001</c:v>
                </c:pt>
                <c:pt idx="164">
                  <c:v>430.05399999999997</c:v>
                </c:pt>
                <c:pt idx="165">
                  <c:v>437.01799999999997</c:v>
                </c:pt>
                <c:pt idx="166">
                  <c:v>444.60599999999999</c:v>
                </c:pt>
                <c:pt idx="167">
                  <c:v>452.50599999999997</c:v>
                </c:pt>
                <c:pt idx="168">
                  <c:v>460.113</c:v>
                </c:pt>
                <c:pt idx="169">
                  <c:v>467.33300000000003</c:v>
                </c:pt>
                <c:pt idx="170">
                  <c:v>476.10599999999999</c:v>
                </c:pt>
                <c:pt idx="171">
                  <c:v>485.834</c:v>
                </c:pt>
                <c:pt idx="172">
                  <c:v>497.40199999999999</c:v>
                </c:pt>
                <c:pt idx="173">
                  <c:v>510.37700000000001</c:v>
                </c:pt>
                <c:pt idx="174">
                  <c:v>523.94200000000001</c:v>
                </c:pt>
                <c:pt idx="175">
                  <c:v>537.63499999999999</c:v>
                </c:pt>
                <c:pt idx="176">
                  <c:v>551.23</c:v>
                </c:pt>
                <c:pt idx="177">
                  <c:v>565.44200000000001</c:v>
                </c:pt>
                <c:pt idx="178">
                  <c:v>581.03</c:v>
                </c:pt>
                <c:pt idx="179">
                  <c:v>599.84699999999998</c:v>
                </c:pt>
                <c:pt idx="180">
                  <c:v>620.30600000000004</c:v>
                </c:pt>
                <c:pt idx="181">
                  <c:v>636.70600000000002</c:v>
                </c:pt>
                <c:pt idx="182">
                  <c:v>651.21699999999998</c:v>
                </c:pt>
                <c:pt idx="183">
                  <c:v>667.03</c:v>
                </c:pt>
                <c:pt idx="184">
                  <c:v>684.50800000000004</c:v>
                </c:pt>
                <c:pt idx="185">
                  <c:v>704.31399999999996</c:v>
                </c:pt>
                <c:pt idx="186">
                  <c:v>728.60900000000004</c:v>
                </c:pt>
                <c:pt idx="187">
                  <c:v>759.62300000000005</c:v>
                </c:pt>
                <c:pt idx="188">
                  <c:v>788.78499999999997</c:v>
                </c:pt>
              </c:numCache>
            </c:numRef>
          </c:xVal>
          <c:yVal>
            <c:numRef>
              <c:f>'volumes sorted'!$W$2:$W$190</c:f>
              <c:numCache>
                <c:formatCode>General</c:formatCode>
                <c:ptCount val="189"/>
                <c:pt idx="0">
                  <c:v>-1052.5580000000002</c:v>
                </c:pt>
                <c:pt idx="1">
                  <c:v>-526.37800000000016</c:v>
                </c:pt>
                <c:pt idx="2">
                  <c:v>-223.33800000000019</c:v>
                </c:pt>
                <c:pt idx="3">
                  <c:v>-12.738000000000284</c:v>
                </c:pt>
                <c:pt idx="4">
                  <c:v>-1162.2860000000001</c:v>
                </c:pt>
                <c:pt idx="5">
                  <c:v>-992.9380000000001</c:v>
                </c:pt>
                <c:pt idx="6">
                  <c:v>-800.69800000000009</c:v>
                </c:pt>
                <c:pt idx="7">
                  <c:v>-927.49800000000027</c:v>
                </c:pt>
                <c:pt idx="8">
                  <c:v>-965.29800000000023</c:v>
                </c:pt>
                <c:pt idx="9">
                  <c:v>-969.61800000000017</c:v>
                </c:pt>
                <c:pt idx="10">
                  <c:v>-301.30800000000022</c:v>
                </c:pt>
                <c:pt idx="11">
                  <c:v>-1168.7660000000001</c:v>
                </c:pt>
                <c:pt idx="12">
                  <c:v>-1213.6940000000002</c:v>
                </c:pt>
                <c:pt idx="13">
                  <c:v>-803.29800000000023</c:v>
                </c:pt>
                <c:pt idx="14">
                  <c:v>-655.97800000000007</c:v>
                </c:pt>
                <c:pt idx="15">
                  <c:v>-753.61800000000017</c:v>
                </c:pt>
                <c:pt idx="16">
                  <c:v>-790.76800000000026</c:v>
                </c:pt>
                <c:pt idx="17">
                  <c:v>-554.02800000000025</c:v>
                </c:pt>
                <c:pt idx="18">
                  <c:v>-498.08800000000019</c:v>
                </c:pt>
                <c:pt idx="19">
                  <c:v>-322.90800000000013</c:v>
                </c:pt>
                <c:pt idx="20">
                  <c:v>-456.61800000000017</c:v>
                </c:pt>
                <c:pt idx="21">
                  <c:v>-703.28800000000024</c:v>
                </c:pt>
                <c:pt idx="22">
                  <c:v>-652.95800000000008</c:v>
                </c:pt>
                <c:pt idx="23">
                  <c:v>-722.50800000000027</c:v>
                </c:pt>
                <c:pt idx="24">
                  <c:v>-417.94800000000009</c:v>
                </c:pt>
                <c:pt idx="25">
                  <c:v>-738.27800000000025</c:v>
                </c:pt>
                <c:pt idx="26">
                  <c:v>-979.97800000000007</c:v>
                </c:pt>
                <c:pt idx="27">
                  <c:v>-1018.6480000000001</c:v>
                </c:pt>
                <c:pt idx="28">
                  <c:v>-763.76800000000026</c:v>
                </c:pt>
                <c:pt idx="29">
                  <c:v>-626.60800000000017</c:v>
                </c:pt>
                <c:pt idx="30">
                  <c:v>-689.02800000000025</c:v>
                </c:pt>
                <c:pt idx="31">
                  <c:v>-219.44800000000009</c:v>
                </c:pt>
                <c:pt idx="32">
                  <c:v>-317.72800000000007</c:v>
                </c:pt>
                <c:pt idx="33">
                  <c:v>-373.01800000000026</c:v>
                </c:pt>
                <c:pt idx="34">
                  <c:v>-180.77800000000025</c:v>
                </c:pt>
                <c:pt idx="35">
                  <c:v>298.30199999999968</c:v>
                </c:pt>
                <c:pt idx="36">
                  <c:v>-373.88800000000015</c:v>
                </c:pt>
                <c:pt idx="37">
                  <c:v>-237.15800000000013</c:v>
                </c:pt>
                <c:pt idx="38">
                  <c:v>-224.41800000000012</c:v>
                </c:pt>
                <c:pt idx="39">
                  <c:v>-87.468000000000075</c:v>
                </c:pt>
                <c:pt idx="40">
                  <c:v>2.3819999999996071</c:v>
                </c:pt>
                <c:pt idx="41">
                  <c:v>419.48199999999997</c:v>
                </c:pt>
                <c:pt idx="42">
                  <c:v>270.87199999999984</c:v>
                </c:pt>
                <c:pt idx="43">
                  <c:v>-723.80800000000022</c:v>
                </c:pt>
                <c:pt idx="44">
                  <c:v>-688.81800000000021</c:v>
                </c:pt>
                <c:pt idx="45">
                  <c:v>-483.61800000000017</c:v>
                </c:pt>
                <c:pt idx="46">
                  <c:v>-461.5780000000002</c:v>
                </c:pt>
                <c:pt idx="47">
                  <c:v>-263.9380000000001</c:v>
                </c:pt>
                <c:pt idx="48">
                  <c:v>-274.30800000000022</c:v>
                </c:pt>
                <c:pt idx="49">
                  <c:v>1527.5619999999999</c:v>
                </c:pt>
                <c:pt idx="50">
                  <c:v>-153.34800000000018</c:v>
                </c:pt>
                <c:pt idx="51">
                  <c:v>187.50199999999995</c:v>
                </c:pt>
                <c:pt idx="52">
                  <c:v>2061.732</c:v>
                </c:pt>
                <c:pt idx="53">
                  <c:v>188.58199999999988</c:v>
                </c:pt>
                <c:pt idx="54">
                  <c:v>493.14199999999983</c:v>
                </c:pt>
                <c:pt idx="55">
                  <c:v>2071.8819999999996</c:v>
                </c:pt>
                <c:pt idx="56">
                  <c:v>641.10199999999986</c:v>
                </c:pt>
                <c:pt idx="57">
                  <c:v>359.86199999999963</c:v>
                </c:pt>
                <c:pt idx="58">
                  <c:v>1799.2919999999999</c:v>
                </c:pt>
                <c:pt idx="59">
                  <c:v>3156.4219999999996</c:v>
                </c:pt>
                <c:pt idx="60">
                  <c:v>4698.442</c:v>
                </c:pt>
                <c:pt idx="61">
                  <c:v>1602.0819999999999</c:v>
                </c:pt>
                <c:pt idx="62">
                  <c:v>2791.8119999999999</c:v>
                </c:pt>
                <c:pt idx="63">
                  <c:v>4958.291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1F3-427B-BECA-1526803B4E91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volumes sorted'!$S$2:$S$190</c:f>
              <c:numCache>
                <c:formatCode>General</c:formatCode>
                <c:ptCount val="189"/>
                <c:pt idx="0">
                  <c:v>101.995</c:v>
                </c:pt>
                <c:pt idx="1">
                  <c:v>109.54300000000001</c:v>
                </c:pt>
                <c:pt idx="2">
                  <c:v>118.727</c:v>
                </c:pt>
                <c:pt idx="3">
                  <c:v>127.505</c:v>
                </c:pt>
                <c:pt idx="4">
                  <c:v>134.214</c:v>
                </c:pt>
                <c:pt idx="5">
                  <c:v>138.87799999999999</c:v>
                </c:pt>
                <c:pt idx="6">
                  <c:v>145.03100000000001</c:v>
                </c:pt>
                <c:pt idx="7">
                  <c:v>151.03700000000001</c:v>
                </c:pt>
                <c:pt idx="8">
                  <c:v>156.89699999999999</c:v>
                </c:pt>
                <c:pt idx="9">
                  <c:v>162.54499999999999</c:v>
                </c:pt>
                <c:pt idx="10">
                  <c:v>170.167</c:v>
                </c:pt>
                <c:pt idx="11">
                  <c:v>178.66</c:v>
                </c:pt>
                <c:pt idx="12">
                  <c:v>184.631</c:v>
                </c:pt>
                <c:pt idx="13">
                  <c:v>191.51400000000001</c:v>
                </c:pt>
                <c:pt idx="14">
                  <c:v>198.851</c:v>
                </c:pt>
                <c:pt idx="15">
                  <c:v>206.63399999999999</c:v>
                </c:pt>
                <c:pt idx="16">
                  <c:v>214.26599999999999</c:v>
                </c:pt>
                <c:pt idx="17">
                  <c:v>222.64099999999999</c:v>
                </c:pt>
                <c:pt idx="18">
                  <c:v>231.346</c:v>
                </c:pt>
                <c:pt idx="19">
                  <c:v>249.68899999999999</c:v>
                </c:pt>
                <c:pt idx="20">
                  <c:v>258.29500000000002</c:v>
                </c:pt>
                <c:pt idx="21">
                  <c:v>265.327</c:v>
                </c:pt>
                <c:pt idx="22">
                  <c:v>271.85199999999998</c:v>
                </c:pt>
                <c:pt idx="23">
                  <c:v>278.86900000000003</c:v>
                </c:pt>
                <c:pt idx="24">
                  <c:v>286.23099999999999</c:v>
                </c:pt>
                <c:pt idx="25">
                  <c:v>293.38900000000001</c:v>
                </c:pt>
                <c:pt idx="26">
                  <c:v>309.286</c:v>
                </c:pt>
                <c:pt idx="27">
                  <c:v>314.70600000000002</c:v>
                </c:pt>
                <c:pt idx="28">
                  <c:v>321.18400000000003</c:v>
                </c:pt>
                <c:pt idx="29">
                  <c:v>328.19200000000001</c:v>
                </c:pt>
                <c:pt idx="30">
                  <c:v>335.36799999999999</c:v>
                </c:pt>
                <c:pt idx="31">
                  <c:v>343.46100000000001</c:v>
                </c:pt>
                <c:pt idx="32">
                  <c:v>352.42599999999999</c:v>
                </c:pt>
                <c:pt idx="33">
                  <c:v>360.82299999999998</c:v>
                </c:pt>
                <c:pt idx="34">
                  <c:v>369.48</c:v>
                </c:pt>
                <c:pt idx="35">
                  <c:v>379.411</c:v>
                </c:pt>
                <c:pt idx="36">
                  <c:v>388.94900000000001</c:v>
                </c:pt>
                <c:pt idx="37">
                  <c:v>397.26299999999998</c:v>
                </c:pt>
                <c:pt idx="38">
                  <c:v>405.779</c:v>
                </c:pt>
                <c:pt idx="39">
                  <c:v>414.69099999999997</c:v>
                </c:pt>
                <c:pt idx="40">
                  <c:v>424.22399999999999</c:v>
                </c:pt>
                <c:pt idx="41">
                  <c:v>434.92899999999997</c:v>
                </c:pt>
                <c:pt idx="42">
                  <c:v>446.30200000000002</c:v>
                </c:pt>
                <c:pt idx="43">
                  <c:v>455.154</c:v>
                </c:pt>
                <c:pt idx="44">
                  <c:v>462.36799999999999</c:v>
                </c:pt>
                <c:pt idx="45">
                  <c:v>470.57400000000001</c:v>
                </c:pt>
                <c:pt idx="46">
                  <c:v>479.09699999999998</c:v>
                </c:pt>
                <c:pt idx="47">
                  <c:v>488.41399999999999</c:v>
                </c:pt>
                <c:pt idx="48">
                  <c:v>498.68900000000002</c:v>
                </c:pt>
                <c:pt idx="49">
                  <c:v>512.64800000000002</c:v>
                </c:pt>
                <c:pt idx="50">
                  <c:v>526.55100000000004</c:v>
                </c:pt>
                <c:pt idx="51">
                  <c:v>537.47299999999996</c:v>
                </c:pt>
                <c:pt idx="52">
                  <c:v>553.43700000000001</c:v>
                </c:pt>
                <c:pt idx="53">
                  <c:v>568.94000000000005</c:v>
                </c:pt>
                <c:pt idx="54">
                  <c:v>580.68899999999996</c:v>
                </c:pt>
                <c:pt idx="55">
                  <c:v>596.70299999999997</c:v>
                </c:pt>
                <c:pt idx="56">
                  <c:v>612.78200000000004</c:v>
                </c:pt>
                <c:pt idx="57">
                  <c:v>624.96699999999998</c:v>
                </c:pt>
                <c:pt idx="58">
                  <c:v>640.00699999999995</c:v>
                </c:pt>
                <c:pt idx="59">
                  <c:v>661.11699999999996</c:v>
                </c:pt>
                <c:pt idx="60">
                  <c:v>688.45600000000002</c:v>
                </c:pt>
                <c:pt idx="61">
                  <c:v>712.87400000000002</c:v>
                </c:pt>
                <c:pt idx="62">
                  <c:v>732.88599999999997</c:v>
                </c:pt>
                <c:pt idx="63">
                  <c:v>761.00400000000002</c:v>
                </c:pt>
                <c:pt idx="64">
                  <c:v>101.88</c:v>
                </c:pt>
                <c:pt idx="65">
                  <c:v>110.768</c:v>
                </c:pt>
                <c:pt idx="66">
                  <c:v>119.89100000000001</c:v>
                </c:pt>
                <c:pt idx="67">
                  <c:v>130.036</c:v>
                </c:pt>
                <c:pt idx="68">
                  <c:v>140.733</c:v>
                </c:pt>
                <c:pt idx="69">
                  <c:v>147.768</c:v>
                </c:pt>
                <c:pt idx="70">
                  <c:v>154.191</c:v>
                </c:pt>
                <c:pt idx="71">
                  <c:v>160.99799999999999</c:v>
                </c:pt>
                <c:pt idx="72">
                  <c:v>168.21700000000001</c:v>
                </c:pt>
                <c:pt idx="73">
                  <c:v>175.191</c:v>
                </c:pt>
                <c:pt idx="74">
                  <c:v>182.226</c:v>
                </c:pt>
                <c:pt idx="75">
                  <c:v>189.148</c:v>
                </c:pt>
                <c:pt idx="76">
                  <c:v>197.24199999999999</c:v>
                </c:pt>
                <c:pt idx="77">
                  <c:v>206.636</c:v>
                </c:pt>
                <c:pt idx="78">
                  <c:v>216.071</c:v>
                </c:pt>
                <c:pt idx="79">
                  <c:v>224.386</c:v>
                </c:pt>
                <c:pt idx="80">
                  <c:v>232.82</c:v>
                </c:pt>
                <c:pt idx="81">
                  <c:v>241.958</c:v>
                </c:pt>
                <c:pt idx="82">
                  <c:v>256.88499999999999</c:v>
                </c:pt>
                <c:pt idx="83">
                  <c:v>273.517</c:v>
                </c:pt>
                <c:pt idx="84">
                  <c:v>282.97500000000002</c:v>
                </c:pt>
                <c:pt idx="85">
                  <c:v>294.56900000000002</c:v>
                </c:pt>
                <c:pt idx="86">
                  <c:v>306.17599999999999</c:v>
                </c:pt>
                <c:pt idx="87">
                  <c:v>315.75200000000001</c:v>
                </c:pt>
                <c:pt idx="88">
                  <c:v>324.57600000000002</c:v>
                </c:pt>
                <c:pt idx="89">
                  <c:v>333.846</c:v>
                </c:pt>
                <c:pt idx="90">
                  <c:v>344.04399999999998</c:v>
                </c:pt>
                <c:pt idx="91">
                  <c:v>352.36</c:v>
                </c:pt>
                <c:pt idx="92">
                  <c:v>359.71800000000002</c:v>
                </c:pt>
                <c:pt idx="93">
                  <c:v>367.66899999999998</c:v>
                </c:pt>
                <c:pt idx="94">
                  <c:v>377.33499999999998</c:v>
                </c:pt>
                <c:pt idx="95">
                  <c:v>388.86599999999999</c:v>
                </c:pt>
                <c:pt idx="96">
                  <c:v>401.13099999999997</c:v>
                </c:pt>
                <c:pt idx="97">
                  <c:v>410.64100000000002</c:v>
                </c:pt>
                <c:pt idx="98">
                  <c:v>420.59100000000001</c:v>
                </c:pt>
                <c:pt idx="99">
                  <c:v>430.286</c:v>
                </c:pt>
                <c:pt idx="100">
                  <c:v>437.00400000000002</c:v>
                </c:pt>
                <c:pt idx="101">
                  <c:v>443.971</c:v>
                </c:pt>
                <c:pt idx="102">
                  <c:v>450.82299999999998</c:v>
                </c:pt>
                <c:pt idx="103">
                  <c:v>457.9</c:v>
                </c:pt>
                <c:pt idx="104">
                  <c:v>465.565</c:v>
                </c:pt>
                <c:pt idx="105">
                  <c:v>473.96100000000001</c:v>
                </c:pt>
                <c:pt idx="106">
                  <c:v>485.12599999999998</c:v>
                </c:pt>
                <c:pt idx="107">
                  <c:v>498.75099999999998</c:v>
                </c:pt>
                <c:pt idx="108">
                  <c:v>513.077</c:v>
                </c:pt>
                <c:pt idx="109">
                  <c:v>524.95399999999995</c:v>
                </c:pt>
                <c:pt idx="110">
                  <c:v>533.26599999999996</c:v>
                </c:pt>
                <c:pt idx="111">
                  <c:v>545.98199999999997</c:v>
                </c:pt>
                <c:pt idx="112">
                  <c:v>559.91399999999999</c:v>
                </c:pt>
                <c:pt idx="113">
                  <c:v>569.71199999999999</c:v>
                </c:pt>
                <c:pt idx="114">
                  <c:v>583.22199999999998</c:v>
                </c:pt>
                <c:pt idx="115">
                  <c:v>598.34100000000001</c:v>
                </c:pt>
                <c:pt idx="116">
                  <c:v>611.04600000000005</c:v>
                </c:pt>
                <c:pt idx="117">
                  <c:v>624.45100000000002</c:v>
                </c:pt>
                <c:pt idx="118">
                  <c:v>638.202</c:v>
                </c:pt>
                <c:pt idx="119">
                  <c:v>653.11199999999997</c:v>
                </c:pt>
                <c:pt idx="120">
                  <c:v>670.62900000000002</c:v>
                </c:pt>
                <c:pt idx="121">
                  <c:v>695.97500000000002</c:v>
                </c:pt>
                <c:pt idx="122">
                  <c:v>721.08699999999999</c:v>
                </c:pt>
                <c:pt idx="123">
                  <c:v>744.18</c:v>
                </c:pt>
                <c:pt idx="124">
                  <c:v>772.61500000000001</c:v>
                </c:pt>
                <c:pt idx="125">
                  <c:v>111.398</c:v>
                </c:pt>
                <c:pt idx="126">
                  <c:v>122.568</c:v>
                </c:pt>
                <c:pt idx="127">
                  <c:v>131.74199999999999</c:v>
                </c:pt>
                <c:pt idx="128">
                  <c:v>138.702</c:v>
                </c:pt>
                <c:pt idx="129">
                  <c:v>145.51499999999999</c:v>
                </c:pt>
                <c:pt idx="130">
                  <c:v>152.60499999999999</c:v>
                </c:pt>
                <c:pt idx="131">
                  <c:v>163.09299999999999</c:v>
                </c:pt>
                <c:pt idx="132">
                  <c:v>172.834</c:v>
                </c:pt>
                <c:pt idx="133">
                  <c:v>182.5</c:v>
                </c:pt>
                <c:pt idx="134">
                  <c:v>190.672</c:v>
                </c:pt>
                <c:pt idx="135">
                  <c:v>197.92099999999999</c:v>
                </c:pt>
                <c:pt idx="136">
                  <c:v>205.33699999999999</c:v>
                </c:pt>
                <c:pt idx="137">
                  <c:v>213.24</c:v>
                </c:pt>
                <c:pt idx="138">
                  <c:v>220.97499999999999</c:v>
                </c:pt>
                <c:pt idx="139">
                  <c:v>229.071</c:v>
                </c:pt>
                <c:pt idx="140">
                  <c:v>239.47800000000001</c:v>
                </c:pt>
                <c:pt idx="141">
                  <c:v>249.56800000000001</c:v>
                </c:pt>
                <c:pt idx="142">
                  <c:v>258.31700000000001</c:v>
                </c:pt>
                <c:pt idx="143">
                  <c:v>268.50700000000001</c:v>
                </c:pt>
                <c:pt idx="144">
                  <c:v>278.06400000000002</c:v>
                </c:pt>
                <c:pt idx="145">
                  <c:v>287.62</c:v>
                </c:pt>
                <c:pt idx="146">
                  <c:v>299.65499999999997</c:v>
                </c:pt>
                <c:pt idx="147">
                  <c:v>310.00799999999998</c:v>
                </c:pt>
                <c:pt idx="148">
                  <c:v>319.08699999999999</c:v>
                </c:pt>
                <c:pt idx="149">
                  <c:v>328.35399999999998</c:v>
                </c:pt>
                <c:pt idx="150">
                  <c:v>336.52100000000002</c:v>
                </c:pt>
                <c:pt idx="151">
                  <c:v>342.33699999999999</c:v>
                </c:pt>
                <c:pt idx="152">
                  <c:v>347.63499999999999</c:v>
                </c:pt>
                <c:pt idx="153">
                  <c:v>353.04700000000003</c:v>
                </c:pt>
                <c:pt idx="154">
                  <c:v>358.48399999999998</c:v>
                </c:pt>
                <c:pt idx="155">
                  <c:v>364.37</c:v>
                </c:pt>
                <c:pt idx="156">
                  <c:v>370.08800000000002</c:v>
                </c:pt>
                <c:pt idx="157">
                  <c:v>375.56299999999999</c:v>
                </c:pt>
                <c:pt idx="158">
                  <c:v>384.85599999999999</c:v>
                </c:pt>
                <c:pt idx="159">
                  <c:v>393.90499999999997</c:v>
                </c:pt>
                <c:pt idx="160">
                  <c:v>399.81</c:v>
                </c:pt>
                <c:pt idx="161">
                  <c:v>407.86900000000003</c:v>
                </c:pt>
                <c:pt idx="162">
                  <c:v>416.09399999999999</c:v>
                </c:pt>
                <c:pt idx="163">
                  <c:v>422.99700000000001</c:v>
                </c:pt>
                <c:pt idx="164">
                  <c:v>430.05399999999997</c:v>
                </c:pt>
                <c:pt idx="165">
                  <c:v>437.01799999999997</c:v>
                </c:pt>
                <c:pt idx="166">
                  <c:v>444.60599999999999</c:v>
                </c:pt>
                <c:pt idx="167">
                  <c:v>452.50599999999997</c:v>
                </c:pt>
                <c:pt idx="168">
                  <c:v>460.113</c:v>
                </c:pt>
                <c:pt idx="169">
                  <c:v>467.33300000000003</c:v>
                </c:pt>
                <c:pt idx="170">
                  <c:v>476.10599999999999</c:v>
                </c:pt>
                <c:pt idx="171">
                  <c:v>485.834</c:v>
                </c:pt>
                <c:pt idx="172">
                  <c:v>497.40199999999999</c:v>
                </c:pt>
                <c:pt idx="173">
                  <c:v>510.37700000000001</c:v>
                </c:pt>
                <c:pt idx="174">
                  <c:v>523.94200000000001</c:v>
                </c:pt>
                <c:pt idx="175">
                  <c:v>537.63499999999999</c:v>
                </c:pt>
                <c:pt idx="176">
                  <c:v>551.23</c:v>
                </c:pt>
                <c:pt idx="177">
                  <c:v>565.44200000000001</c:v>
                </c:pt>
                <c:pt idx="178">
                  <c:v>581.03</c:v>
                </c:pt>
                <c:pt idx="179">
                  <c:v>599.84699999999998</c:v>
                </c:pt>
                <c:pt idx="180">
                  <c:v>620.30600000000004</c:v>
                </c:pt>
                <c:pt idx="181">
                  <c:v>636.70600000000002</c:v>
                </c:pt>
                <c:pt idx="182">
                  <c:v>651.21699999999998</c:v>
                </c:pt>
                <c:pt idx="183">
                  <c:v>667.03</c:v>
                </c:pt>
                <c:pt idx="184">
                  <c:v>684.50800000000004</c:v>
                </c:pt>
                <c:pt idx="185">
                  <c:v>704.31399999999996</c:v>
                </c:pt>
                <c:pt idx="186">
                  <c:v>728.60900000000004</c:v>
                </c:pt>
                <c:pt idx="187">
                  <c:v>759.62300000000005</c:v>
                </c:pt>
                <c:pt idx="188">
                  <c:v>788.78499999999997</c:v>
                </c:pt>
              </c:numCache>
            </c:numRef>
          </c:xVal>
          <c:yVal>
            <c:numRef>
              <c:f>'volumes sorted'!$X$2:$X$190</c:f>
              <c:numCache>
                <c:formatCode>General</c:formatCode>
                <c:ptCount val="189"/>
                <c:pt idx="64">
                  <c:v>-968.41599999999994</c:v>
                </c:pt>
                <c:pt idx="65">
                  <c:v>-1163.2559999999999</c:v>
                </c:pt>
                <c:pt idx="66">
                  <c:v>-1134.306</c:v>
                </c:pt>
                <c:pt idx="67">
                  <c:v>-925.43599999999992</c:v>
                </c:pt>
                <c:pt idx="68">
                  <c:v>-1199.106</c:v>
                </c:pt>
                <c:pt idx="69">
                  <c:v>-1321.58</c:v>
                </c:pt>
                <c:pt idx="70">
                  <c:v>-1178.376</c:v>
                </c:pt>
                <c:pt idx="71">
                  <c:v>-1017.6659999999999</c:v>
                </c:pt>
                <c:pt idx="72">
                  <c:v>-978.35599999999999</c:v>
                </c:pt>
                <c:pt idx="73">
                  <c:v>-938.61599999999999</c:v>
                </c:pt>
                <c:pt idx="74">
                  <c:v>-1069.9359999999999</c:v>
                </c:pt>
                <c:pt idx="75">
                  <c:v>-991.096</c:v>
                </c:pt>
                <c:pt idx="76">
                  <c:v>-816.13599999999997</c:v>
                </c:pt>
                <c:pt idx="77">
                  <c:v>-364.26600000000008</c:v>
                </c:pt>
                <c:pt idx="78">
                  <c:v>-685.02600000000007</c:v>
                </c:pt>
                <c:pt idx="79">
                  <c:v>-778.77600000000007</c:v>
                </c:pt>
                <c:pt idx="80">
                  <c:v>-823.05600000000004</c:v>
                </c:pt>
                <c:pt idx="81">
                  <c:v>-467.51600000000008</c:v>
                </c:pt>
                <c:pt idx="82">
                  <c:v>1285.3240000000001</c:v>
                </c:pt>
                <c:pt idx="83">
                  <c:v>-775.096</c:v>
                </c:pt>
                <c:pt idx="84">
                  <c:v>-613.96599999999989</c:v>
                </c:pt>
                <c:pt idx="85">
                  <c:v>630.62400000000025</c:v>
                </c:pt>
                <c:pt idx="86">
                  <c:v>-269.65599999999995</c:v>
                </c:pt>
                <c:pt idx="87">
                  <c:v>-213.28600000000006</c:v>
                </c:pt>
                <c:pt idx="88">
                  <c:v>-731.46599999999989</c:v>
                </c:pt>
                <c:pt idx="89">
                  <c:v>-84.976000000000113</c:v>
                </c:pt>
                <c:pt idx="90">
                  <c:v>-412.21599999999989</c:v>
                </c:pt>
                <c:pt idx="91">
                  <c:v>-676.17599999999993</c:v>
                </c:pt>
                <c:pt idx="92">
                  <c:v>-682.43599999999992</c:v>
                </c:pt>
                <c:pt idx="93">
                  <c:v>-445.26600000000008</c:v>
                </c:pt>
                <c:pt idx="94">
                  <c:v>233.404</c:v>
                </c:pt>
                <c:pt idx="95">
                  <c:v>488.9340000000002</c:v>
                </c:pt>
                <c:pt idx="96">
                  <c:v>433.42399999999998</c:v>
                </c:pt>
                <c:pt idx="97">
                  <c:v>-1083.336</c:v>
                </c:pt>
                <c:pt idx="98">
                  <c:v>725.45400000000018</c:v>
                </c:pt>
                <c:pt idx="99">
                  <c:v>-951.78600000000006</c:v>
                </c:pt>
                <c:pt idx="100">
                  <c:v>-648.30600000000004</c:v>
                </c:pt>
                <c:pt idx="101">
                  <c:v>-836.44599999999991</c:v>
                </c:pt>
                <c:pt idx="102">
                  <c:v>-542.89599999999996</c:v>
                </c:pt>
                <c:pt idx="103">
                  <c:v>-722.82600000000002</c:v>
                </c:pt>
                <c:pt idx="104">
                  <c:v>-177.42599999999993</c:v>
                </c:pt>
                <c:pt idx="105">
                  <c:v>-495.16599999999994</c:v>
                </c:pt>
                <c:pt idx="106">
                  <c:v>1116.4140000000002</c:v>
                </c:pt>
                <c:pt idx="107">
                  <c:v>959.16400000000021</c:v>
                </c:pt>
                <c:pt idx="108">
                  <c:v>984.22400000000016</c:v>
                </c:pt>
                <c:pt idx="109">
                  <c:v>-457.36599999999999</c:v>
                </c:pt>
                <c:pt idx="110">
                  <c:v>-709.65599999999995</c:v>
                </c:pt>
                <c:pt idx="111">
                  <c:v>1768.5140000000001</c:v>
                </c:pt>
                <c:pt idx="112">
                  <c:v>-222.78600000000006</c:v>
                </c:pt>
                <c:pt idx="113">
                  <c:v>-356.92599999999993</c:v>
                </c:pt>
                <c:pt idx="114">
                  <c:v>1786.0139999999997</c:v>
                </c:pt>
                <c:pt idx="115">
                  <c:v>116.11400000000003</c:v>
                </c:pt>
                <c:pt idx="116">
                  <c:v>509.66400000000021</c:v>
                </c:pt>
                <c:pt idx="117">
                  <c:v>1039.7339999999999</c:v>
                </c:pt>
                <c:pt idx="118">
                  <c:v>626.95400000000018</c:v>
                </c:pt>
                <c:pt idx="119">
                  <c:v>1185.7440000000001</c:v>
                </c:pt>
                <c:pt idx="120">
                  <c:v>1828.7840000000001</c:v>
                </c:pt>
                <c:pt idx="121">
                  <c:v>4658.1640000000007</c:v>
                </c:pt>
                <c:pt idx="122">
                  <c:v>1373.884</c:v>
                </c:pt>
                <c:pt idx="123">
                  <c:v>3745.5639999999999</c:v>
                </c:pt>
                <c:pt idx="124">
                  <c:v>3434.303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1F3-427B-BECA-1526803B4E91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volumes sorted'!$S$2:$S$190</c:f>
              <c:numCache>
                <c:formatCode>General</c:formatCode>
                <c:ptCount val="189"/>
                <c:pt idx="0">
                  <c:v>101.995</c:v>
                </c:pt>
                <c:pt idx="1">
                  <c:v>109.54300000000001</c:v>
                </c:pt>
                <c:pt idx="2">
                  <c:v>118.727</c:v>
                </c:pt>
                <c:pt idx="3">
                  <c:v>127.505</c:v>
                </c:pt>
                <c:pt idx="4">
                  <c:v>134.214</c:v>
                </c:pt>
                <c:pt idx="5">
                  <c:v>138.87799999999999</c:v>
                </c:pt>
                <c:pt idx="6">
                  <c:v>145.03100000000001</c:v>
                </c:pt>
                <c:pt idx="7">
                  <c:v>151.03700000000001</c:v>
                </c:pt>
                <c:pt idx="8">
                  <c:v>156.89699999999999</c:v>
                </c:pt>
                <c:pt idx="9">
                  <c:v>162.54499999999999</c:v>
                </c:pt>
                <c:pt idx="10">
                  <c:v>170.167</c:v>
                </c:pt>
                <c:pt idx="11">
                  <c:v>178.66</c:v>
                </c:pt>
                <c:pt idx="12">
                  <c:v>184.631</c:v>
                </c:pt>
                <c:pt idx="13">
                  <c:v>191.51400000000001</c:v>
                </c:pt>
                <c:pt idx="14">
                  <c:v>198.851</c:v>
                </c:pt>
                <c:pt idx="15">
                  <c:v>206.63399999999999</c:v>
                </c:pt>
                <c:pt idx="16">
                  <c:v>214.26599999999999</c:v>
                </c:pt>
                <c:pt idx="17">
                  <c:v>222.64099999999999</c:v>
                </c:pt>
                <c:pt idx="18">
                  <c:v>231.346</c:v>
                </c:pt>
                <c:pt idx="19">
                  <c:v>249.68899999999999</c:v>
                </c:pt>
                <c:pt idx="20">
                  <c:v>258.29500000000002</c:v>
                </c:pt>
                <c:pt idx="21">
                  <c:v>265.327</c:v>
                </c:pt>
                <c:pt idx="22">
                  <c:v>271.85199999999998</c:v>
                </c:pt>
                <c:pt idx="23">
                  <c:v>278.86900000000003</c:v>
                </c:pt>
                <c:pt idx="24">
                  <c:v>286.23099999999999</c:v>
                </c:pt>
                <c:pt idx="25">
                  <c:v>293.38900000000001</c:v>
                </c:pt>
                <c:pt idx="26">
                  <c:v>309.286</c:v>
                </c:pt>
                <c:pt idx="27">
                  <c:v>314.70600000000002</c:v>
                </c:pt>
                <c:pt idx="28">
                  <c:v>321.18400000000003</c:v>
                </c:pt>
                <c:pt idx="29">
                  <c:v>328.19200000000001</c:v>
                </c:pt>
                <c:pt idx="30">
                  <c:v>335.36799999999999</c:v>
                </c:pt>
                <c:pt idx="31">
                  <c:v>343.46100000000001</c:v>
                </c:pt>
                <c:pt idx="32">
                  <c:v>352.42599999999999</c:v>
                </c:pt>
                <c:pt idx="33">
                  <c:v>360.82299999999998</c:v>
                </c:pt>
                <c:pt idx="34">
                  <c:v>369.48</c:v>
                </c:pt>
                <c:pt idx="35">
                  <c:v>379.411</c:v>
                </c:pt>
                <c:pt idx="36">
                  <c:v>388.94900000000001</c:v>
                </c:pt>
                <c:pt idx="37">
                  <c:v>397.26299999999998</c:v>
                </c:pt>
                <c:pt idx="38">
                  <c:v>405.779</c:v>
                </c:pt>
                <c:pt idx="39">
                  <c:v>414.69099999999997</c:v>
                </c:pt>
                <c:pt idx="40">
                  <c:v>424.22399999999999</c:v>
                </c:pt>
                <c:pt idx="41">
                  <c:v>434.92899999999997</c:v>
                </c:pt>
                <c:pt idx="42">
                  <c:v>446.30200000000002</c:v>
                </c:pt>
                <c:pt idx="43">
                  <c:v>455.154</c:v>
                </c:pt>
                <c:pt idx="44">
                  <c:v>462.36799999999999</c:v>
                </c:pt>
                <c:pt idx="45">
                  <c:v>470.57400000000001</c:v>
                </c:pt>
                <c:pt idx="46">
                  <c:v>479.09699999999998</c:v>
                </c:pt>
                <c:pt idx="47">
                  <c:v>488.41399999999999</c:v>
                </c:pt>
                <c:pt idx="48">
                  <c:v>498.68900000000002</c:v>
                </c:pt>
                <c:pt idx="49">
                  <c:v>512.64800000000002</c:v>
                </c:pt>
                <c:pt idx="50">
                  <c:v>526.55100000000004</c:v>
                </c:pt>
                <c:pt idx="51">
                  <c:v>537.47299999999996</c:v>
                </c:pt>
                <c:pt idx="52">
                  <c:v>553.43700000000001</c:v>
                </c:pt>
                <c:pt idx="53">
                  <c:v>568.94000000000005</c:v>
                </c:pt>
                <c:pt idx="54">
                  <c:v>580.68899999999996</c:v>
                </c:pt>
                <c:pt idx="55">
                  <c:v>596.70299999999997</c:v>
                </c:pt>
                <c:pt idx="56">
                  <c:v>612.78200000000004</c:v>
                </c:pt>
                <c:pt idx="57">
                  <c:v>624.96699999999998</c:v>
                </c:pt>
                <c:pt idx="58">
                  <c:v>640.00699999999995</c:v>
                </c:pt>
                <c:pt idx="59">
                  <c:v>661.11699999999996</c:v>
                </c:pt>
                <c:pt idx="60">
                  <c:v>688.45600000000002</c:v>
                </c:pt>
                <c:pt idx="61">
                  <c:v>712.87400000000002</c:v>
                </c:pt>
                <c:pt idx="62">
                  <c:v>732.88599999999997</c:v>
                </c:pt>
                <c:pt idx="63">
                  <c:v>761.00400000000002</c:v>
                </c:pt>
                <c:pt idx="64">
                  <c:v>101.88</c:v>
                </c:pt>
                <c:pt idx="65">
                  <c:v>110.768</c:v>
                </c:pt>
                <c:pt idx="66">
                  <c:v>119.89100000000001</c:v>
                </c:pt>
                <c:pt idx="67">
                  <c:v>130.036</c:v>
                </c:pt>
                <c:pt idx="68">
                  <c:v>140.733</c:v>
                </c:pt>
                <c:pt idx="69">
                  <c:v>147.768</c:v>
                </c:pt>
                <c:pt idx="70">
                  <c:v>154.191</c:v>
                </c:pt>
                <c:pt idx="71">
                  <c:v>160.99799999999999</c:v>
                </c:pt>
                <c:pt idx="72">
                  <c:v>168.21700000000001</c:v>
                </c:pt>
                <c:pt idx="73">
                  <c:v>175.191</c:v>
                </c:pt>
                <c:pt idx="74">
                  <c:v>182.226</c:v>
                </c:pt>
                <c:pt idx="75">
                  <c:v>189.148</c:v>
                </c:pt>
                <c:pt idx="76">
                  <c:v>197.24199999999999</c:v>
                </c:pt>
                <c:pt idx="77">
                  <c:v>206.636</c:v>
                </c:pt>
                <c:pt idx="78">
                  <c:v>216.071</c:v>
                </c:pt>
                <c:pt idx="79">
                  <c:v>224.386</c:v>
                </c:pt>
                <c:pt idx="80">
                  <c:v>232.82</c:v>
                </c:pt>
                <c:pt idx="81">
                  <c:v>241.958</c:v>
                </c:pt>
                <c:pt idx="82">
                  <c:v>256.88499999999999</c:v>
                </c:pt>
                <c:pt idx="83">
                  <c:v>273.517</c:v>
                </c:pt>
                <c:pt idx="84">
                  <c:v>282.97500000000002</c:v>
                </c:pt>
                <c:pt idx="85">
                  <c:v>294.56900000000002</c:v>
                </c:pt>
                <c:pt idx="86">
                  <c:v>306.17599999999999</c:v>
                </c:pt>
                <c:pt idx="87">
                  <c:v>315.75200000000001</c:v>
                </c:pt>
                <c:pt idx="88">
                  <c:v>324.57600000000002</c:v>
                </c:pt>
                <c:pt idx="89">
                  <c:v>333.846</c:v>
                </c:pt>
                <c:pt idx="90">
                  <c:v>344.04399999999998</c:v>
                </c:pt>
                <c:pt idx="91">
                  <c:v>352.36</c:v>
                </c:pt>
                <c:pt idx="92">
                  <c:v>359.71800000000002</c:v>
                </c:pt>
                <c:pt idx="93">
                  <c:v>367.66899999999998</c:v>
                </c:pt>
                <c:pt idx="94">
                  <c:v>377.33499999999998</c:v>
                </c:pt>
                <c:pt idx="95">
                  <c:v>388.86599999999999</c:v>
                </c:pt>
                <c:pt idx="96">
                  <c:v>401.13099999999997</c:v>
                </c:pt>
                <c:pt idx="97">
                  <c:v>410.64100000000002</c:v>
                </c:pt>
                <c:pt idx="98">
                  <c:v>420.59100000000001</c:v>
                </c:pt>
                <c:pt idx="99">
                  <c:v>430.286</c:v>
                </c:pt>
                <c:pt idx="100">
                  <c:v>437.00400000000002</c:v>
                </c:pt>
                <c:pt idx="101">
                  <c:v>443.971</c:v>
                </c:pt>
                <c:pt idx="102">
                  <c:v>450.82299999999998</c:v>
                </c:pt>
                <c:pt idx="103">
                  <c:v>457.9</c:v>
                </c:pt>
                <c:pt idx="104">
                  <c:v>465.565</c:v>
                </c:pt>
                <c:pt idx="105">
                  <c:v>473.96100000000001</c:v>
                </c:pt>
                <c:pt idx="106">
                  <c:v>485.12599999999998</c:v>
                </c:pt>
                <c:pt idx="107">
                  <c:v>498.75099999999998</c:v>
                </c:pt>
                <c:pt idx="108">
                  <c:v>513.077</c:v>
                </c:pt>
                <c:pt idx="109">
                  <c:v>524.95399999999995</c:v>
                </c:pt>
                <c:pt idx="110">
                  <c:v>533.26599999999996</c:v>
                </c:pt>
                <c:pt idx="111">
                  <c:v>545.98199999999997</c:v>
                </c:pt>
                <c:pt idx="112">
                  <c:v>559.91399999999999</c:v>
                </c:pt>
                <c:pt idx="113">
                  <c:v>569.71199999999999</c:v>
                </c:pt>
                <c:pt idx="114">
                  <c:v>583.22199999999998</c:v>
                </c:pt>
                <c:pt idx="115">
                  <c:v>598.34100000000001</c:v>
                </c:pt>
                <c:pt idx="116">
                  <c:v>611.04600000000005</c:v>
                </c:pt>
                <c:pt idx="117">
                  <c:v>624.45100000000002</c:v>
                </c:pt>
                <c:pt idx="118">
                  <c:v>638.202</c:v>
                </c:pt>
                <c:pt idx="119">
                  <c:v>653.11199999999997</c:v>
                </c:pt>
                <c:pt idx="120">
                  <c:v>670.62900000000002</c:v>
                </c:pt>
                <c:pt idx="121">
                  <c:v>695.97500000000002</c:v>
                </c:pt>
                <c:pt idx="122">
                  <c:v>721.08699999999999</c:v>
                </c:pt>
                <c:pt idx="123">
                  <c:v>744.18</c:v>
                </c:pt>
                <c:pt idx="124">
                  <c:v>772.61500000000001</c:v>
                </c:pt>
                <c:pt idx="125">
                  <c:v>111.398</c:v>
                </c:pt>
                <c:pt idx="126">
                  <c:v>122.568</c:v>
                </c:pt>
                <c:pt idx="127">
                  <c:v>131.74199999999999</c:v>
                </c:pt>
                <c:pt idx="128">
                  <c:v>138.702</c:v>
                </c:pt>
                <c:pt idx="129">
                  <c:v>145.51499999999999</c:v>
                </c:pt>
                <c:pt idx="130">
                  <c:v>152.60499999999999</c:v>
                </c:pt>
                <c:pt idx="131">
                  <c:v>163.09299999999999</c:v>
                </c:pt>
                <c:pt idx="132">
                  <c:v>172.834</c:v>
                </c:pt>
                <c:pt idx="133">
                  <c:v>182.5</c:v>
                </c:pt>
                <c:pt idx="134">
                  <c:v>190.672</c:v>
                </c:pt>
                <c:pt idx="135">
                  <c:v>197.92099999999999</c:v>
                </c:pt>
                <c:pt idx="136">
                  <c:v>205.33699999999999</c:v>
                </c:pt>
                <c:pt idx="137">
                  <c:v>213.24</c:v>
                </c:pt>
                <c:pt idx="138">
                  <c:v>220.97499999999999</c:v>
                </c:pt>
                <c:pt idx="139">
                  <c:v>229.071</c:v>
                </c:pt>
                <c:pt idx="140">
                  <c:v>239.47800000000001</c:v>
                </c:pt>
                <c:pt idx="141">
                  <c:v>249.56800000000001</c:v>
                </c:pt>
                <c:pt idx="142">
                  <c:v>258.31700000000001</c:v>
                </c:pt>
                <c:pt idx="143">
                  <c:v>268.50700000000001</c:v>
                </c:pt>
                <c:pt idx="144">
                  <c:v>278.06400000000002</c:v>
                </c:pt>
                <c:pt idx="145">
                  <c:v>287.62</c:v>
                </c:pt>
                <c:pt idx="146">
                  <c:v>299.65499999999997</c:v>
                </c:pt>
                <c:pt idx="147">
                  <c:v>310.00799999999998</c:v>
                </c:pt>
                <c:pt idx="148">
                  <c:v>319.08699999999999</c:v>
                </c:pt>
                <c:pt idx="149">
                  <c:v>328.35399999999998</c:v>
                </c:pt>
                <c:pt idx="150">
                  <c:v>336.52100000000002</c:v>
                </c:pt>
                <c:pt idx="151">
                  <c:v>342.33699999999999</c:v>
                </c:pt>
                <c:pt idx="152">
                  <c:v>347.63499999999999</c:v>
                </c:pt>
                <c:pt idx="153">
                  <c:v>353.04700000000003</c:v>
                </c:pt>
                <c:pt idx="154">
                  <c:v>358.48399999999998</c:v>
                </c:pt>
                <c:pt idx="155">
                  <c:v>364.37</c:v>
                </c:pt>
                <c:pt idx="156">
                  <c:v>370.08800000000002</c:v>
                </c:pt>
                <c:pt idx="157">
                  <c:v>375.56299999999999</c:v>
                </c:pt>
                <c:pt idx="158">
                  <c:v>384.85599999999999</c:v>
                </c:pt>
                <c:pt idx="159">
                  <c:v>393.90499999999997</c:v>
                </c:pt>
                <c:pt idx="160">
                  <c:v>399.81</c:v>
                </c:pt>
                <c:pt idx="161">
                  <c:v>407.86900000000003</c:v>
                </c:pt>
                <c:pt idx="162">
                  <c:v>416.09399999999999</c:v>
                </c:pt>
                <c:pt idx="163">
                  <c:v>422.99700000000001</c:v>
                </c:pt>
                <c:pt idx="164">
                  <c:v>430.05399999999997</c:v>
                </c:pt>
                <c:pt idx="165">
                  <c:v>437.01799999999997</c:v>
                </c:pt>
                <c:pt idx="166">
                  <c:v>444.60599999999999</c:v>
                </c:pt>
                <c:pt idx="167">
                  <c:v>452.50599999999997</c:v>
                </c:pt>
                <c:pt idx="168">
                  <c:v>460.113</c:v>
                </c:pt>
                <c:pt idx="169">
                  <c:v>467.33300000000003</c:v>
                </c:pt>
                <c:pt idx="170">
                  <c:v>476.10599999999999</c:v>
                </c:pt>
                <c:pt idx="171">
                  <c:v>485.834</c:v>
                </c:pt>
                <c:pt idx="172">
                  <c:v>497.40199999999999</c:v>
                </c:pt>
                <c:pt idx="173">
                  <c:v>510.37700000000001</c:v>
                </c:pt>
                <c:pt idx="174">
                  <c:v>523.94200000000001</c:v>
                </c:pt>
                <c:pt idx="175">
                  <c:v>537.63499999999999</c:v>
                </c:pt>
                <c:pt idx="176">
                  <c:v>551.23</c:v>
                </c:pt>
                <c:pt idx="177">
                  <c:v>565.44200000000001</c:v>
                </c:pt>
                <c:pt idx="178">
                  <c:v>581.03</c:v>
                </c:pt>
                <c:pt idx="179">
                  <c:v>599.84699999999998</c:v>
                </c:pt>
                <c:pt idx="180">
                  <c:v>620.30600000000004</c:v>
                </c:pt>
                <c:pt idx="181">
                  <c:v>636.70600000000002</c:v>
                </c:pt>
                <c:pt idx="182">
                  <c:v>651.21699999999998</c:v>
                </c:pt>
                <c:pt idx="183">
                  <c:v>667.03</c:v>
                </c:pt>
                <c:pt idx="184">
                  <c:v>684.50800000000004</c:v>
                </c:pt>
                <c:pt idx="185">
                  <c:v>704.31399999999996</c:v>
                </c:pt>
                <c:pt idx="186">
                  <c:v>728.60900000000004</c:v>
                </c:pt>
                <c:pt idx="187">
                  <c:v>759.62300000000005</c:v>
                </c:pt>
                <c:pt idx="188">
                  <c:v>788.78499999999997</c:v>
                </c:pt>
              </c:numCache>
            </c:numRef>
          </c:xVal>
          <c:yVal>
            <c:numRef>
              <c:f>'volumes sorted'!$Y$2:$Y$190</c:f>
              <c:numCache>
                <c:formatCode>General</c:formatCode>
                <c:ptCount val="189"/>
                <c:pt idx="125">
                  <c:v>-390.22</c:v>
                </c:pt>
                <c:pt idx="126">
                  <c:v>-501.68000000000006</c:v>
                </c:pt>
                <c:pt idx="127">
                  <c:v>-810.34000000000015</c:v>
                </c:pt>
                <c:pt idx="128">
                  <c:v>-860.02000000000021</c:v>
                </c:pt>
                <c:pt idx="129">
                  <c:v>-1057.2280000000001</c:v>
                </c:pt>
                <c:pt idx="130">
                  <c:v>-859.16000000000008</c:v>
                </c:pt>
                <c:pt idx="131">
                  <c:v>-810.56000000000017</c:v>
                </c:pt>
                <c:pt idx="132">
                  <c:v>-923.31000000000017</c:v>
                </c:pt>
                <c:pt idx="133">
                  <c:v>-818.76000000000022</c:v>
                </c:pt>
                <c:pt idx="134">
                  <c:v>-1079.9080000000001</c:v>
                </c:pt>
                <c:pt idx="135">
                  <c:v>-798.8900000000001</c:v>
                </c:pt>
                <c:pt idx="136">
                  <c:v>-670.59000000000015</c:v>
                </c:pt>
                <c:pt idx="137">
                  <c:v>-722</c:v>
                </c:pt>
                <c:pt idx="138">
                  <c:v>-822.44</c:v>
                </c:pt>
                <c:pt idx="139">
                  <c:v>-537.75</c:v>
                </c:pt>
                <c:pt idx="140">
                  <c:v>348.92999999999984</c:v>
                </c:pt>
                <c:pt idx="141">
                  <c:v>-711.2</c:v>
                </c:pt>
                <c:pt idx="142">
                  <c:v>-150.68000000000006</c:v>
                </c:pt>
                <c:pt idx="143">
                  <c:v>343.75</c:v>
                </c:pt>
                <c:pt idx="144">
                  <c:v>-577.92000000000007</c:v>
                </c:pt>
                <c:pt idx="145">
                  <c:v>-400.59000000000015</c:v>
                </c:pt>
                <c:pt idx="146">
                  <c:v>-254.1400000000001</c:v>
                </c:pt>
                <c:pt idx="147">
                  <c:v>-412.68000000000006</c:v>
                </c:pt>
                <c:pt idx="148">
                  <c:v>-481.80000000000018</c:v>
                </c:pt>
                <c:pt idx="149">
                  <c:v>-216.34000000000015</c:v>
                </c:pt>
                <c:pt idx="150">
                  <c:v>-741.22</c:v>
                </c:pt>
                <c:pt idx="151">
                  <c:v>-1013.5960000000001</c:v>
                </c:pt>
                <c:pt idx="152">
                  <c:v>-963.48400000000015</c:v>
                </c:pt>
                <c:pt idx="153">
                  <c:v>-924.82000000000016</c:v>
                </c:pt>
                <c:pt idx="154">
                  <c:v>-864.12000000000012</c:v>
                </c:pt>
                <c:pt idx="155">
                  <c:v>-847.06000000000017</c:v>
                </c:pt>
                <c:pt idx="156">
                  <c:v>-1043.8360000000002</c:v>
                </c:pt>
                <c:pt idx="157">
                  <c:v>-976.66000000000008</c:v>
                </c:pt>
                <c:pt idx="158">
                  <c:v>367.07999999999993</c:v>
                </c:pt>
                <c:pt idx="159">
                  <c:v>-863.69</c:v>
                </c:pt>
                <c:pt idx="160">
                  <c:v>-822.44</c:v>
                </c:pt>
                <c:pt idx="161">
                  <c:v>7</c:v>
                </c:pt>
                <c:pt idx="162">
                  <c:v>-795.65000000000009</c:v>
                </c:pt>
                <c:pt idx="163">
                  <c:v>-580.95000000000005</c:v>
                </c:pt>
                <c:pt idx="164">
                  <c:v>-687</c:v>
                </c:pt>
                <c:pt idx="165">
                  <c:v>-680.31000000000017</c:v>
                </c:pt>
                <c:pt idx="166">
                  <c:v>-461.72</c:v>
                </c:pt>
                <c:pt idx="167">
                  <c:v>-377.69000000000005</c:v>
                </c:pt>
                <c:pt idx="168">
                  <c:v>-653.74</c:v>
                </c:pt>
                <c:pt idx="169">
                  <c:v>-490.66000000000008</c:v>
                </c:pt>
                <c:pt idx="170">
                  <c:v>-95.600000000000136</c:v>
                </c:pt>
                <c:pt idx="171">
                  <c:v>-274.66000000000008</c:v>
                </c:pt>
                <c:pt idx="172">
                  <c:v>175.26999999999998</c:v>
                </c:pt>
                <c:pt idx="173">
                  <c:v>570.98</c:v>
                </c:pt>
                <c:pt idx="174">
                  <c:v>540.96</c:v>
                </c:pt>
                <c:pt idx="175">
                  <c:v>669.69</c:v>
                </c:pt>
                <c:pt idx="176">
                  <c:v>559.52999999999975</c:v>
                </c:pt>
                <c:pt idx="177">
                  <c:v>1112.92</c:v>
                </c:pt>
                <c:pt idx="178">
                  <c:v>1091.9699999999998</c:v>
                </c:pt>
                <c:pt idx="179">
                  <c:v>2109.98</c:v>
                </c:pt>
                <c:pt idx="180">
                  <c:v>2095.5099999999998</c:v>
                </c:pt>
                <c:pt idx="181">
                  <c:v>896.92000000000007</c:v>
                </c:pt>
                <c:pt idx="182">
                  <c:v>1102.1199999999999</c:v>
                </c:pt>
                <c:pt idx="183">
                  <c:v>1362.4</c:v>
                </c:pt>
                <c:pt idx="184">
                  <c:v>1889.0099999999998</c:v>
                </c:pt>
                <c:pt idx="185">
                  <c:v>2111.92</c:v>
                </c:pt>
                <c:pt idx="186">
                  <c:v>3562.58</c:v>
                </c:pt>
                <c:pt idx="187">
                  <c:v>5180.2</c:v>
                </c:pt>
                <c:pt idx="188">
                  <c:v>2928.3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1F3-427B-BECA-1526803B4E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7594024"/>
        <c:axId val="597604848"/>
      </c:scatterChart>
      <c:valAx>
        <c:axId val="597594024"/>
        <c:scaling>
          <c:orientation val="minMax"/>
          <c:max val="1000"/>
        </c:scaling>
        <c:delete val="1"/>
        <c:axPos val="b"/>
        <c:numFmt formatCode="General" sourceLinked="1"/>
        <c:majorTickMark val="none"/>
        <c:minorTickMark val="none"/>
        <c:tickLblPos val="nextTo"/>
        <c:crossAx val="597604848"/>
        <c:crosses val="autoZero"/>
        <c:crossBetween val="midCat"/>
      </c:valAx>
      <c:valAx>
        <c:axId val="597604848"/>
        <c:scaling>
          <c:orientation val="minMax"/>
          <c:max val="10000"/>
        </c:scaling>
        <c:delete val="1"/>
        <c:axPos val="l"/>
        <c:numFmt formatCode="General" sourceLinked="1"/>
        <c:majorTickMark val="none"/>
        <c:minorTickMark val="none"/>
        <c:tickLblPos val="nextTo"/>
        <c:crossAx val="5975940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volume sorted'!$Q$4:$Q$158</c:f>
              <c:numCache>
                <c:formatCode>General</c:formatCode>
                <c:ptCount val="155"/>
                <c:pt idx="0">
                  <c:v>103.259</c:v>
                </c:pt>
                <c:pt idx="1">
                  <c:v>110.813</c:v>
                </c:pt>
                <c:pt idx="2">
                  <c:v>121.79300000000001</c:v>
                </c:pt>
                <c:pt idx="3">
                  <c:v>131.41900000000001</c:v>
                </c:pt>
                <c:pt idx="4">
                  <c:v>137.821</c:v>
                </c:pt>
                <c:pt idx="5">
                  <c:v>147.75800000000001</c:v>
                </c:pt>
                <c:pt idx="6">
                  <c:v>158.916</c:v>
                </c:pt>
                <c:pt idx="7">
                  <c:v>170.37799999999999</c:v>
                </c:pt>
                <c:pt idx="8">
                  <c:v>182.316</c:v>
                </c:pt>
                <c:pt idx="9">
                  <c:v>192.279</c:v>
                </c:pt>
                <c:pt idx="10">
                  <c:v>199.77799999999999</c:v>
                </c:pt>
                <c:pt idx="11">
                  <c:v>207.84299999999999</c:v>
                </c:pt>
                <c:pt idx="12">
                  <c:v>215.536</c:v>
                </c:pt>
                <c:pt idx="13">
                  <c:v>224.809</c:v>
                </c:pt>
                <c:pt idx="14">
                  <c:v>235.91499999999999</c:v>
                </c:pt>
                <c:pt idx="15">
                  <c:v>245.27</c:v>
                </c:pt>
                <c:pt idx="16">
                  <c:v>252.33500000000001</c:v>
                </c:pt>
                <c:pt idx="17">
                  <c:v>259.36900000000003</c:v>
                </c:pt>
                <c:pt idx="18">
                  <c:v>265.56799999999998</c:v>
                </c:pt>
                <c:pt idx="19">
                  <c:v>274.90499999999997</c:v>
                </c:pt>
                <c:pt idx="20">
                  <c:v>286.334</c:v>
                </c:pt>
                <c:pt idx="21">
                  <c:v>295.12400000000002</c:v>
                </c:pt>
                <c:pt idx="22">
                  <c:v>301.04000000000002</c:v>
                </c:pt>
                <c:pt idx="23">
                  <c:v>307.00700000000001</c:v>
                </c:pt>
                <c:pt idx="24">
                  <c:v>313.5</c:v>
                </c:pt>
                <c:pt idx="25">
                  <c:v>322.59800000000001</c:v>
                </c:pt>
                <c:pt idx="26">
                  <c:v>333.613</c:v>
                </c:pt>
                <c:pt idx="27">
                  <c:v>344.53100000000001</c:v>
                </c:pt>
                <c:pt idx="28">
                  <c:v>355.82</c:v>
                </c:pt>
                <c:pt idx="29">
                  <c:v>365.07100000000003</c:v>
                </c:pt>
                <c:pt idx="30">
                  <c:v>371.54399999999998</c:v>
                </c:pt>
                <c:pt idx="31">
                  <c:v>377.85599999999999</c:v>
                </c:pt>
                <c:pt idx="32">
                  <c:v>384.94</c:v>
                </c:pt>
                <c:pt idx="33">
                  <c:v>391.79199999999997</c:v>
                </c:pt>
                <c:pt idx="34">
                  <c:v>398.28</c:v>
                </c:pt>
                <c:pt idx="35">
                  <c:v>404.48700000000002</c:v>
                </c:pt>
                <c:pt idx="36">
                  <c:v>410.654</c:v>
                </c:pt>
                <c:pt idx="37">
                  <c:v>419.65699999999998</c:v>
                </c:pt>
                <c:pt idx="38">
                  <c:v>428.62599999999998</c:v>
                </c:pt>
                <c:pt idx="39">
                  <c:v>435.74299999999999</c:v>
                </c:pt>
                <c:pt idx="40">
                  <c:v>443.005</c:v>
                </c:pt>
                <c:pt idx="41">
                  <c:v>451.5</c:v>
                </c:pt>
                <c:pt idx="42">
                  <c:v>459.02699999999999</c:v>
                </c:pt>
                <c:pt idx="43">
                  <c:v>466.78300000000002</c:v>
                </c:pt>
                <c:pt idx="44">
                  <c:v>476.71199999999999</c:v>
                </c:pt>
                <c:pt idx="45">
                  <c:v>532.94600000000003</c:v>
                </c:pt>
                <c:pt idx="46">
                  <c:v>552.48</c:v>
                </c:pt>
                <c:pt idx="47">
                  <c:v>572.322</c:v>
                </c:pt>
                <c:pt idx="48">
                  <c:v>594.30700000000002</c:v>
                </c:pt>
                <c:pt idx="49">
                  <c:v>614.93600000000004</c:v>
                </c:pt>
                <c:pt idx="50">
                  <c:v>631.52300000000002</c:v>
                </c:pt>
                <c:pt idx="51">
                  <c:v>650.48199999999997</c:v>
                </c:pt>
                <c:pt idx="52">
                  <c:v>671.72699999999998</c:v>
                </c:pt>
                <c:pt idx="53">
                  <c:v>696.06700000000001</c:v>
                </c:pt>
                <c:pt idx="54">
                  <c:v>732.24599999999998</c:v>
                </c:pt>
                <c:pt idx="55">
                  <c:v>781.36400000000003</c:v>
                </c:pt>
                <c:pt idx="56">
                  <c:v>109.858</c:v>
                </c:pt>
                <c:pt idx="57">
                  <c:v>123.541</c:v>
                </c:pt>
                <c:pt idx="58">
                  <c:v>137.09399999999999</c:v>
                </c:pt>
                <c:pt idx="59">
                  <c:v>146.21100000000001</c:v>
                </c:pt>
                <c:pt idx="60">
                  <c:v>155.09899999999999</c:v>
                </c:pt>
                <c:pt idx="61">
                  <c:v>164.804</c:v>
                </c:pt>
                <c:pt idx="62">
                  <c:v>176.52699999999999</c:v>
                </c:pt>
                <c:pt idx="63">
                  <c:v>188.90299999999999</c:v>
                </c:pt>
                <c:pt idx="64">
                  <c:v>198.63200000000001</c:v>
                </c:pt>
                <c:pt idx="65">
                  <c:v>206.18799999999999</c:v>
                </c:pt>
                <c:pt idx="66">
                  <c:v>213.376</c:v>
                </c:pt>
                <c:pt idx="67">
                  <c:v>220.179</c:v>
                </c:pt>
                <c:pt idx="68">
                  <c:v>230.608</c:v>
                </c:pt>
                <c:pt idx="69">
                  <c:v>242.446</c:v>
                </c:pt>
                <c:pt idx="70">
                  <c:v>252.01900000000001</c:v>
                </c:pt>
                <c:pt idx="71">
                  <c:v>259.17</c:v>
                </c:pt>
                <c:pt idx="72">
                  <c:v>266.61</c:v>
                </c:pt>
                <c:pt idx="73">
                  <c:v>274.14299999999997</c:v>
                </c:pt>
                <c:pt idx="74">
                  <c:v>281.59199999999998</c:v>
                </c:pt>
                <c:pt idx="75">
                  <c:v>289.35500000000002</c:v>
                </c:pt>
                <c:pt idx="76">
                  <c:v>297.202</c:v>
                </c:pt>
                <c:pt idx="77">
                  <c:v>304.923</c:v>
                </c:pt>
                <c:pt idx="78">
                  <c:v>313.887</c:v>
                </c:pt>
                <c:pt idx="79">
                  <c:v>323.98500000000001</c:v>
                </c:pt>
                <c:pt idx="80">
                  <c:v>335.47199999999998</c:v>
                </c:pt>
                <c:pt idx="81">
                  <c:v>344.52800000000002</c:v>
                </c:pt>
                <c:pt idx="82">
                  <c:v>350.435</c:v>
                </c:pt>
                <c:pt idx="83">
                  <c:v>358.02600000000001</c:v>
                </c:pt>
                <c:pt idx="84">
                  <c:v>367.68799999999999</c:v>
                </c:pt>
                <c:pt idx="85">
                  <c:v>368.57900000000001</c:v>
                </c:pt>
                <c:pt idx="86">
                  <c:v>379.62099999999998</c:v>
                </c:pt>
                <c:pt idx="87">
                  <c:v>391.05399999999997</c:v>
                </c:pt>
                <c:pt idx="88">
                  <c:v>403.20800000000003</c:v>
                </c:pt>
                <c:pt idx="89">
                  <c:v>414.892</c:v>
                </c:pt>
                <c:pt idx="90">
                  <c:v>425.286</c:v>
                </c:pt>
                <c:pt idx="91">
                  <c:v>435.38600000000002</c:v>
                </c:pt>
                <c:pt idx="92">
                  <c:v>447.06900000000002</c:v>
                </c:pt>
                <c:pt idx="93">
                  <c:v>459.17</c:v>
                </c:pt>
                <c:pt idx="94">
                  <c:v>472.68</c:v>
                </c:pt>
                <c:pt idx="96">
                  <c:v>533.54999999999995</c:v>
                </c:pt>
                <c:pt idx="97">
                  <c:v>551.15</c:v>
                </c:pt>
                <c:pt idx="98">
                  <c:v>571.51499999999999</c:v>
                </c:pt>
                <c:pt idx="99">
                  <c:v>592.59199999999998</c:v>
                </c:pt>
                <c:pt idx="100">
                  <c:v>608.48699999999997</c:v>
                </c:pt>
                <c:pt idx="101">
                  <c:v>625.91600000000005</c:v>
                </c:pt>
                <c:pt idx="102">
                  <c:v>652.375</c:v>
                </c:pt>
                <c:pt idx="103">
                  <c:v>690.77300000000002</c:v>
                </c:pt>
                <c:pt idx="104">
                  <c:v>735.62199999999996</c:v>
                </c:pt>
                <c:pt idx="105">
                  <c:v>784.83900000000006</c:v>
                </c:pt>
                <c:pt idx="106">
                  <c:v>108.012</c:v>
                </c:pt>
                <c:pt idx="107">
                  <c:v>118.593</c:v>
                </c:pt>
                <c:pt idx="108">
                  <c:v>127.34</c:v>
                </c:pt>
                <c:pt idx="109">
                  <c:v>136.309</c:v>
                </c:pt>
                <c:pt idx="110">
                  <c:v>147.00899999999999</c:v>
                </c:pt>
                <c:pt idx="111">
                  <c:v>158.33600000000001</c:v>
                </c:pt>
                <c:pt idx="112">
                  <c:v>169.13300000000001</c:v>
                </c:pt>
                <c:pt idx="113">
                  <c:v>180.267</c:v>
                </c:pt>
                <c:pt idx="114">
                  <c:v>190.85599999999999</c:v>
                </c:pt>
                <c:pt idx="115">
                  <c:v>201.749</c:v>
                </c:pt>
                <c:pt idx="116">
                  <c:v>212.94399999999999</c:v>
                </c:pt>
                <c:pt idx="117">
                  <c:v>223.01900000000001</c:v>
                </c:pt>
                <c:pt idx="118">
                  <c:v>230.04400000000001</c:v>
                </c:pt>
                <c:pt idx="119">
                  <c:v>237.24799999999999</c:v>
                </c:pt>
                <c:pt idx="120">
                  <c:v>245.56700000000001</c:v>
                </c:pt>
                <c:pt idx="121">
                  <c:v>254.74299999999999</c:v>
                </c:pt>
                <c:pt idx="122">
                  <c:v>271.68200000000002</c:v>
                </c:pt>
                <c:pt idx="123">
                  <c:v>280.08300000000003</c:v>
                </c:pt>
                <c:pt idx="124">
                  <c:v>289.17</c:v>
                </c:pt>
                <c:pt idx="125">
                  <c:v>298.03800000000001</c:v>
                </c:pt>
                <c:pt idx="126">
                  <c:v>307.12</c:v>
                </c:pt>
                <c:pt idx="127">
                  <c:v>315.98399999999998</c:v>
                </c:pt>
                <c:pt idx="128">
                  <c:v>328.47800000000001</c:v>
                </c:pt>
                <c:pt idx="129">
                  <c:v>340.01600000000002</c:v>
                </c:pt>
                <c:pt idx="130">
                  <c:v>348.41199999999998</c:v>
                </c:pt>
                <c:pt idx="131">
                  <c:v>358.30500000000001</c:v>
                </c:pt>
                <c:pt idx="132">
                  <c:v>366.85500000000002</c:v>
                </c:pt>
                <c:pt idx="133">
                  <c:v>374.3</c:v>
                </c:pt>
                <c:pt idx="134">
                  <c:v>384.75</c:v>
                </c:pt>
                <c:pt idx="135">
                  <c:v>394.678</c:v>
                </c:pt>
                <c:pt idx="136">
                  <c:v>401.13</c:v>
                </c:pt>
                <c:pt idx="137">
                  <c:v>410.62900000000002</c:v>
                </c:pt>
                <c:pt idx="138">
                  <c:v>420.21600000000001</c:v>
                </c:pt>
                <c:pt idx="139">
                  <c:v>427.54300000000001</c:v>
                </c:pt>
                <c:pt idx="140">
                  <c:v>438.05500000000001</c:v>
                </c:pt>
                <c:pt idx="141">
                  <c:v>448.69799999999998</c:v>
                </c:pt>
                <c:pt idx="142">
                  <c:v>456.49</c:v>
                </c:pt>
                <c:pt idx="143">
                  <c:v>467.13400000000001</c:v>
                </c:pt>
                <c:pt idx="144">
                  <c:v>480.41199999999998</c:v>
                </c:pt>
                <c:pt idx="145">
                  <c:v>524.721</c:v>
                </c:pt>
                <c:pt idx="146">
                  <c:v>548.952</c:v>
                </c:pt>
                <c:pt idx="147">
                  <c:v>574.03499999999997</c:v>
                </c:pt>
                <c:pt idx="148">
                  <c:v>589.39800000000002</c:v>
                </c:pt>
                <c:pt idx="149">
                  <c:v>606.33100000000002</c:v>
                </c:pt>
                <c:pt idx="150">
                  <c:v>626.976</c:v>
                </c:pt>
                <c:pt idx="151">
                  <c:v>668.13199999999995</c:v>
                </c:pt>
                <c:pt idx="152">
                  <c:v>702.38300000000004</c:v>
                </c:pt>
                <c:pt idx="153">
                  <c:v>746.17700000000002</c:v>
                </c:pt>
                <c:pt idx="154">
                  <c:v>794.16200000000003</c:v>
                </c:pt>
              </c:numCache>
            </c:numRef>
          </c:xVal>
          <c:yVal>
            <c:numRef>
              <c:f>'volume sorted'!$V$4:$V$158</c:f>
              <c:numCache>
                <c:formatCode>General</c:formatCode>
                <c:ptCount val="155"/>
                <c:pt idx="0">
                  <c:v>-1560.27</c:v>
                </c:pt>
                <c:pt idx="1">
                  <c:v>-1540.83</c:v>
                </c:pt>
                <c:pt idx="2">
                  <c:v>-207.67999999999984</c:v>
                </c:pt>
                <c:pt idx="3">
                  <c:v>-1603.04</c:v>
                </c:pt>
                <c:pt idx="4">
                  <c:v>-1762.88</c:v>
                </c:pt>
                <c:pt idx="5">
                  <c:v>-591.51000000000022</c:v>
                </c:pt>
                <c:pt idx="6">
                  <c:v>-918.09999999999991</c:v>
                </c:pt>
                <c:pt idx="7">
                  <c:v>-310.05999999999995</c:v>
                </c:pt>
                <c:pt idx="8">
                  <c:v>-353.05000000000018</c:v>
                </c:pt>
                <c:pt idx="9">
                  <c:v>-1630.47</c:v>
                </c:pt>
                <c:pt idx="10">
                  <c:v>-1113.8</c:v>
                </c:pt>
                <c:pt idx="11">
                  <c:v>-1095.01</c:v>
                </c:pt>
                <c:pt idx="12">
                  <c:v>-1300.42</c:v>
                </c:pt>
                <c:pt idx="13">
                  <c:v>-436.21000000000004</c:v>
                </c:pt>
                <c:pt idx="14">
                  <c:v>-241.38000000000011</c:v>
                </c:pt>
                <c:pt idx="15">
                  <c:v>-1325.05</c:v>
                </c:pt>
                <c:pt idx="16">
                  <c:v>-1043.17</c:v>
                </c:pt>
                <c:pt idx="17">
                  <c:v>-1525.93</c:v>
                </c:pt>
                <c:pt idx="18">
                  <c:v>-1547.53</c:v>
                </c:pt>
                <c:pt idx="19">
                  <c:v>-361.90000000000009</c:v>
                </c:pt>
                <c:pt idx="20">
                  <c:v>-383.7199999999998</c:v>
                </c:pt>
                <c:pt idx="21">
                  <c:v>-1500.66</c:v>
                </c:pt>
                <c:pt idx="22">
                  <c:v>-1527.22</c:v>
                </c:pt>
                <c:pt idx="23">
                  <c:v>-1647.75</c:v>
                </c:pt>
                <c:pt idx="24">
                  <c:v>-1196.0999999999999</c:v>
                </c:pt>
                <c:pt idx="25">
                  <c:v>-232.94999999999982</c:v>
                </c:pt>
                <c:pt idx="26">
                  <c:v>217.40999999999985</c:v>
                </c:pt>
                <c:pt idx="27">
                  <c:v>-262.53999999999996</c:v>
                </c:pt>
                <c:pt idx="28">
                  <c:v>193</c:v>
                </c:pt>
                <c:pt idx="29">
                  <c:v>-1464.15</c:v>
                </c:pt>
                <c:pt idx="30">
                  <c:v>-1368.9</c:v>
                </c:pt>
                <c:pt idx="31">
                  <c:v>-1065.2</c:v>
                </c:pt>
                <c:pt idx="32">
                  <c:v>-1147.06</c:v>
                </c:pt>
                <c:pt idx="33">
                  <c:v>-1131.73</c:v>
                </c:pt>
                <c:pt idx="34">
                  <c:v>-1286.3800000000001</c:v>
                </c:pt>
                <c:pt idx="35">
                  <c:v>-1273.21</c:v>
                </c:pt>
                <c:pt idx="36">
                  <c:v>-1268.24</c:v>
                </c:pt>
                <c:pt idx="37">
                  <c:v>313.73999999999978</c:v>
                </c:pt>
                <c:pt idx="38">
                  <c:v>-1146.42</c:v>
                </c:pt>
                <c:pt idx="39">
                  <c:v>-1222.6600000000001</c:v>
                </c:pt>
                <c:pt idx="40">
                  <c:v>-590.86000000000013</c:v>
                </c:pt>
                <c:pt idx="41">
                  <c:v>-871.02</c:v>
                </c:pt>
                <c:pt idx="42">
                  <c:v>-1180.33</c:v>
                </c:pt>
                <c:pt idx="43">
                  <c:v>-977.5</c:v>
                </c:pt>
                <c:pt idx="44">
                  <c:v>-123.44000000000005</c:v>
                </c:pt>
                <c:pt idx="45">
                  <c:v>1881.8999999999996</c:v>
                </c:pt>
                <c:pt idx="46">
                  <c:v>2972.0600000000004</c:v>
                </c:pt>
                <c:pt idx="47">
                  <c:v>2768.37</c:v>
                </c:pt>
                <c:pt idx="48">
                  <c:v>3952.05</c:v>
                </c:pt>
                <c:pt idx="49">
                  <c:v>789.59000000000015</c:v>
                </c:pt>
                <c:pt idx="50">
                  <c:v>2466.1800000000003</c:v>
                </c:pt>
                <c:pt idx="51">
                  <c:v>2226.42</c:v>
                </c:pt>
                <c:pt idx="52">
                  <c:v>3561.3</c:v>
                </c:pt>
                <c:pt idx="53">
                  <c:v>3904.3100000000004</c:v>
                </c:pt>
                <c:pt idx="54">
                  <c:v>10626.2</c:v>
                </c:pt>
                <c:pt idx="55">
                  <c:v>7487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DA4-4F6F-B3CA-4D0C5BB012D5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volume sorted'!$Q$4:$Q$158</c:f>
              <c:numCache>
                <c:formatCode>General</c:formatCode>
                <c:ptCount val="155"/>
                <c:pt idx="0">
                  <c:v>103.259</c:v>
                </c:pt>
                <c:pt idx="1">
                  <c:v>110.813</c:v>
                </c:pt>
                <c:pt idx="2">
                  <c:v>121.79300000000001</c:v>
                </c:pt>
                <c:pt idx="3">
                  <c:v>131.41900000000001</c:v>
                </c:pt>
                <c:pt idx="4">
                  <c:v>137.821</c:v>
                </c:pt>
                <c:pt idx="5">
                  <c:v>147.75800000000001</c:v>
                </c:pt>
                <c:pt idx="6">
                  <c:v>158.916</c:v>
                </c:pt>
                <c:pt idx="7">
                  <c:v>170.37799999999999</c:v>
                </c:pt>
                <c:pt idx="8">
                  <c:v>182.316</c:v>
                </c:pt>
                <c:pt idx="9">
                  <c:v>192.279</c:v>
                </c:pt>
                <c:pt idx="10">
                  <c:v>199.77799999999999</c:v>
                </c:pt>
                <c:pt idx="11">
                  <c:v>207.84299999999999</c:v>
                </c:pt>
                <c:pt idx="12">
                  <c:v>215.536</c:v>
                </c:pt>
                <c:pt idx="13">
                  <c:v>224.809</c:v>
                </c:pt>
                <c:pt idx="14">
                  <c:v>235.91499999999999</c:v>
                </c:pt>
                <c:pt idx="15">
                  <c:v>245.27</c:v>
                </c:pt>
                <c:pt idx="16">
                  <c:v>252.33500000000001</c:v>
                </c:pt>
                <c:pt idx="17">
                  <c:v>259.36900000000003</c:v>
                </c:pt>
                <c:pt idx="18">
                  <c:v>265.56799999999998</c:v>
                </c:pt>
                <c:pt idx="19">
                  <c:v>274.90499999999997</c:v>
                </c:pt>
                <c:pt idx="20">
                  <c:v>286.334</c:v>
                </c:pt>
                <c:pt idx="21">
                  <c:v>295.12400000000002</c:v>
                </c:pt>
                <c:pt idx="22">
                  <c:v>301.04000000000002</c:v>
                </c:pt>
                <c:pt idx="23">
                  <c:v>307.00700000000001</c:v>
                </c:pt>
                <c:pt idx="24">
                  <c:v>313.5</c:v>
                </c:pt>
                <c:pt idx="25">
                  <c:v>322.59800000000001</c:v>
                </c:pt>
                <c:pt idx="26">
                  <c:v>333.613</c:v>
                </c:pt>
                <c:pt idx="27">
                  <c:v>344.53100000000001</c:v>
                </c:pt>
                <c:pt idx="28">
                  <c:v>355.82</c:v>
                </c:pt>
                <c:pt idx="29">
                  <c:v>365.07100000000003</c:v>
                </c:pt>
                <c:pt idx="30">
                  <c:v>371.54399999999998</c:v>
                </c:pt>
                <c:pt idx="31">
                  <c:v>377.85599999999999</c:v>
                </c:pt>
                <c:pt idx="32">
                  <c:v>384.94</c:v>
                </c:pt>
                <c:pt idx="33">
                  <c:v>391.79199999999997</c:v>
                </c:pt>
                <c:pt idx="34">
                  <c:v>398.28</c:v>
                </c:pt>
                <c:pt idx="35">
                  <c:v>404.48700000000002</c:v>
                </c:pt>
                <c:pt idx="36">
                  <c:v>410.654</c:v>
                </c:pt>
                <c:pt idx="37">
                  <c:v>419.65699999999998</c:v>
                </c:pt>
                <c:pt idx="38">
                  <c:v>428.62599999999998</c:v>
                </c:pt>
                <c:pt idx="39">
                  <c:v>435.74299999999999</c:v>
                </c:pt>
                <c:pt idx="40">
                  <c:v>443.005</c:v>
                </c:pt>
                <c:pt idx="41">
                  <c:v>451.5</c:v>
                </c:pt>
                <c:pt idx="42">
                  <c:v>459.02699999999999</c:v>
                </c:pt>
                <c:pt idx="43">
                  <c:v>466.78300000000002</c:v>
                </c:pt>
                <c:pt idx="44">
                  <c:v>476.71199999999999</c:v>
                </c:pt>
                <c:pt idx="45">
                  <c:v>532.94600000000003</c:v>
                </c:pt>
                <c:pt idx="46">
                  <c:v>552.48</c:v>
                </c:pt>
                <c:pt idx="47">
                  <c:v>572.322</c:v>
                </c:pt>
                <c:pt idx="48">
                  <c:v>594.30700000000002</c:v>
                </c:pt>
                <c:pt idx="49">
                  <c:v>614.93600000000004</c:v>
                </c:pt>
                <c:pt idx="50">
                  <c:v>631.52300000000002</c:v>
                </c:pt>
                <c:pt idx="51">
                  <c:v>650.48199999999997</c:v>
                </c:pt>
                <c:pt idx="52">
                  <c:v>671.72699999999998</c:v>
                </c:pt>
                <c:pt idx="53">
                  <c:v>696.06700000000001</c:v>
                </c:pt>
                <c:pt idx="54">
                  <c:v>732.24599999999998</c:v>
                </c:pt>
                <c:pt idx="55">
                  <c:v>781.36400000000003</c:v>
                </c:pt>
                <c:pt idx="56">
                  <c:v>109.858</c:v>
                </c:pt>
                <c:pt idx="57">
                  <c:v>123.541</c:v>
                </c:pt>
                <c:pt idx="58">
                  <c:v>137.09399999999999</c:v>
                </c:pt>
                <c:pt idx="59">
                  <c:v>146.21100000000001</c:v>
                </c:pt>
                <c:pt idx="60">
                  <c:v>155.09899999999999</c:v>
                </c:pt>
                <c:pt idx="61">
                  <c:v>164.804</c:v>
                </c:pt>
                <c:pt idx="62">
                  <c:v>176.52699999999999</c:v>
                </c:pt>
                <c:pt idx="63">
                  <c:v>188.90299999999999</c:v>
                </c:pt>
                <c:pt idx="64">
                  <c:v>198.63200000000001</c:v>
                </c:pt>
                <c:pt idx="65">
                  <c:v>206.18799999999999</c:v>
                </c:pt>
                <c:pt idx="66">
                  <c:v>213.376</c:v>
                </c:pt>
                <c:pt idx="67">
                  <c:v>220.179</c:v>
                </c:pt>
                <c:pt idx="68">
                  <c:v>230.608</c:v>
                </c:pt>
                <c:pt idx="69">
                  <c:v>242.446</c:v>
                </c:pt>
                <c:pt idx="70">
                  <c:v>252.01900000000001</c:v>
                </c:pt>
                <c:pt idx="71">
                  <c:v>259.17</c:v>
                </c:pt>
                <c:pt idx="72">
                  <c:v>266.61</c:v>
                </c:pt>
                <c:pt idx="73">
                  <c:v>274.14299999999997</c:v>
                </c:pt>
                <c:pt idx="74">
                  <c:v>281.59199999999998</c:v>
                </c:pt>
                <c:pt idx="75">
                  <c:v>289.35500000000002</c:v>
                </c:pt>
                <c:pt idx="76">
                  <c:v>297.202</c:v>
                </c:pt>
                <c:pt idx="77">
                  <c:v>304.923</c:v>
                </c:pt>
                <c:pt idx="78">
                  <c:v>313.887</c:v>
                </c:pt>
                <c:pt idx="79">
                  <c:v>323.98500000000001</c:v>
                </c:pt>
                <c:pt idx="80">
                  <c:v>335.47199999999998</c:v>
                </c:pt>
                <c:pt idx="81">
                  <c:v>344.52800000000002</c:v>
                </c:pt>
                <c:pt idx="82">
                  <c:v>350.435</c:v>
                </c:pt>
                <c:pt idx="83">
                  <c:v>358.02600000000001</c:v>
                </c:pt>
                <c:pt idx="84">
                  <c:v>367.68799999999999</c:v>
                </c:pt>
                <c:pt idx="85">
                  <c:v>368.57900000000001</c:v>
                </c:pt>
                <c:pt idx="86">
                  <c:v>379.62099999999998</c:v>
                </c:pt>
                <c:pt idx="87">
                  <c:v>391.05399999999997</c:v>
                </c:pt>
                <c:pt idx="88">
                  <c:v>403.20800000000003</c:v>
                </c:pt>
                <c:pt idx="89">
                  <c:v>414.892</c:v>
                </c:pt>
                <c:pt idx="90">
                  <c:v>425.286</c:v>
                </c:pt>
                <c:pt idx="91">
                  <c:v>435.38600000000002</c:v>
                </c:pt>
                <c:pt idx="92">
                  <c:v>447.06900000000002</c:v>
                </c:pt>
                <c:pt idx="93">
                  <c:v>459.17</c:v>
                </c:pt>
                <c:pt idx="94">
                  <c:v>472.68</c:v>
                </c:pt>
                <c:pt idx="96">
                  <c:v>533.54999999999995</c:v>
                </c:pt>
                <c:pt idx="97">
                  <c:v>551.15</c:v>
                </c:pt>
                <c:pt idx="98">
                  <c:v>571.51499999999999</c:v>
                </c:pt>
                <c:pt idx="99">
                  <c:v>592.59199999999998</c:v>
                </c:pt>
                <c:pt idx="100">
                  <c:v>608.48699999999997</c:v>
                </c:pt>
                <c:pt idx="101">
                  <c:v>625.91600000000005</c:v>
                </c:pt>
                <c:pt idx="102">
                  <c:v>652.375</c:v>
                </c:pt>
                <c:pt idx="103">
                  <c:v>690.77300000000002</c:v>
                </c:pt>
                <c:pt idx="104">
                  <c:v>735.62199999999996</c:v>
                </c:pt>
                <c:pt idx="105">
                  <c:v>784.83900000000006</c:v>
                </c:pt>
                <c:pt idx="106">
                  <c:v>108.012</c:v>
                </c:pt>
                <c:pt idx="107">
                  <c:v>118.593</c:v>
                </c:pt>
                <c:pt idx="108">
                  <c:v>127.34</c:v>
                </c:pt>
                <c:pt idx="109">
                  <c:v>136.309</c:v>
                </c:pt>
                <c:pt idx="110">
                  <c:v>147.00899999999999</c:v>
                </c:pt>
                <c:pt idx="111">
                  <c:v>158.33600000000001</c:v>
                </c:pt>
                <c:pt idx="112">
                  <c:v>169.13300000000001</c:v>
                </c:pt>
                <c:pt idx="113">
                  <c:v>180.267</c:v>
                </c:pt>
                <c:pt idx="114">
                  <c:v>190.85599999999999</c:v>
                </c:pt>
                <c:pt idx="115">
                  <c:v>201.749</c:v>
                </c:pt>
                <c:pt idx="116">
                  <c:v>212.94399999999999</c:v>
                </c:pt>
                <c:pt idx="117">
                  <c:v>223.01900000000001</c:v>
                </c:pt>
                <c:pt idx="118">
                  <c:v>230.04400000000001</c:v>
                </c:pt>
                <c:pt idx="119">
                  <c:v>237.24799999999999</c:v>
                </c:pt>
                <c:pt idx="120">
                  <c:v>245.56700000000001</c:v>
                </c:pt>
                <c:pt idx="121">
                  <c:v>254.74299999999999</c:v>
                </c:pt>
                <c:pt idx="122">
                  <c:v>271.68200000000002</c:v>
                </c:pt>
                <c:pt idx="123">
                  <c:v>280.08300000000003</c:v>
                </c:pt>
                <c:pt idx="124">
                  <c:v>289.17</c:v>
                </c:pt>
                <c:pt idx="125">
                  <c:v>298.03800000000001</c:v>
                </c:pt>
                <c:pt idx="126">
                  <c:v>307.12</c:v>
                </c:pt>
                <c:pt idx="127">
                  <c:v>315.98399999999998</c:v>
                </c:pt>
                <c:pt idx="128">
                  <c:v>328.47800000000001</c:v>
                </c:pt>
                <c:pt idx="129">
                  <c:v>340.01600000000002</c:v>
                </c:pt>
                <c:pt idx="130">
                  <c:v>348.41199999999998</c:v>
                </c:pt>
                <c:pt idx="131">
                  <c:v>358.30500000000001</c:v>
                </c:pt>
                <c:pt idx="132">
                  <c:v>366.85500000000002</c:v>
                </c:pt>
                <c:pt idx="133">
                  <c:v>374.3</c:v>
                </c:pt>
                <c:pt idx="134">
                  <c:v>384.75</c:v>
                </c:pt>
                <c:pt idx="135">
                  <c:v>394.678</c:v>
                </c:pt>
                <c:pt idx="136">
                  <c:v>401.13</c:v>
                </c:pt>
                <c:pt idx="137">
                  <c:v>410.62900000000002</c:v>
                </c:pt>
                <c:pt idx="138">
                  <c:v>420.21600000000001</c:v>
                </c:pt>
                <c:pt idx="139">
                  <c:v>427.54300000000001</c:v>
                </c:pt>
                <c:pt idx="140">
                  <c:v>438.05500000000001</c:v>
                </c:pt>
                <c:pt idx="141">
                  <c:v>448.69799999999998</c:v>
                </c:pt>
                <c:pt idx="142">
                  <c:v>456.49</c:v>
                </c:pt>
                <c:pt idx="143">
                  <c:v>467.13400000000001</c:v>
                </c:pt>
                <c:pt idx="144">
                  <c:v>480.41199999999998</c:v>
                </c:pt>
                <c:pt idx="145">
                  <c:v>524.721</c:v>
                </c:pt>
                <c:pt idx="146">
                  <c:v>548.952</c:v>
                </c:pt>
                <c:pt idx="147">
                  <c:v>574.03499999999997</c:v>
                </c:pt>
                <c:pt idx="148">
                  <c:v>589.39800000000002</c:v>
                </c:pt>
                <c:pt idx="149">
                  <c:v>606.33100000000002</c:v>
                </c:pt>
                <c:pt idx="150">
                  <c:v>626.976</c:v>
                </c:pt>
                <c:pt idx="151">
                  <c:v>668.13199999999995</c:v>
                </c:pt>
                <c:pt idx="152">
                  <c:v>702.38300000000004</c:v>
                </c:pt>
                <c:pt idx="153">
                  <c:v>746.17700000000002</c:v>
                </c:pt>
                <c:pt idx="154">
                  <c:v>794.16200000000003</c:v>
                </c:pt>
              </c:numCache>
            </c:numRef>
          </c:xVal>
          <c:yVal>
            <c:numRef>
              <c:f>'volume sorted'!$W$4:$W$158</c:f>
              <c:numCache>
                <c:formatCode>General</c:formatCode>
                <c:ptCount val="155"/>
                <c:pt idx="56">
                  <c:v>-762.37799999999993</c:v>
                </c:pt>
                <c:pt idx="57">
                  <c:v>-1155.9280000000001</c:v>
                </c:pt>
                <c:pt idx="58">
                  <c:v>-1323.9780000000001</c:v>
                </c:pt>
                <c:pt idx="59">
                  <c:v>-1557.258</c:v>
                </c:pt>
                <c:pt idx="60">
                  <c:v>-1209.7080000000001</c:v>
                </c:pt>
                <c:pt idx="61">
                  <c:v>-1309.068</c:v>
                </c:pt>
                <c:pt idx="62">
                  <c:v>-610.73799999999983</c:v>
                </c:pt>
                <c:pt idx="63">
                  <c:v>-495.61799999999994</c:v>
                </c:pt>
                <c:pt idx="64">
                  <c:v>-1540.1880000000001</c:v>
                </c:pt>
                <c:pt idx="65">
                  <c:v>-1435.2180000000001</c:v>
                </c:pt>
                <c:pt idx="66">
                  <c:v>-1785.1379999999999</c:v>
                </c:pt>
                <c:pt idx="67">
                  <c:v>-1545.588</c:v>
                </c:pt>
                <c:pt idx="68">
                  <c:v>-517.64800000000014</c:v>
                </c:pt>
                <c:pt idx="69">
                  <c:v>-567.53800000000001</c:v>
                </c:pt>
                <c:pt idx="70">
                  <c:v>-1235.848</c:v>
                </c:pt>
                <c:pt idx="71">
                  <c:v>-1485.538</c:v>
                </c:pt>
                <c:pt idx="72">
                  <c:v>-1236.7080000000001</c:v>
                </c:pt>
                <c:pt idx="73">
                  <c:v>-1546.8879999999999</c:v>
                </c:pt>
                <c:pt idx="74">
                  <c:v>-1552.288</c:v>
                </c:pt>
                <c:pt idx="75">
                  <c:v>-1192.8579999999999</c:v>
                </c:pt>
                <c:pt idx="76">
                  <c:v>-1388.9880000000001</c:v>
                </c:pt>
                <c:pt idx="77">
                  <c:v>-1284.018</c:v>
                </c:pt>
                <c:pt idx="78">
                  <c:v>-903.85799999999995</c:v>
                </c:pt>
                <c:pt idx="79">
                  <c:v>-714.20800000000008</c:v>
                </c:pt>
                <c:pt idx="80">
                  <c:v>-426.92799999999988</c:v>
                </c:pt>
                <c:pt idx="81">
                  <c:v>-1789.2380000000001</c:v>
                </c:pt>
                <c:pt idx="82">
                  <c:v>-1834.3820000000001</c:v>
                </c:pt>
                <c:pt idx="83">
                  <c:v>-1261.9780000000001</c:v>
                </c:pt>
                <c:pt idx="84">
                  <c:v>-933.22800000000007</c:v>
                </c:pt>
                <c:pt idx="85">
                  <c:v>-2722.1419999999998</c:v>
                </c:pt>
                <c:pt idx="86">
                  <c:v>-466.88799999999992</c:v>
                </c:pt>
                <c:pt idx="87">
                  <c:v>-485.24800000000005</c:v>
                </c:pt>
                <c:pt idx="88">
                  <c:v>-75.708000000000084</c:v>
                </c:pt>
                <c:pt idx="89">
                  <c:v>-489.13799999999992</c:v>
                </c:pt>
                <c:pt idx="90">
                  <c:v>-923.9380000000001</c:v>
                </c:pt>
                <c:pt idx="91">
                  <c:v>-485.67799999999988</c:v>
                </c:pt>
                <c:pt idx="92">
                  <c:v>-425.62800000000016</c:v>
                </c:pt>
                <c:pt idx="93">
                  <c:v>175.93199999999979</c:v>
                </c:pt>
                <c:pt idx="94">
                  <c:v>172.69200000000001</c:v>
                </c:pt>
                <c:pt idx="96">
                  <c:v>1976.502</c:v>
                </c:pt>
                <c:pt idx="97">
                  <c:v>-221.07799999999997</c:v>
                </c:pt>
                <c:pt idx="98">
                  <c:v>4111.6620000000003</c:v>
                </c:pt>
                <c:pt idx="99">
                  <c:v>139.64199999999983</c:v>
                </c:pt>
                <c:pt idx="100">
                  <c:v>1593.9720000000002</c:v>
                </c:pt>
                <c:pt idx="101">
                  <c:v>1730.0520000000001</c:v>
                </c:pt>
                <c:pt idx="102">
                  <c:v>5730.3719999999994</c:v>
                </c:pt>
                <c:pt idx="103">
                  <c:v>8179.1620000000003</c:v>
                </c:pt>
                <c:pt idx="104">
                  <c:v>6996.1319999999996</c:v>
                </c:pt>
                <c:pt idx="105">
                  <c:v>10092.261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DA4-4F6F-B3CA-4D0C5BB012D5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volume sorted'!$Q$4:$Q$158</c:f>
              <c:numCache>
                <c:formatCode>General</c:formatCode>
                <c:ptCount val="155"/>
                <c:pt idx="0">
                  <c:v>103.259</c:v>
                </c:pt>
                <c:pt idx="1">
                  <c:v>110.813</c:v>
                </c:pt>
                <c:pt idx="2">
                  <c:v>121.79300000000001</c:v>
                </c:pt>
                <c:pt idx="3">
                  <c:v>131.41900000000001</c:v>
                </c:pt>
                <c:pt idx="4">
                  <c:v>137.821</c:v>
                </c:pt>
                <c:pt idx="5">
                  <c:v>147.75800000000001</c:v>
                </c:pt>
                <c:pt idx="6">
                  <c:v>158.916</c:v>
                </c:pt>
                <c:pt idx="7">
                  <c:v>170.37799999999999</c:v>
                </c:pt>
                <c:pt idx="8">
                  <c:v>182.316</c:v>
                </c:pt>
                <c:pt idx="9">
                  <c:v>192.279</c:v>
                </c:pt>
                <c:pt idx="10">
                  <c:v>199.77799999999999</c:v>
                </c:pt>
                <c:pt idx="11">
                  <c:v>207.84299999999999</c:v>
                </c:pt>
                <c:pt idx="12">
                  <c:v>215.536</c:v>
                </c:pt>
                <c:pt idx="13">
                  <c:v>224.809</c:v>
                </c:pt>
                <c:pt idx="14">
                  <c:v>235.91499999999999</c:v>
                </c:pt>
                <c:pt idx="15">
                  <c:v>245.27</c:v>
                </c:pt>
                <c:pt idx="16">
                  <c:v>252.33500000000001</c:v>
                </c:pt>
                <c:pt idx="17">
                  <c:v>259.36900000000003</c:v>
                </c:pt>
                <c:pt idx="18">
                  <c:v>265.56799999999998</c:v>
                </c:pt>
                <c:pt idx="19">
                  <c:v>274.90499999999997</c:v>
                </c:pt>
                <c:pt idx="20">
                  <c:v>286.334</c:v>
                </c:pt>
                <c:pt idx="21">
                  <c:v>295.12400000000002</c:v>
                </c:pt>
                <c:pt idx="22">
                  <c:v>301.04000000000002</c:v>
                </c:pt>
                <c:pt idx="23">
                  <c:v>307.00700000000001</c:v>
                </c:pt>
                <c:pt idx="24">
                  <c:v>313.5</c:v>
                </c:pt>
                <c:pt idx="25">
                  <c:v>322.59800000000001</c:v>
                </c:pt>
                <c:pt idx="26">
                  <c:v>333.613</c:v>
                </c:pt>
                <c:pt idx="27">
                  <c:v>344.53100000000001</c:v>
                </c:pt>
                <c:pt idx="28">
                  <c:v>355.82</c:v>
                </c:pt>
                <c:pt idx="29">
                  <c:v>365.07100000000003</c:v>
                </c:pt>
                <c:pt idx="30">
                  <c:v>371.54399999999998</c:v>
                </c:pt>
                <c:pt idx="31">
                  <c:v>377.85599999999999</c:v>
                </c:pt>
                <c:pt idx="32">
                  <c:v>384.94</c:v>
                </c:pt>
                <c:pt idx="33">
                  <c:v>391.79199999999997</c:v>
                </c:pt>
                <c:pt idx="34">
                  <c:v>398.28</c:v>
                </c:pt>
                <c:pt idx="35">
                  <c:v>404.48700000000002</c:v>
                </c:pt>
                <c:pt idx="36">
                  <c:v>410.654</c:v>
                </c:pt>
                <c:pt idx="37">
                  <c:v>419.65699999999998</c:v>
                </c:pt>
                <c:pt idx="38">
                  <c:v>428.62599999999998</c:v>
                </c:pt>
                <c:pt idx="39">
                  <c:v>435.74299999999999</c:v>
                </c:pt>
                <c:pt idx="40">
                  <c:v>443.005</c:v>
                </c:pt>
                <c:pt idx="41">
                  <c:v>451.5</c:v>
                </c:pt>
                <c:pt idx="42">
                  <c:v>459.02699999999999</c:v>
                </c:pt>
                <c:pt idx="43">
                  <c:v>466.78300000000002</c:v>
                </c:pt>
                <c:pt idx="44">
                  <c:v>476.71199999999999</c:v>
                </c:pt>
                <c:pt idx="45">
                  <c:v>532.94600000000003</c:v>
                </c:pt>
                <c:pt idx="46">
                  <c:v>552.48</c:v>
                </c:pt>
                <c:pt idx="47">
                  <c:v>572.322</c:v>
                </c:pt>
                <c:pt idx="48">
                  <c:v>594.30700000000002</c:v>
                </c:pt>
                <c:pt idx="49">
                  <c:v>614.93600000000004</c:v>
                </c:pt>
                <c:pt idx="50">
                  <c:v>631.52300000000002</c:v>
                </c:pt>
                <c:pt idx="51">
                  <c:v>650.48199999999997</c:v>
                </c:pt>
                <c:pt idx="52">
                  <c:v>671.72699999999998</c:v>
                </c:pt>
                <c:pt idx="53">
                  <c:v>696.06700000000001</c:v>
                </c:pt>
                <c:pt idx="54">
                  <c:v>732.24599999999998</c:v>
                </c:pt>
                <c:pt idx="55">
                  <c:v>781.36400000000003</c:v>
                </c:pt>
                <c:pt idx="56">
                  <c:v>109.858</c:v>
                </c:pt>
                <c:pt idx="57">
                  <c:v>123.541</c:v>
                </c:pt>
                <c:pt idx="58">
                  <c:v>137.09399999999999</c:v>
                </c:pt>
                <c:pt idx="59">
                  <c:v>146.21100000000001</c:v>
                </c:pt>
                <c:pt idx="60">
                  <c:v>155.09899999999999</c:v>
                </c:pt>
                <c:pt idx="61">
                  <c:v>164.804</c:v>
                </c:pt>
                <c:pt idx="62">
                  <c:v>176.52699999999999</c:v>
                </c:pt>
                <c:pt idx="63">
                  <c:v>188.90299999999999</c:v>
                </c:pt>
                <c:pt idx="64">
                  <c:v>198.63200000000001</c:v>
                </c:pt>
                <c:pt idx="65">
                  <c:v>206.18799999999999</c:v>
                </c:pt>
                <c:pt idx="66">
                  <c:v>213.376</c:v>
                </c:pt>
                <c:pt idx="67">
                  <c:v>220.179</c:v>
                </c:pt>
                <c:pt idx="68">
                  <c:v>230.608</c:v>
                </c:pt>
                <c:pt idx="69">
                  <c:v>242.446</c:v>
                </c:pt>
                <c:pt idx="70">
                  <c:v>252.01900000000001</c:v>
                </c:pt>
                <c:pt idx="71">
                  <c:v>259.17</c:v>
                </c:pt>
                <c:pt idx="72">
                  <c:v>266.61</c:v>
                </c:pt>
                <c:pt idx="73">
                  <c:v>274.14299999999997</c:v>
                </c:pt>
                <c:pt idx="74">
                  <c:v>281.59199999999998</c:v>
                </c:pt>
                <c:pt idx="75">
                  <c:v>289.35500000000002</c:v>
                </c:pt>
                <c:pt idx="76">
                  <c:v>297.202</c:v>
                </c:pt>
                <c:pt idx="77">
                  <c:v>304.923</c:v>
                </c:pt>
                <c:pt idx="78">
                  <c:v>313.887</c:v>
                </c:pt>
                <c:pt idx="79">
                  <c:v>323.98500000000001</c:v>
                </c:pt>
                <c:pt idx="80">
                  <c:v>335.47199999999998</c:v>
                </c:pt>
                <c:pt idx="81">
                  <c:v>344.52800000000002</c:v>
                </c:pt>
                <c:pt idx="82">
                  <c:v>350.435</c:v>
                </c:pt>
                <c:pt idx="83">
                  <c:v>358.02600000000001</c:v>
                </c:pt>
                <c:pt idx="84">
                  <c:v>367.68799999999999</c:v>
                </c:pt>
                <c:pt idx="85">
                  <c:v>368.57900000000001</c:v>
                </c:pt>
                <c:pt idx="86">
                  <c:v>379.62099999999998</c:v>
                </c:pt>
                <c:pt idx="87">
                  <c:v>391.05399999999997</c:v>
                </c:pt>
                <c:pt idx="88">
                  <c:v>403.20800000000003</c:v>
                </c:pt>
                <c:pt idx="89">
                  <c:v>414.892</c:v>
                </c:pt>
                <c:pt idx="90">
                  <c:v>425.286</c:v>
                </c:pt>
                <c:pt idx="91">
                  <c:v>435.38600000000002</c:v>
                </c:pt>
                <c:pt idx="92">
                  <c:v>447.06900000000002</c:v>
                </c:pt>
                <c:pt idx="93">
                  <c:v>459.17</c:v>
                </c:pt>
                <c:pt idx="94">
                  <c:v>472.68</c:v>
                </c:pt>
                <c:pt idx="96">
                  <c:v>533.54999999999995</c:v>
                </c:pt>
                <c:pt idx="97">
                  <c:v>551.15</c:v>
                </c:pt>
                <c:pt idx="98">
                  <c:v>571.51499999999999</c:v>
                </c:pt>
                <c:pt idx="99">
                  <c:v>592.59199999999998</c:v>
                </c:pt>
                <c:pt idx="100">
                  <c:v>608.48699999999997</c:v>
                </c:pt>
                <c:pt idx="101">
                  <c:v>625.91600000000005</c:v>
                </c:pt>
                <c:pt idx="102">
                  <c:v>652.375</c:v>
                </c:pt>
                <c:pt idx="103">
                  <c:v>690.77300000000002</c:v>
                </c:pt>
                <c:pt idx="104">
                  <c:v>735.62199999999996</c:v>
                </c:pt>
                <c:pt idx="105">
                  <c:v>784.83900000000006</c:v>
                </c:pt>
                <c:pt idx="106">
                  <c:v>108.012</c:v>
                </c:pt>
                <c:pt idx="107">
                  <c:v>118.593</c:v>
                </c:pt>
                <c:pt idx="108">
                  <c:v>127.34</c:v>
                </c:pt>
                <c:pt idx="109">
                  <c:v>136.309</c:v>
                </c:pt>
                <c:pt idx="110">
                  <c:v>147.00899999999999</c:v>
                </c:pt>
                <c:pt idx="111">
                  <c:v>158.33600000000001</c:v>
                </c:pt>
                <c:pt idx="112">
                  <c:v>169.13300000000001</c:v>
                </c:pt>
                <c:pt idx="113">
                  <c:v>180.267</c:v>
                </c:pt>
                <c:pt idx="114">
                  <c:v>190.85599999999999</c:v>
                </c:pt>
                <c:pt idx="115">
                  <c:v>201.749</c:v>
                </c:pt>
                <c:pt idx="116">
                  <c:v>212.94399999999999</c:v>
                </c:pt>
                <c:pt idx="117">
                  <c:v>223.01900000000001</c:v>
                </c:pt>
                <c:pt idx="118">
                  <c:v>230.04400000000001</c:v>
                </c:pt>
                <c:pt idx="119">
                  <c:v>237.24799999999999</c:v>
                </c:pt>
                <c:pt idx="120">
                  <c:v>245.56700000000001</c:v>
                </c:pt>
                <c:pt idx="121">
                  <c:v>254.74299999999999</c:v>
                </c:pt>
                <c:pt idx="122">
                  <c:v>271.68200000000002</c:v>
                </c:pt>
                <c:pt idx="123">
                  <c:v>280.08300000000003</c:v>
                </c:pt>
                <c:pt idx="124">
                  <c:v>289.17</c:v>
                </c:pt>
                <c:pt idx="125">
                  <c:v>298.03800000000001</c:v>
                </c:pt>
                <c:pt idx="126">
                  <c:v>307.12</c:v>
                </c:pt>
                <c:pt idx="127">
                  <c:v>315.98399999999998</c:v>
                </c:pt>
                <c:pt idx="128">
                  <c:v>328.47800000000001</c:v>
                </c:pt>
                <c:pt idx="129">
                  <c:v>340.01600000000002</c:v>
                </c:pt>
                <c:pt idx="130">
                  <c:v>348.41199999999998</c:v>
                </c:pt>
                <c:pt idx="131">
                  <c:v>358.30500000000001</c:v>
                </c:pt>
                <c:pt idx="132">
                  <c:v>366.85500000000002</c:v>
                </c:pt>
                <c:pt idx="133">
                  <c:v>374.3</c:v>
                </c:pt>
                <c:pt idx="134">
                  <c:v>384.75</c:v>
                </c:pt>
                <c:pt idx="135">
                  <c:v>394.678</c:v>
                </c:pt>
                <c:pt idx="136">
                  <c:v>401.13</c:v>
                </c:pt>
                <c:pt idx="137">
                  <c:v>410.62900000000002</c:v>
                </c:pt>
                <c:pt idx="138">
                  <c:v>420.21600000000001</c:v>
                </c:pt>
                <c:pt idx="139">
                  <c:v>427.54300000000001</c:v>
                </c:pt>
                <c:pt idx="140">
                  <c:v>438.05500000000001</c:v>
                </c:pt>
                <c:pt idx="141">
                  <c:v>448.69799999999998</c:v>
                </c:pt>
                <c:pt idx="142">
                  <c:v>456.49</c:v>
                </c:pt>
                <c:pt idx="143">
                  <c:v>467.13400000000001</c:v>
                </c:pt>
                <c:pt idx="144">
                  <c:v>480.41199999999998</c:v>
                </c:pt>
                <c:pt idx="145">
                  <c:v>524.721</c:v>
                </c:pt>
                <c:pt idx="146">
                  <c:v>548.952</c:v>
                </c:pt>
                <c:pt idx="147">
                  <c:v>574.03499999999997</c:v>
                </c:pt>
                <c:pt idx="148">
                  <c:v>589.39800000000002</c:v>
                </c:pt>
                <c:pt idx="149">
                  <c:v>606.33100000000002</c:v>
                </c:pt>
                <c:pt idx="150">
                  <c:v>626.976</c:v>
                </c:pt>
                <c:pt idx="151">
                  <c:v>668.13199999999995</c:v>
                </c:pt>
                <c:pt idx="152">
                  <c:v>702.38300000000004</c:v>
                </c:pt>
                <c:pt idx="153">
                  <c:v>746.17700000000002</c:v>
                </c:pt>
                <c:pt idx="154">
                  <c:v>794.16200000000003</c:v>
                </c:pt>
              </c:numCache>
            </c:numRef>
          </c:xVal>
          <c:yVal>
            <c:numRef>
              <c:f>'volume sorted'!$X$4:$X$158</c:f>
              <c:numCache>
                <c:formatCode>General</c:formatCode>
                <c:ptCount val="155"/>
                <c:pt idx="106">
                  <c:v>-1293.3419999999999</c:v>
                </c:pt>
                <c:pt idx="107">
                  <c:v>-1474.992</c:v>
                </c:pt>
                <c:pt idx="108">
                  <c:v>-1366.3419999999999</c:v>
                </c:pt>
                <c:pt idx="109">
                  <c:v>-728.71199999999999</c:v>
                </c:pt>
                <c:pt idx="110">
                  <c:v>-902.16199999999981</c:v>
                </c:pt>
                <c:pt idx="111">
                  <c:v>-995.90199999999982</c:v>
                </c:pt>
                <c:pt idx="112">
                  <c:v>-712.94200000000001</c:v>
                </c:pt>
                <c:pt idx="113">
                  <c:v>-703.22199999999975</c:v>
                </c:pt>
                <c:pt idx="114">
                  <c:v>-1066.1019999999999</c:v>
                </c:pt>
                <c:pt idx="115">
                  <c:v>-786.60199999999986</c:v>
                </c:pt>
                <c:pt idx="116">
                  <c:v>-688.32199999999966</c:v>
                </c:pt>
                <c:pt idx="117">
                  <c:v>-1293.7719999999999</c:v>
                </c:pt>
                <c:pt idx="118">
                  <c:v>-1660.972</c:v>
                </c:pt>
                <c:pt idx="119">
                  <c:v>-1515.6019999999999</c:v>
                </c:pt>
                <c:pt idx="120">
                  <c:v>-1432.0119999999999</c:v>
                </c:pt>
                <c:pt idx="121">
                  <c:v>-1690.7819999999999</c:v>
                </c:pt>
                <c:pt idx="122">
                  <c:v>-1533.1019999999999</c:v>
                </c:pt>
                <c:pt idx="123">
                  <c:v>-1513.4419999999998</c:v>
                </c:pt>
                <c:pt idx="124">
                  <c:v>-1215.1419999999998</c:v>
                </c:pt>
                <c:pt idx="125">
                  <c:v>-1299.3819999999998</c:v>
                </c:pt>
                <c:pt idx="126">
                  <c:v>-1235.4519999999998</c:v>
                </c:pt>
                <c:pt idx="127">
                  <c:v>-1347.3419999999999</c:v>
                </c:pt>
                <c:pt idx="128">
                  <c:v>368.77800000000025</c:v>
                </c:pt>
                <c:pt idx="129">
                  <c:v>-1164.3819999999998</c:v>
                </c:pt>
                <c:pt idx="130">
                  <c:v>-1113.8419999999999</c:v>
                </c:pt>
                <c:pt idx="131">
                  <c:v>-542.30199999999968</c:v>
                </c:pt>
                <c:pt idx="132">
                  <c:v>-1394.6419999999998</c:v>
                </c:pt>
                <c:pt idx="133">
                  <c:v>-1248.4119999999998</c:v>
                </c:pt>
                <c:pt idx="134">
                  <c:v>-109.44200000000001</c:v>
                </c:pt>
                <c:pt idx="135">
                  <c:v>-1466.3519999999999</c:v>
                </c:pt>
                <c:pt idx="136">
                  <c:v>-1737.6519999999998</c:v>
                </c:pt>
                <c:pt idx="137">
                  <c:v>-602.14199999999983</c:v>
                </c:pt>
                <c:pt idx="138">
                  <c:v>-1390.1019999999999</c:v>
                </c:pt>
                <c:pt idx="139">
                  <c:v>-1407.8219999999999</c:v>
                </c:pt>
                <c:pt idx="140">
                  <c:v>158.17800000000034</c:v>
                </c:pt>
                <c:pt idx="141">
                  <c:v>-1299.8219999999999</c:v>
                </c:pt>
                <c:pt idx="142">
                  <c:v>-1277.7819999999999</c:v>
                </c:pt>
                <c:pt idx="143">
                  <c:v>75.018000000000029</c:v>
                </c:pt>
                <c:pt idx="144">
                  <c:v>194.6880000000001</c:v>
                </c:pt>
                <c:pt idx="145">
                  <c:v>382.60800000000017</c:v>
                </c:pt>
                <c:pt idx="146">
                  <c:v>6046.9879999999994</c:v>
                </c:pt>
                <c:pt idx="147">
                  <c:v>1378.1479999999997</c:v>
                </c:pt>
                <c:pt idx="148">
                  <c:v>1075.9680000000003</c:v>
                </c:pt>
                <c:pt idx="149">
                  <c:v>1961.7779999999998</c:v>
                </c:pt>
                <c:pt idx="150">
                  <c:v>1979.0580000000004</c:v>
                </c:pt>
                <c:pt idx="151">
                  <c:v>1465.1979999999999</c:v>
                </c:pt>
                <c:pt idx="152">
                  <c:v>8945.7179999999989</c:v>
                </c:pt>
                <c:pt idx="153">
                  <c:v>6300.7880000000005</c:v>
                </c:pt>
                <c:pt idx="154">
                  <c:v>10877.4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DA4-4F6F-B3CA-4D0C5BB012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2725376"/>
        <c:axId val="692723736"/>
      </c:scatterChart>
      <c:valAx>
        <c:axId val="692725376"/>
        <c:scaling>
          <c:orientation val="minMax"/>
          <c:max val="10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92723736"/>
        <c:crossesAt val="0"/>
        <c:crossBetween val="midCat"/>
        <c:majorUnit val="1000"/>
      </c:valAx>
      <c:valAx>
        <c:axId val="692723736"/>
        <c:scaling>
          <c:orientation val="minMax"/>
          <c:max val="10000"/>
          <c:min val="-2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927253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>
                  <a:alpha val="69000"/>
                </a:srgbClr>
              </a:solidFill>
              <a:ln w="9525">
                <a:noFill/>
              </a:ln>
              <a:effectLst/>
            </c:spPr>
          </c:marker>
          <c:yVal>
            <c:numRef>
              <c:f>'full root volumes'!$B$1:$B$15874</c:f>
              <c:numCache>
                <c:formatCode>General</c:formatCode>
                <c:ptCount val="15874"/>
                <c:pt idx="0">
                  <c:v>0</c:v>
                </c:pt>
                <c:pt idx="1">
                  <c:v>622.72799999999995</c:v>
                </c:pt>
                <c:pt idx="3">
                  <c:v>1191.02</c:v>
                </c:pt>
                <c:pt idx="6">
                  <c:v>744.98400000000004</c:v>
                </c:pt>
                <c:pt idx="9">
                  <c:v>526.39200000000005</c:v>
                </c:pt>
                <c:pt idx="13">
                  <c:v>854.28</c:v>
                </c:pt>
                <c:pt idx="16">
                  <c:v>915.84</c:v>
                </c:pt>
                <c:pt idx="17">
                  <c:v>851.68799999999999</c:v>
                </c:pt>
                <c:pt idx="20">
                  <c:v>1189.51</c:v>
                </c:pt>
                <c:pt idx="22">
                  <c:v>1044.58</c:v>
                </c:pt>
                <c:pt idx="23">
                  <c:v>1259.06</c:v>
                </c:pt>
                <c:pt idx="26">
                  <c:v>1434.02</c:v>
                </c:pt>
                <c:pt idx="27">
                  <c:v>1157.33</c:v>
                </c:pt>
                <c:pt idx="30">
                  <c:v>878.904</c:v>
                </c:pt>
                <c:pt idx="31">
                  <c:v>249.26400000000001</c:v>
                </c:pt>
                <c:pt idx="35">
                  <c:v>817.12800000000004</c:v>
                </c:pt>
                <c:pt idx="40">
                  <c:v>1076.1099999999999</c:v>
                </c:pt>
                <c:pt idx="42">
                  <c:v>549.72</c:v>
                </c:pt>
                <c:pt idx="50">
                  <c:v>4186.3</c:v>
                </c:pt>
                <c:pt idx="51">
                  <c:v>678.67200000000003</c:v>
                </c:pt>
                <c:pt idx="52">
                  <c:v>918</c:v>
                </c:pt>
                <c:pt idx="53">
                  <c:v>789.69600000000003</c:v>
                </c:pt>
                <c:pt idx="65">
                  <c:v>921.45600000000002</c:v>
                </c:pt>
                <c:pt idx="66">
                  <c:v>1007.86</c:v>
                </c:pt>
                <c:pt idx="69">
                  <c:v>1075.25</c:v>
                </c:pt>
                <c:pt idx="73">
                  <c:v>1276.99</c:v>
                </c:pt>
                <c:pt idx="75">
                  <c:v>753.84</c:v>
                </c:pt>
                <c:pt idx="76">
                  <c:v>1401.19</c:v>
                </c:pt>
                <c:pt idx="79">
                  <c:v>1608.34</c:v>
                </c:pt>
                <c:pt idx="81">
                  <c:v>1085.18</c:v>
                </c:pt>
                <c:pt idx="85">
                  <c:v>264.38400000000001</c:v>
                </c:pt>
                <c:pt idx="93">
                  <c:v>726.62400000000002</c:v>
                </c:pt>
                <c:pt idx="95">
                  <c:v>1012.82</c:v>
                </c:pt>
                <c:pt idx="100">
                  <c:v>3949.78</c:v>
                </c:pt>
                <c:pt idx="106">
                  <c:v>1251.94</c:v>
                </c:pt>
                <c:pt idx="109">
                  <c:v>935.06399999999996</c:v>
                </c:pt>
                <c:pt idx="111">
                  <c:v>700.05600000000004</c:v>
                </c:pt>
                <c:pt idx="112">
                  <c:v>919.29600000000005</c:v>
                </c:pt>
                <c:pt idx="114">
                  <c:v>843.69600000000003</c:v>
                </c:pt>
                <c:pt idx="115">
                  <c:v>824.68799999999999</c:v>
                </c:pt>
                <c:pt idx="117">
                  <c:v>895.96799999999996</c:v>
                </c:pt>
                <c:pt idx="120">
                  <c:v>1051.92</c:v>
                </c:pt>
                <c:pt idx="121">
                  <c:v>1424.09</c:v>
                </c:pt>
                <c:pt idx="122">
                  <c:v>104.328</c:v>
                </c:pt>
                <c:pt idx="123">
                  <c:v>934.2</c:v>
                </c:pt>
                <c:pt idx="129">
                  <c:v>729.21600000000001</c:v>
                </c:pt>
                <c:pt idx="135">
                  <c:v>482.11200000000002</c:v>
                </c:pt>
                <c:pt idx="141">
                  <c:v>964.65599999999995</c:v>
                </c:pt>
                <c:pt idx="143">
                  <c:v>699.84</c:v>
                </c:pt>
                <c:pt idx="145">
                  <c:v>1454.98</c:v>
                </c:pt>
                <c:pt idx="147">
                  <c:v>366.12</c:v>
                </c:pt>
                <c:pt idx="148">
                  <c:v>1023.62</c:v>
                </c:pt>
                <c:pt idx="150">
                  <c:v>476.49599999999998</c:v>
                </c:pt>
                <c:pt idx="151">
                  <c:v>1406.38</c:v>
                </c:pt>
                <c:pt idx="154">
                  <c:v>1068.98</c:v>
                </c:pt>
                <c:pt idx="155">
                  <c:v>684.28800000000001</c:v>
                </c:pt>
                <c:pt idx="157">
                  <c:v>930.096</c:v>
                </c:pt>
                <c:pt idx="158">
                  <c:v>813.67200000000003</c:v>
                </c:pt>
                <c:pt idx="159">
                  <c:v>231.55199999999999</c:v>
                </c:pt>
                <c:pt idx="163">
                  <c:v>1180.01</c:v>
                </c:pt>
                <c:pt idx="164">
                  <c:v>180.792</c:v>
                </c:pt>
                <c:pt idx="165">
                  <c:v>583.84799999999996</c:v>
                </c:pt>
                <c:pt idx="168">
                  <c:v>870.048</c:v>
                </c:pt>
                <c:pt idx="170">
                  <c:v>1264.9000000000001</c:v>
                </c:pt>
                <c:pt idx="172">
                  <c:v>842.4</c:v>
                </c:pt>
                <c:pt idx="179">
                  <c:v>720.14400000000001</c:v>
                </c:pt>
                <c:pt idx="180">
                  <c:v>1044.1400000000001</c:v>
                </c:pt>
                <c:pt idx="186">
                  <c:v>1064.45</c:v>
                </c:pt>
                <c:pt idx="189">
                  <c:v>732.24</c:v>
                </c:pt>
                <c:pt idx="196">
                  <c:v>294.40800000000002</c:v>
                </c:pt>
                <c:pt idx="197">
                  <c:v>960.98400000000004</c:v>
                </c:pt>
                <c:pt idx="199">
                  <c:v>883.65599999999995</c:v>
                </c:pt>
                <c:pt idx="211">
                  <c:v>782.78399999999999</c:v>
                </c:pt>
                <c:pt idx="214">
                  <c:v>1223.21</c:v>
                </c:pt>
                <c:pt idx="216">
                  <c:v>185.54400000000001</c:v>
                </c:pt>
                <c:pt idx="221">
                  <c:v>923.18399999999997</c:v>
                </c:pt>
                <c:pt idx="224">
                  <c:v>695.952</c:v>
                </c:pt>
                <c:pt idx="225">
                  <c:v>235.87200000000001</c:v>
                </c:pt>
                <c:pt idx="226">
                  <c:v>738.93600000000004</c:v>
                </c:pt>
                <c:pt idx="228">
                  <c:v>712.15200000000004</c:v>
                </c:pt>
                <c:pt idx="231">
                  <c:v>161.56800000000001</c:v>
                </c:pt>
                <c:pt idx="235">
                  <c:v>1195.99</c:v>
                </c:pt>
                <c:pt idx="237">
                  <c:v>1267.92</c:v>
                </c:pt>
                <c:pt idx="240">
                  <c:v>406.512</c:v>
                </c:pt>
                <c:pt idx="242">
                  <c:v>1395.79</c:v>
                </c:pt>
                <c:pt idx="244">
                  <c:v>3502.01</c:v>
                </c:pt>
                <c:pt idx="246">
                  <c:v>1861.92</c:v>
                </c:pt>
                <c:pt idx="248">
                  <c:v>2611.44</c:v>
                </c:pt>
                <c:pt idx="249">
                  <c:v>654.48</c:v>
                </c:pt>
                <c:pt idx="250">
                  <c:v>1310.04</c:v>
                </c:pt>
                <c:pt idx="251">
                  <c:v>749.52</c:v>
                </c:pt>
                <c:pt idx="252">
                  <c:v>1018.44</c:v>
                </c:pt>
                <c:pt idx="254">
                  <c:v>1043.06</c:v>
                </c:pt>
                <c:pt idx="261">
                  <c:v>729.43200000000002</c:v>
                </c:pt>
                <c:pt idx="262">
                  <c:v>1418.26</c:v>
                </c:pt>
                <c:pt idx="265">
                  <c:v>877.60799999999995</c:v>
                </c:pt>
                <c:pt idx="267">
                  <c:v>538.48800000000006</c:v>
                </c:pt>
                <c:pt idx="268">
                  <c:v>615.81600000000003</c:v>
                </c:pt>
                <c:pt idx="269">
                  <c:v>872.20799999999997</c:v>
                </c:pt>
                <c:pt idx="274">
                  <c:v>1036.3699999999999</c:v>
                </c:pt>
                <c:pt idx="278">
                  <c:v>994.68</c:v>
                </c:pt>
                <c:pt idx="279">
                  <c:v>1044.3599999999999</c:v>
                </c:pt>
                <c:pt idx="280">
                  <c:v>449.71199999999999</c:v>
                </c:pt>
                <c:pt idx="282">
                  <c:v>859.03200000000004</c:v>
                </c:pt>
                <c:pt idx="283">
                  <c:v>939.38400000000001</c:v>
                </c:pt>
                <c:pt idx="284">
                  <c:v>1294.27</c:v>
                </c:pt>
                <c:pt idx="287">
                  <c:v>838.94399999999996</c:v>
                </c:pt>
                <c:pt idx="288">
                  <c:v>2218.75</c:v>
                </c:pt>
                <c:pt idx="305">
                  <c:v>781.70399999999995</c:v>
                </c:pt>
                <c:pt idx="307">
                  <c:v>591.84</c:v>
                </c:pt>
                <c:pt idx="311">
                  <c:v>945.64800000000002</c:v>
                </c:pt>
                <c:pt idx="312">
                  <c:v>1212.4100000000001</c:v>
                </c:pt>
                <c:pt idx="315">
                  <c:v>665.28</c:v>
                </c:pt>
                <c:pt idx="317">
                  <c:v>949.32</c:v>
                </c:pt>
                <c:pt idx="320">
                  <c:v>628.99199999999996</c:v>
                </c:pt>
                <c:pt idx="322">
                  <c:v>912.38400000000001</c:v>
                </c:pt>
                <c:pt idx="330">
                  <c:v>540.64800000000002</c:v>
                </c:pt>
                <c:pt idx="331">
                  <c:v>653.18399999999997</c:v>
                </c:pt>
                <c:pt idx="332">
                  <c:v>1026.43</c:v>
                </c:pt>
                <c:pt idx="340">
                  <c:v>989.49599999999998</c:v>
                </c:pt>
                <c:pt idx="343">
                  <c:v>409.32</c:v>
                </c:pt>
                <c:pt idx="345">
                  <c:v>609.33600000000001</c:v>
                </c:pt>
                <c:pt idx="346">
                  <c:v>659.66399999999999</c:v>
                </c:pt>
                <c:pt idx="357">
                  <c:v>790.34400000000005</c:v>
                </c:pt>
                <c:pt idx="360">
                  <c:v>1159.49</c:v>
                </c:pt>
                <c:pt idx="361">
                  <c:v>855.36</c:v>
                </c:pt>
                <c:pt idx="366">
                  <c:v>1903.61</c:v>
                </c:pt>
                <c:pt idx="370">
                  <c:v>713.01599999999996</c:v>
                </c:pt>
                <c:pt idx="375">
                  <c:v>903.74400000000003</c:v>
                </c:pt>
                <c:pt idx="381">
                  <c:v>721.22400000000005</c:v>
                </c:pt>
                <c:pt idx="384">
                  <c:v>992.08799999999997</c:v>
                </c:pt>
                <c:pt idx="386">
                  <c:v>144.93600000000001</c:v>
                </c:pt>
                <c:pt idx="394">
                  <c:v>682.56</c:v>
                </c:pt>
                <c:pt idx="395">
                  <c:v>1388.23</c:v>
                </c:pt>
                <c:pt idx="400">
                  <c:v>888.40800000000002</c:v>
                </c:pt>
                <c:pt idx="405">
                  <c:v>755.35199999999998</c:v>
                </c:pt>
                <c:pt idx="406">
                  <c:v>1188.43</c:v>
                </c:pt>
                <c:pt idx="409">
                  <c:v>979.12800000000004</c:v>
                </c:pt>
                <c:pt idx="410">
                  <c:v>847.36800000000005</c:v>
                </c:pt>
                <c:pt idx="411">
                  <c:v>806.54399999999998</c:v>
                </c:pt>
                <c:pt idx="415">
                  <c:v>933.98400000000004</c:v>
                </c:pt>
                <c:pt idx="417">
                  <c:v>1007.21</c:v>
                </c:pt>
                <c:pt idx="419">
                  <c:v>182.304</c:v>
                </c:pt>
                <c:pt idx="421">
                  <c:v>870.48</c:v>
                </c:pt>
                <c:pt idx="422">
                  <c:v>896.61599999999999</c:v>
                </c:pt>
                <c:pt idx="424">
                  <c:v>918</c:v>
                </c:pt>
                <c:pt idx="428">
                  <c:v>1747.66</c:v>
                </c:pt>
                <c:pt idx="431">
                  <c:v>275.39999999999998</c:v>
                </c:pt>
                <c:pt idx="435">
                  <c:v>509.11200000000002</c:v>
                </c:pt>
                <c:pt idx="437">
                  <c:v>73.007999999999996</c:v>
                </c:pt>
                <c:pt idx="438">
                  <c:v>1087.1300000000001</c:v>
                </c:pt>
                <c:pt idx="439">
                  <c:v>837.21600000000001</c:v>
                </c:pt>
                <c:pt idx="442">
                  <c:v>895.96799999999996</c:v>
                </c:pt>
                <c:pt idx="444">
                  <c:v>994.89599999999996</c:v>
                </c:pt>
                <c:pt idx="446">
                  <c:v>703.08</c:v>
                </c:pt>
                <c:pt idx="448">
                  <c:v>1423.66</c:v>
                </c:pt>
                <c:pt idx="449">
                  <c:v>866.37599999999998</c:v>
                </c:pt>
                <c:pt idx="452">
                  <c:v>1670.54</c:v>
                </c:pt>
                <c:pt idx="453">
                  <c:v>1106.1400000000001</c:v>
                </c:pt>
                <c:pt idx="455">
                  <c:v>841.96799999999996</c:v>
                </c:pt>
                <c:pt idx="458">
                  <c:v>1219.54</c:v>
                </c:pt>
                <c:pt idx="467">
                  <c:v>994.03200000000004</c:v>
                </c:pt>
                <c:pt idx="476">
                  <c:v>1320.62</c:v>
                </c:pt>
                <c:pt idx="478">
                  <c:v>694.65599999999995</c:v>
                </c:pt>
                <c:pt idx="480">
                  <c:v>636.12</c:v>
                </c:pt>
                <c:pt idx="482">
                  <c:v>844.34400000000005</c:v>
                </c:pt>
                <c:pt idx="483">
                  <c:v>1244.3800000000001</c:v>
                </c:pt>
                <c:pt idx="486">
                  <c:v>918.64800000000002</c:v>
                </c:pt>
                <c:pt idx="487">
                  <c:v>1440.07</c:v>
                </c:pt>
                <c:pt idx="494">
                  <c:v>1148.69</c:v>
                </c:pt>
                <c:pt idx="501">
                  <c:v>437.83199999999999</c:v>
                </c:pt>
                <c:pt idx="503">
                  <c:v>195.696</c:v>
                </c:pt>
                <c:pt idx="504">
                  <c:v>521.42399999999998</c:v>
                </c:pt>
                <c:pt idx="510">
                  <c:v>724.24800000000005</c:v>
                </c:pt>
                <c:pt idx="512">
                  <c:v>1079.57</c:v>
                </c:pt>
                <c:pt idx="514">
                  <c:v>1257.98</c:v>
                </c:pt>
                <c:pt idx="518">
                  <c:v>673.05600000000004</c:v>
                </c:pt>
                <c:pt idx="519">
                  <c:v>727.70399999999995</c:v>
                </c:pt>
                <c:pt idx="525">
                  <c:v>995.11199999999997</c:v>
                </c:pt>
                <c:pt idx="528">
                  <c:v>1343.52</c:v>
                </c:pt>
                <c:pt idx="537">
                  <c:v>1372.68</c:v>
                </c:pt>
                <c:pt idx="538">
                  <c:v>290.30399999999997</c:v>
                </c:pt>
                <c:pt idx="539">
                  <c:v>827.28</c:v>
                </c:pt>
                <c:pt idx="544">
                  <c:v>1092.96</c:v>
                </c:pt>
                <c:pt idx="545">
                  <c:v>953.20799999999997</c:v>
                </c:pt>
                <c:pt idx="547">
                  <c:v>1975.97</c:v>
                </c:pt>
                <c:pt idx="549">
                  <c:v>1411.99</c:v>
                </c:pt>
                <c:pt idx="555">
                  <c:v>899.20799999999997</c:v>
                </c:pt>
                <c:pt idx="556">
                  <c:v>729.21600000000001</c:v>
                </c:pt>
                <c:pt idx="557">
                  <c:v>921.67200000000003</c:v>
                </c:pt>
                <c:pt idx="559">
                  <c:v>670.68</c:v>
                </c:pt>
                <c:pt idx="561">
                  <c:v>903.74400000000003</c:v>
                </c:pt>
                <c:pt idx="563">
                  <c:v>1068.3399999999999</c:v>
                </c:pt>
                <c:pt idx="565">
                  <c:v>1030.0999999999999</c:v>
                </c:pt>
                <c:pt idx="566">
                  <c:v>822.096</c:v>
                </c:pt>
                <c:pt idx="568">
                  <c:v>903.52800000000002</c:v>
                </c:pt>
                <c:pt idx="569">
                  <c:v>937.65599999999995</c:v>
                </c:pt>
                <c:pt idx="571">
                  <c:v>662.04</c:v>
                </c:pt>
                <c:pt idx="574">
                  <c:v>973.94399999999996</c:v>
                </c:pt>
                <c:pt idx="578">
                  <c:v>794.01599999999996</c:v>
                </c:pt>
                <c:pt idx="586">
                  <c:v>1273.32</c:v>
                </c:pt>
                <c:pt idx="591">
                  <c:v>936.79200000000003</c:v>
                </c:pt>
                <c:pt idx="595">
                  <c:v>208.22399999999999</c:v>
                </c:pt>
                <c:pt idx="598">
                  <c:v>728.78399999999999</c:v>
                </c:pt>
                <c:pt idx="604">
                  <c:v>363.96</c:v>
                </c:pt>
                <c:pt idx="605">
                  <c:v>218.80799999999999</c:v>
                </c:pt>
                <c:pt idx="606">
                  <c:v>1041.1199999999999</c:v>
                </c:pt>
                <c:pt idx="610">
                  <c:v>1002.24</c:v>
                </c:pt>
                <c:pt idx="613">
                  <c:v>2169.94</c:v>
                </c:pt>
                <c:pt idx="616">
                  <c:v>1293.4100000000001</c:v>
                </c:pt>
                <c:pt idx="618">
                  <c:v>1071.1400000000001</c:v>
                </c:pt>
                <c:pt idx="619">
                  <c:v>1500.55</c:v>
                </c:pt>
                <c:pt idx="622">
                  <c:v>1969.7</c:v>
                </c:pt>
                <c:pt idx="624">
                  <c:v>952.99199999999996</c:v>
                </c:pt>
                <c:pt idx="626">
                  <c:v>206.71199999999999</c:v>
                </c:pt>
                <c:pt idx="630">
                  <c:v>5091.55</c:v>
                </c:pt>
                <c:pt idx="631">
                  <c:v>1577.45</c:v>
                </c:pt>
                <c:pt idx="633">
                  <c:v>746.28</c:v>
                </c:pt>
                <c:pt idx="644">
                  <c:v>754.05600000000004</c:v>
                </c:pt>
                <c:pt idx="645">
                  <c:v>1193.83</c:v>
                </c:pt>
                <c:pt idx="646">
                  <c:v>173.44800000000001</c:v>
                </c:pt>
                <c:pt idx="654">
                  <c:v>636.76800000000003</c:v>
                </c:pt>
                <c:pt idx="662">
                  <c:v>1415.23</c:v>
                </c:pt>
                <c:pt idx="664">
                  <c:v>340.2</c:v>
                </c:pt>
                <c:pt idx="667">
                  <c:v>588.38400000000001</c:v>
                </c:pt>
                <c:pt idx="668">
                  <c:v>647.35199999999998</c:v>
                </c:pt>
                <c:pt idx="670">
                  <c:v>656.64</c:v>
                </c:pt>
                <c:pt idx="671">
                  <c:v>346.68</c:v>
                </c:pt>
                <c:pt idx="672">
                  <c:v>141.26400000000001</c:v>
                </c:pt>
                <c:pt idx="675">
                  <c:v>474.76799999999997</c:v>
                </c:pt>
                <c:pt idx="678">
                  <c:v>1340.28</c:v>
                </c:pt>
                <c:pt idx="688">
                  <c:v>678.45600000000002</c:v>
                </c:pt>
                <c:pt idx="689">
                  <c:v>848.66399999999999</c:v>
                </c:pt>
                <c:pt idx="690">
                  <c:v>63.72</c:v>
                </c:pt>
                <c:pt idx="691">
                  <c:v>573.048</c:v>
                </c:pt>
                <c:pt idx="696">
                  <c:v>678.88800000000003</c:v>
                </c:pt>
                <c:pt idx="698">
                  <c:v>1414.8</c:v>
                </c:pt>
                <c:pt idx="702">
                  <c:v>744.98400000000004</c:v>
                </c:pt>
                <c:pt idx="704">
                  <c:v>785.37599999999998</c:v>
                </c:pt>
                <c:pt idx="707">
                  <c:v>1404.43</c:v>
                </c:pt>
                <c:pt idx="713">
                  <c:v>1142.6400000000001</c:v>
                </c:pt>
                <c:pt idx="718">
                  <c:v>269.13600000000002</c:v>
                </c:pt>
                <c:pt idx="719">
                  <c:v>1033.56</c:v>
                </c:pt>
                <c:pt idx="722">
                  <c:v>866.59199999999998</c:v>
                </c:pt>
                <c:pt idx="728">
                  <c:v>622.08000000000004</c:v>
                </c:pt>
                <c:pt idx="729">
                  <c:v>809.56799999999998</c:v>
                </c:pt>
                <c:pt idx="734">
                  <c:v>1618.06</c:v>
                </c:pt>
                <c:pt idx="736">
                  <c:v>1915.06</c:v>
                </c:pt>
                <c:pt idx="737">
                  <c:v>794.66399999999999</c:v>
                </c:pt>
                <c:pt idx="740">
                  <c:v>963.14400000000001</c:v>
                </c:pt>
                <c:pt idx="742">
                  <c:v>774.14400000000001</c:v>
                </c:pt>
                <c:pt idx="748">
                  <c:v>1138.32</c:v>
                </c:pt>
                <c:pt idx="759">
                  <c:v>1498.82</c:v>
                </c:pt>
                <c:pt idx="760">
                  <c:v>910.00800000000004</c:v>
                </c:pt>
                <c:pt idx="761">
                  <c:v>645.84</c:v>
                </c:pt>
                <c:pt idx="767">
                  <c:v>509.11200000000002</c:v>
                </c:pt>
                <c:pt idx="768">
                  <c:v>994.46400000000006</c:v>
                </c:pt>
                <c:pt idx="770">
                  <c:v>1013.04</c:v>
                </c:pt>
                <c:pt idx="772">
                  <c:v>1589.98</c:v>
                </c:pt>
                <c:pt idx="773">
                  <c:v>1029.02</c:v>
                </c:pt>
                <c:pt idx="775">
                  <c:v>894.24</c:v>
                </c:pt>
                <c:pt idx="779">
                  <c:v>1375.7</c:v>
                </c:pt>
                <c:pt idx="785">
                  <c:v>184.03200000000001</c:v>
                </c:pt>
                <c:pt idx="786">
                  <c:v>195.048</c:v>
                </c:pt>
                <c:pt idx="791">
                  <c:v>1947.02</c:v>
                </c:pt>
                <c:pt idx="792">
                  <c:v>869.4</c:v>
                </c:pt>
                <c:pt idx="795">
                  <c:v>724.03200000000004</c:v>
                </c:pt>
                <c:pt idx="797">
                  <c:v>518.4</c:v>
                </c:pt>
                <c:pt idx="800">
                  <c:v>1196.42</c:v>
                </c:pt>
                <c:pt idx="801">
                  <c:v>692.71199999999999</c:v>
                </c:pt>
                <c:pt idx="804">
                  <c:v>203.256</c:v>
                </c:pt>
                <c:pt idx="805">
                  <c:v>2450.3000000000002</c:v>
                </c:pt>
                <c:pt idx="809">
                  <c:v>1230.77</c:v>
                </c:pt>
                <c:pt idx="810">
                  <c:v>464.4</c:v>
                </c:pt>
                <c:pt idx="812">
                  <c:v>1203.1199999999999</c:v>
                </c:pt>
                <c:pt idx="815">
                  <c:v>1440.07</c:v>
                </c:pt>
                <c:pt idx="818">
                  <c:v>807.84</c:v>
                </c:pt>
                <c:pt idx="819">
                  <c:v>1218.67</c:v>
                </c:pt>
                <c:pt idx="822">
                  <c:v>1032.26</c:v>
                </c:pt>
                <c:pt idx="825">
                  <c:v>391.608</c:v>
                </c:pt>
                <c:pt idx="828">
                  <c:v>1564.49</c:v>
                </c:pt>
                <c:pt idx="830">
                  <c:v>878.04</c:v>
                </c:pt>
                <c:pt idx="835">
                  <c:v>794.66399999999999</c:v>
                </c:pt>
                <c:pt idx="839">
                  <c:v>1988.93</c:v>
                </c:pt>
                <c:pt idx="843">
                  <c:v>145.80000000000001</c:v>
                </c:pt>
                <c:pt idx="845">
                  <c:v>1117.1500000000001</c:v>
                </c:pt>
                <c:pt idx="852">
                  <c:v>1294.06</c:v>
                </c:pt>
                <c:pt idx="853">
                  <c:v>689.04</c:v>
                </c:pt>
                <c:pt idx="870">
                  <c:v>951.26400000000001</c:v>
                </c:pt>
                <c:pt idx="871">
                  <c:v>847.8</c:v>
                </c:pt>
                <c:pt idx="873">
                  <c:v>1274.83</c:v>
                </c:pt>
                <c:pt idx="875">
                  <c:v>1345.46</c:v>
                </c:pt>
                <c:pt idx="889">
                  <c:v>775.65599999999995</c:v>
                </c:pt>
                <c:pt idx="893">
                  <c:v>1199.6600000000001</c:v>
                </c:pt>
                <c:pt idx="900">
                  <c:v>268.92</c:v>
                </c:pt>
                <c:pt idx="902">
                  <c:v>615.81600000000003</c:v>
                </c:pt>
                <c:pt idx="903">
                  <c:v>854.28</c:v>
                </c:pt>
                <c:pt idx="905">
                  <c:v>1307.02</c:v>
                </c:pt>
                <c:pt idx="908">
                  <c:v>1180.01</c:v>
                </c:pt>
                <c:pt idx="911">
                  <c:v>6818.9</c:v>
                </c:pt>
                <c:pt idx="912">
                  <c:v>925.56</c:v>
                </c:pt>
                <c:pt idx="915">
                  <c:v>585.79200000000003</c:v>
                </c:pt>
                <c:pt idx="917">
                  <c:v>631.58399999999995</c:v>
                </c:pt>
                <c:pt idx="920">
                  <c:v>793.36800000000005</c:v>
                </c:pt>
                <c:pt idx="922">
                  <c:v>777.38400000000001</c:v>
                </c:pt>
                <c:pt idx="929">
                  <c:v>885.6</c:v>
                </c:pt>
                <c:pt idx="931">
                  <c:v>1288.44</c:v>
                </c:pt>
                <c:pt idx="934">
                  <c:v>625.53599999999994</c:v>
                </c:pt>
                <c:pt idx="935">
                  <c:v>847.36800000000005</c:v>
                </c:pt>
                <c:pt idx="953">
                  <c:v>1060.56</c:v>
                </c:pt>
                <c:pt idx="954">
                  <c:v>1164.46</c:v>
                </c:pt>
                <c:pt idx="957">
                  <c:v>496.36799999999999</c:v>
                </c:pt>
                <c:pt idx="958">
                  <c:v>1207.6600000000001</c:v>
                </c:pt>
                <c:pt idx="959">
                  <c:v>867.45600000000002</c:v>
                </c:pt>
                <c:pt idx="960">
                  <c:v>635.04</c:v>
                </c:pt>
                <c:pt idx="961">
                  <c:v>985.82399999999996</c:v>
                </c:pt>
                <c:pt idx="964">
                  <c:v>928.58399999999995</c:v>
                </c:pt>
                <c:pt idx="965">
                  <c:v>937.65599999999995</c:v>
                </c:pt>
                <c:pt idx="976">
                  <c:v>1895.62</c:v>
                </c:pt>
                <c:pt idx="978">
                  <c:v>1041.1199999999999</c:v>
                </c:pt>
                <c:pt idx="979">
                  <c:v>1031.18</c:v>
                </c:pt>
                <c:pt idx="980">
                  <c:v>205.63200000000001</c:v>
                </c:pt>
                <c:pt idx="984">
                  <c:v>879.98400000000004</c:v>
                </c:pt>
                <c:pt idx="987">
                  <c:v>189.864</c:v>
                </c:pt>
                <c:pt idx="991">
                  <c:v>724.46400000000006</c:v>
                </c:pt>
                <c:pt idx="992">
                  <c:v>1574.64</c:v>
                </c:pt>
                <c:pt idx="993">
                  <c:v>1117.8</c:v>
                </c:pt>
                <c:pt idx="996">
                  <c:v>800.49599999999998</c:v>
                </c:pt>
                <c:pt idx="997">
                  <c:v>1372.9</c:v>
                </c:pt>
                <c:pt idx="1001">
                  <c:v>1228.3900000000001</c:v>
                </c:pt>
                <c:pt idx="1003">
                  <c:v>1332.29</c:v>
                </c:pt>
                <c:pt idx="1004">
                  <c:v>193.96799999999999</c:v>
                </c:pt>
                <c:pt idx="1006">
                  <c:v>1289.0899999999999</c:v>
                </c:pt>
                <c:pt idx="1011">
                  <c:v>1330.99</c:v>
                </c:pt>
                <c:pt idx="1016">
                  <c:v>841.75199999999995</c:v>
                </c:pt>
                <c:pt idx="1017">
                  <c:v>1087.1300000000001</c:v>
                </c:pt>
                <c:pt idx="1021">
                  <c:v>294.40800000000002</c:v>
                </c:pt>
                <c:pt idx="1023">
                  <c:v>2028.46</c:v>
                </c:pt>
                <c:pt idx="1027">
                  <c:v>1407.02</c:v>
                </c:pt>
                <c:pt idx="1030">
                  <c:v>1833.62</c:v>
                </c:pt>
                <c:pt idx="1032">
                  <c:v>588.16800000000001</c:v>
                </c:pt>
                <c:pt idx="1037">
                  <c:v>1498.82</c:v>
                </c:pt>
                <c:pt idx="1038">
                  <c:v>475.63200000000001</c:v>
                </c:pt>
                <c:pt idx="1040">
                  <c:v>797.904</c:v>
                </c:pt>
                <c:pt idx="1044">
                  <c:v>1293.19</c:v>
                </c:pt>
                <c:pt idx="1049">
                  <c:v>1096.6300000000001</c:v>
                </c:pt>
                <c:pt idx="1054">
                  <c:v>1141.99</c:v>
                </c:pt>
                <c:pt idx="1057">
                  <c:v>509.54399999999998</c:v>
                </c:pt>
                <c:pt idx="1061">
                  <c:v>990.79200000000003</c:v>
                </c:pt>
                <c:pt idx="1066">
                  <c:v>1147.18</c:v>
                </c:pt>
                <c:pt idx="1071">
                  <c:v>1031.6199999999999</c:v>
                </c:pt>
                <c:pt idx="1072">
                  <c:v>777.16800000000001</c:v>
                </c:pt>
                <c:pt idx="1073">
                  <c:v>825.33600000000001</c:v>
                </c:pt>
                <c:pt idx="1074">
                  <c:v>1046.0899999999999</c:v>
                </c:pt>
                <c:pt idx="1080">
                  <c:v>709.99199999999996</c:v>
                </c:pt>
                <c:pt idx="1083">
                  <c:v>304.99200000000002</c:v>
                </c:pt>
                <c:pt idx="1084">
                  <c:v>749.30399999999997</c:v>
                </c:pt>
                <c:pt idx="1092">
                  <c:v>1510.49</c:v>
                </c:pt>
                <c:pt idx="1095">
                  <c:v>779.976</c:v>
                </c:pt>
                <c:pt idx="1105">
                  <c:v>102.384</c:v>
                </c:pt>
                <c:pt idx="1106">
                  <c:v>1065.0999999999999</c:v>
                </c:pt>
                <c:pt idx="1109">
                  <c:v>1665.79</c:v>
                </c:pt>
                <c:pt idx="1113">
                  <c:v>1314.36</c:v>
                </c:pt>
                <c:pt idx="1114">
                  <c:v>849.096</c:v>
                </c:pt>
                <c:pt idx="1118">
                  <c:v>478.22399999999999</c:v>
                </c:pt>
                <c:pt idx="1120">
                  <c:v>1164.67</c:v>
                </c:pt>
                <c:pt idx="1121">
                  <c:v>689.04</c:v>
                </c:pt>
                <c:pt idx="1122">
                  <c:v>2292.41</c:v>
                </c:pt>
                <c:pt idx="1123">
                  <c:v>986.47199999999998</c:v>
                </c:pt>
                <c:pt idx="1128">
                  <c:v>1023.41</c:v>
                </c:pt>
                <c:pt idx="1130">
                  <c:v>975.024</c:v>
                </c:pt>
                <c:pt idx="1132">
                  <c:v>608.904</c:v>
                </c:pt>
                <c:pt idx="1133">
                  <c:v>1056.46</c:v>
                </c:pt>
                <c:pt idx="1138">
                  <c:v>92.231999999999999</c:v>
                </c:pt>
                <c:pt idx="1146">
                  <c:v>3282.98</c:v>
                </c:pt>
                <c:pt idx="1147">
                  <c:v>739.36800000000005</c:v>
                </c:pt>
                <c:pt idx="1151">
                  <c:v>990.36</c:v>
                </c:pt>
                <c:pt idx="1153">
                  <c:v>1331.86</c:v>
                </c:pt>
                <c:pt idx="1157">
                  <c:v>877.39200000000005</c:v>
                </c:pt>
                <c:pt idx="1161">
                  <c:v>886.89599999999996</c:v>
                </c:pt>
                <c:pt idx="1165">
                  <c:v>789.69600000000003</c:v>
                </c:pt>
                <c:pt idx="1166">
                  <c:v>1110.67</c:v>
                </c:pt>
                <c:pt idx="1169">
                  <c:v>576.50400000000002</c:v>
                </c:pt>
                <c:pt idx="1170">
                  <c:v>232.84800000000001</c:v>
                </c:pt>
                <c:pt idx="1172">
                  <c:v>974.37599999999998</c:v>
                </c:pt>
                <c:pt idx="1174">
                  <c:v>1085.4000000000001</c:v>
                </c:pt>
                <c:pt idx="1178">
                  <c:v>1033.3399999999999</c:v>
                </c:pt>
                <c:pt idx="1183">
                  <c:v>783.43200000000002</c:v>
                </c:pt>
                <c:pt idx="1191">
                  <c:v>717.12</c:v>
                </c:pt>
                <c:pt idx="1198">
                  <c:v>2226.7399999999998</c:v>
                </c:pt>
                <c:pt idx="1199">
                  <c:v>299.59199999999998</c:v>
                </c:pt>
                <c:pt idx="1200">
                  <c:v>157.03200000000001</c:v>
                </c:pt>
                <c:pt idx="1201">
                  <c:v>1145.23</c:v>
                </c:pt>
                <c:pt idx="1203">
                  <c:v>535.46400000000006</c:v>
                </c:pt>
                <c:pt idx="1207">
                  <c:v>1281.53</c:v>
                </c:pt>
                <c:pt idx="1216">
                  <c:v>721.65599999999995</c:v>
                </c:pt>
                <c:pt idx="1219">
                  <c:v>1107.43</c:v>
                </c:pt>
                <c:pt idx="1221">
                  <c:v>944.13599999999997</c:v>
                </c:pt>
                <c:pt idx="1223">
                  <c:v>749.52</c:v>
                </c:pt>
                <c:pt idx="1224">
                  <c:v>813.24</c:v>
                </c:pt>
                <c:pt idx="1230">
                  <c:v>1242.43</c:v>
                </c:pt>
                <c:pt idx="1231">
                  <c:v>1010.45</c:v>
                </c:pt>
                <c:pt idx="1235">
                  <c:v>1186.7</c:v>
                </c:pt>
                <c:pt idx="1236">
                  <c:v>906.33600000000001</c:v>
                </c:pt>
                <c:pt idx="1237">
                  <c:v>923.61599999999999</c:v>
                </c:pt>
                <c:pt idx="1238">
                  <c:v>931.82399999999996</c:v>
                </c:pt>
                <c:pt idx="1239">
                  <c:v>897.69600000000003</c:v>
                </c:pt>
                <c:pt idx="1247">
                  <c:v>439.34399999999999</c:v>
                </c:pt>
                <c:pt idx="1250">
                  <c:v>861.84</c:v>
                </c:pt>
                <c:pt idx="1253">
                  <c:v>883.22400000000005</c:v>
                </c:pt>
                <c:pt idx="1262">
                  <c:v>708.48</c:v>
                </c:pt>
                <c:pt idx="1268">
                  <c:v>217.29599999999999</c:v>
                </c:pt>
                <c:pt idx="1269">
                  <c:v>563.54399999999998</c:v>
                </c:pt>
                <c:pt idx="1271">
                  <c:v>755.78399999999999</c:v>
                </c:pt>
                <c:pt idx="1276">
                  <c:v>797.904</c:v>
                </c:pt>
                <c:pt idx="1277">
                  <c:v>1025.78</c:v>
                </c:pt>
                <c:pt idx="1280">
                  <c:v>1115.8599999999999</c:v>
                </c:pt>
                <c:pt idx="1285">
                  <c:v>552.74400000000003</c:v>
                </c:pt>
                <c:pt idx="1287">
                  <c:v>1276.3399999999999</c:v>
                </c:pt>
                <c:pt idx="1288">
                  <c:v>1095.3399999999999</c:v>
                </c:pt>
                <c:pt idx="1289">
                  <c:v>1313.28</c:v>
                </c:pt>
                <c:pt idx="1291">
                  <c:v>1380.02</c:v>
                </c:pt>
                <c:pt idx="1292">
                  <c:v>1075.46</c:v>
                </c:pt>
                <c:pt idx="1295">
                  <c:v>998.35199999999998</c:v>
                </c:pt>
                <c:pt idx="1297">
                  <c:v>871.12800000000004</c:v>
                </c:pt>
                <c:pt idx="1300">
                  <c:v>804.16800000000001</c:v>
                </c:pt>
                <c:pt idx="1303">
                  <c:v>1029.67</c:v>
                </c:pt>
                <c:pt idx="1310">
                  <c:v>1043.06</c:v>
                </c:pt>
                <c:pt idx="1311">
                  <c:v>1972.94</c:v>
                </c:pt>
                <c:pt idx="1312">
                  <c:v>722.30399999999997</c:v>
                </c:pt>
                <c:pt idx="1313">
                  <c:v>627.69600000000003</c:v>
                </c:pt>
                <c:pt idx="1316">
                  <c:v>806.976</c:v>
                </c:pt>
                <c:pt idx="1322">
                  <c:v>637.20000000000005</c:v>
                </c:pt>
                <c:pt idx="1325">
                  <c:v>1268.1400000000001</c:v>
                </c:pt>
                <c:pt idx="1326">
                  <c:v>3029.83</c:v>
                </c:pt>
                <c:pt idx="1332">
                  <c:v>523.58399999999995</c:v>
                </c:pt>
                <c:pt idx="1336">
                  <c:v>1067.04</c:v>
                </c:pt>
                <c:pt idx="1337">
                  <c:v>624.45600000000002</c:v>
                </c:pt>
                <c:pt idx="1340">
                  <c:v>1935.14</c:v>
                </c:pt>
                <c:pt idx="1342">
                  <c:v>656.85599999999999</c:v>
                </c:pt>
                <c:pt idx="1349">
                  <c:v>2085.0500000000002</c:v>
                </c:pt>
                <c:pt idx="1351">
                  <c:v>201.31200000000001</c:v>
                </c:pt>
                <c:pt idx="1356">
                  <c:v>1755</c:v>
                </c:pt>
                <c:pt idx="1360">
                  <c:v>964.00800000000004</c:v>
                </c:pt>
                <c:pt idx="1364">
                  <c:v>893.37599999999998</c:v>
                </c:pt>
                <c:pt idx="1365">
                  <c:v>1172.23</c:v>
                </c:pt>
                <c:pt idx="1369">
                  <c:v>781.92</c:v>
                </c:pt>
                <c:pt idx="1372">
                  <c:v>792.72</c:v>
                </c:pt>
                <c:pt idx="1373">
                  <c:v>1616.76</c:v>
                </c:pt>
                <c:pt idx="1374">
                  <c:v>904.17600000000004</c:v>
                </c:pt>
                <c:pt idx="1378">
                  <c:v>508.03199999999998</c:v>
                </c:pt>
                <c:pt idx="1384">
                  <c:v>733.75199999999995</c:v>
                </c:pt>
                <c:pt idx="1387">
                  <c:v>1359.07</c:v>
                </c:pt>
                <c:pt idx="1393">
                  <c:v>857.952</c:v>
                </c:pt>
                <c:pt idx="1396">
                  <c:v>1196.21</c:v>
                </c:pt>
                <c:pt idx="1405">
                  <c:v>1148.26</c:v>
                </c:pt>
                <c:pt idx="1406">
                  <c:v>1603.37</c:v>
                </c:pt>
                <c:pt idx="1407">
                  <c:v>551.66399999999999</c:v>
                </c:pt>
                <c:pt idx="1409">
                  <c:v>663.12</c:v>
                </c:pt>
                <c:pt idx="1411">
                  <c:v>832.24800000000005</c:v>
                </c:pt>
                <c:pt idx="1412">
                  <c:v>1156.9000000000001</c:v>
                </c:pt>
                <c:pt idx="1414">
                  <c:v>960.55200000000002</c:v>
                </c:pt>
                <c:pt idx="1415">
                  <c:v>1323.43</c:v>
                </c:pt>
                <c:pt idx="1417">
                  <c:v>1226.02</c:v>
                </c:pt>
                <c:pt idx="1422">
                  <c:v>723.38400000000001</c:v>
                </c:pt>
                <c:pt idx="1431">
                  <c:v>865.94399999999996</c:v>
                </c:pt>
                <c:pt idx="1434">
                  <c:v>1232.28</c:v>
                </c:pt>
                <c:pt idx="1435">
                  <c:v>1880.71</c:v>
                </c:pt>
                <c:pt idx="1439">
                  <c:v>753.40800000000002</c:v>
                </c:pt>
                <c:pt idx="1441">
                  <c:v>1151.28</c:v>
                </c:pt>
                <c:pt idx="1449">
                  <c:v>788.83199999999999</c:v>
                </c:pt>
                <c:pt idx="1452">
                  <c:v>1037.8800000000001</c:v>
                </c:pt>
                <c:pt idx="1457">
                  <c:v>10038.200000000001</c:v>
                </c:pt>
                <c:pt idx="1459">
                  <c:v>1718.5</c:v>
                </c:pt>
                <c:pt idx="1461">
                  <c:v>883.44</c:v>
                </c:pt>
                <c:pt idx="1465">
                  <c:v>1134.8599999999999</c:v>
                </c:pt>
                <c:pt idx="1471">
                  <c:v>957.96</c:v>
                </c:pt>
                <c:pt idx="1474">
                  <c:v>2797.2</c:v>
                </c:pt>
                <c:pt idx="1477">
                  <c:v>879.55200000000002</c:v>
                </c:pt>
                <c:pt idx="1486">
                  <c:v>1389.31</c:v>
                </c:pt>
                <c:pt idx="1490">
                  <c:v>2340.36</c:v>
                </c:pt>
                <c:pt idx="1491">
                  <c:v>826.41600000000005</c:v>
                </c:pt>
                <c:pt idx="1492">
                  <c:v>1071.3599999999999</c:v>
                </c:pt>
                <c:pt idx="1493">
                  <c:v>875.44799999999998</c:v>
                </c:pt>
                <c:pt idx="1497">
                  <c:v>1049.76</c:v>
                </c:pt>
                <c:pt idx="1501">
                  <c:v>1022.54</c:v>
                </c:pt>
                <c:pt idx="1503">
                  <c:v>631.58399999999995</c:v>
                </c:pt>
                <c:pt idx="1504">
                  <c:v>871.34400000000005</c:v>
                </c:pt>
                <c:pt idx="1510">
                  <c:v>1134.22</c:v>
                </c:pt>
                <c:pt idx="1513">
                  <c:v>854.28</c:v>
                </c:pt>
                <c:pt idx="1518">
                  <c:v>691.84799999999996</c:v>
                </c:pt>
                <c:pt idx="1522">
                  <c:v>1378.08</c:v>
                </c:pt>
                <c:pt idx="1523">
                  <c:v>1016.28</c:v>
                </c:pt>
                <c:pt idx="1525">
                  <c:v>788.61599999999999</c:v>
                </c:pt>
                <c:pt idx="1530">
                  <c:v>1049.98</c:v>
                </c:pt>
                <c:pt idx="1539">
                  <c:v>917.35199999999998</c:v>
                </c:pt>
                <c:pt idx="1541">
                  <c:v>797.68799999999999</c:v>
                </c:pt>
                <c:pt idx="1545">
                  <c:v>830.30399999999997</c:v>
                </c:pt>
                <c:pt idx="1549">
                  <c:v>1004.83</c:v>
                </c:pt>
                <c:pt idx="1553">
                  <c:v>3097.44</c:v>
                </c:pt>
                <c:pt idx="1555">
                  <c:v>1306.58</c:v>
                </c:pt>
                <c:pt idx="1558">
                  <c:v>1462.54</c:v>
                </c:pt>
                <c:pt idx="1561">
                  <c:v>1165.97</c:v>
                </c:pt>
                <c:pt idx="1562">
                  <c:v>2637.58</c:v>
                </c:pt>
                <c:pt idx="1564">
                  <c:v>574.77599999999995</c:v>
                </c:pt>
                <c:pt idx="1570">
                  <c:v>1324.51</c:v>
                </c:pt>
                <c:pt idx="1573">
                  <c:v>987.12</c:v>
                </c:pt>
                <c:pt idx="1574">
                  <c:v>919.51199999999994</c:v>
                </c:pt>
                <c:pt idx="1579">
                  <c:v>2511.65</c:v>
                </c:pt>
                <c:pt idx="1580">
                  <c:v>1078.27</c:v>
                </c:pt>
                <c:pt idx="1581">
                  <c:v>915.62400000000002</c:v>
                </c:pt>
                <c:pt idx="1583">
                  <c:v>1080.22</c:v>
                </c:pt>
                <c:pt idx="1586">
                  <c:v>852.76800000000003</c:v>
                </c:pt>
                <c:pt idx="1587">
                  <c:v>974.80799999999999</c:v>
                </c:pt>
                <c:pt idx="1594">
                  <c:v>5559.84</c:v>
                </c:pt>
                <c:pt idx="1595">
                  <c:v>8664.84</c:v>
                </c:pt>
                <c:pt idx="1601">
                  <c:v>1013.69</c:v>
                </c:pt>
                <c:pt idx="1603">
                  <c:v>1280.02</c:v>
                </c:pt>
                <c:pt idx="1604">
                  <c:v>1257.3399999999999</c:v>
                </c:pt>
                <c:pt idx="1605">
                  <c:v>1417.61</c:v>
                </c:pt>
                <c:pt idx="1606">
                  <c:v>1661.47</c:v>
                </c:pt>
                <c:pt idx="1608">
                  <c:v>1902.74</c:v>
                </c:pt>
                <c:pt idx="1609">
                  <c:v>1162.94</c:v>
                </c:pt>
                <c:pt idx="1611">
                  <c:v>1057.0999999999999</c:v>
                </c:pt>
                <c:pt idx="1614">
                  <c:v>2351.59</c:v>
                </c:pt>
                <c:pt idx="1615">
                  <c:v>691.84799999999996</c:v>
                </c:pt>
                <c:pt idx="1622">
                  <c:v>733.96799999999996</c:v>
                </c:pt>
                <c:pt idx="1623">
                  <c:v>827.928</c:v>
                </c:pt>
                <c:pt idx="1630">
                  <c:v>1105.92</c:v>
                </c:pt>
                <c:pt idx="1633">
                  <c:v>958.39200000000005</c:v>
                </c:pt>
                <c:pt idx="1638">
                  <c:v>1071.79</c:v>
                </c:pt>
                <c:pt idx="1645">
                  <c:v>626.83199999999999</c:v>
                </c:pt>
                <c:pt idx="1646">
                  <c:v>747.79200000000003</c:v>
                </c:pt>
                <c:pt idx="1657">
                  <c:v>954.72</c:v>
                </c:pt>
                <c:pt idx="1660">
                  <c:v>433.72800000000001</c:v>
                </c:pt>
                <c:pt idx="1662">
                  <c:v>990.57600000000002</c:v>
                </c:pt>
                <c:pt idx="1663">
                  <c:v>1035.72</c:v>
                </c:pt>
                <c:pt idx="1664">
                  <c:v>788.83199999999999</c:v>
                </c:pt>
                <c:pt idx="1667">
                  <c:v>607.39200000000005</c:v>
                </c:pt>
                <c:pt idx="1670">
                  <c:v>628.34400000000005</c:v>
                </c:pt>
                <c:pt idx="1685">
                  <c:v>357.91199999999998</c:v>
                </c:pt>
                <c:pt idx="1687">
                  <c:v>939.16800000000001</c:v>
                </c:pt>
                <c:pt idx="1690">
                  <c:v>1959.77</c:v>
                </c:pt>
                <c:pt idx="1691">
                  <c:v>1030.97</c:v>
                </c:pt>
                <c:pt idx="1693">
                  <c:v>986.68799999999999</c:v>
                </c:pt>
                <c:pt idx="1695">
                  <c:v>541.51199999999994</c:v>
                </c:pt>
                <c:pt idx="1697">
                  <c:v>693.14400000000001</c:v>
                </c:pt>
                <c:pt idx="1699">
                  <c:v>1894.1</c:v>
                </c:pt>
                <c:pt idx="1701">
                  <c:v>687.31200000000001</c:v>
                </c:pt>
                <c:pt idx="1710">
                  <c:v>716.25599999999997</c:v>
                </c:pt>
                <c:pt idx="1714">
                  <c:v>1844.86</c:v>
                </c:pt>
                <c:pt idx="1716">
                  <c:v>949.75199999999995</c:v>
                </c:pt>
                <c:pt idx="1718">
                  <c:v>1196.21</c:v>
                </c:pt>
                <c:pt idx="1719">
                  <c:v>1170.29</c:v>
                </c:pt>
                <c:pt idx="1721">
                  <c:v>1226.8800000000001</c:v>
                </c:pt>
                <c:pt idx="1722">
                  <c:v>2988.36</c:v>
                </c:pt>
                <c:pt idx="1725">
                  <c:v>445.608</c:v>
                </c:pt>
                <c:pt idx="1726">
                  <c:v>1340.28</c:v>
                </c:pt>
                <c:pt idx="1727">
                  <c:v>810.21600000000001</c:v>
                </c:pt>
                <c:pt idx="1731">
                  <c:v>973.72799999999995</c:v>
                </c:pt>
                <c:pt idx="1732">
                  <c:v>1362.96</c:v>
                </c:pt>
                <c:pt idx="1743">
                  <c:v>1089.07</c:v>
                </c:pt>
                <c:pt idx="1745">
                  <c:v>821.01599999999996</c:v>
                </c:pt>
                <c:pt idx="1747">
                  <c:v>879.12</c:v>
                </c:pt>
                <c:pt idx="1748">
                  <c:v>1060.78</c:v>
                </c:pt>
                <c:pt idx="1750">
                  <c:v>1198.1500000000001</c:v>
                </c:pt>
                <c:pt idx="1752">
                  <c:v>779.54399999999998</c:v>
                </c:pt>
                <c:pt idx="1755">
                  <c:v>748.00800000000004</c:v>
                </c:pt>
                <c:pt idx="1756">
                  <c:v>1060.56</c:v>
                </c:pt>
                <c:pt idx="1757">
                  <c:v>1593.22</c:v>
                </c:pt>
                <c:pt idx="1765">
                  <c:v>470.44799999999998</c:v>
                </c:pt>
                <c:pt idx="1769">
                  <c:v>1222.56</c:v>
                </c:pt>
                <c:pt idx="1770">
                  <c:v>611.928</c:v>
                </c:pt>
                <c:pt idx="1771">
                  <c:v>871.99199999999996</c:v>
                </c:pt>
                <c:pt idx="1773">
                  <c:v>942.40800000000002</c:v>
                </c:pt>
                <c:pt idx="1776">
                  <c:v>1155.3800000000001</c:v>
                </c:pt>
                <c:pt idx="1778">
                  <c:v>1101.82</c:v>
                </c:pt>
                <c:pt idx="1784">
                  <c:v>1041.1199999999999</c:v>
                </c:pt>
                <c:pt idx="1786">
                  <c:v>854.928</c:v>
                </c:pt>
                <c:pt idx="1791">
                  <c:v>1181.95</c:v>
                </c:pt>
                <c:pt idx="1792">
                  <c:v>486.64800000000002</c:v>
                </c:pt>
                <c:pt idx="1793">
                  <c:v>1808.57</c:v>
                </c:pt>
                <c:pt idx="1795">
                  <c:v>1091.6600000000001</c:v>
                </c:pt>
                <c:pt idx="1798">
                  <c:v>1284.55</c:v>
                </c:pt>
                <c:pt idx="1799">
                  <c:v>734.83199999999999</c:v>
                </c:pt>
                <c:pt idx="1802">
                  <c:v>858.38400000000001</c:v>
                </c:pt>
                <c:pt idx="1805">
                  <c:v>1858.9</c:v>
                </c:pt>
                <c:pt idx="1810">
                  <c:v>931.60799999999995</c:v>
                </c:pt>
                <c:pt idx="1820">
                  <c:v>660.096</c:v>
                </c:pt>
                <c:pt idx="1822">
                  <c:v>748.22400000000005</c:v>
                </c:pt>
                <c:pt idx="1833">
                  <c:v>1086.9100000000001</c:v>
                </c:pt>
                <c:pt idx="1838">
                  <c:v>849.74400000000003</c:v>
                </c:pt>
                <c:pt idx="1841">
                  <c:v>1198.58</c:v>
                </c:pt>
                <c:pt idx="1849">
                  <c:v>1528.2</c:v>
                </c:pt>
                <c:pt idx="1860">
                  <c:v>1667.74</c:v>
                </c:pt>
                <c:pt idx="1864">
                  <c:v>1058.6199999999999</c:v>
                </c:pt>
                <c:pt idx="1874">
                  <c:v>802.22400000000005</c:v>
                </c:pt>
                <c:pt idx="1875">
                  <c:v>1049.76</c:v>
                </c:pt>
                <c:pt idx="1884">
                  <c:v>789.48</c:v>
                </c:pt>
                <c:pt idx="1886">
                  <c:v>1085.6199999999999</c:v>
                </c:pt>
                <c:pt idx="1893">
                  <c:v>1114.1300000000001</c:v>
                </c:pt>
                <c:pt idx="1896">
                  <c:v>987.76800000000003</c:v>
                </c:pt>
                <c:pt idx="1898">
                  <c:v>1040.47</c:v>
                </c:pt>
                <c:pt idx="1900">
                  <c:v>364.17599999999999</c:v>
                </c:pt>
                <c:pt idx="1902">
                  <c:v>1140.9100000000001</c:v>
                </c:pt>
                <c:pt idx="1903">
                  <c:v>992.52</c:v>
                </c:pt>
                <c:pt idx="1906">
                  <c:v>895.32</c:v>
                </c:pt>
                <c:pt idx="1907">
                  <c:v>1521.5</c:v>
                </c:pt>
                <c:pt idx="1915">
                  <c:v>1004.83</c:v>
                </c:pt>
                <c:pt idx="1918">
                  <c:v>1331.42</c:v>
                </c:pt>
                <c:pt idx="1920">
                  <c:v>963.14400000000001</c:v>
                </c:pt>
                <c:pt idx="1922">
                  <c:v>713.44799999999998</c:v>
                </c:pt>
                <c:pt idx="1924">
                  <c:v>1532.95</c:v>
                </c:pt>
                <c:pt idx="1926">
                  <c:v>1353.02</c:v>
                </c:pt>
                <c:pt idx="1930">
                  <c:v>2738.02</c:v>
                </c:pt>
                <c:pt idx="1932">
                  <c:v>948.45600000000002</c:v>
                </c:pt>
                <c:pt idx="1938">
                  <c:v>799.84799999999996</c:v>
                </c:pt>
                <c:pt idx="1939">
                  <c:v>897.048</c:v>
                </c:pt>
                <c:pt idx="1940">
                  <c:v>770.68799999999999</c:v>
                </c:pt>
                <c:pt idx="1945">
                  <c:v>665.71199999999999</c:v>
                </c:pt>
                <c:pt idx="1946">
                  <c:v>1470.96</c:v>
                </c:pt>
                <c:pt idx="1948">
                  <c:v>1124.28</c:v>
                </c:pt>
                <c:pt idx="1949">
                  <c:v>1358.42</c:v>
                </c:pt>
                <c:pt idx="1953">
                  <c:v>2520.0700000000002</c:v>
                </c:pt>
                <c:pt idx="1957">
                  <c:v>793.8</c:v>
                </c:pt>
                <c:pt idx="1959">
                  <c:v>1854.79</c:v>
                </c:pt>
                <c:pt idx="1961">
                  <c:v>703.94399999999996</c:v>
                </c:pt>
                <c:pt idx="1963">
                  <c:v>1489.75</c:v>
                </c:pt>
                <c:pt idx="1964">
                  <c:v>1568.16</c:v>
                </c:pt>
                <c:pt idx="1972">
                  <c:v>4232.95</c:v>
                </c:pt>
                <c:pt idx="1980">
                  <c:v>447.33600000000001</c:v>
                </c:pt>
                <c:pt idx="1983">
                  <c:v>988.63199999999995</c:v>
                </c:pt>
                <c:pt idx="1987">
                  <c:v>1935.58</c:v>
                </c:pt>
                <c:pt idx="1988">
                  <c:v>972</c:v>
                </c:pt>
                <c:pt idx="1989">
                  <c:v>1011.1</c:v>
                </c:pt>
                <c:pt idx="1991">
                  <c:v>910.65599999999995</c:v>
                </c:pt>
                <c:pt idx="1993">
                  <c:v>1108.08</c:v>
                </c:pt>
                <c:pt idx="1994">
                  <c:v>925.34400000000005</c:v>
                </c:pt>
                <c:pt idx="1996">
                  <c:v>1050.6199999999999</c:v>
                </c:pt>
                <c:pt idx="1998">
                  <c:v>728.56799999999998</c:v>
                </c:pt>
                <c:pt idx="1999">
                  <c:v>996.19200000000001</c:v>
                </c:pt>
                <c:pt idx="2007">
                  <c:v>1439.86</c:v>
                </c:pt>
                <c:pt idx="2008">
                  <c:v>1188.8599999999999</c:v>
                </c:pt>
                <c:pt idx="2010">
                  <c:v>1196.42</c:v>
                </c:pt>
                <c:pt idx="2016">
                  <c:v>1048.46</c:v>
                </c:pt>
                <c:pt idx="2017">
                  <c:v>1169.21</c:v>
                </c:pt>
                <c:pt idx="2023">
                  <c:v>883.22400000000005</c:v>
                </c:pt>
                <c:pt idx="2032">
                  <c:v>1089.29</c:v>
                </c:pt>
                <c:pt idx="2035">
                  <c:v>1094.47</c:v>
                </c:pt>
                <c:pt idx="2036">
                  <c:v>1922.62</c:v>
                </c:pt>
                <c:pt idx="2039">
                  <c:v>1107.8599999999999</c:v>
                </c:pt>
                <c:pt idx="2040">
                  <c:v>1398.82</c:v>
                </c:pt>
                <c:pt idx="2045">
                  <c:v>1122.55</c:v>
                </c:pt>
                <c:pt idx="2046">
                  <c:v>1651.75</c:v>
                </c:pt>
                <c:pt idx="2050">
                  <c:v>915.40800000000002</c:v>
                </c:pt>
                <c:pt idx="2054">
                  <c:v>703.51199999999994</c:v>
                </c:pt>
                <c:pt idx="2061">
                  <c:v>1336.82</c:v>
                </c:pt>
                <c:pt idx="2070">
                  <c:v>1006.34</c:v>
                </c:pt>
                <c:pt idx="2073">
                  <c:v>647.35199999999998</c:v>
                </c:pt>
                <c:pt idx="2076">
                  <c:v>952.56</c:v>
                </c:pt>
                <c:pt idx="2077">
                  <c:v>1208.3</c:v>
                </c:pt>
                <c:pt idx="2081">
                  <c:v>872.64</c:v>
                </c:pt>
                <c:pt idx="2082">
                  <c:v>1162.3</c:v>
                </c:pt>
                <c:pt idx="2084">
                  <c:v>730.94399999999996</c:v>
                </c:pt>
                <c:pt idx="2085">
                  <c:v>887.976</c:v>
                </c:pt>
                <c:pt idx="2087">
                  <c:v>983.01599999999996</c:v>
                </c:pt>
                <c:pt idx="2089">
                  <c:v>616.24800000000005</c:v>
                </c:pt>
                <c:pt idx="2090">
                  <c:v>803.52</c:v>
                </c:pt>
                <c:pt idx="2091">
                  <c:v>822.52800000000002</c:v>
                </c:pt>
                <c:pt idx="2094">
                  <c:v>1572.26</c:v>
                </c:pt>
                <c:pt idx="2097">
                  <c:v>879.55200000000002</c:v>
                </c:pt>
                <c:pt idx="2099">
                  <c:v>1065.53</c:v>
                </c:pt>
                <c:pt idx="2106">
                  <c:v>870.69600000000003</c:v>
                </c:pt>
                <c:pt idx="2117">
                  <c:v>994.68</c:v>
                </c:pt>
                <c:pt idx="2118">
                  <c:v>3726.43</c:v>
                </c:pt>
                <c:pt idx="2119">
                  <c:v>628.99199999999996</c:v>
                </c:pt>
                <c:pt idx="2120">
                  <c:v>613.87199999999996</c:v>
                </c:pt>
                <c:pt idx="2123">
                  <c:v>1505.95</c:v>
                </c:pt>
                <c:pt idx="2124">
                  <c:v>1451.52</c:v>
                </c:pt>
                <c:pt idx="2126">
                  <c:v>1207.6600000000001</c:v>
                </c:pt>
                <c:pt idx="2132">
                  <c:v>912.81600000000003</c:v>
                </c:pt>
                <c:pt idx="2135">
                  <c:v>880.2</c:v>
                </c:pt>
                <c:pt idx="2136">
                  <c:v>825.33600000000001</c:v>
                </c:pt>
                <c:pt idx="2140">
                  <c:v>864.64800000000002</c:v>
                </c:pt>
                <c:pt idx="2150">
                  <c:v>851.25599999999997</c:v>
                </c:pt>
                <c:pt idx="2152">
                  <c:v>1392.77</c:v>
                </c:pt>
                <c:pt idx="2156">
                  <c:v>1030.75</c:v>
                </c:pt>
                <c:pt idx="2161">
                  <c:v>825.98400000000004</c:v>
                </c:pt>
                <c:pt idx="2165">
                  <c:v>970.48800000000006</c:v>
                </c:pt>
                <c:pt idx="2168">
                  <c:v>2854.66</c:v>
                </c:pt>
                <c:pt idx="2169">
                  <c:v>6148.22</c:v>
                </c:pt>
                <c:pt idx="2176">
                  <c:v>883.87199999999996</c:v>
                </c:pt>
                <c:pt idx="2177">
                  <c:v>1213.06</c:v>
                </c:pt>
                <c:pt idx="2178">
                  <c:v>1492.78</c:v>
                </c:pt>
                <c:pt idx="2181">
                  <c:v>179.71199999999999</c:v>
                </c:pt>
                <c:pt idx="2182">
                  <c:v>1230.98</c:v>
                </c:pt>
                <c:pt idx="2186">
                  <c:v>937.00800000000004</c:v>
                </c:pt>
                <c:pt idx="2193">
                  <c:v>1295.3499999999999</c:v>
                </c:pt>
                <c:pt idx="2196">
                  <c:v>1461.67</c:v>
                </c:pt>
                <c:pt idx="2197">
                  <c:v>1221.05</c:v>
                </c:pt>
                <c:pt idx="2199">
                  <c:v>857.30399999999997</c:v>
                </c:pt>
                <c:pt idx="2201">
                  <c:v>635.904</c:v>
                </c:pt>
                <c:pt idx="2204">
                  <c:v>383.18400000000003</c:v>
                </c:pt>
                <c:pt idx="2210">
                  <c:v>1445.9</c:v>
                </c:pt>
                <c:pt idx="2212">
                  <c:v>1335.53</c:v>
                </c:pt>
                <c:pt idx="2213">
                  <c:v>926.42399999999998</c:v>
                </c:pt>
                <c:pt idx="2215">
                  <c:v>973.72799999999995</c:v>
                </c:pt>
                <c:pt idx="2217">
                  <c:v>149.47200000000001</c:v>
                </c:pt>
                <c:pt idx="2224">
                  <c:v>1021.25</c:v>
                </c:pt>
                <c:pt idx="2227">
                  <c:v>431.13600000000002</c:v>
                </c:pt>
                <c:pt idx="2228">
                  <c:v>1504.01</c:v>
                </c:pt>
                <c:pt idx="2231">
                  <c:v>822.096</c:v>
                </c:pt>
                <c:pt idx="2232">
                  <c:v>455.976</c:v>
                </c:pt>
                <c:pt idx="2237">
                  <c:v>986.25599999999997</c:v>
                </c:pt>
                <c:pt idx="2244">
                  <c:v>399.16800000000001</c:v>
                </c:pt>
                <c:pt idx="2248">
                  <c:v>1008.5</c:v>
                </c:pt>
                <c:pt idx="2250">
                  <c:v>1439.42</c:v>
                </c:pt>
                <c:pt idx="2251">
                  <c:v>423.14400000000001</c:v>
                </c:pt>
                <c:pt idx="2255">
                  <c:v>821.23199999999997</c:v>
                </c:pt>
                <c:pt idx="2258">
                  <c:v>1639.44</c:v>
                </c:pt>
                <c:pt idx="2265">
                  <c:v>1113.26</c:v>
                </c:pt>
                <c:pt idx="2276">
                  <c:v>999.86400000000003</c:v>
                </c:pt>
                <c:pt idx="2282">
                  <c:v>808.70399999999995</c:v>
                </c:pt>
                <c:pt idx="2284">
                  <c:v>1257.1199999999999</c:v>
                </c:pt>
                <c:pt idx="2285">
                  <c:v>451.65600000000001</c:v>
                </c:pt>
                <c:pt idx="2289">
                  <c:v>1349.78</c:v>
                </c:pt>
                <c:pt idx="2293">
                  <c:v>1402.92</c:v>
                </c:pt>
                <c:pt idx="2295">
                  <c:v>1255.3900000000001</c:v>
                </c:pt>
                <c:pt idx="2296">
                  <c:v>7016.33</c:v>
                </c:pt>
                <c:pt idx="2297">
                  <c:v>1489.97</c:v>
                </c:pt>
                <c:pt idx="2302">
                  <c:v>901.58399999999995</c:v>
                </c:pt>
                <c:pt idx="2303">
                  <c:v>935.06399999999996</c:v>
                </c:pt>
                <c:pt idx="2304">
                  <c:v>1118.6600000000001</c:v>
                </c:pt>
                <c:pt idx="2305">
                  <c:v>662.904</c:v>
                </c:pt>
                <c:pt idx="2306">
                  <c:v>1247.6199999999999</c:v>
                </c:pt>
                <c:pt idx="2309">
                  <c:v>1068.3399999999999</c:v>
                </c:pt>
                <c:pt idx="2310">
                  <c:v>578.01599999999996</c:v>
                </c:pt>
                <c:pt idx="2312">
                  <c:v>1559.95</c:v>
                </c:pt>
                <c:pt idx="2316">
                  <c:v>963.14400000000001</c:v>
                </c:pt>
                <c:pt idx="2322">
                  <c:v>626.4</c:v>
                </c:pt>
                <c:pt idx="2324">
                  <c:v>516.45600000000002</c:v>
                </c:pt>
                <c:pt idx="2328">
                  <c:v>1256.26</c:v>
                </c:pt>
                <c:pt idx="2331">
                  <c:v>296.13600000000002</c:v>
                </c:pt>
                <c:pt idx="2334">
                  <c:v>1115.6400000000001</c:v>
                </c:pt>
                <c:pt idx="2335">
                  <c:v>1495.15</c:v>
                </c:pt>
                <c:pt idx="2337">
                  <c:v>1000.73</c:v>
                </c:pt>
                <c:pt idx="2338">
                  <c:v>1690.63</c:v>
                </c:pt>
                <c:pt idx="2339">
                  <c:v>1001.16</c:v>
                </c:pt>
                <c:pt idx="2341">
                  <c:v>1064.8800000000001</c:v>
                </c:pt>
                <c:pt idx="2347">
                  <c:v>1681.13</c:v>
                </c:pt>
                <c:pt idx="2353">
                  <c:v>557.28</c:v>
                </c:pt>
                <c:pt idx="2354">
                  <c:v>1022.11</c:v>
                </c:pt>
                <c:pt idx="2357">
                  <c:v>741.74400000000003</c:v>
                </c:pt>
                <c:pt idx="2362">
                  <c:v>246.45599999999999</c:v>
                </c:pt>
                <c:pt idx="2363">
                  <c:v>755.35199999999998</c:v>
                </c:pt>
                <c:pt idx="2369">
                  <c:v>873.28800000000001</c:v>
                </c:pt>
                <c:pt idx="2374">
                  <c:v>1684.8</c:v>
                </c:pt>
                <c:pt idx="2375">
                  <c:v>853.41600000000005</c:v>
                </c:pt>
                <c:pt idx="2377">
                  <c:v>753.84</c:v>
                </c:pt>
                <c:pt idx="2385">
                  <c:v>1145.8800000000001</c:v>
                </c:pt>
                <c:pt idx="2387">
                  <c:v>221.83199999999999</c:v>
                </c:pt>
                <c:pt idx="2388">
                  <c:v>1295.3499999999999</c:v>
                </c:pt>
                <c:pt idx="2393">
                  <c:v>374.976</c:v>
                </c:pt>
                <c:pt idx="2396">
                  <c:v>669.6</c:v>
                </c:pt>
                <c:pt idx="2398">
                  <c:v>1076.98</c:v>
                </c:pt>
                <c:pt idx="2401">
                  <c:v>968.54399999999998</c:v>
                </c:pt>
                <c:pt idx="2404">
                  <c:v>963.14400000000001</c:v>
                </c:pt>
                <c:pt idx="2406">
                  <c:v>1138.97</c:v>
                </c:pt>
                <c:pt idx="2409">
                  <c:v>1098.1400000000001</c:v>
                </c:pt>
                <c:pt idx="2418">
                  <c:v>476.06400000000002</c:v>
                </c:pt>
                <c:pt idx="2428">
                  <c:v>1058.4000000000001</c:v>
                </c:pt>
                <c:pt idx="2429">
                  <c:v>1237.68</c:v>
                </c:pt>
                <c:pt idx="2430">
                  <c:v>827.71199999999999</c:v>
                </c:pt>
                <c:pt idx="2434">
                  <c:v>728.78399999999999</c:v>
                </c:pt>
                <c:pt idx="2443">
                  <c:v>1569.24</c:v>
                </c:pt>
                <c:pt idx="2445">
                  <c:v>1334.66</c:v>
                </c:pt>
                <c:pt idx="2450">
                  <c:v>763.34400000000005</c:v>
                </c:pt>
                <c:pt idx="2451">
                  <c:v>1526.9</c:v>
                </c:pt>
                <c:pt idx="2452">
                  <c:v>1045.8699999999999</c:v>
                </c:pt>
                <c:pt idx="2457">
                  <c:v>936.79200000000003</c:v>
                </c:pt>
                <c:pt idx="2458">
                  <c:v>551.66399999999999</c:v>
                </c:pt>
                <c:pt idx="2459">
                  <c:v>1100.0899999999999</c:v>
                </c:pt>
                <c:pt idx="2462">
                  <c:v>880.2</c:v>
                </c:pt>
                <c:pt idx="2475">
                  <c:v>1025.57</c:v>
                </c:pt>
                <c:pt idx="2478">
                  <c:v>801.79200000000003</c:v>
                </c:pt>
                <c:pt idx="2479">
                  <c:v>1204.8499999999999</c:v>
                </c:pt>
                <c:pt idx="2481">
                  <c:v>1187.3499999999999</c:v>
                </c:pt>
                <c:pt idx="2488">
                  <c:v>1697.33</c:v>
                </c:pt>
                <c:pt idx="2489">
                  <c:v>994.89599999999996</c:v>
                </c:pt>
                <c:pt idx="2497">
                  <c:v>913.68</c:v>
                </c:pt>
                <c:pt idx="2500">
                  <c:v>1008.94</c:v>
                </c:pt>
                <c:pt idx="2506">
                  <c:v>83.376000000000005</c:v>
                </c:pt>
                <c:pt idx="2508">
                  <c:v>455.54399999999998</c:v>
                </c:pt>
                <c:pt idx="2509">
                  <c:v>875.88</c:v>
                </c:pt>
                <c:pt idx="2513">
                  <c:v>750.38400000000001</c:v>
                </c:pt>
                <c:pt idx="2516">
                  <c:v>1253.23</c:v>
                </c:pt>
                <c:pt idx="2520">
                  <c:v>1232.28</c:v>
                </c:pt>
                <c:pt idx="2521">
                  <c:v>252.28800000000001</c:v>
                </c:pt>
                <c:pt idx="2522">
                  <c:v>1447.63</c:v>
                </c:pt>
                <c:pt idx="2525">
                  <c:v>778.03200000000004</c:v>
                </c:pt>
                <c:pt idx="2529">
                  <c:v>1539</c:v>
                </c:pt>
                <c:pt idx="2533">
                  <c:v>1247.6199999999999</c:v>
                </c:pt>
                <c:pt idx="2536">
                  <c:v>820.8</c:v>
                </c:pt>
                <c:pt idx="2538">
                  <c:v>1130.33</c:v>
                </c:pt>
                <c:pt idx="2539">
                  <c:v>885.81600000000003</c:v>
                </c:pt>
                <c:pt idx="2540">
                  <c:v>724.68</c:v>
                </c:pt>
                <c:pt idx="2541">
                  <c:v>1328.4</c:v>
                </c:pt>
                <c:pt idx="2545">
                  <c:v>5875.2</c:v>
                </c:pt>
                <c:pt idx="2546">
                  <c:v>868.96799999999996</c:v>
                </c:pt>
                <c:pt idx="2549">
                  <c:v>1064.45</c:v>
                </c:pt>
                <c:pt idx="2550">
                  <c:v>1046.0899999999999</c:v>
                </c:pt>
                <c:pt idx="2551">
                  <c:v>978.91200000000003</c:v>
                </c:pt>
                <c:pt idx="2554">
                  <c:v>874.8</c:v>
                </c:pt>
                <c:pt idx="2566">
                  <c:v>1076.76</c:v>
                </c:pt>
                <c:pt idx="2568">
                  <c:v>869.83199999999999</c:v>
                </c:pt>
                <c:pt idx="2574">
                  <c:v>825.98400000000004</c:v>
                </c:pt>
                <c:pt idx="2575">
                  <c:v>872.85599999999999</c:v>
                </c:pt>
                <c:pt idx="2577">
                  <c:v>870.48</c:v>
                </c:pt>
                <c:pt idx="2579">
                  <c:v>279.072</c:v>
                </c:pt>
                <c:pt idx="2583">
                  <c:v>670.89599999999996</c:v>
                </c:pt>
                <c:pt idx="2584">
                  <c:v>837.86400000000003</c:v>
                </c:pt>
                <c:pt idx="2585">
                  <c:v>1133.78</c:v>
                </c:pt>
                <c:pt idx="2586">
                  <c:v>878.47199999999998</c:v>
                </c:pt>
                <c:pt idx="2590">
                  <c:v>855.57600000000002</c:v>
                </c:pt>
                <c:pt idx="2591">
                  <c:v>1230.55</c:v>
                </c:pt>
                <c:pt idx="2592">
                  <c:v>900.28800000000001</c:v>
                </c:pt>
                <c:pt idx="2598">
                  <c:v>961.63199999999995</c:v>
                </c:pt>
                <c:pt idx="2601">
                  <c:v>6384.31</c:v>
                </c:pt>
                <c:pt idx="2603">
                  <c:v>1241.78</c:v>
                </c:pt>
                <c:pt idx="2605">
                  <c:v>1049.1099999999999</c:v>
                </c:pt>
                <c:pt idx="2609">
                  <c:v>1094.47</c:v>
                </c:pt>
                <c:pt idx="2610">
                  <c:v>900.93600000000004</c:v>
                </c:pt>
                <c:pt idx="2617">
                  <c:v>984.74400000000003</c:v>
                </c:pt>
                <c:pt idx="2627">
                  <c:v>854.49599999999998</c:v>
                </c:pt>
                <c:pt idx="2628">
                  <c:v>1684.37</c:v>
                </c:pt>
                <c:pt idx="2630">
                  <c:v>847.58399999999995</c:v>
                </c:pt>
                <c:pt idx="2641">
                  <c:v>1129.03</c:v>
                </c:pt>
                <c:pt idx="2643">
                  <c:v>1278.5</c:v>
                </c:pt>
                <c:pt idx="2645">
                  <c:v>768.096</c:v>
                </c:pt>
                <c:pt idx="2648">
                  <c:v>810.43200000000002</c:v>
                </c:pt>
                <c:pt idx="2649">
                  <c:v>912.16800000000001</c:v>
                </c:pt>
                <c:pt idx="2650">
                  <c:v>884.52</c:v>
                </c:pt>
                <c:pt idx="2655">
                  <c:v>1282.18</c:v>
                </c:pt>
                <c:pt idx="2658">
                  <c:v>974.37599999999998</c:v>
                </c:pt>
                <c:pt idx="2663">
                  <c:v>833.976</c:v>
                </c:pt>
                <c:pt idx="2666">
                  <c:v>1618.7</c:v>
                </c:pt>
                <c:pt idx="2669">
                  <c:v>1104.4100000000001</c:v>
                </c:pt>
                <c:pt idx="2672">
                  <c:v>1062.5</c:v>
                </c:pt>
                <c:pt idx="2676">
                  <c:v>1081.73</c:v>
                </c:pt>
                <c:pt idx="2677">
                  <c:v>1053</c:v>
                </c:pt>
                <c:pt idx="2679">
                  <c:v>821.66399999999999</c:v>
                </c:pt>
                <c:pt idx="2687">
                  <c:v>851.47199999999998</c:v>
                </c:pt>
                <c:pt idx="2700">
                  <c:v>1172.45</c:v>
                </c:pt>
                <c:pt idx="2702">
                  <c:v>738.28800000000001</c:v>
                </c:pt>
                <c:pt idx="2705">
                  <c:v>897.91200000000003</c:v>
                </c:pt>
                <c:pt idx="2708">
                  <c:v>897.69600000000003</c:v>
                </c:pt>
                <c:pt idx="2710">
                  <c:v>1926.07</c:v>
                </c:pt>
                <c:pt idx="2719">
                  <c:v>1583.71</c:v>
                </c:pt>
                <c:pt idx="2720">
                  <c:v>916.48800000000006</c:v>
                </c:pt>
                <c:pt idx="2723">
                  <c:v>1041.3399999999999</c:v>
                </c:pt>
                <c:pt idx="2727">
                  <c:v>1432.51</c:v>
                </c:pt>
                <c:pt idx="2730">
                  <c:v>724.68</c:v>
                </c:pt>
                <c:pt idx="2733">
                  <c:v>1471.61</c:v>
                </c:pt>
                <c:pt idx="2741">
                  <c:v>1272.67</c:v>
                </c:pt>
                <c:pt idx="2745">
                  <c:v>747.14400000000001</c:v>
                </c:pt>
                <c:pt idx="2748">
                  <c:v>954.93600000000004</c:v>
                </c:pt>
                <c:pt idx="2754">
                  <c:v>910.87199999999996</c:v>
                </c:pt>
                <c:pt idx="2762">
                  <c:v>1061.21</c:v>
                </c:pt>
                <c:pt idx="2763">
                  <c:v>1071.3599999999999</c:v>
                </c:pt>
                <c:pt idx="2764">
                  <c:v>1116.94</c:v>
                </c:pt>
                <c:pt idx="2766">
                  <c:v>1368.58</c:v>
                </c:pt>
                <c:pt idx="2769">
                  <c:v>1955.88</c:v>
                </c:pt>
                <c:pt idx="2771">
                  <c:v>978.48</c:v>
                </c:pt>
                <c:pt idx="2774">
                  <c:v>1225.1500000000001</c:v>
                </c:pt>
                <c:pt idx="2775">
                  <c:v>820.36800000000005</c:v>
                </c:pt>
                <c:pt idx="2781">
                  <c:v>1432.08</c:v>
                </c:pt>
                <c:pt idx="2788">
                  <c:v>784.29600000000005</c:v>
                </c:pt>
                <c:pt idx="2798">
                  <c:v>1188.22</c:v>
                </c:pt>
                <c:pt idx="2799">
                  <c:v>1206.3599999999999</c:v>
                </c:pt>
                <c:pt idx="2801">
                  <c:v>1607.69</c:v>
                </c:pt>
                <c:pt idx="2805">
                  <c:v>1189.3</c:v>
                </c:pt>
                <c:pt idx="2806">
                  <c:v>996.19200000000001</c:v>
                </c:pt>
                <c:pt idx="2807">
                  <c:v>1138.0999999999999</c:v>
                </c:pt>
                <c:pt idx="2809">
                  <c:v>1040.04</c:v>
                </c:pt>
                <c:pt idx="2815">
                  <c:v>1999.73</c:v>
                </c:pt>
                <c:pt idx="2818">
                  <c:v>900.072</c:v>
                </c:pt>
                <c:pt idx="2826">
                  <c:v>1190.3800000000001</c:v>
                </c:pt>
                <c:pt idx="2830">
                  <c:v>1194.05</c:v>
                </c:pt>
                <c:pt idx="2831">
                  <c:v>809.13599999999997</c:v>
                </c:pt>
                <c:pt idx="2833">
                  <c:v>519.26400000000001</c:v>
                </c:pt>
                <c:pt idx="2841">
                  <c:v>1009.37</c:v>
                </c:pt>
                <c:pt idx="2842">
                  <c:v>1227.0999999999999</c:v>
                </c:pt>
                <c:pt idx="2845">
                  <c:v>1983.96</c:v>
                </c:pt>
                <c:pt idx="2852">
                  <c:v>1039.18</c:v>
                </c:pt>
                <c:pt idx="2856">
                  <c:v>797.25599999999997</c:v>
                </c:pt>
                <c:pt idx="2857">
                  <c:v>633.31200000000001</c:v>
                </c:pt>
                <c:pt idx="2860">
                  <c:v>1144.8</c:v>
                </c:pt>
                <c:pt idx="2862">
                  <c:v>867.024</c:v>
                </c:pt>
                <c:pt idx="2863">
                  <c:v>1032.05</c:v>
                </c:pt>
                <c:pt idx="2871">
                  <c:v>767.01599999999996</c:v>
                </c:pt>
                <c:pt idx="2876">
                  <c:v>1572.7</c:v>
                </c:pt>
                <c:pt idx="2877">
                  <c:v>726.40800000000002</c:v>
                </c:pt>
                <c:pt idx="2878">
                  <c:v>1028.3800000000001</c:v>
                </c:pt>
                <c:pt idx="2879">
                  <c:v>928.58399999999995</c:v>
                </c:pt>
                <c:pt idx="2882">
                  <c:v>1131.8399999999999</c:v>
                </c:pt>
                <c:pt idx="2884">
                  <c:v>945.43200000000002</c:v>
                </c:pt>
                <c:pt idx="2886">
                  <c:v>1532.95</c:v>
                </c:pt>
                <c:pt idx="2889">
                  <c:v>781.70399999999995</c:v>
                </c:pt>
                <c:pt idx="2890">
                  <c:v>10103.799999999999</c:v>
                </c:pt>
                <c:pt idx="2893">
                  <c:v>769.17600000000004</c:v>
                </c:pt>
                <c:pt idx="2895">
                  <c:v>1676.38</c:v>
                </c:pt>
                <c:pt idx="2897">
                  <c:v>1206.3599999999999</c:v>
                </c:pt>
                <c:pt idx="2898">
                  <c:v>1842.05</c:v>
                </c:pt>
                <c:pt idx="2900">
                  <c:v>864.64800000000002</c:v>
                </c:pt>
                <c:pt idx="2902">
                  <c:v>914.11199999999997</c:v>
                </c:pt>
                <c:pt idx="2907">
                  <c:v>1156.68</c:v>
                </c:pt>
                <c:pt idx="2914">
                  <c:v>151.19999999999999</c:v>
                </c:pt>
                <c:pt idx="2920">
                  <c:v>823.17600000000004</c:v>
                </c:pt>
                <c:pt idx="2921">
                  <c:v>1319.98</c:v>
                </c:pt>
                <c:pt idx="2922">
                  <c:v>756</c:v>
                </c:pt>
                <c:pt idx="2928">
                  <c:v>2745.36</c:v>
                </c:pt>
                <c:pt idx="2929">
                  <c:v>1411.13</c:v>
                </c:pt>
                <c:pt idx="2931">
                  <c:v>856.65599999999995</c:v>
                </c:pt>
                <c:pt idx="2933">
                  <c:v>1224.94</c:v>
                </c:pt>
                <c:pt idx="2939">
                  <c:v>879.98400000000004</c:v>
                </c:pt>
                <c:pt idx="2940">
                  <c:v>1506.6</c:v>
                </c:pt>
                <c:pt idx="2941">
                  <c:v>1518.48</c:v>
                </c:pt>
                <c:pt idx="2944">
                  <c:v>1498.82</c:v>
                </c:pt>
                <c:pt idx="2949">
                  <c:v>842.83199999999999</c:v>
                </c:pt>
                <c:pt idx="2966">
                  <c:v>4872.3100000000004</c:v>
                </c:pt>
                <c:pt idx="2972">
                  <c:v>790.77599999999995</c:v>
                </c:pt>
                <c:pt idx="2976">
                  <c:v>1410.26</c:v>
                </c:pt>
                <c:pt idx="2980">
                  <c:v>707.4</c:v>
                </c:pt>
                <c:pt idx="2981">
                  <c:v>736.34400000000005</c:v>
                </c:pt>
                <c:pt idx="2984">
                  <c:v>1024.06</c:v>
                </c:pt>
                <c:pt idx="2985">
                  <c:v>1200.74</c:v>
                </c:pt>
                <c:pt idx="2986">
                  <c:v>960.33600000000001</c:v>
                </c:pt>
                <c:pt idx="2994">
                  <c:v>1106.3499999999999</c:v>
                </c:pt>
                <c:pt idx="2997">
                  <c:v>1264.25</c:v>
                </c:pt>
                <c:pt idx="3005">
                  <c:v>909.36</c:v>
                </c:pt>
                <c:pt idx="3006">
                  <c:v>1006.13</c:v>
                </c:pt>
                <c:pt idx="3011">
                  <c:v>731.37599999999998</c:v>
                </c:pt>
                <c:pt idx="3014">
                  <c:v>952.77599999999995</c:v>
                </c:pt>
                <c:pt idx="3018">
                  <c:v>1077.4100000000001</c:v>
                </c:pt>
                <c:pt idx="3020">
                  <c:v>903.31200000000001</c:v>
                </c:pt>
                <c:pt idx="3030">
                  <c:v>1015.85</c:v>
                </c:pt>
                <c:pt idx="3032">
                  <c:v>1011.96</c:v>
                </c:pt>
                <c:pt idx="3033">
                  <c:v>906.33600000000001</c:v>
                </c:pt>
                <c:pt idx="3036">
                  <c:v>975.67200000000003</c:v>
                </c:pt>
                <c:pt idx="3037">
                  <c:v>865.51199999999994</c:v>
                </c:pt>
                <c:pt idx="3041">
                  <c:v>828.14400000000001</c:v>
                </c:pt>
                <c:pt idx="3046">
                  <c:v>1350.86</c:v>
                </c:pt>
                <c:pt idx="3053">
                  <c:v>986.68799999999999</c:v>
                </c:pt>
                <c:pt idx="3054">
                  <c:v>1538.35</c:v>
                </c:pt>
                <c:pt idx="3058">
                  <c:v>949.10400000000004</c:v>
                </c:pt>
                <c:pt idx="3060">
                  <c:v>2400.41</c:v>
                </c:pt>
                <c:pt idx="3063">
                  <c:v>1227.96</c:v>
                </c:pt>
                <c:pt idx="3065">
                  <c:v>1658.88</c:v>
                </c:pt>
                <c:pt idx="3069">
                  <c:v>993.81600000000003</c:v>
                </c:pt>
                <c:pt idx="3070">
                  <c:v>984.096</c:v>
                </c:pt>
                <c:pt idx="3078">
                  <c:v>1352.38</c:v>
                </c:pt>
                <c:pt idx="3081">
                  <c:v>1023.62</c:v>
                </c:pt>
                <c:pt idx="3084">
                  <c:v>1439.64</c:v>
                </c:pt>
                <c:pt idx="3086">
                  <c:v>1750.03</c:v>
                </c:pt>
                <c:pt idx="3091">
                  <c:v>1318.25</c:v>
                </c:pt>
                <c:pt idx="3095">
                  <c:v>943.05600000000004</c:v>
                </c:pt>
                <c:pt idx="3097">
                  <c:v>1395.14</c:v>
                </c:pt>
                <c:pt idx="3109">
                  <c:v>629.85599999999999</c:v>
                </c:pt>
                <c:pt idx="3114">
                  <c:v>1309.82</c:v>
                </c:pt>
                <c:pt idx="3120">
                  <c:v>1661.04</c:v>
                </c:pt>
                <c:pt idx="3125">
                  <c:v>1739.66</c:v>
                </c:pt>
                <c:pt idx="3128">
                  <c:v>643.24800000000005</c:v>
                </c:pt>
                <c:pt idx="3130">
                  <c:v>1985.04</c:v>
                </c:pt>
                <c:pt idx="3131">
                  <c:v>1006.34</c:v>
                </c:pt>
                <c:pt idx="3135">
                  <c:v>869.18399999999997</c:v>
                </c:pt>
                <c:pt idx="3136">
                  <c:v>994.68</c:v>
                </c:pt>
                <c:pt idx="3138">
                  <c:v>961.41600000000005</c:v>
                </c:pt>
                <c:pt idx="3142">
                  <c:v>880.2</c:v>
                </c:pt>
                <c:pt idx="3148">
                  <c:v>1669.9</c:v>
                </c:pt>
                <c:pt idx="3152">
                  <c:v>822.96</c:v>
                </c:pt>
                <c:pt idx="3157">
                  <c:v>2011.18</c:v>
                </c:pt>
                <c:pt idx="3161">
                  <c:v>649.72799999999995</c:v>
                </c:pt>
                <c:pt idx="3163">
                  <c:v>878.25599999999997</c:v>
                </c:pt>
                <c:pt idx="3166">
                  <c:v>877.60799999999995</c:v>
                </c:pt>
                <c:pt idx="3169">
                  <c:v>1156.25</c:v>
                </c:pt>
                <c:pt idx="3172">
                  <c:v>1629.94</c:v>
                </c:pt>
                <c:pt idx="3174">
                  <c:v>2043.58</c:v>
                </c:pt>
                <c:pt idx="3176">
                  <c:v>798.76800000000003</c:v>
                </c:pt>
                <c:pt idx="3177">
                  <c:v>843.91200000000003</c:v>
                </c:pt>
                <c:pt idx="3180">
                  <c:v>662.68799999999999</c:v>
                </c:pt>
                <c:pt idx="3185">
                  <c:v>743.47199999999998</c:v>
                </c:pt>
                <c:pt idx="3191">
                  <c:v>1149.1199999999999</c:v>
                </c:pt>
                <c:pt idx="3196">
                  <c:v>762.48</c:v>
                </c:pt>
                <c:pt idx="3197">
                  <c:v>1826.71</c:v>
                </c:pt>
                <c:pt idx="3199">
                  <c:v>1801.22</c:v>
                </c:pt>
                <c:pt idx="3203">
                  <c:v>1696.03</c:v>
                </c:pt>
                <c:pt idx="3207">
                  <c:v>881.06399999999996</c:v>
                </c:pt>
                <c:pt idx="3208">
                  <c:v>1011.74</c:v>
                </c:pt>
                <c:pt idx="3210">
                  <c:v>1105.06</c:v>
                </c:pt>
                <c:pt idx="3214">
                  <c:v>1352.38</c:v>
                </c:pt>
                <c:pt idx="3217">
                  <c:v>1154.52</c:v>
                </c:pt>
                <c:pt idx="3225">
                  <c:v>1097.93</c:v>
                </c:pt>
                <c:pt idx="3234">
                  <c:v>923.83199999999999</c:v>
                </c:pt>
                <c:pt idx="3239">
                  <c:v>1357.78</c:v>
                </c:pt>
                <c:pt idx="3241">
                  <c:v>1028.5899999999999</c:v>
                </c:pt>
                <c:pt idx="3243">
                  <c:v>1416.53</c:v>
                </c:pt>
                <c:pt idx="3246">
                  <c:v>988.41600000000005</c:v>
                </c:pt>
                <c:pt idx="3248">
                  <c:v>944.78399999999999</c:v>
                </c:pt>
                <c:pt idx="3249">
                  <c:v>1094.26</c:v>
                </c:pt>
                <c:pt idx="3252">
                  <c:v>533.52</c:v>
                </c:pt>
                <c:pt idx="3253">
                  <c:v>1512.22</c:v>
                </c:pt>
                <c:pt idx="3264">
                  <c:v>596.37599999999998</c:v>
                </c:pt>
                <c:pt idx="3265">
                  <c:v>785.37599999999998</c:v>
                </c:pt>
                <c:pt idx="3275">
                  <c:v>1564.7</c:v>
                </c:pt>
                <c:pt idx="3276">
                  <c:v>1075.03</c:v>
                </c:pt>
                <c:pt idx="3278">
                  <c:v>891</c:v>
                </c:pt>
                <c:pt idx="3282">
                  <c:v>1131.19</c:v>
                </c:pt>
                <c:pt idx="3285">
                  <c:v>723.16800000000001</c:v>
                </c:pt>
                <c:pt idx="3291">
                  <c:v>2191.75</c:v>
                </c:pt>
                <c:pt idx="3296">
                  <c:v>1269.22</c:v>
                </c:pt>
                <c:pt idx="3298">
                  <c:v>1501.63</c:v>
                </c:pt>
                <c:pt idx="3300">
                  <c:v>931.60799999999995</c:v>
                </c:pt>
                <c:pt idx="3302">
                  <c:v>1099.01</c:v>
                </c:pt>
                <c:pt idx="3304">
                  <c:v>1178.06</c:v>
                </c:pt>
                <c:pt idx="3305">
                  <c:v>2361.1</c:v>
                </c:pt>
                <c:pt idx="3307">
                  <c:v>1641.38</c:v>
                </c:pt>
                <c:pt idx="3309">
                  <c:v>158.328</c:v>
                </c:pt>
                <c:pt idx="3312">
                  <c:v>1475.5</c:v>
                </c:pt>
                <c:pt idx="3314">
                  <c:v>960.33600000000001</c:v>
                </c:pt>
                <c:pt idx="3315">
                  <c:v>932.47199999999998</c:v>
                </c:pt>
                <c:pt idx="3316">
                  <c:v>1239.8399999999999</c:v>
                </c:pt>
                <c:pt idx="3319">
                  <c:v>911.952</c:v>
                </c:pt>
                <c:pt idx="3323">
                  <c:v>1278.94</c:v>
                </c:pt>
                <c:pt idx="3326">
                  <c:v>482.54399999999998</c:v>
                </c:pt>
                <c:pt idx="3342">
                  <c:v>616.89599999999996</c:v>
                </c:pt>
                <c:pt idx="3347">
                  <c:v>727.92</c:v>
                </c:pt>
                <c:pt idx="3348">
                  <c:v>731.80799999999999</c:v>
                </c:pt>
                <c:pt idx="3352">
                  <c:v>1523.88</c:v>
                </c:pt>
                <c:pt idx="3354">
                  <c:v>884.73599999999999</c:v>
                </c:pt>
                <c:pt idx="3358">
                  <c:v>1800.36</c:v>
                </c:pt>
                <c:pt idx="3360">
                  <c:v>988.63199999999995</c:v>
                </c:pt>
                <c:pt idx="3362">
                  <c:v>760.10400000000004</c:v>
                </c:pt>
                <c:pt idx="3364">
                  <c:v>972.21600000000001</c:v>
                </c:pt>
                <c:pt idx="3368">
                  <c:v>1082.3800000000001</c:v>
                </c:pt>
                <c:pt idx="3371">
                  <c:v>1255.18</c:v>
                </c:pt>
                <c:pt idx="3373">
                  <c:v>1029.67</c:v>
                </c:pt>
                <c:pt idx="3374">
                  <c:v>1401.41</c:v>
                </c:pt>
                <c:pt idx="3375">
                  <c:v>1013.26</c:v>
                </c:pt>
                <c:pt idx="3378">
                  <c:v>1360.58</c:v>
                </c:pt>
                <c:pt idx="3382">
                  <c:v>7531.27</c:v>
                </c:pt>
                <c:pt idx="3386">
                  <c:v>1472.26</c:v>
                </c:pt>
                <c:pt idx="3387">
                  <c:v>951.048</c:v>
                </c:pt>
                <c:pt idx="3418">
                  <c:v>838.72799999999995</c:v>
                </c:pt>
                <c:pt idx="3425">
                  <c:v>583.41600000000005</c:v>
                </c:pt>
                <c:pt idx="3426">
                  <c:v>1248.9100000000001</c:v>
                </c:pt>
                <c:pt idx="3427">
                  <c:v>1213.49</c:v>
                </c:pt>
                <c:pt idx="3435">
                  <c:v>891.64800000000002</c:v>
                </c:pt>
                <c:pt idx="3440">
                  <c:v>1173.53</c:v>
                </c:pt>
                <c:pt idx="3443">
                  <c:v>1407.24</c:v>
                </c:pt>
                <c:pt idx="3445">
                  <c:v>1089.72</c:v>
                </c:pt>
                <c:pt idx="3446">
                  <c:v>1066.6099999999999</c:v>
                </c:pt>
                <c:pt idx="3448">
                  <c:v>699.40800000000002</c:v>
                </c:pt>
                <c:pt idx="3451">
                  <c:v>857.08799999999997</c:v>
                </c:pt>
                <c:pt idx="3453">
                  <c:v>1509.84</c:v>
                </c:pt>
                <c:pt idx="3458">
                  <c:v>973.94399999999996</c:v>
                </c:pt>
                <c:pt idx="3461">
                  <c:v>868.96799999999996</c:v>
                </c:pt>
                <c:pt idx="3466">
                  <c:v>961.2</c:v>
                </c:pt>
                <c:pt idx="3467">
                  <c:v>746.28</c:v>
                </c:pt>
                <c:pt idx="3471">
                  <c:v>1527.12</c:v>
                </c:pt>
                <c:pt idx="3477">
                  <c:v>1674</c:v>
                </c:pt>
                <c:pt idx="3479">
                  <c:v>137.16</c:v>
                </c:pt>
                <c:pt idx="3481">
                  <c:v>2234.52</c:v>
                </c:pt>
                <c:pt idx="3482">
                  <c:v>827.28</c:v>
                </c:pt>
                <c:pt idx="3487">
                  <c:v>1953.07</c:v>
                </c:pt>
                <c:pt idx="3490">
                  <c:v>1093.82</c:v>
                </c:pt>
                <c:pt idx="3492">
                  <c:v>1027.94</c:v>
                </c:pt>
                <c:pt idx="3494">
                  <c:v>774.79200000000003</c:v>
                </c:pt>
                <c:pt idx="3497">
                  <c:v>823.60799999999995</c:v>
                </c:pt>
                <c:pt idx="3499">
                  <c:v>743.04</c:v>
                </c:pt>
                <c:pt idx="3500">
                  <c:v>672.62400000000002</c:v>
                </c:pt>
                <c:pt idx="3509">
                  <c:v>1290.5999999999999</c:v>
                </c:pt>
                <c:pt idx="3510">
                  <c:v>2841.7</c:v>
                </c:pt>
                <c:pt idx="3518">
                  <c:v>930.52800000000002</c:v>
                </c:pt>
                <c:pt idx="3520">
                  <c:v>785.80799999999999</c:v>
                </c:pt>
                <c:pt idx="3527">
                  <c:v>878.47199999999998</c:v>
                </c:pt>
                <c:pt idx="3530">
                  <c:v>1065.31</c:v>
                </c:pt>
                <c:pt idx="3532">
                  <c:v>1071.58</c:v>
                </c:pt>
                <c:pt idx="3534">
                  <c:v>1415.88</c:v>
                </c:pt>
                <c:pt idx="3537">
                  <c:v>1243.51</c:v>
                </c:pt>
                <c:pt idx="3545">
                  <c:v>762.048</c:v>
                </c:pt>
                <c:pt idx="3546">
                  <c:v>2103.41</c:v>
                </c:pt>
                <c:pt idx="3551">
                  <c:v>1725.41</c:v>
                </c:pt>
                <c:pt idx="3559">
                  <c:v>322.488</c:v>
                </c:pt>
                <c:pt idx="3560">
                  <c:v>1799.5</c:v>
                </c:pt>
                <c:pt idx="3563">
                  <c:v>1416.74</c:v>
                </c:pt>
                <c:pt idx="3564">
                  <c:v>1653.05</c:v>
                </c:pt>
                <c:pt idx="3567">
                  <c:v>872.64</c:v>
                </c:pt>
                <c:pt idx="3573">
                  <c:v>2650.75</c:v>
                </c:pt>
                <c:pt idx="3575">
                  <c:v>1443.96</c:v>
                </c:pt>
                <c:pt idx="3578">
                  <c:v>1545.48</c:v>
                </c:pt>
                <c:pt idx="3583">
                  <c:v>1297.51</c:v>
                </c:pt>
                <c:pt idx="3587">
                  <c:v>828.79200000000003</c:v>
                </c:pt>
                <c:pt idx="3589">
                  <c:v>1033.56</c:v>
                </c:pt>
                <c:pt idx="3590">
                  <c:v>1257.55</c:v>
                </c:pt>
                <c:pt idx="3591">
                  <c:v>1174.82</c:v>
                </c:pt>
                <c:pt idx="3592">
                  <c:v>1289.3</c:v>
                </c:pt>
                <c:pt idx="3593">
                  <c:v>1227.0999999999999</c:v>
                </c:pt>
                <c:pt idx="3599">
                  <c:v>821.23199999999997</c:v>
                </c:pt>
                <c:pt idx="3602">
                  <c:v>1332.5</c:v>
                </c:pt>
                <c:pt idx="3603">
                  <c:v>589.24800000000005</c:v>
                </c:pt>
                <c:pt idx="3608">
                  <c:v>1045.6600000000001</c:v>
                </c:pt>
                <c:pt idx="3612">
                  <c:v>742.39200000000005</c:v>
                </c:pt>
                <c:pt idx="3618">
                  <c:v>436.32</c:v>
                </c:pt>
                <c:pt idx="3626">
                  <c:v>803.52</c:v>
                </c:pt>
                <c:pt idx="3627">
                  <c:v>614.08799999999997</c:v>
                </c:pt>
                <c:pt idx="3629">
                  <c:v>831.38400000000001</c:v>
                </c:pt>
                <c:pt idx="3631">
                  <c:v>783.21600000000001</c:v>
                </c:pt>
                <c:pt idx="3635">
                  <c:v>984.096</c:v>
                </c:pt>
                <c:pt idx="3641">
                  <c:v>763.77599999999995</c:v>
                </c:pt>
                <c:pt idx="3652">
                  <c:v>1215</c:v>
                </c:pt>
                <c:pt idx="3654">
                  <c:v>690.98400000000004</c:v>
                </c:pt>
                <c:pt idx="3657">
                  <c:v>964.65599999999995</c:v>
                </c:pt>
                <c:pt idx="3660">
                  <c:v>929.23199999999997</c:v>
                </c:pt>
                <c:pt idx="3662">
                  <c:v>754.70399999999995</c:v>
                </c:pt>
                <c:pt idx="3664">
                  <c:v>1261.22</c:v>
                </c:pt>
                <c:pt idx="3666">
                  <c:v>750.38400000000001</c:v>
                </c:pt>
                <c:pt idx="3668">
                  <c:v>1174.82</c:v>
                </c:pt>
                <c:pt idx="3669">
                  <c:v>809.13599999999997</c:v>
                </c:pt>
                <c:pt idx="3676">
                  <c:v>3505.25</c:v>
                </c:pt>
                <c:pt idx="3685">
                  <c:v>1334.88</c:v>
                </c:pt>
                <c:pt idx="3687">
                  <c:v>1075.03</c:v>
                </c:pt>
                <c:pt idx="3689">
                  <c:v>854.71199999999999</c:v>
                </c:pt>
                <c:pt idx="3694">
                  <c:v>1088.21</c:v>
                </c:pt>
                <c:pt idx="3698">
                  <c:v>1310.69</c:v>
                </c:pt>
                <c:pt idx="3699">
                  <c:v>1109.5899999999999</c:v>
                </c:pt>
                <c:pt idx="3701">
                  <c:v>744.76800000000003</c:v>
                </c:pt>
                <c:pt idx="3702">
                  <c:v>2525.2600000000002</c:v>
                </c:pt>
                <c:pt idx="3710">
                  <c:v>1068.3399999999999</c:v>
                </c:pt>
                <c:pt idx="3711">
                  <c:v>1339.85</c:v>
                </c:pt>
                <c:pt idx="3713">
                  <c:v>1321.7</c:v>
                </c:pt>
                <c:pt idx="3714">
                  <c:v>1094.69</c:v>
                </c:pt>
                <c:pt idx="3715">
                  <c:v>1410.91</c:v>
                </c:pt>
                <c:pt idx="3721">
                  <c:v>503.28</c:v>
                </c:pt>
                <c:pt idx="3722">
                  <c:v>528.12</c:v>
                </c:pt>
                <c:pt idx="3729">
                  <c:v>1145.02</c:v>
                </c:pt>
                <c:pt idx="3737">
                  <c:v>859.89599999999996</c:v>
                </c:pt>
                <c:pt idx="3740">
                  <c:v>955.36800000000005</c:v>
                </c:pt>
                <c:pt idx="3742">
                  <c:v>900.28800000000001</c:v>
                </c:pt>
                <c:pt idx="3754">
                  <c:v>797.68799999999999</c:v>
                </c:pt>
                <c:pt idx="3756">
                  <c:v>1078.49</c:v>
                </c:pt>
                <c:pt idx="3757">
                  <c:v>1285.2</c:v>
                </c:pt>
                <c:pt idx="3759">
                  <c:v>737.42399999999998</c:v>
                </c:pt>
                <c:pt idx="3770">
                  <c:v>768.096</c:v>
                </c:pt>
                <c:pt idx="3771">
                  <c:v>833.32799999999997</c:v>
                </c:pt>
                <c:pt idx="3776">
                  <c:v>8198.06</c:v>
                </c:pt>
                <c:pt idx="3778">
                  <c:v>560.08799999999997</c:v>
                </c:pt>
                <c:pt idx="3779">
                  <c:v>746.49599999999998</c:v>
                </c:pt>
                <c:pt idx="3782">
                  <c:v>965.30399999999997</c:v>
                </c:pt>
                <c:pt idx="3785">
                  <c:v>780.84</c:v>
                </c:pt>
                <c:pt idx="3789">
                  <c:v>1377.86</c:v>
                </c:pt>
                <c:pt idx="3795">
                  <c:v>1538.35</c:v>
                </c:pt>
                <c:pt idx="3796">
                  <c:v>724.89599999999996</c:v>
                </c:pt>
                <c:pt idx="3797">
                  <c:v>147.744</c:v>
                </c:pt>
                <c:pt idx="3798">
                  <c:v>1159.49</c:v>
                </c:pt>
                <c:pt idx="3806">
                  <c:v>557.06399999999996</c:v>
                </c:pt>
                <c:pt idx="3809">
                  <c:v>778.24800000000005</c:v>
                </c:pt>
                <c:pt idx="3812">
                  <c:v>616.03200000000004</c:v>
                </c:pt>
                <c:pt idx="3816">
                  <c:v>295.488</c:v>
                </c:pt>
                <c:pt idx="3817">
                  <c:v>792.50400000000002</c:v>
                </c:pt>
                <c:pt idx="3823">
                  <c:v>675.64800000000002</c:v>
                </c:pt>
                <c:pt idx="3824">
                  <c:v>1049.54</c:v>
                </c:pt>
                <c:pt idx="3826">
                  <c:v>792.28800000000001</c:v>
                </c:pt>
                <c:pt idx="3828">
                  <c:v>588.16800000000001</c:v>
                </c:pt>
                <c:pt idx="3832">
                  <c:v>1446.55</c:v>
                </c:pt>
                <c:pt idx="3833">
                  <c:v>654.048</c:v>
                </c:pt>
                <c:pt idx="3836">
                  <c:v>1390.61</c:v>
                </c:pt>
                <c:pt idx="3838">
                  <c:v>778.24800000000005</c:v>
                </c:pt>
                <c:pt idx="3846">
                  <c:v>877.60799999999995</c:v>
                </c:pt>
                <c:pt idx="3852">
                  <c:v>1218.02</c:v>
                </c:pt>
                <c:pt idx="3858">
                  <c:v>1855.87</c:v>
                </c:pt>
                <c:pt idx="3859">
                  <c:v>938.08799999999997</c:v>
                </c:pt>
                <c:pt idx="3860">
                  <c:v>885.81600000000003</c:v>
                </c:pt>
                <c:pt idx="3867">
                  <c:v>1339.42</c:v>
                </c:pt>
                <c:pt idx="3868">
                  <c:v>797.25599999999997</c:v>
                </c:pt>
                <c:pt idx="3871">
                  <c:v>581.68799999999999</c:v>
                </c:pt>
                <c:pt idx="3877">
                  <c:v>1194.48</c:v>
                </c:pt>
                <c:pt idx="3879">
                  <c:v>1315.22</c:v>
                </c:pt>
                <c:pt idx="3885">
                  <c:v>1106.78</c:v>
                </c:pt>
                <c:pt idx="3886">
                  <c:v>471.096</c:v>
                </c:pt>
                <c:pt idx="3889">
                  <c:v>1193.6199999999999</c:v>
                </c:pt>
                <c:pt idx="3898">
                  <c:v>922.10400000000004</c:v>
                </c:pt>
                <c:pt idx="3902">
                  <c:v>978.26400000000001</c:v>
                </c:pt>
                <c:pt idx="3904">
                  <c:v>1309.3900000000001</c:v>
                </c:pt>
                <c:pt idx="3906">
                  <c:v>1013.04</c:v>
                </c:pt>
                <c:pt idx="3915">
                  <c:v>1311.77</c:v>
                </c:pt>
                <c:pt idx="3919">
                  <c:v>833.11199999999997</c:v>
                </c:pt>
                <c:pt idx="3920">
                  <c:v>969.40800000000002</c:v>
                </c:pt>
                <c:pt idx="3921">
                  <c:v>1407.67</c:v>
                </c:pt>
                <c:pt idx="3925">
                  <c:v>409.536</c:v>
                </c:pt>
                <c:pt idx="3930">
                  <c:v>590.976</c:v>
                </c:pt>
                <c:pt idx="3931">
                  <c:v>988.84799999999996</c:v>
                </c:pt>
                <c:pt idx="3939">
                  <c:v>317.73599999999999</c:v>
                </c:pt>
                <c:pt idx="3940">
                  <c:v>1262.52</c:v>
                </c:pt>
                <c:pt idx="3943">
                  <c:v>593.13599999999997</c:v>
                </c:pt>
                <c:pt idx="3945">
                  <c:v>1512.65</c:v>
                </c:pt>
                <c:pt idx="3946">
                  <c:v>759.88800000000003</c:v>
                </c:pt>
                <c:pt idx="3947">
                  <c:v>883.22400000000005</c:v>
                </c:pt>
                <c:pt idx="3948">
                  <c:v>1213.49</c:v>
                </c:pt>
                <c:pt idx="3951">
                  <c:v>759.88800000000003</c:v>
                </c:pt>
                <c:pt idx="3954">
                  <c:v>1324.94</c:v>
                </c:pt>
                <c:pt idx="3956">
                  <c:v>905.904</c:v>
                </c:pt>
                <c:pt idx="3961">
                  <c:v>1577.02</c:v>
                </c:pt>
                <c:pt idx="3962">
                  <c:v>482.76</c:v>
                </c:pt>
                <c:pt idx="3963">
                  <c:v>553.39200000000005</c:v>
                </c:pt>
                <c:pt idx="3969">
                  <c:v>915.19200000000001</c:v>
                </c:pt>
                <c:pt idx="3970">
                  <c:v>873.072</c:v>
                </c:pt>
                <c:pt idx="3973">
                  <c:v>1184.98</c:v>
                </c:pt>
                <c:pt idx="3981">
                  <c:v>613.65599999999995</c:v>
                </c:pt>
                <c:pt idx="3982">
                  <c:v>1171.8</c:v>
                </c:pt>
                <c:pt idx="3990">
                  <c:v>749.52</c:v>
                </c:pt>
                <c:pt idx="3991">
                  <c:v>1744.63</c:v>
                </c:pt>
                <c:pt idx="3995">
                  <c:v>807.19200000000001</c:v>
                </c:pt>
                <c:pt idx="3999">
                  <c:v>847.15200000000004</c:v>
                </c:pt>
                <c:pt idx="4002">
                  <c:v>573.69600000000003</c:v>
                </c:pt>
                <c:pt idx="4004">
                  <c:v>1156.46</c:v>
                </c:pt>
                <c:pt idx="4005">
                  <c:v>821.23199999999997</c:v>
                </c:pt>
                <c:pt idx="4006">
                  <c:v>1657.37</c:v>
                </c:pt>
                <c:pt idx="4008">
                  <c:v>678.45600000000002</c:v>
                </c:pt>
                <c:pt idx="4011">
                  <c:v>1536.41</c:v>
                </c:pt>
                <c:pt idx="4017">
                  <c:v>966.6</c:v>
                </c:pt>
                <c:pt idx="4020">
                  <c:v>1668.38</c:v>
                </c:pt>
                <c:pt idx="4026">
                  <c:v>2204.2800000000002</c:v>
                </c:pt>
                <c:pt idx="4027">
                  <c:v>1568.38</c:v>
                </c:pt>
                <c:pt idx="4030">
                  <c:v>875.88</c:v>
                </c:pt>
                <c:pt idx="4031">
                  <c:v>768.31200000000001</c:v>
                </c:pt>
                <c:pt idx="4037">
                  <c:v>1368.36</c:v>
                </c:pt>
                <c:pt idx="4041">
                  <c:v>743.04</c:v>
                </c:pt>
                <c:pt idx="4043">
                  <c:v>1042.6300000000001</c:v>
                </c:pt>
                <c:pt idx="4050">
                  <c:v>988.2</c:v>
                </c:pt>
                <c:pt idx="4052">
                  <c:v>1137.24</c:v>
                </c:pt>
                <c:pt idx="4054">
                  <c:v>1092.0999999999999</c:v>
                </c:pt>
                <c:pt idx="4057">
                  <c:v>486.43200000000002</c:v>
                </c:pt>
                <c:pt idx="4064">
                  <c:v>817.34400000000005</c:v>
                </c:pt>
                <c:pt idx="4068">
                  <c:v>1518.91</c:v>
                </c:pt>
                <c:pt idx="4069">
                  <c:v>885.16800000000001</c:v>
                </c:pt>
                <c:pt idx="4078">
                  <c:v>1174.3900000000001</c:v>
                </c:pt>
                <c:pt idx="4084">
                  <c:v>1510.92</c:v>
                </c:pt>
                <c:pt idx="4088">
                  <c:v>799.2</c:v>
                </c:pt>
                <c:pt idx="4090">
                  <c:v>386.42399999999998</c:v>
                </c:pt>
                <c:pt idx="4091">
                  <c:v>73.007999999999996</c:v>
                </c:pt>
                <c:pt idx="4101">
                  <c:v>1556.5</c:v>
                </c:pt>
                <c:pt idx="4104">
                  <c:v>1142.8599999999999</c:v>
                </c:pt>
                <c:pt idx="4106">
                  <c:v>1053.43</c:v>
                </c:pt>
                <c:pt idx="4108">
                  <c:v>1177.8499999999999</c:v>
                </c:pt>
                <c:pt idx="4110">
                  <c:v>720.79200000000003</c:v>
                </c:pt>
                <c:pt idx="4112">
                  <c:v>491.18400000000003</c:v>
                </c:pt>
                <c:pt idx="4115">
                  <c:v>795.96</c:v>
                </c:pt>
                <c:pt idx="4128">
                  <c:v>716.04</c:v>
                </c:pt>
                <c:pt idx="4130">
                  <c:v>1517.62</c:v>
                </c:pt>
                <c:pt idx="4131">
                  <c:v>5321.59</c:v>
                </c:pt>
                <c:pt idx="4132">
                  <c:v>1499.69</c:v>
                </c:pt>
                <c:pt idx="4134">
                  <c:v>707.61599999999999</c:v>
                </c:pt>
                <c:pt idx="4137">
                  <c:v>692.49599999999998</c:v>
                </c:pt>
                <c:pt idx="4140">
                  <c:v>895.32</c:v>
                </c:pt>
                <c:pt idx="4144">
                  <c:v>649.94399999999996</c:v>
                </c:pt>
                <c:pt idx="4147">
                  <c:v>2309.9</c:v>
                </c:pt>
                <c:pt idx="4148">
                  <c:v>1730.81</c:v>
                </c:pt>
                <c:pt idx="4155">
                  <c:v>1292.54</c:v>
                </c:pt>
                <c:pt idx="4158">
                  <c:v>1541.38</c:v>
                </c:pt>
                <c:pt idx="4160">
                  <c:v>1185.6199999999999</c:v>
                </c:pt>
                <c:pt idx="4162">
                  <c:v>1052.78</c:v>
                </c:pt>
                <c:pt idx="4167">
                  <c:v>1113.26</c:v>
                </c:pt>
                <c:pt idx="4175">
                  <c:v>582.98400000000004</c:v>
                </c:pt>
                <c:pt idx="4189">
                  <c:v>807.62400000000002</c:v>
                </c:pt>
                <c:pt idx="4190">
                  <c:v>843.69600000000003</c:v>
                </c:pt>
                <c:pt idx="4192">
                  <c:v>720.14400000000001</c:v>
                </c:pt>
                <c:pt idx="4194">
                  <c:v>1195.78</c:v>
                </c:pt>
                <c:pt idx="4198">
                  <c:v>598.32000000000005</c:v>
                </c:pt>
                <c:pt idx="4199">
                  <c:v>649.08000000000004</c:v>
                </c:pt>
                <c:pt idx="4201">
                  <c:v>926.64</c:v>
                </c:pt>
                <c:pt idx="4203">
                  <c:v>715.82399999999996</c:v>
                </c:pt>
                <c:pt idx="4204">
                  <c:v>1494.72</c:v>
                </c:pt>
                <c:pt idx="4205">
                  <c:v>900.50400000000002</c:v>
                </c:pt>
                <c:pt idx="4210">
                  <c:v>1257.1199999999999</c:v>
                </c:pt>
                <c:pt idx="4215">
                  <c:v>732.024</c:v>
                </c:pt>
                <c:pt idx="4216">
                  <c:v>3701.38</c:v>
                </c:pt>
                <c:pt idx="4218">
                  <c:v>780.40800000000002</c:v>
                </c:pt>
                <c:pt idx="4220">
                  <c:v>557.71199999999999</c:v>
                </c:pt>
                <c:pt idx="4224">
                  <c:v>1798.85</c:v>
                </c:pt>
                <c:pt idx="4228">
                  <c:v>1015.85</c:v>
                </c:pt>
                <c:pt idx="4232">
                  <c:v>783.21600000000001</c:v>
                </c:pt>
                <c:pt idx="4235">
                  <c:v>1951.99</c:v>
                </c:pt>
                <c:pt idx="4236">
                  <c:v>799.41600000000005</c:v>
                </c:pt>
                <c:pt idx="4238">
                  <c:v>1325.38</c:v>
                </c:pt>
                <c:pt idx="4245">
                  <c:v>1054.08</c:v>
                </c:pt>
                <c:pt idx="4249">
                  <c:v>1717.63</c:v>
                </c:pt>
                <c:pt idx="4251">
                  <c:v>1871.42</c:v>
                </c:pt>
                <c:pt idx="4253">
                  <c:v>1453.46</c:v>
                </c:pt>
                <c:pt idx="4254">
                  <c:v>1755.86</c:v>
                </c:pt>
                <c:pt idx="4259">
                  <c:v>716.68799999999999</c:v>
                </c:pt>
                <c:pt idx="4260">
                  <c:v>820.15200000000004</c:v>
                </c:pt>
                <c:pt idx="4265">
                  <c:v>142.77600000000001</c:v>
                </c:pt>
                <c:pt idx="4267">
                  <c:v>183.816</c:v>
                </c:pt>
                <c:pt idx="4270">
                  <c:v>1331.21</c:v>
                </c:pt>
                <c:pt idx="4278">
                  <c:v>611.49599999999998</c:v>
                </c:pt>
                <c:pt idx="4279">
                  <c:v>973.94399999999996</c:v>
                </c:pt>
                <c:pt idx="4281">
                  <c:v>1186.7</c:v>
                </c:pt>
                <c:pt idx="4284">
                  <c:v>1106.1400000000001</c:v>
                </c:pt>
                <c:pt idx="4288">
                  <c:v>653.18399999999997</c:v>
                </c:pt>
                <c:pt idx="4290">
                  <c:v>840.024</c:v>
                </c:pt>
                <c:pt idx="4293">
                  <c:v>1807.06</c:v>
                </c:pt>
                <c:pt idx="4300">
                  <c:v>734.4</c:v>
                </c:pt>
                <c:pt idx="4305">
                  <c:v>3235.9</c:v>
                </c:pt>
                <c:pt idx="4307">
                  <c:v>1159.27</c:v>
                </c:pt>
                <c:pt idx="4312">
                  <c:v>1161.22</c:v>
                </c:pt>
                <c:pt idx="4318">
                  <c:v>1387.15</c:v>
                </c:pt>
                <c:pt idx="4321">
                  <c:v>1166.18</c:v>
                </c:pt>
                <c:pt idx="4322">
                  <c:v>949.32</c:v>
                </c:pt>
                <c:pt idx="4324">
                  <c:v>1813.32</c:v>
                </c:pt>
                <c:pt idx="4326">
                  <c:v>762.048</c:v>
                </c:pt>
                <c:pt idx="4332">
                  <c:v>709.34400000000005</c:v>
                </c:pt>
                <c:pt idx="4337">
                  <c:v>952.99199999999996</c:v>
                </c:pt>
                <c:pt idx="4340">
                  <c:v>1788.26</c:v>
                </c:pt>
                <c:pt idx="4343">
                  <c:v>1667.09</c:v>
                </c:pt>
                <c:pt idx="4345">
                  <c:v>687.96</c:v>
                </c:pt>
                <c:pt idx="4347">
                  <c:v>211.89599999999999</c:v>
                </c:pt>
                <c:pt idx="4350">
                  <c:v>500.904</c:v>
                </c:pt>
                <c:pt idx="4355">
                  <c:v>1307.23</c:v>
                </c:pt>
                <c:pt idx="4358">
                  <c:v>675.21600000000001</c:v>
                </c:pt>
                <c:pt idx="4362">
                  <c:v>834.84</c:v>
                </c:pt>
                <c:pt idx="4366">
                  <c:v>773.06399999999996</c:v>
                </c:pt>
                <c:pt idx="4368">
                  <c:v>1861.06</c:v>
                </c:pt>
                <c:pt idx="4369">
                  <c:v>717.76800000000003</c:v>
                </c:pt>
                <c:pt idx="4371">
                  <c:v>985.17600000000004</c:v>
                </c:pt>
                <c:pt idx="4376">
                  <c:v>1150.42</c:v>
                </c:pt>
                <c:pt idx="4377">
                  <c:v>524.44799999999998</c:v>
                </c:pt>
                <c:pt idx="4380">
                  <c:v>770.47199999999998</c:v>
                </c:pt>
                <c:pt idx="4384">
                  <c:v>1130.54</c:v>
                </c:pt>
                <c:pt idx="4386">
                  <c:v>722.08799999999997</c:v>
                </c:pt>
                <c:pt idx="4388">
                  <c:v>198.28800000000001</c:v>
                </c:pt>
                <c:pt idx="4392">
                  <c:v>442.15199999999999</c:v>
                </c:pt>
                <c:pt idx="4402">
                  <c:v>412.34399999999999</c:v>
                </c:pt>
                <c:pt idx="4407">
                  <c:v>1438.99</c:v>
                </c:pt>
                <c:pt idx="4409">
                  <c:v>1436.62</c:v>
                </c:pt>
                <c:pt idx="4413">
                  <c:v>1005.05</c:v>
                </c:pt>
                <c:pt idx="4417">
                  <c:v>984.096</c:v>
                </c:pt>
                <c:pt idx="4418">
                  <c:v>908.71199999999999</c:v>
                </c:pt>
                <c:pt idx="4422">
                  <c:v>1591.27</c:v>
                </c:pt>
                <c:pt idx="4423">
                  <c:v>1180.8699999999999</c:v>
                </c:pt>
                <c:pt idx="4424">
                  <c:v>844.56</c:v>
                </c:pt>
                <c:pt idx="4431">
                  <c:v>1037.02</c:v>
                </c:pt>
                <c:pt idx="4436">
                  <c:v>1178.5</c:v>
                </c:pt>
                <c:pt idx="4437">
                  <c:v>1517.4</c:v>
                </c:pt>
                <c:pt idx="4443">
                  <c:v>1345.25</c:v>
                </c:pt>
                <c:pt idx="4450">
                  <c:v>735.91200000000003</c:v>
                </c:pt>
                <c:pt idx="4451">
                  <c:v>4106.16</c:v>
                </c:pt>
                <c:pt idx="4453">
                  <c:v>881.928</c:v>
                </c:pt>
                <c:pt idx="4460">
                  <c:v>1258.8499999999999</c:v>
                </c:pt>
                <c:pt idx="4462">
                  <c:v>752.11199999999997</c:v>
                </c:pt>
                <c:pt idx="4464">
                  <c:v>876.31200000000001</c:v>
                </c:pt>
                <c:pt idx="4469">
                  <c:v>1295.1400000000001</c:v>
                </c:pt>
                <c:pt idx="4471">
                  <c:v>91.584000000000003</c:v>
                </c:pt>
                <c:pt idx="4472">
                  <c:v>949.75199999999995</c:v>
                </c:pt>
                <c:pt idx="4480">
                  <c:v>1106.78</c:v>
                </c:pt>
                <c:pt idx="4485">
                  <c:v>140.61600000000001</c:v>
                </c:pt>
                <c:pt idx="4487">
                  <c:v>803.08799999999997</c:v>
                </c:pt>
                <c:pt idx="4489">
                  <c:v>620.56799999999998</c:v>
                </c:pt>
                <c:pt idx="4490">
                  <c:v>1339.85</c:v>
                </c:pt>
                <c:pt idx="4492">
                  <c:v>1376.78</c:v>
                </c:pt>
                <c:pt idx="4493">
                  <c:v>2030.18</c:v>
                </c:pt>
                <c:pt idx="4499">
                  <c:v>998.35199999999998</c:v>
                </c:pt>
                <c:pt idx="4500">
                  <c:v>700.92</c:v>
                </c:pt>
                <c:pt idx="4503">
                  <c:v>1983.1</c:v>
                </c:pt>
                <c:pt idx="4506">
                  <c:v>207.792</c:v>
                </c:pt>
                <c:pt idx="4511">
                  <c:v>1020.38</c:v>
                </c:pt>
                <c:pt idx="4517">
                  <c:v>332.85599999999999</c:v>
                </c:pt>
                <c:pt idx="4518">
                  <c:v>930.52800000000002</c:v>
                </c:pt>
                <c:pt idx="4519">
                  <c:v>662.04</c:v>
                </c:pt>
                <c:pt idx="4521">
                  <c:v>118.36799999999999</c:v>
                </c:pt>
                <c:pt idx="4532">
                  <c:v>1178.5</c:v>
                </c:pt>
                <c:pt idx="4533">
                  <c:v>492.91199999999998</c:v>
                </c:pt>
                <c:pt idx="4534">
                  <c:v>700.48800000000006</c:v>
                </c:pt>
                <c:pt idx="4536">
                  <c:v>1042.42</c:v>
                </c:pt>
                <c:pt idx="4540">
                  <c:v>845.20799999999997</c:v>
                </c:pt>
                <c:pt idx="4541">
                  <c:v>1024.06</c:v>
                </c:pt>
                <c:pt idx="4543">
                  <c:v>423.57600000000002</c:v>
                </c:pt>
                <c:pt idx="4545">
                  <c:v>714.74400000000003</c:v>
                </c:pt>
                <c:pt idx="4550">
                  <c:v>1147.18</c:v>
                </c:pt>
                <c:pt idx="4554">
                  <c:v>693.79200000000003</c:v>
                </c:pt>
                <c:pt idx="4557">
                  <c:v>830.52</c:v>
                </c:pt>
                <c:pt idx="4560">
                  <c:v>1414.15</c:v>
                </c:pt>
                <c:pt idx="4563">
                  <c:v>660.96</c:v>
                </c:pt>
                <c:pt idx="4564">
                  <c:v>1059.26</c:v>
                </c:pt>
                <c:pt idx="4571">
                  <c:v>1399.25</c:v>
                </c:pt>
                <c:pt idx="4574">
                  <c:v>831.16800000000001</c:v>
                </c:pt>
                <c:pt idx="4575">
                  <c:v>717.98400000000004</c:v>
                </c:pt>
                <c:pt idx="4576">
                  <c:v>1148.04</c:v>
                </c:pt>
                <c:pt idx="4577">
                  <c:v>894.45600000000002</c:v>
                </c:pt>
                <c:pt idx="4578">
                  <c:v>1987.42</c:v>
                </c:pt>
                <c:pt idx="4581">
                  <c:v>700.70399999999995</c:v>
                </c:pt>
                <c:pt idx="4584">
                  <c:v>1529.28</c:v>
                </c:pt>
                <c:pt idx="4589">
                  <c:v>1064.45</c:v>
                </c:pt>
                <c:pt idx="4591">
                  <c:v>1189.94</c:v>
                </c:pt>
                <c:pt idx="4592">
                  <c:v>3575.66</c:v>
                </c:pt>
                <c:pt idx="4597">
                  <c:v>834.19200000000001</c:v>
                </c:pt>
                <c:pt idx="4605">
                  <c:v>893.59199999999998</c:v>
                </c:pt>
                <c:pt idx="4610">
                  <c:v>693.14400000000001</c:v>
                </c:pt>
                <c:pt idx="4619">
                  <c:v>1305.94</c:v>
                </c:pt>
                <c:pt idx="4620">
                  <c:v>800.28</c:v>
                </c:pt>
                <c:pt idx="4628">
                  <c:v>1203.55</c:v>
                </c:pt>
                <c:pt idx="4630">
                  <c:v>1271.1600000000001</c:v>
                </c:pt>
                <c:pt idx="4632">
                  <c:v>717.76800000000003</c:v>
                </c:pt>
                <c:pt idx="4633">
                  <c:v>1452.38</c:v>
                </c:pt>
                <c:pt idx="4636">
                  <c:v>526.17600000000004</c:v>
                </c:pt>
                <c:pt idx="4638">
                  <c:v>1437.7</c:v>
                </c:pt>
                <c:pt idx="4639">
                  <c:v>910.22400000000005</c:v>
                </c:pt>
                <c:pt idx="4640">
                  <c:v>1003.32</c:v>
                </c:pt>
                <c:pt idx="4641">
                  <c:v>2163.2399999999998</c:v>
                </c:pt>
                <c:pt idx="4644">
                  <c:v>1241.78</c:v>
                </c:pt>
                <c:pt idx="4646">
                  <c:v>885.38400000000001</c:v>
                </c:pt>
                <c:pt idx="4648">
                  <c:v>1435.1</c:v>
                </c:pt>
                <c:pt idx="4665">
                  <c:v>840.67200000000003</c:v>
                </c:pt>
                <c:pt idx="4671">
                  <c:v>1094.47</c:v>
                </c:pt>
                <c:pt idx="4683">
                  <c:v>695.08799999999997</c:v>
                </c:pt>
                <c:pt idx="4688">
                  <c:v>1121.9000000000001</c:v>
                </c:pt>
                <c:pt idx="4689">
                  <c:v>451.44</c:v>
                </c:pt>
                <c:pt idx="4691">
                  <c:v>916.27200000000005</c:v>
                </c:pt>
                <c:pt idx="4696">
                  <c:v>1023.84</c:v>
                </c:pt>
                <c:pt idx="4697">
                  <c:v>1276.99</c:v>
                </c:pt>
                <c:pt idx="4700">
                  <c:v>579.96</c:v>
                </c:pt>
                <c:pt idx="4703">
                  <c:v>1601.64</c:v>
                </c:pt>
                <c:pt idx="4704">
                  <c:v>529.41600000000005</c:v>
                </c:pt>
                <c:pt idx="4706">
                  <c:v>1268.57</c:v>
                </c:pt>
                <c:pt idx="4708">
                  <c:v>285.98399999999998</c:v>
                </c:pt>
                <c:pt idx="4709">
                  <c:v>1613.74</c:v>
                </c:pt>
                <c:pt idx="4712">
                  <c:v>1448.93</c:v>
                </c:pt>
                <c:pt idx="4719">
                  <c:v>930.96</c:v>
                </c:pt>
                <c:pt idx="4723">
                  <c:v>1145.02</c:v>
                </c:pt>
                <c:pt idx="4727">
                  <c:v>872.20799999999997</c:v>
                </c:pt>
                <c:pt idx="4730">
                  <c:v>1460.16</c:v>
                </c:pt>
                <c:pt idx="4734">
                  <c:v>1740.31</c:v>
                </c:pt>
                <c:pt idx="4735">
                  <c:v>2234.7399999999998</c:v>
                </c:pt>
                <c:pt idx="4740">
                  <c:v>1444.39</c:v>
                </c:pt>
                <c:pt idx="4741">
                  <c:v>968.54399999999998</c:v>
                </c:pt>
                <c:pt idx="4747">
                  <c:v>1409.4</c:v>
                </c:pt>
                <c:pt idx="4749">
                  <c:v>809.35199999999998</c:v>
                </c:pt>
                <c:pt idx="4755">
                  <c:v>2450.3000000000002</c:v>
                </c:pt>
                <c:pt idx="4761">
                  <c:v>1347.84</c:v>
                </c:pt>
                <c:pt idx="4765">
                  <c:v>1222.1300000000001</c:v>
                </c:pt>
                <c:pt idx="4766">
                  <c:v>844.77599999999995</c:v>
                </c:pt>
                <c:pt idx="4769">
                  <c:v>998.13599999999997</c:v>
                </c:pt>
                <c:pt idx="4772">
                  <c:v>749.08799999999997</c:v>
                </c:pt>
                <c:pt idx="4773">
                  <c:v>536.11199999999997</c:v>
                </c:pt>
                <c:pt idx="4776">
                  <c:v>746.28</c:v>
                </c:pt>
                <c:pt idx="4777">
                  <c:v>839.59199999999998</c:v>
                </c:pt>
                <c:pt idx="4780">
                  <c:v>1005.26</c:v>
                </c:pt>
                <c:pt idx="4786">
                  <c:v>3553.42</c:v>
                </c:pt>
                <c:pt idx="4789">
                  <c:v>1141.1300000000001</c:v>
                </c:pt>
                <c:pt idx="4790">
                  <c:v>915.40800000000002</c:v>
                </c:pt>
                <c:pt idx="4793">
                  <c:v>597.88800000000003</c:v>
                </c:pt>
                <c:pt idx="4794">
                  <c:v>903.52800000000002</c:v>
                </c:pt>
                <c:pt idx="4795">
                  <c:v>803.952</c:v>
                </c:pt>
                <c:pt idx="4800">
                  <c:v>894.24</c:v>
                </c:pt>
                <c:pt idx="4805">
                  <c:v>927.28800000000001</c:v>
                </c:pt>
                <c:pt idx="4808">
                  <c:v>854.06399999999996</c:v>
                </c:pt>
                <c:pt idx="4810">
                  <c:v>980.42399999999998</c:v>
                </c:pt>
                <c:pt idx="4814">
                  <c:v>1111.75</c:v>
                </c:pt>
                <c:pt idx="4818">
                  <c:v>816.48</c:v>
                </c:pt>
                <c:pt idx="4820">
                  <c:v>1333.58</c:v>
                </c:pt>
                <c:pt idx="4824">
                  <c:v>983.88</c:v>
                </c:pt>
                <c:pt idx="4828">
                  <c:v>342.79199999999997</c:v>
                </c:pt>
                <c:pt idx="4829">
                  <c:v>95.04</c:v>
                </c:pt>
                <c:pt idx="4836">
                  <c:v>270.86399999999998</c:v>
                </c:pt>
                <c:pt idx="4837">
                  <c:v>960.76800000000003</c:v>
                </c:pt>
                <c:pt idx="4844">
                  <c:v>170.85599999999999</c:v>
                </c:pt>
                <c:pt idx="4845">
                  <c:v>1327.97</c:v>
                </c:pt>
                <c:pt idx="4848">
                  <c:v>2093.2600000000002</c:v>
                </c:pt>
                <c:pt idx="4849">
                  <c:v>1079.3499999999999</c:v>
                </c:pt>
                <c:pt idx="4853">
                  <c:v>1655.64</c:v>
                </c:pt>
                <c:pt idx="4859">
                  <c:v>1196.8599999999999</c:v>
                </c:pt>
                <c:pt idx="4863">
                  <c:v>543.024</c:v>
                </c:pt>
                <c:pt idx="4866">
                  <c:v>751.46400000000006</c:v>
                </c:pt>
                <c:pt idx="4868">
                  <c:v>1146.96</c:v>
                </c:pt>
                <c:pt idx="4870">
                  <c:v>1238.1099999999999</c:v>
                </c:pt>
                <c:pt idx="4871">
                  <c:v>1271.3800000000001</c:v>
                </c:pt>
                <c:pt idx="4873">
                  <c:v>1211.98</c:v>
                </c:pt>
                <c:pt idx="4876">
                  <c:v>606.96</c:v>
                </c:pt>
                <c:pt idx="4877">
                  <c:v>811.29600000000005</c:v>
                </c:pt>
                <c:pt idx="4880">
                  <c:v>72.36</c:v>
                </c:pt>
                <c:pt idx="4886">
                  <c:v>686.88</c:v>
                </c:pt>
                <c:pt idx="4894">
                  <c:v>1051.49</c:v>
                </c:pt>
                <c:pt idx="4900">
                  <c:v>337.17599999999999</c:v>
                </c:pt>
                <c:pt idx="4906">
                  <c:v>1438.56</c:v>
                </c:pt>
                <c:pt idx="4912">
                  <c:v>1013.69</c:v>
                </c:pt>
                <c:pt idx="4916">
                  <c:v>856.00800000000004</c:v>
                </c:pt>
                <c:pt idx="4917">
                  <c:v>1247.83</c:v>
                </c:pt>
                <c:pt idx="4918">
                  <c:v>1159.49</c:v>
                </c:pt>
                <c:pt idx="4920">
                  <c:v>886.89599999999996</c:v>
                </c:pt>
                <c:pt idx="4924">
                  <c:v>1458.22</c:v>
                </c:pt>
                <c:pt idx="4928">
                  <c:v>5313.82</c:v>
                </c:pt>
                <c:pt idx="4933">
                  <c:v>823.17600000000004</c:v>
                </c:pt>
                <c:pt idx="4939">
                  <c:v>735.69600000000003</c:v>
                </c:pt>
                <c:pt idx="4941">
                  <c:v>768.52800000000002</c:v>
                </c:pt>
                <c:pt idx="4946">
                  <c:v>869.83199999999999</c:v>
                </c:pt>
                <c:pt idx="4950">
                  <c:v>1199.6600000000001</c:v>
                </c:pt>
                <c:pt idx="4954">
                  <c:v>657.28800000000001</c:v>
                </c:pt>
                <c:pt idx="4955">
                  <c:v>824.904</c:v>
                </c:pt>
                <c:pt idx="4957">
                  <c:v>1021.9</c:v>
                </c:pt>
                <c:pt idx="4958">
                  <c:v>775.87199999999996</c:v>
                </c:pt>
                <c:pt idx="4966">
                  <c:v>1756.08</c:v>
                </c:pt>
                <c:pt idx="4970">
                  <c:v>1299.46</c:v>
                </c:pt>
                <c:pt idx="4971">
                  <c:v>1611.14</c:v>
                </c:pt>
                <c:pt idx="4972">
                  <c:v>994.03200000000004</c:v>
                </c:pt>
                <c:pt idx="4978">
                  <c:v>2156.54</c:v>
                </c:pt>
                <c:pt idx="4979">
                  <c:v>1132.06</c:v>
                </c:pt>
                <c:pt idx="4984">
                  <c:v>945</c:v>
                </c:pt>
                <c:pt idx="4988">
                  <c:v>466.56</c:v>
                </c:pt>
                <c:pt idx="4989">
                  <c:v>925.77599999999995</c:v>
                </c:pt>
                <c:pt idx="4997">
                  <c:v>719.71199999999999</c:v>
                </c:pt>
                <c:pt idx="5006">
                  <c:v>726.19200000000001</c:v>
                </c:pt>
                <c:pt idx="5007">
                  <c:v>917.13599999999997</c:v>
                </c:pt>
                <c:pt idx="5012">
                  <c:v>1442.23</c:v>
                </c:pt>
                <c:pt idx="5019">
                  <c:v>858.81600000000003</c:v>
                </c:pt>
                <c:pt idx="5020">
                  <c:v>1269.6500000000001</c:v>
                </c:pt>
                <c:pt idx="5029">
                  <c:v>736.77599999999995</c:v>
                </c:pt>
                <c:pt idx="5030">
                  <c:v>1135.73</c:v>
                </c:pt>
                <c:pt idx="5031">
                  <c:v>1578.1</c:v>
                </c:pt>
                <c:pt idx="5033">
                  <c:v>1438.78</c:v>
                </c:pt>
                <c:pt idx="5037">
                  <c:v>428.54399999999998</c:v>
                </c:pt>
                <c:pt idx="5038">
                  <c:v>97.847999999999999</c:v>
                </c:pt>
                <c:pt idx="5040">
                  <c:v>1687.39</c:v>
                </c:pt>
                <c:pt idx="5051">
                  <c:v>1165.97</c:v>
                </c:pt>
                <c:pt idx="5060">
                  <c:v>1457.14</c:v>
                </c:pt>
                <c:pt idx="5061">
                  <c:v>960.33600000000001</c:v>
                </c:pt>
                <c:pt idx="5067">
                  <c:v>2526.98</c:v>
                </c:pt>
                <c:pt idx="5069">
                  <c:v>862.48800000000006</c:v>
                </c:pt>
                <c:pt idx="5070">
                  <c:v>1345.46</c:v>
                </c:pt>
                <c:pt idx="5072">
                  <c:v>823.17600000000004</c:v>
                </c:pt>
                <c:pt idx="5076">
                  <c:v>1029.24</c:v>
                </c:pt>
                <c:pt idx="5077">
                  <c:v>720.14400000000001</c:v>
                </c:pt>
                <c:pt idx="5078">
                  <c:v>782.35199999999998</c:v>
                </c:pt>
                <c:pt idx="5081">
                  <c:v>1675.08</c:v>
                </c:pt>
                <c:pt idx="5083">
                  <c:v>1756.08</c:v>
                </c:pt>
                <c:pt idx="5085">
                  <c:v>1148.47</c:v>
                </c:pt>
                <c:pt idx="5091">
                  <c:v>1058.83</c:v>
                </c:pt>
                <c:pt idx="5095">
                  <c:v>117.288</c:v>
                </c:pt>
                <c:pt idx="5096">
                  <c:v>955.36800000000005</c:v>
                </c:pt>
                <c:pt idx="5098">
                  <c:v>1065.31</c:v>
                </c:pt>
                <c:pt idx="5100">
                  <c:v>852.55200000000002</c:v>
                </c:pt>
                <c:pt idx="5101">
                  <c:v>901.15200000000004</c:v>
                </c:pt>
                <c:pt idx="5112">
                  <c:v>1620.43</c:v>
                </c:pt>
                <c:pt idx="5113">
                  <c:v>1588.03</c:v>
                </c:pt>
                <c:pt idx="5116">
                  <c:v>960.55200000000002</c:v>
                </c:pt>
                <c:pt idx="5126">
                  <c:v>1503.36</c:v>
                </c:pt>
                <c:pt idx="5137">
                  <c:v>884.30399999999997</c:v>
                </c:pt>
                <c:pt idx="5139">
                  <c:v>734.61599999999999</c:v>
                </c:pt>
                <c:pt idx="5142">
                  <c:v>1518.26</c:v>
                </c:pt>
                <c:pt idx="5143">
                  <c:v>984.96</c:v>
                </c:pt>
                <c:pt idx="5144">
                  <c:v>1442.02</c:v>
                </c:pt>
                <c:pt idx="5146">
                  <c:v>720.14400000000001</c:v>
                </c:pt>
                <c:pt idx="5149">
                  <c:v>812.59199999999998</c:v>
                </c:pt>
                <c:pt idx="5151">
                  <c:v>1007.21</c:v>
                </c:pt>
                <c:pt idx="5157">
                  <c:v>420.76799999999997</c:v>
                </c:pt>
                <c:pt idx="5159">
                  <c:v>1429.7</c:v>
                </c:pt>
                <c:pt idx="5161">
                  <c:v>747.14400000000001</c:v>
                </c:pt>
                <c:pt idx="5165">
                  <c:v>1596.24</c:v>
                </c:pt>
                <c:pt idx="5167">
                  <c:v>1541.81</c:v>
                </c:pt>
                <c:pt idx="5172">
                  <c:v>527.04</c:v>
                </c:pt>
                <c:pt idx="5180">
                  <c:v>1359.94</c:v>
                </c:pt>
                <c:pt idx="5182">
                  <c:v>1122.55</c:v>
                </c:pt>
                <c:pt idx="5189">
                  <c:v>1890.22</c:v>
                </c:pt>
                <c:pt idx="5194">
                  <c:v>1441.37</c:v>
                </c:pt>
                <c:pt idx="5195">
                  <c:v>1152.79</c:v>
                </c:pt>
                <c:pt idx="5196">
                  <c:v>1346.11</c:v>
                </c:pt>
                <c:pt idx="5197">
                  <c:v>923.4</c:v>
                </c:pt>
                <c:pt idx="5198">
                  <c:v>1775.09</c:v>
                </c:pt>
                <c:pt idx="5202">
                  <c:v>567.21600000000001</c:v>
                </c:pt>
                <c:pt idx="5213">
                  <c:v>1075.25</c:v>
                </c:pt>
                <c:pt idx="5214">
                  <c:v>113.616</c:v>
                </c:pt>
                <c:pt idx="5215">
                  <c:v>692.928</c:v>
                </c:pt>
                <c:pt idx="5219">
                  <c:v>758.16</c:v>
                </c:pt>
                <c:pt idx="5220">
                  <c:v>64.8</c:v>
                </c:pt>
                <c:pt idx="5223">
                  <c:v>434.37599999999998</c:v>
                </c:pt>
                <c:pt idx="5226">
                  <c:v>868.53599999999994</c:v>
                </c:pt>
                <c:pt idx="5239">
                  <c:v>547.99199999999996</c:v>
                </c:pt>
                <c:pt idx="5241">
                  <c:v>86.183999999999997</c:v>
                </c:pt>
                <c:pt idx="5246">
                  <c:v>1558.44</c:v>
                </c:pt>
                <c:pt idx="5256">
                  <c:v>676.08</c:v>
                </c:pt>
                <c:pt idx="5258">
                  <c:v>1020.6</c:v>
                </c:pt>
                <c:pt idx="5271">
                  <c:v>936.57600000000002</c:v>
                </c:pt>
                <c:pt idx="5273">
                  <c:v>2277.0700000000002</c:v>
                </c:pt>
                <c:pt idx="5275">
                  <c:v>1346.11</c:v>
                </c:pt>
                <c:pt idx="5276">
                  <c:v>1244.81</c:v>
                </c:pt>
                <c:pt idx="5278">
                  <c:v>787.32</c:v>
                </c:pt>
                <c:pt idx="5281">
                  <c:v>1080.6500000000001</c:v>
                </c:pt>
                <c:pt idx="5285">
                  <c:v>1238.54</c:v>
                </c:pt>
                <c:pt idx="5287">
                  <c:v>1271.81</c:v>
                </c:pt>
                <c:pt idx="5295">
                  <c:v>905.904</c:v>
                </c:pt>
                <c:pt idx="5296">
                  <c:v>1469.66</c:v>
                </c:pt>
                <c:pt idx="5301">
                  <c:v>993.6</c:v>
                </c:pt>
                <c:pt idx="5302">
                  <c:v>1408.97</c:v>
                </c:pt>
                <c:pt idx="5306">
                  <c:v>1527.55</c:v>
                </c:pt>
                <c:pt idx="5307">
                  <c:v>856.44</c:v>
                </c:pt>
                <c:pt idx="5311">
                  <c:v>1199.02</c:v>
                </c:pt>
                <c:pt idx="5312">
                  <c:v>986.04</c:v>
                </c:pt>
                <c:pt idx="5313">
                  <c:v>548.42399999999998</c:v>
                </c:pt>
                <c:pt idx="5317">
                  <c:v>543.24</c:v>
                </c:pt>
                <c:pt idx="5321">
                  <c:v>1736.42</c:v>
                </c:pt>
                <c:pt idx="5322">
                  <c:v>1487.16</c:v>
                </c:pt>
                <c:pt idx="5323">
                  <c:v>1064.23</c:v>
                </c:pt>
                <c:pt idx="5333">
                  <c:v>1379.59</c:v>
                </c:pt>
                <c:pt idx="5334">
                  <c:v>4387.82</c:v>
                </c:pt>
                <c:pt idx="5339">
                  <c:v>1445.04</c:v>
                </c:pt>
                <c:pt idx="5347">
                  <c:v>953.42399999999998</c:v>
                </c:pt>
                <c:pt idx="5348">
                  <c:v>1585.22</c:v>
                </c:pt>
                <c:pt idx="5352">
                  <c:v>644.54399999999998</c:v>
                </c:pt>
                <c:pt idx="5356">
                  <c:v>1282.3900000000001</c:v>
                </c:pt>
                <c:pt idx="5360">
                  <c:v>642.6</c:v>
                </c:pt>
                <c:pt idx="5366">
                  <c:v>941.32799999999997</c:v>
                </c:pt>
                <c:pt idx="5371">
                  <c:v>1433.59</c:v>
                </c:pt>
                <c:pt idx="5378">
                  <c:v>615.81600000000003</c:v>
                </c:pt>
                <c:pt idx="5379">
                  <c:v>1017.58</c:v>
                </c:pt>
                <c:pt idx="5381">
                  <c:v>875.44799999999998</c:v>
                </c:pt>
                <c:pt idx="5386">
                  <c:v>1043.28</c:v>
                </c:pt>
                <c:pt idx="5390">
                  <c:v>1460.81</c:v>
                </c:pt>
                <c:pt idx="5391">
                  <c:v>1317.6</c:v>
                </c:pt>
                <c:pt idx="5393">
                  <c:v>1592.57</c:v>
                </c:pt>
                <c:pt idx="5394">
                  <c:v>1964.09</c:v>
                </c:pt>
                <c:pt idx="5395">
                  <c:v>66.959999999999994</c:v>
                </c:pt>
                <c:pt idx="5396">
                  <c:v>1467.94</c:v>
                </c:pt>
                <c:pt idx="5404">
                  <c:v>1318.25</c:v>
                </c:pt>
                <c:pt idx="5407">
                  <c:v>932.904</c:v>
                </c:pt>
                <c:pt idx="5408">
                  <c:v>645.19200000000001</c:v>
                </c:pt>
                <c:pt idx="5428">
                  <c:v>805.68</c:v>
                </c:pt>
                <c:pt idx="5430">
                  <c:v>758.59199999999998</c:v>
                </c:pt>
                <c:pt idx="5431">
                  <c:v>2029.97</c:v>
                </c:pt>
                <c:pt idx="5437">
                  <c:v>934.63199999999995</c:v>
                </c:pt>
                <c:pt idx="5441">
                  <c:v>909.57600000000002</c:v>
                </c:pt>
                <c:pt idx="5444">
                  <c:v>1678.97</c:v>
                </c:pt>
                <c:pt idx="5446">
                  <c:v>1740.96</c:v>
                </c:pt>
                <c:pt idx="5450">
                  <c:v>1162.94</c:v>
                </c:pt>
                <c:pt idx="5451">
                  <c:v>635.68799999999999</c:v>
                </c:pt>
                <c:pt idx="5452">
                  <c:v>1412.21</c:v>
                </c:pt>
                <c:pt idx="5454">
                  <c:v>1541.59</c:v>
                </c:pt>
                <c:pt idx="5464">
                  <c:v>1481.54</c:v>
                </c:pt>
                <c:pt idx="5468">
                  <c:v>1028.5899999999999</c:v>
                </c:pt>
                <c:pt idx="5474">
                  <c:v>1038.53</c:v>
                </c:pt>
                <c:pt idx="5482">
                  <c:v>668.30399999999997</c:v>
                </c:pt>
                <c:pt idx="5485">
                  <c:v>3958.63</c:v>
                </c:pt>
                <c:pt idx="5486">
                  <c:v>717.76800000000003</c:v>
                </c:pt>
                <c:pt idx="5489">
                  <c:v>1215.8599999999999</c:v>
                </c:pt>
                <c:pt idx="5491">
                  <c:v>66.959999999999994</c:v>
                </c:pt>
                <c:pt idx="5495">
                  <c:v>1269.43</c:v>
                </c:pt>
                <c:pt idx="5496">
                  <c:v>1061.8599999999999</c:v>
                </c:pt>
                <c:pt idx="5498">
                  <c:v>1205.71</c:v>
                </c:pt>
                <c:pt idx="5506">
                  <c:v>1456.27</c:v>
                </c:pt>
                <c:pt idx="5509">
                  <c:v>1022.54</c:v>
                </c:pt>
                <c:pt idx="5511">
                  <c:v>1229.47</c:v>
                </c:pt>
                <c:pt idx="5512">
                  <c:v>3534.62</c:v>
                </c:pt>
                <c:pt idx="5513">
                  <c:v>1184.76</c:v>
                </c:pt>
                <c:pt idx="5515">
                  <c:v>919.94399999999996</c:v>
                </c:pt>
                <c:pt idx="5522">
                  <c:v>717.98400000000004</c:v>
                </c:pt>
                <c:pt idx="5528">
                  <c:v>233.28</c:v>
                </c:pt>
                <c:pt idx="5530">
                  <c:v>670.89599999999996</c:v>
                </c:pt>
                <c:pt idx="5535">
                  <c:v>581.25599999999997</c:v>
                </c:pt>
                <c:pt idx="5539">
                  <c:v>885.16800000000001</c:v>
                </c:pt>
                <c:pt idx="5546">
                  <c:v>557.928</c:v>
                </c:pt>
                <c:pt idx="5548">
                  <c:v>4163.3999999999996</c:v>
                </c:pt>
                <c:pt idx="5554">
                  <c:v>964.44</c:v>
                </c:pt>
                <c:pt idx="5560">
                  <c:v>993.81600000000003</c:v>
                </c:pt>
                <c:pt idx="5561">
                  <c:v>103.032</c:v>
                </c:pt>
                <c:pt idx="5564">
                  <c:v>1058.4000000000001</c:v>
                </c:pt>
                <c:pt idx="5571">
                  <c:v>644.32799999999997</c:v>
                </c:pt>
                <c:pt idx="5575">
                  <c:v>844.99199999999996</c:v>
                </c:pt>
                <c:pt idx="5577">
                  <c:v>683.85599999999999</c:v>
                </c:pt>
                <c:pt idx="5578">
                  <c:v>707.18399999999997</c:v>
                </c:pt>
                <c:pt idx="5579">
                  <c:v>823.60799999999995</c:v>
                </c:pt>
                <c:pt idx="5580">
                  <c:v>546.91200000000003</c:v>
                </c:pt>
                <c:pt idx="5584">
                  <c:v>1682.42</c:v>
                </c:pt>
                <c:pt idx="5590">
                  <c:v>1411.78</c:v>
                </c:pt>
                <c:pt idx="5592">
                  <c:v>494.85599999999999</c:v>
                </c:pt>
                <c:pt idx="5597">
                  <c:v>754.48800000000006</c:v>
                </c:pt>
                <c:pt idx="5602">
                  <c:v>454.464</c:v>
                </c:pt>
                <c:pt idx="5606">
                  <c:v>1713.96</c:v>
                </c:pt>
                <c:pt idx="5613">
                  <c:v>1036.3699999999999</c:v>
                </c:pt>
                <c:pt idx="5616">
                  <c:v>1846.58</c:v>
                </c:pt>
                <c:pt idx="5619">
                  <c:v>1065.31</c:v>
                </c:pt>
                <c:pt idx="5627">
                  <c:v>1357.34</c:v>
                </c:pt>
                <c:pt idx="5634">
                  <c:v>1121.47</c:v>
                </c:pt>
                <c:pt idx="5639">
                  <c:v>1366.42</c:v>
                </c:pt>
                <c:pt idx="5644">
                  <c:v>1532.52</c:v>
                </c:pt>
                <c:pt idx="5645">
                  <c:v>1710.72</c:v>
                </c:pt>
                <c:pt idx="5647">
                  <c:v>873.72</c:v>
                </c:pt>
                <c:pt idx="5649">
                  <c:v>828.57600000000002</c:v>
                </c:pt>
                <c:pt idx="5664">
                  <c:v>1335.74</c:v>
                </c:pt>
                <c:pt idx="5666">
                  <c:v>410.4</c:v>
                </c:pt>
                <c:pt idx="5668">
                  <c:v>1537.92</c:v>
                </c:pt>
                <c:pt idx="5669">
                  <c:v>1354.75</c:v>
                </c:pt>
                <c:pt idx="5671">
                  <c:v>1156.25</c:v>
                </c:pt>
                <c:pt idx="5672">
                  <c:v>1316.95</c:v>
                </c:pt>
                <c:pt idx="5674">
                  <c:v>559.44000000000005</c:v>
                </c:pt>
                <c:pt idx="5680">
                  <c:v>734.4</c:v>
                </c:pt>
                <c:pt idx="5685">
                  <c:v>1708.99</c:v>
                </c:pt>
                <c:pt idx="5687">
                  <c:v>1075.46</c:v>
                </c:pt>
                <c:pt idx="5689">
                  <c:v>1291.9000000000001</c:v>
                </c:pt>
                <c:pt idx="5691">
                  <c:v>952.99199999999996</c:v>
                </c:pt>
                <c:pt idx="5692">
                  <c:v>879.76800000000003</c:v>
                </c:pt>
                <c:pt idx="5693">
                  <c:v>1415.88</c:v>
                </c:pt>
                <c:pt idx="5696">
                  <c:v>699.62400000000002</c:v>
                </c:pt>
                <c:pt idx="5700">
                  <c:v>1168.1300000000001</c:v>
                </c:pt>
                <c:pt idx="5707">
                  <c:v>610.84799999999996</c:v>
                </c:pt>
                <c:pt idx="5716">
                  <c:v>1342.22</c:v>
                </c:pt>
                <c:pt idx="5720">
                  <c:v>86.616</c:v>
                </c:pt>
                <c:pt idx="5721">
                  <c:v>2129.98</c:v>
                </c:pt>
                <c:pt idx="5731">
                  <c:v>1517.62</c:v>
                </c:pt>
                <c:pt idx="5734">
                  <c:v>977.4</c:v>
                </c:pt>
                <c:pt idx="5735">
                  <c:v>1403.57</c:v>
                </c:pt>
                <c:pt idx="5739">
                  <c:v>1154.74</c:v>
                </c:pt>
                <c:pt idx="5740">
                  <c:v>713.88</c:v>
                </c:pt>
                <c:pt idx="5741">
                  <c:v>471.74400000000003</c:v>
                </c:pt>
                <c:pt idx="5746">
                  <c:v>1577.45</c:v>
                </c:pt>
                <c:pt idx="5747">
                  <c:v>939.81600000000003</c:v>
                </c:pt>
                <c:pt idx="5752">
                  <c:v>703.94399999999996</c:v>
                </c:pt>
                <c:pt idx="5759">
                  <c:v>553.60799999999995</c:v>
                </c:pt>
                <c:pt idx="5765">
                  <c:v>2098.87</c:v>
                </c:pt>
                <c:pt idx="5766">
                  <c:v>1043.28</c:v>
                </c:pt>
                <c:pt idx="5772">
                  <c:v>1189.94</c:v>
                </c:pt>
                <c:pt idx="5773">
                  <c:v>253.584</c:v>
                </c:pt>
                <c:pt idx="5777">
                  <c:v>394.84800000000001</c:v>
                </c:pt>
                <c:pt idx="5780">
                  <c:v>787.96799999999996</c:v>
                </c:pt>
                <c:pt idx="5801">
                  <c:v>997.70399999999995</c:v>
                </c:pt>
                <c:pt idx="5805">
                  <c:v>854.28</c:v>
                </c:pt>
                <c:pt idx="5809">
                  <c:v>1167.05</c:v>
                </c:pt>
                <c:pt idx="5811">
                  <c:v>1252.3699999999999</c:v>
                </c:pt>
                <c:pt idx="5814">
                  <c:v>1543.97</c:v>
                </c:pt>
                <c:pt idx="5815">
                  <c:v>817.12800000000004</c:v>
                </c:pt>
                <c:pt idx="5819">
                  <c:v>2148.77</c:v>
                </c:pt>
                <c:pt idx="5820">
                  <c:v>660.96</c:v>
                </c:pt>
                <c:pt idx="5822">
                  <c:v>1221.7</c:v>
                </c:pt>
                <c:pt idx="5823">
                  <c:v>1172.45</c:v>
                </c:pt>
                <c:pt idx="5824">
                  <c:v>820.8</c:v>
                </c:pt>
                <c:pt idx="5825">
                  <c:v>729</c:v>
                </c:pt>
                <c:pt idx="5826">
                  <c:v>448.63200000000001</c:v>
                </c:pt>
                <c:pt idx="5827">
                  <c:v>826.41600000000005</c:v>
                </c:pt>
                <c:pt idx="5829">
                  <c:v>858.81600000000003</c:v>
                </c:pt>
                <c:pt idx="5836">
                  <c:v>518.61599999999999</c:v>
                </c:pt>
                <c:pt idx="5845">
                  <c:v>1003.32</c:v>
                </c:pt>
                <c:pt idx="5848">
                  <c:v>738.93600000000004</c:v>
                </c:pt>
                <c:pt idx="5852">
                  <c:v>870.48</c:v>
                </c:pt>
                <c:pt idx="5854">
                  <c:v>1809</c:v>
                </c:pt>
                <c:pt idx="5856">
                  <c:v>63.503999999999998</c:v>
                </c:pt>
                <c:pt idx="5861">
                  <c:v>737.64</c:v>
                </c:pt>
                <c:pt idx="5872">
                  <c:v>777.6</c:v>
                </c:pt>
                <c:pt idx="5875">
                  <c:v>611.71199999999999</c:v>
                </c:pt>
                <c:pt idx="5879">
                  <c:v>1031.18</c:v>
                </c:pt>
                <c:pt idx="5880">
                  <c:v>436.32</c:v>
                </c:pt>
                <c:pt idx="5881">
                  <c:v>1217.5899999999999</c:v>
                </c:pt>
                <c:pt idx="5884">
                  <c:v>1752.62</c:v>
                </c:pt>
                <c:pt idx="5885">
                  <c:v>117.93600000000001</c:v>
                </c:pt>
                <c:pt idx="5886">
                  <c:v>1073.3</c:v>
                </c:pt>
                <c:pt idx="5895">
                  <c:v>851.25599999999997</c:v>
                </c:pt>
                <c:pt idx="5896">
                  <c:v>1317.6</c:v>
                </c:pt>
                <c:pt idx="5898">
                  <c:v>725.32799999999997</c:v>
                </c:pt>
                <c:pt idx="5899">
                  <c:v>1383.26</c:v>
                </c:pt>
                <c:pt idx="5905">
                  <c:v>713.66399999999999</c:v>
                </c:pt>
                <c:pt idx="5909">
                  <c:v>1333.37</c:v>
                </c:pt>
                <c:pt idx="5914">
                  <c:v>586.65599999999995</c:v>
                </c:pt>
                <c:pt idx="5915">
                  <c:v>946.51199999999994</c:v>
                </c:pt>
                <c:pt idx="5917">
                  <c:v>965.952</c:v>
                </c:pt>
                <c:pt idx="5918">
                  <c:v>1315.66</c:v>
                </c:pt>
                <c:pt idx="5934">
                  <c:v>628.55999999999995</c:v>
                </c:pt>
                <c:pt idx="5936">
                  <c:v>961.84799999999996</c:v>
                </c:pt>
                <c:pt idx="5938">
                  <c:v>916.05600000000004</c:v>
                </c:pt>
                <c:pt idx="5939">
                  <c:v>1876.61</c:v>
                </c:pt>
                <c:pt idx="5942">
                  <c:v>1507.9</c:v>
                </c:pt>
                <c:pt idx="5943">
                  <c:v>449.06400000000002</c:v>
                </c:pt>
                <c:pt idx="5944">
                  <c:v>1197.5</c:v>
                </c:pt>
                <c:pt idx="5946">
                  <c:v>544.53599999999994</c:v>
                </c:pt>
                <c:pt idx="5948">
                  <c:v>928.58399999999995</c:v>
                </c:pt>
                <c:pt idx="5952">
                  <c:v>1249.3399999999999</c:v>
                </c:pt>
                <c:pt idx="5955">
                  <c:v>1389.1</c:v>
                </c:pt>
                <c:pt idx="5968">
                  <c:v>673.48800000000006</c:v>
                </c:pt>
                <c:pt idx="5979">
                  <c:v>958.60799999999995</c:v>
                </c:pt>
                <c:pt idx="5985">
                  <c:v>2400.84</c:v>
                </c:pt>
                <c:pt idx="5986">
                  <c:v>1019.09</c:v>
                </c:pt>
                <c:pt idx="6005">
                  <c:v>1172.8800000000001</c:v>
                </c:pt>
                <c:pt idx="6006">
                  <c:v>1323.22</c:v>
                </c:pt>
                <c:pt idx="6011">
                  <c:v>1819.37</c:v>
                </c:pt>
                <c:pt idx="6012">
                  <c:v>688.82399999999996</c:v>
                </c:pt>
                <c:pt idx="6017">
                  <c:v>547.12800000000004</c:v>
                </c:pt>
                <c:pt idx="6018">
                  <c:v>681.91200000000003</c:v>
                </c:pt>
                <c:pt idx="6019">
                  <c:v>659.44799999999998</c:v>
                </c:pt>
                <c:pt idx="6020">
                  <c:v>1111.32</c:v>
                </c:pt>
                <c:pt idx="6021">
                  <c:v>396.36</c:v>
                </c:pt>
                <c:pt idx="6022">
                  <c:v>997.92</c:v>
                </c:pt>
                <c:pt idx="6024">
                  <c:v>106.92</c:v>
                </c:pt>
                <c:pt idx="6026">
                  <c:v>1095.77</c:v>
                </c:pt>
                <c:pt idx="6027">
                  <c:v>1691.5</c:v>
                </c:pt>
                <c:pt idx="6028">
                  <c:v>648.21600000000001</c:v>
                </c:pt>
                <c:pt idx="6031">
                  <c:v>1893.02</c:v>
                </c:pt>
                <c:pt idx="6042">
                  <c:v>608.04</c:v>
                </c:pt>
                <c:pt idx="6043">
                  <c:v>948.45600000000002</c:v>
                </c:pt>
                <c:pt idx="6046">
                  <c:v>725.76</c:v>
                </c:pt>
                <c:pt idx="6052">
                  <c:v>410.4</c:v>
                </c:pt>
                <c:pt idx="6053">
                  <c:v>768.31200000000001</c:v>
                </c:pt>
                <c:pt idx="6057">
                  <c:v>881.71199999999999</c:v>
                </c:pt>
                <c:pt idx="6061">
                  <c:v>1145.6600000000001</c:v>
                </c:pt>
                <c:pt idx="6062">
                  <c:v>82.512</c:v>
                </c:pt>
                <c:pt idx="6064">
                  <c:v>1262.52</c:v>
                </c:pt>
                <c:pt idx="6065">
                  <c:v>1503.79</c:v>
                </c:pt>
                <c:pt idx="6071">
                  <c:v>189</c:v>
                </c:pt>
                <c:pt idx="6073">
                  <c:v>831.38400000000001</c:v>
                </c:pt>
                <c:pt idx="6076">
                  <c:v>694.22400000000005</c:v>
                </c:pt>
                <c:pt idx="6082">
                  <c:v>236.73599999999999</c:v>
                </c:pt>
                <c:pt idx="6087">
                  <c:v>1487.59</c:v>
                </c:pt>
                <c:pt idx="6091">
                  <c:v>827.71199999999999</c:v>
                </c:pt>
                <c:pt idx="6096">
                  <c:v>1085.4000000000001</c:v>
                </c:pt>
                <c:pt idx="6097">
                  <c:v>972.64800000000002</c:v>
                </c:pt>
                <c:pt idx="6100">
                  <c:v>807.40800000000002</c:v>
                </c:pt>
                <c:pt idx="6107">
                  <c:v>909.14400000000001</c:v>
                </c:pt>
                <c:pt idx="6118">
                  <c:v>1894.75</c:v>
                </c:pt>
                <c:pt idx="6121">
                  <c:v>1491.48</c:v>
                </c:pt>
                <c:pt idx="6126">
                  <c:v>625.32000000000005</c:v>
                </c:pt>
                <c:pt idx="6127">
                  <c:v>402.40800000000002</c:v>
                </c:pt>
                <c:pt idx="6131">
                  <c:v>1039.6099999999999</c:v>
                </c:pt>
                <c:pt idx="6138">
                  <c:v>3782.38</c:v>
                </c:pt>
                <c:pt idx="6143">
                  <c:v>1444.61</c:v>
                </c:pt>
                <c:pt idx="6150">
                  <c:v>1115.21</c:v>
                </c:pt>
                <c:pt idx="6159">
                  <c:v>1226.23</c:v>
                </c:pt>
                <c:pt idx="6170">
                  <c:v>692.928</c:v>
                </c:pt>
                <c:pt idx="6171">
                  <c:v>1170.94</c:v>
                </c:pt>
                <c:pt idx="6173">
                  <c:v>186.84</c:v>
                </c:pt>
                <c:pt idx="6176">
                  <c:v>859.24800000000005</c:v>
                </c:pt>
                <c:pt idx="6181">
                  <c:v>850.82399999999996</c:v>
                </c:pt>
                <c:pt idx="6183">
                  <c:v>610.41600000000005</c:v>
                </c:pt>
                <c:pt idx="6184">
                  <c:v>1284.3399999999999</c:v>
                </c:pt>
                <c:pt idx="6187">
                  <c:v>1444.82</c:v>
                </c:pt>
                <c:pt idx="6190">
                  <c:v>93.528000000000006</c:v>
                </c:pt>
                <c:pt idx="6192">
                  <c:v>825.33600000000001</c:v>
                </c:pt>
                <c:pt idx="6195">
                  <c:v>1593</c:v>
                </c:pt>
                <c:pt idx="6210">
                  <c:v>1310.04</c:v>
                </c:pt>
                <c:pt idx="6212">
                  <c:v>508.68</c:v>
                </c:pt>
                <c:pt idx="6214">
                  <c:v>889.27200000000005</c:v>
                </c:pt>
                <c:pt idx="6215">
                  <c:v>3728.38</c:v>
                </c:pt>
                <c:pt idx="6221">
                  <c:v>677.37599999999998</c:v>
                </c:pt>
                <c:pt idx="6225">
                  <c:v>995.54399999999998</c:v>
                </c:pt>
                <c:pt idx="6226">
                  <c:v>978.69600000000003</c:v>
                </c:pt>
                <c:pt idx="6228">
                  <c:v>668.952</c:v>
                </c:pt>
                <c:pt idx="6229">
                  <c:v>1145.02</c:v>
                </c:pt>
                <c:pt idx="6234">
                  <c:v>265.464</c:v>
                </c:pt>
                <c:pt idx="6237">
                  <c:v>1909.22</c:v>
                </c:pt>
                <c:pt idx="6239">
                  <c:v>1218.24</c:v>
                </c:pt>
                <c:pt idx="6242">
                  <c:v>963.14400000000001</c:v>
                </c:pt>
                <c:pt idx="6243">
                  <c:v>640.87199999999996</c:v>
                </c:pt>
                <c:pt idx="6257">
                  <c:v>1855.44</c:v>
                </c:pt>
                <c:pt idx="6259">
                  <c:v>1171.3699999999999</c:v>
                </c:pt>
                <c:pt idx="6262">
                  <c:v>1295.3499999999999</c:v>
                </c:pt>
                <c:pt idx="6263">
                  <c:v>1401.41</c:v>
                </c:pt>
                <c:pt idx="6267">
                  <c:v>828.36</c:v>
                </c:pt>
                <c:pt idx="6274">
                  <c:v>1493.64</c:v>
                </c:pt>
                <c:pt idx="6275">
                  <c:v>94.608000000000004</c:v>
                </c:pt>
                <c:pt idx="6278">
                  <c:v>2693.3</c:v>
                </c:pt>
                <c:pt idx="6279">
                  <c:v>1854.79</c:v>
                </c:pt>
                <c:pt idx="6283">
                  <c:v>373.03199999999998</c:v>
                </c:pt>
                <c:pt idx="6285">
                  <c:v>1121.04</c:v>
                </c:pt>
                <c:pt idx="6295">
                  <c:v>1444.82</c:v>
                </c:pt>
                <c:pt idx="6296">
                  <c:v>1321.7</c:v>
                </c:pt>
                <c:pt idx="6297">
                  <c:v>1201.82</c:v>
                </c:pt>
                <c:pt idx="6299">
                  <c:v>826.2</c:v>
                </c:pt>
                <c:pt idx="6303">
                  <c:v>1043.5</c:v>
                </c:pt>
                <c:pt idx="6307">
                  <c:v>849.096</c:v>
                </c:pt>
                <c:pt idx="6308">
                  <c:v>965.952</c:v>
                </c:pt>
                <c:pt idx="6312">
                  <c:v>784.72799999999995</c:v>
                </c:pt>
                <c:pt idx="6327">
                  <c:v>1054.73</c:v>
                </c:pt>
                <c:pt idx="6329">
                  <c:v>843.26400000000001</c:v>
                </c:pt>
                <c:pt idx="6342">
                  <c:v>1311.34</c:v>
                </c:pt>
                <c:pt idx="6343">
                  <c:v>130.464</c:v>
                </c:pt>
                <c:pt idx="6345">
                  <c:v>1003.54</c:v>
                </c:pt>
                <c:pt idx="6347">
                  <c:v>1192.97</c:v>
                </c:pt>
                <c:pt idx="6348">
                  <c:v>1377.43</c:v>
                </c:pt>
                <c:pt idx="6354">
                  <c:v>914.54399999999998</c:v>
                </c:pt>
                <c:pt idx="6360">
                  <c:v>2029.54</c:v>
                </c:pt>
                <c:pt idx="6362">
                  <c:v>2182.25</c:v>
                </c:pt>
                <c:pt idx="6364">
                  <c:v>1580.04</c:v>
                </c:pt>
                <c:pt idx="6368">
                  <c:v>1583.28</c:v>
                </c:pt>
                <c:pt idx="6374">
                  <c:v>778.46400000000006</c:v>
                </c:pt>
                <c:pt idx="6375">
                  <c:v>1211.54</c:v>
                </c:pt>
                <c:pt idx="6376">
                  <c:v>988.84799999999996</c:v>
                </c:pt>
                <c:pt idx="6380">
                  <c:v>2069.06</c:v>
                </c:pt>
                <c:pt idx="6391">
                  <c:v>1022.11</c:v>
                </c:pt>
                <c:pt idx="6393">
                  <c:v>1596.67</c:v>
                </c:pt>
                <c:pt idx="6394">
                  <c:v>570.67200000000003</c:v>
                </c:pt>
                <c:pt idx="6398">
                  <c:v>954.072</c:v>
                </c:pt>
                <c:pt idx="6404">
                  <c:v>1164.67</c:v>
                </c:pt>
                <c:pt idx="6405">
                  <c:v>1774.22</c:v>
                </c:pt>
                <c:pt idx="6406">
                  <c:v>362.88</c:v>
                </c:pt>
                <c:pt idx="6412">
                  <c:v>280.584</c:v>
                </c:pt>
                <c:pt idx="6417">
                  <c:v>470.44799999999998</c:v>
                </c:pt>
                <c:pt idx="6419">
                  <c:v>349.27199999999999</c:v>
                </c:pt>
                <c:pt idx="6420">
                  <c:v>765.93600000000004</c:v>
                </c:pt>
                <c:pt idx="6422">
                  <c:v>641.73599999999999</c:v>
                </c:pt>
                <c:pt idx="6429">
                  <c:v>1066.82</c:v>
                </c:pt>
                <c:pt idx="6430">
                  <c:v>1114.78</c:v>
                </c:pt>
                <c:pt idx="6443">
                  <c:v>68.688000000000002</c:v>
                </c:pt>
                <c:pt idx="6448">
                  <c:v>175.608</c:v>
                </c:pt>
                <c:pt idx="6449">
                  <c:v>885.81600000000003</c:v>
                </c:pt>
                <c:pt idx="6450">
                  <c:v>856.22400000000005</c:v>
                </c:pt>
                <c:pt idx="6456">
                  <c:v>9086.9</c:v>
                </c:pt>
                <c:pt idx="6460">
                  <c:v>774.57600000000002</c:v>
                </c:pt>
                <c:pt idx="6463">
                  <c:v>1541.81</c:v>
                </c:pt>
                <c:pt idx="6469">
                  <c:v>1548.29</c:v>
                </c:pt>
                <c:pt idx="6472">
                  <c:v>638.928</c:v>
                </c:pt>
                <c:pt idx="6475">
                  <c:v>696.6</c:v>
                </c:pt>
                <c:pt idx="6478">
                  <c:v>766.36800000000005</c:v>
                </c:pt>
                <c:pt idx="6480">
                  <c:v>3303.29</c:v>
                </c:pt>
                <c:pt idx="6484">
                  <c:v>1589.11</c:v>
                </c:pt>
                <c:pt idx="6488">
                  <c:v>598.10400000000004</c:v>
                </c:pt>
                <c:pt idx="6489">
                  <c:v>1233.79</c:v>
                </c:pt>
                <c:pt idx="6501">
                  <c:v>1291.03</c:v>
                </c:pt>
                <c:pt idx="6503">
                  <c:v>1256.69</c:v>
                </c:pt>
                <c:pt idx="6504">
                  <c:v>2720.52</c:v>
                </c:pt>
                <c:pt idx="6507">
                  <c:v>1267.06</c:v>
                </c:pt>
                <c:pt idx="6509">
                  <c:v>1027.3</c:v>
                </c:pt>
                <c:pt idx="6516">
                  <c:v>1421.93</c:v>
                </c:pt>
                <c:pt idx="6524">
                  <c:v>562.46400000000006</c:v>
                </c:pt>
                <c:pt idx="6536">
                  <c:v>579.52800000000002</c:v>
                </c:pt>
                <c:pt idx="6545">
                  <c:v>1267.06</c:v>
                </c:pt>
                <c:pt idx="6550">
                  <c:v>324.21600000000001</c:v>
                </c:pt>
                <c:pt idx="6552">
                  <c:v>1027.94</c:v>
                </c:pt>
                <c:pt idx="6555">
                  <c:v>882.36</c:v>
                </c:pt>
                <c:pt idx="6558">
                  <c:v>1350.65</c:v>
                </c:pt>
                <c:pt idx="6563">
                  <c:v>835.92</c:v>
                </c:pt>
                <c:pt idx="6570">
                  <c:v>424.87200000000001</c:v>
                </c:pt>
                <c:pt idx="6572">
                  <c:v>692.06399999999996</c:v>
                </c:pt>
                <c:pt idx="6575">
                  <c:v>1614.17</c:v>
                </c:pt>
                <c:pt idx="6579">
                  <c:v>1431.86</c:v>
                </c:pt>
                <c:pt idx="6582">
                  <c:v>705.88800000000003</c:v>
                </c:pt>
                <c:pt idx="6583">
                  <c:v>756.43200000000002</c:v>
                </c:pt>
                <c:pt idx="6590">
                  <c:v>1832.33</c:v>
                </c:pt>
                <c:pt idx="6595">
                  <c:v>1528.85</c:v>
                </c:pt>
                <c:pt idx="6596">
                  <c:v>946.08</c:v>
                </c:pt>
                <c:pt idx="6598">
                  <c:v>335.88</c:v>
                </c:pt>
                <c:pt idx="6601">
                  <c:v>882.14400000000001</c:v>
                </c:pt>
                <c:pt idx="6605">
                  <c:v>4893.26</c:v>
                </c:pt>
                <c:pt idx="6606">
                  <c:v>762.69600000000003</c:v>
                </c:pt>
                <c:pt idx="6610">
                  <c:v>1077.6199999999999</c:v>
                </c:pt>
                <c:pt idx="6616">
                  <c:v>1092.0999999999999</c:v>
                </c:pt>
                <c:pt idx="6617">
                  <c:v>1416.53</c:v>
                </c:pt>
                <c:pt idx="6618">
                  <c:v>956.88</c:v>
                </c:pt>
                <c:pt idx="6621">
                  <c:v>1621.08</c:v>
                </c:pt>
                <c:pt idx="6625">
                  <c:v>790.34400000000005</c:v>
                </c:pt>
                <c:pt idx="6626">
                  <c:v>1213.49</c:v>
                </c:pt>
                <c:pt idx="6627">
                  <c:v>3009.31</c:v>
                </c:pt>
                <c:pt idx="6629">
                  <c:v>843.48</c:v>
                </c:pt>
                <c:pt idx="6631">
                  <c:v>487.512</c:v>
                </c:pt>
                <c:pt idx="6633">
                  <c:v>415.36799999999999</c:v>
                </c:pt>
                <c:pt idx="6634">
                  <c:v>7112.45</c:v>
                </c:pt>
                <c:pt idx="6635">
                  <c:v>4147.42</c:v>
                </c:pt>
                <c:pt idx="6639">
                  <c:v>2121.12</c:v>
                </c:pt>
                <c:pt idx="6644">
                  <c:v>868.32</c:v>
                </c:pt>
                <c:pt idx="6647">
                  <c:v>1421.93</c:v>
                </c:pt>
                <c:pt idx="6655">
                  <c:v>904.39200000000005</c:v>
                </c:pt>
                <c:pt idx="6668">
                  <c:v>463.10399999999998</c:v>
                </c:pt>
                <c:pt idx="6681">
                  <c:v>1791.72</c:v>
                </c:pt>
                <c:pt idx="6690">
                  <c:v>2739.53</c:v>
                </c:pt>
                <c:pt idx="6694">
                  <c:v>933.55200000000002</c:v>
                </c:pt>
                <c:pt idx="6704">
                  <c:v>986.04</c:v>
                </c:pt>
                <c:pt idx="6706">
                  <c:v>2007.07</c:v>
                </c:pt>
                <c:pt idx="6707">
                  <c:v>1891.08</c:v>
                </c:pt>
                <c:pt idx="6709">
                  <c:v>992.52</c:v>
                </c:pt>
                <c:pt idx="6713">
                  <c:v>714.096</c:v>
                </c:pt>
                <c:pt idx="6724">
                  <c:v>660.31200000000001</c:v>
                </c:pt>
                <c:pt idx="6725">
                  <c:v>1524.53</c:v>
                </c:pt>
                <c:pt idx="6732">
                  <c:v>1091.02</c:v>
                </c:pt>
                <c:pt idx="6735">
                  <c:v>451.65600000000001</c:v>
                </c:pt>
                <c:pt idx="6738">
                  <c:v>1505.09</c:v>
                </c:pt>
                <c:pt idx="6749">
                  <c:v>1289.3</c:v>
                </c:pt>
                <c:pt idx="6755">
                  <c:v>1210.25</c:v>
                </c:pt>
                <c:pt idx="6761">
                  <c:v>901.58399999999995</c:v>
                </c:pt>
                <c:pt idx="6762">
                  <c:v>1678.54</c:v>
                </c:pt>
                <c:pt idx="6766">
                  <c:v>866.59199999999998</c:v>
                </c:pt>
                <c:pt idx="6768">
                  <c:v>1356.48</c:v>
                </c:pt>
                <c:pt idx="6770">
                  <c:v>302.18400000000003</c:v>
                </c:pt>
                <c:pt idx="6777">
                  <c:v>1782.22</c:v>
                </c:pt>
                <c:pt idx="6779">
                  <c:v>1861.06</c:v>
                </c:pt>
                <c:pt idx="6781">
                  <c:v>1225.1500000000001</c:v>
                </c:pt>
                <c:pt idx="6784">
                  <c:v>763.12800000000004</c:v>
                </c:pt>
                <c:pt idx="6786">
                  <c:v>1506.82</c:v>
                </c:pt>
                <c:pt idx="6787">
                  <c:v>1008.07</c:v>
                </c:pt>
                <c:pt idx="6789">
                  <c:v>1159.49</c:v>
                </c:pt>
                <c:pt idx="6790">
                  <c:v>563.76</c:v>
                </c:pt>
                <c:pt idx="6796">
                  <c:v>2106.86</c:v>
                </c:pt>
                <c:pt idx="6798">
                  <c:v>1342.66</c:v>
                </c:pt>
                <c:pt idx="6799">
                  <c:v>923.18399999999997</c:v>
                </c:pt>
                <c:pt idx="6800">
                  <c:v>1051.49</c:v>
                </c:pt>
                <c:pt idx="6802">
                  <c:v>865.29600000000005</c:v>
                </c:pt>
                <c:pt idx="6805">
                  <c:v>948.024</c:v>
                </c:pt>
                <c:pt idx="6806">
                  <c:v>303.69600000000003</c:v>
                </c:pt>
                <c:pt idx="6807">
                  <c:v>3697.27</c:v>
                </c:pt>
                <c:pt idx="6824">
                  <c:v>827.928</c:v>
                </c:pt>
                <c:pt idx="6828">
                  <c:v>803.08799999999997</c:v>
                </c:pt>
                <c:pt idx="6832">
                  <c:v>548.85599999999999</c:v>
                </c:pt>
                <c:pt idx="6837">
                  <c:v>627.91200000000003</c:v>
                </c:pt>
                <c:pt idx="6838">
                  <c:v>1270.94</c:v>
                </c:pt>
                <c:pt idx="6843">
                  <c:v>854.28</c:v>
                </c:pt>
                <c:pt idx="6851">
                  <c:v>1667.74</c:v>
                </c:pt>
                <c:pt idx="6858">
                  <c:v>1318.46</c:v>
                </c:pt>
                <c:pt idx="6860">
                  <c:v>2493.94</c:v>
                </c:pt>
                <c:pt idx="6868">
                  <c:v>575.64</c:v>
                </c:pt>
                <c:pt idx="6871">
                  <c:v>1681.13</c:v>
                </c:pt>
                <c:pt idx="6877">
                  <c:v>1210.9000000000001</c:v>
                </c:pt>
                <c:pt idx="6878">
                  <c:v>808.92</c:v>
                </c:pt>
                <c:pt idx="6883">
                  <c:v>1627.56</c:v>
                </c:pt>
                <c:pt idx="6887">
                  <c:v>661.82399999999996</c:v>
                </c:pt>
                <c:pt idx="6889">
                  <c:v>1691.5</c:v>
                </c:pt>
                <c:pt idx="6890">
                  <c:v>2769.55</c:v>
                </c:pt>
                <c:pt idx="6891">
                  <c:v>772.63199999999995</c:v>
                </c:pt>
                <c:pt idx="6898">
                  <c:v>962.71199999999999</c:v>
                </c:pt>
                <c:pt idx="6902">
                  <c:v>4129.49</c:v>
                </c:pt>
                <c:pt idx="6906">
                  <c:v>443.23200000000003</c:v>
                </c:pt>
                <c:pt idx="6918">
                  <c:v>2387.02</c:v>
                </c:pt>
                <c:pt idx="6919">
                  <c:v>675</c:v>
                </c:pt>
                <c:pt idx="6922">
                  <c:v>1378.94</c:v>
                </c:pt>
                <c:pt idx="6924">
                  <c:v>658.15200000000004</c:v>
                </c:pt>
                <c:pt idx="6930">
                  <c:v>670.03200000000004</c:v>
                </c:pt>
                <c:pt idx="6932">
                  <c:v>870.26400000000001</c:v>
                </c:pt>
                <c:pt idx="6935">
                  <c:v>304.56</c:v>
                </c:pt>
                <c:pt idx="6948">
                  <c:v>1374.19</c:v>
                </c:pt>
                <c:pt idx="6949">
                  <c:v>1071.58</c:v>
                </c:pt>
                <c:pt idx="6954">
                  <c:v>962.06399999999996</c:v>
                </c:pt>
                <c:pt idx="6956">
                  <c:v>1054.51</c:v>
                </c:pt>
                <c:pt idx="6957">
                  <c:v>183.816</c:v>
                </c:pt>
                <c:pt idx="6958">
                  <c:v>643.46400000000006</c:v>
                </c:pt>
                <c:pt idx="6960">
                  <c:v>1399.46</c:v>
                </c:pt>
                <c:pt idx="6962">
                  <c:v>884.08799999999997</c:v>
                </c:pt>
                <c:pt idx="6965">
                  <c:v>1041.1199999999999</c:v>
                </c:pt>
                <c:pt idx="6968">
                  <c:v>989.49599999999998</c:v>
                </c:pt>
                <c:pt idx="6969">
                  <c:v>2164.3200000000002</c:v>
                </c:pt>
                <c:pt idx="6971">
                  <c:v>1673.35</c:v>
                </c:pt>
                <c:pt idx="6976">
                  <c:v>708.26400000000001</c:v>
                </c:pt>
                <c:pt idx="6984">
                  <c:v>1139.4000000000001</c:v>
                </c:pt>
                <c:pt idx="6987">
                  <c:v>1000.73</c:v>
                </c:pt>
                <c:pt idx="6988">
                  <c:v>1366.2</c:v>
                </c:pt>
                <c:pt idx="6989">
                  <c:v>649.08000000000004</c:v>
                </c:pt>
                <c:pt idx="6992">
                  <c:v>1196.42</c:v>
                </c:pt>
                <c:pt idx="6993">
                  <c:v>619.70399999999995</c:v>
                </c:pt>
                <c:pt idx="6998">
                  <c:v>1108.51</c:v>
                </c:pt>
                <c:pt idx="7002">
                  <c:v>951.048</c:v>
                </c:pt>
                <c:pt idx="7011">
                  <c:v>758.59199999999998</c:v>
                </c:pt>
                <c:pt idx="7012">
                  <c:v>1207.01</c:v>
                </c:pt>
                <c:pt idx="7015">
                  <c:v>1304.42</c:v>
                </c:pt>
                <c:pt idx="7020">
                  <c:v>1885.25</c:v>
                </c:pt>
                <c:pt idx="7028">
                  <c:v>1588.25</c:v>
                </c:pt>
                <c:pt idx="7031">
                  <c:v>1144.58</c:v>
                </c:pt>
                <c:pt idx="7032">
                  <c:v>1736.64</c:v>
                </c:pt>
                <c:pt idx="7040">
                  <c:v>2386.15</c:v>
                </c:pt>
                <c:pt idx="7042">
                  <c:v>744.33600000000001</c:v>
                </c:pt>
                <c:pt idx="7051">
                  <c:v>1693.44</c:v>
                </c:pt>
                <c:pt idx="7055">
                  <c:v>566.13599999999997</c:v>
                </c:pt>
                <c:pt idx="7059">
                  <c:v>976.53599999999994</c:v>
                </c:pt>
                <c:pt idx="7060">
                  <c:v>891.86400000000003</c:v>
                </c:pt>
                <c:pt idx="7074">
                  <c:v>1418.04</c:v>
                </c:pt>
                <c:pt idx="7076">
                  <c:v>1236.5999999999999</c:v>
                </c:pt>
                <c:pt idx="7080">
                  <c:v>629.20799999999997</c:v>
                </c:pt>
                <c:pt idx="7085">
                  <c:v>1510.27</c:v>
                </c:pt>
                <c:pt idx="7086">
                  <c:v>676.94399999999996</c:v>
                </c:pt>
                <c:pt idx="7089">
                  <c:v>1150.8499999999999</c:v>
                </c:pt>
                <c:pt idx="7091">
                  <c:v>1647.65</c:v>
                </c:pt>
                <c:pt idx="7095">
                  <c:v>708.48</c:v>
                </c:pt>
                <c:pt idx="7098">
                  <c:v>1276.56</c:v>
                </c:pt>
                <c:pt idx="7105">
                  <c:v>1871.86</c:v>
                </c:pt>
                <c:pt idx="7109">
                  <c:v>1074.5999999999999</c:v>
                </c:pt>
                <c:pt idx="7118">
                  <c:v>930.74400000000003</c:v>
                </c:pt>
                <c:pt idx="7121">
                  <c:v>1175.69</c:v>
                </c:pt>
                <c:pt idx="7123">
                  <c:v>418.392</c:v>
                </c:pt>
                <c:pt idx="7125">
                  <c:v>1676.16</c:v>
                </c:pt>
                <c:pt idx="7126">
                  <c:v>762.48</c:v>
                </c:pt>
                <c:pt idx="7129">
                  <c:v>973.08</c:v>
                </c:pt>
                <c:pt idx="7135">
                  <c:v>779.32799999999997</c:v>
                </c:pt>
                <c:pt idx="7147">
                  <c:v>1161.43</c:v>
                </c:pt>
                <c:pt idx="7152">
                  <c:v>1087.3399999999999</c:v>
                </c:pt>
                <c:pt idx="7158">
                  <c:v>953.42399999999998</c:v>
                </c:pt>
                <c:pt idx="7160">
                  <c:v>1420.42</c:v>
                </c:pt>
                <c:pt idx="7168">
                  <c:v>1258.42</c:v>
                </c:pt>
                <c:pt idx="7170">
                  <c:v>983.23199999999997</c:v>
                </c:pt>
                <c:pt idx="7174">
                  <c:v>1368.14</c:v>
                </c:pt>
                <c:pt idx="7176">
                  <c:v>1065.31</c:v>
                </c:pt>
                <c:pt idx="7184">
                  <c:v>770.47199999999998</c:v>
                </c:pt>
                <c:pt idx="7190">
                  <c:v>540.64800000000002</c:v>
                </c:pt>
                <c:pt idx="7195">
                  <c:v>876.31200000000001</c:v>
                </c:pt>
                <c:pt idx="7200">
                  <c:v>1037.23</c:v>
                </c:pt>
                <c:pt idx="7202">
                  <c:v>622.72799999999995</c:v>
                </c:pt>
                <c:pt idx="7203">
                  <c:v>1702.51</c:v>
                </c:pt>
                <c:pt idx="7207">
                  <c:v>1016.06</c:v>
                </c:pt>
                <c:pt idx="7210">
                  <c:v>1659.53</c:v>
                </c:pt>
                <c:pt idx="7213">
                  <c:v>1092.31</c:v>
                </c:pt>
                <c:pt idx="7217">
                  <c:v>2951.64</c:v>
                </c:pt>
                <c:pt idx="7219">
                  <c:v>796.82399999999996</c:v>
                </c:pt>
                <c:pt idx="7222">
                  <c:v>1536.19</c:v>
                </c:pt>
                <c:pt idx="7230">
                  <c:v>4933.87</c:v>
                </c:pt>
                <c:pt idx="7232">
                  <c:v>707.61599999999999</c:v>
                </c:pt>
                <c:pt idx="7233">
                  <c:v>1421.06</c:v>
                </c:pt>
                <c:pt idx="7235">
                  <c:v>1267.7</c:v>
                </c:pt>
                <c:pt idx="7236">
                  <c:v>2190.46</c:v>
                </c:pt>
                <c:pt idx="7246">
                  <c:v>1011.96</c:v>
                </c:pt>
                <c:pt idx="7247">
                  <c:v>1340.71</c:v>
                </c:pt>
                <c:pt idx="7250">
                  <c:v>875.01599999999996</c:v>
                </c:pt>
                <c:pt idx="7251">
                  <c:v>1402.27</c:v>
                </c:pt>
                <c:pt idx="7270">
                  <c:v>571.32000000000005</c:v>
                </c:pt>
                <c:pt idx="7273">
                  <c:v>1874.66</c:v>
                </c:pt>
                <c:pt idx="7275">
                  <c:v>1746.14</c:v>
                </c:pt>
                <c:pt idx="7276">
                  <c:v>422.49599999999998</c:v>
                </c:pt>
                <c:pt idx="7277">
                  <c:v>1227.0999999999999</c:v>
                </c:pt>
                <c:pt idx="7279">
                  <c:v>818.42399999999998</c:v>
                </c:pt>
                <c:pt idx="7283">
                  <c:v>1552.39</c:v>
                </c:pt>
                <c:pt idx="7285">
                  <c:v>1538.57</c:v>
                </c:pt>
                <c:pt idx="7287">
                  <c:v>1054.51</c:v>
                </c:pt>
                <c:pt idx="7302">
                  <c:v>865.94399999999996</c:v>
                </c:pt>
                <c:pt idx="7304">
                  <c:v>1197.5</c:v>
                </c:pt>
                <c:pt idx="7306">
                  <c:v>1141.1300000000001</c:v>
                </c:pt>
                <c:pt idx="7312">
                  <c:v>833.76</c:v>
                </c:pt>
                <c:pt idx="7313">
                  <c:v>366.55200000000002</c:v>
                </c:pt>
                <c:pt idx="7314">
                  <c:v>1114.56</c:v>
                </c:pt>
                <c:pt idx="7317">
                  <c:v>763.12800000000004</c:v>
                </c:pt>
                <c:pt idx="7323">
                  <c:v>1233.1400000000001</c:v>
                </c:pt>
                <c:pt idx="7329">
                  <c:v>1315.01</c:v>
                </c:pt>
                <c:pt idx="7330">
                  <c:v>916.05600000000004</c:v>
                </c:pt>
                <c:pt idx="7336">
                  <c:v>900.50400000000002</c:v>
                </c:pt>
                <c:pt idx="7354">
                  <c:v>1231.8499999999999</c:v>
                </c:pt>
                <c:pt idx="7359">
                  <c:v>723.6</c:v>
                </c:pt>
                <c:pt idx="7360">
                  <c:v>861.40800000000002</c:v>
                </c:pt>
                <c:pt idx="7365">
                  <c:v>3350.38</c:v>
                </c:pt>
                <c:pt idx="7366">
                  <c:v>1148.47</c:v>
                </c:pt>
                <c:pt idx="7371">
                  <c:v>1180.6600000000001</c:v>
                </c:pt>
                <c:pt idx="7375">
                  <c:v>571.53599999999994</c:v>
                </c:pt>
                <c:pt idx="7377">
                  <c:v>1075.9000000000001</c:v>
                </c:pt>
                <c:pt idx="7389">
                  <c:v>1092.74</c:v>
                </c:pt>
                <c:pt idx="7390">
                  <c:v>898.34400000000005</c:v>
                </c:pt>
                <c:pt idx="7391">
                  <c:v>1032.7</c:v>
                </c:pt>
                <c:pt idx="7396">
                  <c:v>738.72</c:v>
                </c:pt>
                <c:pt idx="7398">
                  <c:v>560.30399999999997</c:v>
                </c:pt>
                <c:pt idx="7405">
                  <c:v>2137.75</c:v>
                </c:pt>
                <c:pt idx="7413">
                  <c:v>1113.9100000000001</c:v>
                </c:pt>
                <c:pt idx="7417">
                  <c:v>711.72</c:v>
                </c:pt>
                <c:pt idx="7419">
                  <c:v>1031.6199999999999</c:v>
                </c:pt>
                <c:pt idx="7426">
                  <c:v>317.30399999999997</c:v>
                </c:pt>
                <c:pt idx="7427">
                  <c:v>1378.51</c:v>
                </c:pt>
                <c:pt idx="7436">
                  <c:v>925.12800000000004</c:v>
                </c:pt>
                <c:pt idx="7438">
                  <c:v>561.6</c:v>
                </c:pt>
                <c:pt idx="7439">
                  <c:v>7475.98</c:v>
                </c:pt>
                <c:pt idx="7444">
                  <c:v>7888.97</c:v>
                </c:pt>
                <c:pt idx="7445">
                  <c:v>1200.31</c:v>
                </c:pt>
                <c:pt idx="7446">
                  <c:v>876.74400000000003</c:v>
                </c:pt>
                <c:pt idx="7448">
                  <c:v>606.52800000000002</c:v>
                </c:pt>
                <c:pt idx="7457">
                  <c:v>1142.21</c:v>
                </c:pt>
                <c:pt idx="7459">
                  <c:v>1732.32</c:v>
                </c:pt>
                <c:pt idx="7477">
                  <c:v>1778.11</c:v>
                </c:pt>
                <c:pt idx="7479">
                  <c:v>184.68</c:v>
                </c:pt>
                <c:pt idx="7482">
                  <c:v>862.05600000000004</c:v>
                </c:pt>
                <c:pt idx="7484">
                  <c:v>7419.6</c:v>
                </c:pt>
                <c:pt idx="7485">
                  <c:v>1299.67</c:v>
                </c:pt>
                <c:pt idx="7490">
                  <c:v>1596.02</c:v>
                </c:pt>
                <c:pt idx="7496">
                  <c:v>900.072</c:v>
                </c:pt>
                <c:pt idx="7497">
                  <c:v>978.048</c:v>
                </c:pt>
                <c:pt idx="7505">
                  <c:v>1006.34</c:v>
                </c:pt>
                <c:pt idx="7512">
                  <c:v>631.15200000000004</c:v>
                </c:pt>
                <c:pt idx="7514">
                  <c:v>524.88</c:v>
                </c:pt>
                <c:pt idx="7516">
                  <c:v>1633.18</c:v>
                </c:pt>
                <c:pt idx="7518">
                  <c:v>2500.1999999999998</c:v>
                </c:pt>
                <c:pt idx="7522">
                  <c:v>637.63199999999995</c:v>
                </c:pt>
                <c:pt idx="7528">
                  <c:v>1716.55</c:v>
                </c:pt>
                <c:pt idx="7536">
                  <c:v>1732.97</c:v>
                </c:pt>
                <c:pt idx="7537">
                  <c:v>976.32</c:v>
                </c:pt>
                <c:pt idx="7539">
                  <c:v>1192.0999999999999</c:v>
                </c:pt>
                <c:pt idx="7542">
                  <c:v>831.38400000000001</c:v>
                </c:pt>
                <c:pt idx="7546">
                  <c:v>827.928</c:v>
                </c:pt>
                <c:pt idx="7547">
                  <c:v>924.048</c:v>
                </c:pt>
                <c:pt idx="7553">
                  <c:v>844.12800000000004</c:v>
                </c:pt>
                <c:pt idx="7555">
                  <c:v>921.24</c:v>
                </c:pt>
                <c:pt idx="7561">
                  <c:v>894.024</c:v>
                </c:pt>
                <c:pt idx="7575">
                  <c:v>1056.67</c:v>
                </c:pt>
                <c:pt idx="7578">
                  <c:v>627.91200000000003</c:v>
                </c:pt>
                <c:pt idx="7585">
                  <c:v>773.71199999999999</c:v>
                </c:pt>
                <c:pt idx="7586">
                  <c:v>557.06399999999996</c:v>
                </c:pt>
                <c:pt idx="7587">
                  <c:v>618.40800000000002</c:v>
                </c:pt>
                <c:pt idx="7589">
                  <c:v>425.08800000000002</c:v>
                </c:pt>
                <c:pt idx="7591">
                  <c:v>1020.6</c:v>
                </c:pt>
                <c:pt idx="7594">
                  <c:v>983.01599999999996</c:v>
                </c:pt>
                <c:pt idx="7595">
                  <c:v>1710.07</c:v>
                </c:pt>
                <c:pt idx="7600">
                  <c:v>987.98400000000004</c:v>
                </c:pt>
                <c:pt idx="7602">
                  <c:v>1358.42</c:v>
                </c:pt>
                <c:pt idx="7603">
                  <c:v>587.952</c:v>
                </c:pt>
                <c:pt idx="7610">
                  <c:v>923.18399999999997</c:v>
                </c:pt>
                <c:pt idx="7618">
                  <c:v>947.16</c:v>
                </c:pt>
                <c:pt idx="7630">
                  <c:v>435.67200000000003</c:v>
                </c:pt>
                <c:pt idx="7632">
                  <c:v>1146.74</c:v>
                </c:pt>
                <c:pt idx="7642">
                  <c:v>827.928</c:v>
                </c:pt>
                <c:pt idx="7643">
                  <c:v>176.904</c:v>
                </c:pt>
                <c:pt idx="7649">
                  <c:v>406.29599999999999</c:v>
                </c:pt>
                <c:pt idx="7650">
                  <c:v>1820.45</c:v>
                </c:pt>
                <c:pt idx="7653">
                  <c:v>1194.48</c:v>
                </c:pt>
                <c:pt idx="7655">
                  <c:v>878.04</c:v>
                </c:pt>
                <c:pt idx="7658">
                  <c:v>726.62400000000002</c:v>
                </c:pt>
                <c:pt idx="7659">
                  <c:v>963.57600000000002</c:v>
                </c:pt>
                <c:pt idx="7665">
                  <c:v>794.66399999999999</c:v>
                </c:pt>
                <c:pt idx="7669">
                  <c:v>852.55200000000002</c:v>
                </c:pt>
                <c:pt idx="7676">
                  <c:v>1252.1500000000001</c:v>
                </c:pt>
                <c:pt idx="7684">
                  <c:v>1097.28</c:v>
                </c:pt>
                <c:pt idx="7690">
                  <c:v>895.53599999999994</c:v>
                </c:pt>
                <c:pt idx="7691">
                  <c:v>1216.08</c:v>
                </c:pt>
                <c:pt idx="7696">
                  <c:v>254.88</c:v>
                </c:pt>
                <c:pt idx="7699">
                  <c:v>863.13599999999997</c:v>
                </c:pt>
                <c:pt idx="7701">
                  <c:v>1451.74</c:v>
                </c:pt>
                <c:pt idx="7706">
                  <c:v>1429.7</c:v>
                </c:pt>
                <c:pt idx="7713">
                  <c:v>1011.1</c:v>
                </c:pt>
                <c:pt idx="7717">
                  <c:v>1065.96</c:v>
                </c:pt>
                <c:pt idx="7724">
                  <c:v>719.49599999999998</c:v>
                </c:pt>
                <c:pt idx="7727">
                  <c:v>966.6</c:v>
                </c:pt>
                <c:pt idx="7733">
                  <c:v>935.28</c:v>
                </c:pt>
                <c:pt idx="7734">
                  <c:v>1148.47</c:v>
                </c:pt>
                <c:pt idx="7736">
                  <c:v>847.58399999999995</c:v>
                </c:pt>
                <c:pt idx="7737">
                  <c:v>1383.91</c:v>
                </c:pt>
                <c:pt idx="7744">
                  <c:v>266.76</c:v>
                </c:pt>
                <c:pt idx="7745">
                  <c:v>891.86400000000003</c:v>
                </c:pt>
                <c:pt idx="7746">
                  <c:v>1656.5</c:v>
                </c:pt>
                <c:pt idx="7747">
                  <c:v>1364.26</c:v>
                </c:pt>
                <c:pt idx="7748">
                  <c:v>1112.4000000000001</c:v>
                </c:pt>
                <c:pt idx="7752">
                  <c:v>1270.51</c:v>
                </c:pt>
                <c:pt idx="7755">
                  <c:v>563.32799999999997</c:v>
                </c:pt>
                <c:pt idx="7760">
                  <c:v>1669.9</c:v>
                </c:pt>
                <c:pt idx="7763">
                  <c:v>1850.26</c:v>
                </c:pt>
                <c:pt idx="7768">
                  <c:v>1059.7</c:v>
                </c:pt>
                <c:pt idx="7772">
                  <c:v>72.792000000000002</c:v>
                </c:pt>
                <c:pt idx="7774">
                  <c:v>1095.98</c:v>
                </c:pt>
                <c:pt idx="7776">
                  <c:v>1368.79</c:v>
                </c:pt>
                <c:pt idx="7781">
                  <c:v>588.38400000000001</c:v>
                </c:pt>
                <c:pt idx="7783">
                  <c:v>525.74400000000003</c:v>
                </c:pt>
                <c:pt idx="7793">
                  <c:v>1178.28</c:v>
                </c:pt>
                <c:pt idx="7799">
                  <c:v>1141.99</c:v>
                </c:pt>
                <c:pt idx="7802">
                  <c:v>1163.5899999999999</c:v>
                </c:pt>
                <c:pt idx="7805">
                  <c:v>1142.8599999999999</c:v>
                </c:pt>
                <c:pt idx="7820">
                  <c:v>954.072</c:v>
                </c:pt>
                <c:pt idx="7822">
                  <c:v>682.34400000000005</c:v>
                </c:pt>
                <c:pt idx="7823">
                  <c:v>1321.7</c:v>
                </c:pt>
                <c:pt idx="7824">
                  <c:v>1066.3900000000001</c:v>
                </c:pt>
                <c:pt idx="7833">
                  <c:v>1141.78</c:v>
                </c:pt>
                <c:pt idx="7839">
                  <c:v>710.64</c:v>
                </c:pt>
                <c:pt idx="7844">
                  <c:v>825.76800000000003</c:v>
                </c:pt>
                <c:pt idx="7847">
                  <c:v>1403.78</c:v>
                </c:pt>
                <c:pt idx="7848">
                  <c:v>219.672</c:v>
                </c:pt>
                <c:pt idx="7852">
                  <c:v>432.43200000000002</c:v>
                </c:pt>
                <c:pt idx="7854">
                  <c:v>1607.04</c:v>
                </c:pt>
                <c:pt idx="7855">
                  <c:v>662.68799999999999</c:v>
                </c:pt>
                <c:pt idx="7863">
                  <c:v>2031.05</c:v>
                </c:pt>
                <c:pt idx="7864">
                  <c:v>1105.06</c:v>
                </c:pt>
                <c:pt idx="7867">
                  <c:v>943.27200000000005</c:v>
                </c:pt>
                <c:pt idx="7868">
                  <c:v>1063.3699999999999</c:v>
                </c:pt>
                <c:pt idx="7879">
                  <c:v>864</c:v>
                </c:pt>
                <c:pt idx="7880">
                  <c:v>1798.85</c:v>
                </c:pt>
                <c:pt idx="7882">
                  <c:v>1874.02</c:v>
                </c:pt>
                <c:pt idx="7893">
                  <c:v>220.536</c:v>
                </c:pt>
                <c:pt idx="7894">
                  <c:v>1141.99</c:v>
                </c:pt>
                <c:pt idx="7895">
                  <c:v>1120.6099999999999</c:v>
                </c:pt>
                <c:pt idx="7897">
                  <c:v>780.62400000000002</c:v>
                </c:pt>
                <c:pt idx="7899">
                  <c:v>613.44000000000005</c:v>
                </c:pt>
                <c:pt idx="7900">
                  <c:v>1776.6</c:v>
                </c:pt>
                <c:pt idx="7907">
                  <c:v>1021.03</c:v>
                </c:pt>
                <c:pt idx="7909">
                  <c:v>937.65599999999995</c:v>
                </c:pt>
                <c:pt idx="7913">
                  <c:v>356.83199999999999</c:v>
                </c:pt>
                <c:pt idx="7914">
                  <c:v>1054.94</c:v>
                </c:pt>
                <c:pt idx="7916">
                  <c:v>589.03200000000004</c:v>
                </c:pt>
                <c:pt idx="7921">
                  <c:v>1262.0899999999999</c:v>
                </c:pt>
                <c:pt idx="7923">
                  <c:v>625.10400000000004</c:v>
                </c:pt>
                <c:pt idx="7924">
                  <c:v>1185.6199999999999</c:v>
                </c:pt>
                <c:pt idx="7927">
                  <c:v>1863.65</c:v>
                </c:pt>
                <c:pt idx="7933">
                  <c:v>1263.5999999999999</c:v>
                </c:pt>
                <c:pt idx="7938">
                  <c:v>968.76</c:v>
                </c:pt>
                <c:pt idx="7948">
                  <c:v>1615.25</c:v>
                </c:pt>
                <c:pt idx="7953">
                  <c:v>1256.69</c:v>
                </c:pt>
                <c:pt idx="7963">
                  <c:v>1283.69</c:v>
                </c:pt>
                <c:pt idx="7966">
                  <c:v>473.25599999999997</c:v>
                </c:pt>
                <c:pt idx="7974">
                  <c:v>453.38400000000001</c:v>
                </c:pt>
                <c:pt idx="7978">
                  <c:v>1690.2</c:v>
                </c:pt>
                <c:pt idx="7981">
                  <c:v>998.13599999999997</c:v>
                </c:pt>
                <c:pt idx="7988">
                  <c:v>610.84799999999996</c:v>
                </c:pt>
                <c:pt idx="7992">
                  <c:v>1086.05</c:v>
                </c:pt>
                <c:pt idx="7995">
                  <c:v>668.73599999999999</c:v>
                </c:pt>
                <c:pt idx="8000">
                  <c:v>1178.06</c:v>
                </c:pt>
                <c:pt idx="8003">
                  <c:v>817.56</c:v>
                </c:pt>
                <c:pt idx="8005">
                  <c:v>1626.05</c:v>
                </c:pt>
                <c:pt idx="8009">
                  <c:v>1275.7</c:v>
                </c:pt>
                <c:pt idx="8016">
                  <c:v>754.92</c:v>
                </c:pt>
                <c:pt idx="8017">
                  <c:v>707.18399999999997</c:v>
                </c:pt>
                <c:pt idx="8021">
                  <c:v>1015.63</c:v>
                </c:pt>
                <c:pt idx="8023">
                  <c:v>496.584</c:v>
                </c:pt>
                <c:pt idx="8027">
                  <c:v>1380.02</c:v>
                </c:pt>
                <c:pt idx="8034">
                  <c:v>1914.41</c:v>
                </c:pt>
                <c:pt idx="8040">
                  <c:v>1493.86</c:v>
                </c:pt>
                <c:pt idx="8041">
                  <c:v>1241.3499999999999</c:v>
                </c:pt>
                <c:pt idx="8047">
                  <c:v>411.048</c:v>
                </c:pt>
                <c:pt idx="8050">
                  <c:v>768.096</c:v>
                </c:pt>
                <c:pt idx="8056">
                  <c:v>7486.56</c:v>
                </c:pt>
                <c:pt idx="8057">
                  <c:v>1435.1</c:v>
                </c:pt>
                <c:pt idx="8058">
                  <c:v>942.62400000000002</c:v>
                </c:pt>
                <c:pt idx="8062">
                  <c:v>777.16800000000001</c:v>
                </c:pt>
                <c:pt idx="8070">
                  <c:v>1193.6199999999999</c:v>
                </c:pt>
                <c:pt idx="8078">
                  <c:v>753.40800000000002</c:v>
                </c:pt>
                <c:pt idx="8081">
                  <c:v>864</c:v>
                </c:pt>
                <c:pt idx="8086">
                  <c:v>4796.28</c:v>
                </c:pt>
                <c:pt idx="8093">
                  <c:v>1575.29</c:v>
                </c:pt>
                <c:pt idx="8094">
                  <c:v>1030.54</c:v>
                </c:pt>
                <c:pt idx="8095">
                  <c:v>736.99199999999996</c:v>
                </c:pt>
                <c:pt idx="8098">
                  <c:v>1734.26</c:v>
                </c:pt>
                <c:pt idx="8111">
                  <c:v>699.19200000000001</c:v>
                </c:pt>
                <c:pt idx="8114">
                  <c:v>880.2</c:v>
                </c:pt>
                <c:pt idx="8117">
                  <c:v>1174.6099999999999</c:v>
                </c:pt>
                <c:pt idx="8118">
                  <c:v>944.56799999999998</c:v>
                </c:pt>
                <c:pt idx="8119">
                  <c:v>935.71199999999999</c:v>
                </c:pt>
                <c:pt idx="8122">
                  <c:v>660.31200000000001</c:v>
                </c:pt>
                <c:pt idx="8123">
                  <c:v>1011.31</c:v>
                </c:pt>
                <c:pt idx="8125">
                  <c:v>1563.62</c:v>
                </c:pt>
                <c:pt idx="8126">
                  <c:v>894.45600000000002</c:v>
                </c:pt>
                <c:pt idx="8132">
                  <c:v>470.44799999999998</c:v>
                </c:pt>
                <c:pt idx="8139">
                  <c:v>1015.63</c:v>
                </c:pt>
                <c:pt idx="8140">
                  <c:v>840.24</c:v>
                </c:pt>
                <c:pt idx="8153">
                  <c:v>528.12</c:v>
                </c:pt>
                <c:pt idx="8166">
                  <c:v>886.24800000000005</c:v>
                </c:pt>
                <c:pt idx="8167">
                  <c:v>695.52</c:v>
                </c:pt>
                <c:pt idx="8173">
                  <c:v>734.61599999999999</c:v>
                </c:pt>
                <c:pt idx="8174">
                  <c:v>1434.24</c:v>
                </c:pt>
                <c:pt idx="8175">
                  <c:v>949.10400000000004</c:v>
                </c:pt>
                <c:pt idx="8176">
                  <c:v>1391.04</c:v>
                </c:pt>
                <c:pt idx="8183">
                  <c:v>1685.66</c:v>
                </c:pt>
                <c:pt idx="8184">
                  <c:v>1309.82</c:v>
                </c:pt>
                <c:pt idx="8193">
                  <c:v>1080</c:v>
                </c:pt>
                <c:pt idx="8195">
                  <c:v>926.64</c:v>
                </c:pt>
                <c:pt idx="8197">
                  <c:v>720.79200000000003</c:v>
                </c:pt>
                <c:pt idx="8199">
                  <c:v>886.68</c:v>
                </c:pt>
                <c:pt idx="8201">
                  <c:v>1373.11</c:v>
                </c:pt>
                <c:pt idx="8205">
                  <c:v>566.35199999999998</c:v>
                </c:pt>
                <c:pt idx="8206">
                  <c:v>1299.8900000000001</c:v>
                </c:pt>
                <c:pt idx="8207">
                  <c:v>876.52800000000002</c:v>
                </c:pt>
                <c:pt idx="8209">
                  <c:v>756.21600000000001</c:v>
                </c:pt>
                <c:pt idx="8210">
                  <c:v>521.64</c:v>
                </c:pt>
                <c:pt idx="8217">
                  <c:v>762.48</c:v>
                </c:pt>
                <c:pt idx="8227">
                  <c:v>794.88</c:v>
                </c:pt>
                <c:pt idx="8228">
                  <c:v>1249.99</c:v>
                </c:pt>
                <c:pt idx="8230">
                  <c:v>474.76799999999997</c:v>
                </c:pt>
                <c:pt idx="8232">
                  <c:v>1095.98</c:v>
                </c:pt>
                <c:pt idx="8233">
                  <c:v>1811.38</c:v>
                </c:pt>
                <c:pt idx="8237">
                  <c:v>933.33600000000001</c:v>
                </c:pt>
                <c:pt idx="8241">
                  <c:v>836.13599999999997</c:v>
                </c:pt>
                <c:pt idx="8242">
                  <c:v>982.15200000000004</c:v>
                </c:pt>
                <c:pt idx="8246">
                  <c:v>1297.94</c:v>
                </c:pt>
                <c:pt idx="8251">
                  <c:v>1090.3699999999999</c:v>
                </c:pt>
                <c:pt idx="8254">
                  <c:v>1221.9100000000001</c:v>
                </c:pt>
                <c:pt idx="8255">
                  <c:v>748.44</c:v>
                </c:pt>
                <c:pt idx="8264">
                  <c:v>1451.74</c:v>
                </c:pt>
                <c:pt idx="8269">
                  <c:v>1214.1400000000001</c:v>
                </c:pt>
                <c:pt idx="8270">
                  <c:v>1211.76</c:v>
                </c:pt>
                <c:pt idx="8272">
                  <c:v>699.62400000000002</c:v>
                </c:pt>
                <c:pt idx="8276">
                  <c:v>932.04</c:v>
                </c:pt>
                <c:pt idx="8278">
                  <c:v>1728.22</c:v>
                </c:pt>
                <c:pt idx="8282">
                  <c:v>1149.98</c:v>
                </c:pt>
                <c:pt idx="8283">
                  <c:v>945.21600000000001</c:v>
                </c:pt>
                <c:pt idx="8289">
                  <c:v>1167.7</c:v>
                </c:pt>
                <c:pt idx="8293">
                  <c:v>992.30399999999997</c:v>
                </c:pt>
                <c:pt idx="8294">
                  <c:v>1082.3800000000001</c:v>
                </c:pt>
                <c:pt idx="8296">
                  <c:v>822.52800000000002</c:v>
                </c:pt>
                <c:pt idx="8310">
                  <c:v>1690.63</c:v>
                </c:pt>
                <c:pt idx="8311">
                  <c:v>740.01599999999996</c:v>
                </c:pt>
                <c:pt idx="8313">
                  <c:v>1965.17</c:v>
                </c:pt>
                <c:pt idx="8317">
                  <c:v>1397.09</c:v>
                </c:pt>
                <c:pt idx="8319">
                  <c:v>1439.42</c:v>
                </c:pt>
                <c:pt idx="8320">
                  <c:v>2762.21</c:v>
                </c:pt>
                <c:pt idx="8330">
                  <c:v>997.05600000000004</c:v>
                </c:pt>
                <c:pt idx="8335">
                  <c:v>781.05600000000004</c:v>
                </c:pt>
                <c:pt idx="8337">
                  <c:v>463.96800000000002</c:v>
                </c:pt>
                <c:pt idx="8339">
                  <c:v>7969.54</c:v>
                </c:pt>
                <c:pt idx="8340">
                  <c:v>968.76</c:v>
                </c:pt>
                <c:pt idx="8341">
                  <c:v>620.35199999999998</c:v>
                </c:pt>
                <c:pt idx="8349">
                  <c:v>1086.9100000000001</c:v>
                </c:pt>
                <c:pt idx="8354">
                  <c:v>277.34399999999999</c:v>
                </c:pt>
                <c:pt idx="8359">
                  <c:v>886.46400000000006</c:v>
                </c:pt>
                <c:pt idx="8364">
                  <c:v>966.81600000000003</c:v>
                </c:pt>
                <c:pt idx="8365">
                  <c:v>228.96</c:v>
                </c:pt>
                <c:pt idx="8376">
                  <c:v>636.76800000000003</c:v>
                </c:pt>
                <c:pt idx="8382">
                  <c:v>837.86400000000003</c:v>
                </c:pt>
                <c:pt idx="8383">
                  <c:v>711.28800000000001</c:v>
                </c:pt>
                <c:pt idx="8388">
                  <c:v>717.98400000000004</c:v>
                </c:pt>
                <c:pt idx="8390">
                  <c:v>1265.76</c:v>
                </c:pt>
                <c:pt idx="8397">
                  <c:v>344.08800000000002</c:v>
                </c:pt>
                <c:pt idx="8399">
                  <c:v>368.06400000000002</c:v>
                </c:pt>
                <c:pt idx="8400">
                  <c:v>987.33600000000001</c:v>
                </c:pt>
                <c:pt idx="8401">
                  <c:v>999.43200000000002</c:v>
                </c:pt>
                <c:pt idx="8402">
                  <c:v>194.83199999999999</c:v>
                </c:pt>
                <c:pt idx="8410">
                  <c:v>116.85599999999999</c:v>
                </c:pt>
                <c:pt idx="8415">
                  <c:v>1352.81</c:v>
                </c:pt>
                <c:pt idx="8422">
                  <c:v>1109.5899999999999</c:v>
                </c:pt>
                <c:pt idx="8423">
                  <c:v>1339.42</c:v>
                </c:pt>
                <c:pt idx="8424">
                  <c:v>1217.81</c:v>
                </c:pt>
                <c:pt idx="8426">
                  <c:v>895.96799999999996</c:v>
                </c:pt>
                <c:pt idx="8427">
                  <c:v>125.496</c:v>
                </c:pt>
                <c:pt idx="8428">
                  <c:v>716.904</c:v>
                </c:pt>
                <c:pt idx="8429">
                  <c:v>1139.83</c:v>
                </c:pt>
                <c:pt idx="8434">
                  <c:v>413.64</c:v>
                </c:pt>
                <c:pt idx="8435">
                  <c:v>2830.68</c:v>
                </c:pt>
                <c:pt idx="8436">
                  <c:v>1133.57</c:v>
                </c:pt>
                <c:pt idx="8437">
                  <c:v>2821.18</c:v>
                </c:pt>
                <c:pt idx="8441">
                  <c:v>703.94399999999996</c:v>
                </c:pt>
                <c:pt idx="8442">
                  <c:v>2267.5700000000002</c:v>
                </c:pt>
                <c:pt idx="8445">
                  <c:v>1307.02</c:v>
                </c:pt>
                <c:pt idx="8450">
                  <c:v>972</c:v>
                </c:pt>
                <c:pt idx="8452">
                  <c:v>353.59199999999998</c:v>
                </c:pt>
                <c:pt idx="8455">
                  <c:v>1380.02</c:v>
                </c:pt>
                <c:pt idx="8458">
                  <c:v>1033.3399999999999</c:v>
                </c:pt>
                <c:pt idx="8465">
                  <c:v>1120.3900000000001</c:v>
                </c:pt>
                <c:pt idx="8466">
                  <c:v>1556.71</c:v>
                </c:pt>
                <c:pt idx="8471">
                  <c:v>924.048</c:v>
                </c:pt>
                <c:pt idx="8472">
                  <c:v>1680.7</c:v>
                </c:pt>
                <c:pt idx="8478">
                  <c:v>1017.79</c:v>
                </c:pt>
                <c:pt idx="8481">
                  <c:v>1054.51</c:v>
                </c:pt>
                <c:pt idx="8485">
                  <c:v>1359.94</c:v>
                </c:pt>
                <c:pt idx="8495">
                  <c:v>630.072</c:v>
                </c:pt>
                <c:pt idx="8499">
                  <c:v>2091.96</c:v>
                </c:pt>
                <c:pt idx="8514">
                  <c:v>937.44</c:v>
                </c:pt>
                <c:pt idx="8519">
                  <c:v>1657.8</c:v>
                </c:pt>
                <c:pt idx="8522">
                  <c:v>684.50400000000002</c:v>
                </c:pt>
                <c:pt idx="8523">
                  <c:v>892.72799999999995</c:v>
                </c:pt>
                <c:pt idx="8525">
                  <c:v>1010.45</c:v>
                </c:pt>
                <c:pt idx="8529">
                  <c:v>976.10400000000004</c:v>
                </c:pt>
                <c:pt idx="8531">
                  <c:v>1273.97</c:v>
                </c:pt>
                <c:pt idx="8534">
                  <c:v>1822.61</c:v>
                </c:pt>
                <c:pt idx="8538">
                  <c:v>1695.82</c:v>
                </c:pt>
                <c:pt idx="8543">
                  <c:v>1115.8599999999999</c:v>
                </c:pt>
                <c:pt idx="8546">
                  <c:v>1235.74</c:v>
                </c:pt>
                <c:pt idx="8547">
                  <c:v>756.43200000000002</c:v>
                </c:pt>
                <c:pt idx="8552">
                  <c:v>1113.48</c:v>
                </c:pt>
                <c:pt idx="8553">
                  <c:v>952.56</c:v>
                </c:pt>
                <c:pt idx="8556">
                  <c:v>1847.45</c:v>
                </c:pt>
                <c:pt idx="8557">
                  <c:v>519.69600000000003</c:v>
                </c:pt>
                <c:pt idx="8565">
                  <c:v>1169.8599999999999</c:v>
                </c:pt>
                <c:pt idx="8566">
                  <c:v>893.16</c:v>
                </c:pt>
                <c:pt idx="8568">
                  <c:v>1093.18</c:v>
                </c:pt>
                <c:pt idx="8584">
                  <c:v>248.4</c:v>
                </c:pt>
                <c:pt idx="8587">
                  <c:v>973.72799999999995</c:v>
                </c:pt>
                <c:pt idx="8589">
                  <c:v>774.57600000000002</c:v>
                </c:pt>
                <c:pt idx="8590">
                  <c:v>1977.26</c:v>
                </c:pt>
                <c:pt idx="8591">
                  <c:v>1275.9100000000001</c:v>
                </c:pt>
                <c:pt idx="8597">
                  <c:v>796.17600000000004</c:v>
                </c:pt>
                <c:pt idx="8599">
                  <c:v>1214.1400000000001</c:v>
                </c:pt>
                <c:pt idx="8605">
                  <c:v>378.21600000000001</c:v>
                </c:pt>
                <c:pt idx="8607">
                  <c:v>1263.3800000000001</c:v>
                </c:pt>
                <c:pt idx="8610">
                  <c:v>687.52800000000002</c:v>
                </c:pt>
                <c:pt idx="8611">
                  <c:v>785.59199999999998</c:v>
                </c:pt>
                <c:pt idx="8617">
                  <c:v>1623.02</c:v>
                </c:pt>
                <c:pt idx="8618">
                  <c:v>1590.62</c:v>
                </c:pt>
                <c:pt idx="8619">
                  <c:v>1325.59</c:v>
                </c:pt>
                <c:pt idx="8621">
                  <c:v>1192.75</c:v>
                </c:pt>
                <c:pt idx="8622">
                  <c:v>1660.82</c:v>
                </c:pt>
                <c:pt idx="8625">
                  <c:v>1064.45</c:v>
                </c:pt>
                <c:pt idx="8626">
                  <c:v>483.19200000000001</c:v>
                </c:pt>
                <c:pt idx="8634">
                  <c:v>1116.72</c:v>
                </c:pt>
                <c:pt idx="8639">
                  <c:v>949.32</c:v>
                </c:pt>
                <c:pt idx="8653">
                  <c:v>1004.4</c:v>
                </c:pt>
                <c:pt idx="8660">
                  <c:v>967.68</c:v>
                </c:pt>
                <c:pt idx="8664">
                  <c:v>705.45600000000002</c:v>
                </c:pt>
                <c:pt idx="8665">
                  <c:v>1855.22</c:v>
                </c:pt>
                <c:pt idx="8669">
                  <c:v>664.63199999999995</c:v>
                </c:pt>
                <c:pt idx="8676">
                  <c:v>1897.99</c:v>
                </c:pt>
                <c:pt idx="8677">
                  <c:v>384.48</c:v>
                </c:pt>
                <c:pt idx="8678">
                  <c:v>952.99199999999996</c:v>
                </c:pt>
                <c:pt idx="8679">
                  <c:v>658.15200000000004</c:v>
                </c:pt>
                <c:pt idx="8681">
                  <c:v>1448.5</c:v>
                </c:pt>
                <c:pt idx="8682">
                  <c:v>1262.3</c:v>
                </c:pt>
                <c:pt idx="8684">
                  <c:v>376.27199999999999</c:v>
                </c:pt>
                <c:pt idx="8688">
                  <c:v>1038.31</c:v>
                </c:pt>
                <c:pt idx="8689">
                  <c:v>1104.6199999999999</c:v>
                </c:pt>
                <c:pt idx="8690">
                  <c:v>897.48</c:v>
                </c:pt>
                <c:pt idx="8693">
                  <c:v>933.98400000000004</c:v>
                </c:pt>
                <c:pt idx="8705">
                  <c:v>1894.32</c:v>
                </c:pt>
                <c:pt idx="8710">
                  <c:v>960.76800000000003</c:v>
                </c:pt>
                <c:pt idx="8712">
                  <c:v>329.4</c:v>
                </c:pt>
                <c:pt idx="8715">
                  <c:v>987.98400000000004</c:v>
                </c:pt>
                <c:pt idx="8717">
                  <c:v>736.34400000000005</c:v>
                </c:pt>
                <c:pt idx="8720">
                  <c:v>3712.18</c:v>
                </c:pt>
                <c:pt idx="8729">
                  <c:v>1028.1600000000001</c:v>
                </c:pt>
                <c:pt idx="8732">
                  <c:v>749.30399999999997</c:v>
                </c:pt>
                <c:pt idx="8734">
                  <c:v>1179.79</c:v>
                </c:pt>
                <c:pt idx="8737">
                  <c:v>355.536</c:v>
                </c:pt>
                <c:pt idx="8746">
                  <c:v>755.35199999999998</c:v>
                </c:pt>
                <c:pt idx="8749">
                  <c:v>867.024</c:v>
                </c:pt>
                <c:pt idx="8756">
                  <c:v>659.23199999999997</c:v>
                </c:pt>
                <c:pt idx="8759">
                  <c:v>966.38400000000001</c:v>
                </c:pt>
                <c:pt idx="8760">
                  <c:v>2788.56</c:v>
                </c:pt>
                <c:pt idx="8766">
                  <c:v>975.88800000000003</c:v>
                </c:pt>
                <c:pt idx="8780">
                  <c:v>1323.86</c:v>
                </c:pt>
                <c:pt idx="8781">
                  <c:v>1395.14</c:v>
                </c:pt>
                <c:pt idx="8786">
                  <c:v>1118.6600000000001</c:v>
                </c:pt>
                <c:pt idx="8788">
                  <c:v>619.05600000000004</c:v>
                </c:pt>
                <c:pt idx="8790">
                  <c:v>1973.16</c:v>
                </c:pt>
                <c:pt idx="8792">
                  <c:v>305.85599999999999</c:v>
                </c:pt>
                <c:pt idx="8794">
                  <c:v>1213.7</c:v>
                </c:pt>
                <c:pt idx="8795">
                  <c:v>1208.3</c:v>
                </c:pt>
                <c:pt idx="8796">
                  <c:v>434.59199999999998</c:v>
                </c:pt>
                <c:pt idx="8800">
                  <c:v>1740.53</c:v>
                </c:pt>
                <c:pt idx="8806">
                  <c:v>933.98400000000004</c:v>
                </c:pt>
                <c:pt idx="8810">
                  <c:v>1022.11</c:v>
                </c:pt>
                <c:pt idx="8811">
                  <c:v>1135.94</c:v>
                </c:pt>
                <c:pt idx="8812">
                  <c:v>1203.77</c:v>
                </c:pt>
                <c:pt idx="8818">
                  <c:v>1259.06</c:v>
                </c:pt>
                <c:pt idx="8823">
                  <c:v>684.93600000000004</c:v>
                </c:pt>
                <c:pt idx="8825">
                  <c:v>802.87199999999996</c:v>
                </c:pt>
                <c:pt idx="8826">
                  <c:v>1406.38</c:v>
                </c:pt>
                <c:pt idx="8827">
                  <c:v>1281.0999999999999</c:v>
                </c:pt>
                <c:pt idx="8829">
                  <c:v>2249.86</c:v>
                </c:pt>
                <c:pt idx="8830">
                  <c:v>1193.4000000000001</c:v>
                </c:pt>
                <c:pt idx="8834">
                  <c:v>778.03200000000004</c:v>
                </c:pt>
                <c:pt idx="8840">
                  <c:v>149.68799999999999</c:v>
                </c:pt>
                <c:pt idx="8844">
                  <c:v>873.28800000000001</c:v>
                </c:pt>
                <c:pt idx="8847">
                  <c:v>859.24800000000005</c:v>
                </c:pt>
                <c:pt idx="8853">
                  <c:v>942.62400000000002</c:v>
                </c:pt>
                <c:pt idx="8858">
                  <c:v>895.75199999999995</c:v>
                </c:pt>
                <c:pt idx="8859">
                  <c:v>923.61599999999999</c:v>
                </c:pt>
                <c:pt idx="8864">
                  <c:v>1958.9</c:v>
                </c:pt>
                <c:pt idx="8872">
                  <c:v>1121.04</c:v>
                </c:pt>
                <c:pt idx="8875">
                  <c:v>1527.77</c:v>
                </c:pt>
                <c:pt idx="8880">
                  <c:v>1341.58</c:v>
                </c:pt>
                <c:pt idx="8881">
                  <c:v>1292.1099999999999</c:v>
                </c:pt>
                <c:pt idx="8885">
                  <c:v>669.81600000000003</c:v>
                </c:pt>
                <c:pt idx="8887">
                  <c:v>1577.45</c:v>
                </c:pt>
                <c:pt idx="8890">
                  <c:v>446.47199999999998</c:v>
                </c:pt>
                <c:pt idx="8891">
                  <c:v>1121.69</c:v>
                </c:pt>
                <c:pt idx="8895">
                  <c:v>721.65599999999995</c:v>
                </c:pt>
                <c:pt idx="8904">
                  <c:v>969.19200000000001</c:v>
                </c:pt>
                <c:pt idx="8905">
                  <c:v>1755</c:v>
                </c:pt>
                <c:pt idx="8915">
                  <c:v>1324.73</c:v>
                </c:pt>
                <c:pt idx="8922">
                  <c:v>676.51199999999994</c:v>
                </c:pt>
                <c:pt idx="8924">
                  <c:v>1940.54</c:v>
                </c:pt>
                <c:pt idx="8928">
                  <c:v>1437.7</c:v>
                </c:pt>
                <c:pt idx="8932">
                  <c:v>949.10400000000004</c:v>
                </c:pt>
                <c:pt idx="8942">
                  <c:v>1232.93</c:v>
                </c:pt>
                <c:pt idx="8947">
                  <c:v>1023.41</c:v>
                </c:pt>
                <c:pt idx="8951">
                  <c:v>469.36799999999999</c:v>
                </c:pt>
                <c:pt idx="8953">
                  <c:v>1125.3599999999999</c:v>
                </c:pt>
                <c:pt idx="8955">
                  <c:v>1136.81</c:v>
                </c:pt>
                <c:pt idx="8958">
                  <c:v>1506.17</c:v>
                </c:pt>
                <c:pt idx="8962">
                  <c:v>2297.16</c:v>
                </c:pt>
                <c:pt idx="8979">
                  <c:v>2833.7</c:v>
                </c:pt>
                <c:pt idx="8983">
                  <c:v>789.91200000000003</c:v>
                </c:pt>
                <c:pt idx="8988">
                  <c:v>522.50400000000002</c:v>
                </c:pt>
                <c:pt idx="8990">
                  <c:v>460.94400000000002</c:v>
                </c:pt>
                <c:pt idx="8991">
                  <c:v>4739.04</c:v>
                </c:pt>
                <c:pt idx="8993">
                  <c:v>687.52800000000002</c:v>
                </c:pt>
                <c:pt idx="8996">
                  <c:v>6515.21</c:v>
                </c:pt>
                <c:pt idx="9000">
                  <c:v>2185.4899999999998</c:v>
                </c:pt>
                <c:pt idx="9002">
                  <c:v>1401.84</c:v>
                </c:pt>
                <c:pt idx="9006">
                  <c:v>624.67200000000003</c:v>
                </c:pt>
                <c:pt idx="9009">
                  <c:v>904.60799999999995</c:v>
                </c:pt>
                <c:pt idx="9015">
                  <c:v>973.29600000000005</c:v>
                </c:pt>
                <c:pt idx="9017">
                  <c:v>886.46400000000006</c:v>
                </c:pt>
                <c:pt idx="9020">
                  <c:v>258.98399999999998</c:v>
                </c:pt>
                <c:pt idx="9026">
                  <c:v>1070.5</c:v>
                </c:pt>
                <c:pt idx="9030">
                  <c:v>1175.69</c:v>
                </c:pt>
                <c:pt idx="9037">
                  <c:v>5487.26</c:v>
                </c:pt>
                <c:pt idx="9041">
                  <c:v>887.32799999999997</c:v>
                </c:pt>
                <c:pt idx="9042">
                  <c:v>1118.23</c:v>
                </c:pt>
                <c:pt idx="9043">
                  <c:v>1232.5</c:v>
                </c:pt>
                <c:pt idx="9046">
                  <c:v>975.024</c:v>
                </c:pt>
                <c:pt idx="9047">
                  <c:v>1228.6099999999999</c:v>
                </c:pt>
                <c:pt idx="9049">
                  <c:v>994.89599999999996</c:v>
                </c:pt>
                <c:pt idx="9059">
                  <c:v>778.89599999999996</c:v>
                </c:pt>
                <c:pt idx="9060">
                  <c:v>241.488</c:v>
                </c:pt>
                <c:pt idx="9062">
                  <c:v>1376.57</c:v>
                </c:pt>
                <c:pt idx="9067">
                  <c:v>1386.29</c:v>
                </c:pt>
                <c:pt idx="9071">
                  <c:v>892.08</c:v>
                </c:pt>
                <c:pt idx="9072">
                  <c:v>1142.42</c:v>
                </c:pt>
                <c:pt idx="9074">
                  <c:v>1127.0899999999999</c:v>
                </c:pt>
                <c:pt idx="9075">
                  <c:v>1087.1300000000001</c:v>
                </c:pt>
                <c:pt idx="9080">
                  <c:v>822.96</c:v>
                </c:pt>
                <c:pt idx="9082">
                  <c:v>1058.6199999999999</c:v>
                </c:pt>
                <c:pt idx="9084">
                  <c:v>1290.17</c:v>
                </c:pt>
                <c:pt idx="9089">
                  <c:v>1089.72</c:v>
                </c:pt>
                <c:pt idx="9091">
                  <c:v>955.58399999999995</c:v>
                </c:pt>
                <c:pt idx="9101">
                  <c:v>1303.1300000000001</c:v>
                </c:pt>
                <c:pt idx="9107">
                  <c:v>310.17599999999999</c:v>
                </c:pt>
                <c:pt idx="9114">
                  <c:v>796.60799999999995</c:v>
                </c:pt>
                <c:pt idx="9115">
                  <c:v>1816.56</c:v>
                </c:pt>
                <c:pt idx="9116">
                  <c:v>641.52</c:v>
                </c:pt>
                <c:pt idx="9121">
                  <c:v>1291.68</c:v>
                </c:pt>
                <c:pt idx="9125">
                  <c:v>1240.92</c:v>
                </c:pt>
                <c:pt idx="9126">
                  <c:v>634.39200000000005</c:v>
                </c:pt>
                <c:pt idx="9127">
                  <c:v>2714.47</c:v>
                </c:pt>
                <c:pt idx="9130">
                  <c:v>875.23199999999997</c:v>
                </c:pt>
                <c:pt idx="9141">
                  <c:v>782.56799999999998</c:v>
                </c:pt>
                <c:pt idx="9147">
                  <c:v>1996.7</c:v>
                </c:pt>
                <c:pt idx="9157">
                  <c:v>794.44799999999998</c:v>
                </c:pt>
                <c:pt idx="9158">
                  <c:v>861.62400000000002</c:v>
                </c:pt>
                <c:pt idx="9160">
                  <c:v>1519.56</c:v>
                </c:pt>
                <c:pt idx="9165">
                  <c:v>1667.74</c:v>
                </c:pt>
                <c:pt idx="9167">
                  <c:v>1311.77</c:v>
                </c:pt>
                <c:pt idx="9174">
                  <c:v>989.49599999999998</c:v>
                </c:pt>
                <c:pt idx="9178">
                  <c:v>4260.82</c:v>
                </c:pt>
                <c:pt idx="9182">
                  <c:v>1086.05</c:v>
                </c:pt>
                <c:pt idx="9183">
                  <c:v>1601.64</c:v>
                </c:pt>
                <c:pt idx="9184">
                  <c:v>1317.17</c:v>
                </c:pt>
                <c:pt idx="9190">
                  <c:v>1148.9000000000001</c:v>
                </c:pt>
                <c:pt idx="9193">
                  <c:v>616.03200000000004</c:v>
                </c:pt>
                <c:pt idx="9196">
                  <c:v>1029.8900000000001</c:v>
                </c:pt>
                <c:pt idx="9202">
                  <c:v>543.88800000000003</c:v>
                </c:pt>
                <c:pt idx="9209">
                  <c:v>473.904</c:v>
                </c:pt>
                <c:pt idx="9215">
                  <c:v>782.56799999999998</c:v>
                </c:pt>
                <c:pt idx="9226">
                  <c:v>590.76</c:v>
                </c:pt>
                <c:pt idx="9227">
                  <c:v>552.096</c:v>
                </c:pt>
                <c:pt idx="9231">
                  <c:v>1600.78</c:v>
                </c:pt>
                <c:pt idx="9241">
                  <c:v>623.59199999999998</c:v>
                </c:pt>
                <c:pt idx="9243">
                  <c:v>1134.43</c:v>
                </c:pt>
                <c:pt idx="9253">
                  <c:v>3921.91</c:v>
                </c:pt>
                <c:pt idx="9255">
                  <c:v>1123.8499999999999</c:v>
                </c:pt>
                <c:pt idx="9258">
                  <c:v>1240.06</c:v>
                </c:pt>
                <c:pt idx="9260">
                  <c:v>2244.46</c:v>
                </c:pt>
                <c:pt idx="9261">
                  <c:v>1550.88</c:v>
                </c:pt>
                <c:pt idx="9262">
                  <c:v>971.35199999999998</c:v>
                </c:pt>
                <c:pt idx="9268">
                  <c:v>927.072</c:v>
                </c:pt>
                <c:pt idx="9275">
                  <c:v>1153.6600000000001</c:v>
                </c:pt>
                <c:pt idx="9280">
                  <c:v>1627.78</c:v>
                </c:pt>
                <c:pt idx="9287">
                  <c:v>1263.5999999999999</c:v>
                </c:pt>
                <c:pt idx="9289">
                  <c:v>604.15200000000004</c:v>
                </c:pt>
                <c:pt idx="9290">
                  <c:v>1336.18</c:v>
                </c:pt>
                <c:pt idx="9295">
                  <c:v>817.99199999999996</c:v>
                </c:pt>
                <c:pt idx="9298">
                  <c:v>594.43200000000002</c:v>
                </c:pt>
                <c:pt idx="9303">
                  <c:v>878.904</c:v>
                </c:pt>
                <c:pt idx="9304">
                  <c:v>1475.06</c:v>
                </c:pt>
                <c:pt idx="9305">
                  <c:v>641.52</c:v>
                </c:pt>
                <c:pt idx="9306">
                  <c:v>922.53599999999994</c:v>
                </c:pt>
                <c:pt idx="9308">
                  <c:v>808.92</c:v>
                </c:pt>
                <c:pt idx="9311">
                  <c:v>675.21600000000001</c:v>
                </c:pt>
                <c:pt idx="9315">
                  <c:v>205.63200000000001</c:v>
                </c:pt>
                <c:pt idx="9318">
                  <c:v>715.17600000000004</c:v>
                </c:pt>
                <c:pt idx="9320">
                  <c:v>816.48</c:v>
                </c:pt>
                <c:pt idx="9324">
                  <c:v>418.17599999999999</c:v>
                </c:pt>
                <c:pt idx="9327">
                  <c:v>506.52</c:v>
                </c:pt>
                <c:pt idx="9329">
                  <c:v>1170.94</c:v>
                </c:pt>
                <c:pt idx="9342">
                  <c:v>604.36800000000005</c:v>
                </c:pt>
                <c:pt idx="9344">
                  <c:v>1916.35</c:v>
                </c:pt>
                <c:pt idx="9352">
                  <c:v>995.976</c:v>
                </c:pt>
                <c:pt idx="9354">
                  <c:v>1022.33</c:v>
                </c:pt>
                <c:pt idx="9359">
                  <c:v>614.73599999999999</c:v>
                </c:pt>
                <c:pt idx="9360">
                  <c:v>675.86400000000003</c:v>
                </c:pt>
                <c:pt idx="9361">
                  <c:v>1241.1400000000001</c:v>
                </c:pt>
                <c:pt idx="9362">
                  <c:v>1391.47</c:v>
                </c:pt>
                <c:pt idx="9364">
                  <c:v>1085.6199999999999</c:v>
                </c:pt>
                <c:pt idx="9366">
                  <c:v>643.67999999999995</c:v>
                </c:pt>
                <c:pt idx="9369">
                  <c:v>2401.92</c:v>
                </c:pt>
                <c:pt idx="9371">
                  <c:v>835.48800000000006</c:v>
                </c:pt>
                <c:pt idx="9383">
                  <c:v>1357.56</c:v>
                </c:pt>
                <c:pt idx="9386">
                  <c:v>1273.32</c:v>
                </c:pt>
                <c:pt idx="9387">
                  <c:v>1899.94</c:v>
                </c:pt>
                <c:pt idx="9389">
                  <c:v>1393.42</c:v>
                </c:pt>
                <c:pt idx="9391">
                  <c:v>2227.61</c:v>
                </c:pt>
                <c:pt idx="9393">
                  <c:v>3572.64</c:v>
                </c:pt>
                <c:pt idx="9394">
                  <c:v>1162.51</c:v>
                </c:pt>
                <c:pt idx="9395">
                  <c:v>644.11199999999997</c:v>
                </c:pt>
                <c:pt idx="9401">
                  <c:v>1423.01</c:v>
                </c:pt>
                <c:pt idx="9406">
                  <c:v>764.42399999999998</c:v>
                </c:pt>
                <c:pt idx="9419">
                  <c:v>1437.26</c:v>
                </c:pt>
                <c:pt idx="9424">
                  <c:v>756.43200000000002</c:v>
                </c:pt>
                <c:pt idx="9430">
                  <c:v>304.12799999999999</c:v>
                </c:pt>
                <c:pt idx="9437">
                  <c:v>1374.62</c:v>
                </c:pt>
                <c:pt idx="9439">
                  <c:v>2098.44</c:v>
                </c:pt>
                <c:pt idx="9444">
                  <c:v>1263.5999999999999</c:v>
                </c:pt>
                <c:pt idx="9445">
                  <c:v>612.79200000000003</c:v>
                </c:pt>
                <c:pt idx="9447">
                  <c:v>244.94399999999999</c:v>
                </c:pt>
                <c:pt idx="9449">
                  <c:v>139.10400000000001</c:v>
                </c:pt>
                <c:pt idx="9450">
                  <c:v>1161</c:v>
                </c:pt>
                <c:pt idx="9453">
                  <c:v>3833.14</c:v>
                </c:pt>
                <c:pt idx="9456">
                  <c:v>1124.28</c:v>
                </c:pt>
                <c:pt idx="9457">
                  <c:v>642.81600000000003</c:v>
                </c:pt>
                <c:pt idx="9462">
                  <c:v>772.41600000000005</c:v>
                </c:pt>
                <c:pt idx="9479">
                  <c:v>511.488</c:v>
                </c:pt>
                <c:pt idx="9480">
                  <c:v>938.08799999999997</c:v>
                </c:pt>
                <c:pt idx="9481">
                  <c:v>555.33600000000001</c:v>
                </c:pt>
                <c:pt idx="9482">
                  <c:v>630.72</c:v>
                </c:pt>
                <c:pt idx="9491">
                  <c:v>892.72799999999995</c:v>
                </c:pt>
                <c:pt idx="9492">
                  <c:v>802.44</c:v>
                </c:pt>
                <c:pt idx="9500">
                  <c:v>1626.26</c:v>
                </c:pt>
                <c:pt idx="9501">
                  <c:v>819.28800000000001</c:v>
                </c:pt>
                <c:pt idx="9507">
                  <c:v>653.61599999999999</c:v>
                </c:pt>
                <c:pt idx="9508">
                  <c:v>152.928</c:v>
                </c:pt>
                <c:pt idx="9510">
                  <c:v>740.88</c:v>
                </c:pt>
                <c:pt idx="9513">
                  <c:v>1120.82</c:v>
                </c:pt>
                <c:pt idx="9518">
                  <c:v>922.10400000000004</c:v>
                </c:pt>
                <c:pt idx="9519">
                  <c:v>203.68799999999999</c:v>
                </c:pt>
                <c:pt idx="9522">
                  <c:v>1210.25</c:v>
                </c:pt>
                <c:pt idx="9524">
                  <c:v>1738.15</c:v>
                </c:pt>
                <c:pt idx="9530">
                  <c:v>1154.0899999999999</c:v>
                </c:pt>
                <c:pt idx="9531">
                  <c:v>1593.22</c:v>
                </c:pt>
                <c:pt idx="9533">
                  <c:v>821.66399999999999</c:v>
                </c:pt>
                <c:pt idx="9536">
                  <c:v>717.98400000000004</c:v>
                </c:pt>
                <c:pt idx="9537">
                  <c:v>1435.97</c:v>
                </c:pt>
                <c:pt idx="9541">
                  <c:v>284.04000000000002</c:v>
                </c:pt>
                <c:pt idx="9543">
                  <c:v>4445.93</c:v>
                </c:pt>
                <c:pt idx="9545">
                  <c:v>1494.94</c:v>
                </c:pt>
                <c:pt idx="9553">
                  <c:v>1759.32</c:v>
                </c:pt>
                <c:pt idx="9556">
                  <c:v>1059.26</c:v>
                </c:pt>
                <c:pt idx="9562">
                  <c:v>1130.33</c:v>
                </c:pt>
                <c:pt idx="9564">
                  <c:v>1345.9</c:v>
                </c:pt>
                <c:pt idx="9569">
                  <c:v>2741.47</c:v>
                </c:pt>
                <c:pt idx="9571">
                  <c:v>1560.17</c:v>
                </c:pt>
                <c:pt idx="9574">
                  <c:v>1240.92</c:v>
                </c:pt>
                <c:pt idx="9575">
                  <c:v>1180.44</c:v>
                </c:pt>
                <c:pt idx="9583">
                  <c:v>1008.07</c:v>
                </c:pt>
                <c:pt idx="9585">
                  <c:v>1142.8599999999999</c:v>
                </c:pt>
                <c:pt idx="9590">
                  <c:v>6042.38</c:v>
                </c:pt>
                <c:pt idx="9592">
                  <c:v>747.36</c:v>
                </c:pt>
                <c:pt idx="9598">
                  <c:v>936.57600000000002</c:v>
                </c:pt>
                <c:pt idx="9600">
                  <c:v>545.4</c:v>
                </c:pt>
                <c:pt idx="9601">
                  <c:v>1235.3</c:v>
                </c:pt>
                <c:pt idx="9604">
                  <c:v>782.35199999999998</c:v>
                </c:pt>
                <c:pt idx="9608">
                  <c:v>1177.8499999999999</c:v>
                </c:pt>
                <c:pt idx="9617">
                  <c:v>1008.5</c:v>
                </c:pt>
                <c:pt idx="9618">
                  <c:v>1367.28</c:v>
                </c:pt>
                <c:pt idx="9633">
                  <c:v>1495.58</c:v>
                </c:pt>
                <c:pt idx="9635">
                  <c:v>1343.74</c:v>
                </c:pt>
                <c:pt idx="9638">
                  <c:v>1099.6600000000001</c:v>
                </c:pt>
                <c:pt idx="9639">
                  <c:v>742.82399999999996</c:v>
                </c:pt>
                <c:pt idx="9647">
                  <c:v>872.85599999999999</c:v>
                </c:pt>
                <c:pt idx="9657">
                  <c:v>993.6</c:v>
                </c:pt>
                <c:pt idx="9658">
                  <c:v>1228.82</c:v>
                </c:pt>
                <c:pt idx="9660">
                  <c:v>797.904</c:v>
                </c:pt>
                <c:pt idx="9663">
                  <c:v>1243.08</c:v>
                </c:pt>
                <c:pt idx="9664">
                  <c:v>2208.6</c:v>
                </c:pt>
                <c:pt idx="9669">
                  <c:v>1036.1500000000001</c:v>
                </c:pt>
                <c:pt idx="9670">
                  <c:v>575.42399999999998</c:v>
                </c:pt>
                <c:pt idx="9673">
                  <c:v>1134.6500000000001</c:v>
                </c:pt>
                <c:pt idx="9676">
                  <c:v>923.61599999999999</c:v>
                </c:pt>
                <c:pt idx="9678">
                  <c:v>3377.81</c:v>
                </c:pt>
                <c:pt idx="9693">
                  <c:v>1055.5899999999999</c:v>
                </c:pt>
                <c:pt idx="9695">
                  <c:v>1237.46</c:v>
                </c:pt>
                <c:pt idx="9697">
                  <c:v>768.31200000000001</c:v>
                </c:pt>
                <c:pt idx="9699">
                  <c:v>560.30399999999997</c:v>
                </c:pt>
                <c:pt idx="9701">
                  <c:v>1254.31</c:v>
                </c:pt>
                <c:pt idx="9704">
                  <c:v>636.33600000000001</c:v>
                </c:pt>
                <c:pt idx="9717">
                  <c:v>1174.3900000000001</c:v>
                </c:pt>
                <c:pt idx="9718">
                  <c:v>2083.1</c:v>
                </c:pt>
                <c:pt idx="9719">
                  <c:v>1600.56</c:v>
                </c:pt>
                <c:pt idx="9724">
                  <c:v>924.26400000000001</c:v>
                </c:pt>
                <c:pt idx="9729">
                  <c:v>1411.78</c:v>
                </c:pt>
                <c:pt idx="9732">
                  <c:v>3046.03</c:v>
                </c:pt>
                <c:pt idx="9738">
                  <c:v>385.99200000000002</c:v>
                </c:pt>
                <c:pt idx="9749">
                  <c:v>4563</c:v>
                </c:pt>
                <c:pt idx="9750">
                  <c:v>978.26400000000001</c:v>
                </c:pt>
                <c:pt idx="9754">
                  <c:v>748.00800000000004</c:v>
                </c:pt>
                <c:pt idx="9755">
                  <c:v>1291.68</c:v>
                </c:pt>
                <c:pt idx="9757">
                  <c:v>1257.98</c:v>
                </c:pt>
                <c:pt idx="9760">
                  <c:v>110.592</c:v>
                </c:pt>
                <c:pt idx="9762">
                  <c:v>1389.96</c:v>
                </c:pt>
                <c:pt idx="9766">
                  <c:v>750.6</c:v>
                </c:pt>
                <c:pt idx="9767">
                  <c:v>1426.9</c:v>
                </c:pt>
                <c:pt idx="9771">
                  <c:v>1568.81</c:v>
                </c:pt>
                <c:pt idx="9775">
                  <c:v>1320.62</c:v>
                </c:pt>
                <c:pt idx="9784">
                  <c:v>682.99199999999996</c:v>
                </c:pt>
                <c:pt idx="9785">
                  <c:v>933.55200000000002</c:v>
                </c:pt>
                <c:pt idx="9787">
                  <c:v>942.84</c:v>
                </c:pt>
                <c:pt idx="9788">
                  <c:v>713.66399999999999</c:v>
                </c:pt>
                <c:pt idx="9789">
                  <c:v>2895.7</c:v>
                </c:pt>
                <c:pt idx="9796">
                  <c:v>1369.01</c:v>
                </c:pt>
                <c:pt idx="9807">
                  <c:v>738.28800000000001</c:v>
                </c:pt>
                <c:pt idx="9808">
                  <c:v>1229.04</c:v>
                </c:pt>
                <c:pt idx="9810">
                  <c:v>793.36800000000005</c:v>
                </c:pt>
                <c:pt idx="9817">
                  <c:v>606.52800000000002</c:v>
                </c:pt>
                <c:pt idx="9823">
                  <c:v>1340.71</c:v>
                </c:pt>
                <c:pt idx="9835">
                  <c:v>921.24</c:v>
                </c:pt>
                <c:pt idx="9837">
                  <c:v>355.32</c:v>
                </c:pt>
                <c:pt idx="9843">
                  <c:v>1202.69</c:v>
                </c:pt>
                <c:pt idx="9844">
                  <c:v>1639.44</c:v>
                </c:pt>
                <c:pt idx="9845">
                  <c:v>1596.24</c:v>
                </c:pt>
                <c:pt idx="9846">
                  <c:v>1107.8599999999999</c:v>
                </c:pt>
                <c:pt idx="9849">
                  <c:v>1090.8</c:v>
                </c:pt>
                <c:pt idx="9853">
                  <c:v>2163.02</c:v>
                </c:pt>
                <c:pt idx="9854">
                  <c:v>844.99199999999996</c:v>
                </c:pt>
                <c:pt idx="9857">
                  <c:v>677.37599999999998</c:v>
                </c:pt>
                <c:pt idx="9864">
                  <c:v>646.27200000000005</c:v>
                </c:pt>
                <c:pt idx="9869">
                  <c:v>478.87200000000001</c:v>
                </c:pt>
                <c:pt idx="9879">
                  <c:v>1044.79</c:v>
                </c:pt>
                <c:pt idx="9882">
                  <c:v>980.64</c:v>
                </c:pt>
                <c:pt idx="9884">
                  <c:v>605.23199999999997</c:v>
                </c:pt>
                <c:pt idx="9890">
                  <c:v>1946.16</c:v>
                </c:pt>
                <c:pt idx="9895">
                  <c:v>3701.16</c:v>
                </c:pt>
                <c:pt idx="9896">
                  <c:v>1356.05</c:v>
                </c:pt>
                <c:pt idx="9899">
                  <c:v>758.59199999999998</c:v>
                </c:pt>
                <c:pt idx="9900">
                  <c:v>105.408</c:v>
                </c:pt>
                <c:pt idx="9901">
                  <c:v>827.06399999999996</c:v>
                </c:pt>
                <c:pt idx="9902">
                  <c:v>873.93600000000004</c:v>
                </c:pt>
                <c:pt idx="9904">
                  <c:v>891</c:v>
                </c:pt>
                <c:pt idx="9907">
                  <c:v>381.45600000000002</c:v>
                </c:pt>
                <c:pt idx="9908">
                  <c:v>868.32</c:v>
                </c:pt>
                <c:pt idx="9910">
                  <c:v>1000.3</c:v>
                </c:pt>
                <c:pt idx="9914">
                  <c:v>576.72</c:v>
                </c:pt>
                <c:pt idx="9921">
                  <c:v>2104.06</c:v>
                </c:pt>
                <c:pt idx="9923">
                  <c:v>3132.22</c:v>
                </c:pt>
                <c:pt idx="9924">
                  <c:v>673.70399999999995</c:v>
                </c:pt>
                <c:pt idx="9931">
                  <c:v>1372.68</c:v>
                </c:pt>
                <c:pt idx="9934">
                  <c:v>739.8</c:v>
                </c:pt>
                <c:pt idx="9935">
                  <c:v>1519.34</c:v>
                </c:pt>
                <c:pt idx="9937">
                  <c:v>683.20799999999997</c:v>
                </c:pt>
                <c:pt idx="9942">
                  <c:v>1306.58</c:v>
                </c:pt>
                <c:pt idx="9943">
                  <c:v>1029.24</c:v>
                </c:pt>
                <c:pt idx="9944">
                  <c:v>1444.39</c:v>
                </c:pt>
                <c:pt idx="9946">
                  <c:v>1318.68</c:v>
                </c:pt>
                <c:pt idx="9953">
                  <c:v>5086.58</c:v>
                </c:pt>
                <c:pt idx="9955">
                  <c:v>1376.14</c:v>
                </c:pt>
                <c:pt idx="9957">
                  <c:v>1685.45</c:v>
                </c:pt>
                <c:pt idx="9968">
                  <c:v>1014.55</c:v>
                </c:pt>
                <c:pt idx="9977">
                  <c:v>5914.73</c:v>
                </c:pt>
                <c:pt idx="9982">
                  <c:v>1624.1</c:v>
                </c:pt>
                <c:pt idx="9987">
                  <c:v>901.8</c:v>
                </c:pt>
                <c:pt idx="9989">
                  <c:v>1668.38</c:v>
                </c:pt>
                <c:pt idx="9998">
                  <c:v>1263.17</c:v>
                </c:pt>
                <c:pt idx="10000">
                  <c:v>534.81600000000003</c:v>
                </c:pt>
                <c:pt idx="10009">
                  <c:v>1055.3800000000001</c:v>
                </c:pt>
                <c:pt idx="10011">
                  <c:v>964.65599999999995</c:v>
                </c:pt>
                <c:pt idx="10012">
                  <c:v>1734.48</c:v>
                </c:pt>
                <c:pt idx="10018">
                  <c:v>1154.95</c:v>
                </c:pt>
                <c:pt idx="10031">
                  <c:v>835.27200000000005</c:v>
                </c:pt>
                <c:pt idx="10034">
                  <c:v>518.4</c:v>
                </c:pt>
                <c:pt idx="10036">
                  <c:v>1751.54</c:v>
                </c:pt>
                <c:pt idx="10040">
                  <c:v>1669.25</c:v>
                </c:pt>
                <c:pt idx="10042">
                  <c:v>1332.94</c:v>
                </c:pt>
                <c:pt idx="10043">
                  <c:v>1452.82</c:v>
                </c:pt>
                <c:pt idx="10044">
                  <c:v>781.92</c:v>
                </c:pt>
                <c:pt idx="10045">
                  <c:v>1654.56</c:v>
                </c:pt>
                <c:pt idx="10047">
                  <c:v>1041.1199999999999</c:v>
                </c:pt>
                <c:pt idx="10059">
                  <c:v>1229.9000000000001</c:v>
                </c:pt>
                <c:pt idx="10066">
                  <c:v>1072.8699999999999</c:v>
                </c:pt>
                <c:pt idx="10069">
                  <c:v>649.08000000000004</c:v>
                </c:pt>
                <c:pt idx="10071">
                  <c:v>973.72799999999995</c:v>
                </c:pt>
                <c:pt idx="10073">
                  <c:v>861.40800000000002</c:v>
                </c:pt>
                <c:pt idx="10075">
                  <c:v>2008.37</c:v>
                </c:pt>
                <c:pt idx="10081">
                  <c:v>1123.42</c:v>
                </c:pt>
                <c:pt idx="10084">
                  <c:v>762.69600000000003</c:v>
                </c:pt>
                <c:pt idx="10085">
                  <c:v>1677.46</c:v>
                </c:pt>
                <c:pt idx="10088">
                  <c:v>997.27200000000005</c:v>
                </c:pt>
                <c:pt idx="10089">
                  <c:v>2458.5100000000002</c:v>
                </c:pt>
                <c:pt idx="10092">
                  <c:v>1751.33</c:v>
                </c:pt>
                <c:pt idx="10094">
                  <c:v>1650.02</c:v>
                </c:pt>
                <c:pt idx="10096">
                  <c:v>937.00800000000004</c:v>
                </c:pt>
                <c:pt idx="10101">
                  <c:v>1177.6300000000001</c:v>
                </c:pt>
                <c:pt idx="10102">
                  <c:v>691.2</c:v>
                </c:pt>
                <c:pt idx="10111">
                  <c:v>1256.69</c:v>
                </c:pt>
                <c:pt idx="10119">
                  <c:v>999.21600000000001</c:v>
                </c:pt>
                <c:pt idx="10122">
                  <c:v>784.94399999999996</c:v>
                </c:pt>
                <c:pt idx="10129">
                  <c:v>1399.03</c:v>
                </c:pt>
                <c:pt idx="10134">
                  <c:v>1369.22</c:v>
                </c:pt>
                <c:pt idx="10141">
                  <c:v>1902.96</c:v>
                </c:pt>
                <c:pt idx="10144">
                  <c:v>1936.87</c:v>
                </c:pt>
                <c:pt idx="10153">
                  <c:v>848.23199999999997</c:v>
                </c:pt>
                <c:pt idx="10157">
                  <c:v>1476.79</c:v>
                </c:pt>
                <c:pt idx="10159">
                  <c:v>1669.9</c:v>
                </c:pt>
                <c:pt idx="10162">
                  <c:v>604.58399999999995</c:v>
                </c:pt>
                <c:pt idx="10166">
                  <c:v>1377.65</c:v>
                </c:pt>
                <c:pt idx="10170">
                  <c:v>1931.47</c:v>
                </c:pt>
                <c:pt idx="10174">
                  <c:v>591.62400000000002</c:v>
                </c:pt>
                <c:pt idx="10177">
                  <c:v>2663.28</c:v>
                </c:pt>
                <c:pt idx="10178">
                  <c:v>1556.71</c:v>
                </c:pt>
                <c:pt idx="10182">
                  <c:v>2078.14</c:v>
                </c:pt>
                <c:pt idx="10183">
                  <c:v>811.29600000000005</c:v>
                </c:pt>
                <c:pt idx="10189">
                  <c:v>1950.26</c:v>
                </c:pt>
                <c:pt idx="10190">
                  <c:v>1381.32</c:v>
                </c:pt>
                <c:pt idx="10194">
                  <c:v>2891.81</c:v>
                </c:pt>
                <c:pt idx="10195">
                  <c:v>1732.32</c:v>
                </c:pt>
                <c:pt idx="10200">
                  <c:v>1996.27</c:v>
                </c:pt>
                <c:pt idx="10203">
                  <c:v>1436.62</c:v>
                </c:pt>
                <c:pt idx="10208">
                  <c:v>780.40800000000002</c:v>
                </c:pt>
                <c:pt idx="10216">
                  <c:v>956.23199999999997</c:v>
                </c:pt>
                <c:pt idx="10227">
                  <c:v>942.19200000000001</c:v>
                </c:pt>
                <c:pt idx="10233">
                  <c:v>802.87199999999996</c:v>
                </c:pt>
                <c:pt idx="10237">
                  <c:v>1834.7</c:v>
                </c:pt>
                <c:pt idx="10240">
                  <c:v>1899.94</c:v>
                </c:pt>
                <c:pt idx="10241">
                  <c:v>1378.08</c:v>
                </c:pt>
                <c:pt idx="10242">
                  <c:v>727.48800000000006</c:v>
                </c:pt>
                <c:pt idx="10243">
                  <c:v>1073.74</c:v>
                </c:pt>
                <c:pt idx="10244">
                  <c:v>966.38400000000001</c:v>
                </c:pt>
                <c:pt idx="10247">
                  <c:v>898.99199999999996</c:v>
                </c:pt>
                <c:pt idx="10251">
                  <c:v>1531.22</c:v>
                </c:pt>
                <c:pt idx="10252">
                  <c:v>910.44</c:v>
                </c:pt>
                <c:pt idx="10253">
                  <c:v>1852.63</c:v>
                </c:pt>
                <c:pt idx="10257">
                  <c:v>907.2</c:v>
                </c:pt>
                <c:pt idx="10260">
                  <c:v>2511.2199999999998</c:v>
                </c:pt>
                <c:pt idx="10273">
                  <c:v>1626.48</c:v>
                </c:pt>
                <c:pt idx="10276">
                  <c:v>981.93600000000004</c:v>
                </c:pt>
                <c:pt idx="10283">
                  <c:v>1042.6300000000001</c:v>
                </c:pt>
                <c:pt idx="10284">
                  <c:v>867.45600000000002</c:v>
                </c:pt>
                <c:pt idx="10285">
                  <c:v>3037.82</c:v>
                </c:pt>
                <c:pt idx="10292">
                  <c:v>108</c:v>
                </c:pt>
                <c:pt idx="10293">
                  <c:v>597.67200000000003</c:v>
                </c:pt>
                <c:pt idx="10300">
                  <c:v>1333.15</c:v>
                </c:pt>
                <c:pt idx="10301">
                  <c:v>972.86400000000003</c:v>
                </c:pt>
                <c:pt idx="10302">
                  <c:v>1982.45</c:v>
                </c:pt>
                <c:pt idx="10305">
                  <c:v>1221.9100000000001</c:v>
                </c:pt>
                <c:pt idx="10307">
                  <c:v>808.70399999999995</c:v>
                </c:pt>
                <c:pt idx="10315">
                  <c:v>768.52800000000002</c:v>
                </c:pt>
                <c:pt idx="10325">
                  <c:v>258.98399999999998</c:v>
                </c:pt>
                <c:pt idx="10326">
                  <c:v>3751.7</c:v>
                </c:pt>
                <c:pt idx="10327">
                  <c:v>800.71199999999999</c:v>
                </c:pt>
                <c:pt idx="10335">
                  <c:v>1120.6099999999999</c:v>
                </c:pt>
                <c:pt idx="10337">
                  <c:v>1474.63</c:v>
                </c:pt>
                <c:pt idx="10338">
                  <c:v>1077.4100000000001</c:v>
                </c:pt>
                <c:pt idx="10347">
                  <c:v>1170.72</c:v>
                </c:pt>
                <c:pt idx="10350">
                  <c:v>840.67200000000003</c:v>
                </c:pt>
                <c:pt idx="10351">
                  <c:v>4566.8900000000003</c:v>
                </c:pt>
                <c:pt idx="10353">
                  <c:v>7999.78</c:v>
                </c:pt>
                <c:pt idx="10356">
                  <c:v>772.41600000000005</c:v>
                </c:pt>
                <c:pt idx="10362">
                  <c:v>1300.54</c:v>
                </c:pt>
                <c:pt idx="10368">
                  <c:v>1269.8599999999999</c:v>
                </c:pt>
                <c:pt idx="10370">
                  <c:v>1465.78</c:v>
                </c:pt>
                <c:pt idx="10374">
                  <c:v>1783.73</c:v>
                </c:pt>
                <c:pt idx="10375">
                  <c:v>2173.61</c:v>
                </c:pt>
                <c:pt idx="10377">
                  <c:v>1407.02</c:v>
                </c:pt>
                <c:pt idx="10382">
                  <c:v>1318.68</c:v>
                </c:pt>
                <c:pt idx="10383">
                  <c:v>107.352</c:v>
                </c:pt>
                <c:pt idx="10385">
                  <c:v>1355.18</c:v>
                </c:pt>
                <c:pt idx="10389">
                  <c:v>900.93600000000004</c:v>
                </c:pt>
                <c:pt idx="10403">
                  <c:v>888.40800000000002</c:v>
                </c:pt>
                <c:pt idx="10404">
                  <c:v>1359.94</c:v>
                </c:pt>
                <c:pt idx="10408">
                  <c:v>704.59199999999998</c:v>
                </c:pt>
                <c:pt idx="10410">
                  <c:v>814.53599999999994</c:v>
                </c:pt>
                <c:pt idx="10412">
                  <c:v>1102.68</c:v>
                </c:pt>
                <c:pt idx="10414">
                  <c:v>1594.08</c:v>
                </c:pt>
                <c:pt idx="10416">
                  <c:v>922.10400000000004</c:v>
                </c:pt>
                <c:pt idx="10419">
                  <c:v>850.60799999999995</c:v>
                </c:pt>
                <c:pt idx="10422">
                  <c:v>1008.5</c:v>
                </c:pt>
                <c:pt idx="10425">
                  <c:v>795.31200000000001</c:v>
                </c:pt>
                <c:pt idx="10428">
                  <c:v>1179.3599999999999</c:v>
                </c:pt>
                <c:pt idx="10434">
                  <c:v>1295.1400000000001</c:v>
                </c:pt>
                <c:pt idx="10438">
                  <c:v>814.10400000000004</c:v>
                </c:pt>
                <c:pt idx="10439">
                  <c:v>1677.67</c:v>
                </c:pt>
                <c:pt idx="10441">
                  <c:v>693.79200000000003</c:v>
                </c:pt>
                <c:pt idx="10443">
                  <c:v>1492.34</c:v>
                </c:pt>
                <c:pt idx="10445">
                  <c:v>1084.54</c:v>
                </c:pt>
                <c:pt idx="10446">
                  <c:v>1202.69</c:v>
                </c:pt>
                <c:pt idx="10447">
                  <c:v>2495.4499999999998</c:v>
                </c:pt>
                <c:pt idx="10450">
                  <c:v>1198.58</c:v>
                </c:pt>
                <c:pt idx="10453">
                  <c:v>5125.25</c:v>
                </c:pt>
                <c:pt idx="10454">
                  <c:v>1214.57</c:v>
                </c:pt>
                <c:pt idx="10456">
                  <c:v>833.54399999999998</c:v>
                </c:pt>
                <c:pt idx="10457">
                  <c:v>872.85599999999999</c:v>
                </c:pt>
                <c:pt idx="10460">
                  <c:v>1096.8499999999999</c:v>
                </c:pt>
                <c:pt idx="10462">
                  <c:v>1145.23</c:v>
                </c:pt>
                <c:pt idx="10471">
                  <c:v>1585.22</c:v>
                </c:pt>
                <c:pt idx="10472">
                  <c:v>1643.98</c:v>
                </c:pt>
                <c:pt idx="10474">
                  <c:v>773.06399999999996</c:v>
                </c:pt>
                <c:pt idx="10482">
                  <c:v>1645.92</c:v>
                </c:pt>
                <c:pt idx="10485">
                  <c:v>1491.91</c:v>
                </c:pt>
                <c:pt idx="10486">
                  <c:v>1701.86</c:v>
                </c:pt>
                <c:pt idx="10487">
                  <c:v>1072.8699999999999</c:v>
                </c:pt>
                <c:pt idx="10488">
                  <c:v>1284.77</c:v>
                </c:pt>
                <c:pt idx="10489">
                  <c:v>1002.02</c:v>
                </c:pt>
                <c:pt idx="10511">
                  <c:v>1885.03</c:v>
                </c:pt>
                <c:pt idx="10515">
                  <c:v>2773.66</c:v>
                </c:pt>
                <c:pt idx="10519">
                  <c:v>846.93600000000004</c:v>
                </c:pt>
                <c:pt idx="10522">
                  <c:v>1037.6600000000001</c:v>
                </c:pt>
                <c:pt idx="10526">
                  <c:v>1235.0899999999999</c:v>
                </c:pt>
                <c:pt idx="10533">
                  <c:v>2383.56</c:v>
                </c:pt>
                <c:pt idx="10538">
                  <c:v>1057.0999999999999</c:v>
                </c:pt>
                <c:pt idx="10543">
                  <c:v>773.28</c:v>
                </c:pt>
                <c:pt idx="10546">
                  <c:v>2243.81</c:v>
                </c:pt>
                <c:pt idx="10550">
                  <c:v>760.96799999999996</c:v>
                </c:pt>
                <c:pt idx="10552">
                  <c:v>1041.77</c:v>
                </c:pt>
                <c:pt idx="10556">
                  <c:v>1338.98</c:v>
                </c:pt>
                <c:pt idx="10558">
                  <c:v>509.32799999999997</c:v>
                </c:pt>
                <c:pt idx="10562">
                  <c:v>542.16</c:v>
                </c:pt>
                <c:pt idx="10565">
                  <c:v>1663.2</c:v>
                </c:pt>
                <c:pt idx="10568">
                  <c:v>1051.92</c:v>
                </c:pt>
                <c:pt idx="10570">
                  <c:v>563.11199999999997</c:v>
                </c:pt>
                <c:pt idx="10577">
                  <c:v>1065.31</c:v>
                </c:pt>
                <c:pt idx="10581">
                  <c:v>940.24800000000005</c:v>
                </c:pt>
                <c:pt idx="10586">
                  <c:v>1006.13</c:v>
                </c:pt>
                <c:pt idx="10588">
                  <c:v>1377.65</c:v>
                </c:pt>
                <c:pt idx="10596">
                  <c:v>1168.99</c:v>
                </c:pt>
                <c:pt idx="10597">
                  <c:v>1267.7</c:v>
                </c:pt>
                <c:pt idx="10598">
                  <c:v>894.88800000000003</c:v>
                </c:pt>
                <c:pt idx="10599">
                  <c:v>940.46400000000006</c:v>
                </c:pt>
                <c:pt idx="10600">
                  <c:v>912.6</c:v>
                </c:pt>
                <c:pt idx="10606">
                  <c:v>999.43200000000002</c:v>
                </c:pt>
                <c:pt idx="10609">
                  <c:v>1357.99</c:v>
                </c:pt>
                <c:pt idx="10613">
                  <c:v>1570.1</c:v>
                </c:pt>
                <c:pt idx="10622">
                  <c:v>1143.72</c:v>
                </c:pt>
                <c:pt idx="10624">
                  <c:v>1082.1600000000001</c:v>
                </c:pt>
                <c:pt idx="10626">
                  <c:v>1261.22</c:v>
                </c:pt>
                <c:pt idx="10629">
                  <c:v>834.40800000000002</c:v>
                </c:pt>
                <c:pt idx="10631">
                  <c:v>1201.3900000000001</c:v>
                </c:pt>
                <c:pt idx="10636">
                  <c:v>2072.09</c:v>
                </c:pt>
                <c:pt idx="10638">
                  <c:v>573.69600000000003</c:v>
                </c:pt>
                <c:pt idx="10639">
                  <c:v>1359.07</c:v>
                </c:pt>
                <c:pt idx="10640">
                  <c:v>1192.97</c:v>
                </c:pt>
                <c:pt idx="10647">
                  <c:v>2006.86</c:v>
                </c:pt>
                <c:pt idx="10650">
                  <c:v>1593.22</c:v>
                </c:pt>
                <c:pt idx="10651">
                  <c:v>952.34400000000005</c:v>
                </c:pt>
                <c:pt idx="10663">
                  <c:v>1717.42</c:v>
                </c:pt>
                <c:pt idx="10669">
                  <c:v>850.17600000000004</c:v>
                </c:pt>
                <c:pt idx="10672">
                  <c:v>512.56799999999998</c:v>
                </c:pt>
                <c:pt idx="10674">
                  <c:v>1359.5</c:v>
                </c:pt>
                <c:pt idx="10682">
                  <c:v>1339.63</c:v>
                </c:pt>
                <c:pt idx="10685">
                  <c:v>1136.5899999999999</c:v>
                </c:pt>
                <c:pt idx="10686">
                  <c:v>1586.95</c:v>
                </c:pt>
                <c:pt idx="10689">
                  <c:v>1040.26</c:v>
                </c:pt>
                <c:pt idx="10692">
                  <c:v>1762.34</c:v>
                </c:pt>
                <c:pt idx="10693">
                  <c:v>1650.46</c:v>
                </c:pt>
                <c:pt idx="10696">
                  <c:v>1211.54</c:v>
                </c:pt>
                <c:pt idx="10697">
                  <c:v>1666.44</c:v>
                </c:pt>
                <c:pt idx="10706">
                  <c:v>3084.48</c:v>
                </c:pt>
                <c:pt idx="10715">
                  <c:v>1583.28</c:v>
                </c:pt>
                <c:pt idx="10723">
                  <c:v>628.55999999999995</c:v>
                </c:pt>
                <c:pt idx="10725">
                  <c:v>943.05600000000004</c:v>
                </c:pt>
                <c:pt idx="10726">
                  <c:v>2072.9499999999998</c:v>
                </c:pt>
                <c:pt idx="10729">
                  <c:v>1935.36</c:v>
                </c:pt>
                <c:pt idx="10731">
                  <c:v>1414.8</c:v>
                </c:pt>
                <c:pt idx="10732">
                  <c:v>1323.86</c:v>
                </c:pt>
                <c:pt idx="10735">
                  <c:v>790.99199999999996</c:v>
                </c:pt>
                <c:pt idx="10739">
                  <c:v>2932.63</c:v>
                </c:pt>
                <c:pt idx="10743">
                  <c:v>953.85599999999999</c:v>
                </c:pt>
                <c:pt idx="10744">
                  <c:v>976.53599999999994</c:v>
                </c:pt>
                <c:pt idx="10745">
                  <c:v>630.072</c:v>
                </c:pt>
                <c:pt idx="10747">
                  <c:v>939.16800000000001</c:v>
                </c:pt>
                <c:pt idx="10750">
                  <c:v>1270.3</c:v>
                </c:pt>
                <c:pt idx="10755">
                  <c:v>2832.62</c:v>
                </c:pt>
                <c:pt idx="10756">
                  <c:v>1835.78</c:v>
                </c:pt>
                <c:pt idx="10757">
                  <c:v>1418.26</c:v>
                </c:pt>
                <c:pt idx="10758">
                  <c:v>1553.9</c:v>
                </c:pt>
                <c:pt idx="10766">
                  <c:v>1627.13</c:v>
                </c:pt>
                <c:pt idx="10772">
                  <c:v>2156.7600000000002</c:v>
                </c:pt>
                <c:pt idx="10776">
                  <c:v>1221.48</c:v>
                </c:pt>
                <c:pt idx="10780">
                  <c:v>1295.3499999999999</c:v>
                </c:pt>
                <c:pt idx="10783">
                  <c:v>989.71199999999999</c:v>
                </c:pt>
                <c:pt idx="10785">
                  <c:v>1564.7</c:v>
                </c:pt>
                <c:pt idx="10786">
                  <c:v>4727.16</c:v>
                </c:pt>
                <c:pt idx="10788">
                  <c:v>567.21600000000001</c:v>
                </c:pt>
                <c:pt idx="10796">
                  <c:v>1403.78</c:v>
                </c:pt>
                <c:pt idx="10799">
                  <c:v>1272.46</c:v>
                </c:pt>
                <c:pt idx="10802">
                  <c:v>1469.88</c:v>
                </c:pt>
                <c:pt idx="10815">
                  <c:v>561.16800000000001</c:v>
                </c:pt>
                <c:pt idx="10816">
                  <c:v>903.096</c:v>
                </c:pt>
                <c:pt idx="10817">
                  <c:v>1113.26</c:v>
                </c:pt>
                <c:pt idx="10819">
                  <c:v>1283.69</c:v>
                </c:pt>
                <c:pt idx="10821">
                  <c:v>936.79200000000003</c:v>
                </c:pt>
                <c:pt idx="10822">
                  <c:v>1652.4</c:v>
                </c:pt>
                <c:pt idx="10824">
                  <c:v>2734.99</c:v>
                </c:pt>
                <c:pt idx="10833">
                  <c:v>3970.73</c:v>
                </c:pt>
                <c:pt idx="10834">
                  <c:v>711.072</c:v>
                </c:pt>
                <c:pt idx="10838">
                  <c:v>1789.56</c:v>
                </c:pt>
                <c:pt idx="10839">
                  <c:v>2190.89</c:v>
                </c:pt>
                <c:pt idx="10842">
                  <c:v>1240.7</c:v>
                </c:pt>
                <c:pt idx="10846">
                  <c:v>1552.82</c:v>
                </c:pt>
                <c:pt idx="10847">
                  <c:v>930.74400000000003</c:v>
                </c:pt>
                <c:pt idx="10851">
                  <c:v>1500.55</c:v>
                </c:pt>
                <c:pt idx="10858">
                  <c:v>1190.81</c:v>
                </c:pt>
                <c:pt idx="10860">
                  <c:v>582.12</c:v>
                </c:pt>
                <c:pt idx="10861">
                  <c:v>979.99199999999996</c:v>
                </c:pt>
                <c:pt idx="10862">
                  <c:v>1974.24</c:v>
                </c:pt>
                <c:pt idx="10865">
                  <c:v>1945.73</c:v>
                </c:pt>
                <c:pt idx="10875">
                  <c:v>2447.06</c:v>
                </c:pt>
                <c:pt idx="10878">
                  <c:v>1255.82</c:v>
                </c:pt>
                <c:pt idx="10880">
                  <c:v>352.94400000000002</c:v>
                </c:pt>
                <c:pt idx="10882">
                  <c:v>1075.9000000000001</c:v>
                </c:pt>
                <c:pt idx="10883">
                  <c:v>1552.82</c:v>
                </c:pt>
                <c:pt idx="10885">
                  <c:v>692.49599999999998</c:v>
                </c:pt>
                <c:pt idx="10891">
                  <c:v>1624.32</c:v>
                </c:pt>
                <c:pt idx="10892">
                  <c:v>1070.93</c:v>
                </c:pt>
                <c:pt idx="10894">
                  <c:v>1418.69</c:v>
                </c:pt>
                <c:pt idx="10903">
                  <c:v>2165.83</c:v>
                </c:pt>
                <c:pt idx="10909">
                  <c:v>194.4</c:v>
                </c:pt>
                <c:pt idx="10911">
                  <c:v>1170.29</c:v>
                </c:pt>
                <c:pt idx="10913">
                  <c:v>860.11199999999997</c:v>
                </c:pt>
                <c:pt idx="10915">
                  <c:v>1392.55</c:v>
                </c:pt>
                <c:pt idx="10919">
                  <c:v>1596.89</c:v>
                </c:pt>
                <c:pt idx="10921">
                  <c:v>820.8</c:v>
                </c:pt>
                <c:pt idx="10928">
                  <c:v>5449.46</c:v>
                </c:pt>
                <c:pt idx="10930">
                  <c:v>1127.74</c:v>
                </c:pt>
                <c:pt idx="10932">
                  <c:v>1409.4</c:v>
                </c:pt>
                <c:pt idx="10935">
                  <c:v>2412.7199999999998</c:v>
                </c:pt>
                <c:pt idx="10939">
                  <c:v>965.73599999999999</c:v>
                </c:pt>
                <c:pt idx="10948">
                  <c:v>880.63199999999995</c:v>
                </c:pt>
                <c:pt idx="10952">
                  <c:v>1408.54</c:v>
                </c:pt>
                <c:pt idx="10954">
                  <c:v>714.96</c:v>
                </c:pt>
                <c:pt idx="10955">
                  <c:v>436.10399999999998</c:v>
                </c:pt>
                <c:pt idx="10956">
                  <c:v>1556.71</c:v>
                </c:pt>
                <c:pt idx="10957">
                  <c:v>1805.98</c:v>
                </c:pt>
                <c:pt idx="10958">
                  <c:v>802.44</c:v>
                </c:pt>
                <c:pt idx="10961">
                  <c:v>175.17599999999999</c:v>
                </c:pt>
                <c:pt idx="10964">
                  <c:v>1149.55</c:v>
                </c:pt>
                <c:pt idx="10965">
                  <c:v>2739.53</c:v>
                </c:pt>
                <c:pt idx="10968">
                  <c:v>1241.57</c:v>
                </c:pt>
                <c:pt idx="10969">
                  <c:v>1114.1300000000001</c:v>
                </c:pt>
                <c:pt idx="10972">
                  <c:v>447.12</c:v>
                </c:pt>
                <c:pt idx="10973">
                  <c:v>1412.64</c:v>
                </c:pt>
                <c:pt idx="10975">
                  <c:v>1344.6</c:v>
                </c:pt>
                <c:pt idx="10980">
                  <c:v>825.98400000000004</c:v>
                </c:pt>
                <c:pt idx="10985">
                  <c:v>1575.5</c:v>
                </c:pt>
                <c:pt idx="10993">
                  <c:v>995.11199999999997</c:v>
                </c:pt>
                <c:pt idx="11001">
                  <c:v>676.94399999999996</c:v>
                </c:pt>
                <c:pt idx="11013">
                  <c:v>1680.05</c:v>
                </c:pt>
                <c:pt idx="11016">
                  <c:v>1097.06</c:v>
                </c:pt>
                <c:pt idx="11033">
                  <c:v>1340.71</c:v>
                </c:pt>
                <c:pt idx="11038">
                  <c:v>854.28</c:v>
                </c:pt>
                <c:pt idx="11043">
                  <c:v>1747.66</c:v>
                </c:pt>
                <c:pt idx="11044">
                  <c:v>2017.44</c:v>
                </c:pt>
                <c:pt idx="11049">
                  <c:v>1668.6</c:v>
                </c:pt>
                <c:pt idx="11050">
                  <c:v>1565.78</c:v>
                </c:pt>
                <c:pt idx="11053">
                  <c:v>1436.62</c:v>
                </c:pt>
                <c:pt idx="11054">
                  <c:v>1843.56</c:v>
                </c:pt>
                <c:pt idx="11057">
                  <c:v>1276.78</c:v>
                </c:pt>
                <c:pt idx="11061">
                  <c:v>1032.7</c:v>
                </c:pt>
                <c:pt idx="11068">
                  <c:v>1521.94</c:v>
                </c:pt>
                <c:pt idx="11073">
                  <c:v>1570.1</c:v>
                </c:pt>
                <c:pt idx="11074">
                  <c:v>1853.06</c:v>
                </c:pt>
                <c:pt idx="11076">
                  <c:v>1549.15</c:v>
                </c:pt>
                <c:pt idx="11077">
                  <c:v>1699.27</c:v>
                </c:pt>
                <c:pt idx="11078">
                  <c:v>1216.08</c:v>
                </c:pt>
                <c:pt idx="11079">
                  <c:v>870.91200000000003</c:v>
                </c:pt>
                <c:pt idx="11080">
                  <c:v>1746.79</c:v>
                </c:pt>
                <c:pt idx="11083">
                  <c:v>775.65599999999995</c:v>
                </c:pt>
                <c:pt idx="11085">
                  <c:v>1696.25</c:v>
                </c:pt>
                <c:pt idx="11088">
                  <c:v>2279.4499999999998</c:v>
                </c:pt>
                <c:pt idx="11091">
                  <c:v>2300.4</c:v>
                </c:pt>
                <c:pt idx="11093">
                  <c:v>1331.21</c:v>
                </c:pt>
                <c:pt idx="11094">
                  <c:v>3989.09</c:v>
                </c:pt>
                <c:pt idx="11100">
                  <c:v>1248.9100000000001</c:v>
                </c:pt>
                <c:pt idx="11101">
                  <c:v>4399.0600000000004</c:v>
                </c:pt>
                <c:pt idx="11104">
                  <c:v>495.28800000000001</c:v>
                </c:pt>
                <c:pt idx="11107">
                  <c:v>1088.8599999999999</c:v>
                </c:pt>
                <c:pt idx="11112">
                  <c:v>1957.82</c:v>
                </c:pt>
                <c:pt idx="11118">
                  <c:v>1003.75</c:v>
                </c:pt>
                <c:pt idx="11121">
                  <c:v>880.84799999999996</c:v>
                </c:pt>
                <c:pt idx="11122">
                  <c:v>1219.75</c:v>
                </c:pt>
                <c:pt idx="11127">
                  <c:v>984.096</c:v>
                </c:pt>
                <c:pt idx="11128">
                  <c:v>787.53599999999994</c:v>
                </c:pt>
                <c:pt idx="11129">
                  <c:v>1478.52</c:v>
                </c:pt>
                <c:pt idx="11136">
                  <c:v>1849.82</c:v>
                </c:pt>
                <c:pt idx="11138">
                  <c:v>1821.31</c:v>
                </c:pt>
                <c:pt idx="11146">
                  <c:v>1779.41</c:v>
                </c:pt>
                <c:pt idx="11147">
                  <c:v>1389.53</c:v>
                </c:pt>
                <c:pt idx="11148">
                  <c:v>718.41600000000005</c:v>
                </c:pt>
                <c:pt idx="11150">
                  <c:v>709.77599999999995</c:v>
                </c:pt>
                <c:pt idx="11153">
                  <c:v>2604.96</c:v>
                </c:pt>
                <c:pt idx="11159">
                  <c:v>1414.15</c:v>
                </c:pt>
                <c:pt idx="11160">
                  <c:v>1663.2</c:v>
                </c:pt>
                <c:pt idx="11162">
                  <c:v>1860.41</c:v>
                </c:pt>
                <c:pt idx="11163">
                  <c:v>1036.3699999999999</c:v>
                </c:pt>
                <c:pt idx="11165">
                  <c:v>1233.3599999999999</c:v>
                </c:pt>
                <c:pt idx="11173">
                  <c:v>1531.22</c:v>
                </c:pt>
                <c:pt idx="11177">
                  <c:v>1082.5899999999999</c:v>
                </c:pt>
                <c:pt idx="11178">
                  <c:v>73.656000000000006</c:v>
                </c:pt>
                <c:pt idx="11180">
                  <c:v>1866.67</c:v>
                </c:pt>
                <c:pt idx="11184">
                  <c:v>1996.27</c:v>
                </c:pt>
                <c:pt idx="11186">
                  <c:v>1371.6</c:v>
                </c:pt>
                <c:pt idx="11195">
                  <c:v>616.24800000000005</c:v>
                </c:pt>
                <c:pt idx="11211">
                  <c:v>968.976</c:v>
                </c:pt>
                <c:pt idx="11214">
                  <c:v>1854.58</c:v>
                </c:pt>
                <c:pt idx="11217">
                  <c:v>1349.35</c:v>
                </c:pt>
                <c:pt idx="11218">
                  <c:v>1662.34</c:v>
                </c:pt>
                <c:pt idx="11219">
                  <c:v>2091.7399999999998</c:v>
                </c:pt>
                <c:pt idx="11220">
                  <c:v>1534.68</c:v>
                </c:pt>
                <c:pt idx="11222">
                  <c:v>1812.89</c:v>
                </c:pt>
                <c:pt idx="11225">
                  <c:v>3002.4</c:v>
                </c:pt>
                <c:pt idx="11226">
                  <c:v>1362.74</c:v>
                </c:pt>
                <c:pt idx="11228">
                  <c:v>1867.54</c:v>
                </c:pt>
                <c:pt idx="11232">
                  <c:v>617.54399999999998</c:v>
                </c:pt>
                <c:pt idx="11233">
                  <c:v>2381.62</c:v>
                </c:pt>
                <c:pt idx="11239">
                  <c:v>1059.05</c:v>
                </c:pt>
                <c:pt idx="11242">
                  <c:v>1066.82</c:v>
                </c:pt>
                <c:pt idx="11248">
                  <c:v>1846.58</c:v>
                </c:pt>
                <c:pt idx="11254">
                  <c:v>2066.9</c:v>
                </c:pt>
                <c:pt idx="11265">
                  <c:v>1439.86</c:v>
                </c:pt>
                <c:pt idx="11272">
                  <c:v>1312.63</c:v>
                </c:pt>
                <c:pt idx="11273">
                  <c:v>2329.7800000000002</c:v>
                </c:pt>
                <c:pt idx="11281">
                  <c:v>1663.2</c:v>
                </c:pt>
                <c:pt idx="11283">
                  <c:v>1855.66</c:v>
                </c:pt>
                <c:pt idx="11287">
                  <c:v>1482.41</c:v>
                </c:pt>
                <c:pt idx="11288">
                  <c:v>949.10400000000004</c:v>
                </c:pt>
                <c:pt idx="11292">
                  <c:v>1767.31</c:v>
                </c:pt>
                <c:pt idx="11297">
                  <c:v>1600.34</c:v>
                </c:pt>
                <c:pt idx="11300">
                  <c:v>1310.9</c:v>
                </c:pt>
                <c:pt idx="11301">
                  <c:v>1317.17</c:v>
                </c:pt>
                <c:pt idx="11305">
                  <c:v>2124.14</c:v>
                </c:pt>
                <c:pt idx="11308">
                  <c:v>1437.7</c:v>
                </c:pt>
                <c:pt idx="11310">
                  <c:v>1877.69</c:v>
                </c:pt>
                <c:pt idx="11314">
                  <c:v>1272.8900000000001</c:v>
                </c:pt>
                <c:pt idx="11318">
                  <c:v>1203.98</c:v>
                </c:pt>
                <c:pt idx="11322">
                  <c:v>1181.52</c:v>
                </c:pt>
                <c:pt idx="11326">
                  <c:v>2078.7800000000002</c:v>
                </c:pt>
                <c:pt idx="11327">
                  <c:v>1726.49</c:v>
                </c:pt>
                <c:pt idx="11328">
                  <c:v>1150.42</c:v>
                </c:pt>
                <c:pt idx="11329">
                  <c:v>1956.74</c:v>
                </c:pt>
                <c:pt idx="11335">
                  <c:v>1078.7</c:v>
                </c:pt>
                <c:pt idx="11336">
                  <c:v>681.69600000000003</c:v>
                </c:pt>
                <c:pt idx="11339">
                  <c:v>3410.86</c:v>
                </c:pt>
                <c:pt idx="11341">
                  <c:v>659.66399999999999</c:v>
                </c:pt>
                <c:pt idx="11342">
                  <c:v>2836.73</c:v>
                </c:pt>
                <c:pt idx="11345">
                  <c:v>1385.64</c:v>
                </c:pt>
                <c:pt idx="11351">
                  <c:v>1384.34</c:v>
                </c:pt>
                <c:pt idx="11352">
                  <c:v>1623.67</c:v>
                </c:pt>
                <c:pt idx="11353">
                  <c:v>2398.46</c:v>
                </c:pt>
                <c:pt idx="11354">
                  <c:v>1229.04</c:v>
                </c:pt>
                <c:pt idx="11359">
                  <c:v>2941.49</c:v>
                </c:pt>
                <c:pt idx="11360">
                  <c:v>1629.72</c:v>
                </c:pt>
                <c:pt idx="11367">
                  <c:v>2029.1</c:v>
                </c:pt>
                <c:pt idx="11368">
                  <c:v>1629.5</c:v>
                </c:pt>
                <c:pt idx="11376">
                  <c:v>1859.76</c:v>
                </c:pt>
                <c:pt idx="11379">
                  <c:v>1009.58</c:v>
                </c:pt>
                <c:pt idx="11384">
                  <c:v>1899.72</c:v>
                </c:pt>
                <c:pt idx="11390">
                  <c:v>796.17600000000004</c:v>
                </c:pt>
                <c:pt idx="11397">
                  <c:v>2009.66</c:v>
                </c:pt>
                <c:pt idx="11400">
                  <c:v>917.56799999999998</c:v>
                </c:pt>
                <c:pt idx="11405">
                  <c:v>2373.84</c:v>
                </c:pt>
                <c:pt idx="11407">
                  <c:v>688.82399999999996</c:v>
                </c:pt>
                <c:pt idx="11413">
                  <c:v>5681.23</c:v>
                </c:pt>
                <c:pt idx="11415">
                  <c:v>2617.92</c:v>
                </c:pt>
                <c:pt idx="11416">
                  <c:v>1315.87</c:v>
                </c:pt>
                <c:pt idx="11417">
                  <c:v>1588.46</c:v>
                </c:pt>
                <c:pt idx="11419">
                  <c:v>2393.71</c:v>
                </c:pt>
                <c:pt idx="11421">
                  <c:v>1238.76</c:v>
                </c:pt>
                <c:pt idx="11422">
                  <c:v>2086.9899999999998</c:v>
                </c:pt>
                <c:pt idx="11423">
                  <c:v>125.496</c:v>
                </c:pt>
                <c:pt idx="11425">
                  <c:v>1799.93</c:v>
                </c:pt>
                <c:pt idx="11429">
                  <c:v>1184.1099999999999</c:v>
                </c:pt>
                <c:pt idx="11431">
                  <c:v>11189.9</c:v>
                </c:pt>
                <c:pt idx="11437">
                  <c:v>2560.0300000000002</c:v>
                </c:pt>
                <c:pt idx="11439">
                  <c:v>1266.8399999999999</c:v>
                </c:pt>
                <c:pt idx="11440">
                  <c:v>1594.94</c:v>
                </c:pt>
                <c:pt idx="11445">
                  <c:v>1283.9000000000001</c:v>
                </c:pt>
                <c:pt idx="11446">
                  <c:v>1547.21</c:v>
                </c:pt>
                <c:pt idx="11458">
                  <c:v>1155.17</c:v>
                </c:pt>
                <c:pt idx="11459">
                  <c:v>1172.02</c:v>
                </c:pt>
                <c:pt idx="11462">
                  <c:v>1504.01</c:v>
                </c:pt>
                <c:pt idx="11464">
                  <c:v>1760.18</c:v>
                </c:pt>
                <c:pt idx="11466">
                  <c:v>681.91200000000003</c:v>
                </c:pt>
                <c:pt idx="11471">
                  <c:v>1659.31</c:v>
                </c:pt>
                <c:pt idx="11481">
                  <c:v>2864.16</c:v>
                </c:pt>
                <c:pt idx="11482">
                  <c:v>1736.86</c:v>
                </c:pt>
                <c:pt idx="11486">
                  <c:v>1850.69</c:v>
                </c:pt>
                <c:pt idx="11489">
                  <c:v>884.30399999999997</c:v>
                </c:pt>
                <c:pt idx="11492">
                  <c:v>1397.95</c:v>
                </c:pt>
                <c:pt idx="11493">
                  <c:v>1507.46</c:v>
                </c:pt>
                <c:pt idx="11498">
                  <c:v>2229.34</c:v>
                </c:pt>
                <c:pt idx="11501">
                  <c:v>1223.42</c:v>
                </c:pt>
                <c:pt idx="11505">
                  <c:v>1643.33</c:v>
                </c:pt>
                <c:pt idx="11509">
                  <c:v>3039.12</c:v>
                </c:pt>
                <c:pt idx="11516">
                  <c:v>823.17600000000004</c:v>
                </c:pt>
                <c:pt idx="11518">
                  <c:v>1894.75</c:v>
                </c:pt>
                <c:pt idx="11524">
                  <c:v>1878.34</c:v>
                </c:pt>
                <c:pt idx="11526">
                  <c:v>717.12</c:v>
                </c:pt>
                <c:pt idx="11528">
                  <c:v>2140.7800000000002</c:v>
                </c:pt>
                <c:pt idx="11534">
                  <c:v>2191.54</c:v>
                </c:pt>
                <c:pt idx="11539">
                  <c:v>638.928</c:v>
                </c:pt>
                <c:pt idx="11540">
                  <c:v>1518.91</c:v>
                </c:pt>
                <c:pt idx="11543">
                  <c:v>1979.42</c:v>
                </c:pt>
                <c:pt idx="11553">
                  <c:v>1379.81</c:v>
                </c:pt>
                <c:pt idx="11556">
                  <c:v>1019.09</c:v>
                </c:pt>
                <c:pt idx="11558">
                  <c:v>918.86400000000003</c:v>
                </c:pt>
                <c:pt idx="11560">
                  <c:v>1578.74</c:v>
                </c:pt>
                <c:pt idx="11563">
                  <c:v>2680.34</c:v>
                </c:pt>
                <c:pt idx="11564">
                  <c:v>1745.5</c:v>
                </c:pt>
                <c:pt idx="11567">
                  <c:v>1691.06</c:v>
                </c:pt>
                <c:pt idx="11570">
                  <c:v>1766.45</c:v>
                </c:pt>
                <c:pt idx="11571">
                  <c:v>1367.71</c:v>
                </c:pt>
                <c:pt idx="11575">
                  <c:v>1445.47</c:v>
                </c:pt>
                <c:pt idx="11578">
                  <c:v>2027.81</c:v>
                </c:pt>
                <c:pt idx="11579">
                  <c:v>2729.59</c:v>
                </c:pt>
                <c:pt idx="11580">
                  <c:v>1813.32</c:v>
                </c:pt>
                <c:pt idx="11585">
                  <c:v>1570.32</c:v>
                </c:pt>
                <c:pt idx="11596">
                  <c:v>2135.81</c:v>
                </c:pt>
                <c:pt idx="11598">
                  <c:v>1138.97</c:v>
                </c:pt>
                <c:pt idx="11600">
                  <c:v>898.56</c:v>
                </c:pt>
                <c:pt idx="11605">
                  <c:v>1302.26</c:v>
                </c:pt>
                <c:pt idx="11606">
                  <c:v>1992.6</c:v>
                </c:pt>
                <c:pt idx="11612">
                  <c:v>2080.08</c:v>
                </c:pt>
                <c:pt idx="11615">
                  <c:v>1808.14</c:v>
                </c:pt>
                <c:pt idx="11621">
                  <c:v>1635.55</c:v>
                </c:pt>
                <c:pt idx="11623">
                  <c:v>2579.4699999999998</c:v>
                </c:pt>
                <c:pt idx="11624">
                  <c:v>2043.58</c:v>
                </c:pt>
                <c:pt idx="11628">
                  <c:v>1377.43</c:v>
                </c:pt>
                <c:pt idx="11630">
                  <c:v>215.78399999999999</c:v>
                </c:pt>
                <c:pt idx="11632">
                  <c:v>1262.0899999999999</c:v>
                </c:pt>
                <c:pt idx="11633">
                  <c:v>1552.61</c:v>
                </c:pt>
                <c:pt idx="11634">
                  <c:v>838.29600000000005</c:v>
                </c:pt>
                <c:pt idx="11637">
                  <c:v>1953.5</c:v>
                </c:pt>
                <c:pt idx="11640">
                  <c:v>2538.86</c:v>
                </c:pt>
                <c:pt idx="11648">
                  <c:v>784.08</c:v>
                </c:pt>
                <c:pt idx="11651">
                  <c:v>1196.6400000000001</c:v>
                </c:pt>
                <c:pt idx="11654">
                  <c:v>2704.32</c:v>
                </c:pt>
                <c:pt idx="11655">
                  <c:v>5879.95</c:v>
                </c:pt>
                <c:pt idx="11658">
                  <c:v>1261.44</c:v>
                </c:pt>
                <c:pt idx="11667">
                  <c:v>1254.74</c:v>
                </c:pt>
                <c:pt idx="11669">
                  <c:v>2948.62</c:v>
                </c:pt>
                <c:pt idx="11672">
                  <c:v>1458</c:v>
                </c:pt>
                <c:pt idx="11681">
                  <c:v>1678.1</c:v>
                </c:pt>
                <c:pt idx="11682">
                  <c:v>2382.2600000000002</c:v>
                </c:pt>
                <c:pt idx="11683">
                  <c:v>1998.65</c:v>
                </c:pt>
                <c:pt idx="11684">
                  <c:v>1065.74</c:v>
                </c:pt>
                <c:pt idx="11688">
                  <c:v>3243.67</c:v>
                </c:pt>
                <c:pt idx="11696">
                  <c:v>2208.17</c:v>
                </c:pt>
                <c:pt idx="11708">
                  <c:v>1665.79</c:v>
                </c:pt>
                <c:pt idx="11711">
                  <c:v>1445.26</c:v>
                </c:pt>
                <c:pt idx="11715">
                  <c:v>1277.8599999999999</c:v>
                </c:pt>
                <c:pt idx="11717">
                  <c:v>645.84</c:v>
                </c:pt>
                <c:pt idx="11720">
                  <c:v>1855.22</c:v>
                </c:pt>
                <c:pt idx="11721">
                  <c:v>62.423999999999999</c:v>
                </c:pt>
                <c:pt idx="11724">
                  <c:v>1751.33</c:v>
                </c:pt>
                <c:pt idx="11725">
                  <c:v>2622.24</c:v>
                </c:pt>
                <c:pt idx="11735">
                  <c:v>1884.38</c:v>
                </c:pt>
                <c:pt idx="11737">
                  <c:v>2194.13</c:v>
                </c:pt>
                <c:pt idx="11738">
                  <c:v>2615.11</c:v>
                </c:pt>
                <c:pt idx="11740">
                  <c:v>1362.1</c:v>
                </c:pt>
                <c:pt idx="11741">
                  <c:v>765.50400000000002</c:v>
                </c:pt>
                <c:pt idx="11746">
                  <c:v>1692.36</c:v>
                </c:pt>
                <c:pt idx="11753">
                  <c:v>759.024</c:v>
                </c:pt>
                <c:pt idx="11756">
                  <c:v>1559.74</c:v>
                </c:pt>
                <c:pt idx="11757">
                  <c:v>2184.19</c:v>
                </c:pt>
                <c:pt idx="11764">
                  <c:v>2097.79</c:v>
                </c:pt>
                <c:pt idx="11770">
                  <c:v>2098.87</c:v>
                </c:pt>
                <c:pt idx="11775">
                  <c:v>2209.9</c:v>
                </c:pt>
                <c:pt idx="11780">
                  <c:v>817.56</c:v>
                </c:pt>
                <c:pt idx="11783">
                  <c:v>1674.22</c:v>
                </c:pt>
                <c:pt idx="11790">
                  <c:v>2335.39</c:v>
                </c:pt>
                <c:pt idx="11792">
                  <c:v>2860.27</c:v>
                </c:pt>
                <c:pt idx="11794">
                  <c:v>2093.2600000000002</c:v>
                </c:pt>
                <c:pt idx="11797">
                  <c:v>1160.1400000000001</c:v>
                </c:pt>
                <c:pt idx="11799">
                  <c:v>1864.73</c:v>
                </c:pt>
                <c:pt idx="11806">
                  <c:v>2273.4</c:v>
                </c:pt>
                <c:pt idx="11807">
                  <c:v>2571.6999999999998</c:v>
                </c:pt>
                <c:pt idx="11810">
                  <c:v>1953.94</c:v>
                </c:pt>
                <c:pt idx="11814">
                  <c:v>4311.58</c:v>
                </c:pt>
                <c:pt idx="11815">
                  <c:v>1119.74</c:v>
                </c:pt>
                <c:pt idx="11817">
                  <c:v>1748.3</c:v>
                </c:pt>
                <c:pt idx="11820">
                  <c:v>1163.3800000000001</c:v>
                </c:pt>
                <c:pt idx="11826">
                  <c:v>76.248000000000005</c:v>
                </c:pt>
                <c:pt idx="11827">
                  <c:v>886.46400000000006</c:v>
                </c:pt>
                <c:pt idx="11830">
                  <c:v>1149.1199999999999</c:v>
                </c:pt>
                <c:pt idx="11834">
                  <c:v>1744.63</c:v>
                </c:pt>
                <c:pt idx="11837">
                  <c:v>1318.25</c:v>
                </c:pt>
                <c:pt idx="11847">
                  <c:v>1738.37</c:v>
                </c:pt>
                <c:pt idx="11849">
                  <c:v>2093.4699999999998</c:v>
                </c:pt>
                <c:pt idx="11854">
                  <c:v>5695.06</c:v>
                </c:pt>
                <c:pt idx="11858">
                  <c:v>2541.2399999999998</c:v>
                </c:pt>
                <c:pt idx="11861">
                  <c:v>1238.33</c:v>
                </c:pt>
                <c:pt idx="11865">
                  <c:v>2255.4699999999998</c:v>
                </c:pt>
                <c:pt idx="11871">
                  <c:v>403.05599999999998</c:v>
                </c:pt>
                <c:pt idx="11872">
                  <c:v>1908.79</c:v>
                </c:pt>
                <c:pt idx="11874">
                  <c:v>1514.16</c:v>
                </c:pt>
                <c:pt idx="11877">
                  <c:v>3978.94</c:v>
                </c:pt>
                <c:pt idx="11878">
                  <c:v>825.98400000000004</c:v>
                </c:pt>
                <c:pt idx="11879">
                  <c:v>2997.22</c:v>
                </c:pt>
                <c:pt idx="11882">
                  <c:v>1838.81</c:v>
                </c:pt>
                <c:pt idx="11889">
                  <c:v>1866.67</c:v>
                </c:pt>
                <c:pt idx="11891">
                  <c:v>803.73599999999999</c:v>
                </c:pt>
                <c:pt idx="11896">
                  <c:v>2247.91</c:v>
                </c:pt>
                <c:pt idx="11898">
                  <c:v>1815.91</c:v>
                </c:pt>
                <c:pt idx="11909">
                  <c:v>804.16800000000001</c:v>
                </c:pt>
                <c:pt idx="11910">
                  <c:v>919.08</c:v>
                </c:pt>
                <c:pt idx="11913">
                  <c:v>1903.39</c:v>
                </c:pt>
                <c:pt idx="11918">
                  <c:v>805.24800000000005</c:v>
                </c:pt>
                <c:pt idx="11922">
                  <c:v>3951.07</c:v>
                </c:pt>
                <c:pt idx="11926">
                  <c:v>787.10400000000004</c:v>
                </c:pt>
                <c:pt idx="11935">
                  <c:v>1110.24</c:v>
                </c:pt>
                <c:pt idx="11940">
                  <c:v>1934.5</c:v>
                </c:pt>
                <c:pt idx="11941">
                  <c:v>441.50400000000002</c:v>
                </c:pt>
                <c:pt idx="11946">
                  <c:v>2430.2199999999998</c:v>
                </c:pt>
                <c:pt idx="11955">
                  <c:v>2971.51</c:v>
                </c:pt>
                <c:pt idx="11957">
                  <c:v>1197.5</c:v>
                </c:pt>
                <c:pt idx="11958">
                  <c:v>3278.45</c:v>
                </c:pt>
                <c:pt idx="11962">
                  <c:v>2141.64</c:v>
                </c:pt>
                <c:pt idx="11970">
                  <c:v>1257.98</c:v>
                </c:pt>
                <c:pt idx="11978">
                  <c:v>2799.79</c:v>
                </c:pt>
                <c:pt idx="11979">
                  <c:v>2347.6999999999998</c:v>
                </c:pt>
                <c:pt idx="11980">
                  <c:v>1862.57</c:v>
                </c:pt>
                <c:pt idx="11981">
                  <c:v>1737.94</c:v>
                </c:pt>
                <c:pt idx="11983">
                  <c:v>2018.3</c:v>
                </c:pt>
                <c:pt idx="11984">
                  <c:v>2638.87</c:v>
                </c:pt>
                <c:pt idx="11986">
                  <c:v>1982.23</c:v>
                </c:pt>
                <c:pt idx="11992">
                  <c:v>3370.68</c:v>
                </c:pt>
                <c:pt idx="11993">
                  <c:v>983.66399999999999</c:v>
                </c:pt>
                <c:pt idx="11995">
                  <c:v>1605.96</c:v>
                </c:pt>
                <c:pt idx="12001">
                  <c:v>793.36800000000005</c:v>
                </c:pt>
                <c:pt idx="12005">
                  <c:v>1845.94</c:v>
                </c:pt>
                <c:pt idx="12013">
                  <c:v>2827.22</c:v>
                </c:pt>
                <c:pt idx="12015">
                  <c:v>1083.8900000000001</c:v>
                </c:pt>
                <c:pt idx="12022">
                  <c:v>1310.47</c:v>
                </c:pt>
                <c:pt idx="12029">
                  <c:v>2264.11</c:v>
                </c:pt>
                <c:pt idx="12030">
                  <c:v>1910.09</c:v>
                </c:pt>
                <c:pt idx="12031">
                  <c:v>888.19200000000001</c:v>
                </c:pt>
                <c:pt idx="12032">
                  <c:v>1145.45</c:v>
                </c:pt>
                <c:pt idx="12036">
                  <c:v>1148.26</c:v>
                </c:pt>
                <c:pt idx="12038">
                  <c:v>3592.08</c:v>
                </c:pt>
                <c:pt idx="12040">
                  <c:v>1890.22</c:v>
                </c:pt>
                <c:pt idx="12042">
                  <c:v>1921.1</c:v>
                </c:pt>
                <c:pt idx="12047">
                  <c:v>2372.7600000000002</c:v>
                </c:pt>
                <c:pt idx="12053">
                  <c:v>1583.28</c:v>
                </c:pt>
                <c:pt idx="12056">
                  <c:v>1427.11</c:v>
                </c:pt>
                <c:pt idx="12059">
                  <c:v>1325.81</c:v>
                </c:pt>
                <c:pt idx="12061">
                  <c:v>790.56</c:v>
                </c:pt>
                <c:pt idx="12063">
                  <c:v>1082.5899999999999</c:v>
                </c:pt>
                <c:pt idx="12064">
                  <c:v>1815.05</c:v>
                </c:pt>
                <c:pt idx="12073">
                  <c:v>1665.79</c:v>
                </c:pt>
                <c:pt idx="12074">
                  <c:v>880.41600000000005</c:v>
                </c:pt>
                <c:pt idx="12077">
                  <c:v>1589.11</c:v>
                </c:pt>
                <c:pt idx="12080">
                  <c:v>1544.83</c:v>
                </c:pt>
                <c:pt idx="12083">
                  <c:v>1339.2</c:v>
                </c:pt>
                <c:pt idx="12090">
                  <c:v>845.64</c:v>
                </c:pt>
                <c:pt idx="12091">
                  <c:v>3328.99</c:v>
                </c:pt>
                <c:pt idx="12099">
                  <c:v>922.75199999999995</c:v>
                </c:pt>
                <c:pt idx="12100">
                  <c:v>3190.97</c:v>
                </c:pt>
                <c:pt idx="12103">
                  <c:v>1464.48</c:v>
                </c:pt>
                <c:pt idx="12117">
                  <c:v>865.29600000000005</c:v>
                </c:pt>
                <c:pt idx="12118">
                  <c:v>1613.09</c:v>
                </c:pt>
                <c:pt idx="12123">
                  <c:v>1297.73</c:v>
                </c:pt>
                <c:pt idx="12125">
                  <c:v>767.44799999999998</c:v>
                </c:pt>
                <c:pt idx="12127">
                  <c:v>11687.8</c:v>
                </c:pt>
                <c:pt idx="12134">
                  <c:v>2036.45</c:v>
                </c:pt>
                <c:pt idx="12136">
                  <c:v>882.57600000000002</c:v>
                </c:pt>
                <c:pt idx="12142">
                  <c:v>1095.55</c:v>
                </c:pt>
                <c:pt idx="12143">
                  <c:v>2461.3200000000002</c:v>
                </c:pt>
                <c:pt idx="12144">
                  <c:v>1449.58</c:v>
                </c:pt>
                <c:pt idx="12147">
                  <c:v>3265.49</c:v>
                </c:pt>
                <c:pt idx="12153">
                  <c:v>1310.47</c:v>
                </c:pt>
                <c:pt idx="12162">
                  <c:v>1083.67</c:v>
                </c:pt>
                <c:pt idx="12163">
                  <c:v>2155.0300000000002</c:v>
                </c:pt>
                <c:pt idx="12172">
                  <c:v>1456.27</c:v>
                </c:pt>
                <c:pt idx="12174">
                  <c:v>1623.02</c:v>
                </c:pt>
                <c:pt idx="12182">
                  <c:v>1894.32</c:v>
                </c:pt>
                <c:pt idx="12186">
                  <c:v>1029.24</c:v>
                </c:pt>
                <c:pt idx="12188">
                  <c:v>2759.4</c:v>
                </c:pt>
                <c:pt idx="12193">
                  <c:v>1780.06</c:v>
                </c:pt>
                <c:pt idx="12194">
                  <c:v>2657.66</c:v>
                </c:pt>
                <c:pt idx="12195">
                  <c:v>824.25599999999997</c:v>
                </c:pt>
                <c:pt idx="12197">
                  <c:v>1296.8599999999999</c:v>
                </c:pt>
                <c:pt idx="12208">
                  <c:v>1966.46</c:v>
                </c:pt>
                <c:pt idx="12212">
                  <c:v>1775.09</c:v>
                </c:pt>
                <c:pt idx="12216">
                  <c:v>2109.02</c:v>
                </c:pt>
                <c:pt idx="12218">
                  <c:v>932.25599999999997</c:v>
                </c:pt>
                <c:pt idx="12225">
                  <c:v>1343.74</c:v>
                </c:pt>
                <c:pt idx="12230">
                  <c:v>1292.33</c:v>
                </c:pt>
                <c:pt idx="12232">
                  <c:v>1336.61</c:v>
                </c:pt>
                <c:pt idx="12234">
                  <c:v>2082.02</c:v>
                </c:pt>
                <c:pt idx="12235">
                  <c:v>1689.55</c:v>
                </c:pt>
                <c:pt idx="12236">
                  <c:v>935.06399999999996</c:v>
                </c:pt>
                <c:pt idx="12242">
                  <c:v>1796.47</c:v>
                </c:pt>
                <c:pt idx="12243">
                  <c:v>1706.18</c:v>
                </c:pt>
                <c:pt idx="12250">
                  <c:v>1143.94</c:v>
                </c:pt>
                <c:pt idx="12254">
                  <c:v>147.744</c:v>
                </c:pt>
                <c:pt idx="12259">
                  <c:v>1041.55</c:v>
                </c:pt>
                <c:pt idx="12260">
                  <c:v>1569.24</c:v>
                </c:pt>
                <c:pt idx="12265">
                  <c:v>1390.61</c:v>
                </c:pt>
                <c:pt idx="12269">
                  <c:v>975.24</c:v>
                </c:pt>
                <c:pt idx="12271">
                  <c:v>2071.2199999999998</c:v>
                </c:pt>
                <c:pt idx="12272">
                  <c:v>2690.06</c:v>
                </c:pt>
                <c:pt idx="12279">
                  <c:v>2648.81</c:v>
                </c:pt>
                <c:pt idx="12280">
                  <c:v>1502.5</c:v>
                </c:pt>
                <c:pt idx="12285">
                  <c:v>1133.1400000000001</c:v>
                </c:pt>
                <c:pt idx="12286">
                  <c:v>1594.3</c:v>
                </c:pt>
                <c:pt idx="12297">
                  <c:v>2422.0100000000002</c:v>
                </c:pt>
                <c:pt idx="12301">
                  <c:v>2573.86</c:v>
                </c:pt>
                <c:pt idx="12304">
                  <c:v>2221.9899999999998</c:v>
                </c:pt>
                <c:pt idx="12306">
                  <c:v>1727.14</c:v>
                </c:pt>
                <c:pt idx="12313">
                  <c:v>1986.34</c:v>
                </c:pt>
                <c:pt idx="12320">
                  <c:v>2340.14</c:v>
                </c:pt>
                <c:pt idx="12325">
                  <c:v>1981.37</c:v>
                </c:pt>
                <c:pt idx="12327">
                  <c:v>1953.07</c:v>
                </c:pt>
                <c:pt idx="12330">
                  <c:v>946.08</c:v>
                </c:pt>
                <c:pt idx="12334">
                  <c:v>826.2</c:v>
                </c:pt>
                <c:pt idx="12337">
                  <c:v>1813.97</c:v>
                </c:pt>
                <c:pt idx="12343">
                  <c:v>933.55200000000002</c:v>
                </c:pt>
                <c:pt idx="12350">
                  <c:v>786.88800000000003</c:v>
                </c:pt>
                <c:pt idx="12352">
                  <c:v>682.99199999999996</c:v>
                </c:pt>
                <c:pt idx="12354">
                  <c:v>1019.09</c:v>
                </c:pt>
                <c:pt idx="12361">
                  <c:v>2623.97</c:v>
                </c:pt>
                <c:pt idx="12362">
                  <c:v>1132.92</c:v>
                </c:pt>
                <c:pt idx="12364">
                  <c:v>2038.39</c:v>
                </c:pt>
                <c:pt idx="12365">
                  <c:v>2552.2600000000002</c:v>
                </c:pt>
                <c:pt idx="12373">
                  <c:v>1997.14</c:v>
                </c:pt>
                <c:pt idx="12375">
                  <c:v>2042.93</c:v>
                </c:pt>
                <c:pt idx="12381">
                  <c:v>5273.21</c:v>
                </c:pt>
                <c:pt idx="12393">
                  <c:v>2002.32</c:v>
                </c:pt>
                <c:pt idx="12395">
                  <c:v>1223.21</c:v>
                </c:pt>
                <c:pt idx="12397">
                  <c:v>2124.36</c:v>
                </c:pt>
                <c:pt idx="12404">
                  <c:v>1699.7</c:v>
                </c:pt>
                <c:pt idx="12405">
                  <c:v>2257.42</c:v>
                </c:pt>
                <c:pt idx="12406">
                  <c:v>963.57600000000002</c:v>
                </c:pt>
                <c:pt idx="12407">
                  <c:v>1796.26</c:v>
                </c:pt>
                <c:pt idx="12408">
                  <c:v>1145.6600000000001</c:v>
                </c:pt>
                <c:pt idx="12412">
                  <c:v>1762.34</c:v>
                </c:pt>
                <c:pt idx="12414">
                  <c:v>2289.17</c:v>
                </c:pt>
                <c:pt idx="12415">
                  <c:v>1393.42</c:v>
                </c:pt>
                <c:pt idx="12418">
                  <c:v>1327.75</c:v>
                </c:pt>
                <c:pt idx="12421">
                  <c:v>5716.01</c:v>
                </c:pt>
                <c:pt idx="12423">
                  <c:v>1778.98</c:v>
                </c:pt>
                <c:pt idx="12428">
                  <c:v>2518.9899999999998</c:v>
                </c:pt>
                <c:pt idx="12429">
                  <c:v>1278.72</c:v>
                </c:pt>
                <c:pt idx="12432">
                  <c:v>1473.98</c:v>
                </c:pt>
                <c:pt idx="12435">
                  <c:v>1960.2</c:v>
                </c:pt>
                <c:pt idx="12440">
                  <c:v>1909.44</c:v>
                </c:pt>
                <c:pt idx="12444">
                  <c:v>2237.11</c:v>
                </c:pt>
                <c:pt idx="12447">
                  <c:v>3643.06</c:v>
                </c:pt>
                <c:pt idx="12450">
                  <c:v>1621.08</c:v>
                </c:pt>
                <c:pt idx="12458">
                  <c:v>1635.34</c:v>
                </c:pt>
                <c:pt idx="12461">
                  <c:v>567.86400000000003</c:v>
                </c:pt>
                <c:pt idx="12462">
                  <c:v>2239.4899999999998</c:v>
                </c:pt>
                <c:pt idx="12463">
                  <c:v>2075.98</c:v>
                </c:pt>
                <c:pt idx="12464">
                  <c:v>1951.56</c:v>
                </c:pt>
                <c:pt idx="12469">
                  <c:v>1734.91</c:v>
                </c:pt>
                <c:pt idx="12493">
                  <c:v>1787.4</c:v>
                </c:pt>
                <c:pt idx="12495">
                  <c:v>684.93600000000004</c:v>
                </c:pt>
                <c:pt idx="12501">
                  <c:v>682.77599999999995</c:v>
                </c:pt>
                <c:pt idx="12505">
                  <c:v>1731.24</c:v>
                </c:pt>
                <c:pt idx="12508">
                  <c:v>1259.06</c:v>
                </c:pt>
                <c:pt idx="12510">
                  <c:v>2121.5500000000002</c:v>
                </c:pt>
                <c:pt idx="12512">
                  <c:v>1444.61</c:v>
                </c:pt>
                <c:pt idx="12516">
                  <c:v>2596.1</c:v>
                </c:pt>
                <c:pt idx="12521">
                  <c:v>1524.1</c:v>
                </c:pt>
                <c:pt idx="12535">
                  <c:v>2816.64</c:v>
                </c:pt>
                <c:pt idx="12541">
                  <c:v>1781.78</c:v>
                </c:pt>
                <c:pt idx="12542">
                  <c:v>2620.73</c:v>
                </c:pt>
                <c:pt idx="12544">
                  <c:v>1102.68</c:v>
                </c:pt>
                <c:pt idx="12547">
                  <c:v>2794.39</c:v>
                </c:pt>
                <c:pt idx="12548">
                  <c:v>2858.33</c:v>
                </c:pt>
                <c:pt idx="12559">
                  <c:v>9014.5400000000009</c:v>
                </c:pt>
                <c:pt idx="12561">
                  <c:v>1616.76</c:v>
                </c:pt>
                <c:pt idx="12563">
                  <c:v>2620.94</c:v>
                </c:pt>
                <c:pt idx="12565">
                  <c:v>5913.65</c:v>
                </c:pt>
                <c:pt idx="12568">
                  <c:v>2230.63</c:v>
                </c:pt>
                <c:pt idx="12573">
                  <c:v>1903.18</c:v>
                </c:pt>
                <c:pt idx="12575">
                  <c:v>1119.53</c:v>
                </c:pt>
                <c:pt idx="12583">
                  <c:v>1816.99</c:v>
                </c:pt>
                <c:pt idx="12584">
                  <c:v>3015.36</c:v>
                </c:pt>
                <c:pt idx="12587">
                  <c:v>1936.87</c:v>
                </c:pt>
                <c:pt idx="12592">
                  <c:v>1735.99</c:v>
                </c:pt>
                <c:pt idx="12597">
                  <c:v>1338.55</c:v>
                </c:pt>
                <c:pt idx="12599">
                  <c:v>1546.78</c:v>
                </c:pt>
                <c:pt idx="12604">
                  <c:v>1575.94</c:v>
                </c:pt>
                <c:pt idx="12606">
                  <c:v>1929.1</c:v>
                </c:pt>
                <c:pt idx="12611">
                  <c:v>2606.4699999999998</c:v>
                </c:pt>
                <c:pt idx="12614">
                  <c:v>866.16</c:v>
                </c:pt>
                <c:pt idx="12615">
                  <c:v>2298.02</c:v>
                </c:pt>
                <c:pt idx="12616">
                  <c:v>2529.36</c:v>
                </c:pt>
                <c:pt idx="12620">
                  <c:v>1038.0999999999999</c:v>
                </c:pt>
                <c:pt idx="12628">
                  <c:v>2028.67</c:v>
                </c:pt>
                <c:pt idx="12630">
                  <c:v>1434.89</c:v>
                </c:pt>
                <c:pt idx="12631">
                  <c:v>2542.1</c:v>
                </c:pt>
                <c:pt idx="12632">
                  <c:v>1090.58</c:v>
                </c:pt>
                <c:pt idx="12634">
                  <c:v>1057.32</c:v>
                </c:pt>
                <c:pt idx="12647">
                  <c:v>1192.97</c:v>
                </c:pt>
                <c:pt idx="12649">
                  <c:v>1871.42</c:v>
                </c:pt>
                <c:pt idx="12650">
                  <c:v>2628.07</c:v>
                </c:pt>
                <c:pt idx="12653">
                  <c:v>809.56799999999998</c:v>
                </c:pt>
                <c:pt idx="12658">
                  <c:v>2183.7600000000002</c:v>
                </c:pt>
                <c:pt idx="12662">
                  <c:v>2390.04</c:v>
                </c:pt>
                <c:pt idx="12663">
                  <c:v>1615.25</c:v>
                </c:pt>
                <c:pt idx="12667">
                  <c:v>1793.66</c:v>
                </c:pt>
                <c:pt idx="12673">
                  <c:v>2783.16</c:v>
                </c:pt>
                <c:pt idx="12674">
                  <c:v>1554.12</c:v>
                </c:pt>
                <c:pt idx="12676">
                  <c:v>1696.25</c:v>
                </c:pt>
                <c:pt idx="12686">
                  <c:v>2008.8</c:v>
                </c:pt>
                <c:pt idx="12687">
                  <c:v>2167.34</c:v>
                </c:pt>
                <c:pt idx="12689">
                  <c:v>2731.97</c:v>
                </c:pt>
                <c:pt idx="12694">
                  <c:v>1245.24</c:v>
                </c:pt>
                <c:pt idx="12696">
                  <c:v>1064.45</c:v>
                </c:pt>
                <c:pt idx="12697">
                  <c:v>2177.5</c:v>
                </c:pt>
                <c:pt idx="12706">
                  <c:v>1533.6</c:v>
                </c:pt>
                <c:pt idx="12708">
                  <c:v>2826.58</c:v>
                </c:pt>
                <c:pt idx="12713">
                  <c:v>1744.42</c:v>
                </c:pt>
                <c:pt idx="12717">
                  <c:v>1913.76</c:v>
                </c:pt>
                <c:pt idx="12723">
                  <c:v>2548.37</c:v>
                </c:pt>
                <c:pt idx="12727">
                  <c:v>5102.1400000000003</c:v>
                </c:pt>
                <c:pt idx="12732">
                  <c:v>1432.94</c:v>
                </c:pt>
                <c:pt idx="12737">
                  <c:v>2137.1</c:v>
                </c:pt>
                <c:pt idx="12738">
                  <c:v>1824.12</c:v>
                </c:pt>
                <c:pt idx="12742">
                  <c:v>3464.21</c:v>
                </c:pt>
                <c:pt idx="12743">
                  <c:v>3412.37</c:v>
                </c:pt>
                <c:pt idx="12751">
                  <c:v>2227.8200000000002</c:v>
                </c:pt>
                <c:pt idx="12752">
                  <c:v>548.20799999999997</c:v>
                </c:pt>
                <c:pt idx="12753">
                  <c:v>1145.02</c:v>
                </c:pt>
                <c:pt idx="12756">
                  <c:v>2074.6799999999998</c:v>
                </c:pt>
                <c:pt idx="12757">
                  <c:v>953.64</c:v>
                </c:pt>
                <c:pt idx="12758">
                  <c:v>2312.5</c:v>
                </c:pt>
                <c:pt idx="12759">
                  <c:v>1221.9100000000001</c:v>
                </c:pt>
                <c:pt idx="12760">
                  <c:v>718.2</c:v>
                </c:pt>
                <c:pt idx="12767">
                  <c:v>2836.08</c:v>
                </c:pt>
                <c:pt idx="12768">
                  <c:v>1965.6</c:v>
                </c:pt>
                <c:pt idx="12771">
                  <c:v>1518.26</c:v>
                </c:pt>
                <c:pt idx="12775">
                  <c:v>1502.93</c:v>
                </c:pt>
                <c:pt idx="12776">
                  <c:v>1169.21</c:v>
                </c:pt>
                <c:pt idx="12794">
                  <c:v>810.21600000000001</c:v>
                </c:pt>
                <c:pt idx="12796">
                  <c:v>1602.72</c:v>
                </c:pt>
                <c:pt idx="12797">
                  <c:v>2886.19</c:v>
                </c:pt>
                <c:pt idx="12799">
                  <c:v>2147.4699999999998</c:v>
                </c:pt>
                <c:pt idx="12800">
                  <c:v>1785.24</c:v>
                </c:pt>
                <c:pt idx="12801">
                  <c:v>1305.72</c:v>
                </c:pt>
                <c:pt idx="12803">
                  <c:v>3771.79</c:v>
                </c:pt>
                <c:pt idx="12810">
                  <c:v>2355.48</c:v>
                </c:pt>
                <c:pt idx="12817">
                  <c:v>1966.46</c:v>
                </c:pt>
                <c:pt idx="12819">
                  <c:v>2598.0500000000002</c:v>
                </c:pt>
                <c:pt idx="12823">
                  <c:v>3378.46</c:v>
                </c:pt>
                <c:pt idx="12825">
                  <c:v>2867.18</c:v>
                </c:pt>
                <c:pt idx="12832">
                  <c:v>1910.95</c:v>
                </c:pt>
                <c:pt idx="12835">
                  <c:v>1530.36</c:v>
                </c:pt>
                <c:pt idx="12844">
                  <c:v>1518.91</c:v>
                </c:pt>
                <c:pt idx="12847">
                  <c:v>1245.02</c:v>
                </c:pt>
                <c:pt idx="12853">
                  <c:v>1567.3</c:v>
                </c:pt>
                <c:pt idx="12854">
                  <c:v>840.24</c:v>
                </c:pt>
                <c:pt idx="12859">
                  <c:v>2242.73</c:v>
                </c:pt>
                <c:pt idx="12864">
                  <c:v>3052.51</c:v>
                </c:pt>
                <c:pt idx="12865">
                  <c:v>1466.42</c:v>
                </c:pt>
                <c:pt idx="12867">
                  <c:v>1699.06</c:v>
                </c:pt>
                <c:pt idx="12871">
                  <c:v>3307.61</c:v>
                </c:pt>
                <c:pt idx="12872">
                  <c:v>1111.32</c:v>
                </c:pt>
                <c:pt idx="12875">
                  <c:v>2669.76</c:v>
                </c:pt>
                <c:pt idx="12876">
                  <c:v>1636.2</c:v>
                </c:pt>
                <c:pt idx="12885">
                  <c:v>2801.95</c:v>
                </c:pt>
                <c:pt idx="12887">
                  <c:v>513</c:v>
                </c:pt>
                <c:pt idx="12891">
                  <c:v>2122.42</c:v>
                </c:pt>
                <c:pt idx="12893">
                  <c:v>2050.6999999999998</c:v>
                </c:pt>
                <c:pt idx="12895">
                  <c:v>2371.46</c:v>
                </c:pt>
                <c:pt idx="12898">
                  <c:v>1996.06</c:v>
                </c:pt>
                <c:pt idx="12900">
                  <c:v>1354.97</c:v>
                </c:pt>
                <c:pt idx="12905">
                  <c:v>1665.36</c:v>
                </c:pt>
                <c:pt idx="12914">
                  <c:v>1433.81</c:v>
                </c:pt>
                <c:pt idx="12916">
                  <c:v>1927.8</c:v>
                </c:pt>
                <c:pt idx="12917">
                  <c:v>1980.5</c:v>
                </c:pt>
                <c:pt idx="12921">
                  <c:v>2307.31</c:v>
                </c:pt>
                <c:pt idx="12922">
                  <c:v>4162.75</c:v>
                </c:pt>
                <c:pt idx="12923">
                  <c:v>2107.5100000000002</c:v>
                </c:pt>
                <c:pt idx="12929">
                  <c:v>2308.1799999999998</c:v>
                </c:pt>
                <c:pt idx="12939">
                  <c:v>2331.7199999999998</c:v>
                </c:pt>
                <c:pt idx="12940">
                  <c:v>1016.93</c:v>
                </c:pt>
                <c:pt idx="12945">
                  <c:v>790.99199999999996</c:v>
                </c:pt>
                <c:pt idx="12946">
                  <c:v>2554.63</c:v>
                </c:pt>
                <c:pt idx="12955">
                  <c:v>1802.3</c:v>
                </c:pt>
                <c:pt idx="12957">
                  <c:v>480.38400000000001</c:v>
                </c:pt>
                <c:pt idx="12958">
                  <c:v>1678.75</c:v>
                </c:pt>
                <c:pt idx="12968">
                  <c:v>2616.62</c:v>
                </c:pt>
                <c:pt idx="12979">
                  <c:v>793.15200000000004</c:v>
                </c:pt>
                <c:pt idx="12981">
                  <c:v>2587.25</c:v>
                </c:pt>
                <c:pt idx="12985">
                  <c:v>3288.6</c:v>
                </c:pt>
                <c:pt idx="12988">
                  <c:v>2619</c:v>
                </c:pt>
                <c:pt idx="12991">
                  <c:v>2106.86</c:v>
                </c:pt>
                <c:pt idx="12999">
                  <c:v>1016.93</c:v>
                </c:pt>
                <c:pt idx="13001">
                  <c:v>1153.44</c:v>
                </c:pt>
                <c:pt idx="13008">
                  <c:v>2773.87</c:v>
                </c:pt>
                <c:pt idx="13009">
                  <c:v>846.93600000000004</c:v>
                </c:pt>
                <c:pt idx="13019">
                  <c:v>2730.67</c:v>
                </c:pt>
                <c:pt idx="13021">
                  <c:v>12595.2</c:v>
                </c:pt>
                <c:pt idx="13032">
                  <c:v>1700.57</c:v>
                </c:pt>
                <c:pt idx="13037">
                  <c:v>2846.45</c:v>
                </c:pt>
                <c:pt idx="13039">
                  <c:v>923.61599999999999</c:v>
                </c:pt>
                <c:pt idx="13042">
                  <c:v>1676.38</c:v>
                </c:pt>
                <c:pt idx="13043">
                  <c:v>1647.43</c:v>
                </c:pt>
                <c:pt idx="13052">
                  <c:v>1024.92</c:v>
                </c:pt>
                <c:pt idx="13053">
                  <c:v>2791.37</c:v>
                </c:pt>
                <c:pt idx="13054">
                  <c:v>1885.68</c:v>
                </c:pt>
                <c:pt idx="13055">
                  <c:v>3301.34</c:v>
                </c:pt>
                <c:pt idx="13061">
                  <c:v>1648.51</c:v>
                </c:pt>
                <c:pt idx="13064">
                  <c:v>1653.05</c:v>
                </c:pt>
                <c:pt idx="13066">
                  <c:v>805.68</c:v>
                </c:pt>
                <c:pt idx="13069">
                  <c:v>2769.34</c:v>
                </c:pt>
                <c:pt idx="13071">
                  <c:v>1002.02</c:v>
                </c:pt>
                <c:pt idx="13074">
                  <c:v>3026.38</c:v>
                </c:pt>
                <c:pt idx="13076">
                  <c:v>1704.02</c:v>
                </c:pt>
                <c:pt idx="13078">
                  <c:v>2385.5</c:v>
                </c:pt>
                <c:pt idx="13079">
                  <c:v>3561.19</c:v>
                </c:pt>
                <c:pt idx="13084">
                  <c:v>1062.94</c:v>
                </c:pt>
                <c:pt idx="13086">
                  <c:v>519.48</c:v>
                </c:pt>
                <c:pt idx="13090">
                  <c:v>2391.5500000000002</c:v>
                </c:pt>
                <c:pt idx="13091">
                  <c:v>2379.02</c:v>
                </c:pt>
                <c:pt idx="13092">
                  <c:v>1974.24</c:v>
                </c:pt>
                <c:pt idx="13093">
                  <c:v>1037.02</c:v>
                </c:pt>
                <c:pt idx="13101">
                  <c:v>2484</c:v>
                </c:pt>
                <c:pt idx="13110">
                  <c:v>2583.58</c:v>
                </c:pt>
                <c:pt idx="13112">
                  <c:v>1881.36</c:v>
                </c:pt>
                <c:pt idx="13115">
                  <c:v>1086.48</c:v>
                </c:pt>
                <c:pt idx="13119">
                  <c:v>1806.62</c:v>
                </c:pt>
                <c:pt idx="13122">
                  <c:v>2184.41</c:v>
                </c:pt>
                <c:pt idx="13126">
                  <c:v>3057.48</c:v>
                </c:pt>
                <c:pt idx="13132">
                  <c:v>679.75199999999995</c:v>
                </c:pt>
                <c:pt idx="13136">
                  <c:v>2031.26</c:v>
                </c:pt>
                <c:pt idx="13139">
                  <c:v>3349.08</c:v>
                </c:pt>
                <c:pt idx="13144">
                  <c:v>1748.74</c:v>
                </c:pt>
                <c:pt idx="13145">
                  <c:v>2280.96</c:v>
                </c:pt>
                <c:pt idx="13146">
                  <c:v>2054.16</c:v>
                </c:pt>
                <c:pt idx="13150">
                  <c:v>2221.56</c:v>
                </c:pt>
                <c:pt idx="13152">
                  <c:v>2090.02</c:v>
                </c:pt>
                <c:pt idx="13155">
                  <c:v>1929.1</c:v>
                </c:pt>
                <c:pt idx="13159">
                  <c:v>1331.21</c:v>
                </c:pt>
                <c:pt idx="13160">
                  <c:v>2203.42</c:v>
                </c:pt>
                <c:pt idx="13170">
                  <c:v>2405.38</c:v>
                </c:pt>
                <c:pt idx="13171">
                  <c:v>2900.88</c:v>
                </c:pt>
                <c:pt idx="13173">
                  <c:v>2552.9</c:v>
                </c:pt>
                <c:pt idx="13176">
                  <c:v>3381.7</c:v>
                </c:pt>
                <c:pt idx="13178">
                  <c:v>2201.2600000000002</c:v>
                </c:pt>
                <c:pt idx="13181">
                  <c:v>2072.9499999999998</c:v>
                </c:pt>
                <c:pt idx="13183">
                  <c:v>1858.9</c:v>
                </c:pt>
                <c:pt idx="13191">
                  <c:v>1824.98</c:v>
                </c:pt>
                <c:pt idx="13193">
                  <c:v>2453.7600000000002</c:v>
                </c:pt>
                <c:pt idx="13194">
                  <c:v>3891.46</c:v>
                </c:pt>
                <c:pt idx="13199">
                  <c:v>4209.84</c:v>
                </c:pt>
                <c:pt idx="13209">
                  <c:v>1449.14</c:v>
                </c:pt>
                <c:pt idx="13232">
                  <c:v>1848.53</c:v>
                </c:pt>
                <c:pt idx="13234">
                  <c:v>2439.5</c:v>
                </c:pt>
                <c:pt idx="13239">
                  <c:v>8982.58</c:v>
                </c:pt>
                <c:pt idx="13242">
                  <c:v>1900.15</c:v>
                </c:pt>
                <c:pt idx="13246">
                  <c:v>1828.01</c:v>
                </c:pt>
                <c:pt idx="13249">
                  <c:v>1561.46</c:v>
                </c:pt>
                <c:pt idx="13252">
                  <c:v>2336.9</c:v>
                </c:pt>
                <c:pt idx="13253">
                  <c:v>1117.1500000000001</c:v>
                </c:pt>
                <c:pt idx="13254">
                  <c:v>1588.46</c:v>
                </c:pt>
                <c:pt idx="13258">
                  <c:v>473.47199999999998</c:v>
                </c:pt>
                <c:pt idx="13263">
                  <c:v>2010.53</c:v>
                </c:pt>
                <c:pt idx="13265">
                  <c:v>3026.81</c:v>
                </c:pt>
                <c:pt idx="13269">
                  <c:v>1534.9</c:v>
                </c:pt>
                <c:pt idx="13273">
                  <c:v>3372.84</c:v>
                </c:pt>
                <c:pt idx="13275">
                  <c:v>1782</c:v>
                </c:pt>
                <c:pt idx="13283">
                  <c:v>169.99199999999999</c:v>
                </c:pt>
                <c:pt idx="13284">
                  <c:v>2484.2199999999998</c:v>
                </c:pt>
                <c:pt idx="13285">
                  <c:v>1020.38</c:v>
                </c:pt>
                <c:pt idx="13289">
                  <c:v>1777.25</c:v>
                </c:pt>
                <c:pt idx="13291">
                  <c:v>2156.33</c:v>
                </c:pt>
                <c:pt idx="13300">
                  <c:v>1862.57</c:v>
                </c:pt>
                <c:pt idx="13305">
                  <c:v>1492.99</c:v>
                </c:pt>
                <c:pt idx="13307">
                  <c:v>3855.38</c:v>
                </c:pt>
                <c:pt idx="13308">
                  <c:v>2688.77</c:v>
                </c:pt>
                <c:pt idx="13311">
                  <c:v>2731.97</c:v>
                </c:pt>
                <c:pt idx="13315">
                  <c:v>2706.26</c:v>
                </c:pt>
                <c:pt idx="13317">
                  <c:v>1674.65</c:v>
                </c:pt>
                <c:pt idx="13318">
                  <c:v>2687.9</c:v>
                </c:pt>
                <c:pt idx="13326">
                  <c:v>1293.19</c:v>
                </c:pt>
                <c:pt idx="13330">
                  <c:v>2941.92</c:v>
                </c:pt>
                <c:pt idx="13332">
                  <c:v>2515.9699999999998</c:v>
                </c:pt>
                <c:pt idx="13337">
                  <c:v>1794.74</c:v>
                </c:pt>
                <c:pt idx="13338">
                  <c:v>1268.78</c:v>
                </c:pt>
                <c:pt idx="13341">
                  <c:v>2295</c:v>
                </c:pt>
                <c:pt idx="13343">
                  <c:v>2170.37</c:v>
                </c:pt>
                <c:pt idx="13348">
                  <c:v>2199.31</c:v>
                </c:pt>
                <c:pt idx="13351">
                  <c:v>2588.98</c:v>
                </c:pt>
                <c:pt idx="13357">
                  <c:v>1784.59</c:v>
                </c:pt>
                <c:pt idx="13359">
                  <c:v>2481.62</c:v>
                </c:pt>
                <c:pt idx="13360">
                  <c:v>1869.7</c:v>
                </c:pt>
                <c:pt idx="13363">
                  <c:v>3418.2</c:v>
                </c:pt>
                <c:pt idx="13369">
                  <c:v>562.89599999999996</c:v>
                </c:pt>
                <c:pt idx="13371">
                  <c:v>1754.35</c:v>
                </c:pt>
                <c:pt idx="13372">
                  <c:v>2063.66</c:v>
                </c:pt>
                <c:pt idx="13380">
                  <c:v>2800.22</c:v>
                </c:pt>
                <c:pt idx="13382">
                  <c:v>1459.51</c:v>
                </c:pt>
                <c:pt idx="13385">
                  <c:v>1993.9</c:v>
                </c:pt>
                <c:pt idx="13391">
                  <c:v>3589.92</c:v>
                </c:pt>
                <c:pt idx="13395">
                  <c:v>2146.61</c:v>
                </c:pt>
                <c:pt idx="13397">
                  <c:v>3691.22</c:v>
                </c:pt>
                <c:pt idx="13398">
                  <c:v>2246.83</c:v>
                </c:pt>
                <c:pt idx="13400">
                  <c:v>2752.06</c:v>
                </c:pt>
                <c:pt idx="13414">
                  <c:v>1586.95</c:v>
                </c:pt>
                <c:pt idx="13418">
                  <c:v>1575.5</c:v>
                </c:pt>
                <c:pt idx="13419">
                  <c:v>2133.2199999999998</c:v>
                </c:pt>
                <c:pt idx="13424">
                  <c:v>3702.89</c:v>
                </c:pt>
                <c:pt idx="13425">
                  <c:v>2825.06</c:v>
                </c:pt>
                <c:pt idx="13428">
                  <c:v>457.05599999999998</c:v>
                </c:pt>
                <c:pt idx="13435">
                  <c:v>1597.54</c:v>
                </c:pt>
                <c:pt idx="13437">
                  <c:v>1799.5</c:v>
                </c:pt>
                <c:pt idx="13438">
                  <c:v>1690.63</c:v>
                </c:pt>
                <c:pt idx="13439">
                  <c:v>3734.42</c:v>
                </c:pt>
                <c:pt idx="13442">
                  <c:v>2171.66</c:v>
                </c:pt>
                <c:pt idx="13445">
                  <c:v>3861.43</c:v>
                </c:pt>
                <c:pt idx="13448">
                  <c:v>2170.8000000000002</c:v>
                </c:pt>
                <c:pt idx="13451">
                  <c:v>2924.86</c:v>
                </c:pt>
                <c:pt idx="13453">
                  <c:v>2759.4</c:v>
                </c:pt>
                <c:pt idx="13454">
                  <c:v>3180.38</c:v>
                </c:pt>
                <c:pt idx="13457">
                  <c:v>1945.94</c:v>
                </c:pt>
                <c:pt idx="13463">
                  <c:v>2292.19</c:v>
                </c:pt>
                <c:pt idx="13486">
                  <c:v>555.33600000000001</c:v>
                </c:pt>
                <c:pt idx="13487">
                  <c:v>844.34400000000005</c:v>
                </c:pt>
                <c:pt idx="13491">
                  <c:v>1838.81</c:v>
                </c:pt>
                <c:pt idx="13494">
                  <c:v>3378.67</c:v>
                </c:pt>
                <c:pt idx="13495">
                  <c:v>2680.56</c:v>
                </c:pt>
                <c:pt idx="13496">
                  <c:v>1028.5899999999999</c:v>
                </c:pt>
                <c:pt idx="13501">
                  <c:v>2458.73</c:v>
                </c:pt>
                <c:pt idx="13507">
                  <c:v>1958.69</c:v>
                </c:pt>
                <c:pt idx="13514">
                  <c:v>1415.23</c:v>
                </c:pt>
                <c:pt idx="13515">
                  <c:v>4156.0600000000004</c:v>
                </c:pt>
                <c:pt idx="13518">
                  <c:v>2056.1</c:v>
                </c:pt>
                <c:pt idx="13523">
                  <c:v>6322.75</c:v>
                </c:pt>
                <c:pt idx="13524">
                  <c:v>2187.86</c:v>
                </c:pt>
                <c:pt idx="13532">
                  <c:v>568.08000000000004</c:v>
                </c:pt>
                <c:pt idx="13534">
                  <c:v>2171.88</c:v>
                </c:pt>
                <c:pt idx="13536">
                  <c:v>898.77599999999995</c:v>
                </c:pt>
                <c:pt idx="13537">
                  <c:v>2717.71</c:v>
                </c:pt>
                <c:pt idx="13539">
                  <c:v>1467.94</c:v>
                </c:pt>
                <c:pt idx="13540">
                  <c:v>3712.61</c:v>
                </c:pt>
                <c:pt idx="13547">
                  <c:v>3051.22</c:v>
                </c:pt>
                <c:pt idx="13549">
                  <c:v>3458.38</c:v>
                </c:pt>
                <c:pt idx="13561">
                  <c:v>974.37599999999998</c:v>
                </c:pt>
                <c:pt idx="13563">
                  <c:v>906.55200000000002</c:v>
                </c:pt>
                <c:pt idx="13570">
                  <c:v>4356.29</c:v>
                </c:pt>
                <c:pt idx="13578">
                  <c:v>1793.88</c:v>
                </c:pt>
                <c:pt idx="13579">
                  <c:v>3350.16</c:v>
                </c:pt>
                <c:pt idx="13580">
                  <c:v>1769.04</c:v>
                </c:pt>
                <c:pt idx="13583">
                  <c:v>2067.98</c:v>
                </c:pt>
                <c:pt idx="13589">
                  <c:v>2703.89</c:v>
                </c:pt>
                <c:pt idx="13591">
                  <c:v>1806.19</c:v>
                </c:pt>
                <c:pt idx="13592">
                  <c:v>1889.78</c:v>
                </c:pt>
                <c:pt idx="13594">
                  <c:v>1684.8</c:v>
                </c:pt>
                <c:pt idx="13596">
                  <c:v>1898.64</c:v>
                </c:pt>
                <c:pt idx="13598">
                  <c:v>2775.38</c:v>
                </c:pt>
                <c:pt idx="13600">
                  <c:v>1024.49</c:v>
                </c:pt>
                <c:pt idx="13601">
                  <c:v>3263.98</c:v>
                </c:pt>
                <c:pt idx="13607">
                  <c:v>3654.5</c:v>
                </c:pt>
                <c:pt idx="13614">
                  <c:v>1651.32</c:v>
                </c:pt>
                <c:pt idx="13622">
                  <c:v>5926.61</c:v>
                </c:pt>
                <c:pt idx="13624">
                  <c:v>3756.89</c:v>
                </c:pt>
                <c:pt idx="13625">
                  <c:v>3174.98</c:v>
                </c:pt>
                <c:pt idx="13627">
                  <c:v>4250.88</c:v>
                </c:pt>
                <c:pt idx="13629">
                  <c:v>962.71199999999999</c:v>
                </c:pt>
                <c:pt idx="13630">
                  <c:v>1041.77</c:v>
                </c:pt>
                <c:pt idx="13632">
                  <c:v>4593.67</c:v>
                </c:pt>
                <c:pt idx="13633">
                  <c:v>1979.86</c:v>
                </c:pt>
                <c:pt idx="13635">
                  <c:v>2538</c:v>
                </c:pt>
                <c:pt idx="13636">
                  <c:v>2535.84</c:v>
                </c:pt>
                <c:pt idx="13638">
                  <c:v>2810.16</c:v>
                </c:pt>
                <c:pt idx="13640">
                  <c:v>2348.35</c:v>
                </c:pt>
                <c:pt idx="13642">
                  <c:v>2433.2399999999998</c:v>
                </c:pt>
                <c:pt idx="13651">
                  <c:v>3348.65</c:v>
                </c:pt>
                <c:pt idx="13652">
                  <c:v>262.65600000000001</c:v>
                </c:pt>
                <c:pt idx="13656">
                  <c:v>1087.99</c:v>
                </c:pt>
                <c:pt idx="13659">
                  <c:v>1600.78</c:v>
                </c:pt>
                <c:pt idx="13664">
                  <c:v>169.77600000000001</c:v>
                </c:pt>
                <c:pt idx="13665">
                  <c:v>12805.6</c:v>
                </c:pt>
                <c:pt idx="13666">
                  <c:v>5911.92</c:v>
                </c:pt>
                <c:pt idx="13670">
                  <c:v>3267.22</c:v>
                </c:pt>
                <c:pt idx="13671">
                  <c:v>2801.95</c:v>
                </c:pt>
                <c:pt idx="13674">
                  <c:v>3138.91</c:v>
                </c:pt>
                <c:pt idx="13684">
                  <c:v>2493.7199999999998</c:v>
                </c:pt>
                <c:pt idx="13685">
                  <c:v>1946.38</c:v>
                </c:pt>
                <c:pt idx="13690">
                  <c:v>2065.8200000000002</c:v>
                </c:pt>
                <c:pt idx="13691">
                  <c:v>1224.5</c:v>
                </c:pt>
                <c:pt idx="13692">
                  <c:v>2996.35</c:v>
                </c:pt>
                <c:pt idx="13695">
                  <c:v>2304.29</c:v>
                </c:pt>
                <c:pt idx="13696">
                  <c:v>2096.71</c:v>
                </c:pt>
                <c:pt idx="13698">
                  <c:v>1954.8</c:v>
                </c:pt>
                <c:pt idx="13703">
                  <c:v>2043.79</c:v>
                </c:pt>
                <c:pt idx="13709">
                  <c:v>2634.77</c:v>
                </c:pt>
                <c:pt idx="13727">
                  <c:v>1016.71</c:v>
                </c:pt>
                <c:pt idx="13729">
                  <c:v>3402</c:v>
                </c:pt>
                <c:pt idx="13732">
                  <c:v>1128.3800000000001</c:v>
                </c:pt>
                <c:pt idx="13735">
                  <c:v>1134.8599999999999</c:v>
                </c:pt>
                <c:pt idx="13736">
                  <c:v>1273.97</c:v>
                </c:pt>
                <c:pt idx="13742">
                  <c:v>1015.85</c:v>
                </c:pt>
                <c:pt idx="13745">
                  <c:v>3441.96</c:v>
                </c:pt>
                <c:pt idx="13750">
                  <c:v>2836.08</c:v>
                </c:pt>
                <c:pt idx="13752">
                  <c:v>2584.44</c:v>
                </c:pt>
                <c:pt idx="13760">
                  <c:v>1873.37</c:v>
                </c:pt>
                <c:pt idx="13761">
                  <c:v>3800.52</c:v>
                </c:pt>
                <c:pt idx="13772">
                  <c:v>761.83199999999999</c:v>
                </c:pt>
                <c:pt idx="13776">
                  <c:v>2466.5</c:v>
                </c:pt>
                <c:pt idx="13781">
                  <c:v>2427.41</c:v>
                </c:pt>
                <c:pt idx="13783">
                  <c:v>2275.7800000000002</c:v>
                </c:pt>
                <c:pt idx="13795">
                  <c:v>3365.71</c:v>
                </c:pt>
                <c:pt idx="13800">
                  <c:v>1996.7</c:v>
                </c:pt>
                <c:pt idx="13804">
                  <c:v>1529.28</c:v>
                </c:pt>
                <c:pt idx="13805">
                  <c:v>1835.78</c:v>
                </c:pt>
                <c:pt idx="13808">
                  <c:v>717.98400000000004</c:v>
                </c:pt>
                <c:pt idx="13812">
                  <c:v>4132.7299999999996</c:v>
                </c:pt>
                <c:pt idx="13817">
                  <c:v>1130.33</c:v>
                </c:pt>
                <c:pt idx="13818">
                  <c:v>4364.28</c:v>
                </c:pt>
                <c:pt idx="13820">
                  <c:v>2708.64</c:v>
                </c:pt>
                <c:pt idx="13822">
                  <c:v>3287.95</c:v>
                </c:pt>
                <c:pt idx="13828">
                  <c:v>3994.92</c:v>
                </c:pt>
                <c:pt idx="13833">
                  <c:v>3688.42</c:v>
                </c:pt>
                <c:pt idx="13836">
                  <c:v>407.37599999999998</c:v>
                </c:pt>
                <c:pt idx="13838">
                  <c:v>1463.4</c:v>
                </c:pt>
                <c:pt idx="13839">
                  <c:v>1794.96</c:v>
                </c:pt>
                <c:pt idx="13840">
                  <c:v>2030.62</c:v>
                </c:pt>
                <c:pt idx="13842">
                  <c:v>1462.54</c:v>
                </c:pt>
                <c:pt idx="13845">
                  <c:v>3249.29</c:v>
                </c:pt>
                <c:pt idx="13851">
                  <c:v>3745.22</c:v>
                </c:pt>
                <c:pt idx="13854">
                  <c:v>864.43200000000002</c:v>
                </c:pt>
                <c:pt idx="13857">
                  <c:v>3568.32</c:v>
                </c:pt>
                <c:pt idx="13858">
                  <c:v>1410.26</c:v>
                </c:pt>
                <c:pt idx="13861">
                  <c:v>3112.13</c:v>
                </c:pt>
                <c:pt idx="13862">
                  <c:v>1160.1400000000001</c:v>
                </c:pt>
                <c:pt idx="13867">
                  <c:v>1984.18</c:v>
                </c:pt>
                <c:pt idx="13868">
                  <c:v>2517.2600000000002</c:v>
                </c:pt>
                <c:pt idx="13869">
                  <c:v>3815.86</c:v>
                </c:pt>
                <c:pt idx="13872">
                  <c:v>859.89599999999996</c:v>
                </c:pt>
                <c:pt idx="13873">
                  <c:v>1454.98</c:v>
                </c:pt>
                <c:pt idx="13876">
                  <c:v>2188.5100000000002</c:v>
                </c:pt>
                <c:pt idx="13879">
                  <c:v>2962.87</c:v>
                </c:pt>
                <c:pt idx="13881">
                  <c:v>1902.31</c:v>
                </c:pt>
                <c:pt idx="13882">
                  <c:v>2420.06</c:v>
                </c:pt>
                <c:pt idx="13886">
                  <c:v>3640.03</c:v>
                </c:pt>
                <c:pt idx="13889">
                  <c:v>2467.37</c:v>
                </c:pt>
                <c:pt idx="13890">
                  <c:v>2498.9</c:v>
                </c:pt>
                <c:pt idx="13891">
                  <c:v>863.56799999999998</c:v>
                </c:pt>
                <c:pt idx="13899">
                  <c:v>3011.9</c:v>
                </c:pt>
                <c:pt idx="13901">
                  <c:v>2903.26</c:v>
                </c:pt>
                <c:pt idx="13902">
                  <c:v>4785.7</c:v>
                </c:pt>
                <c:pt idx="13903">
                  <c:v>2629.37</c:v>
                </c:pt>
                <c:pt idx="13913">
                  <c:v>3049.92</c:v>
                </c:pt>
                <c:pt idx="13915">
                  <c:v>3206.52</c:v>
                </c:pt>
                <c:pt idx="13924">
                  <c:v>1943.35</c:v>
                </c:pt>
                <c:pt idx="13925">
                  <c:v>2993.76</c:v>
                </c:pt>
                <c:pt idx="13934">
                  <c:v>2532.38</c:v>
                </c:pt>
                <c:pt idx="13936">
                  <c:v>3410.42</c:v>
                </c:pt>
                <c:pt idx="13941">
                  <c:v>3127.03</c:v>
                </c:pt>
                <c:pt idx="13942">
                  <c:v>2793.96</c:v>
                </c:pt>
                <c:pt idx="13950">
                  <c:v>3336.77</c:v>
                </c:pt>
                <c:pt idx="13960">
                  <c:v>3841.78</c:v>
                </c:pt>
                <c:pt idx="13965">
                  <c:v>3651.7</c:v>
                </c:pt>
                <c:pt idx="13968">
                  <c:v>1855.66</c:v>
                </c:pt>
                <c:pt idx="13970">
                  <c:v>1602.07</c:v>
                </c:pt>
                <c:pt idx="13978">
                  <c:v>1707.7</c:v>
                </c:pt>
                <c:pt idx="13980">
                  <c:v>2732.83</c:v>
                </c:pt>
                <c:pt idx="13982">
                  <c:v>2431.3000000000002</c:v>
                </c:pt>
                <c:pt idx="13983">
                  <c:v>2962.66</c:v>
                </c:pt>
                <c:pt idx="13987">
                  <c:v>3265.27</c:v>
                </c:pt>
                <c:pt idx="13989">
                  <c:v>662.04</c:v>
                </c:pt>
                <c:pt idx="13990">
                  <c:v>3455.14</c:v>
                </c:pt>
                <c:pt idx="13994">
                  <c:v>2861.35</c:v>
                </c:pt>
                <c:pt idx="13996">
                  <c:v>2109.67</c:v>
                </c:pt>
                <c:pt idx="13997">
                  <c:v>2793.96</c:v>
                </c:pt>
                <c:pt idx="14006">
                  <c:v>4695.41</c:v>
                </c:pt>
                <c:pt idx="14009">
                  <c:v>767.88</c:v>
                </c:pt>
                <c:pt idx="14013">
                  <c:v>428.11200000000002</c:v>
                </c:pt>
                <c:pt idx="14018">
                  <c:v>1637.93</c:v>
                </c:pt>
                <c:pt idx="14020">
                  <c:v>1564.49</c:v>
                </c:pt>
                <c:pt idx="14023">
                  <c:v>2282.4699999999998</c:v>
                </c:pt>
                <c:pt idx="14027">
                  <c:v>1932.55</c:v>
                </c:pt>
                <c:pt idx="14034">
                  <c:v>3369.82</c:v>
                </c:pt>
                <c:pt idx="14039">
                  <c:v>999.43200000000002</c:v>
                </c:pt>
                <c:pt idx="14043">
                  <c:v>2087.86</c:v>
                </c:pt>
                <c:pt idx="14044">
                  <c:v>2266.6999999999998</c:v>
                </c:pt>
                <c:pt idx="14045">
                  <c:v>1719.14</c:v>
                </c:pt>
                <c:pt idx="14050">
                  <c:v>3337.42</c:v>
                </c:pt>
                <c:pt idx="14058">
                  <c:v>699.19200000000001</c:v>
                </c:pt>
                <c:pt idx="14060">
                  <c:v>5222.45</c:v>
                </c:pt>
                <c:pt idx="14061">
                  <c:v>2430.2199999999998</c:v>
                </c:pt>
                <c:pt idx="14064">
                  <c:v>630.072</c:v>
                </c:pt>
                <c:pt idx="14069">
                  <c:v>2605.39</c:v>
                </c:pt>
                <c:pt idx="14070">
                  <c:v>2532.38</c:v>
                </c:pt>
                <c:pt idx="14078">
                  <c:v>1140.48</c:v>
                </c:pt>
                <c:pt idx="14079">
                  <c:v>2729.81</c:v>
                </c:pt>
                <c:pt idx="14083">
                  <c:v>1889.35</c:v>
                </c:pt>
                <c:pt idx="14085">
                  <c:v>1634.26</c:v>
                </c:pt>
                <c:pt idx="14095">
                  <c:v>534.16800000000001</c:v>
                </c:pt>
                <c:pt idx="14100">
                  <c:v>1953.07</c:v>
                </c:pt>
                <c:pt idx="14105">
                  <c:v>4439.45</c:v>
                </c:pt>
                <c:pt idx="14110">
                  <c:v>2914.27</c:v>
                </c:pt>
                <c:pt idx="14113">
                  <c:v>2884.9</c:v>
                </c:pt>
                <c:pt idx="14114">
                  <c:v>366.98399999999998</c:v>
                </c:pt>
                <c:pt idx="14115">
                  <c:v>3045.82</c:v>
                </c:pt>
                <c:pt idx="14117">
                  <c:v>3383.42</c:v>
                </c:pt>
                <c:pt idx="14118">
                  <c:v>2820.53</c:v>
                </c:pt>
                <c:pt idx="14127">
                  <c:v>4969.9399999999996</c:v>
                </c:pt>
                <c:pt idx="14130">
                  <c:v>3745.87</c:v>
                </c:pt>
                <c:pt idx="14133">
                  <c:v>5082.05</c:v>
                </c:pt>
                <c:pt idx="14142">
                  <c:v>3220.34</c:v>
                </c:pt>
                <c:pt idx="14143">
                  <c:v>2651.62</c:v>
                </c:pt>
                <c:pt idx="14145">
                  <c:v>3736.37</c:v>
                </c:pt>
                <c:pt idx="14148">
                  <c:v>2034.07</c:v>
                </c:pt>
                <c:pt idx="14149">
                  <c:v>2805.62</c:v>
                </c:pt>
                <c:pt idx="14155">
                  <c:v>1637.28</c:v>
                </c:pt>
                <c:pt idx="14166">
                  <c:v>5389.63</c:v>
                </c:pt>
                <c:pt idx="14167">
                  <c:v>4318.7</c:v>
                </c:pt>
                <c:pt idx="14169">
                  <c:v>2521.37</c:v>
                </c:pt>
                <c:pt idx="14172">
                  <c:v>784.72799999999995</c:v>
                </c:pt>
                <c:pt idx="14173">
                  <c:v>1893.89</c:v>
                </c:pt>
                <c:pt idx="14176">
                  <c:v>4116.3100000000004</c:v>
                </c:pt>
                <c:pt idx="14178">
                  <c:v>787.96799999999996</c:v>
                </c:pt>
                <c:pt idx="14183">
                  <c:v>1825.42</c:v>
                </c:pt>
                <c:pt idx="14186">
                  <c:v>3991.9</c:v>
                </c:pt>
                <c:pt idx="14192">
                  <c:v>1083.67</c:v>
                </c:pt>
                <c:pt idx="14196">
                  <c:v>899.20799999999997</c:v>
                </c:pt>
                <c:pt idx="14201">
                  <c:v>1199.23</c:v>
                </c:pt>
                <c:pt idx="14206">
                  <c:v>2672.57</c:v>
                </c:pt>
                <c:pt idx="14207">
                  <c:v>1811.81</c:v>
                </c:pt>
                <c:pt idx="14210">
                  <c:v>3599.21</c:v>
                </c:pt>
                <c:pt idx="14211">
                  <c:v>3388.61</c:v>
                </c:pt>
                <c:pt idx="14215">
                  <c:v>4764.53</c:v>
                </c:pt>
                <c:pt idx="14218">
                  <c:v>3125.52</c:v>
                </c:pt>
                <c:pt idx="14220">
                  <c:v>2525.9</c:v>
                </c:pt>
                <c:pt idx="14221">
                  <c:v>2811.89</c:v>
                </c:pt>
                <c:pt idx="14224">
                  <c:v>2445.77</c:v>
                </c:pt>
                <c:pt idx="14225">
                  <c:v>2104.4899999999998</c:v>
                </c:pt>
                <c:pt idx="14226">
                  <c:v>3121.2</c:v>
                </c:pt>
                <c:pt idx="14227">
                  <c:v>2774.09</c:v>
                </c:pt>
                <c:pt idx="14232">
                  <c:v>1045.8699999999999</c:v>
                </c:pt>
                <c:pt idx="14236">
                  <c:v>3821.69</c:v>
                </c:pt>
                <c:pt idx="14237">
                  <c:v>1521.72</c:v>
                </c:pt>
                <c:pt idx="14238">
                  <c:v>1894.32</c:v>
                </c:pt>
                <c:pt idx="14241">
                  <c:v>4005.94</c:v>
                </c:pt>
                <c:pt idx="14242">
                  <c:v>5398.06</c:v>
                </c:pt>
                <c:pt idx="14243">
                  <c:v>3155.76</c:v>
                </c:pt>
                <c:pt idx="14244">
                  <c:v>583.41600000000005</c:v>
                </c:pt>
                <c:pt idx="14246">
                  <c:v>2179.2199999999998</c:v>
                </c:pt>
                <c:pt idx="14249">
                  <c:v>1254.74</c:v>
                </c:pt>
                <c:pt idx="14250">
                  <c:v>1058.6199999999999</c:v>
                </c:pt>
                <c:pt idx="14267">
                  <c:v>3857.33</c:v>
                </c:pt>
                <c:pt idx="14268">
                  <c:v>2741.04</c:v>
                </c:pt>
                <c:pt idx="14269">
                  <c:v>3115.8</c:v>
                </c:pt>
                <c:pt idx="14274">
                  <c:v>3043.87</c:v>
                </c:pt>
                <c:pt idx="14276">
                  <c:v>3120.77</c:v>
                </c:pt>
                <c:pt idx="14280">
                  <c:v>4280.6899999999996</c:v>
                </c:pt>
                <c:pt idx="14290">
                  <c:v>3691.87</c:v>
                </c:pt>
                <c:pt idx="14293">
                  <c:v>997.27200000000005</c:v>
                </c:pt>
                <c:pt idx="14295">
                  <c:v>2733.7</c:v>
                </c:pt>
                <c:pt idx="14308">
                  <c:v>515.16</c:v>
                </c:pt>
                <c:pt idx="14314">
                  <c:v>4509.43</c:v>
                </c:pt>
                <c:pt idx="14317">
                  <c:v>3242.16</c:v>
                </c:pt>
                <c:pt idx="14319">
                  <c:v>5989.9</c:v>
                </c:pt>
                <c:pt idx="14327">
                  <c:v>776.73599999999999</c:v>
                </c:pt>
                <c:pt idx="14329">
                  <c:v>3687.12</c:v>
                </c:pt>
                <c:pt idx="14333">
                  <c:v>6070.68</c:v>
                </c:pt>
                <c:pt idx="14341">
                  <c:v>3741.77</c:v>
                </c:pt>
                <c:pt idx="14348">
                  <c:v>665.71199999999999</c:v>
                </c:pt>
                <c:pt idx="14352">
                  <c:v>1804.9</c:v>
                </c:pt>
                <c:pt idx="14353">
                  <c:v>4257.1400000000003</c:v>
                </c:pt>
                <c:pt idx="14356">
                  <c:v>3488.4</c:v>
                </c:pt>
                <c:pt idx="14357">
                  <c:v>3336.12</c:v>
                </c:pt>
                <c:pt idx="14362">
                  <c:v>1420.85</c:v>
                </c:pt>
                <c:pt idx="14363">
                  <c:v>3481.06</c:v>
                </c:pt>
                <c:pt idx="14365">
                  <c:v>714.96</c:v>
                </c:pt>
                <c:pt idx="14373">
                  <c:v>3592.94</c:v>
                </c:pt>
                <c:pt idx="14375">
                  <c:v>2936.09</c:v>
                </c:pt>
                <c:pt idx="14383">
                  <c:v>751.24800000000005</c:v>
                </c:pt>
                <c:pt idx="14386">
                  <c:v>4239.22</c:v>
                </c:pt>
                <c:pt idx="14390">
                  <c:v>3307.18</c:v>
                </c:pt>
                <c:pt idx="14391">
                  <c:v>5096.5200000000004</c:v>
                </c:pt>
                <c:pt idx="14399">
                  <c:v>2854.87</c:v>
                </c:pt>
                <c:pt idx="14408">
                  <c:v>3077.57</c:v>
                </c:pt>
                <c:pt idx="14412">
                  <c:v>1984.61</c:v>
                </c:pt>
                <c:pt idx="14416">
                  <c:v>3418.63</c:v>
                </c:pt>
                <c:pt idx="14418">
                  <c:v>3871.37</c:v>
                </c:pt>
                <c:pt idx="14419">
                  <c:v>3641.54</c:v>
                </c:pt>
                <c:pt idx="14420">
                  <c:v>3099.6</c:v>
                </c:pt>
                <c:pt idx="14421">
                  <c:v>3685.39</c:v>
                </c:pt>
                <c:pt idx="14422">
                  <c:v>3030.48</c:v>
                </c:pt>
                <c:pt idx="14426">
                  <c:v>3238.7</c:v>
                </c:pt>
                <c:pt idx="14427">
                  <c:v>5392.87</c:v>
                </c:pt>
                <c:pt idx="14431">
                  <c:v>3780.22</c:v>
                </c:pt>
                <c:pt idx="14433">
                  <c:v>911.952</c:v>
                </c:pt>
                <c:pt idx="14436">
                  <c:v>4335.7700000000004</c:v>
                </c:pt>
                <c:pt idx="14442">
                  <c:v>2526.98</c:v>
                </c:pt>
                <c:pt idx="14445">
                  <c:v>2757.02</c:v>
                </c:pt>
                <c:pt idx="14446">
                  <c:v>6265.08</c:v>
                </c:pt>
                <c:pt idx="14450">
                  <c:v>2569.54</c:v>
                </c:pt>
                <c:pt idx="14452">
                  <c:v>1853.93</c:v>
                </c:pt>
                <c:pt idx="14454">
                  <c:v>3538.08</c:v>
                </c:pt>
                <c:pt idx="14457">
                  <c:v>4876.8500000000004</c:v>
                </c:pt>
                <c:pt idx="14460">
                  <c:v>5205.6000000000004</c:v>
                </c:pt>
                <c:pt idx="14463">
                  <c:v>2833.06</c:v>
                </c:pt>
                <c:pt idx="14464">
                  <c:v>4178.3</c:v>
                </c:pt>
                <c:pt idx="14468">
                  <c:v>3317.11</c:v>
                </c:pt>
                <c:pt idx="14474">
                  <c:v>1979.64</c:v>
                </c:pt>
                <c:pt idx="14476">
                  <c:v>512.13599999999997</c:v>
                </c:pt>
                <c:pt idx="14480">
                  <c:v>822.31200000000001</c:v>
                </c:pt>
                <c:pt idx="14481">
                  <c:v>3257.06</c:v>
                </c:pt>
                <c:pt idx="14484">
                  <c:v>4163.83</c:v>
                </c:pt>
                <c:pt idx="14490">
                  <c:v>5934.38</c:v>
                </c:pt>
                <c:pt idx="14491">
                  <c:v>2712.96</c:v>
                </c:pt>
                <c:pt idx="14501">
                  <c:v>2646.86</c:v>
                </c:pt>
                <c:pt idx="14502">
                  <c:v>1692.58</c:v>
                </c:pt>
                <c:pt idx="14503">
                  <c:v>3534.84</c:v>
                </c:pt>
                <c:pt idx="14509">
                  <c:v>1827.58</c:v>
                </c:pt>
                <c:pt idx="14516">
                  <c:v>1769.47</c:v>
                </c:pt>
                <c:pt idx="14519">
                  <c:v>3590.14</c:v>
                </c:pt>
                <c:pt idx="14524">
                  <c:v>3730.1</c:v>
                </c:pt>
                <c:pt idx="14527">
                  <c:v>3602.23</c:v>
                </c:pt>
                <c:pt idx="14531">
                  <c:v>4457.38</c:v>
                </c:pt>
                <c:pt idx="14538">
                  <c:v>413.85599999999999</c:v>
                </c:pt>
                <c:pt idx="14539">
                  <c:v>4953.53</c:v>
                </c:pt>
                <c:pt idx="14541">
                  <c:v>2052.2199999999998</c:v>
                </c:pt>
                <c:pt idx="14544">
                  <c:v>3604.18</c:v>
                </c:pt>
                <c:pt idx="14545">
                  <c:v>1700.57</c:v>
                </c:pt>
                <c:pt idx="14558">
                  <c:v>3452.76</c:v>
                </c:pt>
                <c:pt idx="14576">
                  <c:v>4019.33</c:v>
                </c:pt>
                <c:pt idx="14584">
                  <c:v>3465.72</c:v>
                </c:pt>
                <c:pt idx="14589">
                  <c:v>2455.06</c:v>
                </c:pt>
                <c:pt idx="14591">
                  <c:v>1882.01</c:v>
                </c:pt>
                <c:pt idx="14593">
                  <c:v>1154.52</c:v>
                </c:pt>
                <c:pt idx="14597">
                  <c:v>1728.43</c:v>
                </c:pt>
                <c:pt idx="14599">
                  <c:v>4497.55</c:v>
                </c:pt>
                <c:pt idx="14601">
                  <c:v>3420.58</c:v>
                </c:pt>
                <c:pt idx="14603">
                  <c:v>3388.39</c:v>
                </c:pt>
                <c:pt idx="14604">
                  <c:v>4377.46</c:v>
                </c:pt>
                <c:pt idx="14611">
                  <c:v>5225.8999999999996</c:v>
                </c:pt>
                <c:pt idx="14613">
                  <c:v>2679.7</c:v>
                </c:pt>
                <c:pt idx="14625">
                  <c:v>3145.18</c:v>
                </c:pt>
                <c:pt idx="14627">
                  <c:v>5360.69</c:v>
                </c:pt>
                <c:pt idx="14630">
                  <c:v>4056.48</c:v>
                </c:pt>
                <c:pt idx="14633">
                  <c:v>1279.8</c:v>
                </c:pt>
                <c:pt idx="14635">
                  <c:v>2258.71</c:v>
                </c:pt>
                <c:pt idx="14640">
                  <c:v>3620.16</c:v>
                </c:pt>
                <c:pt idx="14644">
                  <c:v>1708.34</c:v>
                </c:pt>
                <c:pt idx="14645">
                  <c:v>4233.6000000000004</c:v>
                </c:pt>
                <c:pt idx="14649">
                  <c:v>3362.47</c:v>
                </c:pt>
                <c:pt idx="14651">
                  <c:v>4122.1400000000003</c:v>
                </c:pt>
                <c:pt idx="14655">
                  <c:v>888.62400000000002</c:v>
                </c:pt>
                <c:pt idx="14656">
                  <c:v>3484.3</c:v>
                </c:pt>
                <c:pt idx="14657">
                  <c:v>4599.5</c:v>
                </c:pt>
                <c:pt idx="14659">
                  <c:v>2722.25</c:v>
                </c:pt>
                <c:pt idx="14660">
                  <c:v>4110.7</c:v>
                </c:pt>
                <c:pt idx="14667">
                  <c:v>88.343999999999994</c:v>
                </c:pt>
                <c:pt idx="14672">
                  <c:v>1016.28</c:v>
                </c:pt>
                <c:pt idx="14675">
                  <c:v>7015.03</c:v>
                </c:pt>
                <c:pt idx="14676">
                  <c:v>4541.83</c:v>
                </c:pt>
                <c:pt idx="14677">
                  <c:v>5056.13</c:v>
                </c:pt>
                <c:pt idx="14681">
                  <c:v>4185</c:v>
                </c:pt>
                <c:pt idx="14693">
                  <c:v>2729.38</c:v>
                </c:pt>
                <c:pt idx="14695">
                  <c:v>806.76</c:v>
                </c:pt>
                <c:pt idx="14698">
                  <c:v>4120.42</c:v>
                </c:pt>
                <c:pt idx="14700">
                  <c:v>3484.94</c:v>
                </c:pt>
                <c:pt idx="14701">
                  <c:v>5994.86</c:v>
                </c:pt>
                <c:pt idx="14704">
                  <c:v>2619.86</c:v>
                </c:pt>
                <c:pt idx="14706">
                  <c:v>3246.7</c:v>
                </c:pt>
                <c:pt idx="14708">
                  <c:v>5156.1400000000003</c:v>
                </c:pt>
                <c:pt idx="14714">
                  <c:v>300.24</c:v>
                </c:pt>
                <c:pt idx="14724">
                  <c:v>3054.02</c:v>
                </c:pt>
                <c:pt idx="14728">
                  <c:v>2233.0100000000002</c:v>
                </c:pt>
                <c:pt idx="14731">
                  <c:v>643.46400000000006</c:v>
                </c:pt>
                <c:pt idx="14737">
                  <c:v>3540.46</c:v>
                </c:pt>
                <c:pt idx="14739">
                  <c:v>5629.18</c:v>
                </c:pt>
                <c:pt idx="14746">
                  <c:v>10469.1</c:v>
                </c:pt>
                <c:pt idx="14747">
                  <c:v>4748.54</c:v>
                </c:pt>
                <c:pt idx="14748">
                  <c:v>578.23199999999997</c:v>
                </c:pt>
                <c:pt idx="14750">
                  <c:v>4398.41</c:v>
                </c:pt>
                <c:pt idx="14752">
                  <c:v>4311.1400000000003</c:v>
                </c:pt>
                <c:pt idx="14755">
                  <c:v>1319.33</c:v>
                </c:pt>
                <c:pt idx="14769">
                  <c:v>7530.19</c:v>
                </c:pt>
                <c:pt idx="14775">
                  <c:v>3527.06</c:v>
                </c:pt>
                <c:pt idx="14779">
                  <c:v>464.83199999999999</c:v>
                </c:pt>
                <c:pt idx="14784">
                  <c:v>445.82400000000001</c:v>
                </c:pt>
                <c:pt idx="14788">
                  <c:v>5240.38</c:v>
                </c:pt>
                <c:pt idx="14789">
                  <c:v>2749.46</c:v>
                </c:pt>
                <c:pt idx="14792">
                  <c:v>1978.56</c:v>
                </c:pt>
                <c:pt idx="14793">
                  <c:v>6349.75</c:v>
                </c:pt>
                <c:pt idx="14800">
                  <c:v>2609.9299999999998</c:v>
                </c:pt>
                <c:pt idx="14802">
                  <c:v>4782.46</c:v>
                </c:pt>
                <c:pt idx="14804">
                  <c:v>3398.76</c:v>
                </c:pt>
                <c:pt idx="14805">
                  <c:v>376.27199999999999</c:v>
                </c:pt>
                <c:pt idx="14807">
                  <c:v>601.12800000000004</c:v>
                </c:pt>
                <c:pt idx="14821">
                  <c:v>2527.42</c:v>
                </c:pt>
                <c:pt idx="14824">
                  <c:v>3303.94</c:v>
                </c:pt>
                <c:pt idx="14836">
                  <c:v>790.77599999999995</c:v>
                </c:pt>
                <c:pt idx="14837">
                  <c:v>4511.59</c:v>
                </c:pt>
                <c:pt idx="14844">
                  <c:v>4942.3</c:v>
                </c:pt>
                <c:pt idx="14853">
                  <c:v>1618.49</c:v>
                </c:pt>
                <c:pt idx="14863">
                  <c:v>2721.82</c:v>
                </c:pt>
                <c:pt idx="14864">
                  <c:v>3537.43</c:v>
                </c:pt>
                <c:pt idx="14865">
                  <c:v>3716.93</c:v>
                </c:pt>
                <c:pt idx="14868">
                  <c:v>2388.5300000000002</c:v>
                </c:pt>
                <c:pt idx="14874">
                  <c:v>2366.71</c:v>
                </c:pt>
                <c:pt idx="14875">
                  <c:v>3031.99</c:v>
                </c:pt>
                <c:pt idx="14877">
                  <c:v>1345.25</c:v>
                </c:pt>
                <c:pt idx="14880">
                  <c:v>1438.99</c:v>
                </c:pt>
                <c:pt idx="14881">
                  <c:v>9451.08</c:v>
                </c:pt>
                <c:pt idx="14883">
                  <c:v>4964.1099999999997</c:v>
                </c:pt>
                <c:pt idx="14890">
                  <c:v>1811.16</c:v>
                </c:pt>
                <c:pt idx="14896">
                  <c:v>776.08799999999997</c:v>
                </c:pt>
                <c:pt idx="14899">
                  <c:v>7045.27</c:v>
                </c:pt>
                <c:pt idx="14900">
                  <c:v>5193.9399999999996</c:v>
                </c:pt>
                <c:pt idx="14901">
                  <c:v>2872.8</c:v>
                </c:pt>
                <c:pt idx="14903">
                  <c:v>3660.55</c:v>
                </c:pt>
                <c:pt idx="14905">
                  <c:v>3103.27</c:v>
                </c:pt>
                <c:pt idx="14907">
                  <c:v>2360.02</c:v>
                </c:pt>
                <c:pt idx="14912">
                  <c:v>1774.87</c:v>
                </c:pt>
                <c:pt idx="14916">
                  <c:v>3949.99</c:v>
                </c:pt>
                <c:pt idx="14917">
                  <c:v>3148.85</c:v>
                </c:pt>
                <c:pt idx="14920">
                  <c:v>4219.13</c:v>
                </c:pt>
                <c:pt idx="14922">
                  <c:v>5361.34</c:v>
                </c:pt>
                <c:pt idx="14923">
                  <c:v>6072.62</c:v>
                </c:pt>
                <c:pt idx="14925">
                  <c:v>3586.25</c:v>
                </c:pt>
                <c:pt idx="14932">
                  <c:v>6088.82</c:v>
                </c:pt>
                <c:pt idx="14938">
                  <c:v>4105.3</c:v>
                </c:pt>
                <c:pt idx="14941">
                  <c:v>2906.5</c:v>
                </c:pt>
                <c:pt idx="14942">
                  <c:v>5018.54</c:v>
                </c:pt>
                <c:pt idx="14945">
                  <c:v>1761.48</c:v>
                </c:pt>
                <c:pt idx="14948">
                  <c:v>2431.73</c:v>
                </c:pt>
                <c:pt idx="14949">
                  <c:v>3442.18</c:v>
                </c:pt>
                <c:pt idx="14954">
                  <c:v>723.6</c:v>
                </c:pt>
                <c:pt idx="14957">
                  <c:v>3892.75</c:v>
                </c:pt>
                <c:pt idx="14967">
                  <c:v>3412.15</c:v>
                </c:pt>
                <c:pt idx="14975">
                  <c:v>2272.9699999999998</c:v>
                </c:pt>
                <c:pt idx="14977">
                  <c:v>3061.37</c:v>
                </c:pt>
                <c:pt idx="14979">
                  <c:v>3716.06</c:v>
                </c:pt>
                <c:pt idx="14984">
                  <c:v>5487.48</c:v>
                </c:pt>
                <c:pt idx="14990">
                  <c:v>5747.54</c:v>
                </c:pt>
                <c:pt idx="14998">
                  <c:v>7246.8</c:v>
                </c:pt>
                <c:pt idx="14999">
                  <c:v>2104.27</c:v>
                </c:pt>
                <c:pt idx="15002">
                  <c:v>3008.02</c:v>
                </c:pt>
                <c:pt idx="15024">
                  <c:v>766.15200000000004</c:v>
                </c:pt>
                <c:pt idx="15026">
                  <c:v>4831.49</c:v>
                </c:pt>
                <c:pt idx="15032">
                  <c:v>422.71199999999999</c:v>
                </c:pt>
                <c:pt idx="15039">
                  <c:v>3322.94</c:v>
                </c:pt>
                <c:pt idx="15043">
                  <c:v>4053.02</c:v>
                </c:pt>
                <c:pt idx="15054">
                  <c:v>1543.54</c:v>
                </c:pt>
                <c:pt idx="15057">
                  <c:v>5584.46</c:v>
                </c:pt>
                <c:pt idx="15059">
                  <c:v>4303.8</c:v>
                </c:pt>
                <c:pt idx="15062">
                  <c:v>4196.88</c:v>
                </c:pt>
                <c:pt idx="15063">
                  <c:v>2710.8</c:v>
                </c:pt>
                <c:pt idx="15066">
                  <c:v>1325.38</c:v>
                </c:pt>
                <c:pt idx="15071">
                  <c:v>3993.19</c:v>
                </c:pt>
                <c:pt idx="15074">
                  <c:v>7042.68</c:v>
                </c:pt>
                <c:pt idx="15082">
                  <c:v>4643.78</c:v>
                </c:pt>
                <c:pt idx="15085">
                  <c:v>5351.18</c:v>
                </c:pt>
                <c:pt idx="15088">
                  <c:v>3166.56</c:v>
                </c:pt>
                <c:pt idx="15090">
                  <c:v>9430.56</c:v>
                </c:pt>
                <c:pt idx="15095">
                  <c:v>2007.94</c:v>
                </c:pt>
                <c:pt idx="15102">
                  <c:v>3483</c:v>
                </c:pt>
                <c:pt idx="15108">
                  <c:v>3823.2</c:v>
                </c:pt>
                <c:pt idx="15109">
                  <c:v>1790.21</c:v>
                </c:pt>
                <c:pt idx="15111">
                  <c:v>4426.92</c:v>
                </c:pt>
                <c:pt idx="15114">
                  <c:v>4389.55</c:v>
                </c:pt>
                <c:pt idx="15115">
                  <c:v>2787.48</c:v>
                </c:pt>
                <c:pt idx="15116">
                  <c:v>5475.6</c:v>
                </c:pt>
                <c:pt idx="15118">
                  <c:v>4061.66</c:v>
                </c:pt>
                <c:pt idx="15119">
                  <c:v>7591.32</c:v>
                </c:pt>
                <c:pt idx="15120">
                  <c:v>2085.91</c:v>
                </c:pt>
                <c:pt idx="15121">
                  <c:v>3051</c:v>
                </c:pt>
                <c:pt idx="15122">
                  <c:v>6438.53</c:v>
                </c:pt>
                <c:pt idx="15128">
                  <c:v>3702.67</c:v>
                </c:pt>
                <c:pt idx="15131">
                  <c:v>4396.03</c:v>
                </c:pt>
                <c:pt idx="15134">
                  <c:v>2299.54</c:v>
                </c:pt>
                <c:pt idx="15139">
                  <c:v>2132.14</c:v>
                </c:pt>
                <c:pt idx="15140">
                  <c:v>2300.1799999999998</c:v>
                </c:pt>
                <c:pt idx="15144">
                  <c:v>4930.2</c:v>
                </c:pt>
                <c:pt idx="15146">
                  <c:v>5160.46</c:v>
                </c:pt>
                <c:pt idx="15150">
                  <c:v>4582.66</c:v>
                </c:pt>
                <c:pt idx="15154">
                  <c:v>3366.58</c:v>
                </c:pt>
                <c:pt idx="15158">
                  <c:v>5803.06</c:v>
                </c:pt>
                <c:pt idx="15163">
                  <c:v>1564.27</c:v>
                </c:pt>
                <c:pt idx="15164">
                  <c:v>8154</c:v>
                </c:pt>
                <c:pt idx="15165">
                  <c:v>4104</c:v>
                </c:pt>
                <c:pt idx="15166">
                  <c:v>6841.8</c:v>
                </c:pt>
                <c:pt idx="15170">
                  <c:v>4500.79</c:v>
                </c:pt>
                <c:pt idx="15174">
                  <c:v>4291.0600000000004</c:v>
                </c:pt>
                <c:pt idx="15176">
                  <c:v>2628.29</c:v>
                </c:pt>
                <c:pt idx="15191">
                  <c:v>5253.77</c:v>
                </c:pt>
                <c:pt idx="15192">
                  <c:v>2298.46</c:v>
                </c:pt>
                <c:pt idx="15203">
                  <c:v>1157.76</c:v>
                </c:pt>
                <c:pt idx="15204">
                  <c:v>1406.59</c:v>
                </c:pt>
                <c:pt idx="15206">
                  <c:v>6929.93</c:v>
                </c:pt>
                <c:pt idx="15209">
                  <c:v>7188.48</c:v>
                </c:pt>
                <c:pt idx="15212">
                  <c:v>5193.72</c:v>
                </c:pt>
                <c:pt idx="15213">
                  <c:v>8216.42</c:v>
                </c:pt>
                <c:pt idx="15217">
                  <c:v>7425.86</c:v>
                </c:pt>
                <c:pt idx="15222">
                  <c:v>1780.49</c:v>
                </c:pt>
                <c:pt idx="15227">
                  <c:v>1473.55</c:v>
                </c:pt>
                <c:pt idx="15234">
                  <c:v>5762.66</c:v>
                </c:pt>
                <c:pt idx="15238">
                  <c:v>1112.18</c:v>
                </c:pt>
                <c:pt idx="15245">
                  <c:v>3583.44</c:v>
                </c:pt>
                <c:pt idx="15249">
                  <c:v>5471.71</c:v>
                </c:pt>
                <c:pt idx="15261">
                  <c:v>7451.14</c:v>
                </c:pt>
                <c:pt idx="15262">
                  <c:v>2878.42</c:v>
                </c:pt>
                <c:pt idx="15263">
                  <c:v>4596.4799999999996</c:v>
                </c:pt>
                <c:pt idx="15264">
                  <c:v>5439.31</c:v>
                </c:pt>
                <c:pt idx="15265">
                  <c:v>6706.8</c:v>
                </c:pt>
                <c:pt idx="15269">
                  <c:v>785.80799999999999</c:v>
                </c:pt>
                <c:pt idx="15270">
                  <c:v>2663.71</c:v>
                </c:pt>
                <c:pt idx="15274">
                  <c:v>3966.41</c:v>
                </c:pt>
                <c:pt idx="15278">
                  <c:v>5326.34</c:v>
                </c:pt>
                <c:pt idx="15283">
                  <c:v>6487.78</c:v>
                </c:pt>
                <c:pt idx="15287">
                  <c:v>2225.23</c:v>
                </c:pt>
                <c:pt idx="15295">
                  <c:v>4255.63</c:v>
                </c:pt>
                <c:pt idx="15302">
                  <c:v>10146</c:v>
                </c:pt>
                <c:pt idx="15305">
                  <c:v>4412.88</c:v>
                </c:pt>
                <c:pt idx="15307">
                  <c:v>1669.25</c:v>
                </c:pt>
                <c:pt idx="15308">
                  <c:v>6486.26</c:v>
                </c:pt>
                <c:pt idx="15309">
                  <c:v>5001.7</c:v>
                </c:pt>
                <c:pt idx="15315">
                  <c:v>2953.37</c:v>
                </c:pt>
                <c:pt idx="15316">
                  <c:v>2422.87</c:v>
                </c:pt>
                <c:pt idx="15318">
                  <c:v>1102.9000000000001</c:v>
                </c:pt>
                <c:pt idx="15319">
                  <c:v>4601.88</c:v>
                </c:pt>
                <c:pt idx="15320">
                  <c:v>5265</c:v>
                </c:pt>
                <c:pt idx="15325">
                  <c:v>2896.99</c:v>
                </c:pt>
                <c:pt idx="15329">
                  <c:v>3654.07</c:v>
                </c:pt>
                <c:pt idx="15331">
                  <c:v>3006.29</c:v>
                </c:pt>
                <c:pt idx="15333">
                  <c:v>886.24800000000005</c:v>
                </c:pt>
                <c:pt idx="15334">
                  <c:v>2939.54</c:v>
                </c:pt>
                <c:pt idx="15352">
                  <c:v>5222.2299999999996</c:v>
                </c:pt>
                <c:pt idx="15355">
                  <c:v>7087.82</c:v>
                </c:pt>
                <c:pt idx="15357">
                  <c:v>3312.14</c:v>
                </c:pt>
                <c:pt idx="15360">
                  <c:v>1116.07</c:v>
                </c:pt>
                <c:pt idx="15366">
                  <c:v>4504.68</c:v>
                </c:pt>
                <c:pt idx="15378">
                  <c:v>77.328000000000003</c:v>
                </c:pt>
                <c:pt idx="15381">
                  <c:v>1274.4000000000001</c:v>
                </c:pt>
                <c:pt idx="15384">
                  <c:v>3954.74</c:v>
                </c:pt>
                <c:pt idx="15386">
                  <c:v>5592.67</c:v>
                </c:pt>
                <c:pt idx="15388">
                  <c:v>3830.54</c:v>
                </c:pt>
                <c:pt idx="15389">
                  <c:v>6253.63</c:v>
                </c:pt>
                <c:pt idx="15391">
                  <c:v>964.87199999999996</c:v>
                </c:pt>
                <c:pt idx="15392">
                  <c:v>4145.04</c:v>
                </c:pt>
                <c:pt idx="15397">
                  <c:v>5001.05</c:v>
                </c:pt>
                <c:pt idx="15401">
                  <c:v>5736.53</c:v>
                </c:pt>
                <c:pt idx="15410">
                  <c:v>6007.18</c:v>
                </c:pt>
                <c:pt idx="15411">
                  <c:v>6925.39</c:v>
                </c:pt>
                <c:pt idx="15416">
                  <c:v>7503.62</c:v>
                </c:pt>
                <c:pt idx="15423">
                  <c:v>5568.05</c:v>
                </c:pt>
                <c:pt idx="15429">
                  <c:v>4721.9799999999996</c:v>
                </c:pt>
                <c:pt idx="15430">
                  <c:v>9816.34</c:v>
                </c:pt>
                <c:pt idx="15431">
                  <c:v>473.47199999999998</c:v>
                </c:pt>
                <c:pt idx="15436">
                  <c:v>2569.9699999999998</c:v>
                </c:pt>
                <c:pt idx="15439">
                  <c:v>7006.39</c:v>
                </c:pt>
                <c:pt idx="15440">
                  <c:v>2700.65</c:v>
                </c:pt>
                <c:pt idx="15442">
                  <c:v>6383.02</c:v>
                </c:pt>
                <c:pt idx="15443">
                  <c:v>533.52</c:v>
                </c:pt>
                <c:pt idx="15445">
                  <c:v>8133.91</c:v>
                </c:pt>
                <c:pt idx="15446">
                  <c:v>5214.67</c:v>
                </c:pt>
                <c:pt idx="15453">
                  <c:v>8885.16</c:v>
                </c:pt>
                <c:pt idx="15455">
                  <c:v>2297.38</c:v>
                </c:pt>
                <c:pt idx="15456">
                  <c:v>704.80799999999999</c:v>
                </c:pt>
                <c:pt idx="15460">
                  <c:v>2819.23</c:v>
                </c:pt>
                <c:pt idx="15462">
                  <c:v>5599.37</c:v>
                </c:pt>
                <c:pt idx="15464">
                  <c:v>1735.13</c:v>
                </c:pt>
                <c:pt idx="15470">
                  <c:v>4043.74</c:v>
                </c:pt>
                <c:pt idx="15471">
                  <c:v>7921.58</c:v>
                </c:pt>
                <c:pt idx="15478">
                  <c:v>1931.9</c:v>
                </c:pt>
                <c:pt idx="15480">
                  <c:v>3905.06</c:v>
                </c:pt>
                <c:pt idx="15482">
                  <c:v>986.904</c:v>
                </c:pt>
                <c:pt idx="15484">
                  <c:v>1773.36</c:v>
                </c:pt>
                <c:pt idx="15486">
                  <c:v>1878.12</c:v>
                </c:pt>
                <c:pt idx="15490">
                  <c:v>4834.08</c:v>
                </c:pt>
                <c:pt idx="15501">
                  <c:v>3147.98</c:v>
                </c:pt>
                <c:pt idx="15502">
                  <c:v>2644.92</c:v>
                </c:pt>
                <c:pt idx="15503">
                  <c:v>2308.1799999999998</c:v>
                </c:pt>
                <c:pt idx="15505">
                  <c:v>5403.24</c:v>
                </c:pt>
                <c:pt idx="15509">
                  <c:v>9233.14</c:v>
                </c:pt>
                <c:pt idx="15510">
                  <c:v>4058.86</c:v>
                </c:pt>
                <c:pt idx="15511">
                  <c:v>12994.6</c:v>
                </c:pt>
                <c:pt idx="15519">
                  <c:v>6411.1</c:v>
                </c:pt>
                <c:pt idx="15520">
                  <c:v>3019.9</c:v>
                </c:pt>
                <c:pt idx="15541">
                  <c:v>1050.8399999999999</c:v>
                </c:pt>
                <c:pt idx="15548">
                  <c:v>4917.24</c:v>
                </c:pt>
                <c:pt idx="15549">
                  <c:v>9553.4599999999991</c:v>
                </c:pt>
                <c:pt idx="15556">
                  <c:v>8385.1200000000008</c:v>
                </c:pt>
                <c:pt idx="15566">
                  <c:v>6230.3</c:v>
                </c:pt>
                <c:pt idx="15567">
                  <c:v>7900.2</c:v>
                </c:pt>
                <c:pt idx="15568">
                  <c:v>7059.1</c:v>
                </c:pt>
                <c:pt idx="15574">
                  <c:v>4892.3999999999996</c:v>
                </c:pt>
                <c:pt idx="15575">
                  <c:v>8163.72</c:v>
                </c:pt>
                <c:pt idx="15576">
                  <c:v>3226.82</c:v>
                </c:pt>
                <c:pt idx="15579">
                  <c:v>3382.78</c:v>
                </c:pt>
                <c:pt idx="15584">
                  <c:v>8346.67</c:v>
                </c:pt>
                <c:pt idx="15585">
                  <c:v>4499.5</c:v>
                </c:pt>
                <c:pt idx="15595">
                  <c:v>6073.92</c:v>
                </c:pt>
                <c:pt idx="15603">
                  <c:v>4776.41</c:v>
                </c:pt>
                <c:pt idx="15605">
                  <c:v>3236.98</c:v>
                </c:pt>
                <c:pt idx="15606">
                  <c:v>1059.7</c:v>
                </c:pt>
                <c:pt idx="15609">
                  <c:v>7753.54</c:v>
                </c:pt>
                <c:pt idx="15611">
                  <c:v>1032.7</c:v>
                </c:pt>
                <c:pt idx="15614">
                  <c:v>10317</c:v>
                </c:pt>
                <c:pt idx="15617">
                  <c:v>4974.4799999999996</c:v>
                </c:pt>
                <c:pt idx="15618">
                  <c:v>14558.6</c:v>
                </c:pt>
                <c:pt idx="15631">
                  <c:v>3049.06</c:v>
                </c:pt>
                <c:pt idx="15637">
                  <c:v>6011.71</c:v>
                </c:pt>
                <c:pt idx="15638">
                  <c:v>10010.1</c:v>
                </c:pt>
                <c:pt idx="15643">
                  <c:v>2504.3000000000002</c:v>
                </c:pt>
                <c:pt idx="15651">
                  <c:v>1236.3800000000001</c:v>
                </c:pt>
                <c:pt idx="15653">
                  <c:v>7707.96</c:v>
                </c:pt>
                <c:pt idx="15654">
                  <c:v>2578.61</c:v>
                </c:pt>
                <c:pt idx="15657">
                  <c:v>1099.22</c:v>
                </c:pt>
                <c:pt idx="15663">
                  <c:v>12674.4</c:v>
                </c:pt>
                <c:pt idx="15669">
                  <c:v>9237.67</c:v>
                </c:pt>
                <c:pt idx="15674">
                  <c:v>8244.5</c:v>
                </c:pt>
                <c:pt idx="15681">
                  <c:v>4190.83</c:v>
                </c:pt>
                <c:pt idx="15682">
                  <c:v>5553.58</c:v>
                </c:pt>
                <c:pt idx="15689">
                  <c:v>6139.15</c:v>
                </c:pt>
                <c:pt idx="15693">
                  <c:v>4303.37</c:v>
                </c:pt>
                <c:pt idx="15696">
                  <c:v>4023.86</c:v>
                </c:pt>
                <c:pt idx="15702">
                  <c:v>1227.31</c:v>
                </c:pt>
                <c:pt idx="15703">
                  <c:v>5405.18</c:v>
                </c:pt>
                <c:pt idx="15713">
                  <c:v>5427.22</c:v>
                </c:pt>
                <c:pt idx="15715">
                  <c:v>3870.94</c:v>
                </c:pt>
                <c:pt idx="15720">
                  <c:v>4585.46</c:v>
                </c:pt>
                <c:pt idx="15721">
                  <c:v>7592.18</c:v>
                </c:pt>
                <c:pt idx="15723">
                  <c:v>5422.03</c:v>
                </c:pt>
                <c:pt idx="15724">
                  <c:v>7085.23</c:v>
                </c:pt>
                <c:pt idx="15730">
                  <c:v>5776.7</c:v>
                </c:pt>
                <c:pt idx="15731">
                  <c:v>5240.16</c:v>
                </c:pt>
                <c:pt idx="15732">
                  <c:v>2807.35</c:v>
                </c:pt>
                <c:pt idx="15733">
                  <c:v>10116.6</c:v>
                </c:pt>
                <c:pt idx="15734">
                  <c:v>9716.76</c:v>
                </c:pt>
                <c:pt idx="15739">
                  <c:v>8969.4</c:v>
                </c:pt>
                <c:pt idx="15742">
                  <c:v>6190.99</c:v>
                </c:pt>
                <c:pt idx="15744">
                  <c:v>2760.48</c:v>
                </c:pt>
                <c:pt idx="15749">
                  <c:v>6921.94</c:v>
                </c:pt>
                <c:pt idx="15750">
                  <c:v>4736.45</c:v>
                </c:pt>
                <c:pt idx="15751">
                  <c:v>5456.59</c:v>
                </c:pt>
                <c:pt idx="15752">
                  <c:v>7352.64</c:v>
                </c:pt>
                <c:pt idx="15760">
                  <c:v>3378.24</c:v>
                </c:pt>
                <c:pt idx="15762">
                  <c:v>5510.81</c:v>
                </c:pt>
                <c:pt idx="15767">
                  <c:v>5105.38</c:v>
                </c:pt>
                <c:pt idx="15773">
                  <c:v>4290.41</c:v>
                </c:pt>
                <c:pt idx="15781">
                  <c:v>1403.78</c:v>
                </c:pt>
                <c:pt idx="15783">
                  <c:v>16245.8</c:v>
                </c:pt>
                <c:pt idx="15784">
                  <c:v>4337.71</c:v>
                </c:pt>
                <c:pt idx="15787">
                  <c:v>2210.11</c:v>
                </c:pt>
                <c:pt idx="15788">
                  <c:v>11025.3</c:v>
                </c:pt>
                <c:pt idx="15789">
                  <c:v>662.68799999999999</c:v>
                </c:pt>
                <c:pt idx="15792">
                  <c:v>3482.14</c:v>
                </c:pt>
                <c:pt idx="15794">
                  <c:v>5114.45</c:v>
                </c:pt>
                <c:pt idx="15799">
                  <c:v>4720.46</c:v>
                </c:pt>
                <c:pt idx="15807">
                  <c:v>3313.66</c:v>
                </c:pt>
                <c:pt idx="15816">
                  <c:v>6670.51</c:v>
                </c:pt>
                <c:pt idx="15820">
                  <c:v>5863.75</c:v>
                </c:pt>
                <c:pt idx="15822">
                  <c:v>6054.48</c:v>
                </c:pt>
                <c:pt idx="15823">
                  <c:v>4891.1000000000004</c:v>
                </c:pt>
                <c:pt idx="15838">
                  <c:v>7034.26</c:v>
                </c:pt>
                <c:pt idx="15840">
                  <c:v>6811.34</c:v>
                </c:pt>
                <c:pt idx="15845">
                  <c:v>7311.38</c:v>
                </c:pt>
                <c:pt idx="15846">
                  <c:v>4322.59</c:v>
                </c:pt>
                <c:pt idx="15848">
                  <c:v>9356.69</c:v>
                </c:pt>
                <c:pt idx="15849">
                  <c:v>8471.74</c:v>
                </c:pt>
                <c:pt idx="15853">
                  <c:v>4359.96</c:v>
                </c:pt>
                <c:pt idx="15858">
                  <c:v>7652.45</c:v>
                </c:pt>
                <c:pt idx="15864">
                  <c:v>1965.38</c:v>
                </c:pt>
                <c:pt idx="15866">
                  <c:v>10979.3</c:v>
                </c:pt>
                <c:pt idx="15867">
                  <c:v>3111.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6B8-4AC3-B3A4-179EA235EF24}"/>
            </c:ext>
          </c:extLst>
        </c:ser>
        <c:ser>
          <c:idx val="2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>
                  <a:alpha val="70000"/>
                </a:srgbClr>
              </a:solidFill>
              <a:ln w="9525">
                <a:noFill/>
              </a:ln>
              <a:effectLst/>
            </c:spPr>
          </c:marker>
          <c:yVal>
            <c:numRef>
              <c:f>'full root volumes'!$C$1:$C$15874</c:f>
              <c:numCache>
                <c:formatCode>General</c:formatCode>
                <c:ptCount val="15874"/>
                <c:pt idx="0">
                  <c:v>0</c:v>
                </c:pt>
                <c:pt idx="10">
                  <c:v>1730.81</c:v>
                </c:pt>
                <c:pt idx="15">
                  <c:v>1738.37</c:v>
                </c:pt>
                <c:pt idx="37">
                  <c:v>1420.42</c:v>
                </c:pt>
                <c:pt idx="39">
                  <c:v>2360.23</c:v>
                </c:pt>
                <c:pt idx="61">
                  <c:v>6431.83</c:v>
                </c:pt>
                <c:pt idx="62">
                  <c:v>8023.1</c:v>
                </c:pt>
                <c:pt idx="67">
                  <c:v>1252.8</c:v>
                </c:pt>
                <c:pt idx="71">
                  <c:v>1351.73</c:v>
                </c:pt>
                <c:pt idx="72">
                  <c:v>2683.37</c:v>
                </c:pt>
                <c:pt idx="74">
                  <c:v>4591.08</c:v>
                </c:pt>
                <c:pt idx="86">
                  <c:v>3845.23</c:v>
                </c:pt>
                <c:pt idx="87">
                  <c:v>2237.33</c:v>
                </c:pt>
                <c:pt idx="90">
                  <c:v>3321.86</c:v>
                </c:pt>
                <c:pt idx="92">
                  <c:v>2125.66</c:v>
                </c:pt>
                <c:pt idx="98">
                  <c:v>2360.4499999999998</c:v>
                </c:pt>
                <c:pt idx="103">
                  <c:v>2250.29</c:v>
                </c:pt>
                <c:pt idx="104">
                  <c:v>4006.37</c:v>
                </c:pt>
                <c:pt idx="113">
                  <c:v>1954.37</c:v>
                </c:pt>
                <c:pt idx="128">
                  <c:v>2847.31</c:v>
                </c:pt>
                <c:pt idx="140">
                  <c:v>1748.74</c:v>
                </c:pt>
                <c:pt idx="144">
                  <c:v>1681.13</c:v>
                </c:pt>
                <c:pt idx="153">
                  <c:v>2739.74</c:v>
                </c:pt>
                <c:pt idx="162">
                  <c:v>2544.48</c:v>
                </c:pt>
                <c:pt idx="169">
                  <c:v>1837.73</c:v>
                </c:pt>
                <c:pt idx="177">
                  <c:v>1475.5</c:v>
                </c:pt>
                <c:pt idx="178">
                  <c:v>1632.74</c:v>
                </c:pt>
                <c:pt idx="182">
                  <c:v>1138.32</c:v>
                </c:pt>
                <c:pt idx="187">
                  <c:v>1583.93</c:v>
                </c:pt>
                <c:pt idx="192">
                  <c:v>1765.37</c:v>
                </c:pt>
                <c:pt idx="194">
                  <c:v>2897.64</c:v>
                </c:pt>
                <c:pt idx="202">
                  <c:v>1201.18</c:v>
                </c:pt>
                <c:pt idx="204">
                  <c:v>2174.2600000000002</c:v>
                </c:pt>
                <c:pt idx="209">
                  <c:v>3322.73</c:v>
                </c:pt>
                <c:pt idx="212">
                  <c:v>2036.66</c:v>
                </c:pt>
                <c:pt idx="219">
                  <c:v>2973.46</c:v>
                </c:pt>
                <c:pt idx="232">
                  <c:v>2573.86</c:v>
                </c:pt>
                <c:pt idx="234">
                  <c:v>7158.02</c:v>
                </c:pt>
                <c:pt idx="238">
                  <c:v>1677.02</c:v>
                </c:pt>
                <c:pt idx="239">
                  <c:v>1371.17</c:v>
                </c:pt>
                <c:pt idx="243">
                  <c:v>9047.59</c:v>
                </c:pt>
                <c:pt idx="256">
                  <c:v>1635.34</c:v>
                </c:pt>
                <c:pt idx="272">
                  <c:v>6372.22</c:v>
                </c:pt>
                <c:pt idx="277">
                  <c:v>7521.34</c:v>
                </c:pt>
                <c:pt idx="286">
                  <c:v>1628.21</c:v>
                </c:pt>
                <c:pt idx="291">
                  <c:v>1943.35</c:v>
                </c:pt>
                <c:pt idx="292">
                  <c:v>4237.49</c:v>
                </c:pt>
                <c:pt idx="309">
                  <c:v>3316.03</c:v>
                </c:pt>
                <c:pt idx="316">
                  <c:v>2023.06</c:v>
                </c:pt>
                <c:pt idx="318">
                  <c:v>1976.83</c:v>
                </c:pt>
                <c:pt idx="327">
                  <c:v>3308.26</c:v>
                </c:pt>
                <c:pt idx="334">
                  <c:v>1380.02</c:v>
                </c:pt>
                <c:pt idx="342">
                  <c:v>1751.11</c:v>
                </c:pt>
                <c:pt idx="355">
                  <c:v>1570.54</c:v>
                </c:pt>
                <c:pt idx="356">
                  <c:v>2847.74</c:v>
                </c:pt>
                <c:pt idx="364">
                  <c:v>2092.39</c:v>
                </c:pt>
                <c:pt idx="367">
                  <c:v>3296.38</c:v>
                </c:pt>
                <c:pt idx="368">
                  <c:v>1287.79</c:v>
                </c:pt>
                <c:pt idx="369">
                  <c:v>1540.73</c:v>
                </c:pt>
                <c:pt idx="373">
                  <c:v>1699.92</c:v>
                </c:pt>
                <c:pt idx="376">
                  <c:v>3538.94</c:v>
                </c:pt>
                <c:pt idx="377">
                  <c:v>1686.31</c:v>
                </c:pt>
                <c:pt idx="378">
                  <c:v>1443.31</c:v>
                </c:pt>
                <c:pt idx="383">
                  <c:v>1269</c:v>
                </c:pt>
                <c:pt idx="397">
                  <c:v>1723.03</c:v>
                </c:pt>
                <c:pt idx="414">
                  <c:v>3089.23</c:v>
                </c:pt>
                <c:pt idx="418">
                  <c:v>2067.5500000000002</c:v>
                </c:pt>
                <c:pt idx="423">
                  <c:v>4642.49</c:v>
                </c:pt>
                <c:pt idx="434">
                  <c:v>1451.09</c:v>
                </c:pt>
                <c:pt idx="441">
                  <c:v>1303.78</c:v>
                </c:pt>
                <c:pt idx="451">
                  <c:v>3043.87</c:v>
                </c:pt>
                <c:pt idx="459">
                  <c:v>1474.85</c:v>
                </c:pt>
                <c:pt idx="463">
                  <c:v>1581.12</c:v>
                </c:pt>
                <c:pt idx="469">
                  <c:v>4082.62</c:v>
                </c:pt>
                <c:pt idx="470">
                  <c:v>2131.27</c:v>
                </c:pt>
                <c:pt idx="484">
                  <c:v>2168.64</c:v>
                </c:pt>
                <c:pt idx="489">
                  <c:v>2556.14</c:v>
                </c:pt>
                <c:pt idx="495">
                  <c:v>2350.73</c:v>
                </c:pt>
                <c:pt idx="499">
                  <c:v>1995.84</c:v>
                </c:pt>
                <c:pt idx="506">
                  <c:v>1592.57</c:v>
                </c:pt>
                <c:pt idx="507">
                  <c:v>2620.5100000000002</c:v>
                </c:pt>
                <c:pt idx="516">
                  <c:v>2447.06</c:v>
                </c:pt>
                <c:pt idx="520">
                  <c:v>2704.32</c:v>
                </c:pt>
                <c:pt idx="523">
                  <c:v>1859.54</c:v>
                </c:pt>
                <c:pt idx="524">
                  <c:v>1312.85</c:v>
                </c:pt>
                <c:pt idx="535">
                  <c:v>2362.8200000000002</c:v>
                </c:pt>
                <c:pt idx="541">
                  <c:v>1315.87</c:v>
                </c:pt>
                <c:pt idx="542">
                  <c:v>2106.2199999999998</c:v>
                </c:pt>
                <c:pt idx="552">
                  <c:v>1875.74</c:v>
                </c:pt>
                <c:pt idx="554">
                  <c:v>1643.11</c:v>
                </c:pt>
                <c:pt idx="558">
                  <c:v>1069.6300000000001</c:v>
                </c:pt>
                <c:pt idx="564">
                  <c:v>2247.6999999999998</c:v>
                </c:pt>
                <c:pt idx="579">
                  <c:v>1326.02</c:v>
                </c:pt>
                <c:pt idx="587">
                  <c:v>1577.66</c:v>
                </c:pt>
                <c:pt idx="588">
                  <c:v>1634.26</c:v>
                </c:pt>
                <c:pt idx="589">
                  <c:v>1530.79</c:v>
                </c:pt>
                <c:pt idx="596">
                  <c:v>1590.62</c:v>
                </c:pt>
                <c:pt idx="599">
                  <c:v>1421.93</c:v>
                </c:pt>
                <c:pt idx="601">
                  <c:v>1356.48</c:v>
                </c:pt>
                <c:pt idx="608">
                  <c:v>1530.79</c:v>
                </c:pt>
                <c:pt idx="612">
                  <c:v>2423.9499999999998</c:v>
                </c:pt>
                <c:pt idx="615">
                  <c:v>1883.74</c:v>
                </c:pt>
                <c:pt idx="625">
                  <c:v>1562.54</c:v>
                </c:pt>
                <c:pt idx="628">
                  <c:v>3841.13</c:v>
                </c:pt>
                <c:pt idx="634">
                  <c:v>2766.53</c:v>
                </c:pt>
                <c:pt idx="635">
                  <c:v>1139.83</c:v>
                </c:pt>
                <c:pt idx="647">
                  <c:v>1198.58</c:v>
                </c:pt>
                <c:pt idx="652">
                  <c:v>1819.15</c:v>
                </c:pt>
                <c:pt idx="658">
                  <c:v>1559.74</c:v>
                </c:pt>
                <c:pt idx="661">
                  <c:v>1526.04</c:v>
                </c:pt>
                <c:pt idx="677">
                  <c:v>2142.5</c:v>
                </c:pt>
                <c:pt idx="679">
                  <c:v>2031.48</c:v>
                </c:pt>
                <c:pt idx="685">
                  <c:v>3675.02</c:v>
                </c:pt>
                <c:pt idx="693">
                  <c:v>1469.02</c:v>
                </c:pt>
                <c:pt idx="695">
                  <c:v>1504.01</c:v>
                </c:pt>
                <c:pt idx="699">
                  <c:v>1680.91</c:v>
                </c:pt>
                <c:pt idx="708">
                  <c:v>1488.89</c:v>
                </c:pt>
                <c:pt idx="723">
                  <c:v>1368.14</c:v>
                </c:pt>
                <c:pt idx="727">
                  <c:v>1339.63</c:v>
                </c:pt>
                <c:pt idx="733">
                  <c:v>1590.41</c:v>
                </c:pt>
                <c:pt idx="738">
                  <c:v>1580.47</c:v>
                </c:pt>
                <c:pt idx="741">
                  <c:v>3393.58</c:v>
                </c:pt>
                <c:pt idx="749">
                  <c:v>108.432</c:v>
                </c:pt>
                <c:pt idx="750">
                  <c:v>1308.96</c:v>
                </c:pt>
                <c:pt idx="756">
                  <c:v>2360.02</c:v>
                </c:pt>
                <c:pt idx="757">
                  <c:v>1023.84</c:v>
                </c:pt>
                <c:pt idx="764">
                  <c:v>2376.4299999999998</c:v>
                </c:pt>
                <c:pt idx="769">
                  <c:v>1655.42</c:v>
                </c:pt>
                <c:pt idx="774">
                  <c:v>2249.21</c:v>
                </c:pt>
                <c:pt idx="782">
                  <c:v>2317.0300000000002</c:v>
                </c:pt>
                <c:pt idx="784">
                  <c:v>1257.77</c:v>
                </c:pt>
                <c:pt idx="788">
                  <c:v>2420.9299999999998</c:v>
                </c:pt>
                <c:pt idx="793">
                  <c:v>1335.96</c:v>
                </c:pt>
                <c:pt idx="794">
                  <c:v>2160.86</c:v>
                </c:pt>
                <c:pt idx="798">
                  <c:v>1704.02</c:v>
                </c:pt>
                <c:pt idx="814">
                  <c:v>1135.51</c:v>
                </c:pt>
                <c:pt idx="816">
                  <c:v>1877.47</c:v>
                </c:pt>
                <c:pt idx="821">
                  <c:v>101.08799999999999</c:v>
                </c:pt>
                <c:pt idx="823">
                  <c:v>1617.19</c:v>
                </c:pt>
                <c:pt idx="827">
                  <c:v>1605.74</c:v>
                </c:pt>
                <c:pt idx="838">
                  <c:v>2531.9499999999998</c:v>
                </c:pt>
                <c:pt idx="842">
                  <c:v>1728.43</c:v>
                </c:pt>
                <c:pt idx="844">
                  <c:v>1848.53</c:v>
                </c:pt>
                <c:pt idx="848">
                  <c:v>1177.42</c:v>
                </c:pt>
                <c:pt idx="859">
                  <c:v>1818.94</c:v>
                </c:pt>
                <c:pt idx="861">
                  <c:v>1741.82</c:v>
                </c:pt>
                <c:pt idx="864">
                  <c:v>1452.17</c:v>
                </c:pt>
                <c:pt idx="867">
                  <c:v>1923.26</c:v>
                </c:pt>
                <c:pt idx="874">
                  <c:v>3085.13</c:v>
                </c:pt>
                <c:pt idx="880">
                  <c:v>2231.06</c:v>
                </c:pt>
                <c:pt idx="882">
                  <c:v>2197.37</c:v>
                </c:pt>
                <c:pt idx="883">
                  <c:v>1867.1</c:v>
                </c:pt>
                <c:pt idx="896">
                  <c:v>2532.6</c:v>
                </c:pt>
                <c:pt idx="901">
                  <c:v>1475.06</c:v>
                </c:pt>
                <c:pt idx="906">
                  <c:v>2279.66</c:v>
                </c:pt>
                <c:pt idx="907">
                  <c:v>1270.3</c:v>
                </c:pt>
                <c:pt idx="916">
                  <c:v>1195.1300000000001</c:v>
                </c:pt>
                <c:pt idx="924">
                  <c:v>1149.1199999999999</c:v>
                </c:pt>
                <c:pt idx="926">
                  <c:v>1299.8900000000001</c:v>
                </c:pt>
                <c:pt idx="927">
                  <c:v>1648.73</c:v>
                </c:pt>
                <c:pt idx="942">
                  <c:v>1119.74</c:v>
                </c:pt>
                <c:pt idx="943">
                  <c:v>1930.82</c:v>
                </c:pt>
                <c:pt idx="951">
                  <c:v>3207.38</c:v>
                </c:pt>
                <c:pt idx="966">
                  <c:v>2038.18</c:v>
                </c:pt>
                <c:pt idx="967">
                  <c:v>1928.23</c:v>
                </c:pt>
                <c:pt idx="968">
                  <c:v>1767.96</c:v>
                </c:pt>
                <c:pt idx="969">
                  <c:v>1991.09</c:v>
                </c:pt>
                <c:pt idx="985">
                  <c:v>3702.67</c:v>
                </c:pt>
                <c:pt idx="986">
                  <c:v>1959.34</c:v>
                </c:pt>
                <c:pt idx="998">
                  <c:v>1425.6</c:v>
                </c:pt>
                <c:pt idx="1007">
                  <c:v>2851.85</c:v>
                </c:pt>
                <c:pt idx="1025">
                  <c:v>1361.88</c:v>
                </c:pt>
                <c:pt idx="1028">
                  <c:v>1469.23</c:v>
                </c:pt>
                <c:pt idx="1034">
                  <c:v>2384.21</c:v>
                </c:pt>
                <c:pt idx="1043">
                  <c:v>1656.72</c:v>
                </c:pt>
                <c:pt idx="1050">
                  <c:v>2200.1799999999998</c:v>
                </c:pt>
                <c:pt idx="1055">
                  <c:v>1713.74</c:v>
                </c:pt>
                <c:pt idx="1056">
                  <c:v>1898.42</c:v>
                </c:pt>
                <c:pt idx="1059">
                  <c:v>1804.25</c:v>
                </c:pt>
                <c:pt idx="1060">
                  <c:v>1982.88</c:v>
                </c:pt>
                <c:pt idx="1064">
                  <c:v>2800.22</c:v>
                </c:pt>
                <c:pt idx="1065">
                  <c:v>10265.6</c:v>
                </c:pt>
                <c:pt idx="1070">
                  <c:v>2185.4899999999998</c:v>
                </c:pt>
                <c:pt idx="1087">
                  <c:v>2625.7</c:v>
                </c:pt>
                <c:pt idx="1088">
                  <c:v>1836.43</c:v>
                </c:pt>
                <c:pt idx="1094">
                  <c:v>2035.15</c:v>
                </c:pt>
                <c:pt idx="1096">
                  <c:v>4275.29</c:v>
                </c:pt>
                <c:pt idx="1099">
                  <c:v>1802.74</c:v>
                </c:pt>
                <c:pt idx="1101">
                  <c:v>1775.74</c:v>
                </c:pt>
                <c:pt idx="1104">
                  <c:v>1340.71</c:v>
                </c:pt>
                <c:pt idx="1117">
                  <c:v>2011.39</c:v>
                </c:pt>
                <c:pt idx="1127">
                  <c:v>1241.78</c:v>
                </c:pt>
                <c:pt idx="1129">
                  <c:v>1346.76</c:v>
                </c:pt>
                <c:pt idx="1142">
                  <c:v>2804.11</c:v>
                </c:pt>
                <c:pt idx="1143">
                  <c:v>2292.62</c:v>
                </c:pt>
                <c:pt idx="1152">
                  <c:v>1805.76</c:v>
                </c:pt>
                <c:pt idx="1154">
                  <c:v>2023.92</c:v>
                </c:pt>
                <c:pt idx="1159">
                  <c:v>1996.92</c:v>
                </c:pt>
                <c:pt idx="1163">
                  <c:v>4578.12</c:v>
                </c:pt>
                <c:pt idx="1164">
                  <c:v>1308.74</c:v>
                </c:pt>
                <c:pt idx="1168">
                  <c:v>1273.54</c:v>
                </c:pt>
                <c:pt idx="1173">
                  <c:v>1724.76</c:v>
                </c:pt>
                <c:pt idx="1175">
                  <c:v>1263.82</c:v>
                </c:pt>
                <c:pt idx="1176">
                  <c:v>2320.4899999999998</c:v>
                </c:pt>
                <c:pt idx="1177">
                  <c:v>2284.1999999999998</c:v>
                </c:pt>
                <c:pt idx="1185">
                  <c:v>2627.86</c:v>
                </c:pt>
                <c:pt idx="1187">
                  <c:v>1533.6</c:v>
                </c:pt>
                <c:pt idx="1190">
                  <c:v>1769.47</c:v>
                </c:pt>
                <c:pt idx="1206">
                  <c:v>1754.57</c:v>
                </c:pt>
                <c:pt idx="1208">
                  <c:v>1139.4000000000001</c:v>
                </c:pt>
                <c:pt idx="1215">
                  <c:v>4589.57</c:v>
                </c:pt>
                <c:pt idx="1220">
                  <c:v>1836.43</c:v>
                </c:pt>
                <c:pt idx="1226">
                  <c:v>5367.38</c:v>
                </c:pt>
                <c:pt idx="1228">
                  <c:v>1462.54</c:v>
                </c:pt>
                <c:pt idx="1240">
                  <c:v>2171.66</c:v>
                </c:pt>
                <c:pt idx="1267">
                  <c:v>1940.54</c:v>
                </c:pt>
                <c:pt idx="1270">
                  <c:v>3265.92</c:v>
                </c:pt>
                <c:pt idx="1275">
                  <c:v>1381.97</c:v>
                </c:pt>
                <c:pt idx="1290">
                  <c:v>1888.27</c:v>
                </c:pt>
                <c:pt idx="1301">
                  <c:v>1024.7</c:v>
                </c:pt>
                <c:pt idx="1302">
                  <c:v>1606.61</c:v>
                </c:pt>
                <c:pt idx="1306">
                  <c:v>1737.5</c:v>
                </c:pt>
                <c:pt idx="1317">
                  <c:v>1670.76</c:v>
                </c:pt>
                <c:pt idx="1323">
                  <c:v>1604.45</c:v>
                </c:pt>
                <c:pt idx="1324">
                  <c:v>1793.23</c:v>
                </c:pt>
                <c:pt idx="1327">
                  <c:v>1373.54</c:v>
                </c:pt>
                <c:pt idx="1331">
                  <c:v>1094.9000000000001</c:v>
                </c:pt>
                <c:pt idx="1334">
                  <c:v>975.88800000000003</c:v>
                </c:pt>
                <c:pt idx="1335">
                  <c:v>1647</c:v>
                </c:pt>
                <c:pt idx="1341">
                  <c:v>3276.72</c:v>
                </c:pt>
                <c:pt idx="1345">
                  <c:v>3063.53</c:v>
                </c:pt>
                <c:pt idx="1346">
                  <c:v>1589.33</c:v>
                </c:pt>
                <c:pt idx="1347">
                  <c:v>1184.1099999999999</c:v>
                </c:pt>
                <c:pt idx="1350">
                  <c:v>1218.46</c:v>
                </c:pt>
                <c:pt idx="1357">
                  <c:v>1166.18</c:v>
                </c:pt>
                <c:pt idx="1371">
                  <c:v>2360.02</c:v>
                </c:pt>
                <c:pt idx="1375">
                  <c:v>3955.61</c:v>
                </c:pt>
                <c:pt idx="1376">
                  <c:v>2327.4</c:v>
                </c:pt>
                <c:pt idx="1381">
                  <c:v>2546.86</c:v>
                </c:pt>
                <c:pt idx="1383">
                  <c:v>1527.77</c:v>
                </c:pt>
                <c:pt idx="1395">
                  <c:v>1453.46</c:v>
                </c:pt>
                <c:pt idx="1413">
                  <c:v>1747.44</c:v>
                </c:pt>
                <c:pt idx="1416">
                  <c:v>1637.06</c:v>
                </c:pt>
                <c:pt idx="1418">
                  <c:v>3467.45</c:v>
                </c:pt>
                <c:pt idx="1419">
                  <c:v>1469.88</c:v>
                </c:pt>
                <c:pt idx="1420">
                  <c:v>2516.83</c:v>
                </c:pt>
                <c:pt idx="1426">
                  <c:v>2955.74</c:v>
                </c:pt>
                <c:pt idx="1428">
                  <c:v>1283.9000000000001</c:v>
                </c:pt>
                <c:pt idx="1429">
                  <c:v>1930.18</c:v>
                </c:pt>
                <c:pt idx="1430">
                  <c:v>2102.33</c:v>
                </c:pt>
                <c:pt idx="1433">
                  <c:v>1918.94</c:v>
                </c:pt>
                <c:pt idx="1437">
                  <c:v>2539.73</c:v>
                </c:pt>
                <c:pt idx="1443">
                  <c:v>1616.98</c:v>
                </c:pt>
                <c:pt idx="1444">
                  <c:v>1551.31</c:v>
                </c:pt>
                <c:pt idx="1446">
                  <c:v>1993.9</c:v>
                </c:pt>
                <c:pt idx="1455">
                  <c:v>4497.9799999999996</c:v>
                </c:pt>
                <c:pt idx="1460">
                  <c:v>980.85599999999999</c:v>
                </c:pt>
                <c:pt idx="1472">
                  <c:v>2037.74</c:v>
                </c:pt>
                <c:pt idx="1478">
                  <c:v>1716.55</c:v>
                </c:pt>
                <c:pt idx="1484">
                  <c:v>1544.4</c:v>
                </c:pt>
                <c:pt idx="1488">
                  <c:v>1305.72</c:v>
                </c:pt>
                <c:pt idx="1489">
                  <c:v>1863.43</c:v>
                </c:pt>
                <c:pt idx="1495">
                  <c:v>2432.38</c:v>
                </c:pt>
                <c:pt idx="1507">
                  <c:v>674.78399999999999</c:v>
                </c:pt>
                <c:pt idx="1509">
                  <c:v>1057.75</c:v>
                </c:pt>
                <c:pt idx="1511">
                  <c:v>2789.21</c:v>
                </c:pt>
                <c:pt idx="1515">
                  <c:v>2270.59</c:v>
                </c:pt>
                <c:pt idx="1521">
                  <c:v>1910.52</c:v>
                </c:pt>
                <c:pt idx="1526">
                  <c:v>2534.98</c:v>
                </c:pt>
                <c:pt idx="1532">
                  <c:v>1225.3699999999999</c:v>
                </c:pt>
                <c:pt idx="1547">
                  <c:v>1459.51</c:v>
                </c:pt>
                <c:pt idx="1554">
                  <c:v>1559.09</c:v>
                </c:pt>
                <c:pt idx="1557">
                  <c:v>2924.42</c:v>
                </c:pt>
                <c:pt idx="1560">
                  <c:v>1387.37</c:v>
                </c:pt>
                <c:pt idx="1563">
                  <c:v>1573.13</c:v>
                </c:pt>
                <c:pt idx="1565">
                  <c:v>1448.28</c:v>
                </c:pt>
                <c:pt idx="1569">
                  <c:v>1560.38</c:v>
                </c:pt>
                <c:pt idx="1575">
                  <c:v>1764.72</c:v>
                </c:pt>
                <c:pt idx="1576">
                  <c:v>6527.74</c:v>
                </c:pt>
                <c:pt idx="1584">
                  <c:v>2131.92</c:v>
                </c:pt>
                <c:pt idx="1588">
                  <c:v>1102.68</c:v>
                </c:pt>
                <c:pt idx="1591">
                  <c:v>1653.05</c:v>
                </c:pt>
                <c:pt idx="1593">
                  <c:v>1264.9000000000001</c:v>
                </c:pt>
                <c:pt idx="1596">
                  <c:v>1731.67</c:v>
                </c:pt>
                <c:pt idx="1599">
                  <c:v>1489.97</c:v>
                </c:pt>
                <c:pt idx="1617">
                  <c:v>1775.74</c:v>
                </c:pt>
                <c:pt idx="1618">
                  <c:v>1353.02</c:v>
                </c:pt>
                <c:pt idx="1619">
                  <c:v>2684.02</c:v>
                </c:pt>
                <c:pt idx="1632">
                  <c:v>1677.02</c:v>
                </c:pt>
                <c:pt idx="1655">
                  <c:v>1497.74</c:v>
                </c:pt>
                <c:pt idx="1659">
                  <c:v>1276.3399999999999</c:v>
                </c:pt>
                <c:pt idx="1661">
                  <c:v>1643.54</c:v>
                </c:pt>
                <c:pt idx="1671">
                  <c:v>2303.42</c:v>
                </c:pt>
                <c:pt idx="1674">
                  <c:v>1446.12</c:v>
                </c:pt>
                <c:pt idx="1679">
                  <c:v>2468.88</c:v>
                </c:pt>
                <c:pt idx="1680">
                  <c:v>1743.34</c:v>
                </c:pt>
                <c:pt idx="1683">
                  <c:v>1317.6</c:v>
                </c:pt>
                <c:pt idx="1698">
                  <c:v>1534.46</c:v>
                </c:pt>
                <c:pt idx="1700">
                  <c:v>2213.14</c:v>
                </c:pt>
                <c:pt idx="1703">
                  <c:v>2777.98</c:v>
                </c:pt>
                <c:pt idx="1711">
                  <c:v>1625.18</c:v>
                </c:pt>
                <c:pt idx="1728">
                  <c:v>1666.44</c:v>
                </c:pt>
                <c:pt idx="1729">
                  <c:v>866.59199999999998</c:v>
                </c:pt>
                <c:pt idx="1730">
                  <c:v>2601.94</c:v>
                </c:pt>
                <c:pt idx="1736">
                  <c:v>1388.88</c:v>
                </c:pt>
                <c:pt idx="1738">
                  <c:v>2391.5500000000002</c:v>
                </c:pt>
                <c:pt idx="1739">
                  <c:v>1251.29</c:v>
                </c:pt>
                <c:pt idx="1740">
                  <c:v>1566.43</c:v>
                </c:pt>
                <c:pt idx="1746">
                  <c:v>2005.34</c:v>
                </c:pt>
                <c:pt idx="1749">
                  <c:v>2068.1999999999998</c:v>
                </c:pt>
                <c:pt idx="1759">
                  <c:v>1128.3800000000001</c:v>
                </c:pt>
                <c:pt idx="1760">
                  <c:v>1569.67</c:v>
                </c:pt>
                <c:pt idx="1767">
                  <c:v>1069.2</c:v>
                </c:pt>
                <c:pt idx="1768">
                  <c:v>1778.11</c:v>
                </c:pt>
                <c:pt idx="1774">
                  <c:v>3526.63</c:v>
                </c:pt>
                <c:pt idx="1780">
                  <c:v>2468.88</c:v>
                </c:pt>
                <c:pt idx="1781">
                  <c:v>1268.3499999999999</c:v>
                </c:pt>
                <c:pt idx="1788">
                  <c:v>1350.86</c:v>
                </c:pt>
                <c:pt idx="1800">
                  <c:v>2163.46</c:v>
                </c:pt>
                <c:pt idx="1801">
                  <c:v>2056.75</c:v>
                </c:pt>
                <c:pt idx="1808">
                  <c:v>1211.54</c:v>
                </c:pt>
                <c:pt idx="1814">
                  <c:v>1505.09</c:v>
                </c:pt>
                <c:pt idx="1816">
                  <c:v>2039.9</c:v>
                </c:pt>
                <c:pt idx="1818">
                  <c:v>1951.99</c:v>
                </c:pt>
                <c:pt idx="1827">
                  <c:v>2612.09</c:v>
                </c:pt>
                <c:pt idx="1828">
                  <c:v>1305.72</c:v>
                </c:pt>
                <c:pt idx="1829">
                  <c:v>1688.04</c:v>
                </c:pt>
                <c:pt idx="1831">
                  <c:v>2904.12</c:v>
                </c:pt>
                <c:pt idx="1835">
                  <c:v>306.28800000000001</c:v>
                </c:pt>
                <c:pt idx="1839">
                  <c:v>2176.85</c:v>
                </c:pt>
                <c:pt idx="1840">
                  <c:v>1309.18</c:v>
                </c:pt>
                <c:pt idx="1843">
                  <c:v>4575.96</c:v>
                </c:pt>
                <c:pt idx="1846">
                  <c:v>1710.72</c:v>
                </c:pt>
                <c:pt idx="1852">
                  <c:v>1839.67</c:v>
                </c:pt>
                <c:pt idx="1854">
                  <c:v>1355.4</c:v>
                </c:pt>
                <c:pt idx="1856">
                  <c:v>1783.51</c:v>
                </c:pt>
                <c:pt idx="1857">
                  <c:v>3018.17</c:v>
                </c:pt>
                <c:pt idx="1861">
                  <c:v>2099.7399999999998</c:v>
                </c:pt>
                <c:pt idx="1862">
                  <c:v>2131.06</c:v>
                </c:pt>
                <c:pt idx="1872">
                  <c:v>1234.22</c:v>
                </c:pt>
                <c:pt idx="1873">
                  <c:v>2422.66</c:v>
                </c:pt>
                <c:pt idx="1876">
                  <c:v>1230.55</c:v>
                </c:pt>
                <c:pt idx="1892">
                  <c:v>2102.54</c:v>
                </c:pt>
                <c:pt idx="1901">
                  <c:v>2255.2600000000002</c:v>
                </c:pt>
                <c:pt idx="1904">
                  <c:v>2188.3000000000002</c:v>
                </c:pt>
                <c:pt idx="1908">
                  <c:v>1189.3</c:v>
                </c:pt>
                <c:pt idx="1910">
                  <c:v>2776.03</c:v>
                </c:pt>
                <c:pt idx="1911">
                  <c:v>2399.54</c:v>
                </c:pt>
                <c:pt idx="1917">
                  <c:v>1698.84</c:v>
                </c:pt>
                <c:pt idx="1923">
                  <c:v>1346.76</c:v>
                </c:pt>
                <c:pt idx="1925">
                  <c:v>2333.02</c:v>
                </c:pt>
                <c:pt idx="1936">
                  <c:v>2082.2399999999998</c:v>
                </c:pt>
                <c:pt idx="1956">
                  <c:v>1910.09</c:v>
                </c:pt>
                <c:pt idx="1967">
                  <c:v>1430.14</c:v>
                </c:pt>
                <c:pt idx="1970">
                  <c:v>1946.59</c:v>
                </c:pt>
                <c:pt idx="1982">
                  <c:v>1197.29</c:v>
                </c:pt>
                <c:pt idx="2000">
                  <c:v>1107.6500000000001</c:v>
                </c:pt>
                <c:pt idx="2003">
                  <c:v>1045.44</c:v>
                </c:pt>
                <c:pt idx="2006">
                  <c:v>2222.86</c:v>
                </c:pt>
                <c:pt idx="2011">
                  <c:v>1249.78</c:v>
                </c:pt>
                <c:pt idx="2015">
                  <c:v>1840.54</c:v>
                </c:pt>
                <c:pt idx="2018">
                  <c:v>5556.82</c:v>
                </c:pt>
                <c:pt idx="2021">
                  <c:v>1470.74</c:v>
                </c:pt>
                <c:pt idx="2026">
                  <c:v>2111.1799999999998</c:v>
                </c:pt>
                <c:pt idx="2027">
                  <c:v>2104.4899999999998</c:v>
                </c:pt>
                <c:pt idx="2030">
                  <c:v>2910.17</c:v>
                </c:pt>
                <c:pt idx="2038">
                  <c:v>1347.84</c:v>
                </c:pt>
                <c:pt idx="2048">
                  <c:v>1526.9</c:v>
                </c:pt>
                <c:pt idx="2049">
                  <c:v>2091.7399999999998</c:v>
                </c:pt>
                <c:pt idx="2055">
                  <c:v>3241.3</c:v>
                </c:pt>
                <c:pt idx="2058">
                  <c:v>915.62400000000002</c:v>
                </c:pt>
                <c:pt idx="2059">
                  <c:v>2558.9499999999998</c:v>
                </c:pt>
                <c:pt idx="2068">
                  <c:v>1334.02</c:v>
                </c:pt>
                <c:pt idx="2078">
                  <c:v>1070.28</c:v>
                </c:pt>
                <c:pt idx="2080">
                  <c:v>1561.68</c:v>
                </c:pt>
                <c:pt idx="2083">
                  <c:v>2150.5</c:v>
                </c:pt>
                <c:pt idx="2086">
                  <c:v>1774.87</c:v>
                </c:pt>
                <c:pt idx="2095">
                  <c:v>1898.64</c:v>
                </c:pt>
                <c:pt idx="2096">
                  <c:v>1469.66</c:v>
                </c:pt>
                <c:pt idx="2098">
                  <c:v>1579.61</c:v>
                </c:pt>
                <c:pt idx="2108">
                  <c:v>1934.93</c:v>
                </c:pt>
                <c:pt idx="2109">
                  <c:v>2358.0700000000002</c:v>
                </c:pt>
                <c:pt idx="2110">
                  <c:v>2066.9</c:v>
                </c:pt>
                <c:pt idx="2114">
                  <c:v>92.447999999999993</c:v>
                </c:pt>
                <c:pt idx="2129">
                  <c:v>1850.26</c:v>
                </c:pt>
                <c:pt idx="2131">
                  <c:v>1963.22</c:v>
                </c:pt>
                <c:pt idx="2133">
                  <c:v>3999.02</c:v>
                </c:pt>
                <c:pt idx="2134">
                  <c:v>1483.49</c:v>
                </c:pt>
                <c:pt idx="2146">
                  <c:v>1524.53</c:v>
                </c:pt>
                <c:pt idx="2149">
                  <c:v>2748.17</c:v>
                </c:pt>
                <c:pt idx="2153">
                  <c:v>1499.26</c:v>
                </c:pt>
                <c:pt idx="2159">
                  <c:v>1118.45</c:v>
                </c:pt>
                <c:pt idx="2163">
                  <c:v>1407.67</c:v>
                </c:pt>
                <c:pt idx="2164">
                  <c:v>1339.63</c:v>
                </c:pt>
                <c:pt idx="2183">
                  <c:v>2374.6999999999998</c:v>
                </c:pt>
                <c:pt idx="2187">
                  <c:v>2242.73</c:v>
                </c:pt>
                <c:pt idx="2190">
                  <c:v>1831.46</c:v>
                </c:pt>
                <c:pt idx="2194">
                  <c:v>1266.6199999999999</c:v>
                </c:pt>
                <c:pt idx="2209">
                  <c:v>4665.17</c:v>
                </c:pt>
                <c:pt idx="2214">
                  <c:v>1357.99</c:v>
                </c:pt>
                <c:pt idx="2216">
                  <c:v>3046.25</c:v>
                </c:pt>
                <c:pt idx="2218">
                  <c:v>955.58399999999995</c:v>
                </c:pt>
                <c:pt idx="2219">
                  <c:v>3806.78</c:v>
                </c:pt>
                <c:pt idx="2221">
                  <c:v>1667.09</c:v>
                </c:pt>
                <c:pt idx="2241">
                  <c:v>3954.31</c:v>
                </c:pt>
                <c:pt idx="2243">
                  <c:v>2303.42</c:v>
                </c:pt>
                <c:pt idx="2245">
                  <c:v>2128.25</c:v>
                </c:pt>
                <c:pt idx="2249">
                  <c:v>1652.4</c:v>
                </c:pt>
                <c:pt idx="2252">
                  <c:v>2454.62</c:v>
                </c:pt>
                <c:pt idx="2256">
                  <c:v>1231.2</c:v>
                </c:pt>
                <c:pt idx="2261">
                  <c:v>2282.9</c:v>
                </c:pt>
                <c:pt idx="2264">
                  <c:v>1783.51</c:v>
                </c:pt>
                <c:pt idx="2267">
                  <c:v>6902.5</c:v>
                </c:pt>
                <c:pt idx="2273">
                  <c:v>1684.15</c:v>
                </c:pt>
                <c:pt idx="2278">
                  <c:v>2799.79</c:v>
                </c:pt>
                <c:pt idx="2280">
                  <c:v>1080.6500000000001</c:v>
                </c:pt>
                <c:pt idx="2283">
                  <c:v>1740.74</c:v>
                </c:pt>
                <c:pt idx="2298">
                  <c:v>1859.98</c:v>
                </c:pt>
                <c:pt idx="2299">
                  <c:v>1796.9</c:v>
                </c:pt>
                <c:pt idx="2308">
                  <c:v>1946.16</c:v>
                </c:pt>
                <c:pt idx="2311">
                  <c:v>796.17600000000004</c:v>
                </c:pt>
                <c:pt idx="2314">
                  <c:v>3770.5</c:v>
                </c:pt>
                <c:pt idx="2323">
                  <c:v>991.00800000000004</c:v>
                </c:pt>
                <c:pt idx="2329">
                  <c:v>1663.42</c:v>
                </c:pt>
                <c:pt idx="2330">
                  <c:v>2389.61</c:v>
                </c:pt>
                <c:pt idx="2342">
                  <c:v>1281.53</c:v>
                </c:pt>
                <c:pt idx="2344">
                  <c:v>2160.4299999999998</c:v>
                </c:pt>
                <c:pt idx="2350">
                  <c:v>2312.2800000000002</c:v>
                </c:pt>
                <c:pt idx="2352">
                  <c:v>1391.9</c:v>
                </c:pt>
                <c:pt idx="2358">
                  <c:v>1160.57</c:v>
                </c:pt>
                <c:pt idx="2360">
                  <c:v>128.08799999999999</c:v>
                </c:pt>
                <c:pt idx="2379">
                  <c:v>4596.05</c:v>
                </c:pt>
                <c:pt idx="2380">
                  <c:v>1839.89</c:v>
                </c:pt>
                <c:pt idx="2392">
                  <c:v>1555.42</c:v>
                </c:pt>
                <c:pt idx="2394">
                  <c:v>1854.14</c:v>
                </c:pt>
                <c:pt idx="2399">
                  <c:v>1486.51</c:v>
                </c:pt>
                <c:pt idx="2410">
                  <c:v>2287.0100000000002</c:v>
                </c:pt>
                <c:pt idx="2416">
                  <c:v>1238.98</c:v>
                </c:pt>
                <c:pt idx="2423">
                  <c:v>1933.42</c:v>
                </c:pt>
                <c:pt idx="2427">
                  <c:v>3276.5</c:v>
                </c:pt>
                <c:pt idx="2438">
                  <c:v>1530.58</c:v>
                </c:pt>
                <c:pt idx="2439">
                  <c:v>3747.6</c:v>
                </c:pt>
                <c:pt idx="2442">
                  <c:v>2756.81</c:v>
                </c:pt>
                <c:pt idx="2449">
                  <c:v>1495.58</c:v>
                </c:pt>
                <c:pt idx="2456">
                  <c:v>1536.62</c:v>
                </c:pt>
                <c:pt idx="2463">
                  <c:v>926.42399999999998</c:v>
                </c:pt>
                <c:pt idx="2464">
                  <c:v>2234.9499999999998</c:v>
                </c:pt>
                <c:pt idx="2465">
                  <c:v>1403.14</c:v>
                </c:pt>
                <c:pt idx="2466">
                  <c:v>3216.24</c:v>
                </c:pt>
                <c:pt idx="2467">
                  <c:v>1462.75</c:v>
                </c:pt>
                <c:pt idx="2477">
                  <c:v>2079.4299999999998</c:v>
                </c:pt>
                <c:pt idx="2480">
                  <c:v>1839.89</c:v>
                </c:pt>
                <c:pt idx="2485">
                  <c:v>3054.67</c:v>
                </c:pt>
                <c:pt idx="2491">
                  <c:v>2368.44</c:v>
                </c:pt>
                <c:pt idx="2499">
                  <c:v>2507.54</c:v>
                </c:pt>
                <c:pt idx="2503">
                  <c:v>579.96</c:v>
                </c:pt>
                <c:pt idx="2517">
                  <c:v>1623.46</c:v>
                </c:pt>
                <c:pt idx="2518">
                  <c:v>1596.02</c:v>
                </c:pt>
                <c:pt idx="2523">
                  <c:v>608.47199999999998</c:v>
                </c:pt>
                <c:pt idx="2524">
                  <c:v>1258.8499999999999</c:v>
                </c:pt>
                <c:pt idx="2530">
                  <c:v>1808.57</c:v>
                </c:pt>
                <c:pt idx="2535">
                  <c:v>682.77599999999995</c:v>
                </c:pt>
                <c:pt idx="2537">
                  <c:v>2370.38</c:v>
                </c:pt>
                <c:pt idx="2543">
                  <c:v>2968.06</c:v>
                </c:pt>
                <c:pt idx="2547">
                  <c:v>2981.66</c:v>
                </c:pt>
                <c:pt idx="2553">
                  <c:v>3946.75</c:v>
                </c:pt>
                <c:pt idx="2555">
                  <c:v>1508.54</c:v>
                </c:pt>
                <c:pt idx="2558">
                  <c:v>1798.2</c:v>
                </c:pt>
                <c:pt idx="2564">
                  <c:v>1383.26</c:v>
                </c:pt>
                <c:pt idx="2565">
                  <c:v>2023.27</c:v>
                </c:pt>
                <c:pt idx="2569">
                  <c:v>1566</c:v>
                </c:pt>
                <c:pt idx="2581">
                  <c:v>2218.75</c:v>
                </c:pt>
                <c:pt idx="2589">
                  <c:v>1224.5</c:v>
                </c:pt>
                <c:pt idx="2593">
                  <c:v>2046.38</c:v>
                </c:pt>
                <c:pt idx="2594">
                  <c:v>1931.26</c:v>
                </c:pt>
                <c:pt idx="2595">
                  <c:v>336.096</c:v>
                </c:pt>
                <c:pt idx="2600">
                  <c:v>2522.88</c:v>
                </c:pt>
                <c:pt idx="2612">
                  <c:v>1545.7</c:v>
                </c:pt>
                <c:pt idx="2613">
                  <c:v>2139.48</c:v>
                </c:pt>
                <c:pt idx="2616">
                  <c:v>1553.26</c:v>
                </c:pt>
                <c:pt idx="2619">
                  <c:v>987.12</c:v>
                </c:pt>
                <c:pt idx="2632">
                  <c:v>1515.24</c:v>
                </c:pt>
                <c:pt idx="2638">
                  <c:v>3261.6</c:v>
                </c:pt>
                <c:pt idx="2639">
                  <c:v>137.376</c:v>
                </c:pt>
                <c:pt idx="2642">
                  <c:v>1758.24</c:v>
                </c:pt>
                <c:pt idx="2646">
                  <c:v>1097.28</c:v>
                </c:pt>
                <c:pt idx="2662">
                  <c:v>1531.22</c:v>
                </c:pt>
                <c:pt idx="2675">
                  <c:v>2042.06</c:v>
                </c:pt>
                <c:pt idx="2682">
                  <c:v>2074.25</c:v>
                </c:pt>
                <c:pt idx="2688">
                  <c:v>1352.59</c:v>
                </c:pt>
                <c:pt idx="2696">
                  <c:v>2379.02</c:v>
                </c:pt>
                <c:pt idx="2698">
                  <c:v>9157.5400000000009</c:v>
                </c:pt>
                <c:pt idx="2699">
                  <c:v>2180.3000000000002</c:v>
                </c:pt>
                <c:pt idx="2701">
                  <c:v>4123.4399999999996</c:v>
                </c:pt>
                <c:pt idx="2711">
                  <c:v>1113.7</c:v>
                </c:pt>
                <c:pt idx="2712">
                  <c:v>1544.4</c:v>
                </c:pt>
                <c:pt idx="2725">
                  <c:v>934.41600000000005</c:v>
                </c:pt>
                <c:pt idx="2729">
                  <c:v>2893.1</c:v>
                </c:pt>
                <c:pt idx="2735">
                  <c:v>1631.66</c:v>
                </c:pt>
                <c:pt idx="2737">
                  <c:v>1590.41</c:v>
                </c:pt>
                <c:pt idx="2739">
                  <c:v>1919.59</c:v>
                </c:pt>
                <c:pt idx="2742">
                  <c:v>1110.8900000000001</c:v>
                </c:pt>
                <c:pt idx="2744">
                  <c:v>7175.95</c:v>
                </c:pt>
                <c:pt idx="2746">
                  <c:v>652.53599999999994</c:v>
                </c:pt>
                <c:pt idx="2750">
                  <c:v>1363.82</c:v>
                </c:pt>
                <c:pt idx="2751">
                  <c:v>1641.6</c:v>
                </c:pt>
                <c:pt idx="2765">
                  <c:v>1315.66</c:v>
                </c:pt>
                <c:pt idx="2770">
                  <c:v>1492.34</c:v>
                </c:pt>
                <c:pt idx="2773">
                  <c:v>2421.79</c:v>
                </c:pt>
                <c:pt idx="2777">
                  <c:v>1489.54</c:v>
                </c:pt>
                <c:pt idx="2779">
                  <c:v>1554.77</c:v>
                </c:pt>
                <c:pt idx="2783">
                  <c:v>2383.7800000000002</c:v>
                </c:pt>
                <c:pt idx="2784">
                  <c:v>1507.03</c:v>
                </c:pt>
                <c:pt idx="2786">
                  <c:v>1299.8900000000001</c:v>
                </c:pt>
                <c:pt idx="2787">
                  <c:v>1558.87</c:v>
                </c:pt>
                <c:pt idx="2789">
                  <c:v>3127.68</c:v>
                </c:pt>
                <c:pt idx="2790">
                  <c:v>1419.55</c:v>
                </c:pt>
                <c:pt idx="2791">
                  <c:v>1816.99</c:v>
                </c:pt>
                <c:pt idx="2792">
                  <c:v>1625.4</c:v>
                </c:pt>
                <c:pt idx="2794">
                  <c:v>1288.01</c:v>
                </c:pt>
                <c:pt idx="2797">
                  <c:v>1746.36</c:v>
                </c:pt>
                <c:pt idx="2800">
                  <c:v>1092.96</c:v>
                </c:pt>
                <c:pt idx="2803">
                  <c:v>1566.86</c:v>
                </c:pt>
                <c:pt idx="2814">
                  <c:v>6106.97</c:v>
                </c:pt>
                <c:pt idx="2819">
                  <c:v>1976.62</c:v>
                </c:pt>
                <c:pt idx="2824">
                  <c:v>3199.61</c:v>
                </c:pt>
                <c:pt idx="2827">
                  <c:v>1185.8399999999999</c:v>
                </c:pt>
                <c:pt idx="2832">
                  <c:v>3439.37</c:v>
                </c:pt>
                <c:pt idx="2836">
                  <c:v>1531.22</c:v>
                </c:pt>
                <c:pt idx="2839">
                  <c:v>1602.72</c:v>
                </c:pt>
                <c:pt idx="2843">
                  <c:v>1443.53</c:v>
                </c:pt>
                <c:pt idx="2849">
                  <c:v>2020.25</c:v>
                </c:pt>
                <c:pt idx="2854">
                  <c:v>1923.26</c:v>
                </c:pt>
                <c:pt idx="2864">
                  <c:v>2318.54</c:v>
                </c:pt>
                <c:pt idx="2881">
                  <c:v>1796.47</c:v>
                </c:pt>
                <c:pt idx="2883">
                  <c:v>4086.94</c:v>
                </c:pt>
                <c:pt idx="2892">
                  <c:v>1738.8</c:v>
                </c:pt>
                <c:pt idx="2901">
                  <c:v>944.56799999999998</c:v>
                </c:pt>
                <c:pt idx="2904">
                  <c:v>679.10400000000004</c:v>
                </c:pt>
                <c:pt idx="2908">
                  <c:v>1251.94</c:v>
                </c:pt>
                <c:pt idx="2910">
                  <c:v>1454.11</c:v>
                </c:pt>
                <c:pt idx="2913">
                  <c:v>1609.42</c:v>
                </c:pt>
                <c:pt idx="2916">
                  <c:v>1126.22</c:v>
                </c:pt>
                <c:pt idx="2917">
                  <c:v>3470.9</c:v>
                </c:pt>
                <c:pt idx="2924">
                  <c:v>1285.8499999999999</c:v>
                </c:pt>
                <c:pt idx="2926">
                  <c:v>629.20799999999997</c:v>
                </c:pt>
                <c:pt idx="2935">
                  <c:v>1264.03</c:v>
                </c:pt>
                <c:pt idx="2937">
                  <c:v>3578.9</c:v>
                </c:pt>
                <c:pt idx="2938">
                  <c:v>2237.7600000000002</c:v>
                </c:pt>
                <c:pt idx="2947">
                  <c:v>1013.9</c:v>
                </c:pt>
                <c:pt idx="2950">
                  <c:v>66.744</c:v>
                </c:pt>
                <c:pt idx="2953">
                  <c:v>2199.31</c:v>
                </c:pt>
                <c:pt idx="2958">
                  <c:v>1575.72</c:v>
                </c:pt>
                <c:pt idx="2960">
                  <c:v>85.536000000000001</c:v>
                </c:pt>
                <c:pt idx="2961">
                  <c:v>807.40800000000002</c:v>
                </c:pt>
                <c:pt idx="2965">
                  <c:v>1420.2</c:v>
                </c:pt>
                <c:pt idx="2970">
                  <c:v>1384.99</c:v>
                </c:pt>
                <c:pt idx="2973">
                  <c:v>2755.3</c:v>
                </c:pt>
                <c:pt idx="2989">
                  <c:v>1111.54</c:v>
                </c:pt>
                <c:pt idx="2992">
                  <c:v>1390.18</c:v>
                </c:pt>
                <c:pt idx="2996">
                  <c:v>2451.8200000000002</c:v>
                </c:pt>
                <c:pt idx="3001">
                  <c:v>4436.8599999999997</c:v>
                </c:pt>
                <c:pt idx="3007">
                  <c:v>1791.94</c:v>
                </c:pt>
                <c:pt idx="3009">
                  <c:v>1719.36</c:v>
                </c:pt>
                <c:pt idx="3013">
                  <c:v>2576.66</c:v>
                </c:pt>
                <c:pt idx="3015">
                  <c:v>1386.29</c:v>
                </c:pt>
                <c:pt idx="3017">
                  <c:v>1611.58</c:v>
                </c:pt>
                <c:pt idx="3021">
                  <c:v>1302.7</c:v>
                </c:pt>
                <c:pt idx="3031">
                  <c:v>1381.54</c:v>
                </c:pt>
                <c:pt idx="3035">
                  <c:v>1545.91</c:v>
                </c:pt>
                <c:pt idx="3040">
                  <c:v>1401.84</c:v>
                </c:pt>
                <c:pt idx="3042">
                  <c:v>1617.41</c:v>
                </c:pt>
                <c:pt idx="3044">
                  <c:v>1579.18</c:v>
                </c:pt>
                <c:pt idx="3049">
                  <c:v>1902.74</c:v>
                </c:pt>
                <c:pt idx="3055">
                  <c:v>1105.06</c:v>
                </c:pt>
                <c:pt idx="3059">
                  <c:v>1400.33</c:v>
                </c:pt>
                <c:pt idx="3062">
                  <c:v>2092.8200000000002</c:v>
                </c:pt>
                <c:pt idx="3067">
                  <c:v>2107.3000000000002</c:v>
                </c:pt>
                <c:pt idx="3085">
                  <c:v>1786.32</c:v>
                </c:pt>
                <c:pt idx="3088">
                  <c:v>1179.3599999999999</c:v>
                </c:pt>
                <c:pt idx="3092">
                  <c:v>2207.3000000000002</c:v>
                </c:pt>
                <c:pt idx="3093">
                  <c:v>2513.16</c:v>
                </c:pt>
                <c:pt idx="3096">
                  <c:v>1155.82</c:v>
                </c:pt>
                <c:pt idx="3101">
                  <c:v>1087.99</c:v>
                </c:pt>
                <c:pt idx="3112">
                  <c:v>1282.18</c:v>
                </c:pt>
                <c:pt idx="3113">
                  <c:v>2192.4</c:v>
                </c:pt>
                <c:pt idx="3119">
                  <c:v>2006.86</c:v>
                </c:pt>
                <c:pt idx="3122">
                  <c:v>2936.3</c:v>
                </c:pt>
                <c:pt idx="3127">
                  <c:v>1016.28</c:v>
                </c:pt>
                <c:pt idx="3129">
                  <c:v>1584.36</c:v>
                </c:pt>
                <c:pt idx="3132">
                  <c:v>2118.96</c:v>
                </c:pt>
                <c:pt idx="3139">
                  <c:v>2152.44</c:v>
                </c:pt>
                <c:pt idx="3140">
                  <c:v>1954.15</c:v>
                </c:pt>
                <c:pt idx="3141">
                  <c:v>1253.45</c:v>
                </c:pt>
                <c:pt idx="3143">
                  <c:v>1665.58</c:v>
                </c:pt>
                <c:pt idx="3149">
                  <c:v>1340.06</c:v>
                </c:pt>
                <c:pt idx="3151">
                  <c:v>4423.68</c:v>
                </c:pt>
                <c:pt idx="3155">
                  <c:v>3037.18</c:v>
                </c:pt>
                <c:pt idx="3160">
                  <c:v>1658.23</c:v>
                </c:pt>
                <c:pt idx="3173">
                  <c:v>1924.34</c:v>
                </c:pt>
                <c:pt idx="3184">
                  <c:v>1693.22</c:v>
                </c:pt>
                <c:pt idx="3188">
                  <c:v>1353.02</c:v>
                </c:pt>
                <c:pt idx="3190">
                  <c:v>1149.55</c:v>
                </c:pt>
                <c:pt idx="3194">
                  <c:v>2229.77</c:v>
                </c:pt>
                <c:pt idx="3195">
                  <c:v>2979.72</c:v>
                </c:pt>
                <c:pt idx="3201">
                  <c:v>2130.62</c:v>
                </c:pt>
                <c:pt idx="3205">
                  <c:v>1531.66</c:v>
                </c:pt>
                <c:pt idx="3224">
                  <c:v>1378.73</c:v>
                </c:pt>
                <c:pt idx="3226">
                  <c:v>1020.6</c:v>
                </c:pt>
                <c:pt idx="3227">
                  <c:v>1259.06</c:v>
                </c:pt>
                <c:pt idx="3232">
                  <c:v>1632.31</c:v>
                </c:pt>
                <c:pt idx="3233">
                  <c:v>1611.36</c:v>
                </c:pt>
                <c:pt idx="3245">
                  <c:v>1697.98</c:v>
                </c:pt>
                <c:pt idx="3250">
                  <c:v>1551.74</c:v>
                </c:pt>
                <c:pt idx="3251">
                  <c:v>3955.18</c:v>
                </c:pt>
                <c:pt idx="3254">
                  <c:v>1945.51</c:v>
                </c:pt>
                <c:pt idx="3255">
                  <c:v>1033.99</c:v>
                </c:pt>
                <c:pt idx="3256">
                  <c:v>1289.52</c:v>
                </c:pt>
                <c:pt idx="3266">
                  <c:v>1142.42</c:v>
                </c:pt>
                <c:pt idx="3270">
                  <c:v>1973.59</c:v>
                </c:pt>
                <c:pt idx="3271">
                  <c:v>1576.58</c:v>
                </c:pt>
                <c:pt idx="3273">
                  <c:v>2239.4899999999998</c:v>
                </c:pt>
                <c:pt idx="3277">
                  <c:v>1462.54</c:v>
                </c:pt>
                <c:pt idx="3279">
                  <c:v>1183.46</c:v>
                </c:pt>
                <c:pt idx="3281">
                  <c:v>2475.79</c:v>
                </c:pt>
                <c:pt idx="3283">
                  <c:v>1341.36</c:v>
                </c:pt>
                <c:pt idx="3284">
                  <c:v>1526.47</c:v>
                </c:pt>
                <c:pt idx="3289">
                  <c:v>1727.14</c:v>
                </c:pt>
                <c:pt idx="3310">
                  <c:v>4565.59</c:v>
                </c:pt>
                <c:pt idx="3317">
                  <c:v>1454.54</c:v>
                </c:pt>
                <c:pt idx="3320">
                  <c:v>2211.84</c:v>
                </c:pt>
                <c:pt idx="3322">
                  <c:v>2590.06</c:v>
                </c:pt>
                <c:pt idx="3327">
                  <c:v>2300.83</c:v>
                </c:pt>
                <c:pt idx="3328">
                  <c:v>2366.06</c:v>
                </c:pt>
                <c:pt idx="3331">
                  <c:v>1370.09</c:v>
                </c:pt>
                <c:pt idx="3339">
                  <c:v>1717.42</c:v>
                </c:pt>
                <c:pt idx="3340">
                  <c:v>1285.2</c:v>
                </c:pt>
                <c:pt idx="3350">
                  <c:v>1455.19</c:v>
                </c:pt>
                <c:pt idx="3351">
                  <c:v>1564.92</c:v>
                </c:pt>
                <c:pt idx="3359">
                  <c:v>1941.62</c:v>
                </c:pt>
                <c:pt idx="3361">
                  <c:v>1629.29</c:v>
                </c:pt>
                <c:pt idx="3365">
                  <c:v>436.10399999999998</c:v>
                </c:pt>
                <c:pt idx="3366">
                  <c:v>1907.71</c:v>
                </c:pt>
                <c:pt idx="3367">
                  <c:v>2178.58</c:v>
                </c:pt>
                <c:pt idx="3381">
                  <c:v>5035.18</c:v>
                </c:pt>
                <c:pt idx="3385">
                  <c:v>1091.02</c:v>
                </c:pt>
                <c:pt idx="3406">
                  <c:v>1634.69</c:v>
                </c:pt>
                <c:pt idx="3407">
                  <c:v>2697.41</c:v>
                </c:pt>
                <c:pt idx="3408">
                  <c:v>2067.5500000000002</c:v>
                </c:pt>
                <c:pt idx="3419">
                  <c:v>2234.09</c:v>
                </c:pt>
                <c:pt idx="3421">
                  <c:v>1402.7</c:v>
                </c:pt>
                <c:pt idx="3422">
                  <c:v>3020.54</c:v>
                </c:pt>
                <c:pt idx="3424">
                  <c:v>1839.67</c:v>
                </c:pt>
                <c:pt idx="3432">
                  <c:v>2104.06</c:v>
                </c:pt>
                <c:pt idx="3434">
                  <c:v>2217.89</c:v>
                </c:pt>
                <c:pt idx="3436">
                  <c:v>1725.84</c:v>
                </c:pt>
                <c:pt idx="3437">
                  <c:v>1265.1099999999999</c:v>
                </c:pt>
                <c:pt idx="3439">
                  <c:v>2043.58</c:v>
                </c:pt>
                <c:pt idx="3441">
                  <c:v>2821.61</c:v>
                </c:pt>
                <c:pt idx="3442">
                  <c:v>1829.74</c:v>
                </c:pt>
                <c:pt idx="3452">
                  <c:v>2847.96</c:v>
                </c:pt>
                <c:pt idx="3454">
                  <c:v>2281.39</c:v>
                </c:pt>
                <c:pt idx="3455">
                  <c:v>63.072000000000003</c:v>
                </c:pt>
                <c:pt idx="3456">
                  <c:v>3841.78</c:v>
                </c:pt>
                <c:pt idx="3459">
                  <c:v>1337.26</c:v>
                </c:pt>
                <c:pt idx="3463">
                  <c:v>1617.84</c:v>
                </c:pt>
                <c:pt idx="3464">
                  <c:v>1577.02</c:v>
                </c:pt>
                <c:pt idx="3468">
                  <c:v>2235.17</c:v>
                </c:pt>
                <c:pt idx="3473">
                  <c:v>1095.55</c:v>
                </c:pt>
                <c:pt idx="3475">
                  <c:v>2029.97</c:v>
                </c:pt>
                <c:pt idx="3483">
                  <c:v>1639.66</c:v>
                </c:pt>
                <c:pt idx="3485">
                  <c:v>4647.24</c:v>
                </c:pt>
                <c:pt idx="3493">
                  <c:v>2130.62</c:v>
                </c:pt>
                <c:pt idx="3503">
                  <c:v>1816.13</c:v>
                </c:pt>
                <c:pt idx="3505">
                  <c:v>1544.62</c:v>
                </c:pt>
                <c:pt idx="3508">
                  <c:v>1373.11</c:v>
                </c:pt>
                <c:pt idx="3511">
                  <c:v>1310.04</c:v>
                </c:pt>
                <c:pt idx="3512">
                  <c:v>1173.53</c:v>
                </c:pt>
                <c:pt idx="3513">
                  <c:v>1655.21</c:v>
                </c:pt>
                <c:pt idx="3515">
                  <c:v>1357.13</c:v>
                </c:pt>
                <c:pt idx="3517">
                  <c:v>2379.02</c:v>
                </c:pt>
                <c:pt idx="3523">
                  <c:v>4737.1000000000004</c:v>
                </c:pt>
                <c:pt idx="3526">
                  <c:v>1697.11</c:v>
                </c:pt>
                <c:pt idx="3533">
                  <c:v>1649.38</c:v>
                </c:pt>
                <c:pt idx="3541">
                  <c:v>1835.57</c:v>
                </c:pt>
                <c:pt idx="3555">
                  <c:v>1484.14</c:v>
                </c:pt>
                <c:pt idx="3574">
                  <c:v>1734.26</c:v>
                </c:pt>
                <c:pt idx="3577">
                  <c:v>1270.08</c:v>
                </c:pt>
                <c:pt idx="3582">
                  <c:v>1705.32</c:v>
                </c:pt>
                <c:pt idx="3594">
                  <c:v>1603.58</c:v>
                </c:pt>
                <c:pt idx="3601">
                  <c:v>1465.56</c:v>
                </c:pt>
                <c:pt idx="3607">
                  <c:v>2670.62</c:v>
                </c:pt>
                <c:pt idx="3609">
                  <c:v>1501.42</c:v>
                </c:pt>
                <c:pt idx="3610">
                  <c:v>1445.26</c:v>
                </c:pt>
                <c:pt idx="3625">
                  <c:v>1761.26</c:v>
                </c:pt>
                <c:pt idx="3636">
                  <c:v>3651.48</c:v>
                </c:pt>
                <c:pt idx="3637">
                  <c:v>2211.62</c:v>
                </c:pt>
                <c:pt idx="3642">
                  <c:v>1638.58</c:v>
                </c:pt>
                <c:pt idx="3643">
                  <c:v>1726.06</c:v>
                </c:pt>
                <c:pt idx="3645">
                  <c:v>1410.48</c:v>
                </c:pt>
                <c:pt idx="3661">
                  <c:v>1749.17</c:v>
                </c:pt>
                <c:pt idx="3670">
                  <c:v>2831.54</c:v>
                </c:pt>
                <c:pt idx="3672">
                  <c:v>1608.98</c:v>
                </c:pt>
                <c:pt idx="3674">
                  <c:v>1759.1</c:v>
                </c:pt>
                <c:pt idx="3679">
                  <c:v>1230.98</c:v>
                </c:pt>
                <c:pt idx="3680">
                  <c:v>2132.14</c:v>
                </c:pt>
                <c:pt idx="3686">
                  <c:v>1719.14</c:v>
                </c:pt>
                <c:pt idx="3688">
                  <c:v>1215.43</c:v>
                </c:pt>
                <c:pt idx="3692">
                  <c:v>2633.26</c:v>
                </c:pt>
                <c:pt idx="3695">
                  <c:v>2010.96</c:v>
                </c:pt>
                <c:pt idx="3696">
                  <c:v>5156.3500000000004</c:v>
                </c:pt>
                <c:pt idx="3697">
                  <c:v>3371.11</c:v>
                </c:pt>
                <c:pt idx="3704">
                  <c:v>1324.3</c:v>
                </c:pt>
                <c:pt idx="3705">
                  <c:v>1020.6</c:v>
                </c:pt>
                <c:pt idx="3706">
                  <c:v>2491.56</c:v>
                </c:pt>
                <c:pt idx="3712">
                  <c:v>1989.36</c:v>
                </c:pt>
                <c:pt idx="3718">
                  <c:v>1402.27</c:v>
                </c:pt>
                <c:pt idx="3725">
                  <c:v>2311.63</c:v>
                </c:pt>
                <c:pt idx="3727">
                  <c:v>1996.92</c:v>
                </c:pt>
                <c:pt idx="3728">
                  <c:v>1807.49</c:v>
                </c:pt>
                <c:pt idx="3730">
                  <c:v>2285.5</c:v>
                </c:pt>
                <c:pt idx="3732">
                  <c:v>3775.25</c:v>
                </c:pt>
                <c:pt idx="3733">
                  <c:v>1963.22</c:v>
                </c:pt>
                <c:pt idx="3734">
                  <c:v>2328.6999999999998</c:v>
                </c:pt>
                <c:pt idx="3735">
                  <c:v>3990.82</c:v>
                </c:pt>
                <c:pt idx="3739">
                  <c:v>1238.54</c:v>
                </c:pt>
                <c:pt idx="3746">
                  <c:v>1864.51</c:v>
                </c:pt>
                <c:pt idx="3747">
                  <c:v>1770.98</c:v>
                </c:pt>
                <c:pt idx="3748">
                  <c:v>1107.6500000000001</c:v>
                </c:pt>
                <c:pt idx="3755">
                  <c:v>1916.35</c:v>
                </c:pt>
                <c:pt idx="3760">
                  <c:v>2954.66</c:v>
                </c:pt>
                <c:pt idx="3783">
                  <c:v>1557.58</c:v>
                </c:pt>
                <c:pt idx="3786">
                  <c:v>1453.68</c:v>
                </c:pt>
                <c:pt idx="3799">
                  <c:v>1615.03</c:v>
                </c:pt>
                <c:pt idx="3804">
                  <c:v>2231.5</c:v>
                </c:pt>
                <c:pt idx="3810">
                  <c:v>2438.42</c:v>
                </c:pt>
                <c:pt idx="3815">
                  <c:v>1351.73</c:v>
                </c:pt>
                <c:pt idx="3818">
                  <c:v>6348.46</c:v>
                </c:pt>
                <c:pt idx="3821">
                  <c:v>1884.38</c:v>
                </c:pt>
                <c:pt idx="3822">
                  <c:v>1935.79</c:v>
                </c:pt>
                <c:pt idx="3827">
                  <c:v>1200.74</c:v>
                </c:pt>
                <c:pt idx="3835">
                  <c:v>2990.3</c:v>
                </c:pt>
                <c:pt idx="3854">
                  <c:v>1455.84</c:v>
                </c:pt>
                <c:pt idx="3856">
                  <c:v>1673.78</c:v>
                </c:pt>
                <c:pt idx="3869">
                  <c:v>2842.56</c:v>
                </c:pt>
                <c:pt idx="3880">
                  <c:v>1956.96</c:v>
                </c:pt>
                <c:pt idx="3881">
                  <c:v>1586.95</c:v>
                </c:pt>
                <c:pt idx="3884">
                  <c:v>1856.52</c:v>
                </c:pt>
                <c:pt idx="3887">
                  <c:v>1837.3</c:v>
                </c:pt>
                <c:pt idx="3892">
                  <c:v>1494.07</c:v>
                </c:pt>
                <c:pt idx="3893">
                  <c:v>1322.78</c:v>
                </c:pt>
                <c:pt idx="3894">
                  <c:v>1640.52</c:v>
                </c:pt>
                <c:pt idx="3895">
                  <c:v>2973.24</c:v>
                </c:pt>
                <c:pt idx="3903">
                  <c:v>1366.2</c:v>
                </c:pt>
                <c:pt idx="3909">
                  <c:v>1992.17</c:v>
                </c:pt>
                <c:pt idx="3910">
                  <c:v>3406.75</c:v>
                </c:pt>
                <c:pt idx="3917">
                  <c:v>1644.19</c:v>
                </c:pt>
                <c:pt idx="3923">
                  <c:v>2675.16</c:v>
                </c:pt>
                <c:pt idx="3926">
                  <c:v>1371.82</c:v>
                </c:pt>
                <c:pt idx="3934">
                  <c:v>1983.53</c:v>
                </c:pt>
                <c:pt idx="3936">
                  <c:v>1150.42</c:v>
                </c:pt>
                <c:pt idx="3953">
                  <c:v>2544.91</c:v>
                </c:pt>
                <c:pt idx="3955">
                  <c:v>1541.59</c:v>
                </c:pt>
                <c:pt idx="3960">
                  <c:v>1092.31</c:v>
                </c:pt>
                <c:pt idx="3964">
                  <c:v>2932.63</c:v>
                </c:pt>
                <c:pt idx="3967">
                  <c:v>1406.81</c:v>
                </c:pt>
                <c:pt idx="3972">
                  <c:v>2000.81</c:v>
                </c:pt>
                <c:pt idx="3975">
                  <c:v>1512.65</c:v>
                </c:pt>
                <c:pt idx="3978">
                  <c:v>2242.5100000000002</c:v>
                </c:pt>
                <c:pt idx="3980">
                  <c:v>1831.03</c:v>
                </c:pt>
                <c:pt idx="3984">
                  <c:v>4829.1099999999997</c:v>
                </c:pt>
                <c:pt idx="3986">
                  <c:v>1391.26</c:v>
                </c:pt>
                <c:pt idx="3987">
                  <c:v>1588.25</c:v>
                </c:pt>
                <c:pt idx="3996">
                  <c:v>3823.85</c:v>
                </c:pt>
                <c:pt idx="4003">
                  <c:v>4520.0200000000004</c:v>
                </c:pt>
                <c:pt idx="4009">
                  <c:v>1410.91</c:v>
                </c:pt>
                <c:pt idx="4015">
                  <c:v>2101.9</c:v>
                </c:pt>
                <c:pt idx="4023">
                  <c:v>1305.29</c:v>
                </c:pt>
                <c:pt idx="4024">
                  <c:v>2512.5100000000002</c:v>
                </c:pt>
                <c:pt idx="4028">
                  <c:v>2466.7199999999998</c:v>
                </c:pt>
                <c:pt idx="4029">
                  <c:v>2385.7199999999998</c:v>
                </c:pt>
                <c:pt idx="4033">
                  <c:v>3533.11</c:v>
                </c:pt>
                <c:pt idx="4035">
                  <c:v>1381.75</c:v>
                </c:pt>
                <c:pt idx="4044">
                  <c:v>2297.81</c:v>
                </c:pt>
                <c:pt idx="4046">
                  <c:v>1582.2</c:v>
                </c:pt>
                <c:pt idx="4049">
                  <c:v>1260.58</c:v>
                </c:pt>
                <c:pt idx="4051">
                  <c:v>1680.91</c:v>
                </c:pt>
                <c:pt idx="4066">
                  <c:v>2447.5</c:v>
                </c:pt>
                <c:pt idx="4074">
                  <c:v>1794.31</c:v>
                </c:pt>
                <c:pt idx="4085">
                  <c:v>1563.19</c:v>
                </c:pt>
                <c:pt idx="4092">
                  <c:v>1378.3</c:v>
                </c:pt>
                <c:pt idx="4093">
                  <c:v>1085.18</c:v>
                </c:pt>
                <c:pt idx="4094">
                  <c:v>1832.98</c:v>
                </c:pt>
                <c:pt idx="4097">
                  <c:v>1437.48</c:v>
                </c:pt>
                <c:pt idx="4100">
                  <c:v>1868.83</c:v>
                </c:pt>
                <c:pt idx="4103">
                  <c:v>1555.63</c:v>
                </c:pt>
                <c:pt idx="4117">
                  <c:v>2528.06</c:v>
                </c:pt>
                <c:pt idx="4120">
                  <c:v>1956.74</c:v>
                </c:pt>
                <c:pt idx="4122">
                  <c:v>1853.93</c:v>
                </c:pt>
                <c:pt idx="4129">
                  <c:v>1530.58</c:v>
                </c:pt>
                <c:pt idx="4135">
                  <c:v>1315.01</c:v>
                </c:pt>
                <c:pt idx="4146">
                  <c:v>2822.47</c:v>
                </c:pt>
                <c:pt idx="4151">
                  <c:v>3603.1</c:v>
                </c:pt>
                <c:pt idx="4152">
                  <c:v>2052.65</c:v>
                </c:pt>
                <c:pt idx="4164">
                  <c:v>1316.95</c:v>
                </c:pt>
                <c:pt idx="4165">
                  <c:v>1767.31</c:v>
                </c:pt>
                <c:pt idx="4169">
                  <c:v>1235.3</c:v>
                </c:pt>
                <c:pt idx="4170">
                  <c:v>1555.63</c:v>
                </c:pt>
                <c:pt idx="4171">
                  <c:v>1873.37</c:v>
                </c:pt>
                <c:pt idx="4172">
                  <c:v>1791.07</c:v>
                </c:pt>
                <c:pt idx="4181">
                  <c:v>1512.65</c:v>
                </c:pt>
                <c:pt idx="4191">
                  <c:v>2182.6799999999998</c:v>
                </c:pt>
                <c:pt idx="4197">
                  <c:v>1630.37</c:v>
                </c:pt>
                <c:pt idx="4208">
                  <c:v>1626.48</c:v>
                </c:pt>
                <c:pt idx="4211">
                  <c:v>1175.04</c:v>
                </c:pt>
                <c:pt idx="4213">
                  <c:v>1354.54</c:v>
                </c:pt>
                <c:pt idx="4219">
                  <c:v>1907.5</c:v>
                </c:pt>
                <c:pt idx="4221">
                  <c:v>1754.14</c:v>
                </c:pt>
                <c:pt idx="4222">
                  <c:v>2771.5</c:v>
                </c:pt>
                <c:pt idx="4229">
                  <c:v>1559.95</c:v>
                </c:pt>
                <c:pt idx="4231">
                  <c:v>2603.23</c:v>
                </c:pt>
                <c:pt idx="4242">
                  <c:v>1766.23</c:v>
                </c:pt>
                <c:pt idx="4243">
                  <c:v>1534.46</c:v>
                </c:pt>
                <c:pt idx="4246">
                  <c:v>1635.12</c:v>
                </c:pt>
                <c:pt idx="4250">
                  <c:v>1705.97</c:v>
                </c:pt>
                <c:pt idx="4257">
                  <c:v>3795.98</c:v>
                </c:pt>
                <c:pt idx="4262">
                  <c:v>2006.64</c:v>
                </c:pt>
                <c:pt idx="4263">
                  <c:v>1002.67</c:v>
                </c:pt>
                <c:pt idx="4272">
                  <c:v>2998.51</c:v>
                </c:pt>
                <c:pt idx="4276">
                  <c:v>1000.94</c:v>
                </c:pt>
                <c:pt idx="4282">
                  <c:v>151.416</c:v>
                </c:pt>
                <c:pt idx="4285">
                  <c:v>2246.62</c:v>
                </c:pt>
                <c:pt idx="4294">
                  <c:v>2188.94</c:v>
                </c:pt>
                <c:pt idx="4295">
                  <c:v>1866.67</c:v>
                </c:pt>
                <c:pt idx="4297">
                  <c:v>6797.3</c:v>
                </c:pt>
                <c:pt idx="4306">
                  <c:v>1821.1</c:v>
                </c:pt>
                <c:pt idx="4313">
                  <c:v>2503.0100000000002</c:v>
                </c:pt>
                <c:pt idx="4319">
                  <c:v>1313.5</c:v>
                </c:pt>
                <c:pt idx="4320">
                  <c:v>1311.77</c:v>
                </c:pt>
                <c:pt idx="4323">
                  <c:v>2374.6999999999998</c:v>
                </c:pt>
                <c:pt idx="4329">
                  <c:v>1386.07</c:v>
                </c:pt>
                <c:pt idx="4334">
                  <c:v>2294.5700000000002</c:v>
                </c:pt>
                <c:pt idx="4339">
                  <c:v>2517.0500000000002</c:v>
                </c:pt>
                <c:pt idx="4342">
                  <c:v>1602.94</c:v>
                </c:pt>
                <c:pt idx="4356">
                  <c:v>2857.9</c:v>
                </c:pt>
                <c:pt idx="4357">
                  <c:v>1612.44</c:v>
                </c:pt>
                <c:pt idx="4359">
                  <c:v>1906.42</c:v>
                </c:pt>
                <c:pt idx="4364">
                  <c:v>2316.17</c:v>
                </c:pt>
                <c:pt idx="4372">
                  <c:v>3427.49</c:v>
                </c:pt>
                <c:pt idx="4373">
                  <c:v>1829.09</c:v>
                </c:pt>
                <c:pt idx="4375">
                  <c:v>1820.66</c:v>
                </c:pt>
                <c:pt idx="4379">
                  <c:v>1332.5</c:v>
                </c:pt>
                <c:pt idx="4382">
                  <c:v>1994.54</c:v>
                </c:pt>
                <c:pt idx="4389">
                  <c:v>1707.05</c:v>
                </c:pt>
                <c:pt idx="4395">
                  <c:v>2326.54</c:v>
                </c:pt>
                <c:pt idx="4397">
                  <c:v>2201.9</c:v>
                </c:pt>
                <c:pt idx="4399">
                  <c:v>2180.3000000000002</c:v>
                </c:pt>
                <c:pt idx="4408">
                  <c:v>1051.27</c:v>
                </c:pt>
                <c:pt idx="4410">
                  <c:v>1740.1</c:v>
                </c:pt>
                <c:pt idx="4411">
                  <c:v>1167.7</c:v>
                </c:pt>
                <c:pt idx="4416">
                  <c:v>1982.23</c:v>
                </c:pt>
                <c:pt idx="4421">
                  <c:v>1310.04</c:v>
                </c:pt>
                <c:pt idx="4430">
                  <c:v>1326.67</c:v>
                </c:pt>
                <c:pt idx="4432">
                  <c:v>1409.18</c:v>
                </c:pt>
                <c:pt idx="4433">
                  <c:v>2091.31</c:v>
                </c:pt>
                <c:pt idx="4439">
                  <c:v>1407.24</c:v>
                </c:pt>
                <c:pt idx="4442">
                  <c:v>1313.71</c:v>
                </c:pt>
                <c:pt idx="4448">
                  <c:v>1667.52</c:v>
                </c:pt>
                <c:pt idx="4452">
                  <c:v>1890.86</c:v>
                </c:pt>
                <c:pt idx="4467">
                  <c:v>1606.18</c:v>
                </c:pt>
                <c:pt idx="4468">
                  <c:v>1969.49</c:v>
                </c:pt>
                <c:pt idx="4482">
                  <c:v>1219.0999999999999</c:v>
                </c:pt>
                <c:pt idx="4488">
                  <c:v>1783.73</c:v>
                </c:pt>
                <c:pt idx="4491">
                  <c:v>1581.98</c:v>
                </c:pt>
                <c:pt idx="4495">
                  <c:v>2136.2399999999998</c:v>
                </c:pt>
                <c:pt idx="4496">
                  <c:v>534.38400000000001</c:v>
                </c:pt>
                <c:pt idx="4498">
                  <c:v>1733.62</c:v>
                </c:pt>
                <c:pt idx="4512">
                  <c:v>1017.14</c:v>
                </c:pt>
                <c:pt idx="4513">
                  <c:v>1364.47</c:v>
                </c:pt>
                <c:pt idx="4515">
                  <c:v>2205.14</c:v>
                </c:pt>
                <c:pt idx="4522">
                  <c:v>1684.58</c:v>
                </c:pt>
                <c:pt idx="4526">
                  <c:v>2519.21</c:v>
                </c:pt>
                <c:pt idx="4535">
                  <c:v>1097.5</c:v>
                </c:pt>
                <c:pt idx="4544">
                  <c:v>2168.42</c:v>
                </c:pt>
                <c:pt idx="4546">
                  <c:v>1608.34</c:v>
                </c:pt>
                <c:pt idx="4547">
                  <c:v>1863</c:v>
                </c:pt>
                <c:pt idx="4549">
                  <c:v>1562.33</c:v>
                </c:pt>
                <c:pt idx="4556">
                  <c:v>1916.78</c:v>
                </c:pt>
                <c:pt idx="4558">
                  <c:v>3557.95</c:v>
                </c:pt>
                <c:pt idx="4559">
                  <c:v>1827.14</c:v>
                </c:pt>
                <c:pt idx="4565">
                  <c:v>1540.94</c:v>
                </c:pt>
                <c:pt idx="4580">
                  <c:v>2100.6</c:v>
                </c:pt>
                <c:pt idx="4583">
                  <c:v>2274.6999999999998</c:v>
                </c:pt>
                <c:pt idx="4587">
                  <c:v>1432.08</c:v>
                </c:pt>
                <c:pt idx="4595">
                  <c:v>1249.99</c:v>
                </c:pt>
                <c:pt idx="4596">
                  <c:v>5402.59</c:v>
                </c:pt>
                <c:pt idx="4602">
                  <c:v>1874.02</c:v>
                </c:pt>
                <c:pt idx="4611">
                  <c:v>2123.5</c:v>
                </c:pt>
                <c:pt idx="4616">
                  <c:v>1761.7</c:v>
                </c:pt>
                <c:pt idx="4621">
                  <c:v>1205.93</c:v>
                </c:pt>
                <c:pt idx="4623">
                  <c:v>1863.43</c:v>
                </c:pt>
                <c:pt idx="4625">
                  <c:v>1713.31</c:v>
                </c:pt>
                <c:pt idx="4631">
                  <c:v>1373.76</c:v>
                </c:pt>
                <c:pt idx="4634">
                  <c:v>628.12800000000004</c:v>
                </c:pt>
                <c:pt idx="4642">
                  <c:v>2123.71</c:v>
                </c:pt>
                <c:pt idx="4643">
                  <c:v>2879.28</c:v>
                </c:pt>
                <c:pt idx="4645">
                  <c:v>1134</c:v>
                </c:pt>
                <c:pt idx="4647">
                  <c:v>3338.71</c:v>
                </c:pt>
                <c:pt idx="4651">
                  <c:v>1332.94</c:v>
                </c:pt>
                <c:pt idx="4652">
                  <c:v>2072.52</c:v>
                </c:pt>
                <c:pt idx="4654">
                  <c:v>1524.74</c:v>
                </c:pt>
                <c:pt idx="4658">
                  <c:v>1739.23</c:v>
                </c:pt>
                <c:pt idx="4660">
                  <c:v>1407.89</c:v>
                </c:pt>
                <c:pt idx="4661">
                  <c:v>1528.85</c:v>
                </c:pt>
                <c:pt idx="4670">
                  <c:v>2036.66</c:v>
                </c:pt>
                <c:pt idx="4673">
                  <c:v>1410.48</c:v>
                </c:pt>
                <c:pt idx="4676">
                  <c:v>5479.27</c:v>
                </c:pt>
                <c:pt idx="4684">
                  <c:v>2079.2199999999998</c:v>
                </c:pt>
                <c:pt idx="4690">
                  <c:v>2294.7800000000002</c:v>
                </c:pt>
                <c:pt idx="4701">
                  <c:v>1667.74</c:v>
                </c:pt>
                <c:pt idx="4705">
                  <c:v>1842.91</c:v>
                </c:pt>
                <c:pt idx="4710">
                  <c:v>2453.7600000000002</c:v>
                </c:pt>
                <c:pt idx="4714">
                  <c:v>1392.98</c:v>
                </c:pt>
                <c:pt idx="4715">
                  <c:v>1799.28</c:v>
                </c:pt>
                <c:pt idx="4720">
                  <c:v>4069.22</c:v>
                </c:pt>
                <c:pt idx="4731">
                  <c:v>1087.99</c:v>
                </c:pt>
                <c:pt idx="4736">
                  <c:v>1270.51</c:v>
                </c:pt>
                <c:pt idx="4737">
                  <c:v>2032.56</c:v>
                </c:pt>
                <c:pt idx="4744">
                  <c:v>1915.27</c:v>
                </c:pt>
                <c:pt idx="4751">
                  <c:v>1437.7</c:v>
                </c:pt>
                <c:pt idx="4757">
                  <c:v>1602.5</c:v>
                </c:pt>
                <c:pt idx="4759">
                  <c:v>2551.1799999999998</c:v>
                </c:pt>
                <c:pt idx="4764">
                  <c:v>1656.29</c:v>
                </c:pt>
                <c:pt idx="4781">
                  <c:v>1559.74</c:v>
                </c:pt>
                <c:pt idx="4784">
                  <c:v>1426.25</c:v>
                </c:pt>
                <c:pt idx="4785">
                  <c:v>1961.06</c:v>
                </c:pt>
                <c:pt idx="4796">
                  <c:v>1252.1500000000001</c:v>
                </c:pt>
                <c:pt idx="4797">
                  <c:v>2156.54</c:v>
                </c:pt>
                <c:pt idx="4798">
                  <c:v>1597.1</c:v>
                </c:pt>
                <c:pt idx="4802">
                  <c:v>2407.3200000000002</c:v>
                </c:pt>
                <c:pt idx="4803">
                  <c:v>1272.02</c:v>
                </c:pt>
                <c:pt idx="4817">
                  <c:v>2550.1</c:v>
                </c:pt>
                <c:pt idx="4821">
                  <c:v>1649.59</c:v>
                </c:pt>
                <c:pt idx="4823">
                  <c:v>1249.1300000000001</c:v>
                </c:pt>
                <c:pt idx="4825">
                  <c:v>908.71199999999999</c:v>
                </c:pt>
                <c:pt idx="4830">
                  <c:v>2171.23</c:v>
                </c:pt>
                <c:pt idx="4840">
                  <c:v>1529.71</c:v>
                </c:pt>
                <c:pt idx="4841">
                  <c:v>1868.62</c:v>
                </c:pt>
                <c:pt idx="4847">
                  <c:v>1833.62</c:v>
                </c:pt>
                <c:pt idx="4858">
                  <c:v>1433.59</c:v>
                </c:pt>
                <c:pt idx="4860">
                  <c:v>2215.08</c:v>
                </c:pt>
                <c:pt idx="4878">
                  <c:v>1330.78</c:v>
                </c:pt>
                <c:pt idx="4881">
                  <c:v>1397.52</c:v>
                </c:pt>
                <c:pt idx="4882">
                  <c:v>1289.74</c:v>
                </c:pt>
                <c:pt idx="4883">
                  <c:v>1936.66</c:v>
                </c:pt>
                <c:pt idx="4885">
                  <c:v>2025.22</c:v>
                </c:pt>
                <c:pt idx="4887">
                  <c:v>1104.4100000000001</c:v>
                </c:pt>
                <c:pt idx="4902">
                  <c:v>1777.25</c:v>
                </c:pt>
                <c:pt idx="4907">
                  <c:v>1852.85</c:v>
                </c:pt>
                <c:pt idx="4914">
                  <c:v>1817.21</c:v>
                </c:pt>
                <c:pt idx="4919">
                  <c:v>1399.46</c:v>
                </c:pt>
                <c:pt idx="4925">
                  <c:v>1513.3</c:v>
                </c:pt>
                <c:pt idx="4931">
                  <c:v>1340.5</c:v>
                </c:pt>
                <c:pt idx="4935">
                  <c:v>1676.59</c:v>
                </c:pt>
                <c:pt idx="4942">
                  <c:v>1128.82</c:v>
                </c:pt>
                <c:pt idx="4949">
                  <c:v>2326.1</c:v>
                </c:pt>
                <c:pt idx="4953">
                  <c:v>1804.03</c:v>
                </c:pt>
                <c:pt idx="4960">
                  <c:v>2669.54</c:v>
                </c:pt>
                <c:pt idx="4961">
                  <c:v>1457.35</c:v>
                </c:pt>
                <c:pt idx="4964">
                  <c:v>2103.62</c:v>
                </c:pt>
                <c:pt idx="4967">
                  <c:v>1915.7</c:v>
                </c:pt>
                <c:pt idx="4980">
                  <c:v>2403.4299999999998</c:v>
                </c:pt>
                <c:pt idx="4981">
                  <c:v>4434.26</c:v>
                </c:pt>
                <c:pt idx="4985">
                  <c:v>1633.18</c:v>
                </c:pt>
                <c:pt idx="4986">
                  <c:v>1567.3</c:v>
                </c:pt>
                <c:pt idx="4991">
                  <c:v>1412.64</c:v>
                </c:pt>
                <c:pt idx="4993">
                  <c:v>1880.71</c:v>
                </c:pt>
                <c:pt idx="5001">
                  <c:v>1567.51</c:v>
                </c:pt>
                <c:pt idx="5009">
                  <c:v>2007.94</c:v>
                </c:pt>
                <c:pt idx="5013">
                  <c:v>1548.5</c:v>
                </c:pt>
                <c:pt idx="5016">
                  <c:v>343.87200000000001</c:v>
                </c:pt>
                <c:pt idx="5017">
                  <c:v>2779.92</c:v>
                </c:pt>
                <c:pt idx="5021">
                  <c:v>1421.5</c:v>
                </c:pt>
                <c:pt idx="5023">
                  <c:v>1926.72</c:v>
                </c:pt>
                <c:pt idx="5026">
                  <c:v>1540.73</c:v>
                </c:pt>
                <c:pt idx="5028">
                  <c:v>166.96799999999999</c:v>
                </c:pt>
                <c:pt idx="5035">
                  <c:v>1528.2</c:v>
                </c:pt>
                <c:pt idx="5036">
                  <c:v>2977.13</c:v>
                </c:pt>
                <c:pt idx="5041">
                  <c:v>1505.95</c:v>
                </c:pt>
                <c:pt idx="5044">
                  <c:v>4757.18</c:v>
                </c:pt>
                <c:pt idx="5045">
                  <c:v>1246.75</c:v>
                </c:pt>
                <c:pt idx="5047">
                  <c:v>1159.49</c:v>
                </c:pt>
                <c:pt idx="5049">
                  <c:v>2766.1</c:v>
                </c:pt>
                <c:pt idx="5053">
                  <c:v>2347.06</c:v>
                </c:pt>
                <c:pt idx="5068">
                  <c:v>2416.39</c:v>
                </c:pt>
                <c:pt idx="5071">
                  <c:v>1229.47</c:v>
                </c:pt>
                <c:pt idx="5073">
                  <c:v>2491.9899999999998</c:v>
                </c:pt>
                <c:pt idx="5088">
                  <c:v>3452.76</c:v>
                </c:pt>
                <c:pt idx="5097">
                  <c:v>1155.3800000000001</c:v>
                </c:pt>
                <c:pt idx="5099">
                  <c:v>1129.68</c:v>
                </c:pt>
                <c:pt idx="5108">
                  <c:v>2825.28</c:v>
                </c:pt>
                <c:pt idx="5110">
                  <c:v>2244.46</c:v>
                </c:pt>
                <c:pt idx="5118">
                  <c:v>1434.24</c:v>
                </c:pt>
                <c:pt idx="5122">
                  <c:v>2462.83</c:v>
                </c:pt>
                <c:pt idx="5123">
                  <c:v>1628.86</c:v>
                </c:pt>
                <c:pt idx="5125">
                  <c:v>2091.7399999999998</c:v>
                </c:pt>
                <c:pt idx="5131">
                  <c:v>1405.51</c:v>
                </c:pt>
                <c:pt idx="5132">
                  <c:v>2957.9</c:v>
                </c:pt>
                <c:pt idx="5135">
                  <c:v>1530.36</c:v>
                </c:pt>
                <c:pt idx="5148">
                  <c:v>1783.08</c:v>
                </c:pt>
                <c:pt idx="5154">
                  <c:v>1374.19</c:v>
                </c:pt>
                <c:pt idx="5158">
                  <c:v>2749.68</c:v>
                </c:pt>
                <c:pt idx="5162">
                  <c:v>166.75200000000001</c:v>
                </c:pt>
                <c:pt idx="5166">
                  <c:v>1575.29</c:v>
                </c:pt>
                <c:pt idx="5168">
                  <c:v>4706.8599999999997</c:v>
                </c:pt>
                <c:pt idx="5177">
                  <c:v>2047.25</c:v>
                </c:pt>
                <c:pt idx="5184">
                  <c:v>2359.58</c:v>
                </c:pt>
                <c:pt idx="5185">
                  <c:v>1403.14</c:v>
                </c:pt>
                <c:pt idx="5190">
                  <c:v>2528.2800000000002</c:v>
                </c:pt>
                <c:pt idx="5191">
                  <c:v>2298.46</c:v>
                </c:pt>
                <c:pt idx="5204">
                  <c:v>1286.71</c:v>
                </c:pt>
                <c:pt idx="5210">
                  <c:v>5802.19</c:v>
                </c:pt>
                <c:pt idx="5217">
                  <c:v>1492.13</c:v>
                </c:pt>
                <c:pt idx="5224">
                  <c:v>1674</c:v>
                </c:pt>
                <c:pt idx="5225">
                  <c:v>1073.74</c:v>
                </c:pt>
                <c:pt idx="5230">
                  <c:v>1289.0899999999999</c:v>
                </c:pt>
                <c:pt idx="5232">
                  <c:v>1670.76</c:v>
                </c:pt>
                <c:pt idx="5237">
                  <c:v>1123.6300000000001</c:v>
                </c:pt>
                <c:pt idx="5244">
                  <c:v>4168.8</c:v>
                </c:pt>
                <c:pt idx="5250">
                  <c:v>2333.66</c:v>
                </c:pt>
                <c:pt idx="5261">
                  <c:v>1224.72</c:v>
                </c:pt>
                <c:pt idx="5262">
                  <c:v>1686.74</c:v>
                </c:pt>
                <c:pt idx="5264">
                  <c:v>1462.32</c:v>
                </c:pt>
                <c:pt idx="5266">
                  <c:v>1697.11</c:v>
                </c:pt>
                <c:pt idx="5267">
                  <c:v>2105.14</c:v>
                </c:pt>
                <c:pt idx="5268">
                  <c:v>996.19200000000001</c:v>
                </c:pt>
                <c:pt idx="5269">
                  <c:v>4169.45</c:v>
                </c:pt>
                <c:pt idx="5274">
                  <c:v>1855.87</c:v>
                </c:pt>
                <c:pt idx="5279">
                  <c:v>1710.94</c:v>
                </c:pt>
                <c:pt idx="5282">
                  <c:v>1606.18</c:v>
                </c:pt>
                <c:pt idx="5286">
                  <c:v>1183.46</c:v>
                </c:pt>
                <c:pt idx="5290">
                  <c:v>1883.74</c:v>
                </c:pt>
                <c:pt idx="5292">
                  <c:v>1103.1099999999999</c:v>
                </c:pt>
                <c:pt idx="5293">
                  <c:v>2613.8200000000002</c:v>
                </c:pt>
                <c:pt idx="5294">
                  <c:v>1786.1</c:v>
                </c:pt>
                <c:pt idx="5305">
                  <c:v>1855.01</c:v>
                </c:pt>
                <c:pt idx="5309">
                  <c:v>1789.13</c:v>
                </c:pt>
                <c:pt idx="5319">
                  <c:v>3266.78</c:v>
                </c:pt>
                <c:pt idx="5320">
                  <c:v>1063.1500000000001</c:v>
                </c:pt>
                <c:pt idx="5329">
                  <c:v>1809</c:v>
                </c:pt>
                <c:pt idx="5331">
                  <c:v>2810.81</c:v>
                </c:pt>
                <c:pt idx="5340">
                  <c:v>1577.45</c:v>
                </c:pt>
                <c:pt idx="5342">
                  <c:v>1291.9000000000001</c:v>
                </c:pt>
                <c:pt idx="5344">
                  <c:v>3991.68</c:v>
                </c:pt>
                <c:pt idx="5354">
                  <c:v>1482.19</c:v>
                </c:pt>
                <c:pt idx="5359">
                  <c:v>1847.88</c:v>
                </c:pt>
                <c:pt idx="5362">
                  <c:v>1639.01</c:v>
                </c:pt>
                <c:pt idx="5364">
                  <c:v>6039.79</c:v>
                </c:pt>
                <c:pt idx="5369">
                  <c:v>1442.88</c:v>
                </c:pt>
                <c:pt idx="5376">
                  <c:v>2534.54</c:v>
                </c:pt>
                <c:pt idx="5377">
                  <c:v>2453.11</c:v>
                </c:pt>
                <c:pt idx="5380">
                  <c:v>2569.75</c:v>
                </c:pt>
                <c:pt idx="5384">
                  <c:v>2194.56</c:v>
                </c:pt>
                <c:pt idx="5385">
                  <c:v>1822.18</c:v>
                </c:pt>
                <c:pt idx="5389">
                  <c:v>2577.5300000000002</c:v>
                </c:pt>
                <c:pt idx="5400">
                  <c:v>1166.83</c:v>
                </c:pt>
                <c:pt idx="5401">
                  <c:v>1613.3</c:v>
                </c:pt>
                <c:pt idx="5410">
                  <c:v>1644.41</c:v>
                </c:pt>
                <c:pt idx="5414">
                  <c:v>1626.48</c:v>
                </c:pt>
                <c:pt idx="5420">
                  <c:v>1676.59</c:v>
                </c:pt>
                <c:pt idx="5432">
                  <c:v>1407.24</c:v>
                </c:pt>
                <c:pt idx="5435">
                  <c:v>1550.45</c:v>
                </c:pt>
                <c:pt idx="5449">
                  <c:v>1506.17</c:v>
                </c:pt>
                <c:pt idx="5458">
                  <c:v>1241.1400000000001</c:v>
                </c:pt>
                <c:pt idx="5461">
                  <c:v>2764.8</c:v>
                </c:pt>
                <c:pt idx="5465">
                  <c:v>1411.34</c:v>
                </c:pt>
                <c:pt idx="5470">
                  <c:v>1467.5</c:v>
                </c:pt>
                <c:pt idx="5472">
                  <c:v>1341.79</c:v>
                </c:pt>
                <c:pt idx="5475">
                  <c:v>2340.14</c:v>
                </c:pt>
                <c:pt idx="5477">
                  <c:v>1982.23</c:v>
                </c:pt>
                <c:pt idx="5478">
                  <c:v>1523.45</c:v>
                </c:pt>
                <c:pt idx="5481">
                  <c:v>2339.71</c:v>
                </c:pt>
                <c:pt idx="5487">
                  <c:v>1060.78</c:v>
                </c:pt>
                <c:pt idx="5497">
                  <c:v>1666.44</c:v>
                </c:pt>
                <c:pt idx="5501">
                  <c:v>2555.06</c:v>
                </c:pt>
                <c:pt idx="5502">
                  <c:v>2201.2600000000002</c:v>
                </c:pt>
                <c:pt idx="5508">
                  <c:v>2275.7800000000002</c:v>
                </c:pt>
                <c:pt idx="5516">
                  <c:v>2465.64</c:v>
                </c:pt>
                <c:pt idx="5517">
                  <c:v>1984.82</c:v>
                </c:pt>
                <c:pt idx="5518">
                  <c:v>1696.25</c:v>
                </c:pt>
                <c:pt idx="5519">
                  <c:v>2164.3200000000002</c:v>
                </c:pt>
                <c:pt idx="5520">
                  <c:v>1986.77</c:v>
                </c:pt>
                <c:pt idx="5525">
                  <c:v>1410.05</c:v>
                </c:pt>
                <c:pt idx="5541">
                  <c:v>3082.1</c:v>
                </c:pt>
                <c:pt idx="5544">
                  <c:v>1203.55</c:v>
                </c:pt>
                <c:pt idx="5547">
                  <c:v>1626.7</c:v>
                </c:pt>
                <c:pt idx="5549">
                  <c:v>2420.9299999999998</c:v>
                </c:pt>
                <c:pt idx="5552">
                  <c:v>1361.02</c:v>
                </c:pt>
                <c:pt idx="5555">
                  <c:v>1514.81</c:v>
                </c:pt>
                <c:pt idx="5562">
                  <c:v>2272.54</c:v>
                </c:pt>
                <c:pt idx="5565">
                  <c:v>1674.65</c:v>
                </c:pt>
                <c:pt idx="5567">
                  <c:v>1549.58</c:v>
                </c:pt>
                <c:pt idx="5576">
                  <c:v>1472.9</c:v>
                </c:pt>
                <c:pt idx="5585">
                  <c:v>1928.66</c:v>
                </c:pt>
                <c:pt idx="5586">
                  <c:v>1996.49</c:v>
                </c:pt>
                <c:pt idx="5593">
                  <c:v>2790.29</c:v>
                </c:pt>
                <c:pt idx="5594">
                  <c:v>1376.57</c:v>
                </c:pt>
                <c:pt idx="5609">
                  <c:v>1631.02</c:v>
                </c:pt>
                <c:pt idx="5610">
                  <c:v>2179.87</c:v>
                </c:pt>
                <c:pt idx="5612">
                  <c:v>1725.62</c:v>
                </c:pt>
                <c:pt idx="5620">
                  <c:v>1775.74</c:v>
                </c:pt>
                <c:pt idx="5622">
                  <c:v>1579.61</c:v>
                </c:pt>
                <c:pt idx="5628">
                  <c:v>1397.52</c:v>
                </c:pt>
                <c:pt idx="5637">
                  <c:v>1717.85</c:v>
                </c:pt>
                <c:pt idx="5642">
                  <c:v>2034.94</c:v>
                </c:pt>
                <c:pt idx="5643">
                  <c:v>1384.78</c:v>
                </c:pt>
                <c:pt idx="5646">
                  <c:v>1444.39</c:v>
                </c:pt>
                <c:pt idx="5651">
                  <c:v>1902.96</c:v>
                </c:pt>
                <c:pt idx="5653">
                  <c:v>2538.2199999999998</c:v>
                </c:pt>
                <c:pt idx="5654">
                  <c:v>1304.42</c:v>
                </c:pt>
                <c:pt idx="5655">
                  <c:v>1682.86</c:v>
                </c:pt>
                <c:pt idx="5657">
                  <c:v>1380.89</c:v>
                </c:pt>
                <c:pt idx="5659">
                  <c:v>2381.83</c:v>
                </c:pt>
                <c:pt idx="5661">
                  <c:v>1779.84</c:v>
                </c:pt>
                <c:pt idx="5675">
                  <c:v>1436.18</c:v>
                </c:pt>
                <c:pt idx="5677">
                  <c:v>1716.77</c:v>
                </c:pt>
                <c:pt idx="5682">
                  <c:v>1327.75</c:v>
                </c:pt>
                <c:pt idx="5684">
                  <c:v>1497.1</c:v>
                </c:pt>
                <c:pt idx="5690">
                  <c:v>1312.63</c:v>
                </c:pt>
                <c:pt idx="5695">
                  <c:v>2144.02</c:v>
                </c:pt>
                <c:pt idx="5698">
                  <c:v>1414.15</c:v>
                </c:pt>
                <c:pt idx="5699">
                  <c:v>1756.3</c:v>
                </c:pt>
                <c:pt idx="5701">
                  <c:v>2271.67</c:v>
                </c:pt>
                <c:pt idx="5706">
                  <c:v>3010.39</c:v>
                </c:pt>
                <c:pt idx="5725">
                  <c:v>3791.88</c:v>
                </c:pt>
                <c:pt idx="5738">
                  <c:v>1617.62</c:v>
                </c:pt>
                <c:pt idx="5748">
                  <c:v>1702.94</c:v>
                </c:pt>
                <c:pt idx="5755">
                  <c:v>1449.58</c:v>
                </c:pt>
                <c:pt idx="5774">
                  <c:v>1515.02</c:v>
                </c:pt>
                <c:pt idx="5775">
                  <c:v>1388.88</c:v>
                </c:pt>
                <c:pt idx="5783">
                  <c:v>1283.04</c:v>
                </c:pt>
                <c:pt idx="5785">
                  <c:v>2662.85</c:v>
                </c:pt>
                <c:pt idx="5786">
                  <c:v>3036.74</c:v>
                </c:pt>
                <c:pt idx="5788">
                  <c:v>2395.2199999999998</c:v>
                </c:pt>
                <c:pt idx="5789">
                  <c:v>1256.47</c:v>
                </c:pt>
                <c:pt idx="5791">
                  <c:v>1595.38</c:v>
                </c:pt>
                <c:pt idx="5792">
                  <c:v>2008.37</c:v>
                </c:pt>
                <c:pt idx="5797">
                  <c:v>1833.62</c:v>
                </c:pt>
                <c:pt idx="5798">
                  <c:v>2238.62</c:v>
                </c:pt>
                <c:pt idx="5802">
                  <c:v>2649.67</c:v>
                </c:pt>
                <c:pt idx="5803">
                  <c:v>1961.06</c:v>
                </c:pt>
                <c:pt idx="5808">
                  <c:v>1273.75</c:v>
                </c:pt>
                <c:pt idx="5831">
                  <c:v>1264.25</c:v>
                </c:pt>
                <c:pt idx="5834">
                  <c:v>1316.74</c:v>
                </c:pt>
                <c:pt idx="5835">
                  <c:v>1690.63</c:v>
                </c:pt>
                <c:pt idx="5839">
                  <c:v>2272.9699999999998</c:v>
                </c:pt>
                <c:pt idx="5842">
                  <c:v>1536.84</c:v>
                </c:pt>
                <c:pt idx="5843">
                  <c:v>1814.83</c:v>
                </c:pt>
                <c:pt idx="5844">
                  <c:v>1921.97</c:v>
                </c:pt>
                <c:pt idx="5849">
                  <c:v>1733.83</c:v>
                </c:pt>
                <c:pt idx="5851">
                  <c:v>1674.22</c:v>
                </c:pt>
                <c:pt idx="5855">
                  <c:v>2892.67</c:v>
                </c:pt>
                <c:pt idx="5867">
                  <c:v>1947.02</c:v>
                </c:pt>
                <c:pt idx="5874">
                  <c:v>1216.08</c:v>
                </c:pt>
                <c:pt idx="5877">
                  <c:v>2870.64</c:v>
                </c:pt>
                <c:pt idx="5878">
                  <c:v>2059.13</c:v>
                </c:pt>
                <c:pt idx="5892">
                  <c:v>1634.26</c:v>
                </c:pt>
                <c:pt idx="5894">
                  <c:v>1736.64</c:v>
                </c:pt>
                <c:pt idx="5900">
                  <c:v>1414.37</c:v>
                </c:pt>
                <c:pt idx="5903">
                  <c:v>1601.21</c:v>
                </c:pt>
                <c:pt idx="5906">
                  <c:v>1385.21</c:v>
                </c:pt>
                <c:pt idx="5907">
                  <c:v>1535.11</c:v>
                </c:pt>
                <c:pt idx="5912">
                  <c:v>3430.08</c:v>
                </c:pt>
                <c:pt idx="5913">
                  <c:v>1341.58</c:v>
                </c:pt>
                <c:pt idx="5919">
                  <c:v>2278.37</c:v>
                </c:pt>
                <c:pt idx="5921">
                  <c:v>1536.41</c:v>
                </c:pt>
                <c:pt idx="5922">
                  <c:v>1696.25</c:v>
                </c:pt>
                <c:pt idx="5926">
                  <c:v>1755.43</c:v>
                </c:pt>
                <c:pt idx="5933">
                  <c:v>2180.9499999999998</c:v>
                </c:pt>
                <c:pt idx="5937">
                  <c:v>1704.89</c:v>
                </c:pt>
                <c:pt idx="5958">
                  <c:v>1424.74</c:v>
                </c:pt>
                <c:pt idx="5960">
                  <c:v>2401.6999999999998</c:v>
                </c:pt>
                <c:pt idx="5964">
                  <c:v>1721.95</c:v>
                </c:pt>
                <c:pt idx="5967">
                  <c:v>1998.65</c:v>
                </c:pt>
                <c:pt idx="5978">
                  <c:v>2268.65</c:v>
                </c:pt>
                <c:pt idx="5980">
                  <c:v>1316.3</c:v>
                </c:pt>
                <c:pt idx="5984">
                  <c:v>1456.92</c:v>
                </c:pt>
                <c:pt idx="5987">
                  <c:v>1352.81</c:v>
                </c:pt>
                <c:pt idx="5988">
                  <c:v>1219.97</c:v>
                </c:pt>
                <c:pt idx="5995">
                  <c:v>2674.51</c:v>
                </c:pt>
                <c:pt idx="5999">
                  <c:v>1574.21</c:v>
                </c:pt>
                <c:pt idx="6000">
                  <c:v>1505.3</c:v>
                </c:pt>
                <c:pt idx="6003">
                  <c:v>2580.34</c:v>
                </c:pt>
                <c:pt idx="6004">
                  <c:v>4051.3</c:v>
                </c:pt>
                <c:pt idx="6007">
                  <c:v>1735.78</c:v>
                </c:pt>
                <c:pt idx="6013">
                  <c:v>1896.48</c:v>
                </c:pt>
                <c:pt idx="6015">
                  <c:v>1417.61</c:v>
                </c:pt>
                <c:pt idx="6016">
                  <c:v>2304.0700000000002</c:v>
                </c:pt>
                <c:pt idx="6033">
                  <c:v>1675.08</c:v>
                </c:pt>
                <c:pt idx="6034">
                  <c:v>1243.73</c:v>
                </c:pt>
                <c:pt idx="6036">
                  <c:v>3233.3</c:v>
                </c:pt>
                <c:pt idx="6037">
                  <c:v>1191.46</c:v>
                </c:pt>
                <c:pt idx="6047">
                  <c:v>1820.02</c:v>
                </c:pt>
                <c:pt idx="6051">
                  <c:v>3264.62</c:v>
                </c:pt>
                <c:pt idx="6059">
                  <c:v>1715.9</c:v>
                </c:pt>
                <c:pt idx="6063">
                  <c:v>1868.83</c:v>
                </c:pt>
                <c:pt idx="6066">
                  <c:v>1212.4100000000001</c:v>
                </c:pt>
                <c:pt idx="6069">
                  <c:v>2254.61</c:v>
                </c:pt>
                <c:pt idx="6074">
                  <c:v>1895.18</c:v>
                </c:pt>
                <c:pt idx="6079">
                  <c:v>1665.79</c:v>
                </c:pt>
                <c:pt idx="6098">
                  <c:v>1552.39</c:v>
                </c:pt>
                <c:pt idx="6101">
                  <c:v>2377.3000000000002</c:v>
                </c:pt>
                <c:pt idx="6116">
                  <c:v>1317.17</c:v>
                </c:pt>
                <c:pt idx="6119">
                  <c:v>1855.44</c:v>
                </c:pt>
                <c:pt idx="6128">
                  <c:v>1224.07</c:v>
                </c:pt>
                <c:pt idx="6130">
                  <c:v>1914.19</c:v>
                </c:pt>
                <c:pt idx="6139">
                  <c:v>2466.7199999999998</c:v>
                </c:pt>
                <c:pt idx="6140">
                  <c:v>1885.46</c:v>
                </c:pt>
                <c:pt idx="6142">
                  <c:v>1526.69</c:v>
                </c:pt>
                <c:pt idx="6145">
                  <c:v>1578.74</c:v>
                </c:pt>
                <c:pt idx="6153">
                  <c:v>1597.1</c:v>
                </c:pt>
                <c:pt idx="6158">
                  <c:v>3411.72</c:v>
                </c:pt>
                <c:pt idx="6166">
                  <c:v>2369.9499999999998</c:v>
                </c:pt>
                <c:pt idx="6168">
                  <c:v>1618.49</c:v>
                </c:pt>
                <c:pt idx="6169">
                  <c:v>1922.62</c:v>
                </c:pt>
                <c:pt idx="6174">
                  <c:v>1639.01</c:v>
                </c:pt>
                <c:pt idx="6179">
                  <c:v>1732.75</c:v>
                </c:pt>
                <c:pt idx="6185">
                  <c:v>2760.05</c:v>
                </c:pt>
                <c:pt idx="6189">
                  <c:v>1768.61</c:v>
                </c:pt>
                <c:pt idx="6194">
                  <c:v>1535.76</c:v>
                </c:pt>
                <c:pt idx="6197">
                  <c:v>1905.98</c:v>
                </c:pt>
                <c:pt idx="6206">
                  <c:v>1486.73</c:v>
                </c:pt>
                <c:pt idx="6208">
                  <c:v>1595.59</c:v>
                </c:pt>
                <c:pt idx="6213">
                  <c:v>919.94399999999996</c:v>
                </c:pt>
                <c:pt idx="6217">
                  <c:v>3014.28</c:v>
                </c:pt>
                <c:pt idx="6218">
                  <c:v>1767.31</c:v>
                </c:pt>
                <c:pt idx="6219">
                  <c:v>1540.51</c:v>
                </c:pt>
                <c:pt idx="6223">
                  <c:v>1811.38</c:v>
                </c:pt>
                <c:pt idx="6224">
                  <c:v>2174.69</c:v>
                </c:pt>
                <c:pt idx="6227">
                  <c:v>2390.4699999999998</c:v>
                </c:pt>
                <c:pt idx="6231">
                  <c:v>1675.3</c:v>
                </c:pt>
                <c:pt idx="6232">
                  <c:v>2089.58</c:v>
                </c:pt>
                <c:pt idx="6235">
                  <c:v>2560.9</c:v>
                </c:pt>
                <c:pt idx="6238">
                  <c:v>1451.52</c:v>
                </c:pt>
                <c:pt idx="6241">
                  <c:v>1848.31</c:v>
                </c:pt>
                <c:pt idx="6244">
                  <c:v>2088.94</c:v>
                </c:pt>
                <c:pt idx="6250">
                  <c:v>1761.7</c:v>
                </c:pt>
                <c:pt idx="6252">
                  <c:v>2052.65</c:v>
                </c:pt>
                <c:pt idx="6266">
                  <c:v>1072.6600000000001</c:v>
                </c:pt>
                <c:pt idx="6268">
                  <c:v>1368.58</c:v>
                </c:pt>
                <c:pt idx="6269">
                  <c:v>1756.51</c:v>
                </c:pt>
                <c:pt idx="6270">
                  <c:v>1857.17</c:v>
                </c:pt>
                <c:pt idx="6271">
                  <c:v>1287.3599999999999</c:v>
                </c:pt>
                <c:pt idx="6281">
                  <c:v>1311.77</c:v>
                </c:pt>
                <c:pt idx="6288">
                  <c:v>2586.17</c:v>
                </c:pt>
                <c:pt idx="6301">
                  <c:v>1498.18</c:v>
                </c:pt>
                <c:pt idx="6302">
                  <c:v>2020.25</c:v>
                </c:pt>
                <c:pt idx="6304">
                  <c:v>1891.51</c:v>
                </c:pt>
                <c:pt idx="6305">
                  <c:v>1406.16</c:v>
                </c:pt>
                <c:pt idx="6330">
                  <c:v>1216.08</c:v>
                </c:pt>
                <c:pt idx="6334">
                  <c:v>3067.2</c:v>
                </c:pt>
                <c:pt idx="6353">
                  <c:v>1373.33</c:v>
                </c:pt>
                <c:pt idx="6356">
                  <c:v>2638.66</c:v>
                </c:pt>
                <c:pt idx="6357">
                  <c:v>1993.68</c:v>
                </c:pt>
                <c:pt idx="6358">
                  <c:v>1928.45</c:v>
                </c:pt>
                <c:pt idx="6361">
                  <c:v>1755.86</c:v>
                </c:pt>
                <c:pt idx="6369">
                  <c:v>2679.05</c:v>
                </c:pt>
                <c:pt idx="6370">
                  <c:v>1467.94</c:v>
                </c:pt>
                <c:pt idx="6384">
                  <c:v>1762.13</c:v>
                </c:pt>
                <c:pt idx="6387">
                  <c:v>1605.53</c:v>
                </c:pt>
                <c:pt idx="6399">
                  <c:v>2148.98</c:v>
                </c:pt>
                <c:pt idx="6402">
                  <c:v>1544.18</c:v>
                </c:pt>
                <c:pt idx="6411">
                  <c:v>2070.58</c:v>
                </c:pt>
                <c:pt idx="6413">
                  <c:v>4660.8500000000004</c:v>
                </c:pt>
                <c:pt idx="6418">
                  <c:v>2084.83</c:v>
                </c:pt>
                <c:pt idx="6421">
                  <c:v>663.12</c:v>
                </c:pt>
                <c:pt idx="6425">
                  <c:v>2121.34</c:v>
                </c:pt>
                <c:pt idx="6427">
                  <c:v>2760.48</c:v>
                </c:pt>
                <c:pt idx="6428">
                  <c:v>1128.3800000000001</c:v>
                </c:pt>
                <c:pt idx="6433">
                  <c:v>1802.52</c:v>
                </c:pt>
                <c:pt idx="6437">
                  <c:v>1652.18</c:v>
                </c:pt>
                <c:pt idx="6440">
                  <c:v>1971.65</c:v>
                </c:pt>
                <c:pt idx="6444">
                  <c:v>1558.01</c:v>
                </c:pt>
                <c:pt idx="6452">
                  <c:v>2476.66</c:v>
                </c:pt>
                <c:pt idx="6453">
                  <c:v>1840.75</c:v>
                </c:pt>
                <c:pt idx="6455">
                  <c:v>1484.35</c:v>
                </c:pt>
                <c:pt idx="6457">
                  <c:v>1644.19</c:v>
                </c:pt>
                <c:pt idx="6464">
                  <c:v>1781.57</c:v>
                </c:pt>
                <c:pt idx="6466">
                  <c:v>1617.19</c:v>
                </c:pt>
                <c:pt idx="6474">
                  <c:v>1604.66</c:v>
                </c:pt>
                <c:pt idx="6482">
                  <c:v>2278.15</c:v>
                </c:pt>
                <c:pt idx="6490">
                  <c:v>2079.65</c:v>
                </c:pt>
                <c:pt idx="6491">
                  <c:v>1243.51</c:v>
                </c:pt>
                <c:pt idx="6492">
                  <c:v>2005.13</c:v>
                </c:pt>
                <c:pt idx="6493">
                  <c:v>1569.67</c:v>
                </c:pt>
                <c:pt idx="6497">
                  <c:v>2147.69</c:v>
                </c:pt>
                <c:pt idx="6502">
                  <c:v>1798.63</c:v>
                </c:pt>
                <c:pt idx="6505">
                  <c:v>1913.11</c:v>
                </c:pt>
                <c:pt idx="6511">
                  <c:v>5401.3</c:v>
                </c:pt>
                <c:pt idx="6526">
                  <c:v>1652.18</c:v>
                </c:pt>
                <c:pt idx="6527">
                  <c:v>1821.74</c:v>
                </c:pt>
                <c:pt idx="6529">
                  <c:v>1527.77</c:v>
                </c:pt>
                <c:pt idx="6531">
                  <c:v>2853.58</c:v>
                </c:pt>
                <c:pt idx="6534">
                  <c:v>1888.92</c:v>
                </c:pt>
                <c:pt idx="6538">
                  <c:v>3132.86</c:v>
                </c:pt>
                <c:pt idx="6540">
                  <c:v>1256.26</c:v>
                </c:pt>
                <c:pt idx="6542">
                  <c:v>1467.07</c:v>
                </c:pt>
                <c:pt idx="6543">
                  <c:v>1868.83</c:v>
                </c:pt>
                <c:pt idx="6548">
                  <c:v>1941.84</c:v>
                </c:pt>
                <c:pt idx="6549">
                  <c:v>1812.89</c:v>
                </c:pt>
                <c:pt idx="6554">
                  <c:v>3294.86</c:v>
                </c:pt>
                <c:pt idx="6556">
                  <c:v>1494.07</c:v>
                </c:pt>
                <c:pt idx="6574">
                  <c:v>1778.76</c:v>
                </c:pt>
                <c:pt idx="6577">
                  <c:v>1688.04</c:v>
                </c:pt>
                <c:pt idx="6578">
                  <c:v>1437.91</c:v>
                </c:pt>
                <c:pt idx="6584">
                  <c:v>1714.82</c:v>
                </c:pt>
                <c:pt idx="6593">
                  <c:v>2453.11</c:v>
                </c:pt>
                <c:pt idx="6597">
                  <c:v>2441.23</c:v>
                </c:pt>
                <c:pt idx="6600">
                  <c:v>838.94399999999996</c:v>
                </c:pt>
                <c:pt idx="6608">
                  <c:v>1951.78</c:v>
                </c:pt>
                <c:pt idx="6609">
                  <c:v>2071.87</c:v>
                </c:pt>
                <c:pt idx="6614">
                  <c:v>1630.58</c:v>
                </c:pt>
                <c:pt idx="6615">
                  <c:v>1885.46</c:v>
                </c:pt>
                <c:pt idx="6622">
                  <c:v>2626.56</c:v>
                </c:pt>
                <c:pt idx="6628">
                  <c:v>1773.36</c:v>
                </c:pt>
                <c:pt idx="6641">
                  <c:v>1017.58</c:v>
                </c:pt>
                <c:pt idx="6653">
                  <c:v>1649.38</c:v>
                </c:pt>
                <c:pt idx="6658">
                  <c:v>2633.9</c:v>
                </c:pt>
                <c:pt idx="6662">
                  <c:v>176.904</c:v>
                </c:pt>
                <c:pt idx="6666">
                  <c:v>1385.86</c:v>
                </c:pt>
                <c:pt idx="6669">
                  <c:v>1970.57</c:v>
                </c:pt>
                <c:pt idx="6672">
                  <c:v>1636.42</c:v>
                </c:pt>
                <c:pt idx="6673">
                  <c:v>2226.96</c:v>
                </c:pt>
                <c:pt idx="6674">
                  <c:v>2112.0500000000002</c:v>
                </c:pt>
                <c:pt idx="6677">
                  <c:v>1798.63</c:v>
                </c:pt>
                <c:pt idx="6682">
                  <c:v>2202.34</c:v>
                </c:pt>
                <c:pt idx="6686">
                  <c:v>2334.7399999999998</c:v>
                </c:pt>
                <c:pt idx="6687">
                  <c:v>1854.36</c:v>
                </c:pt>
                <c:pt idx="6692">
                  <c:v>2000.38</c:v>
                </c:pt>
                <c:pt idx="6696">
                  <c:v>1986.12</c:v>
                </c:pt>
                <c:pt idx="6697">
                  <c:v>1596.02</c:v>
                </c:pt>
                <c:pt idx="6698">
                  <c:v>1381.32</c:v>
                </c:pt>
                <c:pt idx="6705">
                  <c:v>2143.37</c:v>
                </c:pt>
                <c:pt idx="6715">
                  <c:v>1947.46</c:v>
                </c:pt>
                <c:pt idx="6716">
                  <c:v>1488.67</c:v>
                </c:pt>
                <c:pt idx="6717">
                  <c:v>3129.41</c:v>
                </c:pt>
                <c:pt idx="6718">
                  <c:v>2403.4299999999998</c:v>
                </c:pt>
                <c:pt idx="6739">
                  <c:v>2080.73</c:v>
                </c:pt>
                <c:pt idx="6753">
                  <c:v>3044.52</c:v>
                </c:pt>
                <c:pt idx="6759">
                  <c:v>3276.29</c:v>
                </c:pt>
                <c:pt idx="6764">
                  <c:v>2351.16</c:v>
                </c:pt>
                <c:pt idx="6785">
                  <c:v>2372.11</c:v>
                </c:pt>
                <c:pt idx="6788">
                  <c:v>2099.9499999999998</c:v>
                </c:pt>
                <c:pt idx="6791">
                  <c:v>1518.26</c:v>
                </c:pt>
                <c:pt idx="6795">
                  <c:v>1624.32</c:v>
                </c:pt>
                <c:pt idx="6797">
                  <c:v>2484</c:v>
                </c:pt>
                <c:pt idx="6803">
                  <c:v>2051.5700000000002</c:v>
                </c:pt>
                <c:pt idx="6808">
                  <c:v>1546.99</c:v>
                </c:pt>
                <c:pt idx="6810">
                  <c:v>1456.49</c:v>
                </c:pt>
                <c:pt idx="6813">
                  <c:v>2583.14</c:v>
                </c:pt>
                <c:pt idx="6814">
                  <c:v>1423.66</c:v>
                </c:pt>
                <c:pt idx="6819">
                  <c:v>1000.3</c:v>
                </c:pt>
                <c:pt idx="6821">
                  <c:v>1338.12</c:v>
                </c:pt>
                <c:pt idx="6822">
                  <c:v>1791.5</c:v>
                </c:pt>
                <c:pt idx="6823">
                  <c:v>1391.9</c:v>
                </c:pt>
                <c:pt idx="6834">
                  <c:v>1537.49</c:v>
                </c:pt>
                <c:pt idx="6835">
                  <c:v>1931.9</c:v>
                </c:pt>
                <c:pt idx="6846">
                  <c:v>1934.28</c:v>
                </c:pt>
                <c:pt idx="6847">
                  <c:v>2270.59</c:v>
                </c:pt>
                <c:pt idx="6849">
                  <c:v>2326.1</c:v>
                </c:pt>
                <c:pt idx="6854">
                  <c:v>1835.78</c:v>
                </c:pt>
                <c:pt idx="6855">
                  <c:v>1724.76</c:v>
                </c:pt>
                <c:pt idx="6856">
                  <c:v>1190.3800000000001</c:v>
                </c:pt>
                <c:pt idx="6857">
                  <c:v>1354.97</c:v>
                </c:pt>
                <c:pt idx="6864">
                  <c:v>2239.06</c:v>
                </c:pt>
                <c:pt idx="6866">
                  <c:v>1698.41</c:v>
                </c:pt>
                <c:pt idx="6873">
                  <c:v>1998</c:v>
                </c:pt>
                <c:pt idx="6876">
                  <c:v>2320.27</c:v>
                </c:pt>
                <c:pt idx="6880">
                  <c:v>1123.6300000000001</c:v>
                </c:pt>
                <c:pt idx="6892">
                  <c:v>1428.41</c:v>
                </c:pt>
                <c:pt idx="6897">
                  <c:v>2917.3</c:v>
                </c:pt>
                <c:pt idx="6899">
                  <c:v>2108.59</c:v>
                </c:pt>
                <c:pt idx="6900">
                  <c:v>1343.95</c:v>
                </c:pt>
                <c:pt idx="6905">
                  <c:v>1367.06</c:v>
                </c:pt>
                <c:pt idx="6907">
                  <c:v>1687.61</c:v>
                </c:pt>
                <c:pt idx="6908">
                  <c:v>1195.1300000000001</c:v>
                </c:pt>
                <c:pt idx="6909">
                  <c:v>1647</c:v>
                </c:pt>
                <c:pt idx="6911">
                  <c:v>1482.84</c:v>
                </c:pt>
                <c:pt idx="6912">
                  <c:v>2189.81</c:v>
                </c:pt>
                <c:pt idx="6915">
                  <c:v>2077.6999999999998</c:v>
                </c:pt>
                <c:pt idx="6925">
                  <c:v>3407.18</c:v>
                </c:pt>
                <c:pt idx="6927">
                  <c:v>2793.74</c:v>
                </c:pt>
                <c:pt idx="6934">
                  <c:v>1572.7</c:v>
                </c:pt>
                <c:pt idx="6936">
                  <c:v>1761.7</c:v>
                </c:pt>
                <c:pt idx="6942">
                  <c:v>1442.23</c:v>
                </c:pt>
                <c:pt idx="6945">
                  <c:v>1902.96</c:v>
                </c:pt>
                <c:pt idx="6961">
                  <c:v>1516.97</c:v>
                </c:pt>
                <c:pt idx="6970">
                  <c:v>1599.05</c:v>
                </c:pt>
                <c:pt idx="6972">
                  <c:v>1244.3800000000001</c:v>
                </c:pt>
                <c:pt idx="6978">
                  <c:v>1369.87</c:v>
                </c:pt>
                <c:pt idx="6982">
                  <c:v>2542.1</c:v>
                </c:pt>
                <c:pt idx="6983">
                  <c:v>1713.96</c:v>
                </c:pt>
                <c:pt idx="6986">
                  <c:v>1639.66</c:v>
                </c:pt>
                <c:pt idx="7003">
                  <c:v>3093.34</c:v>
                </c:pt>
                <c:pt idx="7005">
                  <c:v>2849.26</c:v>
                </c:pt>
                <c:pt idx="7016">
                  <c:v>1566.65</c:v>
                </c:pt>
                <c:pt idx="7019">
                  <c:v>1322.35</c:v>
                </c:pt>
                <c:pt idx="7026">
                  <c:v>1006.99</c:v>
                </c:pt>
                <c:pt idx="7029">
                  <c:v>1387.58</c:v>
                </c:pt>
                <c:pt idx="7030">
                  <c:v>1634.04</c:v>
                </c:pt>
                <c:pt idx="7041">
                  <c:v>1878.55</c:v>
                </c:pt>
                <c:pt idx="7046">
                  <c:v>1391.04</c:v>
                </c:pt>
                <c:pt idx="7047">
                  <c:v>1887.41</c:v>
                </c:pt>
                <c:pt idx="7050">
                  <c:v>1264.03</c:v>
                </c:pt>
                <c:pt idx="7053">
                  <c:v>1696.9</c:v>
                </c:pt>
                <c:pt idx="7054">
                  <c:v>2271.2399999999998</c:v>
                </c:pt>
                <c:pt idx="7056">
                  <c:v>2703.02</c:v>
                </c:pt>
                <c:pt idx="7061">
                  <c:v>2740.39</c:v>
                </c:pt>
                <c:pt idx="7062">
                  <c:v>1443.74</c:v>
                </c:pt>
                <c:pt idx="7065">
                  <c:v>2159.7800000000002</c:v>
                </c:pt>
                <c:pt idx="7075">
                  <c:v>1850.26</c:v>
                </c:pt>
                <c:pt idx="7087">
                  <c:v>1009.8</c:v>
                </c:pt>
                <c:pt idx="7088">
                  <c:v>2649.46</c:v>
                </c:pt>
                <c:pt idx="7092">
                  <c:v>2482.6999999999998</c:v>
                </c:pt>
                <c:pt idx="7093">
                  <c:v>1168.1300000000001</c:v>
                </c:pt>
                <c:pt idx="7094">
                  <c:v>1131.6199999999999</c:v>
                </c:pt>
                <c:pt idx="7097">
                  <c:v>1825.85</c:v>
                </c:pt>
                <c:pt idx="7101">
                  <c:v>1436.18</c:v>
                </c:pt>
                <c:pt idx="7108">
                  <c:v>1511.57</c:v>
                </c:pt>
                <c:pt idx="7110">
                  <c:v>1529.71</c:v>
                </c:pt>
                <c:pt idx="7113">
                  <c:v>2510.7800000000002</c:v>
                </c:pt>
                <c:pt idx="7116">
                  <c:v>1393.85</c:v>
                </c:pt>
                <c:pt idx="7119">
                  <c:v>1808.14</c:v>
                </c:pt>
                <c:pt idx="7134">
                  <c:v>2009.66</c:v>
                </c:pt>
                <c:pt idx="7140">
                  <c:v>1295.3499999999999</c:v>
                </c:pt>
                <c:pt idx="7141">
                  <c:v>1108.3</c:v>
                </c:pt>
                <c:pt idx="7142">
                  <c:v>1563.41</c:v>
                </c:pt>
                <c:pt idx="7143">
                  <c:v>1756.94</c:v>
                </c:pt>
                <c:pt idx="7148">
                  <c:v>1721.09</c:v>
                </c:pt>
                <c:pt idx="7156">
                  <c:v>1808.57</c:v>
                </c:pt>
                <c:pt idx="7161">
                  <c:v>1345.68</c:v>
                </c:pt>
                <c:pt idx="7162">
                  <c:v>1603.58</c:v>
                </c:pt>
                <c:pt idx="7173">
                  <c:v>1852.2</c:v>
                </c:pt>
                <c:pt idx="7177">
                  <c:v>1446.77</c:v>
                </c:pt>
                <c:pt idx="7183">
                  <c:v>1355.4</c:v>
                </c:pt>
                <c:pt idx="7193">
                  <c:v>2040.77</c:v>
                </c:pt>
                <c:pt idx="7199">
                  <c:v>1441.37</c:v>
                </c:pt>
                <c:pt idx="7201">
                  <c:v>1895.83</c:v>
                </c:pt>
                <c:pt idx="7209">
                  <c:v>1410.91</c:v>
                </c:pt>
                <c:pt idx="7212">
                  <c:v>1344.82</c:v>
                </c:pt>
                <c:pt idx="7214">
                  <c:v>2438.64</c:v>
                </c:pt>
                <c:pt idx="7221">
                  <c:v>1896.05</c:v>
                </c:pt>
                <c:pt idx="7223">
                  <c:v>1812.24</c:v>
                </c:pt>
                <c:pt idx="7226">
                  <c:v>1735.99</c:v>
                </c:pt>
                <c:pt idx="7227">
                  <c:v>1799.06</c:v>
                </c:pt>
                <c:pt idx="7234">
                  <c:v>1223.6400000000001</c:v>
                </c:pt>
                <c:pt idx="7240">
                  <c:v>1923.48</c:v>
                </c:pt>
                <c:pt idx="7253">
                  <c:v>1758.02</c:v>
                </c:pt>
                <c:pt idx="7255">
                  <c:v>1726.7</c:v>
                </c:pt>
                <c:pt idx="7256">
                  <c:v>1468.58</c:v>
                </c:pt>
                <c:pt idx="7259">
                  <c:v>2738.02</c:v>
                </c:pt>
                <c:pt idx="7261">
                  <c:v>1445.69</c:v>
                </c:pt>
                <c:pt idx="7264">
                  <c:v>1815.26</c:v>
                </c:pt>
                <c:pt idx="7271">
                  <c:v>1421.71</c:v>
                </c:pt>
                <c:pt idx="7272">
                  <c:v>1497.53</c:v>
                </c:pt>
                <c:pt idx="7278">
                  <c:v>2121.34</c:v>
                </c:pt>
                <c:pt idx="7284">
                  <c:v>2071.66</c:v>
                </c:pt>
                <c:pt idx="7286">
                  <c:v>964.65599999999995</c:v>
                </c:pt>
                <c:pt idx="7291">
                  <c:v>2578.39</c:v>
                </c:pt>
                <c:pt idx="7293">
                  <c:v>2074.6799999999998</c:v>
                </c:pt>
                <c:pt idx="7295">
                  <c:v>2317.6799999999998</c:v>
                </c:pt>
                <c:pt idx="7299">
                  <c:v>2306.66</c:v>
                </c:pt>
                <c:pt idx="7307">
                  <c:v>2052.86</c:v>
                </c:pt>
                <c:pt idx="7316">
                  <c:v>2088.7199999999998</c:v>
                </c:pt>
                <c:pt idx="7318">
                  <c:v>1273.0999999999999</c:v>
                </c:pt>
                <c:pt idx="7333">
                  <c:v>2597.4</c:v>
                </c:pt>
                <c:pt idx="7337">
                  <c:v>1454.54</c:v>
                </c:pt>
                <c:pt idx="7340">
                  <c:v>1978.34</c:v>
                </c:pt>
                <c:pt idx="7342">
                  <c:v>2086.56</c:v>
                </c:pt>
                <c:pt idx="7344">
                  <c:v>1745.71</c:v>
                </c:pt>
                <c:pt idx="7345">
                  <c:v>1582.2</c:v>
                </c:pt>
                <c:pt idx="7351">
                  <c:v>1442.02</c:v>
                </c:pt>
                <c:pt idx="7363">
                  <c:v>1377.65</c:v>
                </c:pt>
                <c:pt idx="7370">
                  <c:v>3131.78</c:v>
                </c:pt>
                <c:pt idx="7373">
                  <c:v>2276.86</c:v>
                </c:pt>
                <c:pt idx="7379">
                  <c:v>1740.31</c:v>
                </c:pt>
                <c:pt idx="7381">
                  <c:v>2131.6999999999998</c:v>
                </c:pt>
                <c:pt idx="7382">
                  <c:v>2176.42</c:v>
                </c:pt>
                <c:pt idx="7385">
                  <c:v>2835</c:v>
                </c:pt>
                <c:pt idx="7388">
                  <c:v>1781.57</c:v>
                </c:pt>
                <c:pt idx="7395">
                  <c:v>1546.78</c:v>
                </c:pt>
                <c:pt idx="7397">
                  <c:v>1482.41</c:v>
                </c:pt>
                <c:pt idx="7400">
                  <c:v>1037.02</c:v>
                </c:pt>
                <c:pt idx="7402">
                  <c:v>1273.75</c:v>
                </c:pt>
                <c:pt idx="7404">
                  <c:v>1543.1</c:v>
                </c:pt>
                <c:pt idx="7408">
                  <c:v>1784.38</c:v>
                </c:pt>
                <c:pt idx="7409">
                  <c:v>1541.59</c:v>
                </c:pt>
                <c:pt idx="7411">
                  <c:v>1832.11</c:v>
                </c:pt>
                <c:pt idx="7414">
                  <c:v>1179.1400000000001</c:v>
                </c:pt>
                <c:pt idx="7415">
                  <c:v>1276.3399999999999</c:v>
                </c:pt>
                <c:pt idx="7416">
                  <c:v>1712.45</c:v>
                </c:pt>
                <c:pt idx="7421">
                  <c:v>2559.6</c:v>
                </c:pt>
                <c:pt idx="7432">
                  <c:v>1024.06</c:v>
                </c:pt>
                <c:pt idx="7434">
                  <c:v>3171.96</c:v>
                </c:pt>
                <c:pt idx="7440">
                  <c:v>1507.03</c:v>
                </c:pt>
                <c:pt idx="7447">
                  <c:v>1956.31</c:v>
                </c:pt>
                <c:pt idx="7449">
                  <c:v>2946.89</c:v>
                </c:pt>
                <c:pt idx="7456">
                  <c:v>2549.4499999999998</c:v>
                </c:pt>
                <c:pt idx="7458">
                  <c:v>1790.42</c:v>
                </c:pt>
                <c:pt idx="7461">
                  <c:v>3105</c:v>
                </c:pt>
                <c:pt idx="7465">
                  <c:v>2528.06</c:v>
                </c:pt>
                <c:pt idx="7466">
                  <c:v>2316.8200000000002</c:v>
                </c:pt>
                <c:pt idx="7468">
                  <c:v>1553.26</c:v>
                </c:pt>
                <c:pt idx="7469">
                  <c:v>1821.74</c:v>
                </c:pt>
                <c:pt idx="7471">
                  <c:v>2410.13</c:v>
                </c:pt>
                <c:pt idx="7474">
                  <c:v>1125.1400000000001</c:v>
                </c:pt>
                <c:pt idx="7498">
                  <c:v>2338.85</c:v>
                </c:pt>
                <c:pt idx="7502">
                  <c:v>1870.34</c:v>
                </c:pt>
                <c:pt idx="7507">
                  <c:v>1653.05</c:v>
                </c:pt>
                <c:pt idx="7509">
                  <c:v>1278.07</c:v>
                </c:pt>
                <c:pt idx="7515">
                  <c:v>1846.37</c:v>
                </c:pt>
                <c:pt idx="7521">
                  <c:v>1301.18</c:v>
                </c:pt>
                <c:pt idx="7523">
                  <c:v>1979.42</c:v>
                </c:pt>
                <c:pt idx="7525">
                  <c:v>1537.06</c:v>
                </c:pt>
                <c:pt idx="7531">
                  <c:v>3020.76</c:v>
                </c:pt>
                <c:pt idx="7534">
                  <c:v>1759.32</c:v>
                </c:pt>
                <c:pt idx="7538">
                  <c:v>2383.7800000000002</c:v>
                </c:pt>
                <c:pt idx="7541">
                  <c:v>2672.14</c:v>
                </c:pt>
                <c:pt idx="7548">
                  <c:v>1375.49</c:v>
                </c:pt>
                <c:pt idx="7556">
                  <c:v>1662.34</c:v>
                </c:pt>
                <c:pt idx="7572">
                  <c:v>2398.9</c:v>
                </c:pt>
                <c:pt idx="7577">
                  <c:v>1548.29</c:v>
                </c:pt>
                <c:pt idx="7579">
                  <c:v>2335.8200000000002</c:v>
                </c:pt>
                <c:pt idx="7584">
                  <c:v>2247.0500000000002</c:v>
                </c:pt>
                <c:pt idx="7601">
                  <c:v>1618.06</c:v>
                </c:pt>
                <c:pt idx="7604">
                  <c:v>1465.13</c:v>
                </c:pt>
                <c:pt idx="7605">
                  <c:v>1722.6</c:v>
                </c:pt>
                <c:pt idx="7609">
                  <c:v>1954.8</c:v>
                </c:pt>
                <c:pt idx="7619">
                  <c:v>1726.06</c:v>
                </c:pt>
                <c:pt idx="7621">
                  <c:v>1972.73</c:v>
                </c:pt>
                <c:pt idx="7622">
                  <c:v>1942.49</c:v>
                </c:pt>
                <c:pt idx="7624">
                  <c:v>1195.1300000000001</c:v>
                </c:pt>
                <c:pt idx="7625">
                  <c:v>1702.08</c:v>
                </c:pt>
                <c:pt idx="7626">
                  <c:v>1018.87</c:v>
                </c:pt>
                <c:pt idx="7629">
                  <c:v>2003.4</c:v>
                </c:pt>
                <c:pt idx="7635">
                  <c:v>1763.86</c:v>
                </c:pt>
                <c:pt idx="7637">
                  <c:v>1887.62</c:v>
                </c:pt>
                <c:pt idx="7639">
                  <c:v>1319.54</c:v>
                </c:pt>
                <c:pt idx="7644">
                  <c:v>1209.5999999999999</c:v>
                </c:pt>
                <c:pt idx="7646">
                  <c:v>1592.57</c:v>
                </c:pt>
                <c:pt idx="7657">
                  <c:v>1619.14</c:v>
                </c:pt>
                <c:pt idx="7660">
                  <c:v>1647.65</c:v>
                </c:pt>
                <c:pt idx="7663">
                  <c:v>1779.19</c:v>
                </c:pt>
                <c:pt idx="7664">
                  <c:v>2340.58</c:v>
                </c:pt>
                <c:pt idx="7666">
                  <c:v>2756.16</c:v>
                </c:pt>
                <c:pt idx="7673">
                  <c:v>1689.12</c:v>
                </c:pt>
                <c:pt idx="7677">
                  <c:v>3690.36</c:v>
                </c:pt>
                <c:pt idx="7681">
                  <c:v>1766.45</c:v>
                </c:pt>
                <c:pt idx="7685">
                  <c:v>1564.49</c:v>
                </c:pt>
                <c:pt idx="7686">
                  <c:v>1857.82</c:v>
                </c:pt>
                <c:pt idx="7687">
                  <c:v>2108.38</c:v>
                </c:pt>
                <c:pt idx="7689">
                  <c:v>1990.22</c:v>
                </c:pt>
                <c:pt idx="7692">
                  <c:v>1212.8399999999999</c:v>
                </c:pt>
                <c:pt idx="7693">
                  <c:v>1610.06</c:v>
                </c:pt>
                <c:pt idx="7697">
                  <c:v>1272.8900000000001</c:v>
                </c:pt>
                <c:pt idx="7702">
                  <c:v>2154.8200000000002</c:v>
                </c:pt>
                <c:pt idx="7703">
                  <c:v>2025</c:v>
                </c:pt>
                <c:pt idx="7707">
                  <c:v>1649.16</c:v>
                </c:pt>
                <c:pt idx="7708">
                  <c:v>1089.07</c:v>
                </c:pt>
                <c:pt idx="7722">
                  <c:v>1406.38</c:v>
                </c:pt>
                <c:pt idx="7750">
                  <c:v>1610.06</c:v>
                </c:pt>
                <c:pt idx="7754">
                  <c:v>1447.85</c:v>
                </c:pt>
                <c:pt idx="7757">
                  <c:v>2764.37</c:v>
                </c:pt>
                <c:pt idx="7759">
                  <c:v>1805.76</c:v>
                </c:pt>
                <c:pt idx="7761">
                  <c:v>2652.7</c:v>
                </c:pt>
                <c:pt idx="7765">
                  <c:v>1309.6099999999999</c:v>
                </c:pt>
                <c:pt idx="7766">
                  <c:v>1820.66</c:v>
                </c:pt>
                <c:pt idx="7767">
                  <c:v>2305.15</c:v>
                </c:pt>
                <c:pt idx="7778">
                  <c:v>3044.09</c:v>
                </c:pt>
                <c:pt idx="7785">
                  <c:v>1743.12</c:v>
                </c:pt>
                <c:pt idx="7790">
                  <c:v>1938.38</c:v>
                </c:pt>
                <c:pt idx="7792">
                  <c:v>2598.48</c:v>
                </c:pt>
                <c:pt idx="7796">
                  <c:v>2202.5500000000002</c:v>
                </c:pt>
                <c:pt idx="7808">
                  <c:v>2081.81</c:v>
                </c:pt>
                <c:pt idx="7811">
                  <c:v>1531.44</c:v>
                </c:pt>
                <c:pt idx="7813">
                  <c:v>1175.04</c:v>
                </c:pt>
                <c:pt idx="7818">
                  <c:v>1918.08</c:v>
                </c:pt>
                <c:pt idx="7819">
                  <c:v>1784.38</c:v>
                </c:pt>
                <c:pt idx="7825">
                  <c:v>2210.33</c:v>
                </c:pt>
                <c:pt idx="7832">
                  <c:v>1879.63</c:v>
                </c:pt>
                <c:pt idx="7836">
                  <c:v>1542.02</c:v>
                </c:pt>
                <c:pt idx="7841">
                  <c:v>1865.81</c:v>
                </c:pt>
                <c:pt idx="7842">
                  <c:v>1734.7</c:v>
                </c:pt>
                <c:pt idx="7845">
                  <c:v>1686.31</c:v>
                </c:pt>
                <c:pt idx="7846">
                  <c:v>2407.54</c:v>
                </c:pt>
                <c:pt idx="7850">
                  <c:v>2740.18</c:v>
                </c:pt>
                <c:pt idx="7851">
                  <c:v>1684.8</c:v>
                </c:pt>
                <c:pt idx="7856">
                  <c:v>2301.2600000000002</c:v>
                </c:pt>
                <c:pt idx="7858">
                  <c:v>1738.58</c:v>
                </c:pt>
                <c:pt idx="7859">
                  <c:v>2119.39</c:v>
                </c:pt>
                <c:pt idx="7860">
                  <c:v>1753.27</c:v>
                </c:pt>
                <c:pt idx="7861">
                  <c:v>1865.16</c:v>
                </c:pt>
                <c:pt idx="7865">
                  <c:v>1002.46</c:v>
                </c:pt>
                <c:pt idx="7866">
                  <c:v>1691.28</c:v>
                </c:pt>
                <c:pt idx="7873">
                  <c:v>2990.3</c:v>
                </c:pt>
                <c:pt idx="7876">
                  <c:v>2187.65</c:v>
                </c:pt>
                <c:pt idx="7877">
                  <c:v>76.896000000000001</c:v>
                </c:pt>
                <c:pt idx="7887">
                  <c:v>1281.53</c:v>
                </c:pt>
                <c:pt idx="7898">
                  <c:v>1452.17</c:v>
                </c:pt>
                <c:pt idx="7902">
                  <c:v>1440.94</c:v>
                </c:pt>
                <c:pt idx="7930">
                  <c:v>2014.63</c:v>
                </c:pt>
                <c:pt idx="7932">
                  <c:v>2048.33</c:v>
                </c:pt>
                <c:pt idx="7941">
                  <c:v>1722.6</c:v>
                </c:pt>
                <c:pt idx="7944">
                  <c:v>1567.73</c:v>
                </c:pt>
                <c:pt idx="7945">
                  <c:v>1639.87</c:v>
                </c:pt>
                <c:pt idx="7951">
                  <c:v>2111.4</c:v>
                </c:pt>
                <c:pt idx="7952">
                  <c:v>1089.29</c:v>
                </c:pt>
                <c:pt idx="7956">
                  <c:v>1818.29</c:v>
                </c:pt>
                <c:pt idx="7958">
                  <c:v>1441.58</c:v>
                </c:pt>
                <c:pt idx="7960">
                  <c:v>1543.1</c:v>
                </c:pt>
                <c:pt idx="7965">
                  <c:v>1222.3399999999999</c:v>
                </c:pt>
                <c:pt idx="7967">
                  <c:v>1659.1</c:v>
                </c:pt>
                <c:pt idx="7970">
                  <c:v>2206.0100000000002</c:v>
                </c:pt>
                <c:pt idx="7979">
                  <c:v>1465.34</c:v>
                </c:pt>
                <c:pt idx="7980">
                  <c:v>2590.06</c:v>
                </c:pt>
                <c:pt idx="7987">
                  <c:v>1543.75</c:v>
                </c:pt>
                <c:pt idx="7990">
                  <c:v>1809.43</c:v>
                </c:pt>
                <c:pt idx="7991">
                  <c:v>1905.12</c:v>
                </c:pt>
                <c:pt idx="7993">
                  <c:v>2865.89</c:v>
                </c:pt>
                <c:pt idx="7996">
                  <c:v>1936.22</c:v>
                </c:pt>
                <c:pt idx="7997">
                  <c:v>1517.4</c:v>
                </c:pt>
                <c:pt idx="7999">
                  <c:v>1312.2</c:v>
                </c:pt>
                <c:pt idx="8002">
                  <c:v>1488.89</c:v>
                </c:pt>
                <c:pt idx="8018">
                  <c:v>1232.71</c:v>
                </c:pt>
                <c:pt idx="8022">
                  <c:v>2274.2600000000002</c:v>
                </c:pt>
                <c:pt idx="8033">
                  <c:v>2462.1799999999998</c:v>
                </c:pt>
                <c:pt idx="8035">
                  <c:v>1244.81</c:v>
                </c:pt>
                <c:pt idx="8038">
                  <c:v>1677.67</c:v>
                </c:pt>
                <c:pt idx="8042">
                  <c:v>1157.98</c:v>
                </c:pt>
                <c:pt idx="8045">
                  <c:v>1899.94</c:v>
                </c:pt>
                <c:pt idx="8054">
                  <c:v>1610.28</c:v>
                </c:pt>
                <c:pt idx="8061">
                  <c:v>2285.2800000000002</c:v>
                </c:pt>
                <c:pt idx="8063">
                  <c:v>2116.15</c:v>
                </c:pt>
                <c:pt idx="8064">
                  <c:v>1664.5</c:v>
                </c:pt>
                <c:pt idx="8065">
                  <c:v>1205.28</c:v>
                </c:pt>
                <c:pt idx="8073">
                  <c:v>1521.07</c:v>
                </c:pt>
                <c:pt idx="8076">
                  <c:v>2582.71</c:v>
                </c:pt>
                <c:pt idx="8077">
                  <c:v>1767.31</c:v>
                </c:pt>
                <c:pt idx="8083">
                  <c:v>1736.21</c:v>
                </c:pt>
                <c:pt idx="8091">
                  <c:v>1494.07</c:v>
                </c:pt>
                <c:pt idx="8099">
                  <c:v>1924.99</c:v>
                </c:pt>
                <c:pt idx="8106">
                  <c:v>1203.55</c:v>
                </c:pt>
                <c:pt idx="8107">
                  <c:v>1714.18</c:v>
                </c:pt>
                <c:pt idx="8108">
                  <c:v>1798.2</c:v>
                </c:pt>
                <c:pt idx="8109">
                  <c:v>1158.8399999999999</c:v>
                </c:pt>
                <c:pt idx="8112">
                  <c:v>1970.14</c:v>
                </c:pt>
                <c:pt idx="8120">
                  <c:v>1586.3</c:v>
                </c:pt>
                <c:pt idx="8124">
                  <c:v>2992.25</c:v>
                </c:pt>
                <c:pt idx="8128">
                  <c:v>1334.45</c:v>
                </c:pt>
                <c:pt idx="8129">
                  <c:v>2004.48</c:v>
                </c:pt>
                <c:pt idx="8130">
                  <c:v>1725.84</c:v>
                </c:pt>
                <c:pt idx="8137">
                  <c:v>2711.88</c:v>
                </c:pt>
                <c:pt idx="8148">
                  <c:v>1307.02</c:v>
                </c:pt>
                <c:pt idx="8150">
                  <c:v>1795.61</c:v>
                </c:pt>
                <c:pt idx="8155">
                  <c:v>2005.13</c:v>
                </c:pt>
                <c:pt idx="8157">
                  <c:v>1980.5</c:v>
                </c:pt>
                <c:pt idx="8161">
                  <c:v>1846.8</c:v>
                </c:pt>
                <c:pt idx="8163">
                  <c:v>1685.66</c:v>
                </c:pt>
                <c:pt idx="8177">
                  <c:v>1190.3800000000001</c:v>
                </c:pt>
                <c:pt idx="8179">
                  <c:v>1859.76</c:v>
                </c:pt>
                <c:pt idx="8180">
                  <c:v>3103.49</c:v>
                </c:pt>
                <c:pt idx="8182">
                  <c:v>2395.87</c:v>
                </c:pt>
                <c:pt idx="8185">
                  <c:v>3170.23</c:v>
                </c:pt>
                <c:pt idx="8190">
                  <c:v>1287.1400000000001</c:v>
                </c:pt>
                <c:pt idx="8191">
                  <c:v>2591.5700000000002</c:v>
                </c:pt>
                <c:pt idx="8203">
                  <c:v>3541.1</c:v>
                </c:pt>
                <c:pt idx="8204">
                  <c:v>1356.91</c:v>
                </c:pt>
                <c:pt idx="8212">
                  <c:v>1569.46</c:v>
                </c:pt>
                <c:pt idx="8214">
                  <c:v>2332.15</c:v>
                </c:pt>
                <c:pt idx="8218">
                  <c:v>1897.78</c:v>
                </c:pt>
                <c:pt idx="8221">
                  <c:v>2093.4699999999998</c:v>
                </c:pt>
                <c:pt idx="8225">
                  <c:v>1759.1</c:v>
                </c:pt>
                <c:pt idx="8236">
                  <c:v>2911.46</c:v>
                </c:pt>
                <c:pt idx="8239">
                  <c:v>1933.42</c:v>
                </c:pt>
                <c:pt idx="8245">
                  <c:v>1608.12</c:v>
                </c:pt>
                <c:pt idx="8247">
                  <c:v>1441.37</c:v>
                </c:pt>
                <c:pt idx="8250">
                  <c:v>1123.8499999999999</c:v>
                </c:pt>
                <c:pt idx="8257">
                  <c:v>1087.1300000000001</c:v>
                </c:pt>
                <c:pt idx="8258">
                  <c:v>1667.3</c:v>
                </c:pt>
                <c:pt idx="8259">
                  <c:v>1408.54</c:v>
                </c:pt>
                <c:pt idx="8266">
                  <c:v>2724.19</c:v>
                </c:pt>
                <c:pt idx="8267">
                  <c:v>1720.01</c:v>
                </c:pt>
                <c:pt idx="8273">
                  <c:v>1076.1099999999999</c:v>
                </c:pt>
                <c:pt idx="8275">
                  <c:v>1740.1</c:v>
                </c:pt>
                <c:pt idx="8279">
                  <c:v>1618.49</c:v>
                </c:pt>
                <c:pt idx="8280">
                  <c:v>2044.44</c:v>
                </c:pt>
                <c:pt idx="8295">
                  <c:v>2630.45</c:v>
                </c:pt>
                <c:pt idx="8305">
                  <c:v>1253.23</c:v>
                </c:pt>
                <c:pt idx="8306">
                  <c:v>1366.2</c:v>
                </c:pt>
                <c:pt idx="8325">
                  <c:v>1849.61</c:v>
                </c:pt>
                <c:pt idx="8327">
                  <c:v>1797.12</c:v>
                </c:pt>
                <c:pt idx="8328">
                  <c:v>2234.09</c:v>
                </c:pt>
                <c:pt idx="8331">
                  <c:v>1429.7</c:v>
                </c:pt>
                <c:pt idx="8342">
                  <c:v>1763.21</c:v>
                </c:pt>
                <c:pt idx="8343">
                  <c:v>1996.49</c:v>
                </c:pt>
                <c:pt idx="8345">
                  <c:v>1052.57</c:v>
                </c:pt>
                <c:pt idx="8346">
                  <c:v>1536.62</c:v>
                </c:pt>
                <c:pt idx="8348">
                  <c:v>2280.7399999999998</c:v>
                </c:pt>
                <c:pt idx="8350">
                  <c:v>1551.1</c:v>
                </c:pt>
                <c:pt idx="8351">
                  <c:v>2318.54</c:v>
                </c:pt>
                <c:pt idx="8352">
                  <c:v>1335.53</c:v>
                </c:pt>
                <c:pt idx="8363">
                  <c:v>1982.45</c:v>
                </c:pt>
                <c:pt idx="8367">
                  <c:v>1576.58</c:v>
                </c:pt>
                <c:pt idx="8370">
                  <c:v>2090.02</c:v>
                </c:pt>
                <c:pt idx="8373">
                  <c:v>1276.56</c:v>
                </c:pt>
                <c:pt idx="8377">
                  <c:v>2816.64</c:v>
                </c:pt>
                <c:pt idx="8378">
                  <c:v>1940.33</c:v>
                </c:pt>
                <c:pt idx="8379">
                  <c:v>961.63199999999995</c:v>
                </c:pt>
                <c:pt idx="8384">
                  <c:v>1764.94</c:v>
                </c:pt>
                <c:pt idx="8385">
                  <c:v>5271.7</c:v>
                </c:pt>
                <c:pt idx="8389">
                  <c:v>2051.5700000000002</c:v>
                </c:pt>
                <c:pt idx="8395">
                  <c:v>1719.58</c:v>
                </c:pt>
                <c:pt idx="8396">
                  <c:v>3990.6</c:v>
                </c:pt>
                <c:pt idx="8405">
                  <c:v>73.656000000000006</c:v>
                </c:pt>
                <c:pt idx="8406">
                  <c:v>2078.14</c:v>
                </c:pt>
                <c:pt idx="8407">
                  <c:v>1567.73</c:v>
                </c:pt>
                <c:pt idx="8416">
                  <c:v>4533.41</c:v>
                </c:pt>
                <c:pt idx="8425">
                  <c:v>1451.95</c:v>
                </c:pt>
                <c:pt idx="8430">
                  <c:v>1617.84</c:v>
                </c:pt>
                <c:pt idx="8431">
                  <c:v>2217.89</c:v>
                </c:pt>
                <c:pt idx="8444">
                  <c:v>2453.54</c:v>
                </c:pt>
                <c:pt idx="8446">
                  <c:v>2100.17</c:v>
                </c:pt>
                <c:pt idx="8457">
                  <c:v>1166.18</c:v>
                </c:pt>
                <c:pt idx="8461">
                  <c:v>1771.63</c:v>
                </c:pt>
                <c:pt idx="8463">
                  <c:v>1466.21</c:v>
                </c:pt>
                <c:pt idx="8468">
                  <c:v>1902.31</c:v>
                </c:pt>
                <c:pt idx="8469">
                  <c:v>1752.19</c:v>
                </c:pt>
                <c:pt idx="8470">
                  <c:v>1057.0999999999999</c:v>
                </c:pt>
                <c:pt idx="8477">
                  <c:v>1394.28</c:v>
                </c:pt>
                <c:pt idx="8479">
                  <c:v>1847.66</c:v>
                </c:pt>
                <c:pt idx="8480">
                  <c:v>1192.75</c:v>
                </c:pt>
                <c:pt idx="8486">
                  <c:v>904.82399999999996</c:v>
                </c:pt>
                <c:pt idx="8487">
                  <c:v>1359.07</c:v>
                </c:pt>
                <c:pt idx="8496">
                  <c:v>1758.67</c:v>
                </c:pt>
                <c:pt idx="8497">
                  <c:v>2207.9499999999998</c:v>
                </c:pt>
                <c:pt idx="8498">
                  <c:v>1665.36</c:v>
                </c:pt>
                <c:pt idx="8502">
                  <c:v>3074.33</c:v>
                </c:pt>
                <c:pt idx="8503">
                  <c:v>1950.91</c:v>
                </c:pt>
                <c:pt idx="8504">
                  <c:v>2749.25</c:v>
                </c:pt>
                <c:pt idx="8517">
                  <c:v>2653.78</c:v>
                </c:pt>
                <c:pt idx="8524">
                  <c:v>1275.05</c:v>
                </c:pt>
                <c:pt idx="8527">
                  <c:v>2240.7800000000002</c:v>
                </c:pt>
                <c:pt idx="8537">
                  <c:v>1576.58</c:v>
                </c:pt>
                <c:pt idx="8539">
                  <c:v>1731.46</c:v>
                </c:pt>
                <c:pt idx="8540">
                  <c:v>1414.15</c:v>
                </c:pt>
                <c:pt idx="8545">
                  <c:v>2272.3200000000002</c:v>
                </c:pt>
                <c:pt idx="8559">
                  <c:v>2471.4699999999998</c:v>
                </c:pt>
                <c:pt idx="8560">
                  <c:v>1172.8800000000001</c:v>
                </c:pt>
                <c:pt idx="8562">
                  <c:v>1521.07</c:v>
                </c:pt>
                <c:pt idx="8567">
                  <c:v>1800.79</c:v>
                </c:pt>
                <c:pt idx="8569">
                  <c:v>1638.58</c:v>
                </c:pt>
                <c:pt idx="8570">
                  <c:v>2768.69</c:v>
                </c:pt>
                <c:pt idx="8573">
                  <c:v>1874.88</c:v>
                </c:pt>
                <c:pt idx="8577">
                  <c:v>1740.96</c:v>
                </c:pt>
                <c:pt idx="8579">
                  <c:v>2313.79</c:v>
                </c:pt>
                <c:pt idx="8596">
                  <c:v>1522.8</c:v>
                </c:pt>
                <c:pt idx="8600">
                  <c:v>2849.26</c:v>
                </c:pt>
                <c:pt idx="8603">
                  <c:v>1891.08</c:v>
                </c:pt>
                <c:pt idx="8604">
                  <c:v>1780.27</c:v>
                </c:pt>
                <c:pt idx="8606">
                  <c:v>1301.83</c:v>
                </c:pt>
                <c:pt idx="8616">
                  <c:v>1570.32</c:v>
                </c:pt>
                <c:pt idx="8623">
                  <c:v>3535.06</c:v>
                </c:pt>
                <c:pt idx="8630">
                  <c:v>1861.7</c:v>
                </c:pt>
                <c:pt idx="8636">
                  <c:v>1947.46</c:v>
                </c:pt>
                <c:pt idx="8637">
                  <c:v>1916.14</c:v>
                </c:pt>
                <c:pt idx="8641">
                  <c:v>1100.3</c:v>
                </c:pt>
                <c:pt idx="8642">
                  <c:v>2586.8200000000002</c:v>
                </c:pt>
                <c:pt idx="8643">
                  <c:v>1582.85</c:v>
                </c:pt>
                <c:pt idx="8646">
                  <c:v>1434.67</c:v>
                </c:pt>
                <c:pt idx="8650">
                  <c:v>1809.22</c:v>
                </c:pt>
                <c:pt idx="8656">
                  <c:v>2244.89</c:v>
                </c:pt>
                <c:pt idx="8659">
                  <c:v>1355.83</c:v>
                </c:pt>
                <c:pt idx="8663">
                  <c:v>974.37599999999998</c:v>
                </c:pt>
                <c:pt idx="8668">
                  <c:v>1824.98</c:v>
                </c:pt>
                <c:pt idx="8671">
                  <c:v>1129.9000000000001</c:v>
                </c:pt>
                <c:pt idx="8672">
                  <c:v>1224.94</c:v>
                </c:pt>
                <c:pt idx="8674">
                  <c:v>2645.57</c:v>
                </c:pt>
                <c:pt idx="8683">
                  <c:v>2244.89</c:v>
                </c:pt>
                <c:pt idx="8685">
                  <c:v>1780.49</c:v>
                </c:pt>
                <c:pt idx="8696">
                  <c:v>1854.58</c:v>
                </c:pt>
                <c:pt idx="8698">
                  <c:v>1459.73</c:v>
                </c:pt>
                <c:pt idx="8700">
                  <c:v>4757.18</c:v>
                </c:pt>
                <c:pt idx="8703">
                  <c:v>1959.77</c:v>
                </c:pt>
                <c:pt idx="8704">
                  <c:v>1636.85</c:v>
                </c:pt>
                <c:pt idx="8706">
                  <c:v>1245.02</c:v>
                </c:pt>
                <c:pt idx="8707">
                  <c:v>1553.9</c:v>
                </c:pt>
                <c:pt idx="8709">
                  <c:v>2198.66</c:v>
                </c:pt>
                <c:pt idx="8713">
                  <c:v>1417.18</c:v>
                </c:pt>
                <c:pt idx="8714">
                  <c:v>1660.18</c:v>
                </c:pt>
                <c:pt idx="8727">
                  <c:v>81.647999999999996</c:v>
                </c:pt>
                <c:pt idx="8735">
                  <c:v>2786.62</c:v>
                </c:pt>
                <c:pt idx="8741">
                  <c:v>1874.45</c:v>
                </c:pt>
                <c:pt idx="8742">
                  <c:v>1746.36</c:v>
                </c:pt>
                <c:pt idx="8753">
                  <c:v>1182.17</c:v>
                </c:pt>
                <c:pt idx="8757">
                  <c:v>1674</c:v>
                </c:pt>
                <c:pt idx="8762">
                  <c:v>1212.6199999999999</c:v>
                </c:pt>
                <c:pt idx="8765">
                  <c:v>2433.46</c:v>
                </c:pt>
                <c:pt idx="8772">
                  <c:v>1705.54</c:v>
                </c:pt>
                <c:pt idx="8782">
                  <c:v>1602.5</c:v>
                </c:pt>
                <c:pt idx="8783">
                  <c:v>1751.33</c:v>
                </c:pt>
                <c:pt idx="8791">
                  <c:v>1793.23</c:v>
                </c:pt>
                <c:pt idx="8798">
                  <c:v>1118.45</c:v>
                </c:pt>
                <c:pt idx="8802">
                  <c:v>1245.02</c:v>
                </c:pt>
                <c:pt idx="8803">
                  <c:v>1364.26</c:v>
                </c:pt>
                <c:pt idx="8808">
                  <c:v>1625.62</c:v>
                </c:pt>
                <c:pt idx="8813">
                  <c:v>1664.06</c:v>
                </c:pt>
                <c:pt idx="8816">
                  <c:v>1734.7</c:v>
                </c:pt>
                <c:pt idx="8832">
                  <c:v>2806.92</c:v>
                </c:pt>
                <c:pt idx="8833">
                  <c:v>1998.43</c:v>
                </c:pt>
                <c:pt idx="8849">
                  <c:v>2430.65</c:v>
                </c:pt>
                <c:pt idx="8860">
                  <c:v>1402.7</c:v>
                </c:pt>
                <c:pt idx="8861">
                  <c:v>2176.1999999999998</c:v>
                </c:pt>
                <c:pt idx="8866">
                  <c:v>1645.06</c:v>
                </c:pt>
                <c:pt idx="8869">
                  <c:v>2210.98</c:v>
                </c:pt>
                <c:pt idx="8870">
                  <c:v>2703.24</c:v>
                </c:pt>
                <c:pt idx="8871">
                  <c:v>2175.34</c:v>
                </c:pt>
                <c:pt idx="8873">
                  <c:v>1215.22</c:v>
                </c:pt>
                <c:pt idx="8878">
                  <c:v>1485.86</c:v>
                </c:pt>
                <c:pt idx="8882">
                  <c:v>1910.3</c:v>
                </c:pt>
                <c:pt idx="8883">
                  <c:v>2247.2600000000002</c:v>
                </c:pt>
                <c:pt idx="8886">
                  <c:v>1213.27</c:v>
                </c:pt>
                <c:pt idx="8894">
                  <c:v>1317.17</c:v>
                </c:pt>
                <c:pt idx="8896">
                  <c:v>1738.15</c:v>
                </c:pt>
                <c:pt idx="8897">
                  <c:v>1709.42</c:v>
                </c:pt>
                <c:pt idx="8900">
                  <c:v>1188.43</c:v>
                </c:pt>
                <c:pt idx="8903">
                  <c:v>1732.32</c:v>
                </c:pt>
                <c:pt idx="8907">
                  <c:v>1832.76</c:v>
                </c:pt>
                <c:pt idx="8908">
                  <c:v>1234.44</c:v>
                </c:pt>
                <c:pt idx="8910">
                  <c:v>1819.58</c:v>
                </c:pt>
                <c:pt idx="8912">
                  <c:v>1782.65</c:v>
                </c:pt>
                <c:pt idx="8914">
                  <c:v>1749.82</c:v>
                </c:pt>
                <c:pt idx="8917">
                  <c:v>1378.73</c:v>
                </c:pt>
                <c:pt idx="8918">
                  <c:v>1874.02</c:v>
                </c:pt>
                <c:pt idx="8920">
                  <c:v>1513.94</c:v>
                </c:pt>
                <c:pt idx="8925">
                  <c:v>1342.22</c:v>
                </c:pt>
                <c:pt idx="8930">
                  <c:v>2266.92</c:v>
                </c:pt>
                <c:pt idx="8931">
                  <c:v>1339.63</c:v>
                </c:pt>
                <c:pt idx="8934">
                  <c:v>2048.98</c:v>
                </c:pt>
                <c:pt idx="8941">
                  <c:v>2000.38</c:v>
                </c:pt>
                <c:pt idx="8945">
                  <c:v>1931.26</c:v>
                </c:pt>
                <c:pt idx="8950">
                  <c:v>2520.7199999999998</c:v>
                </c:pt>
                <c:pt idx="8960">
                  <c:v>3278.02</c:v>
                </c:pt>
                <c:pt idx="8964">
                  <c:v>1475.71</c:v>
                </c:pt>
                <c:pt idx="8967">
                  <c:v>1797.55</c:v>
                </c:pt>
                <c:pt idx="8976">
                  <c:v>1156.46</c:v>
                </c:pt>
                <c:pt idx="8977">
                  <c:v>2723.33</c:v>
                </c:pt>
                <c:pt idx="8978">
                  <c:v>2161.08</c:v>
                </c:pt>
                <c:pt idx="8981">
                  <c:v>2545.13</c:v>
                </c:pt>
                <c:pt idx="8985">
                  <c:v>2689.63</c:v>
                </c:pt>
                <c:pt idx="8986">
                  <c:v>1743.77</c:v>
                </c:pt>
                <c:pt idx="8989">
                  <c:v>2664.36</c:v>
                </c:pt>
                <c:pt idx="8994">
                  <c:v>1642.46</c:v>
                </c:pt>
                <c:pt idx="8999">
                  <c:v>1103.76</c:v>
                </c:pt>
                <c:pt idx="9013">
                  <c:v>2567.16</c:v>
                </c:pt>
                <c:pt idx="9016">
                  <c:v>1754.35</c:v>
                </c:pt>
                <c:pt idx="9022">
                  <c:v>1146.0999999999999</c:v>
                </c:pt>
                <c:pt idx="9025">
                  <c:v>1638.79</c:v>
                </c:pt>
                <c:pt idx="9028">
                  <c:v>1952.86</c:v>
                </c:pt>
                <c:pt idx="9029">
                  <c:v>1383.26</c:v>
                </c:pt>
                <c:pt idx="9032">
                  <c:v>2771.5</c:v>
                </c:pt>
                <c:pt idx="9033">
                  <c:v>1595.16</c:v>
                </c:pt>
                <c:pt idx="9038">
                  <c:v>1635.55</c:v>
                </c:pt>
                <c:pt idx="9045">
                  <c:v>2661.98</c:v>
                </c:pt>
                <c:pt idx="9051">
                  <c:v>1307.6600000000001</c:v>
                </c:pt>
                <c:pt idx="9057">
                  <c:v>2703.02</c:v>
                </c:pt>
                <c:pt idx="9068">
                  <c:v>2317.0300000000002</c:v>
                </c:pt>
                <c:pt idx="9086">
                  <c:v>2281.1799999999998</c:v>
                </c:pt>
                <c:pt idx="9090">
                  <c:v>1486.08</c:v>
                </c:pt>
                <c:pt idx="9092">
                  <c:v>1426.9</c:v>
                </c:pt>
                <c:pt idx="9093">
                  <c:v>2927.45</c:v>
                </c:pt>
                <c:pt idx="9094">
                  <c:v>1761.7</c:v>
                </c:pt>
                <c:pt idx="9105">
                  <c:v>1509.84</c:v>
                </c:pt>
                <c:pt idx="9118">
                  <c:v>1988.06</c:v>
                </c:pt>
                <c:pt idx="9129">
                  <c:v>2220.91</c:v>
                </c:pt>
                <c:pt idx="9131">
                  <c:v>1967.98</c:v>
                </c:pt>
                <c:pt idx="9139">
                  <c:v>1384.78</c:v>
                </c:pt>
                <c:pt idx="9146">
                  <c:v>1514.16</c:v>
                </c:pt>
                <c:pt idx="9149">
                  <c:v>1101.3800000000001</c:v>
                </c:pt>
                <c:pt idx="9153">
                  <c:v>1712.66</c:v>
                </c:pt>
                <c:pt idx="9154">
                  <c:v>1991.3</c:v>
                </c:pt>
                <c:pt idx="9156">
                  <c:v>2497.8200000000002</c:v>
                </c:pt>
                <c:pt idx="9161">
                  <c:v>1987.42</c:v>
                </c:pt>
                <c:pt idx="9164">
                  <c:v>1412.42</c:v>
                </c:pt>
                <c:pt idx="9166">
                  <c:v>1667.74</c:v>
                </c:pt>
                <c:pt idx="9169">
                  <c:v>117.072</c:v>
                </c:pt>
                <c:pt idx="9170">
                  <c:v>1658.02</c:v>
                </c:pt>
                <c:pt idx="9171">
                  <c:v>1618.06</c:v>
                </c:pt>
                <c:pt idx="9175">
                  <c:v>1885.03</c:v>
                </c:pt>
                <c:pt idx="9177">
                  <c:v>127.44</c:v>
                </c:pt>
                <c:pt idx="9186">
                  <c:v>2128.9</c:v>
                </c:pt>
                <c:pt idx="9189">
                  <c:v>1191.46</c:v>
                </c:pt>
                <c:pt idx="9198">
                  <c:v>2385.5</c:v>
                </c:pt>
                <c:pt idx="9205">
                  <c:v>2323.94</c:v>
                </c:pt>
                <c:pt idx="9206">
                  <c:v>2285.71</c:v>
                </c:pt>
                <c:pt idx="9211">
                  <c:v>1643.76</c:v>
                </c:pt>
                <c:pt idx="9212">
                  <c:v>1799.06</c:v>
                </c:pt>
                <c:pt idx="9213">
                  <c:v>1795.39</c:v>
                </c:pt>
                <c:pt idx="9217">
                  <c:v>1386.07</c:v>
                </c:pt>
                <c:pt idx="9218">
                  <c:v>2149.63</c:v>
                </c:pt>
                <c:pt idx="9219">
                  <c:v>2524.8200000000002</c:v>
                </c:pt>
                <c:pt idx="9220">
                  <c:v>1608.12</c:v>
                </c:pt>
                <c:pt idx="9223">
                  <c:v>2271.2399999999998</c:v>
                </c:pt>
                <c:pt idx="9225">
                  <c:v>2246.4</c:v>
                </c:pt>
                <c:pt idx="9229">
                  <c:v>1783.3</c:v>
                </c:pt>
                <c:pt idx="9236">
                  <c:v>1814.4</c:v>
                </c:pt>
                <c:pt idx="9237">
                  <c:v>1559.74</c:v>
                </c:pt>
                <c:pt idx="9239">
                  <c:v>2187.4299999999998</c:v>
                </c:pt>
                <c:pt idx="9244">
                  <c:v>1494.07</c:v>
                </c:pt>
                <c:pt idx="9245">
                  <c:v>2110.9699999999998</c:v>
                </c:pt>
                <c:pt idx="9248">
                  <c:v>2227.1799999999998</c:v>
                </c:pt>
                <c:pt idx="9249">
                  <c:v>2170.8000000000002</c:v>
                </c:pt>
                <c:pt idx="9250">
                  <c:v>1177.8499999999999</c:v>
                </c:pt>
                <c:pt idx="9251">
                  <c:v>1899.94</c:v>
                </c:pt>
                <c:pt idx="9254">
                  <c:v>1992.38</c:v>
                </c:pt>
                <c:pt idx="9259">
                  <c:v>2146.39</c:v>
                </c:pt>
                <c:pt idx="9266">
                  <c:v>1653.91</c:v>
                </c:pt>
                <c:pt idx="9269">
                  <c:v>1605.31</c:v>
                </c:pt>
                <c:pt idx="9281">
                  <c:v>1150.6300000000001</c:v>
                </c:pt>
                <c:pt idx="9288">
                  <c:v>1460.59</c:v>
                </c:pt>
                <c:pt idx="9291">
                  <c:v>2232.79</c:v>
                </c:pt>
                <c:pt idx="9307">
                  <c:v>2491.13</c:v>
                </c:pt>
                <c:pt idx="9312">
                  <c:v>2404.5100000000002</c:v>
                </c:pt>
                <c:pt idx="9313">
                  <c:v>1112.4000000000001</c:v>
                </c:pt>
                <c:pt idx="9317">
                  <c:v>1569.46</c:v>
                </c:pt>
                <c:pt idx="9328">
                  <c:v>2130.19</c:v>
                </c:pt>
                <c:pt idx="9330">
                  <c:v>3054.02</c:v>
                </c:pt>
                <c:pt idx="9334">
                  <c:v>1637.28</c:v>
                </c:pt>
                <c:pt idx="9335">
                  <c:v>1716.34</c:v>
                </c:pt>
                <c:pt idx="9338">
                  <c:v>1204.2</c:v>
                </c:pt>
                <c:pt idx="9346">
                  <c:v>2309.9</c:v>
                </c:pt>
                <c:pt idx="9365">
                  <c:v>3198.74</c:v>
                </c:pt>
                <c:pt idx="9367">
                  <c:v>5029.13</c:v>
                </c:pt>
                <c:pt idx="9368">
                  <c:v>1523.66</c:v>
                </c:pt>
                <c:pt idx="9374">
                  <c:v>2032.34</c:v>
                </c:pt>
                <c:pt idx="9377">
                  <c:v>1930.61</c:v>
                </c:pt>
                <c:pt idx="9378">
                  <c:v>1888.27</c:v>
                </c:pt>
                <c:pt idx="9380">
                  <c:v>1830.82</c:v>
                </c:pt>
                <c:pt idx="9382">
                  <c:v>3033.29</c:v>
                </c:pt>
                <c:pt idx="9385">
                  <c:v>3075.41</c:v>
                </c:pt>
                <c:pt idx="9399">
                  <c:v>2588.98</c:v>
                </c:pt>
                <c:pt idx="9405">
                  <c:v>1712.66</c:v>
                </c:pt>
                <c:pt idx="9407">
                  <c:v>1972.51</c:v>
                </c:pt>
                <c:pt idx="9410">
                  <c:v>2174.04</c:v>
                </c:pt>
                <c:pt idx="9411">
                  <c:v>1801.66</c:v>
                </c:pt>
                <c:pt idx="9412">
                  <c:v>1663.63</c:v>
                </c:pt>
                <c:pt idx="9423">
                  <c:v>1933.42</c:v>
                </c:pt>
                <c:pt idx="9427">
                  <c:v>1777.46</c:v>
                </c:pt>
                <c:pt idx="9433">
                  <c:v>1659.31</c:v>
                </c:pt>
                <c:pt idx="9436">
                  <c:v>1706.4</c:v>
                </c:pt>
                <c:pt idx="9471">
                  <c:v>1548.72</c:v>
                </c:pt>
                <c:pt idx="9477">
                  <c:v>1921.75</c:v>
                </c:pt>
                <c:pt idx="9478">
                  <c:v>1914.84</c:v>
                </c:pt>
                <c:pt idx="9483">
                  <c:v>1531.66</c:v>
                </c:pt>
                <c:pt idx="9484">
                  <c:v>2415.31</c:v>
                </c:pt>
                <c:pt idx="9485">
                  <c:v>1884.6</c:v>
                </c:pt>
                <c:pt idx="9488">
                  <c:v>1553.26</c:v>
                </c:pt>
                <c:pt idx="9496">
                  <c:v>1736.21</c:v>
                </c:pt>
                <c:pt idx="9497">
                  <c:v>3225.74</c:v>
                </c:pt>
                <c:pt idx="9499">
                  <c:v>1453.25</c:v>
                </c:pt>
                <c:pt idx="9502">
                  <c:v>1259.71</c:v>
                </c:pt>
                <c:pt idx="9503">
                  <c:v>1816.99</c:v>
                </c:pt>
                <c:pt idx="9505">
                  <c:v>1775.95</c:v>
                </c:pt>
                <c:pt idx="9506">
                  <c:v>2849.26</c:v>
                </c:pt>
                <c:pt idx="9512">
                  <c:v>1535.98</c:v>
                </c:pt>
                <c:pt idx="9514">
                  <c:v>2119.1799999999998</c:v>
                </c:pt>
                <c:pt idx="9521">
                  <c:v>1289.95</c:v>
                </c:pt>
                <c:pt idx="9525">
                  <c:v>1326.24</c:v>
                </c:pt>
                <c:pt idx="9526">
                  <c:v>1907.5</c:v>
                </c:pt>
                <c:pt idx="9534">
                  <c:v>3168.07</c:v>
                </c:pt>
                <c:pt idx="9539">
                  <c:v>1808.57</c:v>
                </c:pt>
                <c:pt idx="9542">
                  <c:v>2610.36</c:v>
                </c:pt>
                <c:pt idx="9544">
                  <c:v>1430.78</c:v>
                </c:pt>
                <c:pt idx="9548">
                  <c:v>2244.46</c:v>
                </c:pt>
                <c:pt idx="9549">
                  <c:v>3181.25</c:v>
                </c:pt>
                <c:pt idx="9559">
                  <c:v>2282.9</c:v>
                </c:pt>
                <c:pt idx="9565">
                  <c:v>2079.65</c:v>
                </c:pt>
                <c:pt idx="9566">
                  <c:v>2318.11</c:v>
                </c:pt>
                <c:pt idx="9567">
                  <c:v>1366.85</c:v>
                </c:pt>
                <c:pt idx="9568">
                  <c:v>2393.2800000000002</c:v>
                </c:pt>
                <c:pt idx="9570">
                  <c:v>2406.89</c:v>
                </c:pt>
                <c:pt idx="9576">
                  <c:v>2003.83</c:v>
                </c:pt>
                <c:pt idx="9582">
                  <c:v>92.016000000000005</c:v>
                </c:pt>
                <c:pt idx="9586">
                  <c:v>1498.39</c:v>
                </c:pt>
                <c:pt idx="9594">
                  <c:v>2930.26</c:v>
                </c:pt>
                <c:pt idx="9596">
                  <c:v>2229.77</c:v>
                </c:pt>
                <c:pt idx="9607">
                  <c:v>2133.86</c:v>
                </c:pt>
                <c:pt idx="9613">
                  <c:v>2125.2199999999998</c:v>
                </c:pt>
                <c:pt idx="9614">
                  <c:v>1593.22</c:v>
                </c:pt>
                <c:pt idx="9621">
                  <c:v>2021.54</c:v>
                </c:pt>
                <c:pt idx="9626">
                  <c:v>1654.34</c:v>
                </c:pt>
                <c:pt idx="9627">
                  <c:v>2166.91</c:v>
                </c:pt>
                <c:pt idx="9628">
                  <c:v>2923.56</c:v>
                </c:pt>
                <c:pt idx="9630">
                  <c:v>1685.23</c:v>
                </c:pt>
                <c:pt idx="9632">
                  <c:v>2446.1999999999998</c:v>
                </c:pt>
                <c:pt idx="9659">
                  <c:v>1748.95</c:v>
                </c:pt>
                <c:pt idx="9674">
                  <c:v>1875.1</c:v>
                </c:pt>
                <c:pt idx="9675">
                  <c:v>1456.06</c:v>
                </c:pt>
                <c:pt idx="9677">
                  <c:v>3818.66</c:v>
                </c:pt>
                <c:pt idx="9683">
                  <c:v>2026.51</c:v>
                </c:pt>
                <c:pt idx="9705">
                  <c:v>2252.23</c:v>
                </c:pt>
                <c:pt idx="9706">
                  <c:v>2335.8200000000002</c:v>
                </c:pt>
                <c:pt idx="9709">
                  <c:v>1822.39</c:v>
                </c:pt>
                <c:pt idx="9713">
                  <c:v>2135.81</c:v>
                </c:pt>
                <c:pt idx="9721">
                  <c:v>3394.22</c:v>
                </c:pt>
                <c:pt idx="9722">
                  <c:v>1825.63</c:v>
                </c:pt>
                <c:pt idx="9723">
                  <c:v>2415.1</c:v>
                </c:pt>
                <c:pt idx="9726">
                  <c:v>2117.23</c:v>
                </c:pt>
                <c:pt idx="9727">
                  <c:v>1369.01</c:v>
                </c:pt>
                <c:pt idx="9731">
                  <c:v>3050.57</c:v>
                </c:pt>
                <c:pt idx="9733">
                  <c:v>1650.89</c:v>
                </c:pt>
                <c:pt idx="9734">
                  <c:v>2915.14</c:v>
                </c:pt>
                <c:pt idx="9737">
                  <c:v>3021.84</c:v>
                </c:pt>
                <c:pt idx="9740">
                  <c:v>2150.71</c:v>
                </c:pt>
                <c:pt idx="9748">
                  <c:v>1897.78</c:v>
                </c:pt>
                <c:pt idx="9751">
                  <c:v>1518.26</c:v>
                </c:pt>
                <c:pt idx="9752">
                  <c:v>2333.23</c:v>
                </c:pt>
                <c:pt idx="9758">
                  <c:v>1449.36</c:v>
                </c:pt>
                <c:pt idx="9759">
                  <c:v>1509.84</c:v>
                </c:pt>
                <c:pt idx="9761">
                  <c:v>2870.86</c:v>
                </c:pt>
                <c:pt idx="9764">
                  <c:v>3367.87</c:v>
                </c:pt>
                <c:pt idx="9765">
                  <c:v>2159.35</c:v>
                </c:pt>
                <c:pt idx="9768">
                  <c:v>1454.76</c:v>
                </c:pt>
                <c:pt idx="9772">
                  <c:v>1213.27</c:v>
                </c:pt>
                <c:pt idx="9777">
                  <c:v>1602.72</c:v>
                </c:pt>
                <c:pt idx="9779">
                  <c:v>1765.58</c:v>
                </c:pt>
                <c:pt idx="9783">
                  <c:v>2673.22</c:v>
                </c:pt>
                <c:pt idx="9799">
                  <c:v>1489.75</c:v>
                </c:pt>
                <c:pt idx="9802">
                  <c:v>1901.88</c:v>
                </c:pt>
                <c:pt idx="9815">
                  <c:v>2068.42</c:v>
                </c:pt>
                <c:pt idx="9816">
                  <c:v>1803.38</c:v>
                </c:pt>
                <c:pt idx="9836">
                  <c:v>1785.89</c:v>
                </c:pt>
                <c:pt idx="9838">
                  <c:v>2343.6</c:v>
                </c:pt>
                <c:pt idx="9841">
                  <c:v>1638.36</c:v>
                </c:pt>
                <c:pt idx="9842">
                  <c:v>1863.86</c:v>
                </c:pt>
                <c:pt idx="9851">
                  <c:v>2013.34</c:v>
                </c:pt>
                <c:pt idx="9852">
                  <c:v>1779.19</c:v>
                </c:pt>
                <c:pt idx="9858">
                  <c:v>1722.17</c:v>
                </c:pt>
                <c:pt idx="9859">
                  <c:v>1936.22</c:v>
                </c:pt>
                <c:pt idx="9865">
                  <c:v>2201.04</c:v>
                </c:pt>
                <c:pt idx="9881">
                  <c:v>1657.8</c:v>
                </c:pt>
                <c:pt idx="9888">
                  <c:v>3028.75</c:v>
                </c:pt>
                <c:pt idx="9892">
                  <c:v>1309.18</c:v>
                </c:pt>
                <c:pt idx="9897">
                  <c:v>1437.48</c:v>
                </c:pt>
                <c:pt idx="9911">
                  <c:v>2628.29</c:v>
                </c:pt>
                <c:pt idx="9912">
                  <c:v>2396.9499999999998</c:v>
                </c:pt>
                <c:pt idx="9913">
                  <c:v>1953.29</c:v>
                </c:pt>
                <c:pt idx="9917">
                  <c:v>2309.9</c:v>
                </c:pt>
                <c:pt idx="9920">
                  <c:v>1855.87</c:v>
                </c:pt>
                <c:pt idx="9927">
                  <c:v>2993.11</c:v>
                </c:pt>
                <c:pt idx="9929">
                  <c:v>1525.61</c:v>
                </c:pt>
                <c:pt idx="9933">
                  <c:v>1938.6</c:v>
                </c:pt>
                <c:pt idx="9940">
                  <c:v>2330.64</c:v>
                </c:pt>
                <c:pt idx="9945">
                  <c:v>2079.86</c:v>
                </c:pt>
                <c:pt idx="9954">
                  <c:v>1939.68</c:v>
                </c:pt>
                <c:pt idx="9956">
                  <c:v>2886.62</c:v>
                </c:pt>
                <c:pt idx="9959">
                  <c:v>1469.66</c:v>
                </c:pt>
                <c:pt idx="9961">
                  <c:v>2269.73</c:v>
                </c:pt>
                <c:pt idx="9962">
                  <c:v>3103.06</c:v>
                </c:pt>
                <c:pt idx="9964">
                  <c:v>2372.98</c:v>
                </c:pt>
                <c:pt idx="9969">
                  <c:v>1951.99</c:v>
                </c:pt>
                <c:pt idx="9970">
                  <c:v>1699.92</c:v>
                </c:pt>
                <c:pt idx="9976">
                  <c:v>1037.6600000000001</c:v>
                </c:pt>
                <c:pt idx="9980">
                  <c:v>3303.94</c:v>
                </c:pt>
                <c:pt idx="9983">
                  <c:v>2313.36</c:v>
                </c:pt>
                <c:pt idx="9985">
                  <c:v>1158.6199999999999</c:v>
                </c:pt>
                <c:pt idx="9988">
                  <c:v>1706.62</c:v>
                </c:pt>
                <c:pt idx="9993">
                  <c:v>1820.88</c:v>
                </c:pt>
                <c:pt idx="9996">
                  <c:v>1174.3900000000001</c:v>
                </c:pt>
                <c:pt idx="9997">
                  <c:v>1689.34</c:v>
                </c:pt>
                <c:pt idx="10005">
                  <c:v>1317.17</c:v>
                </c:pt>
                <c:pt idx="10013">
                  <c:v>1886.98</c:v>
                </c:pt>
                <c:pt idx="10017">
                  <c:v>1823.26</c:v>
                </c:pt>
                <c:pt idx="10032">
                  <c:v>1451.3</c:v>
                </c:pt>
                <c:pt idx="10038">
                  <c:v>2209.6799999999998</c:v>
                </c:pt>
                <c:pt idx="10039">
                  <c:v>1008.94</c:v>
                </c:pt>
                <c:pt idx="10049">
                  <c:v>1730.16</c:v>
                </c:pt>
                <c:pt idx="10051">
                  <c:v>6007.82</c:v>
                </c:pt>
                <c:pt idx="10056">
                  <c:v>2841.7</c:v>
                </c:pt>
                <c:pt idx="10058">
                  <c:v>3084.26</c:v>
                </c:pt>
                <c:pt idx="10065">
                  <c:v>2119.61</c:v>
                </c:pt>
                <c:pt idx="10074">
                  <c:v>2758.54</c:v>
                </c:pt>
                <c:pt idx="10076">
                  <c:v>1746.79</c:v>
                </c:pt>
                <c:pt idx="10077">
                  <c:v>1714.18</c:v>
                </c:pt>
                <c:pt idx="10083">
                  <c:v>1874.02</c:v>
                </c:pt>
                <c:pt idx="10087">
                  <c:v>2334.31</c:v>
                </c:pt>
                <c:pt idx="10090">
                  <c:v>1503.14</c:v>
                </c:pt>
                <c:pt idx="10093">
                  <c:v>2769.34</c:v>
                </c:pt>
                <c:pt idx="10100">
                  <c:v>2396.09</c:v>
                </c:pt>
                <c:pt idx="10109">
                  <c:v>1733.4</c:v>
                </c:pt>
                <c:pt idx="10112">
                  <c:v>2586.17</c:v>
                </c:pt>
                <c:pt idx="10115">
                  <c:v>3402.65</c:v>
                </c:pt>
                <c:pt idx="10116">
                  <c:v>1569.02</c:v>
                </c:pt>
                <c:pt idx="10124">
                  <c:v>2069.5</c:v>
                </c:pt>
                <c:pt idx="10126">
                  <c:v>2890.94</c:v>
                </c:pt>
                <c:pt idx="10127">
                  <c:v>1496.88</c:v>
                </c:pt>
                <c:pt idx="10131">
                  <c:v>2881.22</c:v>
                </c:pt>
                <c:pt idx="10133">
                  <c:v>1697.33</c:v>
                </c:pt>
                <c:pt idx="10138">
                  <c:v>1790.86</c:v>
                </c:pt>
                <c:pt idx="10143">
                  <c:v>4184.3500000000004</c:v>
                </c:pt>
                <c:pt idx="10149">
                  <c:v>1911.6</c:v>
                </c:pt>
                <c:pt idx="10151">
                  <c:v>2341.66</c:v>
                </c:pt>
                <c:pt idx="10154">
                  <c:v>2604.5300000000002</c:v>
                </c:pt>
                <c:pt idx="10164">
                  <c:v>3031.78</c:v>
                </c:pt>
                <c:pt idx="10167">
                  <c:v>2539.5100000000002</c:v>
                </c:pt>
                <c:pt idx="10173">
                  <c:v>1704.02</c:v>
                </c:pt>
                <c:pt idx="10185">
                  <c:v>2355.91</c:v>
                </c:pt>
                <c:pt idx="10193">
                  <c:v>2321.14</c:v>
                </c:pt>
                <c:pt idx="10197">
                  <c:v>2161.08</c:v>
                </c:pt>
                <c:pt idx="10201">
                  <c:v>1724.76</c:v>
                </c:pt>
                <c:pt idx="10206">
                  <c:v>1625.18</c:v>
                </c:pt>
                <c:pt idx="10210">
                  <c:v>1741.82</c:v>
                </c:pt>
                <c:pt idx="10212">
                  <c:v>1890</c:v>
                </c:pt>
                <c:pt idx="10213">
                  <c:v>1197.29</c:v>
                </c:pt>
                <c:pt idx="10214">
                  <c:v>2900.88</c:v>
                </c:pt>
                <c:pt idx="10228">
                  <c:v>1688.26</c:v>
                </c:pt>
                <c:pt idx="10230">
                  <c:v>1267.27</c:v>
                </c:pt>
                <c:pt idx="10235">
                  <c:v>2493.29</c:v>
                </c:pt>
                <c:pt idx="10236">
                  <c:v>2706.05</c:v>
                </c:pt>
                <c:pt idx="10245">
                  <c:v>3147.77</c:v>
                </c:pt>
                <c:pt idx="10246">
                  <c:v>1450.22</c:v>
                </c:pt>
                <c:pt idx="10249">
                  <c:v>2324.16</c:v>
                </c:pt>
                <c:pt idx="10256">
                  <c:v>2112.91</c:v>
                </c:pt>
                <c:pt idx="10259">
                  <c:v>4819.3900000000003</c:v>
                </c:pt>
                <c:pt idx="10261">
                  <c:v>3003.05</c:v>
                </c:pt>
                <c:pt idx="10268">
                  <c:v>1862.57</c:v>
                </c:pt>
                <c:pt idx="10269">
                  <c:v>1578.53</c:v>
                </c:pt>
                <c:pt idx="10272">
                  <c:v>2184.41</c:v>
                </c:pt>
                <c:pt idx="10275">
                  <c:v>3089.23</c:v>
                </c:pt>
                <c:pt idx="10279">
                  <c:v>1276.99</c:v>
                </c:pt>
                <c:pt idx="10282">
                  <c:v>2093.2600000000002</c:v>
                </c:pt>
                <c:pt idx="10286">
                  <c:v>1627.13</c:v>
                </c:pt>
                <c:pt idx="10288">
                  <c:v>3093.77</c:v>
                </c:pt>
                <c:pt idx="10289">
                  <c:v>2223.7199999999998</c:v>
                </c:pt>
                <c:pt idx="10290">
                  <c:v>2533.6799999999998</c:v>
                </c:pt>
                <c:pt idx="10297">
                  <c:v>2371.46</c:v>
                </c:pt>
                <c:pt idx="10303">
                  <c:v>2730.89</c:v>
                </c:pt>
                <c:pt idx="10316">
                  <c:v>3230.71</c:v>
                </c:pt>
                <c:pt idx="10320">
                  <c:v>2373.41</c:v>
                </c:pt>
                <c:pt idx="10334">
                  <c:v>1754.57</c:v>
                </c:pt>
                <c:pt idx="10339">
                  <c:v>2004.91</c:v>
                </c:pt>
                <c:pt idx="10341">
                  <c:v>1956.74</c:v>
                </c:pt>
                <c:pt idx="10343">
                  <c:v>14871.2</c:v>
                </c:pt>
                <c:pt idx="10346">
                  <c:v>1908.79</c:v>
                </c:pt>
                <c:pt idx="10352">
                  <c:v>3881.74</c:v>
                </c:pt>
                <c:pt idx="10357">
                  <c:v>3295.51</c:v>
                </c:pt>
                <c:pt idx="10360">
                  <c:v>2236.46</c:v>
                </c:pt>
                <c:pt idx="10364">
                  <c:v>3329.64</c:v>
                </c:pt>
                <c:pt idx="10367">
                  <c:v>1626.26</c:v>
                </c:pt>
                <c:pt idx="10376">
                  <c:v>2054.16</c:v>
                </c:pt>
                <c:pt idx="10388">
                  <c:v>3541.75</c:v>
                </c:pt>
                <c:pt idx="10405">
                  <c:v>1963.44</c:v>
                </c:pt>
                <c:pt idx="10407">
                  <c:v>2120.4699999999998</c:v>
                </c:pt>
                <c:pt idx="10413">
                  <c:v>2620.5100000000002</c:v>
                </c:pt>
                <c:pt idx="10418">
                  <c:v>2633.69</c:v>
                </c:pt>
                <c:pt idx="10420">
                  <c:v>1101.3800000000001</c:v>
                </c:pt>
                <c:pt idx="10430">
                  <c:v>2534.11</c:v>
                </c:pt>
                <c:pt idx="10433">
                  <c:v>2199.31</c:v>
                </c:pt>
                <c:pt idx="10437">
                  <c:v>2530.0100000000002</c:v>
                </c:pt>
                <c:pt idx="10442">
                  <c:v>2387.4499999999998</c:v>
                </c:pt>
                <c:pt idx="10448">
                  <c:v>2040.98</c:v>
                </c:pt>
                <c:pt idx="10451">
                  <c:v>2183.7600000000002</c:v>
                </c:pt>
                <c:pt idx="10455">
                  <c:v>1237.03</c:v>
                </c:pt>
                <c:pt idx="10458">
                  <c:v>2598.6999999999998</c:v>
                </c:pt>
                <c:pt idx="10459">
                  <c:v>1861.7</c:v>
                </c:pt>
                <c:pt idx="10461">
                  <c:v>2849.47</c:v>
                </c:pt>
                <c:pt idx="10481">
                  <c:v>1937.09</c:v>
                </c:pt>
                <c:pt idx="10483">
                  <c:v>1249.3399999999999</c:v>
                </c:pt>
                <c:pt idx="10491">
                  <c:v>2388.31</c:v>
                </c:pt>
                <c:pt idx="10494">
                  <c:v>3573.72</c:v>
                </c:pt>
                <c:pt idx="10501">
                  <c:v>2074.25</c:v>
                </c:pt>
                <c:pt idx="10504">
                  <c:v>2626.56</c:v>
                </c:pt>
                <c:pt idx="10505">
                  <c:v>1245.46</c:v>
                </c:pt>
                <c:pt idx="10508">
                  <c:v>1510.06</c:v>
                </c:pt>
                <c:pt idx="10509">
                  <c:v>2041.85</c:v>
                </c:pt>
                <c:pt idx="10512">
                  <c:v>6450.41</c:v>
                </c:pt>
                <c:pt idx="10513">
                  <c:v>1762.78</c:v>
                </c:pt>
                <c:pt idx="10516">
                  <c:v>2317.9</c:v>
                </c:pt>
                <c:pt idx="10517">
                  <c:v>2002.1</c:v>
                </c:pt>
                <c:pt idx="10527">
                  <c:v>1243.94</c:v>
                </c:pt>
                <c:pt idx="10539">
                  <c:v>1974.67</c:v>
                </c:pt>
                <c:pt idx="10540">
                  <c:v>2369.52</c:v>
                </c:pt>
                <c:pt idx="10554">
                  <c:v>1971.65</c:v>
                </c:pt>
                <c:pt idx="10560">
                  <c:v>2082.89</c:v>
                </c:pt>
                <c:pt idx="10573">
                  <c:v>2356.13</c:v>
                </c:pt>
                <c:pt idx="10574">
                  <c:v>1246.97</c:v>
                </c:pt>
                <c:pt idx="10576">
                  <c:v>1887.62</c:v>
                </c:pt>
                <c:pt idx="10579">
                  <c:v>2106</c:v>
                </c:pt>
                <c:pt idx="10580">
                  <c:v>3182.54</c:v>
                </c:pt>
                <c:pt idx="10582">
                  <c:v>2872.37</c:v>
                </c:pt>
                <c:pt idx="10583">
                  <c:v>1986.77</c:v>
                </c:pt>
                <c:pt idx="10584">
                  <c:v>1648.3</c:v>
                </c:pt>
                <c:pt idx="10589">
                  <c:v>2086.7800000000002</c:v>
                </c:pt>
                <c:pt idx="10595">
                  <c:v>2609.71</c:v>
                </c:pt>
                <c:pt idx="10605">
                  <c:v>2474.71</c:v>
                </c:pt>
                <c:pt idx="10607">
                  <c:v>2733.26</c:v>
                </c:pt>
                <c:pt idx="10612">
                  <c:v>2278.15</c:v>
                </c:pt>
                <c:pt idx="10620">
                  <c:v>2127.6</c:v>
                </c:pt>
                <c:pt idx="10621">
                  <c:v>3011.9</c:v>
                </c:pt>
                <c:pt idx="10627">
                  <c:v>1192.32</c:v>
                </c:pt>
                <c:pt idx="10628">
                  <c:v>1787.83</c:v>
                </c:pt>
                <c:pt idx="10633">
                  <c:v>3658.82</c:v>
                </c:pt>
                <c:pt idx="10656">
                  <c:v>1731.67</c:v>
                </c:pt>
                <c:pt idx="10657">
                  <c:v>2885.33</c:v>
                </c:pt>
                <c:pt idx="10660">
                  <c:v>2798.5</c:v>
                </c:pt>
                <c:pt idx="10661">
                  <c:v>2434.3200000000002</c:v>
                </c:pt>
                <c:pt idx="10662">
                  <c:v>2609.71</c:v>
                </c:pt>
                <c:pt idx="10664">
                  <c:v>2974.97</c:v>
                </c:pt>
                <c:pt idx="10666">
                  <c:v>2044.22</c:v>
                </c:pt>
                <c:pt idx="10667">
                  <c:v>2827.01</c:v>
                </c:pt>
                <c:pt idx="10673">
                  <c:v>2263.0300000000002</c:v>
                </c:pt>
                <c:pt idx="10678">
                  <c:v>1276.78</c:v>
                </c:pt>
                <c:pt idx="10681">
                  <c:v>1702.94</c:v>
                </c:pt>
                <c:pt idx="10691">
                  <c:v>1525.82</c:v>
                </c:pt>
                <c:pt idx="10702">
                  <c:v>1838.16</c:v>
                </c:pt>
                <c:pt idx="10703">
                  <c:v>2122.63</c:v>
                </c:pt>
                <c:pt idx="10716">
                  <c:v>1881.36</c:v>
                </c:pt>
                <c:pt idx="10718">
                  <c:v>3390.34</c:v>
                </c:pt>
                <c:pt idx="10720">
                  <c:v>2046.17</c:v>
                </c:pt>
                <c:pt idx="10727">
                  <c:v>1395.79</c:v>
                </c:pt>
                <c:pt idx="10733">
                  <c:v>1821.31</c:v>
                </c:pt>
                <c:pt idx="10751">
                  <c:v>2314.87</c:v>
                </c:pt>
                <c:pt idx="10754">
                  <c:v>3068.06</c:v>
                </c:pt>
                <c:pt idx="10759">
                  <c:v>1590.84</c:v>
                </c:pt>
                <c:pt idx="10760">
                  <c:v>2189.59</c:v>
                </c:pt>
                <c:pt idx="10761">
                  <c:v>1396.44</c:v>
                </c:pt>
                <c:pt idx="10775">
                  <c:v>1636.85</c:v>
                </c:pt>
                <c:pt idx="10777">
                  <c:v>3680.86</c:v>
                </c:pt>
                <c:pt idx="10778">
                  <c:v>2485.94</c:v>
                </c:pt>
                <c:pt idx="10779">
                  <c:v>1738.8</c:v>
                </c:pt>
                <c:pt idx="10781">
                  <c:v>1700.35</c:v>
                </c:pt>
                <c:pt idx="10782">
                  <c:v>1919.81</c:v>
                </c:pt>
                <c:pt idx="10784">
                  <c:v>1745.06</c:v>
                </c:pt>
                <c:pt idx="10787">
                  <c:v>1662.77</c:v>
                </c:pt>
                <c:pt idx="10794">
                  <c:v>2385.0700000000002</c:v>
                </c:pt>
                <c:pt idx="10797">
                  <c:v>2279.88</c:v>
                </c:pt>
                <c:pt idx="10798">
                  <c:v>2899.15</c:v>
                </c:pt>
                <c:pt idx="10801">
                  <c:v>2967.84</c:v>
                </c:pt>
                <c:pt idx="10803">
                  <c:v>3069.58</c:v>
                </c:pt>
                <c:pt idx="10804">
                  <c:v>3619.73</c:v>
                </c:pt>
                <c:pt idx="10806">
                  <c:v>3230.93</c:v>
                </c:pt>
                <c:pt idx="10810">
                  <c:v>2380.1</c:v>
                </c:pt>
                <c:pt idx="10811">
                  <c:v>2776.68</c:v>
                </c:pt>
                <c:pt idx="10812">
                  <c:v>1283.26</c:v>
                </c:pt>
                <c:pt idx="10820">
                  <c:v>110.80800000000001</c:v>
                </c:pt>
                <c:pt idx="10823">
                  <c:v>2513.16</c:v>
                </c:pt>
                <c:pt idx="10832">
                  <c:v>1901.23</c:v>
                </c:pt>
                <c:pt idx="10848">
                  <c:v>2057.1799999999998</c:v>
                </c:pt>
                <c:pt idx="10854">
                  <c:v>2430.2199999999998</c:v>
                </c:pt>
                <c:pt idx="10863">
                  <c:v>1941.84</c:v>
                </c:pt>
                <c:pt idx="10867">
                  <c:v>1934.5</c:v>
                </c:pt>
                <c:pt idx="10868">
                  <c:v>4087.8</c:v>
                </c:pt>
                <c:pt idx="10871">
                  <c:v>2341.87</c:v>
                </c:pt>
                <c:pt idx="10872">
                  <c:v>1898.21</c:v>
                </c:pt>
                <c:pt idx="10877">
                  <c:v>3341.95</c:v>
                </c:pt>
                <c:pt idx="10879">
                  <c:v>3001.1</c:v>
                </c:pt>
                <c:pt idx="10886">
                  <c:v>2177.5</c:v>
                </c:pt>
                <c:pt idx="10889">
                  <c:v>2378.16</c:v>
                </c:pt>
                <c:pt idx="10906">
                  <c:v>2742.55</c:v>
                </c:pt>
                <c:pt idx="10907">
                  <c:v>2398.25</c:v>
                </c:pt>
                <c:pt idx="10912">
                  <c:v>2910.82</c:v>
                </c:pt>
                <c:pt idx="10914">
                  <c:v>2525.9</c:v>
                </c:pt>
                <c:pt idx="10916">
                  <c:v>1416.96</c:v>
                </c:pt>
                <c:pt idx="10920">
                  <c:v>2157.41</c:v>
                </c:pt>
                <c:pt idx="10922">
                  <c:v>1863.65</c:v>
                </c:pt>
                <c:pt idx="10927">
                  <c:v>1902.96</c:v>
                </c:pt>
                <c:pt idx="10929">
                  <c:v>1839.89</c:v>
                </c:pt>
                <c:pt idx="10936">
                  <c:v>1956.31</c:v>
                </c:pt>
                <c:pt idx="10938">
                  <c:v>2544.2600000000002</c:v>
                </c:pt>
                <c:pt idx="10946">
                  <c:v>3672.65</c:v>
                </c:pt>
                <c:pt idx="10959">
                  <c:v>144.28800000000001</c:v>
                </c:pt>
                <c:pt idx="10960">
                  <c:v>2711.02</c:v>
                </c:pt>
                <c:pt idx="10974">
                  <c:v>1711.15</c:v>
                </c:pt>
                <c:pt idx="10977">
                  <c:v>4108.1000000000004</c:v>
                </c:pt>
                <c:pt idx="10982">
                  <c:v>1965.17</c:v>
                </c:pt>
                <c:pt idx="10984">
                  <c:v>2062.15</c:v>
                </c:pt>
                <c:pt idx="10991">
                  <c:v>1722.82</c:v>
                </c:pt>
                <c:pt idx="10992">
                  <c:v>4131.6499999999996</c:v>
                </c:pt>
                <c:pt idx="10995">
                  <c:v>2308.8200000000002</c:v>
                </c:pt>
                <c:pt idx="10996">
                  <c:v>2512.73</c:v>
                </c:pt>
                <c:pt idx="10998">
                  <c:v>1704.46</c:v>
                </c:pt>
                <c:pt idx="11002">
                  <c:v>3516.05</c:v>
                </c:pt>
                <c:pt idx="11008">
                  <c:v>2279.23</c:v>
                </c:pt>
                <c:pt idx="11009">
                  <c:v>2034.07</c:v>
                </c:pt>
                <c:pt idx="11010">
                  <c:v>2506.25</c:v>
                </c:pt>
                <c:pt idx="11011">
                  <c:v>1749.17</c:v>
                </c:pt>
                <c:pt idx="11014">
                  <c:v>2539.08</c:v>
                </c:pt>
                <c:pt idx="11015">
                  <c:v>1986.77</c:v>
                </c:pt>
                <c:pt idx="11018">
                  <c:v>1537.92</c:v>
                </c:pt>
                <c:pt idx="11023">
                  <c:v>2607.5500000000002</c:v>
                </c:pt>
                <c:pt idx="11024">
                  <c:v>2552.69</c:v>
                </c:pt>
                <c:pt idx="11026">
                  <c:v>1577.02</c:v>
                </c:pt>
                <c:pt idx="11029">
                  <c:v>1893.02</c:v>
                </c:pt>
                <c:pt idx="11032">
                  <c:v>2082.2399999999998</c:v>
                </c:pt>
                <c:pt idx="11035">
                  <c:v>2971.73</c:v>
                </c:pt>
                <c:pt idx="11055">
                  <c:v>1623.89</c:v>
                </c:pt>
                <c:pt idx="11060">
                  <c:v>2548.15</c:v>
                </c:pt>
                <c:pt idx="11063">
                  <c:v>3348.65</c:v>
                </c:pt>
                <c:pt idx="11065">
                  <c:v>2197.15</c:v>
                </c:pt>
                <c:pt idx="11075">
                  <c:v>2947.97</c:v>
                </c:pt>
                <c:pt idx="11081">
                  <c:v>2212.4899999999998</c:v>
                </c:pt>
                <c:pt idx="11082">
                  <c:v>1753.27</c:v>
                </c:pt>
                <c:pt idx="11089">
                  <c:v>3053.16</c:v>
                </c:pt>
                <c:pt idx="11090">
                  <c:v>1940.54</c:v>
                </c:pt>
                <c:pt idx="11097">
                  <c:v>1623.67</c:v>
                </c:pt>
                <c:pt idx="11099">
                  <c:v>1592.14</c:v>
                </c:pt>
                <c:pt idx="11103">
                  <c:v>2189.81</c:v>
                </c:pt>
                <c:pt idx="11110">
                  <c:v>2099.52</c:v>
                </c:pt>
                <c:pt idx="11114">
                  <c:v>1860.19</c:v>
                </c:pt>
                <c:pt idx="11137">
                  <c:v>2290.6799999999998</c:v>
                </c:pt>
                <c:pt idx="11139">
                  <c:v>2788.56</c:v>
                </c:pt>
                <c:pt idx="11140">
                  <c:v>2814.91</c:v>
                </c:pt>
                <c:pt idx="11142">
                  <c:v>2276.21</c:v>
                </c:pt>
                <c:pt idx="11145">
                  <c:v>1944.65</c:v>
                </c:pt>
                <c:pt idx="11154">
                  <c:v>2768.69</c:v>
                </c:pt>
                <c:pt idx="11166">
                  <c:v>2684.23</c:v>
                </c:pt>
                <c:pt idx="11169">
                  <c:v>2177.2800000000002</c:v>
                </c:pt>
                <c:pt idx="11170">
                  <c:v>2201.2600000000002</c:v>
                </c:pt>
                <c:pt idx="11175">
                  <c:v>2806.27</c:v>
                </c:pt>
                <c:pt idx="11182">
                  <c:v>3473.71</c:v>
                </c:pt>
                <c:pt idx="11185">
                  <c:v>2669.54</c:v>
                </c:pt>
                <c:pt idx="11188">
                  <c:v>1906.63</c:v>
                </c:pt>
                <c:pt idx="11190">
                  <c:v>2425.25</c:v>
                </c:pt>
                <c:pt idx="11191">
                  <c:v>3397.03</c:v>
                </c:pt>
                <c:pt idx="11193">
                  <c:v>1801.87</c:v>
                </c:pt>
                <c:pt idx="11194">
                  <c:v>2218.1</c:v>
                </c:pt>
                <c:pt idx="11196">
                  <c:v>2775.6</c:v>
                </c:pt>
                <c:pt idx="11198">
                  <c:v>1815.7</c:v>
                </c:pt>
                <c:pt idx="11202">
                  <c:v>2561.11</c:v>
                </c:pt>
                <c:pt idx="11204">
                  <c:v>2495.66</c:v>
                </c:pt>
                <c:pt idx="11221">
                  <c:v>1689.12</c:v>
                </c:pt>
                <c:pt idx="11224">
                  <c:v>1921.54</c:v>
                </c:pt>
                <c:pt idx="11231">
                  <c:v>2378.38</c:v>
                </c:pt>
                <c:pt idx="11235">
                  <c:v>3120.77</c:v>
                </c:pt>
                <c:pt idx="11238">
                  <c:v>4057.78</c:v>
                </c:pt>
                <c:pt idx="11245">
                  <c:v>3324.02</c:v>
                </c:pt>
                <c:pt idx="11246">
                  <c:v>1686.74</c:v>
                </c:pt>
                <c:pt idx="11249">
                  <c:v>1654.78</c:v>
                </c:pt>
                <c:pt idx="11250">
                  <c:v>2436.6999999999998</c:v>
                </c:pt>
                <c:pt idx="11261">
                  <c:v>3810.89</c:v>
                </c:pt>
                <c:pt idx="11262">
                  <c:v>3138.7</c:v>
                </c:pt>
                <c:pt idx="11266">
                  <c:v>2459.16</c:v>
                </c:pt>
                <c:pt idx="11267">
                  <c:v>2145.96</c:v>
                </c:pt>
                <c:pt idx="11268">
                  <c:v>2441.88</c:v>
                </c:pt>
                <c:pt idx="11276">
                  <c:v>2291.7600000000002</c:v>
                </c:pt>
                <c:pt idx="11277">
                  <c:v>2846.45</c:v>
                </c:pt>
                <c:pt idx="11279">
                  <c:v>2267.35</c:v>
                </c:pt>
                <c:pt idx="11285">
                  <c:v>1461.67</c:v>
                </c:pt>
                <c:pt idx="11293">
                  <c:v>1494.72</c:v>
                </c:pt>
                <c:pt idx="11299">
                  <c:v>1508.98</c:v>
                </c:pt>
                <c:pt idx="11306">
                  <c:v>1499.04</c:v>
                </c:pt>
                <c:pt idx="11307">
                  <c:v>1854.58</c:v>
                </c:pt>
                <c:pt idx="11311">
                  <c:v>2772.79</c:v>
                </c:pt>
                <c:pt idx="11313">
                  <c:v>2641.9</c:v>
                </c:pt>
                <c:pt idx="11316">
                  <c:v>2100.6</c:v>
                </c:pt>
                <c:pt idx="11319">
                  <c:v>2898.5</c:v>
                </c:pt>
                <c:pt idx="11320">
                  <c:v>1511.35</c:v>
                </c:pt>
                <c:pt idx="11323">
                  <c:v>1797.34</c:v>
                </c:pt>
                <c:pt idx="11325">
                  <c:v>2220.0500000000002</c:v>
                </c:pt>
                <c:pt idx="11337">
                  <c:v>1889.57</c:v>
                </c:pt>
                <c:pt idx="11356">
                  <c:v>2876.26</c:v>
                </c:pt>
                <c:pt idx="11369">
                  <c:v>2272.75</c:v>
                </c:pt>
                <c:pt idx="11370">
                  <c:v>2361.1</c:v>
                </c:pt>
                <c:pt idx="11372">
                  <c:v>1941.41</c:v>
                </c:pt>
                <c:pt idx="11374">
                  <c:v>2974.1</c:v>
                </c:pt>
                <c:pt idx="11375">
                  <c:v>3526.63</c:v>
                </c:pt>
                <c:pt idx="11377">
                  <c:v>4299.26</c:v>
                </c:pt>
                <c:pt idx="11380">
                  <c:v>1715.47</c:v>
                </c:pt>
                <c:pt idx="11383">
                  <c:v>3724.06</c:v>
                </c:pt>
                <c:pt idx="11388">
                  <c:v>3475.22</c:v>
                </c:pt>
                <c:pt idx="11392">
                  <c:v>2196.29</c:v>
                </c:pt>
                <c:pt idx="11396">
                  <c:v>2063.02</c:v>
                </c:pt>
                <c:pt idx="11403">
                  <c:v>1784.59</c:v>
                </c:pt>
                <c:pt idx="11404">
                  <c:v>3543.48</c:v>
                </c:pt>
                <c:pt idx="11406">
                  <c:v>1548.94</c:v>
                </c:pt>
                <c:pt idx="11412">
                  <c:v>3528.14</c:v>
                </c:pt>
                <c:pt idx="11414">
                  <c:v>2255.69</c:v>
                </c:pt>
                <c:pt idx="11420">
                  <c:v>3389.69</c:v>
                </c:pt>
                <c:pt idx="11424">
                  <c:v>1973.81</c:v>
                </c:pt>
                <c:pt idx="11427">
                  <c:v>2096.71</c:v>
                </c:pt>
                <c:pt idx="11428">
                  <c:v>234.36</c:v>
                </c:pt>
                <c:pt idx="11434">
                  <c:v>2099.7399999999998</c:v>
                </c:pt>
                <c:pt idx="11438">
                  <c:v>3986.93</c:v>
                </c:pt>
                <c:pt idx="11451">
                  <c:v>2935.87</c:v>
                </c:pt>
                <c:pt idx="11463">
                  <c:v>2620.94</c:v>
                </c:pt>
                <c:pt idx="11469">
                  <c:v>1731.89</c:v>
                </c:pt>
                <c:pt idx="11474">
                  <c:v>2198.66</c:v>
                </c:pt>
                <c:pt idx="11477">
                  <c:v>2704.32</c:v>
                </c:pt>
                <c:pt idx="11479">
                  <c:v>1496.88</c:v>
                </c:pt>
                <c:pt idx="11480">
                  <c:v>2049.41</c:v>
                </c:pt>
                <c:pt idx="11485">
                  <c:v>2200.8200000000002</c:v>
                </c:pt>
                <c:pt idx="11488">
                  <c:v>2965.9</c:v>
                </c:pt>
                <c:pt idx="11491">
                  <c:v>3116.88</c:v>
                </c:pt>
                <c:pt idx="11497">
                  <c:v>3289.46</c:v>
                </c:pt>
                <c:pt idx="11499">
                  <c:v>2144.4499999999998</c:v>
                </c:pt>
                <c:pt idx="11500">
                  <c:v>1620</c:v>
                </c:pt>
                <c:pt idx="11504">
                  <c:v>2490.0500000000002</c:v>
                </c:pt>
                <c:pt idx="11513">
                  <c:v>3250.15</c:v>
                </c:pt>
                <c:pt idx="11515">
                  <c:v>1570.75</c:v>
                </c:pt>
                <c:pt idx="11519">
                  <c:v>2710.37</c:v>
                </c:pt>
                <c:pt idx="11525">
                  <c:v>4000.75</c:v>
                </c:pt>
                <c:pt idx="11533">
                  <c:v>1931.47</c:v>
                </c:pt>
                <c:pt idx="11535">
                  <c:v>2595.02</c:v>
                </c:pt>
                <c:pt idx="11537">
                  <c:v>2095.63</c:v>
                </c:pt>
                <c:pt idx="11547">
                  <c:v>2838.67</c:v>
                </c:pt>
                <c:pt idx="11548">
                  <c:v>2086.13</c:v>
                </c:pt>
                <c:pt idx="11550">
                  <c:v>2339.2800000000002</c:v>
                </c:pt>
                <c:pt idx="11551">
                  <c:v>1823.69</c:v>
                </c:pt>
                <c:pt idx="11552">
                  <c:v>3122.5</c:v>
                </c:pt>
                <c:pt idx="11554">
                  <c:v>3252.31</c:v>
                </c:pt>
                <c:pt idx="11555">
                  <c:v>1433.38</c:v>
                </c:pt>
                <c:pt idx="11561">
                  <c:v>1546.56</c:v>
                </c:pt>
                <c:pt idx="11565">
                  <c:v>2965.46</c:v>
                </c:pt>
                <c:pt idx="11591">
                  <c:v>2732.83</c:v>
                </c:pt>
                <c:pt idx="11595">
                  <c:v>2651.18</c:v>
                </c:pt>
                <c:pt idx="11601">
                  <c:v>2711.88</c:v>
                </c:pt>
                <c:pt idx="11604">
                  <c:v>3773.74</c:v>
                </c:pt>
                <c:pt idx="11608">
                  <c:v>2381.83</c:v>
                </c:pt>
                <c:pt idx="11610">
                  <c:v>4515.05</c:v>
                </c:pt>
                <c:pt idx="11613">
                  <c:v>2245.1</c:v>
                </c:pt>
                <c:pt idx="11617">
                  <c:v>2910.6</c:v>
                </c:pt>
                <c:pt idx="11622">
                  <c:v>2009.23</c:v>
                </c:pt>
                <c:pt idx="11644">
                  <c:v>1447.85</c:v>
                </c:pt>
                <c:pt idx="11645">
                  <c:v>1871.86</c:v>
                </c:pt>
                <c:pt idx="11652">
                  <c:v>3743.06</c:v>
                </c:pt>
                <c:pt idx="11653">
                  <c:v>2390.04</c:v>
                </c:pt>
                <c:pt idx="11660">
                  <c:v>2453.7600000000002</c:v>
                </c:pt>
                <c:pt idx="11662">
                  <c:v>2054.16</c:v>
                </c:pt>
                <c:pt idx="11673">
                  <c:v>2386.8000000000002</c:v>
                </c:pt>
                <c:pt idx="11675">
                  <c:v>1834.27</c:v>
                </c:pt>
                <c:pt idx="11679">
                  <c:v>3553.85</c:v>
                </c:pt>
                <c:pt idx="11680">
                  <c:v>2985.12</c:v>
                </c:pt>
                <c:pt idx="11686">
                  <c:v>1964.74</c:v>
                </c:pt>
                <c:pt idx="11690">
                  <c:v>3365.93</c:v>
                </c:pt>
                <c:pt idx="11691">
                  <c:v>1934.28</c:v>
                </c:pt>
                <c:pt idx="11693">
                  <c:v>2482.27</c:v>
                </c:pt>
                <c:pt idx="11699">
                  <c:v>4296.8900000000003</c:v>
                </c:pt>
                <c:pt idx="11700">
                  <c:v>7260.19</c:v>
                </c:pt>
                <c:pt idx="11707">
                  <c:v>2213.14</c:v>
                </c:pt>
                <c:pt idx="11710">
                  <c:v>2522.88</c:v>
                </c:pt>
                <c:pt idx="11712">
                  <c:v>2046.82</c:v>
                </c:pt>
                <c:pt idx="11713">
                  <c:v>1907.28</c:v>
                </c:pt>
                <c:pt idx="11727">
                  <c:v>3519.29</c:v>
                </c:pt>
                <c:pt idx="11730">
                  <c:v>2441.23</c:v>
                </c:pt>
                <c:pt idx="11731">
                  <c:v>2933.93</c:v>
                </c:pt>
                <c:pt idx="11732">
                  <c:v>2323.73</c:v>
                </c:pt>
                <c:pt idx="11733">
                  <c:v>2202.98</c:v>
                </c:pt>
                <c:pt idx="11734">
                  <c:v>1392.77</c:v>
                </c:pt>
                <c:pt idx="11745">
                  <c:v>5572.58</c:v>
                </c:pt>
                <c:pt idx="11748">
                  <c:v>2792.88</c:v>
                </c:pt>
                <c:pt idx="11754">
                  <c:v>2118.96</c:v>
                </c:pt>
                <c:pt idx="11755">
                  <c:v>2312.9299999999998</c:v>
                </c:pt>
                <c:pt idx="11763">
                  <c:v>1789.56</c:v>
                </c:pt>
                <c:pt idx="11767">
                  <c:v>2298.67</c:v>
                </c:pt>
                <c:pt idx="11776">
                  <c:v>2793.96</c:v>
                </c:pt>
                <c:pt idx="11779">
                  <c:v>2629.37</c:v>
                </c:pt>
                <c:pt idx="11785">
                  <c:v>1903.61</c:v>
                </c:pt>
                <c:pt idx="11786">
                  <c:v>1885.25</c:v>
                </c:pt>
                <c:pt idx="11813">
                  <c:v>2932.2</c:v>
                </c:pt>
                <c:pt idx="11816">
                  <c:v>4649.18</c:v>
                </c:pt>
                <c:pt idx="11821">
                  <c:v>3374.14</c:v>
                </c:pt>
                <c:pt idx="11829">
                  <c:v>3740.04</c:v>
                </c:pt>
                <c:pt idx="11832">
                  <c:v>3018.17</c:v>
                </c:pt>
                <c:pt idx="11833">
                  <c:v>2760.05</c:v>
                </c:pt>
                <c:pt idx="11843">
                  <c:v>1754.14</c:v>
                </c:pt>
                <c:pt idx="11845">
                  <c:v>2689.63</c:v>
                </c:pt>
                <c:pt idx="11848">
                  <c:v>2773.66</c:v>
                </c:pt>
                <c:pt idx="11850">
                  <c:v>2601.29</c:v>
                </c:pt>
                <c:pt idx="11851">
                  <c:v>3403.73</c:v>
                </c:pt>
                <c:pt idx="11852">
                  <c:v>3152.52</c:v>
                </c:pt>
                <c:pt idx="11853">
                  <c:v>2856.6</c:v>
                </c:pt>
                <c:pt idx="11856">
                  <c:v>4272.26</c:v>
                </c:pt>
                <c:pt idx="11862">
                  <c:v>2005.56</c:v>
                </c:pt>
                <c:pt idx="11863">
                  <c:v>2478.17</c:v>
                </c:pt>
                <c:pt idx="11870">
                  <c:v>5098.68</c:v>
                </c:pt>
                <c:pt idx="11876">
                  <c:v>1827.36</c:v>
                </c:pt>
                <c:pt idx="11880">
                  <c:v>2076.84</c:v>
                </c:pt>
                <c:pt idx="11886">
                  <c:v>2741.9</c:v>
                </c:pt>
                <c:pt idx="11887">
                  <c:v>3382.34</c:v>
                </c:pt>
                <c:pt idx="11892">
                  <c:v>2878.42</c:v>
                </c:pt>
                <c:pt idx="11893">
                  <c:v>2343.8200000000002</c:v>
                </c:pt>
                <c:pt idx="11895">
                  <c:v>2449.2199999999998</c:v>
                </c:pt>
                <c:pt idx="11902">
                  <c:v>2279.4499999999998</c:v>
                </c:pt>
                <c:pt idx="11905">
                  <c:v>2605.61</c:v>
                </c:pt>
                <c:pt idx="11915">
                  <c:v>2191.75</c:v>
                </c:pt>
                <c:pt idx="11920">
                  <c:v>2041.63</c:v>
                </c:pt>
                <c:pt idx="11923">
                  <c:v>2967.41</c:v>
                </c:pt>
                <c:pt idx="11925">
                  <c:v>1619.35</c:v>
                </c:pt>
                <c:pt idx="11928">
                  <c:v>2121.5500000000002</c:v>
                </c:pt>
                <c:pt idx="11931">
                  <c:v>2128.46</c:v>
                </c:pt>
                <c:pt idx="11934">
                  <c:v>2293.6999999999998</c:v>
                </c:pt>
                <c:pt idx="11937">
                  <c:v>2177.06</c:v>
                </c:pt>
                <c:pt idx="11959">
                  <c:v>3264.84</c:v>
                </c:pt>
                <c:pt idx="11965">
                  <c:v>3029.62</c:v>
                </c:pt>
                <c:pt idx="11966">
                  <c:v>1738.58</c:v>
                </c:pt>
                <c:pt idx="11972">
                  <c:v>2775.6</c:v>
                </c:pt>
                <c:pt idx="11973">
                  <c:v>2848.82</c:v>
                </c:pt>
                <c:pt idx="11977">
                  <c:v>3216.02</c:v>
                </c:pt>
                <c:pt idx="11988">
                  <c:v>2275.34</c:v>
                </c:pt>
                <c:pt idx="11994">
                  <c:v>2844.72</c:v>
                </c:pt>
                <c:pt idx="11999">
                  <c:v>1675.73</c:v>
                </c:pt>
                <c:pt idx="12007">
                  <c:v>2671.06</c:v>
                </c:pt>
                <c:pt idx="12014">
                  <c:v>2265.19</c:v>
                </c:pt>
                <c:pt idx="12016">
                  <c:v>2910.17</c:v>
                </c:pt>
                <c:pt idx="12019">
                  <c:v>2736.07</c:v>
                </c:pt>
                <c:pt idx="12021">
                  <c:v>2363.04</c:v>
                </c:pt>
                <c:pt idx="12027">
                  <c:v>4646.59</c:v>
                </c:pt>
                <c:pt idx="12044">
                  <c:v>3074.33</c:v>
                </c:pt>
                <c:pt idx="12045">
                  <c:v>1426.9</c:v>
                </c:pt>
                <c:pt idx="12046">
                  <c:v>2545.56</c:v>
                </c:pt>
                <c:pt idx="12054">
                  <c:v>2154.38</c:v>
                </c:pt>
                <c:pt idx="12060">
                  <c:v>2164.3200000000002</c:v>
                </c:pt>
                <c:pt idx="12066">
                  <c:v>3494.45</c:v>
                </c:pt>
                <c:pt idx="12084">
                  <c:v>2529.36</c:v>
                </c:pt>
                <c:pt idx="12086">
                  <c:v>5432.4</c:v>
                </c:pt>
                <c:pt idx="12088">
                  <c:v>3668.33</c:v>
                </c:pt>
                <c:pt idx="12093">
                  <c:v>3280.18</c:v>
                </c:pt>
                <c:pt idx="12104">
                  <c:v>2495.88</c:v>
                </c:pt>
                <c:pt idx="12109">
                  <c:v>3420.14</c:v>
                </c:pt>
                <c:pt idx="12111">
                  <c:v>3051.86</c:v>
                </c:pt>
                <c:pt idx="12113">
                  <c:v>2778.19</c:v>
                </c:pt>
                <c:pt idx="12114">
                  <c:v>4674.24</c:v>
                </c:pt>
                <c:pt idx="12116">
                  <c:v>1511.35</c:v>
                </c:pt>
                <c:pt idx="12122">
                  <c:v>2762.21</c:v>
                </c:pt>
                <c:pt idx="12130">
                  <c:v>2048.11</c:v>
                </c:pt>
                <c:pt idx="12137">
                  <c:v>2766.96</c:v>
                </c:pt>
                <c:pt idx="12140">
                  <c:v>4195.58</c:v>
                </c:pt>
                <c:pt idx="12141">
                  <c:v>2070.14</c:v>
                </c:pt>
                <c:pt idx="12146">
                  <c:v>2076.62</c:v>
                </c:pt>
                <c:pt idx="12148">
                  <c:v>2546.64</c:v>
                </c:pt>
                <c:pt idx="12151">
                  <c:v>3639.38</c:v>
                </c:pt>
                <c:pt idx="12152">
                  <c:v>2828.09</c:v>
                </c:pt>
                <c:pt idx="12155">
                  <c:v>2953.37</c:v>
                </c:pt>
                <c:pt idx="12156">
                  <c:v>2582.9299999999998</c:v>
                </c:pt>
                <c:pt idx="12164">
                  <c:v>5566.32</c:v>
                </c:pt>
                <c:pt idx="12165">
                  <c:v>4711.3900000000003</c:v>
                </c:pt>
                <c:pt idx="12167">
                  <c:v>3033.07</c:v>
                </c:pt>
                <c:pt idx="12168">
                  <c:v>2520.5</c:v>
                </c:pt>
                <c:pt idx="12169">
                  <c:v>2243.38</c:v>
                </c:pt>
                <c:pt idx="12173">
                  <c:v>2616.19</c:v>
                </c:pt>
                <c:pt idx="12176">
                  <c:v>2869.99</c:v>
                </c:pt>
                <c:pt idx="12184">
                  <c:v>2535.62</c:v>
                </c:pt>
                <c:pt idx="12200">
                  <c:v>3505.03</c:v>
                </c:pt>
                <c:pt idx="12202">
                  <c:v>3275.86</c:v>
                </c:pt>
                <c:pt idx="12205">
                  <c:v>2696.11</c:v>
                </c:pt>
                <c:pt idx="12207">
                  <c:v>3756.67</c:v>
                </c:pt>
                <c:pt idx="12213">
                  <c:v>2512.94</c:v>
                </c:pt>
                <c:pt idx="12219">
                  <c:v>5247.29</c:v>
                </c:pt>
                <c:pt idx="12220">
                  <c:v>1958.9</c:v>
                </c:pt>
                <c:pt idx="12222">
                  <c:v>1811.38</c:v>
                </c:pt>
                <c:pt idx="12223">
                  <c:v>2419.85</c:v>
                </c:pt>
                <c:pt idx="12227">
                  <c:v>2301.0500000000002</c:v>
                </c:pt>
                <c:pt idx="12239">
                  <c:v>2430.65</c:v>
                </c:pt>
                <c:pt idx="12244">
                  <c:v>2048.98</c:v>
                </c:pt>
                <c:pt idx="12246">
                  <c:v>3825.79</c:v>
                </c:pt>
                <c:pt idx="12248">
                  <c:v>1499.04</c:v>
                </c:pt>
                <c:pt idx="12255">
                  <c:v>3308.69</c:v>
                </c:pt>
                <c:pt idx="12267">
                  <c:v>2477.9499999999998</c:v>
                </c:pt>
                <c:pt idx="12270">
                  <c:v>2628.07</c:v>
                </c:pt>
                <c:pt idx="12273">
                  <c:v>3171.96</c:v>
                </c:pt>
                <c:pt idx="12281">
                  <c:v>4612.68</c:v>
                </c:pt>
                <c:pt idx="12282">
                  <c:v>3228.34</c:v>
                </c:pt>
                <c:pt idx="12287">
                  <c:v>4726.3</c:v>
                </c:pt>
                <c:pt idx="12291">
                  <c:v>3039.55</c:v>
                </c:pt>
                <c:pt idx="12292">
                  <c:v>2396.52</c:v>
                </c:pt>
                <c:pt idx="12302">
                  <c:v>2595.46</c:v>
                </c:pt>
                <c:pt idx="12307">
                  <c:v>1939.03</c:v>
                </c:pt>
                <c:pt idx="12310">
                  <c:v>2059.56</c:v>
                </c:pt>
                <c:pt idx="12312">
                  <c:v>3610.66</c:v>
                </c:pt>
                <c:pt idx="12316">
                  <c:v>2064.96</c:v>
                </c:pt>
                <c:pt idx="12317">
                  <c:v>3665.09</c:v>
                </c:pt>
                <c:pt idx="12322">
                  <c:v>3019.25</c:v>
                </c:pt>
                <c:pt idx="12328">
                  <c:v>3173.47</c:v>
                </c:pt>
                <c:pt idx="12331">
                  <c:v>2247.0500000000002</c:v>
                </c:pt>
                <c:pt idx="12332">
                  <c:v>2760.48</c:v>
                </c:pt>
                <c:pt idx="12347">
                  <c:v>2479.0300000000002</c:v>
                </c:pt>
                <c:pt idx="12367">
                  <c:v>2541.67</c:v>
                </c:pt>
                <c:pt idx="12378">
                  <c:v>2630.45</c:v>
                </c:pt>
                <c:pt idx="12389">
                  <c:v>3631.82</c:v>
                </c:pt>
                <c:pt idx="12392">
                  <c:v>2655.94</c:v>
                </c:pt>
                <c:pt idx="12396">
                  <c:v>2851.63</c:v>
                </c:pt>
                <c:pt idx="12401">
                  <c:v>2047.03</c:v>
                </c:pt>
                <c:pt idx="12402">
                  <c:v>4305.1000000000004</c:v>
                </c:pt>
                <c:pt idx="12411">
                  <c:v>4088.45</c:v>
                </c:pt>
                <c:pt idx="12422">
                  <c:v>2620.3000000000002</c:v>
                </c:pt>
                <c:pt idx="12426">
                  <c:v>4793.8999999999996</c:v>
                </c:pt>
                <c:pt idx="12430">
                  <c:v>2796.98</c:v>
                </c:pt>
                <c:pt idx="12439">
                  <c:v>3374.35</c:v>
                </c:pt>
                <c:pt idx="12441">
                  <c:v>1963.22</c:v>
                </c:pt>
                <c:pt idx="12443">
                  <c:v>4775.54</c:v>
                </c:pt>
                <c:pt idx="12446">
                  <c:v>3094.42</c:v>
                </c:pt>
                <c:pt idx="12451">
                  <c:v>2338.63</c:v>
                </c:pt>
                <c:pt idx="12453">
                  <c:v>2836.94</c:v>
                </c:pt>
                <c:pt idx="12455">
                  <c:v>3235.46</c:v>
                </c:pt>
                <c:pt idx="12456">
                  <c:v>3073.68</c:v>
                </c:pt>
                <c:pt idx="12457">
                  <c:v>4027.75</c:v>
                </c:pt>
                <c:pt idx="12459">
                  <c:v>3154.68</c:v>
                </c:pt>
                <c:pt idx="12467">
                  <c:v>3620.38</c:v>
                </c:pt>
                <c:pt idx="12472">
                  <c:v>2720.74</c:v>
                </c:pt>
                <c:pt idx="12473">
                  <c:v>2664.14</c:v>
                </c:pt>
                <c:pt idx="12474">
                  <c:v>3849.98</c:v>
                </c:pt>
                <c:pt idx="12475">
                  <c:v>3887.14</c:v>
                </c:pt>
                <c:pt idx="12476">
                  <c:v>2709.94</c:v>
                </c:pt>
                <c:pt idx="12478">
                  <c:v>4540.97</c:v>
                </c:pt>
                <c:pt idx="12482">
                  <c:v>4385.45</c:v>
                </c:pt>
                <c:pt idx="12487">
                  <c:v>3449.52</c:v>
                </c:pt>
                <c:pt idx="12491">
                  <c:v>5797.01</c:v>
                </c:pt>
                <c:pt idx="12492">
                  <c:v>2337.98</c:v>
                </c:pt>
                <c:pt idx="12498">
                  <c:v>2824.63</c:v>
                </c:pt>
                <c:pt idx="12506">
                  <c:v>2861.78</c:v>
                </c:pt>
                <c:pt idx="12513">
                  <c:v>4709.88</c:v>
                </c:pt>
                <c:pt idx="12522">
                  <c:v>1811.81</c:v>
                </c:pt>
                <c:pt idx="12526">
                  <c:v>3754.94</c:v>
                </c:pt>
                <c:pt idx="12530">
                  <c:v>3293.35</c:v>
                </c:pt>
                <c:pt idx="12532">
                  <c:v>4673.59</c:v>
                </c:pt>
                <c:pt idx="12537">
                  <c:v>5740.2</c:v>
                </c:pt>
                <c:pt idx="12538">
                  <c:v>5657.9</c:v>
                </c:pt>
                <c:pt idx="12545">
                  <c:v>2541.67</c:v>
                </c:pt>
                <c:pt idx="12546">
                  <c:v>2168.21</c:v>
                </c:pt>
                <c:pt idx="12549">
                  <c:v>5018.76</c:v>
                </c:pt>
                <c:pt idx="12551">
                  <c:v>3109.75</c:v>
                </c:pt>
                <c:pt idx="12555">
                  <c:v>2930.47</c:v>
                </c:pt>
                <c:pt idx="12562">
                  <c:v>2453.98</c:v>
                </c:pt>
                <c:pt idx="12570">
                  <c:v>2512.08</c:v>
                </c:pt>
                <c:pt idx="12572">
                  <c:v>5181.1899999999996</c:v>
                </c:pt>
                <c:pt idx="12574">
                  <c:v>4147.8500000000004</c:v>
                </c:pt>
                <c:pt idx="12576">
                  <c:v>3401.57</c:v>
                </c:pt>
                <c:pt idx="12579">
                  <c:v>2534.98</c:v>
                </c:pt>
                <c:pt idx="12582">
                  <c:v>3352.1</c:v>
                </c:pt>
                <c:pt idx="12591">
                  <c:v>4016.74</c:v>
                </c:pt>
                <c:pt idx="12595">
                  <c:v>2936.09</c:v>
                </c:pt>
                <c:pt idx="12598">
                  <c:v>3464.42</c:v>
                </c:pt>
                <c:pt idx="12607">
                  <c:v>5836.97</c:v>
                </c:pt>
                <c:pt idx="12609">
                  <c:v>3907.66</c:v>
                </c:pt>
                <c:pt idx="12613">
                  <c:v>4103.3500000000004</c:v>
                </c:pt>
                <c:pt idx="12618">
                  <c:v>2528.2800000000002</c:v>
                </c:pt>
                <c:pt idx="12625">
                  <c:v>2105.5700000000002</c:v>
                </c:pt>
                <c:pt idx="12626">
                  <c:v>3210.19</c:v>
                </c:pt>
                <c:pt idx="12635">
                  <c:v>3127.03</c:v>
                </c:pt>
                <c:pt idx="12639">
                  <c:v>2442.31</c:v>
                </c:pt>
                <c:pt idx="12640">
                  <c:v>2659.82</c:v>
                </c:pt>
                <c:pt idx="12645">
                  <c:v>3126.38</c:v>
                </c:pt>
                <c:pt idx="12660">
                  <c:v>2480.54</c:v>
                </c:pt>
                <c:pt idx="12661">
                  <c:v>3074.11</c:v>
                </c:pt>
                <c:pt idx="12664">
                  <c:v>2660.9</c:v>
                </c:pt>
                <c:pt idx="12668">
                  <c:v>3772.01</c:v>
                </c:pt>
                <c:pt idx="12675">
                  <c:v>1843.78</c:v>
                </c:pt>
                <c:pt idx="12681">
                  <c:v>2746.66</c:v>
                </c:pt>
                <c:pt idx="12682">
                  <c:v>4297.54</c:v>
                </c:pt>
                <c:pt idx="12693">
                  <c:v>2036.23</c:v>
                </c:pt>
                <c:pt idx="12700">
                  <c:v>2010.1</c:v>
                </c:pt>
                <c:pt idx="12703">
                  <c:v>2813.83</c:v>
                </c:pt>
                <c:pt idx="12710">
                  <c:v>3160.73</c:v>
                </c:pt>
                <c:pt idx="12712">
                  <c:v>2335.8200000000002</c:v>
                </c:pt>
                <c:pt idx="12715">
                  <c:v>7126.7</c:v>
                </c:pt>
                <c:pt idx="12719">
                  <c:v>3240</c:v>
                </c:pt>
                <c:pt idx="12721">
                  <c:v>4074.41</c:v>
                </c:pt>
                <c:pt idx="12722">
                  <c:v>4613.33</c:v>
                </c:pt>
                <c:pt idx="12729">
                  <c:v>3966.62</c:v>
                </c:pt>
                <c:pt idx="12734">
                  <c:v>8973.07</c:v>
                </c:pt>
                <c:pt idx="12741">
                  <c:v>1541.59</c:v>
                </c:pt>
                <c:pt idx="12747">
                  <c:v>2852.93</c:v>
                </c:pt>
                <c:pt idx="12763">
                  <c:v>4193.21</c:v>
                </c:pt>
                <c:pt idx="12764">
                  <c:v>3351.89</c:v>
                </c:pt>
                <c:pt idx="12770">
                  <c:v>2601.5</c:v>
                </c:pt>
                <c:pt idx="12774">
                  <c:v>2539.3000000000002</c:v>
                </c:pt>
                <c:pt idx="12781">
                  <c:v>2577.96</c:v>
                </c:pt>
                <c:pt idx="12784">
                  <c:v>5102.3500000000004</c:v>
                </c:pt>
                <c:pt idx="12787">
                  <c:v>5159.38</c:v>
                </c:pt>
                <c:pt idx="12791">
                  <c:v>2814.48</c:v>
                </c:pt>
                <c:pt idx="12806">
                  <c:v>4030.78</c:v>
                </c:pt>
                <c:pt idx="12811">
                  <c:v>5884.06</c:v>
                </c:pt>
                <c:pt idx="12814">
                  <c:v>3576.96</c:v>
                </c:pt>
                <c:pt idx="12815">
                  <c:v>5490.72</c:v>
                </c:pt>
                <c:pt idx="12818">
                  <c:v>3060.07</c:v>
                </c:pt>
                <c:pt idx="12820">
                  <c:v>4623.91</c:v>
                </c:pt>
                <c:pt idx="12824">
                  <c:v>3729.89</c:v>
                </c:pt>
                <c:pt idx="12826">
                  <c:v>3316.68</c:v>
                </c:pt>
                <c:pt idx="12827">
                  <c:v>3601.8</c:v>
                </c:pt>
                <c:pt idx="12837">
                  <c:v>657.28800000000001</c:v>
                </c:pt>
                <c:pt idx="12840">
                  <c:v>2345.11</c:v>
                </c:pt>
                <c:pt idx="12842">
                  <c:v>6504.41</c:v>
                </c:pt>
                <c:pt idx="12856">
                  <c:v>4046.33</c:v>
                </c:pt>
                <c:pt idx="12861">
                  <c:v>3508.92</c:v>
                </c:pt>
                <c:pt idx="12862">
                  <c:v>136.29599999999999</c:v>
                </c:pt>
                <c:pt idx="12868">
                  <c:v>2766.1</c:v>
                </c:pt>
                <c:pt idx="12870">
                  <c:v>2722.68</c:v>
                </c:pt>
                <c:pt idx="12874">
                  <c:v>3158.57</c:v>
                </c:pt>
                <c:pt idx="12877">
                  <c:v>3402.22</c:v>
                </c:pt>
                <c:pt idx="12879">
                  <c:v>3616.06</c:v>
                </c:pt>
                <c:pt idx="12883">
                  <c:v>3064.18</c:v>
                </c:pt>
                <c:pt idx="12884">
                  <c:v>2786.4</c:v>
                </c:pt>
                <c:pt idx="12888">
                  <c:v>4029.26</c:v>
                </c:pt>
                <c:pt idx="12892">
                  <c:v>2214.86</c:v>
                </c:pt>
                <c:pt idx="12897">
                  <c:v>2013.34</c:v>
                </c:pt>
                <c:pt idx="12899">
                  <c:v>2703.67</c:v>
                </c:pt>
                <c:pt idx="12903">
                  <c:v>3086.86</c:v>
                </c:pt>
                <c:pt idx="12910">
                  <c:v>4384.8</c:v>
                </c:pt>
                <c:pt idx="12915">
                  <c:v>4358.45</c:v>
                </c:pt>
                <c:pt idx="12920">
                  <c:v>2958.77</c:v>
                </c:pt>
                <c:pt idx="12933">
                  <c:v>1678.32</c:v>
                </c:pt>
                <c:pt idx="12934">
                  <c:v>2775.17</c:v>
                </c:pt>
                <c:pt idx="12935">
                  <c:v>3866.83</c:v>
                </c:pt>
                <c:pt idx="12936">
                  <c:v>4259.3</c:v>
                </c:pt>
                <c:pt idx="12938">
                  <c:v>3095.71</c:v>
                </c:pt>
                <c:pt idx="12942">
                  <c:v>3314.95</c:v>
                </c:pt>
                <c:pt idx="12944">
                  <c:v>3314.74</c:v>
                </c:pt>
                <c:pt idx="12948">
                  <c:v>2298.02</c:v>
                </c:pt>
                <c:pt idx="12966">
                  <c:v>3955.82</c:v>
                </c:pt>
                <c:pt idx="12969">
                  <c:v>3676.32</c:v>
                </c:pt>
                <c:pt idx="12973">
                  <c:v>5783.18</c:v>
                </c:pt>
                <c:pt idx="12975">
                  <c:v>2281.61</c:v>
                </c:pt>
                <c:pt idx="12976">
                  <c:v>3875.9</c:v>
                </c:pt>
                <c:pt idx="12980">
                  <c:v>3473.28</c:v>
                </c:pt>
                <c:pt idx="12983">
                  <c:v>3298.32</c:v>
                </c:pt>
                <c:pt idx="12987">
                  <c:v>4090.82</c:v>
                </c:pt>
                <c:pt idx="12990">
                  <c:v>3039.12</c:v>
                </c:pt>
                <c:pt idx="12993">
                  <c:v>5377.54</c:v>
                </c:pt>
                <c:pt idx="13002">
                  <c:v>5369.76</c:v>
                </c:pt>
                <c:pt idx="13005">
                  <c:v>2550.1</c:v>
                </c:pt>
                <c:pt idx="13010">
                  <c:v>6281.71</c:v>
                </c:pt>
                <c:pt idx="13012">
                  <c:v>3454.49</c:v>
                </c:pt>
                <c:pt idx="13018">
                  <c:v>6708.31</c:v>
                </c:pt>
                <c:pt idx="13020">
                  <c:v>1020.38</c:v>
                </c:pt>
                <c:pt idx="13028">
                  <c:v>4795.8500000000004</c:v>
                </c:pt>
                <c:pt idx="13029">
                  <c:v>3019.03</c:v>
                </c:pt>
                <c:pt idx="13034">
                  <c:v>4302.29</c:v>
                </c:pt>
                <c:pt idx="13035">
                  <c:v>3276.07</c:v>
                </c:pt>
                <c:pt idx="13044">
                  <c:v>3748.03</c:v>
                </c:pt>
                <c:pt idx="13048">
                  <c:v>3638.52</c:v>
                </c:pt>
                <c:pt idx="13065">
                  <c:v>4147.2</c:v>
                </c:pt>
                <c:pt idx="13087">
                  <c:v>4874.8999999999996</c:v>
                </c:pt>
                <c:pt idx="13094">
                  <c:v>2008.58</c:v>
                </c:pt>
                <c:pt idx="13095">
                  <c:v>2683.15</c:v>
                </c:pt>
                <c:pt idx="13098">
                  <c:v>3226.82</c:v>
                </c:pt>
                <c:pt idx="13099">
                  <c:v>5817.96</c:v>
                </c:pt>
                <c:pt idx="13103">
                  <c:v>3128.11</c:v>
                </c:pt>
                <c:pt idx="13113">
                  <c:v>3158.78</c:v>
                </c:pt>
                <c:pt idx="13116">
                  <c:v>3483</c:v>
                </c:pt>
                <c:pt idx="13118">
                  <c:v>3708.29</c:v>
                </c:pt>
                <c:pt idx="13130">
                  <c:v>4265.3500000000004</c:v>
                </c:pt>
                <c:pt idx="13141">
                  <c:v>2640.82</c:v>
                </c:pt>
                <c:pt idx="13142">
                  <c:v>3795.98</c:v>
                </c:pt>
                <c:pt idx="13149">
                  <c:v>7473.38</c:v>
                </c:pt>
                <c:pt idx="13151">
                  <c:v>4483.08</c:v>
                </c:pt>
                <c:pt idx="13153">
                  <c:v>3343.9</c:v>
                </c:pt>
                <c:pt idx="13163">
                  <c:v>3388.61</c:v>
                </c:pt>
                <c:pt idx="13165">
                  <c:v>6910.7</c:v>
                </c:pt>
                <c:pt idx="13172">
                  <c:v>3833.35</c:v>
                </c:pt>
                <c:pt idx="13177">
                  <c:v>5984.71</c:v>
                </c:pt>
                <c:pt idx="13180">
                  <c:v>5680.37</c:v>
                </c:pt>
                <c:pt idx="13185">
                  <c:v>2428.27</c:v>
                </c:pt>
                <c:pt idx="13187">
                  <c:v>6410.23</c:v>
                </c:pt>
                <c:pt idx="13188">
                  <c:v>3406.1</c:v>
                </c:pt>
                <c:pt idx="13196">
                  <c:v>2839.54</c:v>
                </c:pt>
                <c:pt idx="13203">
                  <c:v>4857.1899999999996</c:v>
                </c:pt>
                <c:pt idx="13212">
                  <c:v>4304.2299999999996</c:v>
                </c:pt>
                <c:pt idx="13219">
                  <c:v>5292.22</c:v>
                </c:pt>
                <c:pt idx="13229">
                  <c:v>3667.03</c:v>
                </c:pt>
                <c:pt idx="13230">
                  <c:v>2201.4699999999998</c:v>
                </c:pt>
                <c:pt idx="13231">
                  <c:v>4457.38</c:v>
                </c:pt>
                <c:pt idx="13235">
                  <c:v>4071.38</c:v>
                </c:pt>
                <c:pt idx="13236">
                  <c:v>5869.8</c:v>
                </c:pt>
                <c:pt idx="13264">
                  <c:v>2758.54</c:v>
                </c:pt>
                <c:pt idx="13268">
                  <c:v>3402.65</c:v>
                </c:pt>
                <c:pt idx="13271">
                  <c:v>3907.01</c:v>
                </c:pt>
                <c:pt idx="13276">
                  <c:v>5663.3</c:v>
                </c:pt>
                <c:pt idx="13292">
                  <c:v>4582.4399999999996</c:v>
                </c:pt>
                <c:pt idx="13293">
                  <c:v>5175.1400000000003</c:v>
                </c:pt>
                <c:pt idx="13294">
                  <c:v>4068.58</c:v>
                </c:pt>
                <c:pt idx="13296">
                  <c:v>5226.34</c:v>
                </c:pt>
                <c:pt idx="13299">
                  <c:v>4228.2</c:v>
                </c:pt>
                <c:pt idx="13301">
                  <c:v>5020.0600000000004</c:v>
                </c:pt>
                <c:pt idx="13302">
                  <c:v>2588.54</c:v>
                </c:pt>
                <c:pt idx="13303">
                  <c:v>3951.29</c:v>
                </c:pt>
                <c:pt idx="13304">
                  <c:v>3069.14</c:v>
                </c:pt>
                <c:pt idx="13319">
                  <c:v>8832.89</c:v>
                </c:pt>
                <c:pt idx="13328">
                  <c:v>3384.29</c:v>
                </c:pt>
                <c:pt idx="13334">
                  <c:v>5899.39</c:v>
                </c:pt>
                <c:pt idx="13336">
                  <c:v>7621.78</c:v>
                </c:pt>
                <c:pt idx="13339">
                  <c:v>3772.22</c:v>
                </c:pt>
                <c:pt idx="13349">
                  <c:v>4644.8599999999997</c:v>
                </c:pt>
                <c:pt idx="13350">
                  <c:v>3011.69</c:v>
                </c:pt>
                <c:pt idx="13352">
                  <c:v>3015.58</c:v>
                </c:pt>
                <c:pt idx="13354">
                  <c:v>3490.34</c:v>
                </c:pt>
                <c:pt idx="13355">
                  <c:v>7346.38</c:v>
                </c:pt>
                <c:pt idx="13364">
                  <c:v>6699.24</c:v>
                </c:pt>
                <c:pt idx="13367">
                  <c:v>3561.62</c:v>
                </c:pt>
                <c:pt idx="13381">
                  <c:v>3335.47</c:v>
                </c:pt>
                <c:pt idx="13386">
                  <c:v>3005.42</c:v>
                </c:pt>
                <c:pt idx="13388">
                  <c:v>1940.98</c:v>
                </c:pt>
                <c:pt idx="13389">
                  <c:v>6119.93</c:v>
                </c:pt>
                <c:pt idx="13401">
                  <c:v>4653.29</c:v>
                </c:pt>
                <c:pt idx="13409">
                  <c:v>4467.96</c:v>
                </c:pt>
                <c:pt idx="13410">
                  <c:v>5641.27</c:v>
                </c:pt>
                <c:pt idx="13420">
                  <c:v>3218.18</c:v>
                </c:pt>
                <c:pt idx="13422">
                  <c:v>11789.9</c:v>
                </c:pt>
                <c:pt idx="13423">
                  <c:v>4298.83</c:v>
                </c:pt>
                <c:pt idx="13440">
                  <c:v>2571.91</c:v>
                </c:pt>
                <c:pt idx="13450">
                  <c:v>4350.67</c:v>
                </c:pt>
                <c:pt idx="13452">
                  <c:v>3108.02</c:v>
                </c:pt>
                <c:pt idx="13458">
                  <c:v>1993.03</c:v>
                </c:pt>
                <c:pt idx="13460">
                  <c:v>5094.79</c:v>
                </c:pt>
                <c:pt idx="13462">
                  <c:v>6186.89</c:v>
                </c:pt>
                <c:pt idx="13465">
                  <c:v>6432.91</c:v>
                </c:pt>
                <c:pt idx="13466">
                  <c:v>3413.66</c:v>
                </c:pt>
                <c:pt idx="13467">
                  <c:v>4002.05</c:v>
                </c:pt>
                <c:pt idx="13472">
                  <c:v>4039.2</c:v>
                </c:pt>
                <c:pt idx="13476">
                  <c:v>4845.96</c:v>
                </c:pt>
                <c:pt idx="13477">
                  <c:v>3662.06</c:v>
                </c:pt>
                <c:pt idx="13482">
                  <c:v>2462.1799999999998</c:v>
                </c:pt>
                <c:pt idx="13483">
                  <c:v>6669.86</c:v>
                </c:pt>
                <c:pt idx="13489">
                  <c:v>1501.42</c:v>
                </c:pt>
                <c:pt idx="13492">
                  <c:v>876.52800000000002</c:v>
                </c:pt>
                <c:pt idx="13521">
                  <c:v>2938.68</c:v>
                </c:pt>
                <c:pt idx="13531">
                  <c:v>1698.41</c:v>
                </c:pt>
                <c:pt idx="13545">
                  <c:v>8805.24</c:v>
                </c:pt>
                <c:pt idx="13548">
                  <c:v>5170.3900000000003</c:v>
                </c:pt>
                <c:pt idx="13550">
                  <c:v>3502.01</c:v>
                </c:pt>
                <c:pt idx="13553">
                  <c:v>2829.6</c:v>
                </c:pt>
                <c:pt idx="13555">
                  <c:v>6864.05</c:v>
                </c:pt>
                <c:pt idx="13557">
                  <c:v>4766.04</c:v>
                </c:pt>
                <c:pt idx="13560">
                  <c:v>4106.38</c:v>
                </c:pt>
                <c:pt idx="13572">
                  <c:v>3270.67</c:v>
                </c:pt>
                <c:pt idx="13576">
                  <c:v>3537.22</c:v>
                </c:pt>
                <c:pt idx="13577">
                  <c:v>2225.02</c:v>
                </c:pt>
                <c:pt idx="13587">
                  <c:v>4980.3100000000004</c:v>
                </c:pt>
                <c:pt idx="13588">
                  <c:v>2885.33</c:v>
                </c:pt>
                <c:pt idx="13595">
                  <c:v>3877.85</c:v>
                </c:pt>
                <c:pt idx="13608">
                  <c:v>5532.62</c:v>
                </c:pt>
                <c:pt idx="13611">
                  <c:v>4556.3</c:v>
                </c:pt>
                <c:pt idx="13612">
                  <c:v>3974.18</c:v>
                </c:pt>
                <c:pt idx="13615">
                  <c:v>3488.4</c:v>
                </c:pt>
                <c:pt idx="13619">
                  <c:v>2964.82</c:v>
                </c:pt>
                <c:pt idx="13645">
                  <c:v>4395.6000000000004</c:v>
                </c:pt>
                <c:pt idx="13649">
                  <c:v>3733.56</c:v>
                </c:pt>
                <c:pt idx="13650">
                  <c:v>4574.66</c:v>
                </c:pt>
                <c:pt idx="13653">
                  <c:v>4064.26</c:v>
                </c:pt>
                <c:pt idx="13654">
                  <c:v>9528.6200000000008</c:v>
                </c:pt>
                <c:pt idx="13655">
                  <c:v>7195.82</c:v>
                </c:pt>
                <c:pt idx="13657">
                  <c:v>2782.94</c:v>
                </c:pt>
                <c:pt idx="13667">
                  <c:v>3507.41</c:v>
                </c:pt>
                <c:pt idx="13675">
                  <c:v>6351.7</c:v>
                </c:pt>
                <c:pt idx="13676">
                  <c:v>4381.99</c:v>
                </c:pt>
                <c:pt idx="13677">
                  <c:v>5505.19</c:v>
                </c:pt>
                <c:pt idx="13681">
                  <c:v>3929.04</c:v>
                </c:pt>
                <c:pt idx="13687">
                  <c:v>6237.22</c:v>
                </c:pt>
                <c:pt idx="13688">
                  <c:v>7130.38</c:v>
                </c:pt>
                <c:pt idx="13708">
                  <c:v>6955.2</c:v>
                </c:pt>
                <c:pt idx="13714">
                  <c:v>4479.1899999999996</c:v>
                </c:pt>
                <c:pt idx="13715">
                  <c:v>3116.45</c:v>
                </c:pt>
                <c:pt idx="13721">
                  <c:v>3044.3</c:v>
                </c:pt>
                <c:pt idx="13725">
                  <c:v>3553.2</c:v>
                </c:pt>
                <c:pt idx="13726">
                  <c:v>3487.32</c:v>
                </c:pt>
                <c:pt idx="13734">
                  <c:v>3908.95</c:v>
                </c:pt>
                <c:pt idx="13743">
                  <c:v>6736.61</c:v>
                </c:pt>
                <c:pt idx="13744">
                  <c:v>2575.15</c:v>
                </c:pt>
                <c:pt idx="13747">
                  <c:v>5357.45</c:v>
                </c:pt>
                <c:pt idx="13757">
                  <c:v>4887.8599999999997</c:v>
                </c:pt>
                <c:pt idx="13763">
                  <c:v>2539.5100000000002</c:v>
                </c:pt>
                <c:pt idx="13768">
                  <c:v>3683.02</c:v>
                </c:pt>
                <c:pt idx="13778">
                  <c:v>3316.9</c:v>
                </c:pt>
                <c:pt idx="13787">
                  <c:v>4393.01</c:v>
                </c:pt>
                <c:pt idx="13794">
                  <c:v>17007.599999999999</c:v>
                </c:pt>
                <c:pt idx="13798">
                  <c:v>3952.8</c:v>
                </c:pt>
                <c:pt idx="13799">
                  <c:v>6719.54</c:v>
                </c:pt>
                <c:pt idx="13802">
                  <c:v>5321.16</c:v>
                </c:pt>
                <c:pt idx="13806">
                  <c:v>2718.79</c:v>
                </c:pt>
                <c:pt idx="13807">
                  <c:v>5686.42</c:v>
                </c:pt>
                <c:pt idx="13809">
                  <c:v>3632.69</c:v>
                </c:pt>
                <c:pt idx="13815">
                  <c:v>2787.26</c:v>
                </c:pt>
                <c:pt idx="13821">
                  <c:v>6023.16</c:v>
                </c:pt>
                <c:pt idx="13831">
                  <c:v>3670.06</c:v>
                </c:pt>
                <c:pt idx="13834">
                  <c:v>4132.9399999999996</c:v>
                </c:pt>
                <c:pt idx="13849">
                  <c:v>3288.38</c:v>
                </c:pt>
                <c:pt idx="13855">
                  <c:v>5848.85</c:v>
                </c:pt>
                <c:pt idx="13856">
                  <c:v>6323.62</c:v>
                </c:pt>
                <c:pt idx="13860">
                  <c:v>5644.08</c:v>
                </c:pt>
                <c:pt idx="13864">
                  <c:v>3415.61</c:v>
                </c:pt>
                <c:pt idx="13870">
                  <c:v>4191.4799999999996</c:v>
                </c:pt>
                <c:pt idx="13880">
                  <c:v>8717.5400000000009</c:v>
                </c:pt>
                <c:pt idx="13885">
                  <c:v>2793.53</c:v>
                </c:pt>
                <c:pt idx="13887">
                  <c:v>3701.59</c:v>
                </c:pt>
                <c:pt idx="13888">
                  <c:v>5104.51</c:v>
                </c:pt>
                <c:pt idx="13898">
                  <c:v>4507.2700000000004</c:v>
                </c:pt>
                <c:pt idx="13900">
                  <c:v>7002.72</c:v>
                </c:pt>
                <c:pt idx="13905">
                  <c:v>4950.29</c:v>
                </c:pt>
                <c:pt idx="13908">
                  <c:v>6434.42</c:v>
                </c:pt>
                <c:pt idx="13909">
                  <c:v>4590</c:v>
                </c:pt>
                <c:pt idx="13916">
                  <c:v>4083.05</c:v>
                </c:pt>
                <c:pt idx="13918">
                  <c:v>4787.8599999999997</c:v>
                </c:pt>
                <c:pt idx="13920">
                  <c:v>5917.97</c:v>
                </c:pt>
                <c:pt idx="13922">
                  <c:v>3740.04</c:v>
                </c:pt>
                <c:pt idx="13929">
                  <c:v>5265</c:v>
                </c:pt>
                <c:pt idx="13931">
                  <c:v>3481.7</c:v>
                </c:pt>
                <c:pt idx="13935">
                  <c:v>9480.89</c:v>
                </c:pt>
                <c:pt idx="13954">
                  <c:v>7708.61</c:v>
                </c:pt>
                <c:pt idx="13964">
                  <c:v>4194.9399999999996</c:v>
                </c:pt>
                <c:pt idx="13975">
                  <c:v>2640.82</c:v>
                </c:pt>
                <c:pt idx="13984">
                  <c:v>6383.66</c:v>
                </c:pt>
                <c:pt idx="13985">
                  <c:v>6041.3</c:v>
                </c:pt>
                <c:pt idx="13991">
                  <c:v>3838.32</c:v>
                </c:pt>
                <c:pt idx="14003">
                  <c:v>8794.44</c:v>
                </c:pt>
                <c:pt idx="14010">
                  <c:v>3122.93</c:v>
                </c:pt>
                <c:pt idx="14012">
                  <c:v>7937.14</c:v>
                </c:pt>
                <c:pt idx="14014">
                  <c:v>1994.33</c:v>
                </c:pt>
                <c:pt idx="14028">
                  <c:v>5056.5600000000004</c:v>
                </c:pt>
                <c:pt idx="14029">
                  <c:v>3523.39</c:v>
                </c:pt>
                <c:pt idx="14036">
                  <c:v>4903.8500000000004</c:v>
                </c:pt>
                <c:pt idx="14040">
                  <c:v>9457.99</c:v>
                </c:pt>
                <c:pt idx="14041">
                  <c:v>11579.8</c:v>
                </c:pt>
                <c:pt idx="14047">
                  <c:v>3736.15</c:v>
                </c:pt>
                <c:pt idx="14049">
                  <c:v>6662.52</c:v>
                </c:pt>
                <c:pt idx="14052">
                  <c:v>4529.09</c:v>
                </c:pt>
                <c:pt idx="14053">
                  <c:v>7221.53</c:v>
                </c:pt>
                <c:pt idx="14054">
                  <c:v>4272.26</c:v>
                </c:pt>
                <c:pt idx="14056">
                  <c:v>4768.2</c:v>
                </c:pt>
                <c:pt idx="14057">
                  <c:v>6513.26</c:v>
                </c:pt>
                <c:pt idx="14062">
                  <c:v>1006.13</c:v>
                </c:pt>
                <c:pt idx="14063">
                  <c:v>3942.43</c:v>
                </c:pt>
                <c:pt idx="14067">
                  <c:v>4905.1400000000003</c:v>
                </c:pt>
                <c:pt idx="14072">
                  <c:v>2720.95</c:v>
                </c:pt>
                <c:pt idx="14074">
                  <c:v>4857.41</c:v>
                </c:pt>
                <c:pt idx="14077">
                  <c:v>3491.21</c:v>
                </c:pt>
                <c:pt idx="14103">
                  <c:v>4493.0200000000004</c:v>
                </c:pt>
                <c:pt idx="14116">
                  <c:v>3010.61</c:v>
                </c:pt>
                <c:pt idx="14120">
                  <c:v>6245.86</c:v>
                </c:pt>
                <c:pt idx="14126">
                  <c:v>5440.39</c:v>
                </c:pt>
                <c:pt idx="14131">
                  <c:v>6314.98</c:v>
                </c:pt>
                <c:pt idx="14132">
                  <c:v>5378.18</c:v>
                </c:pt>
                <c:pt idx="14134">
                  <c:v>1484.78</c:v>
                </c:pt>
                <c:pt idx="14135">
                  <c:v>3803.11</c:v>
                </c:pt>
                <c:pt idx="14137">
                  <c:v>5677.99</c:v>
                </c:pt>
                <c:pt idx="14141">
                  <c:v>4699.08</c:v>
                </c:pt>
                <c:pt idx="14152">
                  <c:v>4986.3599999999997</c:v>
                </c:pt>
                <c:pt idx="14164">
                  <c:v>5599.37</c:v>
                </c:pt>
                <c:pt idx="14168">
                  <c:v>4405.32</c:v>
                </c:pt>
                <c:pt idx="14171">
                  <c:v>2580.5500000000002</c:v>
                </c:pt>
                <c:pt idx="14174">
                  <c:v>5071.46</c:v>
                </c:pt>
                <c:pt idx="14179">
                  <c:v>3125.95</c:v>
                </c:pt>
                <c:pt idx="14184">
                  <c:v>6663.38</c:v>
                </c:pt>
                <c:pt idx="14187">
                  <c:v>5449.46</c:v>
                </c:pt>
                <c:pt idx="14205">
                  <c:v>6318.86</c:v>
                </c:pt>
                <c:pt idx="14208">
                  <c:v>3577.18</c:v>
                </c:pt>
                <c:pt idx="14213">
                  <c:v>4109.83</c:v>
                </c:pt>
                <c:pt idx="14217">
                  <c:v>7422.62</c:v>
                </c:pt>
                <c:pt idx="14222">
                  <c:v>7159.97</c:v>
                </c:pt>
                <c:pt idx="14235">
                  <c:v>8966.59</c:v>
                </c:pt>
                <c:pt idx="14239">
                  <c:v>3977.64</c:v>
                </c:pt>
                <c:pt idx="14254">
                  <c:v>6469.2</c:v>
                </c:pt>
                <c:pt idx="14263">
                  <c:v>4846.3900000000003</c:v>
                </c:pt>
                <c:pt idx="14287">
                  <c:v>4494.1000000000004</c:v>
                </c:pt>
                <c:pt idx="14291">
                  <c:v>7164.94</c:v>
                </c:pt>
                <c:pt idx="14294">
                  <c:v>6032.45</c:v>
                </c:pt>
                <c:pt idx="14298">
                  <c:v>7523.5</c:v>
                </c:pt>
                <c:pt idx="14302">
                  <c:v>3311.71</c:v>
                </c:pt>
                <c:pt idx="14303">
                  <c:v>6701.83</c:v>
                </c:pt>
                <c:pt idx="14307">
                  <c:v>3781.51</c:v>
                </c:pt>
                <c:pt idx="14310">
                  <c:v>3937.46</c:v>
                </c:pt>
                <c:pt idx="14311">
                  <c:v>3629.45</c:v>
                </c:pt>
                <c:pt idx="14316">
                  <c:v>3130.06</c:v>
                </c:pt>
                <c:pt idx="14318">
                  <c:v>3681.07</c:v>
                </c:pt>
                <c:pt idx="14320">
                  <c:v>4580.71</c:v>
                </c:pt>
                <c:pt idx="14323">
                  <c:v>9798.41</c:v>
                </c:pt>
                <c:pt idx="14331">
                  <c:v>9734.26</c:v>
                </c:pt>
                <c:pt idx="14334">
                  <c:v>16306.1</c:v>
                </c:pt>
                <c:pt idx="14335">
                  <c:v>3447.36</c:v>
                </c:pt>
                <c:pt idx="14336">
                  <c:v>2522.88</c:v>
                </c:pt>
                <c:pt idx="14345">
                  <c:v>5564.59</c:v>
                </c:pt>
                <c:pt idx="14351">
                  <c:v>6271.56</c:v>
                </c:pt>
                <c:pt idx="14354">
                  <c:v>5476.9</c:v>
                </c:pt>
                <c:pt idx="14360">
                  <c:v>4949.8599999999997</c:v>
                </c:pt>
                <c:pt idx="14364">
                  <c:v>3351.89</c:v>
                </c:pt>
                <c:pt idx="14366">
                  <c:v>4861.3</c:v>
                </c:pt>
                <c:pt idx="14369">
                  <c:v>5592.67</c:v>
                </c:pt>
                <c:pt idx="14393">
                  <c:v>7634.52</c:v>
                </c:pt>
                <c:pt idx="14394">
                  <c:v>5138.42</c:v>
                </c:pt>
                <c:pt idx="14397">
                  <c:v>7493.9</c:v>
                </c:pt>
                <c:pt idx="14398">
                  <c:v>6455.38</c:v>
                </c:pt>
                <c:pt idx="14402">
                  <c:v>7001.86</c:v>
                </c:pt>
                <c:pt idx="14403">
                  <c:v>4178.3</c:v>
                </c:pt>
                <c:pt idx="14409">
                  <c:v>5372.57</c:v>
                </c:pt>
                <c:pt idx="14410">
                  <c:v>4566.8900000000003</c:v>
                </c:pt>
                <c:pt idx="14411">
                  <c:v>4389.12</c:v>
                </c:pt>
                <c:pt idx="14414">
                  <c:v>8529.41</c:v>
                </c:pt>
                <c:pt idx="14415">
                  <c:v>4977.5</c:v>
                </c:pt>
                <c:pt idx="14429">
                  <c:v>5107.97</c:v>
                </c:pt>
                <c:pt idx="14432">
                  <c:v>4548.1000000000004</c:v>
                </c:pt>
                <c:pt idx="14437">
                  <c:v>6826.46</c:v>
                </c:pt>
                <c:pt idx="14440">
                  <c:v>5862.46</c:v>
                </c:pt>
                <c:pt idx="14441">
                  <c:v>8734.18</c:v>
                </c:pt>
                <c:pt idx="14461">
                  <c:v>6023.16</c:v>
                </c:pt>
                <c:pt idx="14465">
                  <c:v>7781.62</c:v>
                </c:pt>
                <c:pt idx="14470">
                  <c:v>6450.62</c:v>
                </c:pt>
                <c:pt idx="14487">
                  <c:v>5327.64</c:v>
                </c:pt>
                <c:pt idx="14504">
                  <c:v>3497.9</c:v>
                </c:pt>
                <c:pt idx="14508">
                  <c:v>5630.9</c:v>
                </c:pt>
                <c:pt idx="14512">
                  <c:v>3782.81</c:v>
                </c:pt>
                <c:pt idx="14515">
                  <c:v>9745.27</c:v>
                </c:pt>
                <c:pt idx="14517">
                  <c:v>4411.37</c:v>
                </c:pt>
                <c:pt idx="14520">
                  <c:v>8140.82</c:v>
                </c:pt>
                <c:pt idx="14523">
                  <c:v>5869.15</c:v>
                </c:pt>
                <c:pt idx="14528">
                  <c:v>4307.26</c:v>
                </c:pt>
                <c:pt idx="14537">
                  <c:v>5367.6</c:v>
                </c:pt>
                <c:pt idx="14546">
                  <c:v>8488.7999999999993</c:v>
                </c:pt>
                <c:pt idx="14548">
                  <c:v>10224.799999999999</c:v>
                </c:pt>
                <c:pt idx="14551">
                  <c:v>4671.6499999999996</c:v>
                </c:pt>
                <c:pt idx="14553">
                  <c:v>14231.6</c:v>
                </c:pt>
                <c:pt idx="14562">
                  <c:v>5298.7</c:v>
                </c:pt>
                <c:pt idx="14563">
                  <c:v>4456.9399999999996</c:v>
                </c:pt>
                <c:pt idx="14566">
                  <c:v>4065.55</c:v>
                </c:pt>
                <c:pt idx="14570">
                  <c:v>6148.01</c:v>
                </c:pt>
                <c:pt idx="14580">
                  <c:v>5028.26</c:v>
                </c:pt>
                <c:pt idx="14583">
                  <c:v>5737.18</c:v>
                </c:pt>
                <c:pt idx="14590">
                  <c:v>6899.47</c:v>
                </c:pt>
                <c:pt idx="14610">
                  <c:v>3238.7</c:v>
                </c:pt>
                <c:pt idx="14612">
                  <c:v>4391.28</c:v>
                </c:pt>
                <c:pt idx="14614">
                  <c:v>9405.07</c:v>
                </c:pt>
                <c:pt idx="14619">
                  <c:v>10039.5</c:v>
                </c:pt>
                <c:pt idx="14628">
                  <c:v>3640.25</c:v>
                </c:pt>
                <c:pt idx="14641">
                  <c:v>3791.45</c:v>
                </c:pt>
                <c:pt idx="14646">
                  <c:v>8380.3700000000008</c:v>
                </c:pt>
                <c:pt idx="14647">
                  <c:v>5501.52</c:v>
                </c:pt>
                <c:pt idx="14650">
                  <c:v>6473.3</c:v>
                </c:pt>
                <c:pt idx="14653">
                  <c:v>8192.02</c:v>
                </c:pt>
                <c:pt idx="14658">
                  <c:v>3927.74</c:v>
                </c:pt>
                <c:pt idx="14661">
                  <c:v>5437.15</c:v>
                </c:pt>
                <c:pt idx="14663">
                  <c:v>11067.2</c:v>
                </c:pt>
                <c:pt idx="14665">
                  <c:v>7557.41</c:v>
                </c:pt>
                <c:pt idx="14674">
                  <c:v>4680.72</c:v>
                </c:pt>
                <c:pt idx="14679">
                  <c:v>11690.4</c:v>
                </c:pt>
                <c:pt idx="14684">
                  <c:v>17174.2</c:v>
                </c:pt>
                <c:pt idx="14688">
                  <c:v>6066.58</c:v>
                </c:pt>
                <c:pt idx="14689">
                  <c:v>6907.03</c:v>
                </c:pt>
                <c:pt idx="14694">
                  <c:v>3992.11</c:v>
                </c:pt>
                <c:pt idx="14696">
                  <c:v>4483.51</c:v>
                </c:pt>
                <c:pt idx="14699">
                  <c:v>7968.46</c:v>
                </c:pt>
                <c:pt idx="14703">
                  <c:v>6456.02</c:v>
                </c:pt>
                <c:pt idx="14710">
                  <c:v>5955.12</c:v>
                </c:pt>
                <c:pt idx="14711">
                  <c:v>4421.5200000000004</c:v>
                </c:pt>
                <c:pt idx="14712">
                  <c:v>7874.5</c:v>
                </c:pt>
                <c:pt idx="14715">
                  <c:v>5719.46</c:v>
                </c:pt>
                <c:pt idx="14720">
                  <c:v>4417.63</c:v>
                </c:pt>
                <c:pt idx="14730">
                  <c:v>8616.02</c:v>
                </c:pt>
                <c:pt idx="14741">
                  <c:v>4871.88</c:v>
                </c:pt>
                <c:pt idx="14744">
                  <c:v>7329.31</c:v>
                </c:pt>
                <c:pt idx="14756">
                  <c:v>6464.45</c:v>
                </c:pt>
                <c:pt idx="14757">
                  <c:v>6397.27</c:v>
                </c:pt>
                <c:pt idx="14758">
                  <c:v>8028.5</c:v>
                </c:pt>
                <c:pt idx="14764">
                  <c:v>4588.2700000000004</c:v>
                </c:pt>
                <c:pt idx="14768">
                  <c:v>4363.2</c:v>
                </c:pt>
                <c:pt idx="14783">
                  <c:v>5919.05</c:v>
                </c:pt>
                <c:pt idx="14786">
                  <c:v>8164.15</c:v>
                </c:pt>
                <c:pt idx="14787">
                  <c:v>5265</c:v>
                </c:pt>
                <c:pt idx="14801">
                  <c:v>5022.6499999999996</c:v>
                </c:pt>
                <c:pt idx="14809">
                  <c:v>5891.18</c:v>
                </c:pt>
                <c:pt idx="14817">
                  <c:v>2756.81</c:v>
                </c:pt>
                <c:pt idx="14825">
                  <c:v>8488.15</c:v>
                </c:pt>
                <c:pt idx="14826">
                  <c:v>6637.9</c:v>
                </c:pt>
                <c:pt idx="14831">
                  <c:v>5293.51</c:v>
                </c:pt>
                <c:pt idx="14832">
                  <c:v>10775.4</c:v>
                </c:pt>
                <c:pt idx="14843">
                  <c:v>7361.93</c:v>
                </c:pt>
                <c:pt idx="14845">
                  <c:v>5992.49</c:v>
                </c:pt>
                <c:pt idx="14855">
                  <c:v>9344.3799999999992</c:v>
                </c:pt>
                <c:pt idx="14862">
                  <c:v>10978.2</c:v>
                </c:pt>
                <c:pt idx="14869">
                  <c:v>4719.17</c:v>
                </c:pt>
                <c:pt idx="14878">
                  <c:v>7447.03</c:v>
                </c:pt>
                <c:pt idx="14882">
                  <c:v>10455</c:v>
                </c:pt>
                <c:pt idx="14891">
                  <c:v>6482.16</c:v>
                </c:pt>
                <c:pt idx="14898">
                  <c:v>7740.58</c:v>
                </c:pt>
                <c:pt idx="14902">
                  <c:v>4097.74</c:v>
                </c:pt>
                <c:pt idx="14910">
                  <c:v>7087.61</c:v>
                </c:pt>
                <c:pt idx="14914">
                  <c:v>4156.92</c:v>
                </c:pt>
                <c:pt idx="14915">
                  <c:v>6357.74</c:v>
                </c:pt>
                <c:pt idx="14929">
                  <c:v>6315.62</c:v>
                </c:pt>
                <c:pt idx="14930">
                  <c:v>6816.31</c:v>
                </c:pt>
                <c:pt idx="14935">
                  <c:v>4611.38</c:v>
                </c:pt>
                <c:pt idx="14937">
                  <c:v>7105.1</c:v>
                </c:pt>
                <c:pt idx="14939">
                  <c:v>8071.06</c:v>
                </c:pt>
                <c:pt idx="14943">
                  <c:v>8899.6299999999992</c:v>
                </c:pt>
                <c:pt idx="14947">
                  <c:v>5780.16</c:v>
                </c:pt>
                <c:pt idx="14956">
                  <c:v>4950.72</c:v>
                </c:pt>
                <c:pt idx="14959">
                  <c:v>5273.64</c:v>
                </c:pt>
                <c:pt idx="14964">
                  <c:v>12471.2</c:v>
                </c:pt>
                <c:pt idx="14965">
                  <c:v>5109.7</c:v>
                </c:pt>
                <c:pt idx="14973">
                  <c:v>6654.1</c:v>
                </c:pt>
                <c:pt idx="14983">
                  <c:v>5525.5</c:v>
                </c:pt>
                <c:pt idx="14987">
                  <c:v>5635.44</c:v>
                </c:pt>
                <c:pt idx="14991">
                  <c:v>11871.8</c:v>
                </c:pt>
                <c:pt idx="14993">
                  <c:v>10956</c:v>
                </c:pt>
                <c:pt idx="14996">
                  <c:v>4926.1000000000004</c:v>
                </c:pt>
                <c:pt idx="15001">
                  <c:v>6030.29</c:v>
                </c:pt>
                <c:pt idx="15004">
                  <c:v>5825.3</c:v>
                </c:pt>
                <c:pt idx="15009">
                  <c:v>11358.8</c:v>
                </c:pt>
                <c:pt idx="15013">
                  <c:v>12395.8</c:v>
                </c:pt>
                <c:pt idx="15015">
                  <c:v>8434.15</c:v>
                </c:pt>
                <c:pt idx="15016">
                  <c:v>5529.38</c:v>
                </c:pt>
                <c:pt idx="15017">
                  <c:v>6036.34</c:v>
                </c:pt>
                <c:pt idx="15021">
                  <c:v>6915.67</c:v>
                </c:pt>
                <c:pt idx="15029">
                  <c:v>8426.59</c:v>
                </c:pt>
                <c:pt idx="15031">
                  <c:v>5856.84</c:v>
                </c:pt>
                <c:pt idx="15050">
                  <c:v>3707.21</c:v>
                </c:pt>
                <c:pt idx="15056">
                  <c:v>4589.57</c:v>
                </c:pt>
                <c:pt idx="15058">
                  <c:v>6173.71</c:v>
                </c:pt>
                <c:pt idx="15064">
                  <c:v>8081.64</c:v>
                </c:pt>
                <c:pt idx="15070">
                  <c:v>5152.68</c:v>
                </c:pt>
                <c:pt idx="15076">
                  <c:v>10026.9</c:v>
                </c:pt>
                <c:pt idx="15078">
                  <c:v>8816.69</c:v>
                </c:pt>
                <c:pt idx="15091">
                  <c:v>8495.06</c:v>
                </c:pt>
                <c:pt idx="15097">
                  <c:v>8883</c:v>
                </c:pt>
                <c:pt idx="15103">
                  <c:v>8148.17</c:v>
                </c:pt>
                <c:pt idx="15110">
                  <c:v>9546.5499999999993</c:v>
                </c:pt>
                <c:pt idx="15113">
                  <c:v>10198.9</c:v>
                </c:pt>
                <c:pt idx="15126">
                  <c:v>4919.62</c:v>
                </c:pt>
                <c:pt idx="15138">
                  <c:v>8022.24</c:v>
                </c:pt>
                <c:pt idx="15145">
                  <c:v>7533.43</c:v>
                </c:pt>
                <c:pt idx="15153">
                  <c:v>6726.02</c:v>
                </c:pt>
                <c:pt idx="15161">
                  <c:v>13969.4</c:v>
                </c:pt>
                <c:pt idx="15162">
                  <c:v>7387.42</c:v>
                </c:pt>
                <c:pt idx="15169">
                  <c:v>6286.46</c:v>
                </c:pt>
                <c:pt idx="15173">
                  <c:v>6132.24</c:v>
                </c:pt>
                <c:pt idx="15177">
                  <c:v>6404.62</c:v>
                </c:pt>
                <c:pt idx="15181">
                  <c:v>4108.1000000000004</c:v>
                </c:pt>
                <c:pt idx="15182">
                  <c:v>7717.03</c:v>
                </c:pt>
                <c:pt idx="15183">
                  <c:v>7859.59</c:v>
                </c:pt>
                <c:pt idx="15188">
                  <c:v>5592.89</c:v>
                </c:pt>
                <c:pt idx="15196">
                  <c:v>7293.46</c:v>
                </c:pt>
                <c:pt idx="15198">
                  <c:v>9122.11</c:v>
                </c:pt>
                <c:pt idx="15201">
                  <c:v>9457.99</c:v>
                </c:pt>
                <c:pt idx="15216">
                  <c:v>6474.6</c:v>
                </c:pt>
                <c:pt idx="15221">
                  <c:v>6359.04</c:v>
                </c:pt>
                <c:pt idx="15223">
                  <c:v>4299.91</c:v>
                </c:pt>
                <c:pt idx="15224">
                  <c:v>9241.7800000000007</c:v>
                </c:pt>
                <c:pt idx="15226">
                  <c:v>7770.6</c:v>
                </c:pt>
                <c:pt idx="15228">
                  <c:v>5916.24</c:v>
                </c:pt>
                <c:pt idx="15231">
                  <c:v>6244.34</c:v>
                </c:pt>
                <c:pt idx="15232">
                  <c:v>6509.59</c:v>
                </c:pt>
                <c:pt idx="15233">
                  <c:v>7746.41</c:v>
                </c:pt>
                <c:pt idx="15236">
                  <c:v>9234.43</c:v>
                </c:pt>
                <c:pt idx="15239">
                  <c:v>11374.6</c:v>
                </c:pt>
                <c:pt idx="15244">
                  <c:v>8159.83</c:v>
                </c:pt>
                <c:pt idx="15268">
                  <c:v>6435.07</c:v>
                </c:pt>
                <c:pt idx="15277">
                  <c:v>16704.099999999999</c:v>
                </c:pt>
                <c:pt idx="15280">
                  <c:v>11022.7</c:v>
                </c:pt>
                <c:pt idx="15281">
                  <c:v>5584.46</c:v>
                </c:pt>
                <c:pt idx="15285">
                  <c:v>13538.2</c:v>
                </c:pt>
                <c:pt idx="15289">
                  <c:v>10533.2</c:v>
                </c:pt>
                <c:pt idx="15291">
                  <c:v>5050.3</c:v>
                </c:pt>
                <c:pt idx="15299">
                  <c:v>12169</c:v>
                </c:pt>
                <c:pt idx="15304">
                  <c:v>7240.75</c:v>
                </c:pt>
                <c:pt idx="15306">
                  <c:v>8524.01</c:v>
                </c:pt>
                <c:pt idx="15311">
                  <c:v>5247.29</c:v>
                </c:pt>
                <c:pt idx="15314">
                  <c:v>9070.06</c:v>
                </c:pt>
                <c:pt idx="15323">
                  <c:v>5429.38</c:v>
                </c:pt>
                <c:pt idx="15324">
                  <c:v>9795.17</c:v>
                </c:pt>
                <c:pt idx="15338">
                  <c:v>7881.41</c:v>
                </c:pt>
                <c:pt idx="15339">
                  <c:v>6302.88</c:v>
                </c:pt>
                <c:pt idx="15342">
                  <c:v>8584.7000000000007</c:v>
                </c:pt>
                <c:pt idx="15346">
                  <c:v>6295.32</c:v>
                </c:pt>
                <c:pt idx="15349">
                  <c:v>7060.18</c:v>
                </c:pt>
                <c:pt idx="15371">
                  <c:v>2166.0500000000002</c:v>
                </c:pt>
                <c:pt idx="15373">
                  <c:v>6902.28</c:v>
                </c:pt>
                <c:pt idx="15395">
                  <c:v>12302.1</c:v>
                </c:pt>
                <c:pt idx="15398">
                  <c:v>12339.6</c:v>
                </c:pt>
                <c:pt idx="15400">
                  <c:v>3452.76</c:v>
                </c:pt>
                <c:pt idx="15405">
                  <c:v>4718.09</c:v>
                </c:pt>
                <c:pt idx="15412">
                  <c:v>11412.1</c:v>
                </c:pt>
                <c:pt idx="15413">
                  <c:v>8746.7000000000007</c:v>
                </c:pt>
                <c:pt idx="15414">
                  <c:v>6451.06</c:v>
                </c:pt>
                <c:pt idx="15419">
                  <c:v>9226.8700000000008</c:v>
                </c:pt>
                <c:pt idx="15421">
                  <c:v>5669.35</c:v>
                </c:pt>
                <c:pt idx="15433">
                  <c:v>7064.93</c:v>
                </c:pt>
                <c:pt idx="15438">
                  <c:v>8718.19</c:v>
                </c:pt>
                <c:pt idx="15448">
                  <c:v>10123.1</c:v>
                </c:pt>
                <c:pt idx="15450">
                  <c:v>8579.9500000000007</c:v>
                </c:pt>
                <c:pt idx="15452">
                  <c:v>3780.43</c:v>
                </c:pt>
                <c:pt idx="15457">
                  <c:v>8633.2999999999993</c:v>
                </c:pt>
                <c:pt idx="15458">
                  <c:v>7413.12</c:v>
                </c:pt>
                <c:pt idx="15459">
                  <c:v>8617.32</c:v>
                </c:pt>
                <c:pt idx="15463">
                  <c:v>6496.2</c:v>
                </c:pt>
                <c:pt idx="15466">
                  <c:v>10173</c:v>
                </c:pt>
                <c:pt idx="15467">
                  <c:v>9099</c:v>
                </c:pt>
                <c:pt idx="15474">
                  <c:v>3117.1</c:v>
                </c:pt>
                <c:pt idx="15492">
                  <c:v>9476.57</c:v>
                </c:pt>
                <c:pt idx="15498">
                  <c:v>11445.4</c:v>
                </c:pt>
                <c:pt idx="15504">
                  <c:v>7865.64</c:v>
                </c:pt>
                <c:pt idx="15514">
                  <c:v>8278.6299999999992</c:v>
                </c:pt>
                <c:pt idx="15515">
                  <c:v>4915.9399999999996</c:v>
                </c:pt>
                <c:pt idx="15521">
                  <c:v>9785.66</c:v>
                </c:pt>
                <c:pt idx="15525">
                  <c:v>7010.28</c:v>
                </c:pt>
                <c:pt idx="15527">
                  <c:v>7208.57</c:v>
                </c:pt>
                <c:pt idx="15530">
                  <c:v>5707.37</c:v>
                </c:pt>
                <c:pt idx="15532">
                  <c:v>9658.44</c:v>
                </c:pt>
                <c:pt idx="15536">
                  <c:v>6507.65</c:v>
                </c:pt>
                <c:pt idx="15542">
                  <c:v>2870.21</c:v>
                </c:pt>
                <c:pt idx="15543">
                  <c:v>8730.07</c:v>
                </c:pt>
                <c:pt idx="15545">
                  <c:v>11691.9</c:v>
                </c:pt>
                <c:pt idx="15551">
                  <c:v>7544.02</c:v>
                </c:pt>
                <c:pt idx="15552">
                  <c:v>13391.4</c:v>
                </c:pt>
                <c:pt idx="15562">
                  <c:v>7082.42</c:v>
                </c:pt>
                <c:pt idx="15569">
                  <c:v>6745.25</c:v>
                </c:pt>
                <c:pt idx="15573">
                  <c:v>9156.4599999999991</c:v>
                </c:pt>
                <c:pt idx="15588">
                  <c:v>6575.47</c:v>
                </c:pt>
                <c:pt idx="15591">
                  <c:v>7246.58</c:v>
                </c:pt>
                <c:pt idx="15592">
                  <c:v>18420</c:v>
                </c:pt>
                <c:pt idx="15594">
                  <c:v>15897.2</c:v>
                </c:pt>
                <c:pt idx="15597">
                  <c:v>9098.7800000000007</c:v>
                </c:pt>
                <c:pt idx="15608">
                  <c:v>12188.4</c:v>
                </c:pt>
                <c:pt idx="15619">
                  <c:v>2516.1799999999998</c:v>
                </c:pt>
                <c:pt idx="15625">
                  <c:v>9156.89</c:v>
                </c:pt>
                <c:pt idx="15629">
                  <c:v>6522.98</c:v>
                </c:pt>
                <c:pt idx="15632">
                  <c:v>9126.86</c:v>
                </c:pt>
                <c:pt idx="15634">
                  <c:v>10177.700000000001</c:v>
                </c:pt>
                <c:pt idx="15636">
                  <c:v>10050.9</c:v>
                </c:pt>
                <c:pt idx="15641">
                  <c:v>12230.1</c:v>
                </c:pt>
                <c:pt idx="15652">
                  <c:v>5616.43</c:v>
                </c:pt>
                <c:pt idx="15659">
                  <c:v>6790.18</c:v>
                </c:pt>
                <c:pt idx="15667">
                  <c:v>6907.46</c:v>
                </c:pt>
                <c:pt idx="15673">
                  <c:v>11651.5</c:v>
                </c:pt>
                <c:pt idx="15676">
                  <c:v>5997.46</c:v>
                </c:pt>
                <c:pt idx="15677">
                  <c:v>7807.75</c:v>
                </c:pt>
                <c:pt idx="15684">
                  <c:v>9985.0300000000007</c:v>
                </c:pt>
                <c:pt idx="15687">
                  <c:v>6355.15</c:v>
                </c:pt>
                <c:pt idx="15691">
                  <c:v>13435.4</c:v>
                </c:pt>
                <c:pt idx="15701">
                  <c:v>9603.58</c:v>
                </c:pt>
                <c:pt idx="15705">
                  <c:v>9037.8700000000008</c:v>
                </c:pt>
                <c:pt idx="15706">
                  <c:v>7707.53</c:v>
                </c:pt>
                <c:pt idx="15707">
                  <c:v>6200.93</c:v>
                </c:pt>
                <c:pt idx="15708">
                  <c:v>7387.2</c:v>
                </c:pt>
                <c:pt idx="15726">
                  <c:v>9183.4599999999991</c:v>
                </c:pt>
                <c:pt idx="15728">
                  <c:v>6370.49</c:v>
                </c:pt>
                <c:pt idx="15738">
                  <c:v>10399.1</c:v>
                </c:pt>
                <c:pt idx="15743">
                  <c:v>5910.84</c:v>
                </c:pt>
                <c:pt idx="15748">
                  <c:v>8285.33</c:v>
                </c:pt>
                <c:pt idx="15755">
                  <c:v>4366.22</c:v>
                </c:pt>
                <c:pt idx="15759">
                  <c:v>12939.7</c:v>
                </c:pt>
                <c:pt idx="15761">
                  <c:v>12131</c:v>
                </c:pt>
                <c:pt idx="15764">
                  <c:v>8133.48</c:v>
                </c:pt>
                <c:pt idx="15765">
                  <c:v>12891.3</c:v>
                </c:pt>
                <c:pt idx="15766">
                  <c:v>5037.34</c:v>
                </c:pt>
                <c:pt idx="15771">
                  <c:v>3585.6</c:v>
                </c:pt>
                <c:pt idx="15775">
                  <c:v>11046.5</c:v>
                </c:pt>
                <c:pt idx="15791">
                  <c:v>11433.7</c:v>
                </c:pt>
                <c:pt idx="15793">
                  <c:v>5474.95</c:v>
                </c:pt>
                <c:pt idx="15795">
                  <c:v>5838.05</c:v>
                </c:pt>
                <c:pt idx="15796">
                  <c:v>5968.08</c:v>
                </c:pt>
                <c:pt idx="15800">
                  <c:v>10197.799999999999</c:v>
                </c:pt>
                <c:pt idx="15802">
                  <c:v>9262.08</c:v>
                </c:pt>
                <c:pt idx="15804">
                  <c:v>8250.1200000000008</c:v>
                </c:pt>
                <c:pt idx="15814">
                  <c:v>3971.81</c:v>
                </c:pt>
                <c:pt idx="15817">
                  <c:v>15163.2</c:v>
                </c:pt>
                <c:pt idx="15818">
                  <c:v>4592.38</c:v>
                </c:pt>
                <c:pt idx="15819">
                  <c:v>8842.39</c:v>
                </c:pt>
                <c:pt idx="15821">
                  <c:v>8161.78</c:v>
                </c:pt>
                <c:pt idx="15827">
                  <c:v>9672.48</c:v>
                </c:pt>
                <c:pt idx="15832">
                  <c:v>10458.9</c:v>
                </c:pt>
                <c:pt idx="15837">
                  <c:v>7806.24</c:v>
                </c:pt>
                <c:pt idx="15839">
                  <c:v>13803.5</c:v>
                </c:pt>
                <c:pt idx="15841">
                  <c:v>10924.6</c:v>
                </c:pt>
                <c:pt idx="15844">
                  <c:v>6301.58</c:v>
                </c:pt>
                <c:pt idx="15860">
                  <c:v>7885.08</c:v>
                </c:pt>
                <c:pt idx="15861">
                  <c:v>7918.56</c:v>
                </c:pt>
                <c:pt idx="15868">
                  <c:v>10782.7</c:v>
                </c:pt>
                <c:pt idx="15873">
                  <c:v>7188.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6B8-4AC3-B3A4-179EA235EF24}"/>
            </c:ext>
          </c:extLst>
        </c:ser>
        <c:ser>
          <c:idx val="3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>
                  <a:alpha val="70000"/>
                </a:srgbClr>
              </a:solidFill>
              <a:ln w="9525">
                <a:noFill/>
              </a:ln>
              <a:effectLst/>
            </c:spPr>
          </c:marker>
          <c:yVal>
            <c:numRef>
              <c:f>'full root volumes'!$D$1:$D$15874</c:f>
              <c:numCache>
                <c:formatCode>General</c:formatCode>
                <c:ptCount val="15874"/>
                <c:pt idx="0">
                  <c:v>0</c:v>
                </c:pt>
                <c:pt idx="4">
                  <c:v>1478.52</c:v>
                </c:pt>
                <c:pt idx="7">
                  <c:v>697.68</c:v>
                </c:pt>
                <c:pt idx="8">
                  <c:v>577.15200000000004</c:v>
                </c:pt>
                <c:pt idx="14">
                  <c:v>1426.68</c:v>
                </c:pt>
                <c:pt idx="19">
                  <c:v>1010.66</c:v>
                </c:pt>
                <c:pt idx="45">
                  <c:v>1350.22</c:v>
                </c:pt>
                <c:pt idx="48">
                  <c:v>1009.8</c:v>
                </c:pt>
                <c:pt idx="57">
                  <c:v>1195.99</c:v>
                </c:pt>
                <c:pt idx="63">
                  <c:v>1042.2</c:v>
                </c:pt>
                <c:pt idx="64">
                  <c:v>1117.1500000000001</c:v>
                </c:pt>
                <c:pt idx="68">
                  <c:v>1245.8900000000001</c:v>
                </c:pt>
                <c:pt idx="80">
                  <c:v>752.32799999999997</c:v>
                </c:pt>
                <c:pt idx="126">
                  <c:v>1878.34</c:v>
                </c:pt>
                <c:pt idx="130">
                  <c:v>1227.0999999999999</c:v>
                </c:pt>
                <c:pt idx="134">
                  <c:v>822.096</c:v>
                </c:pt>
                <c:pt idx="136">
                  <c:v>709.34400000000005</c:v>
                </c:pt>
                <c:pt idx="139">
                  <c:v>4723.7</c:v>
                </c:pt>
                <c:pt idx="161">
                  <c:v>1520.42</c:v>
                </c:pt>
                <c:pt idx="175">
                  <c:v>2542.3200000000002</c:v>
                </c:pt>
                <c:pt idx="184">
                  <c:v>1413.94</c:v>
                </c:pt>
                <c:pt idx="206">
                  <c:v>1512.43</c:v>
                </c:pt>
                <c:pt idx="207">
                  <c:v>1535.98</c:v>
                </c:pt>
                <c:pt idx="210">
                  <c:v>1164.8900000000001</c:v>
                </c:pt>
                <c:pt idx="215">
                  <c:v>962.06399999999996</c:v>
                </c:pt>
                <c:pt idx="223">
                  <c:v>2354.62</c:v>
                </c:pt>
                <c:pt idx="227">
                  <c:v>1408.32</c:v>
                </c:pt>
                <c:pt idx="229">
                  <c:v>2337.5500000000002</c:v>
                </c:pt>
                <c:pt idx="233">
                  <c:v>1301.83</c:v>
                </c:pt>
                <c:pt idx="236">
                  <c:v>1155.3800000000001</c:v>
                </c:pt>
                <c:pt idx="241">
                  <c:v>1399.25</c:v>
                </c:pt>
                <c:pt idx="260">
                  <c:v>1568.16</c:v>
                </c:pt>
                <c:pt idx="263">
                  <c:v>1251.07</c:v>
                </c:pt>
                <c:pt idx="270">
                  <c:v>2986.2</c:v>
                </c:pt>
                <c:pt idx="296">
                  <c:v>844.99199999999996</c:v>
                </c:pt>
                <c:pt idx="301">
                  <c:v>1501.63</c:v>
                </c:pt>
                <c:pt idx="302">
                  <c:v>1991.3</c:v>
                </c:pt>
                <c:pt idx="306">
                  <c:v>1291.03</c:v>
                </c:pt>
                <c:pt idx="319">
                  <c:v>611.06399999999996</c:v>
                </c:pt>
                <c:pt idx="328">
                  <c:v>1059.9100000000001</c:v>
                </c:pt>
                <c:pt idx="329">
                  <c:v>801.79200000000003</c:v>
                </c:pt>
                <c:pt idx="336">
                  <c:v>864.64800000000002</c:v>
                </c:pt>
                <c:pt idx="337">
                  <c:v>1208.0899999999999</c:v>
                </c:pt>
                <c:pt idx="341">
                  <c:v>1555.2</c:v>
                </c:pt>
                <c:pt idx="344">
                  <c:v>2102.54</c:v>
                </c:pt>
                <c:pt idx="348">
                  <c:v>1137.67</c:v>
                </c:pt>
                <c:pt idx="359">
                  <c:v>1962.79</c:v>
                </c:pt>
                <c:pt idx="363">
                  <c:v>1069.8499999999999</c:v>
                </c:pt>
                <c:pt idx="365">
                  <c:v>884.73599999999999</c:v>
                </c:pt>
                <c:pt idx="379">
                  <c:v>1758.67</c:v>
                </c:pt>
                <c:pt idx="380">
                  <c:v>771.33600000000001</c:v>
                </c:pt>
                <c:pt idx="385">
                  <c:v>1025.78</c:v>
                </c:pt>
                <c:pt idx="389">
                  <c:v>1571.18</c:v>
                </c:pt>
                <c:pt idx="396">
                  <c:v>2265.41</c:v>
                </c:pt>
                <c:pt idx="399">
                  <c:v>1362.1</c:v>
                </c:pt>
                <c:pt idx="401">
                  <c:v>2631.31</c:v>
                </c:pt>
                <c:pt idx="403">
                  <c:v>889.05600000000004</c:v>
                </c:pt>
                <c:pt idx="420">
                  <c:v>752.32799999999997</c:v>
                </c:pt>
                <c:pt idx="433">
                  <c:v>1515.67</c:v>
                </c:pt>
                <c:pt idx="440">
                  <c:v>1839.02</c:v>
                </c:pt>
                <c:pt idx="443">
                  <c:v>1474.63</c:v>
                </c:pt>
                <c:pt idx="445">
                  <c:v>752.54399999999998</c:v>
                </c:pt>
                <c:pt idx="447">
                  <c:v>735.48</c:v>
                </c:pt>
                <c:pt idx="454">
                  <c:v>1392.55</c:v>
                </c:pt>
                <c:pt idx="464">
                  <c:v>1184.33</c:v>
                </c:pt>
                <c:pt idx="473">
                  <c:v>8503.49</c:v>
                </c:pt>
                <c:pt idx="474">
                  <c:v>2773.87</c:v>
                </c:pt>
                <c:pt idx="477">
                  <c:v>1013.04</c:v>
                </c:pt>
                <c:pt idx="490">
                  <c:v>2311.1999999999998</c:v>
                </c:pt>
                <c:pt idx="497">
                  <c:v>795.96</c:v>
                </c:pt>
                <c:pt idx="500">
                  <c:v>1293.6199999999999</c:v>
                </c:pt>
                <c:pt idx="508">
                  <c:v>645.40800000000002</c:v>
                </c:pt>
                <c:pt idx="513">
                  <c:v>1629.72</c:v>
                </c:pt>
                <c:pt idx="531">
                  <c:v>1456.7</c:v>
                </c:pt>
                <c:pt idx="532">
                  <c:v>2049.41</c:v>
                </c:pt>
                <c:pt idx="534">
                  <c:v>699.40800000000002</c:v>
                </c:pt>
                <c:pt idx="536">
                  <c:v>763.99199999999996</c:v>
                </c:pt>
                <c:pt idx="540">
                  <c:v>856.65599999999995</c:v>
                </c:pt>
                <c:pt idx="543">
                  <c:v>723.38400000000001</c:v>
                </c:pt>
                <c:pt idx="546">
                  <c:v>1176.55</c:v>
                </c:pt>
                <c:pt idx="550">
                  <c:v>759.24</c:v>
                </c:pt>
                <c:pt idx="553">
                  <c:v>1360.58</c:v>
                </c:pt>
                <c:pt idx="560">
                  <c:v>1144.3699999999999</c:v>
                </c:pt>
                <c:pt idx="577">
                  <c:v>2426.11</c:v>
                </c:pt>
                <c:pt idx="580">
                  <c:v>1362.53</c:v>
                </c:pt>
                <c:pt idx="583">
                  <c:v>1597.1</c:v>
                </c:pt>
                <c:pt idx="593">
                  <c:v>783.43200000000002</c:v>
                </c:pt>
                <c:pt idx="594">
                  <c:v>916.05600000000004</c:v>
                </c:pt>
                <c:pt idx="617">
                  <c:v>917.13599999999997</c:v>
                </c:pt>
                <c:pt idx="627">
                  <c:v>2549.88</c:v>
                </c:pt>
                <c:pt idx="632">
                  <c:v>795.52800000000002</c:v>
                </c:pt>
                <c:pt idx="636">
                  <c:v>655.99199999999996</c:v>
                </c:pt>
                <c:pt idx="642">
                  <c:v>1221.48</c:v>
                </c:pt>
                <c:pt idx="650">
                  <c:v>2067.77</c:v>
                </c:pt>
                <c:pt idx="651">
                  <c:v>1076.33</c:v>
                </c:pt>
                <c:pt idx="660">
                  <c:v>2049.62</c:v>
                </c:pt>
                <c:pt idx="663">
                  <c:v>2233.2199999999998</c:v>
                </c:pt>
                <c:pt idx="666">
                  <c:v>615.81600000000003</c:v>
                </c:pt>
                <c:pt idx="673">
                  <c:v>952.99199999999996</c:v>
                </c:pt>
                <c:pt idx="676">
                  <c:v>1013.69</c:v>
                </c:pt>
                <c:pt idx="682">
                  <c:v>1586.52</c:v>
                </c:pt>
                <c:pt idx="687">
                  <c:v>1048.46</c:v>
                </c:pt>
                <c:pt idx="692">
                  <c:v>3903.98</c:v>
                </c:pt>
                <c:pt idx="706">
                  <c:v>984.96</c:v>
                </c:pt>
                <c:pt idx="712">
                  <c:v>922.75199999999995</c:v>
                </c:pt>
                <c:pt idx="714">
                  <c:v>1033.56</c:v>
                </c:pt>
                <c:pt idx="715">
                  <c:v>1393.2</c:v>
                </c:pt>
                <c:pt idx="720">
                  <c:v>974.16</c:v>
                </c:pt>
                <c:pt idx="732">
                  <c:v>1086.9100000000001</c:v>
                </c:pt>
                <c:pt idx="735">
                  <c:v>1160.78</c:v>
                </c:pt>
                <c:pt idx="747">
                  <c:v>898.12800000000004</c:v>
                </c:pt>
                <c:pt idx="752">
                  <c:v>1477.66</c:v>
                </c:pt>
                <c:pt idx="753">
                  <c:v>2296.5100000000002</c:v>
                </c:pt>
                <c:pt idx="754">
                  <c:v>2439.5</c:v>
                </c:pt>
                <c:pt idx="755">
                  <c:v>843.26400000000001</c:v>
                </c:pt>
                <c:pt idx="762">
                  <c:v>1661.9</c:v>
                </c:pt>
                <c:pt idx="763">
                  <c:v>1148.04</c:v>
                </c:pt>
                <c:pt idx="796">
                  <c:v>1054.08</c:v>
                </c:pt>
                <c:pt idx="802">
                  <c:v>1025.57</c:v>
                </c:pt>
                <c:pt idx="806">
                  <c:v>747.57600000000002</c:v>
                </c:pt>
                <c:pt idx="807">
                  <c:v>1118.23</c:v>
                </c:pt>
                <c:pt idx="808">
                  <c:v>865.51199999999994</c:v>
                </c:pt>
                <c:pt idx="813">
                  <c:v>1333.37</c:v>
                </c:pt>
                <c:pt idx="824">
                  <c:v>1362.53</c:v>
                </c:pt>
                <c:pt idx="832">
                  <c:v>2037.53</c:v>
                </c:pt>
                <c:pt idx="834">
                  <c:v>900.072</c:v>
                </c:pt>
                <c:pt idx="837">
                  <c:v>4010.69</c:v>
                </c:pt>
                <c:pt idx="840">
                  <c:v>961.84799999999996</c:v>
                </c:pt>
                <c:pt idx="841">
                  <c:v>933.33600000000001</c:v>
                </c:pt>
                <c:pt idx="847">
                  <c:v>589.89599999999996</c:v>
                </c:pt>
                <c:pt idx="854">
                  <c:v>1475.93</c:v>
                </c:pt>
                <c:pt idx="857">
                  <c:v>1360.15</c:v>
                </c:pt>
                <c:pt idx="872">
                  <c:v>1548.94</c:v>
                </c:pt>
                <c:pt idx="877">
                  <c:v>759.024</c:v>
                </c:pt>
                <c:pt idx="881">
                  <c:v>960.98400000000004</c:v>
                </c:pt>
                <c:pt idx="887">
                  <c:v>1369.01</c:v>
                </c:pt>
                <c:pt idx="888">
                  <c:v>802.65599999999995</c:v>
                </c:pt>
                <c:pt idx="891">
                  <c:v>898.99199999999996</c:v>
                </c:pt>
                <c:pt idx="904">
                  <c:v>1128.5999999999999</c:v>
                </c:pt>
                <c:pt idx="918">
                  <c:v>1254.96</c:v>
                </c:pt>
                <c:pt idx="919">
                  <c:v>1356.05</c:v>
                </c:pt>
                <c:pt idx="921">
                  <c:v>1044.58</c:v>
                </c:pt>
                <c:pt idx="930">
                  <c:v>957.74400000000003</c:v>
                </c:pt>
                <c:pt idx="938">
                  <c:v>897.26400000000001</c:v>
                </c:pt>
                <c:pt idx="945">
                  <c:v>1098.3599999999999</c:v>
                </c:pt>
                <c:pt idx="948">
                  <c:v>1041.3399999999999</c:v>
                </c:pt>
                <c:pt idx="949">
                  <c:v>1069.42</c:v>
                </c:pt>
                <c:pt idx="950">
                  <c:v>1048.68</c:v>
                </c:pt>
                <c:pt idx="971">
                  <c:v>3841.13</c:v>
                </c:pt>
                <c:pt idx="973">
                  <c:v>1712.88</c:v>
                </c:pt>
                <c:pt idx="977">
                  <c:v>765.50400000000002</c:v>
                </c:pt>
                <c:pt idx="990">
                  <c:v>1119.53</c:v>
                </c:pt>
                <c:pt idx="994">
                  <c:v>915.62400000000002</c:v>
                </c:pt>
                <c:pt idx="995">
                  <c:v>1018.44</c:v>
                </c:pt>
                <c:pt idx="999">
                  <c:v>1286.71</c:v>
                </c:pt>
                <c:pt idx="1000">
                  <c:v>1432.94</c:v>
                </c:pt>
                <c:pt idx="1005">
                  <c:v>1183.46</c:v>
                </c:pt>
                <c:pt idx="1010">
                  <c:v>1622.81</c:v>
                </c:pt>
                <c:pt idx="1014">
                  <c:v>117.288</c:v>
                </c:pt>
                <c:pt idx="1015">
                  <c:v>1535.33</c:v>
                </c:pt>
                <c:pt idx="1024">
                  <c:v>1116.29</c:v>
                </c:pt>
                <c:pt idx="1026">
                  <c:v>877.17600000000004</c:v>
                </c:pt>
                <c:pt idx="1033">
                  <c:v>789.48</c:v>
                </c:pt>
                <c:pt idx="1036">
                  <c:v>1375.92</c:v>
                </c:pt>
                <c:pt idx="1042">
                  <c:v>866.37599999999998</c:v>
                </c:pt>
                <c:pt idx="1045">
                  <c:v>1983.31</c:v>
                </c:pt>
                <c:pt idx="1052">
                  <c:v>939.16800000000001</c:v>
                </c:pt>
                <c:pt idx="1053">
                  <c:v>1397.52</c:v>
                </c:pt>
                <c:pt idx="1075">
                  <c:v>864.64800000000002</c:v>
                </c:pt>
                <c:pt idx="1076">
                  <c:v>749.73599999999999</c:v>
                </c:pt>
                <c:pt idx="1078">
                  <c:v>972</c:v>
                </c:pt>
                <c:pt idx="1086">
                  <c:v>964.00800000000004</c:v>
                </c:pt>
                <c:pt idx="1091">
                  <c:v>1019.09</c:v>
                </c:pt>
                <c:pt idx="1097">
                  <c:v>1261.6600000000001</c:v>
                </c:pt>
                <c:pt idx="1100">
                  <c:v>1633.18</c:v>
                </c:pt>
                <c:pt idx="1102">
                  <c:v>1022.11</c:v>
                </c:pt>
                <c:pt idx="1103">
                  <c:v>1297.73</c:v>
                </c:pt>
                <c:pt idx="1108">
                  <c:v>1191.02</c:v>
                </c:pt>
                <c:pt idx="1112">
                  <c:v>1115.21</c:v>
                </c:pt>
                <c:pt idx="1115">
                  <c:v>901.15200000000004</c:v>
                </c:pt>
                <c:pt idx="1116">
                  <c:v>1209.17</c:v>
                </c:pt>
                <c:pt idx="1144">
                  <c:v>684.072</c:v>
                </c:pt>
                <c:pt idx="1150">
                  <c:v>1127.3</c:v>
                </c:pt>
                <c:pt idx="1158">
                  <c:v>1304.6400000000001</c:v>
                </c:pt>
                <c:pt idx="1162">
                  <c:v>1231.6300000000001</c:v>
                </c:pt>
                <c:pt idx="1167">
                  <c:v>1453.25</c:v>
                </c:pt>
                <c:pt idx="1179">
                  <c:v>997.05600000000004</c:v>
                </c:pt>
                <c:pt idx="1182">
                  <c:v>1339.63</c:v>
                </c:pt>
                <c:pt idx="1192">
                  <c:v>1185.8399999999999</c:v>
                </c:pt>
                <c:pt idx="1195">
                  <c:v>4729.75</c:v>
                </c:pt>
                <c:pt idx="1197">
                  <c:v>1239.4100000000001</c:v>
                </c:pt>
                <c:pt idx="1210">
                  <c:v>1248.7</c:v>
                </c:pt>
                <c:pt idx="1211">
                  <c:v>1636.63</c:v>
                </c:pt>
                <c:pt idx="1214">
                  <c:v>1372.46</c:v>
                </c:pt>
                <c:pt idx="1222">
                  <c:v>682.12800000000004</c:v>
                </c:pt>
                <c:pt idx="1227">
                  <c:v>1022.54</c:v>
                </c:pt>
                <c:pt idx="1232">
                  <c:v>1810.3</c:v>
                </c:pt>
                <c:pt idx="1233">
                  <c:v>1731.02</c:v>
                </c:pt>
                <c:pt idx="1243">
                  <c:v>1236.3800000000001</c:v>
                </c:pt>
                <c:pt idx="1245">
                  <c:v>1390.39</c:v>
                </c:pt>
                <c:pt idx="1248">
                  <c:v>717.98400000000004</c:v>
                </c:pt>
                <c:pt idx="1251">
                  <c:v>1134.8599999999999</c:v>
                </c:pt>
                <c:pt idx="1252">
                  <c:v>1789.13</c:v>
                </c:pt>
                <c:pt idx="1260">
                  <c:v>2069.2800000000002</c:v>
                </c:pt>
                <c:pt idx="1261">
                  <c:v>885.16800000000001</c:v>
                </c:pt>
                <c:pt idx="1274">
                  <c:v>1143.07</c:v>
                </c:pt>
                <c:pt idx="1278">
                  <c:v>1099.22</c:v>
                </c:pt>
                <c:pt idx="1279">
                  <c:v>1405.08</c:v>
                </c:pt>
                <c:pt idx="1284">
                  <c:v>8639.14</c:v>
                </c:pt>
                <c:pt idx="1286">
                  <c:v>8916.26</c:v>
                </c:pt>
                <c:pt idx="1296">
                  <c:v>1590.62</c:v>
                </c:pt>
                <c:pt idx="1298">
                  <c:v>709.56</c:v>
                </c:pt>
                <c:pt idx="1307">
                  <c:v>3784.75</c:v>
                </c:pt>
                <c:pt idx="1308">
                  <c:v>1929.96</c:v>
                </c:pt>
                <c:pt idx="1318">
                  <c:v>1666.44</c:v>
                </c:pt>
                <c:pt idx="1319">
                  <c:v>1140.26</c:v>
                </c:pt>
                <c:pt idx="1329">
                  <c:v>1699.7</c:v>
                </c:pt>
                <c:pt idx="1339">
                  <c:v>1707.48</c:v>
                </c:pt>
                <c:pt idx="1343">
                  <c:v>1409.62</c:v>
                </c:pt>
                <c:pt idx="1352">
                  <c:v>1424.95</c:v>
                </c:pt>
                <c:pt idx="1354">
                  <c:v>1227.31</c:v>
                </c:pt>
                <c:pt idx="1358">
                  <c:v>1154.3</c:v>
                </c:pt>
                <c:pt idx="1361">
                  <c:v>1141.1300000000001</c:v>
                </c:pt>
                <c:pt idx="1368">
                  <c:v>2703.46</c:v>
                </c:pt>
                <c:pt idx="1377">
                  <c:v>1174.82</c:v>
                </c:pt>
                <c:pt idx="1382">
                  <c:v>931.39200000000005</c:v>
                </c:pt>
                <c:pt idx="1388">
                  <c:v>660.31200000000001</c:v>
                </c:pt>
                <c:pt idx="1390">
                  <c:v>1097.06</c:v>
                </c:pt>
                <c:pt idx="1391">
                  <c:v>1688.69</c:v>
                </c:pt>
                <c:pt idx="1397">
                  <c:v>1051.06</c:v>
                </c:pt>
                <c:pt idx="1400">
                  <c:v>1090.3699999999999</c:v>
                </c:pt>
                <c:pt idx="1408">
                  <c:v>876.74400000000003</c:v>
                </c:pt>
                <c:pt idx="1421">
                  <c:v>598.32000000000005</c:v>
                </c:pt>
                <c:pt idx="1425">
                  <c:v>3592.3</c:v>
                </c:pt>
                <c:pt idx="1436">
                  <c:v>1649.59</c:v>
                </c:pt>
                <c:pt idx="1440">
                  <c:v>142.99199999999999</c:v>
                </c:pt>
                <c:pt idx="1445">
                  <c:v>1812.46</c:v>
                </c:pt>
                <c:pt idx="1450">
                  <c:v>1227.31</c:v>
                </c:pt>
                <c:pt idx="1458">
                  <c:v>3244.54</c:v>
                </c:pt>
                <c:pt idx="1462">
                  <c:v>1088.6400000000001</c:v>
                </c:pt>
                <c:pt idx="1466">
                  <c:v>707.61599999999999</c:v>
                </c:pt>
                <c:pt idx="1468">
                  <c:v>1041.3399999999999</c:v>
                </c:pt>
                <c:pt idx="1475">
                  <c:v>2751.19</c:v>
                </c:pt>
                <c:pt idx="1480">
                  <c:v>1284.55</c:v>
                </c:pt>
                <c:pt idx="1481">
                  <c:v>1300.97</c:v>
                </c:pt>
                <c:pt idx="1483">
                  <c:v>917.56799999999998</c:v>
                </c:pt>
                <c:pt idx="1499">
                  <c:v>2986.2</c:v>
                </c:pt>
                <c:pt idx="1500">
                  <c:v>1300.97</c:v>
                </c:pt>
                <c:pt idx="1505">
                  <c:v>1866.89</c:v>
                </c:pt>
                <c:pt idx="1506">
                  <c:v>2237.7600000000002</c:v>
                </c:pt>
                <c:pt idx="1517">
                  <c:v>4174.2</c:v>
                </c:pt>
                <c:pt idx="1524">
                  <c:v>1174.6099999999999</c:v>
                </c:pt>
                <c:pt idx="1527">
                  <c:v>910.22400000000005</c:v>
                </c:pt>
                <c:pt idx="1528">
                  <c:v>1911.82</c:v>
                </c:pt>
                <c:pt idx="1533">
                  <c:v>1330.56</c:v>
                </c:pt>
                <c:pt idx="1534">
                  <c:v>2326.75</c:v>
                </c:pt>
                <c:pt idx="1535">
                  <c:v>1267.92</c:v>
                </c:pt>
                <c:pt idx="1540">
                  <c:v>1092.74</c:v>
                </c:pt>
                <c:pt idx="1543">
                  <c:v>1338.98</c:v>
                </c:pt>
                <c:pt idx="1544">
                  <c:v>823.39200000000005</c:v>
                </c:pt>
                <c:pt idx="1548">
                  <c:v>742.60799999999995</c:v>
                </c:pt>
                <c:pt idx="1551">
                  <c:v>1147.82</c:v>
                </c:pt>
                <c:pt idx="1566">
                  <c:v>1888.06</c:v>
                </c:pt>
                <c:pt idx="1567">
                  <c:v>1153.01</c:v>
                </c:pt>
                <c:pt idx="1571">
                  <c:v>895.10400000000004</c:v>
                </c:pt>
                <c:pt idx="1572">
                  <c:v>1249.99</c:v>
                </c:pt>
                <c:pt idx="1578">
                  <c:v>761.4</c:v>
                </c:pt>
                <c:pt idx="1582">
                  <c:v>1662.77</c:v>
                </c:pt>
                <c:pt idx="1592">
                  <c:v>1990.44</c:v>
                </c:pt>
                <c:pt idx="1598">
                  <c:v>1390.61</c:v>
                </c:pt>
                <c:pt idx="1600">
                  <c:v>1580.04</c:v>
                </c:pt>
                <c:pt idx="1626">
                  <c:v>1157.1099999999999</c:v>
                </c:pt>
                <c:pt idx="1627">
                  <c:v>1002.67</c:v>
                </c:pt>
                <c:pt idx="1628">
                  <c:v>2301.2600000000002</c:v>
                </c:pt>
                <c:pt idx="1637">
                  <c:v>1391.69</c:v>
                </c:pt>
                <c:pt idx="1639">
                  <c:v>1221.26</c:v>
                </c:pt>
                <c:pt idx="1642">
                  <c:v>1612.87</c:v>
                </c:pt>
                <c:pt idx="1643">
                  <c:v>732.88800000000003</c:v>
                </c:pt>
                <c:pt idx="1648">
                  <c:v>2007.72</c:v>
                </c:pt>
                <c:pt idx="1651">
                  <c:v>1614.82</c:v>
                </c:pt>
                <c:pt idx="1656">
                  <c:v>916.05600000000004</c:v>
                </c:pt>
                <c:pt idx="1675">
                  <c:v>1001.38</c:v>
                </c:pt>
                <c:pt idx="1676">
                  <c:v>966.38400000000001</c:v>
                </c:pt>
                <c:pt idx="1682">
                  <c:v>1340.28</c:v>
                </c:pt>
                <c:pt idx="1686">
                  <c:v>1450.66</c:v>
                </c:pt>
                <c:pt idx="1692">
                  <c:v>1274.4000000000001</c:v>
                </c:pt>
                <c:pt idx="1694">
                  <c:v>1320.84</c:v>
                </c:pt>
                <c:pt idx="1696">
                  <c:v>1196.6400000000001</c:v>
                </c:pt>
                <c:pt idx="1702">
                  <c:v>966.16800000000001</c:v>
                </c:pt>
                <c:pt idx="1704">
                  <c:v>1089.5</c:v>
                </c:pt>
                <c:pt idx="1707">
                  <c:v>778.24800000000005</c:v>
                </c:pt>
                <c:pt idx="1708">
                  <c:v>897.26400000000001</c:v>
                </c:pt>
                <c:pt idx="1723">
                  <c:v>1213.06</c:v>
                </c:pt>
                <c:pt idx="1724">
                  <c:v>1761.05</c:v>
                </c:pt>
                <c:pt idx="1734">
                  <c:v>1720.44</c:v>
                </c:pt>
                <c:pt idx="1742">
                  <c:v>1124.06</c:v>
                </c:pt>
                <c:pt idx="1744">
                  <c:v>743.04</c:v>
                </c:pt>
                <c:pt idx="1753">
                  <c:v>3186.22</c:v>
                </c:pt>
                <c:pt idx="1758">
                  <c:v>984.74400000000003</c:v>
                </c:pt>
                <c:pt idx="1764">
                  <c:v>938.73599999999999</c:v>
                </c:pt>
                <c:pt idx="1772">
                  <c:v>1353.46</c:v>
                </c:pt>
                <c:pt idx="1775">
                  <c:v>1271.1600000000001</c:v>
                </c:pt>
                <c:pt idx="1777">
                  <c:v>2504.3000000000002</c:v>
                </c:pt>
                <c:pt idx="1787">
                  <c:v>1255.3900000000001</c:v>
                </c:pt>
                <c:pt idx="1796">
                  <c:v>3044.52</c:v>
                </c:pt>
                <c:pt idx="1807">
                  <c:v>1035.07</c:v>
                </c:pt>
                <c:pt idx="1809">
                  <c:v>1188.8599999999999</c:v>
                </c:pt>
                <c:pt idx="1811">
                  <c:v>803.952</c:v>
                </c:pt>
                <c:pt idx="1813">
                  <c:v>1497.53</c:v>
                </c:pt>
                <c:pt idx="1815">
                  <c:v>1055.5899999999999</c:v>
                </c:pt>
                <c:pt idx="1821">
                  <c:v>2373.84</c:v>
                </c:pt>
                <c:pt idx="1825">
                  <c:v>1238.98</c:v>
                </c:pt>
                <c:pt idx="1830">
                  <c:v>1174.82</c:v>
                </c:pt>
                <c:pt idx="1836">
                  <c:v>704.16</c:v>
                </c:pt>
                <c:pt idx="1842">
                  <c:v>1281.31</c:v>
                </c:pt>
                <c:pt idx="1844">
                  <c:v>1127.3</c:v>
                </c:pt>
                <c:pt idx="1848">
                  <c:v>1673.14</c:v>
                </c:pt>
                <c:pt idx="1850">
                  <c:v>3101.54</c:v>
                </c:pt>
                <c:pt idx="1851">
                  <c:v>1032.9100000000001</c:v>
                </c:pt>
                <c:pt idx="1855">
                  <c:v>1076.33</c:v>
                </c:pt>
                <c:pt idx="1867">
                  <c:v>573.48</c:v>
                </c:pt>
                <c:pt idx="1868">
                  <c:v>1110.67</c:v>
                </c:pt>
                <c:pt idx="1869">
                  <c:v>1380.02</c:v>
                </c:pt>
                <c:pt idx="1877">
                  <c:v>1702.94</c:v>
                </c:pt>
                <c:pt idx="1879">
                  <c:v>975.88800000000003</c:v>
                </c:pt>
                <c:pt idx="1880">
                  <c:v>1359.29</c:v>
                </c:pt>
                <c:pt idx="1887">
                  <c:v>1196.6400000000001</c:v>
                </c:pt>
                <c:pt idx="1889">
                  <c:v>768.096</c:v>
                </c:pt>
                <c:pt idx="1890">
                  <c:v>861.19200000000001</c:v>
                </c:pt>
                <c:pt idx="1895">
                  <c:v>6816.31</c:v>
                </c:pt>
                <c:pt idx="1899">
                  <c:v>1193.83</c:v>
                </c:pt>
                <c:pt idx="1912">
                  <c:v>1700.78</c:v>
                </c:pt>
                <c:pt idx="1914">
                  <c:v>1008.94</c:v>
                </c:pt>
                <c:pt idx="1916">
                  <c:v>1357.56</c:v>
                </c:pt>
                <c:pt idx="1944">
                  <c:v>951.91200000000003</c:v>
                </c:pt>
                <c:pt idx="1947">
                  <c:v>957.31200000000001</c:v>
                </c:pt>
                <c:pt idx="1950">
                  <c:v>2094.12</c:v>
                </c:pt>
                <c:pt idx="1951">
                  <c:v>1208.52</c:v>
                </c:pt>
                <c:pt idx="1955">
                  <c:v>1204.6300000000001</c:v>
                </c:pt>
                <c:pt idx="1958">
                  <c:v>1420.85</c:v>
                </c:pt>
                <c:pt idx="1965">
                  <c:v>852.76800000000003</c:v>
                </c:pt>
                <c:pt idx="1966">
                  <c:v>893.59199999999998</c:v>
                </c:pt>
                <c:pt idx="1968">
                  <c:v>960.12</c:v>
                </c:pt>
                <c:pt idx="1974">
                  <c:v>738.28800000000001</c:v>
                </c:pt>
                <c:pt idx="1975">
                  <c:v>1305.29</c:v>
                </c:pt>
                <c:pt idx="1976">
                  <c:v>2163.46</c:v>
                </c:pt>
                <c:pt idx="1977">
                  <c:v>780.40800000000002</c:v>
                </c:pt>
                <c:pt idx="1978">
                  <c:v>6326.64</c:v>
                </c:pt>
                <c:pt idx="1981">
                  <c:v>1398.6</c:v>
                </c:pt>
                <c:pt idx="1986">
                  <c:v>1266.19</c:v>
                </c:pt>
                <c:pt idx="1992">
                  <c:v>2935.44</c:v>
                </c:pt>
                <c:pt idx="1995">
                  <c:v>1193.83</c:v>
                </c:pt>
                <c:pt idx="2001">
                  <c:v>1099.22</c:v>
                </c:pt>
                <c:pt idx="2013">
                  <c:v>729.43200000000002</c:v>
                </c:pt>
                <c:pt idx="2019">
                  <c:v>2846.66</c:v>
                </c:pt>
                <c:pt idx="2024">
                  <c:v>881.49599999999998</c:v>
                </c:pt>
                <c:pt idx="2029">
                  <c:v>1251.5</c:v>
                </c:pt>
                <c:pt idx="2031">
                  <c:v>1265.76</c:v>
                </c:pt>
                <c:pt idx="2033">
                  <c:v>1604.88</c:v>
                </c:pt>
                <c:pt idx="2034">
                  <c:v>671.32799999999997</c:v>
                </c:pt>
                <c:pt idx="2037">
                  <c:v>1191.24</c:v>
                </c:pt>
                <c:pt idx="2042">
                  <c:v>1214.1400000000001</c:v>
                </c:pt>
                <c:pt idx="2043">
                  <c:v>814.75199999999995</c:v>
                </c:pt>
                <c:pt idx="2056">
                  <c:v>1248.7</c:v>
                </c:pt>
                <c:pt idx="2057">
                  <c:v>1137.24</c:v>
                </c:pt>
                <c:pt idx="2062">
                  <c:v>839.16</c:v>
                </c:pt>
                <c:pt idx="2063">
                  <c:v>1139.6199999999999</c:v>
                </c:pt>
                <c:pt idx="2072">
                  <c:v>2024.35</c:v>
                </c:pt>
                <c:pt idx="2075">
                  <c:v>1799.93</c:v>
                </c:pt>
                <c:pt idx="2079">
                  <c:v>1603.15</c:v>
                </c:pt>
                <c:pt idx="2101">
                  <c:v>1334.45</c:v>
                </c:pt>
                <c:pt idx="2103">
                  <c:v>1135.3</c:v>
                </c:pt>
                <c:pt idx="2104">
                  <c:v>877.60799999999995</c:v>
                </c:pt>
                <c:pt idx="2113">
                  <c:v>1902.96</c:v>
                </c:pt>
                <c:pt idx="2116">
                  <c:v>1462.75</c:v>
                </c:pt>
                <c:pt idx="2125">
                  <c:v>848.66399999999999</c:v>
                </c:pt>
                <c:pt idx="2127">
                  <c:v>1050.8399999999999</c:v>
                </c:pt>
                <c:pt idx="2137">
                  <c:v>1836.65</c:v>
                </c:pt>
                <c:pt idx="2138">
                  <c:v>1096.6300000000001</c:v>
                </c:pt>
                <c:pt idx="2145">
                  <c:v>844.12800000000004</c:v>
                </c:pt>
                <c:pt idx="2147">
                  <c:v>1198.58</c:v>
                </c:pt>
                <c:pt idx="2148">
                  <c:v>3868.78</c:v>
                </c:pt>
                <c:pt idx="2151">
                  <c:v>1959.77</c:v>
                </c:pt>
                <c:pt idx="2154">
                  <c:v>1117.8</c:v>
                </c:pt>
                <c:pt idx="2160">
                  <c:v>1330.56</c:v>
                </c:pt>
                <c:pt idx="2162">
                  <c:v>1929.31</c:v>
                </c:pt>
                <c:pt idx="2166">
                  <c:v>2245.54</c:v>
                </c:pt>
                <c:pt idx="2167">
                  <c:v>1140.48</c:v>
                </c:pt>
                <c:pt idx="2172">
                  <c:v>962.06399999999996</c:v>
                </c:pt>
                <c:pt idx="2191">
                  <c:v>707.18399999999997</c:v>
                </c:pt>
                <c:pt idx="2192">
                  <c:v>1548.72</c:v>
                </c:pt>
                <c:pt idx="2198">
                  <c:v>1311.77</c:v>
                </c:pt>
                <c:pt idx="2200">
                  <c:v>1525.82</c:v>
                </c:pt>
                <c:pt idx="2220">
                  <c:v>1329.48</c:v>
                </c:pt>
                <c:pt idx="2223">
                  <c:v>1805.11</c:v>
                </c:pt>
                <c:pt idx="2225">
                  <c:v>636.76800000000003</c:v>
                </c:pt>
                <c:pt idx="2233">
                  <c:v>1099.44</c:v>
                </c:pt>
                <c:pt idx="2236">
                  <c:v>1792.15</c:v>
                </c:pt>
                <c:pt idx="2239">
                  <c:v>1167.05</c:v>
                </c:pt>
                <c:pt idx="2246">
                  <c:v>793.58399999999995</c:v>
                </c:pt>
                <c:pt idx="2247">
                  <c:v>906.55200000000002</c:v>
                </c:pt>
                <c:pt idx="2254">
                  <c:v>1327.54</c:v>
                </c:pt>
                <c:pt idx="2263">
                  <c:v>1303.56</c:v>
                </c:pt>
                <c:pt idx="2266">
                  <c:v>1205.93</c:v>
                </c:pt>
                <c:pt idx="2272">
                  <c:v>1096.8499999999999</c:v>
                </c:pt>
                <c:pt idx="2274">
                  <c:v>3417.34</c:v>
                </c:pt>
                <c:pt idx="2275">
                  <c:v>1116.5</c:v>
                </c:pt>
                <c:pt idx="2279">
                  <c:v>1691.93</c:v>
                </c:pt>
                <c:pt idx="2281">
                  <c:v>1124.71</c:v>
                </c:pt>
                <c:pt idx="2290">
                  <c:v>1561.46</c:v>
                </c:pt>
                <c:pt idx="2291">
                  <c:v>1140.26</c:v>
                </c:pt>
                <c:pt idx="2292">
                  <c:v>1838.59</c:v>
                </c:pt>
                <c:pt idx="2294">
                  <c:v>878.47199999999998</c:v>
                </c:pt>
                <c:pt idx="2307">
                  <c:v>2688.77</c:v>
                </c:pt>
                <c:pt idx="2315">
                  <c:v>1259.06</c:v>
                </c:pt>
                <c:pt idx="2325">
                  <c:v>1615.46</c:v>
                </c:pt>
                <c:pt idx="2332">
                  <c:v>1004.18</c:v>
                </c:pt>
                <c:pt idx="2340">
                  <c:v>861.62400000000002</c:v>
                </c:pt>
                <c:pt idx="2345">
                  <c:v>1415.88</c:v>
                </c:pt>
                <c:pt idx="2348">
                  <c:v>1824.55</c:v>
                </c:pt>
                <c:pt idx="2359">
                  <c:v>1355.4</c:v>
                </c:pt>
                <c:pt idx="2364">
                  <c:v>1472.26</c:v>
                </c:pt>
                <c:pt idx="2365">
                  <c:v>1365.98</c:v>
                </c:pt>
                <c:pt idx="2366">
                  <c:v>1488.02</c:v>
                </c:pt>
                <c:pt idx="2373">
                  <c:v>1670.33</c:v>
                </c:pt>
                <c:pt idx="2376">
                  <c:v>912.38400000000001</c:v>
                </c:pt>
                <c:pt idx="2383">
                  <c:v>2146.39</c:v>
                </c:pt>
                <c:pt idx="2389">
                  <c:v>930.096</c:v>
                </c:pt>
                <c:pt idx="2390">
                  <c:v>970.92</c:v>
                </c:pt>
                <c:pt idx="2402">
                  <c:v>828.14400000000001</c:v>
                </c:pt>
                <c:pt idx="2408">
                  <c:v>1254.96</c:v>
                </c:pt>
                <c:pt idx="2411">
                  <c:v>884.73599999999999</c:v>
                </c:pt>
                <c:pt idx="2412">
                  <c:v>770.25599999999997</c:v>
                </c:pt>
                <c:pt idx="2419">
                  <c:v>931.82399999999996</c:v>
                </c:pt>
                <c:pt idx="2421">
                  <c:v>2136.2399999999998</c:v>
                </c:pt>
                <c:pt idx="2422">
                  <c:v>1176.77</c:v>
                </c:pt>
                <c:pt idx="2431">
                  <c:v>1174.6099999999999</c:v>
                </c:pt>
                <c:pt idx="2436">
                  <c:v>1789.13</c:v>
                </c:pt>
                <c:pt idx="2437">
                  <c:v>1220.83</c:v>
                </c:pt>
                <c:pt idx="2446">
                  <c:v>1331.21</c:v>
                </c:pt>
                <c:pt idx="2453">
                  <c:v>1033.1300000000001</c:v>
                </c:pt>
                <c:pt idx="2460">
                  <c:v>1030.75</c:v>
                </c:pt>
                <c:pt idx="2461">
                  <c:v>2524.39</c:v>
                </c:pt>
                <c:pt idx="2468">
                  <c:v>1302.05</c:v>
                </c:pt>
                <c:pt idx="2469">
                  <c:v>839.16</c:v>
                </c:pt>
                <c:pt idx="2470">
                  <c:v>1086.9100000000001</c:v>
                </c:pt>
                <c:pt idx="2471">
                  <c:v>990.57600000000002</c:v>
                </c:pt>
                <c:pt idx="2473">
                  <c:v>1619.57</c:v>
                </c:pt>
                <c:pt idx="2483">
                  <c:v>1988.06</c:v>
                </c:pt>
                <c:pt idx="2484">
                  <c:v>1151.93</c:v>
                </c:pt>
                <c:pt idx="2495">
                  <c:v>1502.5</c:v>
                </c:pt>
                <c:pt idx="2498">
                  <c:v>647.13599999999997</c:v>
                </c:pt>
                <c:pt idx="2505">
                  <c:v>4739.26</c:v>
                </c:pt>
                <c:pt idx="2507">
                  <c:v>1355.18</c:v>
                </c:pt>
                <c:pt idx="2511">
                  <c:v>1159.49</c:v>
                </c:pt>
                <c:pt idx="2515">
                  <c:v>1067.26</c:v>
                </c:pt>
                <c:pt idx="2528">
                  <c:v>2761.13</c:v>
                </c:pt>
                <c:pt idx="2531">
                  <c:v>1406.38</c:v>
                </c:pt>
                <c:pt idx="2532">
                  <c:v>1221.7</c:v>
                </c:pt>
                <c:pt idx="2556">
                  <c:v>1221.9100000000001</c:v>
                </c:pt>
                <c:pt idx="2559">
                  <c:v>1226.8800000000001</c:v>
                </c:pt>
                <c:pt idx="2560">
                  <c:v>1185.6199999999999</c:v>
                </c:pt>
                <c:pt idx="2571">
                  <c:v>872.20799999999997</c:v>
                </c:pt>
                <c:pt idx="2572">
                  <c:v>1294.49</c:v>
                </c:pt>
                <c:pt idx="2573">
                  <c:v>1027.94</c:v>
                </c:pt>
                <c:pt idx="2597">
                  <c:v>870.69600000000003</c:v>
                </c:pt>
                <c:pt idx="2604">
                  <c:v>1011.31</c:v>
                </c:pt>
                <c:pt idx="2607">
                  <c:v>2227.1799999999998</c:v>
                </c:pt>
                <c:pt idx="2614">
                  <c:v>1449.79</c:v>
                </c:pt>
                <c:pt idx="2620">
                  <c:v>1105.49</c:v>
                </c:pt>
                <c:pt idx="2621">
                  <c:v>1321.49</c:v>
                </c:pt>
                <c:pt idx="2623">
                  <c:v>952.77599999999995</c:v>
                </c:pt>
                <c:pt idx="2624">
                  <c:v>1472.9</c:v>
                </c:pt>
                <c:pt idx="2625">
                  <c:v>1310.26</c:v>
                </c:pt>
                <c:pt idx="2631">
                  <c:v>854.28</c:v>
                </c:pt>
                <c:pt idx="2636">
                  <c:v>1975.97</c:v>
                </c:pt>
                <c:pt idx="2652">
                  <c:v>1519.34</c:v>
                </c:pt>
                <c:pt idx="2653">
                  <c:v>2257.42</c:v>
                </c:pt>
                <c:pt idx="2654">
                  <c:v>2316.8200000000002</c:v>
                </c:pt>
                <c:pt idx="2656">
                  <c:v>567.21600000000001</c:v>
                </c:pt>
                <c:pt idx="2657">
                  <c:v>1074.82</c:v>
                </c:pt>
                <c:pt idx="2659">
                  <c:v>1611.58</c:v>
                </c:pt>
                <c:pt idx="2660">
                  <c:v>1928.45</c:v>
                </c:pt>
                <c:pt idx="2661">
                  <c:v>875.01599999999996</c:v>
                </c:pt>
                <c:pt idx="2664">
                  <c:v>1347.62</c:v>
                </c:pt>
                <c:pt idx="2665">
                  <c:v>1818.29</c:v>
                </c:pt>
                <c:pt idx="2671">
                  <c:v>763.12800000000004</c:v>
                </c:pt>
                <c:pt idx="2678">
                  <c:v>3934.66</c:v>
                </c:pt>
                <c:pt idx="2680">
                  <c:v>1097.71</c:v>
                </c:pt>
                <c:pt idx="2681">
                  <c:v>1038.53</c:v>
                </c:pt>
                <c:pt idx="2683">
                  <c:v>1546.99</c:v>
                </c:pt>
                <c:pt idx="2692">
                  <c:v>1134</c:v>
                </c:pt>
                <c:pt idx="2703">
                  <c:v>1613.09</c:v>
                </c:pt>
                <c:pt idx="2706">
                  <c:v>1236.3800000000001</c:v>
                </c:pt>
                <c:pt idx="2713">
                  <c:v>1681.78</c:v>
                </c:pt>
                <c:pt idx="2715">
                  <c:v>1096.2</c:v>
                </c:pt>
                <c:pt idx="2721">
                  <c:v>1287.79</c:v>
                </c:pt>
                <c:pt idx="2722">
                  <c:v>713.01599999999996</c:v>
                </c:pt>
                <c:pt idx="2728">
                  <c:v>1245.02</c:v>
                </c:pt>
                <c:pt idx="2738">
                  <c:v>980.42399999999998</c:v>
                </c:pt>
                <c:pt idx="2743">
                  <c:v>2881.22</c:v>
                </c:pt>
                <c:pt idx="2747">
                  <c:v>1018.01</c:v>
                </c:pt>
                <c:pt idx="2752">
                  <c:v>840.88800000000003</c:v>
                </c:pt>
                <c:pt idx="2753">
                  <c:v>2366.9299999999998</c:v>
                </c:pt>
                <c:pt idx="2756">
                  <c:v>837</c:v>
                </c:pt>
                <c:pt idx="2758">
                  <c:v>2493.29</c:v>
                </c:pt>
                <c:pt idx="2759">
                  <c:v>1308.74</c:v>
                </c:pt>
                <c:pt idx="2760">
                  <c:v>1954.37</c:v>
                </c:pt>
                <c:pt idx="2776">
                  <c:v>3628.8</c:v>
                </c:pt>
                <c:pt idx="2778">
                  <c:v>936.36</c:v>
                </c:pt>
                <c:pt idx="2802">
                  <c:v>2319.84</c:v>
                </c:pt>
                <c:pt idx="2811">
                  <c:v>1075.9000000000001</c:v>
                </c:pt>
                <c:pt idx="2817">
                  <c:v>1017.36</c:v>
                </c:pt>
                <c:pt idx="2821">
                  <c:v>1648.3</c:v>
                </c:pt>
                <c:pt idx="2828">
                  <c:v>1026.22</c:v>
                </c:pt>
                <c:pt idx="2834">
                  <c:v>1334.02</c:v>
                </c:pt>
                <c:pt idx="2835">
                  <c:v>1399.46</c:v>
                </c:pt>
                <c:pt idx="2850">
                  <c:v>819.072</c:v>
                </c:pt>
                <c:pt idx="2853">
                  <c:v>2324.81</c:v>
                </c:pt>
                <c:pt idx="2858">
                  <c:v>1010.45</c:v>
                </c:pt>
                <c:pt idx="2859">
                  <c:v>1064.23</c:v>
                </c:pt>
                <c:pt idx="2869">
                  <c:v>1523.45</c:v>
                </c:pt>
                <c:pt idx="2870">
                  <c:v>1330.13</c:v>
                </c:pt>
                <c:pt idx="2874">
                  <c:v>1225.8</c:v>
                </c:pt>
                <c:pt idx="2875">
                  <c:v>1805.11</c:v>
                </c:pt>
                <c:pt idx="2885">
                  <c:v>1267.49</c:v>
                </c:pt>
                <c:pt idx="2891">
                  <c:v>1270.94</c:v>
                </c:pt>
                <c:pt idx="2894">
                  <c:v>1086.9100000000001</c:v>
                </c:pt>
                <c:pt idx="2905">
                  <c:v>1140.7</c:v>
                </c:pt>
                <c:pt idx="2909">
                  <c:v>1115.8599999999999</c:v>
                </c:pt>
                <c:pt idx="2915">
                  <c:v>763.34400000000005</c:v>
                </c:pt>
                <c:pt idx="2918">
                  <c:v>1572.91</c:v>
                </c:pt>
                <c:pt idx="2919">
                  <c:v>1169.21</c:v>
                </c:pt>
                <c:pt idx="2927">
                  <c:v>5009.04</c:v>
                </c:pt>
                <c:pt idx="2930">
                  <c:v>887.76</c:v>
                </c:pt>
                <c:pt idx="2945">
                  <c:v>1236.3800000000001</c:v>
                </c:pt>
                <c:pt idx="2951">
                  <c:v>2879.71</c:v>
                </c:pt>
                <c:pt idx="2952">
                  <c:v>4014.79</c:v>
                </c:pt>
                <c:pt idx="2954">
                  <c:v>1021.03</c:v>
                </c:pt>
                <c:pt idx="2955">
                  <c:v>1202.04</c:v>
                </c:pt>
                <c:pt idx="2956">
                  <c:v>1674.65</c:v>
                </c:pt>
                <c:pt idx="2957">
                  <c:v>1269.8599999999999</c:v>
                </c:pt>
                <c:pt idx="2962">
                  <c:v>2188.08</c:v>
                </c:pt>
                <c:pt idx="2964">
                  <c:v>2045.52</c:v>
                </c:pt>
                <c:pt idx="2967">
                  <c:v>722.30399999999997</c:v>
                </c:pt>
                <c:pt idx="2969">
                  <c:v>6607.22</c:v>
                </c:pt>
                <c:pt idx="2974">
                  <c:v>1407.46</c:v>
                </c:pt>
                <c:pt idx="2975">
                  <c:v>2414.02</c:v>
                </c:pt>
                <c:pt idx="2979">
                  <c:v>1271.5899999999999</c:v>
                </c:pt>
                <c:pt idx="2987">
                  <c:v>2623.97</c:v>
                </c:pt>
                <c:pt idx="2990">
                  <c:v>1544.83</c:v>
                </c:pt>
                <c:pt idx="2995">
                  <c:v>1340.71</c:v>
                </c:pt>
                <c:pt idx="2999">
                  <c:v>1322.57</c:v>
                </c:pt>
                <c:pt idx="3019">
                  <c:v>1683.07</c:v>
                </c:pt>
                <c:pt idx="3023">
                  <c:v>1255.82</c:v>
                </c:pt>
                <c:pt idx="3025">
                  <c:v>913.89599999999996</c:v>
                </c:pt>
                <c:pt idx="3027">
                  <c:v>1633.61</c:v>
                </c:pt>
                <c:pt idx="3028">
                  <c:v>1088.21</c:v>
                </c:pt>
                <c:pt idx="3047">
                  <c:v>977.61599999999999</c:v>
                </c:pt>
                <c:pt idx="3050">
                  <c:v>2607.34</c:v>
                </c:pt>
                <c:pt idx="3066">
                  <c:v>1772.71</c:v>
                </c:pt>
                <c:pt idx="3071">
                  <c:v>1619.57</c:v>
                </c:pt>
                <c:pt idx="3073">
                  <c:v>885.81600000000003</c:v>
                </c:pt>
                <c:pt idx="3076">
                  <c:v>1261.44</c:v>
                </c:pt>
                <c:pt idx="3077">
                  <c:v>2572.7800000000002</c:v>
                </c:pt>
                <c:pt idx="3089">
                  <c:v>1065.31</c:v>
                </c:pt>
                <c:pt idx="3094">
                  <c:v>3294.43</c:v>
                </c:pt>
                <c:pt idx="3098">
                  <c:v>1137.67</c:v>
                </c:pt>
                <c:pt idx="3099">
                  <c:v>866.16</c:v>
                </c:pt>
                <c:pt idx="3102">
                  <c:v>1462.75</c:v>
                </c:pt>
                <c:pt idx="3103">
                  <c:v>1323.22</c:v>
                </c:pt>
                <c:pt idx="3105">
                  <c:v>1472.47</c:v>
                </c:pt>
                <c:pt idx="3107">
                  <c:v>1230.98</c:v>
                </c:pt>
                <c:pt idx="3111">
                  <c:v>871.56</c:v>
                </c:pt>
                <c:pt idx="3117">
                  <c:v>1585.66</c:v>
                </c:pt>
                <c:pt idx="3126">
                  <c:v>1270.08</c:v>
                </c:pt>
                <c:pt idx="3133">
                  <c:v>1178.93</c:v>
                </c:pt>
                <c:pt idx="3134">
                  <c:v>1477.01</c:v>
                </c:pt>
                <c:pt idx="3137">
                  <c:v>1157.98</c:v>
                </c:pt>
                <c:pt idx="3144">
                  <c:v>1846.15</c:v>
                </c:pt>
                <c:pt idx="3146">
                  <c:v>713.88</c:v>
                </c:pt>
                <c:pt idx="3153">
                  <c:v>925.99199999999996</c:v>
                </c:pt>
                <c:pt idx="3159">
                  <c:v>1152.3599999999999</c:v>
                </c:pt>
                <c:pt idx="3168">
                  <c:v>1135.94</c:v>
                </c:pt>
                <c:pt idx="3170">
                  <c:v>1271.5899999999999</c:v>
                </c:pt>
                <c:pt idx="3181">
                  <c:v>960.12</c:v>
                </c:pt>
                <c:pt idx="3182">
                  <c:v>1259.06</c:v>
                </c:pt>
                <c:pt idx="3183">
                  <c:v>1093.3900000000001</c:v>
                </c:pt>
                <c:pt idx="3200">
                  <c:v>908.06399999999996</c:v>
                </c:pt>
                <c:pt idx="3202">
                  <c:v>799.84799999999996</c:v>
                </c:pt>
                <c:pt idx="3211">
                  <c:v>1388.02</c:v>
                </c:pt>
                <c:pt idx="3212">
                  <c:v>1113.05</c:v>
                </c:pt>
                <c:pt idx="3213">
                  <c:v>4285.66</c:v>
                </c:pt>
                <c:pt idx="3216">
                  <c:v>730.72799999999995</c:v>
                </c:pt>
                <c:pt idx="3219">
                  <c:v>1508.33</c:v>
                </c:pt>
                <c:pt idx="3220">
                  <c:v>1081.51</c:v>
                </c:pt>
                <c:pt idx="3221">
                  <c:v>1476.79</c:v>
                </c:pt>
                <c:pt idx="3231">
                  <c:v>1355.62</c:v>
                </c:pt>
                <c:pt idx="3235">
                  <c:v>2169.29</c:v>
                </c:pt>
                <c:pt idx="3236">
                  <c:v>1081.73</c:v>
                </c:pt>
                <c:pt idx="3240">
                  <c:v>967.68</c:v>
                </c:pt>
                <c:pt idx="3244">
                  <c:v>1432.08</c:v>
                </c:pt>
                <c:pt idx="3257">
                  <c:v>3392.5</c:v>
                </c:pt>
                <c:pt idx="3259">
                  <c:v>1011.74</c:v>
                </c:pt>
                <c:pt idx="3260">
                  <c:v>1951.34</c:v>
                </c:pt>
                <c:pt idx="3261">
                  <c:v>676.94399999999996</c:v>
                </c:pt>
                <c:pt idx="3267">
                  <c:v>1539.86</c:v>
                </c:pt>
                <c:pt idx="3268">
                  <c:v>2354.4</c:v>
                </c:pt>
                <c:pt idx="3272">
                  <c:v>1469.66</c:v>
                </c:pt>
                <c:pt idx="3292">
                  <c:v>813.45600000000002</c:v>
                </c:pt>
                <c:pt idx="3295">
                  <c:v>1092.0999999999999</c:v>
                </c:pt>
                <c:pt idx="3299">
                  <c:v>1923.91</c:v>
                </c:pt>
                <c:pt idx="3306">
                  <c:v>4038.77</c:v>
                </c:pt>
                <c:pt idx="3308">
                  <c:v>1384.34</c:v>
                </c:pt>
                <c:pt idx="3318">
                  <c:v>1369.87</c:v>
                </c:pt>
                <c:pt idx="3324">
                  <c:v>874.15200000000004</c:v>
                </c:pt>
                <c:pt idx="3325">
                  <c:v>1022.54</c:v>
                </c:pt>
                <c:pt idx="3332">
                  <c:v>1275.9100000000001</c:v>
                </c:pt>
                <c:pt idx="3335">
                  <c:v>1146.31</c:v>
                </c:pt>
                <c:pt idx="3336">
                  <c:v>1213.27</c:v>
                </c:pt>
                <c:pt idx="3341">
                  <c:v>1461.89</c:v>
                </c:pt>
                <c:pt idx="3344">
                  <c:v>1207.8699999999999</c:v>
                </c:pt>
                <c:pt idx="3349">
                  <c:v>1061.6400000000001</c:v>
                </c:pt>
                <c:pt idx="3355">
                  <c:v>1695.82</c:v>
                </c:pt>
                <c:pt idx="3357">
                  <c:v>1356.26</c:v>
                </c:pt>
                <c:pt idx="3369">
                  <c:v>2701.94</c:v>
                </c:pt>
                <c:pt idx="3377">
                  <c:v>1114.3399999999999</c:v>
                </c:pt>
                <c:pt idx="3394">
                  <c:v>826.63199999999995</c:v>
                </c:pt>
                <c:pt idx="3398">
                  <c:v>1026.22</c:v>
                </c:pt>
                <c:pt idx="3399">
                  <c:v>1122.55</c:v>
                </c:pt>
                <c:pt idx="3402">
                  <c:v>1420.63</c:v>
                </c:pt>
                <c:pt idx="3410">
                  <c:v>1522.58</c:v>
                </c:pt>
                <c:pt idx="3413">
                  <c:v>1324.94</c:v>
                </c:pt>
                <c:pt idx="3414">
                  <c:v>1543.97</c:v>
                </c:pt>
                <c:pt idx="3416">
                  <c:v>1086.05</c:v>
                </c:pt>
                <c:pt idx="3417">
                  <c:v>2059.13</c:v>
                </c:pt>
                <c:pt idx="3420">
                  <c:v>1959.12</c:v>
                </c:pt>
                <c:pt idx="3423">
                  <c:v>1265.1099999999999</c:v>
                </c:pt>
                <c:pt idx="3431">
                  <c:v>2285.2800000000002</c:v>
                </c:pt>
                <c:pt idx="3438">
                  <c:v>1172.45</c:v>
                </c:pt>
                <c:pt idx="3450">
                  <c:v>1227.0999999999999</c:v>
                </c:pt>
                <c:pt idx="3457">
                  <c:v>913.68</c:v>
                </c:pt>
                <c:pt idx="3462">
                  <c:v>2088.29</c:v>
                </c:pt>
                <c:pt idx="3469">
                  <c:v>1815.48</c:v>
                </c:pt>
                <c:pt idx="3470">
                  <c:v>1359.94</c:v>
                </c:pt>
                <c:pt idx="3476">
                  <c:v>1627.34</c:v>
                </c:pt>
                <c:pt idx="3478">
                  <c:v>1213.7</c:v>
                </c:pt>
                <c:pt idx="3480">
                  <c:v>1564.27</c:v>
                </c:pt>
                <c:pt idx="3488">
                  <c:v>831.38400000000001</c:v>
                </c:pt>
                <c:pt idx="3501">
                  <c:v>883.00800000000004</c:v>
                </c:pt>
                <c:pt idx="3502">
                  <c:v>3269.81</c:v>
                </c:pt>
                <c:pt idx="3514">
                  <c:v>2019.6</c:v>
                </c:pt>
                <c:pt idx="3516">
                  <c:v>1495.58</c:v>
                </c:pt>
                <c:pt idx="3521">
                  <c:v>1997.35</c:v>
                </c:pt>
                <c:pt idx="3524">
                  <c:v>1953.94</c:v>
                </c:pt>
                <c:pt idx="3525">
                  <c:v>1068.3399999999999</c:v>
                </c:pt>
                <c:pt idx="3528">
                  <c:v>1470.74</c:v>
                </c:pt>
                <c:pt idx="3535">
                  <c:v>1066.6099999999999</c:v>
                </c:pt>
                <c:pt idx="3536">
                  <c:v>1602.94</c:v>
                </c:pt>
                <c:pt idx="3539">
                  <c:v>1763.64</c:v>
                </c:pt>
                <c:pt idx="3542">
                  <c:v>1245.67</c:v>
                </c:pt>
                <c:pt idx="3553">
                  <c:v>1783.73</c:v>
                </c:pt>
                <c:pt idx="3558">
                  <c:v>1172.6600000000001</c:v>
                </c:pt>
                <c:pt idx="3561">
                  <c:v>1037.8800000000001</c:v>
                </c:pt>
                <c:pt idx="3565">
                  <c:v>1326.89</c:v>
                </c:pt>
                <c:pt idx="3568">
                  <c:v>940.89599999999996</c:v>
                </c:pt>
                <c:pt idx="3569">
                  <c:v>4679.6400000000003</c:v>
                </c:pt>
                <c:pt idx="3570">
                  <c:v>1325.59</c:v>
                </c:pt>
                <c:pt idx="3579">
                  <c:v>2648.81</c:v>
                </c:pt>
                <c:pt idx="3580">
                  <c:v>1607.26</c:v>
                </c:pt>
                <c:pt idx="3595">
                  <c:v>1272.02</c:v>
                </c:pt>
                <c:pt idx="3600">
                  <c:v>972.21600000000001</c:v>
                </c:pt>
                <c:pt idx="3611">
                  <c:v>962.49599999999998</c:v>
                </c:pt>
                <c:pt idx="3619">
                  <c:v>4508.1400000000003</c:v>
                </c:pt>
                <c:pt idx="3622">
                  <c:v>903.096</c:v>
                </c:pt>
                <c:pt idx="3624">
                  <c:v>623.37599999999998</c:v>
                </c:pt>
                <c:pt idx="3632">
                  <c:v>1743.12</c:v>
                </c:pt>
                <c:pt idx="3634">
                  <c:v>882.14400000000001</c:v>
                </c:pt>
                <c:pt idx="3638">
                  <c:v>1138.97</c:v>
                </c:pt>
                <c:pt idx="3644">
                  <c:v>1025.57</c:v>
                </c:pt>
                <c:pt idx="3646">
                  <c:v>1528.85</c:v>
                </c:pt>
                <c:pt idx="3647">
                  <c:v>1441.15</c:v>
                </c:pt>
                <c:pt idx="3649">
                  <c:v>1940.54</c:v>
                </c:pt>
                <c:pt idx="3651">
                  <c:v>2324.38</c:v>
                </c:pt>
                <c:pt idx="3658">
                  <c:v>1032.9100000000001</c:v>
                </c:pt>
                <c:pt idx="3659">
                  <c:v>960.33600000000001</c:v>
                </c:pt>
                <c:pt idx="3663">
                  <c:v>1402.27</c:v>
                </c:pt>
                <c:pt idx="3665">
                  <c:v>1719.14</c:v>
                </c:pt>
                <c:pt idx="3671">
                  <c:v>1141.56</c:v>
                </c:pt>
                <c:pt idx="3682">
                  <c:v>1037.45</c:v>
                </c:pt>
                <c:pt idx="3683">
                  <c:v>2525.2600000000002</c:v>
                </c:pt>
                <c:pt idx="3693">
                  <c:v>838.72799999999995</c:v>
                </c:pt>
                <c:pt idx="3700">
                  <c:v>2307.31</c:v>
                </c:pt>
                <c:pt idx="3707">
                  <c:v>868.10400000000004</c:v>
                </c:pt>
                <c:pt idx="3708">
                  <c:v>1153.6600000000001</c:v>
                </c:pt>
                <c:pt idx="3716">
                  <c:v>1884.17</c:v>
                </c:pt>
                <c:pt idx="3717">
                  <c:v>1744.85</c:v>
                </c:pt>
                <c:pt idx="3720">
                  <c:v>1342.01</c:v>
                </c:pt>
                <c:pt idx="3723">
                  <c:v>862.70399999999995</c:v>
                </c:pt>
                <c:pt idx="3731">
                  <c:v>1053.8599999999999</c:v>
                </c:pt>
                <c:pt idx="3745">
                  <c:v>1301.6199999999999</c:v>
                </c:pt>
                <c:pt idx="3749">
                  <c:v>1070.28</c:v>
                </c:pt>
                <c:pt idx="3758">
                  <c:v>2018.74</c:v>
                </c:pt>
                <c:pt idx="3762">
                  <c:v>1312.42</c:v>
                </c:pt>
                <c:pt idx="3768">
                  <c:v>1670.98</c:v>
                </c:pt>
                <c:pt idx="3772">
                  <c:v>898.12800000000004</c:v>
                </c:pt>
                <c:pt idx="3777">
                  <c:v>1940.98</c:v>
                </c:pt>
                <c:pt idx="3781">
                  <c:v>1851.12</c:v>
                </c:pt>
                <c:pt idx="3790">
                  <c:v>1556.93</c:v>
                </c:pt>
                <c:pt idx="3791">
                  <c:v>7534.51</c:v>
                </c:pt>
                <c:pt idx="3793">
                  <c:v>918.86400000000003</c:v>
                </c:pt>
                <c:pt idx="3794">
                  <c:v>1010.45</c:v>
                </c:pt>
                <c:pt idx="3800">
                  <c:v>678.67200000000003</c:v>
                </c:pt>
                <c:pt idx="3801">
                  <c:v>1439.42</c:v>
                </c:pt>
                <c:pt idx="3803">
                  <c:v>1157.76</c:v>
                </c:pt>
                <c:pt idx="3813">
                  <c:v>3867.05</c:v>
                </c:pt>
                <c:pt idx="3814">
                  <c:v>1409.18</c:v>
                </c:pt>
                <c:pt idx="3820">
                  <c:v>3699</c:v>
                </c:pt>
                <c:pt idx="3829">
                  <c:v>1594.08</c:v>
                </c:pt>
                <c:pt idx="3830">
                  <c:v>1327.32</c:v>
                </c:pt>
                <c:pt idx="3834">
                  <c:v>1453.9</c:v>
                </c:pt>
                <c:pt idx="3840">
                  <c:v>1888.06</c:v>
                </c:pt>
                <c:pt idx="3843">
                  <c:v>1424.52</c:v>
                </c:pt>
                <c:pt idx="3845">
                  <c:v>973.94399999999996</c:v>
                </c:pt>
                <c:pt idx="3848">
                  <c:v>1071.58</c:v>
                </c:pt>
                <c:pt idx="3861">
                  <c:v>2795.9</c:v>
                </c:pt>
                <c:pt idx="3870">
                  <c:v>1215</c:v>
                </c:pt>
                <c:pt idx="3872">
                  <c:v>1293.6199999999999</c:v>
                </c:pt>
                <c:pt idx="3873">
                  <c:v>1161</c:v>
                </c:pt>
                <c:pt idx="3874">
                  <c:v>1311.55</c:v>
                </c:pt>
                <c:pt idx="3875">
                  <c:v>1528.2</c:v>
                </c:pt>
                <c:pt idx="3876">
                  <c:v>1567.08</c:v>
                </c:pt>
                <c:pt idx="3890">
                  <c:v>1331.86</c:v>
                </c:pt>
                <c:pt idx="3896">
                  <c:v>1407.67</c:v>
                </c:pt>
                <c:pt idx="3897">
                  <c:v>1205.71</c:v>
                </c:pt>
                <c:pt idx="3899">
                  <c:v>2232.36</c:v>
                </c:pt>
                <c:pt idx="3900">
                  <c:v>1092.96</c:v>
                </c:pt>
                <c:pt idx="3905">
                  <c:v>1015.63</c:v>
                </c:pt>
                <c:pt idx="3911">
                  <c:v>1332.5</c:v>
                </c:pt>
                <c:pt idx="3913">
                  <c:v>2517.2600000000002</c:v>
                </c:pt>
                <c:pt idx="3914">
                  <c:v>1145.45</c:v>
                </c:pt>
                <c:pt idx="3932">
                  <c:v>1199.8800000000001</c:v>
                </c:pt>
                <c:pt idx="3942">
                  <c:v>1065.53</c:v>
                </c:pt>
                <c:pt idx="3950">
                  <c:v>1111.97</c:v>
                </c:pt>
                <c:pt idx="3959">
                  <c:v>1193.83</c:v>
                </c:pt>
                <c:pt idx="3965">
                  <c:v>2286.36</c:v>
                </c:pt>
                <c:pt idx="3974">
                  <c:v>646.05600000000004</c:v>
                </c:pt>
                <c:pt idx="3977">
                  <c:v>1516.75</c:v>
                </c:pt>
                <c:pt idx="3979">
                  <c:v>2135.59</c:v>
                </c:pt>
                <c:pt idx="3985">
                  <c:v>997.70399999999995</c:v>
                </c:pt>
                <c:pt idx="3988">
                  <c:v>1193.4000000000001</c:v>
                </c:pt>
                <c:pt idx="3989">
                  <c:v>1886.11</c:v>
                </c:pt>
                <c:pt idx="3992">
                  <c:v>1117.58</c:v>
                </c:pt>
                <c:pt idx="3993">
                  <c:v>1186.49</c:v>
                </c:pt>
                <c:pt idx="4010">
                  <c:v>1828.87</c:v>
                </c:pt>
                <c:pt idx="4014">
                  <c:v>1010.88</c:v>
                </c:pt>
                <c:pt idx="4016">
                  <c:v>1247.18</c:v>
                </c:pt>
                <c:pt idx="4018">
                  <c:v>1548.07</c:v>
                </c:pt>
                <c:pt idx="4019">
                  <c:v>1638.14</c:v>
                </c:pt>
                <c:pt idx="4022">
                  <c:v>1739.45</c:v>
                </c:pt>
                <c:pt idx="4025">
                  <c:v>1054.73</c:v>
                </c:pt>
                <c:pt idx="4042">
                  <c:v>992.952</c:v>
                </c:pt>
                <c:pt idx="4055">
                  <c:v>1563.41</c:v>
                </c:pt>
                <c:pt idx="4059">
                  <c:v>2530.2199999999998</c:v>
                </c:pt>
                <c:pt idx="4063">
                  <c:v>1086.05</c:v>
                </c:pt>
                <c:pt idx="4067">
                  <c:v>1283.04</c:v>
                </c:pt>
                <c:pt idx="4076">
                  <c:v>1320.41</c:v>
                </c:pt>
                <c:pt idx="4077">
                  <c:v>2272.3200000000002</c:v>
                </c:pt>
                <c:pt idx="4080">
                  <c:v>827.06399999999996</c:v>
                </c:pt>
                <c:pt idx="4081">
                  <c:v>1526.69</c:v>
                </c:pt>
                <c:pt idx="4087">
                  <c:v>1672.49</c:v>
                </c:pt>
                <c:pt idx="4089">
                  <c:v>1318.03</c:v>
                </c:pt>
                <c:pt idx="4096">
                  <c:v>1505.3</c:v>
                </c:pt>
                <c:pt idx="4107">
                  <c:v>832.68</c:v>
                </c:pt>
                <c:pt idx="4116">
                  <c:v>1924.99</c:v>
                </c:pt>
                <c:pt idx="4118">
                  <c:v>1540.94</c:v>
                </c:pt>
                <c:pt idx="4121">
                  <c:v>1148.47</c:v>
                </c:pt>
                <c:pt idx="4125">
                  <c:v>1408.1</c:v>
                </c:pt>
                <c:pt idx="4126">
                  <c:v>2949.7</c:v>
                </c:pt>
                <c:pt idx="4127">
                  <c:v>1019.52</c:v>
                </c:pt>
                <c:pt idx="4133">
                  <c:v>1087.56</c:v>
                </c:pt>
                <c:pt idx="4138">
                  <c:v>1412.42</c:v>
                </c:pt>
                <c:pt idx="4139">
                  <c:v>3459.02</c:v>
                </c:pt>
                <c:pt idx="4141">
                  <c:v>1105.7</c:v>
                </c:pt>
                <c:pt idx="4143">
                  <c:v>1552.39</c:v>
                </c:pt>
                <c:pt idx="4145">
                  <c:v>1189.08</c:v>
                </c:pt>
                <c:pt idx="4150">
                  <c:v>1380.67</c:v>
                </c:pt>
                <c:pt idx="4154">
                  <c:v>1829.3</c:v>
                </c:pt>
                <c:pt idx="4159">
                  <c:v>1162.51</c:v>
                </c:pt>
                <c:pt idx="4161">
                  <c:v>2115.94</c:v>
                </c:pt>
                <c:pt idx="4163">
                  <c:v>856.00800000000004</c:v>
                </c:pt>
                <c:pt idx="4177">
                  <c:v>1078.06</c:v>
                </c:pt>
                <c:pt idx="4183">
                  <c:v>944.78399999999999</c:v>
                </c:pt>
                <c:pt idx="4185">
                  <c:v>1279.8</c:v>
                </c:pt>
                <c:pt idx="4188">
                  <c:v>1750.03</c:v>
                </c:pt>
                <c:pt idx="4206">
                  <c:v>1503.79</c:v>
                </c:pt>
                <c:pt idx="4207">
                  <c:v>1299.46</c:v>
                </c:pt>
                <c:pt idx="4209">
                  <c:v>1639.01</c:v>
                </c:pt>
                <c:pt idx="4217">
                  <c:v>1124.93</c:v>
                </c:pt>
                <c:pt idx="4223">
                  <c:v>1105.27</c:v>
                </c:pt>
                <c:pt idx="4225">
                  <c:v>4805.57</c:v>
                </c:pt>
                <c:pt idx="4226">
                  <c:v>3114.29</c:v>
                </c:pt>
                <c:pt idx="4227">
                  <c:v>4472.0600000000004</c:v>
                </c:pt>
                <c:pt idx="4230">
                  <c:v>2981.88</c:v>
                </c:pt>
                <c:pt idx="4233">
                  <c:v>1075.68</c:v>
                </c:pt>
                <c:pt idx="4239">
                  <c:v>1418.47</c:v>
                </c:pt>
                <c:pt idx="4240">
                  <c:v>956.88</c:v>
                </c:pt>
                <c:pt idx="4241">
                  <c:v>3603.96</c:v>
                </c:pt>
                <c:pt idx="4248">
                  <c:v>1151.93</c:v>
                </c:pt>
                <c:pt idx="4252">
                  <c:v>1101.17</c:v>
                </c:pt>
                <c:pt idx="4273">
                  <c:v>1583.71</c:v>
                </c:pt>
                <c:pt idx="4274">
                  <c:v>79.055999999999997</c:v>
                </c:pt>
                <c:pt idx="4280">
                  <c:v>1101.3800000000001</c:v>
                </c:pt>
                <c:pt idx="4289">
                  <c:v>1605.74</c:v>
                </c:pt>
                <c:pt idx="4291">
                  <c:v>1807.7</c:v>
                </c:pt>
                <c:pt idx="4292">
                  <c:v>1546.34</c:v>
                </c:pt>
                <c:pt idx="4296">
                  <c:v>4302.9399999999996</c:v>
                </c:pt>
                <c:pt idx="4298">
                  <c:v>1014.98</c:v>
                </c:pt>
                <c:pt idx="4301">
                  <c:v>4453.2700000000004</c:v>
                </c:pt>
                <c:pt idx="4302">
                  <c:v>577.36800000000005</c:v>
                </c:pt>
                <c:pt idx="4309">
                  <c:v>1624.97</c:v>
                </c:pt>
                <c:pt idx="4317">
                  <c:v>1423.01</c:v>
                </c:pt>
                <c:pt idx="4331">
                  <c:v>5890.32</c:v>
                </c:pt>
                <c:pt idx="4333">
                  <c:v>1505.3</c:v>
                </c:pt>
                <c:pt idx="4335">
                  <c:v>1034.21</c:v>
                </c:pt>
                <c:pt idx="4341">
                  <c:v>1075.03</c:v>
                </c:pt>
                <c:pt idx="4346">
                  <c:v>1447.2</c:v>
                </c:pt>
                <c:pt idx="4348">
                  <c:v>2359.8000000000002</c:v>
                </c:pt>
                <c:pt idx="4349">
                  <c:v>1184.1099999999999</c:v>
                </c:pt>
                <c:pt idx="4351">
                  <c:v>1460.16</c:v>
                </c:pt>
                <c:pt idx="4352">
                  <c:v>2726.57</c:v>
                </c:pt>
                <c:pt idx="4353">
                  <c:v>1248.9100000000001</c:v>
                </c:pt>
                <c:pt idx="4360">
                  <c:v>2702.16</c:v>
                </c:pt>
                <c:pt idx="4374">
                  <c:v>916.70399999999995</c:v>
                </c:pt>
                <c:pt idx="4383">
                  <c:v>782.35199999999998</c:v>
                </c:pt>
                <c:pt idx="4385">
                  <c:v>2147.2600000000002</c:v>
                </c:pt>
                <c:pt idx="4387">
                  <c:v>1244.81</c:v>
                </c:pt>
                <c:pt idx="4390">
                  <c:v>1361.45</c:v>
                </c:pt>
                <c:pt idx="4398">
                  <c:v>1594.08</c:v>
                </c:pt>
                <c:pt idx="4400">
                  <c:v>1148.69</c:v>
                </c:pt>
                <c:pt idx="4403">
                  <c:v>1336.39</c:v>
                </c:pt>
                <c:pt idx="4420">
                  <c:v>1443.1</c:v>
                </c:pt>
                <c:pt idx="4426">
                  <c:v>1034.6400000000001</c:v>
                </c:pt>
                <c:pt idx="4434">
                  <c:v>1188.22</c:v>
                </c:pt>
                <c:pt idx="4438">
                  <c:v>1172.23</c:v>
                </c:pt>
                <c:pt idx="4444">
                  <c:v>1702.3</c:v>
                </c:pt>
                <c:pt idx="4445">
                  <c:v>1866.89</c:v>
                </c:pt>
                <c:pt idx="4449">
                  <c:v>1265.54</c:v>
                </c:pt>
                <c:pt idx="4455">
                  <c:v>1034.21</c:v>
                </c:pt>
                <c:pt idx="4457">
                  <c:v>1146.31</c:v>
                </c:pt>
                <c:pt idx="4458">
                  <c:v>1941.19</c:v>
                </c:pt>
                <c:pt idx="4459">
                  <c:v>1489.1</c:v>
                </c:pt>
                <c:pt idx="4465">
                  <c:v>1055.5899999999999</c:v>
                </c:pt>
                <c:pt idx="4473">
                  <c:v>2665.44</c:v>
                </c:pt>
                <c:pt idx="4474">
                  <c:v>1224.29</c:v>
                </c:pt>
                <c:pt idx="4475">
                  <c:v>1272.46</c:v>
                </c:pt>
                <c:pt idx="4478">
                  <c:v>1460.81</c:v>
                </c:pt>
                <c:pt idx="4479">
                  <c:v>1460.59</c:v>
                </c:pt>
                <c:pt idx="4481">
                  <c:v>890.35199999999998</c:v>
                </c:pt>
                <c:pt idx="4484">
                  <c:v>1113.7</c:v>
                </c:pt>
                <c:pt idx="4486">
                  <c:v>1175.69</c:v>
                </c:pt>
                <c:pt idx="4497">
                  <c:v>1138.32</c:v>
                </c:pt>
                <c:pt idx="4504">
                  <c:v>1359.07</c:v>
                </c:pt>
                <c:pt idx="4514">
                  <c:v>1570.1</c:v>
                </c:pt>
                <c:pt idx="4516">
                  <c:v>3348.65</c:v>
                </c:pt>
                <c:pt idx="4520">
                  <c:v>2191.54</c:v>
                </c:pt>
                <c:pt idx="4523">
                  <c:v>1626.91</c:v>
                </c:pt>
                <c:pt idx="4525">
                  <c:v>903.31200000000001</c:v>
                </c:pt>
                <c:pt idx="4527">
                  <c:v>1307.8800000000001</c:v>
                </c:pt>
                <c:pt idx="4531">
                  <c:v>1695.38</c:v>
                </c:pt>
                <c:pt idx="4542">
                  <c:v>790.12800000000004</c:v>
                </c:pt>
                <c:pt idx="4551">
                  <c:v>1287.1400000000001</c:v>
                </c:pt>
                <c:pt idx="4568">
                  <c:v>1230.98</c:v>
                </c:pt>
                <c:pt idx="4569">
                  <c:v>2907.14</c:v>
                </c:pt>
                <c:pt idx="4570">
                  <c:v>1440.94</c:v>
                </c:pt>
                <c:pt idx="4585">
                  <c:v>1522.8</c:v>
                </c:pt>
                <c:pt idx="4593">
                  <c:v>1275.9100000000001</c:v>
                </c:pt>
                <c:pt idx="4598">
                  <c:v>2020.25</c:v>
                </c:pt>
                <c:pt idx="4599">
                  <c:v>1739.88</c:v>
                </c:pt>
                <c:pt idx="4601">
                  <c:v>2163.02</c:v>
                </c:pt>
                <c:pt idx="4606">
                  <c:v>1317.17</c:v>
                </c:pt>
                <c:pt idx="4607">
                  <c:v>1572.26</c:v>
                </c:pt>
                <c:pt idx="4608">
                  <c:v>4106.16</c:v>
                </c:pt>
                <c:pt idx="4613">
                  <c:v>2302.13</c:v>
                </c:pt>
                <c:pt idx="4614">
                  <c:v>4156.92</c:v>
                </c:pt>
                <c:pt idx="4615">
                  <c:v>1151.06</c:v>
                </c:pt>
                <c:pt idx="4626">
                  <c:v>1092.74</c:v>
                </c:pt>
                <c:pt idx="4649">
                  <c:v>1057.75</c:v>
                </c:pt>
                <c:pt idx="4650">
                  <c:v>1111.97</c:v>
                </c:pt>
                <c:pt idx="4674">
                  <c:v>1325.16</c:v>
                </c:pt>
                <c:pt idx="4675">
                  <c:v>1238.76</c:v>
                </c:pt>
                <c:pt idx="4678">
                  <c:v>2300.62</c:v>
                </c:pt>
                <c:pt idx="4681">
                  <c:v>1456.49</c:v>
                </c:pt>
                <c:pt idx="4687">
                  <c:v>980.42399999999998</c:v>
                </c:pt>
                <c:pt idx="4692">
                  <c:v>1244.1600000000001</c:v>
                </c:pt>
                <c:pt idx="4694">
                  <c:v>1402.49</c:v>
                </c:pt>
                <c:pt idx="4695">
                  <c:v>1206.58</c:v>
                </c:pt>
                <c:pt idx="4698">
                  <c:v>956.44799999999998</c:v>
                </c:pt>
                <c:pt idx="4699">
                  <c:v>1543.32</c:v>
                </c:pt>
                <c:pt idx="4702">
                  <c:v>947.80799999999999</c:v>
                </c:pt>
                <c:pt idx="4707">
                  <c:v>1232.71</c:v>
                </c:pt>
                <c:pt idx="4711">
                  <c:v>5428.73</c:v>
                </c:pt>
                <c:pt idx="4713">
                  <c:v>2311.85</c:v>
                </c:pt>
                <c:pt idx="4722">
                  <c:v>1409.4</c:v>
                </c:pt>
                <c:pt idx="4726">
                  <c:v>1022.54</c:v>
                </c:pt>
                <c:pt idx="4728">
                  <c:v>1084.32</c:v>
                </c:pt>
                <c:pt idx="4739">
                  <c:v>805.24800000000005</c:v>
                </c:pt>
                <c:pt idx="4745">
                  <c:v>1317.38</c:v>
                </c:pt>
                <c:pt idx="4746">
                  <c:v>1670.54</c:v>
                </c:pt>
                <c:pt idx="4748">
                  <c:v>1129.03</c:v>
                </c:pt>
                <c:pt idx="4753">
                  <c:v>1030.54</c:v>
                </c:pt>
                <c:pt idx="4754">
                  <c:v>816.69600000000003</c:v>
                </c:pt>
                <c:pt idx="4756">
                  <c:v>4126.8999999999996</c:v>
                </c:pt>
                <c:pt idx="4758">
                  <c:v>1426.25</c:v>
                </c:pt>
                <c:pt idx="4762">
                  <c:v>1483.92</c:v>
                </c:pt>
                <c:pt idx="4763">
                  <c:v>2181.8200000000002</c:v>
                </c:pt>
                <c:pt idx="4767">
                  <c:v>1536.19</c:v>
                </c:pt>
                <c:pt idx="4768">
                  <c:v>1687.61</c:v>
                </c:pt>
                <c:pt idx="4774">
                  <c:v>3021.19</c:v>
                </c:pt>
                <c:pt idx="4775">
                  <c:v>1543.54</c:v>
                </c:pt>
                <c:pt idx="4779">
                  <c:v>904.60799999999995</c:v>
                </c:pt>
                <c:pt idx="4782">
                  <c:v>1246.32</c:v>
                </c:pt>
                <c:pt idx="4788">
                  <c:v>2886.41</c:v>
                </c:pt>
                <c:pt idx="4792">
                  <c:v>1605.74</c:v>
                </c:pt>
                <c:pt idx="4801">
                  <c:v>1124.71</c:v>
                </c:pt>
                <c:pt idx="4809">
                  <c:v>1076.33</c:v>
                </c:pt>
                <c:pt idx="4815">
                  <c:v>8492.4699999999993</c:v>
                </c:pt>
                <c:pt idx="4831">
                  <c:v>1070.06</c:v>
                </c:pt>
                <c:pt idx="4833">
                  <c:v>1734.91</c:v>
                </c:pt>
                <c:pt idx="4839">
                  <c:v>1317.38</c:v>
                </c:pt>
                <c:pt idx="4842">
                  <c:v>911.73599999999999</c:v>
                </c:pt>
                <c:pt idx="4846">
                  <c:v>1452.6</c:v>
                </c:pt>
                <c:pt idx="4850">
                  <c:v>921.67200000000003</c:v>
                </c:pt>
                <c:pt idx="4867">
                  <c:v>983.66399999999999</c:v>
                </c:pt>
                <c:pt idx="4879">
                  <c:v>1579.39</c:v>
                </c:pt>
                <c:pt idx="4889">
                  <c:v>1865.81</c:v>
                </c:pt>
                <c:pt idx="4892">
                  <c:v>1179.3599999999999</c:v>
                </c:pt>
                <c:pt idx="4895">
                  <c:v>668.08799999999997</c:v>
                </c:pt>
                <c:pt idx="4899">
                  <c:v>1128.82</c:v>
                </c:pt>
                <c:pt idx="4901">
                  <c:v>994.68</c:v>
                </c:pt>
                <c:pt idx="4903">
                  <c:v>1498.39</c:v>
                </c:pt>
                <c:pt idx="4905">
                  <c:v>990.36</c:v>
                </c:pt>
                <c:pt idx="4913">
                  <c:v>759.24</c:v>
                </c:pt>
                <c:pt idx="4915">
                  <c:v>2750.11</c:v>
                </c:pt>
                <c:pt idx="4922">
                  <c:v>1380.46</c:v>
                </c:pt>
                <c:pt idx="4927">
                  <c:v>1485.65</c:v>
                </c:pt>
                <c:pt idx="4932">
                  <c:v>746.06399999999996</c:v>
                </c:pt>
                <c:pt idx="4934">
                  <c:v>1602.5</c:v>
                </c:pt>
                <c:pt idx="4936">
                  <c:v>1013.04</c:v>
                </c:pt>
                <c:pt idx="4937">
                  <c:v>1195.1300000000001</c:v>
                </c:pt>
                <c:pt idx="4943">
                  <c:v>1763.21</c:v>
                </c:pt>
                <c:pt idx="4944">
                  <c:v>1339.85</c:v>
                </c:pt>
                <c:pt idx="4945">
                  <c:v>1255.3900000000001</c:v>
                </c:pt>
                <c:pt idx="4951">
                  <c:v>1297.94</c:v>
                </c:pt>
                <c:pt idx="4959">
                  <c:v>1323.86</c:v>
                </c:pt>
                <c:pt idx="4963">
                  <c:v>1185.8399999999999</c:v>
                </c:pt>
                <c:pt idx="4965">
                  <c:v>944.78399999999999</c:v>
                </c:pt>
                <c:pt idx="4968">
                  <c:v>1188.22</c:v>
                </c:pt>
                <c:pt idx="4969">
                  <c:v>2554.42</c:v>
                </c:pt>
                <c:pt idx="4975">
                  <c:v>1409.18</c:v>
                </c:pt>
                <c:pt idx="4976">
                  <c:v>1246.0999999999999</c:v>
                </c:pt>
                <c:pt idx="4977">
                  <c:v>744.76800000000003</c:v>
                </c:pt>
                <c:pt idx="4983">
                  <c:v>1203.77</c:v>
                </c:pt>
                <c:pt idx="4999">
                  <c:v>2886.41</c:v>
                </c:pt>
                <c:pt idx="5002">
                  <c:v>1168.99</c:v>
                </c:pt>
                <c:pt idx="5003">
                  <c:v>1298.1600000000001</c:v>
                </c:pt>
                <c:pt idx="5005">
                  <c:v>1232.93</c:v>
                </c:pt>
                <c:pt idx="5015">
                  <c:v>1117.58</c:v>
                </c:pt>
                <c:pt idx="5022">
                  <c:v>1095.55</c:v>
                </c:pt>
                <c:pt idx="5024">
                  <c:v>1176.3399999999999</c:v>
                </c:pt>
                <c:pt idx="5032">
                  <c:v>6346.08</c:v>
                </c:pt>
                <c:pt idx="5039">
                  <c:v>2413.15</c:v>
                </c:pt>
                <c:pt idx="5042">
                  <c:v>1294.49</c:v>
                </c:pt>
                <c:pt idx="5048">
                  <c:v>3192.48</c:v>
                </c:pt>
                <c:pt idx="5054">
                  <c:v>1226.02</c:v>
                </c:pt>
                <c:pt idx="5057">
                  <c:v>1214.1400000000001</c:v>
                </c:pt>
                <c:pt idx="5062">
                  <c:v>1720.01</c:v>
                </c:pt>
                <c:pt idx="5075">
                  <c:v>1754.78</c:v>
                </c:pt>
                <c:pt idx="5079">
                  <c:v>3125.52</c:v>
                </c:pt>
                <c:pt idx="5084">
                  <c:v>921.67200000000003</c:v>
                </c:pt>
                <c:pt idx="5086">
                  <c:v>1704.67</c:v>
                </c:pt>
                <c:pt idx="5087">
                  <c:v>1472.69</c:v>
                </c:pt>
                <c:pt idx="5092">
                  <c:v>4772.5200000000004</c:v>
                </c:pt>
                <c:pt idx="5093">
                  <c:v>1608.12</c:v>
                </c:pt>
                <c:pt idx="5094">
                  <c:v>916.48800000000006</c:v>
                </c:pt>
                <c:pt idx="5102">
                  <c:v>1415.45</c:v>
                </c:pt>
                <c:pt idx="5104">
                  <c:v>654.91200000000003</c:v>
                </c:pt>
                <c:pt idx="5106">
                  <c:v>2647.73</c:v>
                </c:pt>
                <c:pt idx="5109">
                  <c:v>1235.0899999999999</c:v>
                </c:pt>
                <c:pt idx="5111">
                  <c:v>4236.41</c:v>
                </c:pt>
                <c:pt idx="5114">
                  <c:v>1052.3499999999999</c:v>
                </c:pt>
                <c:pt idx="5120">
                  <c:v>1437.91</c:v>
                </c:pt>
                <c:pt idx="5121">
                  <c:v>1980.5</c:v>
                </c:pt>
                <c:pt idx="5128">
                  <c:v>958.60799999999995</c:v>
                </c:pt>
                <c:pt idx="5130">
                  <c:v>4124.5200000000004</c:v>
                </c:pt>
                <c:pt idx="5133">
                  <c:v>1375.49</c:v>
                </c:pt>
                <c:pt idx="5136">
                  <c:v>2746.87</c:v>
                </c:pt>
                <c:pt idx="5138">
                  <c:v>1058.18</c:v>
                </c:pt>
                <c:pt idx="5140">
                  <c:v>3050.14</c:v>
                </c:pt>
                <c:pt idx="5147">
                  <c:v>1982.66</c:v>
                </c:pt>
                <c:pt idx="5153">
                  <c:v>1264.25</c:v>
                </c:pt>
                <c:pt idx="5155">
                  <c:v>1414.58</c:v>
                </c:pt>
                <c:pt idx="5156">
                  <c:v>1220.6199999999999</c:v>
                </c:pt>
                <c:pt idx="5171">
                  <c:v>1148.04</c:v>
                </c:pt>
                <c:pt idx="5187">
                  <c:v>1644.41</c:v>
                </c:pt>
                <c:pt idx="5193">
                  <c:v>874.15200000000004</c:v>
                </c:pt>
                <c:pt idx="5201">
                  <c:v>1603.8</c:v>
                </c:pt>
                <c:pt idx="5203">
                  <c:v>2480.54</c:v>
                </c:pt>
                <c:pt idx="5205">
                  <c:v>1511.35</c:v>
                </c:pt>
                <c:pt idx="5208">
                  <c:v>3035.88</c:v>
                </c:pt>
                <c:pt idx="5211">
                  <c:v>1552.61</c:v>
                </c:pt>
                <c:pt idx="5212">
                  <c:v>848.88</c:v>
                </c:pt>
                <c:pt idx="5227">
                  <c:v>1535.33</c:v>
                </c:pt>
                <c:pt idx="5228">
                  <c:v>1268.78</c:v>
                </c:pt>
                <c:pt idx="5231">
                  <c:v>1557.79</c:v>
                </c:pt>
                <c:pt idx="5234">
                  <c:v>989.49599999999998</c:v>
                </c:pt>
                <c:pt idx="5242">
                  <c:v>1393.2</c:v>
                </c:pt>
                <c:pt idx="5245">
                  <c:v>1221.26</c:v>
                </c:pt>
                <c:pt idx="5248">
                  <c:v>1623.46</c:v>
                </c:pt>
                <c:pt idx="5252">
                  <c:v>1919.81</c:v>
                </c:pt>
                <c:pt idx="5253">
                  <c:v>1394.93</c:v>
                </c:pt>
                <c:pt idx="5259">
                  <c:v>680.4</c:v>
                </c:pt>
                <c:pt idx="5263">
                  <c:v>1521.72</c:v>
                </c:pt>
                <c:pt idx="5272">
                  <c:v>1000.08</c:v>
                </c:pt>
                <c:pt idx="5280">
                  <c:v>2987.93</c:v>
                </c:pt>
                <c:pt idx="5284">
                  <c:v>903.96</c:v>
                </c:pt>
                <c:pt idx="5291">
                  <c:v>1445.26</c:v>
                </c:pt>
                <c:pt idx="5310">
                  <c:v>1199.23</c:v>
                </c:pt>
                <c:pt idx="5316">
                  <c:v>1195.3399999999999</c:v>
                </c:pt>
                <c:pt idx="5318">
                  <c:v>1310.9</c:v>
                </c:pt>
                <c:pt idx="5324">
                  <c:v>1759.32</c:v>
                </c:pt>
                <c:pt idx="5328">
                  <c:v>1232.5</c:v>
                </c:pt>
                <c:pt idx="5336">
                  <c:v>1334.23</c:v>
                </c:pt>
                <c:pt idx="5337">
                  <c:v>1460.81</c:v>
                </c:pt>
                <c:pt idx="5343">
                  <c:v>918.64800000000002</c:v>
                </c:pt>
                <c:pt idx="5345">
                  <c:v>1995.19</c:v>
                </c:pt>
                <c:pt idx="5350">
                  <c:v>1002.02</c:v>
                </c:pt>
                <c:pt idx="5351">
                  <c:v>947.59199999999998</c:v>
                </c:pt>
                <c:pt idx="5357">
                  <c:v>878.47199999999998</c:v>
                </c:pt>
                <c:pt idx="5358">
                  <c:v>2516.4</c:v>
                </c:pt>
                <c:pt idx="5373">
                  <c:v>1419.55</c:v>
                </c:pt>
                <c:pt idx="5382">
                  <c:v>1638.36</c:v>
                </c:pt>
                <c:pt idx="5387">
                  <c:v>988.84799999999996</c:v>
                </c:pt>
                <c:pt idx="5392">
                  <c:v>1087.3399999999999</c:v>
                </c:pt>
                <c:pt idx="5397">
                  <c:v>1308.0999999999999</c:v>
                </c:pt>
                <c:pt idx="5399">
                  <c:v>2180.7399999999998</c:v>
                </c:pt>
                <c:pt idx="5402">
                  <c:v>952.56</c:v>
                </c:pt>
                <c:pt idx="5406">
                  <c:v>1324.08</c:v>
                </c:pt>
                <c:pt idx="5411">
                  <c:v>2099.3000000000002</c:v>
                </c:pt>
                <c:pt idx="5418">
                  <c:v>909.36</c:v>
                </c:pt>
                <c:pt idx="5419">
                  <c:v>2286.58</c:v>
                </c:pt>
                <c:pt idx="5425">
                  <c:v>3038.26</c:v>
                </c:pt>
                <c:pt idx="5438">
                  <c:v>1577.23</c:v>
                </c:pt>
                <c:pt idx="5439">
                  <c:v>1317.6</c:v>
                </c:pt>
                <c:pt idx="5442">
                  <c:v>2949.26</c:v>
                </c:pt>
                <c:pt idx="5443">
                  <c:v>2793.31</c:v>
                </c:pt>
                <c:pt idx="5445">
                  <c:v>2406.89</c:v>
                </c:pt>
                <c:pt idx="5447">
                  <c:v>1733.4</c:v>
                </c:pt>
                <c:pt idx="5448">
                  <c:v>733.10400000000004</c:v>
                </c:pt>
                <c:pt idx="5453">
                  <c:v>847.8</c:v>
                </c:pt>
                <c:pt idx="5455">
                  <c:v>1215</c:v>
                </c:pt>
                <c:pt idx="5456">
                  <c:v>1435.54</c:v>
                </c:pt>
                <c:pt idx="5460">
                  <c:v>9607.25</c:v>
                </c:pt>
                <c:pt idx="5466">
                  <c:v>1289.74</c:v>
                </c:pt>
                <c:pt idx="5467">
                  <c:v>1101.5999999999999</c:v>
                </c:pt>
                <c:pt idx="5471">
                  <c:v>1367.28</c:v>
                </c:pt>
                <c:pt idx="5473">
                  <c:v>2233.87</c:v>
                </c:pt>
                <c:pt idx="5479">
                  <c:v>1341.79</c:v>
                </c:pt>
                <c:pt idx="5483">
                  <c:v>1366.2</c:v>
                </c:pt>
                <c:pt idx="5488">
                  <c:v>1521.94</c:v>
                </c:pt>
                <c:pt idx="5493">
                  <c:v>1258.42</c:v>
                </c:pt>
                <c:pt idx="5494">
                  <c:v>1317.82</c:v>
                </c:pt>
                <c:pt idx="5514">
                  <c:v>9400.9699999999993</c:v>
                </c:pt>
                <c:pt idx="5526">
                  <c:v>997.05600000000004</c:v>
                </c:pt>
                <c:pt idx="5533">
                  <c:v>1566</c:v>
                </c:pt>
                <c:pt idx="5536">
                  <c:v>1128.5999999999999</c:v>
                </c:pt>
                <c:pt idx="5537">
                  <c:v>1378.08</c:v>
                </c:pt>
                <c:pt idx="5545">
                  <c:v>1480.46</c:v>
                </c:pt>
                <c:pt idx="5550">
                  <c:v>922.75199999999995</c:v>
                </c:pt>
                <c:pt idx="5553">
                  <c:v>2167.34</c:v>
                </c:pt>
                <c:pt idx="5566">
                  <c:v>2772.79</c:v>
                </c:pt>
                <c:pt idx="5569">
                  <c:v>1452.38</c:v>
                </c:pt>
                <c:pt idx="5570">
                  <c:v>730.72799999999995</c:v>
                </c:pt>
                <c:pt idx="5581">
                  <c:v>2297.16</c:v>
                </c:pt>
                <c:pt idx="5583">
                  <c:v>2568.89</c:v>
                </c:pt>
                <c:pt idx="5589">
                  <c:v>1319.33</c:v>
                </c:pt>
                <c:pt idx="5598">
                  <c:v>1380.89</c:v>
                </c:pt>
                <c:pt idx="5599">
                  <c:v>1704.24</c:v>
                </c:pt>
                <c:pt idx="5600">
                  <c:v>1090.1500000000001</c:v>
                </c:pt>
                <c:pt idx="5601">
                  <c:v>1731.67</c:v>
                </c:pt>
                <c:pt idx="5605">
                  <c:v>614.08799999999997</c:v>
                </c:pt>
                <c:pt idx="5607">
                  <c:v>1236.3800000000001</c:v>
                </c:pt>
                <c:pt idx="5611">
                  <c:v>4869.9399999999996</c:v>
                </c:pt>
                <c:pt idx="5615">
                  <c:v>839.59199999999998</c:v>
                </c:pt>
                <c:pt idx="5629">
                  <c:v>1254.0999999999999</c:v>
                </c:pt>
                <c:pt idx="5630">
                  <c:v>1026.43</c:v>
                </c:pt>
                <c:pt idx="5636">
                  <c:v>1791.07</c:v>
                </c:pt>
                <c:pt idx="5638">
                  <c:v>2166.0500000000002</c:v>
                </c:pt>
                <c:pt idx="5640">
                  <c:v>1922.83</c:v>
                </c:pt>
                <c:pt idx="5641">
                  <c:v>1625.62</c:v>
                </c:pt>
                <c:pt idx="5648">
                  <c:v>1400.98</c:v>
                </c:pt>
                <c:pt idx="5650">
                  <c:v>2496.96</c:v>
                </c:pt>
                <c:pt idx="5665">
                  <c:v>1192.97</c:v>
                </c:pt>
                <c:pt idx="5670">
                  <c:v>3803.54</c:v>
                </c:pt>
                <c:pt idx="5676">
                  <c:v>1672.06</c:v>
                </c:pt>
                <c:pt idx="5678">
                  <c:v>1652.62</c:v>
                </c:pt>
                <c:pt idx="5681">
                  <c:v>3471.12</c:v>
                </c:pt>
                <c:pt idx="5683">
                  <c:v>1173.96</c:v>
                </c:pt>
                <c:pt idx="5686">
                  <c:v>1359.72</c:v>
                </c:pt>
                <c:pt idx="5688">
                  <c:v>2664.79</c:v>
                </c:pt>
                <c:pt idx="5697">
                  <c:v>1772.71</c:v>
                </c:pt>
                <c:pt idx="5702">
                  <c:v>1137.02</c:v>
                </c:pt>
                <c:pt idx="5703">
                  <c:v>1111.32</c:v>
                </c:pt>
                <c:pt idx="5711">
                  <c:v>1021.03</c:v>
                </c:pt>
                <c:pt idx="5715">
                  <c:v>1523.23</c:v>
                </c:pt>
                <c:pt idx="5717">
                  <c:v>1175.26</c:v>
                </c:pt>
                <c:pt idx="5724">
                  <c:v>2311.85</c:v>
                </c:pt>
                <c:pt idx="5727">
                  <c:v>980.85599999999999</c:v>
                </c:pt>
                <c:pt idx="5728">
                  <c:v>1456.92</c:v>
                </c:pt>
                <c:pt idx="5732">
                  <c:v>154.22399999999999</c:v>
                </c:pt>
                <c:pt idx="5733">
                  <c:v>1519.56</c:v>
                </c:pt>
                <c:pt idx="5737">
                  <c:v>1177.2</c:v>
                </c:pt>
                <c:pt idx="5743">
                  <c:v>1454.98</c:v>
                </c:pt>
                <c:pt idx="5745">
                  <c:v>1479.6</c:v>
                </c:pt>
                <c:pt idx="5749">
                  <c:v>1427.11</c:v>
                </c:pt>
                <c:pt idx="5750">
                  <c:v>2703.02</c:v>
                </c:pt>
                <c:pt idx="5760">
                  <c:v>1400.11</c:v>
                </c:pt>
                <c:pt idx="5761">
                  <c:v>1734.91</c:v>
                </c:pt>
                <c:pt idx="5763">
                  <c:v>1104.8399999999999</c:v>
                </c:pt>
                <c:pt idx="5764">
                  <c:v>5477.76</c:v>
                </c:pt>
                <c:pt idx="5767">
                  <c:v>1768.39</c:v>
                </c:pt>
                <c:pt idx="5768">
                  <c:v>1081.73</c:v>
                </c:pt>
                <c:pt idx="5781">
                  <c:v>1659.74</c:v>
                </c:pt>
                <c:pt idx="5782">
                  <c:v>2861.57</c:v>
                </c:pt>
                <c:pt idx="5787">
                  <c:v>2029.1</c:v>
                </c:pt>
                <c:pt idx="5794">
                  <c:v>1167.48</c:v>
                </c:pt>
                <c:pt idx="5799">
                  <c:v>2271.02</c:v>
                </c:pt>
                <c:pt idx="5806">
                  <c:v>888.40800000000002</c:v>
                </c:pt>
                <c:pt idx="5807">
                  <c:v>2048.98</c:v>
                </c:pt>
                <c:pt idx="5810">
                  <c:v>2060.64</c:v>
                </c:pt>
                <c:pt idx="5813">
                  <c:v>775.65599999999995</c:v>
                </c:pt>
                <c:pt idx="5828">
                  <c:v>1284.98</c:v>
                </c:pt>
                <c:pt idx="5830">
                  <c:v>1018.66</c:v>
                </c:pt>
                <c:pt idx="5833">
                  <c:v>1304.6400000000001</c:v>
                </c:pt>
                <c:pt idx="5837">
                  <c:v>3997.73</c:v>
                </c:pt>
                <c:pt idx="5840">
                  <c:v>542.37599999999998</c:v>
                </c:pt>
                <c:pt idx="5857">
                  <c:v>1434.46</c:v>
                </c:pt>
                <c:pt idx="5865">
                  <c:v>863.35199999999998</c:v>
                </c:pt>
                <c:pt idx="5868">
                  <c:v>2896.78</c:v>
                </c:pt>
                <c:pt idx="5869">
                  <c:v>2045.09</c:v>
                </c:pt>
                <c:pt idx="5870">
                  <c:v>2554.42</c:v>
                </c:pt>
                <c:pt idx="5871">
                  <c:v>161.136</c:v>
                </c:pt>
                <c:pt idx="5876">
                  <c:v>1427.98</c:v>
                </c:pt>
                <c:pt idx="5883">
                  <c:v>1418.9</c:v>
                </c:pt>
                <c:pt idx="5888">
                  <c:v>449.28</c:v>
                </c:pt>
                <c:pt idx="5893">
                  <c:v>795.52800000000002</c:v>
                </c:pt>
                <c:pt idx="5897">
                  <c:v>2626.99</c:v>
                </c:pt>
                <c:pt idx="5901">
                  <c:v>1736.86</c:v>
                </c:pt>
                <c:pt idx="5902">
                  <c:v>1855.87</c:v>
                </c:pt>
                <c:pt idx="5904">
                  <c:v>1196.8599999999999</c:v>
                </c:pt>
                <c:pt idx="5908">
                  <c:v>1275.9100000000001</c:v>
                </c:pt>
                <c:pt idx="5920">
                  <c:v>1133.78</c:v>
                </c:pt>
                <c:pt idx="5923">
                  <c:v>1407.89</c:v>
                </c:pt>
                <c:pt idx="5925">
                  <c:v>4083.05</c:v>
                </c:pt>
                <c:pt idx="5928">
                  <c:v>1082.3800000000001</c:v>
                </c:pt>
                <c:pt idx="5929">
                  <c:v>1988.71</c:v>
                </c:pt>
                <c:pt idx="5930">
                  <c:v>855.36</c:v>
                </c:pt>
                <c:pt idx="5940">
                  <c:v>1206.3599999999999</c:v>
                </c:pt>
                <c:pt idx="5941">
                  <c:v>1146.53</c:v>
                </c:pt>
                <c:pt idx="5949">
                  <c:v>1068.55</c:v>
                </c:pt>
                <c:pt idx="5950">
                  <c:v>1545.7</c:v>
                </c:pt>
                <c:pt idx="5956">
                  <c:v>768.52800000000002</c:v>
                </c:pt>
                <c:pt idx="5957">
                  <c:v>967.89599999999996</c:v>
                </c:pt>
                <c:pt idx="5959">
                  <c:v>988.84799999999996</c:v>
                </c:pt>
                <c:pt idx="5962">
                  <c:v>1772.93</c:v>
                </c:pt>
                <c:pt idx="5969">
                  <c:v>1949.18</c:v>
                </c:pt>
                <c:pt idx="5971">
                  <c:v>1108.94</c:v>
                </c:pt>
                <c:pt idx="5975">
                  <c:v>801.14400000000001</c:v>
                </c:pt>
                <c:pt idx="5981">
                  <c:v>1273.75</c:v>
                </c:pt>
                <c:pt idx="5989">
                  <c:v>782.78399999999999</c:v>
                </c:pt>
                <c:pt idx="5991">
                  <c:v>2136.67</c:v>
                </c:pt>
                <c:pt idx="5993">
                  <c:v>2663.06</c:v>
                </c:pt>
                <c:pt idx="6001">
                  <c:v>1125.58</c:v>
                </c:pt>
                <c:pt idx="6002">
                  <c:v>1300.54</c:v>
                </c:pt>
                <c:pt idx="6008">
                  <c:v>2626.78</c:v>
                </c:pt>
                <c:pt idx="6025">
                  <c:v>1162.3</c:v>
                </c:pt>
                <c:pt idx="6032">
                  <c:v>1273.0999999999999</c:v>
                </c:pt>
                <c:pt idx="6038">
                  <c:v>1259.71</c:v>
                </c:pt>
                <c:pt idx="6039">
                  <c:v>1466.64</c:v>
                </c:pt>
                <c:pt idx="6044">
                  <c:v>746.49599999999998</c:v>
                </c:pt>
                <c:pt idx="6048">
                  <c:v>901.15200000000004</c:v>
                </c:pt>
                <c:pt idx="6050">
                  <c:v>1924.34</c:v>
                </c:pt>
                <c:pt idx="6054">
                  <c:v>1765.8</c:v>
                </c:pt>
                <c:pt idx="6055">
                  <c:v>696.81600000000003</c:v>
                </c:pt>
                <c:pt idx="6067">
                  <c:v>1154.95</c:v>
                </c:pt>
                <c:pt idx="6070">
                  <c:v>1075.25</c:v>
                </c:pt>
                <c:pt idx="6072">
                  <c:v>1465.13</c:v>
                </c:pt>
                <c:pt idx="6078">
                  <c:v>1274.6199999999999</c:v>
                </c:pt>
                <c:pt idx="6080">
                  <c:v>788.18399999999997</c:v>
                </c:pt>
                <c:pt idx="6081">
                  <c:v>1443.53</c:v>
                </c:pt>
                <c:pt idx="6086">
                  <c:v>1490.62</c:v>
                </c:pt>
                <c:pt idx="6093">
                  <c:v>923.18399999999997</c:v>
                </c:pt>
                <c:pt idx="6099">
                  <c:v>1043.71</c:v>
                </c:pt>
                <c:pt idx="6102">
                  <c:v>1018.66</c:v>
                </c:pt>
                <c:pt idx="6103">
                  <c:v>1853.28</c:v>
                </c:pt>
                <c:pt idx="6105">
                  <c:v>2364.12</c:v>
                </c:pt>
                <c:pt idx="6109">
                  <c:v>959.68799999999999</c:v>
                </c:pt>
                <c:pt idx="6111">
                  <c:v>639.14400000000001</c:v>
                </c:pt>
                <c:pt idx="6112">
                  <c:v>4287.17</c:v>
                </c:pt>
                <c:pt idx="6113">
                  <c:v>965.30399999999997</c:v>
                </c:pt>
                <c:pt idx="6114">
                  <c:v>3127.25</c:v>
                </c:pt>
                <c:pt idx="6115">
                  <c:v>2111.62</c:v>
                </c:pt>
                <c:pt idx="6124">
                  <c:v>1315.44</c:v>
                </c:pt>
                <c:pt idx="6129">
                  <c:v>1392.34</c:v>
                </c:pt>
                <c:pt idx="6132">
                  <c:v>1135.94</c:v>
                </c:pt>
                <c:pt idx="6133">
                  <c:v>1253.02</c:v>
                </c:pt>
                <c:pt idx="6134">
                  <c:v>2105.35</c:v>
                </c:pt>
                <c:pt idx="6136">
                  <c:v>1320.62</c:v>
                </c:pt>
                <c:pt idx="6141">
                  <c:v>676.72799999999995</c:v>
                </c:pt>
                <c:pt idx="6146">
                  <c:v>2987.06</c:v>
                </c:pt>
                <c:pt idx="6147">
                  <c:v>1464.05</c:v>
                </c:pt>
                <c:pt idx="6156">
                  <c:v>1323.22</c:v>
                </c:pt>
                <c:pt idx="6161">
                  <c:v>1123.42</c:v>
                </c:pt>
                <c:pt idx="6164">
                  <c:v>2533.6799999999998</c:v>
                </c:pt>
                <c:pt idx="6167">
                  <c:v>3352.75</c:v>
                </c:pt>
                <c:pt idx="6172">
                  <c:v>1466.21</c:v>
                </c:pt>
                <c:pt idx="6175">
                  <c:v>2209.46</c:v>
                </c:pt>
                <c:pt idx="6178">
                  <c:v>1137.02</c:v>
                </c:pt>
                <c:pt idx="6191">
                  <c:v>1422.79</c:v>
                </c:pt>
                <c:pt idx="6199">
                  <c:v>2674.3</c:v>
                </c:pt>
                <c:pt idx="6203">
                  <c:v>1256.9000000000001</c:v>
                </c:pt>
                <c:pt idx="6204">
                  <c:v>1532.52</c:v>
                </c:pt>
                <c:pt idx="6207">
                  <c:v>863.56799999999998</c:v>
                </c:pt>
                <c:pt idx="6209">
                  <c:v>1643.11</c:v>
                </c:pt>
                <c:pt idx="6211">
                  <c:v>1759.1</c:v>
                </c:pt>
                <c:pt idx="6220">
                  <c:v>953.42399999999998</c:v>
                </c:pt>
                <c:pt idx="6222">
                  <c:v>1303.78</c:v>
                </c:pt>
                <c:pt idx="6236">
                  <c:v>1181.0899999999999</c:v>
                </c:pt>
                <c:pt idx="6246">
                  <c:v>856.65599999999995</c:v>
                </c:pt>
                <c:pt idx="6247">
                  <c:v>1414.15</c:v>
                </c:pt>
                <c:pt idx="6248">
                  <c:v>2483.5700000000002</c:v>
                </c:pt>
                <c:pt idx="6249">
                  <c:v>1476.58</c:v>
                </c:pt>
                <c:pt idx="6260">
                  <c:v>1397.09</c:v>
                </c:pt>
                <c:pt idx="6264">
                  <c:v>989.928</c:v>
                </c:pt>
                <c:pt idx="6272">
                  <c:v>1711.37</c:v>
                </c:pt>
                <c:pt idx="6276">
                  <c:v>3069.58</c:v>
                </c:pt>
                <c:pt idx="6286">
                  <c:v>944.78399999999999</c:v>
                </c:pt>
                <c:pt idx="6287">
                  <c:v>1776.82</c:v>
                </c:pt>
                <c:pt idx="6289">
                  <c:v>2261.3000000000002</c:v>
                </c:pt>
                <c:pt idx="6290">
                  <c:v>3315.38</c:v>
                </c:pt>
                <c:pt idx="6291">
                  <c:v>848.88</c:v>
                </c:pt>
                <c:pt idx="6292">
                  <c:v>723.38400000000001</c:v>
                </c:pt>
                <c:pt idx="6293">
                  <c:v>1462.54</c:v>
                </c:pt>
                <c:pt idx="6300">
                  <c:v>676.08</c:v>
                </c:pt>
                <c:pt idx="6309">
                  <c:v>1298.5899999999999</c:v>
                </c:pt>
                <c:pt idx="6315">
                  <c:v>1056.46</c:v>
                </c:pt>
                <c:pt idx="6317">
                  <c:v>1276.1300000000001</c:v>
                </c:pt>
                <c:pt idx="6319">
                  <c:v>1268.3499999999999</c:v>
                </c:pt>
                <c:pt idx="6320">
                  <c:v>1099.8699999999999</c:v>
                </c:pt>
                <c:pt idx="6322">
                  <c:v>997.70399999999995</c:v>
                </c:pt>
                <c:pt idx="6323">
                  <c:v>891.43200000000002</c:v>
                </c:pt>
                <c:pt idx="6324">
                  <c:v>1378.94</c:v>
                </c:pt>
                <c:pt idx="6325">
                  <c:v>1678.75</c:v>
                </c:pt>
                <c:pt idx="6326">
                  <c:v>1728.86</c:v>
                </c:pt>
                <c:pt idx="6331">
                  <c:v>1392.12</c:v>
                </c:pt>
                <c:pt idx="6332">
                  <c:v>1267.92</c:v>
                </c:pt>
                <c:pt idx="6333">
                  <c:v>1013.69</c:v>
                </c:pt>
                <c:pt idx="6338">
                  <c:v>1274.4000000000001</c:v>
                </c:pt>
                <c:pt idx="6340">
                  <c:v>1552.61</c:v>
                </c:pt>
                <c:pt idx="6351">
                  <c:v>1572.48</c:v>
                </c:pt>
                <c:pt idx="6359">
                  <c:v>1376.35</c:v>
                </c:pt>
                <c:pt idx="6373">
                  <c:v>1723.9</c:v>
                </c:pt>
                <c:pt idx="6378">
                  <c:v>1374.41</c:v>
                </c:pt>
                <c:pt idx="6379">
                  <c:v>1730.16</c:v>
                </c:pt>
                <c:pt idx="6381">
                  <c:v>896.83199999999999</c:v>
                </c:pt>
                <c:pt idx="6385">
                  <c:v>855.57600000000002</c:v>
                </c:pt>
                <c:pt idx="6389">
                  <c:v>1980.5</c:v>
                </c:pt>
                <c:pt idx="6392">
                  <c:v>1463.83</c:v>
                </c:pt>
                <c:pt idx="6396">
                  <c:v>1384.34</c:v>
                </c:pt>
                <c:pt idx="6397">
                  <c:v>1444.39</c:v>
                </c:pt>
                <c:pt idx="6407">
                  <c:v>1034.6400000000001</c:v>
                </c:pt>
                <c:pt idx="6409">
                  <c:v>1847.45</c:v>
                </c:pt>
                <c:pt idx="6415">
                  <c:v>1167.9100000000001</c:v>
                </c:pt>
                <c:pt idx="6423">
                  <c:v>1532.95</c:v>
                </c:pt>
                <c:pt idx="6424">
                  <c:v>1304.8599999999999</c:v>
                </c:pt>
                <c:pt idx="6426">
                  <c:v>1556.93</c:v>
                </c:pt>
                <c:pt idx="6436">
                  <c:v>892.94399999999996</c:v>
                </c:pt>
                <c:pt idx="6438">
                  <c:v>984.096</c:v>
                </c:pt>
                <c:pt idx="6439">
                  <c:v>1587.17</c:v>
                </c:pt>
                <c:pt idx="6441">
                  <c:v>1161.8599999999999</c:v>
                </c:pt>
                <c:pt idx="6442">
                  <c:v>1329.7</c:v>
                </c:pt>
                <c:pt idx="6446">
                  <c:v>1519.99</c:v>
                </c:pt>
                <c:pt idx="6447">
                  <c:v>1149.3399999999999</c:v>
                </c:pt>
                <c:pt idx="6458">
                  <c:v>1809.86</c:v>
                </c:pt>
                <c:pt idx="6459">
                  <c:v>1502.28</c:v>
                </c:pt>
                <c:pt idx="6465">
                  <c:v>1404.43</c:v>
                </c:pt>
                <c:pt idx="6467">
                  <c:v>1226.02</c:v>
                </c:pt>
                <c:pt idx="6470">
                  <c:v>1489.32</c:v>
                </c:pt>
                <c:pt idx="6471">
                  <c:v>2874.31</c:v>
                </c:pt>
                <c:pt idx="6477">
                  <c:v>886.46400000000006</c:v>
                </c:pt>
                <c:pt idx="6485">
                  <c:v>1596.02</c:v>
                </c:pt>
                <c:pt idx="6486">
                  <c:v>2045.52</c:v>
                </c:pt>
                <c:pt idx="6500">
                  <c:v>1319.11</c:v>
                </c:pt>
                <c:pt idx="6508">
                  <c:v>995.54399999999998</c:v>
                </c:pt>
                <c:pt idx="6510">
                  <c:v>1304.21</c:v>
                </c:pt>
                <c:pt idx="6512">
                  <c:v>1612.01</c:v>
                </c:pt>
                <c:pt idx="6513">
                  <c:v>2366.5</c:v>
                </c:pt>
                <c:pt idx="6519">
                  <c:v>730.29600000000005</c:v>
                </c:pt>
                <c:pt idx="6520">
                  <c:v>1186.06</c:v>
                </c:pt>
                <c:pt idx="6521">
                  <c:v>875.01599999999996</c:v>
                </c:pt>
                <c:pt idx="6522">
                  <c:v>2145.96</c:v>
                </c:pt>
                <c:pt idx="6523">
                  <c:v>1661.9</c:v>
                </c:pt>
                <c:pt idx="6530">
                  <c:v>1028.1600000000001</c:v>
                </c:pt>
                <c:pt idx="6532">
                  <c:v>956.23199999999997</c:v>
                </c:pt>
                <c:pt idx="6535">
                  <c:v>804.81600000000003</c:v>
                </c:pt>
                <c:pt idx="6541">
                  <c:v>1435.75</c:v>
                </c:pt>
                <c:pt idx="6551">
                  <c:v>1742.04</c:v>
                </c:pt>
                <c:pt idx="6560">
                  <c:v>1390.39</c:v>
                </c:pt>
                <c:pt idx="6562">
                  <c:v>905.904</c:v>
                </c:pt>
                <c:pt idx="6565">
                  <c:v>1886.11</c:v>
                </c:pt>
                <c:pt idx="6586">
                  <c:v>1237.9000000000001</c:v>
                </c:pt>
                <c:pt idx="6589">
                  <c:v>1395.36</c:v>
                </c:pt>
                <c:pt idx="6591">
                  <c:v>1249.3399999999999</c:v>
                </c:pt>
                <c:pt idx="6594">
                  <c:v>1184.76</c:v>
                </c:pt>
                <c:pt idx="6599">
                  <c:v>3537.43</c:v>
                </c:pt>
                <c:pt idx="6607">
                  <c:v>1712.23</c:v>
                </c:pt>
                <c:pt idx="6613">
                  <c:v>1399.03</c:v>
                </c:pt>
                <c:pt idx="6620">
                  <c:v>1659.96</c:v>
                </c:pt>
                <c:pt idx="6623">
                  <c:v>1012.39</c:v>
                </c:pt>
                <c:pt idx="6632">
                  <c:v>1200.53</c:v>
                </c:pt>
                <c:pt idx="6636">
                  <c:v>1118.8800000000001</c:v>
                </c:pt>
                <c:pt idx="6637">
                  <c:v>1775.52</c:v>
                </c:pt>
                <c:pt idx="6638">
                  <c:v>1692.36</c:v>
                </c:pt>
                <c:pt idx="6640">
                  <c:v>707.61599999999999</c:v>
                </c:pt>
                <c:pt idx="6642">
                  <c:v>945.86400000000003</c:v>
                </c:pt>
                <c:pt idx="6645">
                  <c:v>1813.1</c:v>
                </c:pt>
                <c:pt idx="6649">
                  <c:v>1572.26</c:v>
                </c:pt>
                <c:pt idx="6652">
                  <c:v>1078.06</c:v>
                </c:pt>
                <c:pt idx="6654">
                  <c:v>772.63199999999995</c:v>
                </c:pt>
                <c:pt idx="6656">
                  <c:v>1559.09</c:v>
                </c:pt>
                <c:pt idx="6657">
                  <c:v>743.25599999999997</c:v>
                </c:pt>
                <c:pt idx="6660">
                  <c:v>937.87199999999996</c:v>
                </c:pt>
                <c:pt idx="6663">
                  <c:v>1198.58</c:v>
                </c:pt>
                <c:pt idx="6664">
                  <c:v>1337.47</c:v>
                </c:pt>
                <c:pt idx="6671">
                  <c:v>3175.85</c:v>
                </c:pt>
                <c:pt idx="6676">
                  <c:v>1521.5</c:v>
                </c:pt>
                <c:pt idx="6679">
                  <c:v>1795.61</c:v>
                </c:pt>
                <c:pt idx="6680">
                  <c:v>2116.37</c:v>
                </c:pt>
                <c:pt idx="6683">
                  <c:v>1459.73</c:v>
                </c:pt>
                <c:pt idx="6684">
                  <c:v>1910.3</c:v>
                </c:pt>
                <c:pt idx="6685">
                  <c:v>1201.18</c:v>
                </c:pt>
                <c:pt idx="6688">
                  <c:v>1660.61</c:v>
                </c:pt>
                <c:pt idx="6689">
                  <c:v>1567.94</c:v>
                </c:pt>
                <c:pt idx="6691">
                  <c:v>1332.72</c:v>
                </c:pt>
                <c:pt idx="6702">
                  <c:v>1451.74</c:v>
                </c:pt>
                <c:pt idx="6703">
                  <c:v>1235.74</c:v>
                </c:pt>
                <c:pt idx="6708">
                  <c:v>3446.93</c:v>
                </c:pt>
                <c:pt idx="6712">
                  <c:v>1267.49</c:v>
                </c:pt>
                <c:pt idx="6719">
                  <c:v>2428.06</c:v>
                </c:pt>
                <c:pt idx="6720">
                  <c:v>1616.33</c:v>
                </c:pt>
                <c:pt idx="6722">
                  <c:v>956.44799999999998</c:v>
                </c:pt>
                <c:pt idx="6727">
                  <c:v>4012.42</c:v>
                </c:pt>
                <c:pt idx="6729">
                  <c:v>2233.66</c:v>
                </c:pt>
                <c:pt idx="6733">
                  <c:v>1338.55</c:v>
                </c:pt>
                <c:pt idx="6734">
                  <c:v>970.48800000000006</c:v>
                </c:pt>
                <c:pt idx="6737">
                  <c:v>2744.28</c:v>
                </c:pt>
                <c:pt idx="6740">
                  <c:v>1386.07</c:v>
                </c:pt>
                <c:pt idx="6748">
                  <c:v>1481.98</c:v>
                </c:pt>
                <c:pt idx="6751">
                  <c:v>869.4</c:v>
                </c:pt>
                <c:pt idx="6752">
                  <c:v>1587.6</c:v>
                </c:pt>
                <c:pt idx="6754">
                  <c:v>1961.93</c:v>
                </c:pt>
                <c:pt idx="6760">
                  <c:v>1908.14</c:v>
                </c:pt>
                <c:pt idx="6765">
                  <c:v>1191.24</c:v>
                </c:pt>
                <c:pt idx="6772">
                  <c:v>2396.52</c:v>
                </c:pt>
                <c:pt idx="6773">
                  <c:v>1600.13</c:v>
                </c:pt>
                <c:pt idx="6776">
                  <c:v>840.45600000000002</c:v>
                </c:pt>
                <c:pt idx="6780">
                  <c:v>619.91999999999996</c:v>
                </c:pt>
                <c:pt idx="6782">
                  <c:v>1373.33</c:v>
                </c:pt>
                <c:pt idx="6783">
                  <c:v>1296.8599999999999</c:v>
                </c:pt>
                <c:pt idx="6792">
                  <c:v>1395.14</c:v>
                </c:pt>
                <c:pt idx="6804">
                  <c:v>956.23199999999997</c:v>
                </c:pt>
                <c:pt idx="6815">
                  <c:v>1217.1600000000001</c:v>
                </c:pt>
                <c:pt idx="6816">
                  <c:v>1545.7</c:v>
                </c:pt>
                <c:pt idx="6825">
                  <c:v>1094.69</c:v>
                </c:pt>
                <c:pt idx="6826">
                  <c:v>1002.24</c:v>
                </c:pt>
                <c:pt idx="6831">
                  <c:v>1540.73</c:v>
                </c:pt>
                <c:pt idx="6841">
                  <c:v>842.83199999999999</c:v>
                </c:pt>
                <c:pt idx="6845">
                  <c:v>842.18399999999997</c:v>
                </c:pt>
                <c:pt idx="6850">
                  <c:v>2198.66</c:v>
                </c:pt>
                <c:pt idx="6853">
                  <c:v>2016.36</c:v>
                </c:pt>
                <c:pt idx="6859">
                  <c:v>1297.08</c:v>
                </c:pt>
                <c:pt idx="6861">
                  <c:v>1443.74</c:v>
                </c:pt>
                <c:pt idx="6863">
                  <c:v>1120.6099999999999</c:v>
                </c:pt>
                <c:pt idx="6869">
                  <c:v>521.20799999999997</c:v>
                </c:pt>
                <c:pt idx="6870">
                  <c:v>3710.23</c:v>
                </c:pt>
                <c:pt idx="6874">
                  <c:v>1510.7</c:v>
                </c:pt>
                <c:pt idx="6881">
                  <c:v>1597.32</c:v>
                </c:pt>
                <c:pt idx="6886">
                  <c:v>2531.9499999999998</c:v>
                </c:pt>
                <c:pt idx="6888">
                  <c:v>1123.6300000000001</c:v>
                </c:pt>
                <c:pt idx="6903">
                  <c:v>1794.1</c:v>
                </c:pt>
                <c:pt idx="6910">
                  <c:v>1859.33</c:v>
                </c:pt>
                <c:pt idx="6913">
                  <c:v>2875.82</c:v>
                </c:pt>
                <c:pt idx="6914">
                  <c:v>3676.97</c:v>
                </c:pt>
                <c:pt idx="6916">
                  <c:v>1699.49</c:v>
                </c:pt>
                <c:pt idx="6917">
                  <c:v>2182.0300000000002</c:v>
                </c:pt>
                <c:pt idx="6921">
                  <c:v>1453.25</c:v>
                </c:pt>
                <c:pt idx="6931">
                  <c:v>1040.26</c:v>
                </c:pt>
                <c:pt idx="6933">
                  <c:v>1527.98</c:v>
                </c:pt>
                <c:pt idx="6937">
                  <c:v>2886.62</c:v>
                </c:pt>
                <c:pt idx="6938">
                  <c:v>1338.77</c:v>
                </c:pt>
                <c:pt idx="6939">
                  <c:v>1626.05</c:v>
                </c:pt>
                <c:pt idx="6941">
                  <c:v>941.76</c:v>
                </c:pt>
                <c:pt idx="6946">
                  <c:v>1403.35</c:v>
                </c:pt>
                <c:pt idx="6947">
                  <c:v>1750.03</c:v>
                </c:pt>
                <c:pt idx="6950">
                  <c:v>1114.99</c:v>
                </c:pt>
                <c:pt idx="6953">
                  <c:v>1871.21</c:v>
                </c:pt>
                <c:pt idx="6963">
                  <c:v>1342.44</c:v>
                </c:pt>
                <c:pt idx="6966">
                  <c:v>1814.18</c:v>
                </c:pt>
                <c:pt idx="6967">
                  <c:v>1282.82</c:v>
                </c:pt>
                <c:pt idx="6975">
                  <c:v>1259.28</c:v>
                </c:pt>
                <c:pt idx="6980">
                  <c:v>1690.85</c:v>
                </c:pt>
                <c:pt idx="6981">
                  <c:v>1489.32</c:v>
                </c:pt>
                <c:pt idx="6991">
                  <c:v>2760.26</c:v>
                </c:pt>
                <c:pt idx="6995">
                  <c:v>1055.1600000000001</c:v>
                </c:pt>
                <c:pt idx="6996">
                  <c:v>800.28</c:v>
                </c:pt>
                <c:pt idx="6997">
                  <c:v>1402.27</c:v>
                </c:pt>
                <c:pt idx="7001">
                  <c:v>803.30399999999997</c:v>
                </c:pt>
                <c:pt idx="7004">
                  <c:v>708.48</c:v>
                </c:pt>
                <c:pt idx="7009">
                  <c:v>908.71199999999999</c:v>
                </c:pt>
                <c:pt idx="7010">
                  <c:v>1287.1400000000001</c:v>
                </c:pt>
                <c:pt idx="7018">
                  <c:v>944.78399999999999</c:v>
                </c:pt>
                <c:pt idx="7023">
                  <c:v>994.46400000000006</c:v>
                </c:pt>
                <c:pt idx="7024">
                  <c:v>907.2</c:v>
                </c:pt>
                <c:pt idx="7027">
                  <c:v>1524.74</c:v>
                </c:pt>
                <c:pt idx="7033">
                  <c:v>1894.32</c:v>
                </c:pt>
                <c:pt idx="7036">
                  <c:v>1648.08</c:v>
                </c:pt>
                <c:pt idx="7044">
                  <c:v>756.64800000000002</c:v>
                </c:pt>
                <c:pt idx="7052">
                  <c:v>1670.33</c:v>
                </c:pt>
                <c:pt idx="7058">
                  <c:v>1842.91</c:v>
                </c:pt>
                <c:pt idx="7063">
                  <c:v>2862.65</c:v>
                </c:pt>
                <c:pt idx="7064">
                  <c:v>899.20799999999997</c:v>
                </c:pt>
                <c:pt idx="7066">
                  <c:v>1847.66</c:v>
                </c:pt>
                <c:pt idx="7068">
                  <c:v>1253.8800000000001</c:v>
                </c:pt>
                <c:pt idx="7071">
                  <c:v>1906.42</c:v>
                </c:pt>
                <c:pt idx="7079">
                  <c:v>1568.38</c:v>
                </c:pt>
                <c:pt idx="7082">
                  <c:v>1492.13</c:v>
                </c:pt>
                <c:pt idx="7099">
                  <c:v>1512.43</c:v>
                </c:pt>
                <c:pt idx="7102">
                  <c:v>713.66399999999999</c:v>
                </c:pt>
                <c:pt idx="7106">
                  <c:v>1866.24</c:v>
                </c:pt>
                <c:pt idx="7122">
                  <c:v>1667.52</c:v>
                </c:pt>
                <c:pt idx="7124">
                  <c:v>1403.14</c:v>
                </c:pt>
                <c:pt idx="7127">
                  <c:v>1390.18</c:v>
                </c:pt>
                <c:pt idx="7130">
                  <c:v>1817.21</c:v>
                </c:pt>
                <c:pt idx="7132">
                  <c:v>1549.37</c:v>
                </c:pt>
                <c:pt idx="7133">
                  <c:v>1387.58</c:v>
                </c:pt>
                <c:pt idx="7139">
                  <c:v>979.12800000000004</c:v>
                </c:pt>
                <c:pt idx="7145">
                  <c:v>1736.64</c:v>
                </c:pt>
                <c:pt idx="7146">
                  <c:v>1309.6099999999999</c:v>
                </c:pt>
                <c:pt idx="7149">
                  <c:v>1545.91</c:v>
                </c:pt>
                <c:pt idx="7165">
                  <c:v>1157.76</c:v>
                </c:pt>
                <c:pt idx="7166">
                  <c:v>962.49599999999998</c:v>
                </c:pt>
                <c:pt idx="7167">
                  <c:v>1031.18</c:v>
                </c:pt>
                <c:pt idx="7169">
                  <c:v>1684.37</c:v>
                </c:pt>
                <c:pt idx="7171">
                  <c:v>1273.0999999999999</c:v>
                </c:pt>
                <c:pt idx="7175">
                  <c:v>736.12800000000004</c:v>
                </c:pt>
                <c:pt idx="7178">
                  <c:v>1305.72</c:v>
                </c:pt>
                <c:pt idx="7182">
                  <c:v>1162.08</c:v>
                </c:pt>
                <c:pt idx="7185">
                  <c:v>1438.78</c:v>
                </c:pt>
                <c:pt idx="7187">
                  <c:v>1055.1600000000001</c:v>
                </c:pt>
                <c:pt idx="7189">
                  <c:v>994.89599999999996</c:v>
                </c:pt>
                <c:pt idx="7194">
                  <c:v>1007.42</c:v>
                </c:pt>
                <c:pt idx="7198">
                  <c:v>998.78399999999999</c:v>
                </c:pt>
                <c:pt idx="7204">
                  <c:v>1172.23</c:v>
                </c:pt>
                <c:pt idx="7206">
                  <c:v>1243.73</c:v>
                </c:pt>
                <c:pt idx="7208">
                  <c:v>1167.26</c:v>
                </c:pt>
                <c:pt idx="7215">
                  <c:v>1766.45</c:v>
                </c:pt>
                <c:pt idx="7216">
                  <c:v>2271.46</c:v>
                </c:pt>
                <c:pt idx="7218">
                  <c:v>2485.94</c:v>
                </c:pt>
                <c:pt idx="7220">
                  <c:v>3469.39</c:v>
                </c:pt>
                <c:pt idx="7224">
                  <c:v>1602.72</c:v>
                </c:pt>
                <c:pt idx="7225">
                  <c:v>1270.94</c:v>
                </c:pt>
                <c:pt idx="7229">
                  <c:v>1842.26</c:v>
                </c:pt>
                <c:pt idx="7237">
                  <c:v>1660.82</c:v>
                </c:pt>
                <c:pt idx="7239">
                  <c:v>716.04</c:v>
                </c:pt>
                <c:pt idx="7241">
                  <c:v>662.25599999999997</c:v>
                </c:pt>
                <c:pt idx="7248">
                  <c:v>1529.06</c:v>
                </c:pt>
                <c:pt idx="7249">
                  <c:v>1391.47</c:v>
                </c:pt>
                <c:pt idx="7254">
                  <c:v>1463.18</c:v>
                </c:pt>
                <c:pt idx="7266">
                  <c:v>673.27200000000005</c:v>
                </c:pt>
                <c:pt idx="7267">
                  <c:v>1476.36</c:v>
                </c:pt>
                <c:pt idx="7268">
                  <c:v>1410.7</c:v>
                </c:pt>
                <c:pt idx="7280">
                  <c:v>2062.58</c:v>
                </c:pt>
                <c:pt idx="7282">
                  <c:v>1083.24</c:v>
                </c:pt>
                <c:pt idx="7288">
                  <c:v>1792.15</c:v>
                </c:pt>
                <c:pt idx="7292">
                  <c:v>1071.1400000000001</c:v>
                </c:pt>
                <c:pt idx="7294">
                  <c:v>1524.31</c:v>
                </c:pt>
                <c:pt idx="7296">
                  <c:v>1356.48</c:v>
                </c:pt>
                <c:pt idx="7297">
                  <c:v>1278.07</c:v>
                </c:pt>
                <c:pt idx="7303">
                  <c:v>1466.86</c:v>
                </c:pt>
                <c:pt idx="7305">
                  <c:v>1775.74</c:v>
                </c:pt>
                <c:pt idx="7321">
                  <c:v>1153.6600000000001</c:v>
                </c:pt>
                <c:pt idx="7322">
                  <c:v>1669.03</c:v>
                </c:pt>
                <c:pt idx="7324">
                  <c:v>1672.92</c:v>
                </c:pt>
                <c:pt idx="7326">
                  <c:v>1515.24</c:v>
                </c:pt>
                <c:pt idx="7331">
                  <c:v>2360.88</c:v>
                </c:pt>
                <c:pt idx="7332">
                  <c:v>2768.47</c:v>
                </c:pt>
                <c:pt idx="7334">
                  <c:v>1642.46</c:v>
                </c:pt>
                <c:pt idx="7338">
                  <c:v>2593.5100000000002</c:v>
                </c:pt>
                <c:pt idx="7339">
                  <c:v>1744.63</c:v>
                </c:pt>
                <c:pt idx="7346">
                  <c:v>1583.5</c:v>
                </c:pt>
                <c:pt idx="7348">
                  <c:v>820.58399999999995</c:v>
                </c:pt>
                <c:pt idx="7355">
                  <c:v>1437.26</c:v>
                </c:pt>
                <c:pt idx="7356">
                  <c:v>940.24800000000005</c:v>
                </c:pt>
                <c:pt idx="7362">
                  <c:v>1033.56</c:v>
                </c:pt>
                <c:pt idx="7367">
                  <c:v>766.36800000000005</c:v>
                </c:pt>
                <c:pt idx="7372">
                  <c:v>15535.8</c:v>
                </c:pt>
                <c:pt idx="7374">
                  <c:v>1188.8599999999999</c:v>
                </c:pt>
                <c:pt idx="7376">
                  <c:v>1381.97</c:v>
                </c:pt>
                <c:pt idx="7386">
                  <c:v>1487.59</c:v>
                </c:pt>
                <c:pt idx="7392">
                  <c:v>1729.51</c:v>
                </c:pt>
                <c:pt idx="7393">
                  <c:v>930.31200000000001</c:v>
                </c:pt>
                <c:pt idx="7399">
                  <c:v>1773.36</c:v>
                </c:pt>
                <c:pt idx="7401">
                  <c:v>1028.81</c:v>
                </c:pt>
                <c:pt idx="7410">
                  <c:v>978.48</c:v>
                </c:pt>
                <c:pt idx="7412">
                  <c:v>1728</c:v>
                </c:pt>
                <c:pt idx="7418">
                  <c:v>1278.29</c:v>
                </c:pt>
                <c:pt idx="7422">
                  <c:v>1340.71</c:v>
                </c:pt>
                <c:pt idx="7423">
                  <c:v>1358.64</c:v>
                </c:pt>
                <c:pt idx="7425">
                  <c:v>1627.99</c:v>
                </c:pt>
                <c:pt idx="7428">
                  <c:v>1496.88</c:v>
                </c:pt>
                <c:pt idx="7431">
                  <c:v>2069.9299999999998</c:v>
                </c:pt>
                <c:pt idx="7435">
                  <c:v>1822.18</c:v>
                </c:pt>
                <c:pt idx="7437">
                  <c:v>1619.14</c:v>
                </c:pt>
                <c:pt idx="7442">
                  <c:v>758.80799999999999</c:v>
                </c:pt>
                <c:pt idx="7443">
                  <c:v>822.096</c:v>
                </c:pt>
                <c:pt idx="7451">
                  <c:v>3705.26</c:v>
                </c:pt>
                <c:pt idx="7452">
                  <c:v>1916.78</c:v>
                </c:pt>
                <c:pt idx="7462">
                  <c:v>1863.65</c:v>
                </c:pt>
                <c:pt idx="7470">
                  <c:v>2111.62</c:v>
                </c:pt>
                <c:pt idx="7472">
                  <c:v>3376.3</c:v>
                </c:pt>
                <c:pt idx="7476">
                  <c:v>2011.61</c:v>
                </c:pt>
                <c:pt idx="7480">
                  <c:v>938.73599999999999</c:v>
                </c:pt>
                <c:pt idx="7481">
                  <c:v>1110.24</c:v>
                </c:pt>
                <c:pt idx="7487">
                  <c:v>1249.3399999999999</c:v>
                </c:pt>
                <c:pt idx="7489">
                  <c:v>1417.39</c:v>
                </c:pt>
                <c:pt idx="7491">
                  <c:v>1745.28</c:v>
                </c:pt>
                <c:pt idx="7499">
                  <c:v>1505.3</c:v>
                </c:pt>
                <c:pt idx="7501">
                  <c:v>1760.18</c:v>
                </c:pt>
                <c:pt idx="7503">
                  <c:v>1969.7</c:v>
                </c:pt>
                <c:pt idx="7506">
                  <c:v>1274.6199999999999</c:v>
                </c:pt>
                <c:pt idx="7508">
                  <c:v>1317.17</c:v>
                </c:pt>
                <c:pt idx="7510">
                  <c:v>1384.13</c:v>
                </c:pt>
                <c:pt idx="7511">
                  <c:v>1373.98</c:v>
                </c:pt>
                <c:pt idx="7517">
                  <c:v>1816.13</c:v>
                </c:pt>
                <c:pt idx="7519">
                  <c:v>1063.58</c:v>
                </c:pt>
                <c:pt idx="7524">
                  <c:v>1102.9000000000001</c:v>
                </c:pt>
                <c:pt idx="7530">
                  <c:v>1645.92</c:v>
                </c:pt>
                <c:pt idx="7532">
                  <c:v>1760.62</c:v>
                </c:pt>
                <c:pt idx="7543">
                  <c:v>1094.26</c:v>
                </c:pt>
                <c:pt idx="7550">
                  <c:v>1009.37</c:v>
                </c:pt>
                <c:pt idx="7557">
                  <c:v>1639.66</c:v>
                </c:pt>
                <c:pt idx="7562">
                  <c:v>961.63199999999995</c:v>
                </c:pt>
                <c:pt idx="7563">
                  <c:v>1014.77</c:v>
                </c:pt>
                <c:pt idx="7564">
                  <c:v>2123.2800000000002</c:v>
                </c:pt>
                <c:pt idx="7566">
                  <c:v>3777.84</c:v>
                </c:pt>
                <c:pt idx="7567">
                  <c:v>966.38400000000001</c:v>
                </c:pt>
                <c:pt idx="7568">
                  <c:v>1139.18</c:v>
                </c:pt>
                <c:pt idx="7574">
                  <c:v>3066.98</c:v>
                </c:pt>
                <c:pt idx="7581">
                  <c:v>1636.2</c:v>
                </c:pt>
                <c:pt idx="7582">
                  <c:v>1685.88</c:v>
                </c:pt>
                <c:pt idx="7590">
                  <c:v>1229.26</c:v>
                </c:pt>
                <c:pt idx="7599">
                  <c:v>909.14400000000001</c:v>
                </c:pt>
                <c:pt idx="7607">
                  <c:v>1009.58</c:v>
                </c:pt>
                <c:pt idx="7608">
                  <c:v>2041.2</c:v>
                </c:pt>
                <c:pt idx="7613">
                  <c:v>870.69600000000003</c:v>
                </c:pt>
                <c:pt idx="7620">
                  <c:v>1689.34</c:v>
                </c:pt>
                <c:pt idx="7623">
                  <c:v>1869.26</c:v>
                </c:pt>
                <c:pt idx="7631">
                  <c:v>1742.69</c:v>
                </c:pt>
                <c:pt idx="7636">
                  <c:v>1645.06</c:v>
                </c:pt>
                <c:pt idx="7641">
                  <c:v>1412.64</c:v>
                </c:pt>
                <c:pt idx="7645">
                  <c:v>1510.06</c:v>
                </c:pt>
                <c:pt idx="7651">
                  <c:v>1225.8</c:v>
                </c:pt>
                <c:pt idx="7654">
                  <c:v>869.4</c:v>
                </c:pt>
                <c:pt idx="7656">
                  <c:v>1518.7</c:v>
                </c:pt>
                <c:pt idx="7661">
                  <c:v>1818.5</c:v>
                </c:pt>
                <c:pt idx="7667">
                  <c:v>1087.99</c:v>
                </c:pt>
                <c:pt idx="7670">
                  <c:v>1689.12</c:v>
                </c:pt>
                <c:pt idx="7672">
                  <c:v>1706.83</c:v>
                </c:pt>
                <c:pt idx="7675">
                  <c:v>1864.51</c:v>
                </c:pt>
                <c:pt idx="7679">
                  <c:v>1528.42</c:v>
                </c:pt>
                <c:pt idx="7682">
                  <c:v>1783.73</c:v>
                </c:pt>
                <c:pt idx="7695">
                  <c:v>1147.82</c:v>
                </c:pt>
                <c:pt idx="7709">
                  <c:v>870.048</c:v>
                </c:pt>
                <c:pt idx="7710">
                  <c:v>1536.41</c:v>
                </c:pt>
                <c:pt idx="7711">
                  <c:v>1289.74</c:v>
                </c:pt>
                <c:pt idx="7714">
                  <c:v>1210.9000000000001</c:v>
                </c:pt>
                <c:pt idx="7716">
                  <c:v>1659.96</c:v>
                </c:pt>
                <c:pt idx="7719">
                  <c:v>1208.3</c:v>
                </c:pt>
                <c:pt idx="7720">
                  <c:v>887.11199999999997</c:v>
                </c:pt>
                <c:pt idx="7721">
                  <c:v>1689.34</c:v>
                </c:pt>
                <c:pt idx="7723">
                  <c:v>1137.02</c:v>
                </c:pt>
                <c:pt idx="7728">
                  <c:v>1754.35</c:v>
                </c:pt>
                <c:pt idx="7729">
                  <c:v>1734.26</c:v>
                </c:pt>
                <c:pt idx="7730">
                  <c:v>1119.74</c:v>
                </c:pt>
                <c:pt idx="7731">
                  <c:v>1111.32</c:v>
                </c:pt>
                <c:pt idx="7735">
                  <c:v>1135.51</c:v>
                </c:pt>
                <c:pt idx="7738">
                  <c:v>1200.0999999999999</c:v>
                </c:pt>
                <c:pt idx="7749">
                  <c:v>1127.3</c:v>
                </c:pt>
                <c:pt idx="7751">
                  <c:v>1780.7</c:v>
                </c:pt>
                <c:pt idx="7762">
                  <c:v>2874.74</c:v>
                </c:pt>
                <c:pt idx="7764">
                  <c:v>722.08799999999997</c:v>
                </c:pt>
                <c:pt idx="7771">
                  <c:v>968.976</c:v>
                </c:pt>
                <c:pt idx="7773">
                  <c:v>1570.75</c:v>
                </c:pt>
                <c:pt idx="7777">
                  <c:v>1294.06</c:v>
                </c:pt>
                <c:pt idx="7779">
                  <c:v>1298.5899999999999</c:v>
                </c:pt>
                <c:pt idx="7787">
                  <c:v>2387.66</c:v>
                </c:pt>
                <c:pt idx="7788">
                  <c:v>1450.44</c:v>
                </c:pt>
                <c:pt idx="7789">
                  <c:v>1243.73</c:v>
                </c:pt>
                <c:pt idx="7794">
                  <c:v>1324.51</c:v>
                </c:pt>
                <c:pt idx="7804">
                  <c:v>2348.35</c:v>
                </c:pt>
                <c:pt idx="7806">
                  <c:v>1590.41</c:v>
                </c:pt>
                <c:pt idx="7809">
                  <c:v>853.84799999999996</c:v>
                </c:pt>
                <c:pt idx="7810">
                  <c:v>1993.03</c:v>
                </c:pt>
                <c:pt idx="7814">
                  <c:v>4047.19</c:v>
                </c:pt>
                <c:pt idx="7816">
                  <c:v>1397.52</c:v>
                </c:pt>
                <c:pt idx="7827">
                  <c:v>1110.46</c:v>
                </c:pt>
                <c:pt idx="7830">
                  <c:v>1418.04</c:v>
                </c:pt>
                <c:pt idx="7835">
                  <c:v>1433.16</c:v>
                </c:pt>
                <c:pt idx="7837">
                  <c:v>1149.3399999999999</c:v>
                </c:pt>
                <c:pt idx="7840">
                  <c:v>1873.37</c:v>
                </c:pt>
                <c:pt idx="7849">
                  <c:v>835.27200000000005</c:v>
                </c:pt>
                <c:pt idx="7857">
                  <c:v>1947.46</c:v>
                </c:pt>
                <c:pt idx="7862">
                  <c:v>1725.41</c:v>
                </c:pt>
                <c:pt idx="7874">
                  <c:v>3256.2</c:v>
                </c:pt>
                <c:pt idx="7889">
                  <c:v>1891.73</c:v>
                </c:pt>
                <c:pt idx="7901">
                  <c:v>1881.58</c:v>
                </c:pt>
                <c:pt idx="7905">
                  <c:v>1116.29</c:v>
                </c:pt>
                <c:pt idx="7908">
                  <c:v>1033.1300000000001</c:v>
                </c:pt>
                <c:pt idx="7912">
                  <c:v>1239.8399999999999</c:v>
                </c:pt>
                <c:pt idx="7919">
                  <c:v>914.54399999999998</c:v>
                </c:pt>
                <c:pt idx="7920">
                  <c:v>1804.25</c:v>
                </c:pt>
                <c:pt idx="7922">
                  <c:v>989.28</c:v>
                </c:pt>
                <c:pt idx="7925">
                  <c:v>2054.38</c:v>
                </c:pt>
                <c:pt idx="7928">
                  <c:v>2260.87</c:v>
                </c:pt>
                <c:pt idx="7931">
                  <c:v>1718.71</c:v>
                </c:pt>
                <c:pt idx="7934">
                  <c:v>1721.09</c:v>
                </c:pt>
                <c:pt idx="7936">
                  <c:v>1443.31</c:v>
                </c:pt>
                <c:pt idx="7937">
                  <c:v>1612.22</c:v>
                </c:pt>
                <c:pt idx="7939">
                  <c:v>1780.49</c:v>
                </c:pt>
                <c:pt idx="7942">
                  <c:v>2260.66</c:v>
                </c:pt>
                <c:pt idx="7943">
                  <c:v>1269.43</c:v>
                </c:pt>
                <c:pt idx="7946">
                  <c:v>2237.33</c:v>
                </c:pt>
                <c:pt idx="7947">
                  <c:v>857.952</c:v>
                </c:pt>
                <c:pt idx="7955">
                  <c:v>825.33600000000001</c:v>
                </c:pt>
                <c:pt idx="7957">
                  <c:v>1306.8</c:v>
                </c:pt>
                <c:pt idx="7959">
                  <c:v>997.05600000000004</c:v>
                </c:pt>
                <c:pt idx="7961">
                  <c:v>1361.23</c:v>
                </c:pt>
                <c:pt idx="7964">
                  <c:v>3431.38</c:v>
                </c:pt>
                <c:pt idx="7968">
                  <c:v>2113.7800000000002</c:v>
                </c:pt>
                <c:pt idx="7972">
                  <c:v>2029.32</c:v>
                </c:pt>
                <c:pt idx="7982">
                  <c:v>2279.23</c:v>
                </c:pt>
                <c:pt idx="7985">
                  <c:v>1829.52</c:v>
                </c:pt>
                <c:pt idx="7994">
                  <c:v>1134</c:v>
                </c:pt>
                <c:pt idx="8007">
                  <c:v>944.56799999999998</c:v>
                </c:pt>
                <c:pt idx="8012">
                  <c:v>1018.66</c:v>
                </c:pt>
                <c:pt idx="8013">
                  <c:v>2863.08</c:v>
                </c:pt>
                <c:pt idx="8014">
                  <c:v>1025.78</c:v>
                </c:pt>
                <c:pt idx="8015">
                  <c:v>1802.3</c:v>
                </c:pt>
                <c:pt idx="8020">
                  <c:v>1869.05</c:v>
                </c:pt>
                <c:pt idx="8028">
                  <c:v>891.86400000000003</c:v>
                </c:pt>
                <c:pt idx="8032">
                  <c:v>1664.28</c:v>
                </c:pt>
                <c:pt idx="8043">
                  <c:v>1205.28</c:v>
                </c:pt>
                <c:pt idx="8048">
                  <c:v>2320.4899999999998</c:v>
                </c:pt>
                <c:pt idx="8053">
                  <c:v>1060.78</c:v>
                </c:pt>
                <c:pt idx="8069">
                  <c:v>1146.31</c:v>
                </c:pt>
                <c:pt idx="8075">
                  <c:v>1687.39</c:v>
                </c:pt>
                <c:pt idx="8082">
                  <c:v>773.71199999999999</c:v>
                </c:pt>
                <c:pt idx="8084">
                  <c:v>2645.57</c:v>
                </c:pt>
                <c:pt idx="8085">
                  <c:v>981.72</c:v>
                </c:pt>
                <c:pt idx="8087">
                  <c:v>1392.77</c:v>
                </c:pt>
                <c:pt idx="8090">
                  <c:v>1454.54</c:v>
                </c:pt>
                <c:pt idx="8097">
                  <c:v>1153.6600000000001</c:v>
                </c:pt>
                <c:pt idx="8100">
                  <c:v>1671.84</c:v>
                </c:pt>
                <c:pt idx="8101">
                  <c:v>3427.06</c:v>
                </c:pt>
                <c:pt idx="8102">
                  <c:v>1433.81</c:v>
                </c:pt>
                <c:pt idx="8104">
                  <c:v>8203.0300000000007</c:v>
                </c:pt>
                <c:pt idx="8113">
                  <c:v>884.952</c:v>
                </c:pt>
                <c:pt idx="8121">
                  <c:v>2515.9699999999998</c:v>
                </c:pt>
                <c:pt idx="8133">
                  <c:v>3644.57</c:v>
                </c:pt>
                <c:pt idx="8135">
                  <c:v>1913.98</c:v>
                </c:pt>
                <c:pt idx="8136">
                  <c:v>2459.38</c:v>
                </c:pt>
                <c:pt idx="8138">
                  <c:v>1040.26</c:v>
                </c:pt>
                <c:pt idx="8144">
                  <c:v>2552.04</c:v>
                </c:pt>
                <c:pt idx="8151">
                  <c:v>1544.83</c:v>
                </c:pt>
                <c:pt idx="8154">
                  <c:v>1404</c:v>
                </c:pt>
                <c:pt idx="8156">
                  <c:v>6612.84</c:v>
                </c:pt>
                <c:pt idx="8159">
                  <c:v>898.99199999999996</c:v>
                </c:pt>
                <c:pt idx="8160">
                  <c:v>1819.8</c:v>
                </c:pt>
                <c:pt idx="8164">
                  <c:v>899.85599999999999</c:v>
                </c:pt>
                <c:pt idx="8168">
                  <c:v>2995.7</c:v>
                </c:pt>
                <c:pt idx="8170">
                  <c:v>984.96</c:v>
                </c:pt>
                <c:pt idx="8172">
                  <c:v>2037.31</c:v>
                </c:pt>
                <c:pt idx="8181">
                  <c:v>1462.54</c:v>
                </c:pt>
                <c:pt idx="8187">
                  <c:v>1331.42</c:v>
                </c:pt>
                <c:pt idx="8188">
                  <c:v>1178.5</c:v>
                </c:pt>
                <c:pt idx="8189">
                  <c:v>1704.46</c:v>
                </c:pt>
                <c:pt idx="8208">
                  <c:v>2360.66</c:v>
                </c:pt>
                <c:pt idx="8213">
                  <c:v>1648.73</c:v>
                </c:pt>
                <c:pt idx="8215">
                  <c:v>1717.85</c:v>
                </c:pt>
                <c:pt idx="8219">
                  <c:v>1627.34</c:v>
                </c:pt>
                <c:pt idx="8220">
                  <c:v>806.54399999999998</c:v>
                </c:pt>
                <c:pt idx="8223">
                  <c:v>1296</c:v>
                </c:pt>
                <c:pt idx="8226">
                  <c:v>1635.55</c:v>
                </c:pt>
                <c:pt idx="8229">
                  <c:v>1013.26</c:v>
                </c:pt>
                <c:pt idx="8231">
                  <c:v>2181.17</c:v>
                </c:pt>
                <c:pt idx="8234">
                  <c:v>1127.95</c:v>
                </c:pt>
                <c:pt idx="8244">
                  <c:v>1623.46</c:v>
                </c:pt>
                <c:pt idx="8256">
                  <c:v>1087.1300000000001</c:v>
                </c:pt>
                <c:pt idx="8261">
                  <c:v>1443.31</c:v>
                </c:pt>
                <c:pt idx="8265">
                  <c:v>2366.71</c:v>
                </c:pt>
                <c:pt idx="8268">
                  <c:v>641.30399999999997</c:v>
                </c:pt>
                <c:pt idx="8277">
                  <c:v>1613.3</c:v>
                </c:pt>
                <c:pt idx="8286">
                  <c:v>1196.21</c:v>
                </c:pt>
                <c:pt idx="8288">
                  <c:v>1786.97</c:v>
                </c:pt>
                <c:pt idx="8290">
                  <c:v>1327.1</c:v>
                </c:pt>
                <c:pt idx="8292">
                  <c:v>1255.6099999999999</c:v>
                </c:pt>
                <c:pt idx="8300">
                  <c:v>829.65599999999995</c:v>
                </c:pt>
                <c:pt idx="8301">
                  <c:v>1299.46</c:v>
                </c:pt>
                <c:pt idx="8302">
                  <c:v>1806.41</c:v>
                </c:pt>
                <c:pt idx="8303">
                  <c:v>1307.8800000000001</c:v>
                </c:pt>
                <c:pt idx="8308">
                  <c:v>1605.74</c:v>
                </c:pt>
                <c:pt idx="8321">
                  <c:v>1108.73</c:v>
                </c:pt>
                <c:pt idx="8324">
                  <c:v>1081.08</c:v>
                </c:pt>
                <c:pt idx="8334">
                  <c:v>1589.11</c:v>
                </c:pt>
                <c:pt idx="8344">
                  <c:v>1043.28</c:v>
                </c:pt>
                <c:pt idx="8353">
                  <c:v>1318.68</c:v>
                </c:pt>
                <c:pt idx="8356">
                  <c:v>1254.74</c:v>
                </c:pt>
                <c:pt idx="8362">
                  <c:v>1578.96</c:v>
                </c:pt>
                <c:pt idx="8368">
                  <c:v>1038.0999999999999</c:v>
                </c:pt>
                <c:pt idx="8369">
                  <c:v>1540.94</c:v>
                </c:pt>
                <c:pt idx="8372">
                  <c:v>1623.02</c:v>
                </c:pt>
                <c:pt idx="8374">
                  <c:v>1138.54</c:v>
                </c:pt>
                <c:pt idx="8380">
                  <c:v>2325.46</c:v>
                </c:pt>
                <c:pt idx="8387">
                  <c:v>1186.27</c:v>
                </c:pt>
                <c:pt idx="8393">
                  <c:v>1661.47</c:v>
                </c:pt>
                <c:pt idx="8403">
                  <c:v>2513.38</c:v>
                </c:pt>
                <c:pt idx="8409">
                  <c:v>2689.63</c:v>
                </c:pt>
                <c:pt idx="8413">
                  <c:v>1203.55</c:v>
                </c:pt>
                <c:pt idx="8419">
                  <c:v>838.51199999999994</c:v>
                </c:pt>
                <c:pt idx="8433">
                  <c:v>961.84799999999996</c:v>
                </c:pt>
                <c:pt idx="8440">
                  <c:v>2080.94</c:v>
                </c:pt>
                <c:pt idx="8443">
                  <c:v>2545.13</c:v>
                </c:pt>
                <c:pt idx="8447">
                  <c:v>1899.94</c:v>
                </c:pt>
                <c:pt idx="8451">
                  <c:v>1103.54</c:v>
                </c:pt>
                <c:pt idx="8454">
                  <c:v>1420.85</c:v>
                </c:pt>
                <c:pt idx="8459">
                  <c:v>1857.38</c:v>
                </c:pt>
                <c:pt idx="8462">
                  <c:v>1059.7</c:v>
                </c:pt>
                <c:pt idx="8473">
                  <c:v>1867.32</c:v>
                </c:pt>
                <c:pt idx="8474">
                  <c:v>805.03200000000004</c:v>
                </c:pt>
                <c:pt idx="8475">
                  <c:v>1254.53</c:v>
                </c:pt>
                <c:pt idx="8476">
                  <c:v>1782.22</c:v>
                </c:pt>
                <c:pt idx="8484">
                  <c:v>1248.9100000000001</c:v>
                </c:pt>
                <c:pt idx="8489">
                  <c:v>1362.31</c:v>
                </c:pt>
                <c:pt idx="8490">
                  <c:v>1752.41</c:v>
                </c:pt>
                <c:pt idx="8492">
                  <c:v>1296.22</c:v>
                </c:pt>
                <c:pt idx="8500">
                  <c:v>833.32799999999997</c:v>
                </c:pt>
                <c:pt idx="8506">
                  <c:v>1250.8599999999999</c:v>
                </c:pt>
                <c:pt idx="8507">
                  <c:v>1299.46</c:v>
                </c:pt>
                <c:pt idx="8510">
                  <c:v>1200.53</c:v>
                </c:pt>
                <c:pt idx="8511">
                  <c:v>2049.41</c:v>
                </c:pt>
                <c:pt idx="8512">
                  <c:v>2807.57</c:v>
                </c:pt>
                <c:pt idx="8516">
                  <c:v>1688.47</c:v>
                </c:pt>
                <c:pt idx="8520">
                  <c:v>1621.08</c:v>
                </c:pt>
                <c:pt idx="8526">
                  <c:v>1512.43</c:v>
                </c:pt>
                <c:pt idx="8533">
                  <c:v>1544.62</c:v>
                </c:pt>
                <c:pt idx="8535">
                  <c:v>1240.49</c:v>
                </c:pt>
                <c:pt idx="8541">
                  <c:v>1437.7</c:v>
                </c:pt>
                <c:pt idx="8554">
                  <c:v>1714.39</c:v>
                </c:pt>
                <c:pt idx="8555">
                  <c:v>1431</c:v>
                </c:pt>
                <c:pt idx="8571">
                  <c:v>1748.74</c:v>
                </c:pt>
                <c:pt idx="8576">
                  <c:v>2316.17</c:v>
                </c:pt>
                <c:pt idx="8578">
                  <c:v>738.93600000000004</c:v>
                </c:pt>
                <c:pt idx="8582">
                  <c:v>2616.41</c:v>
                </c:pt>
                <c:pt idx="8583">
                  <c:v>1859.98</c:v>
                </c:pt>
                <c:pt idx="8585">
                  <c:v>1624.75</c:v>
                </c:pt>
                <c:pt idx="8588">
                  <c:v>1459.08</c:v>
                </c:pt>
                <c:pt idx="8592">
                  <c:v>1060.78</c:v>
                </c:pt>
                <c:pt idx="8598">
                  <c:v>1993.03</c:v>
                </c:pt>
                <c:pt idx="8608">
                  <c:v>1383.7</c:v>
                </c:pt>
                <c:pt idx="8615">
                  <c:v>1696.9</c:v>
                </c:pt>
                <c:pt idx="8627">
                  <c:v>1210.9000000000001</c:v>
                </c:pt>
                <c:pt idx="8628">
                  <c:v>1299.24</c:v>
                </c:pt>
                <c:pt idx="8629">
                  <c:v>2435.62</c:v>
                </c:pt>
                <c:pt idx="8631">
                  <c:v>1252.8</c:v>
                </c:pt>
                <c:pt idx="8638">
                  <c:v>2861.14</c:v>
                </c:pt>
                <c:pt idx="8644">
                  <c:v>1620.22</c:v>
                </c:pt>
                <c:pt idx="8648">
                  <c:v>1698.19</c:v>
                </c:pt>
                <c:pt idx="8649">
                  <c:v>1948.97</c:v>
                </c:pt>
                <c:pt idx="8658">
                  <c:v>983.01599999999996</c:v>
                </c:pt>
                <c:pt idx="8670">
                  <c:v>1999.73</c:v>
                </c:pt>
                <c:pt idx="8673">
                  <c:v>1094.69</c:v>
                </c:pt>
                <c:pt idx="8680">
                  <c:v>828.79200000000003</c:v>
                </c:pt>
                <c:pt idx="8686">
                  <c:v>1528.63</c:v>
                </c:pt>
                <c:pt idx="8697">
                  <c:v>844.34400000000005</c:v>
                </c:pt>
                <c:pt idx="8699">
                  <c:v>1668.38</c:v>
                </c:pt>
                <c:pt idx="8702">
                  <c:v>1164.8900000000001</c:v>
                </c:pt>
                <c:pt idx="8708">
                  <c:v>2039.04</c:v>
                </c:pt>
                <c:pt idx="8722">
                  <c:v>1940.54</c:v>
                </c:pt>
                <c:pt idx="8724">
                  <c:v>1690.85</c:v>
                </c:pt>
                <c:pt idx="8728">
                  <c:v>1506.6</c:v>
                </c:pt>
                <c:pt idx="8730">
                  <c:v>1346.54</c:v>
                </c:pt>
                <c:pt idx="8733">
                  <c:v>1386.07</c:v>
                </c:pt>
                <c:pt idx="8736">
                  <c:v>1532.52</c:v>
                </c:pt>
                <c:pt idx="8738">
                  <c:v>1119.96</c:v>
                </c:pt>
                <c:pt idx="8740">
                  <c:v>1734.7</c:v>
                </c:pt>
                <c:pt idx="8752">
                  <c:v>1029.8900000000001</c:v>
                </c:pt>
                <c:pt idx="8755">
                  <c:v>951.26400000000001</c:v>
                </c:pt>
                <c:pt idx="8758">
                  <c:v>2439.7199999999998</c:v>
                </c:pt>
                <c:pt idx="8761">
                  <c:v>1550.23</c:v>
                </c:pt>
                <c:pt idx="8764">
                  <c:v>1857.82</c:v>
                </c:pt>
                <c:pt idx="8767">
                  <c:v>1272.67</c:v>
                </c:pt>
                <c:pt idx="8769">
                  <c:v>1958.47</c:v>
                </c:pt>
                <c:pt idx="8771">
                  <c:v>2486.59</c:v>
                </c:pt>
                <c:pt idx="8773">
                  <c:v>1271.3800000000001</c:v>
                </c:pt>
                <c:pt idx="8775">
                  <c:v>1777.03</c:v>
                </c:pt>
                <c:pt idx="8776">
                  <c:v>3025.3</c:v>
                </c:pt>
                <c:pt idx="8779">
                  <c:v>1748.95</c:v>
                </c:pt>
                <c:pt idx="8784">
                  <c:v>1825.2</c:v>
                </c:pt>
                <c:pt idx="8793">
                  <c:v>1696.03</c:v>
                </c:pt>
                <c:pt idx="8801">
                  <c:v>1250.21</c:v>
                </c:pt>
                <c:pt idx="8804">
                  <c:v>1341.79</c:v>
                </c:pt>
                <c:pt idx="8809">
                  <c:v>1077.8399999999999</c:v>
                </c:pt>
                <c:pt idx="8814">
                  <c:v>989.49599999999998</c:v>
                </c:pt>
                <c:pt idx="8820">
                  <c:v>1585.66</c:v>
                </c:pt>
                <c:pt idx="8821">
                  <c:v>1454.76</c:v>
                </c:pt>
                <c:pt idx="8822">
                  <c:v>1538.14</c:v>
                </c:pt>
                <c:pt idx="8824">
                  <c:v>2132.5700000000002</c:v>
                </c:pt>
                <c:pt idx="8837">
                  <c:v>7028.86</c:v>
                </c:pt>
                <c:pt idx="8838">
                  <c:v>1955.45</c:v>
                </c:pt>
                <c:pt idx="8839">
                  <c:v>1505.09</c:v>
                </c:pt>
                <c:pt idx="8841">
                  <c:v>1687.61</c:v>
                </c:pt>
                <c:pt idx="8845">
                  <c:v>1123.8499999999999</c:v>
                </c:pt>
                <c:pt idx="8852">
                  <c:v>1517.62</c:v>
                </c:pt>
                <c:pt idx="8854">
                  <c:v>1971.86</c:v>
                </c:pt>
                <c:pt idx="8855">
                  <c:v>1168.99</c:v>
                </c:pt>
                <c:pt idx="8856">
                  <c:v>1135.94</c:v>
                </c:pt>
                <c:pt idx="8862">
                  <c:v>1380.02</c:v>
                </c:pt>
                <c:pt idx="8865">
                  <c:v>819.50400000000002</c:v>
                </c:pt>
                <c:pt idx="8876">
                  <c:v>1315.44</c:v>
                </c:pt>
                <c:pt idx="8877">
                  <c:v>2218.1</c:v>
                </c:pt>
                <c:pt idx="8879">
                  <c:v>1933.63</c:v>
                </c:pt>
                <c:pt idx="8884">
                  <c:v>1727.57</c:v>
                </c:pt>
                <c:pt idx="8889">
                  <c:v>923.18399999999997</c:v>
                </c:pt>
                <c:pt idx="8892">
                  <c:v>959.04</c:v>
                </c:pt>
                <c:pt idx="8893">
                  <c:v>856.44</c:v>
                </c:pt>
                <c:pt idx="8899">
                  <c:v>1401.62</c:v>
                </c:pt>
                <c:pt idx="8901">
                  <c:v>2752.06</c:v>
                </c:pt>
                <c:pt idx="8906">
                  <c:v>1589.76</c:v>
                </c:pt>
                <c:pt idx="8921">
                  <c:v>1442.88</c:v>
                </c:pt>
                <c:pt idx="8933">
                  <c:v>1784.38</c:v>
                </c:pt>
                <c:pt idx="8937">
                  <c:v>2560.9</c:v>
                </c:pt>
                <c:pt idx="8938">
                  <c:v>1251.5</c:v>
                </c:pt>
                <c:pt idx="8948">
                  <c:v>1613.09</c:v>
                </c:pt>
                <c:pt idx="8956">
                  <c:v>1803.6</c:v>
                </c:pt>
                <c:pt idx="8957">
                  <c:v>1124.5</c:v>
                </c:pt>
                <c:pt idx="8961">
                  <c:v>1742.04</c:v>
                </c:pt>
                <c:pt idx="8966">
                  <c:v>1924.99</c:v>
                </c:pt>
                <c:pt idx="8971">
                  <c:v>1694.09</c:v>
                </c:pt>
                <c:pt idx="8974">
                  <c:v>1916.78</c:v>
                </c:pt>
                <c:pt idx="8980">
                  <c:v>1650.67</c:v>
                </c:pt>
                <c:pt idx="8982">
                  <c:v>1527.98</c:v>
                </c:pt>
                <c:pt idx="8987">
                  <c:v>4328.8599999999997</c:v>
                </c:pt>
                <c:pt idx="8992">
                  <c:v>1203.98</c:v>
                </c:pt>
                <c:pt idx="8995">
                  <c:v>3037.39</c:v>
                </c:pt>
                <c:pt idx="8998">
                  <c:v>1771.42</c:v>
                </c:pt>
                <c:pt idx="9003">
                  <c:v>2516.83</c:v>
                </c:pt>
                <c:pt idx="9004">
                  <c:v>1771.2</c:v>
                </c:pt>
                <c:pt idx="9007">
                  <c:v>717.98400000000004</c:v>
                </c:pt>
                <c:pt idx="9018">
                  <c:v>1259.06</c:v>
                </c:pt>
                <c:pt idx="9019">
                  <c:v>1273.32</c:v>
                </c:pt>
                <c:pt idx="9023">
                  <c:v>1120.6099999999999</c:v>
                </c:pt>
                <c:pt idx="9027">
                  <c:v>1006.99</c:v>
                </c:pt>
                <c:pt idx="9036">
                  <c:v>2024.78</c:v>
                </c:pt>
                <c:pt idx="9040">
                  <c:v>1910.52</c:v>
                </c:pt>
                <c:pt idx="9053">
                  <c:v>1874.66</c:v>
                </c:pt>
                <c:pt idx="9054">
                  <c:v>1257.3399999999999</c:v>
                </c:pt>
                <c:pt idx="9055">
                  <c:v>1688.9</c:v>
                </c:pt>
                <c:pt idx="9056">
                  <c:v>4373.3500000000004</c:v>
                </c:pt>
                <c:pt idx="9065">
                  <c:v>1429.06</c:v>
                </c:pt>
                <c:pt idx="9069">
                  <c:v>1837.94</c:v>
                </c:pt>
                <c:pt idx="9073">
                  <c:v>1984.39</c:v>
                </c:pt>
                <c:pt idx="9079">
                  <c:v>1582.63</c:v>
                </c:pt>
                <c:pt idx="9087">
                  <c:v>2409.0500000000002</c:v>
                </c:pt>
                <c:pt idx="9098">
                  <c:v>1843.99</c:v>
                </c:pt>
                <c:pt idx="9099">
                  <c:v>1605.74</c:v>
                </c:pt>
                <c:pt idx="9104">
                  <c:v>2066.69</c:v>
                </c:pt>
                <c:pt idx="9106">
                  <c:v>1478.74</c:v>
                </c:pt>
                <c:pt idx="9109">
                  <c:v>776.52</c:v>
                </c:pt>
                <c:pt idx="9110">
                  <c:v>844.99199999999996</c:v>
                </c:pt>
                <c:pt idx="9112">
                  <c:v>1472.9</c:v>
                </c:pt>
                <c:pt idx="9113">
                  <c:v>1630.37</c:v>
                </c:pt>
                <c:pt idx="9119">
                  <c:v>1965.38</c:v>
                </c:pt>
                <c:pt idx="9122">
                  <c:v>1653.91</c:v>
                </c:pt>
                <c:pt idx="9123">
                  <c:v>1699.92</c:v>
                </c:pt>
                <c:pt idx="9124">
                  <c:v>3266.35</c:v>
                </c:pt>
                <c:pt idx="9135">
                  <c:v>1422.58</c:v>
                </c:pt>
                <c:pt idx="9138">
                  <c:v>4594.54</c:v>
                </c:pt>
                <c:pt idx="9140">
                  <c:v>2423.52</c:v>
                </c:pt>
                <c:pt idx="9142">
                  <c:v>1233.58</c:v>
                </c:pt>
                <c:pt idx="9143">
                  <c:v>1613.74</c:v>
                </c:pt>
                <c:pt idx="9144">
                  <c:v>1670.33</c:v>
                </c:pt>
                <c:pt idx="9145">
                  <c:v>1656.07</c:v>
                </c:pt>
                <c:pt idx="9148">
                  <c:v>1637.93</c:v>
                </c:pt>
                <c:pt idx="9151">
                  <c:v>1175.26</c:v>
                </c:pt>
                <c:pt idx="9152">
                  <c:v>1497.96</c:v>
                </c:pt>
                <c:pt idx="9155">
                  <c:v>1425.6</c:v>
                </c:pt>
                <c:pt idx="9159">
                  <c:v>2323.73</c:v>
                </c:pt>
                <c:pt idx="9162">
                  <c:v>1264.68</c:v>
                </c:pt>
                <c:pt idx="9163">
                  <c:v>1690.85</c:v>
                </c:pt>
                <c:pt idx="9172">
                  <c:v>1667.95</c:v>
                </c:pt>
                <c:pt idx="9176">
                  <c:v>1403.35</c:v>
                </c:pt>
                <c:pt idx="9180">
                  <c:v>1979.64</c:v>
                </c:pt>
                <c:pt idx="9187">
                  <c:v>1576.8</c:v>
                </c:pt>
                <c:pt idx="9191">
                  <c:v>1102.46</c:v>
                </c:pt>
                <c:pt idx="9192">
                  <c:v>1317.17</c:v>
                </c:pt>
                <c:pt idx="9197">
                  <c:v>1364.69</c:v>
                </c:pt>
                <c:pt idx="9201">
                  <c:v>2133.86</c:v>
                </c:pt>
                <c:pt idx="9203">
                  <c:v>1019.74</c:v>
                </c:pt>
                <c:pt idx="9207">
                  <c:v>3039.77</c:v>
                </c:pt>
                <c:pt idx="9208">
                  <c:v>1235.3</c:v>
                </c:pt>
                <c:pt idx="9214">
                  <c:v>1394.93</c:v>
                </c:pt>
                <c:pt idx="9221">
                  <c:v>1912.46</c:v>
                </c:pt>
                <c:pt idx="9238">
                  <c:v>1632.53</c:v>
                </c:pt>
                <c:pt idx="9257">
                  <c:v>2574.94</c:v>
                </c:pt>
                <c:pt idx="9263">
                  <c:v>1774.66</c:v>
                </c:pt>
                <c:pt idx="9264">
                  <c:v>1761.48</c:v>
                </c:pt>
                <c:pt idx="9271">
                  <c:v>1648.51</c:v>
                </c:pt>
                <c:pt idx="9272">
                  <c:v>2117.66</c:v>
                </c:pt>
                <c:pt idx="9273">
                  <c:v>2008.58</c:v>
                </c:pt>
                <c:pt idx="9277">
                  <c:v>1208.95</c:v>
                </c:pt>
                <c:pt idx="9278">
                  <c:v>1253.8800000000001</c:v>
                </c:pt>
                <c:pt idx="9282">
                  <c:v>1351.94</c:v>
                </c:pt>
                <c:pt idx="9286">
                  <c:v>1959.55</c:v>
                </c:pt>
                <c:pt idx="9292">
                  <c:v>1443.1</c:v>
                </c:pt>
                <c:pt idx="9293">
                  <c:v>1929.53</c:v>
                </c:pt>
                <c:pt idx="9300">
                  <c:v>1797.77</c:v>
                </c:pt>
                <c:pt idx="9302">
                  <c:v>1684.58</c:v>
                </c:pt>
                <c:pt idx="9322">
                  <c:v>3555.36</c:v>
                </c:pt>
                <c:pt idx="9325">
                  <c:v>2014.85</c:v>
                </c:pt>
                <c:pt idx="9326">
                  <c:v>1293.19</c:v>
                </c:pt>
                <c:pt idx="9336">
                  <c:v>987.12</c:v>
                </c:pt>
                <c:pt idx="9337">
                  <c:v>967.24800000000005</c:v>
                </c:pt>
                <c:pt idx="9339">
                  <c:v>2316.6</c:v>
                </c:pt>
                <c:pt idx="9341">
                  <c:v>1974.89</c:v>
                </c:pt>
                <c:pt idx="9349">
                  <c:v>2439.29</c:v>
                </c:pt>
                <c:pt idx="9353">
                  <c:v>2473.42</c:v>
                </c:pt>
                <c:pt idx="9356">
                  <c:v>1672.7</c:v>
                </c:pt>
                <c:pt idx="9357">
                  <c:v>1805.76</c:v>
                </c:pt>
                <c:pt idx="9363">
                  <c:v>2072.3000000000002</c:v>
                </c:pt>
                <c:pt idx="9370">
                  <c:v>1745.28</c:v>
                </c:pt>
                <c:pt idx="9375">
                  <c:v>1258.8499999999999</c:v>
                </c:pt>
                <c:pt idx="9376">
                  <c:v>1882.01</c:v>
                </c:pt>
                <c:pt idx="9379">
                  <c:v>1162.73</c:v>
                </c:pt>
                <c:pt idx="9381">
                  <c:v>1187.57</c:v>
                </c:pt>
                <c:pt idx="9398">
                  <c:v>1190.81</c:v>
                </c:pt>
                <c:pt idx="9400">
                  <c:v>1579.18</c:v>
                </c:pt>
                <c:pt idx="9403">
                  <c:v>1786.1</c:v>
                </c:pt>
                <c:pt idx="9408">
                  <c:v>1239.8399999999999</c:v>
                </c:pt>
                <c:pt idx="9414">
                  <c:v>1544.83</c:v>
                </c:pt>
                <c:pt idx="9418">
                  <c:v>1169.42</c:v>
                </c:pt>
                <c:pt idx="9421">
                  <c:v>1971.22</c:v>
                </c:pt>
                <c:pt idx="9425">
                  <c:v>3188.81</c:v>
                </c:pt>
                <c:pt idx="9428">
                  <c:v>1604.45</c:v>
                </c:pt>
                <c:pt idx="9429">
                  <c:v>1716.12</c:v>
                </c:pt>
                <c:pt idx="9431">
                  <c:v>1134.8599999999999</c:v>
                </c:pt>
                <c:pt idx="9432">
                  <c:v>1636.42</c:v>
                </c:pt>
                <c:pt idx="9434">
                  <c:v>3066.55</c:v>
                </c:pt>
                <c:pt idx="9440">
                  <c:v>865.08</c:v>
                </c:pt>
                <c:pt idx="9442">
                  <c:v>1368.14</c:v>
                </c:pt>
                <c:pt idx="9448">
                  <c:v>2825.06</c:v>
                </c:pt>
                <c:pt idx="9451">
                  <c:v>2677.54</c:v>
                </c:pt>
                <c:pt idx="9452">
                  <c:v>2593.08</c:v>
                </c:pt>
                <c:pt idx="9455">
                  <c:v>2237.54</c:v>
                </c:pt>
                <c:pt idx="9458">
                  <c:v>949.75199999999995</c:v>
                </c:pt>
                <c:pt idx="9461">
                  <c:v>1866.24</c:v>
                </c:pt>
                <c:pt idx="9464">
                  <c:v>1758.02</c:v>
                </c:pt>
                <c:pt idx="9465">
                  <c:v>1666.22</c:v>
                </c:pt>
                <c:pt idx="9468">
                  <c:v>1601.64</c:v>
                </c:pt>
                <c:pt idx="9472">
                  <c:v>962.06399999999996</c:v>
                </c:pt>
                <c:pt idx="9473">
                  <c:v>1437.7</c:v>
                </c:pt>
                <c:pt idx="9475">
                  <c:v>1579.82</c:v>
                </c:pt>
                <c:pt idx="9487">
                  <c:v>2015.71</c:v>
                </c:pt>
                <c:pt idx="9489">
                  <c:v>1400.98</c:v>
                </c:pt>
                <c:pt idx="9493">
                  <c:v>1323.65</c:v>
                </c:pt>
                <c:pt idx="9494">
                  <c:v>1405.73</c:v>
                </c:pt>
                <c:pt idx="9504">
                  <c:v>1173.0999999999999</c:v>
                </c:pt>
                <c:pt idx="9511">
                  <c:v>1489.54</c:v>
                </c:pt>
                <c:pt idx="9523">
                  <c:v>1571.83</c:v>
                </c:pt>
                <c:pt idx="9527">
                  <c:v>1139.4000000000001</c:v>
                </c:pt>
                <c:pt idx="9528">
                  <c:v>3044.09</c:v>
                </c:pt>
                <c:pt idx="9529">
                  <c:v>1744.42</c:v>
                </c:pt>
                <c:pt idx="9532">
                  <c:v>1610.93</c:v>
                </c:pt>
                <c:pt idx="9540">
                  <c:v>968.32799999999997</c:v>
                </c:pt>
                <c:pt idx="9547">
                  <c:v>1923.7</c:v>
                </c:pt>
                <c:pt idx="9550">
                  <c:v>1314.58</c:v>
                </c:pt>
                <c:pt idx="9551">
                  <c:v>2246.4</c:v>
                </c:pt>
                <c:pt idx="9555">
                  <c:v>1751.98</c:v>
                </c:pt>
                <c:pt idx="9558">
                  <c:v>1874.23</c:v>
                </c:pt>
                <c:pt idx="9561">
                  <c:v>1836.22</c:v>
                </c:pt>
                <c:pt idx="9563">
                  <c:v>2789.21</c:v>
                </c:pt>
                <c:pt idx="9572">
                  <c:v>967.46400000000006</c:v>
                </c:pt>
                <c:pt idx="9577">
                  <c:v>1411.99</c:v>
                </c:pt>
                <c:pt idx="9579">
                  <c:v>1493.86</c:v>
                </c:pt>
                <c:pt idx="9580">
                  <c:v>1390.82</c:v>
                </c:pt>
                <c:pt idx="9581">
                  <c:v>1007.21</c:v>
                </c:pt>
                <c:pt idx="9589">
                  <c:v>929.23199999999997</c:v>
                </c:pt>
                <c:pt idx="9593">
                  <c:v>4040.93</c:v>
                </c:pt>
                <c:pt idx="9599">
                  <c:v>1363.82</c:v>
                </c:pt>
                <c:pt idx="9602">
                  <c:v>1377.43</c:v>
                </c:pt>
                <c:pt idx="9605">
                  <c:v>1438.13</c:v>
                </c:pt>
                <c:pt idx="9609">
                  <c:v>2134.73</c:v>
                </c:pt>
                <c:pt idx="9612">
                  <c:v>1774.22</c:v>
                </c:pt>
                <c:pt idx="9616">
                  <c:v>1549.58</c:v>
                </c:pt>
                <c:pt idx="9623">
                  <c:v>1622.59</c:v>
                </c:pt>
                <c:pt idx="9629">
                  <c:v>1261.6600000000001</c:v>
                </c:pt>
                <c:pt idx="9648">
                  <c:v>2064.7399999999998</c:v>
                </c:pt>
                <c:pt idx="9649">
                  <c:v>2821.39</c:v>
                </c:pt>
                <c:pt idx="9652">
                  <c:v>873.93600000000004</c:v>
                </c:pt>
                <c:pt idx="9654">
                  <c:v>1542.67</c:v>
                </c:pt>
                <c:pt idx="9667">
                  <c:v>1333.37</c:v>
                </c:pt>
                <c:pt idx="9671">
                  <c:v>1941.62</c:v>
                </c:pt>
                <c:pt idx="9680">
                  <c:v>1828.66</c:v>
                </c:pt>
                <c:pt idx="9681">
                  <c:v>2048.54</c:v>
                </c:pt>
                <c:pt idx="9682">
                  <c:v>1826.5</c:v>
                </c:pt>
                <c:pt idx="9684">
                  <c:v>2075.11</c:v>
                </c:pt>
                <c:pt idx="9685">
                  <c:v>1777.46</c:v>
                </c:pt>
                <c:pt idx="9686">
                  <c:v>1361.45</c:v>
                </c:pt>
                <c:pt idx="9689">
                  <c:v>2067.77</c:v>
                </c:pt>
                <c:pt idx="9691">
                  <c:v>2862.22</c:v>
                </c:pt>
                <c:pt idx="9698">
                  <c:v>1218.02</c:v>
                </c:pt>
                <c:pt idx="9700">
                  <c:v>2444.9</c:v>
                </c:pt>
                <c:pt idx="9702">
                  <c:v>1415.45</c:v>
                </c:pt>
                <c:pt idx="9703">
                  <c:v>1923.48</c:v>
                </c:pt>
                <c:pt idx="9712">
                  <c:v>1484.78</c:v>
                </c:pt>
                <c:pt idx="9714">
                  <c:v>1066.3900000000001</c:v>
                </c:pt>
                <c:pt idx="9715">
                  <c:v>1917.43</c:v>
                </c:pt>
                <c:pt idx="9725">
                  <c:v>2313.14</c:v>
                </c:pt>
                <c:pt idx="9730">
                  <c:v>1879.2</c:v>
                </c:pt>
                <c:pt idx="9735">
                  <c:v>1853.71</c:v>
                </c:pt>
                <c:pt idx="9739">
                  <c:v>1254.31</c:v>
                </c:pt>
                <c:pt idx="9742">
                  <c:v>1808.78</c:v>
                </c:pt>
                <c:pt idx="9743">
                  <c:v>1377</c:v>
                </c:pt>
                <c:pt idx="9744">
                  <c:v>1149.3399999999999</c:v>
                </c:pt>
                <c:pt idx="9753">
                  <c:v>898.56</c:v>
                </c:pt>
                <c:pt idx="9763">
                  <c:v>1467.5</c:v>
                </c:pt>
                <c:pt idx="9770">
                  <c:v>1663.63</c:v>
                </c:pt>
                <c:pt idx="9773">
                  <c:v>1286.28</c:v>
                </c:pt>
                <c:pt idx="9776">
                  <c:v>1831.25</c:v>
                </c:pt>
                <c:pt idx="9778">
                  <c:v>1407.46</c:v>
                </c:pt>
                <c:pt idx="9780">
                  <c:v>1820.88</c:v>
                </c:pt>
                <c:pt idx="9781">
                  <c:v>1829.09</c:v>
                </c:pt>
                <c:pt idx="9786">
                  <c:v>1181.3</c:v>
                </c:pt>
                <c:pt idx="9792">
                  <c:v>1323</c:v>
                </c:pt>
                <c:pt idx="9794">
                  <c:v>2485.3000000000002</c:v>
                </c:pt>
                <c:pt idx="9797">
                  <c:v>3702.67</c:v>
                </c:pt>
                <c:pt idx="9804">
                  <c:v>1332.5</c:v>
                </c:pt>
                <c:pt idx="9813">
                  <c:v>2120.2600000000002</c:v>
                </c:pt>
                <c:pt idx="9814">
                  <c:v>1313.71</c:v>
                </c:pt>
                <c:pt idx="9818">
                  <c:v>1404.22</c:v>
                </c:pt>
                <c:pt idx="9819">
                  <c:v>1271.3800000000001</c:v>
                </c:pt>
                <c:pt idx="9820">
                  <c:v>1404.43</c:v>
                </c:pt>
                <c:pt idx="9822">
                  <c:v>1057.54</c:v>
                </c:pt>
                <c:pt idx="9824">
                  <c:v>1561.25</c:v>
                </c:pt>
                <c:pt idx="9826">
                  <c:v>1309.3900000000001</c:v>
                </c:pt>
                <c:pt idx="9827">
                  <c:v>2290.25</c:v>
                </c:pt>
                <c:pt idx="9828">
                  <c:v>1759.54</c:v>
                </c:pt>
                <c:pt idx="9831">
                  <c:v>1480.03</c:v>
                </c:pt>
                <c:pt idx="9832">
                  <c:v>1366.85</c:v>
                </c:pt>
                <c:pt idx="9833">
                  <c:v>1102.9000000000001</c:v>
                </c:pt>
                <c:pt idx="9840">
                  <c:v>1190.3800000000001</c:v>
                </c:pt>
                <c:pt idx="9855">
                  <c:v>1618.49</c:v>
                </c:pt>
                <c:pt idx="9861">
                  <c:v>1414.37</c:v>
                </c:pt>
                <c:pt idx="9866">
                  <c:v>1024.92</c:v>
                </c:pt>
                <c:pt idx="9867">
                  <c:v>1824.12</c:v>
                </c:pt>
                <c:pt idx="9872">
                  <c:v>1480.25</c:v>
                </c:pt>
                <c:pt idx="9875">
                  <c:v>1723.25</c:v>
                </c:pt>
                <c:pt idx="9878">
                  <c:v>1668.6</c:v>
                </c:pt>
                <c:pt idx="9880">
                  <c:v>2902.61</c:v>
                </c:pt>
                <c:pt idx="9891">
                  <c:v>1919.38</c:v>
                </c:pt>
                <c:pt idx="9894">
                  <c:v>2858.11</c:v>
                </c:pt>
                <c:pt idx="9903">
                  <c:v>1335.74</c:v>
                </c:pt>
                <c:pt idx="9909">
                  <c:v>1823.04</c:v>
                </c:pt>
                <c:pt idx="9915">
                  <c:v>1699.7</c:v>
                </c:pt>
                <c:pt idx="9919">
                  <c:v>1160.1400000000001</c:v>
                </c:pt>
                <c:pt idx="9932">
                  <c:v>1051.27</c:v>
                </c:pt>
                <c:pt idx="9939">
                  <c:v>1843.99</c:v>
                </c:pt>
                <c:pt idx="9941">
                  <c:v>1326.89</c:v>
                </c:pt>
                <c:pt idx="9948">
                  <c:v>1967.76</c:v>
                </c:pt>
                <c:pt idx="9949">
                  <c:v>2570.1799999999998</c:v>
                </c:pt>
                <c:pt idx="9951">
                  <c:v>887.976</c:v>
                </c:pt>
                <c:pt idx="9960">
                  <c:v>4815.29</c:v>
                </c:pt>
                <c:pt idx="9965">
                  <c:v>1323.86</c:v>
                </c:pt>
                <c:pt idx="9967">
                  <c:v>849.096</c:v>
                </c:pt>
                <c:pt idx="9972">
                  <c:v>1296.22</c:v>
                </c:pt>
                <c:pt idx="9974">
                  <c:v>2481.84</c:v>
                </c:pt>
                <c:pt idx="9975">
                  <c:v>955.36800000000005</c:v>
                </c:pt>
                <c:pt idx="9981">
                  <c:v>2213.7800000000002</c:v>
                </c:pt>
                <c:pt idx="9986">
                  <c:v>2173.8200000000002</c:v>
                </c:pt>
                <c:pt idx="9991">
                  <c:v>1542.67</c:v>
                </c:pt>
                <c:pt idx="9992">
                  <c:v>1905.55</c:v>
                </c:pt>
                <c:pt idx="9994">
                  <c:v>2518.56</c:v>
                </c:pt>
                <c:pt idx="9995">
                  <c:v>2087.42</c:v>
                </c:pt>
                <c:pt idx="10001">
                  <c:v>2409.2600000000002</c:v>
                </c:pt>
                <c:pt idx="10002">
                  <c:v>1685.23</c:v>
                </c:pt>
                <c:pt idx="10003">
                  <c:v>1941.19</c:v>
                </c:pt>
                <c:pt idx="10004">
                  <c:v>2218.75</c:v>
                </c:pt>
                <c:pt idx="10006">
                  <c:v>1996.27</c:v>
                </c:pt>
                <c:pt idx="10007">
                  <c:v>1178.5</c:v>
                </c:pt>
                <c:pt idx="10010">
                  <c:v>2544.48</c:v>
                </c:pt>
                <c:pt idx="10014">
                  <c:v>1119.53</c:v>
                </c:pt>
                <c:pt idx="10015">
                  <c:v>1297.3</c:v>
                </c:pt>
                <c:pt idx="10016">
                  <c:v>1775.52</c:v>
                </c:pt>
                <c:pt idx="10021">
                  <c:v>1613.74</c:v>
                </c:pt>
                <c:pt idx="10024">
                  <c:v>2206.44</c:v>
                </c:pt>
                <c:pt idx="10027">
                  <c:v>1670.33</c:v>
                </c:pt>
                <c:pt idx="10028">
                  <c:v>1278.07</c:v>
                </c:pt>
                <c:pt idx="10029">
                  <c:v>2103.19</c:v>
                </c:pt>
                <c:pt idx="10033">
                  <c:v>1145.45</c:v>
                </c:pt>
                <c:pt idx="10035">
                  <c:v>1559.09</c:v>
                </c:pt>
                <c:pt idx="10041">
                  <c:v>1554.98</c:v>
                </c:pt>
                <c:pt idx="10050">
                  <c:v>1188</c:v>
                </c:pt>
                <c:pt idx="10054">
                  <c:v>2195.64</c:v>
                </c:pt>
                <c:pt idx="10057">
                  <c:v>1681.78</c:v>
                </c:pt>
                <c:pt idx="10070">
                  <c:v>1111.97</c:v>
                </c:pt>
                <c:pt idx="10072">
                  <c:v>1238.33</c:v>
                </c:pt>
                <c:pt idx="10078">
                  <c:v>4142.66</c:v>
                </c:pt>
                <c:pt idx="10079">
                  <c:v>1642.68</c:v>
                </c:pt>
                <c:pt idx="10080">
                  <c:v>2059.56</c:v>
                </c:pt>
                <c:pt idx="10082">
                  <c:v>1078.7</c:v>
                </c:pt>
                <c:pt idx="10086">
                  <c:v>1740.31</c:v>
                </c:pt>
                <c:pt idx="10097">
                  <c:v>2554.85</c:v>
                </c:pt>
                <c:pt idx="10098">
                  <c:v>1630.37</c:v>
                </c:pt>
                <c:pt idx="10099">
                  <c:v>1790.64</c:v>
                </c:pt>
                <c:pt idx="10105">
                  <c:v>1151.93</c:v>
                </c:pt>
                <c:pt idx="10106">
                  <c:v>1540.3</c:v>
                </c:pt>
                <c:pt idx="10107">
                  <c:v>1623.89</c:v>
                </c:pt>
                <c:pt idx="10110">
                  <c:v>2024.14</c:v>
                </c:pt>
                <c:pt idx="10118">
                  <c:v>1386.07</c:v>
                </c:pt>
                <c:pt idx="10120">
                  <c:v>2485.73</c:v>
                </c:pt>
                <c:pt idx="10121">
                  <c:v>904.39200000000005</c:v>
                </c:pt>
                <c:pt idx="10130">
                  <c:v>1918.08</c:v>
                </c:pt>
                <c:pt idx="10132">
                  <c:v>1279.8</c:v>
                </c:pt>
                <c:pt idx="10137">
                  <c:v>1913.98</c:v>
                </c:pt>
                <c:pt idx="10140">
                  <c:v>2047.03</c:v>
                </c:pt>
                <c:pt idx="10142">
                  <c:v>1143.07</c:v>
                </c:pt>
                <c:pt idx="10146">
                  <c:v>1378.3</c:v>
                </c:pt>
                <c:pt idx="10148">
                  <c:v>1108.94</c:v>
                </c:pt>
                <c:pt idx="10152">
                  <c:v>1375.7</c:v>
                </c:pt>
                <c:pt idx="10156">
                  <c:v>4778.3500000000004</c:v>
                </c:pt>
                <c:pt idx="10172">
                  <c:v>2214.65</c:v>
                </c:pt>
                <c:pt idx="10181">
                  <c:v>2104.27</c:v>
                </c:pt>
                <c:pt idx="10186">
                  <c:v>1093.82</c:v>
                </c:pt>
                <c:pt idx="10187">
                  <c:v>1746.14</c:v>
                </c:pt>
                <c:pt idx="10188">
                  <c:v>1433.16</c:v>
                </c:pt>
                <c:pt idx="10191">
                  <c:v>2054.81</c:v>
                </c:pt>
                <c:pt idx="10196">
                  <c:v>1656.29</c:v>
                </c:pt>
                <c:pt idx="10199">
                  <c:v>1459.73</c:v>
                </c:pt>
                <c:pt idx="10205">
                  <c:v>2154.8200000000002</c:v>
                </c:pt>
                <c:pt idx="10207">
                  <c:v>1324.08</c:v>
                </c:pt>
                <c:pt idx="10209">
                  <c:v>2512.3000000000002</c:v>
                </c:pt>
                <c:pt idx="10215">
                  <c:v>1664.06</c:v>
                </c:pt>
                <c:pt idx="10218">
                  <c:v>2571.6999999999998</c:v>
                </c:pt>
                <c:pt idx="10219">
                  <c:v>1482.19</c:v>
                </c:pt>
                <c:pt idx="10220">
                  <c:v>1709.64</c:v>
                </c:pt>
                <c:pt idx="10223">
                  <c:v>1057.54</c:v>
                </c:pt>
                <c:pt idx="10224">
                  <c:v>1933.42</c:v>
                </c:pt>
                <c:pt idx="10225">
                  <c:v>1511.35</c:v>
                </c:pt>
                <c:pt idx="10231">
                  <c:v>1438.78</c:v>
                </c:pt>
                <c:pt idx="10238">
                  <c:v>1496.66</c:v>
                </c:pt>
                <c:pt idx="10254">
                  <c:v>1232.28</c:v>
                </c:pt>
                <c:pt idx="10262">
                  <c:v>1414.58</c:v>
                </c:pt>
                <c:pt idx="10263">
                  <c:v>943.27200000000005</c:v>
                </c:pt>
                <c:pt idx="10264">
                  <c:v>1486.73</c:v>
                </c:pt>
                <c:pt idx="10265">
                  <c:v>2024.14</c:v>
                </c:pt>
                <c:pt idx="10270">
                  <c:v>1080.6500000000001</c:v>
                </c:pt>
                <c:pt idx="10277">
                  <c:v>1462.75</c:v>
                </c:pt>
                <c:pt idx="10278">
                  <c:v>1214.57</c:v>
                </c:pt>
                <c:pt idx="10280">
                  <c:v>1405.94</c:v>
                </c:pt>
                <c:pt idx="10281">
                  <c:v>2136.67</c:v>
                </c:pt>
                <c:pt idx="10287">
                  <c:v>1653.05</c:v>
                </c:pt>
                <c:pt idx="10291">
                  <c:v>3195.29</c:v>
                </c:pt>
                <c:pt idx="10294">
                  <c:v>1758.46</c:v>
                </c:pt>
                <c:pt idx="10295">
                  <c:v>2333.23</c:v>
                </c:pt>
                <c:pt idx="10296">
                  <c:v>1726.27</c:v>
                </c:pt>
                <c:pt idx="10304">
                  <c:v>1251.94</c:v>
                </c:pt>
                <c:pt idx="10306">
                  <c:v>1907.93</c:v>
                </c:pt>
                <c:pt idx="10308">
                  <c:v>2362.39</c:v>
                </c:pt>
                <c:pt idx="10311">
                  <c:v>1388.88</c:v>
                </c:pt>
                <c:pt idx="10312">
                  <c:v>1443.53</c:v>
                </c:pt>
                <c:pt idx="10313">
                  <c:v>1943.78</c:v>
                </c:pt>
                <c:pt idx="10317">
                  <c:v>2657.66</c:v>
                </c:pt>
                <c:pt idx="10318">
                  <c:v>2210.98</c:v>
                </c:pt>
                <c:pt idx="10321">
                  <c:v>2788.78</c:v>
                </c:pt>
                <c:pt idx="10322">
                  <c:v>1537.06</c:v>
                </c:pt>
                <c:pt idx="10323">
                  <c:v>1465.99</c:v>
                </c:pt>
                <c:pt idx="10333">
                  <c:v>1036.1500000000001</c:v>
                </c:pt>
                <c:pt idx="10340">
                  <c:v>1892.59</c:v>
                </c:pt>
                <c:pt idx="10345">
                  <c:v>2342.09</c:v>
                </c:pt>
                <c:pt idx="10358">
                  <c:v>2476.0100000000002</c:v>
                </c:pt>
                <c:pt idx="10361">
                  <c:v>1948.54</c:v>
                </c:pt>
                <c:pt idx="10363">
                  <c:v>973.72799999999995</c:v>
                </c:pt>
                <c:pt idx="10369">
                  <c:v>1608.55</c:v>
                </c:pt>
                <c:pt idx="10371">
                  <c:v>1876.18</c:v>
                </c:pt>
                <c:pt idx="10372">
                  <c:v>1552.18</c:v>
                </c:pt>
                <c:pt idx="10378">
                  <c:v>2222.64</c:v>
                </c:pt>
                <c:pt idx="10381">
                  <c:v>1250.8599999999999</c:v>
                </c:pt>
                <c:pt idx="10386">
                  <c:v>1945.3</c:v>
                </c:pt>
                <c:pt idx="10387">
                  <c:v>1516.75</c:v>
                </c:pt>
                <c:pt idx="10391">
                  <c:v>2537.14</c:v>
                </c:pt>
                <c:pt idx="10397">
                  <c:v>1676.81</c:v>
                </c:pt>
                <c:pt idx="10398">
                  <c:v>1345.46</c:v>
                </c:pt>
                <c:pt idx="10406">
                  <c:v>1616.33</c:v>
                </c:pt>
                <c:pt idx="10415">
                  <c:v>1280.6600000000001</c:v>
                </c:pt>
                <c:pt idx="10421">
                  <c:v>1244.3800000000001</c:v>
                </c:pt>
                <c:pt idx="10427">
                  <c:v>1775.74</c:v>
                </c:pt>
                <c:pt idx="10429">
                  <c:v>2471.4699999999998</c:v>
                </c:pt>
                <c:pt idx="10432">
                  <c:v>1578.96</c:v>
                </c:pt>
                <c:pt idx="10435">
                  <c:v>2187.4299999999998</c:v>
                </c:pt>
                <c:pt idx="10436">
                  <c:v>2320.06</c:v>
                </c:pt>
                <c:pt idx="10449">
                  <c:v>1532.74</c:v>
                </c:pt>
                <c:pt idx="10464">
                  <c:v>1103.33</c:v>
                </c:pt>
                <c:pt idx="10466">
                  <c:v>1223.21</c:v>
                </c:pt>
                <c:pt idx="10467">
                  <c:v>1895.18</c:v>
                </c:pt>
                <c:pt idx="10469">
                  <c:v>1533.17</c:v>
                </c:pt>
                <c:pt idx="10470">
                  <c:v>1318.46</c:v>
                </c:pt>
                <c:pt idx="10476">
                  <c:v>1595.38</c:v>
                </c:pt>
                <c:pt idx="10478">
                  <c:v>1580.69</c:v>
                </c:pt>
                <c:pt idx="10479">
                  <c:v>1177.42</c:v>
                </c:pt>
                <c:pt idx="10480">
                  <c:v>2081.59</c:v>
                </c:pt>
                <c:pt idx="10484">
                  <c:v>1390.39</c:v>
                </c:pt>
                <c:pt idx="10497">
                  <c:v>1802.52</c:v>
                </c:pt>
                <c:pt idx="10500">
                  <c:v>1395.14</c:v>
                </c:pt>
                <c:pt idx="10502">
                  <c:v>1827.36</c:v>
                </c:pt>
                <c:pt idx="10506">
                  <c:v>902.88</c:v>
                </c:pt>
                <c:pt idx="10507">
                  <c:v>2733.26</c:v>
                </c:pt>
                <c:pt idx="10514">
                  <c:v>1985.47</c:v>
                </c:pt>
                <c:pt idx="10518">
                  <c:v>2124.36</c:v>
                </c:pt>
                <c:pt idx="10520">
                  <c:v>1189.08</c:v>
                </c:pt>
                <c:pt idx="10525">
                  <c:v>1011.96</c:v>
                </c:pt>
                <c:pt idx="10528">
                  <c:v>2121.34</c:v>
                </c:pt>
                <c:pt idx="10529">
                  <c:v>1748.74</c:v>
                </c:pt>
                <c:pt idx="10530">
                  <c:v>2241.86</c:v>
                </c:pt>
                <c:pt idx="10531">
                  <c:v>1248.7</c:v>
                </c:pt>
                <c:pt idx="10537">
                  <c:v>1435.1</c:v>
                </c:pt>
                <c:pt idx="10542">
                  <c:v>2031.05</c:v>
                </c:pt>
                <c:pt idx="10544">
                  <c:v>1869.91</c:v>
                </c:pt>
                <c:pt idx="10547">
                  <c:v>1497.96</c:v>
                </c:pt>
                <c:pt idx="10548">
                  <c:v>2483.35</c:v>
                </c:pt>
                <c:pt idx="10549">
                  <c:v>1338.55</c:v>
                </c:pt>
                <c:pt idx="10557">
                  <c:v>947.80799999999999</c:v>
                </c:pt>
                <c:pt idx="10561">
                  <c:v>1569.67</c:v>
                </c:pt>
                <c:pt idx="10563">
                  <c:v>2814.26</c:v>
                </c:pt>
                <c:pt idx="10564">
                  <c:v>2570.62</c:v>
                </c:pt>
                <c:pt idx="10566">
                  <c:v>1553.9</c:v>
                </c:pt>
                <c:pt idx="10569">
                  <c:v>2080.08</c:v>
                </c:pt>
                <c:pt idx="10572">
                  <c:v>1456.49</c:v>
                </c:pt>
                <c:pt idx="10575">
                  <c:v>1684.58</c:v>
                </c:pt>
                <c:pt idx="10585">
                  <c:v>2007.94</c:v>
                </c:pt>
                <c:pt idx="10592">
                  <c:v>1418.04</c:v>
                </c:pt>
                <c:pt idx="10593">
                  <c:v>2156.33</c:v>
                </c:pt>
                <c:pt idx="10604">
                  <c:v>2180.7399999999998</c:v>
                </c:pt>
                <c:pt idx="10608">
                  <c:v>1685.23</c:v>
                </c:pt>
                <c:pt idx="10614">
                  <c:v>2339.9299999999998</c:v>
                </c:pt>
                <c:pt idx="10615">
                  <c:v>1563.19</c:v>
                </c:pt>
                <c:pt idx="10616">
                  <c:v>2854.66</c:v>
                </c:pt>
                <c:pt idx="10617">
                  <c:v>1375.49</c:v>
                </c:pt>
                <c:pt idx="10618">
                  <c:v>1508.11</c:v>
                </c:pt>
                <c:pt idx="10619">
                  <c:v>1595.81</c:v>
                </c:pt>
                <c:pt idx="10623">
                  <c:v>2574.94</c:v>
                </c:pt>
                <c:pt idx="10630">
                  <c:v>1017.14</c:v>
                </c:pt>
                <c:pt idx="10634">
                  <c:v>1465.13</c:v>
                </c:pt>
                <c:pt idx="10635">
                  <c:v>2134.08</c:v>
                </c:pt>
                <c:pt idx="10637">
                  <c:v>1919.59</c:v>
                </c:pt>
                <c:pt idx="10644">
                  <c:v>1328.83</c:v>
                </c:pt>
                <c:pt idx="10645">
                  <c:v>2017.87</c:v>
                </c:pt>
                <c:pt idx="10652">
                  <c:v>1133.1400000000001</c:v>
                </c:pt>
                <c:pt idx="10654">
                  <c:v>2158.06</c:v>
                </c:pt>
                <c:pt idx="10655">
                  <c:v>2941.27</c:v>
                </c:pt>
                <c:pt idx="10658">
                  <c:v>1202.26</c:v>
                </c:pt>
                <c:pt idx="10671">
                  <c:v>1915.49</c:v>
                </c:pt>
                <c:pt idx="10675">
                  <c:v>800.71199999999999</c:v>
                </c:pt>
                <c:pt idx="10676">
                  <c:v>3040.85</c:v>
                </c:pt>
                <c:pt idx="10688">
                  <c:v>874.15200000000004</c:v>
                </c:pt>
                <c:pt idx="10690">
                  <c:v>1304.6400000000001</c:v>
                </c:pt>
                <c:pt idx="10694">
                  <c:v>2625.48</c:v>
                </c:pt>
                <c:pt idx="10695">
                  <c:v>1593.43</c:v>
                </c:pt>
                <c:pt idx="10699">
                  <c:v>1868.83</c:v>
                </c:pt>
                <c:pt idx="10700">
                  <c:v>1794.53</c:v>
                </c:pt>
                <c:pt idx="10701">
                  <c:v>1513.08</c:v>
                </c:pt>
                <c:pt idx="10705">
                  <c:v>1896.05</c:v>
                </c:pt>
                <c:pt idx="10707">
                  <c:v>1037.23</c:v>
                </c:pt>
                <c:pt idx="10708">
                  <c:v>1755.86</c:v>
                </c:pt>
                <c:pt idx="10710">
                  <c:v>2381.62</c:v>
                </c:pt>
                <c:pt idx="10712">
                  <c:v>2038.61</c:v>
                </c:pt>
                <c:pt idx="10713">
                  <c:v>1073.52</c:v>
                </c:pt>
                <c:pt idx="10717">
                  <c:v>2594.38</c:v>
                </c:pt>
                <c:pt idx="10721">
                  <c:v>1485.22</c:v>
                </c:pt>
                <c:pt idx="10728">
                  <c:v>2218.75</c:v>
                </c:pt>
                <c:pt idx="10730">
                  <c:v>1610.28</c:v>
                </c:pt>
                <c:pt idx="10740">
                  <c:v>2383.13</c:v>
                </c:pt>
                <c:pt idx="10741">
                  <c:v>1844.64</c:v>
                </c:pt>
                <c:pt idx="10748">
                  <c:v>1373.54</c:v>
                </c:pt>
                <c:pt idx="10749">
                  <c:v>1524.74</c:v>
                </c:pt>
                <c:pt idx="10752">
                  <c:v>1478.3</c:v>
                </c:pt>
                <c:pt idx="10753">
                  <c:v>1279.1500000000001</c:v>
                </c:pt>
                <c:pt idx="10762">
                  <c:v>1521.5</c:v>
                </c:pt>
                <c:pt idx="10763">
                  <c:v>2107.3000000000002</c:v>
                </c:pt>
                <c:pt idx="10764">
                  <c:v>1092.53</c:v>
                </c:pt>
                <c:pt idx="10768">
                  <c:v>2486.59</c:v>
                </c:pt>
                <c:pt idx="10771">
                  <c:v>1414.8</c:v>
                </c:pt>
                <c:pt idx="10774">
                  <c:v>1351.51</c:v>
                </c:pt>
                <c:pt idx="10789">
                  <c:v>1621.08</c:v>
                </c:pt>
                <c:pt idx="10800">
                  <c:v>2106.65</c:v>
                </c:pt>
                <c:pt idx="10805">
                  <c:v>1595.59</c:v>
                </c:pt>
                <c:pt idx="10808">
                  <c:v>1902.1</c:v>
                </c:pt>
                <c:pt idx="10825">
                  <c:v>2866.54</c:v>
                </c:pt>
                <c:pt idx="10827">
                  <c:v>2141.21</c:v>
                </c:pt>
                <c:pt idx="10830">
                  <c:v>2687.69</c:v>
                </c:pt>
                <c:pt idx="10835">
                  <c:v>2879.06</c:v>
                </c:pt>
                <c:pt idx="10840">
                  <c:v>1240.06</c:v>
                </c:pt>
                <c:pt idx="10841">
                  <c:v>1189.73</c:v>
                </c:pt>
                <c:pt idx="10843">
                  <c:v>2306.4499999999998</c:v>
                </c:pt>
                <c:pt idx="10850">
                  <c:v>1772.93</c:v>
                </c:pt>
                <c:pt idx="10853">
                  <c:v>1716.55</c:v>
                </c:pt>
                <c:pt idx="10856">
                  <c:v>1788.26</c:v>
                </c:pt>
                <c:pt idx="10857">
                  <c:v>1373.76</c:v>
                </c:pt>
                <c:pt idx="10859">
                  <c:v>2220.48</c:v>
                </c:pt>
                <c:pt idx="10864">
                  <c:v>890.35199999999998</c:v>
                </c:pt>
                <c:pt idx="10884">
                  <c:v>1467.72</c:v>
                </c:pt>
                <c:pt idx="10888">
                  <c:v>1218.02</c:v>
                </c:pt>
                <c:pt idx="10895">
                  <c:v>1390.82</c:v>
                </c:pt>
                <c:pt idx="10897">
                  <c:v>3249.5</c:v>
                </c:pt>
                <c:pt idx="10898">
                  <c:v>3123.36</c:v>
                </c:pt>
                <c:pt idx="10899">
                  <c:v>1713.96</c:v>
                </c:pt>
                <c:pt idx="10900">
                  <c:v>2379.46</c:v>
                </c:pt>
                <c:pt idx="10901">
                  <c:v>1461.67</c:v>
                </c:pt>
                <c:pt idx="10902">
                  <c:v>2364.77</c:v>
                </c:pt>
                <c:pt idx="10905">
                  <c:v>1286.71</c:v>
                </c:pt>
                <c:pt idx="10910">
                  <c:v>2397.8200000000002</c:v>
                </c:pt>
                <c:pt idx="10918">
                  <c:v>1440.94</c:v>
                </c:pt>
                <c:pt idx="10923">
                  <c:v>1589.98</c:v>
                </c:pt>
                <c:pt idx="10924">
                  <c:v>2510.7800000000002</c:v>
                </c:pt>
                <c:pt idx="10925">
                  <c:v>2589.62</c:v>
                </c:pt>
                <c:pt idx="10933">
                  <c:v>1540.73</c:v>
                </c:pt>
                <c:pt idx="10934">
                  <c:v>2116.8000000000002</c:v>
                </c:pt>
                <c:pt idx="10937">
                  <c:v>1740.31</c:v>
                </c:pt>
                <c:pt idx="10940">
                  <c:v>2587.6799999999998</c:v>
                </c:pt>
                <c:pt idx="10941">
                  <c:v>4010.69</c:v>
                </c:pt>
                <c:pt idx="10942">
                  <c:v>1872.5</c:v>
                </c:pt>
                <c:pt idx="10944">
                  <c:v>2585.9499999999998</c:v>
                </c:pt>
                <c:pt idx="10945">
                  <c:v>2029.54</c:v>
                </c:pt>
                <c:pt idx="10949">
                  <c:v>1995.62</c:v>
                </c:pt>
                <c:pt idx="10962">
                  <c:v>898.99199999999996</c:v>
                </c:pt>
                <c:pt idx="10966">
                  <c:v>1846.37</c:v>
                </c:pt>
                <c:pt idx="10970">
                  <c:v>1619.14</c:v>
                </c:pt>
                <c:pt idx="10971">
                  <c:v>1578.74</c:v>
                </c:pt>
                <c:pt idx="10978">
                  <c:v>2535.84</c:v>
                </c:pt>
                <c:pt idx="10981">
                  <c:v>3187.08</c:v>
                </c:pt>
                <c:pt idx="10986">
                  <c:v>2433.67</c:v>
                </c:pt>
                <c:pt idx="10987">
                  <c:v>2366.2800000000002</c:v>
                </c:pt>
                <c:pt idx="10990">
                  <c:v>1934.71</c:v>
                </c:pt>
                <c:pt idx="10994">
                  <c:v>1775.09</c:v>
                </c:pt>
                <c:pt idx="10997">
                  <c:v>7608.82</c:v>
                </c:pt>
                <c:pt idx="11000">
                  <c:v>1757.81</c:v>
                </c:pt>
                <c:pt idx="11003">
                  <c:v>2746.44</c:v>
                </c:pt>
                <c:pt idx="11007">
                  <c:v>1454.33</c:v>
                </c:pt>
                <c:pt idx="11012">
                  <c:v>4653.5</c:v>
                </c:pt>
                <c:pt idx="11019">
                  <c:v>1958.26</c:v>
                </c:pt>
                <c:pt idx="11022">
                  <c:v>1035.5</c:v>
                </c:pt>
                <c:pt idx="11027">
                  <c:v>3222.29</c:v>
                </c:pt>
                <c:pt idx="11028">
                  <c:v>3087.5</c:v>
                </c:pt>
                <c:pt idx="11030">
                  <c:v>2885.76</c:v>
                </c:pt>
                <c:pt idx="11039">
                  <c:v>2350.08</c:v>
                </c:pt>
                <c:pt idx="11040">
                  <c:v>2142.7199999999998</c:v>
                </c:pt>
                <c:pt idx="11041">
                  <c:v>2921.62</c:v>
                </c:pt>
                <c:pt idx="11045">
                  <c:v>1344.38</c:v>
                </c:pt>
                <c:pt idx="11048">
                  <c:v>665.71199999999999</c:v>
                </c:pt>
                <c:pt idx="11051">
                  <c:v>3102.19</c:v>
                </c:pt>
                <c:pt idx="11052">
                  <c:v>1286.28</c:v>
                </c:pt>
                <c:pt idx="11059">
                  <c:v>1344.17</c:v>
                </c:pt>
                <c:pt idx="11067">
                  <c:v>1312.85</c:v>
                </c:pt>
                <c:pt idx="11069">
                  <c:v>1823.47</c:v>
                </c:pt>
                <c:pt idx="11070">
                  <c:v>1537.27</c:v>
                </c:pt>
                <c:pt idx="11072">
                  <c:v>505.65600000000001</c:v>
                </c:pt>
                <c:pt idx="11086">
                  <c:v>1046.0899999999999</c:v>
                </c:pt>
                <c:pt idx="11095">
                  <c:v>1520.21</c:v>
                </c:pt>
                <c:pt idx="11098">
                  <c:v>2167.13</c:v>
                </c:pt>
                <c:pt idx="11109">
                  <c:v>1629.94</c:v>
                </c:pt>
                <c:pt idx="11111">
                  <c:v>1623.02</c:v>
                </c:pt>
                <c:pt idx="11113">
                  <c:v>1720.01</c:v>
                </c:pt>
                <c:pt idx="11115">
                  <c:v>1682.42</c:v>
                </c:pt>
                <c:pt idx="11120">
                  <c:v>1862.78</c:v>
                </c:pt>
                <c:pt idx="11123">
                  <c:v>1785.02</c:v>
                </c:pt>
                <c:pt idx="11124">
                  <c:v>2219.1799999999998</c:v>
                </c:pt>
                <c:pt idx="11130">
                  <c:v>1408.32</c:v>
                </c:pt>
                <c:pt idx="11133">
                  <c:v>2487.02</c:v>
                </c:pt>
                <c:pt idx="11134">
                  <c:v>1683.94</c:v>
                </c:pt>
                <c:pt idx="11151">
                  <c:v>1783.3</c:v>
                </c:pt>
                <c:pt idx="11152">
                  <c:v>3082.1</c:v>
                </c:pt>
                <c:pt idx="11156">
                  <c:v>1031.18</c:v>
                </c:pt>
                <c:pt idx="11157">
                  <c:v>1108.73</c:v>
                </c:pt>
                <c:pt idx="11164">
                  <c:v>2008.58</c:v>
                </c:pt>
                <c:pt idx="11167">
                  <c:v>2067.98</c:v>
                </c:pt>
                <c:pt idx="11171">
                  <c:v>1600.99</c:v>
                </c:pt>
                <c:pt idx="11172">
                  <c:v>2349</c:v>
                </c:pt>
                <c:pt idx="11174">
                  <c:v>3729.89</c:v>
                </c:pt>
                <c:pt idx="11176">
                  <c:v>1671.62</c:v>
                </c:pt>
                <c:pt idx="11181">
                  <c:v>1929.31</c:v>
                </c:pt>
                <c:pt idx="11192">
                  <c:v>2152.0100000000002</c:v>
                </c:pt>
                <c:pt idx="11197">
                  <c:v>681.48</c:v>
                </c:pt>
                <c:pt idx="11200">
                  <c:v>1600.78</c:v>
                </c:pt>
                <c:pt idx="11201">
                  <c:v>2857.25</c:v>
                </c:pt>
                <c:pt idx="11203">
                  <c:v>1692.79</c:v>
                </c:pt>
                <c:pt idx="11205">
                  <c:v>2612.7399999999998</c:v>
                </c:pt>
                <c:pt idx="11206">
                  <c:v>1302.05</c:v>
                </c:pt>
                <c:pt idx="11208">
                  <c:v>1909.22</c:v>
                </c:pt>
                <c:pt idx="11209">
                  <c:v>2527.85</c:v>
                </c:pt>
                <c:pt idx="11210">
                  <c:v>2098.66</c:v>
                </c:pt>
                <c:pt idx="11212">
                  <c:v>2431.94</c:v>
                </c:pt>
                <c:pt idx="11213">
                  <c:v>1935.58</c:v>
                </c:pt>
                <c:pt idx="11223">
                  <c:v>2276.21</c:v>
                </c:pt>
                <c:pt idx="11230">
                  <c:v>1389.96</c:v>
                </c:pt>
                <c:pt idx="11237">
                  <c:v>2078.7800000000002</c:v>
                </c:pt>
                <c:pt idx="11240">
                  <c:v>1616.98</c:v>
                </c:pt>
                <c:pt idx="11243">
                  <c:v>2185.92</c:v>
                </c:pt>
                <c:pt idx="11244">
                  <c:v>2381.83</c:v>
                </c:pt>
                <c:pt idx="11247">
                  <c:v>1435.32</c:v>
                </c:pt>
                <c:pt idx="11253">
                  <c:v>2291.33</c:v>
                </c:pt>
                <c:pt idx="11256">
                  <c:v>1935.14</c:v>
                </c:pt>
                <c:pt idx="11257">
                  <c:v>1440.29</c:v>
                </c:pt>
                <c:pt idx="11258">
                  <c:v>1225.8</c:v>
                </c:pt>
                <c:pt idx="11263">
                  <c:v>2666.09</c:v>
                </c:pt>
                <c:pt idx="11274">
                  <c:v>2151.14</c:v>
                </c:pt>
                <c:pt idx="11278">
                  <c:v>1787.83</c:v>
                </c:pt>
                <c:pt idx="11280">
                  <c:v>1283.69</c:v>
                </c:pt>
                <c:pt idx="11282">
                  <c:v>1416.74</c:v>
                </c:pt>
                <c:pt idx="11284">
                  <c:v>1342.01</c:v>
                </c:pt>
                <c:pt idx="11289">
                  <c:v>2220.6999999999998</c:v>
                </c:pt>
                <c:pt idx="11294">
                  <c:v>1990.01</c:v>
                </c:pt>
                <c:pt idx="11298">
                  <c:v>2440.58</c:v>
                </c:pt>
                <c:pt idx="11303">
                  <c:v>1839.46</c:v>
                </c:pt>
                <c:pt idx="11317">
                  <c:v>1929.96</c:v>
                </c:pt>
                <c:pt idx="11321">
                  <c:v>2071.0100000000002</c:v>
                </c:pt>
                <c:pt idx="11330">
                  <c:v>2322.86</c:v>
                </c:pt>
                <c:pt idx="11331">
                  <c:v>1558.44</c:v>
                </c:pt>
                <c:pt idx="11332">
                  <c:v>1407.89</c:v>
                </c:pt>
                <c:pt idx="11333">
                  <c:v>2703.46</c:v>
                </c:pt>
                <c:pt idx="11334">
                  <c:v>1510.06</c:v>
                </c:pt>
                <c:pt idx="11344">
                  <c:v>1476.58</c:v>
                </c:pt>
                <c:pt idx="11348">
                  <c:v>3133.08</c:v>
                </c:pt>
                <c:pt idx="11349">
                  <c:v>3435.05</c:v>
                </c:pt>
                <c:pt idx="11357">
                  <c:v>858.81600000000003</c:v>
                </c:pt>
                <c:pt idx="11366">
                  <c:v>1683.72</c:v>
                </c:pt>
                <c:pt idx="11371">
                  <c:v>2057.83</c:v>
                </c:pt>
                <c:pt idx="11373">
                  <c:v>1524.96</c:v>
                </c:pt>
                <c:pt idx="11378">
                  <c:v>2047.03</c:v>
                </c:pt>
                <c:pt idx="11381">
                  <c:v>2283.98</c:v>
                </c:pt>
                <c:pt idx="11382">
                  <c:v>1997.35</c:v>
                </c:pt>
                <c:pt idx="11385">
                  <c:v>1374.62</c:v>
                </c:pt>
                <c:pt idx="11389">
                  <c:v>2057.1799999999998</c:v>
                </c:pt>
                <c:pt idx="11391">
                  <c:v>1797.77</c:v>
                </c:pt>
                <c:pt idx="11393">
                  <c:v>2819.23</c:v>
                </c:pt>
                <c:pt idx="11394">
                  <c:v>2127.6</c:v>
                </c:pt>
                <c:pt idx="11398">
                  <c:v>2533.6799999999998</c:v>
                </c:pt>
                <c:pt idx="11401">
                  <c:v>1157.76</c:v>
                </c:pt>
                <c:pt idx="11402">
                  <c:v>3615.41</c:v>
                </c:pt>
                <c:pt idx="11408">
                  <c:v>1583.5</c:v>
                </c:pt>
                <c:pt idx="11409">
                  <c:v>1560.6</c:v>
                </c:pt>
                <c:pt idx="11410">
                  <c:v>4582.22</c:v>
                </c:pt>
                <c:pt idx="11411">
                  <c:v>1851.12</c:v>
                </c:pt>
                <c:pt idx="11418">
                  <c:v>1893.24</c:v>
                </c:pt>
                <c:pt idx="11426">
                  <c:v>1798.42</c:v>
                </c:pt>
                <c:pt idx="11432">
                  <c:v>1307.8800000000001</c:v>
                </c:pt>
                <c:pt idx="11436">
                  <c:v>4036.61</c:v>
                </c:pt>
                <c:pt idx="11441">
                  <c:v>1594.73</c:v>
                </c:pt>
                <c:pt idx="11442">
                  <c:v>1189.51</c:v>
                </c:pt>
                <c:pt idx="11443">
                  <c:v>2643.41</c:v>
                </c:pt>
                <c:pt idx="11444">
                  <c:v>1649.81</c:v>
                </c:pt>
                <c:pt idx="11447">
                  <c:v>1939.9</c:v>
                </c:pt>
                <c:pt idx="11449">
                  <c:v>2437.56</c:v>
                </c:pt>
                <c:pt idx="11450">
                  <c:v>1835.14</c:v>
                </c:pt>
                <c:pt idx="11453">
                  <c:v>1630.37</c:v>
                </c:pt>
                <c:pt idx="11454">
                  <c:v>3151.22</c:v>
                </c:pt>
                <c:pt idx="11456">
                  <c:v>1226.6600000000001</c:v>
                </c:pt>
                <c:pt idx="11457">
                  <c:v>2182.9</c:v>
                </c:pt>
                <c:pt idx="11461">
                  <c:v>2615.98</c:v>
                </c:pt>
                <c:pt idx="11467">
                  <c:v>1942.06</c:v>
                </c:pt>
                <c:pt idx="11473">
                  <c:v>2645.14</c:v>
                </c:pt>
                <c:pt idx="11475">
                  <c:v>2239.27</c:v>
                </c:pt>
                <c:pt idx="11476">
                  <c:v>2417.69</c:v>
                </c:pt>
                <c:pt idx="11478">
                  <c:v>1904.04</c:v>
                </c:pt>
                <c:pt idx="11483">
                  <c:v>2644.49</c:v>
                </c:pt>
                <c:pt idx="11487">
                  <c:v>2163.2399999999998</c:v>
                </c:pt>
                <c:pt idx="11496">
                  <c:v>2674.08</c:v>
                </c:pt>
                <c:pt idx="11502">
                  <c:v>1722.17</c:v>
                </c:pt>
                <c:pt idx="11503">
                  <c:v>1621.3</c:v>
                </c:pt>
                <c:pt idx="11506">
                  <c:v>1909.66</c:v>
                </c:pt>
                <c:pt idx="11507">
                  <c:v>2464.13</c:v>
                </c:pt>
                <c:pt idx="11508">
                  <c:v>3013.63</c:v>
                </c:pt>
                <c:pt idx="11510">
                  <c:v>939.16800000000001</c:v>
                </c:pt>
                <c:pt idx="11512">
                  <c:v>1981.15</c:v>
                </c:pt>
                <c:pt idx="11517">
                  <c:v>1751.11</c:v>
                </c:pt>
                <c:pt idx="11523">
                  <c:v>2202.77</c:v>
                </c:pt>
                <c:pt idx="11536">
                  <c:v>1208.95</c:v>
                </c:pt>
                <c:pt idx="11538">
                  <c:v>851.47199999999998</c:v>
                </c:pt>
                <c:pt idx="11546">
                  <c:v>1566.43</c:v>
                </c:pt>
                <c:pt idx="11549">
                  <c:v>1078.7</c:v>
                </c:pt>
                <c:pt idx="11557">
                  <c:v>2417.69</c:v>
                </c:pt>
                <c:pt idx="11566">
                  <c:v>1861.49</c:v>
                </c:pt>
                <c:pt idx="11568">
                  <c:v>2251.8000000000002</c:v>
                </c:pt>
                <c:pt idx="11573">
                  <c:v>1580.69</c:v>
                </c:pt>
                <c:pt idx="11576">
                  <c:v>1669.03</c:v>
                </c:pt>
                <c:pt idx="11577">
                  <c:v>2364.34</c:v>
                </c:pt>
                <c:pt idx="11581">
                  <c:v>2753.35</c:v>
                </c:pt>
                <c:pt idx="11582">
                  <c:v>2095.85</c:v>
                </c:pt>
                <c:pt idx="11583">
                  <c:v>1393.2</c:v>
                </c:pt>
                <c:pt idx="11584">
                  <c:v>2440.37</c:v>
                </c:pt>
                <c:pt idx="11593">
                  <c:v>1645.7</c:v>
                </c:pt>
                <c:pt idx="11602">
                  <c:v>1526.69</c:v>
                </c:pt>
                <c:pt idx="11603">
                  <c:v>1578.1</c:v>
                </c:pt>
                <c:pt idx="11609">
                  <c:v>1331.64</c:v>
                </c:pt>
                <c:pt idx="11611">
                  <c:v>2130.19</c:v>
                </c:pt>
                <c:pt idx="11614">
                  <c:v>2057.62</c:v>
                </c:pt>
                <c:pt idx="11618">
                  <c:v>1653.91</c:v>
                </c:pt>
                <c:pt idx="11619">
                  <c:v>1260.58</c:v>
                </c:pt>
                <c:pt idx="11625">
                  <c:v>1658.45</c:v>
                </c:pt>
                <c:pt idx="11626">
                  <c:v>2222.42</c:v>
                </c:pt>
                <c:pt idx="11627">
                  <c:v>364.392</c:v>
                </c:pt>
                <c:pt idx="11629">
                  <c:v>1676.59</c:v>
                </c:pt>
                <c:pt idx="11635">
                  <c:v>2133.65</c:v>
                </c:pt>
                <c:pt idx="11636">
                  <c:v>2815.13</c:v>
                </c:pt>
                <c:pt idx="11638">
                  <c:v>2614.0300000000002</c:v>
                </c:pt>
                <c:pt idx="11641">
                  <c:v>304.56</c:v>
                </c:pt>
                <c:pt idx="11642">
                  <c:v>2328.2600000000002</c:v>
                </c:pt>
                <c:pt idx="11657">
                  <c:v>1731.46</c:v>
                </c:pt>
                <c:pt idx="11659">
                  <c:v>2726.57</c:v>
                </c:pt>
                <c:pt idx="11664">
                  <c:v>1741.39</c:v>
                </c:pt>
                <c:pt idx="11668">
                  <c:v>1789.78</c:v>
                </c:pt>
                <c:pt idx="11670">
                  <c:v>1788.05</c:v>
                </c:pt>
                <c:pt idx="11674">
                  <c:v>3277.8</c:v>
                </c:pt>
                <c:pt idx="11677">
                  <c:v>1440.29</c:v>
                </c:pt>
                <c:pt idx="11678">
                  <c:v>2046.38</c:v>
                </c:pt>
                <c:pt idx="11685">
                  <c:v>12840.6</c:v>
                </c:pt>
                <c:pt idx="11689">
                  <c:v>2738.88</c:v>
                </c:pt>
                <c:pt idx="11695">
                  <c:v>2260.0100000000002</c:v>
                </c:pt>
                <c:pt idx="11701">
                  <c:v>2624.18</c:v>
                </c:pt>
                <c:pt idx="11702">
                  <c:v>1577.02</c:v>
                </c:pt>
                <c:pt idx="11703">
                  <c:v>1662.12</c:v>
                </c:pt>
                <c:pt idx="11706">
                  <c:v>1199.6600000000001</c:v>
                </c:pt>
                <c:pt idx="11709">
                  <c:v>1928.02</c:v>
                </c:pt>
                <c:pt idx="11716">
                  <c:v>1287.3599999999999</c:v>
                </c:pt>
                <c:pt idx="11718">
                  <c:v>3589.7</c:v>
                </c:pt>
                <c:pt idx="11719">
                  <c:v>1944.43</c:v>
                </c:pt>
                <c:pt idx="11726">
                  <c:v>1504.44</c:v>
                </c:pt>
                <c:pt idx="11728">
                  <c:v>1087.99</c:v>
                </c:pt>
                <c:pt idx="11729">
                  <c:v>2629.15</c:v>
                </c:pt>
                <c:pt idx="11736">
                  <c:v>3972.24</c:v>
                </c:pt>
                <c:pt idx="11739">
                  <c:v>2128.0300000000002</c:v>
                </c:pt>
                <c:pt idx="11744">
                  <c:v>2584.87</c:v>
                </c:pt>
                <c:pt idx="11747">
                  <c:v>1545.7</c:v>
                </c:pt>
                <c:pt idx="11751">
                  <c:v>3068.93</c:v>
                </c:pt>
                <c:pt idx="11752">
                  <c:v>2368.44</c:v>
                </c:pt>
                <c:pt idx="11759">
                  <c:v>2879.5</c:v>
                </c:pt>
                <c:pt idx="11761">
                  <c:v>2728.51</c:v>
                </c:pt>
                <c:pt idx="11762">
                  <c:v>2912.98</c:v>
                </c:pt>
                <c:pt idx="11765">
                  <c:v>2337.12</c:v>
                </c:pt>
                <c:pt idx="11768">
                  <c:v>2852.28</c:v>
                </c:pt>
                <c:pt idx="11771">
                  <c:v>1593.86</c:v>
                </c:pt>
                <c:pt idx="11772">
                  <c:v>1275.48</c:v>
                </c:pt>
                <c:pt idx="11777">
                  <c:v>2350.5100000000002</c:v>
                </c:pt>
                <c:pt idx="11778">
                  <c:v>1117.1500000000001</c:v>
                </c:pt>
                <c:pt idx="11789">
                  <c:v>2095.42</c:v>
                </c:pt>
                <c:pt idx="11791">
                  <c:v>2536.6999999999998</c:v>
                </c:pt>
                <c:pt idx="11795">
                  <c:v>1974.89</c:v>
                </c:pt>
                <c:pt idx="11800">
                  <c:v>1873.8</c:v>
                </c:pt>
                <c:pt idx="11802">
                  <c:v>1149.55</c:v>
                </c:pt>
                <c:pt idx="11803">
                  <c:v>3854.3</c:v>
                </c:pt>
                <c:pt idx="11811">
                  <c:v>2190.02</c:v>
                </c:pt>
                <c:pt idx="11812">
                  <c:v>1680.91</c:v>
                </c:pt>
                <c:pt idx="11818">
                  <c:v>2113.56</c:v>
                </c:pt>
                <c:pt idx="11819">
                  <c:v>3525.55</c:v>
                </c:pt>
                <c:pt idx="11823">
                  <c:v>1840.75</c:v>
                </c:pt>
                <c:pt idx="11824">
                  <c:v>3222.07</c:v>
                </c:pt>
                <c:pt idx="11825">
                  <c:v>1226.8800000000001</c:v>
                </c:pt>
                <c:pt idx="11835">
                  <c:v>2393.71</c:v>
                </c:pt>
                <c:pt idx="11836">
                  <c:v>1316.09</c:v>
                </c:pt>
                <c:pt idx="11838">
                  <c:v>4307.47</c:v>
                </c:pt>
                <c:pt idx="11839">
                  <c:v>2767.39</c:v>
                </c:pt>
                <c:pt idx="11840">
                  <c:v>1937.52</c:v>
                </c:pt>
                <c:pt idx="11841">
                  <c:v>2195.86</c:v>
                </c:pt>
                <c:pt idx="11844">
                  <c:v>1575.72</c:v>
                </c:pt>
                <c:pt idx="11855">
                  <c:v>2884.68</c:v>
                </c:pt>
                <c:pt idx="11857">
                  <c:v>3727.08</c:v>
                </c:pt>
                <c:pt idx="11869">
                  <c:v>1957.39</c:v>
                </c:pt>
                <c:pt idx="11884">
                  <c:v>1401.41</c:v>
                </c:pt>
                <c:pt idx="11885">
                  <c:v>2333.23</c:v>
                </c:pt>
                <c:pt idx="11888">
                  <c:v>1510.06</c:v>
                </c:pt>
                <c:pt idx="11899">
                  <c:v>1988.71</c:v>
                </c:pt>
                <c:pt idx="11900">
                  <c:v>2821.61</c:v>
                </c:pt>
                <c:pt idx="11901">
                  <c:v>2321.35</c:v>
                </c:pt>
                <c:pt idx="11903">
                  <c:v>2958.98</c:v>
                </c:pt>
                <c:pt idx="11906">
                  <c:v>2376.86</c:v>
                </c:pt>
                <c:pt idx="11907">
                  <c:v>1046.95</c:v>
                </c:pt>
                <c:pt idx="11914">
                  <c:v>2306.88</c:v>
                </c:pt>
                <c:pt idx="11916">
                  <c:v>2049.62</c:v>
                </c:pt>
                <c:pt idx="11919">
                  <c:v>1373.11</c:v>
                </c:pt>
                <c:pt idx="11921">
                  <c:v>1076.98</c:v>
                </c:pt>
                <c:pt idx="11924">
                  <c:v>2301.0500000000002</c:v>
                </c:pt>
                <c:pt idx="11927">
                  <c:v>1320.41</c:v>
                </c:pt>
                <c:pt idx="11929">
                  <c:v>2529.36</c:v>
                </c:pt>
                <c:pt idx="11932">
                  <c:v>1173.74</c:v>
                </c:pt>
                <c:pt idx="11933">
                  <c:v>1416.74</c:v>
                </c:pt>
                <c:pt idx="11938">
                  <c:v>2274.0500000000002</c:v>
                </c:pt>
                <c:pt idx="11942">
                  <c:v>1435.54</c:v>
                </c:pt>
                <c:pt idx="11944">
                  <c:v>1470.96</c:v>
                </c:pt>
                <c:pt idx="11947">
                  <c:v>3105.43</c:v>
                </c:pt>
                <c:pt idx="11948">
                  <c:v>2038.18</c:v>
                </c:pt>
                <c:pt idx="11950">
                  <c:v>1926.94</c:v>
                </c:pt>
                <c:pt idx="11952">
                  <c:v>518.4</c:v>
                </c:pt>
                <c:pt idx="11954">
                  <c:v>2172.31</c:v>
                </c:pt>
                <c:pt idx="11956">
                  <c:v>1926.94</c:v>
                </c:pt>
                <c:pt idx="11961">
                  <c:v>2474.06</c:v>
                </c:pt>
                <c:pt idx="11963">
                  <c:v>1563.19</c:v>
                </c:pt>
                <c:pt idx="11971">
                  <c:v>2687.69</c:v>
                </c:pt>
                <c:pt idx="11976">
                  <c:v>1849.61</c:v>
                </c:pt>
                <c:pt idx="11985">
                  <c:v>3589.92</c:v>
                </c:pt>
                <c:pt idx="11990">
                  <c:v>2264.7600000000002</c:v>
                </c:pt>
                <c:pt idx="11997">
                  <c:v>2015.5</c:v>
                </c:pt>
                <c:pt idx="11998">
                  <c:v>3302.86</c:v>
                </c:pt>
                <c:pt idx="12000">
                  <c:v>1389.1</c:v>
                </c:pt>
                <c:pt idx="12002">
                  <c:v>1555.2</c:v>
                </c:pt>
                <c:pt idx="12003">
                  <c:v>1990.01</c:v>
                </c:pt>
                <c:pt idx="12012">
                  <c:v>3362.69</c:v>
                </c:pt>
                <c:pt idx="12017">
                  <c:v>1986.12</c:v>
                </c:pt>
                <c:pt idx="12023">
                  <c:v>1655.86</c:v>
                </c:pt>
                <c:pt idx="12024">
                  <c:v>1518.05</c:v>
                </c:pt>
                <c:pt idx="12026">
                  <c:v>2945.38</c:v>
                </c:pt>
                <c:pt idx="12028">
                  <c:v>1148.9000000000001</c:v>
                </c:pt>
                <c:pt idx="12034">
                  <c:v>3249.29</c:v>
                </c:pt>
                <c:pt idx="12037">
                  <c:v>1612.01</c:v>
                </c:pt>
                <c:pt idx="12041">
                  <c:v>2735.42</c:v>
                </c:pt>
                <c:pt idx="12043">
                  <c:v>2378.59</c:v>
                </c:pt>
                <c:pt idx="12048">
                  <c:v>2547.0700000000002</c:v>
                </c:pt>
                <c:pt idx="12049">
                  <c:v>2704.54</c:v>
                </c:pt>
                <c:pt idx="12050">
                  <c:v>2237.33</c:v>
                </c:pt>
                <c:pt idx="12055">
                  <c:v>2686.82</c:v>
                </c:pt>
                <c:pt idx="12057">
                  <c:v>2017.22</c:v>
                </c:pt>
                <c:pt idx="12062">
                  <c:v>2025</c:v>
                </c:pt>
                <c:pt idx="12069">
                  <c:v>2170.58</c:v>
                </c:pt>
                <c:pt idx="12070">
                  <c:v>1705.1</c:v>
                </c:pt>
                <c:pt idx="12071">
                  <c:v>2746.01</c:v>
                </c:pt>
                <c:pt idx="12081">
                  <c:v>1809.22</c:v>
                </c:pt>
                <c:pt idx="12082">
                  <c:v>1570.75</c:v>
                </c:pt>
                <c:pt idx="12087">
                  <c:v>2113.13</c:v>
                </c:pt>
                <c:pt idx="12092">
                  <c:v>1412.21</c:v>
                </c:pt>
                <c:pt idx="12094">
                  <c:v>1524.53</c:v>
                </c:pt>
                <c:pt idx="12095">
                  <c:v>1827.36</c:v>
                </c:pt>
                <c:pt idx="12098">
                  <c:v>1396.22</c:v>
                </c:pt>
                <c:pt idx="12101">
                  <c:v>751.89599999999996</c:v>
                </c:pt>
                <c:pt idx="12105">
                  <c:v>1503.79</c:v>
                </c:pt>
                <c:pt idx="12106">
                  <c:v>2445.5500000000002</c:v>
                </c:pt>
                <c:pt idx="12112">
                  <c:v>2190.89</c:v>
                </c:pt>
                <c:pt idx="12119">
                  <c:v>2523.5300000000002</c:v>
                </c:pt>
                <c:pt idx="12120">
                  <c:v>2321.7800000000002</c:v>
                </c:pt>
                <c:pt idx="12126">
                  <c:v>2123.5</c:v>
                </c:pt>
                <c:pt idx="12128">
                  <c:v>1776.38</c:v>
                </c:pt>
                <c:pt idx="12135">
                  <c:v>2148.12</c:v>
                </c:pt>
                <c:pt idx="12138">
                  <c:v>1982.66</c:v>
                </c:pt>
                <c:pt idx="12139">
                  <c:v>2503.44</c:v>
                </c:pt>
                <c:pt idx="12145">
                  <c:v>2608.1999999999998</c:v>
                </c:pt>
                <c:pt idx="12149">
                  <c:v>2689.85</c:v>
                </c:pt>
                <c:pt idx="12150">
                  <c:v>1720.22</c:v>
                </c:pt>
                <c:pt idx="12157">
                  <c:v>1304.6400000000001</c:v>
                </c:pt>
                <c:pt idx="12158">
                  <c:v>2222.86</c:v>
                </c:pt>
                <c:pt idx="12159">
                  <c:v>1950.48</c:v>
                </c:pt>
                <c:pt idx="12170">
                  <c:v>1299.02</c:v>
                </c:pt>
                <c:pt idx="12171">
                  <c:v>1418.69</c:v>
                </c:pt>
                <c:pt idx="12175">
                  <c:v>1805.76</c:v>
                </c:pt>
                <c:pt idx="12177">
                  <c:v>2458.5100000000002</c:v>
                </c:pt>
                <c:pt idx="12180">
                  <c:v>1635.77</c:v>
                </c:pt>
                <c:pt idx="12185">
                  <c:v>2498.2600000000002</c:v>
                </c:pt>
                <c:pt idx="12189">
                  <c:v>1593.43</c:v>
                </c:pt>
                <c:pt idx="12191">
                  <c:v>949.32</c:v>
                </c:pt>
                <c:pt idx="12201">
                  <c:v>2156.11</c:v>
                </c:pt>
                <c:pt idx="12204">
                  <c:v>2893.32</c:v>
                </c:pt>
                <c:pt idx="12206">
                  <c:v>1746.79</c:v>
                </c:pt>
                <c:pt idx="12209">
                  <c:v>3027.24</c:v>
                </c:pt>
                <c:pt idx="12210">
                  <c:v>1913.76</c:v>
                </c:pt>
                <c:pt idx="12211">
                  <c:v>3130.27</c:v>
                </c:pt>
                <c:pt idx="12217">
                  <c:v>2800.01</c:v>
                </c:pt>
                <c:pt idx="12226">
                  <c:v>2133.2199999999998</c:v>
                </c:pt>
                <c:pt idx="12231">
                  <c:v>2908.44</c:v>
                </c:pt>
                <c:pt idx="12233">
                  <c:v>2499.34</c:v>
                </c:pt>
                <c:pt idx="12237">
                  <c:v>2129.98</c:v>
                </c:pt>
                <c:pt idx="12245">
                  <c:v>2445.34</c:v>
                </c:pt>
                <c:pt idx="12249">
                  <c:v>2248.56</c:v>
                </c:pt>
                <c:pt idx="12252">
                  <c:v>2111.83</c:v>
                </c:pt>
                <c:pt idx="12253">
                  <c:v>391.82400000000001</c:v>
                </c:pt>
                <c:pt idx="12256">
                  <c:v>1096.42</c:v>
                </c:pt>
                <c:pt idx="12257">
                  <c:v>1691.5</c:v>
                </c:pt>
                <c:pt idx="12261">
                  <c:v>1944.86</c:v>
                </c:pt>
                <c:pt idx="12262">
                  <c:v>5663.74</c:v>
                </c:pt>
                <c:pt idx="12263">
                  <c:v>1506.6</c:v>
                </c:pt>
                <c:pt idx="12264">
                  <c:v>1861.27</c:v>
                </c:pt>
                <c:pt idx="12266">
                  <c:v>1761.7</c:v>
                </c:pt>
                <c:pt idx="12268">
                  <c:v>3172.82</c:v>
                </c:pt>
                <c:pt idx="12274">
                  <c:v>1455.84</c:v>
                </c:pt>
                <c:pt idx="12277">
                  <c:v>825.33600000000001</c:v>
                </c:pt>
                <c:pt idx="12283">
                  <c:v>1363.61</c:v>
                </c:pt>
                <c:pt idx="12293">
                  <c:v>2186.14</c:v>
                </c:pt>
                <c:pt idx="12295">
                  <c:v>3070.22</c:v>
                </c:pt>
                <c:pt idx="12296">
                  <c:v>2032.34</c:v>
                </c:pt>
                <c:pt idx="12298">
                  <c:v>2546.86</c:v>
                </c:pt>
                <c:pt idx="12299">
                  <c:v>2117.02</c:v>
                </c:pt>
                <c:pt idx="12300">
                  <c:v>1909.01</c:v>
                </c:pt>
                <c:pt idx="12303">
                  <c:v>1651.97</c:v>
                </c:pt>
                <c:pt idx="12308">
                  <c:v>2048.7600000000002</c:v>
                </c:pt>
                <c:pt idx="12309">
                  <c:v>3408.7</c:v>
                </c:pt>
                <c:pt idx="12314">
                  <c:v>2794.18</c:v>
                </c:pt>
                <c:pt idx="12319">
                  <c:v>3815.64</c:v>
                </c:pt>
                <c:pt idx="12321">
                  <c:v>2408.62</c:v>
                </c:pt>
                <c:pt idx="12324">
                  <c:v>2131.92</c:v>
                </c:pt>
                <c:pt idx="12326">
                  <c:v>2080.94</c:v>
                </c:pt>
                <c:pt idx="12329">
                  <c:v>1260.3599999999999</c:v>
                </c:pt>
                <c:pt idx="12335">
                  <c:v>2144.23</c:v>
                </c:pt>
                <c:pt idx="12336">
                  <c:v>1803.38</c:v>
                </c:pt>
                <c:pt idx="12338">
                  <c:v>2184.84</c:v>
                </c:pt>
                <c:pt idx="12339">
                  <c:v>3020.11</c:v>
                </c:pt>
                <c:pt idx="12344">
                  <c:v>2169.0700000000002</c:v>
                </c:pt>
                <c:pt idx="12345">
                  <c:v>1381.1</c:v>
                </c:pt>
                <c:pt idx="12346">
                  <c:v>1734.48</c:v>
                </c:pt>
                <c:pt idx="12348">
                  <c:v>3476.09</c:v>
                </c:pt>
                <c:pt idx="12349">
                  <c:v>2263.9</c:v>
                </c:pt>
                <c:pt idx="12351">
                  <c:v>1369.01</c:v>
                </c:pt>
                <c:pt idx="12355">
                  <c:v>1774.66</c:v>
                </c:pt>
                <c:pt idx="12356">
                  <c:v>4204.01</c:v>
                </c:pt>
                <c:pt idx="12357">
                  <c:v>1877.69</c:v>
                </c:pt>
                <c:pt idx="12363">
                  <c:v>3290.76</c:v>
                </c:pt>
                <c:pt idx="12366">
                  <c:v>2053.08</c:v>
                </c:pt>
                <c:pt idx="12368">
                  <c:v>3229.63</c:v>
                </c:pt>
                <c:pt idx="12372">
                  <c:v>3065.26</c:v>
                </c:pt>
                <c:pt idx="12376">
                  <c:v>2636.5</c:v>
                </c:pt>
                <c:pt idx="12377">
                  <c:v>1905.77</c:v>
                </c:pt>
                <c:pt idx="12380">
                  <c:v>2636.06</c:v>
                </c:pt>
                <c:pt idx="12385">
                  <c:v>1609.63</c:v>
                </c:pt>
                <c:pt idx="12387">
                  <c:v>2325.2399999999998</c:v>
                </c:pt>
                <c:pt idx="12388">
                  <c:v>1721.74</c:v>
                </c:pt>
                <c:pt idx="12398">
                  <c:v>1572.48</c:v>
                </c:pt>
                <c:pt idx="12409">
                  <c:v>2506.46</c:v>
                </c:pt>
                <c:pt idx="12413">
                  <c:v>1698.41</c:v>
                </c:pt>
                <c:pt idx="12419">
                  <c:v>1645.92</c:v>
                </c:pt>
                <c:pt idx="12420">
                  <c:v>2481.62</c:v>
                </c:pt>
                <c:pt idx="12424">
                  <c:v>1829.09</c:v>
                </c:pt>
                <c:pt idx="12427">
                  <c:v>2174.69</c:v>
                </c:pt>
                <c:pt idx="12431">
                  <c:v>2611.0100000000002</c:v>
                </c:pt>
                <c:pt idx="12436">
                  <c:v>1608.98</c:v>
                </c:pt>
                <c:pt idx="12438">
                  <c:v>977.61599999999999</c:v>
                </c:pt>
                <c:pt idx="12442">
                  <c:v>1540.3</c:v>
                </c:pt>
                <c:pt idx="12445">
                  <c:v>1745.93</c:v>
                </c:pt>
                <c:pt idx="12460">
                  <c:v>3268.73</c:v>
                </c:pt>
                <c:pt idx="12465">
                  <c:v>2869.34</c:v>
                </c:pt>
                <c:pt idx="12468">
                  <c:v>1801.87</c:v>
                </c:pt>
                <c:pt idx="12471">
                  <c:v>3177.79</c:v>
                </c:pt>
                <c:pt idx="12480">
                  <c:v>2891.38</c:v>
                </c:pt>
                <c:pt idx="12481">
                  <c:v>2996.14</c:v>
                </c:pt>
                <c:pt idx="12483">
                  <c:v>2499.5500000000002</c:v>
                </c:pt>
                <c:pt idx="12485">
                  <c:v>2553.98</c:v>
                </c:pt>
                <c:pt idx="12488">
                  <c:v>1527.98</c:v>
                </c:pt>
                <c:pt idx="12489">
                  <c:v>1508.98</c:v>
                </c:pt>
                <c:pt idx="12499">
                  <c:v>2478.17</c:v>
                </c:pt>
                <c:pt idx="12500">
                  <c:v>2633.69</c:v>
                </c:pt>
                <c:pt idx="12502">
                  <c:v>1830.82</c:v>
                </c:pt>
                <c:pt idx="12504">
                  <c:v>1347.62</c:v>
                </c:pt>
                <c:pt idx="12507">
                  <c:v>1893.46</c:v>
                </c:pt>
                <c:pt idx="12509">
                  <c:v>1631.02</c:v>
                </c:pt>
                <c:pt idx="12511">
                  <c:v>2075.33</c:v>
                </c:pt>
                <c:pt idx="12515">
                  <c:v>1960.63</c:v>
                </c:pt>
                <c:pt idx="12518">
                  <c:v>3055.32</c:v>
                </c:pt>
                <c:pt idx="12519">
                  <c:v>2249.86</c:v>
                </c:pt>
                <c:pt idx="12520">
                  <c:v>4952.2299999999996</c:v>
                </c:pt>
                <c:pt idx="12524">
                  <c:v>2628.07</c:v>
                </c:pt>
                <c:pt idx="12525">
                  <c:v>1473.98</c:v>
                </c:pt>
                <c:pt idx="12527">
                  <c:v>2040.98</c:v>
                </c:pt>
                <c:pt idx="12531">
                  <c:v>2342.52</c:v>
                </c:pt>
                <c:pt idx="12536">
                  <c:v>2319.41</c:v>
                </c:pt>
                <c:pt idx="12539">
                  <c:v>2046.6</c:v>
                </c:pt>
                <c:pt idx="12540">
                  <c:v>3025.51</c:v>
                </c:pt>
                <c:pt idx="12550">
                  <c:v>2185.4899999999998</c:v>
                </c:pt>
                <c:pt idx="12556">
                  <c:v>975.88800000000003</c:v>
                </c:pt>
                <c:pt idx="12557">
                  <c:v>2592.4299999999998</c:v>
                </c:pt>
                <c:pt idx="12558">
                  <c:v>3196.58</c:v>
                </c:pt>
                <c:pt idx="12566">
                  <c:v>1993.9</c:v>
                </c:pt>
                <c:pt idx="12567">
                  <c:v>1447.2</c:v>
                </c:pt>
                <c:pt idx="12569">
                  <c:v>2685.96</c:v>
                </c:pt>
                <c:pt idx="12577">
                  <c:v>1891.73</c:v>
                </c:pt>
                <c:pt idx="12578">
                  <c:v>1714.39</c:v>
                </c:pt>
                <c:pt idx="12580">
                  <c:v>1779.62</c:v>
                </c:pt>
                <c:pt idx="12581">
                  <c:v>2655.5</c:v>
                </c:pt>
                <c:pt idx="12585">
                  <c:v>1779.41</c:v>
                </c:pt>
                <c:pt idx="12586">
                  <c:v>1952.64</c:v>
                </c:pt>
                <c:pt idx="12589">
                  <c:v>2246.83</c:v>
                </c:pt>
                <c:pt idx="12593">
                  <c:v>3561.41</c:v>
                </c:pt>
                <c:pt idx="12600">
                  <c:v>4452.1899999999996</c:v>
                </c:pt>
                <c:pt idx="12601">
                  <c:v>3822.12</c:v>
                </c:pt>
                <c:pt idx="12602">
                  <c:v>973.51199999999994</c:v>
                </c:pt>
                <c:pt idx="12605">
                  <c:v>1836.86</c:v>
                </c:pt>
                <c:pt idx="12608">
                  <c:v>2381.62</c:v>
                </c:pt>
                <c:pt idx="12617">
                  <c:v>1449.58</c:v>
                </c:pt>
                <c:pt idx="12619">
                  <c:v>3722.98</c:v>
                </c:pt>
                <c:pt idx="12622">
                  <c:v>2710.37</c:v>
                </c:pt>
                <c:pt idx="12624">
                  <c:v>2686.18</c:v>
                </c:pt>
                <c:pt idx="12629">
                  <c:v>1759.54</c:v>
                </c:pt>
                <c:pt idx="12633">
                  <c:v>3387.1</c:v>
                </c:pt>
                <c:pt idx="12636">
                  <c:v>3174.98</c:v>
                </c:pt>
                <c:pt idx="12643">
                  <c:v>4965.41</c:v>
                </c:pt>
                <c:pt idx="12644">
                  <c:v>4045.9</c:v>
                </c:pt>
                <c:pt idx="12646">
                  <c:v>2191.9699999999998</c:v>
                </c:pt>
                <c:pt idx="12654">
                  <c:v>3284.28</c:v>
                </c:pt>
                <c:pt idx="12657">
                  <c:v>2949.26</c:v>
                </c:pt>
                <c:pt idx="12665">
                  <c:v>2760.05</c:v>
                </c:pt>
                <c:pt idx="12669">
                  <c:v>1930.61</c:v>
                </c:pt>
                <c:pt idx="12671">
                  <c:v>1741.82</c:v>
                </c:pt>
                <c:pt idx="12672">
                  <c:v>1921.75</c:v>
                </c:pt>
                <c:pt idx="12678">
                  <c:v>1732.97</c:v>
                </c:pt>
                <c:pt idx="12680">
                  <c:v>3169.15</c:v>
                </c:pt>
                <c:pt idx="12683">
                  <c:v>4087.15</c:v>
                </c:pt>
                <c:pt idx="12684">
                  <c:v>3303.29</c:v>
                </c:pt>
                <c:pt idx="12688">
                  <c:v>2050.06</c:v>
                </c:pt>
                <c:pt idx="12690">
                  <c:v>2390.2600000000002</c:v>
                </c:pt>
                <c:pt idx="12695">
                  <c:v>1708.13</c:v>
                </c:pt>
                <c:pt idx="12698">
                  <c:v>1313.93</c:v>
                </c:pt>
                <c:pt idx="12699">
                  <c:v>3047.54</c:v>
                </c:pt>
                <c:pt idx="12702">
                  <c:v>2426.54</c:v>
                </c:pt>
                <c:pt idx="12709">
                  <c:v>2830.9</c:v>
                </c:pt>
                <c:pt idx="12711">
                  <c:v>1614.82</c:v>
                </c:pt>
                <c:pt idx="12718">
                  <c:v>2101.6799999999998</c:v>
                </c:pt>
                <c:pt idx="12724">
                  <c:v>3100.03</c:v>
                </c:pt>
                <c:pt idx="12725">
                  <c:v>2183.33</c:v>
                </c:pt>
                <c:pt idx="12731">
                  <c:v>2490.91</c:v>
                </c:pt>
                <c:pt idx="12733">
                  <c:v>1872.29</c:v>
                </c:pt>
                <c:pt idx="12735">
                  <c:v>4146.34</c:v>
                </c:pt>
                <c:pt idx="12736">
                  <c:v>2657.88</c:v>
                </c:pt>
                <c:pt idx="12739">
                  <c:v>4300.13</c:v>
                </c:pt>
                <c:pt idx="12744">
                  <c:v>1909.01</c:v>
                </c:pt>
                <c:pt idx="12748">
                  <c:v>1014.77</c:v>
                </c:pt>
                <c:pt idx="12755">
                  <c:v>2331.5</c:v>
                </c:pt>
                <c:pt idx="12772">
                  <c:v>2323.5100000000002</c:v>
                </c:pt>
                <c:pt idx="12778">
                  <c:v>2079.65</c:v>
                </c:pt>
                <c:pt idx="12783">
                  <c:v>2517.91</c:v>
                </c:pt>
                <c:pt idx="12785">
                  <c:v>2029.54</c:v>
                </c:pt>
                <c:pt idx="12786">
                  <c:v>3687.77</c:v>
                </c:pt>
                <c:pt idx="12789">
                  <c:v>2782.08</c:v>
                </c:pt>
                <c:pt idx="12792">
                  <c:v>1670.98</c:v>
                </c:pt>
                <c:pt idx="12793">
                  <c:v>2498.2600000000002</c:v>
                </c:pt>
                <c:pt idx="12795">
                  <c:v>2600.86</c:v>
                </c:pt>
                <c:pt idx="12804">
                  <c:v>1873.8</c:v>
                </c:pt>
                <c:pt idx="12807">
                  <c:v>2351.38</c:v>
                </c:pt>
                <c:pt idx="12808">
                  <c:v>2080.08</c:v>
                </c:pt>
                <c:pt idx="12809">
                  <c:v>4095.36</c:v>
                </c:pt>
                <c:pt idx="12816">
                  <c:v>2065.1799999999998</c:v>
                </c:pt>
                <c:pt idx="12822">
                  <c:v>2797.63</c:v>
                </c:pt>
                <c:pt idx="12828">
                  <c:v>4067.93</c:v>
                </c:pt>
                <c:pt idx="12830">
                  <c:v>3374.35</c:v>
                </c:pt>
                <c:pt idx="12831">
                  <c:v>4124.09</c:v>
                </c:pt>
                <c:pt idx="12833">
                  <c:v>9330.34</c:v>
                </c:pt>
                <c:pt idx="12836">
                  <c:v>1725.19</c:v>
                </c:pt>
                <c:pt idx="12839">
                  <c:v>2893.1</c:v>
                </c:pt>
                <c:pt idx="12841">
                  <c:v>2346.84</c:v>
                </c:pt>
                <c:pt idx="12843">
                  <c:v>2785.75</c:v>
                </c:pt>
                <c:pt idx="12850">
                  <c:v>3186.86</c:v>
                </c:pt>
                <c:pt idx="12851">
                  <c:v>1539.86</c:v>
                </c:pt>
                <c:pt idx="12855">
                  <c:v>2395.66</c:v>
                </c:pt>
                <c:pt idx="12857">
                  <c:v>3134.59</c:v>
                </c:pt>
                <c:pt idx="12858">
                  <c:v>1257.77</c:v>
                </c:pt>
                <c:pt idx="12860">
                  <c:v>1221.7</c:v>
                </c:pt>
                <c:pt idx="12873">
                  <c:v>3257.5</c:v>
                </c:pt>
                <c:pt idx="12880">
                  <c:v>2099.52</c:v>
                </c:pt>
                <c:pt idx="12881">
                  <c:v>2073.17</c:v>
                </c:pt>
                <c:pt idx="12889">
                  <c:v>2116.58</c:v>
                </c:pt>
                <c:pt idx="12894">
                  <c:v>2121.77</c:v>
                </c:pt>
                <c:pt idx="12904">
                  <c:v>3039.55</c:v>
                </c:pt>
                <c:pt idx="12912">
                  <c:v>2269.94</c:v>
                </c:pt>
                <c:pt idx="12913">
                  <c:v>1846.8</c:v>
                </c:pt>
                <c:pt idx="12918">
                  <c:v>3721.9</c:v>
                </c:pt>
                <c:pt idx="12919">
                  <c:v>2051.7800000000002</c:v>
                </c:pt>
                <c:pt idx="12927">
                  <c:v>2860.49</c:v>
                </c:pt>
                <c:pt idx="12928">
                  <c:v>3143.88</c:v>
                </c:pt>
                <c:pt idx="12930">
                  <c:v>3638.74</c:v>
                </c:pt>
                <c:pt idx="12931">
                  <c:v>2748.6</c:v>
                </c:pt>
                <c:pt idx="12937">
                  <c:v>1182.82</c:v>
                </c:pt>
                <c:pt idx="12941">
                  <c:v>3846.53</c:v>
                </c:pt>
                <c:pt idx="12943">
                  <c:v>2290.46</c:v>
                </c:pt>
                <c:pt idx="12949">
                  <c:v>2636.5</c:v>
                </c:pt>
                <c:pt idx="12950">
                  <c:v>3623.62</c:v>
                </c:pt>
                <c:pt idx="12953">
                  <c:v>2951.42</c:v>
                </c:pt>
                <c:pt idx="12954">
                  <c:v>2415.1</c:v>
                </c:pt>
                <c:pt idx="12956">
                  <c:v>2095.85</c:v>
                </c:pt>
                <c:pt idx="12961">
                  <c:v>3729.02</c:v>
                </c:pt>
                <c:pt idx="12962">
                  <c:v>1869.05</c:v>
                </c:pt>
                <c:pt idx="12963">
                  <c:v>2654.21</c:v>
                </c:pt>
                <c:pt idx="12965">
                  <c:v>2728.73</c:v>
                </c:pt>
                <c:pt idx="12967">
                  <c:v>1788.05</c:v>
                </c:pt>
                <c:pt idx="12970">
                  <c:v>2763.29</c:v>
                </c:pt>
                <c:pt idx="12971">
                  <c:v>3005.21</c:v>
                </c:pt>
                <c:pt idx="12982">
                  <c:v>3437.21</c:v>
                </c:pt>
                <c:pt idx="12986">
                  <c:v>3774.6</c:v>
                </c:pt>
                <c:pt idx="12989">
                  <c:v>1748.09</c:v>
                </c:pt>
                <c:pt idx="12992">
                  <c:v>1855.66</c:v>
                </c:pt>
                <c:pt idx="12995">
                  <c:v>1767.1</c:v>
                </c:pt>
                <c:pt idx="12998">
                  <c:v>2361.1</c:v>
                </c:pt>
                <c:pt idx="13006">
                  <c:v>2388.1</c:v>
                </c:pt>
                <c:pt idx="13007">
                  <c:v>2294.7800000000002</c:v>
                </c:pt>
                <c:pt idx="13011">
                  <c:v>2378.81</c:v>
                </c:pt>
                <c:pt idx="13014">
                  <c:v>1616.98</c:v>
                </c:pt>
                <c:pt idx="13015">
                  <c:v>1658.02</c:v>
                </c:pt>
                <c:pt idx="13022">
                  <c:v>60.911999999999999</c:v>
                </c:pt>
                <c:pt idx="13023">
                  <c:v>1629.29</c:v>
                </c:pt>
                <c:pt idx="13024">
                  <c:v>2209.46</c:v>
                </c:pt>
                <c:pt idx="13031">
                  <c:v>2487.89</c:v>
                </c:pt>
                <c:pt idx="13038">
                  <c:v>2470.61</c:v>
                </c:pt>
                <c:pt idx="13046">
                  <c:v>2460.89</c:v>
                </c:pt>
                <c:pt idx="13049">
                  <c:v>3071.3</c:v>
                </c:pt>
                <c:pt idx="13050">
                  <c:v>2532.38</c:v>
                </c:pt>
                <c:pt idx="13051">
                  <c:v>2004.91</c:v>
                </c:pt>
                <c:pt idx="13058">
                  <c:v>4007.88</c:v>
                </c:pt>
                <c:pt idx="13062">
                  <c:v>2829.82</c:v>
                </c:pt>
                <c:pt idx="13067">
                  <c:v>3526.85</c:v>
                </c:pt>
                <c:pt idx="13070">
                  <c:v>3921.05</c:v>
                </c:pt>
                <c:pt idx="13073">
                  <c:v>3039.98</c:v>
                </c:pt>
                <c:pt idx="13075">
                  <c:v>2489.1799999999998</c:v>
                </c:pt>
                <c:pt idx="13077">
                  <c:v>2932.63</c:v>
                </c:pt>
                <c:pt idx="13080">
                  <c:v>2299.75</c:v>
                </c:pt>
                <c:pt idx="13081">
                  <c:v>3942.86</c:v>
                </c:pt>
                <c:pt idx="13085">
                  <c:v>2790.07</c:v>
                </c:pt>
                <c:pt idx="13088">
                  <c:v>2447.06</c:v>
                </c:pt>
                <c:pt idx="13089">
                  <c:v>1961.28</c:v>
                </c:pt>
                <c:pt idx="13097">
                  <c:v>3407.18</c:v>
                </c:pt>
                <c:pt idx="13102">
                  <c:v>3615.19</c:v>
                </c:pt>
                <c:pt idx="13106">
                  <c:v>4275.5</c:v>
                </c:pt>
                <c:pt idx="13111">
                  <c:v>2250.94</c:v>
                </c:pt>
                <c:pt idx="13114">
                  <c:v>3398.54</c:v>
                </c:pt>
                <c:pt idx="13117">
                  <c:v>2204.71</c:v>
                </c:pt>
                <c:pt idx="13124">
                  <c:v>1961.71</c:v>
                </c:pt>
                <c:pt idx="13125">
                  <c:v>3876.12</c:v>
                </c:pt>
                <c:pt idx="13128">
                  <c:v>2665.44</c:v>
                </c:pt>
                <c:pt idx="13131">
                  <c:v>1900.15</c:v>
                </c:pt>
                <c:pt idx="13133">
                  <c:v>2358.5</c:v>
                </c:pt>
                <c:pt idx="13137">
                  <c:v>2439.29</c:v>
                </c:pt>
                <c:pt idx="13138">
                  <c:v>2374.4899999999998</c:v>
                </c:pt>
                <c:pt idx="13140">
                  <c:v>2039.9</c:v>
                </c:pt>
                <c:pt idx="13143">
                  <c:v>1677.67</c:v>
                </c:pt>
                <c:pt idx="13148">
                  <c:v>2684.45</c:v>
                </c:pt>
                <c:pt idx="13154">
                  <c:v>2136.02</c:v>
                </c:pt>
                <c:pt idx="13156">
                  <c:v>1856.74</c:v>
                </c:pt>
                <c:pt idx="13157">
                  <c:v>2864.38</c:v>
                </c:pt>
                <c:pt idx="13158">
                  <c:v>2706.91</c:v>
                </c:pt>
                <c:pt idx="13161">
                  <c:v>2408.83</c:v>
                </c:pt>
                <c:pt idx="13162">
                  <c:v>3308.26</c:v>
                </c:pt>
                <c:pt idx="13166">
                  <c:v>2687.04</c:v>
                </c:pt>
                <c:pt idx="13167">
                  <c:v>2781.86</c:v>
                </c:pt>
                <c:pt idx="13169">
                  <c:v>3224.23</c:v>
                </c:pt>
                <c:pt idx="13179">
                  <c:v>4762.37</c:v>
                </c:pt>
                <c:pt idx="13182">
                  <c:v>1667.09</c:v>
                </c:pt>
                <c:pt idx="13184">
                  <c:v>2072.3000000000002</c:v>
                </c:pt>
                <c:pt idx="13189">
                  <c:v>1306.1500000000001</c:v>
                </c:pt>
                <c:pt idx="13190">
                  <c:v>2076.62</c:v>
                </c:pt>
                <c:pt idx="13197">
                  <c:v>3744.36</c:v>
                </c:pt>
                <c:pt idx="13202">
                  <c:v>2896.13</c:v>
                </c:pt>
                <c:pt idx="13205">
                  <c:v>1743.98</c:v>
                </c:pt>
                <c:pt idx="13208">
                  <c:v>1958.26</c:v>
                </c:pt>
                <c:pt idx="13211">
                  <c:v>3937.9</c:v>
                </c:pt>
                <c:pt idx="13213">
                  <c:v>3326.83</c:v>
                </c:pt>
                <c:pt idx="13215">
                  <c:v>2877.77</c:v>
                </c:pt>
                <c:pt idx="13218">
                  <c:v>2760.26</c:v>
                </c:pt>
                <c:pt idx="13220">
                  <c:v>1991.74</c:v>
                </c:pt>
                <c:pt idx="13221">
                  <c:v>1406.16</c:v>
                </c:pt>
                <c:pt idx="13225">
                  <c:v>2198.88</c:v>
                </c:pt>
                <c:pt idx="13227">
                  <c:v>2776.9</c:v>
                </c:pt>
                <c:pt idx="13233">
                  <c:v>2260.2199999999998</c:v>
                </c:pt>
                <c:pt idx="13241">
                  <c:v>2687.9</c:v>
                </c:pt>
                <c:pt idx="13243">
                  <c:v>2470.1799999999998</c:v>
                </c:pt>
                <c:pt idx="13247">
                  <c:v>3219.05</c:v>
                </c:pt>
                <c:pt idx="13248">
                  <c:v>2336.9</c:v>
                </c:pt>
                <c:pt idx="13259">
                  <c:v>1457.35</c:v>
                </c:pt>
                <c:pt idx="13260">
                  <c:v>3126.6</c:v>
                </c:pt>
                <c:pt idx="13261">
                  <c:v>3854.52</c:v>
                </c:pt>
                <c:pt idx="13278">
                  <c:v>5194.8</c:v>
                </c:pt>
                <c:pt idx="13281">
                  <c:v>1319.54</c:v>
                </c:pt>
                <c:pt idx="13282">
                  <c:v>2817.5</c:v>
                </c:pt>
                <c:pt idx="13286">
                  <c:v>2576.23</c:v>
                </c:pt>
                <c:pt idx="13287">
                  <c:v>2313.14</c:v>
                </c:pt>
                <c:pt idx="13288">
                  <c:v>1451.95</c:v>
                </c:pt>
                <c:pt idx="13290">
                  <c:v>2826.79</c:v>
                </c:pt>
                <c:pt idx="13297">
                  <c:v>2468.23</c:v>
                </c:pt>
                <c:pt idx="13298">
                  <c:v>2580.77</c:v>
                </c:pt>
                <c:pt idx="13309">
                  <c:v>2924.21</c:v>
                </c:pt>
                <c:pt idx="13310">
                  <c:v>2384.86</c:v>
                </c:pt>
                <c:pt idx="13312">
                  <c:v>2555.5</c:v>
                </c:pt>
                <c:pt idx="13313">
                  <c:v>2778.19</c:v>
                </c:pt>
                <c:pt idx="13316">
                  <c:v>3050.35</c:v>
                </c:pt>
                <c:pt idx="13320">
                  <c:v>2301.91</c:v>
                </c:pt>
                <c:pt idx="13321">
                  <c:v>3683.88</c:v>
                </c:pt>
                <c:pt idx="13322">
                  <c:v>2501.5</c:v>
                </c:pt>
                <c:pt idx="13323">
                  <c:v>3010.18</c:v>
                </c:pt>
                <c:pt idx="13325">
                  <c:v>2320.6999999999998</c:v>
                </c:pt>
                <c:pt idx="13333">
                  <c:v>1965.38</c:v>
                </c:pt>
                <c:pt idx="13335">
                  <c:v>2293.92</c:v>
                </c:pt>
                <c:pt idx="13340">
                  <c:v>3174.77</c:v>
                </c:pt>
                <c:pt idx="13342">
                  <c:v>3036.31</c:v>
                </c:pt>
                <c:pt idx="13344">
                  <c:v>2284.42</c:v>
                </c:pt>
                <c:pt idx="13345">
                  <c:v>1435.54</c:v>
                </c:pt>
                <c:pt idx="13356">
                  <c:v>2234.09</c:v>
                </c:pt>
                <c:pt idx="13362">
                  <c:v>2470.61</c:v>
                </c:pt>
                <c:pt idx="13366">
                  <c:v>3031.56</c:v>
                </c:pt>
                <c:pt idx="13368">
                  <c:v>1788.91</c:v>
                </c:pt>
                <c:pt idx="13373">
                  <c:v>4104.6499999999996</c:v>
                </c:pt>
                <c:pt idx="13374">
                  <c:v>3370.9</c:v>
                </c:pt>
                <c:pt idx="13377">
                  <c:v>1961.71</c:v>
                </c:pt>
                <c:pt idx="13378">
                  <c:v>3308.47</c:v>
                </c:pt>
                <c:pt idx="13383">
                  <c:v>1554.34</c:v>
                </c:pt>
                <c:pt idx="13384">
                  <c:v>2414.02</c:v>
                </c:pt>
                <c:pt idx="13387">
                  <c:v>3092.04</c:v>
                </c:pt>
                <c:pt idx="13394">
                  <c:v>3134.38</c:v>
                </c:pt>
                <c:pt idx="13399">
                  <c:v>2607.12</c:v>
                </c:pt>
                <c:pt idx="13402">
                  <c:v>4453.49</c:v>
                </c:pt>
                <c:pt idx="13403">
                  <c:v>3103.92</c:v>
                </c:pt>
                <c:pt idx="13404">
                  <c:v>1705.32</c:v>
                </c:pt>
                <c:pt idx="13407">
                  <c:v>1762.99</c:v>
                </c:pt>
                <c:pt idx="13411">
                  <c:v>1949.83</c:v>
                </c:pt>
                <c:pt idx="13415">
                  <c:v>4515.26</c:v>
                </c:pt>
                <c:pt idx="13416">
                  <c:v>2321.35</c:v>
                </c:pt>
                <c:pt idx="13421">
                  <c:v>1535.54</c:v>
                </c:pt>
                <c:pt idx="13426">
                  <c:v>3250.15</c:v>
                </c:pt>
                <c:pt idx="13427">
                  <c:v>1554.12</c:v>
                </c:pt>
                <c:pt idx="13429">
                  <c:v>3227.26</c:v>
                </c:pt>
                <c:pt idx="13430">
                  <c:v>3056.83</c:v>
                </c:pt>
                <c:pt idx="13431">
                  <c:v>2839.32</c:v>
                </c:pt>
                <c:pt idx="13436">
                  <c:v>2722.9</c:v>
                </c:pt>
                <c:pt idx="13443">
                  <c:v>2569.1</c:v>
                </c:pt>
                <c:pt idx="13446">
                  <c:v>2166.91</c:v>
                </c:pt>
                <c:pt idx="13447">
                  <c:v>2608.1999999999998</c:v>
                </c:pt>
                <c:pt idx="13456">
                  <c:v>2957.69</c:v>
                </c:pt>
                <c:pt idx="13461">
                  <c:v>2346.19</c:v>
                </c:pt>
                <c:pt idx="13464">
                  <c:v>2376.4299999999998</c:v>
                </c:pt>
                <c:pt idx="13469">
                  <c:v>2661.77</c:v>
                </c:pt>
                <c:pt idx="13471">
                  <c:v>4226.6899999999996</c:v>
                </c:pt>
                <c:pt idx="13474">
                  <c:v>2876.26</c:v>
                </c:pt>
                <c:pt idx="13481">
                  <c:v>2333.02</c:v>
                </c:pt>
                <c:pt idx="13485">
                  <c:v>3226.18</c:v>
                </c:pt>
                <c:pt idx="13488">
                  <c:v>2375.14</c:v>
                </c:pt>
                <c:pt idx="13493">
                  <c:v>2523.96</c:v>
                </c:pt>
                <c:pt idx="13499">
                  <c:v>3058.13</c:v>
                </c:pt>
                <c:pt idx="13502">
                  <c:v>3138.91</c:v>
                </c:pt>
                <c:pt idx="13504">
                  <c:v>3795.77</c:v>
                </c:pt>
                <c:pt idx="13506">
                  <c:v>3236.98</c:v>
                </c:pt>
                <c:pt idx="13508">
                  <c:v>2650.32</c:v>
                </c:pt>
                <c:pt idx="13509">
                  <c:v>2636.93</c:v>
                </c:pt>
                <c:pt idx="13510">
                  <c:v>2628.29</c:v>
                </c:pt>
                <c:pt idx="13512">
                  <c:v>2783.59</c:v>
                </c:pt>
                <c:pt idx="13513">
                  <c:v>2215.94</c:v>
                </c:pt>
                <c:pt idx="13516">
                  <c:v>4093.2</c:v>
                </c:pt>
                <c:pt idx="13525">
                  <c:v>3417.34</c:v>
                </c:pt>
                <c:pt idx="13528">
                  <c:v>2657.23</c:v>
                </c:pt>
                <c:pt idx="13530">
                  <c:v>3493.37</c:v>
                </c:pt>
                <c:pt idx="13533">
                  <c:v>3929.9</c:v>
                </c:pt>
                <c:pt idx="13535">
                  <c:v>2704.1</c:v>
                </c:pt>
                <c:pt idx="13538">
                  <c:v>2188.3000000000002</c:v>
                </c:pt>
                <c:pt idx="13542">
                  <c:v>2430.4299999999998</c:v>
                </c:pt>
                <c:pt idx="13543">
                  <c:v>2818.37</c:v>
                </c:pt>
                <c:pt idx="13544">
                  <c:v>2416.1799999999998</c:v>
                </c:pt>
                <c:pt idx="13551">
                  <c:v>2404.73</c:v>
                </c:pt>
                <c:pt idx="13558">
                  <c:v>2475.79</c:v>
                </c:pt>
                <c:pt idx="13565">
                  <c:v>2409.0500000000002</c:v>
                </c:pt>
                <c:pt idx="13567">
                  <c:v>3191.4</c:v>
                </c:pt>
                <c:pt idx="13569">
                  <c:v>1936.87</c:v>
                </c:pt>
                <c:pt idx="13573">
                  <c:v>1862.14</c:v>
                </c:pt>
                <c:pt idx="13575">
                  <c:v>2059.56</c:v>
                </c:pt>
                <c:pt idx="13581">
                  <c:v>3072.6</c:v>
                </c:pt>
                <c:pt idx="13582">
                  <c:v>2585.09</c:v>
                </c:pt>
                <c:pt idx="13584">
                  <c:v>2776.68</c:v>
                </c:pt>
                <c:pt idx="13585">
                  <c:v>3236.54</c:v>
                </c:pt>
                <c:pt idx="13586">
                  <c:v>1702.08</c:v>
                </c:pt>
                <c:pt idx="13590">
                  <c:v>1804.25</c:v>
                </c:pt>
                <c:pt idx="13593">
                  <c:v>4134.24</c:v>
                </c:pt>
                <c:pt idx="13599">
                  <c:v>2902.39</c:v>
                </c:pt>
                <c:pt idx="13603">
                  <c:v>3536.57</c:v>
                </c:pt>
                <c:pt idx="13604">
                  <c:v>7987.03</c:v>
                </c:pt>
                <c:pt idx="13606">
                  <c:v>1932.12</c:v>
                </c:pt>
                <c:pt idx="13610">
                  <c:v>3227.69</c:v>
                </c:pt>
                <c:pt idx="13616">
                  <c:v>4972.32</c:v>
                </c:pt>
                <c:pt idx="13617">
                  <c:v>2460.46</c:v>
                </c:pt>
                <c:pt idx="13618">
                  <c:v>2887.27</c:v>
                </c:pt>
                <c:pt idx="13620">
                  <c:v>2434.75</c:v>
                </c:pt>
                <c:pt idx="13623">
                  <c:v>3518.86</c:v>
                </c:pt>
                <c:pt idx="13626">
                  <c:v>3243.67</c:v>
                </c:pt>
                <c:pt idx="13628">
                  <c:v>4794.12</c:v>
                </c:pt>
                <c:pt idx="13637">
                  <c:v>3213.43</c:v>
                </c:pt>
                <c:pt idx="13639">
                  <c:v>2574.94</c:v>
                </c:pt>
                <c:pt idx="13647">
                  <c:v>4068.36</c:v>
                </c:pt>
                <c:pt idx="13648">
                  <c:v>2851.85</c:v>
                </c:pt>
                <c:pt idx="13663">
                  <c:v>4158.8599999999997</c:v>
                </c:pt>
                <c:pt idx="13668">
                  <c:v>2361.7399999999998</c:v>
                </c:pt>
                <c:pt idx="13669">
                  <c:v>3503.95</c:v>
                </c:pt>
                <c:pt idx="13673">
                  <c:v>2100.17</c:v>
                </c:pt>
                <c:pt idx="13679">
                  <c:v>2358.29</c:v>
                </c:pt>
                <c:pt idx="13682">
                  <c:v>2386.37</c:v>
                </c:pt>
                <c:pt idx="13694">
                  <c:v>3177.79</c:v>
                </c:pt>
                <c:pt idx="13711">
                  <c:v>3108.02</c:v>
                </c:pt>
                <c:pt idx="13712">
                  <c:v>3183.62</c:v>
                </c:pt>
                <c:pt idx="13713">
                  <c:v>2459.38</c:v>
                </c:pt>
                <c:pt idx="13716">
                  <c:v>2712.31</c:v>
                </c:pt>
                <c:pt idx="13717">
                  <c:v>2855.3</c:v>
                </c:pt>
                <c:pt idx="13718">
                  <c:v>3790.58</c:v>
                </c:pt>
                <c:pt idx="13719">
                  <c:v>3220.99</c:v>
                </c:pt>
                <c:pt idx="13720">
                  <c:v>2279.66</c:v>
                </c:pt>
                <c:pt idx="13722">
                  <c:v>2155.0300000000002</c:v>
                </c:pt>
                <c:pt idx="13723">
                  <c:v>2842.13</c:v>
                </c:pt>
                <c:pt idx="13724">
                  <c:v>2447.9299999999998</c:v>
                </c:pt>
                <c:pt idx="13728">
                  <c:v>1623.24</c:v>
                </c:pt>
                <c:pt idx="13730">
                  <c:v>2981.23</c:v>
                </c:pt>
                <c:pt idx="13733">
                  <c:v>2396.52</c:v>
                </c:pt>
                <c:pt idx="13737">
                  <c:v>2281.1799999999998</c:v>
                </c:pt>
                <c:pt idx="13738">
                  <c:v>1437.05</c:v>
                </c:pt>
                <c:pt idx="13739">
                  <c:v>2273.62</c:v>
                </c:pt>
                <c:pt idx="13740">
                  <c:v>1906.85</c:v>
                </c:pt>
                <c:pt idx="13741">
                  <c:v>3080.16</c:v>
                </c:pt>
                <c:pt idx="13746">
                  <c:v>4450.46</c:v>
                </c:pt>
                <c:pt idx="13748">
                  <c:v>3496.61</c:v>
                </c:pt>
                <c:pt idx="13756">
                  <c:v>2041.2</c:v>
                </c:pt>
                <c:pt idx="13759">
                  <c:v>2250.29</c:v>
                </c:pt>
                <c:pt idx="13762">
                  <c:v>2173.39</c:v>
                </c:pt>
                <c:pt idx="13765">
                  <c:v>3885.19</c:v>
                </c:pt>
                <c:pt idx="13766">
                  <c:v>4152.38</c:v>
                </c:pt>
                <c:pt idx="13767">
                  <c:v>5428.08</c:v>
                </c:pt>
                <c:pt idx="13769">
                  <c:v>3429.65</c:v>
                </c:pt>
                <c:pt idx="13773">
                  <c:v>4237.2700000000004</c:v>
                </c:pt>
                <c:pt idx="13779">
                  <c:v>1724.54</c:v>
                </c:pt>
                <c:pt idx="13784">
                  <c:v>3520.58</c:v>
                </c:pt>
                <c:pt idx="13785">
                  <c:v>2102.11</c:v>
                </c:pt>
                <c:pt idx="13786">
                  <c:v>2547.94</c:v>
                </c:pt>
                <c:pt idx="13788">
                  <c:v>4461.26</c:v>
                </c:pt>
                <c:pt idx="13790">
                  <c:v>4580.93</c:v>
                </c:pt>
                <c:pt idx="13791">
                  <c:v>2285.9299999999998</c:v>
                </c:pt>
                <c:pt idx="13792">
                  <c:v>1956.53</c:v>
                </c:pt>
                <c:pt idx="13797">
                  <c:v>3453.19</c:v>
                </c:pt>
                <c:pt idx="13810">
                  <c:v>3388.18</c:v>
                </c:pt>
                <c:pt idx="13811">
                  <c:v>3358.8</c:v>
                </c:pt>
                <c:pt idx="13813">
                  <c:v>5196.74</c:v>
                </c:pt>
                <c:pt idx="13819">
                  <c:v>3453.84</c:v>
                </c:pt>
                <c:pt idx="13824">
                  <c:v>2828.52</c:v>
                </c:pt>
                <c:pt idx="13825">
                  <c:v>1699.27</c:v>
                </c:pt>
                <c:pt idx="13827">
                  <c:v>3295.3</c:v>
                </c:pt>
                <c:pt idx="13829">
                  <c:v>2828.3</c:v>
                </c:pt>
                <c:pt idx="13837">
                  <c:v>2447.06</c:v>
                </c:pt>
                <c:pt idx="13841">
                  <c:v>2892.02</c:v>
                </c:pt>
                <c:pt idx="13843">
                  <c:v>5023.9399999999996</c:v>
                </c:pt>
                <c:pt idx="13852">
                  <c:v>1699.92</c:v>
                </c:pt>
                <c:pt idx="13853">
                  <c:v>2703.46</c:v>
                </c:pt>
                <c:pt idx="13859">
                  <c:v>2617.6999999999998</c:v>
                </c:pt>
                <c:pt idx="13866">
                  <c:v>3065.26</c:v>
                </c:pt>
                <c:pt idx="13871">
                  <c:v>2434.54</c:v>
                </c:pt>
                <c:pt idx="13875">
                  <c:v>3033.94</c:v>
                </c:pt>
                <c:pt idx="13877">
                  <c:v>1680.48</c:v>
                </c:pt>
                <c:pt idx="13878">
                  <c:v>2895.26</c:v>
                </c:pt>
                <c:pt idx="13883">
                  <c:v>3682.8</c:v>
                </c:pt>
                <c:pt idx="13893">
                  <c:v>2577.31</c:v>
                </c:pt>
                <c:pt idx="13894">
                  <c:v>3821.47</c:v>
                </c:pt>
                <c:pt idx="13896">
                  <c:v>2877.34</c:v>
                </c:pt>
                <c:pt idx="13897">
                  <c:v>4309.42</c:v>
                </c:pt>
                <c:pt idx="13906">
                  <c:v>3194.42</c:v>
                </c:pt>
                <c:pt idx="13907">
                  <c:v>2431.08</c:v>
                </c:pt>
                <c:pt idx="13910">
                  <c:v>2587.25</c:v>
                </c:pt>
                <c:pt idx="13911">
                  <c:v>1900.8</c:v>
                </c:pt>
                <c:pt idx="13912">
                  <c:v>5050.51</c:v>
                </c:pt>
                <c:pt idx="13914">
                  <c:v>2287.66</c:v>
                </c:pt>
                <c:pt idx="13917">
                  <c:v>2780.78</c:v>
                </c:pt>
                <c:pt idx="13919">
                  <c:v>2420.2800000000002</c:v>
                </c:pt>
                <c:pt idx="13921">
                  <c:v>2761.56</c:v>
                </c:pt>
                <c:pt idx="13926">
                  <c:v>3515.18</c:v>
                </c:pt>
                <c:pt idx="13932">
                  <c:v>2547.0700000000002</c:v>
                </c:pt>
                <c:pt idx="13933">
                  <c:v>4600.37</c:v>
                </c:pt>
                <c:pt idx="13937">
                  <c:v>2322</c:v>
                </c:pt>
                <c:pt idx="13938">
                  <c:v>2276.21</c:v>
                </c:pt>
                <c:pt idx="13939">
                  <c:v>6212.38</c:v>
                </c:pt>
                <c:pt idx="13940">
                  <c:v>2461.75</c:v>
                </c:pt>
                <c:pt idx="13944">
                  <c:v>3051</c:v>
                </c:pt>
                <c:pt idx="13945">
                  <c:v>2495.4499999999998</c:v>
                </c:pt>
                <c:pt idx="13948">
                  <c:v>4411.1499999999996</c:v>
                </c:pt>
                <c:pt idx="13959">
                  <c:v>3225.53</c:v>
                </c:pt>
                <c:pt idx="13962">
                  <c:v>2530.2199999999998</c:v>
                </c:pt>
                <c:pt idx="13963">
                  <c:v>4053.89</c:v>
                </c:pt>
                <c:pt idx="13971">
                  <c:v>4284.79</c:v>
                </c:pt>
                <c:pt idx="13972">
                  <c:v>2661.98</c:v>
                </c:pt>
                <c:pt idx="13973">
                  <c:v>2559.6</c:v>
                </c:pt>
                <c:pt idx="13974">
                  <c:v>3808.51</c:v>
                </c:pt>
                <c:pt idx="13977">
                  <c:v>3974.18</c:v>
                </c:pt>
                <c:pt idx="13981">
                  <c:v>1713.96</c:v>
                </c:pt>
                <c:pt idx="13992">
                  <c:v>2278.8000000000002</c:v>
                </c:pt>
                <c:pt idx="13993">
                  <c:v>2785.97</c:v>
                </c:pt>
                <c:pt idx="13995">
                  <c:v>2930.04</c:v>
                </c:pt>
                <c:pt idx="13999">
                  <c:v>3227.47</c:v>
                </c:pt>
                <c:pt idx="14000">
                  <c:v>2492.21</c:v>
                </c:pt>
                <c:pt idx="14002">
                  <c:v>2886.19</c:v>
                </c:pt>
                <c:pt idx="14005">
                  <c:v>2835</c:v>
                </c:pt>
                <c:pt idx="14007">
                  <c:v>2503.66</c:v>
                </c:pt>
                <c:pt idx="14011">
                  <c:v>2477.3000000000002</c:v>
                </c:pt>
                <c:pt idx="14016">
                  <c:v>4441.3900000000003</c:v>
                </c:pt>
                <c:pt idx="14017">
                  <c:v>2544.2600000000002</c:v>
                </c:pt>
                <c:pt idx="14019">
                  <c:v>3437.42</c:v>
                </c:pt>
                <c:pt idx="14021">
                  <c:v>3778.7</c:v>
                </c:pt>
                <c:pt idx="14022">
                  <c:v>4618.7299999999996</c:v>
                </c:pt>
                <c:pt idx="14024">
                  <c:v>3358.37</c:v>
                </c:pt>
                <c:pt idx="14025">
                  <c:v>3149.5</c:v>
                </c:pt>
                <c:pt idx="14026">
                  <c:v>5350.54</c:v>
                </c:pt>
                <c:pt idx="14030">
                  <c:v>2565.2199999999998</c:v>
                </c:pt>
                <c:pt idx="14032">
                  <c:v>2422.2199999999998</c:v>
                </c:pt>
                <c:pt idx="14037">
                  <c:v>2717.71</c:v>
                </c:pt>
                <c:pt idx="14038">
                  <c:v>3481.92</c:v>
                </c:pt>
                <c:pt idx="14042">
                  <c:v>2692.66</c:v>
                </c:pt>
                <c:pt idx="14046">
                  <c:v>3129.41</c:v>
                </c:pt>
                <c:pt idx="14048">
                  <c:v>3651.26</c:v>
                </c:pt>
                <c:pt idx="14055">
                  <c:v>3641.33</c:v>
                </c:pt>
                <c:pt idx="14068">
                  <c:v>2264.11</c:v>
                </c:pt>
                <c:pt idx="14073">
                  <c:v>4516.78</c:v>
                </c:pt>
                <c:pt idx="14076">
                  <c:v>3139.13</c:v>
                </c:pt>
                <c:pt idx="14081">
                  <c:v>3337.63</c:v>
                </c:pt>
                <c:pt idx="14086">
                  <c:v>3598.34</c:v>
                </c:pt>
                <c:pt idx="14087">
                  <c:v>2288.09</c:v>
                </c:pt>
                <c:pt idx="14089">
                  <c:v>2992.25</c:v>
                </c:pt>
                <c:pt idx="14090">
                  <c:v>1628.21</c:v>
                </c:pt>
                <c:pt idx="14093">
                  <c:v>2153.52</c:v>
                </c:pt>
                <c:pt idx="14094">
                  <c:v>2878.2</c:v>
                </c:pt>
                <c:pt idx="14102">
                  <c:v>3732.05</c:v>
                </c:pt>
                <c:pt idx="14107">
                  <c:v>5063.8999999999996</c:v>
                </c:pt>
                <c:pt idx="14108">
                  <c:v>1731.46</c:v>
                </c:pt>
                <c:pt idx="14111">
                  <c:v>2596.75</c:v>
                </c:pt>
                <c:pt idx="14112">
                  <c:v>4239.22</c:v>
                </c:pt>
                <c:pt idx="14119">
                  <c:v>2540.59</c:v>
                </c:pt>
                <c:pt idx="14121">
                  <c:v>2545.13</c:v>
                </c:pt>
                <c:pt idx="14122">
                  <c:v>2518.13</c:v>
                </c:pt>
                <c:pt idx="14128">
                  <c:v>3611.74</c:v>
                </c:pt>
                <c:pt idx="14129">
                  <c:v>2587.25</c:v>
                </c:pt>
                <c:pt idx="14140">
                  <c:v>2807.14</c:v>
                </c:pt>
                <c:pt idx="14144">
                  <c:v>2657.88</c:v>
                </c:pt>
                <c:pt idx="14146">
                  <c:v>2767.18</c:v>
                </c:pt>
                <c:pt idx="14150">
                  <c:v>4275.9399999999996</c:v>
                </c:pt>
                <c:pt idx="14156">
                  <c:v>2714.47</c:v>
                </c:pt>
                <c:pt idx="14159">
                  <c:v>3030.91</c:v>
                </c:pt>
                <c:pt idx="14160">
                  <c:v>2098.66</c:v>
                </c:pt>
                <c:pt idx="14161">
                  <c:v>3244.75</c:v>
                </c:pt>
                <c:pt idx="14162">
                  <c:v>2552.04</c:v>
                </c:pt>
                <c:pt idx="14165">
                  <c:v>3963.17</c:v>
                </c:pt>
                <c:pt idx="14175">
                  <c:v>3826.44</c:v>
                </c:pt>
                <c:pt idx="14180">
                  <c:v>3862.73</c:v>
                </c:pt>
                <c:pt idx="14182">
                  <c:v>2885.33</c:v>
                </c:pt>
                <c:pt idx="14189">
                  <c:v>4719.6000000000004</c:v>
                </c:pt>
                <c:pt idx="14190">
                  <c:v>4470.55</c:v>
                </c:pt>
                <c:pt idx="14191">
                  <c:v>3555.36</c:v>
                </c:pt>
                <c:pt idx="14193">
                  <c:v>3694.25</c:v>
                </c:pt>
                <c:pt idx="14195">
                  <c:v>3484.51</c:v>
                </c:pt>
                <c:pt idx="14197">
                  <c:v>3732.91</c:v>
                </c:pt>
                <c:pt idx="14198">
                  <c:v>4037.26</c:v>
                </c:pt>
                <c:pt idx="14200">
                  <c:v>3892.32</c:v>
                </c:pt>
                <c:pt idx="14203">
                  <c:v>2244.2399999999998</c:v>
                </c:pt>
                <c:pt idx="14209">
                  <c:v>2855.3</c:v>
                </c:pt>
                <c:pt idx="14212">
                  <c:v>3662.71</c:v>
                </c:pt>
                <c:pt idx="14219">
                  <c:v>3664.44</c:v>
                </c:pt>
                <c:pt idx="14229">
                  <c:v>2440.37</c:v>
                </c:pt>
                <c:pt idx="14231">
                  <c:v>2945.59</c:v>
                </c:pt>
                <c:pt idx="14240">
                  <c:v>4998.67</c:v>
                </c:pt>
                <c:pt idx="14251">
                  <c:v>5623.13</c:v>
                </c:pt>
                <c:pt idx="14252">
                  <c:v>2735.21</c:v>
                </c:pt>
                <c:pt idx="14253">
                  <c:v>2175.34</c:v>
                </c:pt>
                <c:pt idx="14256">
                  <c:v>2606.2600000000002</c:v>
                </c:pt>
                <c:pt idx="14257">
                  <c:v>3861.65</c:v>
                </c:pt>
                <c:pt idx="14259">
                  <c:v>2772.58</c:v>
                </c:pt>
                <c:pt idx="14260">
                  <c:v>3009.1</c:v>
                </c:pt>
                <c:pt idx="14262">
                  <c:v>3758.83</c:v>
                </c:pt>
                <c:pt idx="14264">
                  <c:v>3604.39</c:v>
                </c:pt>
                <c:pt idx="14265">
                  <c:v>5665.9</c:v>
                </c:pt>
                <c:pt idx="14271">
                  <c:v>2537.5700000000002</c:v>
                </c:pt>
                <c:pt idx="14273">
                  <c:v>2815.34</c:v>
                </c:pt>
                <c:pt idx="14277">
                  <c:v>3349.08</c:v>
                </c:pt>
                <c:pt idx="14279">
                  <c:v>2866.54</c:v>
                </c:pt>
                <c:pt idx="14281">
                  <c:v>4282.8500000000004</c:v>
                </c:pt>
                <c:pt idx="14282">
                  <c:v>3786.91</c:v>
                </c:pt>
                <c:pt idx="14283">
                  <c:v>3314.95</c:v>
                </c:pt>
                <c:pt idx="14284">
                  <c:v>2877.12</c:v>
                </c:pt>
                <c:pt idx="14286">
                  <c:v>3975.48</c:v>
                </c:pt>
                <c:pt idx="14288">
                  <c:v>1877.69</c:v>
                </c:pt>
                <c:pt idx="14296">
                  <c:v>3441.31</c:v>
                </c:pt>
                <c:pt idx="14299">
                  <c:v>4040.93</c:v>
                </c:pt>
                <c:pt idx="14300">
                  <c:v>4529.74</c:v>
                </c:pt>
                <c:pt idx="14301">
                  <c:v>4591.3</c:v>
                </c:pt>
                <c:pt idx="14304">
                  <c:v>2867.18</c:v>
                </c:pt>
                <c:pt idx="14305">
                  <c:v>2089.15</c:v>
                </c:pt>
                <c:pt idx="14312">
                  <c:v>4213.08</c:v>
                </c:pt>
                <c:pt idx="14313">
                  <c:v>2689.85</c:v>
                </c:pt>
                <c:pt idx="14315">
                  <c:v>2594.38</c:v>
                </c:pt>
                <c:pt idx="14321">
                  <c:v>2512.5100000000002</c:v>
                </c:pt>
                <c:pt idx="14324">
                  <c:v>2622.89</c:v>
                </c:pt>
                <c:pt idx="14332">
                  <c:v>4909.46</c:v>
                </c:pt>
                <c:pt idx="14340">
                  <c:v>2683.58</c:v>
                </c:pt>
                <c:pt idx="14343">
                  <c:v>2576.4499999999998</c:v>
                </c:pt>
                <c:pt idx="14344">
                  <c:v>5546.02</c:v>
                </c:pt>
                <c:pt idx="14346">
                  <c:v>3387.31</c:v>
                </c:pt>
                <c:pt idx="14347">
                  <c:v>4986.79</c:v>
                </c:pt>
                <c:pt idx="14350">
                  <c:v>3012.77</c:v>
                </c:pt>
                <c:pt idx="14367">
                  <c:v>2997.43</c:v>
                </c:pt>
                <c:pt idx="14371">
                  <c:v>2174.9</c:v>
                </c:pt>
                <c:pt idx="14374">
                  <c:v>3397.68</c:v>
                </c:pt>
                <c:pt idx="14377">
                  <c:v>5733.94</c:v>
                </c:pt>
                <c:pt idx="14380">
                  <c:v>3464.86</c:v>
                </c:pt>
                <c:pt idx="14381">
                  <c:v>4027.97</c:v>
                </c:pt>
                <c:pt idx="14384">
                  <c:v>4156.49</c:v>
                </c:pt>
                <c:pt idx="14385">
                  <c:v>5297.18</c:v>
                </c:pt>
                <c:pt idx="14387">
                  <c:v>2371.9</c:v>
                </c:pt>
                <c:pt idx="14389">
                  <c:v>2418.77</c:v>
                </c:pt>
                <c:pt idx="14401">
                  <c:v>3060.5</c:v>
                </c:pt>
                <c:pt idx="14406">
                  <c:v>5824.87</c:v>
                </c:pt>
                <c:pt idx="14424">
                  <c:v>2976.05</c:v>
                </c:pt>
                <c:pt idx="14428">
                  <c:v>3867.05</c:v>
                </c:pt>
                <c:pt idx="14430">
                  <c:v>3504.38</c:v>
                </c:pt>
                <c:pt idx="14435">
                  <c:v>4873.6099999999997</c:v>
                </c:pt>
                <c:pt idx="14439">
                  <c:v>2945.81</c:v>
                </c:pt>
                <c:pt idx="14444">
                  <c:v>3749.33</c:v>
                </c:pt>
                <c:pt idx="14447">
                  <c:v>4423.25</c:v>
                </c:pt>
                <c:pt idx="14449">
                  <c:v>3212.57</c:v>
                </c:pt>
                <c:pt idx="14451">
                  <c:v>3003.05</c:v>
                </c:pt>
                <c:pt idx="14456">
                  <c:v>3791.88</c:v>
                </c:pt>
                <c:pt idx="14458">
                  <c:v>5073.84</c:v>
                </c:pt>
                <c:pt idx="14459">
                  <c:v>3846.53</c:v>
                </c:pt>
                <c:pt idx="14462">
                  <c:v>2615.33</c:v>
                </c:pt>
                <c:pt idx="14471">
                  <c:v>3918.02</c:v>
                </c:pt>
                <c:pt idx="14472">
                  <c:v>3378.46</c:v>
                </c:pt>
                <c:pt idx="14473">
                  <c:v>3704.62</c:v>
                </c:pt>
                <c:pt idx="14475">
                  <c:v>2370.17</c:v>
                </c:pt>
                <c:pt idx="14478">
                  <c:v>5097.82</c:v>
                </c:pt>
                <c:pt idx="14482">
                  <c:v>8533.2999999999993</c:v>
                </c:pt>
                <c:pt idx="14483">
                  <c:v>5298.91</c:v>
                </c:pt>
                <c:pt idx="14485">
                  <c:v>2689.63</c:v>
                </c:pt>
                <c:pt idx="14489">
                  <c:v>4697.3500000000004</c:v>
                </c:pt>
                <c:pt idx="14492">
                  <c:v>6095.3</c:v>
                </c:pt>
                <c:pt idx="14495">
                  <c:v>3004.13</c:v>
                </c:pt>
                <c:pt idx="14496">
                  <c:v>2685.1</c:v>
                </c:pt>
                <c:pt idx="14497">
                  <c:v>5528.74</c:v>
                </c:pt>
                <c:pt idx="14498">
                  <c:v>7824.17</c:v>
                </c:pt>
                <c:pt idx="14507">
                  <c:v>4138.78</c:v>
                </c:pt>
                <c:pt idx="14518">
                  <c:v>3769.85</c:v>
                </c:pt>
                <c:pt idx="14522">
                  <c:v>2971.3</c:v>
                </c:pt>
                <c:pt idx="14525">
                  <c:v>6093.58</c:v>
                </c:pt>
                <c:pt idx="14526">
                  <c:v>5916.46</c:v>
                </c:pt>
                <c:pt idx="14530">
                  <c:v>4771.01</c:v>
                </c:pt>
                <c:pt idx="14532">
                  <c:v>4009.61</c:v>
                </c:pt>
                <c:pt idx="14535">
                  <c:v>5218.78</c:v>
                </c:pt>
                <c:pt idx="14536">
                  <c:v>4273.5600000000004</c:v>
                </c:pt>
                <c:pt idx="14540">
                  <c:v>5435.21</c:v>
                </c:pt>
                <c:pt idx="14542">
                  <c:v>10267.1</c:v>
                </c:pt>
                <c:pt idx="14549">
                  <c:v>2554.63</c:v>
                </c:pt>
                <c:pt idx="14550">
                  <c:v>3197.45</c:v>
                </c:pt>
                <c:pt idx="14554">
                  <c:v>4904.5</c:v>
                </c:pt>
                <c:pt idx="14555">
                  <c:v>6011.06</c:v>
                </c:pt>
                <c:pt idx="14556">
                  <c:v>7806.46</c:v>
                </c:pt>
                <c:pt idx="14557">
                  <c:v>4080.24</c:v>
                </c:pt>
                <c:pt idx="14560">
                  <c:v>3977.21</c:v>
                </c:pt>
                <c:pt idx="14564">
                  <c:v>3688.42</c:v>
                </c:pt>
                <c:pt idx="14565">
                  <c:v>9732.9599999999991</c:v>
                </c:pt>
                <c:pt idx="14569">
                  <c:v>5411.45</c:v>
                </c:pt>
                <c:pt idx="14571">
                  <c:v>4812.7</c:v>
                </c:pt>
                <c:pt idx="14574">
                  <c:v>4791.96</c:v>
                </c:pt>
                <c:pt idx="14579">
                  <c:v>4790.2299999999996</c:v>
                </c:pt>
                <c:pt idx="14582">
                  <c:v>5353.56</c:v>
                </c:pt>
                <c:pt idx="14586">
                  <c:v>3891.24</c:v>
                </c:pt>
                <c:pt idx="14598">
                  <c:v>3320.78</c:v>
                </c:pt>
                <c:pt idx="14605">
                  <c:v>2799.79</c:v>
                </c:pt>
                <c:pt idx="14606">
                  <c:v>3087.29</c:v>
                </c:pt>
                <c:pt idx="14608">
                  <c:v>9042.6200000000008</c:v>
                </c:pt>
                <c:pt idx="14616">
                  <c:v>3310.2</c:v>
                </c:pt>
                <c:pt idx="14623">
                  <c:v>3305.23</c:v>
                </c:pt>
                <c:pt idx="14624">
                  <c:v>3916.3</c:v>
                </c:pt>
                <c:pt idx="14626">
                  <c:v>4174.42</c:v>
                </c:pt>
                <c:pt idx="14629">
                  <c:v>61.344000000000001</c:v>
                </c:pt>
                <c:pt idx="14632">
                  <c:v>3119.9</c:v>
                </c:pt>
                <c:pt idx="14634">
                  <c:v>4147.42</c:v>
                </c:pt>
                <c:pt idx="14643">
                  <c:v>6796.44</c:v>
                </c:pt>
                <c:pt idx="14654">
                  <c:v>4067.93</c:v>
                </c:pt>
                <c:pt idx="14664">
                  <c:v>3392.5</c:v>
                </c:pt>
                <c:pt idx="14666">
                  <c:v>5412.74</c:v>
                </c:pt>
                <c:pt idx="14669">
                  <c:v>3180.82</c:v>
                </c:pt>
                <c:pt idx="14670">
                  <c:v>6555.17</c:v>
                </c:pt>
                <c:pt idx="14671">
                  <c:v>3485.38</c:v>
                </c:pt>
                <c:pt idx="14673">
                  <c:v>10384.200000000001</c:v>
                </c:pt>
                <c:pt idx="14678">
                  <c:v>4672.08</c:v>
                </c:pt>
                <c:pt idx="14680">
                  <c:v>3851.71</c:v>
                </c:pt>
                <c:pt idx="14682">
                  <c:v>3391.2</c:v>
                </c:pt>
                <c:pt idx="14683">
                  <c:v>2025</c:v>
                </c:pt>
                <c:pt idx="14685">
                  <c:v>2613.17</c:v>
                </c:pt>
                <c:pt idx="14686">
                  <c:v>2291.7600000000002</c:v>
                </c:pt>
                <c:pt idx="14690">
                  <c:v>5360.47</c:v>
                </c:pt>
                <c:pt idx="14702">
                  <c:v>4198.18</c:v>
                </c:pt>
                <c:pt idx="14705">
                  <c:v>8194.18</c:v>
                </c:pt>
                <c:pt idx="14713">
                  <c:v>3172.82</c:v>
                </c:pt>
                <c:pt idx="14717">
                  <c:v>4993.7</c:v>
                </c:pt>
                <c:pt idx="14721">
                  <c:v>5871.53</c:v>
                </c:pt>
                <c:pt idx="14723">
                  <c:v>6452.35</c:v>
                </c:pt>
                <c:pt idx="14726">
                  <c:v>2901.74</c:v>
                </c:pt>
                <c:pt idx="14729">
                  <c:v>3488.4</c:v>
                </c:pt>
                <c:pt idx="14732">
                  <c:v>5944.75</c:v>
                </c:pt>
                <c:pt idx="14734">
                  <c:v>3172.61</c:v>
                </c:pt>
                <c:pt idx="14736">
                  <c:v>2494.58</c:v>
                </c:pt>
                <c:pt idx="14742">
                  <c:v>2948.4</c:v>
                </c:pt>
                <c:pt idx="14745">
                  <c:v>3706.34</c:v>
                </c:pt>
                <c:pt idx="14749">
                  <c:v>3815.86</c:v>
                </c:pt>
                <c:pt idx="14754">
                  <c:v>3838.97</c:v>
                </c:pt>
                <c:pt idx="14760">
                  <c:v>2812.75</c:v>
                </c:pt>
                <c:pt idx="14763">
                  <c:v>5328.94</c:v>
                </c:pt>
                <c:pt idx="14765">
                  <c:v>6809.83</c:v>
                </c:pt>
                <c:pt idx="14771">
                  <c:v>2144.88</c:v>
                </c:pt>
                <c:pt idx="14774">
                  <c:v>5455.94</c:v>
                </c:pt>
                <c:pt idx="14776">
                  <c:v>7569.5</c:v>
                </c:pt>
                <c:pt idx="14780">
                  <c:v>5301.94</c:v>
                </c:pt>
                <c:pt idx="14785">
                  <c:v>7887.02</c:v>
                </c:pt>
                <c:pt idx="14790">
                  <c:v>5126.33</c:v>
                </c:pt>
                <c:pt idx="14791">
                  <c:v>4106.59</c:v>
                </c:pt>
                <c:pt idx="14795">
                  <c:v>6510.67</c:v>
                </c:pt>
                <c:pt idx="14796">
                  <c:v>3847.39</c:v>
                </c:pt>
                <c:pt idx="14798">
                  <c:v>6198.98</c:v>
                </c:pt>
                <c:pt idx="14806">
                  <c:v>5765.9</c:v>
                </c:pt>
                <c:pt idx="14811">
                  <c:v>3057.7</c:v>
                </c:pt>
                <c:pt idx="14812">
                  <c:v>4793.47</c:v>
                </c:pt>
                <c:pt idx="14814">
                  <c:v>3465.94</c:v>
                </c:pt>
                <c:pt idx="14815">
                  <c:v>4218.4799999999996</c:v>
                </c:pt>
                <c:pt idx="14816">
                  <c:v>5544.5</c:v>
                </c:pt>
                <c:pt idx="14819">
                  <c:v>3287.95</c:v>
                </c:pt>
                <c:pt idx="14820">
                  <c:v>3511.73</c:v>
                </c:pt>
                <c:pt idx="14822">
                  <c:v>5313.17</c:v>
                </c:pt>
                <c:pt idx="14823">
                  <c:v>5793.77</c:v>
                </c:pt>
                <c:pt idx="14829">
                  <c:v>3801.6</c:v>
                </c:pt>
                <c:pt idx="14830">
                  <c:v>6200.93</c:v>
                </c:pt>
                <c:pt idx="14835">
                  <c:v>5750.35</c:v>
                </c:pt>
                <c:pt idx="14839">
                  <c:v>6760.8</c:v>
                </c:pt>
                <c:pt idx="14842">
                  <c:v>6582.6</c:v>
                </c:pt>
                <c:pt idx="14846">
                  <c:v>5930.28</c:v>
                </c:pt>
                <c:pt idx="14847">
                  <c:v>4039.63</c:v>
                </c:pt>
                <c:pt idx="14848">
                  <c:v>2110.9699999999998</c:v>
                </c:pt>
                <c:pt idx="14849">
                  <c:v>3508.92</c:v>
                </c:pt>
                <c:pt idx="14851">
                  <c:v>2807.57</c:v>
                </c:pt>
                <c:pt idx="14852">
                  <c:v>5885.35</c:v>
                </c:pt>
                <c:pt idx="14854">
                  <c:v>5051.8100000000004</c:v>
                </c:pt>
                <c:pt idx="14856">
                  <c:v>2857.68</c:v>
                </c:pt>
                <c:pt idx="14858">
                  <c:v>4037.69</c:v>
                </c:pt>
                <c:pt idx="14860">
                  <c:v>4121.71</c:v>
                </c:pt>
                <c:pt idx="14861">
                  <c:v>3953.02</c:v>
                </c:pt>
                <c:pt idx="14866">
                  <c:v>3459.24</c:v>
                </c:pt>
                <c:pt idx="14873">
                  <c:v>3712.82</c:v>
                </c:pt>
                <c:pt idx="14885">
                  <c:v>1918.3</c:v>
                </c:pt>
                <c:pt idx="14886">
                  <c:v>2834.57</c:v>
                </c:pt>
                <c:pt idx="14887">
                  <c:v>1118.45</c:v>
                </c:pt>
                <c:pt idx="14893">
                  <c:v>4852.22</c:v>
                </c:pt>
                <c:pt idx="14894">
                  <c:v>5936.54</c:v>
                </c:pt>
                <c:pt idx="14906">
                  <c:v>5406.7</c:v>
                </c:pt>
                <c:pt idx="14911">
                  <c:v>6160.54</c:v>
                </c:pt>
                <c:pt idx="14918">
                  <c:v>4021.06</c:v>
                </c:pt>
                <c:pt idx="14924">
                  <c:v>4137.7</c:v>
                </c:pt>
                <c:pt idx="14928">
                  <c:v>6976.8</c:v>
                </c:pt>
                <c:pt idx="14933">
                  <c:v>3948.26</c:v>
                </c:pt>
                <c:pt idx="14934">
                  <c:v>7593.48</c:v>
                </c:pt>
                <c:pt idx="14936">
                  <c:v>4302.29</c:v>
                </c:pt>
                <c:pt idx="14940">
                  <c:v>4412.45</c:v>
                </c:pt>
                <c:pt idx="14944">
                  <c:v>3481.27</c:v>
                </c:pt>
                <c:pt idx="14946">
                  <c:v>3548.23</c:v>
                </c:pt>
                <c:pt idx="14951">
                  <c:v>5214.24</c:v>
                </c:pt>
                <c:pt idx="14953">
                  <c:v>2646.43</c:v>
                </c:pt>
                <c:pt idx="14958">
                  <c:v>3893.62</c:v>
                </c:pt>
                <c:pt idx="14963">
                  <c:v>5849.28</c:v>
                </c:pt>
                <c:pt idx="14966">
                  <c:v>6133.75</c:v>
                </c:pt>
                <c:pt idx="14971">
                  <c:v>4281.9799999999996</c:v>
                </c:pt>
                <c:pt idx="14972">
                  <c:v>3283.85</c:v>
                </c:pt>
                <c:pt idx="14974">
                  <c:v>4852.87</c:v>
                </c:pt>
                <c:pt idx="14981">
                  <c:v>4258.01</c:v>
                </c:pt>
                <c:pt idx="14986">
                  <c:v>4670.1400000000003</c:v>
                </c:pt>
                <c:pt idx="14994">
                  <c:v>3836.16</c:v>
                </c:pt>
                <c:pt idx="14995">
                  <c:v>4035.53</c:v>
                </c:pt>
                <c:pt idx="15000">
                  <c:v>3019.46</c:v>
                </c:pt>
                <c:pt idx="15006">
                  <c:v>8650.3700000000008</c:v>
                </c:pt>
                <c:pt idx="15007">
                  <c:v>6295.32</c:v>
                </c:pt>
                <c:pt idx="15008">
                  <c:v>4070.3</c:v>
                </c:pt>
                <c:pt idx="15010">
                  <c:v>4615.2700000000004</c:v>
                </c:pt>
                <c:pt idx="15011">
                  <c:v>4738.82</c:v>
                </c:pt>
                <c:pt idx="15012">
                  <c:v>2252.88</c:v>
                </c:pt>
                <c:pt idx="15014">
                  <c:v>5132.8100000000004</c:v>
                </c:pt>
                <c:pt idx="15019">
                  <c:v>3791.02</c:v>
                </c:pt>
                <c:pt idx="15020">
                  <c:v>4949.6400000000003</c:v>
                </c:pt>
                <c:pt idx="15023">
                  <c:v>4385.45</c:v>
                </c:pt>
                <c:pt idx="15025">
                  <c:v>5337.36</c:v>
                </c:pt>
                <c:pt idx="15027">
                  <c:v>3925.8</c:v>
                </c:pt>
                <c:pt idx="15033">
                  <c:v>3964.9</c:v>
                </c:pt>
                <c:pt idx="15034">
                  <c:v>4053.24</c:v>
                </c:pt>
                <c:pt idx="15036">
                  <c:v>4434.05</c:v>
                </c:pt>
                <c:pt idx="15038">
                  <c:v>4612.8999999999996</c:v>
                </c:pt>
                <c:pt idx="15041">
                  <c:v>4972.32</c:v>
                </c:pt>
                <c:pt idx="15047">
                  <c:v>7091.06</c:v>
                </c:pt>
                <c:pt idx="15049">
                  <c:v>9310.25</c:v>
                </c:pt>
                <c:pt idx="15055">
                  <c:v>3668.76</c:v>
                </c:pt>
                <c:pt idx="15060">
                  <c:v>3588.62</c:v>
                </c:pt>
                <c:pt idx="15061">
                  <c:v>4458.0200000000004</c:v>
                </c:pt>
                <c:pt idx="15068">
                  <c:v>4075.27</c:v>
                </c:pt>
                <c:pt idx="15069">
                  <c:v>5222.0200000000004</c:v>
                </c:pt>
                <c:pt idx="15072">
                  <c:v>5015.5200000000004</c:v>
                </c:pt>
                <c:pt idx="15075">
                  <c:v>5778.22</c:v>
                </c:pt>
                <c:pt idx="15079">
                  <c:v>3539.81</c:v>
                </c:pt>
                <c:pt idx="15084">
                  <c:v>6929.06</c:v>
                </c:pt>
                <c:pt idx="15086">
                  <c:v>7987.9</c:v>
                </c:pt>
                <c:pt idx="15087">
                  <c:v>3931.2</c:v>
                </c:pt>
                <c:pt idx="15092">
                  <c:v>7238.81</c:v>
                </c:pt>
                <c:pt idx="15099">
                  <c:v>3664.44</c:v>
                </c:pt>
                <c:pt idx="15101">
                  <c:v>7621.78</c:v>
                </c:pt>
                <c:pt idx="15104">
                  <c:v>4655.66</c:v>
                </c:pt>
                <c:pt idx="15105">
                  <c:v>7748.14</c:v>
                </c:pt>
                <c:pt idx="15106">
                  <c:v>4368.82</c:v>
                </c:pt>
                <c:pt idx="15107">
                  <c:v>7594.13</c:v>
                </c:pt>
                <c:pt idx="15112">
                  <c:v>3608.93</c:v>
                </c:pt>
                <c:pt idx="15117">
                  <c:v>3502.66</c:v>
                </c:pt>
                <c:pt idx="15129">
                  <c:v>6095.74</c:v>
                </c:pt>
                <c:pt idx="15130">
                  <c:v>4808.8100000000004</c:v>
                </c:pt>
                <c:pt idx="15132">
                  <c:v>3930.77</c:v>
                </c:pt>
                <c:pt idx="15133">
                  <c:v>3049.7</c:v>
                </c:pt>
                <c:pt idx="15135">
                  <c:v>4671.22</c:v>
                </c:pt>
                <c:pt idx="15137">
                  <c:v>4846.3900000000003</c:v>
                </c:pt>
                <c:pt idx="15143">
                  <c:v>4161.24</c:v>
                </c:pt>
                <c:pt idx="15147">
                  <c:v>3674.59</c:v>
                </c:pt>
                <c:pt idx="15148">
                  <c:v>4051.73</c:v>
                </c:pt>
                <c:pt idx="15151">
                  <c:v>4880.3</c:v>
                </c:pt>
                <c:pt idx="15152">
                  <c:v>3806.35</c:v>
                </c:pt>
                <c:pt idx="15157">
                  <c:v>3842.21</c:v>
                </c:pt>
                <c:pt idx="15167">
                  <c:v>4115.45</c:v>
                </c:pt>
                <c:pt idx="15171">
                  <c:v>5586.62</c:v>
                </c:pt>
                <c:pt idx="15172">
                  <c:v>5313.17</c:v>
                </c:pt>
                <c:pt idx="15178">
                  <c:v>6687.14</c:v>
                </c:pt>
                <c:pt idx="15179">
                  <c:v>4728.67</c:v>
                </c:pt>
                <c:pt idx="15184">
                  <c:v>4885.2700000000004</c:v>
                </c:pt>
                <c:pt idx="15185">
                  <c:v>3692.52</c:v>
                </c:pt>
                <c:pt idx="15186">
                  <c:v>4959.1400000000003</c:v>
                </c:pt>
                <c:pt idx="15200">
                  <c:v>3602.45</c:v>
                </c:pt>
                <c:pt idx="15202">
                  <c:v>7673.83</c:v>
                </c:pt>
                <c:pt idx="15205">
                  <c:v>4962.82</c:v>
                </c:pt>
                <c:pt idx="15207">
                  <c:v>4270.1000000000004</c:v>
                </c:pt>
                <c:pt idx="15218">
                  <c:v>2893.32</c:v>
                </c:pt>
                <c:pt idx="15219">
                  <c:v>6837.26</c:v>
                </c:pt>
                <c:pt idx="15220">
                  <c:v>5165.42</c:v>
                </c:pt>
                <c:pt idx="15225">
                  <c:v>4984.2</c:v>
                </c:pt>
                <c:pt idx="15230">
                  <c:v>5164.99</c:v>
                </c:pt>
                <c:pt idx="15240">
                  <c:v>1229.47</c:v>
                </c:pt>
                <c:pt idx="15242">
                  <c:v>3479.54</c:v>
                </c:pt>
                <c:pt idx="15243">
                  <c:v>5245.13</c:v>
                </c:pt>
                <c:pt idx="15246">
                  <c:v>4700.59</c:v>
                </c:pt>
                <c:pt idx="15248">
                  <c:v>3560.33</c:v>
                </c:pt>
                <c:pt idx="15250">
                  <c:v>7013.3</c:v>
                </c:pt>
                <c:pt idx="15251">
                  <c:v>4100.9799999999996</c:v>
                </c:pt>
                <c:pt idx="15254">
                  <c:v>8397</c:v>
                </c:pt>
                <c:pt idx="15256">
                  <c:v>3475.22</c:v>
                </c:pt>
                <c:pt idx="15257">
                  <c:v>5520.96</c:v>
                </c:pt>
                <c:pt idx="15260">
                  <c:v>7120.44</c:v>
                </c:pt>
                <c:pt idx="15267">
                  <c:v>5217.05</c:v>
                </c:pt>
                <c:pt idx="15271">
                  <c:v>7599.74</c:v>
                </c:pt>
                <c:pt idx="15273">
                  <c:v>5396.11</c:v>
                </c:pt>
                <c:pt idx="15275">
                  <c:v>4398.62</c:v>
                </c:pt>
                <c:pt idx="15284">
                  <c:v>6098.54</c:v>
                </c:pt>
                <c:pt idx="15288">
                  <c:v>5860.73</c:v>
                </c:pt>
                <c:pt idx="15290">
                  <c:v>4854.17</c:v>
                </c:pt>
                <c:pt idx="15292">
                  <c:v>5596.56</c:v>
                </c:pt>
                <c:pt idx="15293">
                  <c:v>5568.48</c:v>
                </c:pt>
                <c:pt idx="15296">
                  <c:v>4419.3599999999997</c:v>
                </c:pt>
                <c:pt idx="15297">
                  <c:v>5303.02</c:v>
                </c:pt>
                <c:pt idx="15298">
                  <c:v>6883.92</c:v>
                </c:pt>
                <c:pt idx="15301">
                  <c:v>3564.86</c:v>
                </c:pt>
                <c:pt idx="15303">
                  <c:v>4654.8</c:v>
                </c:pt>
                <c:pt idx="15310">
                  <c:v>4310.5</c:v>
                </c:pt>
                <c:pt idx="15312">
                  <c:v>4810.1000000000004</c:v>
                </c:pt>
                <c:pt idx="15321">
                  <c:v>5245.34</c:v>
                </c:pt>
                <c:pt idx="15326">
                  <c:v>6899.26</c:v>
                </c:pt>
                <c:pt idx="15327">
                  <c:v>4356.72</c:v>
                </c:pt>
                <c:pt idx="15328">
                  <c:v>6038.5</c:v>
                </c:pt>
                <c:pt idx="15332">
                  <c:v>6482.59</c:v>
                </c:pt>
                <c:pt idx="15335">
                  <c:v>7448.54</c:v>
                </c:pt>
                <c:pt idx="15337">
                  <c:v>5633.06</c:v>
                </c:pt>
                <c:pt idx="15345">
                  <c:v>6279.55</c:v>
                </c:pt>
                <c:pt idx="15350">
                  <c:v>2370.6</c:v>
                </c:pt>
                <c:pt idx="15351">
                  <c:v>7090.42</c:v>
                </c:pt>
                <c:pt idx="15353">
                  <c:v>5421.38</c:v>
                </c:pt>
                <c:pt idx="15354">
                  <c:v>4418.0600000000004</c:v>
                </c:pt>
                <c:pt idx="15358">
                  <c:v>6391.01</c:v>
                </c:pt>
                <c:pt idx="15359">
                  <c:v>4759.34</c:v>
                </c:pt>
                <c:pt idx="15361">
                  <c:v>8170.42</c:v>
                </c:pt>
                <c:pt idx="15364">
                  <c:v>2546.21</c:v>
                </c:pt>
                <c:pt idx="15369">
                  <c:v>6581.52</c:v>
                </c:pt>
                <c:pt idx="15370">
                  <c:v>5299.56</c:v>
                </c:pt>
                <c:pt idx="15376">
                  <c:v>3841.99</c:v>
                </c:pt>
                <c:pt idx="15379">
                  <c:v>3732.05</c:v>
                </c:pt>
                <c:pt idx="15380">
                  <c:v>6311.95</c:v>
                </c:pt>
                <c:pt idx="15382">
                  <c:v>6615.43</c:v>
                </c:pt>
                <c:pt idx="15385">
                  <c:v>6439.18</c:v>
                </c:pt>
                <c:pt idx="15393">
                  <c:v>3854.09</c:v>
                </c:pt>
                <c:pt idx="15396">
                  <c:v>6064.2</c:v>
                </c:pt>
                <c:pt idx="15399">
                  <c:v>4402.7299999999996</c:v>
                </c:pt>
                <c:pt idx="15403">
                  <c:v>5921.64</c:v>
                </c:pt>
                <c:pt idx="15404">
                  <c:v>3419.93</c:v>
                </c:pt>
                <c:pt idx="15420">
                  <c:v>4138.5600000000004</c:v>
                </c:pt>
                <c:pt idx="15422">
                  <c:v>5679.72</c:v>
                </c:pt>
                <c:pt idx="15425">
                  <c:v>5760.29</c:v>
                </c:pt>
                <c:pt idx="15426">
                  <c:v>7966.08</c:v>
                </c:pt>
                <c:pt idx="15428">
                  <c:v>6283.87</c:v>
                </c:pt>
                <c:pt idx="15432">
                  <c:v>4109.18</c:v>
                </c:pt>
                <c:pt idx="15434">
                  <c:v>8746.27</c:v>
                </c:pt>
                <c:pt idx="15441">
                  <c:v>6715.66</c:v>
                </c:pt>
                <c:pt idx="15444">
                  <c:v>6667.27</c:v>
                </c:pt>
                <c:pt idx="15449">
                  <c:v>6521.9</c:v>
                </c:pt>
                <c:pt idx="15451">
                  <c:v>7545.1</c:v>
                </c:pt>
                <c:pt idx="15465">
                  <c:v>3786.7</c:v>
                </c:pt>
                <c:pt idx="15468">
                  <c:v>5550.55</c:v>
                </c:pt>
                <c:pt idx="15473">
                  <c:v>5515.34</c:v>
                </c:pt>
                <c:pt idx="15477">
                  <c:v>5184.22</c:v>
                </c:pt>
                <c:pt idx="15483">
                  <c:v>5431.32</c:v>
                </c:pt>
                <c:pt idx="15488">
                  <c:v>3837.67</c:v>
                </c:pt>
                <c:pt idx="15495">
                  <c:v>4626.72</c:v>
                </c:pt>
                <c:pt idx="15497">
                  <c:v>4998.46</c:v>
                </c:pt>
                <c:pt idx="15506">
                  <c:v>7286.33</c:v>
                </c:pt>
                <c:pt idx="15507">
                  <c:v>5209.2700000000004</c:v>
                </c:pt>
                <c:pt idx="15512">
                  <c:v>5965.27</c:v>
                </c:pt>
                <c:pt idx="15513">
                  <c:v>6900.77</c:v>
                </c:pt>
                <c:pt idx="15516">
                  <c:v>3422.3</c:v>
                </c:pt>
                <c:pt idx="15517">
                  <c:v>5509.73</c:v>
                </c:pt>
                <c:pt idx="15526">
                  <c:v>6844.39</c:v>
                </c:pt>
                <c:pt idx="15531">
                  <c:v>5509.73</c:v>
                </c:pt>
                <c:pt idx="15533">
                  <c:v>4760.21</c:v>
                </c:pt>
                <c:pt idx="15535">
                  <c:v>6658.2</c:v>
                </c:pt>
                <c:pt idx="15537">
                  <c:v>2574.5</c:v>
                </c:pt>
                <c:pt idx="15538">
                  <c:v>5318.57</c:v>
                </c:pt>
                <c:pt idx="15539">
                  <c:v>5113.1499999999996</c:v>
                </c:pt>
                <c:pt idx="15540">
                  <c:v>3683.45</c:v>
                </c:pt>
                <c:pt idx="15544">
                  <c:v>5352.91</c:v>
                </c:pt>
                <c:pt idx="15547">
                  <c:v>7138.58</c:v>
                </c:pt>
                <c:pt idx="15555">
                  <c:v>11688.8</c:v>
                </c:pt>
                <c:pt idx="15558">
                  <c:v>2814.91</c:v>
                </c:pt>
                <c:pt idx="15559">
                  <c:v>7020.65</c:v>
                </c:pt>
                <c:pt idx="15560">
                  <c:v>4389.12</c:v>
                </c:pt>
                <c:pt idx="15563">
                  <c:v>4695.84</c:v>
                </c:pt>
                <c:pt idx="15564">
                  <c:v>5776.49</c:v>
                </c:pt>
                <c:pt idx="15565">
                  <c:v>7987.46</c:v>
                </c:pt>
                <c:pt idx="15570">
                  <c:v>4772.09</c:v>
                </c:pt>
                <c:pt idx="15572">
                  <c:v>2606.9</c:v>
                </c:pt>
                <c:pt idx="15577">
                  <c:v>5871.31</c:v>
                </c:pt>
                <c:pt idx="15581">
                  <c:v>6845.69</c:v>
                </c:pt>
                <c:pt idx="15586">
                  <c:v>5076.43</c:v>
                </c:pt>
                <c:pt idx="15589">
                  <c:v>5159.59</c:v>
                </c:pt>
                <c:pt idx="15596">
                  <c:v>4087.37</c:v>
                </c:pt>
                <c:pt idx="15598">
                  <c:v>6666.62</c:v>
                </c:pt>
                <c:pt idx="15599">
                  <c:v>6196.82</c:v>
                </c:pt>
                <c:pt idx="15602">
                  <c:v>15175.9</c:v>
                </c:pt>
                <c:pt idx="15604">
                  <c:v>3934.87</c:v>
                </c:pt>
                <c:pt idx="15615">
                  <c:v>6406.13</c:v>
                </c:pt>
                <c:pt idx="15616">
                  <c:v>3425.33</c:v>
                </c:pt>
                <c:pt idx="15620">
                  <c:v>6391.22</c:v>
                </c:pt>
                <c:pt idx="15622">
                  <c:v>4599.5</c:v>
                </c:pt>
                <c:pt idx="15626">
                  <c:v>12124.7</c:v>
                </c:pt>
                <c:pt idx="15633">
                  <c:v>5183.3500000000004</c:v>
                </c:pt>
                <c:pt idx="15635">
                  <c:v>5499.36</c:v>
                </c:pt>
                <c:pt idx="15644">
                  <c:v>5655.1</c:v>
                </c:pt>
                <c:pt idx="15645">
                  <c:v>5709.74</c:v>
                </c:pt>
                <c:pt idx="15650">
                  <c:v>11706.8</c:v>
                </c:pt>
                <c:pt idx="15655">
                  <c:v>7033.61</c:v>
                </c:pt>
                <c:pt idx="15656">
                  <c:v>5591.16</c:v>
                </c:pt>
                <c:pt idx="15658">
                  <c:v>5752.94</c:v>
                </c:pt>
                <c:pt idx="15660">
                  <c:v>6418.22</c:v>
                </c:pt>
                <c:pt idx="15664">
                  <c:v>4535.78</c:v>
                </c:pt>
                <c:pt idx="15666">
                  <c:v>6990.41</c:v>
                </c:pt>
                <c:pt idx="15678">
                  <c:v>4935.17</c:v>
                </c:pt>
                <c:pt idx="15679">
                  <c:v>5854.46</c:v>
                </c:pt>
                <c:pt idx="15680">
                  <c:v>4585.68</c:v>
                </c:pt>
                <c:pt idx="15686">
                  <c:v>10807.3</c:v>
                </c:pt>
                <c:pt idx="15688">
                  <c:v>8015.11</c:v>
                </c:pt>
                <c:pt idx="15694">
                  <c:v>6459.91</c:v>
                </c:pt>
                <c:pt idx="15695">
                  <c:v>4336.63</c:v>
                </c:pt>
                <c:pt idx="15698">
                  <c:v>5706.94</c:v>
                </c:pt>
                <c:pt idx="15699">
                  <c:v>7775.14</c:v>
                </c:pt>
                <c:pt idx="15700">
                  <c:v>6411.74</c:v>
                </c:pt>
                <c:pt idx="15704">
                  <c:v>4449.38</c:v>
                </c:pt>
                <c:pt idx="15714">
                  <c:v>5269.97</c:v>
                </c:pt>
                <c:pt idx="15716">
                  <c:v>7037.5</c:v>
                </c:pt>
                <c:pt idx="15718">
                  <c:v>2952.07</c:v>
                </c:pt>
                <c:pt idx="15719">
                  <c:v>5539.97</c:v>
                </c:pt>
                <c:pt idx="15727">
                  <c:v>8636.98</c:v>
                </c:pt>
                <c:pt idx="15729">
                  <c:v>6198.55</c:v>
                </c:pt>
                <c:pt idx="15735">
                  <c:v>6018.84</c:v>
                </c:pt>
                <c:pt idx="15736">
                  <c:v>3644.35</c:v>
                </c:pt>
                <c:pt idx="15737">
                  <c:v>6788.88</c:v>
                </c:pt>
                <c:pt idx="15745">
                  <c:v>3027.89</c:v>
                </c:pt>
                <c:pt idx="15746">
                  <c:v>7144.42</c:v>
                </c:pt>
                <c:pt idx="15747">
                  <c:v>3420.36</c:v>
                </c:pt>
                <c:pt idx="15756">
                  <c:v>5859</c:v>
                </c:pt>
                <c:pt idx="15757">
                  <c:v>5622.7</c:v>
                </c:pt>
                <c:pt idx="15769">
                  <c:v>6797.09</c:v>
                </c:pt>
                <c:pt idx="15777">
                  <c:v>6354.72</c:v>
                </c:pt>
                <c:pt idx="15778">
                  <c:v>7241.4</c:v>
                </c:pt>
                <c:pt idx="15779">
                  <c:v>4715.5</c:v>
                </c:pt>
                <c:pt idx="15780">
                  <c:v>5570.86</c:v>
                </c:pt>
                <c:pt idx="15782">
                  <c:v>6247.8</c:v>
                </c:pt>
                <c:pt idx="15786">
                  <c:v>4886.78</c:v>
                </c:pt>
                <c:pt idx="15790">
                  <c:v>16438</c:v>
                </c:pt>
                <c:pt idx="15798">
                  <c:v>9152.14</c:v>
                </c:pt>
                <c:pt idx="15801">
                  <c:v>10256.1</c:v>
                </c:pt>
                <c:pt idx="15809">
                  <c:v>6803.78</c:v>
                </c:pt>
                <c:pt idx="15812">
                  <c:v>9364.0300000000007</c:v>
                </c:pt>
                <c:pt idx="15815">
                  <c:v>6091.85</c:v>
                </c:pt>
                <c:pt idx="15825">
                  <c:v>5457.67</c:v>
                </c:pt>
                <c:pt idx="15826">
                  <c:v>4697.57</c:v>
                </c:pt>
                <c:pt idx="15831">
                  <c:v>8378.64</c:v>
                </c:pt>
                <c:pt idx="15834">
                  <c:v>7502.54</c:v>
                </c:pt>
                <c:pt idx="15835">
                  <c:v>10041.4</c:v>
                </c:pt>
                <c:pt idx="15836">
                  <c:v>10140.1</c:v>
                </c:pt>
                <c:pt idx="15842">
                  <c:v>3358.58</c:v>
                </c:pt>
                <c:pt idx="15843">
                  <c:v>6067.66</c:v>
                </c:pt>
                <c:pt idx="15850">
                  <c:v>5933.3</c:v>
                </c:pt>
                <c:pt idx="15855">
                  <c:v>8748.65</c:v>
                </c:pt>
                <c:pt idx="15869">
                  <c:v>4659.9799999999996</c:v>
                </c:pt>
                <c:pt idx="15870">
                  <c:v>5614.27</c:v>
                </c:pt>
                <c:pt idx="15872">
                  <c:v>615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6B8-4AC3-B3A4-179EA235EF24}"/>
            </c:ext>
          </c:extLst>
        </c:ser>
        <c:ser>
          <c:idx val="4"/>
          <c:order val="3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>
                  <a:alpha val="70000"/>
                </a:srgbClr>
              </a:solidFill>
              <a:ln w="9525">
                <a:noFill/>
              </a:ln>
              <a:effectLst/>
            </c:spPr>
          </c:marker>
          <c:yVal>
            <c:numRef>
              <c:f>'full root volumes'!$E$1:$E$15874</c:f>
              <c:numCache>
                <c:formatCode>General</c:formatCode>
                <c:ptCount val="15874"/>
                <c:pt idx="2">
                  <c:v>692.28</c:v>
                </c:pt>
                <c:pt idx="5">
                  <c:v>1025.3499999999999</c:v>
                </c:pt>
                <c:pt idx="11">
                  <c:v>718.41600000000005</c:v>
                </c:pt>
                <c:pt idx="12">
                  <c:v>613.65599999999995</c:v>
                </c:pt>
                <c:pt idx="18">
                  <c:v>1648.51</c:v>
                </c:pt>
                <c:pt idx="21">
                  <c:v>1018.66</c:v>
                </c:pt>
                <c:pt idx="24">
                  <c:v>979.99199999999996</c:v>
                </c:pt>
                <c:pt idx="25">
                  <c:v>856.87199999999996</c:v>
                </c:pt>
                <c:pt idx="28">
                  <c:v>716.904</c:v>
                </c:pt>
                <c:pt idx="29">
                  <c:v>816.91200000000003</c:v>
                </c:pt>
                <c:pt idx="32">
                  <c:v>875.23199999999997</c:v>
                </c:pt>
                <c:pt idx="33">
                  <c:v>429.40800000000002</c:v>
                </c:pt>
                <c:pt idx="34">
                  <c:v>1453.9</c:v>
                </c:pt>
                <c:pt idx="36">
                  <c:v>598.96799999999996</c:v>
                </c:pt>
                <c:pt idx="38">
                  <c:v>1131.4100000000001</c:v>
                </c:pt>
                <c:pt idx="41">
                  <c:v>635.25599999999997</c:v>
                </c:pt>
                <c:pt idx="43">
                  <c:v>250.34399999999999</c:v>
                </c:pt>
                <c:pt idx="44">
                  <c:v>841.53599999999994</c:v>
                </c:pt>
                <c:pt idx="46">
                  <c:v>836.35199999999998</c:v>
                </c:pt>
                <c:pt idx="47">
                  <c:v>528.12</c:v>
                </c:pt>
                <c:pt idx="49">
                  <c:v>1014.77</c:v>
                </c:pt>
                <c:pt idx="54">
                  <c:v>815.18399999999997</c:v>
                </c:pt>
                <c:pt idx="55">
                  <c:v>907.84799999999996</c:v>
                </c:pt>
                <c:pt idx="56">
                  <c:v>420.33600000000001</c:v>
                </c:pt>
                <c:pt idx="58">
                  <c:v>3560.54</c:v>
                </c:pt>
                <c:pt idx="59">
                  <c:v>810</c:v>
                </c:pt>
                <c:pt idx="60">
                  <c:v>1317.38</c:v>
                </c:pt>
                <c:pt idx="70">
                  <c:v>828.14400000000001</c:v>
                </c:pt>
                <c:pt idx="77">
                  <c:v>736.77599999999995</c:v>
                </c:pt>
                <c:pt idx="78">
                  <c:v>1091.6600000000001</c:v>
                </c:pt>
                <c:pt idx="82">
                  <c:v>470.01600000000002</c:v>
                </c:pt>
                <c:pt idx="83">
                  <c:v>1047.82</c:v>
                </c:pt>
                <c:pt idx="84">
                  <c:v>579.96</c:v>
                </c:pt>
                <c:pt idx="88">
                  <c:v>487.512</c:v>
                </c:pt>
                <c:pt idx="89">
                  <c:v>1149.55</c:v>
                </c:pt>
                <c:pt idx="91">
                  <c:v>1019.3</c:v>
                </c:pt>
                <c:pt idx="94">
                  <c:v>1016.93</c:v>
                </c:pt>
                <c:pt idx="96">
                  <c:v>591.62400000000002</c:v>
                </c:pt>
                <c:pt idx="97">
                  <c:v>452.30399999999997</c:v>
                </c:pt>
                <c:pt idx="99">
                  <c:v>809.13599999999997</c:v>
                </c:pt>
                <c:pt idx="101">
                  <c:v>1331.86</c:v>
                </c:pt>
                <c:pt idx="102">
                  <c:v>1123.42</c:v>
                </c:pt>
                <c:pt idx="105">
                  <c:v>2529.58</c:v>
                </c:pt>
                <c:pt idx="107">
                  <c:v>934.84799999999996</c:v>
                </c:pt>
                <c:pt idx="108">
                  <c:v>964.87199999999996</c:v>
                </c:pt>
                <c:pt idx="110">
                  <c:v>420.33600000000001</c:v>
                </c:pt>
                <c:pt idx="116">
                  <c:v>869.83199999999999</c:v>
                </c:pt>
                <c:pt idx="118">
                  <c:v>1694.09</c:v>
                </c:pt>
                <c:pt idx="119">
                  <c:v>699.62400000000002</c:v>
                </c:pt>
                <c:pt idx="124">
                  <c:v>899.64</c:v>
                </c:pt>
                <c:pt idx="125">
                  <c:v>1134.8599999999999</c:v>
                </c:pt>
                <c:pt idx="127">
                  <c:v>703.72799999999995</c:v>
                </c:pt>
                <c:pt idx="131">
                  <c:v>1186.92</c:v>
                </c:pt>
                <c:pt idx="132">
                  <c:v>336.096</c:v>
                </c:pt>
                <c:pt idx="133">
                  <c:v>995.32799999999997</c:v>
                </c:pt>
                <c:pt idx="137">
                  <c:v>931.17600000000004</c:v>
                </c:pt>
                <c:pt idx="138">
                  <c:v>748.00800000000004</c:v>
                </c:pt>
                <c:pt idx="142">
                  <c:v>1167.05</c:v>
                </c:pt>
                <c:pt idx="146">
                  <c:v>883.65599999999995</c:v>
                </c:pt>
                <c:pt idx="149">
                  <c:v>1200.31</c:v>
                </c:pt>
                <c:pt idx="152">
                  <c:v>881.928</c:v>
                </c:pt>
                <c:pt idx="156">
                  <c:v>906.55200000000002</c:v>
                </c:pt>
                <c:pt idx="160">
                  <c:v>770.25599999999997</c:v>
                </c:pt>
                <c:pt idx="166">
                  <c:v>1426.9</c:v>
                </c:pt>
                <c:pt idx="167">
                  <c:v>673.27200000000005</c:v>
                </c:pt>
                <c:pt idx="171">
                  <c:v>683.20799999999997</c:v>
                </c:pt>
                <c:pt idx="173">
                  <c:v>848.01599999999996</c:v>
                </c:pt>
                <c:pt idx="174">
                  <c:v>642.38400000000001</c:v>
                </c:pt>
                <c:pt idx="176">
                  <c:v>878.25599999999997</c:v>
                </c:pt>
                <c:pt idx="181">
                  <c:v>1051.06</c:v>
                </c:pt>
                <c:pt idx="183">
                  <c:v>882.14400000000001</c:v>
                </c:pt>
                <c:pt idx="185">
                  <c:v>1014.55</c:v>
                </c:pt>
                <c:pt idx="188">
                  <c:v>639.14400000000001</c:v>
                </c:pt>
                <c:pt idx="190">
                  <c:v>399.81599999999997</c:v>
                </c:pt>
                <c:pt idx="191">
                  <c:v>804.6</c:v>
                </c:pt>
                <c:pt idx="193">
                  <c:v>813.67200000000003</c:v>
                </c:pt>
                <c:pt idx="195">
                  <c:v>1276.3399999999999</c:v>
                </c:pt>
                <c:pt idx="198">
                  <c:v>1153.6600000000001</c:v>
                </c:pt>
                <c:pt idx="200">
                  <c:v>1354.32</c:v>
                </c:pt>
                <c:pt idx="201">
                  <c:v>653.18399999999997</c:v>
                </c:pt>
                <c:pt idx="203">
                  <c:v>2064.96</c:v>
                </c:pt>
                <c:pt idx="205">
                  <c:v>497.88</c:v>
                </c:pt>
                <c:pt idx="208">
                  <c:v>882.79200000000003</c:v>
                </c:pt>
                <c:pt idx="213">
                  <c:v>595.72799999999995</c:v>
                </c:pt>
                <c:pt idx="217">
                  <c:v>719.06399999999996</c:v>
                </c:pt>
                <c:pt idx="218">
                  <c:v>960.55200000000002</c:v>
                </c:pt>
                <c:pt idx="220">
                  <c:v>627.48</c:v>
                </c:pt>
                <c:pt idx="222">
                  <c:v>888.84</c:v>
                </c:pt>
                <c:pt idx="230">
                  <c:v>1696.25</c:v>
                </c:pt>
                <c:pt idx="245">
                  <c:v>949.10400000000004</c:v>
                </c:pt>
                <c:pt idx="247">
                  <c:v>871.34400000000005</c:v>
                </c:pt>
                <c:pt idx="253">
                  <c:v>1368.14</c:v>
                </c:pt>
                <c:pt idx="255">
                  <c:v>1033.1300000000001</c:v>
                </c:pt>
                <c:pt idx="257">
                  <c:v>939.38400000000001</c:v>
                </c:pt>
                <c:pt idx="258">
                  <c:v>1123.2</c:v>
                </c:pt>
                <c:pt idx="259">
                  <c:v>3608.28</c:v>
                </c:pt>
                <c:pt idx="264">
                  <c:v>1308.74</c:v>
                </c:pt>
                <c:pt idx="266">
                  <c:v>831.38400000000001</c:v>
                </c:pt>
                <c:pt idx="271">
                  <c:v>905.47199999999998</c:v>
                </c:pt>
                <c:pt idx="273">
                  <c:v>622.08000000000004</c:v>
                </c:pt>
                <c:pt idx="275">
                  <c:v>1066.3900000000001</c:v>
                </c:pt>
                <c:pt idx="276">
                  <c:v>866.16</c:v>
                </c:pt>
                <c:pt idx="281">
                  <c:v>4602.96</c:v>
                </c:pt>
                <c:pt idx="285">
                  <c:v>740.44799999999998</c:v>
                </c:pt>
                <c:pt idx="289">
                  <c:v>481.68</c:v>
                </c:pt>
                <c:pt idx="290">
                  <c:v>876.96</c:v>
                </c:pt>
                <c:pt idx="293">
                  <c:v>977.61599999999999</c:v>
                </c:pt>
                <c:pt idx="294">
                  <c:v>690.76800000000003</c:v>
                </c:pt>
                <c:pt idx="295">
                  <c:v>1361.23</c:v>
                </c:pt>
                <c:pt idx="297">
                  <c:v>671.32799999999997</c:v>
                </c:pt>
                <c:pt idx="298">
                  <c:v>1042.8499999999999</c:v>
                </c:pt>
                <c:pt idx="299">
                  <c:v>632.66399999999999</c:v>
                </c:pt>
                <c:pt idx="300">
                  <c:v>757.51199999999994</c:v>
                </c:pt>
                <c:pt idx="303">
                  <c:v>11819.7</c:v>
                </c:pt>
                <c:pt idx="304">
                  <c:v>981.50400000000002</c:v>
                </c:pt>
                <c:pt idx="308">
                  <c:v>665.71199999999999</c:v>
                </c:pt>
                <c:pt idx="310">
                  <c:v>3179.74</c:v>
                </c:pt>
                <c:pt idx="313">
                  <c:v>163.08000000000001</c:v>
                </c:pt>
                <c:pt idx="314">
                  <c:v>1689.12</c:v>
                </c:pt>
                <c:pt idx="321">
                  <c:v>1099.22</c:v>
                </c:pt>
                <c:pt idx="323">
                  <c:v>1249.78</c:v>
                </c:pt>
                <c:pt idx="324">
                  <c:v>1833.84</c:v>
                </c:pt>
                <c:pt idx="325">
                  <c:v>822.52800000000002</c:v>
                </c:pt>
                <c:pt idx="326">
                  <c:v>678.88800000000003</c:v>
                </c:pt>
                <c:pt idx="333">
                  <c:v>1119.53</c:v>
                </c:pt>
                <c:pt idx="335">
                  <c:v>1185.4100000000001</c:v>
                </c:pt>
                <c:pt idx="338">
                  <c:v>560.30399999999997</c:v>
                </c:pt>
                <c:pt idx="339">
                  <c:v>769.82399999999996</c:v>
                </c:pt>
                <c:pt idx="347">
                  <c:v>906.12</c:v>
                </c:pt>
                <c:pt idx="349">
                  <c:v>646.91999999999996</c:v>
                </c:pt>
                <c:pt idx="350">
                  <c:v>926.64</c:v>
                </c:pt>
                <c:pt idx="351">
                  <c:v>906.55200000000002</c:v>
                </c:pt>
                <c:pt idx="352">
                  <c:v>60.911999999999999</c:v>
                </c:pt>
                <c:pt idx="353">
                  <c:v>616.24800000000005</c:v>
                </c:pt>
                <c:pt idx="354">
                  <c:v>1361.88</c:v>
                </c:pt>
                <c:pt idx="358">
                  <c:v>408.67200000000003</c:v>
                </c:pt>
                <c:pt idx="362">
                  <c:v>791.64</c:v>
                </c:pt>
                <c:pt idx="371">
                  <c:v>819.072</c:v>
                </c:pt>
                <c:pt idx="372">
                  <c:v>483.62400000000002</c:v>
                </c:pt>
                <c:pt idx="374">
                  <c:v>627.91200000000003</c:v>
                </c:pt>
                <c:pt idx="382">
                  <c:v>1222.3399999999999</c:v>
                </c:pt>
                <c:pt idx="387">
                  <c:v>1389.1</c:v>
                </c:pt>
                <c:pt idx="388">
                  <c:v>352.29599999999999</c:v>
                </c:pt>
                <c:pt idx="390">
                  <c:v>1010.23</c:v>
                </c:pt>
                <c:pt idx="391">
                  <c:v>1102.46</c:v>
                </c:pt>
                <c:pt idx="392">
                  <c:v>1157.98</c:v>
                </c:pt>
                <c:pt idx="393">
                  <c:v>327.45600000000002</c:v>
                </c:pt>
                <c:pt idx="398">
                  <c:v>984.74400000000003</c:v>
                </c:pt>
                <c:pt idx="402">
                  <c:v>1035.72</c:v>
                </c:pt>
                <c:pt idx="404">
                  <c:v>1057.75</c:v>
                </c:pt>
                <c:pt idx="407">
                  <c:v>575.42399999999998</c:v>
                </c:pt>
                <c:pt idx="408">
                  <c:v>1011.53</c:v>
                </c:pt>
                <c:pt idx="412">
                  <c:v>797.904</c:v>
                </c:pt>
                <c:pt idx="413">
                  <c:v>647.35199999999998</c:v>
                </c:pt>
                <c:pt idx="416">
                  <c:v>785.16</c:v>
                </c:pt>
                <c:pt idx="425">
                  <c:v>975.024</c:v>
                </c:pt>
                <c:pt idx="426">
                  <c:v>986.68799999999999</c:v>
                </c:pt>
                <c:pt idx="427">
                  <c:v>1186.27</c:v>
                </c:pt>
                <c:pt idx="429">
                  <c:v>734.4</c:v>
                </c:pt>
                <c:pt idx="430">
                  <c:v>1053</c:v>
                </c:pt>
                <c:pt idx="432">
                  <c:v>583.63199999999995</c:v>
                </c:pt>
                <c:pt idx="436">
                  <c:v>775.22400000000005</c:v>
                </c:pt>
                <c:pt idx="450">
                  <c:v>725.11199999999997</c:v>
                </c:pt>
                <c:pt idx="456">
                  <c:v>1101.5999999999999</c:v>
                </c:pt>
                <c:pt idx="457">
                  <c:v>1001.16</c:v>
                </c:pt>
                <c:pt idx="460">
                  <c:v>878.904</c:v>
                </c:pt>
                <c:pt idx="461">
                  <c:v>737.42399999999998</c:v>
                </c:pt>
                <c:pt idx="462">
                  <c:v>1187.3499999999999</c:v>
                </c:pt>
                <c:pt idx="465">
                  <c:v>1201.3900000000001</c:v>
                </c:pt>
                <c:pt idx="466">
                  <c:v>3789.07</c:v>
                </c:pt>
                <c:pt idx="468">
                  <c:v>838.29600000000005</c:v>
                </c:pt>
                <c:pt idx="471">
                  <c:v>650.37599999999998</c:v>
                </c:pt>
                <c:pt idx="472">
                  <c:v>2102.33</c:v>
                </c:pt>
                <c:pt idx="475">
                  <c:v>1180.6600000000001</c:v>
                </c:pt>
                <c:pt idx="479">
                  <c:v>1008.5</c:v>
                </c:pt>
                <c:pt idx="481">
                  <c:v>554.47199999999998</c:v>
                </c:pt>
                <c:pt idx="485">
                  <c:v>870.048</c:v>
                </c:pt>
                <c:pt idx="488">
                  <c:v>753.19200000000001</c:v>
                </c:pt>
                <c:pt idx="491">
                  <c:v>1117.1500000000001</c:v>
                </c:pt>
                <c:pt idx="492">
                  <c:v>1547.64</c:v>
                </c:pt>
                <c:pt idx="493">
                  <c:v>798.12</c:v>
                </c:pt>
                <c:pt idx="496">
                  <c:v>603.50400000000002</c:v>
                </c:pt>
                <c:pt idx="498">
                  <c:v>1091.6600000000001</c:v>
                </c:pt>
                <c:pt idx="502">
                  <c:v>1369.01</c:v>
                </c:pt>
                <c:pt idx="505">
                  <c:v>1306.58</c:v>
                </c:pt>
                <c:pt idx="509">
                  <c:v>775.44</c:v>
                </c:pt>
                <c:pt idx="511">
                  <c:v>818.42399999999998</c:v>
                </c:pt>
                <c:pt idx="515">
                  <c:v>1172.23</c:v>
                </c:pt>
                <c:pt idx="517">
                  <c:v>1711.8</c:v>
                </c:pt>
                <c:pt idx="521">
                  <c:v>835.27200000000005</c:v>
                </c:pt>
                <c:pt idx="522">
                  <c:v>880.84799999999996</c:v>
                </c:pt>
                <c:pt idx="526">
                  <c:v>500.04</c:v>
                </c:pt>
                <c:pt idx="527">
                  <c:v>746.71199999999999</c:v>
                </c:pt>
                <c:pt idx="529">
                  <c:v>581.904</c:v>
                </c:pt>
                <c:pt idx="530">
                  <c:v>909.14400000000001</c:v>
                </c:pt>
                <c:pt idx="533">
                  <c:v>1109.3800000000001</c:v>
                </c:pt>
                <c:pt idx="548">
                  <c:v>1088.42</c:v>
                </c:pt>
                <c:pt idx="551">
                  <c:v>1437.05</c:v>
                </c:pt>
                <c:pt idx="562">
                  <c:v>1418.26</c:v>
                </c:pt>
                <c:pt idx="567">
                  <c:v>1278.5</c:v>
                </c:pt>
                <c:pt idx="570">
                  <c:v>899.64</c:v>
                </c:pt>
                <c:pt idx="572">
                  <c:v>1259.71</c:v>
                </c:pt>
                <c:pt idx="573">
                  <c:v>1496.66</c:v>
                </c:pt>
                <c:pt idx="575">
                  <c:v>536.11199999999997</c:v>
                </c:pt>
                <c:pt idx="576">
                  <c:v>1259.5</c:v>
                </c:pt>
                <c:pt idx="581">
                  <c:v>624.24</c:v>
                </c:pt>
                <c:pt idx="582">
                  <c:v>903.96</c:v>
                </c:pt>
                <c:pt idx="584">
                  <c:v>398.73599999999999</c:v>
                </c:pt>
                <c:pt idx="585">
                  <c:v>876.96</c:v>
                </c:pt>
                <c:pt idx="590">
                  <c:v>1127.3</c:v>
                </c:pt>
                <c:pt idx="592">
                  <c:v>1121.47</c:v>
                </c:pt>
                <c:pt idx="597">
                  <c:v>497.88</c:v>
                </c:pt>
                <c:pt idx="600">
                  <c:v>1482.41</c:v>
                </c:pt>
                <c:pt idx="602">
                  <c:v>2005.56</c:v>
                </c:pt>
                <c:pt idx="603">
                  <c:v>1134.8599999999999</c:v>
                </c:pt>
                <c:pt idx="607">
                  <c:v>1072.44</c:v>
                </c:pt>
                <c:pt idx="609">
                  <c:v>1709.64</c:v>
                </c:pt>
                <c:pt idx="611">
                  <c:v>761.83199999999999</c:v>
                </c:pt>
                <c:pt idx="614">
                  <c:v>357.48</c:v>
                </c:pt>
                <c:pt idx="620">
                  <c:v>1089.5</c:v>
                </c:pt>
                <c:pt idx="621">
                  <c:v>977.61599999999999</c:v>
                </c:pt>
                <c:pt idx="623">
                  <c:v>761.61599999999999</c:v>
                </c:pt>
                <c:pt idx="629">
                  <c:v>958.82399999999996</c:v>
                </c:pt>
                <c:pt idx="637">
                  <c:v>1143.5</c:v>
                </c:pt>
                <c:pt idx="638">
                  <c:v>793.8</c:v>
                </c:pt>
                <c:pt idx="639">
                  <c:v>551.88</c:v>
                </c:pt>
                <c:pt idx="640">
                  <c:v>853.41600000000005</c:v>
                </c:pt>
                <c:pt idx="641">
                  <c:v>648.64800000000002</c:v>
                </c:pt>
                <c:pt idx="643">
                  <c:v>1096.2</c:v>
                </c:pt>
                <c:pt idx="648">
                  <c:v>1526.9</c:v>
                </c:pt>
                <c:pt idx="649">
                  <c:v>1419.98</c:v>
                </c:pt>
                <c:pt idx="653">
                  <c:v>957.096</c:v>
                </c:pt>
                <c:pt idx="655">
                  <c:v>1881.58</c:v>
                </c:pt>
                <c:pt idx="656">
                  <c:v>776.73599999999999</c:v>
                </c:pt>
                <c:pt idx="657">
                  <c:v>971.35199999999998</c:v>
                </c:pt>
                <c:pt idx="659">
                  <c:v>178.2</c:v>
                </c:pt>
                <c:pt idx="665">
                  <c:v>1246.54</c:v>
                </c:pt>
                <c:pt idx="669">
                  <c:v>1182.82</c:v>
                </c:pt>
                <c:pt idx="674">
                  <c:v>932.47199999999998</c:v>
                </c:pt>
                <c:pt idx="680">
                  <c:v>1541.16</c:v>
                </c:pt>
                <c:pt idx="681">
                  <c:v>595.94399999999996</c:v>
                </c:pt>
                <c:pt idx="683">
                  <c:v>1077.19</c:v>
                </c:pt>
                <c:pt idx="684">
                  <c:v>1341.36</c:v>
                </c:pt>
                <c:pt idx="686">
                  <c:v>561.38400000000001</c:v>
                </c:pt>
                <c:pt idx="694">
                  <c:v>1055.5899999999999</c:v>
                </c:pt>
                <c:pt idx="697">
                  <c:v>528.55200000000002</c:v>
                </c:pt>
                <c:pt idx="700">
                  <c:v>664.84799999999996</c:v>
                </c:pt>
                <c:pt idx="701">
                  <c:v>631.36800000000005</c:v>
                </c:pt>
                <c:pt idx="703">
                  <c:v>1627.34</c:v>
                </c:pt>
                <c:pt idx="705">
                  <c:v>892.72799999999995</c:v>
                </c:pt>
                <c:pt idx="709">
                  <c:v>1180.44</c:v>
                </c:pt>
                <c:pt idx="710">
                  <c:v>1468.58</c:v>
                </c:pt>
                <c:pt idx="711">
                  <c:v>887.54399999999998</c:v>
                </c:pt>
                <c:pt idx="716">
                  <c:v>1114.78</c:v>
                </c:pt>
                <c:pt idx="717">
                  <c:v>784.72799999999995</c:v>
                </c:pt>
                <c:pt idx="721">
                  <c:v>685.8</c:v>
                </c:pt>
                <c:pt idx="724">
                  <c:v>993.38400000000001</c:v>
                </c:pt>
                <c:pt idx="725">
                  <c:v>1054.51</c:v>
                </c:pt>
                <c:pt idx="726">
                  <c:v>312.55200000000002</c:v>
                </c:pt>
                <c:pt idx="730">
                  <c:v>1162.94</c:v>
                </c:pt>
                <c:pt idx="731">
                  <c:v>271.512</c:v>
                </c:pt>
                <c:pt idx="739">
                  <c:v>962.928</c:v>
                </c:pt>
                <c:pt idx="743">
                  <c:v>775.44</c:v>
                </c:pt>
                <c:pt idx="744">
                  <c:v>793.8</c:v>
                </c:pt>
                <c:pt idx="745">
                  <c:v>671.32799999999997</c:v>
                </c:pt>
                <c:pt idx="746">
                  <c:v>1489.75</c:v>
                </c:pt>
                <c:pt idx="751">
                  <c:v>1259.93</c:v>
                </c:pt>
                <c:pt idx="758">
                  <c:v>781.05600000000004</c:v>
                </c:pt>
                <c:pt idx="765">
                  <c:v>763.77599999999995</c:v>
                </c:pt>
                <c:pt idx="766">
                  <c:v>1305.72</c:v>
                </c:pt>
                <c:pt idx="771">
                  <c:v>849.31200000000001</c:v>
                </c:pt>
                <c:pt idx="776">
                  <c:v>1115.6400000000001</c:v>
                </c:pt>
                <c:pt idx="777">
                  <c:v>1263.17</c:v>
                </c:pt>
                <c:pt idx="778">
                  <c:v>474.55200000000002</c:v>
                </c:pt>
                <c:pt idx="780">
                  <c:v>692.28</c:v>
                </c:pt>
                <c:pt idx="781">
                  <c:v>1371.38</c:v>
                </c:pt>
                <c:pt idx="783">
                  <c:v>857.52</c:v>
                </c:pt>
                <c:pt idx="787">
                  <c:v>767.44799999999998</c:v>
                </c:pt>
                <c:pt idx="789">
                  <c:v>381.45600000000002</c:v>
                </c:pt>
                <c:pt idx="790">
                  <c:v>996.84</c:v>
                </c:pt>
                <c:pt idx="799">
                  <c:v>1527.77</c:v>
                </c:pt>
                <c:pt idx="803">
                  <c:v>1348.92</c:v>
                </c:pt>
                <c:pt idx="811">
                  <c:v>2539.08</c:v>
                </c:pt>
                <c:pt idx="817">
                  <c:v>903.31200000000001</c:v>
                </c:pt>
                <c:pt idx="820">
                  <c:v>1307.6600000000001</c:v>
                </c:pt>
                <c:pt idx="826">
                  <c:v>968.54399999999998</c:v>
                </c:pt>
                <c:pt idx="829">
                  <c:v>1452.82</c:v>
                </c:pt>
                <c:pt idx="831">
                  <c:v>1153.44</c:v>
                </c:pt>
                <c:pt idx="833">
                  <c:v>1265.54</c:v>
                </c:pt>
                <c:pt idx="836">
                  <c:v>1130.54</c:v>
                </c:pt>
                <c:pt idx="846">
                  <c:v>521.85599999999999</c:v>
                </c:pt>
                <c:pt idx="849">
                  <c:v>423.79199999999997</c:v>
                </c:pt>
                <c:pt idx="850">
                  <c:v>6664.46</c:v>
                </c:pt>
                <c:pt idx="851">
                  <c:v>930.52800000000002</c:v>
                </c:pt>
                <c:pt idx="855">
                  <c:v>1294.49</c:v>
                </c:pt>
                <c:pt idx="856">
                  <c:v>1037.8800000000001</c:v>
                </c:pt>
                <c:pt idx="858">
                  <c:v>594</c:v>
                </c:pt>
                <c:pt idx="860">
                  <c:v>931.17600000000004</c:v>
                </c:pt>
                <c:pt idx="862">
                  <c:v>1395.79</c:v>
                </c:pt>
                <c:pt idx="863">
                  <c:v>1100.0899999999999</c:v>
                </c:pt>
                <c:pt idx="865">
                  <c:v>1147.3900000000001</c:v>
                </c:pt>
                <c:pt idx="866">
                  <c:v>873.28800000000001</c:v>
                </c:pt>
                <c:pt idx="868">
                  <c:v>1260.1400000000001</c:v>
                </c:pt>
                <c:pt idx="869">
                  <c:v>1227.31</c:v>
                </c:pt>
                <c:pt idx="876">
                  <c:v>618.19200000000001</c:v>
                </c:pt>
                <c:pt idx="878">
                  <c:v>1194.26</c:v>
                </c:pt>
                <c:pt idx="879">
                  <c:v>891.86400000000003</c:v>
                </c:pt>
                <c:pt idx="884">
                  <c:v>1576.15</c:v>
                </c:pt>
                <c:pt idx="885">
                  <c:v>1436.62</c:v>
                </c:pt>
                <c:pt idx="886">
                  <c:v>738.072</c:v>
                </c:pt>
                <c:pt idx="890">
                  <c:v>1337.69</c:v>
                </c:pt>
                <c:pt idx="892">
                  <c:v>872.42399999999998</c:v>
                </c:pt>
                <c:pt idx="894">
                  <c:v>987.98400000000004</c:v>
                </c:pt>
                <c:pt idx="895">
                  <c:v>779.54399999999998</c:v>
                </c:pt>
                <c:pt idx="897">
                  <c:v>617.976</c:v>
                </c:pt>
                <c:pt idx="898">
                  <c:v>392.47199999999998</c:v>
                </c:pt>
                <c:pt idx="899">
                  <c:v>552.52800000000002</c:v>
                </c:pt>
                <c:pt idx="909">
                  <c:v>903.96</c:v>
                </c:pt>
                <c:pt idx="910">
                  <c:v>1030.32</c:v>
                </c:pt>
                <c:pt idx="913">
                  <c:v>976.32</c:v>
                </c:pt>
                <c:pt idx="914">
                  <c:v>1002.02</c:v>
                </c:pt>
                <c:pt idx="923">
                  <c:v>1034.6400000000001</c:v>
                </c:pt>
                <c:pt idx="925">
                  <c:v>728.35199999999998</c:v>
                </c:pt>
                <c:pt idx="928">
                  <c:v>875.44799999999998</c:v>
                </c:pt>
                <c:pt idx="932">
                  <c:v>700.27200000000005</c:v>
                </c:pt>
                <c:pt idx="933">
                  <c:v>1460.38</c:v>
                </c:pt>
                <c:pt idx="936">
                  <c:v>1304.6400000000001</c:v>
                </c:pt>
                <c:pt idx="937">
                  <c:v>761.18399999999997</c:v>
                </c:pt>
                <c:pt idx="939">
                  <c:v>1056.8900000000001</c:v>
                </c:pt>
                <c:pt idx="940">
                  <c:v>836.35199999999998</c:v>
                </c:pt>
                <c:pt idx="941">
                  <c:v>2221.7800000000002</c:v>
                </c:pt>
                <c:pt idx="944">
                  <c:v>792.28800000000001</c:v>
                </c:pt>
                <c:pt idx="946">
                  <c:v>1139.6199999999999</c:v>
                </c:pt>
                <c:pt idx="947">
                  <c:v>1019.3</c:v>
                </c:pt>
                <c:pt idx="952">
                  <c:v>1671.62</c:v>
                </c:pt>
                <c:pt idx="955">
                  <c:v>1146.0999999999999</c:v>
                </c:pt>
                <c:pt idx="956">
                  <c:v>1255.18</c:v>
                </c:pt>
                <c:pt idx="962">
                  <c:v>735.69600000000003</c:v>
                </c:pt>
                <c:pt idx="963">
                  <c:v>1195.78</c:v>
                </c:pt>
                <c:pt idx="970">
                  <c:v>752.54399999999998</c:v>
                </c:pt>
                <c:pt idx="972">
                  <c:v>1234.01</c:v>
                </c:pt>
                <c:pt idx="974">
                  <c:v>496.584</c:v>
                </c:pt>
                <c:pt idx="975">
                  <c:v>737.20799999999997</c:v>
                </c:pt>
                <c:pt idx="981">
                  <c:v>1137.24</c:v>
                </c:pt>
                <c:pt idx="982">
                  <c:v>696.81600000000003</c:v>
                </c:pt>
                <c:pt idx="983">
                  <c:v>1048.9000000000001</c:v>
                </c:pt>
                <c:pt idx="988">
                  <c:v>1557.14</c:v>
                </c:pt>
                <c:pt idx="989">
                  <c:v>1162.3</c:v>
                </c:pt>
                <c:pt idx="1002">
                  <c:v>945.43200000000002</c:v>
                </c:pt>
                <c:pt idx="1008">
                  <c:v>2590.4899999999998</c:v>
                </c:pt>
                <c:pt idx="1009">
                  <c:v>676.51199999999994</c:v>
                </c:pt>
                <c:pt idx="1012">
                  <c:v>805.46400000000006</c:v>
                </c:pt>
                <c:pt idx="1013">
                  <c:v>2466.7199999999998</c:v>
                </c:pt>
                <c:pt idx="1018">
                  <c:v>585.14400000000001</c:v>
                </c:pt>
                <c:pt idx="1019">
                  <c:v>912.16800000000001</c:v>
                </c:pt>
                <c:pt idx="1020">
                  <c:v>519.26400000000001</c:v>
                </c:pt>
                <c:pt idx="1022">
                  <c:v>1097.93</c:v>
                </c:pt>
                <c:pt idx="1029">
                  <c:v>1813.97</c:v>
                </c:pt>
                <c:pt idx="1031">
                  <c:v>1492.99</c:v>
                </c:pt>
                <c:pt idx="1035">
                  <c:v>1021.9</c:v>
                </c:pt>
                <c:pt idx="1039">
                  <c:v>1192.0999999999999</c:v>
                </c:pt>
                <c:pt idx="1041">
                  <c:v>1206.58</c:v>
                </c:pt>
                <c:pt idx="1046">
                  <c:v>713.23199999999997</c:v>
                </c:pt>
                <c:pt idx="1047">
                  <c:v>1440.07</c:v>
                </c:pt>
                <c:pt idx="1048">
                  <c:v>551.01599999999996</c:v>
                </c:pt>
                <c:pt idx="1051">
                  <c:v>1286.06</c:v>
                </c:pt>
                <c:pt idx="1058">
                  <c:v>1197.72</c:v>
                </c:pt>
                <c:pt idx="1062">
                  <c:v>509.32799999999997</c:v>
                </c:pt>
                <c:pt idx="1063">
                  <c:v>1249.1300000000001</c:v>
                </c:pt>
                <c:pt idx="1067">
                  <c:v>881.06399999999996</c:v>
                </c:pt>
                <c:pt idx="1068">
                  <c:v>1144.3699999999999</c:v>
                </c:pt>
                <c:pt idx="1069">
                  <c:v>636.98400000000004</c:v>
                </c:pt>
                <c:pt idx="1077">
                  <c:v>858.16800000000001</c:v>
                </c:pt>
                <c:pt idx="1079">
                  <c:v>979.77599999999995</c:v>
                </c:pt>
                <c:pt idx="1081">
                  <c:v>1024.49</c:v>
                </c:pt>
                <c:pt idx="1082">
                  <c:v>1116.94</c:v>
                </c:pt>
                <c:pt idx="1085">
                  <c:v>401.32799999999997</c:v>
                </c:pt>
                <c:pt idx="1089">
                  <c:v>853.63199999999995</c:v>
                </c:pt>
                <c:pt idx="1090">
                  <c:v>1256.04</c:v>
                </c:pt>
                <c:pt idx="1093">
                  <c:v>1034.8599999999999</c:v>
                </c:pt>
                <c:pt idx="1098">
                  <c:v>1542.67</c:v>
                </c:pt>
                <c:pt idx="1107">
                  <c:v>1571.83</c:v>
                </c:pt>
                <c:pt idx="1110">
                  <c:v>1746.14</c:v>
                </c:pt>
                <c:pt idx="1111">
                  <c:v>3090.31</c:v>
                </c:pt>
                <c:pt idx="1119">
                  <c:v>796.60799999999995</c:v>
                </c:pt>
                <c:pt idx="1124">
                  <c:v>1198.58</c:v>
                </c:pt>
                <c:pt idx="1125">
                  <c:v>1311.12</c:v>
                </c:pt>
                <c:pt idx="1126">
                  <c:v>1134.22</c:v>
                </c:pt>
                <c:pt idx="1131">
                  <c:v>1080.6500000000001</c:v>
                </c:pt>
                <c:pt idx="1134">
                  <c:v>1429.27</c:v>
                </c:pt>
                <c:pt idx="1135">
                  <c:v>1134.8599999999999</c:v>
                </c:pt>
                <c:pt idx="1136">
                  <c:v>1336.39</c:v>
                </c:pt>
                <c:pt idx="1137">
                  <c:v>1411.78</c:v>
                </c:pt>
                <c:pt idx="1139">
                  <c:v>1432.51</c:v>
                </c:pt>
                <c:pt idx="1140">
                  <c:v>1091.45</c:v>
                </c:pt>
                <c:pt idx="1141">
                  <c:v>1190.3800000000001</c:v>
                </c:pt>
                <c:pt idx="1145">
                  <c:v>791.42399999999998</c:v>
                </c:pt>
                <c:pt idx="1148">
                  <c:v>829.00800000000004</c:v>
                </c:pt>
                <c:pt idx="1149">
                  <c:v>687.74400000000003</c:v>
                </c:pt>
                <c:pt idx="1155">
                  <c:v>1733.18</c:v>
                </c:pt>
                <c:pt idx="1156">
                  <c:v>838.08</c:v>
                </c:pt>
                <c:pt idx="1160">
                  <c:v>1014.77</c:v>
                </c:pt>
                <c:pt idx="1171">
                  <c:v>1292.98</c:v>
                </c:pt>
                <c:pt idx="1180">
                  <c:v>664.2</c:v>
                </c:pt>
                <c:pt idx="1181">
                  <c:v>513.64800000000002</c:v>
                </c:pt>
                <c:pt idx="1184">
                  <c:v>2267.5700000000002</c:v>
                </c:pt>
                <c:pt idx="1186">
                  <c:v>1286.71</c:v>
                </c:pt>
                <c:pt idx="1188">
                  <c:v>1254.53</c:v>
                </c:pt>
                <c:pt idx="1189">
                  <c:v>1301.4000000000001</c:v>
                </c:pt>
                <c:pt idx="1193">
                  <c:v>853.41600000000005</c:v>
                </c:pt>
                <c:pt idx="1194">
                  <c:v>2107.73</c:v>
                </c:pt>
                <c:pt idx="1196">
                  <c:v>1151.28</c:v>
                </c:pt>
                <c:pt idx="1202">
                  <c:v>899.20799999999997</c:v>
                </c:pt>
                <c:pt idx="1204">
                  <c:v>2503.44</c:v>
                </c:pt>
                <c:pt idx="1205">
                  <c:v>1458</c:v>
                </c:pt>
                <c:pt idx="1209">
                  <c:v>1161</c:v>
                </c:pt>
                <c:pt idx="1212">
                  <c:v>651.88800000000003</c:v>
                </c:pt>
                <c:pt idx="1213">
                  <c:v>1883.74</c:v>
                </c:pt>
                <c:pt idx="1217">
                  <c:v>360.072</c:v>
                </c:pt>
                <c:pt idx="1218">
                  <c:v>1308.74</c:v>
                </c:pt>
                <c:pt idx="1225">
                  <c:v>713.88</c:v>
                </c:pt>
                <c:pt idx="1229">
                  <c:v>2166.6999999999998</c:v>
                </c:pt>
                <c:pt idx="1234">
                  <c:v>943.92</c:v>
                </c:pt>
                <c:pt idx="1241">
                  <c:v>768.52800000000002</c:v>
                </c:pt>
                <c:pt idx="1242">
                  <c:v>870.26400000000001</c:v>
                </c:pt>
                <c:pt idx="1244">
                  <c:v>1125.3599999999999</c:v>
                </c:pt>
                <c:pt idx="1246">
                  <c:v>1418.9</c:v>
                </c:pt>
                <c:pt idx="1249">
                  <c:v>850.82399999999996</c:v>
                </c:pt>
                <c:pt idx="1254">
                  <c:v>682.77599999999995</c:v>
                </c:pt>
                <c:pt idx="1255">
                  <c:v>1037.6600000000001</c:v>
                </c:pt>
                <c:pt idx="1256">
                  <c:v>779.976</c:v>
                </c:pt>
                <c:pt idx="1257">
                  <c:v>575.85599999999999</c:v>
                </c:pt>
                <c:pt idx="1258">
                  <c:v>1150.8499999999999</c:v>
                </c:pt>
                <c:pt idx="1259">
                  <c:v>1045.6600000000001</c:v>
                </c:pt>
                <c:pt idx="1263">
                  <c:v>428.76</c:v>
                </c:pt>
                <c:pt idx="1264">
                  <c:v>1664.71</c:v>
                </c:pt>
                <c:pt idx="1265">
                  <c:v>961.2</c:v>
                </c:pt>
                <c:pt idx="1266">
                  <c:v>1032.48</c:v>
                </c:pt>
                <c:pt idx="1272">
                  <c:v>1366.2</c:v>
                </c:pt>
                <c:pt idx="1273">
                  <c:v>165.024</c:v>
                </c:pt>
                <c:pt idx="1281">
                  <c:v>1103.33</c:v>
                </c:pt>
                <c:pt idx="1282">
                  <c:v>1181.95</c:v>
                </c:pt>
                <c:pt idx="1283">
                  <c:v>989.06399999999996</c:v>
                </c:pt>
                <c:pt idx="1293">
                  <c:v>1234.01</c:v>
                </c:pt>
                <c:pt idx="1294">
                  <c:v>1245.02</c:v>
                </c:pt>
                <c:pt idx="1299">
                  <c:v>1556.71</c:v>
                </c:pt>
                <c:pt idx="1304">
                  <c:v>1285.2</c:v>
                </c:pt>
                <c:pt idx="1305">
                  <c:v>762.048</c:v>
                </c:pt>
                <c:pt idx="1309">
                  <c:v>1307.45</c:v>
                </c:pt>
                <c:pt idx="1314">
                  <c:v>1271.5899999999999</c:v>
                </c:pt>
                <c:pt idx="1315">
                  <c:v>681.048</c:v>
                </c:pt>
                <c:pt idx="1320">
                  <c:v>1174.82</c:v>
                </c:pt>
                <c:pt idx="1321">
                  <c:v>1383.05</c:v>
                </c:pt>
                <c:pt idx="1328">
                  <c:v>1522.58</c:v>
                </c:pt>
                <c:pt idx="1330">
                  <c:v>1151.06</c:v>
                </c:pt>
                <c:pt idx="1333">
                  <c:v>1543.75</c:v>
                </c:pt>
                <c:pt idx="1338">
                  <c:v>1512.22</c:v>
                </c:pt>
                <c:pt idx="1344">
                  <c:v>1053.8599999999999</c:v>
                </c:pt>
                <c:pt idx="1348">
                  <c:v>755.56799999999998</c:v>
                </c:pt>
                <c:pt idx="1353">
                  <c:v>630.072</c:v>
                </c:pt>
                <c:pt idx="1355">
                  <c:v>435.67200000000003</c:v>
                </c:pt>
                <c:pt idx="1359">
                  <c:v>1336.61</c:v>
                </c:pt>
                <c:pt idx="1362">
                  <c:v>1134.22</c:v>
                </c:pt>
                <c:pt idx="1363">
                  <c:v>844.56</c:v>
                </c:pt>
                <c:pt idx="1366">
                  <c:v>540.43200000000002</c:v>
                </c:pt>
                <c:pt idx="1367">
                  <c:v>1152.58</c:v>
                </c:pt>
                <c:pt idx="1370">
                  <c:v>3274.34</c:v>
                </c:pt>
                <c:pt idx="1379">
                  <c:v>842.4</c:v>
                </c:pt>
                <c:pt idx="1380">
                  <c:v>836.78399999999999</c:v>
                </c:pt>
                <c:pt idx="1385">
                  <c:v>1421.71</c:v>
                </c:pt>
                <c:pt idx="1386">
                  <c:v>998.78399999999999</c:v>
                </c:pt>
                <c:pt idx="1389">
                  <c:v>787.32</c:v>
                </c:pt>
                <c:pt idx="1392">
                  <c:v>1276.1300000000001</c:v>
                </c:pt>
                <c:pt idx="1394">
                  <c:v>1206.79</c:v>
                </c:pt>
                <c:pt idx="1398">
                  <c:v>1097.71</c:v>
                </c:pt>
                <c:pt idx="1399">
                  <c:v>827.71199999999999</c:v>
                </c:pt>
                <c:pt idx="1401">
                  <c:v>889.70399999999995</c:v>
                </c:pt>
                <c:pt idx="1402">
                  <c:v>1878.34</c:v>
                </c:pt>
                <c:pt idx="1403">
                  <c:v>1316.09</c:v>
                </c:pt>
                <c:pt idx="1404">
                  <c:v>1435.32</c:v>
                </c:pt>
                <c:pt idx="1410">
                  <c:v>932.68799999999999</c:v>
                </c:pt>
                <c:pt idx="1423">
                  <c:v>2837.81</c:v>
                </c:pt>
                <c:pt idx="1424">
                  <c:v>779.32799999999997</c:v>
                </c:pt>
                <c:pt idx="1427">
                  <c:v>1492.34</c:v>
                </c:pt>
                <c:pt idx="1432">
                  <c:v>390.74400000000003</c:v>
                </c:pt>
                <c:pt idx="1438">
                  <c:v>1091.6600000000001</c:v>
                </c:pt>
                <c:pt idx="1442">
                  <c:v>1469.45</c:v>
                </c:pt>
                <c:pt idx="1447">
                  <c:v>1168.78</c:v>
                </c:pt>
                <c:pt idx="1448">
                  <c:v>929.01599999999996</c:v>
                </c:pt>
                <c:pt idx="1451">
                  <c:v>561.81600000000003</c:v>
                </c:pt>
                <c:pt idx="1453">
                  <c:v>701.78399999999999</c:v>
                </c:pt>
                <c:pt idx="1454">
                  <c:v>847.15200000000004</c:v>
                </c:pt>
                <c:pt idx="1456">
                  <c:v>1349.35</c:v>
                </c:pt>
                <c:pt idx="1463">
                  <c:v>1348.92</c:v>
                </c:pt>
                <c:pt idx="1464">
                  <c:v>992.952</c:v>
                </c:pt>
                <c:pt idx="1467">
                  <c:v>1187.3499999999999</c:v>
                </c:pt>
                <c:pt idx="1469">
                  <c:v>228.52799999999999</c:v>
                </c:pt>
                <c:pt idx="1470">
                  <c:v>1257.3399999999999</c:v>
                </c:pt>
                <c:pt idx="1473">
                  <c:v>515.80799999999999</c:v>
                </c:pt>
                <c:pt idx="1476">
                  <c:v>1165.0999999999999</c:v>
                </c:pt>
                <c:pt idx="1479">
                  <c:v>819.50400000000002</c:v>
                </c:pt>
                <c:pt idx="1482">
                  <c:v>619.48800000000006</c:v>
                </c:pt>
                <c:pt idx="1485">
                  <c:v>283.608</c:v>
                </c:pt>
                <c:pt idx="1487">
                  <c:v>683.42399999999998</c:v>
                </c:pt>
                <c:pt idx="1494">
                  <c:v>1059.48</c:v>
                </c:pt>
                <c:pt idx="1496">
                  <c:v>665.928</c:v>
                </c:pt>
                <c:pt idx="1498">
                  <c:v>839.16</c:v>
                </c:pt>
                <c:pt idx="1502">
                  <c:v>1043.71</c:v>
                </c:pt>
                <c:pt idx="1508">
                  <c:v>1571.62</c:v>
                </c:pt>
                <c:pt idx="1512">
                  <c:v>1424.95</c:v>
                </c:pt>
                <c:pt idx="1514">
                  <c:v>676.51199999999994</c:v>
                </c:pt>
                <c:pt idx="1516">
                  <c:v>1345.46</c:v>
                </c:pt>
                <c:pt idx="1519">
                  <c:v>1206.79</c:v>
                </c:pt>
                <c:pt idx="1520">
                  <c:v>1370.95</c:v>
                </c:pt>
                <c:pt idx="1529">
                  <c:v>1006.13</c:v>
                </c:pt>
                <c:pt idx="1531">
                  <c:v>1719.79</c:v>
                </c:pt>
                <c:pt idx="1536">
                  <c:v>705.88800000000003</c:v>
                </c:pt>
                <c:pt idx="1537">
                  <c:v>406.72800000000001</c:v>
                </c:pt>
                <c:pt idx="1538">
                  <c:v>1863.65</c:v>
                </c:pt>
                <c:pt idx="1542">
                  <c:v>6356.45</c:v>
                </c:pt>
                <c:pt idx="1546">
                  <c:v>908.06399999999996</c:v>
                </c:pt>
                <c:pt idx="1550">
                  <c:v>861.62400000000002</c:v>
                </c:pt>
                <c:pt idx="1552">
                  <c:v>11524.9</c:v>
                </c:pt>
                <c:pt idx="1556">
                  <c:v>937.65599999999995</c:v>
                </c:pt>
                <c:pt idx="1559">
                  <c:v>1220.83</c:v>
                </c:pt>
                <c:pt idx="1568">
                  <c:v>1218.46</c:v>
                </c:pt>
                <c:pt idx="1577">
                  <c:v>961.2</c:v>
                </c:pt>
                <c:pt idx="1585">
                  <c:v>763.34400000000005</c:v>
                </c:pt>
                <c:pt idx="1589">
                  <c:v>1059.05</c:v>
                </c:pt>
                <c:pt idx="1590">
                  <c:v>814.75199999999995</c:v>
                </c:pt>
                <c:pt idx="1597">
                  <c:v>1078.27</c:v>
                </c:pt>
                <c:pt idx="1602">
                  <c:v>869.83199999999999</c:v>
                </c:pt>
                <c:pt idx="1607">
                  <c:v>1372.03</c:v>
                </c:pt>
                <c:pt idx="1610">
                  <c:v>469.15199999999999</c:v>
                </c:pt>
                <c:pt idx="1612">
                  <c:v>728.78399999999999</c:v>
                </c:pt>
                <c:pt idx="1613">
                  <c:v>843.91200000000003</c:v>
                </c:pt>
                <c:pt idx="1616">
                  <c:v>760.96799999999996</c:v>
                </c:pt>
                <c:pt idx="1620">
                  <c:v>1053.8599999999999</c:v>
                </c:pt>
                <c:pt idx="1621">
                  <c:v>1804.25</c:v>
                </c:pt>
                <c:pt idx="1624">
                  <c:v>711.93600000000004</c:v>
                </c:pt>
                <c:pt idx="1625">
                  <c:v>2175.5500000000002</c:v>
                </c:pt>
                <c:pt idx="1629">
                  <c:v>1820.02</c:v>
                </c:pt>
                <c:pt idx="1631">
                  <c:v>2789.86</c:v>
                </c:pt>
                <c:pt idx="1634">
                  <c:v>1504.22</c:v>
                </c:pt>
                <c:pt idx="1635">
                  <c:v>848.66399999999999</c:v>
                </c:pt>
                <c:pt idx="1636">
                  <c:v>1150.6300000000001</c:v>
                </c:pt>
                <c:pt idx="1640">
                  <c:v>579.096</c:v>
                </c:pt>
                <c:pt idx="1641">
                  <c:v>709.12800000000004</c:v>
                </c:pt>
                <c:pt idx="1644">
                  <c:v>760.96799999999996</c:v>
                </c:pt>
                <c:pt idx="1647">
                  <c:v>1280.8800000000001</c:v>
                </c:pt>
                <c:pt idx="1649">
                  <c:v>1064.23</c:v>
                </c:pt>
                <c:pt idx="1650">
                  <c:v>976.53599999999994</c:v>
                </c:pt>
                <c:pt idx="1652">
                  <c:v>536.976</c:v>
                </c:pt>
                <c:pt idx="1653">
                  <c:v>1094.26</c:v>
                </c:pt>
                <c:pt idx="1654">
                  <c:v>1355.83</c:v>
                </c:pt>
                <c:pt idx="1658">
                  <c:v>858.81600000000003</c:v>
                </c:pt>
                <c:pt idx="1665">
                  <c:v>663.33600000000001</c:v>
                </c:pt>
                <c:pt idx="1666">
                  <c:v>2083.3200000000002</c:v>
                </c:pt>
                <c:pt idx="1668">
                  <c:v>1072.6600000000001</c:v>
                </c:pt>
                <c:pt idx="1669">
                  <c:v>1220.6199999999999</c:v>
                </c:pt>
                <c:pt idx="1672">
                  <c:v>1218.24</c:v>
                </c:pt>
                <c:pt idx="1673">
                  <c:v>421.84800000000001</c:v>
                </c:pt>
                <c:pt idx="1677">
                  <c:v>1793.23</c:v>
                </c:pt>
                <c:pt idx="1678">
                  <c:v>737.20799999999997</c:v>
                </c:pt>
                <c:pt idx="1681">
                  <c:v>1500.77</c:v>
                </c:pt>
                <c:pt idx="1684">
                  <c:v>564.40800000000002</c:v>
                </c:pt>
                <c:pt idx="1688">
                  <c:v>183.6</c:v>
                </c:pt>
                <c:pt idx="1689">
                  <c:v>292.68</c:v>
                </c:pt>
                <c:pt idx="1705">
                  <c:v>1095.3399999999999</c:v>
                </c:pt>
                <c:pt idx="1706">
                  <c:v>1024.49</c:v>
                </c:pt>
                <c:pt idx="1709">
                  <c:v>1163.5899999999999</c:v>
                </c:pt>
                <c:pt idx="1712">
                  <c:v>1434.89</c:v>
                </c:pt>
                <c:pt idx="1713">
                  <c:v>795.52800000000002</c:v>
                </c:pt>
                <c:pt idx="1715">
                  <c:v>1014.98</c:v>
                </c:pt>
                <c:pt idx="1717">
                  <c:v>1566</c:v>
                </c:pt>
                <c:pt idx="1720">
                  <c:v>14550.2</c:v>
                </c:pt>
                <c:pt idx="1733">
                  <c:v>739.58399999999995</c:v>
                </c:pt>
                <c:pt idx="1735">
                  <c:v>833.11199999999997</c:v>
                </c:pt>
                <c:pt idx="1737">
                  <c:v>1233.58</c:v>
                </c:pt>
                <c:pt idx="1741">
                  <c:v>533.952</c:v>
                </c:pt>
                <c:pt idx="1751">
                  <c:v>1107.6500000000001</c:v>
                </c:pt>
                <c:pt idx="1754">
                  <c:v>806.54399999999998</c:v>
                </c:pt>
                <c:pt idx="1761">
                  <c:v>1231.42</c:v>
                </c:pt>
                <c:pt idx="1762">
                  <c:v>738.93600000000004</c:v>
                </c:pt>
                <c:pt idx="1763">
                  <c:v>477.36</c:v>
                </c:pt>
                <c:pt idx="1766">
                  <c:v>1564.92</c:v>
                </c:pt>
                <c:pt idx="1779">
                  <c:v>1179.3599999999999</c:v>
                </c:pt>
                <c:pt idx="1782">
                  <c:v>832.03200000000004</c:v>
                </c:pt>
                <c:pt idx="1783">
                  <c:v>1053.22</c:v>
                </c:pt>
                <c:pt idx="1785">
                  <c:v>918</c:v>
                </c:pt>
                <c:pt idx="1789">
                  <c:v>938.08799999999997</c:v>
                </c:pt>
                <c:pt idx="1790">
                  <c:v>964.65599999999995</c:v>
                </c:pt>
                <c:pt idx="1794">
                  <c:v>907.2</c:v>
                </c:pt>
                <c:pt idx="1797">
                  <c:v>778.46400000000006</c:v>
                </c:pt>
                <c:pt idx="1803">
                  <c:v>1730.81</c:v>
                </c:pt>
                <c:pt idx="1804">
                  <c:v>707.18399999999997</c:v>
                </c:pt>
                <c:pt idx="1806">
                  <c:v>2274.2600000000002</c:v>
                </c:pt>
                <c:pt idx="1812">
                  <c:v>2176.63</c:v>
                </c:pt>
                <c:pt idx="1817">
                  <c:v>521.42399999999998</c:v>
                </c:pt>
                <c:pt idx="1819">
                  <c:v>814.53599999999994</c:v>
                </c:pt>
                <c:pt idx="1823">
                  <c:v>3530.74</c:v>
                </c:pt>
                <c:pt idx="1824">
                  <c:v>2305.58</c:v>
                </c:pt>
                <c:pt idx="1826">
                  <c:v>2527.1999999999998</c:v>
                </c:pt>
                <c:pt idx="1832">
                  <c:v>922.32</c:v>
                </c:pt>
                <c:pt idx="1834">
                  <c:v>854.28</c:v>
                </c:pt>
                <c:pt idx="1837">
                  <c:v>1634.69</c:v>
                </c:pt>
                <c:pt idx="1845">
                  <c:v>807.19200000000001</c:v>
                </c:pt>
                <c:pt idx="1847">
                  <c:v>778.03200000000004</c:v>
                </c:pt>
                <c:pt idx="1853">
                  <c:v>1048.25</c:v>
                </c:pt>
                <c:pt idx="1858">
                  <c:v>1121.69</c:v>
                </c:pt>
                <c:pt idx="1859">
                  <c:v>452.73599999999999</c:v>
                </c:pt>
                <c:pt idx="1863">
                  <c:v>725.54399999999998</c:v>
                </c:pt>
                <c:pt idx="1865">
                  <c:v>997.05600000000004</c:v>
                </c:pt>
                <c:pt idx="1866">
                  <c:v>921.24</c:v>
                </c:pt>
                <c:pt idx="1870">
                  <c:v>796.82399999999996</c:v>
                </c:pt>
                <c:pt idx="1871">
                  <c:v>590.976</c:v>
                </c:pt>
                <c:pt idx="1878">
                  <c:v>741.52800000000002</c:v>
                </c:pt>
                <c:pt idx="1881">
                  <c:v>802.87199999999996</c:v>
                </c:pt>
                <c:pt idx="1882">
                  <c:v>1231.8499999999999</c:v>
                </c:pt>
                <c:pt idx="1883">
                  <c:v>1159.49</c:v>
                </c:pt>
                <c:pt idx="1885">
                  <c:v>1220.18</c:v>
                </c:pt>
                <c:pt idx="1888">
                  <c:v>1059.9100000000001</c:v>
                </c:pt>
                <c:pt idx="1891">
                  <c:v>1095.55</c:v>
                </c:pt>
                <c:pt idx="1894">
                  <c:v>1203.3399999999999</c:v>
                </c:pt>
                <c:pt idx="1897">
                  <c:v>692.71199999999999</c:v>
                </c:pt>
                <c:pt idx="1905">
                  <c:v>1578.53</c:v>
                </c:pt>
                <c:pt idx="1909">
                  <c:v>722.952</c:v>
                </c:pt>
                <c:pt idx="1913">
                  <c:v>412.56</c:v>
                </c:pt>
                <c:pt idx="1919">
                  <c:v>11452.1</c:v>
                </c:pt>
                <c:pt idx="1921">
                  <c:v>941.11199999999997</c:v>
                </c:pt>
                <c:pt idx="1927">
                  <c:v>1469.88</c:v>
                </c:pt>
                <c:pt idx="1928">
                  <c:v>559.87199999999996</c:v>
                </c:pt>
                <c:pt idx="1929">
                  <c:v>1004.83</c:v>
                </c:pt>
                <c:pt idx="1931">
                  <c:v>606.096</c:v>
                </c:pt>
                <c:pt idx="1933">
                  <c:v>1558.01</c:v>
                </c:pt>
                <c:pt idx="1934">
                  <c:v>651.024</c:v>
                </c:pt>
                <c:pt idx="1935">
                  <c:v>847.58399999999995</c:v>
                </c:pt>
                <c:pt idx="1937">
                  <c:v>1147.6099999999999</c:v>
                </c:pt>
                <c:pt idx="1941">
                  <c:v>1553.04</c:v>
                </c:pt>
                <c:pt idx="1942">
                  <c:v>1310.26</c:v>
                </c:pt>
                <c:pt idx="1943">
                  <c:v>1315.66</c:v>
                </c:pt>
                <c:pt idx="1952">
                  <c:v>1102.25</c:v>
                </c:pt>
                <c:pt idx="1954">
                  <c:v>1213.27</c:v>
                </c:pt>
                <c:pt idx="1960">
                  <c:v>967.68</c:v>
                </c:pt>
                <c:pt idx="1962">
                  <c:v>401.76</c:v>
                </c:pt>
                <c:pt idx="1969">
                  <c:v>1064.02</c:v>
                </c:pt>
                <c:pt idx="1971">
                  <c:v>716.904</c:v>
                </c:pt>
                <c:pt idx="1973">
                  <c:v>864.64800000000002</c:v>
                </c:pt>
                <c:pt idx="1979">
                  <c:v>1083.46</c:v>
                </c:pt>
                <c:pt idx="1984">
                  <c:v>905.904</c:v>
                </c:pt>
                <c:pt idx="1985">
                  <c:v>1294.49</c:v>
                </c:pt>
                <c:pt idx="1990">
                  <c:v>945.64800000000002</c:v>
                </c:pt>
                <c:pt idx="1997">
                  <c:v>1539.43</c:v>
                </c:pt>
                <c:pt idx="2002">
                  <c:v>491.83199999999999</c:v>
                </c:pt>
                <c:pt idx="2004">
                  <c:v>1819.15</c:v>
                </c:pt>
                <c:pt idx="2005">
                  <c:v>2582.5</c:v>
                </c:pt>
                <c:pt idx="2009">
                  <c:v>671.976</c:v>
                </c:pt>
                <c:pt idx="2012">
                  <c:v>1622.59</c:v>
                </c:pt>
                <c:pt idx="2014">
                  <c:v>1183.03</c:v>
                </c:pt>
                <c:pt idx="2020">
                  <c:v>965.52</c:v>
                </c:pt>
                <c:pt idx="2022">
                  <c:v>777.16800000000001</c:v>
                </c:pt>
                <c:pt idx="2025">
                  <c:v>1716.34</c:v>
                </c:pt>
                <c:pt idx="2028">
                  <c:v>2417.04</c:v>
                </c:pt>
                <c:pt idx="2041">
                  <c:v>522.072</c:v>
                </c:pt>
                <c:pt idx="2044">
                  <c:v>314.06400000000002</c:v>
                </c:pt>
                <c:pt idx="2047">
                  <c:v>1363.18</c:v>
                </c:pt>
                <c:pt idx="2051">
                  <c:v>1477.01</c:v>
                </c:pt>
                <c:pt idx="2052">
                  <c:v>478.87200000000001</c:v>
                </c:pt>
                <c:pt idx="2053">
                  <c:v>680.4</c:v>
                </c:pt>
                <c:pt idx="2060">
                  <c:v>941.11199999999997</c:v>
                </c:pt>
                <c:pt idx="2064">
                  <c:v>969.19200000000001</c:v>
                </c:pt>
                <c:pt idx="2065">
                  <c:v>696.16800000000001</c:v>
                </c:pt>
                <c:pt idx="2066">
                  <c:v>668.52</c:v>
                </c:pt>
                <c:pt idx="2067">
                  <c:v>1311.34</c:v>
                </c:pt>
                <c:pt idx="2069">
                  <c:v>1186.49</c:v>
                </c:pt>
                <c:pt idx="2071">
                  <c:v>589.03200000000004</c:v>
                </c:pt>
                <c:pt idx="2074">
                  <c:v>722.73599999999999</c:v>
                </c:pt>
                <c:pt idx="2088">
                  <c:v>2211.41</c:v>
                </c:pt>
                <c:pt idx="2092">
                  <c:v>885.16800000000001</c:v>
                </c:pt>
                <c:pt idx="2093">
                  <c:v>1084.0999999999999</c:v>
                </c:pt>
                <c:pt idx="2100">
                  <c:v>911.52</c:v>
                </c:pt>
                <c:pt idx="2102">
                  <c:v>445.82400000000001</c:v>
                </c:pt>
                <c:pt idx="2105">
                  <c:v>714.31200000000001</c:v>
                </c:pt>
                <c:pt idx="2107">
                  <c:v>599.18399999999997</c:v>
                </c:pt>
                <c:pt idx="2111">
                  <c:v>2214.86</c:v>
                </c:pt>
                <c:pt idx="2112">
                  <c:v>1928.66</c:v>
                </c:pt>
                <c:pt idx="2115">
                  <c:v>559.22400000000005</c:v>
                </c:pt>
                <c:pt idx="2121">
                  <c:v>518.61599999999999</c:v>
                </c:pt>
                <c:pt idx="2122">
                  <c:v>1217.1600000000001</c:v>
                </c:pt>
                <c:pt idx="2128">
                  <c:v>963.36</c:v>
                </c:pt>
                <c:pt idx="2130">
                  <c:v>899.85599999999999</c:v>
                </c:pt>
                <c:pt idx="2139">
                  <c:v>1260.3599999999999</c:v>
                </c:pt>
                <c:pt idx="2141">
                  <c:v>2002.75</c:v>
                </c:pt>
                <c:pt idx="2142">
                  <c:v>1450.87</c:v>
                </c:pt>
                <c:pt idx="2143">
                  <c:v>1164.24</c:v>
                </c:pt>
                <c:pt idx="2144">
                  <c:v>986.68799999999999</c:v>
                </c:pt>
                <c:pt idx="2155">
                  <c:v>728.35199999999998</c:v>
                </c:pt>
                <c:pt idx="2157">
                  <c:v>548.20799999999997</c:v>
                </c:pt>
                <c:pt idx="2158">
                  <c:v>927.50400000000002</c:v>
                </c:pt>
                <c:pt idx="2170">
                  <c:v>941.32799999999997</c:v>
                </c:pt>
                <c:pt idx="2171">
                  <c:v>1631.66</c:v>
                </c:pt>
                <c:pt idx="2173">
                  <c:v>1360.15</c:v>
                </c:pt>
                <c:pt idx="2174">
                  <c:v>1293.4100000000001</c:v>
                </c:pt>
                <c:pt idx="2175">
                  <c:v>1246.0999999999999</c:v>
                </c:pt>
                <c:pt idx="2179">
                  <c:v>1883.52</c:v>
                </c:pt>
                <c:pt idx="2180">
                  <c:v>1134.43</c:v>
                </c:pt>
                <c:pt idx="2184">
                  <c:v>1398.17</c:v>
                </c:pt>
                <c:pt idx="2185">
                  <c:v>2151.79</c:v>
                </c:pt>
                <c:pt idx="2188">
                  <c:v>1309.82</c:v>
                </c:pt>
                <c:pt idx="2189">
                  <c:v>955.15200000000004</c:v>
                </c:pt>
                <c:pt idx="2195">
                  <c:v>1335.74</c:v>
                </c:pt>
                <c:pt idx="2202">
                  <c:v>1190.1600000000001</c:v>
                </c:pt>
                <c:pt idx="2203">
                  <c:v>726.19200000000001</c:v>
                </c:pt>
                <c:pt idx="2205">
                  <c:v>1805.33</c:v>
                </c:pt>
                <c:pt idx="2206">
                  <c:v>1473.55</c:v>
                </c:pt>
                <c:pt idx="2207">
                  <c:v>680.83199999999999</c:v>
                </c:pt>
                <c:pt idx="2208">
                  <c:v>1540.94</c:v>
                </c:pt>
                <c:pt idx="2211">
                  <c:v>1014.77</c:v>
                </c:pt>
                <c:pt idx="2222">
                  <c:v>2650.1</c:v>
                </c:pt>
                <c:pt idx="2226">
                  <c:v>834.84</c:v>
                </c:pt>
                <c:pt idx="2229">
                  <c:v>541.72799999999995</c:v>
                </c:pt>
                <c:pt idx="2230">
                  <c:v>507.16800000000001</c:v>
                </c:pt>
                <c:pt idx="2234">
                  <c:v>865.72799999999995</c:v>
                </c:pt>
                <c:pt idx="2235">
                  <c:v>700.92</c:v>
                </c:pt>
                <c:pt idx="2238">
                  <c:v>795.096</c:v>
                </c:pt>
                <c:pt idx="2240">
                  <c:v>489.24</c:v>
                </c:pt>
                <c:pt idx="2242">
                  <c:v>747.57600000000002</c:v>
                </c:pt>
                <c:pt idx="2253">
                  <c:v>1060.56</c:v>
                </c:pt>
                <c:pt idx="2257">
                  <c:v>894.88800000000003</c:v>
                </c:pt>
                <c:pt idx="2259">
                  <c:v>548.42399999999998</c:v>
                </c:pt>
                <c:pt idx="2260">
                  <c:v>1145.23</c:v>
                </c:pt>
                <c:pt idx="2262">
                  <c:v>2241.86</c:v>
                </c:pt>
                <c:pt idx="2268">
                  <c:v>539.35199999999998</c:v>
                </c:pt>
                <c:pt idx="2269">
                  <c:v>1060.56</c:v>
                </c:pt>
                <c:pt idx="2270">
                  <c:v>705.67200000000003</c:v>
                </c:pt>
                <c:pt idx="2271">
                  <c:v>1285.8499999999999</c:v>
                </c:pt>
                <c:pt idx="2277">
                  <c:v>1608.55</c:v>
                </c:pt>
                <c:pt idx="2286">
                  <c:v>1212.4100000000001</c:v>
                </c:pt>
                <c:pt idx="2287">
                  <c:v>1348.49</c:v>
                </c:pt>
                <c:pt idx="2288">
                  <c:v>1680.7</c:v>
                </c:pt>
                <c:pt idx="2300">
                  <c:v>771.55200000000002</c:v>
                </c:pt>
                <c:pt idx="2301">
                  <c:v>1004.83</c:v>
                </c:pt>
                <c:pt idx="2313">
                  <c:v>2279.23</c:v>
                </c:pt>
                <c:pt idx="2317">
                  <c:v>1087.99</c:v>
                </c:pt>
                <c:pt idx="2318">
                  <c:v>1546.56</c:v>
                </c:pt>
                <c:pt idx="2319">
                  <c:v>2254.61</c:v>
                </c:pt>
                <c:pt idx="2320">
                  <c:v>595.29600000000005</c:v>
                </c:pt>
                <c:pt idx="2321">
                  <c:v>904.60799999999995</c:v>
                </c:pt>
                <c:pt idx="2326">
                  <c:v>752.32799999999997</c:v>
                </c:pt>
                <c:pt idx="2327">
                  <c:v>1771.2</c:v>
                </c:pt>
                <c:pt idx="2333">
                  <c:v>707.83199999999999</c:v>
                </c:pt>
                <c:pt idx="2336">
                  <c:v>1225.3699999999999</c:v>
                </c:pt>
                <c:pt idx="2343">
                  <c:v>1538.14</c:v>
                </c:pt>
                <c:pt idx="2346">
                  <c:v>4726.9399999999996</c:v>
                </c:pt>
                <c:pt idx="2349">
                  <c:v>822.31200000000001</c:v>
                </c:pt>
                <c:pt idx="2351">
                  <c:v>778.03200000000004</c:v>
                </c:pt>
                <c:pt idx="2355">
                  <c:v>430.488</c:v>
                </c:pt>
                <c:pt idx="2356">
                  <c:v>880.84799999999996</c:v>
                </c:pt>
                <c:pt idx="2361">
                  <c:v>1052.57</c:v>
                </c:pt>
                <c:pt idx="2367">
                  <c:v>1778.33</c:v>
                </c:pt>
                <c:pt idx="2368">
                  <c:v>1145.23</c:v>
                </c:pt>
                <c:pt idx="2370">
                  <c:v>495.50400000000002</c:v>
                </c:pt>
                <c:pt idx="2371">
                  <c:v>568.08000000000004</c:v>
                </c:pt>
                <c:pt idx="2372">
                  <c:v>290.52</c:v>
                </c:pt>
                <c:pt idx="2378">
                  <c:v>587.952</c:v>
                </c:pt>
                <c:pt idx="2381">
                  <c:v>563.76</c:v>
                </c:pt>
                <c:pt idx="2382">
                  <c:v>879.76800000000003</c:v>
                </c:pt>
                <c:pt idx="2384">
                  <c:v>720.79200000000003</c:v>
                </c:pt>
                <c:pt idx="2386">
                  <c:v>1283.9000000000001</c:v>
                </c:pt>
                <c:pt idx="2391">
                  <c:v>1508.98</c:v>
                </c:pt>
                <c:pt idx="2395">
                  <c:v>1059.7</c:v>
                </c:pt>
                <c:pt idx="2397">
                  <c:v>680.61599999999999</c:v>
                </c:pt>
                <c:pt idx="2400">
                  <c:v>787.96799999999996</c:v>
                </c:pt>
                <c:pt idx="2403">
                  <c:v>773.49599999999998</c:v>
                </c:pt>
                <c:pt idx="2405">
                  <c:v>495.50400000000002</c:v>
                </c:pt>
                <c:pt idx="2407">
                  <c:v>562.24800000000005</c:v>
                </c:pt>
                <c:pt idx="2413">
                  <c:v>846.072</c:v>
                </c:pt>
                <c:pt idx="2414">
                  <c:v>706.10400000000004</c:v>
                </c:pt>
                <c:pt idx="2415">
                  <c:v>548.85599999999999</c:v>
                </c:pt>
                <c:pt idx="2417">
                  <c:v>1361.45</c:v>
                </c:pt>
                <c:pt idx="2420">
                  <c:v>798.12</c:v>
                </c:pt>
                <c:pt idx="2424">
                  <c:v>1250.21</c:v>
                </c:pt>
                <c:pt idx="2425">
                  <c:v>1105.27</c:v>
                </c:pt>
                <c:pt idx="2426">
                  <c:v>827.49599999999998</c:v>
                </c:pt>
                <c:pt idx="2432">
                  <c:v>1233.3599999999999</c:v>
                </c:pt>
                <c:pt idx="2433">
                  <c:v>863.56799999999998</c:v>
                </c:pt>
                <c:pt idx="2435">
                  <c:v>821.01599999999996</c:v>
                </c:pt>
                <c:pt idx="2440">
                  <c:v>492.48</c:v>
                </c:pt>
                <c:pt idx="2441">
                  <c:v>1613.74</c:v>
                </c:pt>
                <c:pt idx="2444">
                  <c:v>1352.38</c:v>
                </c:pt>
                <c:pt idx="2447">
                  <c:v>2060.86</c:v>
                </c:pt>
                <c:pt idx="2448">
                  <c:v>422.71199999999999</c:v>
                </c:pt>
                <c:pt idx="2454">
                  <c:v>2620.08</c:v>
                </c:pt>
                <c:pt idx="2455">
                  <c:v>1265.76</c:v>
                </c:pt>
                <c:pt idx="2472">
                  <c:v>600.26400000000001</c:v>
                </c:pt>
                <c:pt idx="2474">
                  <c:v>1108.73</c:v>
                </c:pt>
                <c:pt idx="2476">
                  <c:v>1478.74</c:v>
                </c:pt>
                <c:pt idx="2482">
                  <c:v>467.20800000000003</c:v>
                </c:pt>
                <c:pt idx="2486">
                  <c:v>1219.32</c:v>
                </c:pt>
                <c:pt idx="2487">
                  <c:v>676.94399999999996</c:v>
                </c:pt>
                <c:pt idx="2490">
                  <c:v>559.65599999999995</c:v>
                </c:pt>
                <c:pt idx="2492">
                  <c:v>1218.24</c:v>
                </c:pt>
                <c:pt idx="2493">
                  <c:v>1127.0899999999999</c:v>
                </c:pt>
                <c:pt idx="2494">
                  <c:v>582.33600000000001</c:v>
                </c:pt>
                <c:pt idx="2496">
                  <c:v>719.06399999999996</c:v>
                </c:pt>
                <c:pt idx="2501">
                  <c:v>1499.47</c:v>
                </c:pt>
                <c:pt idx="2502">
                  <c:v>195.91200000000001</c:v>
                </c:pt>
                <c:pt idx="2504">
                  <c:v>2466.0700000000002</c:v>
                </c:pt>
                <c:pt idx="2510">
                  <c:v>668.952</c:v>
                </c:pt>
                <c:pt idx="2512">
                  <c:v>658.58399999999995</c:v>
                </c:pt>
                <c:pt idx="2514">
                  <c:v>1062.72</c:v>
                </c:pt>
                <c:pt idx="2519">
                  <c:v>991.22400000000005</c:v>
                </c:pt>
                <c:pt idx="2526">
                  <c:v>415.8</c:v>
                </c:pt>
                <c:pt idx="2527">
                  <c:v>706.96799999999996</c:v>
                </c:pt>
                <c:pt idx="2534">
                  <c:v>577.58399999999995</c:v>
                </c:pt>
                <c:pt idx="2542">
                  <c:v>751.46400000000006</c:v>
                </c:pt>
                <c:pt idx="2544">
                  <c:v>1307.02</c:v>
                </c:pt>
                <c:pt idx="2548">
                  <c:v>1570.1</c:v>
                </c:pt>
                <c:pt idx="2552">
                  <c:v>642.16800000000001</c:v>
                </c:pt>
                <c:pt idx="2557">
                  <c:v>615.16800000000001</c:v>
                </c:pt>
                <c:pt idx="2561">
                  <c:v>1666.66</c:v>
                </c:pt>
                <c:pt idx="2562">
                  <c:v>521.85599999999999</c:v>
                </c:pt>
                <c:pt idx="2563">
                  <c:v>624.24</c:v>
                </c:pt>
                <c:pt idx="2567">
                  <c:v>860.76</c:v>
                </c:pt>
                <c:pt idx="2570">
                  <c:v>825.76800000000003</c:v>
                </c:pt>
                <c:pt idx="2576">
                  <c:v>1837.08</c:v>
                </c:pt>
                <c:pt idx="2578">
                  <c:v>639.14400000000001</c:v>
                </c:pt>
                <c:pt idx="2580">
                  <c:v>690.33600000000001</c:v>
                </c:pt>
                <c:pt idx="2582">
                  <c:v>195.48</c:v>
                </c:pt>
                <c:pt idx="2587">
                  <c:v>1315.87</c:v>
                </c:pt>
                <c:pt idx="2588">
                  <c:v>657.72</c:v>
                </c:pt>
                <c:pt idx="2596">
                  <c:v>916.70399999999995</c:v>
                </c:pt>
                <c:pt idx="2599">
                  <c:v>764.85599999999999</c:v>
                </c:pt>
                <c:pt idx="2602">
                  <c:v>145.584</c:v>
                </c:pt>
                <c:pt idx="2606">
                  <c:v>1197.29</c:v>
                </c:pt>
                <c:pt idx="2608">
                  <c:v>736.77599999999995</c:v>
                </c:pt>
                <c:pt idx="2611">
                  <c:v>1175.47</c:v>
                </c:pt>
                <c:pt idx="2615">
                  <c:v>708.048</c:v>
                </c:pt>
                <c:pt idx="2618">
                  <c:v>686.66399999999999</c:v>
                </c:pt>
                <c:pt idx="2622">
                  <c:v>531.14400000000001</c:v>
                </c:pt>
                <c:pt idx="2626">
                  <c:v>714.31200000000001</c:v>
                </c:pt>
                <c:pt idx="2629">
                  <c:v>577.15200000000004</c:v>
                </c:pt>
                <c:pt idx="2633">
                  <c:v>404.56799999999998</c:v>
                </c:pt>
                <c:pt idx="2634">
                  <c:v>1016.06</c:v>
                </c:pt>
                <c:pt idx="2635">
                  <c:v>1343.3</c:v>
                </c:pt>
                <c:pt idx="2637">
                  <c:v>762.048</c:v>
                </c:pt>
                <c:pt idx="2640">
                  <c:v>1371.17</c:v>
                </c:pt>
                <c:pt idx="2644">
                  <c:v>685.58399999999995</c:v>
                </c:pt>
                <c:pt idx="2647">
                  <c:v>931.60799999999995</c:v>
                </c:pt>
                <c:pt idx="2651">
                  <c:v>715.60799999999995</c:v>
                </c:pt>
                <c:pt idx="2667">
                  <c:v>816.26400000000001</c:v>
                </c:pt>
                <c:pt idx="2668">
                  <c:v>2110.54</c:v>
                </c:pt>
                <c:pt idx="2670">
                  <c:v>2072.3000000000002</c:v>
                </c:pt>
                <c:pt idx="2673">
                  <c:v>727.05600000000004</c:v>
                </c:pt>
                <c:pt idx="2674">
                  <c:v>68.471999999999994</c:v>
                </c:pt>
                <c:pt idx="2684">
                  <c:v>1423.87</c:v>
                </c:pt>
                <c:pt idx="2685">
                  <c:v>746.71199999999999</c:v>
                </c:pt>
                <c:pt idx="2686">
                  <c:v>2145.31</c:v>
                </c:pt>
                <c:pt idx="2689">
                  <c:v>699.40800000000002</c:v>
                </c:pt>
                <c:pt idx="2690">
                  <c:v>772.41600000000005</c:v>
                </c:pt>
                <c:pt idx="2691">
                  <c:v>1142.8599999999999</c:v>
                </c:pt>
                <c:pt idx="2693">
                  <c:v>1258.2</c:v>
                </c:pt>
                <c:pt idx="2694">
                  <c:v>3973.75</c:v>
                </c:pt>
                <c:pt idx="2695">
                  <c:v>1316.3</c:v>
                </c:pt>
                <c:pt idx="2697">
                  <c:v>1552.82</c:v>
                </c:pt>
                <c:pt idx="2704">
                  <c:v>584.06399999999996</c:v>
                </c:pt>
                <c:pt idx="2707">
                  <c:v>1108.51</c:v>
                </c:pt>
                <c:pt idx="2709">
                  <c:v>1335.53</c:v>
                </c:pt>
                <c:pt idx="2714">
                  <c:v>1122.1199999999999</c:v>
                </c:pt>
                <c:pt idx="2716">
                  <c:v>1326.02</c:v>
                </c:pt>
                <c:pt idx="2717">
                  <c:v>1756.08</c:v>
                </c:pt>
                <c:pt idx="2718">
                  <c:v>651.45600000000002</c:v>
                </c:pt>
                <c:pt idx="2724">
                  <c:v>633.096</c:v>
                </c:pt>
                <c:pt idx="2726">
                  <c:v>1645.92</c:v>
                </c:pt>
                <c:pt idx="2731">
                  <c:v>1929.31</c:v>
                </c:pt>
                <c:pt idx="2732">
                  <c:v>672.40800000000002</c:v>
                </c:pt>
                <c:pt idx="2734">
                  <c:v>1172.8800000000001</c:v>
                </c:pt>
                <c:pt idx="2736">
                  <c:v>771.12</c:v>
                </c:pt>
                <c:pt idx="2740">
                  <c:v>3527.28</c:v>
                </c:pt>
                <c:pt idx="2749">
                  <c:v>979.34400000000005</c:v>
                </c:pt>
                <c:pt idx="2755">
                  <c:v>1324.08</c:v>
                </c:pt>
                <c:pt idx="2757">
                  <c:v>625.75199999999995</c:v>
                </c:pt>
                <c:pt idx="2761">
                  <c:v>710.20799999999997</c:v>
                </c:pt>
                <c:pt idx="2767">
                  <c:v>1092.74</c:v>
                </c:pt>
                <c:pt idx="2768">
                  <c:v>817.77599999999995</c:v>
                </c:pt>
                <c:pt idx="2772">
                  <c:v>670.24800000000005</c:v>
                </c:pt>
                <c:pt idx="2780">
                  <c:v>1309.18</c:v>
                </c:pt>
                <c:pt idx="2782">
                  <c:v>1998</c:v>
                </c:pt>
                <c:pt idx="2785">
                  <c:v>1853.28</c:v>
                </c:pt>
                <c:pt idx="2793">
                  <c:v>1146.53</c:v>
                </c:pt>
                <c:pt idx="2795">
                  <c:v>1249.1300000000001</c:v>
                </c:pt>
                <c:pt idx="2796">
                  <c:v>1666.87</c:v>
                </c:pt>
                <c:pt idx="2804">
                  <c:v>3926.23</c:v>
                </c:pt>
                <c:pt idx="2808">
                  <c:v>121.608</c:v>
                </c:pt>
                <c:pt idx="2810">
                  <c:v>643.89599999999996</c:v>
                </c:pt>
                <c:pt idx="2812">
                  <c:v>1559.3</c:v>
                </c:pt>
                <c:pt idx="2813">
                  <c:v>913.89599999999996</c:v>
                </c:pt>
                <c:pt idx="2816">
                  <c:v>625.75199999999995</c:v>
                </c:pt>
                <c:pt idx="2820">
                  <c:v>944.78399999999999</c:v>
                </c:pt>
                <c:pt idx="2822">
                  <c:v>854.28</c:v>
                </c:pt>
                <c:pt idx="2823">
                  <c:v>1540.51</c:v>
                </c:pt>
                <c:pt idx="2825">
                  <c:v>1041.55</c:v>
                </c:pt>
                <c:pt idx="2829">
                  <c:v>824.47199999999998</c:v>
                </c:pt>
                <c:pt idx="2837">
                  <c:v>1162.94</c:v>
                </c:pt>
                <c:pt idx="2838">
                  <c:v>800.49599999999998</c:v>
                </c:pt>
                <c:pt idx="2840">
                  <c:v>609.98400000000004</c:v>
                </c:pt>
                <c:pt idx="2844">
                  <c:v>1340.06</c:v>
                </c:pt>
                <c:pt idx="2846">
                  <c:v>2194.56</c:v>
                </c:pt>
                <c:pt idx="2847">
                  <c:v>980.42399999999998</c:v>
                </c:pt>
                <c:pt idx="2848">
                  <c:v>601.99199999999996</c:v>
                </c:pt>
                <c:pt idx="2851">
                  <c:v>621.86400000000003</c:v>
                </c:pt>
                <c:pt idx="2855">
                  <c:v>686.23199999999997</c:v>
                </c:pt>
                <c:pt idx="2861">
                  <c:v>687.96</c:v>
                </c:pt>
                <c:pt idx="2865">
                  <c:v>554.47199999999998</c:v>
                </c:pt>
                <c:pt idx="2866">
                  <c:v>894.24</c:v>
                </c:pt>
                <c:pt idx="2867">
                  <c:v>919.51199999999994</c:v>
                </c:pt>
                <c:pt idx="2868">
                  <c:v>527.25599999999997</c:v>
                </c:pt>
                <c:pt idx="2872">
                  <c:v>716.04</c:v>
                </c:pt>
                <c:pt idx="2873">
                  <c:v>1556.06</c:v>
                </c:pt>
                <c:pt idx="2880">
                  <c:v>1177.8499999999999</c:v>
                </c:pt>
                <c:pt idx="2887">
                  <c:v>763.99199999999996</c:v>
                </c:pt>
                <c:pt idx="2888">
                  <c:v>582.33600000000001</c:v>
                </c:pt>
                <c:pt idx="2896">
                  <c:v>774.14400000000001</c:v>
                </c:pt>
                <c:pt idx="2899">
                  <c:v>988.84799999999996</c:v>
                </c:pt>
                <c:pt idx="2903">
                  <c:v>1211.33</c:v>
                </c:pt>
                <c:pt idx="2906">
                  <c:v>1133.1400000000001</c:v>
                </c:pt>
                <c:pt idx="2911">
                  <c:v>1584.79</c:v>
                </c:pt>
                <c:pt idx="2912">
                  <c:v>1201.3900000000001</c:v>
                </c:pt>
                <c:pt idx="2923">
                  <c:v>1840.97</c:v>
                </c:pt>
                <c:pt idx="2925">
                  <c:v>674.13599999999997</c:v>
                </c:pt>
                <c:pt idx="2932">
                  <c:v>745.2</c:v>
                </c:pt>
                <c:pt idx="2934">
                  <c:v>1239.8399999999999</c:v>
                </c:pt>
                <c:pt idx="2936">
                  <c:v>901.58399999999995</c:v>
                </c:pt>
                <c:pt idx="2942">
                  <c:v>902.01599999999996</c:v>
                </c:pt>
                <c:pt idx="2943">
                  <c:v>1388.02</c:v>
                </c:pt>
                <c:pt idx="2946">
                  <c:v>1085.18</c:v>
                </c:pt>
                <c:pt idx="2948">
                  <c:v>1353.67</c:v>
                </c:pt>
                <c:pt idx="2959">
                  <c:v>1138.75</c:v>
                </c:pt>
                <c:pt idx="2963">
                  <c:v>895.32</c:v>
                </c:pt>
                <c:pt idx="2968">
                  <c:v>2177.9299999999998</c:v>
                </c:pt>
                <c:pt idx="2971">
                  <c:v>1745.93</c:v>
                </c:pt>
                <c:pt idx="2977">
                  <c:v>1387.58</c:v>
                </c:pt>
                <c:pt idx="2978">
                  <c:v>1488.24</c:v>
                </c:pt>
                <c:pt idx="2982">
                  <c:v>852.12</c:v>
                </c:pt>
                <c:pt idx="2983">
                  <c:v>735.69600000000003</c:v>
                </c:pt>
                <c:pt idx="2988">
                  <c:v>984.31200000000001</c:v>
                </c:pt>
                <c:pt idx="2991">
                  <c:v>2103.62</c:v>
                </c:pt>
                <c:pt idx="2993">
                  <c:v>874.58399999999995</c:v>
                </c:pt>
                <c:pt idx="2998">
                  <c:v>1555.42</c:v>
                </c:pt>
                <c:pt idx="3000">
                  <c:v>562.89599999999996</c:v>
                </c:pt>
                <c:pt idx="3002">
                  <c:v>969.84</c:v>
                </c:pt>
                <c:pt idx="3003">
                  <c:v>715.82399999999996</c:v>
                </c:pt>
                <c:pt idx="3004">
                  <c:v>867.88800000000003</c:v>
                </c:pt>
                <c:pt idx="3008">
                  <c:v>919.29600000000005</c:v>
                </c:pt>
                <c:pt idx="3010">
                  <c:v>1318.9</c:v>
                </c:pt>
                <c:pt idx="3012">
                  <c:v>514.08000000000004</c:v>
                </c:pt>
                <c:pt idx="3016">
                  <c:v>1323.43</c:v>
                </c:pt>
                <c:pt idx="3022">
                  <c:v>540.21600000000001</c:v>
                </c:pt>
                <c:pt idx="3024">
                  <c:v>830.52</c:v>
                </c:pt>
                <c:pt idx="3026">
                  <c:v>2409.91</c:v>
                </c:pt>
                <c:pt idx="3029">
                  <c:v>1081.51</c:v>
                </c:pt>
                <c:pt idx="3034">
                  <c:v>942.62400000000002</c:v>
                </c:pt>
                <c:pt idx="3038">
                  <c:v>1094.04</c:v>
                </c:pt>
                <c:pt idx="3039">
                  <c:v>770.04</c:v>
                </c:pt>
                <c:pt idx="3043">
                  <c:v>771.33600000000001</c:v>
                </c:pt>
                <c:pt idx="3045">
                  <c:v>1293.4100000000001</c:v>
                </c:pt>
                <c:pt idx="3048">
                  <c:v>1557.79</c:v>
                </c:pt>
                <c:pt idx="3051">
                  <c:v>844.34400000000005</c:v>
                </c:pt>
                <c:pt idx="3052">
                  <c:v>2262.6</c:v>
                </c:pt>
                <c:pt idx="3056">
                  <c:v>2853.36</c:v>
                </c:pt>
                <c:pt idx="3057">
                  <c:v>1230.77</c:v>
                </c:pt>
                <c:pt idx="3061">
                  <c:v>1427.11</c:v>
                </c:pt>
                <c:pt idx="3064">
                  <c:v>943.27200000000005</c:v>
                </c:pt>
                <c:pt idx="3068">
                  <c:v>1228.82</c:v>
                </c:pt>
                <c:pt idx="3072">
                  <c:v>842.18399999999997</c:v>
                </c:pt>
                <c:pt idx="3074">
                  <c:v>64.152000000000001</c:v>
                </c:pt>
                <c:pt idx="3075">
                  <c:v>1130.33</c:v>
                </c:pt>
                <c:pt idx="3079">
                  <c:v>1698.84</c:v>
                </c:pt>
                <c:pt idx="3080">
                  <c:v>1466.42</c:v>
                </c:pt>
                <c:pt idx="3082">
                  <c:v>968.54399999999998</c:v>
                </c:pt>
                <c:pt idx="3083">
                  <c:v>730.72799999999995</c:v>
                </c:pt>
                <c:pt idx="3087">
                  <c:v>1071.3599999999999</c:v>
                </c:pt>
                <c:pt idx="3090">
                  <c:v>1924.56</c:v>
                </c:pt>
                <c:pt idx="3100">
                  <c:v>916.05600000000004</c:v>
                </c:pt>
                <c:pt idx="3104">
                  <c:v>1904.26</c:v>
                </c:pt>
                <c:pt idx="3106">
                  <c:v>643.67999999999995</c:v>
                </c:pt>
                <c:pt idx="3108">
                  <c:v>800.71199999999999</c:v>
                </c:pt>
                <c:pt idx="3110">
                  <c:v>695.952</c:v>
                </c:pt>
                <c:pt idx="3115">
                  <c:v>869.18399999999997</c:v>
                </c:pt>
                <c:pt idx="3116">
                  <c:v>1364.26</c:v>
                </c:pt>
                <c:pt idx="3118">
                  <c:v>1546.78</c:v>
                </c:pt>
                <c:pt idx="3121">
                  <c:v>663.55200000000002</c:v>
                </c:pt>
                <c:pt idx="3123">
                  <c:v>493.56</c:v>
                </c:pt>
                <c:pt idx="3124">
                  <c:v>1014.12</c:v>
                </c:pt>
                <c:pt idx="3145">
                  <c:v>1628.64</c:v>
                </c:pt>
                <c:pt idx="3147">
                  <c:v>1246.32</c:v>
                </c:pt>
                <c:pt idx="3150">
                  <c:v>722.73599999999999</c:v>
                </c:pt>
                <c:pt idx="3154">
                  <c:v>1014.55</c:v>
                </c:pt>
                <c:pt idx="3156">
                  <c:v>493.34399999999999</c:v>
                </c:pt>
                <c:pt idx="3158">
                  <c:v>3186.43</c:v>
                </c:pt>
                <c:pt idx="3162">
                  <c:v>1173.96</c:v>
                </c:pt>
                <c:pt idx="3164">
                  <c:v>1028.5899999999999</c:v>
                </c:pt>
                <c:pt idx="3165">
                  <c:v>1282.82</c:v>
                </c:pt>
                <c:pt idx="3167">
                  <c:v>1099.8699999999999</c:v>
                </c:pt>
                <c:pt idx="3171">
                  <c:v>1151.5</c:v>
                </c:pt>
                <c:pt idx="3175">
                  <c:v>1113.48</c:v>
                </c:pt>
                <c:pt idx="3178">
                  <c:v>813.88800000000003</c:v>
                </c:pt>
                <c:pt idx="3179">
                  <c:v>789.048</c:v>
                </c:pt>
                <c:pt idx="3186">
                  <c:v>897.48</c:v>
                </c:pt>
                <c:pt idx="3187">
                  <c:v>1442.88</c:v>
                </c:pt>
                <c:pt idx="3189">
                  <c:v>3537.86</c:v>
                </c:pt>
                <c:pt idx="3192">
                  <c:v>608.25599999999997</c:v>
                </c:pt>
                <c:pt idx="3193">
                  <c:v>876.74400000000003</c:v>
                </c:pt>
                <c:pt idx="3198">
                  <c:v>817.56</c:v>
                </c:pt>
                <c:pt idx="3204">
                  <c:v>899.42399999999998</c:v>
                </c:pt>
                <c:pt idx="3206">
                  <c:v>1340.93</c:v>
                </c:pt>
                <c:pt idx="3209">
                  <c:v>621.21600000000001</c:v>
                </c:pt>
                <c:pt idx="3215">
                  <c:v>959.04</c:v>
                </c:pt>
                <c:pt idx="3218">
                  <c:v>747.14400000000001</c:v>
                </c:pt>
                <c:pt idx="3222">
                  <c:v>941.11199999999997</c:v>
                </c:pt>
                <c:pt idx="3223">
                  <c:v>981.28800000000001</c:v>
                </c:pt>
                <c:pt idx="3228">
                  <c:v>736.12800000000004</c:v>
                </c:pt>
                <c:pt idx="3229">
                  <c:v>874.15200000000004</c:v>
                </c:pt>
                <c:pt idx="3230">
                  <c:v>833.11199999999997</c:v>
                </c:pt>
                <c:pt idx="3237">
                  <c:v>1002.02</c:v>
                </c:pt>
                <c:pt idx="3238">
                  <c:v>1336.82</c:v>
                </c:pt>
                <c:pt idx="3242">
                  <c:v>733.75199999999995</c:v>
                </c:pt>
                <c:pt idx="3247">
                  <c:v>1360.15</c:v>
                </c:pt>
                <c:pt idx="3258">
                  <c:v>634.39200000000005</c:v>
                </c:pt>
                <c:pt idx="3262">
                  <c:v>676.51199999999994</c:v>
                </c:pt>
                <c:pt idx="3263">
                  <c:v>1063.1500000000001</c:v>
                </c:pt>
                <c:pt idx="3269">
                  <c:v>970.05600000000004</c:v>
                </c:pt>
                <c:pt idx="3274">
                  <c:v>1011.31</c:v>
                </c:pt>
                <c:pt idx="3280">
                  <c:v>1570.32</c:v>
                </c:pt>
                <c:pt idx="3286">
                  <c:v>870.048</c:v>
                </c:pt>
                <c:pt idx="3287">
                  <c:v>948.67200000000003</c:v>
                </c:pt>
                <c:pt idx="3288">
                  <c:v>811.08</c:v>
                </c:pt>
                <c:pt idx="3290">
                  <c:v>983.23199999999997</c:v>
                </c:pt>
                <c:pt idx="3293">
                  <c:v>912.38400000000001</c:v>
                </c:pt>
                <c:pt idx="3294">
                  <c:v>1396.87</c:v>
                </c:pt>
                <c:pt idx="3297">
                  <c:v>1650.89</c:v>
                </c:pt>
                <c:pt idx="3301">
                  <c:v>1252.1500000000001</c:v>
                </c:pt>
                <c:pt idx="3303">
                  <c:v>1111.32</c:v>
                </c:pt>
                <c:pt idx="3311">
                  <c:v>761.18399999999997</c:v>
                </c:pt>
                <c:pt idx="3313">
                  <c:v>1912.68</c:v>
                </c:pt>
                <c:pt idx="3321">
                  <c:v>2020.9</c:v>
                </c:pt>
                <c:pt idx="3329">
                  <c:v>619.05600000000004</c:v>
                </c:pt>
                <c:pt idx="3330">
                  <c:v>734.4</c:v>
                </c:pt>
                <c:pt idx="3333">
                  <c:v>762.69600000000003</c:v>
                </c:pt>
                <c:pt idx="3334">
                  <c:v>826.84799999999996</c:v>
                </c:pt>
                <c:pt idx="3337">
                  <c:v>1504.87</c:v>
                </c:pt>
                <c:pt idx="3338">
                  <c:v>1268.3499999999999</c:v>
                </c:pt>
                <c:pt idx="3343">
                  <c:v>975.45600000000002</c:v>
                </c:pt>
                <c:pt idx="3345">
                  <c:v>1384.56</c:v>
                </c:pt>
                <c:pt idx="3346">
                  <c:v>1574.21</c:v>
                </c:pt>
                <c:pt idx="3353">
                  <c:v>1513.73</c:v>
                </c:pt>
                <c:pt idx="3356">
                  <c:v>766.15200000000004</c:v>
                </c:pt>
                <c:pt idx="3363">
                  <c:v>896.83199999999999</c:v>
                </c:pt>
                <c:pt idx="3370">
                  <c:v>1403.14</c:v>
                </c:pt>
                <c:pt idx="3372">
                  <c:v>1084.32</c:v>
                </c:pt>
                <c:pt idx="3376">
                  <c:v>1081.94</c:v>
                </c:pt>
                <c:pt idx="3379">
                  <c:v>1748.52</c:v>
                </c:pt>
                <c:pt idx="3380">
                  <c:v>1578.53</c:v>
                </c:pt>
                <c:pt idx="3383">
                  <c:v>1040.26</c:v>
                </c:pt>
                <c:pt idx="3384">
                  <c:v>844.77599999999995</c:v>
                </c:pt>
                <c:pt idx="3388">
                  <c:v>1454.54</c:v>
                </c:pt>
                <c:pt idx="3389">
                  <c:v>1430.78</c:v>
                </c:pt>
                <c:pt idx="3390">
                  <c:v>1313.5</c:v>
                </c:pt>
                <c:pt idx="3391">
                  <c:v>769.39200000000005</c:v>
                </c:pt>
                <c:pt idx="3392">
                  <c:v>1059.48</c:v>
                </c:pt>
                <c:pt idx="3393">
                  <c:v>1244.5899999999999</c:v>
                </c:pt>
                <c:pt idx="3395">
                  <c:v>1181.95</c:v>
                </c:pt>
                <c:pt idx="3396">
                  <c:v>1208.74</c:v>
                </c:pt>
                <c:pt idx="3397">
                  <c:v>834.40800000000002</c:v>
                </c:pt>
                <c:pt idx="3400">
                  <c:v>1771.2</c:v>
                </c:pt>
                <c:pt idx="3401">
                  <c:v>921.24</c:v>
                </c:pt>
                <c:pt idx="3403">
                  <c:v>1017.36</c:v>
                </c:pt>
                <c:pt idx="3404">
                  <c:v>1066.6099999999999</c:v>
                </c:pt>
                <c:pt idx="3405">
                  <c:v>13231.9</c:v>
                </c:pt>
                <c:pt idx="3409">
                  <c:v>574.12800000000004</c:v>
                </c:pt>
                <c:pt idx="3411">
                  <c:v>1022.98</c:v>
                </c:pt>
                <c:pt idx="3412">
                  <c:v>775.22400000000005</c:v>
                </c:pt>
                <c:pt idx="3415">
                  <c:v>814.75199999999995</c:v>
                </c:pt>
                <c:pt idx="3428">
                  <c:v>961.84799999999996</c:v>
                </c:pt>
                <c:pt idx="3429">
                  <c:v>96.983999999999995</c:v>
                </c:pt>
                <c:pt idx="3430">
                  <c:v>1176.55</c:v>
                </c:pt>
                <c:pt idx="3433">
                  <c:v>2296.73</c:v>
                </c:pt>
                <c:pt idx="3444">
                  <c:v>1749.82</c:v>
                </c:pt>
                <c:pt idx="3447">
                  <c:v>653.18399999999997</c:v>
                </c:pt>
                <c:pt idx="3449">
                  <c:v>1028.5899999999999</c:v>
                </c:pt>
                <c:pt idx="3460">
                  <c:v>999.43200000000002</c:v>
                </c:pt>
                <c:pt idx="3465">
                  <c:v>997.05600000000004</c:v>
                </c:pt>
                <c:pt idx="3472">
                  <c:v>836.13599999999997</c:v>
                </c:pt>
                <c:pt idx="3474">
                  <c:v>767.23199999999997</c:v>
                </c:pt>
                <c:pt idx="3484">
                  <c:v>1716.77</c:v>
                </c:pt>
                <c:pt idx="3486">
                  <c:v>1510.92</c:v>
                </c:pt>
                <c:pt idx="3489">
                  <c:v>1059.26</c:v>
                </c:pt>
                <c:pt idx="3491">
                  <c:v>687.96</c:v>
                </c:pt>
                <c:pt idx="3495">
                  <c:v>1802.74</c:v>
                </c:pt>
                <c:pt idx="3496">
                  <c:v>744.76800000000003</c:v>
                </c:pt>
                <c:pt idx="3498">
                  <c:v>651.88800000000003</c:v>
                </c:pt>
                <c:pt idx="3504">
                  <c:v>797.47199999999998</c:v>
                </c:pt>
                <c:pt idx="3506">
                  <c:v>1624.54</c:v>
                </c:pt>
                <c:pt idx="3507">
                  <c:v>822.31200000000001</c:v>
                </c:pt>
                <c:pt idx="3519">
                  <c:v>1734.91</c:v>
                </c:pt>
                <c:pt idx="3522">
                  <c:v>620.13599999999997</c:v>
                </c:pt>
                <c:pt idx="3529">
                  <c:v>1283.9000000000001</c:v>
                </c:pt>
                <c:pt idx="3531">
                  <c:v>1235.0899999999999</c:v>
                </c:pt>
                <c:pt idx="3538">
                  <c:v>1255.82</c:v>
                </c:pt>
                <c:pt idx="3540">
                  <c:v>655.99199999999996</c:v>
                </c:pt>
                <c:pt idx="3543">
                  <c:v>1203.98</c:v>
                </c:pt>
                <c:pt idx="3544">
                  <c:v>664.84799999999996</c:v>
                </c:pt>
                <c:pt idx="3547">
                  <c:v>1422.14</c:v>
                </c:pt>
                <c:pt idx="3548">
                  <c:v>541.72799999999995</c:v>
                </c:pt>
                <c:pt idx="3549">
                  <c:v>681.048</c:v>
                </c:pt>
                <c:pt idx="3550">
                  <c:v>1365.55</c:v>
                </c:pt>
                <c:pt idx="3552">
                  <c:v>1401.62</c:v>
                </c:pt>
                <c:pt idx="3554">
                  <c:v>687.31200000000001</c:v>
                </c:pt>
                <c:pt idx="3556">
                  <c:v>1645.06</c:v>
                </c:pt>
                <c:pt idx="3557">
                  <c:v>807.62400000000002</c:v>
                </c:pt>
                <c:pt idx="3562">
                  <c:v>1170.5</c:v>
                </c:pt>
                <c:pt idx="3566">
                  <c:v>1186.7</c:v>
                </c:pt>
                <c:pt idx="3571">
                  <c:v>1254.0999999999999</c:v>
                </c:pt>
                <c:pt idx="3572">
                  <c:v>1323</c:v>
                </c:pt>
                <c:pt idx="3576">
                  <c:v>944.78399999999999</c:v>
                </c:pt>
                <c:pt idx="3581">
                  <c:v>1143.72</c:v>
                </c:pt>
                <c:pt idx="3584">
                  <c:v>747.14400000000001</c:v>
                </c:pt>
                <c:pt idx="3585">
                  <c:v>669.6</c:v>
                </c:pt>
                <c:pt idx="3586">
                  <c:v>1075.9000000000001</c:v>
                </c:pt>
                <c:pt idx="3588">
                  <c:v>521.64</c:v>
                </c:pt>
                <c:pt idx="3596">
                  <c:v>719.71199999999999</c:v>
                </c:pt>
                <c:pt idx="3597">
                  <c:v>960.33600000000001</c:v>
                </c:pt>
                <c:pt idx="3598">
                  <c:v>962.71199999999999</c:v>
                </c:pt>
                <c:pt idx="3604">
                  <c:v>1294.06</c:v>
                </c:pt>
                <c:pt idx="3605">
                  <c:v>681.69600000000003</c:v>
                </c:pt>
                <c:pt idx="3606">
                  <c:v>1671.19</c:v>
                </c:pt>
                <c:pt idx="3613">
                  <c:v>851.25599999999997</c:v>
                </c:pt>
                <c:pt idx="3614">
                  <c:v>711.72</c:v>
                </c:pt>
                <c:pt idx="3615">
                  <c:v>595.94399999999996</c:v>
                </c:pt>
                <c:pt idx="3616">
                  <c:v>1033.78</c:v>
                </c:pt>
                <c:pt idx="3617">
                  <c:v>712.36800000000005</c:v>
                </c:pt>
                <c:pt idx="3620">
                  <c:v>1197.07</c:v>
                </c:pt>
                <c:pt idx="3621">
                  <c:v>1349.14</c:v>
                </c:pt>
                <c:pt idx="3623">
                  <c:v>1056.67</c:v>
                </c:pt>
                <c:pt idx="3628">
                  <c:v>1524.53</c:v>
                </c:pt>
                <c:pt idx="3630">
                  <c:v>800.49599999999998</c:v>
                </c:pt>
                <c:pt idx="3633">
                  <c:v>1295.78</c:v>
                </c:pt>
                <c:pt idx="3639">
                  <c:v>994.24800000000005</c:v>
                </c:pt>
                <c:pt idx="3640">
                  <c:v>791.20799999999997</c:v>
                </c:pt>
                <c:pt idx="3648">
                  <c:v>1732.32</c:v>
                </c:pt>
                <c:pt idx="3650">
                  <c:v>808.05600000000004</c:v>
                </c:pt>
                <c:pt idx="3653">
                  <c:v>1522.58</c:v>
                </c:pt>
                <c:pt idx="3655">
                  <c:v>749.952</c:v>
                </c:pt>
                <c:pt idx="3656">
                  <c:v>1288.44</c:v>
                </c:pt>
                <c:pt idx="3667">
                  <c:v>666.79200000000003</c:v>
                </c:pt>
                <c:pt idx="3673">
                  <c:v>748.22400000000005</c:v>
                </c:pt>
                <c:pt idx="3675">
                  <c:v>747.36</c:v>
                </c:pt>
                <c:pt idx="3677">
                  <c:v>902.44799999999998</c:v>
                </c:pt>
                <c:pt idx="3678">
                  <c:v>849.52800000000002</c:v>
                </c:pt>
                <c:pt idx="3681">
                  <c:v>781.48800000000006</c:v>
                </c:pt>
                <c:pt idx="3684">
                  <c:v>2491.56</c:v>
                </c:pt>
                <c:pt idx="3690">
                  <c:v>514.72799999999995</c:v>
                </c:pt>
                <c:pt idx="3691">
                  <c:v>701.35199999999998</c:v>
                </c:pt>
                <c:pt idx="3703">
                  <c:v>817.12800000000004</c:v>
                </c:pt>
                <c:pt idx="3709">
                  <c:v>813.88800000000003</c:v>
                </c:pt>
                <c:pt idx="3719">
                  <c:v>937.87199999999996</c:v>
                </c:pt>
                <c:pt idx="3724">
                  <c:v>1248.9100000000001</c:v>
                </c:pt>
                <c:pt idx="3726">
                  <c:v>621.64800000000002</c:v>
                </c:pt>
                <c:pt idx="3736">
                  <c:v>1124.28</c:v>
                </c:pt>
                <c:pt idx="3738">
                  <c:v>2369.09</c:v>
                </c:pt>
                <c:pt idx="3741">
                  <c:v>1054.51</c:v>
                </c:pt>
                <c:pt idx="3743">
                  <c:v>863.78399999999999</c:v>
                </c:pt>
                <c:pt idx="3744">
                  <c:v>1834.06</c:v>
                </c:pt>
                <c:pt idx="3750">
                  <c:v>1011.1</c:v>
                </c:pt>
                <c:pt idx="3751">
                  <c:v>778.46400000000006</c:v>
                </c:pt>
                <c:pt idx="3752">
                  <c:v>1440.5</c:v>
                </c:pt>
                <c:pt idx="3753">
                  <c:v>679.96799999999996</c:v>
                </c:pt>
                <c:pt idx="3761">
                  <c:v>900.72</c:v>
                </c:pt>
                <c:pt idx="3763">
                  <c:v>737.42399999999998</c:v>
                </c:pt>
                <c:pt idx="3764">
                  <c:v>704.59199999999998</c:v>
                </c:pt>
                <c:pt idx="3765">
                  <c:v>999.21600000000001</c:v>
                </c:pt>
                <c:pt idx="3766">
                  <c:v>866.37599999999998</c:v>
                </c:pt>
                <c:pt idx="3767">
                  <c:v>1122.1199999999999</c:v>
                </c:pt>
                <c:pt idx="3769">
                  <c:v>1153.6600000000001</c:v>
                </c:pt>
                <c:pt idx="3773">
                  <c:v>626.18399999999997</c:v>
                </c:pt>
                <c:pt idx="3774">
                  <c:v>757.29600000000005</c:v>
                </c:pt>
                <c:pt idx="3775">
                  <c:v>938.73599999999999</c:v>
                </c:pt>
                <c:pt idx="3780">
                  <c:v>860.76</c:v>
                </c:pt>
                <c:pt idx="3784">
                  <c:v>600.26400000000001</c:v>
                </c:pt>
                <c:pt idx="3787">
                  <c:v>1502.28</c:v>
                </c:pt>
                <c:pt idx="3788">
                  <c:v>1686.31</c:v>
                </c:pt>
                <c:pt idx="3792">
                  <c:v>762.69600000000003</c:v>
                </c:pt>
                <c:pt idx="3802">
                  <c:v>673.05600000000004</c:v>
                </c:pt>
                <c:pt idx="3805">
                  <c:v>830.30399999999997</c:v>
                </c:pt>
                <c:pt idx="3807">
                  <c:v>3382.34</c:v>
                </c:pt>
                <c:pt idx="3808">
                  <c:v>1193.83</c:v>
                </c:pt>
                <c:pt idx="3811">
                  <c:v>1402.7</c:v>
                </c:pt>
                <c:pt idx="3819">
                  <c:v>742.60799999999995</c:v>
                </c:pt>
                <c:pt idx="3825">
                  <c:v>1402.27</c:v>
                </c:pt>
                <c:pt idx="3831">
                  <c:v>640.65599999999995</c:v>
                </c:pt>
                <c:pt idx="3837">
                  <c:v>930.096</c:v>
                </c:pt>
                <c:pt idx="3839">
                  <c:v>968.976</c:v>
                </c:pt>
                <c:pt idx="3841">
                  <c:v>1281.96</c:v>
                </c:pt>
                <c:pt idx="3842">
                  <c:v>748.44</c:v>
                </c:pt>
                <c:pt idx="3844">
                  <c:v>1548.94</c:v>
                </c:pt>
                <c:pt idx="3847">
                  <c:v>755.13599999999997</c:v>
                </c:pt>
                <c:pt idx="3849">
                  <c:v>598.32000000000005</c:v>
                </c:pt>
                <c:pt idx="3850">
                  <c:v>1215.8599999999999</c:v>
                </c:pt>
                <c:pt idx="3851">
                  <c:v>1544.18</c:v>
                </c:pt>
                <c:pt idx="3853">
                  <c:v>1265.76</c:v>
                </c:pt>
                <c:pt idx="3855">
                  <c:v>754.48800000000006</c:v>
                </c:pt>
                <c:pt idx="3857">
                  <c:v>1239.4100000000001</c:v>
                </c:pt>
                <c:pt idx="3862">
                  <c:v>801.14400000000001</c:v>
                </c:pt>
                <c:pt idx="3863">
                  <c:v>1662.12</c:v>
                </c:pt>
                <c:pt idx="3864">
                  <c:v>780.62400000000002</c:v>
                </c:pt>
                <c:pt idx="3865">
                  <c:v>769.82399999999996</c:v>
                </c:pt>
                <c:pt idx="3866">
                  <c:v>1173.96</c:v>
                </c:pt>
                <c:pt idx="3878">
                  <c:v>851.04</c:v>
                </c:pt>
                <c:pt idx="3882">
                  <c:v>934.63199999999995</c:v>
                </c:pt>
                <c:pt idx="3883">
                  <c:v>637.20000000000005</c:v>
                </c:pt>
                <c:pt idx="3888">
                  <c:v>797.25599999999997</c:v>
                </c:pt>
                <c:pt idx="3891">
                  <c:v>1740.53</c:v>
                </c:pt>
                <c:pt idx="3901">
                  <c:v>775.22400000000005</c:v>
                </c:pt>
                <c:pt idx="3907">
                  <c:v>872.20799999999997</c:v>
                </c:pt>
                <c:pt idx="3908">
                  <c:v>1254.0999999999999</c:v>
                </c:pt>
                <c:pt idx="3912">
                  <c:v>1082.5899999999999</c:v>
                </c:pt>
                <c:pt idx="3916">
                  <c:v>1538.57</c:v>
                </c:pt>
                <c:pt idx="3918">
                  <c:v>725.976</c:v>
                </c:pt>
                <c:pt idx="3922">
                  <c:v>2509.4899999999998</c:v>
                </c:pt>
                <c:pt idx="3924">
                  <c:v>662.04</c:v>
                </c:pt>
                <c:pt idx="3927">
                  <c:v>1180.22</c:v>
                </c:pt>
                <c:pt idx="3928">
                  <c:v>1114.1300000000001</c:v>
                </c:pt>
                <c:pt idx="3929">
                  <c:v>817.77599999999995</c:v>
                </c:pt>
                <c:pt idx="3933">
                  <c:v>596.80799999999999</c:v>
                </c:pt>
                <c:pt idx="3935">
                  <c:v>1590.19</c:v>
                </c:pt>
                <c:pt idx="3937">
                  <c:v>835.05600000000004</c:v>
                </c:pt>
                <c:pt idx="3938">
                  <c:v>1638.14</c:v>
                </c:pt>
                <c:pt idx="3941">
                  <c:v>789.048</c:v>
                </c:pt>
                <c:pt idx="3944">
                  <c:v>954.072</c:v>
                </c:pt>
                <c:pt idx="3949">
                  <c:v>1033.99</c:v>
                </c:pt>
                <c:pt idx="3952">
                  <c:v>995.54399999999998</c:v>
                </c:pt>
                <c:pt idx="3957">
                  <c:v>1443.1</c:v>
                </c:pt>
                <c:pt idx="3958">
                  <c:v>1035.29</c:v>
                </c:pt>
                <c:pt idx="3966">
                  <c:v>505.44</c:v>
                </c:pt>
                <c:pt idx="3968">
                  <c:v>1060.78</c:v>
                </c:pt>
                <c:pt idx="3971">
                  <c:v>1304.6400000000001</c:v>
                </c:pt>
                <c:pt idx="3976">
                  <c:v>824.904</c:v>
                </c:pt>
                <c:pt idx="3983">
                  <c:v>859.24800000000005</c:v>
                </c:pt>
                <c:pt idx="3994">
                  <c:v>687.52800000000002</c:v>
                </c:pt>
                <c:pt idx="3997">
                  <c:v>702.86400000000003</c:v>
                </c:pt>
                <c:pt idx="3998">
                  <c:v>2186.5700000000002</c:v>
                </c:pt>
                <c:pt idx="4000">
                  <c:v>1381.1</c:v>
                </c:pt>
                <c:pt idx="4001">
                  <c:v>922.96799999999996</c:v>
                </c:pt>
                <c:pt idx="4007">
                  <c:v>450.57600000000002</c:v>
                </c:pt>
                <c:pt idx="4012">
                  <c:v>894.45600000000002</c:v>
                </c:pt>
                <c:pt idx="4013">
                  <c:v>1796.47</c:v>
                </c:pt>
                <c:pt idx="4021">
                  <c:v>991.87199999999996</c:v>
                </c:pt>
                <c:pt idx="4032">
                  <c:v>746.06399999999996</c:v>
                </c:pt>
                <c:pt idx="4034">
                  <c:v>1126.6600000000001</c:v>
                </c:pt>
                <c:pt idx="4036">
                  <c:v>937.65599999999995</c:v>
                </c:pt>
                <c:pt idx="4038">
                  <c:v>900.072</c:v>
                </c:pt>
                <c:pt idx="4039">
                  <c:v>319.89600000000002</c:v>
                </c:pt>
                <c:pt idx="4040">
                  <c:v>1813.54</c:v>
                </c:pt>
                <c:pt idx="4045">
                  <c:v>702.43200000000002</c:v>
                </c:pt>
                <c:pt idx="4047">
                  <c:v>1451.3</c:v>
                </c:pt>
                <c:pt idx="4048">
                  <c:v>868.96799999999996</c:v>
                </c:pt>
                <c:pt idx="4053">
                  <c:v>1282.18</c:v>
                </c:pt>
                <c:pt idx="4056">
                  <c:v>734.61599999999999</c:v>
                </c:pt>
                <c:pt idx="4058">
                  <c:v>1363.39</c:v>
                </c:pt>
                <c:pt idx="4060">
                  <c:v>952.77599999999995</c:v>
                </c:pt>
                <c:pt idx="4061">
                  <c:v>1603.15</c:v>
                </c:pt>
                <c:pt idx="4062">
                  <c:v>848.66399999999999</c:v>
                </c:pt>
                <c:pt idx="4065">
                  <c:v>1205.28</c:v>
                </c:pt>
                <c:pt idx="4070">
                  <c:v>713.88</c:v>
                </c:pt>
                <c:pt idx="4071">
                  <c:v>1037.45</c:v>
                </c:pt>
                <c:pt idx="4072">
                  <c:v>1758.24</c:v>
                </c:pt>
                <c:pt idx="4073">
                  <c:v>1201.6099999999999</c:v>
                </c:pt>
                <c:pt idx="4075">
                  <c:v>970.05600000000004</c:v>
                </c:pt>
                <c:pt idx="4079">
                  <c:v>922.32</c:v>
                </c:pt>
                <c:pt idx="4082">
                  <c:v>854.928</c:v>
                </c:pt>
                <c:pt idx="4083">
                  <c:v>942.84</c:v>
                </c:pt>
                <c:pt idx="4086">
                  <c:v>714.96</c:v>
                </c:pt>
                <c:pt idx="4095">
                  <c:v>5994</c:v>
                </c:pt>
                <c:pt idx="4098">
                  <c:v>794.01599999999996</c:v>
                </c:pt>
                <c:pt idx="4099">
                  <c:v>237.816</c:v>
                </c:pt>
                <c:pt idx="4102">
                  <c:v>1482.41</c:v>
                </c:pt>
                <c:pt idx="4105">
                  <c:v>668.52</c:v>
                </c:pt>
                <c:pt idx="4109">
                  <c:v>589.46400000000006</c:v>
                </c:pt>
                <c:pt idx="4111">
                  <c:v>484.92</c:v>
                </c:pt>
                <c:pt idx="4113">
                  <c:v>1524.31</c:v>
                </c:pt>
                <c:pt idx="4114">
                  <c:v>1085.83</c:v>
                </c:pt>
                <c:pt idx="4119">
                  <c:v>756.21600000000001</c:v>
                </c:pt>
                <c:pt idx="4123">
                  <c:v>1340.71</c:v>
                </c:pt>
                <c:pt idx="4124">
                  <c:v>481.89600000000002</c:v>
                </c:pt>
                <c:pt idx="4136">
                  <c:v>634.17600000000004</c:v>
                </c:pt>
                <c:pt idx="4142">
                  <c:v>704.16</c:v>
                </c:pt>
                <c:pt idx="4149">
                  <c:v>715.60799999999995</c:v>
                </c:pt>
                <c:pt idx="4153">
                  <c:v>1204.2</c:v>
                </c:pt>
                <c:pt idx="4156">
                  <c:v>3563.35</c:v>
                </c:pt>
                <c:pt idx="4157">
                  <c:v>1913.54</c:v>
                </c:pt>
                <c:pt idx="4166">
                  <c:v>724.68</c:v>
                </c:pt>
                <c:pt idx="4168">
                  <c:v>1002.46</c:v>
                </c:pt>
                <c:pt idx="4173">
                  <c:v>984.74400000000003</c:v>
                </c:pt>
                <c:pt idx="4174">
                  <c:v>1077.19</c:v>
                </c:pt>
                <c:pt idx="4176">
                  <c:v>2286.58</c:v>
                </c:pt>
                <c:pt idx="4178">
                  <c:v>1809.65</c:v>
                </c:pt>
                <c:pt idx="4179">
                  <c:v>971.56799999999998</c:v>
                </c:pt>
                <c:pt idx="4180">
                  <c:v>973.94399999999996</c:v>
                </c:pt>
                <c:pt idx="4182">
                  <c:v>1301.4000000000001</c:v>
                </c:pt>
                <c:pt idx="4184">
                  <c:v>486.64800000000002</c:v>
                </c:pt>
                <c:pt idx="4186">
                  <c:v>849.31200000000001</c:v>
                </c:pt>
                <c:pt idx="4187">
                  <c:v>1395.14</c:v>
                </c:pt>
                <c:pt idx="4193">
                  <c:v>1303.78</c:v>
                </c:pt>
                <c:pt idx="4195">
                  <c:v>871.99199999999996</c:v>
                </c:pt>
                <c:pt idx="4196">
                  <c:v>642.81600000000003</c:v>
                </c:pt>
                <c:pt idx="4200">
                  <c:v>708.48</c:v>
                </c:pt>
                <c:pt idx="4202">
                  <c:v>3237.62</c:v>
                </c:pt>
                <c:pt idx="4212">
                  <c:v>5405.4</c:v>
                </c:pt>
                <c:pt idx="4214">
                  <c:v>1644.84</c:v>
                </c:pt>
                <c:pt idx="4234">
                  <c:v>1073.0899999999999</c:v>
                </c:pt>
                <c:pt idx="4237">
                  <c:v>713.44799999999998</c:v>
                </c:pt>
                <c:pt idx="4244">
                  <c:v>1043.93</c:v>
                </c:pt>
                <c:pt idx="4247">
                  <c:v>1003.75</c:v>
                </c:pt>
                <c:pt idx="4255">
                  <c:v>1382.18</c:v>
                </c:pt>
                <c:pt idx="4256">
                  <c:v>815.83199999999999</c:v>
                </c:pt>
                <c:pt idx="4258">
                  <c:v>694.87199999999996</c:v>
                </c:pt>
                <c:pt idx="4261">
                  <c:v>1569.67</c:v>
                </c:pt>
                <c:pt idx="4264">
                  <c:v>1041.1199999999999</c:v>
                </c:pt>
                <c:pt idx="4266">
                  <c:v>848.66399999999999</c:v>
                </c:pt>
                <c:pt idx="4268">
                  <c:v>1940.54</c:v>
                </c:pt>
                <c:pt idx="4269">
                  <c:v>883.65599999999995</c:v>
                </c:pt>
                <c:pt idx="4271">
                  <c:v>1367.71</c:v>
                </c:pt>
                <c:pt idx="4275">
                  <c:v>1052.78</c:v>
                </c:pt>
                <c:pt idx="4277">
                  <c:v>858.38400000000001</c:v>
                </c:pt>
                <c:pt idx="4283">
                  <c:v>270</c:v>
                </c:pt>
                <c:pt idx="4286">
                  <c:v>2357.42</c:v>
                </c:pt>
                <c:pt idx="4287">
                  <c:v>1453.25</c:v>
                </c:pt>
                <c:pt idx="4299">
                  <c:v>1226.8800000000001</c:v>
                </c:pt>
                <c:pt idx="4303">
                  <c:v>928.36800000000005</c:v>
                </c:pt>
                <c:pt idx="4304">
                  <c:v>1307.23</c:v>
                </c:pt>
                <c:pt idx="4308">
                  <c:v>1451.3</c:v>
                </c:pt>
                <c:pt idx="4310">
                  <c:v>1190.81</c:v>
                </c:pt>
                <c:pt idx="4311">
                  <c:v>698.32799999999997</c:v>
                </c:pt>
                <c:pt idx="4314">
                  <c:v>851.47199999999998</c:v>
                </c:pt>
                <c:pt idx="4315">
                  <c:v>2004.48</c:v>
                </c:pt>
                <c:pt idx="4316">
                  <c:v>978.48</c:v>
                </c:pt>
                <c:pt idx="4325">
                  <c:v>932.47199999999998</c:v>
                </c:pt>
                <c:pt idx="4327">
                  <c:v>450.79199999999997</c:v>
                </c:pt>
                <c:pt idx="4328">
                  <c:v>1227.74</c:v>
                </c:pt>
                <c:pt idx="4330">
                  <c:v>845.42399999999998</c:v>
                </c:pt>
                <c:pt idx="4336">
                  <c:v>621.64800000000002</c:v>
                </c:pt>
                <c:pt idx="4338">
                  <c:v>1372.25</c:v>
                </c:pt>
                <c:pt idx="4344">
                  <c:v>1016.28</c:v>
                </c:pt>
                <c:pt idx="4354">
                  <c:v>1006.99</c:v>
                </c:pt>
                <c:pt idx="4361">
                  <c:v>1409.4</c:v>
                </c:pt>
                <c:pt idx="4363">
                  <c:v>886.24800000000005</c:v>
                </c:pt>
                <c:pt idx="4365">
                  <c:v>702.21600000000001</c:v>
                </c:pt>
                <c:pt idx="4367">
                  <c:v>746.49599999999998</c:v>
                </c:pt>
                <c:pt idx="4370">
                  <c:v>1117.3699999999999</c:v>
                </c:pt>
                <c:pt idx="4378">
                  <c:v>963.36</c:v>
                </c:pt>
                <c:pt idx="4381">
                  <c:v>774.14400000000001</c:v>
                </c:pt>
                <c:pt idx="4391">
                  <c:v>972.64800000000002</c:v>
                </c:pt>
                <c:pt idx="4393">
                  <c:v>1180.8699999999999</c:v>
                </c:pt>
                <c:pt idx="4394">
                  <c:v>1392.98</c:v>
                </c:pt>
                <c:pt idx="4396">
                  <c:v>917.78399999999999</c:v>
                </c:pt>
                <c:pt idx="4401">
                  <c:v>892.51199999999994</c:v>
                </c:pt>
                <c:pt idx="4404">
                  <c:v>900.50400000000002</c:v>
                </c:pt>
                <c:pt idx="4405">
                  <c:v>1043.06</c:v>
                </c:pt>
                <c:pt idx="4406">
                  <c:v>1648.51</c:v>
                </c:pt>
                <c:pt idx="4412">
                  <c:v>458.35199999999998</c:v>
                </c:pt>
                <c:pt idx="4414">
                  <c:v>628.12800000000004</c:v>
                </c:pt>
                <c:pt idx="4415">
                  <c:v>1351.73</c:v>
                </c:pt>
                <c:pt idx="4419">
                  <c:v>2730.02</c:v>
                </c:pt>
                <c:pt idx="4425">
                  <c:v>1129.25</c:v>
                </c:pt>
                <c:pt idx="4427">
                  <c:v>491.83199999999999</c:v>
                </c:pt>
                <c:pt idx="4428">
                  <c:v>1015.42</c:v>
                </c:pt>
                <c:pt idx="4429">
                  <c:v>644.76</c:v>
                </c:pt>
                <c:pt idx="4435">
                  <c:v>1084.97</c:v>
                </c:pt>
                <c:pt idx="4440">
                  <c:v>1050.4100000000001</c:v>
                </c:pt>
                <c:pt idx="4441">
                  <c:v>815.18399999999997</c:v>
                </c:pt>
                <c:pt idx="4446">
                  <c:v>1259.28</c:v>
                </c:pt>
                <c:pt idx="4447">
                  <c:v>2736.29</c:v>
                </c:pt>
                <c:pt idx="4454">
                  <c:v>1275.05</c:v>
                </c:pt>
                <c:pt idx="4456">
                  <c:v>925.34400000000005</c:v>
                </c:pt>
                <c:pt idx="4461">
                  <c:v>969.40800000000002</c:v>
                </c:pt>
                <c:pt idx="4463">
                  <c:v>781.27200000000005</c:v>
                </c:pt>
                <c:pt idx="4466">
                  <c:v>1077.19</c:v>
                </c:pt>
                <c:pt idx="4470">
                  <c:v>748.44</c:v>
                </c:pt>
                <c:pt idx="4476">
                  <c:v>859.89599999999996</c:v>
                </c:pt>
                <c:pt idx="4477">
                  <c:v>1485.65</c:v>
                </c:pt>
                <c:pt idx="4483">
                  <c:v>1306.3699999999999</c:v>
                </c:pt>
                <c:pt idx="4494">
                  <c:v>884.73599999999999</c:v>
                </c:pt>
                <c:pt idx="4501">
                  <c:v>1009.58</c:v>
                </c:pt>
                <c:pt idx="4502">
                  <c:v>953.85599999999999</c:v>
                </c:pt>
                <c:pt idx="4505">
                  <c:v>808.27200000000005</c:v>
                </c:pt>
                <c:pt idx="4507">
                  <c:v>976.10400000000004</c:v>
                </c:pt>
                <c:pt idx="4508">
                  <c:v>1125.3599999999999</c:v>
                </c:pt>
                <c:pt idx="4509">
                  <c:v>2390.2600000000002</c:v>
                </c:pt>
                <c:pt idx="4510">
                  <c:v>2055.46</c:v>
                </c:pt>
                <c:pt idx="4524">
                  <c:v>911.73599999999999</c:v>
                </c:pt>
                <c:pt idx="4528">
                  <c:v>1413.07</c:v>
                </c:pt>
                <c:pt idx="4529">
                  <c:v>808.70399999999995</c:v>
                </c:pt>
                <c:pt idx="4530">
                  <c:v>742.60799999999995</c:v>
                </c:pt>
                <c:pt idx="4537">
                  <c:v>1107.6500000000001</c:v>
                </c:pt>
                <c:pt idx="4538">
                  <c:v>674.78399999999999</c:v>
                </c:pt>
                <c:pt idx="4539">
                  <c:v>715.82399999999996</c:v>
                </c:pt>
                <c:pt idx="4548">
                  <c:v>872.64</c:v>
                </c:pt>
                <c:pt idx="4552">
                  <c:v>872.20799999999997</c:v>
                </c:pt>
                <c:pt idx="4553">
                  <c:v>869.83199999999999</c:v>
                </c:pt>
                <c:pt idx="4555">
                  <c:v>1248.05</c:v>
                </c:pt>
                <c:pt idx="4561">
                  <c:v>1402.06</c:v>
                </c:pt>
                <c:pt idx="4562">
                  <c:v>477.79199999999997</c:v>
                </c:pt>
                <c:pt idx="4566">
                  <c:v>837.43200000000002</c:v>
                </c:pt>
                <c:pt idx="4567">
                  <c:v>1017.14</c:v>
                </c:pt>
                <c:pt idx="4572">
                  <c:v>952.99199999999996</c:v>
                </c:pt>
                <c:pt idx="4573">
                  <c:v>849.096</c:v>
                </c:pt>
                <c:pt idx="4579">
                  <c:v>1430.35</c:v>
                </c:pt>
                <c:pt idx="4582">
                  <c:v>1640.09</c:v>
                </c:pt>
                <c:pt idx="4586">
                  <c:v>1983.74</c:v>
                </c:pt>
                <c:pt idx="4588">
                  <c:v>1279.8</c:v>
                </c:pt>
                <c:pt idx="4590">
                  <c:v>1236.17</c:v>
                </c:pt>
                <c:pt idx="4594">
                  <c:v>1492.78</c:v>
                </c:pt>
                <c:pt idx="4600">
                  <c:v>1644.41</c:v>
                </c:pt>
                <c:pt idx="4603">
                  <c:v>474.33600000000001</c:v>
                </c:pt>
                <c:pt idx="4604">
                  <c:v>708.048</c:v>
                </c:pt>
                <c:pt idx="4609">
                  <c:v>623.59199999999998</c:v>
                </c:pt>
                <c:pt idx="4612">
                  <c:v>918.21600000000001</c:v>
                </c:pt>
                <c:pt idx="4617">
                  <c:v>1117.58</c:v>
                </c:pt>
                <c:pt idx="4618">
                  <c:v>968.11199999999997</c:v>
                </c:pt>
                <c:pt idx="4622">
                  <c:v>1474.2</c:v>
                </c:pt>
                <c:pt idx="4624">
                  <c:v>773.49599999999998</c:v>
                </c:pt>
                <c:pt idx="4627">
                  <c:v>990.14400000000001</c:v>
                </c:pt>
                <c:pt idx="4629">
                  <c:v>895.10400000000004</c:v>
                </c:pt>
                <c:pt idx="4635">
                  <c:v>1128.82</c:v>
                </c:pt>
                <c:pt idx="4637">
                  <c:v>998.56799999999998</c:v>
                </c:pt>
                <c:pt idx="4653">
                  <c:v>1537.06</c:v>
                </c:pt>
                <c:pt idx="4655">
                  <c:v>1334.66</c:v>
                </c:pt>
                <c:pt idx="4656">
                  <c:v>1826.5</c:v>
                </c:pt>
                <c:pt idx="4657">
                  <c:v>397.65600000000001</c:v>
                </c:pt>
                <c:pt idx="4659">
                  <c:v>921.024</c:v>
                </c:pt>
                <c:pt idx="4662">
                  <c:v>1138.75</c:v>
                </c:pt>
                <c:pt idx="4663">
                  <c:v>1068.1199999999999</c:v>
                </c:pt>
                <c:pt idx="4664">
                  <c:v>1379.16</c:v>
                </c:pt>
                <c:pt idx="4666">
                  <c:v>1069.2</c:v>
                </c:pt>
                <c:pt idx="4667">
                  <c:v>424.65600000000001</c:v>
                </c:pt>
                <c:pt idx="4668">
                  <c:v>1253.02</c:v>
                </c:pt>
                <c:pt idx="4669">
                  <c:v>984.096</c:v>
                </c:pt>
                <c:pt idx="4672">
                  <c:v>135.43199999999999</c:v>
                </c:pt>
                <c:pt idx="4677">
                  <c:v>1080.43</c:v>
                </c:pt>
                <c:pt idx="4679">
                  <c:v>1006.99</c:v>
                </c:pt>
                <c:pt idx="4680">
                  <c:v>759.45600000000002</c:v>
                </c:pt>
                <c:pt idx="4682">
                  <c:v>1052.78</c:v>
                </c:pt>
                <c:pt idx="4685">
                  <c:v>1066.3900000000001</c:v>
                </c:pt>
                <c:pt idx="4686">
                  <c:v>1408.1</c:v>
                </c:pt>
                <c:pt idx="4693">
                  <c:v>882.14400000000001</c:v>
                </c:pt>
                <c:pt idx="4716">
                  <c:v>537.62400000000002</c:v>
                </c:pt>
                <c:pt idx="4717">
                  <c:v>724.24800000000005</c:v>
                </c:pt>
                <c:pt idx="4718">
                  <c:v>1075.46</c:v>
                </c:pt>
                <c:pt idx="4721">
                  <c:v>885.81600000000003</c:v>
                </c:pt>
                <c:pt idx="4724">
                  <c:v>1165.97</c:v>
                </c:pt>
                <c:pt idx="4725">
                  <c:v>1128.5999999999999</c:v>
                </c:pt>
                <c:pt idx="4729">
                  <c:v>1159.49</c:v>
                </c:pt>
                <c:pt idx="4732">
                  <c:v>762.91200000000003</c:v>
                </c:pt>
                <c:pt idx="4733">
                  <c:v>817.56</c:v>
                </c:pt>
                <c:pt idx="4738">
                  <c:v>1168.78</c:v>
                </c:pt>
                <c:pt idx="4742">
                  <c:v>957.31200000000001</c:v>
                </c:pt>
                <c:pt idx="4743">
                  <c:v>830.08799999999997</c:v>
                </c:pt>
                <c:pt idx="4750">
                  <c:v>877.82399999999996</c:v>
                </c:pt>
                <c:pt idx="4752">
                  <c:v>918</c:v>
                </c:pt>
                <c:pt idx="4760">
                  <c:v>435.24</c:v>
                </c:pt>
                <c:pt idx="4770">
                  <c:v>1062.29</c:v>
                </c:pt>
                <c:pt idx="4771">
                  <c:v>1171.58</c:v>
                </c:pt>
                <c:pt idx="4778">
                  <c:v>913.68</c:v>
                </c:pt>
                <c:pt idx="4783">
                  <c:v>911.08799999999997</c:v>
                </c:pt>
                <c:pt idx="4787">
                  <c:v>816.048</c:v>
                </c:pt>
                <c:pt idx="4791">
                  <c:v>680.61599999999999</c:v>
                </c:pt>
                <c:pt idx="4799">
                  <c:v>1242.8599999999999</c:v>
                </c:pt>
                <c:pt idx="4804">
                  <c:v>791.64</c:v>
                </c:pt>
                <c:pt idx="4806">
                  <c:v>1471.82</c:v>
                </c:pt>
                <c:pt idx="4807">
                  <c:v>1189.73</c:v>
                </c:pt>
                <c:pt idx="4811">
                  <c:v>1208.3</c:v>
                </c:pt>
                <c:pt idx="4812">
                  <c:v>1160.78</c:v>
                </c:pt>
                <c:pt idx="4813">
                  <c:v>503.28</c:v>
                </c:pt>
                <c:pt idx="4816">
                  <c:v>991.65599999999995</c:v>
                </c:pt>
                <c:pt idx="4819">
                  <c:v>824.904</c:v>
                </c:pt>
                <c:pt idx="4822">
                  <c:v>602.85599999999999</c:v>
                </c:pt>
                <c:pt idx="4826">
                  <c:v>979.34400000000005</c:v>
                </c:pt>
                <c:pt idx="4827">
                  <c:v>561.6</c:v>
                </c:pt>
                <c:pt idx="4832">
                  <c:v>1471.39</c:v>
                </c:pt>
                <c:pt idx="4834">
                  <c:v>1340.28</c:v>
                </c:pt>
                <c:pt idx="4835">
                  <c:v>1337.69</c:v>
                </c:pt>
                <c:pt idx="4838">
                  <c:v>994.03200000000004</c:v>
                </c:pt>
                <c:pt idx="4843">
                  <c:v>1058.18</c:v>
                </c:pt>
                <c:pt idx="4851">
                  <c:v>925.56</c:v>
                </c:pt>
                <c:pt idx="4852">
                  <c:v>586.22400000000005</c:v>
                </c:pt>
                <c:pt idx="4854">
                  <c:v>978.91200000000003</c:v>
                </c:pt>
                <c:pt idx="4855">
                  <c:v>609.98400000000004</c:v>
                </c:pt>
                <c:pt idx="4856">
                  <c:v>816.91200000000003</c:v>
                </c:pt>
                <c:pt idx="4857">
                  <c:v>1352.16</c:v>
                </c:pt>
                <c:pt idx="4861">
                  <c:v>657.28800000000001</c:v>
                </c:pt>
                <c:pt idx="4862">
                  <c:v>414.50400000000002</c:v>
                </c:pt>
                <c:pt idx="4864">
                  <c:v>938.952</c:v>
                </c:pt>
                <c:pt idx="4865">
                  <c:v>2105.7800000000002</c:v>
                </c:pt>
                <c:pt idx="4869">
                  <c:v>935.49599999999998</c:v>
                </c:pt>
                <c:pt idx="4872">
                  <c:v>1284.55</c:v>
                </c:pt>
                <c:pt idx="4874">
                  <c:v>1836.43</c:v>
                </c:pt>
                <c:pt idx="4875">
                  <c:v>1305.5</c:v>
                </c:pt>
                <c:pt idx="4884">
                  <c:v>748.22400000000005</c:v>
                </c:pt>
                <c:pt idx="4888">
                  <c:v>1298.3800000000001</c:v>
                </c:pt>
                <c:pt idx="4890">
                  <c:v>298.72800000000001</c:v>
                </c:pt>
                <c:pt idx="4891">
                  <c:v>1086.05</c:v>
                </c:pt>
                <c:pt idx="4893">
                  <c:v>1333.15</c:v>
                </c:pt>
                <c:pt idx="4896">
                  <c:v>1994.54</c:v>
                </c:pt>
                <c:pt idx="4897">
                  <c:v>1550.45</c:v>
                </c:pt>
                <c:pt idx="4898">
                  <c:v>843.48</c:v>
                </c:pt>
                <c:pt idx="4904">
                  <c:v>925.77599999999995</c:v>
                </c:pt>
                <c:pt idx="4908">
                  <c:v>1412.64</c:v>
                </c:pt>
                <c:pt idx="4909">
                  <c:v>1342.22</c:v>
                </c:pt>
                <c:pt idx="4910">
                  <c:v>469.15199999999999</c:v>
                </c:pt>
                <c:pt idx="4911">
                  <c:v>591.62400000000002</c:v>
                </c:pt>
                <c:pt idx="4921">
                  <c:v>1176.1199999999999</c:v>
                </c:pt>
                <c:pt idx="4923">
                  <c:v>1945.51</c:v>
                </c:pt>
                <c:pt idx="4926">
                  <c:v>1122.77</c:v>
                </c:pt>
                <c:pt idx="4929">
                  <c:v>1117.58</c:v>
                </c:pt>
                <c:pt idx="4930">
                  <c:v>1612.87</c:v>
                </c:pt>
                <c:pt idx="4938">
                  <c:v>609.33600000000001</c:v>
                </c:pt>
                <c:pt idx="4940">
                  <c:v>748.87199999999996</c:v>
                </c:pt>
                <c:pt idx="4947">
                  <c:v>908.928</c:v>
                </c:pt>
                <c:pt idx="4948">
                  <c:v>1121.47</c:v>
                </c:pt>
                <c:pt idx="4952">
                  <c:v>1556.5</c:v>
                </c:pt>
                <c:pt idx="4956">
                  <c:v>755.35199999999998</c:v>
                </c:pt>
                <c:pt idx="4962">
                  <c:v>1615.68</c:v>
                </c:pt>
                <c:pt idx="4973">
                  <c:v>1064.6600000000001</c:v>
                </c:pt>
                <c:pt idx="4974">
                  <c:v>1211.54</c:v>
                </c:pt>
                <c:pt idx="4982">
                  <c:v>1389.74</c:v>
                </c:pt>
                <c:pt idx="4987">
                  <c:v>1289.74</c:v>
                </c:pt>
                <c:pt idx="4990">
                  <c:v>800.928</c:v>
                </c:pt>
                <c:pt idx="4992">
                  <c:v>4066.42</c:v>
                </c:pt>
                <c:pt idx="4994">
                  <c:v>525.96</c:v>
                </c:pt>
                <c:pt idx="4995">
                  <c:v>934.41600000000005</c:v>
                </c:pt>
                <c:pt idx="4996">
                  <c:v>1279.8</c:v>
                </c:pt>
                <c:pt idx="4998">
                  <c:v>2755.73</c:v>
                </c:pt>
                <c:pt idx="5000">
                  <c:v>462.67200000000003</c:v>
                </c:pt>
                <c:pt idx="5004">
                  <c:v>915.62400000000002</c:v>
                </c:pt>
                <c:pt idx="5008">
                  <c:v>889.70399999999995</c:v>
                </c:pt>
                <c:pt idx="5010">
                  <c:v>635.904</c:v>
                </c:pt>
                <c:pt idx="5011">
                  <c:v>1016.28</c:v>
                </c:pt>
                <c:pt idx="5014">
                  <c:v>713.01599999999996</c:v>
                </c:pt>
                <c:pt idx="5018">
                  <c:v>934.84799999999996</c:v>
                </c:pt>
                <c:pt idx="5025">
                  <c:v>519.26400000000001</c:v>
                </c:pt>
                <c:pt idx="5027">
                  <c:v>617.76</c:v>
                </c:pt>
                <c:pt idx="5034">
                  <c:v>1078.06</c:v>
                </c:pt>
                <c:pt idx="5043">
                  <c:v>1287.3599999999999</c:v>
                </c:pt>
                <c:pt idx="5046">
                  <c:v>483.62400000000002</c:v>
                </c:pt>
                <c:pt idx="5050">
                  <c:v>1119.31</c:v>
                </c:pt>
                <c:pt idx="5052">
                  <c:v>949.10400000000004</c:v>
                </c:pt>
                <c:pt idx="5055">
                  <c:v>1249.78</c:v>
                </c:pt>
                <c:pt idx="5056">
                  <c:v>631.58399999999995</c:v>
                </c:pt>
                <c:pt idx="5058">
                  <c:v>1040.9000000000001</c:v>
                </c:pt>
                <c:pt idx="5059">
                  <c:v>555.12</c:v>
                </c:pt>
                <c:pt idx="5063">
                  <c:v>761.4</c:v>
                </c:pt>
                <c:pt idx="5064">
                  <c:v>808.92</c:v>
                </c:pt>
                <c:pt idx="5065">
                  <c:v>891.21600000000001</c:v>
                </c:pt>
                <c:pt idx="5066">
                  <c:v>1364.04</c:v>
                </c:pt>
                <c:pt idx="5074">
                  <c:v>1040.26</c:v>
                </c:pt>
                <c:pt idx="5080">
                  <c:v>614.73599999999999</c:v>
                </c:pt>
                <c:pt idx="5082">
                  <c:v>711.93600000000004</c:v>
                </c:pt>
                <c:pt idx="5089">
                  <c:v>742.60799999999995</c:v>
                </c:pt>
                <c:pt idx="5090">
                  <c:v>1373.98</c:v>
                </c:pt>
                <c:pt idx="5103">
                  <c:v>1153.44</c:v>
                </c:pt>
                <c:pt idx="5105">
                  <c:v>805.03200000000004</c:v>
                </c:pt>
                <c:pt idx="5107">
                  <c:v>1511.78</c:v>
                </c:pt>
                <c:pt idx="5115">
                  <c:v>2745.14</c:v>
                </c:pt>
                <c:pt idx="5117">
                  <c:v>1005.91</c:v>
                </c:pt>
                <c:pt idx="5119">
                  <c:v>779.54399999999998</c:v>
                </c:pt>
                <c:pt idx="5124">
                  <c:v>2403.86</c:v>
                </c:pt>
                <c:pt idx="5127">
                  <c:v>1460.38</c:v>
                </c:pt>
                <c:pt idx="5129">
                  <c:v>1186.06</c:v>
                </c:pt>
                <c:pt idx="5134">
                  <c:v>800.49599999999998</c:v>
                </c:pt>
                <c:pt idx="5141">
                  <c:v>946.72799999999995</c:v>
                </c:pt>
                <c:pt idx="5145">
                  <c:v>927.072</c:v>
                </c:pt>
                <c:pt idx="5150">
                  <c:v>671.54399999999998</c:v>
                </c:pt>
                <c:pt idx="5152">
                  <c:v>1070.28</c:v>
                </c:pt>
                <c:pt idx="5160">
                  <c:v>674.78399999999999</c:v>
                </c:pt>
                <c:pt idx="5163">
                  <c:v>1113.7</c:v>
                </c:pt>
                <c:pt idx="5164">
                  <c:v>1468.8</c:v>
                </c:pt>
                <c:pt idx="5169">
                  <c:v>1067.04</c:v>
                </c:pt>
                <c:pt idx="5170">
                  <c:v>832.89599999999996</c:v>
                </c:pt>
                <c:pt idx="5173">
                  <c:v>504.79199999999997</c:v>
                </c:pt>
                <c:pt idx="5174">
                  <c:v>918</c:v>
                </c:pt>
                <c:pt idx="5175">
                  <c:v>654.69600000000003</c:v>
                </c:pt>
                <c:pt idx="5176">
                  <c:v>905.04</c:v>
                </c:pt>
                <c:pt idx="5178">
                  <c:v>567.86400000000003</c:v>
                </c:pt>
                <c:pt idx="5179">
                  <c:v>832.68</c:v>
                </c:pt>
                <c:pt idx="5181">
                  <c:v>556.20000000000005</c:v>
                </c:pt>
                <c:pt idx="5183">
                  <c:v>814.75199999999995</c:v>
                </c:pt>
                <c:pt idx="5186">
                  <c:v>399.16800000000001</c:v>
                </c:pt>
                <c:pt idx="5188">
                  <c:v>961.63199999999995</c:v>
                </c:pt>
                <c:pt idx="5192">
                  <c:v>1228.6099999999999</c:v>
                </c:pt>
                <c:pt idx="5199">
                  <c:v>1549.15</c:v>
                </c:pt>
                <c:pt idx="5200">
                  <c:v>872.20799999999997</c:v>
                </c:pt>
                <c:pt idx="5206">
                  <c:v>1182.82</c:v>
                </c:pt>
                <c:pt idx="5207">
                  <c:v>831.6</c:v>
                </c:pt>
                <c:pt idx="5209">
                  <c:v>1617.62</c:v>
                </c:pt>
                <c:pt idx="5216">
                  <c:v>668.30399999999997</c:v>
                </c:pt>
                <c:pt idx="5218">
                  <c:v>539.35199999999998</c:v>
                </c:pt>
                <c:pt idx="5221">
                  <c:v>1247.6199999999999</c:v>
                </c:pt>
                <c:pt idx="5222">
                  <c:v>5832.65</c:v>
                </c:pt>
                <c:pt idx="5229">
                  <c:v>1453.03</c:v>
                </c:pt>
                <c:pt idx="5233">
                  <c:v>947.80799999999999</c:v>
                </c:pt>
                <c:pt idx="5235">
                  <c:v>1088.6400000000001</c:v>
                </c:pt>
                <c:pt idx="5236">
                  <c:v>810.21600000000001</c:v>
                </c:pt>
                <c:pt idx="5238">
                  <c:v>665.71199999999999</c:v>
                </c:pt>
                <c:pt idx="5240">
                  <c:v>1019.52</c:v>
                </c:pt>
                <c:pt idx="5243">
                  <c:v>728.78399999999999</c:v>
                </c:pt>
                <c:pt idx="5247">
                  <c:v>524.01599999999996</c:v>
                </c:pt>
                <c:pt idx="5249">
                  <c:v>854.928</c:v>
                </c:pt>
                <c:pt idx="5251">
                  <c:v>1100.95</c:v>
                </c:pt>
                <c:pt idx="5254">
                  <c:v>941.976</c:v>
                </c:pt>
                <c:pt idx="5255">
                  <c:v>1005.05</c:v>
                </c:pt>
                <c:pt idx="5257">
                  <c:v>2717.28</c:v>
                </c:pt>
                <c:pt idx="5260">
                  <c:v>1772.93</c:v>
                </c:pt>
                <c:pt idx="5265">
                  <c:v>798.55200000000002</c:v>
                </c:pt>
                <c:pt idx="5270">
                  <c:v>840.67200000000003</c:v>
                </c:pt>
                <c:pt idx="5277">
                  <c:v>1729.08</c:v>
                </c:pt>
                <c:pt idx="5283">
                  <c:v>1108.08</c:v>
                </c:pt>
                <c:pt idx="5288">
                  <c:v>928.36800000000005</c:v>
                </c:pt>
                <c:pt idx="5289">
                  <c:v>935.28</c:v>
                </c:pt>
                <c:pt idx="5297">
                  <c:v>613.22400000000005</c:v>
                </c:pt>
                <c:pt idx="5298">
                  <c:v>731.16</c:v>
                </c:pt>
                <c:pt idx="5299">
                  <c:v>545.61599999999999</c:v>
                </c:pt>
                <c:pt idx="5300">
                  <c:v>1346.76</c:v>
                </c:pt>
                <c:pt idx="5303">
                  <c:v>508.03199999999998</c:v>
                </c:pt>
                <c:pt idx="5304">
                  <c:v>543.024</c:v>
                </c:pt>
                <c:pt idx="5308">
                  <c:v>623.16</c:v>
                </c:pt>
                <c:pt idx="5314">
                  <c:v>902.23199999999997</c:v>
                </c:pt>
                <c:pt idx="5315">
                  <c:v>1163.3800000000001</c:v>
                </c:pt>
                <c:pt idx="5325">
                  <c:v>1892.81</c:v>
                </c:pt>
                <c:pt idx="5326">
                  <c:v>1192.32</c:v>
                </c:pt>
                <c:pt idx="5327">
                  <c:v>677.37599999999998</c:v>
                </c:pt>
                <c:pt idx="5330">
                  <c:v>1603.15</c:v>
                </c:pt>
                <c:pt idx="5332">
                  <c:v>2373.84</c:v>
                </c:pt>
                <c:pt idx="5335">
                  <c:v>632.44799999999998</c:v>
                </c:pt>
                <c:pt idx="5338">
                  <c:v>929.66399999999999</c:v>
                </c:pt>
                <c:pt idx="5341">
                  <c:v>1325.59</c:v>
                </c:pt>
                <c:pt idx="5346">
                  <c:v>1494.07</c:v>
                </c:pt>
                <c:pt idx="5349">
                  <c:v>644.11199999999997</c:v>
                </c:pt>
                <c:pt idx="5353">
                  <c:v>528.76800000000003</c:v>
                </c:pt>
                <c:pt idx="5355">
                  <c:v>670.68</c:v>
                </c:pt>
                <c:pt idx="5361">
                  <c:v>855.36</c:v>
                </c:pt>
                <c:pt idx="5363">
                  <c:v>1421.93</c:v>
                </c:pt>
                <c:pt idx="5365">
                  <c:v>2441.23</c:v>
                </c:pt>
                <c:pt idx="5367">
                  <c:v>1314.14</c:v>
                </c:pt>
                <c:pt idx="5368">
                  <c:v>725.54399999999998</c:v>
                </c:pt>
                <c:pt idx="5370">
                  <c:v>977.83199999999999</c:v>
                </c:pt>
                <c:pt idx="5372">
                  <c:v>910.22400000000005</c:v>
                </c:pt>
                <c:pt idx="5374">
                  <c:v>601.55999999999995</c:v>
                </c:pt>
                <c:pt idx="5375">
                  <c:v>471.096</c:v>
                </c:pt>
                <c:pt idx="5383">
                  <c:v>849.52800000000002</c:v>
                </c:pt>
                <c:pt idx="5388">
                  <c:v>897.048</c:v>
                </c:pt>
                <c:pt idx="5398">
                  <c:v>418.17599999999999</c:v>
                </c:pt>
                <c:pt idx="5403">
                  <c:v>807.19200000000001</c:v>
                </c:pt>
                <c:pt idx="5405">
                  <c:v>1097.28</c:v>
                </c:pt>
                <c:pt idx="5409">
                  <c:v>1301.4000000000001</c:v>
                </c:pt>
                <c:pt idx="5412">
                  <c:v>1178.28</c:v>
                </c:pt>
                <c:pt idx="5413">
                  <c:v>695.30399999999997</c:v>
                </c:pt>
                <c:pt idx="5415">
                  <c:v>1417.18</c:v>
                </c:pt>
                <c:pt idx="5416">
                  <c:v>1651.1</c:v>
                </c:pt>
                <c:pt idx="5417">
                  <c:v>917.78399999999999</c:v>
                </c:pt>
                <c:pt idx="5421">
                  <c:v>772.84799999999996</c:v>
                </c:pt>
                <c:pt idx="5422">
                  <c:v>794.88</c:v>
                </c:pt>
                <c:pt idx="5423">
                  <c:v>886.24800000000005</c:v>
                </c:pt>
                <c:pt idx="5424">
                  <c:v>1437.05</c:v>
                </c:pt>
                <c:pt idx="5426">
                  <c:v>1378.51</c:v>
                </c:pt>
                <c:pt idx="5427">
                  <c:v>693.14400000000001</c:v>
                </c:pt>
                <c:pt idx="5429">
                  <c:v>1004.83</c:v>
                </c:pt>
                <c:pt idx="5433">
                  <c:v>746.49599999999998</c:v>
                </c:pt>
                <c:pt idx="5434">
                  <c:v>858.16800000000001</c:v>
                </c:pt>
                <c:pt idx="5436">
                  <c:v>1389.1</c:v>
                </c:pt>
                <c:pt idx="5440">
                  <c:v>949.53599999999994</c:v>
                </c:pt>
                <c:pt idx="5457">
                  <c:v>807.62400000000002</c:v>
                </c:pt>
                <c:pt idx="5459">
                  <c:v>657.72</c:v>
                </c:pt>
                <c:pt idx="5462">
                  <c:v>1384.78</c:v>
                </c:pt>
                <c:pt idx="5463">
                  <c:v>897.26400000000001</c:v>
                </c:pt>
                <c:pt idx="5469">
                  <c:v>829.00800000000004</c:v>
                </c:pt>
                <c:pt idx="5476">
                  <c:v>814.53599999999994</c:v>
                </c:pt>
                <c:pt idx="5480">
                  <c:v>1188.22</c:v>
                </c:pt>
                <c:pt idx="5484">
                  <c:v>803.52</c:v>
                </c:pt>
                <c:pt idx="5490">
                  <c:v>2102.54</c:v>
                </c:pt>
                <c:pt idx="5492">
                  <c:v>810</c:v>
                </c:pt>
                <c:pt idx="5499">
                  <c:v>782.35199999999998</c:v>
                </c:pt>
                <c:pt idx="5500">
                  <c:v>486.86399999999998</c:v>
                </c:pt>
                <c:pt idx="5503">
                  <c:v>1017.79</c:v>
                </c:pt>
                <c:pt idx="5504">
                  <c:v>703.29600000000005</c:v>
                </c:pt>
                <c:pt idx="5505">
                  <c:v>1320.41</c:v>
                </c:pt>
                <c:pt idx="5507">
                  <c:v>1033.1300000000001</c:v>
                </c:pt>
                <c:pt idx="5510">
                  <c:v>543.88800000000003</c:v>
                </c:pt>
                <c:pt idx="5521">
                  <c:v>1122.3399999999999</c:v>
                </c:pt>
                <c:pt idx="5523">
                  <c:v>740.23199999999997</c:v>
                </c:pt>
                <c:pt idx="5524">
                  <c:v>1109.1600000000001</c:v>
                </c:pt>
                <c:pt idx="5527">
                  <c:v>589.89599999999996</c:v>
                </c:pt>
                <c:pt idx="5529">
                  <c:v>947.80799999999999</c:v>
                </c:pt>
                <c:pt idx="5531">
                  <c:v>916.48800000000006</c:v>
                </c:pt>
                <c:pt idx="5532">
                  <c:v>1732.75</c:v>
                </c:pt>
                <c:pt idx="5534">
                  <c:v>2237.98</c:v>
                </c:pt>
                <c:pt idx="5538">
                  <c:v>1052.57</c:v>
                </c:pt>
                <c:pt idx="5540">
                  <c:v>882.36</c:v>
                </c:pt>
                <c:pt idx="5542">
                  <c:v>480.38400000000001</c:v>
                </c:pt>
                <c:pt idx="5543">
                  <c:v>1032.48</c:v>
                </c:pt>
                <c:pt idx="5551">
                  <c:v>1171.8</c:v>
                </c:pt>
                <c:pt idx="5556">
                  <c:v>1489.32</c:v>
                </c:pt>
                <c:pt idx="5557">
                  <c:v>1172.02</c:v>
                </c:pt>
                <c:pt idx="5558">
                  <c:v>1110.67</c:v>
                </c:pt>
                <c:pt idx="5559">
                  <c:v>671.976</c:v>
                </c:pt>
                <c:pt idx="5563">
                  <c:v>992.52</c:v>
                </c:pt>
                <c:pt idx="5568">
                  <c:v>752.11199999999997</c:v>
                </c:pt>
                <c:pt idx="5572">
                  <c:v>1618.49</c:v>
                </c:pt>
                <c:pt idx="5573">
                  <c:v>854.06399999999996</c:v>
                </c:pt>
                <c:pt idx="5574">
                  <c:v>682.34400000000005</c:v>
                </c:pt>
                <c:pt idx="5582">
                  <c:v>774.79200000000003</c:v>
                </c:pt>
                <c:pt idx="5587">
                  <c:v>995.32799999999997</c:v>
                </c:pt>
                <c:pt idx="5588">
                  <c:v>1735.78</c:v>
                </c:pt>
                <c:pt idx="5591">
                  <c:v>1143.29</c:v>
                </c:pt>
                <c:pt idx="5595">
                  <c:v>2956.82</c:v>
                </c:pt>
                <c:pt idx="5596">
                  <c:v>895.96799999999996</c:v>
                </c:pt>
                <c:pt idx="5603">
                  <c:v>496.36799999999999</c:v>
                </c:pt>
                <c:pt idx="5604">
                  <c:v>1090.1500000000001</c:v>
                </c:pt>
                <c:pt idx="5608">
                  <c:v>1813.1</c:v>
                </c:pt>
                <c:pt idx="5614">
                  <c:v>911.52</c:v>
                </c:pt>
                <c:pt idx="5617">
                  <c:v>1170.07</c:v>
                </c:pt>
                <c:pt idx="5618">
                  <c:v>909.57600000000002</c:v>
                </c:pt>
                <c:pt idx="5621">
                  <c:v>1586.74</c:v>
                </c:pt>
                <c:pt idx="5623">
                  <c:v>934.63199999999995</c:v>
                </c:pt>
                <c:pt idx="5624">
                  <c:v>1201.82</c:v>
                </c:pt>
                <c:pt idx="5625">
                  <c:v>543.88800000000003</c:v>
                </c:pt>
                <c:pt idx="5626">
                  <c:v>1349.14</c:v>
                </c:pt>
                <c:pt idx="5631">
                  <c:v>846.50400000000002</c:v>
                </c:pt>
                <c:pt idx="5632">
                  <c:v>1031.18</c:v>
                </c:pt>
                <c:pt idx="5633">
                  <c:v>800.49599999999998</c:v>
                </c:pt>
                <c:pt idx="5635">
                  <c:v>966.6</c:v>
                </c:pt>
                <c:pt idx="5652">
                  <c:v>954.28800000000001</c:v>
                </c:pt>
                <c:pt idx="5656">
                  <c:v>1359.5</c:v>
                </c:pt>
                <c:pt idx="5658">
                  <c:v>1118.6600000000001</c:v>
                </c:pt>
                <c:pt idx="5660">
                  <c:v>854.71199999999999</c:v>
                </c:pt>
                <c:pt idx="5662">
                  <c:v>1364.9</c:v>
                </c:pt>
                <c:pt idx="5663">
                  <c:v>1112.4000000000001</c:v>
                </c:pt>
                <c:pt idx="5667">
                  <c:v>1009.37</c:v>
                </c:pt>
                <c:pt idx="5673">
                  <c:v>790.34400000000005</c:v>
                </c:pt>
                <c:pt idx="5679">
                  <c:v>1180.44</c:v>
                </c:pt>
                <c:pt idx="5694">
                  <c:v>1016.71</c:v>
                </c:pt>
                <c:pt idx="5704">
                  <c:v>511.27199999999999</c:v>
                </c:pt>
                <c:pt idx="5705">
                  <c:v>919.08</c:v>
                </c:pt>
                <c:pt idx="5708">
                  <c:v>1546.56</c:v>
                </c:pt>
                <c:pt idx="5709">
                  <c:v>1192.32</c:v>
                </c:pt>
                <c:pt idx="5710">
                  <c:v>1522.37</c:v>
                </c:pt>
                <c:pt idx="5712">
                  <c:v>829.44</c:v>
                </c:pt>
                <c:pt idx="5713">
                  <c:v>1264.25</c:v>
                </c:pt>
                <c:pt idx="5714">
                  <c:v>687.74400000000003</c:v>
                </c:pt>
                <c:pt idx="5718">
                  <c:v>1579.82</c:v>
                </c:pt>
                <c:pt idx="5719">
                  <c:v>1157.98</c:v>
                </c:pt>
                <c:pt idx="5722">
                  <c:v>790.99199999999996</c:v>
                </c:pt>
                <c:pt idx="5723">
                  <c:v>714.096</c:v>
                </c:pt>
                <c:pt idx="5726">
                  <c:v>291.81599999999997</c:v>
                </c:pt>
                <c:pt idx="5729">
                  <c:v>989.928</c:v>
                </c:pt>
                <c:pt idx="5730">
                  <c:v>594.64800000000002</c:v>
                </c:pt>
                <c:pt idx="5736">
                  <c:v>932.04</c:v>
                </c:pt>
                <c:pt idx="5742">
                  <c:v>973.94399999999996</c:v>
                </c:pt>
                <c:pt idx="5744">
                  <c:v>848.44799999999998</c:v>
                </c:pt>
                <c:pt idx="5751">
                  <c:v>1059.05</c:v>
                </c:pt>
                <c:pt idx="5753">
                  <c:v>978.48</c:v>
                </c:pt>
                <c:pt idx="5754">
                  <c:v>1005.05</c:v>
                </c:pt>
                <c:pt idx="5756">
                  <c:v>1034.42</c:v>
                </c:pt>
                <c:pt idx="5757">
                  <c:v>1563.62</c:v>
                </c:pt>
                <c:pt idx="5758">
                  <c:v>1168.1300000000001</c:v>
                </c:pt>
                <c:pt idx="5762">
                  <c:v>836.56799999999998</c:v>
                </c:pt>
                <c:pt idx="5769">
                  <c:v>1546.13</c:v>
                </c:pt>
                <c:pt idx="5770">
                  <c:v>1145.23</c:v>
                </c:pt>
                <c:pt idx="5771">
                  <c:v>906.98400000000004</c:v>
                </c:pt>
                <c:pt idx="5776">
                  <c:v>843.48</c:v>
                </c:pt>
                <c:pt idx="5778">
                  <c:v>482.11200000000002</c:v>
                </c:pt>
                <c:pt idx="5779">
                  <c:v>1161.8599999999999</c:v>
                </c:pt>
                <c:pt idx="5784">
                  <c:v>981.50400000000002</c:v>
                </c:pt>
                <c:pt idx="5790">
                  <c:v>1167.9100000000001</c:v>
                </c:pt>
                <c:pt idx="5793">
                  <c:v>1033.56</c:v>
                </c:pt>
                <c:pt idx="5795">
                  <c:v>874.15200000000004</c:v>
                </c:pt>
                <c:pt idx="5796">
                  <c:v>860.32799999999997</c:v>
                </c:pt>
                <c:pt idx="5800">
                  <c:v>1337.04</c:v>
                </c:pt>
                <c:pt idx="5804">
                  <c:v>633.31200000000001</c:v>
                </c:pt>
                <c:pt idx="5812">
                  <c:v>1257.98</c:v>
                </c:pt>
                <c:pt idx="5816">
                  <c:v>1324.08</c:v>
                </c:pt>
                <c:pt idx="5817">
                  <c:v>1156.25</c:v>
                </c:pt>
                <c:pt idx="5818">
                  <c:v>1102.46</c:v>
                </c:pt>
                <c:pt idx="5821">
                  <c:v>874.15200000000004</c:v>
                </c:pt>
                <c:pt idx="5832">
                  <c:v>889.70399999999995</c:v>
                </c:pt>
                <c:pt idx="5838">
                  <c:v>1322.57</c:v>
                </c:pt>
                <c:pt idx="5841">
                  <c:v>1219.75</c:v>
                </c:pt>
                <c:pt idx="5846">
                  <c:v>1361.66</c:v>
                </c:pt>
                <c:pt idx="5847">
                  <c:v>941.76</c:v>
                </c:pt>
                <c:pt idx="5850">
                  <c:v>1429.92</c:v>
                </c:pt>
                <c:pt idx="5853">
                  <c:v>1201.18</c:v>
                </c:pt>
                <c:pt idx="5858">
                  <c:v>659.23199999999997</c:v>
                </c:pt>
                <c:pt idx="5859">
                  <c:v>878.68799999999999</c:v>
                </c:pt>
                <c:pt idx="5860">
                  <c:v>1206.79</c:v>
                </c:pt>
                <c:pt idx="5862">
                  <c:v>1054.08</c:v>
                </c:pt>
                <c:pt idx="5863">
                  <c:v>917.56799999999998</c:v>
                </c:pt>
                <c:pt idx="5864">
                  <c:v>795.96</c:v>
                </c:pt>
                <c:pt idx="5866">
                  <c:v>949.32</c:v>
                </c:pt>
                <c:pt idx="5873">
                  <c:v>1174.18</c:v>
                </c:pt>
                <c:pt idx="5882">
                  <c:v>1267.7</c:v>
                </c:pt>
                <c:pt idx="5887">
                  <c:v>1070.5</c:v>
                </c:pt>
                <c:pt idx="5889">
                  <c:v>815.61599999999999</c:v>
                </c:pt>
                <c:pt idx="5890">
                  <c:v>852.12</c:v>
                </c:pt>
                <c:pt idx="5891">
                  <c:v>941.76</c:v>
                </c:pt>
                <c:pt idx="5910">
                  <c:v>723.38400000000001</c:v>
                </c:pt>
                <c:pt idx="5911">
                  <c:v>480.81599999999997</c:v>
                </c:pt>
                <c:pt idx="5916">
                  <c:v>434.16</c:v>
                </c:pt>
                <c:pt idx="5924">
                  <c:v>1098.3599999999999</c:v>
                </c:pt>
                <c:pt idx="5927">
                  <c:v>740.44799999999998</c:v>
                </c:pt>
                <c:pt idx="5931">
                  <c:v>845.42399999999998</c:v>
                </c:pt>
                <c:pt idx="5932">
                  <c:v>1128.5999999999999</c:v>
                </c:pt>
                <c:pt idx="5935">
                  <c:v>1340.93</c:v>
                </c:pt>
                <c:pt idx="5945">
                  <c:v>667.22400000000005</c:v>
                </c:pt>
                <c:pt idx="5947">
                  <c:v>1157.33</c:v>
                </c:pt>
                <c:pt idx="5951">
                  <c:v>681.48</c:v>
                </c:pt>
                <c:pt idx="5953">
                  <c:v>1376.57</c:v>
                </c:pt>
                <c:pt idx="5954">
                  <c:v>1283.9000000000001</c:v>
                </c:pt>
                <c:pt idx="5961">
                  <c:v>556.63199999999995</c:v>
                </c:pt>
                <c:pt idx="5963">
                  <c:v>1340.71</c:v>
                </c:pt>
                <c:pt idx="5965">
                  <c:v>552.96</c:v>
                </c:pt>
                <c:pt idx="5966">
                  <c:v>819.072</c:v>
                </c:pt>
                <c:pt idx="5970">
                  <c:v>1031.6199999999999</c:v>
                </c:pt>
                <c:pt idx="5972">
                  <c:v>641.30399999999997</c:v>
                </c:pt>
                <c:pt idx="5973">
                  <c:v>1099.8699999999999</c:v>
                </c:pt>
                <c:pt idx="5974">
                  <c:v>809.78399999999999</c:v>
                </c:pt>
                <c:pt idx="5976">
                  <c:v>788.83199999999999</c:v>
                </c:pt>
                <c:pt idx="5977">
                  <c:v>1636.63</c:v>
                </c:pt>
                <c:pt idx="5982">
                  <c:v>1344.6</c:v>
                </c:pt>
                <c:pt idx="5983">
                  <c:v>613.44000000000005</c:v>
                </c:pt>
                <c:pt idx="5990">
                  <c:v>1215.8599999999999</c:v>
                </c:pt>
                <c:pt idx="5992">
                  <c:v>1342.66</c:v>
                </c:pt>
                <c:pt idx="5994">
                  <c:v>1051.27</c:v>
                </c:pt>
                <c:pt idx="5996">
                  <c:v>924.48</c:v>
                </c:pt>
                <c:pt idx="5997">
                  <c:v>1767.53</c:v>
                </c:pt>
                <c:pt idx="5998">
                  <c:v>1183.46</c:v>
                </c:pt>
                <c:pt idx="6009">
                  <c:v>1578.1</c:v>
                </c:pt>
                <c:pt idx="6010">
                  <c:v>3717.58</c:v>
                </c:pt>
                <c:pt idx="6014">
                  <c:v>764.42399999999998</c:v>
                </c:pt>
                <c:pt idx="6023">
                  <c:v>748.87199999999996</c:v>
                </c:pt>
                <c:pt idx="6029">
                  <c:v>746.28</c:v>
                </c:pt>
                <c:pt idx="6030">
                  <c:v>1260.1400000000001</c:v>
                </c:pt>
                <c:pt idx="6035">
                  <c:v>1058.6199999999999</c:v>
                </c:pt>
                <c:pt idx="6040">
                  <c:v>1306.1500000000001</c:v>
                </c:pt>
                <c:pt idx="6041">
                  <c:v>1112.6199999999999</c:v>
                </c:pt>
                <c:pt idx="6045">
                  <c:v>1397.3</c:v>
                </c:pt>
                <c:pt idx="6049">
                  <c:v>521.85599999999999</c:v>
                </c:pt>
                <c:pt idx="6056">
                  <c:v>943.27200000000005</c:v>
                </c:pt>
                <c:pt idx="6058">
                  <c:v>1057.75</c:v>
                </c:pt>
                <c:pt idx="6060">
                  <c:v>1178.71</c:v>
                </c:pt>
                <c:pt idx="6068">
                  <c:v>568.94399999999996</c:v>
                </c:pt>
                <c:pt idx="6075">
                  <c:v>781.70399999999995</c:v>
                </c:pt>
                <c:pt idx="6077">
                  <c:v>1329.7</c:v>
                </c:pt>
                <c:pt idx="6083">
                  <c:v>824.04</c:v>
                </c:pt>
                <c:pt idx="6084">
                  <c:v>697.24800000000005</c:v>
                </c:pt>
                <c:pt idx="6085">
                  <c:v>1150.6300000000001</c:v>
                </c:pt>
                <c:pt idx="6088">
                  <c:v>703.08</c:v>
                </c:pt>
                <c:pt idx="6089">
                  <c:v>1730.16</c:v>
                </c:pt>
                <c:pt idx="6090">
                  <c:v>1191.8900000000001</c:v>
                </c:pt>
                <c:pt idx="6092">
                  <c:v>1716.77</c:v>
                </c:pt>
                <c:pt idx="6094">
                  <c:v>1021.25</c:v>
                </c:pt>
                <c:pt idx="6095">
                  <c:v>1620.43</c:v>
                </c:pt>
                <c:pt idx="6104">
                  <c:v>816.048</c:v>
                </c:pt>
                <c:pt idx="6106">
                  <c:v>1010.23</c:v>
                </c:pt>
                <c:pt idx="6108">
                  <c:v>697.24800000000005</c:v>
                </c:pt>
                <c:pt idx="6110">
                  <c:v>414.72</c:v>
                </c:pt>
                <c:pt idx="6117">
                  <c:v>2619.2199999999998</c:v>
                </c:pt>
                <c:pt idx="6120">
                  <c:v>1296.8599999999999</c:v>
                </c:pt>
                <c:pt idx="6122">
                  <c:v>1291.03</c:v>
                </c:pt>
                <c:pt idx="6123">
                  <c:v>1123.6300000000001</c:v>
                </c:pt>
                <c:pt idx="6125">
                  <c:v>472.608</c:v>
                </c:pt>
                <c:pt idx="6135">
                  <c:v>1267.06</c:v>
                </c:pt>
                <c:pt idx="6137">
                  <c:v>878.25599999999997</c:v>
                </c:pt>
                <c:pt idx="6144">
                  <c:v>573.69600000000003</c:v>
                </c:pt>
                <c:pt idx="6148">
                  <c:v>822.096</c:v>
                </c:pt>
                <c:pt idx="6149">
                  <c:v>1133.57</c:v>
                </c:pt>
                <c:pt idx="6151">
                  <c:v>370.44</c:v>
                </c:pt>
                <c:pt idx="6152">
                  <c:v>714.96</c:v>
                </c:pt>
                <c:pt idx="6154">
                  <c:v>905.25599999999997</c:v>
                </c:pt>
                <c:pt idx="6155">
                  <c:v>1463.18</c:v>
                </c:pt>
                <c:pt idx="6157">
                  <c:v>906.76800000000003</c:v>
                </c:pt>
                <c:pt idx="6160">
                  <c:v>860.54399999999998</c:v>
                </c:pt>
                <c:pt idx="6162">
                  <c:v>1173.53</c:v>
                </c:pt>
                <c:pt idx="6163">
                  <c:v>913.24800000000005</c:v>
                </c:pt>
                <c:pt idx="6165">
                  <c:v>653.4</c:v>
                </c:pt>
                <c:pt idx="6177">
                  <c:v>974.80799999999999</c:v>
                </c:pt>
                <c:pt idx="6180">
                  <c:v>630.93600000000004</c:v>
                </c:pt>
                <c:pt idx="6182">
                  <c:v>1194.26</c:v>
                </c:pt>
                <c:pt idx="6186">
                  <c:v>926.42399999999998</c:v>
                </c:pt>
                <c:pt idx="6188">
                  <c:v>1516.75</c:v>
                </c:pt>
                <c:pt idx="6193">
                  <c:v>1025.1400000000001</c:v>
                </c:pt>
                <c:pt idx="6196">
                  <c:v>662.04</c:v>
                </c:pt>
                <c:pt idx="6198">
                  <c:v>778.03200000000004</c:v>
                </c:pt>
                <c:pt idx="6200">
                  <c:v>1449.14</c:v>
                </c:pt>
                <c:pt idx="6201">
                  <c:v>772.41600000000005</c:v>
                </c:pt>
                <c:pt idx="6202">
                  <c:v>1154.74</c:v>
                </c:pt>
                <c:pt idx="6205">
                  <c:v>963.14400000000001</c:v>
                </c:pt>
                <c:pt idx="6216">
                  <c:v>1548.29</c:v>
                </c:pt>
                <c:pt idx="6230">
                  <c:v>939.16800000000001</c:v>
                </c:pt>
                <c:pt idx="6233">
                  <c:v>754.70399999999995</c:v>
                </c:pt>
                <c:pt idx="6240">
                  <c:v>949.96799999999996</c:v>
                </c:pt>
                <c:pt idx="6245">
                  <c:v>1027.3</c:v>
                </c:pt>
                <c:pt idx="6251">
                  <c:v>1218.8900000000001</c:v>
                </c:pt>
                <c:pt idx="6253">
                  <c:v>1108.51</c:v>
                </c:pt>
                <c:pt idx="6254">
                  <c:v>1380.67</c:v>
                </c:pt>
                <c:pt idx="6255">
                  <c:v>71.712000000000003</c:v>
                </c:pt>
                <c:pt idx="6256">
                  <c:v>1407.89</c:v>
                </c:pt>
                <c:pt idx="6258">
                  <c:v>925.12800000000004</c:v>
                </c:pt>
                <c:pt idx="6261">
                  <c:v>977.61599999999999</c:v>
                </c:pt>
                <c:pt idx="6265">
                  <c:v>767.44799999999998</c:v>
                </c:pt>
                <c:pt idx="6273">
                  <c:v>967.89599999999996</c:v>
                </c:pt>
                <c:pt idx="6277">
                  <c:v>880.84799999999996</c:v>
                </c:pt>
                <c:pt idx="6280">
                  <c:v>842.18399999999997</c:v>
                </c:pt>
                <c:pt idx="6282">
                  <c:v>695.08799999999997</c:v>
                </c:pt>
                <c:pt idx="6284">
                  <c:v>1081.94</c:v>
                </c:pt>
                <c:pt idx="6294">
                  <c:v>1424.09</c:v>
                </c:pt>
                <c:pt idx="6298">
                  <c:v>544.10400000000004</c:v>
                </c:pt>
                <c:pt idx="6306">
                  <c:v>1870.99</c:v>
                </c:pt>
                <c:pt idx="6310">
                  <c:v>1293.8399999999999</c:v>
                </c:pt>
                <c:pt idx="6311">
                  <c:v>560.952</c:v>
                </c:pt>
                <c:pt idx="6313">
                  <c:v>1057.54</c:v>
                </c:pt>
                <c:pt idx="6314">
                  <c:v>961.41600000000005</c:v>
                </c:pt>
                <c:pt idx="6316">
                  <c:v>934.2</c:v>
                </c:pt>
                <c:pt idx="6318">
                  <c:v>964.87199999999996</c:v>
                </c:pt>
                <c:pt idx="6321">
                  <c:v>1125.79</c:v>
                </c:pt>
                <c:pt idx="6328">
                  <c:v>611.06399999999996</c:v>
                </c:pt>
                <c:pt idx="6335">
                  <c:v>929.88</c:v>
                </c:pt>
                <c:pt idx="6336">
                  <c:v>2049.19</c:v>
                </c:pt>
                <c:pt idx="6337">
                  <c:v>1410.26</c:v>
                </c:pt>
                <c:pt idx="6339">
                  <c:v>812.16</c:v>
                </c:pt>
                <c:pt idx="6341">
                  <c:v>378.43200000000002</c:v>
                </c:pt>
                <c:pt idx="6344">
                  <c:v>857.952</c:v>
                </c:pt>
                <c:pt idx="6346">
                  <c:v>759.67200000000003</c:v>
                </c:pt>
                <c:pt idx="6349">
                  <c:v>984.96</c:v>
                </c:pt>
                <c:pt idx="6350">
                  <c:v>994.24800000000005</c:v>
                </c:pt>
                <c:pt idx="6352">
                  <c:v>903.74400000000003</c:v>
                </c:pt>
                <c:pt idx="6355">
                  <c:v>723.38400000000001</c:v>
                </c:pt>
                <c:pt idx="6363">
                  <c:v>868.10400000000004</c:v>
                </c:pt>
                <c:pt idx="6365">
                  <c:v>871.56</c:v>
                </c:pt>
                <c:pt idx="6366">
                  <c:v>1533.82</c:v>
                </c:pt>
                <c:pt idx="6367">
                  <c:v>655.77599999999995</c:v>
                </c:pt>
                <c:pt idx="6371">
                  <c:v>813.88800000000003</c:v>
                </c:pt>
                <c:pt idx="6372">
                  <c:v>1746.79</c:v>
                </c:pt>
                <c:pt idx="6377">
                  <c:v>774.79200000000003</c:v>
                </c:pt>
                <c:pt idx="6382">
                  <c:v>987.98400000000004</c:v>
                </c:pt>
                <c:pt idx="6383">
                  <c:v>713.01599999999996</c:v>
                </c:pt>
                <c:pt idx="6386">
                  <c:v>829.44</c:v>
                </c:pt>
                <c:pt idx="6388">
                  <c:v>1596.67</c:v>
                </c:pt>
                <c:pt idx="6390">
                  <c:v>720.79200000000003</c:v>
                </c:pt>
                <c:pt idx="6395">
                  <c:v>1141.1300000000001</c:v>
                </c:pt>
                <c:pt idx="6400">
                  <c:v>881.71199999999999</c:v>
                </c:pt>
                <c:pt idx="6401">
                  <c:v>693.57600000000002</c:v>
                </c:pt>
                <c:pt idx="6403">
                  <c:v>748.44</c:v>
                </c:pt>
                <c:pt idx="6408">
                  <c:v>1703.16</c:v>
                </c:pt>
                <c:pt idx="6410">
                  <c:v>978.91200000000003</c:v>
                </c:pt>
                <c:pt idx="6414">
                  <c:v>1626.91</c:v>
                </c:pt>
                <c:pt idx="6416">
                  <c:v>936.36</c:v>
                </c:pt>
                <c:pt idx="6431">
                  <c:v>1650.02</c:v>
                </c:pt>
                <c:pt idx="6432">
                  <c:v>875.44799999999998</c:v>
                </c:pt>
                <c:pt idx="6434">
                  <c:v>835.70399999999995</c:v>
                </c:pt>
                <c:pt idx="6435">
                  <c:v>2691.58</c:v>
                </c:pt>
                <c:pt idx="6445">
                  <c:v>14628.6</c:v>
                </c:pt>
                <c:pt idx="6451">
                  <c:v>1550.23</c:v>
                </c:pt>
                <c:pt idx="6454">
                  <c:v>852.12</c:v>
                </c:pt>
                <c:pt idx="6461">
                  <c:v>1272.02</c:v>
                </c:pt>
                <c:pt idx="6462">
                  <c:v>979.34400000000005</c:v>
                </c:pt>
                <c:pt idx="6468">
                  <c:v>1505.09</c:v>
                </c:pt>
                <c:pt idx="6473">
                  <c:v>1611.58</c:v>
                </c:pt>
                <c:pt idx="6476">
                  <c:v>1472.47</c:v>
                </c:pt>
                <c:pt idx="6479">
                  <c:v>873.50400000000002</c:v>
                </c:pt>
                <c:pt idx="6481">
                  <c:v>1102.03</c:v>
                </c:pt>
                <c:pt idx="6483">
                  <c:v>707.18399999999997</c:v>
                </c:pt>
                <c:pt idx="6487">
                  <c:v>684.28800000000001</c:v>
                </c:pt>
                <c:pt idx="6494">
                  <c:v>947.80799999999999</c:v>
                </c:pt>
                <c:pt idx="6495">
                  <c:v>731.37599999999998</c:v>
                </c:pt>
                <c:pt idx="6496">
                  <c:v>1706.4</c:v>
                </c:pt>
                <c:pt idx="6498">
                  <c:v>1292.1099999999999</c:v>
                </c:pt>
                <c:pt idx="6499">
                  <c:v>942.40800000000002</c:v>
                </c:pt>
                <c:pt idx="6506">
                  <c:v>1156.9000000000001</c:v>
                </c:pt>
                <c:pt idx="6514">
                  <c:v>1286.28</c:v>
                </c:pt>
                <c:pt idx="6515">
                  <c:v>543.88800000000003</c:v>
                </c:pt>
                <c:pt idx="6517">
                  <c:v>969.40800000000002</c:v>
                </c:pt>
                <c:pt idx="6518">
                  <c:v>1553.9</c:v>
                </c:pt>
                <c:pt idx="6525">
                  <c:v>1060.56</c:v>
                </c:pt>
                <c:pt idx="6528">
                  <c:v>658.15200000000004</c:v>
                </c:pt>
                <c:pt idx="6533">
                  <c:v>930.31200000000001</c:v>
                </c:pt>
                <c:pt idx="6537">
                  <c:v>1045.01</c:v>
                </c:pt>
                <c:pt idx="6539">
                  <c:v>785.37599999999998</c:v>
                </c:pt>
                <c:pt idx="6544">
                  <c:v>995.54399999999998</c:v>
                </c:pt>
                <c:pt idx="6546">
                  <c:v>459.43200000000002</c:v>
                </c:pt>
                <c:pt idx="6547">
                  <c:v>829.65599999999995</c:v>
                </c:pt>
                <c:pt idx="6553">
                  <c:v>956.44799999999998</c:v>
                </c:pt>
                <c:pt idx="6557">
                  <c:v>658.8</c:v>
                </c:pt>
                <c:pt idx="6559">
                  <c:v>1002.02</c:v>
                </c:pt>
                <c:pt idx="6561">
                  <c:v>774.36</c:v>
                </c:pt>
                <c:pt idx="6564">
                  <c:v>692.06399999999996</c:v>
                </c:pt>
                <c:pt idx="6566">
                  <c:v>908.06399999999996</c:v>
                </c:pt>
                <c:pt idx="6567">
                  <c:v>848.44799999999998</c:v>
                </c:pt>
                <c:pt idx="6568">
                  <c:v>759.45600000000002</c:v>
                </c:pt>
                <c:pt idx="6569">
                  <c:v>1579.61</c:v>
                </c:pt>
                <c:pt idx="6571">
                  <c:v>198.93600000000001</c:v>
                </c:pt>
                <c:pt idx="6573">
                  <c:v>1105.27</c:v>
                </c:pt>
                <c:pt idx="6576">
                  <c:v>843.048</c:v>
                </c:pt>
                <c:pt idx="6580">
                  <c:v>896.4</c:v>
                </c:pt>
                <c:pt idx="6581">
                  <c:v>1170.94</c:v>
                </c:pt>
                <c:pt idx="6585">
                  <c:v>1202.26</c:v>
                </c:pt>
                <c:pt idx="6587">
                  <c:v>768.74400000000003</c:v>
                </c:pt>
                <c:pt idx="6588">
                  <c:v>1269.6500000000001</c:v>
                </c:pt>
                <c:pt idx="6592">
                  <c:v>1006.78</c:v>
                </c:pt>
                <c:pt idx="6602">
                  <c:v>2502.79</c:v>
                </c:pt>
                <c:pt idx="6603">
                  <c:v>1030.54</c:v>
                </c:pt>
                <c:pt idx="6604">
                  <c:v>601.77599999999995</c:v>
                </c:pt>
                <c:pt idx="6611">
                  <c:v>1024.49</c:v>
                </c:pt>
                <c:pt idx="6612">
                  <c:v>948.67200000000003</c:v>
                </c:pt>
                <c:pt idx="6619">
                  <c:v>712.58399999999995</c:v>
                </c:pt>
                <c:pt idx="6624">
                  <c:v>975.67200000000003</c:v>
                </c:pt>
                <c:pt idx="6630">
                  <c:v>1191.02</c:v>
                </c:pt>
                <c:pt idx="6643">
                  <c:v>1130.33</c:v>
                </c:pt>
                <c:pt idx="6646">
                  <c:v>844.77599999999995</c:v>
                </c:pt>
                <c:pt idx="6648">
                  <c:v>1170.29</c:v>
                </c:pt>
                <c:pt idx="6650">
                  <c:v>1006.13</c:v>
                </c:pt>
                <c:pt idx="6651">
                  <c:v>1907.71</c:v>
                </c:pt>
                <c:pt idx="6659">
                  <c:v>729.64800000000002</c:v>
                </c:pt>
                <c:pt idx="6661">
                  <c:v>955.58399999999995</c:v>
                </c:pt>
                <c:pt idx="6665">
                  <c:v>620.13599999999997</c:v>
                </c:pt>
                <c:pt idx="6667">
                  <c:v>1444.61</c:v>
                </c:pt>
                <c:pt idx="6670">
                  <c:v>1009.37</c:v>
                </c:pt>
                <c:pt idx="6675">
                  <c:v>887.32799999999997</c:v>
                </c:pt>
                <c:pt idx="6678">
                  <c:v>1944.86</c:v>
                </c:pt>
                <c:pt idx="6693">
                  <c:v>1377.86</c:v>
                </c:pt>
                <c:pt idx="6695">
                  <c:v>1001.81</c:v>
                </c:pt>
                <c:pt idx="6699">
                  <c:v>559.00800000000004</c:v>
                </c:pt>
                <c:pt idx="6700">
                  <c:v>965.952</c:v>
                </c:pt>
                <c:pt idx="6701">
                  <c:v>1164.67</c:v>
                </c:pt>
                <c:pt idx="6710">
                  <c:v>640.44000000000005</c:v>
                </c:pt>
                <c:pt idx="6711">
                  <c:v>858.38400000000001</c:v>
                </c:pt>
                <c:pt idx="6714">
                  <c:v>770.25599999999997</c:v>
                </c:pt>
                <c:pt idx="6721">
                  <c:v>554.25599999999997</c:v>
                </c:pt>
                <c:pt idx="6723">
                  <c:v>1108.08</c:v>
                </c:pt>
                <c:pt idx="6726">
                  <c:v>713.44799999999998</c:v>
                </c:pt>
                <c:pt idx="6728">
                  <c:v>1160.78</c:v>
                </c:pt>
                <c:pt idx="6730">
                  <c:v>869.83199999999999</c:v>
                </c:pt>
                <c:pt idx="6731">
                  <c:v>1421.5</c:v>
                </c:pt>
                <c:pt idx="6736">
                  <c:v>757.08</c:v>
                </c:pt>
                <c:pt idx="6741">
                  <c:v>923.18399999999997</c:v>
                </c:pt>
                <c:pt idx="6742">
                  <c:v>395.49599999999998</c:v>
                </c:pt>
                <c:pt idx="6743">
                  <c:v>946.29600000000005</c:v>
                </c:pt>
                <c:pt idx="6744">
                  <c:v>2768.69</c:v>
                </c:pt>
                <c:pt idx="6745">
                  <c:v>1286.06</c:v>
                </c:pt>
                <c:pt idx="6746">
                  <c:v>1088.21</c:v>
                </c:pt>
                <c:pt idx="6747">
                  <c:v>2058.0500000000002</c:v>
                </c:pt>
                <c:pt idx="6750">
                  <c:v>872.64</c:v>
                </c:pt>
                <c:pt idx="6756">
                  <c:v>1143.29</c:v>
                </c:pt>
                <c:pt idx="6757">
                  <c:v>1173.74</c:v>
                </c:pt>
                <c:pt idx="6758">
                  <c:v>1755</c:v>
                </c:pt>
                <c:pt idx="6763">
                  <c:v>982.36800000000005</c:v>
                </c:pt>
                <c:pt idx="6767">
                  <c:v>701.78399999999999</c:v>
                </c:pt>
                <c:pt idx="6769">
                  <c:v>947.59199999999998</c:v>
                </c:pt>
                <c:pt idx="6771">
                  <c:v>1079.57</c:v>
                </c:pt>
                <c:pt idx="6774">
                  <c:v>1143.5</c:v>
                </c:pt>
                <c:pt idx="6775">
                  <c:v>1159.92</c:v>
                </c:pt>
                <c:pt idx="6778">
                  <c:v>864.64800000000002</c:v>
                </c:pt>
                <c:pt idx="6793">
                  <c:v>1281.96</c:v>
                </c:pt>
                <c:pt idx="6794">
                  <c:v>1273.97</c:v>
                </c:pt>
                <c:pt idx="6801">
                  <c:v>1996.49</c:v>
                </c:pt>
                <c:pt idx="6809">
                  <c:v>560.52</c:v>
                </c:pt>
                <c:pt idx="6811">
                  <c:v>758.37599999999998</c:v>
                </c:pt>
                <c:pt idx="6812">
                  <c:v>1239.4100000000001</c:v>
                </c:pt>
                <c:pt idx="6817">
                  <c:v>1505.74</c:v>
                </c:pt>
                <c:pt idx="6818">
                  <c:v>1014.98</c:v>
                </c:pt>
                <c:pt idx="6820">
                  <c:v>875.44799999999998</c:v>
                </c:pt>
                <c:pt idx="6827">
                  <c:v>487.72800000000001</c:v>
                </c:pt>
                <c:pt idx="6829">
                  <c:v>2163.46</c:v>
                </c:pt>
                <c:pt idx="6830">
                  <c:v>1027.73</c:v>
                </c:pt>
                <c:pt idx="6833">
                  <c:v>1423.87</c:v>
                </c:pt>
                <c:pt idx="6836">
                  <c:v>508.89600000000002</c:v>
                </c:pt>
                <c:pt idx="6839">
                  <c:v>882.36</c:v>
                </c:pt>
                <c:pt idx="6840">
                  <c:v>1239.8399999999999</c:v>
                </c:pt>
                <c:pt idx="6842">
                  <c:v>1200.96</c:v>
                </c:pt>
                <c:pt idx="6844">
                  <c:v>1131.8399999999999</c:v>
                </c:pt>
                <c:pt idx="6848">
                  <c:v>893.80799999999999</c:v>
                </c:pt>
                <c:pt idx="6852">
                  <c:v>812.37599999999998</c:v>
                </c:pt>
                <c:pt idx="6862">
                  <c:v>421.84800000000001</c:v>
                </c:pt>
                <c:pt idx="6865">
                  <c:v>1785.02</c:v>
                </c:pt>
                <c:pt idx="6867">
                  <c:v>827.49599999999998</c:v>
                </c:pt>
                <c:pt idx="6872">
                  <c:v>635.25599999999997</c:v>
                </c:pt>
                <c:pt idx="6875">
                  <c:v>1140.7</c:v>
                </c:pt>
                <c:pt idx="6879">
                  <c:v>1503.14</c:v>
                </c:pt>
                <c:pt idx="6882">
                  <c:v>1068.3399999999999</c:v>
                </c:pt>
                <c:pt idx="6884">
                  <c:v>720.57600000000002</c:v>
                </c:pt>
                <c:pt idx="6885">
                  <c:v>1510.27</c:v>
                </c:pt>
                <c:pt idx="6893">
                  <c:v>883.00800000000004</c:v>
                </c:pt>
                <c:pt idx="6894">
                  <c:v>792.28800000000001</c:v>
                </c:pt>
                <c:pt idx="6895">
                  <c:v>1869.26</c:v>
                </c:pt>
                <c:pt idx="6896">
                  <c:v>998.13599999999997</c:v>
                </c:pt>
                <c:pt idx="6901">
                  <c:v>1324.94</c:v>
                </c:pt>
                <c:pt idx="6904">
                  <c:v>1145.02</c:v>
                </c:pt>
                <c:pt idx="6920">
                  <c:v>1196.8599999999999</c:v>
                </c:pt>
                <c:pt idx="6923">
                  <c:v>553.82399999999996</c:v>
                </c:pt>
                <c:pt idx="6926">
                  <c:v>776.952</c:v>
                </c:pt>
                <c:pt idx="6928">
                  <c:v>897.26400000000001</c:v>
                </c:pt>
                <c:pt idx="6929">
                  <c:v>937.22400000000005</c:v>
                </c:pt>
                <c:pt idx="6940">
                  <c:v>1081.08</c:v>
                </c:pt>
                <c:pt idx="6943">
                  <c:v>1300.32</c:v>
                </c:pt>
                <c:pt idx="6944">
                  <c:v>480.38400000000001</c:v>
                </c:pt>
                <c:pt idx="6951">
                  <c:v>1394.28</c:v>
                </c:pt>
                <c:pt idx="6952">
                  <c:v>568.29600000000005</c:v>
                </c:pt>
                <c:pt idx="6955">
                  <c:v>454.68</c:v>
                </c:pt>
                <c:pt idx="6959">
                  <c:v>1125.3599999999999</c:v>
                </c:pt>
                <c:pt idx="6964">
                  <c:v>1344.82</c:v>
                </c:pt>
                <c:pt idx="6973">
                  <c:v>715.17600000000004</c:v>
                </c:pt>
                <c:pt idx="6974">
                  <c:v>810.43200000000002</c:v>
                </c:pt>
                <c:pt idx="6977">
                  <c:v>959.04</c:v>
                </c:pt>
                <c:pt idx="6979">
                  <c:v>1241.1400000000001</c:v>
                </c:pt>
                <c:pt idx="6985">
                  <c:v>595.29600000000005</c:v>
                </c:pt>
                <c:pt idx="6990">
                  <c:v>894.024</c:v>
                </c:pt>
                <c:pt idx="6994">
                  <c:v>909.14400000000001</c:v>
                </c:pt>
                <c:pt idx="6999">
                  <c:v>911.30399999999997</c:v>
                </c:pt>
                <c:pt idx="7000">
                  <c:v>1156.03</c:v>
                </c:pt>
                <c:pt idx="7006">
                  <c:v>374.54399999999998</c:v>
                </c:pt>
                <c:pt idx="7007">
                  <c:v>1493.64</c:v>
                </c:pt>
                <c:pt idx="7008">
                  <c:v>1071.3599999999999</c:v>
                </c:pt>
                <c:pt idx="7013">
                  <c:v>1448.93</c:v>
                </c:pt>
                <c:pt idx="7014">
                  <c:v>1523.88</c:v>
                </c:pt>
                <c:pt idx="7017">
                  <c:v>565.91999999999996</c:v>
                </c:pt>
                <c:pt idx="7021">
                  <c:v>961.63199999999995</c:v>
                </c:pt>
                <c:pt idx="7022">
                  <c:v>61.128</c:v>
                </c:pt>
                <c:pt idx="7025">
                  <c:v>495.072</c:v>
                </c:pt>
                <c:pt idx="7034">
                  <c:v>1234.6600000000001</c:v>
                </c:pt>
                <c:pt idx="7035">
                  <c:v>782.56799999999998</c:v>
                </c:pt>
                <c:pt idx="7037">
                  <c:v>1159.06</c:v>
                </c:pt>
                <c:pt idx="7038">
                  <c:v>748.65599999999995</c:v>
                </c:pt>
                <c:pt idx="7039">
                  <c:v>1106.1400000000001</c:v>
                </c:pt>
                <c:pt idx="7043">
                  <c:v>2232.79</c:v>
                </c:pt>
                <c:pt idx="7045">
                  <c:v>1310.47</c:v>
                </c:pt>
                <c:pt idx="7048">
                  <c:v>1006.34</c:v>
                </c:pt>
                <c:pt idx="7049">
                  <c:v>1253.02</c:v>
                </c:pt>
                <c:pt idx="7057">
                  <c:v>898.56</c:v>
                </c:pt>
                <c:pt idx="7067">
                  <c:v>333.28800000000001</c:v>
                </c:pt>
                <c:pt idx="7069">
                  <c:v>1076.76</c:v>
                </c:pt>
                <c:pt idx="7070">
                  <c:v>1234.22</c:v>
                </c:pt>
                <c:pt idx="7072">
                  <c:v>1147.18</c:v>
                </c:pt>
                <c:pt idx="7073">
                  <c:v>497.01600000000002</c:v>
                </c:pt>
                <c:pt idx="7077">
                  <c:v>892.72799999999995</c:v>
                </c:pt>
                <c:pt idx="7078">
                  <c:v>648.64800000000002</c:v>
                </c:pt>
                <c:pt idx="7081">
                  <c:v>1162.08</c:v>
                </c:pt>
                <c:pt idx="7083">
                  <c:v>1789.78</c:v>
                </c:pt>
                <c:pt idx="7084">
                  <c:v>608.68799999999999</c:v>
                </c:pt>
                <c:pt idx="7090">
                  <c:v>947.59199999999998</c:v>
                </c:pt>
                <c:pt idx="7096">
                  <c:v>679.53599999999994</c:v>
                </c:pt>
                <c:pt idx="7100">
                  <c:v>1902.53</c:v>
                </c:pt>
                <c:pt idx="7103">
                  <c:v>1223.42</c:v>
                </c:pt>
                <c:pt idx="7104">
                  <c:v>883.65599999999995</c:v>
                </c:pt>
                <c:pt idx="7107">
                  <c:v>702</c:v>
                </c:pt>
                <c:pt idx="7111">
                  <c:v>909.36</c:v>
                </c:pt>
                <c:pt idx="7112">
                  <c:v>1298.3800000000001</c:v>
                </c:pt>
                <c:pt idx="7114">
                  <c:v>1324.3</c:v>
                </c:pt>
                <c:pt idx="7115">
                  <c:v>1083.24</c:v>
                </c:pt>
                <c:pt idx="7117">
                  <c:v>777.6</c:v>
                </c:pt>
                <c:pt idx="7120">
                  <c:v>1245.8900000000001</c:v>
                </c:pt>
                <c:pt idx="7128">
                  <c:v>1325.59</c:v>
                </c:pt>
                <c:pt idx="7131">
                  <c:v>630.50400000000002</c:v>
                </c:pt>
                <c:pt idx="7136">
                  <c:v>1090.1500000000001</c:v>
                </c:pt>
                <c:pt idx="7137">
                  <c:v>304.12799999999999</c:v>
                </c:pt>
                <c:pt idx="7138">
                  <c:v>1103.54</c:v>
                </c:pt>
                <c:pt idx="7144">
                  <c:v>433.512</c:v>
                </c:pt>
                <c:pt idx="7150">
                  <c:v>1140.26</c:v>
                </c:pt>
                <c:pt idx="7151">
                  <c:v>1665.36</c:v>
                </c:pt>
                <c:pt idx="7153">
                  <c:v>1394.5</c:v>
                </c:pt>
                <c:pt idx="7154">
                  <c:v>1184.76</c:v>
                </c:pt>
                <c:pt idx="7155">
                  <c:v>1563.41</c:v>
                </c:pt>
                <c:pt idx="7157">
                  <c:v>1229.9000000000001</c:v>
                </c:pt>
                <c:pt idx="7159">
                  <c:v>1113.9100000000001</c:v>
                </c:pt>
                <c:pt idx="7163">
                  <c:v>966.16800000000001</c:v>
                </c:pt>
                <c:pt idx="7164">
                  <c:v>1176.98</c:v>
                </c:pt>
                <c:pt idx="7172">
                  <c:v>1391.04</c:v>
                </c:pt>
                <c:pt idx="7179">
                  <c:v>1138.75</c:v>
                </c:pt>
                <c:pt idx="7180">
                  <c:v>1022.33</c:v>
                </c:pt>
                <c:pt idx="7181">
                  <c:v>601.34400000000005</c:v>
                </c:pt>
                <c:pt idx="7186">
                  <c:v>981.072</c:v>
                </c:pt>
                <c:pt idx="7188">
                  <c:v>1408.75</c:v>
                </c:pt>
                <c:pt idx="7191">
                  <c:v>566.56799999999998</c:v>
                </c:pt>
                <c:pt idx="7192">
                  <c:v>3126.82</c:v>
                </c:pt>
                <c:pt idx="7196">
                  <c:v>419.68799999999999</c:v>
                </c:pt>
                <c:pt idx="7197">
                  <c:v>1299.24</c:v>
                </c:pt>
                <c:pt idx="7205">
                  <c:v>599.61599999999999</c:v>
                </c:pt>
                <c:pt idx="7211">
                  <c:v>714.096</c:v>
                </c:pt>
                <c:pt idx="7228">
                  <c:v>1028.3800000000001</c:v>
                </c:pt>
                <c:pt idx="7231">
                  <c:v>1473.55</c:v>
                </c:pt>
                <c:pt idx="7238">
                  <c:v>524.01599999999996</c:v>
                </c:pt>
                <c:pt idx="7242">
                  <c:v>965.08799999999997</c:v>
                </c:pt>
                <c:pt idx="7243">
                  <c:v>1018.22</c:v>
                </c:pt>
                <c:pt idx="7244">
                  <c:v>1855.22</c:v>
                </c:pt>
                <c:pt idx="7245">
                  <c:v>985.17600000000004</c:v>
                </c:pt>
                <c:pt idx="7252">
                  <c:v>1198.3699999999999</c:v>
                </c:pt>
                <c:pt idx="7257">
                  <c:v>873.72</c:v>
                </c:pt>
                <c:pt idx="7258">
                  <c:v>956.01599999999996</c:v>
                </c:pt>
                <c:pt idx="7260">
                  <c:v>846.72</c:v>
                </c:pt>
                <c:pt idx="7262">
                  <c:v>809.13599999999997</c:v>
                </c:pt>
                <c:pt idx="7263">
                  <c:v>1040.69</c:v>
                </c:pt>
                <c:pt idx="7265">
                  <c:v>1452.82</c:v>
                </c:pt>
                <c:pt idx="7269">
                  <c:v>624.67200000000003</c:v>
                </c:pt>
                <c:pt idx="7274">
                  <c:v>1332.72</c:v>
                </c:pt>
                <c:pt idx="7281">
                  <c:v>1373.76</c:v>
                </c:pt>
                <c:pt idx="7289">
                  <c:v>777.38400000000001</c:v>
                </c:pt>
                <c:pt idx="7290">
                  <c:v>1400.33</c:v>
                </c:pt>
                <c:pt idx="7298">
                  <c:v>721.65599999999995</c:v>
                </c:pt>
                <c:pt idx="7300">
                  <c:v>656.64</c:v>
                </c:pt>
                <c:pt idx="7301">
                  <c:v>646.48800000000006</c:v>
                </c:pt>
                <c:pt idx="7308">
                  <c:v>800.06399999999996</c:v>
                </c:pt>
                <c:pt idx="7309">
                  <c:v>1160.1400000000001</c:v>
                </c:pt>
                <c:pt idx="7310">
                  <c:v>753.62400000000002</c:v>
                </c:pt>
                <c:pt idx="7311">
                  <c:v>629.42399999999998</c:v>
                </c:pt>
                <c:pt idx="7315">
                  <c:v>1641.82</c:v>
                </c:pt>
                <c:pt idx="7319">
                  <c:v>835.05600000000004</c:v>
                </c:pt>
                <c:pt idx="7320">
                  <c:v>1074.82</c:v>
                </c:pt>
                <c:pt idx="7325">
                  <c:v>567</c:v>
                </c:pt>
                <c:pt idx="7327">
                  <c:v>732.67200000000003</c:v>
                </c:pt>
                <c:pt idx="7328">
                  <c:v>2022.84</c:v>
                </c:pt>
                <c:pt idx="7335">
                  <c:v>864.21600000000001</c:v>
                </c:pt>
                <c:pt idx="7341">
                  <c:v>1734.7</c:v>
                </c:pt>
                <c:pt idx="7343">
                  <c:v>1965.17</c:v>
                </c:pt>
                <c:pt idx="7347">
                  <c:v>756.43200000000002</c:v>
                </c:pt>
                <c:pt idx="7349">
                  <c:v>1262.0899999999999</c:v>
                </c:pt>
                <c:pt idx="7350">
                  <c:v>1336.18</c:v>
                </c:pt>
                <c:pt idx="7352">
                  <c:v>998.13599999999997</c:v>
                </c:pt>
                <c:pt idx="7353">
                  <c:v>914.76</c:v>
                </c:pt>
                <c:pt idx="7357">
                  <c:v>897.91200000000003</c:v>
                </c:pt>
                <c:pt idx="7358">
                  <c:v>671.976</c:v>
                </c:pt>
                <c:pt idx="7361">
                  <c:v>1440.07</c:v>
                </c:pt>
                <c:pt idx="7364">
                  <c:v>1358.64</c:v>
                </c:pt>
                <c:pt idx="7368">
                  <c:v>1031.18</c:v>
                </c:pt>
                <c:pt idx="7369">
                  <c:v>1100.3</c:v>
                </c:pt>
                <c:pt idx="7378">
                  <c:v>630.93600000000004</c:v>
                </c:pt>
                <c:pt idx="7380">
                  <c:v>588.38400000000001</c:v>
                </c:pt>
                <c:pt idx="7383">
                  <c:v>1358.42</c:v>
                </c:pt>
                <c:pt idx="7384">
                  <c:v>1235.0899999999999</c:v>
                </c:pt>
                <c:pt idx="7387">
                  <c:v>839.59199999999998</c:v>
                </c:pt>
                <c:pt idx="7394">
                  <c:v>905.904</c:v>
                </c:pt>
                <c:pt idx="7403">
                  <c:v>1039.6099999999999</c:v>
                </c:pt>
                <c:pt idx="7406">
                  <c:v>967.89599999999996</c:v>
                </c:pt>
                <c:pt idx="7407">
                  <c:v>876.74400000000003</c:v>
                </c:pt>
                <c:pt idx="7420">
                  <c:v>759.024</c:v>
                </c:pt>
                <c:pt idx="7424">
                  <c:v>830.08799999999997</c:v>
                </c:pt>
                <c:pt idx="7429">
                  <c:v>1410.7</c:v>
                </c:pt>
                <c:pt idx="7430">
                  <c:v>897.91200000000003</c:v>
                </c:pt>
                <c:pt idx="7433">
                  <c:v>830.30399999999997</c:v>
                </c:pt>
                <c:pt idx="7441">
                  <c:v>856.00800000000004</c:v>
                </c:pt>
                <c:pt idx="7450">
                  <c:v>995.11199999999997</c:v>
                </c:pt>
                <c:pt idx="7453">
                  <c:v>1238.1099999999999</c:v>
                </c:pt>
                <c:pt idx="7454">
                  <c:v>805.03200000000004</c:v>
                </c:pt>
                <c:pt idx="7455">
                  <c:v>1589.54</c:v>
                </c:pt>
                <c:pt idx="7460">
                  <c:v>1021.9</c:v>
                </c:pt>
                <c:pt idx="7463">
                  <c:v>969.19200000000001</c:v>
                </c:pt>
                <c:pt idx="7464">
                  <c:v>443.01600000000002</c:v>
                </c:pt>
                <c:pt idx="7467">
                  <c:v>2699.57</c:v>
                </c:pt>
                <c:pt idx="7473">
                  <c:v>840.88800000000003</c:v>
                </c:pt>
                <c:pt idx="7475">
                  <c:v>365.904</c:v>
                </c:pt>
                <c:pt idx="7478">
                  <c:v>738.28800000000001</c:v>
                </c:pt>
                <c:pt idx="7483">
                  <c:v>1344.17</c:v>
                </c:pt>
                <c:pt idx="7486">
                  <c:v>1125.3599999999999</c:v>
                </c:pt>
                <c:pt idx="7488">
                  <c:v>521.85599999999999</c:v>
                </c:pt>
                <c:pt idx="7492">
                  <c:v>1514.59</c:v>
                </c:pt>
                <c:pt idx="7493">
                  <c:v>614.08799999999997</c:v>
                </c:pt>
                <c:pt idx="7494">
                  <c:v>781.70399999999995</c:v>
                </c:pt>
                <c:pt idx="7495">
                  <c:v>646.70399999999995</c:v>
                </c:pt>
                <c:pt idx="7500">
                  <c:v>1486.94</c:v>
                </c:pt>
                <c:pt idx="7504">
                  <c:v>891.43200000000002</c:v>
                </c:pt>
                <c:pt idx="7513">
                  <c:v>2986.63</c:v>
                </c:pt>
                <c:pt idx="7520">
                  <c:v>1594.51</c:v>
                </c:pt>
                <c:pt idx="7526">
                  <c:v>863.35199999999998</c:v>
                </c:pt>
                <c:pt idx="7527">
                  <c:v>539.35199999999998</c:v>
                </c:pt>
                <c:pt idx="7529">
                  <c:v>712.8</c:v>
                </c:pt>
                <c:pt idx="7533">
                  <c:v>859.03200000000004</c:v>
                </c:pt>
                <c:pt idx="7535">
                  <c:v>3790.8</c:v>
                </c:pt>
                <c:pt idx="7540">
                  <c:v>1175.9000000000001</c:v>
                </c:pt>
                <c:pt idx="7544">
                  <c:v>531.79200000000003</c:v>
                </c:pt>
                <c:pt idx="7545">
                  <c:v>1975.75</c:v>
                </c:pt>
                <c:pt idx="7549">
                  <c:v>1126.8699999999999</c:v>
                </c:pt>
                <c:pt idx="7551">
                  <c:v>1021.9</c:v>
                </c:pt>
                <c:pt idx="7552">
                  <c:v>2354.4</c:v>
                </c:pt>
                <c:pt idx="7554">
                  <c:v>1512.22</c:v>
                </c:pt>
                <c:pt idx="7558">
                  <c:v>995.32799999999997</c:v>
                </c:pt>
                <c:pt idx="7559">
                  <c:v>704.59199999999998</c:v>
                </c:pt>
                <c:pt idx="7560">
                  <c:v>736.12800000000004</c:v>
                </c:pt>
                <c:pt idx="7565">
                  <c:v>1887.41</c:v>
                </c:pt>
                <c:pt idx="7569">
                  <c:v>1337.26</c:v>
                </c:pt>
                <c:pt idx="7570">
                  <c:v>919.08</c:v>
                </c:pt>
                <c:pt idx="7571">
                  <c:v>810.43200000000002</c:v>
                </c:pt>
                <c:pt idx="7573">
                  <c:v>780.19200000000001</c:v>
                </c:pt>
                <c:pt idx="7576">
                  <c:v>1235.95</c:v>
                </c:pt>
                <c:pt idx="7580">
                  <c:v>1206.3599999999999</c:v>
                </c:pt>
                <c:pt idx="7583">
                  <c:v>572.61599999999999</c:v>
                </c:pt>
                <c:pt idx="7588">
                  <c:v>749.30399999999997</c:v>
                </c:pt>
                <c:pt idx="7592">
                  <c:v>1211.1099999999999</c:v>
                </c:pt>
                <c:pt idx="7593">
                  <c:v>649.51199999999994</c:v>
                </c:pt>
                <c:pt idx="7596">
                  <c:v>1491.91</c:v>
                </c:pt>
                <c:pt idx="7597">
                  <c:v>938.952</c:v>
                </c:pt>
                <c:pt idx="7598">
                  <c:v>1198.58</c:v>
                </c:pt>
                <c:pt idx="7606">
                  <c:v>1113.7</c:v>
                </c:pt>
                <c:pt idx="7611">
                  <c:v>946.08</c:v>
                </c:pt>
                <c:pt idx="7612">
                  <c:v>1092.74</c:v>
                </c:pt>
                <c:pt idx="7614">
                  <c:v>2315.7399999999998</c:v>
                </c:pt>
                <c:pt idx="7615">
                  <c:v>1359.72</c:v>
                </c:pt>
                <c:pt idx="7616">
                  <c:v>1458.22</c:v>
                </c:pt>
                <c:pt idx="7617">
                  <c:v>1355.4</c:v>
                </c:pt>
                <c:pt idx="7627">
                  <c:v>1344.82</c:v>
                </c:pt>
                <c:pt idx="7628">
                  <c:v>582.33600000000001</c:v>
                </c:pt>
                <c:pt idx="7633">
                  <c:v>10245.299999999999</c:v>
                </c:pt>
                <c:pt idx="7634">
                  <c:v>871.12800000000004</c:v>
                </c:pt>
                <c:pt idx="7638">
                  <c:v>655.77599999999995</c:v>
                </c:pt>
                <c:pt idx="7640">
                  <c:v>1063.8</c:v>
                </c:pt>
                <c:pt idx="7647">
                  <c:v>1445.04</c:v>
                </c:pt>
                <c:pt idx="7648">
                  <c:v>1076.33</c:v>
                </c:pt>
                <c:pt idx="7652">
                  <c:v>471.31200000000001</c:v>
                </c:pt>
                <c:pt idx="7662">
                  <c:v>294.40800000000002</c:v>
                </c:pt>
                <c:pt idx="7668">
                  <c:v>1576.58</c:v>
                </c:pt>
                <c:pt idx="7671">
                  <c:v>472.82400000000001</c:v>
                </c:pt>
                <c:pt idx="7674">
                  <c:v>2105.35</c:v>
                </c:pt>
                <c:pt idx="7678">
                  <c:v>1232.5</c:v>
                </c:pt>
                <c:pt idx="7680">
                  <c:v>793.15200000000004</c:v>
                </c:pt>
                <c:pt idx="7683">
                  <c:v>1313.71</c:v>
                </c:pt>
                <c:pt idx="7688">
                  <c:v>1128.3800000000001</c:v>
                </c:pt>
                <c:pt idx="7694">
                  <c:v>3885.41</c:v>
                </c:pt>
                <c:pt idx="7698">
                  <c:v>947.37599999999998</c:v>
                </c:pt>
                <c:pt idx="7700">
                  <c:v>710.42399999999998</c:v>
                </c:pt>
                <c:pt idx="7704">
                  <c:v>869.83199999999999</c:v>
                </c:pt>
                <c:pt idx="7705">
                  <c:v>609.98400000000004</c:v>
                </c:pt>
                <c:pt idx="7712">
                  <c:v>913.24800000000005</c:v>
                </c:pt>
                <c:pt idx="7715">
                  <c:v>1003.32</c:v>
                </c:pt>
                <c:pt idx="7718">
                  <c:v>1117.1500000000001</c:v>
                </c:pt>
                <c:pt idx="7725">
                  <c:v>831.38400000000001</c:v>
                </c:pt>
                <c:pt idx="7726">
                  <c:v>1074.5999999999999</c:v>
                </c:pt>
                <c:pt idx="7732">
                  <c:v>987.76800000000003</c:v>
                </c:pt>
                <c:pt idx="7739">
                  <c:v>1347.19</c:v>
                </c:pt>
                <c:pt idx="7740">
                  <c:v>492.69600000000003</c:v>
                </c:pt>
                <c:pt idx="7741">
                  <c:v>1002.67</c:v>
                </c:pt>
                <c:pt idx="7742">
                  <c:v>1152.3599999999999</c:v>
                </c:pt>
                <c:pt idx="7743">
                  <c:v>1584.14</c:v>
                </c:pt>
                <c:pt idx="7753">
                  <c:v>869.4</c:v>
                </c:pt>
                <c:pt idx="7756">
                  <c:v>619.91999999999996</c:v>
                </c:pt>
                <c:pt idx="7758">
                  <c:v>754.05600000000004</c:v>
                </c:pt>
                <c:pt idx="7769">
                  <c:v>1350.22</c:v>
                </c:pt>
                <c:pt idx="7770">
                  <c:v>972.43200000000002</c:v>
                </c:pt>
                <c:pt idx="7775">
                  <c:v>1470.31</c:v>
                </c:pt>
                <c:pt idx="7780">
                  <c:v>859.68</c:v>
                </c:pt>
                <c:pt idx="7782">
                  <c:v>1175.26</c:v>
                </c:pt>
                <c:pt idx="7784">
                  <c:v>1253.6600000000001</c:v>
                </c:pt>
                <c:pt idx="7786">
                  <c:v>763.56</c:v>
                </c:pt>
                <c:pt idx="7791">
                  <c:v>1256.9000000000001</c:v>
                </c:pt>
                <c:pt idx="7795">
                  <c:v>1022.98</c:v>
                </c:pt>
                <c:pt idx="7797">
                  <c:v>1167.26</c:v>
                </c:pt>
                <c:pt idx="7798">
                  <c:v>1060.99</c:v>
                </c:pt>
                <c:pt idx="7800">
                  <c:v>482.32799999999997</c:v>
                </c:pt>
                <c:pt idx="7801">
                  <c:v>821.01599999999996</c:v>
                </c:pt>
                <c:pt idx="7803">
                  <c:v>683.42399999999998</c:v>
                </c:pt>
                <c:pt idx="7807">
                  <c:v>1334.45</c:v>
                </c:pt>
                <c:pt idx="7812">
                  <c:v>489.88799999999998</c:v>
                </c:pt>
                <c:pt idx="7815">
                  <c:v>1490.62</c:v>
                </c:pt>
                <c:pt idx="7817">
                  <c:v>983.66399999999999</c:v>
                </c:pt>
                <c:pt idx="7821">
                  <c:v>425.52</c:v>
                </c:pt>
                <c:pt idx="7826">
                  <c:v>959.25599999999997</c:v>
                </c:pt>
                <c:pt idx="7828">
                  <c:v>1300.97</c:v>
                </c:pt>
                <c:pt idx="7829">
                  <c:v>756.64800000000002</c:v>
                </c:pt>
                <c:pt idx="7831">
                  <c:v>1026.43</c:v>
                </c:pt>
                <c:pt idx="7834">
                  <c:v>942.84</c:v>
                </c:pt>
                <c:pt idx="7838">
                  <c:v>820.58399999999995</c:v>
                </c:pt>
                <c:pt idx="7843">
                  <c:v>1279.3699999999999</c:v>
                </c:pt>
                <c:pt idx="7853">
                  <c:v>702.43200000000002</c:v>
                </c:pt>
                <c:pt idx="7869">
                  <c:v>1303.3399999999999</c:v>
                </c:pt>
                <c:pt idx="7870">
                  <c:v>1580.47</c:v>
                </c:pt>
                <c:pt idx="7871">
                  <c:v>1843.99</c:v>
                </c:pt>
                <c:pt idx="7872">
                  <c:v>807.19200000000001</c:v>
                </c:pt>
                <c:pt idx="7875">
                  <c:v>1329.48</c:v>
                </c:pt>
                <c:pt idx="7878">
                  <c:v>756.43200000000002</c:v>
                </c:pt>
                <c:pt idx="7881">
                  <c:v>719.06399999999996</c:v>
                </c:pt>
                <c:pt idx="7883">
                  <c:v>1742.04</c:v>
                </c:pt>
                <c:pt idx="7884">
                  <c:v>397.65600000000001</c:v>
                </c:pt>
                <c:pt idx="7885">
                  <c:v>884.30399999999997</c:v>
                </c:pt>
                <c:pt idx="7886">
                  <c:v>702.86400000000003</c:v>
                </c:pt>
                <c:pt idx="7888">
                  <c:v>1824.98</c:v>
                </c:pt>
                <c:pt idx="7890">
                  <c:v>1121.26</c:v>
                </c:pt>
                <c:pt idx="7891">
                  <c:v>913.03200000000004</c:v>
                </c:pt>
                <c:pt idx="7892">
                  <c:v>1386.5</c:v>
                </c:pt>
                <c:pt idx="7896">
                  <c:v>746.928</c:v>
                </c:pt>
                <c:pt idx="7903">
                  <c:v>606.74400000000003</c:v>
                </c:pt>
                <c:pt idx="7904">
                  <c:v>1054.08</c:v>
                </c:pt>
                <c:pt idx="7906">
                  <c:v>842.18399999999997</c:v>
                </c:pt>
                <c:pt idx="7910">
                  <c:v>1580.9</c:v>
                </c:pt>
                <c:pt idx="7911">
                  <c:v>1095.1199999999999</c:v>
                </c:pt>
                <c:pt idx="7915">
                  <c:v>1397.3</c:v>
                </c:pt>
                <c:pt idx="7917">
                  <c:v>730.08</c:v>
                </c:pt>
                <c:pt idx="7918">
                  <c:v>771.98400000000004</c:v>
                </c:pt>
                <c:pt idx="7926">
                  <c:v>1324.51</c:v>
                </c:pt>
                <c:pt idx="7929">
                  <c:v>836.56799999999998</c:v>
                </c:pt>
                <c:pt idx="7935">
                  <c:v>957.74400000000003</c:v>
                </c:pt>
                <c:pt idx="7940">
                  <c:v>1024.49</c:v>
                </c:pt>
                <c:pt idx="7949">
                  <c:v>865.29600000000005</c:v>
                </c:pt>
                <c:pt idx="7950">
                  <c:v>625.10400000000004</c:v>
                </c:pt>
                <c:pt idx="7954">
                  <c:v>1313.5</c:v>
                </c:pt>
                <c:pt idx="7962">
                  <c:v>1585.87</c:v>
                </c:pt>
                <c:pt idx="7969">
                  <c:v>1136.1600000000001</c:v>
                </c:pt>
                <c:pt idx="7971">
                  <c:v>451.44</c:v>
                </c:pt>
                <c:pt idx="7973">
                  <c:v>945.64800000000002</c:v>
                </c:pt>
                <c:pt idx="7975">
                  <c:v>975.024</c:v>
                </c:pt>
                <c:pt idx="7976">
                  <c:v>1434.89</c:v>
                </c:pt>
                <c:pt idx="7977">
                  <c:v>1682.42</c:v>
                </c:pt>
                <c:pt idx="7983">
                  <c:v>1174.3900000000001</c:v>
                </c:pt>
                <c:pt idx="7984">
                  <c:v>717.12</c:v>
                </c:pt>
                <c:pt idx="7986">
                  <c:v>734.83199999999999</c:v>
                </c:pt>
                <c:pt idx="7989">
                  <c:v>883.00800000000004</c:v>
                </c:pt>
                <c:pt idx="7998">
                  <c:v>385.99200000000002</c:v>
                </c:pt>
                <c:pt idx="8001">
                  <c:v>1209.5999999999999</c:v>
                </c:pt>
                <c:pt idx="8004">
                  <c:v>1445.47</c:v>
                </c:pt>
                <c:pt idx="8006">
                  <c:v>1057.75</c:v>
                </c:pt>
                <c:pt idx="8008">
                  <c:v>1249.1300000000001</c:v>
                </c:pt>
                <c:pt idx="8010">
                  <c:v>1318.46</c:v>
                </c:pt>
                <c:pt idx="8011">
                  <c:v>744.76800000000003</c:v>
                </c:pt>
                <c:pt idx="8019">
                  <c:v>463.96800000000002</c:v>
                </c:pt>
                <c:pt idx="8024">
                  <c:v>821.44799999999998</c:v>
                </c:pt>
                <c:pt idx="8025">
                  <c:v>1155.3800000000001</c:v>
                </c:pt>
                <c:pt idx="8026">
                  <c:v>909.57600000000002</c:v>
                </c:pt>
                <c:pt idx="8029">
                  <c:v>903.96</c:v>
                </c:pt>
                <c:pt idx="8030">
                  <c:v>668.30399999999997</c:v>
                </c:pt>
                <c:pt idx="8031">
                  <c:v>1231.2</c:v>
                </c:pt>
                <c:pt idx="8036">
                  <c:v>655.99199999999996</c:v>
                </c:pt>
                <c:pt idx="8037">
                  <c:v>723.38400000000001</c:v>
                </c:pt>
                <c:pt idx="8039">
                  <c:v>1146.74</c:v>
                </c:pt>
                <c:pt idx="8044">
                  <c:v>937.22400000000005</c:v>
                </c:pt>
                <c:pt idx="8046">
                  <c:v>674.13599999999997</c:v>
                </c:pt>
                <c:pt idx="8049">
                  <c:v>928.36800000000005</c:v>
                </c:pt>
                <c:pt idx="8051">
                  <c:v>1158.8399999999999</c:v>
                </c:pt>
                <c:pt idx="8052">
                  <c:v>1229.04</c:v>
                </c:pt>
                <c:pt idx="8055">
                  <c:v>1074.82</c:v>
                </c:pt>
                <c:pt idx="8059">
                  <c:v>1267.7</c:v>
                </c:pt>
                <c:pt idx="8060">
                  <c:v>813.88800000000003</c:v>
                </c:pt>
                <c:pt idx="8066">
                  <c:v>1298.1600000000001</c:v>
                </c:pt>
                <c:pt idx="8067">
                  <c:v>1256.47</c:v>
                </c:pt>
                <c:pt idx="8068">
                  <c:v>1445.9</c:v>
                </c:pt>
                <c:pt idx="8071">
                  <c:v>1444.18</c:v>
                </c:pt>
                <c:pt idx="8072">
                  <c:v>760.10400000000004</c:v>
                </c:pt>
                <c:pt idx="8074">
                  <c:v>1128.82</c:v>
                </c:pt>
                <c:pt idx="8079">
                  <c:v>640.87199999999996</c:v>
                </c:pt>
                <c:pt idx="8080">
                  <c:v>1351.73</c:v>
                </c:pt>
                <c:pt idx="8088">
                  <c:v>1088.21</c:v>
                </c:pt>
                <c:pt idx="8089">
                  <c:v>972</c:v>
                </c:pt>
                <c:pt idx="8092">
                  <c:v>1562.11</c:v>
                </c:pt>
                <c:pt idx="8096">
                  <c:v>667.65599999999995</c:v>
                </c:pt>
                <c:pt idx="8103">
                  <c:v>866.37599999999998</c:v>
                </c:pt>
                <c:pt idx="8105">
                  <c:v>1450.87</c:v>
                </c:pt>
                <c:pt idx="8110">
                  <c:v>1235.74</c:v>
                </c:pt>
                <c:pt idx="8115">
                  <c:v>1552.18</c:v>
                </c:pt>
                <c:pt idx="8116">
                  <c:v>1018.87</c:v>
                </c:pt>
                <c:pt idx="8127">
                  <c:v>1447.2</c:v>
                </c:pt>
                <c:pt idx="8131">
                  <c:v>1703.81</c:v>
                </c:pt>
                <c:pt idx="8134">
                  <c:v>1119.53</c:v>
                </c:pt>
                <c:pt idx="8141">
                  <c:v>953.64</c:v>
                </c:pt>
                <c:pt idx="8142">
                  <c:v>896.4</c:v>
                </c:pt>
                <c:pt idx="8143">
                  <c:v>1123.2</c:v>
                </c:pt>
                <c:pt idx="8145">
                  <c:v>1197.72</c:v>
                </c:pt>
                <c:pt idx="8146">
                  <c:v>1182.17</c:v>
                </c:pt>
                <c:pt idx="8147">
                  <c:v>2013.12</c:v>
                </c:pt>
                <c:pt idx="8149">
                  <c:v>2906.93</c:v>
                </c:pt>
                <c:pt idx="8152">
                  <c:v>684.28800000000001</c:v>
                </c:pt>
                <c:pt idx="8158">
                  <c:v>1261.44</c:v>
                </c:pt>
                <c:pt idx="8162">
                  <c:v>659.01599999999996</c:v>
                </c:pt>
                <c:pt idx="8165">
                  <c:v>1062.94</c:v>
                </c:pt>
                <c:pt idx="8169">
                  <c:v>1569.02</c:v>
                </c:pt>
                <c:pt idx="8171">
                  <c:v>865.51199999999994</c:v>
                </c:pt>
                <c:pt idx="8178">
                  <c:v>1302.26</c:v>
                </c:pt>
                <c:pt idx="8186">
                  <c:v>1032.26</c:v>
                </c:pt>
                <c:pt idx="8192">
                  <c:v>1154.52</c:v>
                </c:pt>
                <c:pt idx="8194">
                  <c:v>948.24</c:v>
                </c:pt>
                <c:pt idx="8196">
                  <c:v>889.48800000000006</c:v>
                </c:pt>
                <c:pt idx="8198">
                  <c:v>971.78399999999999</c:v>
                </c:pt>
                <c:pt idx="8200">
                  <c:v>1004.62</c:v>
                </c:pt>
                <c:pt idx="8202">
                  <c:v>1147.3900000000001</c:v>
                </c:pt>
                <c:pt idx="8211">
                  <c:v>931.60799999999995</c:v>
                </c:pt>
                <c:pt idx="8216">
                  <c:v>1815.26</c:v>
                </c:pt>
                <c:pt idx="8222">
                  <c:v>1179.79</c:v>
                </c:pt>
                <c:pt idx="8224">
                  <c:v>1219.32</c:v>
                </c:pt>
                <c:pt idx="8235">
                  <c:v>1474.63</c:v>
                </c:pt>
                <c:pt idx="8238">
                  <c:v>645.62400000000002</c:v>
                </c:pt>
                <c:pt idx="8240">
                  <c:v>700.92</c:v>
                </c:pt>
                <c:pt idx="8243">
                  <c:v>2117.66</c:v>
                </c:pt>
                <c:pt idx="8248">
                  <c:v>1100.52</c:v>
                </c:pt>
                <c:pt idx="8249">
                  <c:v>1614.82</c:v>
                </c:pt>
                <c:pt idx="8252">
                  <c:v>1221.05</c:v>
                </c:pt>
                <c:pt idx="8253">
                  <c:v>1762.56</c:v>
                </c:pt>
                <c:pt idx="8260">
                  <c:v>920.37599999999998</c:v>
                </c:pt>
                <c:pt idx="8262">
                  <c:v>1259.71</c:v>
                </c:pt>
                <c:pt idx="8263">
                  <c:v>1531.01</c:v>
                </c:pt>
                <c:pt idx="8271">
                  <c:v>958.17600000000004</c:v>
                </c:pt>
                <c:pt idx="8274">
                  <c:v>1045.44</c:v>
                </c:pt>
                <c:pt idx="8281">
                  <c:v>892.94399999999996</c:v>
                </c:pt>
                <c:pt idx="8284">
                  <c:v>641.52</c:v>
                </c:pt>
                <c:pt idx="8285">
                  <c:v>730.08</c:v>
                </c:pt>
                <c:pt idx="8287">
                  <c:v>1344.17</c:v>
                </c:pt>
                <c:pt idx="8291">
                  <c:v>925.12800000000004</c:v>
                </c:pt>
                <c:pt idx="8297">
                  <c:v>610.20000000000005</c:v>
                </c:pt>
                <c:pt idx="8298">
                  <c:v>1282.82</c:v>
                </c:pt>
                <c:pt idx="8299">
                  <c:v>893.59199999999998</c:v>
                </c:pt>
                <c:pt idx="8304">
                  <c:v>1486.08</c:v>
                </c:pt>
                <c:pt idx="8307">
                  <c:v>798.33600000000001</c:v>
                </c:pt>
                <c:pt idx="8309">
                  <c:v>667.44</c:v>
                </c:pt>
                <c:pt idx="8312">
                  <c:v>650.16</c:v>
                </c:pt>
                <c:pt idx="8314">
                  <c:v>1589.33</c:v>
                </c:pt>
                <c:pt idx="8315">
                  <c:v>501.33600000000001</c:v>
                </c:pt>
                <c:pt idx="8316">
                  <c:v>568.94399999999996</c:v>
                </c:pt>
                <c:pt idx="8318">
                  <c:v>1205.06</c:v>
                </c:pt>
                <c:pt idx="8322">
                  <c:v>1667.74</c:v>
                </c:pt>
                <c:pt idx="8323">
                  <c:v>942.19200000000001</c:v>
                </c:pt>
                <c:pt idx="8326">
                  <c:v>1498.39</c:v>
                </c:pt>
                <c:pt idx="8329">
                  <c:v>669.81600000000003</c:v>
                </c:pt>
                <c:pt idx="8332">
                  <c:v>1471.61</c:v>
                </c:pt>
                <c:pt idx="8333">
                  <c:v>1148.47</c:v>
                </c:pt>
                <c:pt idx="8336">
                  <c:v>1121.9000000000001</c:v>
                </c:pt>
                <c:pt idx="8338">
                  <c:v>1150.42</c:v>
                </c:pt>
                <c:pt idx="8347">
                  <c:v>1012.18</c:v>
                </c:pt>
                <c:pt idx="8355">
                  <c:v>1458.22</c:v>
                </c:pt>
                <c:pt idx="8357">
                  <c:v>1320.19</c:v>
                </c:pt>
                <c:pt idx="8358">
                  <c:v>1194.9100000000001</c:v>
                </c:pt>
                <c:pt idx="8360">
                  <c:v>1195.56</c:v>
                </c:pt>
                <c:pt idx="8361">
                  <c:v>1343.52</c:v>
                </c:pt>
                <c:pt idx="8366">
                  <c:v>865.72799999999995</c:v>
                </c:pt>
                <c:pt idx="8371">
                  <c:v>870.26400000000001</c:v>
                </c:pt>
                <c:pt idx="8375">
                  <c:v>841.96799999999996</c:v>
                </c:pt>
                <c:pt idx="8381">
                  <c:v>1040.47</c:v>
                </c:pt>
                <c:pt idx="8386">
                  <c:v>1366.85</c:v>
                </c:pt>
                <c:pt idx="8391">
                  <c:v>1066.3900000000001</c:v>
                </c:pt>
                <c:pt idx="8392">
                  <c:v>1750.68</c:v>
                </c:pt>
                <c:pt idx="8394">
                  <c:v>1220.83</c:v>
                </c:pt>
                <c:pt idx="8398">
                  <c:v>1639.44</c:v>
                </c:pt>
                <c:pt idx="8404">
                  <c:v>1291.68</c:v>
                </c:pt>
                <c:pt idx="8408">
                  <c:v>521.64</c:v>
                </c:pt>
                <c:pt idx="8411">
                  <c:v>1083.67</c:v>
                </c:pt>
                <c:pt idx="8412">
                  <c:v>1589.11</c:v>
                </c:pt>
                <c:pt idx="8414">
                  <c:v>1170.29</c:v>
                </c:pt>
                <c:pt idx="8417">
                  <c:v>811.08</c:v>
                </c:pt>
                <c:pt idx="8418">
                  <c:v>1178.5</c:v>
                </c:pt>
                <c:pt idx="8420">
                  <c:v>1980.07</c:v>
                </c:pt>
                <c:pt idx="8421">
                  <c:v>1343.74</c:v>
                </c:pt>
                <c:pt idx="8432">
                  <c:v>1492.78</c:v>
                </c:pt>
                <c:pt idx="8438">
                  <c:v>954.72</c:v>
                </c:pt>
                <c:pt idx="8439">
                  <c:v>767.66399999999999</c:v>
                </c:pt>
                <c:pt idx="8448">
                  <c:v>1332.94</c:v>
                </c:pt>
                <c:pt idx="8449">
                  <c:v>1414.58</c:v>
                </c:pt>
                <c:pt idx="8453">
                  <c:v>776.30399999999997</c:v>
                </c:pt>
                <c:pt idx="8456">
                  <c:v>1380.24</c:v>
                </c:pt>
                <c:pt idx="8460">
                  <c:v>1438.34</c:v>
                </c:pt>
                <c:pt idx="8464">
                  <c:v>743.904</c:v>
                </c:pt>
                <c:pt idx="8467">
                  <c:v>698.11199999999997</c:v>
                </c:pt>
                <c:pt idx="8482">
                  <c:v>1185.19</c:v>
                </c:pt>
                <c:pt idx="8483">
                  <c:v>901.15200000000004</c:v>
                </c:pt>
                <c:pt idx="8488">
                  <c:v>650.16</c:v>
                </c:pt>
                <c:pt idx="8491">
                  <c:v>866.37599999999998</c:v>
                </c:pt>
                <c:pt idx="8493">
                  <c:v>1078.49</c:v>
                </c:pt>
                <c:pt idx="8494">
                  <c:v>1195.99</c:v>
                </c:pt>
                <c:pt idx="8501">
                  <c:v>685.58399999999995</c:v>
                </c:pt>
                <c:pt idx="8505">
                  <c:v>1286.28</c:v>
                </c:pt>
                <c:pt idx="8508">
                  <c:v>712.15200000000004</c:v>
                </c:pt>
                <c:pt idx="8509">
                  <c:v>1126.6600000000001</c:v>
                </c:pt>
                <c:pt idx="8513">
                  <c:v>1505.74</c:v>
                </c:pt>
                <c:pt idx="8515">
                  <c:v>1608.98</c:v>
                </c:pt>
                <c:pt idx="8518">
                  <c:v>1396.01</c:v>
                </c:pt>
                <c:pt idx="8521">
                  <c:v>907.63199999999995</c:v>
                </c:pt>
                <c:pt idx="8528">
                  <c:v>2278.15</c:v>
                </c:pt>
                <c:pt idx="8530">
                  <c:v>1023.84</c:v>
                </c:pt>
                <c:pt idx="8532">
                  <c:v>1127.0899999999999</c:v>
                </c:pt>
                <c:pt idx="8536">
                  <c:v>1971.22</c:v>
                </c:pt>
                <c:pt idx="8542">
                  <c:v>614.08799999999997</c:v>
                </c:pt>
                <c:pt idx="8544">
                  <c:v>2096.2800000000002</c:v>
                </c:pt>
                <c:pt idx="8548">
                  <c:v>671.54399999999998</c:v>
                </c:pt>
                <c:pt idx="8549">
                  <c:v>930.52800000000002</c:v>
                </c:pt>
                <c:pt idx="8550">
                  <c:v>1872.5</c:v>
                </c:pt>
                <c:pt idx="8551">
                  <c:v>1178.28</c:v>
                </c:pt>
                <c:pt idx="8558">
                  <c:v>794.01599999999996</c:v>
                </c:pt>
                <c:pt idx="8561">
                  <c:v>1428.19</c:v>
                </c:pt>
                <c:pt idx="8563">
                  <c:v>897.26400000000001</c:v>
                </c:pt>
                <c:pt idx="8564">
                  <c:v>1257.77</c:v>
                </c:pt>
                <c:pt idx="8572">
                  <c:v>1808.57</c:v>
                </c:pt>
                <c:pt idx="8574">
                  <c:v>1291.9000000000001</c:v>
                </c:pt>
                <c:pt idx="8575">
                  <c:v>1130.54</c:v>
                </c:pt>
                <c:pt idx="8580">
                  <c:v>617.11199999999997</c:v>
                </c:pt>
                <c:pt idx="8581">
                  <c:v>675.43200000000002</c:v>
                </c:pt>
                <c:pt idx="8586">
                  <c:v>1614.6</c:v>
                </c:pt>
                <c:pt idx="8593">
                  <c:v>912.38400000000001</c:v>
                </c:pt>
                <c:pt idx="8594">
                  <c:v>950.61599999999999</c:v>
                </c:pt>
                <c:pt idx="8595">
                  <c:v>765.72</c:v>
                </c:pt>
                <c:pt idx="8601">
                  <c:v>790.56</c:v>
                </c:pt>
                <c:pt idx="8602">
                  <c:v>1300.97</c:v>
                </c:pt>
                <c:pt idx="8609">
                  <c:v>905.68799999999999</c:v>
                </c:pt>
                <c:pt idx="8612">
                  <c:v>1684.58</c:v>
                </c:pt>
                <c:pt idx="8613">
                  <c:v>1015.42</c:v>
                </c:pt>
                <c:pt idx="8614">
                  <c:v>1476.14</c:v>
                </c:pt>
                <c:pt idx="8620">
                  <c:v>1953.72</c:v>
                </c:pt>
                <c:pt idx="8624">
                  <c:v>931.82399999999996</c:v>
                </c:pt>
                <c:pt idx="8632">
                  <c:v>857.30399999999997</c:v>
                </c:pt>
                <c:pt idx="8633">
                  <c:v>661.17600000000004</c:v>
                </c:pt>
                <c:pt idx="8635">
                  <c:v>430.92</c:v>
                </c:pt>
                <c:pt idx="8640">
                  <c:v>1635.77</c:v>
                </c:pt>
                <c:pt idx="8645">
                  <c:v>662.47199999999998</c:v>
                </c:pt>
                <c:pt idx="8647">
                  <c:v>1705.54</c:v>
                </c:pt>
                <c:pt idx="8651">
                  <c:v>1116.07</c:v>
                </c:pt>
                <c:pt idx="8652">
                  <c:v>1439.42</c:v>
                </c:pt>
                <c:pt idx="8654">
                  <c:v>809.13599999999997</c:v>
                </c:pt>
                <c:pt idx="8655">
                  <c:v>1216.51</c:v>
                </c:pt>
                <c:pt idx="8657">
                  <c:v>1326.24</c:v>
                </c:pt>
                <c:pt idx="8661">
                  <c:v>1355.18</c:v>
                </c:pt>
                <c:pt idx="8662">
                  <c:v>1271.3800000000001</c:v>
                </c:pt>
                <c:pt idx="8666">
                  <c:v>1614.38</c:v>
                </c:pt>
                <c:pt idx="8667">
                  <c:v>1242.22</c:v>
                </c:pt>
                <c:pt idx="8675">
                  <c:v>795.96</c:v>
                </c:pt>
                <c:pt idx="8687">
                  <c:v>1322.14</c:v>
                </c:pt>
                <c:pt idx="8691">
                  <c:v>1785.89</c:v>
                </c:pt>
                <c:pt idx="8692">
                  <c:v>1265.98</c:v>
                </c:pt>
                <c:pt idx="8694">
                  <c:v>1677.24</c:v>
                </c:pt>
                <c:pt idx="8695">
                  <c:v>919.72799999999995</c:v>
                </c:pt>
                <c:pt idx="8701">
                  <c:v>1321.7</c:v>
                </c:pt>
                <c:pt idx="8711">
                  <c:v>614.52</c:v>
                </c:pt>
                <c:pt idx="8716">
                  <c:v>843.048</c:v>
                </c:pt>
                <c:pt idx="8718">
                  <c:v>1271.5899999999999</c:v>
                </c:pt>
                <c:pt idx="8719">
                  <c:v>704.37599999999998</c:v>
                </c:pt>
                <c:pt idx="8721">
                  <c:v>1620.65</c:v>
                </c:pt>
                <c:pt idx="8723">
                  <c:v>974.80799999999999</c:v>
                </c:pt>
                <c:pt idx="8725">
                  <c:v>1234.44</c:v>
                </c:pt>
                <c:pt idx="8726">
                  <c:v>1143.5</c:v>
                </c:pt>
                <c:pt idx="8731">
                  <c:v>824.47199999999998</c:v>
                </c:pt>
                <c:pt idx="8739">
                  <c:v>751.89599999999996</c:v>
                </c:pt>
                <c:pt idx="8743">
                  <c:v>1230.77</c:v>
                </c:pt>
                <c:pt idx="8744">
                  <c:v>858.16800000000001</c:v>
                </c:pt>
                <c:pt idx="8745">
                  <c:v>1091.23</c:v>
                </c:pt>
                <c:pt idx="8747">
                  <c:v>813.67200000000003</c:v>
                </c:pt>
                <c:pt idx="8748">
                  <c:v>1227.0999999999999</c:v>
                </c:pt>
                <c:pt idx="8750">
                  <c:v>862.92</c:v>
                </c:pt>
                <c:pt idx="8751">
                  <c:v>835.92</c:v>
                </c:pt>
                <c:pt idx="8754">
                  <c:v>776.73599999999999</c:v>
                </c:pt>
                <c:pt idx="8763">
                  <c:v>713.44799999999998</c:v>
                </c:pt>
                <c:pt idx="8768">
                  <c:v>1526.69</c:v>
                </c:pt>
                <c:pt idx="8770">
                  <c:v>3070.66</c:v>
                </c:pt>
                <c:pt idx="8774">
                  <c:v>1278.07</c:v>
                </c:pt>
                <c:pt idx="8777">
                  <c:v>1194.9100000000001</c:v>
                </c:pt>
                <c:pt idx="8778">
                  <c:v>1180.01</c:v>
                </c:pt>
                <c:pt idx="8785">
                  <c:v>785.80799999999999</c:v>
                </c:pt>
                <c:pt idx="8787">
                  <c:v>1207.22</c:v>
                </c:pt>
                <c:pt idx="8789">
                  <c:v>1383.7</c:v>
                </c:pt>
                <c:pt idx="8797">
                  <c:v>949.96799999999996</c:v>
                </c:pt>
                <c:pt idx="8799">
                  <c:v>1337.9</c:v>
                </c:pt>
                <c:pt idx="8805">
                  <c:v>1353.89</c:v>
                </c:pt>
                <c:pt idx="8807">
                  <c:v>760.96799999999996</c:v>
                </c:pt>
                <c:pt idx="8815">
                  <c:v>768.52800000000002</c:v>
                </c:pt>
                <c:pt idx="8817">
                  <c:v>824.25599999999997</c:v>
                </c:pt>
                <c:pt idx="8819">
                  <c:v>751.46400000000006</c:v>
                </c:pt>
                <c:pt idx="8828">
                  <c:v>1273.32</c:v>
                </c:pt>
                <c:pt idx="8831">
                  <c:v>863.56799999999998</c:v>
                </c:pt>
                <c:pt idx="8835">
                  <c:v>1748.74</c:v>
                </c:pt>
                <c:pt idx="8836">
                  <c:v>743.47199999999998</c:v>
                </c:pt>
                <c:pt idx="8842">
                  <c:v>739.36800000000005</c:v>
                </c:pt>
                <c:pt idx="8843">
                  <c:v>866.80799999999999</c:v>
                </c:pt>
                <c:pt idx="8846">
                  <c:v>915.84</c:v>
                </c:pt>
                <c:pt idx="8848">
                  <c:v>931.17600000000004</c:v>
                </c:pt>
                <c:pt idx="8850">
                  <c:v>1526.04</c:v>
                </c:pt>
                <c:pt idx="8851">
                  <c:v>370.65600000000001</c:v>
                </c:pt>
                <c:pt idx="8857">
                  <c:v>575.64</c:v>
                </c:pt>
                <c:pt idx="8863">
                  <c:v>1334.88</c:v>
                </c:pt>
                <c:pt idx="8867">
                  <c:v>1524.96</c:v>
                </c:pt>
                <c:pt idx="8868">
                  <c:v>854.28</c:v>
                </c:pt>
                <c:pt idx="8874">
                  <c:v>7495.42</c:v>
                </c:pt>
                <c:pt idx="8888">
                  <c:v>706.75199999999995</c:v>
                </c:pt>
                <c:pt idx="8898">
                  <c:v>1266.8399999999999</c:v>
                </c:pt>
                <c:pt idx="8902">
                  <c:v>1020.38</c:v>
                </c:pt>
                <c:pt idx="8909">
                  <c:v>941.54399999999998</c:v>
                </c:pt>
                <c:pt idx="8911">
                  <c:v>1312.85</c:v>
                </c:pt>
                <c:pt idx="8913">
                  <c:v>986.904</c:v>
                </c:pt>
                <c:pt idx="8916">
                  <c:v>1188.43</c:v>
                </c:pt>
                <c:pt idx="8919">
                  <c:v>1727.57</c:v>
                </c:pt>
                <c:pt idx="8923">
                  <c:v>706.53599999999994</c:v>
                </c:pt>
                <c:pt idx="8926">
                  <c:v>1040.26</c:v>
                </c:pt>
                <c:pt idx="8927">
                  <c:v>897.048</c:v>
                </c:pt>
                <c:pt idx="8929">
                  <c:v>751.03200000000004</c:v>
                </c:pt>
                <c:pt idx="8935">
                  <c:v>1144.1500000000001</c:v>
                </c:pt>
                <c:pt idx="8936">
                  <c:v>673.92</c:v>
                </c:pt>
                <c:pt idx="8939">
                  <c:v>740.23199999999997</c:v>
                </c:pt>
                <c:pt idx="8940">
                  <c:v>1132.27</c:v>
                </c:pt>
                <c:pt idx="8943">
                  <c:v>1246.0999999999999</c:v>
                </c:pt>
                <c:pt idx="8944">
                  <c:v>724.89599999999996</c:v>
                </c:pt>
                <c:pt idx="8946">
                  <c:v>1234.8699999999999</c:v>
                </c:pt>
                <c:pt idx="8949">
                  <c:v>352.72800000000001</c:v>
                </c:pt>
                <c:pt idx="8952">
                  <c:v>829.22400000000005</c:v>
                </c:pt>
                <c:pt idx="8954">
                  <c:v>1181.52</c:v>
                </c:pt>
                <c:pt idx="8959">
                  <c:v>1708.13</c:v>
                </c:pt>
                <c:pt idx="8963">
                  <c:v>594</c:v>
                </c:pt>
                <c:pt idx="8965">
                  <c:v>1259.93</c:v>
                </c:pt>
                <c:pt idx="8968">
                  <c:v>546.48</c:v>
                </c:pt>
                <c:pt idx="8969">
                  <c:v>754.48800000000006</c:v>
                </c:pt>
                <c:pt idx="8970">
                  <c:v>2332.58</c:v>
                </c:pt>
                <c:pt idx="8972">
                  <c:v>1789.56</c:v>
                </c:pt>
                <c:pt idx="8973">
                  <c:v>334.8</c:v>
                </c:pt>
                <c:pt idx="8975">
                  <c:v>1255.18</c:v>
                </c:pt>
                <c:pt idx="8984">
                  <c:v>1267.49</c:v>
                </c:pt>
                <c:pt idx="8997">
                  <c:v>1104.4100000000001</c:v>
                </c:pt>
                <c:pt idx="9001">
                  <c:v>2020.25</c:v>
                </c:pt>
                <c:pt idx="9005">
                  <c:v>1996.7</c:v>
                </c:pt>
                <c:pt idx="9008">
                  <c:v>939.16800000000001</c:v>
                </c:pt>
                <c:pt idx="9010">
                  <c:v>975.024</c:v>
                </c:pt>
                <c:pt idx="9011">
                  <c:v>828.79200000000003</c:v>
                </c:pt>
                <c:pt idx="9012">
                  <c:v>2274.0500000000002</c:v>
                </c:pt>
                <c:pt idx="9014">
                  <c:v>964.87199999999996</c:v>
                </c:pt>
                <c:pt idx="9021">
                  <c:v>999.86400000000003</c:v>
                </c:pt>
                <c:pt idx="9024">
                  <c:v>1629.29</c:v>
                </c:pt>
                <c:pt idx="9031">
                  <c:v>1121.69</c:v>
                </c:pt>
                <c:pt idx="9034">
                  <c:v>1746.36</c:v>
                </c:pt>
                <c:pt idx="9035">
                  <c:v>393.76799999999997</c:v>
                </c:pt>
                <c:pt idx="9039">
                  <c:v>80.784000000000006</c:v>
                </c:pt>
                <c:pt idx="9044">
                  <c:v>873.28800000000001</c:v>
                </c:pt>
                <c:pt idx="9048">
                  <c:v>2206.0100000000002</c:v>
                </c:pt>
                <c:pt idx="9050">
                  <c:v>1730.59</c:v>
                </c:pt>
                <c:pt idx="9052">
                  <c:v>1371.17</c:v>
                </c:pt>
                <c:pt idx="9058">
                  <c:v>877.39200000000005</c:v>
                </c:pt>
                <c:pt idx="9061">
                  <c:v>1820.88</c:v>
                </c:pt>
                <c:pt idx="9063">
                  <c:v>1345.46</c:v>
                </c:pt>
                <c:pt idx="9064">
                  <c:v>894.88800000000003</c:v>
                </c:pt>
                <c:pt idx="9066">
                  <c:v>1940.54</c:v>
                </c:pt>
                <c:pt idx="9070">
                  <c:v>666.36</c:v>
                </c:pt>
                <c:pt idx="9076">
                  <c:v>799.84799999999996</c:v>
                </c:pt>
                <c:pt idx="9077">
                  <c:v>464.4</c:v>
                </c:pt>
                <c:pt idx="9078">
                  <c:v>1127.74</c:v>
                </c:pt>
                <c:pt idx="9081">
                  <c:v>1048.03</c:v>
                </c:pt>
                <c:pt idx="9083">
                  <c:v>1097.5</c:v>
                </c:pt>
                <c:pt idx="9085">
                  <c:v>1623.67</c:v>
                </c:pt>
                <c:pt idx="9088">
                  <c:v>1516.54</c:v>
                </c:pt>
                <c:pt idx="9095">
                  <c:v>742.82399999999996</c:v>
                </c:pt>
                <c:pt idx="9096">
                  <c:v>899.42399999999998</c:v>
                </c:pt>
                <c:pt idx="9097">
                  <c:v>659.66399999999999</c:v>
                </c:pt>
                <c:pt idx="9100">
                  <c:v>979.34400000000005</c:v>
                </c:pt>
                <c:pt idx="9102">
                  <c:v>1591.27</c:v>
                </c:pt>
                <c:pt idx="9103">
                  <c:v>814.53599999999994</c:v>
                </c:pt>
                <c:pt idx="9108">
                  <c:v>949.32</c:v>
                </c:pt>
                <c:pt idx="9111">
                  <c:v>602.20799999999997</c:v>
                </c:pt>
                <c:pt idx="9117">
                  <c:v>2862.65</c:v>
                </c:pt>
                <c:pt idx="9120">
                  <c:v>1215.22</c:v>
                </c:pt>
                <c:pt idx="9128">
                  <c:v>1051.49</c:v>
                </c:pt>
                <c:pt idx="9132">
                  <c:v>1534.25</c:v>
                </c:pt>
                <c:pt idx="9133">
                  <c:v>590.76</c:v>
                </c:pt>
                <c:pt idx="9134">
                  <c:v>2364.77</c:v>
                </c:pt>
                <c:pt idx="9136">
                  <c:v>643.89599999999996</c:v>
                </c:pt>
                <c:pt idx="9137">
                  <c:v>601.12800000000004</c:v>
                </c:pt>
                <c:pt idx="9150">
                  <c:v>1004.62</c:v>
                </c:pt>
                <c:pt idx="9168">
                  <c:v>1145.45</c:v>
                </c:pt>
                <c:pt idx="9173">
                  <c:v>1240.27</c:v>
                </c:pt>
                <c:pt idx="9179">
                  <c:v>1058.83</c:v>
                </c:pt>
                <c:pt idx="9181">
                  <c:v>1276.78</c:v>
                </c:pt>
                <c:pt idx="9185">
                  <c:v>542.59199999999998</c:v>
                </c:pt>
                <c:pt idx="9188">
                  <c:v>807.62400000000002</c:v>
                </c:pt>
                <c:pt idx="9194">
                  <c:v>1357.78</c:v>
                </c:pt>
                <c:pt idx="9195">
                  <c:v>1145.45</c:v>
                </c:pt>
                <c:pt idx="9199">
                  <c:v>1547.86</c:v>
                </c:pt>
                <c:pt idx="9200">
                  <c:v>1537.49</c:v>
                </c:pt>
                <c:pt idx="9204">
                  <c:v>549.93600000000004</c:v>
                </c:pt>
                <c:pt idx="9210">
                  <c:v>1411.13</c:v>
                </c:pt>
                <c:pt idx="9216">
                  <c:v>924.26400000000001</c:v>
                </c:pt>
                <c:pt idx="9222">
                  <c:v>1509.41</c:v>
                </c:pt>
                <c:pt idx="9224">
                  <c:v>842.18399999999997</c:v>
                </c:pt>
                <c:pt idx="9228">
                  <c:v>1360.15</c:v>
                </c:pt>
                <c:pt idx="9230">
                  <c:v>892.72799999999995</c:v>
                </c:pt>
                <c:pt idx="9232">
                  <c:v>1963.22</c:v>
                </c:pt>
                <c:pt idx="9233">
                  <c:v>1954.8</c:v>
                </c:pt>
                <c:pt idx="9234">
                  <c:v>1326.89</c:v>
                </c:pt>
                <c:pt idx="9235">
                  <c:v>1310.69</c:v>
                </c:pt>
                <c:pt idx="9240">
                  <c:v>1177.2</c:v>
                </c:pt>
                <c:pt idx="9242">
                  <c:v>2029.97</c:v>
                </c:pt>
                <c:pt idx="9246">
                  <c:v>986.47199999999998</c:v>
                </c:pt>
                <c:pt idx="9247">
                  <c:v>799.63199999999995</c:v>
                </c:pt>
                <c:pt idx="9252">
                  <c:v>1076.76</c:v>
                </c:pt>
                <c:pt idx="9256">
                  <c:v>632.88</c:v>
                </c:pt>
                <c:pt idx="9265">
                  <c:v>845.20799999999997</c:v>
                </c:pt>
                <c:pt idx="9267">
                  <c:v>1059.9100000000001</c:v>
                </c:pt>
                <c:pt idx="9270">
                  <c:v>1110.24</c:v>
                </c:pt>
                <c:pt idx="9274">
                  <c:v>1622.16</c:v>
                </c:pt>
                <c:pt idx="9276">
                  <c:v>692.06399999999996</c:v>
                </c:pt>
                <c:pt idx="9279">
                  <c:v>1013.47</c:v>
                </c:pt>
                <c:pt idx="9283">
                  <c:v>1083.02</c:v>
                </c:pt>
                <c:pt idx="9284">
                  <c:v>1263.82</c:v>
                </c:pt>
                <c:pt idx="9285">
                  <c:v>990.79200000000003</c:v>
                </c:pt>
                <c:pt idx="9294">
                  <c:v>703.51199999999994</c:v>
                </c:pt>
                <c:pt idx="9296">
                  <c:v>949.75199999999995</c:v>
                </c:pt>
                <c:pt idx="9297">
                  <c:v>728.56799999999998</c:v>
                </c:pt>
                <c:pt idx="9299">
                  <c:v>1290.5999999999999</c:v>
                </c:pt>
                <c:pt idx="9301">
                  <c:v>1194.26</c:v>
                </c:pt>
                <c:pt idx="9309">
                  <c:v>849.096</c:v>
                </c:pt>
                <c:pt idx="9310">
                  <c:v>1856.09</c:v>
                </c:pt>
                <c:pt idx="9314">
                  <c:v>1312.63</c:v>
                </c:pt>
                <c:pt idx="9316">
                  <c:v>644.54399999999998</c:v>
                </c:pt>
                <c:pt idx="9319">
                  <c:v>1341.79</c:v>
                </c:pt>
                <c:pt idx="9321">
                  <c:v>1131.4100000000001</c:v>
                </c:pt>
                <c:pt idx="9323">
                  <c:v>64.367999999999995</c:v>
                </c:pt>
                <c:pt idx="9331">
                  <c:v>638.928</c:v>
                </c:pt>
                <c:pt idx="9332">
                  <c:v>551.01599999999996</c:v>
                </c:pt>
                <c:pt idx="9333">
                  <c:v>994.24800000000005</c:v>
                </c:pt>
                <c:pt idx="9340">
                  <c:v>1999.94</c:v>
                </c:pt>
                <c:pt idx="9343">
                  <c:v>901.8</c:v>
                </c:pt>
                <c:pt idx="9345">
                  <c:v>1219.0999999999999</c:v>
                </c:pt>
                <c:pt idx="9347">
                  <c:v>808.92</c:v>
                </c:pt>
                <c:pt idx="9348">
                  <c:v>1162.08</c:v>
                </c:pt>
                <c:pt idx="9350">
                  <c:v>2021.54</c:v>
                </c:pt>
                <c:pt idx="9351">
                  <c:v>1356.26</c:v>
                </c:pt>
                <c:pt idx="9355">
                  <c:v>941.976</c:v>
                </c:pt>
                <c:pt idx="9358">
                  <c:v>795.96</c:v>
                </c:pt>
                <c:pt idx="9372">
                  <c:v>1356.7</c:v>
                </c:pt>
                <c:pt idx="9373">
                  <c:v>1840.75</c:v>
                </c:pt>
                <c:pt idx="9384">
                  <c:v>607.17600000000004</c:v>
                </c:pt>
                <c:pt idx="9388">
                  <c:v>665.49599999999998</c:v>
                </c:pt>
                <c:pt idx="9390">
                  <c:v>1026.6500000000001</c:v>
                </c:pt>
                <c:pt idx="9392">
                  <c:v>1387.37</c:v>
                </c:pt>
                <c:pt idx="9396">
                  <c:v>915.84</c:v>
                </c:pt>
                <c:pt idx="9397">
                  <c:v>1127.52</c:v>
                </c:pt>
                <c:pt idx="9402">
                  <c:v>846.50400000000002</c:v>
                </c:pt>
                <c:pt idx="9404">
                  <c:v>1038.74</c:v>
                </c:pt>
                <c:pt idx="9409">
                  <c:v>1639.01</c:v>
                </c:pt>
                <c:pt idx="9413">
                  <c:v>159.19200000000001</c:v>
                </c:pt>
                <c:pt idx="9415">
                  <c:v>538.05600000000004</c:v>
                </c:pt>
                <c:pt idx="9416">
                  <c:v>879.76800000000003</c:v>
                </c:pt>
                <c:pt idx="9417">
                  <c:v>1457.35</c:v>
                </c:pt>
                <c:pt idx="9420">
                  <c:v>2726.57</c:v>
                </c:pt>
                <c:pt idx="9422">
                  <c:v>850.17600000000004</c:v>
                </c:pt>
                <c:pt idx="9426">
                  <c:v>1054.94</c:v>
                </c:pt>
                <c:pt idx="9435">
                  <c:v>1301.4000000000001</c:v>
                </c:pt>
                <c:pt idx="9438">
                  <c:v>1526.04</c:v>
                </c:pt>
                <c:pt idx="9441">
                  <c:v>1383.7</c:v>
                </c:pt>
                <c:pt idx="9443">
                  <c:v>999.21600000000001</c:v>
                </c:pt>
                <c:pt idx="9446">
                  <c:v>1194.26</c:v>
                </c:pt>
                <c:pt idx="9454">
                  <c:v>5179.8999999999996</c:v>
                </c:pt>
                <c:pt idx="9459">
                  <c:v>957.96</c:v>
                </c:pt>
                <c:pt idx="9460">
                  <c:v>768.096</c:v>
                </c:pt>
                <c:pt idx="9463">
                  <c:v>1333.37</c:v>
                </c:pt>
                <c:pt idx="9466">
                  <c:v>691.63199999999995</c:v>
                </c:pt>
                <c:pt idx="9467">
                  <c:v>1263.5999999999999</c:v>
                </c:pt>
                <c:pt idx="9469">
                  <c:v>816.26400000000001</c:v>
                </c:pt>
                <c:pt idx="9470">
                  <c:v>986.68799999999999</c:v>
                </c:pt>
                <c:pt idx="9474">
                  <c:v>3021.62</c:v>
                </c:pt>
                <c:pt idx="9476">
                  <c:v>1291.25</c:v>
                </c:pt>
                <c:pt idx="9486">
                  <c:v>882.36</c:v>
                </c:pt>
                <c:pt idx="9490">
                  <c:v>1486.73</c:v>
                </c:pt>
                <c:pt idx="9495">
                  <c:v>813.67200000000003</c:v>
                </c:pt>
                <c:pt idx="9498">
                  <c:v>757.72799999999995</c:v>
                </c:pt>
                <c:pt idx="9509">
                  <c:v>1858.9</c:v>
                </c:pt>
                <c:pt idx="9515">
                  <c:v>1585.22</c:v>
                </c:pt>
                <c:pt idx="9516">
                  <c:v>935.49599999999998</c:v>
                </c:pt>
                <c:pt idx="9517">
                  <c:v>1091.45</c:v>
                </c:pt>
                <c:pt idx="9520">
                  <c:v>1758.46</c:v>
                </c:pt>
                <c:pt idx="9535">
                  <c:v>861.62400000000002</c:v>
                </c:pt>
                <c:pt idx="9538">
                  <c:v>883.00800000000004</c:v>
                </c:pt>
                <c:pt idx="9546">
                  <c:v>498.52800000000002</c:v>
                </c:pt>
                <c:pt idx="9552">
                  <c:v>636.55200000000002</c:v>
                </c:pt>
                <c:pt idx="9554">
                  <c:v>677.59199999999998</c:v>
                </c:pt>
                <c:pt idx="9557">
                  <c:v>1958.47</c:v>
                </c:pt>
                <c:pt idx="9560">
                  <c:v>1163.5899999999999</c:v>
                </c:pt>
                <c:pt idx="9573">
                  <c:v>2503.66</c:v>
                </c:pt>
                <c:pt idx="9578">
                  <c:v>965.08799999999997</c:v>
                </c:pt>
                <c:pt idx="9584">
                  <c:v>976.10400000000004</c:v>
                </c:pt>
                <c:pt idx="9587">
                  <c:v>836.35199999999998</c:v>
                </c:pt>
                <c:pt idx="9588">
                  <c:v>763.99199999999996</c:v>
                </c:pt>
                <c:pt idx="9591">
                  <c:v>847.15200000000004</c:v>
                </c:pt>
                <c:pt idx="9595">
                  <c:v>668.52</c:v>
                </c:pt>
                <c:pt idx="9597">
                  <c:v>1129.9000000000001</c:v>
                </c:pt>
                <c:pt idx="9603">
                  <c:v>1067.47</c:v>
                </c:pt>
                <c:pt idx="9606">
                  <c:v>1811.38</c:v>
                </c:pt>
                <c:pt idx="9610">
                  <c:v>803.30399999999997</c:v>
                </c:pt>
                <c:pt idx="9611">
                  <c:v>528.98400000000004</c:v>
                </c:pt>
                <c:pt idx="9615">
                  <c:v>2121.34</c:v>
                </c:pt>
                <c:pt idx="9619">
                  <c:v>2164.3200000000002</c:v>
                </c:pt>
                <c:pt idx="9620">
                  <c:v>1482.84</c:v>
                </c:pt>
                <c:pt idx="9622">
                  <c:v>447.12</c:v>
                </c:pt>
                <c:pt idx="9624">
                  <c:v>1067.47</c:v>
                </c:pt>
                <c:pt idx="9625">
                  <c:v>1113.7</c:v>
                </c:pt>
                <c:pt idx="9631">
                  <c:v>995.76</c:v>
                </c:pt>
                <c:pt idx="9634">
                  <c:v>1758.67</c:v>
                </c:pt>
                <c:pt idx="9636">
                  <c:v>1504.01</c:v>
                </c:pt>
                <c:pt idx="9637">
                  <c:v>2002.54</c:v>
                </c:pt>
                <c:pt idx="9640">
                  <c:v>1174.82</c:v>
                </c:pt>
                <c:pt idx="9641">
                  <c:v>936.36</c:v>
                </c:pt>
                <c:pt idx="9642">
                  <c:v>181.44</c:v>
                </c:pt>
                <c:pt idx="9643">
                  <c:v>1189.3</c:v>
                </c:pt>
                <c:pt idx="9644">
                  <c:v>750.81600000000003</c:v>
                </c:pt>
                <c:pt idx="9645">
                  <c:v>857.08799999999997</c:v>
                </c:pt>
                <c:pt idx="9646">
                  <c:v>1881.79</c:v>
                </c:pt>
                <c:pt idx="9650">
                  <c:v>831.81600000000003</c:v>
                </c:pt>
                <c:pt idx="9651">
                  <c:v>1705.97</c:v>
                </c:pt>
                <c:pt idx="9653">
                  <c:v>1844.64</c:v>
                </c:pt>
                <c:pt idx="9655">
                  <c:v>817.12800000000004</c:v>
                </c:pt>
                <c:pt idx="9656">
                  <c:v>1848.53</c:v>
                </c:pt>
                <c:pt idx="9661">
                  <c:v>803.08799999999997</c:v>
                </c:pt>
                <c:pt idx="9662">
                  <c:v>4269.8900000000003</c:v>
                </c:pt>
                <c:pt idx="9665">
                  <c:v>1078.92</c:v>
                </c:pt>
                <c:pt idx="9666">
                  <c:v>1388.66</c:v>
                </c:pt>
                <c:pt idx="9668">
                  <c:v>803.52</c:v>
                </c:pt>
                <c:pt idx="9672">
                  <c:v>988.2</c:v>
                </c:pt>
                <c:pt idx="9679">
                  <c:v>833.11199999999997</c:v>
                </c:pt>
                <c:pt idx="9687">
                  <c:v>1737.5</c:v>
                </c:pt>
                <c:pt idx="9688">
                  <c:v>1255.6099999999999</c:v>
                </c:pt>
                <c:pt idx="9690">
                  <c:v>1557.36</c:v>
                </c:pt>
                <c:pt idx="9692">
                  <c:v>2030.18</c:v>
                </c:pt>
                <c:pt idx="9694">
                  <c:v>1907.71</c:v>
                </c:pt>
                <c:pt idx="9696">
                  <c:v>1872.5</c:v>
                </c:pt>
                <c:pt idx="9707">
                  <c:v>2265.41</c:v>
                </c:pt>
                <c:pt idx="9708">
                  <c:v>1271.81</c:v>
                </c:pt>
                <c:pt idx="9710">
                  <c:v>580.39200000000005</c:v>
                </c:pt>
                <c:pt idx="9711">
                  <c:v>1364.9</c:v>
                </c:pt>
                <c:pt idx="9716">
                  <c:v>1450.44</c:v>
                </c:pt>
                <c:pt idx="9720">
                  <c:v>2048.7600000000002</c:v>
                </c:pt>
                <c:pt idx="9728">
                  <c:v>896.83199999999999</c:v>
                </c:pt>
                <c:pt idx="9736">
                  <c:v>758.37599999999998</c:v>
                </c:pt>
                <c:pt idx="9741">
                  <c:v>518.83199999999999</c:v>
                </c:pt>
                <c:pt idx="9745">
                  <c:v>675</c:v>
                </c:pt>
                <c:pt idx="9746">
                  <c:v>977.4</c:v>
                </c:pt>
                <c:pt idx="9747">
                  <c:v>1270.73</c:v>
                </c:pt>
                <c:pt idx="9756">
                  <c:v>1047.17</c:v>
                </c:pt>
                <c:pt idx="9769">
                  <c:v>826.84799999999996</c:v>
                </c:pt>
                <c:pt idx="9774">
                  <c:v>737.64</c:v>
                </c:pt>
                <c:pt idx="9782">
                  <c:v>205.63200000000001</c:v>
                </c:pt>
                <c:pt idx="9790">
                  <c:v>5892.91</c:v>
                </c:pt>
                <c:pt idx="9791">
                  <c:v>1928.66</c:v>
                </c:pt>
                <c:pt idx="9793">
                  <c:v>1038.31</c:v>
                </c:pt>
                <c:pt idx="9795">
                  <c:v>1270.73</c:v>
                </c:pt>
                <c:pt idx="9798">
                  <c:v>527.04</c:v>
                </c:pt>
                <c:pt idx="9800">
                  <c:v>774.14400000000001</c:v>
                </c:pt>
                <c:pt idx="9801">
                  <c:v>880.63199999999995</c:v>
                </c:pt>
                <c:pt idx="9803">
                  <c:v>668.952</c:v>
                </c:pt>
                <c:pt idx="9805">
                  <c:v>1730.16</c:v>
                </c:pt>
                <c:pt idx="9806">
                  <c:v>1278.07</c:v>
                </c:pt>
                <c:pt idx="9809">
                  <c:v>1997.57</c:v>
                </c:pt>
                <c:pt idx="9811">
                  <c:v>1349.14</c:v>
                </c:pt>
                <c:pt idx="9812">
                  <c:v>1070.93</c:v>
                </c:pt>
                <c:pt idx="9821">
                  <c:v>910.65599999999995</c:v>
                </c:pt>
                <c:pt idx="9825">
                  <c:v>1365.55</c:v>
                </c:pt>
                <c:pt idx="9829">
                  <c:v>707.83199999999999</c:v>
                </c:pt>
                <c:pt idx="9830">
                  <c:v>898.77599999999995</c:v>
                </c:pt>
                <c:pt idx="9834">
                  <c:v>604.36800000000005</c:v>
                </c:pt>
                <c:pt idx="9839">
                  <c:v>977.4</c:v>
                </c:pt>
                <c:pt idx="9847">
                  <c:v>1090.58</c:v>
                </c:pt>
                <c:pt idx="9848">
                  <c:v>861.40800000000002</c:v>
                </c:pt>
                <c:pt idx="9850">
                  <c:v>1031.6199999999999</c:v>
                </c:pt>
                <c:pt idx="9856">
                  <c:v>1488.89</c:v>
                </c:pt>
                <c:pt idx="9860">
                  <c:v>385.77600000000001</c:v>
                </c:pt>
                <c:pt idx="9862">
                  <c:v>1149.77</c:v>
                </c:pt>
                <c:pt idx="9863">
                  <c:v>954.28800000000001</c:v>
                </c:pt>
                <c:pt idx="9868">
                  <c:v>1057.75</c:v>
                </c:pt>
                <c:pt idx="9870">
                  <c:v>1241.78</c:v>
                </c:pt>
                <c:pt idx="9871">
                  <c:v>1156.25</c:v>
                </c:pt>
                <c:pt idx="9873">
                  <c:v>3145.18</c:v>
                </c:pt>
                <c:pt idx="9874">
                  <c:v>1024.06</c:v>
                </c:pt>
                <c:pt idx="9876">
                  <c:v>1081.51</c:v>
                </c:pt>
                <c:pt idx="9877">
                  <c:v>746.928</c:v>
                </c:pt>
                <c:pt idx="9883">
                  <c:v>1377.22</c:v>
                </c:pt>
                <c:pt idx="9885">
                  <c:v>1240.92</c:v>
                </c:pt>
                <c:pt idx="9886">
                  <c:v>645.62400000000002</c:v>
                </c:pt>
                <c:pt idx="9887">
                  <c:v>2170.37</c:v>
                </c:pt>
                <c:pt idx="9889">
                  <c:v>1775.3</c:v>
                </c:pt>
                <c:pt idx="9893">
                  <c:v>985.82399999999996</c:v>
                </c:pt>
                <c:pt idx="9898">
                  <c:v>820.15200000000004</c:v>
                </c:pt>
                <c:pt idx="9905">
                  <c:v>1802.95</c:v>
                </c:pt>
                <c:pt idx="9906">
                  <c:v>1196.8599999999999</c:v>
                </c:pt>
                <c:pt idx="9916">
                  <c:v>1656.94</c:v>
                </c:pt>
                <c:pt idx="9918">
                  <c:v>1291.25</c:v>
                </c:pt>
                <c:pt idx="9922">
                  <c:v>2281.39</c:v>
                </c:pt>
                <c:pt idx="9925">
                  <c:v>796.60799999999995</c:v>
                </c:pt>
                <c:pt idx="9926">
                  <c:v>700.70399999999995</c:v>
                </c:pt>
                <c:pt idx="9928">
                  <c:v>688.60799999999995</c:v>
                </c:pt>
                <c:pt idx="9930">
                  <c:v>79.92</c:v>
                </c:pt>
                <c:pt idx="9936">
                  <c:v>800.06399999999996</c:v>
                </c:pt>
                <c:pt idx="9938">
                  <c:v>1138.75</c:v>
                </c:pt>
                <c:pt idx="9947">
                  <c:v>2150.2800000000002</c:v>
                </c:pt>
                <c:pt idx="9950">
                  <c:v>1173.53</c:v>
                </c:pt>
                <c:pt idx="9952">
                  <c:v>755.56799999999998</c:v>
                </c:pt>
                <c:pt idx="9958">
                  <c:v>5098.25</c:v>
                </c:pt>
                <c:pt idx="9963">
                  <c:v>1685.88</c:v>
                </c:pt>
                <c:pt idx="9966">
                  <c:v>2002.75</c:v>
                </c:pt>
                <c:pt idx="9971">
                  <c:v>1062.72</c:v>
                </c:pt>
                <c:pt idx="9973">
                  <c:v>1224.72</c:v>
                </c:pt>
                <c:pt idx="9978">
                  <c:v>967.89599999999996</c:v>
                </c:pt>
                <c:pt idx="9979">
                  <c:v>607.82399999999996</c:v>
                </c:pt>
                <c:pt idx="9984">
                  <c:v>1325.59</c:v>
                </c:pt>
                <c:pt idx="9990">
                  <c:v>1220.6199999999999</c:v>
                </c:pt>
                <c:pt idx="9999">
                  <c:v>802.87199999999996</c:v>
                </c:pt>
                <c:pt idx="10008">
                  <c:v>1440.94</c:v>
                </c:pt>
                <c:pt idx="10019">
                  <c:v>1346.33</c:v>
                </c:pt>
                <c:pt idx="10020">
                  <c:v>3944.59</c:v>
                </c:pt>
                <c:pt idx="10022">
                  <c:v>1104.19</c:v>
                </c:pt>
                <c:pt idx="10023">
                  <c:v>765.72</c:v>
                </c:pt>
                <c:pt idx="10025">
                  <c:v>932.904</c:v>
                </c:pt>
                <c:pt idx="10026">
                  <c:v>1214.78</c:v>
                </c:pt>
                <c:pt idx="10030">
                  <c:v>955.15200000000004</c:v>
                </c:pt>
                <c:pt idx="10037">
                  <c:v>1006.56</c:v>
                </c:pt>
                <c:pt idx="10046">
                  <c:v>1148.47</c:v>
                </c:pt>
                <c:pt idx="10048">
                  <c:v>1581.34</c:v>
                </c:pt>
                <c:pt idx="10052">
                  <c:v>1303.3399999999999</c:v>
                </c:pt>
                <c:pt idx="10053">
                  <c:v>936.79200000000003</c:v>
                </c:pt>
                <c:pt idx="10055">
                  <c:v>2339.9299999999998</c:v>
                </c:pt>
                <c:pt idx="10060">
                  <c:v>908.06399999999996</c:v>
                </c:pt>
                <c:pt idx="10061">
                  <c:v>970.27200000000005</c:v>
                </c:pt>
                <c:pt idx="10062">
                  <c:v>1473.34</c:v>
                </c:pt>
                <c:pt idx="10063">
                  <c:v>1644.62</c:v>
                </c:pt>
                <c:pt idx="10064">
                  <c:v>790.12800000000004</c:v>
                </c:pt>
                <c:pt idx="10067">
                  <c:v>626.18399999999997</c:v>
                </c:pt>
                <c:pt idx="10068">
                  <c:v>1773.36</c:v>
                </c:pt>
                <c:pt idx="10091">
                  <c:v>1209.17</c:v>
                </c:pt>
                <c:pt idx="10095">
                  <c:v>1843.34</c:v>
                </c:pt>
                <c:pt idx="10103">
                  <c:v>1458.65</c:v>
                </c:pt>
                <c:pt idx="10104">
                  <c:v>773.71199999999999</c:v>
                </c:pt>
                <c:pt idx="10108">
                  <c:v>976.10400000000004</c:v>
                </c:pt>
                <c:pt idx="10113">
                  <c:v>1488.02</c:v>
                </c:pt>
                <c:pt idx="10114">
                  <c:v>1007.42</c:v>
                </c:pt>
                <c:pt idx="10117">
                  <c:v>940.46400000000006</c:v>
                </c:pt>
                <c:pt idx="10123">
                  <c:v>1520.64</c:v>
                </c:pt>
                <c:pt idx="10125">
                  <c:v>624.24</c:v>
                </c:pt>
                <c:pt idx="10128">
                  <c:v>792.72</c:v>
                </c:pt>
                <c:pt idx="10135">
                  <c:v>1428.19</c:v>
                </c:pt>
                <c:pt idx="10136">
                  <c:v>1610.06</c:v>
                </c:pt>
                <c:pt idx="10139">
                  <c:v>1468.15</c:v>
                </c:pt>
                <c:pt idx="10145">
                  <c:v>1617.41</c:v>
                </c:pt>
                <c:pt idx="10147">
                  <c:v>1396.01</c:v>
                </c:pt>
                <c:pt idx="10150">
                  <c:v>892.29600000000005</c:v>
                </c:pt>
                <c:pt idx="10155">
                  <c:v>1577.45</c:v>
                </c:pt>
                <c:pt idx="10158">
                  <c:v>715.82399999999996</c:v>
                </c:pt>
                <c:pt idx="10160">
                  <c:v>764.20799999999997</c:v>
                </c:pt>
                <c:pt idx="10161">
                  <c:v>5283.14</c:v>
                </c:pt>
                <c:pt idx="10163">
                  <c:v>1353.89</c:v>
                </c:pt>
                <c:pt idx="10165">
                  <c:v>991.87199999999996</c:v>
                </c:pt>
                <c:pt idx="10168">
                  <c:v>135.43199999999999</c:v>
                </c:pt>
                <c:pt idx="10169">
                  <c:v>1626.05</c:v>
                </c:pt>
                <c:pt idx="10171">
                  <c:v>992.52</c:v>
                </c:pt>
                <c:pt idx="10175">
                  <c:v>1647.86</c:v>
                </c:pt>
                <c:pt idx="10176">
                  <c:v>1913.54</c:v>
                </c:pt>
                <c:pt idx="10179">
                  <c:v>937.87199999999996</c:v>
                </c:pt>
                <c:pt idx="10180">
                  <c:v>2103.19</c:v>
                </c:pt>
                <c:pt idx="10184">
                  <c:v>1951.13</c:v>
                </c:pt>
                <c:pt idx="10192">
                  <c:v>1126.01</c:v>
                </c:pt>
                <c:pt idx="10198">
                  <c:v>2608.85</c:v>
                </c:pt>
                <c:pt idx="10202">
                  <c:v>1703.16</c:v>
                </c:pt>
                <c:pt idx="10204">
                  <c:v>902.01599999999996</c:v>
                </c:pt>
                <c:pt idx="10211">
                  <c:v>1206.1400000000001</c:v>
                </c:pt>
                <c:pt idx="10217">
                  <c:v>1106.3499999999999</c:v>
                </c:pt>
                <c:pt idx="10221">
                  <c:v>1566.65</c:v>
                </c:pt>
                <c:pt idx="10222">
                  <c:v>1507.9</c:v>
                </c:pt>
                <c:pt idx="10226">
                  <c:v>1250.8599999999999</c:v>
                </c:pt>
                <c:pt idx="10229">
                  <c:v>445.608</c:v>
                </c:pt>
                <c:pt idx="10232">
                  <c:v>1554.55</c:v>
                </c:pt>
                <c:pt idx="10234">
                  <c:v>971.35199999999998</c:v>
                </c:pt>
                <c:pt idx="10239">
                  <c:v>668.73599999999999</c:v>
                </c:pt>
                <c:pt idx="10248">
                  <c:v>1481.33</c:v>
                </c:pt>
                <c:pt idx="10250">
                  <c:v>1314.58</c:v>
                </c:pt>
                <c:pt idx="10255">
                  <c:v>2264.98</c:v>
                </c:pt>
                <c:pt idx="10258">
                  <c:v>1870.56</c:v>
                </c:pt>
                <c:pt idx="10266">
                  <c:v>2233.44</c:v>
                </c:pt>
                <c:pt idx="10267">
                  <c:v>710.64</c:v>
                </c:pt>
                <c:pt idx="10271">
                  <c:v>2332.58</c:v>
                </c:pt>
                <c:pt idx="10274">
                  <c:v>848.23199999999997</c:v>
                </c:pt>
                <c:pt idx="10298">
                  <c:v>938.08799999999997</c:v>
                </c:pt>
                <c:pt idx="10299">
                  <c:v>1157.54</c:v>
                </c:pt>
                <c:pt idx="10309">
                  <c:v>810.64800000000002</c:v>
                </c:pt>
                <c:pt idx="10310">
                  <c:v>744.33600000000001</c:v>
                </c:pt>
                <c:pt idx="10314">
                  <c:v>5188.54</c:v>
                </c:pt>
                <c:pt idx="10319">
                  <c:v>9211.32</c:v>
                </c:pt>
                <c:pt idx="10324">
                  <c:v>729.86400000000003</c:v>
                </c:pt>
                <c:pt idx="10328">
                  <c:v>1747.01</c:v>
                </c:pt>
                <c:pt idx="10329">
                  <c:v>1809</c:v>
                </c:pt>
                <c:pt idx="10330">
                  <c:v>1831.68</c:v>
                </c:pt>
                <c:pt idx="10331">
                  <c:v>1975.54</c:v>
                </c:pt>
                <c:pt idx="10332">
                  <c:v>1428.41</c:v>
                </c:pt>
                <c:pt idx="10336">
                  <c:v>548.64</c:v>
                </c:pt>
                <c:pt idx="10342">
                  <c:v>1047.5999999999999</c:v>
                </c:pt>
                <c:pt idx="10344">
                  <c:v>1518.48</c:v>
                </c:pt>
                <c:pt idx="10348">
                  <c:v>1251.72</c:v>
                </c:pt>
                <c:pt idx="10349">
                  <c:v>2685.96</c:v>
                </c:pt>
                <c:pt idx="10354">
                  <c:v>1402.92</c:v>
                </c:pt>
                <c:pt idx="10355">
                  <c:v>1050.8399999999999</c:v>
                </c:pt>
                <c:pt idx="10359">
                  <c:v>814.75199999999995</c:v>
                </c:pt>
                <c:pt idx="10365">
                  <c:v>2773.22</c:v>
                </c:pt>
                <c:pt idx="10366">
                  <c:v>711.50400000000002</c:v>
                </c:pt>
                <c:pt idx="10373">
                  <c:v>632.01599999999996</c:v>
                </c:pt>
                <c:pt idx="10379">
                  <c:v>106.70399999999999</c:v>
                </c:pt>
                <c:pt idx="10380">
                  <c:v>997.48800000000006</c:v>
                </c:pt>
                <c:pt idx="10384">
                  <c:v>603.28800000000001</c:v>
                </c:pt>
                <c:pt idx="10390">
                  <c:v>417.096</c:v>
                </c:pt>
                <c:pt idx="10392">
                  <c:v>905.68799999999999</c:v>
                </c:pt>
                <c:pt idx="10393">
                  <c:v>728.56799999999998</c:v>
                </c:pt>
                <c:pt idx="10394">
                  <c:v>1874.66</c:v>
                </c:pt>
                <c:pt idx="10395">
                  <c:v>1170.94</c:v>
                </c:pt>
                <c:pt idx="10396">
                  <c:v>1702.94</c:v>
                </c:pt>
                <c:pt idx="10399">
                  <c:v>1660.39</c:v>
                </c:pt>
                <c:pt idx="10400">
                  <c:v>1702.94</c:v>
                </c:pt>
                <c:pt idx="10401">
                  <c:v>1217.5899999999999</c:v>
                </c:pt>
                <c:pt idx="10402">
                  <c:v>1681.56</c:v>
                </c:pt>
                <c:pt idx="10409">
                  <c:v>1830.17</c:v>
                </c:pt>
                <c:pt idx="10411">
                  <c:v>1829.95</c:v>
                </c:pt>
                <c:pt idx="10417">
                  <c:v>553.17600000000004</c:v>
                </c:pt>
                <c:pt idx="10423">
                  <c:v>1237.46</c:v>
                </c:pt>
                <c:pt idx="10424">
                  <c:v>1558.87</c:v>
                </c:pt>
                <c:pt idx="10426">
                  <c:v>606.31200000000001</c:v>
                </c:pt>
                <c:pt idx="10431">
                  <c:v>831.6</c:v>
                </c:pt>
                <c:pt idx="10440">
                  <c:v>2155.25</c:v>
                </c:pt>
                <c:pt idx="10444">
                  <c:v>2250.0700000000002</c:v>
                </c:pt>
                <c:pt idx="10452">
                  <c:v>1871.64</c:v>
                </c:pt>
                <c:pt idx="10463">
                  <c:v>1234.6600000000001</c:v>
                </c:pt>
                <c:pt idx="10465">
                  <c:v>2435.4</c:v>
                </c:pt>
                <c:pt idx="10468">
                  <c:v>1248.7</c:v>
                </c:pt>
                <c:pt idx="10473">
                  <c:v>1105.7</c:v>
                </c:pt>
                <c:pt idx="10475">
                  <c:v>1046.52</c:v>
                </c:pt>
                <c:pt idx="10477">
                  <c:v>672.40800000000002</c:v>
                </c:pt>
                <c:pt idx="10490">
                  <c:v>915.62400000000002</c:v>
                </c:pt>
                <c:pt idx="10492">
                  <c:v>909.14400000000001</c:v>
                </c:pt>
                <c:pt idx="10493">
                  <c:v>1235.0899999999999</c:v>
                </c:pt>
                <c:pt idx="10495">
                  <c:v>1613.3</c:v>
                </c:pt>
                <c:pt idx="10496">
                  <c:v>1785.24</c:v>
                </c:pt>
                <c:pt idx="10498">
                  <c:v>1239.8399999999999</c:v>
                </c:pt>
                <c:pt idx="10499">
                  <c:v>809.78399999999999</c:v>
                </c:pt>
                <c:pt idx="10503">
                  <c:v>1313.28</c:v>
                </c:pt>
                <c:pt idx="10510">
                  <c:v>1180.6600000000001</c:v>
                </c:pt>
                <c:pt idx="10521">
                  <c:v>635.904</c:v>
                </c:pt>
                <c:pt idx="10523">
                  <c:v>1237.9000000000001</c:v>
                </c:pt>
                <c:pt idx="10524">
                  <c:v>2537.7800000000002</c:v>
                </c:pt>
                <c:pt idx="10532">
                  <c:v>1074.17</c:v>
                </c:pt>
                <c:pt idx="10534">
                  <c:v>2468.88</c:v>
                </c:pt>
                <c:pt idx="10535">
                  <c:v>964.22400000000005</c:v>
                </c:pt>
                <c:pt idx="10536">
                  <c:v>1442.23</c:v>
                </c:pt>
                <c:pt idx="10541">
                  <c:v>644.11199999999997</c:v>
                </c:pt>
                <c:pt idx="10545">
                  <c:v>792.072</c:v>
                </c:pt>
                <c:pt idx="10551">
                  <c:v>829.00800000000004</c:v>
                </c:pt>
                <c:pt idx="10553">
                  <c:v>1340.28</c:v>
                </c:pt>
                <c:pt idx="10555">
                  <c:v>1152.79</c:v>
                </c:pt>
                <c:pt idx="10559">
                  <c:v>1958.26</c:v>
                </c:pt>
                <c:pt idx="10567">
                  <c:v>968.11199999999997</c:v>
                </c:pt>
                <c:pt idx="10571">
                  <c:v>691.2</c:v>
                </c:pt>
                <c:pt idx="10578">
                  <c:v>768.52800000000002</c:v>
                </c:pt>
                <c:pt idx="10587">
                  <c:v>1009.37</c:v>
                </c:pt>
                <c:pt idx="10590">
                  <c:v>900.072</c:v>
                </c:pt>
                <c:pt idx="10591">
                  <c:v>2341.0100000000002</c:v>
                </c:pt>
                <c:pt idx="10594">
                  <c:v>671.54399999999998</c:v>
                </c:pt>
                <c:pt idx="10601">
                  <c:v>701.56799999999998</c:v>
                </c:pt>
                <c:pt idx="10602">
                  <c:v>1218.67</c:v>
                </c:pt>
                <c:pt idx="10603">
                  <c:v>2154.8200000000002</c:v>
                </c:pt>
                <c:pt idx="10610">
                  <c:v>510.40800000000002</c:v>
                </c:pt>
                <c:pt idx="10611">
                  <c:v>1511.14</c:v>
                </c:pt>
                <c:pt idx="10625">
                  <c:v>958.17600000000004</c:v>
                </c:pt>
                <c:pt idx="10632">
                  <c:v>964.22400000000005</c:v>
                </c:pt>
                <c:pt idx="10641">
                  <c:v>1534.9</c:v>
                </c:pt>
                <c:pt idx="10642">
                  <c:v>2345.7600000000002</c:v>
                </c:pt>
                <c:pt idx="10643">
                  <c:v>2621.59</c:v>
                </c:pt>
                <c:pt idx="10646">
                  <c:v>1085.83</c:v>
                </c:pt>
                <c:pt idx="10648">
                  <c:v>1854.58</c:v>
                </c:pt>
                <c:pt idx="10649">
                  <c:v>1115.6400000000001</c:v>
                </c:pt>
                <c:pt idx="10653">
                  <c:v>1109.5899999999999</c:v>
                </c:pt>
                <c:pt idx="10659">
                  <c:v>6262.7</c:v>
                </c:pt>
                <c:pt idx="10665">
                  <c:v>1987.2</c:v>
                </c:pt>
                <c:pt idx="10668">
                  <c:v>2158.92</c:v>
                </c:pt>
                <c:pt idx="10670">
                  <c:v>748.65599999999995</c:v>
                </c:pt>
                <c:pt idx="10677">
                  <c:v>1109.81</c:v>
                </c:pt>
                <c:pt idx="10679">
                  <c:v>3033.72</c:v>
                </c:pt>
                <c:pt idx="10680">
                  <c:v>1422.14</c:v>
                </c:pt>
                <c:pt idx="10683">
                  <c:v>1642.9</c:v>
                </c:pt>
                <c:pt idx="10684">
                  <c:v>1210.68</c:v>
                </c:pt>
                <c:pt idx="10687">
                  <c:v>808.27200000000005</c:v>
                </c:pt>
                <c:pt idx="10698">
                  <c:v>676.94399999999996</c:v>
                </c:pt>
                <c:pt idx="10704">
                  <c:v>2752.27</c:v>
                </c:pt>
                <c:pt idx="10709">
                  <c:v>1350.65</c:v>
                </c:pt>
                <c:pt idx="10711">
                  <c:v>1727.14</c:v>
                </c:pt>
                <c:pt idx="10714">
                  <c:v>883.44</c:v>
                </c:pt>
                <c:pt idx="10719">
                  <c:v>1159.49</c:v>
                </c:pt>
                <c:pt idx="10722">
                  <c:v>1216.3</c:v>
                </c:pt>
                <c:pt idx="10724">
                  <c:v>1502.28</c:v>
                </c:pt>
                <c:pt idx="10734">
                  <c:v>1454.98</c:v>
                </c:pt>
                <c:pt idx="10736">
                  <c:v>439.77600000000001</c:v>
                </c:pt>
                <c:pt idx="10737">
                  <c:v>1067.47</c:v>
                </c:pt>
                <c:pt idx="10738">
                  <c:v>1595.16</c:v>
                </c:pt>
                <c:pt idx="10742">
                  <c:v>1588.25</c:v>
                </c:pt>
                <c:pt idx="10746">
                  <c:v>1850.9</c:v>
                </c:pt>
                <c:pt idx="10765">
                  <c:v>1726.27</c:v>
                </c:pt>
                <c:pt idx="10767">
                  <c:v>862.05600000000004</c:v>
                </c:pt>
                <c:pt idx="10769">
                  <c:v>1340.5</c:v>
                </c:pt>
                <c:pt idx="10770">
                  <c:v>1667.52</c:v>
                </c:pt>
                <c:pt idx="10773">
                  <c:v>2074.25</c:v>
                </c:pt>
                <c:pt idx="10790">
                  <c:v>1753.49</c:v>
                </c:pt>
                <c:pt idx="10791">
                  <c:v>1911.6</c:v>
                </c:pt>
                <c:pt idx="10792">
                  <c:v>1102.03</c:v>
                </c:pt>
                <c:pt idx="10793">
                  <c:v>1885.03</c:v>
                </c:pt>
                <c:pt idx="10795">
                  <c:v>979.99199999999996</c:v>
                </c:pt>
                <c:pt idx="10807">
                  <c:v>1156.9000000000001</c:v>
                </c:pt>
                <c:pt idx="10809">
                  <c:v>1720.22</c:v>
                </c:pt>
                <c:pt idx="10813">
                  <c:v>904.39200000000005</c:v>
                </c:pt>
                <c:pt idx="10814">
                  <c:v>1214.78</c:v>
                </c:pt>
                <c:pt idx="10818">
                  <c:v>1247.18</c:v>
                </c:pt>
                <c:pt idx="10826">
                  <c:v>1756.94</c:v>
                </c:pt>
                <c:pt idx="10828">
                  <c:v>719.49599999999998</c:v>
                </c:pt>
                <c:pt idx="10829">
                  <c:v>1488.24</c:v>
                </c:pt>
                <c:pt idx="10831">
                  <c:v>836.35199999999998</c:v>
                </c:pt>
                <c:pt idx="10836">
                  <c:v>1185.19</c:v>
                </c:pt>
                <c:pt idx="10837">
                  <c:v>1434.24</c:v>
                </c:pt>
                <c:pt idx="10844">
                  <c:v>2026.3</c:v>
                </c:pt>
                <c:pt idx="10845">
                  <c:v>1171.8</c:v>
                </c:pt>
                <c:pt idx="10849">
                  <c:v>1902.31</c:v>
                </c:pt>
                <c:pt idx="10852">
                  <c:v>1201.3900000000001</c:v>
                </c:pt>
                <c:pt idx="10855">
                  <c:v>1914.41</c:v>
                </c:pt>
                <c:pt idx="10866">
                  <c:v>1100.74</c:v>
                </c:pt>
                <c:pt idx="10869">
                  <c:v>652.96799999999996</c:v>
                </c:pt>
                <c:pt idx="10870">
                  <c:v>866.37599999999998</c:v>
                </c:pt>
                <c:pt idx="10873">
                  <c:v>5806.51</c:v>
                </c:pt>
                <c:pt idx="10874">
                  <c:v>797.904</c:v>
                </c:pt>
                <c:pt idx="10876">
                  <c:v>536.76</c:v>
                </c:pt>
                <c:pt idx="10881">
                  <c:v>1508.54</c:v>
                </c:pt>
                <c:pt idx="10887">
                  <c:v>644.76</c:v>
                </c:pt>
                <c:pt idx="10890">
                  <c:v>1818.72</c:v>
                </c:pt>
                <c:pt idx="10893">
                  <c:v>2598.91</c:v>
                </c:pt>
                <c:pt idx="10896">
                  <c:v>810.64800000000002</c:v>
                </c:pt>
                <c:pt idx="10904">
                  <c:v>1100.0899999999999</c:v>
                </c:pt>
                <c:pt idx="10908">
                  <c:v>1356.05</c:v>
                </c:pt>
                <c:pt idx="10917">
                  <c:v>1308.74</c:v>
                </c:pt>
                <c:pt idx="10926">
                  <c:v>1834.7</c:v>
                </c:pt>
                <c:pt idx="10931">
                  <c:v>870.69600000000003</c:v>
                </c:pt>
                <c:pt idx="10943">
                  <c:v>1243.51</c:v>
                </c:pt>
                <c:pt idx="10947">
                  <c:v>786.24</c:v>
                </c:pt>
                <c:pt idx="10950">
                  <c:v>650.16</c:v>
                </c:pt>
                <c:pt idx="10951">
                  <c:v>2073.17</c:v>
                </c:pt>
                <c:pt idx="10953">
                  <c:v>1705.75</c:v>
                </c:pt>
                <c:pt idx="10963">
                  <c:v>1195.78</c:v>
                </c:pt>
                <c:pt idx="10967">
                  <c:v>1210.9000000000001</c:v>
                </c:pt>
                <c:pt idx="10976">
                  <c:v>2301.91</c:v>
                </c:pt>
                <c:pt idx="10979">
                  <c:v>1301.6199999999999</c:v>
                </c:pt>
                <c:pt idx="10983">
                  <c:v>1029.8900000000001</c:v>
                </c:pt>
                <c:pt idx="10988">
                  <c:v>2516.83</c:v>
                </c:pt>
                <c:pt idx="10989">
                  <c:v>1368.58</c:v>
                </c:pt>
                <c:pt idx="10999">
                  <c:v>1171.58</c:v>
                </c:pt>
                <c:pt idx="11004">
                  <c:v>1433.81</c:v>
                </c:pt>
                <c:pt idx="11005">
                  <c:v>824.68799999999999</c:v>
                </c:pt>
                <c:pt idx="11006">
                  <c:v>1823.9</c:v>
                </c:pt>
                <c:pt idx="11017">
                  <c:v>1677.24</c:v>
                </c:pt>
                <c:pt idx="11020">
                  <c:v>689.68799999999999</c:v>
                </c:pt>
                <c:pt idx="11021">
                  <c:v>453.38400000000001</c:v>
                </c:pt>
                <c:pt idx="11025">
                  <c:v>1418.9</c:v>
                </c:pt>
                <c:pt idx="11031">
                  <c:v>3252.31</c:v>
                </c:pt>
                <c:pt idx="11034">
                  <c:v>1339.85</c:v>
                </c:pt>
                <c:pt idx="11036">
                  <c:v>1509.41</c:v>
                </c:pt>
                <c:pt idx="11037">
                  <c:v>1261.6600000000001</c:v>
                </c:pt>
                <c:pt idx="11042">
                  <c:v>859.46400000000006</c:v>
                </c:pt>
                <c:pt idx="11046">
                  <c:v>884.952</c:v>
                </c:pt>
                <c:pt idx="11047">
                  <c:v>2194.7800000000002</c:v>
                </c:pt>
                <c:pt idx="11056">
                  <c:v>996.40800000000002</c:v>
                </c:pt>
                <c:pt idx="11058">
                  <c:v>567.43200000000002</c:v>
                </c:pt>
                <c:pt idx="11062">
                  <c:v>803.73599999999999</c:v>
                </c:pt>
                <c:pt idx="11064">
                  <c:v>1578.96</c:v>
                </c:pt>
                <c:pt idx="11066">
                  <c:v>1253.02</c:v>
                </c:pt>
                <c:pt idx="11071">
                  <c:v>29785.1</c:v>
                </c:pt>
                <c:pt idx="11084">
                  <c:v>916.70399999999995</c:v>
                </c:pt>
                <c:pt idx="11087">
                  <c:v>179.71199999999999</c:v>
                </c:pt>
                <c:pt idx="11092">
                  <c:v>1454.54</c:v>
                </c:pt>
                <c:pt idx="11096">
                  <c:v>601.12800000000004</c:v>
                </c:pt>
                <c:pt idx="11102">
                  <c:v>957.31200000000001</c:v>
                </c:pt>
                <c:pt idx="11105">
                  <c:v>1468.37</c:v>
                </c:pt>
                <c:pt idx="11106">
                  <c:v>1228.18</c:v>
                </c:pt>
                <c:pt idx="11108">
                  <c:v>2015.93</c:v>
                </c:pt>
                <c:pt idx="11116">
                  <c:v>1930.61</c:v>
                </c:pt>
                <c:pt idx="11117">
                  <c:v>781.92</c:v>
                </c:pt>
                <c:pt idx="11119">
                  <c:v>818.85599999999999</c:v>
                </c:pt>
                <c:pt idx="11125">
                  <c:v>735.91200000000003</c:v>
                </c:pt>
                <c:pt idx="11126">
                  <c:v>1359.94</c:v>
                </c:pt>
                <c:pt idx="11131">
                  <c:v>1653.26</c:v>
                </c:pt>
                <c:pt idx="11132">
                  <c:v>1231.42</c:v>
                </c:pt>
                <c:pt idx="11135">
                  <c:v>778.89599999999996</c:v>
                </c:pt>
                <c:pt idx="11141">
                  <c:v>1361.88</c:v>
                </c:pt>
                <c:pt idx="11143">
                  <c:v>1175.47</c:v>
                </c:pt>
                <c:pt idx="11144">
                  <c:v>1114.1300000000001</c:v>
                </c:pt>
                <c:pt idx="11149">
                  <c:v>1829.3</c:v>
                </c:pt>
                <c:pt idx="11155">
                  <c:v>1327.75</c:v>
                </c:pt>
                <c:pt idx="11158">
                  <c:v>2022.84</c:v>
                </c:pt>
                <c:pt idx="11161">
                  <c:v>830.08799999999997</c:v>
                </c:pt>
                <c:pt idx="11168">
                  <c:v>1205.28</c:v>
                </c:pt>
                <c:pt idx="11179">
                  <c:v>771.76800000000003</c:v>
                </c:pt>
                <c:pt idx="11183">
                  <c:v>6220.15</c:v>
                </c:pt>
                <c:pt idx="11187">
                  <c:v>2343.38</c:v>
                </c:pt>
                <c:pt idx="11189">
                  <c:v>3327.91</c:v>
                </c:pt>
                <c:pt idx="11199">
                  <c:v>1060.1300000000001</c:v>
                </c:pt>
                <c:pt idx="11207">
                  <c:v>1111.97</c:v>
                </c:pt>
                <c:pt idx="11215">
                  <c:v>2358.29</c:v>
                </c:pt>
                <c:pt idx="11216">
                  <c:v>10581.8</c:v>
                </c:pt>
                <c:pt idx="11227">
                  <c:v>965.73599999999999</c:v>
                </c:pt>
                <c:pt idx="11229">
                  <c:v>2072.9499999999998</c:v>
                </c:pt>
                <c:pt idx="11234">
                  <c:v>2290.25</c:v>
                </c:pt>
                <c:pt idx="11236">
                  <c:v>1917.22</c:v>
                </c:pt>
                <c:pt idx="11241">
                  <c:v>88263.9</c:v>
                </c:pt>
                <c:pt idx="11251">
                  <c:v>1133.3499999999999</c:v>
                </c:pt>
                <c:pt idx="11252">
                  <c:v>1407.67</c:v>
                </c:pt>
                <c:pt idx="11255">
                  <c:v>1988.71</c:v>
                </c:pt>
                <c:pt idx="11259">
                  <c:v>1372.25</c:v>
                </c:pt>
                <c:pt idx="11260">
                  <c:v>1828.87</c:v>
                </c:pt>
                <c:pt idx="11264">
                  <c:v>2070.36</c:v>
                </c:pt>
                <c:pt idx="11269">
                  <c:v>1950.26</c:v>
                </c:pt>
                <c:pt idx="11270">
                  <c:v>1267.49</c:v>
                </c:pt>
                <c:pt idx="11271">
                  <c:v>1252.58</c:v>
                </c:pt>
                <c:pt idx="11275">
                  <c:v>2155.25</c:v>
                </c:pt>
                <c:pt idx="11286">
                  <c:v>2114.86</c:v>
                </c:pt>
                <c:pt idx="11290">
                  <c:v>1552.61</c:v>
                </c:pt>
                <c:pt idx="11291">
                  <c:v>598.96799999999996</c:v>
                </c:pt>
                <c:pt idx="11295">
                  <c:v>965.952</c:v>
                </c:pt>
                <c:pt idx="11296">
                  <c:v>2071.44</c:v>
                </c:pt>
                <c:pt idx="11302">
                  <c:v>1393.63</c:v>
                </c:pt>
                <c:pt idx="11304">
                  <c:v>2733.91</c:v>
                </c:pt>
                <c:pt idx="11309">
                  <c:v>1149.55</c:v>
                </c:pt>
                <c:pt idx="11312">
                  <c:v>1418.9</c:v>
                </c:pt>
                <c:pt idx="11315">
                  <c:v>918</c:v>
                </c:pt>
                <c:pt idx="11324">
                  <c:v>1145.02</c:v>
                </c:pt>
                <c:pt idx="11338">
                  <c:v>996.19200000000001</c:v>
                </c:pt>
                <c:pt idx="11340">
                  <c:v>1546.34</c:v>
                </c:pt>
                <c:pt idx="11343">
                  <c:v>368.06400000000002</c:v>
                </c:pt>
                <c:pt idx="11346">
                  <c:v>3123.36</c:v>
                </c:pt>
                <c:pt idx="11347">
                  <c:v>877.60799999999995</c:v>
                </c:pt>
                <c:pt idx="11350">
                  <c:v>1421.71</c:v>
                </c:pt>
                <c:pt idx="11355">
                  <c:v>1549.37</c:v>
                </c:pt>
                <c:pt idx="11358">
                  <c:v>1700.14</c:v>
                </c:pt>
                <c:pt idx="11361">
                  <c:v>1187.78</c:v>
                </c:pt>
                <c:pt idx="11362">
                  <c:v>704.80799999999999</c:v>
                </c:pt>
                <c:pt idx="11363">
                  <c:v>1462.32</c:v>
                </c:pt>
                <c:pt idx="11364">
                  <c:v>1686.96</c:v>
                </c:pt>
                <c:pt idx="11365">
                  <c:v>5949.07</c:v>
                </c:pt>
                <c:pt idx="11386">
                  <c:v>1213.7</c:v>
                </c:pt>
                <c:pt idx="11387">
                  <c:v>1150.8499999999999</c:v>
                </c:pt>
                <c:pt idx="11395">
                  <c:v>865.72799999999995</c:v>
                </c:pt>
                <c:pt idx="11399">
                  <c:v>1094.69</c:v>
                </c:pt>
                <c:pt idx="11430">
                  <c:v>1666.66</c:v>
                </c:pt>
                <c:pt idx="11433">
                  <c:v>1395.14</c:v>
                </c:pt>
                <c:pt idx="11435">
                  <c:v>2423.09</c:v>
                </c:pt>
                <c:pt idx="11448">
                  <c:v>1501.42</c:v>
                </c:pt>
                <c:pt idx="11452">
                  <c:v>1890</c:v>
                </c:pt>
                <c:pt idx="11455">
                  <c:v>1211.1099999999999</c:v>
                </c:pt>
                <c:pt idx="11460">
                  <c:v>3464.86</c:v>
                </c:pt>
                <c:pt idx="11465">
                  <c:v>1534.25</c:v>
                </c:pt>
                <c:pt idx="11468">
                  <c:v>1696.9</c:v>
                </c:pt>
                <c:pt idx="11470">
                  <c:v>1133.3499999999999</c:v>
                </c:pt>
                <c:pt idx="11472">
                  <c:v>1380.02</c:v>
                </c:pt>
                <c:pt idx="11484">
                  <c:v>835.92</c:v>
                </c:pt>
                <c:pt idx="11490">
                  <c:v>2619.4299999999998</c:v>
                </c:pt>
                <c:pt idx="11494">
                  <c:v>2626.56</c:v>
                </c:pt>
                <c:pt idx="11495">
                  <c:v>776.52</c:v>
                </c:pt>
                <c:pt idx="11511">
                  <c:v>1794.74</c:v>
                </c:pt>
                <c:pt idx="11514">
                  <c:v>1123.42</c:v>
                </c:pt>
                <c:pt idx="11520">
                  <c:v>1063.58</c:v>
                </c:pt>
                <c:pt idx="11521">
                  <c:v>2153.3000000000002</c:v>
                </c:pt>
                <c:pt idx="11522">
                  <c:v>1579.61</c:v>
                </c:pt>
                <c:pt idx="11527">
                  <c:v>1454.33</c:v>
                </c:pt>
                <c:pt idx="11529">
                  <c:v>1842.7</c:v>
                </c:pt>
                <c:pt idx="11530">
                  <c:v>1853.93</c:v>
                </c:pt>
                <c:pt idx="11531">
                  <c:v>1294.06</c:v>
                </c:pt>
                <c:pt idx="11532">
                  <c:v>2957.26</c:v>
                </c:pt>
                <c:pt idx="11541">
                  <c:v>892.08</c:v>
                </c:pt>
                <c:pt idx="11542">
                  <c:v>205.2</c:v>
                </c:pt>
                <c:pt idx="11544">
                  <c:v>2638.66</c:v>
                </c:pt>
                <c:pt idx="11545">
                  <c:v>898.34400000000005</c:v>
                </c:pt>
                <c:pt idx="11559">
                  <c:v>1587.82</c:v>
                </c:pt>
                <c:pt idx="11562">
                  <c:v>1467.94</c:v>
                </c:pt>
                <c:pt idx="11569">
                  <c:v>3479.33</c:v>
                </c:pt>
                <c:pt idx="11572">
                  <c:v>2007.94</c:v>
                </c:pt>
                <c:pt idx="11574">
                  <c:v>793.8</c:v>
                </c:pt>
                <c:pt idx="11586">
                  <c:v>11641.5</c:v>
                </c:pt>
                <c:pt idx="11587">
                  <c:v>1020.17</c:v>
                </c:pt>
                <c:pt idx="11588">
                  <c:v>618.62400000000002</c:v>
                </c:pt>
                <c:pt idx="11589">
                  <c:v>1366.42</c:v>
                </c:pt>
                <c:pt idx="11590">
                  <c:v>1677.46</c:v>
                </c:pt>
                <c:pt idx="11592">
                  <c:v>1182.5999999999999</c:v>
                </c:pt>
                <c:pt idx="11594">
                  <c:v>4410.5</c:v>
                </c:pt>
                <c:pt idx="11597">
                  <c:v>1090.3699999999999</c:v>
                </c:pt>
                <c:pt idx="11599">
                  <c:v>602.85599999999999</c:v>
                </c:pt>
                <c:pt idx="11607">
                  <c:v>166.10400000000001</c:v>
                </c:pt>
                <c:pt idx="11616">
                  <c:v>1197.94</c:v>
                </c:pt>
                <c:pt idx="11620">
                  <c:v>1161.22</c:v>
                </c:pt>
                <c:pt idx="11631">
                  <c:v>1337.26</c:v>
                </c:pt>
                <c:pt idx="11639">
                  <c:v>1254.31</c:v>
                </c:pt>
                <c:pt idx="11643">
                  <c:v>69.552000000000007</c:v>
                </c:pt>
                <c:pt idx="11646">
                  <c:v>1742.26</c:v>
                </c:pt>
                <c:pt idx="11647">
                  <c:v>815.18399999999997</c:v>
                </c:pt>
                <c:pt idx="11649">
                  <c:v>1462.75</c:v>
                </c:pt>
                <c:pt idx="11650">
                  <c:v>3014.06</c:v>
                </c:pt>
                <c:pt idx="11656">
                  <c:v>1640.74</c:v>
                </c:pt>
                <c:pt idx="11661">
                  <c:v>1256.47</c:v>
                </c:pt>
                <c:pt idx="11663">
                  <c:v>1225.58</c:v>
                </c:pt>
                <c:pt idx="11665">
                  <c:v>1136.5899999999999</c:v>
                </c:pt>
                <c:pt idx="11666">
                  <c:v>1913.11</c:v>
                </c:pt>
                <c:pt idx="11671">
                  <c:v>2261.7399999999998</c:v>
                </c:pt>
                <c:pt idx="11676">
                  <c:v>7536.02</c:v>
                </c:pt>
                <c:pt idx="11687">
                  <c:v>2706.91</c:v>
                </c:pt>
                <c:pt idx="11692">
                  <c:v>1344.38</c:v>
                </c:pt>
                <c:pt idx="11694">
                  <c:v>3056.18</c:v>
                </c:pt>
                <c:pt idx="11697">
                  <c:v>1595.38</c:v>
                </c:pt>
                <c:pt idx="11698">
                  <c:v>1863.22</c:v>
                </c:pt>
                <c:pt idx="11704">
                  <c:v>2127.38</c:v>
                </c:pt>
                <c:pt idx="11705">
                  <c:v>1909.22</c:v>
                </c:pt>
                <c:pt idx="11714">
                  <c:v>2101.46</c:v>
                </c:pt>
                <c:pt idx="11722">
                  <c:v>1660.82</c:v>
                </c:pt>
                <c:pt idx="11723">
                  <c:v>815.61599999999999</c:v>
                </c:pt>
                <c:pt idx="11742">
                  <c:v>1068.1199999999999</c:v>
                </c:pt>
                <c:pt idx="11743">
                  <c:v>676.29600000000005</c:v>
                </c:pt>
                <c:pt idx="11749">
                  <c:v>9814.61</c:v>
                </c:pt>
                <c:pt idx="11750">
                  <c:v>2593.3000000000002</c:v>
                </c:pt>
                <c:pt idx="11758">
                  <c:v>2142.7199999999998</c:v>
                </c:pt>
                <c:pt idx="11760">
                  <c:v>1712.23</c:v>
                </c:pt>
                <c:pt idx="11766">
                  <c:v>1312.42</c:v>
                </c:pt>
                <c:pt idx="11769">
                  <c:v>2108.16</c:v>
                </c:pt>
                <c:pt idx="11773">
                  <c:v>1246.0999999999999</c:v>
                </c:pt>
                <c:pt idx="11774">
                  <c:v>963.14400000000001</c:v>
                </c:pt>
                <c:pt idx="11781">
                  <c:v>1396.44</c:v>
                </c:pt>
                <c:pt idx="11782">
                  <c:v>3703.32</c:v>
                </c:pt>
                <c:pt idx="11784">
                  <c:v>1618.49</c:v>
                </c:pt>
                <c:pt idx="11787">
                  <c:v>1079.78</c:v>
                </c:pt>
                <c:pt idx="11788">
                  <c:v>3021.19</c:v>
                </c:pt>
                <c:pt idx="11793">
                  <c:v>1758.89</c:v>
                </c:pt>
                <c:pt idx="11796">
                  <c:v>1271.81</c:v>
                </c:pt>
                <c:pt idx="11798">
                  <c:v>1543.97</c:v>
                </c:pt>
                <c:pt idx="11801">
                  <c:v>2255.69</c:v>
                </c:pt>
                <c:pt idx="11804">
                  <c:v>2061.94</c:v>
                </c:pt>
                <c:pt idx="11805">
                  <c:v>2260.66</c:v>
                </c:pt>
                <c:pt idx="11808">
                  <c:v>1469.88</c:v>
                </c:pt>
                <c:pt idx="11809">
                  <c:v>1953.5</c:v>
                </c:pt>
                <c:pt idx="11822">
                  <c:v>1735.78</c:v>
                </c:pt>
                <c:pt idx="11828">
                  <c:v>1693.01</c:v>
                </c:pt>
                <c:pt idx="11831">
                  <c:v>1517.18</c:v>
                </c:pt>
                <c:pt idx="11842">
                  <c:v>2173.8200000000002</c:v>
                </c:pt>
                <c:pt idx="11846">
                  <c:v>2080.5100000000002</c:v>
                </c:pt>
                <c:pt idx="11859">
                  <c:v>793.15200000000004</c:v>
                </c:pt>
                <c:pt idx="11860">
                  <c:v>1448.5</c:v>
                </c:pt>
                <c:pt idx="11864">
                  <c:v>833.54399999999998</c:v>
                </c:pt>
                <c:pt idx="11866">
                  <c:v>869.4</c:v>
                </c:pt>
                <c:pt idx="11867">
                  <c:v>1983.31</c:v>
                </c:pt>
                <c:pt idx="11868">
                  <c:v>1281.74</c:v>
                </c:pt>
                <c:pt idx="11873">
                  <c:v>1247.6199999999999</c:v>
                </c:pt>
                <c:pt idx="11875">
                  <c:v>1757.59</c:v>
                </c:pt>
                <c:pt idx="11881">
                  <c:v>3872.66</c:v>
                </c:pt>
                <c:pt idx="11883">
                  <c:v>1686.74</c:v>
                </c:pt>
                <c:pt idx="11890">
                  <c:v>1202.69</c:v>
                </c:pt>
                <c:pt idx="11894">
                  <c:v>2458.5100000000002</c:v>
                </c:pt>
                <c:pt idx="11897">
                  <c:v>2007.29</c:v>
                </c:pt>
                <c:pt idx="11904">
                  <c:v>1086.26</c:v>
                </c:pt>
                <c:pt idx="11908">
                  <c:v>1624.32</c:v>
                </c:pt>
                <c:pt idx="11911">
                  <c:v>1464.26</c:v>
                </c:pt>
                <c:pt idx="11912">
                  <c:v>1075.46</c:v>
                </c:pt>
                <c:pt idx="11917">
                  <c:v>1034.21</c:v>
                </c:pt>
                <c:pt idx="11930">
                  <c:v>1398.6</c:v>
                </c:pt>
                <c:pt idx="11936">
                  <c:v>1703.81</c:v>
                </c:pt>
                <c:pt idx="11939">
                  <c:v>210.16800000000001</c:v>
                </c:pt>
                <c:pt idx="11943">
                  <c:v>1134</c:v>
                </c:pt>
                <c:pt idx="11945">
                  <c:v>1518.05</c:v>
                </c:pt>
                <c:pt idx="11949">
                  <c:v>1027.3</c:v>
                </c:pt>
                <c:pt idx="11951">
                  <c:v>993.16800000000001</c:v>
                </c:pt>
                <c:pt idx="11953">
                  <c:v>2795.69</c:v>
                </c:pt>
                <c:pt idx="11960">
                  <c:v>1217.81</c:v>
                </c:pt>
                <c:pt idx="11964">
                  <c:v>1915.06</c:v>
                </c:pt>
                <c:pt idx="11967">
                  <c:v>1673.57</c:v>
                </c:pt>
                <c:pt idx="11968">
                  <c:v>1073.74</c:v>
                </c:pt>
                <c:pt idx="11969">
                  <c:v>1746.58</c:v>
                </c:pt>
                <c:pt idx="11974">
                  <c:v>1303.56</c:v>
                </c:pt>
                <c:pt idx="11975">
                  <c:v>770.47199999999998</c:v>
                </c:pt>
                <c:pt idx="11982">
                  <c:v>2097.14</c:v>
                </c:pt>
                <c:pt idx="11987">
                  <c:v>1545.26</c:v>
                </c:pt>
                <c:pt idx="11989">
                  <c:v>726.19200000000001</c:v>
                </c:pt>
                <c:pt idx="11991">
                  <c:v>1271.3800000000001</c:v>
                </c:pt>
                <c:pt idx="11996">
                  <c:v>2372.11</c:v>
                </c:pt>
                <c:pt idx="12004">
                  <c:v>1111.32</c:v>
                </c:pt>
                <c:pt idx="12006">
                  <c:v>814.53599999999994</c:v>
                </c:pt>
                <c:pt idx="12008">
                  <c:v>1173.96</c:v>
                </c:pt>
                <c:pt idx="12009">
                  <c:v>1172.45</c:v>
                </c:pt>
                <c:pt idx="12010">
                  <c:v>1304.21</c:v>
                </c:pt>
                <c:pt idx="12011">
                  <c:v>1301.18</c:v>
                </c:pt>
                <c:pt idx="12018">
                  <c:v>1154.52</c:v>
                </c:pt>
                <c:pt idx="12020">
                  <c:v>2245.75</c:v>
                </c:pt>
                <c:pt idx="12025">
                  <c:v>1910.52</c:v>
                </c:pt>
                <c:pt idx="12033">
                  <c:v>2713.39</c:v>
                </c:pt>
                <c:pt idx="12035">
                  <c:v>905.25599999999997</c:v>
                </c:pt>
                <c:pt idx="12039">
                  <c:v>1672.27</c:v>
                </c:pt>
                <c:pt idx="12051">
                  <c:v>1698.19</c:v>
                </c:pt>
                <c:pt idx="12052">
                  <c:v>1424.95</c:v>
                </c:pt>
                <c:pt idx="12058">
                  <c:v>1864.08</c:v>
                </c:pt>
                <c:pt idx="12065">
                  <c:v>816.91200000000003</c:v>
                </c:pt>
                <c:pt idx="12067">
                  <c:v>1521.72</c:v>
                </c:pt>
                <c:pt idx="12068">
                  <c:v>2008.8</c:v>
                </c:pt>
                <c:pt idx="12072">
                  <c:v>2414.02</c:v>
                </c:pt>
                <c:pt idx="12075">
                  <c:v>1356.05</c:v>
                </c:pt>
                <c:pt idx="12076">
                  <c:v>1069.8499999999999</c:v>
                </c:pt>
                <c:pt idx="12078">
                  <c:v>1845.5</c:v>
                </c:pt>
                <c:pt idx="12079">
                  <c:v>1442.23</c:v>
                </c:pt>
                <c:pt idx="12085">
                  <c:v>4254.34</c:v>
                </c:pt>
                <c:pt idx="12089">
                  <c:v>1284.98</c:v>
                </c:pt>
                <c:pt idx="12096">
                  <c:v>1486.73</c:v>
                </c:pt>
                <c:pt idx="12097">
                  <c:v>987.33600000000001</c:v>
                </c:pt>
                <c:pt idx="12102">
                  <c:v>2412.5</c:v>
                </c:pt>
                <c:pt idx="12107">
                  <c:v>1106.78</c:v>
                </c:pt>
                <c:pt idx="12108">
                  <c:v>989.28</c:v>
                </c:pt>
                <c:pt idx="12110">
                  <c:v>1753.49</c:v>
                </c:pt>
                <c:pt idx="12115">
                  <c:v>2239.06</c:v>
                </c:pt>
                <c:pt idx="12121">
                  <c:v>2222.64</c:v>
                </c:pt>
                <c:pt idx="12124">
                  <c:v>1183.03</c:v>
                </c:pt>
                <c:pt idx="12129">
                  <c:v>2671.92</c:v>
                </c:pt>
                <c:pt idx="12131">
                  <c:v>1302.05</c:v>
                </c:pt>
                <c:pt idx="12132">
                  <c:v>1597.32</c:v>
                </c:pt>
                <c:pt idx="12133">
                  <c:v>2056.54</c:v>
                </c:pt>
                <c:pt idx="12154">
                  <c:v>2539.3000000000002</c:v>
                </c:pt>
                <c:pt idx="12160">
                  <c:v>2525.4699999999998</c:v>
                </c:pt>
                <c:pt idx="12161">
                  <c:v>1373.33</c:v>
                </c:pt>
                <c:pt idx="12166">
                  <c:v>1890.86</c:v>
                </c:pt>
                <c:pt idx="12178">
                  <c:v>2339.9299999999998</c:v>
                </c:pt>
                <c:pt idx="12179">
                  <c:v>3294.22</c:v>
                </c:pt>
                <c:pt idx="12181">
                  <c:v>958.17600000000004</c:v>
                </c:pt>
                <c:pt idx="12183">
                  <c:v>1128.5999999999999</c:v>
                </c:pt>
                <c:pt idx="12187">
                  <c:v>1510.49</c:v>
                </c:pt>
                <c:pt idx="12190">
                  <c:v>1696.46</c:v>
                </c:pt>
                <c:pt idx="12192">
                  <c:v>1942.49</c:v>
                </c:pt>
                <c:pt idx="12196">
                  <c:v>1398.17</c:v>
                </c:pt>
                <c:pt idx="12198">
                  <c:v>1253.45</c:v>
                </c:pt>
                <c:pt idx="12199">
                  <c:v>1012.18</c:v>
                </c:pt>
                <c:pt idx="12203">
                  <c:v>1336.61</c:v>
                </c:pt>
                <c:pt idx="12214">
                  <c:v>1435.32</c:v>
                </c:pt>
                <c:pt idx="12215">
                  <c:v>2406.67</c:v>
                </c:pt>
                <c:pt idx="12221">
                  <c:v>13525.9</c:v>
                </c:pt>
                <c:pt idx="12224">
                  <c:v>1891.73</c:v>
                </c:pt>
                <c:pt idx="12228">
                  <c:v>960.76800000000003</c:v>
                </c:pt>
                <c:pt idx="12229">
                  <c:v>1260.3599999999999</c:v>
                </c:pt>
                <c:pt idx="12238">
                  <c:v>1597.75</c:v>
                </c:pt>
                <c:pt idx="12240">
                  <c:v>917.78399999999999</c:v>
                </c:pt>
                <c:pt idx="12241">
                  <c:v>2124.79</c:v>
                </c:pt>
                <c:pt idx="12247">
                  <c:v>823.82399999999996</c:v>
                </c:pt>
                <c:pt idx="12251">
                  <c:v>1754.14</c:v>
                </c:pt>
                <c:pt idx="12258">
                  <c:v>1958.04</c:v>
                </c:pt>
                <c:pt idx="12275">
                  <c:v>1600.34</c:v>
                </c:pt>
                <c:pt idx="12276">
                  <c:v>3845.45</c:v>
                </c:pt>
                <c:pt idx="12278">
                  <c:v>1636.2</c:v>
                </c:pt>
                <c:pt idx="12284">
                  <c:v>2873.02</c:v>
                </c:pt>
                <c:pt idx="12288">
                  <c:v>2780.14</c:v>
                </c:pt>
                <c:pt idx="12289">
                  <c:v>2242.5100000000002</c:v>
                </c:pt>
                <c:pt idx="12290">
                  <c:v>2074.46</c:v>
                </c:pt>
                <c:pt idx="12294">
                  <c:v>1584.36</c:v>
                </c:pt>
                <c:pt idx="12305">
                  <c:v>200.44800000000001</c:v>
                </c:pt>
                <c:pt idx="12311">
                  <c:v>2099.3000000000002</c:v>
                </c:pt>
                <c:pt idx="12315">
                  <c:v>4170.1000000000004</c:v>
                </c:pt>
                <c:pt idx="12318">
                  <c:v>1961.71</c:v>
                </c:pt>
                <c:pt idx="12323">
                  <c:v>2369.9499999999998</c:v>
                </c:pt>
                <c:pt idx="12333">
                  <c:v>1811.16</c:v>
                </c:pt>
                <c:pt idx="12340">
                  <c:v>98.063999999999993</c:v>
                </c:pt>
                <c:pt idx="12341">
                  <c:v>1940.54</c:v>
                </c:pt>
                <c:pt idx="12342">
                  <c:v>2795.04</c:v>
                </c:pt>
                <c:pt idx="12353">
                  <c:v>1538.78</c:v>
                </c:pt>
                <c:pt idx="12358">
                  <c:v>2395.2199999999998</c:v>
                </c:pt>
                <c:pt idx="12359">
                  <c:v>2320.92</c:v>
                </c:pt>
                <c:pt idx="12360">
                  <c:v>1623.24</c:v>
                </c:pt>
                <c:pt idx="12369">
                  <c:v>2051.35</c:v>
                </c:pt>
                <c:pt idx="12370">
                  <c:v>1125.58</c:v>
                </c:pt>
                <c:pt idx="12371">
                  <c:v>4035.31</c:v>
                </c:pt>
                <c:pt idx="12374">
                  <c:v>3389.9</c:v>
                </c:pt>
                <c:pt idx="12379">
                  <c:v>1452.38</c:v>
                </c:pt>
                <c:pt idx="12382">
                  <c:v>2325.67</c:v>
                </c:pt>
                <c:pt idx="12383">
                  <c:v>920.16</c:v>
                </c:pt>
                <c:pt idx="12384">
                  <c:v>1369.66</c:v>
                </c:pt>
                <c:pt idx="12386">
                  <c:v>2960.06</c:v>
                </c:pt>
                <c:pt idx="12390">
                  <c:v>1183.68</c:v>
                </c:pt>
                <c:pt idx="12391">
                  <c:v>1351.3</c:v>
                </c:pt>
                <c:pt idx="12394">
                  <c:v>1602.29</c:v>
                </c:pt>
                <c:pt idx="12399">
                  <c:v>1559.3</c:v>
                </c:pt>
                <c:pt idx="12400">
                  <c:v>4543.78</c:v>
                </c:pt>
                <c:pt idx="12403">
                  <c:v>807.19200000000001</c:v>
                </c:pt>
                <c:pt idx="12410">
                  <c:v>849.096</c:v>
                </c:pt>
                <c:pt idx="12416">
                  <c:v>2108.16</c:v>
                </c:pt>
                <c:pt idx="12417">
                  <c:v>1670.11</c:v>
                </c:pt>
                <c:pt idx="12425">
                  <c:v>1074.5999999999999</c:v>
                </c:pt>
                <c:pt idx="12433">
                  <c:v>1799.28</c:v>
                </c:pt>
                <c:pt idx="12434">
                  <c:v>10587</c:v>
                </c:pt>
                <c:pt idx="12437">
                  <c:v>1961.93</c:v>
                </c:pt>
                <c:pt idx="12448">
                  <c:v>739.58399999999995</c:v>
                </c:pt>
                <c:pt idx="12449">
                  <c:v>2329.7800000000002</c:v>
                </c:pt>
                <c:pt idx="12452">
                  <c:v>1335.96</c:v>
                </c:pt>
                <c:pt idx="12454">
                  <c:v>996.40800000000002</c:v>
                </c:pt>
                <c:pt idx="12466">
                  <c:v>1843.78</c:v>
                </c:pt>
                <c:pt idx="12470">
                  <c:v>8226.58</c:v>
                </c:pt>
                <c:pt idx="12477">
                  <c:v>1301.18</c:v>
                </c:pt>
                <c:pt idx="12479">
                  <c:v>1198.58</c:v>
                </c:pt>
                <c:pt idx="12484">
                  <c:v>1300.32</c:v>
                </c:pt>
                <c:pt idx="12486">
                  <c:v>1222.56</c:v>
                </c:pt>
                <c:pt idx="12490">
                  <c:v>1010.23</c:v>
                </c:pt>
                <c:pt idx="12494">
                  <c:v>3145.39</c:v>
                </c:pt>
                <c:pt idx="12496">
                  <c:v>1363.82</c:v>
                </c:pt>
                <c:pt idx="12497">
                  <c:v>3864.67</c:v>
                </c:pt>
                <c:pt idx="12503">
                  <c:v>7631.71</c:v>
                </c:pt>
                <c:pt idx="12514">
                  <c:v>2465.42</c:v>
                </c:pt>
                <c:pt idx="12517">
                  <c:v>2171.88</c:v>
                </c:pt>
                <c:pt idx="12523">
                  <c:v>1917.65</c:v>
                </c:pt>
                <c:pt idx="12528">
                  <c:v>1944.65</c:v>
                </c:pt>
                <c:pt idx="12529">
                  <c:v>1359.72</c:v>
                </c:pt>
                <c:pt idx="12533">
                  <c:v>1627.56</c:v>
                </c:pt>
                <c:pt idx="12534">
                  <c:v>4140.29</c:v>
                </c:pt>
                <c:pt idx="12543">
                  <c:v>2835.65</c:v>
                </c:pt>
                <c:pt idx="12552">
                  <c:v>1700.35</c:v>
                </c:pt>
                <c:pt idx="12553">
                  <c:v>1584.14</c:v>
                </c:pt>
                <c:pt idx="12554">
                  <c:v>1285.6300000000001</c:v>
                </c:pt>
                <c:pt idx="12560">
                  <c:v>1457.14</c:v>
                </c:pt>
                <c:pt idx="12564">
                  <c:v>2792.45</c:v>
                </c:pt>
                <c:pt idx="12571">
                  <c:v>1477.01</c:v>
                </c:pt>
                <c:pt idx="12588">
                  <c:v>1688.69</c:v>
                </c:pt>
                <c:pt idx="12590">
                  <c:v>1844.86</c:v>
                </c:pt>
                <c:pt idx="12594">
                  <c:v>616.03200000000004</c:v>
                </c:pt>
                <c:pt idx="12596">
                  <c:v>6423.41</c:v>
                </c:pt>
                <c:pt idx="12603">
                  <c:v>1553.47</c:v>
                </c:pt>
                <c:pt idx="12610">
                  <c:v>2092.39</c:v>
                </c:pt>
                <c:pt idx="12612">
                  <c:v>1826.5</c:v>
                </c:pt>
                <c:pt idx="12621">
                  <c:v>1386.94</c:v>
                </c:pt>
                <c:pt idx="12623">
                  <c:v>1812.89</c:v>
                </c:pt>
                <c:pt idx="12627">
                  <c:v>3339.14</c:v>
                </c:pt>
                <c:pt idx="12637">
                  <c:v>1002.89</c:v>
                </c:pt>
                <c:pt idx="12638">
                  <c:v>2522.02</c:v>
                </c:pt>
                <c:pt idx="12641">
                  <c:v>995.976</c:v>
                </c:pt>
                <c:pt idx="12642">
                  <c:v>3471.12</c:v>
                </c:pt>
                <c:pt idx="12648">
                  <c:v>1552.82</c:v>
                </c:pt>
                <c:pt idx="12651">
                  <c:v>1419.55</c:v>
                </c:pt>
                <c:pt idx="12652">
                  <c:v>2242.08</c:v>
                </c:pt>
                <c:pt idx="12655">
                  <c:v>1041.77</c:v>
                </c:pt>
                <c:pt idx="12656">
                  <c:v>2455.06</c:v>
                </c:pt>
                <c:pt idx="12659">
                  <c:v>1011.31</c:v>
                </c:pt>
                <c:pt idx="12666">
                  <c:v>1782.86</c:v>
                </c:pt>
                <c:pt idx="12670">
                  <c:v>1876.18</c:v>
                </c:pt>
                <c:pt idx="12677">
                  <c:v>990.14400000000001</c:v>
                </c:pt>
                <c:pt idx="12679">
                  <c:v>416.44799999999998</c:v>
                </c:pt>
                <c:pt idx="12685">
                  <c:v>1937.52</c:v>
                </c:pt>
                <c:pt idx="12691">
                  <c:v>505.87200000000001</c:v>
                </c:pt>
                <c:pt idx="12692">
                  <c:v>1306.8</c:v>
                </c:pt>
                <c:pt idx="12701">
                  <c:v>3057.48</c:v>
                </c:pt>
                <c:pt idx="12704">
                  <c:v>2031.91</c:v>
                </c:pt>
                <c:pt idx="12705">
                  <c:v>1182.82</c:v>
                </c:pt>
                <c:pt idx="12707">
                  <c:v>1628.42</c:v>
                </c:pt>
                <c:pt idx="12714">
                  <c:v>18797</c:v>
                </c:pt>
                <c:pt idx="12716">
                  <c:v>2136.46</c:v>
                </c:pt>
                <c:pt idx="12720">
                  <c:v>1700.35</c:v>
                </c:pt>
                <c:pt idx="12726">
                  <c:v>2404.5100000000002</c:v>
                </c:pt>
                <c:pt idx="12728">
                  <c:v>1752.19</c:v>
                </c:pt>
                <c:pt idx="12730">
                  <c:v>2340.14</c:v>
                </c:pt>
                <c:pt idx="12740">
                  <c:v>468.72</c:v>
                </c:pt>
                <c:pt idx="12745">
                  <c:v>1358.21</c:v>
                </c:pt>
                <c:pt idx="12746">
                  <c:v>2055.02</c:v>
                </c:pt>
                <c:pt idx="12749">
                  <c:v>6148.44</c:v>
                </c:pt>
                <c:pt idx="12750">
                  <c:v>1096.6300000000001</c:v>
                </c:pt>
                <c:pt idx="12754">
                  <c:v>1576.8</c:v>
                </c:pt>
                <c:pt idx="12761">
                  <c:v>1694.09</c:v>
                </c:pt>
                <c:pt idx="12762">
                  <c:v>2601.94</c:v>
                </c:pt>
                <c:pt idx="12765">
                  <c:v>2437.13</c:v>
                </c:pt>
                <c:pt idx="12766">
                  <c:v>1952.86</c:v>
                </c:pt>
                <c:pt idx="12769">
                  <c:v>7976.02</c:v>
                </c:pt>
                <c:pt idx="12773">
                  <c:v>905.25599999999997</c:v>
                </c:pt>
                <c:pt idx="12777">
                  <c:v>2206.87</c:v>
                </c:pt>
                <c:pt idx="12779">
                  <c:v>2619.86</c:v>
                </c:pt>
                <c:pt idx="12780">
                  <c:v>2946.02</c:v>
                </c:pt>
                <c:pt idx="12782">
                  <c:v>1308.74</c:v>
                </c:pt>
                <c:pt idx="12788">
                  <c:v>1364.69</c:v>
                </c:pt>
                <c:pt idx="12790">
                  <c:v>9343.94</c:v>
                </c:pt>
                <c:pt idx="12798">
                  <c:v>676.72799999999995</c:v>
                </c:pt>
                <c:pt idx="12802">
                  <c:v>2862</c:v>
                </c:pt>
                <c:pt idx="12805">
                  <c:v>2417.04</c:v>
                </c:pt>
                <c:pt idx="12812">
                  <c:v>1872.72</c:v>
                </c:pt>
                <c:pt idx="12813">
                  <c:v>1669.68</c:v>
                </c:pt>
                <c:pt idx="12821">
                  <c:v>1422.58</c:v>
                </c:pt>
                <c:pt idx="12829">
                  <c:v>923.83199999999999</c:v>
                </c:pt>
                <c:pt idx="12834">
                  <c:v>1769.26</c:v>
                </c:pt>
                <c:pt idx="12838">
                  <c:v>1422.58</c:v>
                </c:pt>
                <c:pt idx="12845">
                  <c:v>2345.98</c:v>
                </c:pt>
                <c:pt idx="12846">
                  <c:v>1997.14</c:v>
                </c:pt>
                <c:pt idx="12848">
                  <c:v>1344.6</c:v>
                </c:pt>
                <c:pt idx="12849">
                  <c:v>446.04</c:v>
                </c:pt>
                <c:pt idx="12852">
                  <c:v>2667.38</c:v>
                </c:pt>
                <c:pt idx="12863">
                  <c:v>2062.37</c:v>
                </c:pt>
                <c:pt idx="12866">
                  <c:v>3654.29</c:v>
                </c:pt>
                <c:pt idx="12869">
                  <c:v>2624.83</c:v>
                </c:pt>
                <c:pt idx="12878">
                  <c:v>2931.98</c:v>
                </c:pt>
                <c:pt idx="12882">
                  <c:v>2480.98</c:v>
                </c:pt>
                <c:pt idx="12886">
                  <c:v>1484.57</c:v>
                </c:pt>
                <c:pt idx="12890">
                  <c:v>489.24</c:v>
                </c:pt>
                <c:pt idx="12896">
                  <c:v>1469.02</c:v>
                </c:pt>
                <c:pt idx="12901">
                  <c:v>2372.11</c:v>
                </c:pt>
                <c:pt idx="12902">
                  <c:v>2299.54</c:v>
                </c:pt>
                <c:pt idx="12906">
                  <c:v>1177.42</c:v>
                </c:pt>
                <c:pt idx="12907">
                  <c:v>1284.98</c:v>
                </c:pt>
                <c:pt idx="12908">
                  <c:v>1087.78</c:v>
                </c:pt>
                <c:pt idx="12909">
                  <c:v>3108.67</c:v>
                </c:pt>
                <c:pt idx="12911">
                  <c:v>3881.52</c:v>
                </c:pt>
                <c:pt idx="12924">
                  <c:v>1053.22</c:v>
                </c:pt>
                <c:pt idx="12925">
                  <c:v>2826.14</c:v>
                </c:pt>
                <c:pt idx="12926">
                  <c:v>4714.2</c:v>
                </c:pt>
                <c:pt idx="12932">
                  <c:v>1964.52</c:v>
                </c:pt>
                <c:pt idx="12947">
                  <c:v>1670.11</c:v>
                </c:pt>
                <c:pt idx="12951">
                  <c:v>549.50400000000002</c:v>
                </c:pt>
                <c:pt idx="12952">
                  <c:v>1497.74</c:v>
                </c:pt>
                <c:pt idx="12959">
                  <c:v>1853.06</c:v>
                </c:pt>
                <c:pt idx="12960">
                  <c:v>1572.05</c:v>
                </c:pt>
                <c:pt idx="12964">
                  <c:v>2922.48</c:v>
                </c:pt>
                <c:pt idx="12972">
                  <c:v>635.25599999999997</c:v>
                </c:pt>
                <c:pt idx="12974">
                  <c:v>4818.96</c:v>
                </c:pt>
                <c:pt idx="12977">
                  <c:v>1816.99</c:v>
                </c:pt>
                <c:pt idx="12978">
                  <c:v>2423.09</c:v>
                </c:pt>
                <c:pt idx="12984">
                  <c:v>792.93600000000004</c:v>
                </c:pt>
                <c:pt idx="12994">
                  <c:v>2471.04</c:v>
                </c:pt>
                <c:pt idx="12996">
                  <c:v>1562.11</c:v>
                </c:pt>
                <c:pt idx="12997">
                  <c:v>2427.41</c:v>
                </c:pt>
                <c:pt idx="13000">
                  <c:v>2584.66</c:v>
                </c:pt>
                <c:pt idx="13003">
                  <c:v>1632.31</c:v>
                </c:pt>
                <c:pt idx="13004">
                  <c:v>2452.25</c:v>
                </c:pt>
                <c:pt idx="13013">
                  <c:v>1275.48</c:v>
                </c:pt>
                <c:pt idx="13016">
                  <c:v>567.64800000000002</c:v>
                </c:pt>
                <c:pt idx="13017">
                  <c:v>1766.66</c:v>
                </c:pt>
                <c:pt idx="13025">
                  <c:v>1065.53</c:v>
                </c:pt>
                <c:pt idx="13026">
                  <c:v>3080.16</c:v>
                </c:pt>
                <c:pt idx="13027">
                  <c:v>2626.34</c:v>
                </c:pt>
                <c:pt idx="13030">
                  <c:v>1995.41</c:v>
                </c:pt>
                <c:pt idx="13033">
                  <c:v>2189.38</c:v>
                </c:pt>
                <c:pt idx="13036">
                  <c:v>2037.53</c:v>
                </c:pt>
                <c:pt idx="13040">
                  <c:v>2056.9699999999998</c:v>
                </c:pt>
                <c:pt idx="13041">
                  <c:v>716.04</c:v>
                </c:pt>
                <c:pt idx="13045">
                  <c:v>1448.71</c:v>
                </c:pt>
                <c:pt idx="13047">
                  <c:v>2302.7800000000002</c:v>
                </c:pt>
                <c:pt idx="13056">
                  <c:v>1566.22</c:v>
                </c:pt>
                <c:pt idx="13057">
                  <c:v>1847.02</c:v>
                </c:pt>
                <c:pt idx="13059">
                  <c:v>1358.64</c:v>
                </c:pt>
                <c:pt idx="13060">
                  <c:v>1038.74</c:v>
                </c:pt>
                <c:pt idx="13063">
                  <c:v>1789.34</c:v>
                </c:pt>
                <c:pt idx="13068">
                  <c:v>2693.3</c:v>
                </c:pt>
                <c:pt idx="13072">
                  <c:v>1799.93</c:v>
                </c:pt>
                <c:pt idx="13082">
                  <c:v>3138.26</c:v>
                </c:pt>
                <c:pt idx="13083">
                  <c:v>1792.37</c:v>
                </c:pt>
                <c:pt idx="13096">
                  <c:v>3390.77</c:v>
                </c:pt>
                <c:pt idx="13100">
                  <c:v>1443.96</c:v>
                </c:pt>
                <c:pt idx="13104">
                  <c:v>2334.1</c:v>
                </c:pt>
                <c:pt idx="13105">
                  <c:v>1722.6</c:v>
                </c:pt>
                <c:pt idx="13107">
                  <c:v>681.048</c:v>
                </c:pt>
                <c:pt idx="13108">
                  <c:v>2280.96</c:v>
                </c:pt>
                <c:pt idx="13109">
                  <c:v>2029.97</c:v>
                </c:pt>
                <c:pt idx="13120">
                  <c:v>1643.98</c:v>
                </c:pt>
                <c:pt idx="13121">
                  <c:v>1966.9</c:v>
                </c:pt>
                <c:pt idx="13123">
                  <c:v>1476.79</c:v>
                </c:pt>
                <c:pt idx="13127">
                  <c:v>1528.63</c:v>
                </c:pt>
                <c:pt idx="13129">
                  <c:v>2148.77</c:v>
                </c:pt>
                <c:pt idx="13134">
                  <c:v>1111.0999999999999</c:v>
                </c:pt>
                <c:pt idx="13135">
                  <c:v>1749.6</c:v>
                </c:pt>
                <c:pt idx="13147">
                  <c:v>1157.76</c:v>
                </c:pt>
                <c:pt idx="13164">
                  <c:v>1472.26</c:v>
                </c:pt>
                <c:pt idx="13168">
                  <c:v>3740.69</c:v>
                </c:pt>
                <c:pt idx="13174">
                  <c:v>4464.9399999999996</c:v>
                </c:pt>
                <c:pt idx="13175">
                  <c:v>2347.92</c:v>
                </c:pt>
                <c:pt idx="13186">
                  <c:v>1707.48</c:v>
                </c:pt>
                <c:pt idx="13192">
                  <c:v>439.99200000000002</c:v>
                </c:pt>
                <c:pt idx="13195">
                  <c:v>1885.68</c:v>
                </c:pt>
                <c:pt idx="13198">
                  <c:v>2193.48</c:v>
                </c:pt>
                <c:pt idx="13200">
                  <c:v>1620.65</c:v>
                </c:pt>
                <c:pt idx="13201">
                  <c:v>2957.47</c:v>
                </c:pt>
                <c:pt idx="13204">
                  <c:v>2917.51</c:v>
                </c:pt>
                <c:pt idx="13206">
                  <c:v>2253.1</c:v>
                </c:pt>
                <c:pt idx="13207">
                  <c:v>2113.56</c:v>
                </c:pt>
                <c:pt idx="13210">
                  <c:v>2708.86</c:v>
                </c:pt>
                <c:pt idx="13214">
                  <c:v>2407.1</c:v>
                </c:pt>
                <c:pt idx="13216">
                  <c:v>3457.08</c:v>
                </c:pt>
                <c:pt idx="13217">
                  <c:v>3570.91</c:v>
                </c:pt>
                <c:pt idx="13222">
                  <c:v>10134.1</c:v>
                </c:pt>
                <c:pt idx="13223">
                  <c:v>1156.25</c:v>
                </c:pt>
                <c:pt idx="13224">
                  <c:v>1615.46</c:v>
                </c:pt>
                <c:pt idx="13226">
                  <c:v>1564.27</c:v>
                </c:pt>
                <c:pt idx="13228">
                  <c:v>1696.68</c:v>
                </c:pt>
                <c:pt idx="13237">
                  <c:v>896.18399999999997</c:v>
                </c:pt>
                <c:pt idx="13238">
                  <c:v>2611.87</c:v>
                </c:pt>
                <c:pt idx="13240">
                  <c:v>3172.39</c:v>
                </c:pt>
                <c:pt idx="13244">
                  <c:v>2857.68</c:v>
                </c:pt>
                <c:pt idx="13245">
                  <c:v>3270.67</c:v>
                </c:pt>
                <c:pt idx="13250">
                  <c:v>1984.61</c:v>
                </c:pt>
                <c:pt idx="13251">
                  <c:v>1957.61</c:v>
                </c:pt>
                <c:pt idx="13255">
                  <c:v>2730.67</c:v>
                </c:pt>
                <c:pt idx="13256">
                  <c:v>2314.2199999999998</c:v>
                </c:pt>
                <c:pt idx="13257">
                  <c:v>1164.02</c:v>
                </c:pt>
                <c:pt idx="13262">
                  <c:v>805.68</c:v>
                </c:pt>
                <c:pt idx="13266">
                  <c:v>1456.49</c:v>
                </c:pt>
                <c:pt idx="13267">
                  <c:v>2334.31</c:v>
                </c:pt>
                <c:pt idx="13270">
                  <c:v>1093.6099999999999</c:v>
                </c:pt>
                <c:pt idx="13272">
                  <c:v>2482.27</c:v>
                </c:pt>
                <c:pt idx="13274">
                  <c:v>4285.22</c:v>
                </c:pt>
                <c:pt idx="13277">
                  <c:v>2087.86</c:v>
                </c:pt>
                <c:pt idx="13279">
                  <c:v>1801.44</c:v>
                </c:pt>
                <c:pt idx="13280">
                  <c:v>2330.21</c:v>
                </c:pt>
                <c:pt idx="13295">
                  <c:v>3444.34</c:v>
                </c:pt>
                <c:pt idx="13306">
                  <c:v>1498.61</c:v>
                </c:pt>
                <c:pt idx="13314">
                  <c:v>1159.49</c:v>
                </c:pt>
                <c:pt idx="13324">
                  <c:v>2262.6</c:v>
                </c:pt>
                <c:pt idx="13327">
                  <c:v>3712.39</c:v>
                </c:pt>
                <c:pt idx="13329">
                  <c:v>2053.08</c:v>
                </c:pt>
                <c:pt idx="13331">
                  <c:v>1389.74</c:v>
                </c:pt>
                <c:pt idx="13346">
                  <c:v>2482.6999999999998</c:v>
                </c:pt>
                <c:pt idx="13347">
                  <c:v>2675.59</c:v>
                </c:pt>
                <c:pt idx="13353">
                  <c:v>16461.599999999999</c:v>
                </c:pt>
                <c:pt idx="13358">
                  <c:v>2958.34</c:v>
                </c:pt>
                <c:pt idx="13361">
                  <c:v>2037.53</c:v>
                </c:pt>
                <c:pt idx="13365">
                  <c:v>1754.57</c:v>
                </c:pt>
                <c:pt idx="13370">
                  <c:v>841.53599999999994</c:v>
                </c:pt>
                <c:pt idx="13375">
                  <c:v>772.84799999999996</c:v>
                </c:pt>
                <c:pt idx="13376">
                  <c:v>10768.5</c:v>
                </c:pt>
                <c:pt idx="13379">
                  <c:v>2347.06</c:v>
                </c:pt>
                <c:pt idx="13390">
                  <c:v>709.56</c:v>
                </c:pt>
                <c:pt idx="13392">
                  <c:v>2213.14</c:v>
                </c:pt>
                <c:pt idx="13393">
                  <c:v>3185.35</c:v>
                </c:pt>
                <c:pt idx="13396">
                  <c:v>2530.2199999999998</c:v>
                </c:pt>
                <c:pt idx="13405">
                  <c:v>4822.8500000000004</c:v>
                </c:pt>
                <c:pt idx="13406">
                  <c:v>1979.86</c:v>
                </c:pt>
                <c:pt idx="13408">
                  <c:v>2588.54</c:v>
                </c:pt>
                <c:pt idx="13412">
                  <c:v>2355.91</c:v>
                </c:pt>
                <c:pt idx="13413">
                  <c:v>3144.96</c:v>
                </c:pt>
                <c:pt idx="13417">
                  <c:v>3579.34</c:v>
                </c:pt>
                <c:pt idx="13432">
                  <c:v>1918.08</c:v>
                </c:pt>
                <c:pt idx="13433">
                  <c:v>1347.19</c:v>
                </c:pt>
                <c:pt idx="13434">
                  <c:v>3604.18</c:v>
                </c:pt>
                <c:pt idx="13441">
                  <c:v>1844.42</c:v>
                </c:pt>
                <c:pt idx="13444">
                  <c:v>2201.69</c:v>
                </c:pt>
                <c:pt idx="13449">
                  <c:v>9184.5400000000009</c:v>
                </c:pt>
                <c:pt idx="13455">
                  <c:v>1438.99</c:v>
                </c:pt>
                <c:pt idx="13459">
                  <c:v>4290.84</c:v>
                </c:pt>
                <c:pt idx="13468">
                  <c:v>1513.3</c:v>
                </c:pt>
                <c:pt idx="13470">
                  <c:v>2671.06</c:v>
                </c:pt>
                <c:pt idx="13473">
                  <c:v>1650.24</c:v>
                </c:pt>
                <c:pt idx="13475">
                  <c:v>1857.6</c:v>
                </c:pt>
                <c:pt idx="13478">
                  <c:v>2053.08</c:v>
                </c:pt>
                <c:pt idx="13479">
                  <c:v>3413.45</c:v>
                </c:pt>
                <c:pt idx="13480">
                  <c:v>3997.3</c:v>
                </c:pt>
                <c:pt idx="13484">
                  <c:v>1684.8</c:v>
                </c:pt>
                <c:pt idx="13490">
                  <c:v>687.52800000000002</c:v>
                </c:pt>
                <c:pt idx="13497">
                  <c:v>1667.3</c:v>
                </c:pt>
                <c:pt idx="13498">
                  <c:v>2002.97</c:v>
                </c:pt>
                <c:pt idx="13500">
                  <c:v>2109.89</c:v>
                </c:pt>
                <c:pt idx="13503">
                  <c:v>854.49599999999998</c:v>
                </c:pt>
                <c:pt idx="13505">
                  <c:v>2781.22</c:v>
                </c:pt>
                <c:pt idx="13511">
                  <c:v>3189.89</c:v>
                </c:pt>
                <c:pt idx="13517">
                  <c:v>1909.44</c:v>
                </c:pt>
                <c:pt idx="13519">
                  <c:v>1338.77</c:v>
                </c:pt>
                <c:pt idx="13520">
                  <c:v>1899.72</c:v>
                </c:pt>
                <c:pt idx="13522">
                  <c:v>2656.37</c:v>
                </c:pt>
                <c:pt idx="13526">
                  <c:v>3292.92</c:v>
                </c:pt>
                <c:pt idx="13527">
                  <c:v>4639.46</c:v>
                </c:pt>
                <c:pt idx="13529">
                  <c:v>2877.12</c:v>
                </c:pt>
                <c:pt idx="13541">
                  <c:v>2854.01</c:v>
                </c:pt>
                <c:pt idx="13546">
                  <c:v>2124.79</c:v>
                </c:pt>
                <c:pt idx="13552">
                  <c:v>2501.06</c:v>
                </c:pt>
                <c:pt idx="13554">
                  <c:v>1734.7</c:v>
                </c:pt>
                <c:pt idx="13556">
                  <c:v>1657.37</c:v>
                </c:pt>
                <c:pt idx="13559">
                  <c:v>1734.26</c:v>
                </c:pt>
                <c:pt idx="13562">
                  <c:v>2204.71</c:v>
                </c:pt>
                <c:pt idx="13564">
                  <c:v>2218.1</c:v>
                </c:pt>
                <c:pt idx="13566">
                  <c:v>1714.61</c:v>
                </c:pt>
                <c:pt idx="13568">
                  <c:v>1701.86</c:v>
                </c:pt>
                <c:pt idx="13571">
                  <c:v>2871.5</c:v>
                </c:pt>
                <c:pt idx="13574">
                  <c:v>459</c:v>
                </c:pt>
                <c:pt idx="13597">
                  <c:v>2095.63</c:v>
                </c:pt>
                <c:pt idx="13602">
                  <c:v>2655.94</c:v>
                </c:pt>
                <c:pt idx="13605">
                  <c:v>3660.98</c:v>
                </c:pt>
                <c:pt idx="13609">
                  <c:v>783.43200000000002</c:v>
                </c:pt>
                <c:pt idx="13613">
                  <c:v>3124.44</c:v>
                </c:pt>
                <c:pt idx="13621">
                  <c:v>2068.85</c:v>
                </c:pt>
                <c:pt idx="13631">
                  <c:v>1879.63</c:v>
                </c:pt>
                <c:pt idx="13634">
                  <c:v>2076.19</c:v>
                </c:pt>
                <c:pt idx="13641">
                  <c:v>2840.4</c:v>
                </c:pt>
                <c:pt idx="13643">
                  <c:v>2613.6</c:v>
                </c:pt>
                <c:pt idx="13644">
                  <c:v>3001.97</c:v>
                </c:pt>
                <c:pt idx="13646">
                  <c:v>3444.34</c:v>
                </c:pt>
                <c:pt idx="13658">
                  <c:v>5979.1</c:v>
                </c:pt>
                <c:pt idx="13660">
                  <c:v>2070.14</c:v>
                </c:pt>
                <c:pt idx="13661">
                  <c:v>2783.81</c:v>
                </c:pt>
                <c:pt idx="13662">
                  <c:v>1042.8499999999999</c:v>
                </c:pt>
                <c:pt idx="13672">
                  <c:v>2496.7399999999998</c:v>
                </c:pt>
                <c:pt idx="13678">
                  <c:v>3755.59</c:v>
                </c:pt>
                <c:pt idx="13680">
                  <c:v>3805.92</c:v>
                </c:pt>
                <c:pt idx="13683">
                  <c:v>4284.1400000000003</c:v>
                </c:pt>
                <c:pt idx="13686">
                  <c:v>1330.99</c:v>
                </c:pt>
                <c:pt idx="13689">
                  <c:v>2376</c:v>
                </c:pt>
                <c:pt idx="13693">
                  <c:v>3966.62</c:v>
                </c:pt>
                <c:pt idx="13697">
                  <c:v>2376</c:v>
                </c:pt>
                <c:pt idx="13699">
                  <c:v>2567.16</c:v>
                </c:pt>
                <c:pt idx="13700">
                  <c:v>2637.36</c:v>
                </c:pt>
                <c:pt idx="13701">
                  <c:v>1451.3</c:v>
                </c:pt>
                <c:pt idx="13702">
                  <c:v>2755.08</c:v>
                </c:pt>
                <c:pt idx="13704">
                  <c:v>1497.74</c:v>
                </c:pt>
                <c:pt idx="13705">
                  <c:v>1122.98</c:v>
                </c:pt>
                <c:pt idx="13706">
                  <c:v>11419.5</c:v>
                </c:pt>
                <c:pt idx="13707">
                  <c:v>2193.2600000000002</c:v>
                </c:pt>
                <c:pt idx="13710">
                  <c:v>1232.93</c:v>
                </c:pt>
                <c:pt idx="13731">
                  <c:v>4605.34</c:v>
                </c:pt>
                <c:pt idx="13749">
                  <c:v>2478.6</c:v>
                </c:pt>
                <c:pt idx="13751">
                  <c:v>2011.18</c:v>
                </c:pt>
                <c:pt idx="13753">
                  <c:v>2844.72</c:v>
                </c:pt>
                <c:pt idx="13754">
                  <c:v>3054.02</c:v>
                </c:pt>
                <c:pt idx="13755">
                  <c:v>1466.86</c:v>
                </c:pt>
                <c:pt idx="13758">
                  <c:v>1027.3</c:v>
                </c:pt>
                <c:pt idx="13764">
                  <c:v>2199.7399999999998</c:v>
                </c:pt>
                <c:pt idx="13770">
                  <c:v>2454.62</c:v>
                </c:pt>
                <c:pt idx="13771">
                  <c:v>2071.2199999999998</c:v>
                </c:pt>
                <c:pt idx="13774">
                  <c:v>1785.89</c:v>
                </c:pt>
                <c:pt idx="13775">
                  <c:v>2363.04</c:v>
                </c:pt>
                <c:pt idx="13777">
                  <c:v>2147.9</c:v>
                </c:pt>
                <c:pt idx="13780">
                  <c:v>2753.14</c:v>
                </c:pt>
                <c:pt idx="13782">
                  <c:v>4006.58</c:v>
                </c:pt>
                <c:pt idx="13789">
                  <c:v>1685.45</c:v>
                </c:pt>
                <c:pt idx="13793">
                  <c:v>2111.1799999999998</c:v>
                </c:pt>
                <c:pt idx="13796">
                  <c:v>2748.38</c:v>
                </c:pt>
                <c:pt idx="13801">
                  <c:v>4819.3900000000003</c:v>
                </c:pt>
                <c:pt idx="13803">
                  <c:v>3032.64</c:v>
                </c:pt>
                <c:pt idx="13814">
                  <c:v>2063.02</c:v>
                </c:pt>
                <c:pt idx="13816">
                  <c:v>3459.89</c:v>
                </c:pt>
                <c:pt idx="13823">
                  <c:v>3009.31</c:v>
                </c:pt>
                <c:pt idx="13826">
                  <c:v>1809.65</c:v>
                </c:pt>
                <c:pt idx="13830">
                  <c:v>5521.18</c:v>
                </c:pt>
                <c:pt idx="13832">
                  <c:v>1559.3</c:v>
                </c:pt>
                <c:pt idx="13835">
                  <c:v>1759.97</c:v>
                </c:pt>
                <c:pt idx="13844">
                  <c:v>3563.14</c:v>
                </c:pt>
                <c:pt idx="13846">
                  <c:v>841.75199999999995</c:v>
                </c:pt>
                <c:pt idx="13847">
                  <c:v>2652.05</c:v>
                </c:pt>
                <c:pt idx="13848">
                  <c:v>976.96799999999996</c:v>
                </c:pt>
                <c:pt idx="13850">
                  <c:v>1096.2</c:v>
                </c:pt>
                <c:pt idx="13863">
                  <c:v>3350.16</c:v>
                </c:pt>
                <c:pt idx="13865">
                  <c:v>3262.9</c:v>
                </c:pt>
                <c:pt idx="13874">
                  <c:v>3793.39</c:v>
                </c:pt>
                <c:pt idx="13884">
                  <c:v>2202.98</c:v>
                </c:pt>
                <c:pt idx="13892">
                  <c:v>2038.18</c:v>
                </c:pt>
                <c:pt idx="13895">
                  <c:v>2511.86</c:v>
                </c:pt>
                <c:pt idx="13904">
                  <c:v>2169.5</c:v>
                </c:pt>
                <c:pt idx="13923">
                  <c:v>1726.49</c:v>
                </c:pt>
                <c:pt idx="13927">
                  <c:v>5068.87</c:v>
                </c:pt>
                <c:pt idx="13928">
                  <c:v>2344.0300000000002</c:v>
                </c:pt>
                <c:pt idx="13930">
                  <c:v>2494.37</c:v>
                </c:pt>
                <c:pt idx="13943">
                  <c:v>1808.35</c:v>
                </c:pt>
                <c:pt idx="13946">
                  <c:v>2911.9</c:v>
                </c:pt>
                <c:pt idx="13947">
                  <c:v>2325.89</c:v>
                </c:pt>
                <c:pt idx="13949">
                  <c:v>2025.65</c:v>
                </c:pt>
                <c:pt idx="13951">
                  <c:v>3835.3</c:v>
                </c:pt>
                <c:pt idx="13952">
                  <c:v>3087.29</c:v>
                </c:pt>
                <c:pt idx="13953">
                  <c:v>3420.36</c:v>
                </c:pt>
                <c:pt idx="13955">
                  <c:v>831.16800000000001</c:v>
                </c:pt>
                <c:pt idx="13956">
                  <c:v>3493.37</c:v>
                </c:pt>
                <c:pt idx="13957">
                  <c:v>3846.74</c:v>
                </c:pt>
                <c:pt idx="13958">
                  <c:v>3671.14</c:v>
                </c:pt>
                <c:pt idx="13961">
                  <c:v>16049.7</c:v>
                </c:pt>
                <c:pt idx="13966">
                  <c:v>2586.8200000000002</c:v>
                </c:pt>
                <c:pt idx="13967">
                  <c:v>3782.81</c:v>
                </c:pt>
                <c:pt idx="13969">
                  <c:v>2123.71</c:v>
                </c:pt>
                <c:pt idx="13976">
                  <c:v>2065.39</c:v>
                </c:pt>
                <c:pt idx="13979">
                  <c:v>1010.23</c:v>
                </c:pt>
                <c:pt idx="13986">
                  <c:v>1427.76</c:v>
                </c:pt>
                <c:pt idx="13988">
                  <c:v>4528.66</c:v>
                </c:pt>
                <c:pt idx="13998">
                  <c:v>2921.83</c:v>
                </c:pt>
                <c:pt idx="14001">
                  <c:v>2401.27</c:v>
                </c:pt>
                <c:pt idx="14004">
                  <c:v>1021.9</c:v>
                </c:pt>
                <c:pt idx="14008">
                  <c:v>2493.5</c:v>
                </c:pt>
                <c:pt idx="14015">
                  <c:v>2689.42</c:v>
                </c:pt>
                <c:pt idx="14031">
                  <c:v>2388.96</c:v>
                </c:pt>
                <c:pt idx="14033">
                  <c:v>1600.99</c:v>
                </c:pt>
                <c:pt idx="14035">
                  <c:v>1237.9000000000001</c:v>
                </c:pt>
                <c:pt idx="14051">
                  <c:v>3718.22</c:v>
                </c:pt>
                <c:pt idx="14059">
                  <c:v>1968.41</c:v>
                </c:pt>
                <c:pt idx="14065">
                  <c:v>2428.27</c:v>
                </c:pt>
                <c:pt idx="14066">
                  <c:v>3051.65</c:v>
                </c:pt>
                <c:pt idx="14071">
                  <c:v>4722.1899999999996</c:v>
                </c:pt>
                <c:pt idx="14075">
                  <c:v>2818.8</c:v>
                </c:pt>
                <c:pt idx="14080">
                  <c:v>1766.66</c:v>
                </c:pt>
                <c:pt idx="14082">
                  <c:v>4229.93</c:v>
                </c:pt>
                <c:pt idx="14084">
                  <c:v>2324.16</c:v>
                </c:pt>
                <c:pt idx="14088">
                  <c:v>2056.3200000000002</c:v>
                </c:pt>
                <c:pt idx="14091">
                  <c:v>3245.62</c:v>
                </c:pt>
                <c:pt idx="14092">
                  <c:v>2499.12</c:v>
                </c:pt>
                <c:pt idx="14096">
                  <c:v>1982.88</c:v>
                </c:pt>
                <c:pt idx="14097">
                  <c:v>5511.89</c:v>
                </c:pt>
                <c:pt idx="14098">
                  <c:v>2202.34</c:v>
                </c:pt>
                <c:pt idx="14099">
                  <c:v>3529.22</c:v>
                </c:pt>
                <c:pt idx="14101">
                  <c:v>3019.9</c:v>
                </c:pt>
                <c:pt idx="14104">
                  <c:v>2004.91</c:v>
                </c:pt>
                <c:pt idx="14106">
                  <c:v>3265.27</c:v>
                </c:pt>
                <c:pt idx="14109">
                  <c:v>1636.42</c:v>
                </c:pt>
                <c:pt idx="14123">
                  <c:v>4869.29</c:v>
                </c:pt>
                <c:pt idx="14124">
                  <c:v>3938.33</c:v>
                </c:pt>
                <c:pt idx="14125">
                  <c:v>2757.02</c:v>
                </c:pt>
                <c:pt idx="14136">
                  <c:v>2817.29</c:v>
                </c:pt>
                <c:pt idx="14138">
                  <c:v>1493.86</c:v>
                </c:pt>
                <c:pt idx="14139">
                  <c:v>2900.45</c:v>
                </c:pt>
                <c:pt idx="14147">
                  <c:v>5885.57</c:v>
                </c:pt>
                <c:pt idx="14151">
                  <c:v>3123.58</c:v>
                </c:pt>
                <c:pt idx="14153">
                  <c:v>2556.36</c:v>
                </c:pt>
                <c:pt idx="14154">
                  <c:v>2451.17</c:v>
                </c:pt>
                <c:pt idx="14157">
                  <c:v>3269.38</c:v>
                </c:pt>
                <c:pt idx="14158">
                  <c:v>2949.91</c:v>
                </c:pt>
                <c:pt idx="14163">
                  <c:v>2237.98</c:v>
                </c:pt>
                <c:pt idx="14170">
                  <c:v>1789.56</c:v>
                </c:pt>
                <c:pt idx="14177">
                  <c:v>2469.7399999999998</c:v>
                </c:pt>
                <c:pt idx="14181">
                  <c:v>4200.12</c:v>
                </c:pt>
                <c:pt idx="14185">
                  <c:v>2871.29</c:v>
                </c:pt>
                <c:pt idx="14188">
                  <c:v>2130.62</c:v>
                </c:pt>
                <c:pt idx="14194">
                  <c:v>1325.59</c:v>
                </c:pt>
                <c:pt idx="14199">
                  <c:v>22283</c:v>
                </c:pt>
                <c:pt idx="14202">
                  <c:v>4239.6499999999996</c:v>
                </c:pt>
                <c:pt idx="14204">
                  <c:v>5457.02</c:v>
                </c:pt>
                <c:pt idx="14214">
                  <c:v>2113.56</c:v>
                </c:pt>
                <c:pt idx="14216">
                  <c:v>2454.62</c:v>
                </c:pt>
                <c:pt idx="14223">
                  <c:v>2589.19</c:v>
                </c:pt>
                <c:pt idx="14228">
                  <c:v>2620.5100000000002</c:v>
                </c:pt>
                <c:pt idx="14230">
                  <c:v>3286.22</c:v>
                </c:pt>
                <c:pt idx="14233">
                  <c:v>2457.4299999999998</c:v>
                </c:pt>
                <c:pt idx="14234">
                  <c:v>1845.29</c:v>
                </c:pt>
                <c:pt idx="14245">
                  <c:v>3541.54</c:v>
                </c:pt>
                <c:pt idx="14247">
                  <c:v>1593.43</c:v>
                </c:pt>
                <c:pt idx="14248">
                  <c:v>2774.74</c:v>
                </c:pt>
                <c:pt idx="14255">
                  <c:v>2651.83</c:v>
                </c:pt>
                <c:pt idx="14258">
                  <c:v>2627.64</c:v>
                </c:pt>
                <c:pt idx="14261">
                  <c:v>4882.25</c:v>
                </c:pt>
                <c:pt idx="14266">
                  <c:v>1856.74</c:v>
                </c:pt>
                <c:pt idx="14270">
                  <c:v>4577.47</c:v>
                </c:pt>
                <c:pt idx="14272">
                  <c:v>631.15200000000004</c:v>
                </c:pt>
                <c:pt idx="14275">
                  <c:v>982.8</c:v>
                </c:pt>
                <c:pt idx="14278">
                  <c:v>2786.4</c:v>
                </c:pt>
                <c:pt idx="14285">
                  <c:v>3320.14</c:v>
                </c:pt>
                <c:pt idx="14289">
                  <c:v>2339.5</c:v>
                </c:pt>
                <c:pt idx="14292">
                  <c:v>1459.94</c:v>
                </c:pt>
                <c:pt idx="14297">
                  <c:v>2319.19</c:v>
                </c:pt>
                <c:pt idx="14306">
                  <c:v>26916.6</c:v>
                </c:pt>
                <c:pt idx="14309">
                  <c:v>3263.54</c:v>
                </c:pt>
                <c:pt idx="14322">
                  <c:v>2411.21</c:v>
                </c:pt>
                <c:pt idx="14325">
                  <c:v>1758.02</c:v>
                </c:pt>
                <c:pt idx="14326">
                  <c:v>1476.79</c:v>
                </c:pt>
                <c:pt idx="14328">
                  <c:v>2830.03</c:v>
                </c:pt>
                <c:pt idx="14330">
                  <c:v>3468.1</c:v>
                </c:pt>
                <c:pt idx="14337">
                  <c:v>3274.13</c:v>
                </c:pt>
                <c:pt idx="14338">
                  <c:v>3524.26</c:v>
                </c:pt>
                <c:pt idx="14339">
                  <c:v>6295.32</c:v>
                </c:pt>
                <c:pt idx="14342">
                  <c:v>2983.18</c:v>
                </c:pt>
                <c:pt idx="14349">
                  <c:v>3351.24</c:v>
                </c:pt>
                <c:pt idx="14355">
                  <c:v>3394.87</c:v>
                </c:pt>
                <c:pt idx="14358">
                  <c:v>579.74400000000003</c:v>
                </c:pt>
                <c:pt idx="14359">
                  <c:v>4082.62</c:v>
                </c:pt>
                <c:pt idx="14361">
                  <c:v>1696.46</c:v>
                </c:pt>
                <c:pt idx="14368">
                  <c:v>653.4</c:v>
                </c:pt>
                <c:pt idx="14370">
                  <c:v>3111.7</c:v>
                </c:pt>
                <c:pt idx="14372">
                  <c:v>2612.7399999999998</c:v>
                </c:pt>
                <c:pt idx="14376">
                  <c:v>1680.05</c:v>
                </c:pt>
                <c:pt idx="14378">
                  <c:v>3630.1</c:v>
                </c:pt>
                <c:pt idx="14379">
                  <c:v>2024.35</c:v>
                </c:pt>
                <c:pt idx="14382">
                  <c:v>4820.6899999999996</c:v>
                </c:pt>
                <c:pt idx="14388">
                  <c:v>2255.2600000000002</c:v>
                </c:pt>
                <c:pt idx="14392">
                  <c:v>3988.87</c:v>
                </c:pt>
                <c:pt idx="14395">
                  <c:v>1063.3699999999999</c:v>
                </c:pt>
                <c:pt idx="14396">
                  <c:v>3749.54</c:v>
                </c:pt>
                <c:pt idx="14400">
                  <c:v>2576.4499999999998</c:v>
                </c:pt>
                <c:pt idx="14404">
                  <c:v>2895.7</c:v>
                </c:pt>
                <c:pt idx="14405">
                  <c:v>2659.18</c:v>
                </c:pt>
                <c:pt idx="14407">
                  <c:v>3725.35</c:v>
                </c:pt>
                <c:pt idx="14413">
                  <c:v>2864.38</c:v>
                </c:pt>
                <c:pt idx="14417">
                  <c:v>3359.02</c:v>
                </c:pt>
                <c:pt idx="14423">
                  <c:v>4073.54</c:v>
                </c:pt>
                <c:pt idx="14425">
                  <c:v>3753.86</c:v>
                </c:pt>
                <c:pt idx="14434">
                  <c:v>4872.53</c:v>
                </c:pt>
                <c:pt idx="14438">
                  <c:v>3664.66</c:v>
                </c:pt>
                <c:pt idx="14443">
                  <c:v>1980.94</c:v>
                </c:pt>
                <c:pt idx="14448">
                  <c:v>2896.34</c:v>
                </c:pt>
                <c:pt idx="14453">
                  <c:v>2485.73</c:v>
                </c:pt>
                <c:pt idx="14455">
                  <c:v>2700.43</c:v>
                </c:pt>
                <c:pt idx="14466">
                  <c:v>5430.89</c:v>
                </c:pt>
                <c:pt idx="14467">
                  <c:v>341.28</c:v>
                </c:pt>
                <c:pt idx="14469">
                  <c:v>4031.64</c:v>
                </c:pt>
                <c:pt idx="14477">
                  <c:v>2989.44</c:v>
                </c:pt>
                <c:pt idx="14479">
                  <c:v>2210.98</c:v>
                </c:pt>
                <c:pt idx="14486">
                  <c:v>2812.75</c:v>
                </c:pt>
                <c:pt idx="14488">
                  <c:v>345.81599999999997</c:v>
                </c:pt>
                <c:pt idx="14493">
                  <c:v>3700.3</c:v>
                </c:pt>
                <c:pt idx="14494">
                  <c:v>1057.75</c:v>
                </c:pt>
                <c:pt idx="14499">
                  <c:v>848.88</c:v>
                </c:pt>
                <c:pt idx="14500">
                  <c:v>6116.9</c:v>
                </c:pt>
                <c:pt idx="14505">
                  <c:v>2096.5</c:v>
                </c:pt>
                <c:pt idx="14506">
                  <c:v>2344.0300000000002</c:v>
                </c:pt>
                <c:pt idx="14510">
                  <c:v>2279.88</c:v>
                </c:pt>
                <c:pt idx="14511">
                  <c:v>5626.58</c:v>
                </c:pt>
                <c:pt idx="14513">
                  <c:v>3438.5</c:v>
                </c:pt>
                <c:pt idx="14514">
                  <c:v>3513.46</c:v>
                </c:pt>
                <c:pt idx="14521">
                  <c:v>2261.52</c:v>
                </c:pt>
                <c:pt idx="14529">
                  <c:v>3460.32</c:v>
                </c:pt>
                <c:pt idx="14533">
                  <c:v>5647.97</c:v>
                </c:pt>
                <c:pt idx="14534">
                  <c:v>2407.1</c:v>
                </c:pt>
                <c:pt idx="14543">
                  <c:v>3175.85</c:v>
                </c:pt>
                <c:pt idx="14547">
                  <c:v>3063.53</c:v>
                </c:pt>
                <c:pt idx="14552">
                  <c:v>2094.5500000000002</c:v>
                </c:pt>
                <c:pt idx="14559">
                  <c:v>3303.94</c:v>
                </c:pt>
                <c:pt idx="14561">
                  <c:v>597.67200000000003</c:v>
                </c:pt>
                <c:pt idx="14567">
                  <c:v>2523.31</c:v>
                </c:pt>
                <c:pt idx="14568">
                  <c:v>2301.48</c:v>
                </c:pt>
                <c:pt idx="14572">
                  <c:v>5890.32</c:v>
                </c:pt>
                <c:pt idx="14573">
                  <c:v>2743.85</c:v>
                </c:pt>
                <c:pt idx="14575">
                  <c:v>3480.41</c:v>
                </c:pt>
                <c:pt idx="14577">
                  <c:v>3942</c:v>
                </c:pt>
                <c:pt idx="14578">
                  <c:v>146.66399999999999</c:v>
                </c:pt>
                <c:pt idx="14581">
                  <c:v>6192.72</c:v>
                </c:pt>
                <c:pt idx="14585">
                  <c:v>4105.51</c:v>
                </c:pt>
                <c:pt idx="14587">
                  <c:v>1931.26</c:v>
                </c:pt>
                <c:pt idx="14588">
                  <c:v>2440.58</c:v>
                </c:pt>
                <c:pt idx="14592">
                  <c:v>3437.42</c:v>
                </c:pt>
                <c:pt idx="14594">
                  <c:v>6285.17</c:v>
                </c:pt>
                <c:pt idx="14595">
                  <c:v>1195.56</c:v>
                </c:pt>
                <c:pt idx="14596">
                  <c:v>2056.3200000000002</c:v>
                </c:pt>
                <c:pt idx="14600">
                  <c:v>3390.34</c:v>
                </c:pt>
                <c:pt idx="14602">
                  <c:v>2513.16</c:v>
                </c:pt>
                <c:pt idx="14607">
                  <c:v>4134.8900000000003</c:v>
                </c:pt>
                <c:pt idx="14609">
                  <c:v>4151.95</c:v>
                </c:pt>
                <c:pt idx="14615">
                  <c:v>3584.09</c:v>
                </c:pt>
                <c:pt idx="14617">
                  <c:v>2519.64</c:v>
                </c:pt>
                <c:pt idx="14618">
                  <c:v>4952.2299999999996</c:v>
                </c:pt>
                <c:pt idx="14620">
                  <c:v>22610</c:v>
                </c:pt>
                <c:pt idx="14621">
                  <c:v>6351.48</c:v>
                </c:pt>
                <c:pt idx="14622">
                  <c:v>3016.66</c:v>
                </c:pt>
                <c:pt idx="14631">
                  <c:v>4233.82</c:v>
                </c:pt>
                <c:pt idx="14636">
                  <c:v>779.76</c:v>
                </c:pt>
                <c:pt idx="14637">
                  <c:v>547.99199999999996</c:v>
                </c:pt>
                <c:pt idx="14638">
                  <c:v>3990.17</c:v>
                </c:pt>
                <c:pt idx="14639">
                  <c:v>5633.5</c:v>
                </c:pt>
                <c:pt idx="14642">
                  <c:v>1934.71</c:v>
                </c:pt>
                <c:pt idx="14648">
                  <c:v>3395.52</c:v>
                </c:pt>
                <c:pt idx="14652">
                  <c:v>3505.9</c:v>
                </c:pt>
                <c:pt idx="14662">
                  <c:v>1563.84</c:v>
                </c:pt>
                <c:pt idx="14668">
                  <c:v>4013.5</c:v>
                </c:pt>
                <c:pt idx="14687">
                  <c:v>2875.39</c:v>
                </c:pt>
                <c:pt idx="14691">
                  <c:v>4367.95</c:v>
                </c:pt>
                <c:pt idx="14692">
                  <c:v>2345.7600000000002</c:v>
                </c:pt>
                <c:pt idx="14697">
                  <c:v>5366.95</c:v>
                </c:pt>
                <c:pt idx="14707">
                  <c:v>1324.51</c:v>
                </c:pt>
                <c:pt idx="14709">
                  <c:v>2779.27</c:v>
                </c:pt>
                <c:pt idx="14716">
                  <c:v>326.16000000000003</c:v>
                </c:pt>
                <c:pt idx="14718">
                  <c:v>2530.66</c:v>
                </c:pt>
                <c:pt idx="14719">
                  <c:v>2890.3</c:v>
                </c:pt>
                <c:pt idx="14722">
                  <c:v>4512.0200000000004</c:v>
                </c:pt>
                <c:pt idx="14725">
                  <c:v>1941.62</c:v>
                </c:pt>
                <c:pt idx="14727">
                  <c:v>1766.02</c:v>
                </c:pt>
                <c:pt idx="14733">
                  <c:v>2346.41</c:v>
                </c:pt>
                <c:pt idx="14735">
                  <c:v>298.94400000000002</c:v>
                </c:pt>
                <c:pt idx="14738">
                  <c:v>4042.22</c:v>
                </c:pt>
                <c:pt idx="14740">
                  <c:v>2402.7800000000002</c:v>
                </c:pt>
                <c:pt idx="14743">
                  <c:v>4117.18</c:v>
                </c:pt>
                <c:pt idx="14751">
                  <c:v>763.77599999999995</c:v>
                </c:pt>
                <c:pt idx="14753">
                  <c:v>2591.7800000000002</c:v>
                </c:pt>
                <c:pt idx="14759">
                  <c:v>3137.18</c:v>
                </c:pt>
                <c:pt idx="14761">
                  <c:v>3403.3</c:v>
                </c:pt>
                <c:pt idx="14762">
                  <c:v>2318.7600000000002</c:v>
                </c:pt>
                <c:pt idx="14766">
                  <c:v>3730.54</c:v>
                </c:pt>
                <c:pt idx="14767">
                  <c:v>1711.37</c:v>
                </c:pt>
                <c:pt idx="14770">
                  <c:v>3220.56</c:v>
                </c:pt>
                <c:pt idx="14772">
                  <c:v>1210.25</c:v>
                </c:pt>
                <c:pt idx="14773">
                  <c:v>11334.2</c:v>
                </c:pt>
                <c:pt idx="14777">
                  <c:v>2264.98</c:v>
                </c:pt>
                <c:pt idx="14778">
                  <c:v>20295.8</c:v>
                </c:pt>
                <c:pt idx="14781">
                  <c:v>7706.02</c:v>
                </c:pt>
                <c:pt idx="14782">
                  <c:v>970.05600000000004</c:v>
                </c:pt>
                <c:pt idx="14794">
                  <c:v>2464.7800000000002</c:v>
                </c:pt>
                <c:pt idx="14797">
                  <c:v>3835.51</c:v>
                </c:pt>
                <c:pt idx="14799">
                  <c:v>3537.86</c:v>
                </c:pt>
                <c:pt idx="14803">
                  <c:v>3084.05</c:v>
                </c:pt>
                <c:pt idx="14808">
                  <c:v>3397.03</c:v>
                </c:pt>
                <c:pt idx="14810">
                  <c:v>3255.77</c:v>
                </c:pt>
                <c:pt idx="14813">
                  <c:v>4300.13</c:v>
                </c:pt>
                <c:pt idx="14818">
                  <c:v>6540.26</c:v>
                </c:pt>
                <c:pt idx="14827">
                  <c:v>4558.25</c:v>
                </c:pt>
                <c:pt idx="14828">
                  <c:v>3602.02</c:v>
                </c:pt>
                <c:pt idx="14833">
                  <c:v>1488.02</c:v>
                </c:pt>
                <c:pt idx="14834">
                  <c:v>4938.62</c:v>
                </c:pt>
                <c:pt idx="14838">
                  <c:v>4060.8</c:v>
                </c:pt>
                <c:pt idx="14840">
                  <c:v>2586.6</c:v>
                </c:pt>
                <c:pt idx="14841">
                  <c:v>1896.7</c:v>
                </c:pt>
                <c:pt idx="14850">
                  <c:v>2707.99</c:v>
                </c:pt>
                <c:pt idx="14857">
                  <c:v>2722.9</c:v>
                </c:pt>
                <c:pt idx="14859">
                  <c:v>3024.22</c:v>
                </c:pt>
                <c:pt idx="14867">
                  <c:v>3075.41</c:v>
                </c:pt>
                <c:pt idx="14870">
                  <c:v>3384.07</c:v>
                </c:pt>
                <c:pt idx="14871">
                  <c:v>11556.2</c:v>
                </c:pt>
                <c:pt idx="14872">
                  <c:v>2339.5</c:v>
                </c:pt>
                <c:pt idx="14876">
                  <c:v>28383.7</c:v>
                </c:pt>
                <c:pt idx="14879">
                  <c:v>5458.32</c:v>
                </c:pt>
                <c:pt idx="14884">
                  <c:v>5054.83</c:v>
                </c:pt>
                <c:pt idx="14888">
                  <c:v>5476.9</c:v>
                </c:pt>
                <c:pt idx="14889">
                  <c:v>2892.02</c:v>
                </c:pt>
                <c:pt idx="14892">
                  <c:v>3168.72</c:v>
                </c:pt>
                <c:pt idx="14895">
                  <c:v>5842.15</c:v>
                </c:pt>
                <c:pt idx="14897">
                  <c:v>3374.35</c:v>
                </c:pt>
                <c:pt idx="14904">
                  <c:v>5938.06</c:v>
                </c:pt>
                <c:pt idx="14908">
                  <c:v>134.78399999999999</c:v>
                </c:pt>
                <c:pt idx="14909">
                  <c:v>2957.69</c:v>
                </c:pt>
                <c:pt idx="14913">
                  <c:v>542.16</c:v>
                </c:pt>
                <c:pt idx="14919">
                  <c:v>5848.2</c:v>
                </c:pt>
                <c:pt idx="14921">
                  <c:v>3737.45</c:v>
                </c:pt>
                <c:pt idx="14926">
                  <c:v>2870.86</c:v>
                </c:pt>
                <c:pt idx="14927">
                  <c:v>1334.66</c:v>
                </c:pt>
                <c:pt idx="14931">
                  <c:v>2985.77</c:v>
                </c:pt>
                <c:pt idx="14950">
                  <c:v>4573.1499999999996</c:v>
                </c:pt>
                <c:pt idx="14952">
                  <c:v>5090.8999999999996</c:v>
                </c:pt>
                <c:pt idx="14955">
                  <c:v>5257.66</c:v>
                </c:pt>
                <c:pt idx="14960">
                  <c:v>3306.53</c:v>
                </c:pt>
                <c:pt idx="14961">
                  <c:v>1328.18</c:v>
                </c:pt>
                <c:pt idx="14962">
                  <c:v>6189.48</c:v>
                </c:pt>
                <c:pt idx="14968">
                  <c:v>854.28</c:v>
                </c:pt>
                <c:pt idx="14969">
                  <c:v>3800.74</c:v>
                </c:pt>
                <c:pt idx="14970">
                  <c:v>5695.27</c:v>
                </c:pt>
                <c:pt idx="14976">
                  <c:v>1887.62</c:v>
                </c:pt>
                <c:pt idx="14978">
                  <c:v>3732.7</c:v>
                </c:pt>
                <c:pt idx="14980">
                  <c:v>373.89600000000002</c:v>
                </c:pt>
                <c:pt idx="14982">
                  <c:v>2518.34</c:v>
                </c:pt>
                <c:pt idx="14985">
                  <c:v>5867.86</c:v>
                </c:pt>
                <c:pt idx="14988">
                  <c:v>1257.3399999999999</c:v>
                </c:pt>
                <c:pt idx="14989">
                  <c:v>3503.09</c:v>
                </c:pt>
                <c:pt idx="14992">
                  <c:v>2534.11</c:v>
                </c:pt>
                <c:pt idx="14997">
                  <c:v>8016.62</c:v>
                </c:pt>
                <c:pt idx="15003">
                  <c:v>186.40799999999999</c:v>
                </c:pt>
                <c:pt idx="15005">
                  <c:v>4050.86</c:v>
                </c:pt>
                <c:pt idx="15018">
                  <c:v>1562.33</c:v>
                </c:pt>
                <c:pt idx="15022">
                  <c:v>1544.83</c:v>
                </c:pt>
                <c:pt idx="15028">
                  <c:v>861.19200000000001</c:v>
                </c:pt>
                <c:pt idx="15030">
                  <c:v>5191.78</c:v>
                </c:pt>
                <c:pt idx="15035">
                  <c:v>978.48</c:v>
                </c:pt>
                <c:pt idx="15037">
                  <c:v>3099.82</c:v>
                </c:pt>
                <c:pt idx="15040">
                  <c:v>3648.46</c:v>
                </c:pt>
                <c:pt idx="15042">
                  <c:v>4607.93</c:v>
                </c:pt>
                <c:pt idx="15044">
                  <c:v>5964.19</c:v>
                </c:pt>
                <c:pt idx="15045">
                  <c:v>4082.62</c:v>
                </c:pt>
                <c:pt idx="15046">
                  <c:v>22160.3</c:v>
                </c:pt>
                <c:pt idx="15048">
                  <c:v>1683.29</c:v>
                </c:pt>
                <c:pt idx="15051">
                  <c:v>99.144000000000005</c:v>
                </c:pt>
                <c:pt idx="15052">
                  <c:v>507.6</c:v>
                </c:pt>
                <c:pt idx="15053">
                  <c:v>665.28</c:v>
                </c:pt>
                <c:pt idx="15065">
                  <c:v>3559.46</c:v>
                </c:pt>
                <c:pt idx="15067">
                  <c:v>2935.87</c:v>
                </c:pt>
                <c:pt idx="15073">
                  <c:v>819.93600000000004</c:v>
                </c:pt>
                <c:pt idx="15077">
                  <c:v>2280.96</c:v>
                </c:pt>
                <c:pt idx="15080">
                  <c:v>4033.15</c:v>
                </c:pt>
                <c:pt idx="15081">
                  <c:v>1176.98</c:v>
                </c:pt>
                <c:pt idx="15083">
                  <c:v>5031.9399999999996</c:v>
                </c:pt>
                <c:pt idx="15089">
                  <c:v>3891.89</c:v>
                </c:pt>
                <c:pt idx="15093">
                  <c:v>3905.5</c:v>
                </c:pt>
                <c:pt idx="15094">
                  <c:v>4091.04</c:v>
                </c:pt>
                <c:pt idx="15096">
                  <c:v>1303.78</c:v>
                </c:pt>
                <c:pt idx="15098">
                  <c:v>1084.97</c:v>
                </c:pt>
                <c:pt idx="15100">
                  <c:v>4025.81</c:v>
                </c:pt>
                <c:pt idx="15123">
                  <c:v>706.10400000000004</c:v>
                </c:pt>
                <c:pt idx="15124">
                  <c:v>4093.63</c:v>
                </c:pt>
                <c:pt idx="15125">
                  <c:v>8704.15</c:v>
                </c:pt>
                <c:pt idx="15127">
                  <c:v>601.55999999999995</c:v>
                </c:pt>
                <c:pt idx="15136">
                  <c:v>2934.36</c:v>
                </c:pt>
                <c:pt idx="15141">
                  <c:v>3114.29</c:v>
                </c:pt>
                <c:pt idx="15142">
                  <c:v>4192.13</c:v>
                </c:pt>
                <c:pt idx="15149">
                  <c:v>5119.8500000000004</c:v>
                </c:pt>
                <c:pt idx="15155">
                  <c:v>3757.1</c:v>
                </c:pt>
                <c:pt idx="15156">
                  <c:v>6159.46</c:v>
                </c:pt>
                <c:pt idx="15159">
                  <c:v>540.43200000000002</c:v>
                </c:pt>
                <c:pt idx="15160">
                  <c:v>3538.94</c:v>
                </c:pt>
                <c:pt idx="15168">
                  <c:v>3578.69</c:v>
                </c:pt>
                <c:pt idx="15175">
                  <c:v>3406.75</c:v>
                </c:pt>
                <c:pt idx="15180">
                  <c:v>29943.4</c:v>
                </c:pt>
                <c:pt idx="15187">
                  <c:v>5298.7</c:v>
                </c:pt>
                <c:pt idx="15189">
                  <c:v>2706.48</c:v>
                </c:pt>
                <c:pt idx="15190">
                  <c:v>4314.17</c:v>
                </c:pt>
                <c:pt idx="15193">
                  <c:v>4926.3100000000004</c:v>
                </c:pt>
                <c:pt idx="15194">
                  <c:v>6177.38</c:v>
                </c:pt>
                <c:pt idx="15195">
                  <c:v>2669.76</c:v>
                </c:pt>
                <c:pt idx="15197">
                  <c:v>6729.26</c:v>
                </c:pt>
                <c:pt idx="15199">
                  <c:v>4066.42</c:v>
                </c:pt>
                <c:pt idx="15208">
                  <c:v>2746.87</c:v>
                </c:pt>
                <c:pt idx="15210">
                  <c:v>731.80799999999999</c:v>
                </c:pt>
                <c:pt idx="15211">
                  <c:v>3887.57</c:v>
                </c:pt>
                <c:pt idx="15214">
                  <c:v>6647.4</c:v>
                </c:pt>
                <c:pt idx="15215">
                  <c:v>2022.41</c:v>
                </c:pt>
                <c:pt idx="15229">
                  <c:v>6166.37</c:v>
                </c:pt>
                <c:pt idx="15235">
                  <c:v>5792.69</c:v>
                </c:pt>
                <c:pt idx="15237">
                  <c:v>5675.4</c:v>
                </c:pt>
                <c:pt idx="15241">
                  <c:v>4113.9399999999996</c:v>
                </c:pt>
                <c:pt idx="15247">
                  <c:v>3186.86</c:v>
                </c:pt>
                <c:pt idx="15252">
                  <c:v>6589.94</c:v>
                </c:pt>
                <c:pt idx="15253">
                  <c:v>3682.15</c:v>
                </c:pt>
                <c:pt idx="15255">
                  <c:v>4226.04</c:v>
                </c:pt>
                <c:pt idx="15258">
                  <c:v>13250.1</c:v>
                </c:pt>
                <c:pt idx="15259">
                  <c:v>635.47199999999998</c:v>
                </c:pt>
                <c:pt idx="15266">
                  <c:v>4855.68</c:v>
                </c:pt>
                <c:pt idx="15272">
                  <c:v>2696.54</c:v>
                </c:pt>
                <c:pt idx="15276">
                  <c:v>1710.72</c:v>
                </c:pt>
                <c:pt idx="15279">
                  <c:v>223.99199999999999</c:v>
                </c:pt>
                <c:pt idx="15282">
                  <c:v>4552.2</c:v>
                </c:pt>
                <c:pt idx="15286">
                  <c:v>7089.12</c:v>
                </c:pt>
                <c:pt idx="15294">
                  <c:v>1897.78</c:v>
                </c:pt>
                <c:pt idx="15300">
                  <c:v>5255.06</c:v>
                </c:pt>
                <c:pt idx="15313">
                  <c:v>3167.42</c:v>
                </c:pt>
                <c:pt idx="15317">
                  <c:v>3467.02</c:v>
                </c:pt>
                <c:pt idx="15322">
                  <c:v>2512.5100000000002</c:v>
                </c:pt>
                <c:pt idx="15330">
                  <c:v>941.32799999999997</c:v>
                </c:pt>
                <c:pt idx="15336">
                  <c:v>4575.1000000000004</c:v>
                </c:pt>
                <c:pt idx="15340">
                  <c:v>4796.28</c:v>
                </c:pt>
                <c:pt idx="15341">
                  <c:v>4592.38</c:v>
                </c:pt>
                <c:pt idx="15343">
                  <c:v>3053.38</c:v>
                </c:pt>
                <c:pt idx="15344">
                  <c:v>147.96</c:v>
                </c:pt>
                <c:pt idx="15347">
                  <c:v>5292</c:v>
                </c:pt>
                <c:pt idx="15348">
                  <c:v>1105.7</c:v>
                </c:pt>
                <c:pt idx="15356">
                  <c:v>6496.42</c:v>
                </c:pt>
                <c:pt idx="15362">
                  <c:v>1446.77</c:v>
                </c:pt>
                <c:pt idx="15363">
                  <c:v>6176.74</c:v>
                </c:pt>
                <c:pt idx="15365">
                  <c:v>4842.72</c:v>
                </c:pt>
                <c:pt idx="15367">
                  <c:v>2681.21</c:v>
                </c:pt>
                <c:pt idx="15368">
                  <c:v>3538.51</c:v>
                </c:pt>
                <c:pt idx="15372">
                  <c:v>3548.66</c:v>
                </c:pt>
                <c:pt idx="15374">
                  <c:v>699.19200000000001</c:v>
                </c:pt>
                <c:pt idx="15375">
                  <c:v>10958.8</c:v>
                </c:pt>
                <c:pt idx="15377">
                  <c:v>6547.39</c:v>
                </c:pt>
                <c:pt idx="15383">
                  <c:v>2984.04</c:v>
                </c:pt>
                <c:pt idx="15387">
                  <c:v>4630.82</c:v>
                </c:pt>
                <c:pt idx="15390">
                  <c:v>1632.1</c:v>
                </c:pt>
                <c:pt idx="15394">
                  <c:v>5202.79</c:v>
                </c:pt>
                <c:pt idx="15402">
                  <c:v>4143.1000000000004</c:v>
                </c:pt>
                <c:pt idx="15406">
                  <c:v>2194.7800000000002</c:v>
                </c:pt>
                <c:pt idx="15407">
                  <c:v>1805.33</c:v>
                </c:pt>
                <c:pt idx="15408">
                  <c:v>2693.74</c:v>
                </c:pt>
                <c:pt idx="15409">
                  <c:v>4739.47</c:v>
                </c:pt>
                <c:pt idx="15415">
                  <c:v>6141.96</c:v>
                </c:pt>
                <c:pt idx="15417">
                  <c:v>12965</c:v>
                </c:pt>
                <c:pt idx="15418">
                  <c:v>1886.76</c:v>
                </c:pt>
                <c:pt idx="15424">
                  <c:v>6537.46</c:v>
                </c:pt>
                <c:pt idx="15427">
                  <c:v>676.51199999999994</c:v>
                </c:pt>
                <c:pt idx="15435">
                  <c:v>4277.2299999999996</c:v>
                </c:pt>
                <c:pt idx="15437">
                  <c:v>4442.6899999999996</c:v>
                </c:pt>
                <c:pt idx="15447">
                  <c:v>1274.4000000000001</c:v>
                </c:pt>
                <c:pt idx="15454">
                  <c:v>5119.2</c:v>
                </c:pt>
                <c:pt idx="15461">
                  <c:v>4090.18</c:v>
                </c:pt>
                <c:pt idx="15469">
                  <c:v>5735.02</c:v>
                </c:pt>
                <c:pt idx="15472">
                  <c:v>6634.22</c:v>
                </c:pt>
                <c:pt idx="15475">
                  <c:v>9086.0400000000009</c:v>
                </c:pt>
                <c:pt idx="15476">
                  <c:v>2144.02</c:v>
                </c:pt>
                <c:pt idx="15479">
                  <c:v>10086.299999999999</c:v>
                </c:pt>
                <c:pt idx="15481">
                  <c:v>2900.23</c:v>
                </c:pt>
                <c:pt idx="15485">
                  <c:v>3488.83</c:v>
                </c:pt>
                <c:pt idx="15487">
                  <c:v>6675.26</c:v>
                </c:pt>
                <c:pt idx="15489">
                  <c:v>5985.79</c:v>
                </c:pt>
                <c:pt idx="15491">
                  <c:v>3616.06</c:v>
                </c:pt>
                <c:pt idx="15493">
                  <c:v>4231.01</c:v>
                </c:pt>
                <c:pt idx="15494">
                  <c:v>3108.02</c:v>
                </c:pt>
                <c:pt idx="15496">
                  <c:v>617.976</c:v>
                </c:pt>
                <c:pt idx="15499">
                  <c:v>424.00799999999998</c:v>
                </c:pt>
                <c:pt idx="15500">
                  <c:v>5232.6000000000004</c:v>
                </c:pt>
                <c:pt idx="15508">
                  <c:v>5783.18</c:v>
                </c:pt>
                <c:pt idx="15518">
                  <c:v>3388.39</c:v>
                </c:pt>
                <c:pt idx="15522">
                  <c:v>433.94400000000002</c:v>
                </c:pt>
                <c:pt idx="15523">
                  <c:v>5434.78</c:v>
                </c:pt>
                <c:pt idx="15524">
                  <c:v>5569.13</c:v>
                </c:pt>
                <c:pt idx="15528">
                  <c:v>3794.26</c:v>
                </c:pt>
                <c:pt idx="15529">
                  <c:v>560.73599999999999</c:v>
                </c:pt>
                <c:pt idx="15534">
                  <c:v>2728.3</c:v>
                </c:pt>
                <c:pt idx="15546">
                  <c:v>4729.1000000000004</c:v>
                </c:pt>
                <c:pt idx="15550">
                  <c:v>7891.56</c:v>
                </c:pt>
                <c:pt idx="15553">
                  <c:v>2116.58</c:v>
                </c:pt>
                <c:pt idx="15554">
                  <c:v>603.28800000000001</c:v>
                </c:pt>
                <c:pt idx="15557">
                  <c:v>4965.41</c:v>
                </c:pt>
                <c:pt idx="15561">
                  <c:v>4756.32</c:v>
                </c:pt>
                <c:pt idx="15571">
                  <c:v>3866.62</c:v>
                </c:pt>
                <c:pt idx="15578">
                  <c:v>5034.96</c:v>
                </c:pt>
                <c:pt idx="15580">
                  <c:v>11143</c:v>
                </c:pt>
                <c:pt idx="15582">
                  <c:v>7132.32</c:v>
                </c:pt>
                <c:pt idx="15583">
                  <c:v>4333.6099999999997</c:v>
                </c:pt>
                <c:pt idx="15587">
                  <c:v>611.28</c:v>
                </c:pt>
                <c:pt idx="15590">
                  <c:v>4594.32</c:v>
                </c:pt>
                <c:pt idx="15593">
                  <c:v>4015.66</c:v>
                </c:pt>
                <c:pt idx="15600">
                  <c:v>7814.88</c:v>
                </c:pt>
                <c:pt idx="15601">
                  <c:v>1647</c:v>
                </c:pt>
                <c:pt idx="15607">
                  <c:v>23509.4</c:v>
                </c:pt>
                <c:pt idx="15610">
                  <c:v>392.25599999999997</c:v>
                </c:pt>
                <c:pt idx="15612">
                  <c:v>5513.4</c:v>
                </c:pt>
                <c:pt idx="15613">
                  <c:v>3821.04</c:v>
                </c:pt>
                <c:pt idx="15621">
                  <c:v>3028.1</c:v>
                </c:pt>
                <c:pt idx="15623">
                  <c:v>5281.85</c:v>
                </c:pt>
                <c:pt idx="15624">
                  <c:v>416.88</c:v>
                </c:pt>
                <c:pt idx="15627">
                  <c:v>9401.18</c:v>
                </c:pt>
                <c:pt idx="15628">
                  <c:v>7062.98</c:v>
                </c:pt>
                <c:pt idx="15630">
                  <c:v>4520.0200000000004</c:v>
                </c:pt>
                <c:pt idx="15639">
                  <c:v>1394.28</c:v>
                </c:pt>
                <c:pt idx="15640">
                  <c:v>5310.58</c:v>
                </c:pt>
                <c:pt idx="15642">
                  <c:v>1635.98</c:v>
                </c:pt>
                <c:pt idx="15646">
                  <c:v>3038.04</c:v>
                </c:pt>
                <c:pt idx="15647">
                  <c:v>6275.02</c:v>
                </c:pt>
                <c:pt idx="15648">
                  <c:v>6237.86</c:v>
                </c:pt>
                <c:pt idx="15649">
                  <c:v>3961.66</c:v>
                </c:pt>
                <c:pt idx="15661">
                  <c:v>1294.7</c:v>
                </c:pt>
                <c:pt idx="15662">
                  <c:v>5998.1</c:v>
                </c:pt>
                <c:pt idx="15665">
                  <c:v>305.64</c:v>
                </c:pt>
                <c:pt idx="15668">
                  <c:v>4136.62</c:v>
                </c:pt>
                <c:pt idx="15670">
                  <c:v>4704.4799999999996</c:v>
                </c:pt>
                <c:pt idx="15671">
                  <c:v>4179.82</c:v>
                </c:pt>
                <c:pt idx="15672">
                  <c:v>3097.44</c:v>
                </c:pt>
                <c:pt idx="15675">
                  <c:v>3505.25</c:v>
                </c:pt>
                <c:pt idx="15683">
                  <c:v>60.048000000000002</c:v>
                </c:pt>
                <c:pt idx="15685">
                  <c:v>4527.1400000000003</c:v>
                </c:pt>
                <c:pt idx="15690">
                  <c:v>8519.9</c:v>
                </c:pt>
                <c:pt idx="15692">
                  <c:v>2663.28</c:v>
                </c:pt>
                <c:pt idx="15697">
                  <c:v>393.12</c:v>
                </c:pt>
                <c:pt idx="15709">
                  <c:v>822.52800000000002</c:v>
                </c:pt>
                <c:pt idx="15710">
                  <c:v>9184.32</c:v>
                </c:pt>
                <c:pt idx="15711">
                  <c:v>848.01599999999996</c:v>
                </c:pt>
                <c:pt idx="15712">
                  <c:v>4828.8999999999996</c:v>
                </c:pt>
                <c:pt idx="15717">
                  <c:v>1559.52</c:v>
                </c:pt>
                <c:pt idx="15722">
                  <c:v>636.12</c:v>
                </c:pt>
                <c:pt idx="15725">
                  <c:v>1334.88</c:v>
                </c:pt>
                <c:pt idx="15740">
                  <c:v>1274.18</c:v>
                </c:pt>
                <c:pt idx="15741">
                  <c:v>3772.22</c:v>
                </c:pt>
                <c:pt idx="15753">
                  <c:v>2778.41</c:v>
                </c:pt>
                <c:pt idx="15754">
                  <c:v>1381.75</c:v>
                </c:pt>
                <c:pt idx="15758">
                  <c:v>2315.09</c:v>
                </c:pt>
                <c:pt idx="15763">
                  <c:v>5109.26</c:v>
                </c:pt>
                <c:pt idx="15768">
                  <c:v>1035.07</c:v>
                </c:pt>
                <c:pt idx="15770">
                  <c:v>6506.78</c:v>
                </c:pt>
                <c:pt idx="15772">
                  <c:v>6680.66</c:v>
                </c:pt>
                <c:pt idx="15774">
                  <c:v>4526.71</c:v>
                </c:pt>
                <c:pt idx="15776">
                  <c:v>514.08000000000004</c:v>
                </c:pt>
                <c:pt idx="15785">
                  <c:v>7596.29</c:v>
                </c:pt>
                <c:pt idx="15797">
                  <c:v>7729.34</c:v>
                </c:pt>
                <c:pt idx="15803">
                  <c:v>3811.75</c:v>
                </c:pt>
                <c:pt idx="15805">
                  <c:v>5459.4</c:v>
                </c:pt>
                <c:pt idx="15806">
                  <c:v>8756.2099999999991</c:v>
                </c:pt>
                <c:pt idx="15808">
                  <c:v>4016.52</c:v>
                </c:pt>
                <c:pt idx="15810">
                  <c:v>3894.48</c:v>
                </c:pt>
                <c:pt idx="15811">
                  <c:v>7254.14</c:v>
                </c:pt>
                <c:pt idx="15813">
                  <c:v>7585.06</c:v>
                </c:pt>
                <c:pt idx="15824">
                  <c:v>6147.58</c:v>
                </c:pt>
                <c:pt idx="15828">
                  <c:v>4562.1400000000003</c:v>
                </c:pt>
                <c:pt idx="15829">
                  <c:v>2257.85</c:v>
                </c:pt>
                <c:pt idx="15830">
                  <c:v>3039.77</c:v>
                </c:pt>
                <c:pt idx="15833">
                  <c:v>272.80799999999999</c:v>
                </c:pt>
                <c:pt idx="15847">
                  <c:v>1797.98</c:v>
                </c:pt>
                <c:pt idx="15851">
                  <c:v>9058.61</c:v>
                </c:pt>
                <c:pt idx="15852">
                  <c:v>6681.1</c:v>
                </c:pt>
                <c:pt idx="15854">
                  <c:v>4142.88</c:v>
                </c:pt>
                <c:pt idx="15856">
                  <c:v>101.736</c:v>
                </c:pt>
                <c:pt idx="15857">
                  <c:v>6837.7</c:v>
                </c:pt>
                <c:pt idx="15859">
                  <c:v>13683.2</c:v>
                </c:pt>
                <c:pt idx="15862">
                  <c:v>2356.34</c:v>
                </c:pt>
                <c:pt idx="15863">
                  <c:v>4032.72</c:v>
                </c:pt>
                <c:pt idx="15865">
                  <c:v>1235.95</c:v>
                </c:pt>
                <c:pt idx="15871">
                  <c:v>8479.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6B8-4AC3-B3A4-179EA235EF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6375552"/>
        <c:axId val="836376536"/>
      </c:scatterChart>
      <c:valAx>
        <c:axId val="836375552"/>
        <c:scaling>
          <c:orientation val="minMax"/>
        </c:scaling>
        <c:delete val="1"/>
        <c:axPos val="b"/>
        <c:majorTickMark val="none"/>
        <c:minorTickMark val="none"/>
        <c:tickLblPos val="nextTo"/>
        <c:crossAx val="836376536"/>
        <c:crosses val="autoZero"/>
        <c:crossBetween val="midCat"/>
      </c:valAx>
      <c:valAx>
        <c:axId val="836376536"/>
        <c:scaling>
          <c:orientation val="minMax"/>
          <c:max val="3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363755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ull root volumes'!$F$4</c:f>
              <c:strCache>
                <c:ptCount val="1"/>
                <c:pt idx="0">
                  <c:v>average 100 to 500 µ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D6B-492D-A6BD-11BBFA18D0C8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D6B-492D-A6BD-11BBFA18D0C8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D6B-492D-A6BD-11BBFA18D0C8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D6B-492D-A6BD-11BBFA18D0C8}"/>
              </c:ext>
            </c:extLst>
          </c:dPt>
          <c:errBars>
            <c:errBarType val="both"/>
            <c:errValType val="cust"/>
            <c:noEndCap val="0"/>
            <c:plus>
              <c:numRef>
                <c:f>'full root volumes'!$G$7:$J$7</c:f>
                <c:numCache>
                  <c:formatCode>General</c:formatCode>
                  <c:ptCount val="4"/>
                  <c:pt idx="0">
                    <c:v>16.258065520732117</c:v>
                  </c:pt>
                  <c:pt idx="1">
                    <c:v>16.120627802491018</c:v>
                  </c:pt>
                  <c:pt idx="2">
                    <c:v>21.703489719182663</c:v>
                  </c:pt>
                  <c:pt idx="3">
                    <c:v>23.144938280436666</c:v>
                  </c:pt>
                </c:numCache>
              </c:numRef>
            </c:plus>
            <c:minus>
              <c:numRef>
                <c:f>'full root volumes'!$G$7:$J$7</c:f>
                <c:numCache>
                  <c:formatCode>General</c:formatCode>
                  <c:ptCount val="4"/>
                  <c:pt idx="0">
                    <c:v>16.258065520732117</c:v>
                  </c:pt>
                  <c:pt idx="1">
                    <c:v>16.120627802491018</c:v>
                  </c:pt>
                  <c:pt idx="2">
                    <c:v>21.703489719182663</c:v>
                  </c:pt>
                  <c:pt idx="3">
                    <c:v>23.1449382804366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ull root volumes'!$G$3:$J$3</c:f>
              <c:strCache>
                <c:ptCount val="4"/>
                <c:pt idx="0">
                  <c:v>wt72</c:v>
                </c:pt>
                <c:pt idx="1">
                  <c:v>wt71</c:v>
                </c:pt>
                <c:pt idx="2">
                  <c:v>aux1 01</c:v>
                </c:pt>
                <c:pt idx="3">
                  <c:v>aux1 02</c:v>
                </c:pt>
              </c:strCache>
            </c:strRef>
          </c:cat>
          <c:val>
            <c:numRef>
              <c:f>'full root volumes'!$G$4:$J$4</c:f>
              <c:numCache>
                <c:formatCode>General</c:formatCode>
                <c:ptCount val="4"/>
                <c:pt idx="0">
                  <c:v>1118.6215016891867</c:v>
                </c:pt>
                <c:pt idx="1">
                  <c:v>1108.4964382470123</c:v>
                </c:pt>
                <c:pt idx="2">
                  <c:v>1953.3702500000009</c:v>
                </c:pt>
                <c:pt idx="3">
                  <c:v>1555.47412159814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D6B-492D-A6BD-11BBFA18D0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1"/>
        <c:overlap val="-27"/>
        <c:axId val="818527664"/>
        <c:axId val="818530616"/>
      </c:barChart>
      <c:catAx>
        <c:axId val="818527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18530616"/>
        <c:crosses val="autoZero"/>
        <c:auto val="1"/>
        <c:lblAlgn val="ctr"/>
        <c:lblOffset val="100"/>
        <c:noMultiLvlLbl val="0"/>
      </c:catAx>
      <c:valAx>
        <c:axId val="8185306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18527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accent1">
        <a:lumMod val="40000"/>
        <a:lumOff val="60000"/>
      </a:schemeClr>
    </a:solidFill>
    <a:ln w="12700">
      <a:solidFill>
        <a:srgbClr val="0070C0"/>
      </a:solidFill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Epidermis file sorting'!$AD$2:$AD$204</c:f>
              <c:numCache>
                <c:formatCode>General</c:formatCode>
                <c:ptCount val="203"/>
                <c:pt idx="0">
                  <c:v>10.547799999999999</c:v>
                </c:pt>
                <c:pt idx="1">
                  <c:v>22.392900000000004</c:v>
                </c:pt>
                <c:pt idx="2">
                  <c:v>19.001200000000004</c:v>
                </c:pt>
                <c:pt idx="3">
                  <c:v>22.803799999999995</c:v>
                </c:pt>
                <c:pt idx="4">
                  <c:v>15.084000000000003</c:v>
                </c:pt>
                <c:pt idx="5">
                  <c:v>9.8799999999999955</c:v>
                </c:pt>
                <c:pt idx="6">
                  <c:v>8.1570000000000107</c:v>
                </c:pt>
                <c:pt idx="7">
                  <c:v>9.8839999999999861</c:v>
                </c:pt>
                <c:pt idx="8">
                  <c:v>9.75</c:v>
                </c:pt>
                <c:pt idx="9">
                  <c:v>9.1520000000000152</c:v>
                </c:pt>
                <c:pt idx="10">
                  <c:v>8.1839999999999975</c:v>
                </c:pt>
                <c:pt idx="11">
                  <c:v>7.4659999999999798</c:v>
                </c:pt>
                <c:pt idx="12">
                  <c:v>8.2060000000000173</c:v>
                </c:pt>
                <c:pt idx="13">
                  <c:v>9.3199999999999932</c:v>
                </c:pt>
                <c:pt idx="14">
                  <c:v>8.7940000000000111</c:v>
                </c:pt>
                <c:pt idx="15">
                  <c:v>7.2719999999999914</c:v>
                </c:pt>
                <c:pt idx="16">
                  <c:v>6.6869999999999834</c:v>
                </c:pt>
                <c:pt idx="17">
                  <c:v>6.1570000000000107</c:v>
                </c:pt>
                <c:pt idx="18">
                  <c:v>7.0929999999999893</c:v>
                </c:pt>
                <c:pt idx="19">
                  <c:v>7.896000000000015</c:v>
                </c:pt>
                <c:pt idx="20">
                  <c:v>7.7820000000000107</c:v>
                </c:pt>
                <c:pt idx="21">
                  <c:v>8.0499999999999829</c:v>
                </c:pt>
                <c:pt idx="22">
                  <c:v>10.822000000000031</c:v>
                </c:pt>
                <c:pt idx="23">
                  <c:v>9.7649999999999864</c:v>
                </c:pt>
                <c:pt idx="24">
                  <c:v>6.1479999999999677</c:v>
                </c:pt>
                <c:pt idx="25">
                  <c:v>9.4279999999999973</c:v>
                </c:pt>
                <c:pt idx="26">
                  <c:v>10.311000000000035</c:v>
                </c:pt>
                <c:pt idx="27">
                  <c:v>7.2849999999999682</c:v>
                </c:pt>
                <c:pt idx="28">
                  <c:v>7.5880000000000223</c:v>
                </c:pt>
                <c:pt idx="29">
                  <c:v>7.8829999999999814</c:v>
                </c:pt>
                <c:pt idx="30">
                  <c:v>6.9360000000000355</c:v>
                </c:pt>
                <c:pt idx="31">
                  <c:v>7.2589999999999577</c:v>
                </c:pt>
                <c:pt idx="32">
                  <c:v>8.7379999999999995</c:v>
                </c:pt>
                <c:pt idx="33">
                  <c:v>8.7040000000000077</c:v>
                </c:pt>
                <c:pt idx="34">
                  <c:v>8.3210000000000264</c:v>
                </c:pt>
                <c:pt idx="35">
                  <c:v>8.5179999999999723</c:v>
                </c:pt>
                <c:pt idx="36">
                  <c:v>8.7800000000000296</c:v>
                </c:pt>
                <c:pt idx="37">
                  <c:v>8.1239999999999668</c:v>
                </c:pt>
                <c:pt idx="38">
                  <c:v>8.9209999999999923</c:v>
                </c:pt>
                <c:pt idx="39">
                  <c:v>8.7180000000000177</c:v>
                </c:pt>
                <c:pt idx="40">
                  <c:v>9.7610000000000241</c:v>
                </c:pt>
                <c:pt idx="41">
                  <c:v>10.495000000000005</c:v>
                </c:pt>
                <c:pt idx="42">
                  <c:v>10.399999999999977</c:v>
                </c:pt>
                <c:pt idx="43">
                  <c:v>8.0559999999999832</c:v>
                </c:pt>
                <c:pt idx="44">
                  <c:v>6.3170000000000073</c:v>
                </c:pt>
                <c:pt idx="45">
                  <c:v>8.3240000000000123</c:v>
                </c:pt>
                <c:pt idx="46">
                  <c:v>10.627999999999986</c:v>
                </c:pt>
                <c:pt idx="47">
                  <c:v>10.766999999999996</c:v>
                </c:pt>
                <c:pt idx="48">
                  <c:v>10.545000000000016</c:v>
                </c:pt>
                <c:pt idx="49">
                  <c:v>11.805000000000007</c:v>
                </c:pt>
                <c:pt idx="50">
                  <c:v>12.634999999999991</c:v>
                </c:pt>
                <c:pt idx="51">
                  <c:v>13.985000000000014</c:v>
                </c:pt>
                <c:pt idx="52">
                  <c:v>12.326999999999998</c:v>
                </c:pt>
                <c:pt idx="53">
                  <c:v>19.277000000000044</c:v>
                </c:pt>
                <c:pt idx="54">
                  <c:v>13.464999999999918</c:v>
                </c:pt>
                <c:pt idx="55">
                  <c:v>15.519999999999982</c:v>
                </c:pt>
                <c:pt idx="56">
                  <c:v>19.036000000000058</c:v>
                </c:pt>
                <c:pt idx="57">
                  <c:v>20.739000000000033</c:v>
                </c:pt>
                <c:pt idx="58">
                  <c:v>16.505999999999972</c:v>
                </c:pt>
                <c:pt idx="59">
                  <c:v>12.212999999999965</c:v>
                </c:pt>
                <c:pt idx="60">
                  <c:v>19.277000000000044</c:v>
                </c:pt>
                <c:pt idx="61">
                  <c:v>21.920999999999935</c:v>
                </c:pt>
                <c:pt idx="62">
                  <c:v>18.158999999999992</c:v>
                </c:pt>
                <c:pt idx="63">
                  <c:v>21.759000000000015</c:v>
                </c:pt>
                <c:pt idx="64">
                  <c:v>28.215000000000032</c:v>
                </c:pt>
                <c:pt idx="65">
                  <c:v>25.495999999999981</c:v>
                </c:pt>
                <c:pt idx="66">
                  <c:v>28.008000000000038</c:v>
                </c:pt>
                <c:pt idx="67">
                  <c:v>13.1371</c:v>
                </c:pt>
                <c:pt idx="68">
                  <c:v>16.101799999999997</c:v>
                </c:pt>
                <c:pt idx="69">
                  <c:v>16.112200000000001</c:v>
                </c:pt>
                <c:pt idx="70">
                  <c:v>9.3307999999999964</c:v>
                </c:pt>
                <c:pt idx="71">
                  <c:v>9.7606999999999999</c:v>
                </c:pt>
                <c:pt idx="72">
                  <c:v>9.2075000000000102</c:v>
                </c:pt>
                <c:pt idx="73">
                  <c:v>7.5480000000000018</c:v>
                </c:pt>
                <c:pt idx="74">
                  <c:v>9.1839999999999975</c:v>
                </c:pt>
                <c:pt idx="75">
                  <c:v>8.7779999999999916</c:v>
                </c:pt>
                <c:pt idx="76">
                  <c:v>6.7090000000000032</c:v>
                </c:pt>
                <c:pt idx="77">
                  <c:v>4.6639999999999873</c:v>
                </c:pt>
                <c:pt idx="78">
                  <c:v>6.15300000000002</c:v>
                </c:pt>
                <c:pt idx="79">
                  <c:v>6.0060000000000002</c:v>
                </c:pt>
                <c:pt idx="80">
                  <c:v>5.8599999999999852</c:v>
                </c:pt>
                <c:pt idx="81">
                  <c:v>5.6479999999999961</c:v>
                </c:pt>
                <c:pt idx="82">
                  <c:v>7.6220000000000141</c:v>
                </c:pt>
                <c:pt idx="83">
                  <c:v>8.492999999999995</c:v>
                </c:pt>
                <c:pt idx="84">
                  <c:v>5.9710000000000036</c:v>
                </c:pt>
                <c:pt idx="85">
                  <c:v>6.8830000000000098</c:v>
                </c:pt>
                <c:pt idx="86">
                  <c:v>7.3369999999999891</c:v>
                </c:pt>
                <c:pt idx="87">
                  <c:v>7.782999999999987</c:v>
                </c:pt>
                <c:pt idx="88">
                  <c:v>7.632000000000005</c:v>
                </c:pt>
                <c:pt idx="89">
                  <c:v>8.375</c:v>
                </c:pt>
                <c:pt idx="90">
                  <c:v>8.7050000000000125</c:v>
                </c:pt>
                <c:pt idx="91">
                  <c:v>18.342999999999989</c:v>
                </c:pt>
                <c:pt idx="92">
                  <c:v>8.606000000000023</c:v>
                </c:pt>
                <c:pt idx="93">
                  <c:v>7.0319999999999823</c:v>
                </c:pt>
                <c:pt idx="94">
                  <c:v>6.5249999999999773</c:v>
                </c:pt>
                <c:pt idx="95">
                  <c:v>7.0170000000000528</c:v>
                </c:pt>
                <c:pt idx="96">
                  <c:v>7.3619999999999663</c:v>
                </c:pt>
                <c:pt idx="97">
                  <c:v>7.1580000000000155</c:v>
                </c:pt>
                <c:pt idx="98">
                  <c:v>15.896999999999991</c:v>
                </c:pt>
                <c:pt idx="99">
                  <c:v>5.4200000000000159</c:v>
                </c:pt>
                <c:pt idx="100">
                  <c:v>6.4780000000000086</c:v>
                </c:pt>
                <c:pt idx="101">
                  <c:v>7.0079999999999814</c:v>
                </c:pt>
                <c:pt idx="102">
                  <c:v>7.1759999999999877</c:v>
                </c:pt>
                <c:pt idx="103">
                  <c:v>8.0930000000000177</c:v>
                </c:pt>
                <c:pt idx="104">
                  <c:v>8.964999999999975</c:v>
                </c:pt>
                <c:pt idx="105">
                  <c:v>8.3969999999999914</c:v>
                </c:pt>
                <c:pt idx="106">
                  <c:v>8.6570000000000391</c:v>
                </c:pt>
                <c:pt idx="107">
                  <c:v>9.9309999999999832</c:v>
                </c:pt>
                <c:pt idx="108">
                  <c:v>9.5380000000000109</c:v>
                </c:pt>
                <c:pt idx="109">
                  <c:v>8.3139999999999645</c:v>
                </c:pt>
                <c:pt idx="110">
                  <c:v>8.5160000000000196</c:v>
                </c:pt>
                <c:pt idx="111">
                  <c:v>8.9119999999999777</c:v>
                </c:pt>
                <c:pt idx="112">
                  <c:v>9.5330000000000155</c:v>
                </c:pt>
                <c:pt idx="113">
                  <c:v>10.704999999999984</c:v>
                </c:pt>
                <c:pt idx="114">
                  <c:v>11.373000000000047</c:v>
                </c:pt>
                <c:pt idx="115">
                  <c:v>8.8519999999999754</c:v>
                </c:pt>
                <c:pt idx="116">
                  <c:v>7.2139999999999986</c:v>
                </c:pt>
                <c:pt idx="117">
                  <c:v>8.2060000000000173</c:v>
                </c:pt>
                <c:pt idx="118">
                  <c:v>8.5229999999999677</c:v>
                </c:pt>
                <c:pt idx="119">
                  <c:v>9.3170000000000073</c:v>
                </c:pt>
                <c:pt idx="120">
                  <c:v>10.275000000000034</c:v>
                </c:pt>
                <c:pt idx="121">
                  <c:v>13.959000000000003</c:v>
                </c:pt>
                <c:pt idx="122">
                  <c:v>13.90300000000002</c:v>
                </c:pt>
                <c:pt idx="123">
                  <c:v>10.921999999999912</c:v>
                </c:pt>
                <c:pt idx="124">
                  <c:v>15.964000000000055</c:v>
                </c:pt>
                <c:pt idx="125">
                  <c:v>15.503000000000043</c:v>
                </c:pt>
                <c:pt idx="126">
                  <c:v>11.74899999999991</c:v>
                </c:pt>
                <c:pt idx="127">
                  <c:v>16.01400000000001</c:v>
                </c:pt>
                <c:pt idx="128">
                  <c:v>16.079000000000065</c:v>
                </c:pt>
                <c:pt idx="129">
                  <c:v>12.184999999999945</c:v>
                </c:pt>
                <c:pt idx="130">
                  <c:v>15.039999999999964</c:v>
                </c:pt>
                <c:pt idx="131">
                  <c:v>21.110000000000014</c:v>
                </c:pt>
                <c:pt idx="132">
                  <c:v>27.339000000000055</c:v>
                </c:pt>
                <c:pt idx="133">
                  <c:v>24.418000000000006</c:v>
                </c:pt>
                <c:pt idx="134">
                  <c:v>20.011999999999944</c:v>
                </c:pt>
                <c:pt idx="135">
                  <c:v>28.118000000000052</c:v>
                </c:pt>
                <c:pt idx="136">
                  <c:v>42.255999999999972</c:v>
                </c:pt>
                <c:pt idx="138">
                  <c:v>14.176200000000001</c:v>
                </c:pt>
                <c:pt idx="139">
                  <c:v>10.767800000000001</c:v>
                </c:pt>
                <c:pt idx="140">
                  <c:v>12.344699999999996</c:v>
                </c:pt>
                <c:pt idx="141">
                  <c:v>25.825299999999999</c:v>
                </c:pt>
                <c:pt idx="142">
                  <c:v>8.8880000000000052</c:v>
                </c:pt>
                <c:pt idx="143">
                  <c:v>9.1230000000000047</c:v>
                </c:pt>
                <c:pt idx="144">
                  <c:v>10.144999999999996</c:v>
                </c:pt>
                <c:pt idx="145">
                  <c:v>10.697000000000003</c:v>
                </c:pt>
                <c:pt idx="146">
                  <c:v>7.0349999999999966</c:v>
                </c:pt>
                <c:pt idx="147">
                  <c:v>6.4230000000000018</c:v>
                </c:pt>
                <c:pt idx="148">
                  <c:v>6.8069999999999879</c:v>
                </c:pt>
                <c:pt idx="149">
                  <c:v>7.2190000000000225</c:v>
                </c:pt>
                <c:pt idx="150">
                  <c:v>6.9739999999999895</c:v>
                </c:pt>
                <c:pt idx="151">
                  <c:v>7.0349999999999966</c:v>
                </c:pt>
                <c:pt idx="152">
                  <c:v>6.921999999999997</c:v>
                </c:pt>
                <c:pt idx="153">
                  <c:v>8.0939999999999941</c:v>
                </c:pt>
                <c:pt idx="154">
                  <c:v>9.3940000000000055</c:v>
                </c:pt>
                <c:pt idx="155">
                  <c:v>9.4350000000000023</c:v>
                </c:pt>
                <c:pt idx="156">
                  <c:v>8.3149999999999977</c:v>
                </c:pt>
                <c:pt idx="157">
                  <c:v>8.4339999999999975</c:v>
                </c:pt>
                <c:pt idx="158">
                  <c:v>9.1380000000000052</c:v>
                </c:pt>
                <c:pt idx="159">
                  <c:v>14.926999999999992</c:v>
                </c:pt>
                <c:pt idx="160">
                  <c:v>16.632000000000005</c:v>
                </c:pt>
                <c:pt idx="161">
                  <c:v>9.4580000000000268</c:v>
                </c:pt>
                <c:pt idx="162">
                  <c:v>11.593999999999994</c:v>
                </c:pt>
                <c:pt idx="163">
                  <c:v>11.606999999999971</c:v>
                </c:pt>
                <c:pt idx="164">
                  <c:v>9.5760000000000218</c:v>
                </c:pt>
                <c:pt idx="165">
                  <c:v>8.8240000000000123</c:v>
                </c:pt>
                <c:pt idx="166">
                  <c:v>9.2699999999999818</c:v>
                </c:pt>
                <c:pt idx="167">
                  <c:v>10.197999999999979</c:v>
                </c:pt>
                <c:pt idx="168">
                  <c:v>8.3160000000000309</c:v>
                </c:pt>
                <c:pt idx="169">
                  <c:v>7.3580000000000041</c:v>
                </c:pt>
                <c:pt idx="170">
                  <c:v>7.950999999999965</c:v>
                </c:pt>
                <c:pt idx="171">
                  <c:v>9.6659999999999968</c:v>
                </c:pt>
                <c:pt idx="172">
                  <c:v>11.531000000000006</c:v>
                </c:pt>
                <c:pt idx="173">
                  <c:v>12.264999999999986</c:v>
                </c:pt>
                <c:pt idx="174">
                  <c:v>9.5100000000000477</c:v>
                </c:pt>
                <c:pt idx="175">
                  <c:v>9.9499999999999886</c:v>
                </c:pt>
                <c:pt idx="176">
                  <c:v>9.6949999999999932</c:v>
                </c:pt>
                <c:pt idx="177">
                  <c:v>6.7180000000000177</c:v>
                </c:pt>
                <c:pt idx="178">
                  <c:v>6.9669999999999845</c:v>
                </c:pt>
                <c:pt idx="179">
                  <c:v>6.8519999999999754</c:v>
                </c:pt>
                <c:pt idx="180">
                  <c:v>7.0769999999999982</c:v>
                </c:pt>
                <c:pt idx="181">
                  <c:v>7.6650000000000205</c:v>
                </c:pt>
                <c:pt idx="182">
                  <c:v>8.396000000000015</c:v>
                </c:pt>
                <c:pt idx="183">
                  <c:v>11.164999999999964</c:v>
                </c:pt>
                <c:pt idx="184">
                  <c:v>13.625</c:v>
                </c:pt>
                <c:pt idx="185">
                  <c:v>14.326000000000022</c:v>
                </c:pt>
                <c:pt idx="186">
                  <c:v>11.876999999999953</c:v>
                </c:pt>
                <c:pt idx="187">
                  <c:v>8.3120000000000118</c:v>
                </c:pt>
                <c:pt idx="188">
                  <c:v>12.716000000000008</c:v>
                </c:pt>
                <c:pt idx="189">
                  <c:v>13.932000000000016</c:v>
                </c:pt>
                <c:pt idx="190">
                  <c:v>9.7980000000000018</c:v>
                </c:pt>
                <c:pt idx="191">
                  <c:v>13.509999999999991</c:v>
                </c:pt>
                <c:pt idx="192">
                  <c:v>15.119000000000028</c:v>
                </c:pt>
                <c:pt idx="193">
                  <c:v>12.705000000000041</c:v>
                </c:pt>
                <c:pt idx="194">
                  <c:v>13.404999999999973</c:v>
                </c:pt>
                <c:pt idx="195">
                  <c:v>13.750999999999976</c:v>
                </c:pt>
                <c:pt idx="196">
                  <c:v>14.909999999999968</c:v>
                </c:pt>
                <c:pt idx="197">
                  <c:v>17.517000000000053</c:v>
                </c:pt>
                <c:pt idx="198">
                  <c:v>25.346000000000004</c:v>
                </c:pt>
                <c:pt idx="199">
                  <c:v>25.111999999999966</c:v>
                </c:pt>
                <c:pt idx="200">
                  <c:v>23.092999999999961</c:v>
                </c:pt>
                <c:pt idx="201">
                  <c:v>28.435000000000059</c:v>
                </c:pt>
                <c:pt idx="202">
                  <c:v>30.379999999999995</c:v>
                </c:pt>
              </c:numCache>
            </c:numRef>
          </c:xVal>
          <c:yVal>
            <c:numRef>
              <c:f>'Epidermis file sorting'!$AE$2:$AE$204</c:f>
              <c:numCache>
                <c:formatCode>General</c:formatCode>
                <c:ptCount val="203"/>
                <c:pt idx="0">
                  <c:v>23.564299999999999</c:v>
                </c:pt>
                <c:pt idx="1">
                  <c:v>34.112099999999998</c:v>
                </c:pt>
                <c:pt idx="2">
                  <c:v>56.505000000000003</c:v>
                </c:pt>
                <c:pt idx="3">
                  <c:v>75.506200000000007</c:v>
                </c:pt>
                <c:pt idx="4">
                  <c:v>98.31</c:v>
                </c:pt>
                <c:pt idx="5">
                  <c:v>113.39400000000001</c:v>
                </c:pt>
                <c:pt idx="6">
                  <c:v>123.274</c:v>
                </c:pt>
                <c:pt idx="7">
                  <c:v>131.43100000000001</c:v>
                </c:pt>
                <c:pt idx="8">
                  <c:v>141.315</c:v>
                </c:pt>
                <c:pt idx="9">
                  <c:v>151.065</c:v>
                </c:pt>
                <c:pt idx="10">
                  <c:v>160.21700000000001</c:v>
                </c:pt>
                <c:pt idx="11">
                  <c:v>168.40100000000001</c:v>
                </c:pt>
                <c:pt idx="12">
                  <c:v>175.86699999999999</c:v>
                </c:pt>
                <c:pt idx="13">
                  <c:v>184.07300000000001</c:v>
                </c:pt>
                <c:pt idx="14">
                  <c:v>193.393</c:v>
                </c:pt>
                <c:pt idx="15">
                  <c:v>202.18700000000001</c:v>
                </c:pt>
                <c:pt idx="16">
                  <c:v>209.459</c:v>
                </c:pt>
                <c:pt idx="17">
                  <c:v>216.14599999999999</c:v>
                </c:pt>
                <c:pt idx="18">
                  <c:v>222.303</c:v>
                </c:pt>
                <c:pt idx="19">
                  <c:v>229.39599999999999</c:v>
                </c:pt>
                <c:pt idx="20">
                  <c:v>237.292</c:v>
                </c:pt>
                <c:pt idx="21">
                  <c:v>245.07400000000001</c:v>
                </c:pt>
                <c:pt idx="22">
                  <c:v>253.124</c:v>
                </c:pt>
                <c:pt idx="23">
                  <c:v>263.94600000000003</c:v>
                </c:pt>
                <c:pt idx="24">
                  <c:v>273.71100000000001</c:v>
                </c:pt>
                <c:pt idx="25">
                  <c:v>279.85899999999998</c:v>
                </c:pt>
                <c:pt idx="26">
                  <c:v>289.28699999999998</c:v>
                </c:pt>
                <c:pt idx="27">
                  <c:v>299.59800000000001</c:v>
                </c:pt>
                <c:pt idx="28">
                  <c:v>306.88299999999998</c:v>
                </c:pt>
                <c:pt idx="29">
                  <c:v>314.471</c:v>
                </c:pt>
                <c:pt idx="30">
                  <c:v>322.35399999999998</c:v>
                </c:pt>
                <c:pt idx="31">
                  <c:v>329.29</c:v>
                </c:pt>
                <c:pt idx="32">
                  <c:v>336.54899999999998</c:v>
                </c:pt>
                <c:pt idx="33">
                  <c:v>345.28699999999998</c:v>
                </c:pt>
                <c:pt idx="34">
                  <c:v>353.99099999999999</c:v>
                </c:pt>
                <c:pt idx="35">
                  <c:v>362.31200000000001</c:v>
                </c:pt>
                <c:pt idx="36">
                  <c:v>370.83</c:v>
                </c:pt>
                <c:pt idx="37">
                  <c:v>379.61</c:v>
                </c:pt>
                <c:pt idx="38">
                  <c:v>387.73399999999998</c:v>
                </c:pt>
                <c:pt idx="39">
                  <c:v>396.65499999999997</c:v>
                </c:pt>
                <c:pt idx="40">
                  <c:v>405.37299999999999</c:v>
                </c:pt>
                <c:pt idx="41">
                  <c:v>415.13400000000001</c:v>
                </c:pt>
                <c:pt idx="42">
                  <c:v>425.62900000000002</c:v>
                </c:pt>
                <c:pt idx="43">
                  <c:v>436.029</c:v>
                </c:pt>
                <c:pt idx="44">
                  <c:v>444.08499999999998</c:v>
                </c:pt>
                <c:pt idx="45">
                  <c:v>450.40199999999999</c:v>
                </c:pt>
                <c:pt idx="46">
                  <c:v>458.726</c:v>
                </c:pt>
                <c:pt idx="47">
                  <c:v>469.35399999999998</c:v>
                </c:pt>
                <c:pt idx="48">
                  <c:v>480.12099999999998</c:v>
                </c:pt>
                <c:pt idx="49">
                  <c:v>490.666</c:v>
                </c:pt>
                <c:pt idx="50">
                  <c:v>502.471</c:v>
                </c:pt>
                <c:pt idx="51">
                  <c:v>515.10599999999999</c:v>
                </c:pt>
                <c:pt idx="52">
                  <c:v>529.09100000000001</c:v>
                </c:pt>
                <c:pt idx="53">
                  <c:v>541.41800000000001</c:v>
                </c:pt>
                <c:pt idx="54">
                  <c:v>560.69500000000005</c:v>
                </c:pt>
                <c:pt idx="55">
                  <c:v>574.16</c:v>
                </c:pt>
                <c:pt idx="56">
                  <c:v>589.67999999999995</c:v>
                </c:pt>
                <c:pt idx="57">
                  <c:v>608.71600000000001</c:v>
                </c:pt>
                <c:pt idx="58">
                  <c:v>629.45500000000004</c:v>
                </c:pt>
                <c:pt idx="59">
                  <c:v>645.96100000000001</c:v>
                </c:pt>
                <c:pt idx="60">
                  <c:v>658.17399999999998</c:v>
                </c:pt>
                <c:pt idx="61">
                  <c:v>677.45100000000002</c:v>
                </c:pt>
                <c:pt idx="62">
                  <c:v>699.37199999999996</c:v>
                </c:pt>
                <c:pt idx="63">
                  <c:v>717.53099999999995</c:v>
                </c:pt>
                <c:pt idx="64">
                  <c:v>739.29</c:v>
                </c:pt>
                <c:pt idx="65">
                  <c:v>767.505</c:v>
                </c:pt>
                <c:pt idx="66">
                  <c:v>793.000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0D3-4984-ABAD-A98D1E09D123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Epidermis file sorting'!$AD$2:$AD$204</c:f>
              <c:numCache>
                <c:formatCode>General</c:formatCode>
                <c:ptCount val="203"/>
                <c:pt idx="0">
                  <c:v>10.547799999999999</c:v>
                </c:pt>
                <c:pt idx="1">
                  <c:v>22.392900000000004</c:v>
                </c:pt>
                <c:pt idx="2">
                  <c:v>19.001200000000004</c:v>
                </c:pt>
                <c:pt idx="3">
                  <c:v>22.803799999999995</c:v>
                </c:pt>
                <c:pt idx="4">
                  <c:v>15.084000000000003</c:v>
                </c:pt>
                <c:pt idx="5">
                  <c:v>9.8799999999999955</c:v>
                </c:pt>
                <c:pt idx="6">
                  <c:v>8.1570000000000107</c:v>
                </c:pt>
                <c:pt idx="7">
                  <c:v>9.8839999999999861</c:v>
                </c:pt>
                <c:pt idx="8">
                  <c:v>9.75</c:v>
                </c:pt>
                <c:pt idx="9">
                  <c:v>9.1520000000000152</c:v>
                </c:pt>
                <c:pt idx="10">
                  <c:v>8.1839999999999975</c:v>
                </c:pt>
                <c:pt idx="11">
                  <c:v>7.4659999999999798</c:v>
                </c:pt>
                <c:pt idx="12">
                  <c:v>8.2060000000000173</c:v>
                </c:pt>
                <c:pt idx="13">
                  <c:v>9.3199999999999932</c:v>
                </c:pt>
                <c:pt idx="14">
                  <c:v>8.7940000000000111</c:v>
                </c:pt>
                <c:pt idx="15">
                  <c:v>7.2719999999999914</c:v>
                </c:pt>
                <c:pt idx="16">
                  <c:v>6.6869999999999834</c:v>
                </c:pt>
                <c:pt idx="17">
                  <c:v>6.1570000000000107</c:v>
                </c:pt>
                <c:pt idx="18">
                  <c:v>7.0929999999999893</c:v>
                </c:pt>
                <c:pt idx="19">
                  <c:v>7.896000000000015</c:v>
                </c:pt>
                <c:pt idx="20">
                  <c:v>7.7820000000000107</c:v>
                </c:pt>
                <c:pt idx="21">
                  <c:v>8.0499999999999829</c:v>
                </c:pt>
                <c:pt idx="22">
                  <c:v>10.822000000000031</c:v>
                </c:pt>
                <c:pt idx="23">
                  <c:v>9.7649999999999864</c:v>
                </c:pt>
                <c:pt idx="24">
                  <c:v>6.1479999999999677</c:v>
                </c:pt>
                <c:pt idx="25">
                  <c:v>9.4279999999999973</c:v>
                </c:pt>
                <c:pt idx="26">
                  <c:v>10.311000000000035</c:v>
                </c:pt>
                <c:pt idx="27">
                  <c:v>7.2849999999999682</c:v>
                </c:pt>
                <c:pt idx="28">
                  <c:v>7.5880000000000223</c:v>
                </c:pt>
                <c:pt idx="29">
                  <c:v>7.8829999999999814</c:v>
                </c:pt>
                <c:pt idx="30">
                  <c:v>6.9360000000000355</c:v>
                </c:pt>
                <c:pt idx="31">
                  <c:v>7.2589999999999577</c:v>
                </c:pt>
                <c:pt idx="32">
                  <c:v>8.7379999999999995</c:v>
                </c:pt>
                <c:pt idx="33">
                  <c:v>8.7040000000000077</c:v>
                </c:pt>
                <c:pt idx="34">
                  <c:v>8.3210000000000264</c:v>
                </c:pt>
                <c:pt idx="35">
                  <c:v>8.5179999999999723</c:v>
                </c:pt>
                <c:pt idx="36">
                  <c:v>8.7800000000000296</c:v>
                </c:pt>
                <c:pt idx="37">
                  <c:v>8.1239999999999668</c:v>
                </c:pt>
                <c:pt idx="38">
                  <c:v>8.9209999999999923</c:v>
                </c:pt>
                <c:pt idx="39">
                  <c:v>8.7180000000000177</c:v>
                </c:pt>
                <c:pt idx="40">
                  <c:v>9.7610000000000241</c:v>
                </c:pt>
                <c:pt idx="41">
                  <c:v>10.495000000000005</c:v>
                </c:pt>
                <c:pt idx="42">
                  <c:v>10.399999999999977</c:v>
                </c:pt>
                <c:pt idx="43">
                  <c:v>8.0559999999999832</c:v>
                </c:pt>
                <c:pt idx="44">
                  <c:v>6.3170000000000073</c:v>
                </c:pt>
                <c:pt idx="45">
                  <c:v>8.3240000000000123</c:v>
                </c:pt>
                <c:pt idx="46">
                  <c:v>10.627999999999986</c:v>
                </c:pt>
                <c:pt idx="47">
                  <c:v>10.766999999999996</c:v>
                </c:pt>
                <c:pt idx="48">
                  <c:v>10.545000000000016</c:v>
                </c:pt>
                <c:pt idx="49">
                  <c:v>11.805000000000007</c:v>
                </c:pt>
                <c:pt idx="50">
                  <c:v>12.634999999999991</c:v>
                </c:pt>
                <c:pt idx="51">
                  <c:v>13.985000000000014</c:v>
                </c:pt>
                <c:pt idx="52">
                  <c:v>12.326999999999998</c:v>
                </c:pt>
                <c:pt idx="53">
                  <c:v>19.277000000000044</c:v>
                </c:pt>
                <c:pt idx="54">
                  <c:v>13.464999999999918</c:v>
                </c:pt>
                <c:pt idx="55">
                  <c:v>15.519999999999982</c:v>
                </c:pt>
                <c:pt idx="56">
                  <c:v>19.036000000000058</c:v>
                </c:pt>
                <c:pt idx="57">
                  <c:v>20.739000000000033</c:v>
                </c:pt>
                <c:pt idx="58">
                  <c:v>16.505999999999972</c:v>
                </c:pt>
                <c:pt idx="59">
                  <c:v>12.212999999999965</c:v>
                </c:pt>
                <c:pt idx="60">
                  <c:v>19.277000000000044</c:v>
                </c:pt>
                <c:pt idx="61">
                  <c:v>21.920999999999935</c:v>
                </c:pt>
                <c:pt idx="62">
                  <c:v>18.158999999999992</c:v>
                </c:pt>
                <c:pt idx="63">
                  <c:v>21.759000000000015</c:v>
                </c:pt>
                <c:pt idx="64">
                  <c:v>28.215000000000032</c:v>
                </c:pt>
                <c:pt idx="65">
                  <c:v>25.495999999999981</c:v>
                </c:pt>
                <c:pt idx="66">
                  <c:v>28.008000000000038</c:v>
                </c:pt>
                <c:pt idx="67">
                  <c:v>13.1371</c:v>
                </c:pt>
                <c:pt idx="68">
                  <c:v>16.101799999999997</c:v>
                </c:pt>
                <c:pt idx="69">
                  <c:v>16.112200000000001</c:v>
                </c:pt>
                <c:pt idx="70">
                  <c:v>9.3307999999999964</c:v>
                </c:pt>
                <c:pt idx="71">
                  <c:v>9.7606999999999999</c:v>
                </c:pt>
                <c:pt idx="72">
                  <c:v>9.2075000000000102</c:v>
                </c:pt>
                <c:pt idx="73">
                  <c:v>7.5480000000000018</c:v>
                </c:pt>
                <c:pt idx="74">
                  <c:v>9.1839999999999975</c:v>
                </c:pt>
                <c:pt idx="75">
                  <c:v>8.7779999999999916</c:v>
                </c:pt>
                <c:pt idx="76">
                  <c:v>6.7090000000000032</c:v>
                </c:pt>
                <c:pt idx="77">
                  <c:v>4.6639999999999873</c:v>
                </c:pt>
                <c:pt idx="78">
                  <c:v>6.15300000000002</c:v>
                </c:pt>
                <c:pt idx="79">
                  <c:v>6.0060000000000002</c:v>
                </c:pt>
                <c:pt idx="80">
                  <c:v>5.8599999999999852</c:v>
                </c:pt>
                <c:pt idx="81">
                  <c:v>5.6479999999999961</c:v>
                </c:pt>
                <c:pt idx="82">
                  <c:v>7.6220000000000141</c:v>
                </c:pt>
                <c:pt idx="83">
                  <c:v>8.492999999999995</c:v>
                </c:pt>
                <c:pt idx="84">
                  <c:v>5.9710000000000036</c:v>
                </c:pt>
                <c:pt idx="85">
                  <c:v>6.8830000000000098</c:v>
                </c:pt>
                <c:pt idx="86">
                  <c:v>7.3369999999999891</c:v>
                </c:pt>
                <c:pt idx="87">
                  <c:v>7.782999999999987</c:v>
                </c:pt>
                <c:pt idx="88">
                  <c:v>7.632000000000005</c:v>
                </c:pt>
                <c:pt idx="89">
                  <c:v>8.375</c:v>
                </c:pt>
                <c:pt idx="90">
                  <c:v>8.7050000000000125</c:v>
                </c:pt>
                <c:pt idx="91">
                  <c:v>18.342999999999989</c:v>
                </c:pt>
                <c:pt idx="92">
                  <c:v>8.606000000000023</c:v>
                </c:pt>
                <c:pt idx="93">
                  <c:v>7.0319999999999823</c:v>
                </c:pt>
                <c:pt idx="94">
                  <c:v>6.5249999999999773</c:v>
                </c:pt>
                <c:pt idx="95">
                  <c:v>7.0170000000000528</c:v>
                </c:pt>
                <c:pt idx="96">
                  <c:v>7.3619999999999663</c:v>
                </c:pt>
                <c:pt idx="97">
                  <c:v>7.1580000000000155</c:v>
                </c:pt>
                <c:pt idx="98">
                  <c:v>15.896999999999991</c:v>
                </c:pt>
                <c:pt idx="99">
                  <c:v>5.4200000000000159</c:v>
                </c:pt>
                <c:pt idx="100">
                  <c:v>6.4780000000000086</c:v>
                </c:pt>
                <c:pt idx="101">
                  <c:v>7.0079999999999814</c:v>
                </c:pt>
                <c:pt idx="102">
                  <c:v>7.1759999999999877</c:v>
                </c:pt>
                <c:pt idx="103">
                  <c:v>8.0930000000000177</c:v>
                </c:pt>
                <c:pt idx="104">
                  <c:v>8.964999999999975</c:v>
                </c:pt>
                <c:pt idx="105">
                  <c:v>8.3969999999999914</c:v>
                </c:pt>
                <c:pt idx="106">
                  <c:v>8.6570000000000391</c:v>
                </c:pt>
                <c:pt idx="107">
                  <c:v>9.9309999999999832</c:v>
                </c:pt>
                <c:pt idx="108">
                  <c:v>9.5380000000000109</c:v>
                </c:pt>
                <c:pt idx="109">
                  <c:v>8.3139999999999645</c:v>
                </c:pt>
                <c:pt idx="110">
                  <c:v>8.5160000000000196</c:v>
                </c:pt>
                <c:pt idx="111">
                  <c:v>8.9119999999999777</c:v>
                </c:pt>
                <c:pt idx="112">
                  <c:v>9.5330000000000155</c:v>
                </c:pt>
                <c:pt idx="113">
                  <c:v>10.704999999999984</c:v>
                </c:pt>
                <c:pt idx="114">
                  <c:v>11.373000000000047</c:v>
                </c:pt>
                <c:pt idx="115">
                  <c:v>8.8519999999999754</c:v>
                </c:pt>
                <c:pt idx="116">
                  <c:v>7.2139999999999986</c:v>
                </c:pt>
                <c:pt idx="117">
                  <c:v>8.2060000000000173</c:v>
                </c:pt>
                <c:pt idx="118">
                  <c:v>8.5229999999999677</c:v>
                </c:pt>
                <c:pt idx="119">
                  <c:v>9.3170000000000073</c:v>
                </c:pt>
                <c:pt idx="120">
                  <c:v>10.275000000000034</c:v>
                </c:pt>
                <c:pt idx="121">
                  <c:v>13.959000000000003</c:v>
                </c:pt>
                <c:pt idx="122">
                  <c:v>13.90300000000002</c:v>
                </c:pt>
                <c:pt idx="123">
                  <c:v>10.921999999999912</c:v>
                </c:pt>
                <c:pt idx="124">
                  <c:v>15.964000000000055</c:v>
                </c:pt>
                <c:pt idx="125">
                  <c:v>15.503000000000043</c:v>
                </c:pt>
                <c:pt idx="126">
                  <c:v>11.74899999999991</c:v>
                </c:pt>
                <c:pt idx="127">
                  <c:v>16.01400000000001</c:v>
                </c:pt>
                <c:pt idx="128">
                  <c:v>16.079000000000065</c:v>
                </c:pt>
                <c:pt idx="129">
                  <c:v>12.184999999999945</c:v>
                </c:pt>
                <c:pt idx="130">
                  <c:v>15.039999999999964</c:v>
                </c:pt>
                <c:pt idx="131">
                  <c:v>21.110000000000014</c:v>
                </c:pt>
                <c:pt idx="132">
                  <c:v>27.339000000000055</c:v>
                </c:pt>
                <c:pt idx="133">
                  <c:v>24.418000000000006</c:v>
                </c:pt>
                <c:pt idx="134">
                  <c:v>20.011999999999944</c:v>
                </c:pt>
                <c:pt idx="135">
                  <c:v>28.118000000000052</c:v>
                </c:pt>
                <c:pt idx="136">
                  <c:v>42.255999999999972</c:v>
                </c:pt>
                <c:pt idx="138">
                  <c:v>14.176200000000001</c:v>
                </c:pt>
                <c:pt idx="139">
                  <c:v>10.767800000000001</c:v>
                </c:pt>
                <c:pt idx="140">
                  <c:v>12.344699999999996</c:v>
                </c:pt>
                <c:pt idx="141">
                  <c:v>25.825299999999999</c:v>
                </c:pt>
                <c:pt idx="142">
                  <c:v>8.8880000000000052</c:v>
                </c:pt>
                <c:pt idx="143">
                  <c:v>9.1230000000000047</c:v>
                </c:pt>
                <c:pt idx="144">
                  <c:v>10.144999999999996</c:v>
                </c:pt>
                <c:pt idx="145">
                  <c:v>10.697000000000003</c:v>
                </c:pt>
                <c:pt idx="146">
                  <c:v>7.0349999999999966</c:v>
                </c:pt>
                <c:pt idx="147">
                  <c:v>6.4230000000000018</c:v>
                </c:pt>
                <c:pt idx="148">
                  <c:v>6.8069999999999879</c:v>
                </c:pt>
                <c:pt idx="149">
                  <c:v>7.2190000000000225</c:v>
                </c:pt>
                <c:pt idx="150">
                  <c:v>6.9739999999999895</c:v>
                </c:pt>
                <c:pt idx="151">
                  <c:v>7.0349999999999966</c:v>
                </c:pt>
                <c:pt idx="152">
                  <c:v>6.921999999999997</c:v>
                </c:pt>
                <c:pt idx="153">
                  <c:v>8.0939999999999941</c:v>
                </c:pt>
                <c:pt idx="154">
                  <c:v>9.3940000000000055</c:v>
                </c:pt>
                <c:pt idx="155">
                  <c:v>9.4350000000000023</c:v>
                </c:pt>
                <c:pt idx="156">
                  <c:v>8.3149999999999977</c:v>
                </c:pt>
                <c:pt idx="157">
                  <c:v>8.4339999999999975</c:v>
                </c:pt>
                <c:pt idx="158">
                  <c:v>9.1380000000000052</c:v>
                </c:pt>
                <c:pt idx="159">
                  <c:v>14.926999999999992</c:v>
                </c:pt>
                <c:pt idx="160">
                  <c:v>16.632000000000005</c:v>
                </c:pt>
                <c:pt idx="161">
                  <c:v>9.4580000000000268</c:v>
                </c:pt>
                <c:pt idx="162">
                  <c:v>11.593999999999994</c:v>
                </c:pt>
                <c:pt idx="163">
                  <c:v>11.606999999999971</c:v>
                </c:pt>
                <c:pt idx="164">
                  <c:v>9.5760000000000218</c:v>
                </c:pt>
                <c:pt idx="165">
                  <c:v>8.8240000000000123</c:v>
                </c:pt>
                <c:pt idx="166">
                  <c:v>9.2699999999999818</c:v>
                </c:pt>
                <c:pt idx="167">
                  <c:v>10.197999999999979</c:v>
                </c:pt>
                <c:pt idx="168">
                  <c:v>8.3160000000000309</c:v>
                </c:pt>
                <c:pt idx="169">
                  <c:v>7.3580000000000041</c:v>
                </c:pt>
                <c:pt idx="170">
                  <c:v>7.950999999999965</c:v>
                </c:pt>
                <c:pt idx="171">
                  <c:v>9.6659999999999968</c:v>
                </c:pt>
                <c:pt idx="172">
                  <c:v>11.531000000000006</c:v>
                </c:pt>
                <c:pt idx="173">
                  <c:v>12.264999999999986</c:v>
                </c:pt>
                <c:pt idx="174">
                  <c:v>9.5100000000000477</c:v>
                </c:pt>
                <c:pt idx="175">
                  <c:v>9.9499999999999886</c:v>
                </c:pt>
                <c:pt idx="176">
                  <c:v>9.6949999999999932</c:v>
                </c:pt>
                <c:pt idx="177">
                  <c:v>6.7180000000000177</c:v>
                </c:pt>
                <c:pt idx="178">
                  <c:v>6.9669999999999845</c:v>
                </c:pt>
                <c:pt idx="179">
                  <c:v>6.8519999999999754</c:v>
                </c:pt>
                <c:pt idx="180">
                  <c:v>7.0769999999999982</c:v>
                </c:pt>
                <c:pt idx="181">
                  <c:v>7.6650000000000205</c:v>
                </c:pt>
                <c:pt idx="182">
                  <c:v>8.396000000000015</c:v>
                </c:pt>
                <c:pt idx="183">
                  <c:v>11.164999999999964</c:v>
                </c:pt>
                <c:pt idx="184">
                  <c:v>13.625</c:v>
                </c:pt>
                <c:pt idx="185">
                  <c:v>14.326000000000022</c:v>
                </c:pt>
                <c:pt idx="186">
                  <c:v>11.876999999999953</c:v>
                </c:pt>
                <c:pt idx="187">
                  <c:v>8.3120000000000118</c:v>
                </c:pt>
                <c:pt idx="188">
                  <c:v>12.716000000000008</c:v>
                </c:pt>
                <c:pt idx="189">
                  <c:v>13.932000000000016</c:v>
                </c:pt>
                <c:pt idx="190">
                  <c:v>9.7980000000000018</c:v>
                </c:pt>
                <c:pt idx="191">
                  <c:v>13.509999999999991</c:v>
                </c:pt>
                <c:pt idx="192">
                  <c:v>15.119000000000028</c:v>
                </c:pt>
                <c:pt idx="193">
                  <c:v>12.705000000000041</c:v>
                </c:pt>
                <c:pt idx="194">
                  <c:v>13.404999999999973</c:v>
                </c:pt>
                <c:pt idx="195">
                  <c:v>13.750999999999976</c:v>
                </c:pt>
                <c:pt idx="196">
                  <c:v>14.909999999999968</c:v>
                </c:pt>
                <c:pt idx="197">
                  <c:v>17.517000000000053</c:v>
                </c:pt>
                <c:pt idx="198">
                  <c:v>25.346000000000004</c:v>
                </c:pt>
                <c:pt idx="199">
                  <c:v>25.111999999999966</c:v>
                </c:pt>
                <c:pt idx="200">
                  <c:v>23.092999999999961</c:v>
                </c:pt>
                <c:pt idx="201">
                  <c:v>28.435000000000059</c:v>
                </c:pt>
                <c:pt idx="202">
                  <c:v>30.379999999999995</c:v>
                </c:pt>
              </c:numCache>
            </c:numRef>
          </c:xVal>
          <c:yVal>
            <c:numRef>
              <c:f>'Epidermis file sorting'!$AF$2:$AF$204</c:f>
              <c:numCache>
                <c:formatCode>General</c:formatCode>
                <c:ptCount val="203"/>
                <c:pt idx="67">
                  <c:v>28.344899999999999</c:v>
                </c:pt>
                <c:pt idx="68">
                  <c:v>41.481999999999999</c:v>
                </c:pt>
                <c:pt idx="69">
                  <c:v>57.583799999999997</c:v>
                </c:pt>
                <c:pt idx="70">
                  <c:v>73.695999999999998</c:v>
                </c:pt>
                <c:pt idx="71">
                  <c:v>83.026799999999994</c:v>
                </c:pt>
                <c:pt idx="72">
                  <c:v>92.787499999999994</c:v>
                </c:pt>
                <c:pt idx="73">
                  <c:v>101.995</c:v>
                </c:pt>
                <c:pt idx="74">
                  <c:v>109.54300000000001</c:v>
                </c:pt>
                <c:pt idx="75">
                  <c:v>118.727</c:v>
                </c:pt>
                <c:pt idx="76">
                  <c:v>127.505</c:v>
                </c:pt>
                <c:pt idx="77">
                  <c:v>134.214</c:v>
                </c:pt>
                <c:pt idx="78">
                  <c:v>138.87799999999999</c:v>
                </c:pt>
                <c:pt idx="79">
                  <c:v>145.03100000000001</c:v>
                </c:pt>
                <c:pt idx="80">
                  <c:v>151.03700000000001</c:v>
                </c:pt>
                <c:pt idx="81">
                  <c:v>156.89699999999999</c:v>
                </c:pt>
                <c:pt idx="82">
                  <c:v>162.54499999999999</c:v>
                </c:pt>
                <c:pt idx="83">
                  <c:v>170.167</c:v>
                </c:pt>
                <c:pt idx="84">
                  <c:v>178.66</c:v>
                </c:pt>
                <c:pt idx="85">
                  <c:v>184.631</c:v>
                </c:pt>
                <c:pt idx="86">
                  <c:v>191.51400000000001</c:v>
                </c:pt>
                <c:pt idx="87">
                  <c:v>198.851</c:v>
                </c:pt>
                <c:pt idx="88">
                  <c:v>206.63399999999999</c:v>
                </c:pt>
                <c:pt idx="89">
                  <c:v>214.26599999999999</c:v>
                </c:pt>
                <c:pt idx="90">
                  <c:v>222.64099999999999</c:v>
                </c:pt>
                <c:pt idx="91">
                  <c:v>231.346</c:v>
                </c:pt>
                <c:pt idx="92">
                  <c:v>249.68899999999999</c:v>
                </c:pt>
                <c:pt idx="93">
                  <c:v>258.29500000000002</c:v>
                </c:pt>
                <c:pt idx="94">
                  <c:v>265.327</c:v>
                </c:pt>
                <c:pt idx="95">
                  <c:v>271.85199999999998</c:v>
                </c:pt>
                <c:pt idx="96">
                  <c:v>278.86900000000003</c:v>
                </c:pt>
                <c:pt idx="97">
                  <c:v>286.23099999999999</c:v>
                </c:pt>
                <c:pt idx="98">
                  <c:v>293.38900000000001</c:v>
                </c:pt>
                <c:pt idx="99">
                  <c:v>309.286</c:v>
                </c:pt>
                <c:pt idx="100">
                  <c:v>314.70600000000002</c:v>
                </c:pt>
                <c:pt idx="101">
                  <c:v>321.18400000000003</c:v>
                </c:pt>
                <c:pt idx="102">
                  <c:v>328.19200000000001</c:v>
                </c:pt>
                <c:pt idx="103">
                  <c:v>335.36799999999999</c:v>
                </c:pt>
                <c:pt idx="104">
                  <c:v>343.46100000000001</c:v>
                </c:pt>
                <c:pt idx="105">
                  <c:v>352.42599999999999</c:v>
                </c:pt>
                <c:pt idx="106">
                  <c:v>360.82299999999998</c:v>
                </c:pt>
                <c:pt idx="107">
                  <c:v>369.48</c:v>
                </c:pt>
                <c:pt idx="108">
                  <c:v>379.411</c:v>
                </c:pt>
                <c:pt idx="109">
                  <c:v>388.94900000000001</c:v>
                </c:pt>
                <c:pt idx="110">
                  <c:v>397.26299999999998</c:v>
                </c:pt>
                <c:pt idx="111">
                  <c:v>405.779</c:v>
                </c:pt>
                <c:pt idx="112">
                  <c:v>414.69099999999997</c:v>
                </c:pt>
                <c:pt idx="113">
                  <c:v>424.22399999999999</c:v>
                </c:pt>
                <c:pt idx="114">
                  <c:v>434.92899999999997</c:v>
                </c:pt>
                <c:pt idx="115">
                  <c:v>446.30200000000002</c:v>
                </c:pt>
                <c:pt idx="116">
                  <c:v>455.154</c:v>
                </c:pt>
                <c:pt idx="117">
                  <c:v>462.36799999999999</c:v>
                </c:pt>
                <c:pt idx="118">
                  <c:v>470.57400000000001</c:v>
                </c:pt>
                <c:pt idx="119">
                  <c:v>479.09699999999998</c:v>
                </c:pt>
                <c:pt idx="120">
                  <c:v>488.41399999999999</c:v>
                </c:pt>
                <c:pt idx="121">
                  <c:v>498.68900000000002</c:v>
                </c:pt>
                <c:pt idx="122">
                  <c:v>512.64800000000002</c:v>
                </c:pt>
                <c:pt idx="123">
                  <c:v>526.55100000000004</c:v>
                </c:pt>
                <c:pt idx="124">
                  <c:v>537.47299999999996</c:v>
                </c:pt>
                <c:pt idx="125">
                  <c:v>553.43700000000001</c:v>
                </c:pt>
                <c:pt idx="126">
                  <c:v>568.94000000000005</c:v>
                </c:pt>
                <c:pt idx="127">
                  <c:v>580.68899999999996</c:v>
                </c:pt>
                <c:pt idx="128">
                  <c:v>596.70299999999997</c:v>
                </c:pt>
                <c:pt idx="129">
                  <c:v>612.78200000000004</c:v>
                </c:pt>
                <c:pt idx="130">
                  <c:v>624.96699999999998</c:v>
                </c:pt>
                <c:pt idx="131">
                  <c:v>640.00699999999995</c:v>
                </c:pt>
                <c:pt idx="132">
                  <c:v>661.11699999999996</c:v>
                </c:pt>
                <c:pt idx="133">
                  <c:v>688.45600000000002</c:v>
                </c:pt>
                <c:pt idx="134">
                  <c:v>712.87400000000002</c:v>
                </c:pt>
                <c:pt idx="135">
                  <c:v>732.88599999999997</c:v>
                </c:pt>
                <c:pt idx="136">
                  <c:v>761.004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D3-4984-ABAD-A98D1E09D123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Epidermis file sorting'!$AD$2:$AD$204</c:f>
              <c:numCache>
                <c:formatCode>General</c:formatCode>
                <c:ptCount val="203"/>
                <c:pt idx="0">
                  <c:v>10.547799999999999</c:v>
                </c:pt>
                <c:pt idx="1">
                  <c:v>22.392900000000004</c:v>
                </c:pt>
                <c:pt idx="2">
                  <c:v>19.001200000000004</c:v>
                </c:pt>
                <c:pt idx="3">
                  <c:v>22.803799999999995</c:v>
                </c:pt>
                <c:pt idx="4">
                  <c:v>15.084000000000003</c:v>
                </c:pt>
                <c:pt idx="5">
                  <c:v>9.8799999999999955</c:v>
                </c:pt>
                <c:pt idx="6">
                  <c:v>8.1570000000000107</c:v>
                </c:pt>
                <c:pt idx="7">
                  <c:v>9.8839999999999861</c:v>
                </c:pt>
                <c:pt idx="8">
                  <c:v>9.75</c:v>
                </c:pt>
                <c:pt idx="9">
                  <c:v>9.1520000000000152</c:v>
                </c:pt>
                <c:pt idx="10">
                  <c:v>8.1839999999999975</c:v>
                </c:pt>
                <c:pt idx="11">
                  <c:v>7.4659999999999798</c:v>
                </c:pt>
                <c:pt idx="12">
                  <c:v>8.2060000000000173</c:v>
                </c:pt>
                <c:pt idx="13">
                  <c:v>9.3199999999999932</c:v>
                </c:pt>
                <c:pt idx="14">
                  <c:v>8.7940000000000111</c:v>
                </c:pt>
                <c:pt idx="15">
                  <c:v>7.2719999999999914</c:v>
                </c:pt>
                <c:pt idx="16">
                  <c:v>6.6869999999999834</c:v>
                </c:pt>
                <c:pt idx="17">
                  <c:v>6.1570000000000107</c:v>
                </c:pt>
                <c:pt idx="18">
                  <c:v>7.0929999999999893</c:v>
                </c:pt>
                <c:pt idx="19">
                  <c:v>7.896000000000015</c:v>
                </c:pt>
                <c:pt idx="20">
                  <c:v>7.7820000000000107</c:v>
                </c:pt>
                <c:pt idx="21">
                  <c:v>8.0499999999999829</c:v>
                </c:pt>
                <c:pt idx="22">
                  <c:v>10.822000000000031</c:v>
                </c:pt>
                <c:pt idx="23">
                  <c:v>9.7649999999999864</c:v>
                </c:pt>
                <c:pt idx="24">
                  <c:v>6.1479999999999677</c:v>
                </c:pt>
                <c:pt idx="25">
                  <c:v>9.4279999999999973</c:v>
                </c:pt>
                <c:pt idx="26">
                  <c:v>10.311000000000035</c:v>
                </c:pt>
                <c:pt idx="27">
                  <c:v>7.2849999999999682</c:v>
                </c:pt>
                <c:pt idx="28">
                  <c:v>7.5880000000000223</c:v>
                </c:pt>
                <c:pt idx="29">
                  <c:v>7.8829999999999814</c:v>
                </c:pt>
                <c:pt idx="30">
                  <c:v>6.9360000000000355</c:v>
                </c:pt>
                <c:pt idx="31">
                  <c:v>7.2589999999999577</c:v>
                </c:pt>
                <c:pt idx="32">
                  <c:v>8.7379999999999995</c:v>
                </c:pt>
                <c:pt idx="33">
                  <c:v>8.7040000000000077</c:v>
                </c:pt>
                <c:pt idx="34">
                  <c:v>8.3210000000000264</c:v>
                </c:pt>
                <c:pt idx="35">
                  <c:v>8.5179999999999723</c:v>
                </c:pt>
                <c:pt idx="36">
                  <c:v>8.7800000000000296</c:v>
                </c:pt>
                <c:pt idx="37">
                  <c:v>8.1239999999999668</c:v>
                </c:pt>
                <c:pt idx="38">
                  <c:v>8.9209999999999923</c:v>
                </c:pt>
                <c:pt idx="39">
                  <c:v>8.7180000000000177</c:v>
                </c:pt>
                <c:pt idx="40">
                  <c:v>9.7610000000000241</c:v>
                </c:pt>
                <c:pt idx="41">
                  <c:v>10.495000000000005</c:v>
                </c:pt>
                <c:pt idx="42">
                  <c:v>10.399999999999977</c:v>
                </c:pt>
                <c:pt idx="43">
                  <c:v>8.0559999999999832</c:v>
                </c:pt>
                <c:pt idx="44">
                  <c:v>6.3170000000000073</c:v>
                </c:pt>
                <c:pt idx="45">
                  <c:v>8.3240000000000123</c:v>
                </c:pt>
                <c:pt idx="46">
                  <c:v>10.627999999999986</c:v>
                </c:pt>
                <c:pt idx="47">
                  <c:v>10.766999999999996</c:v>
                </c:pt>
                <c:pt idx="48">
                  <c:v>10.545000000000016</c:v>
                </c:pt>
                <c:pt idx="49">
                  <c:v>11.805000000000007</c:v>
                </c:pt>
                <c:pt idx="50">
                  <c:v>12.634999999999991</c:v>
                </c:pt>
                <c:pt idx="51">
                  <c:v>13.985000000000014</c:v>
                </c:pt>
                <c:pt idx="52">
                  <c:v>12.326999999999998</c:v>
                </c:pt>
                <c:pt idx="53">
                  <c:v>19.277000000000044</c:v>
                </c:pt>
                <c:pt idx="54">
                  <c:v>13.464999999999918</c:v>
                </c:pt>
                <c:pt idx="55">
                  <c:v>15.519999999999982</c:v>
                </c:pt>
                <c:pt idx="56">
                  <c:v>19.036000000000058</c:v>
                </c:pt>
                <c:pt idx="57">
                  <c:v>20.739000000000033</c:v>
                </c:pt>
                <c:pt idx="58">
                  <c:v>16.505999999999972</c:v>
                </c:pt>
                <c:pt idx="59">
                  <c:v>12.212999999999965</c:v>
                </c:pt>
                <c:pt idx="60">
                  <c:v>19.277000000000044</c:v>
                </c:pt>
                <c:pt idx="61">
                  <c:v>21.920999999999935</c:v>
                </c:pt>
                <c:pt idx="62">
                  <c:v>18.158999999999992</c:v>
                </c:pt>
                <c:pt idx="63">
                  <c:v>21.759000000000015</c:v>
                </c:pt>
                <c:pt idx="64">
                  <c:v>28.215000000000032</c:v>
                </c:pt>
                <c:pt idx="65">
                  <c:v>25.495999999999981</c:v>
                </c:pt>
                <c:pt idx="66">
                  <c:v>28.008000000000038</c:v>
                </c:pt>
                <c:pt idx="67">
                  <c:v>13.1371</c:v>
                </c:pt>
                <c:pt idx="68">
                  <c:v>16.101799999999997</c:v>
                </c:pt>
                <c:pt idx="69">
                  <c:v>16.112200000000001</c:v>
                </c:pt>
                <c:pt idx="70">
                  <c:v>9.3307999999999964</c:v>
                </c:pt>
                <c:pt idx="71">
                  <c:v>9.7606999999999999</c:v>
                </c:pt>
                <c:pt idx="72">
                  <c:v>9.2075000000000102</c:v>
                </c:pt>
                <c:pt idx="73">
                  <c:v>7.5480000000000018</c:v>
                </c:pt>
                <c:pt idx="74">
                  <c:v>9.1839999999999975</c:v>
                </c:pt>
                <c:pt idx="75">
                  <c:v>8.7779999999999916</c:v>
                </c:pt>
                <c:pt idx="76">
                  <c:v>6.7090000000000032</c:v>
                </c:pt>
                <c:pt idx="77">
                  <c:v>4.6639999999999873</c:v>
                </c:pt>
                <c:pt idx="78">
                  <c:v>6.15300000000002</c:v>
                </c:pt>
                <c:pt idx="79">
                  <c:v>6.0060000000000002</c:v>
                </c:pt>
                <c:pt idx="80">
                  <c:v>5.8599999999999852</c:v>
                </c:pt>
                <c:pt idx="81">
                  <c:v>5.6479999999999961</c:v>
                </c:pt>
                <c:pt idx="82">
                  <c:v>7.6220000000000141</c:v>
                </c:pt>
                <c:pt idx="83">
                  <c:v>8.492999999999995</c:v>
                </c:pt>
                <c:pt idx="84">
                  <c:v>5.9710000000000036</c:v>
                </c:pt>
                <c:pt idx="85">
                  <c:v>6.8830000000000098</c:v>
                </c:pt>
                <c:pt idx="86">
                  <c:v>7.3369999999999891</c:v>
                </c:pt>
                <c:pt idx="87">
                  <c:v>7.782999999999987</c:v>
                </c:pt>
                <c:pt idx="88">
                  <c:v>7.632000000000005</c:v>
                </c:pt>
                <c:pt idx="89">
                  <c:v>8.375</c:v>
                </c:pt>
                <c:pt idx="90">
                  <c:v>8.7050000000000125</c:v>
                </c:pt>
                <c:pt idx="91">
                  <c:v>18.342999999999989</c:v>
                </c:pt>
                <c:pt idx="92">
                  <c:v>8.606000000000023</c:v>
                </c:pt>
                <c:pt idx="93">
                  <c:v>7.0319999999999823</c:v>
                </c:pt>
                <c:pt idx="94">
                  <c:v>6.5249999999999773</c:v>
                </c:pt>
                <c:pt idx="95">
                  <c:v>7.0170000000000528</c:v>
                </c:pt>
                <c:pt idx="96">
                  <c:v>7.3619999999999663</c:v>
                </c:pt>
                <c:pt idx="97">
                  <c:v>7.1580000000000155</c:v>
                </c:pt>
                <c:pt idx="98">
                  <c:v>15.896999999999991</c:v>
                </c:pt>
                <c:pt idx="99">
                  <c:v>5.4200000000000159</c:v>
                </c:pt>
                <c:pt idx="100">
                  <c:v>6.4780000000000086</c:v>
                </c:pt>
                <c:pt idx="101">
                  <c:v>7.0079999999999814</c:v>
                </c:pt>
                <c:pt idx="102">
                  <c:v>7.1759999999999877</c:v>
                </c:pt>
                <c:pt idx="103">
                  <c:v>8.0930000000000177</c:v>
                </c:pt>
                <c:pt idx="104">
                  <c:v>8.964999999999975</c:v>
                </c:pt>
                <c:pt idx="105">
                  <c:v>8.3969999999999914</c:v>
                </c:pt>
                <c:pt idx="106">
                  <c:v>8.6570000000000391</c:v>
                </c:pt>
                <c:pt idx="107">
                  <c:v>9.9309999999999832</c:v>
                </c:pt>
                <c:pt idx="108">
                  <c:v>9.5380000000000109</c:v>
                </c:pt>
                <c:pt idx="109">
                  <c:v>8.3139999999999645</c:v>
                </c:pt>
                <c:pt idx="110">
                  <c:v>8.5160000000000196</c:v>
                </c:pt>
                <c:pt idx="111">
                  <c:v>8.9119999999999777</c:v>
                </c:pt>
                <c:pt idx="112">
                  <c:v>9.5330000000000155</c:v>
                </c:pt>
                <c:pt idx="113">
                  <c:v>10.704999999999984</c:v>
                </c:pt>
                <c:pt idx="114">
                  <c:v>11.373000000000047</c:v>
                </c:pt>
                <c:pt idx="115">
                  <c:v>8.8519999999999754</c:v>
                </c:pt>
                <c:pt idx="116">
                  <c:v>7.2139999999999986</c:v>
                </c:pt>
                <c:pt idx="117">
                  <c:v>8.2060000000000173</c:v>
                </c:pt>
                <c:pt idx="118">
                  <c:v>8.5229999999999677</c:v>
                </c:pt>
                <c:pt idx="119">
                  <c:v>9.3170000000000073</c:v>
                </c:pt>
                <c:pt idx="120">
                  <c:v>10.275000000000034</c:v>
                </c:pt>
                <c:pt idx="121">
                  <c:v>13.959000000000003</c:v>
                </c:pt>
                <c:pt idx="122">
                  <c:v>13.90300000000002</c:v>
                </c:pt>
                <c:pt idx="123">
                  <c:v>10.921999999999912</c:v>
                </c:pt>
                <c:pt idx="124">
                  <c:v>15.964000000000055</c:v>
                </c:pt>
                <c:pt idx="125">
                  <c:v>15.503000000000043</c:v>
                </c:pt>
                <c:pt idx="126">
                  <c:v>11.74899999999991</c:v>
                </c:pt>
                <c:pt idx="127">
                  <c:v>16.01400000000001</c:v>
                </c:pt>
                <c:pt idx="128">
                  <c:v>16.079000000000065</c:v>
                </c:pt>
                <c:pt idx="129">
                  <c:v>12.184999999999945</c:v>
                </c:pt>
                <c:pt idx="130">
                  <c:v>15.039999999999964</c:v>
                </c:pt>
                <c:pt idx="131">
                  <c:v>21.110000000000014</c:v>
                </c:pt>
                <c:pt idx="132">
                  <c:v>27.339000000000055</c:v>
                </c:pt>
                <c:pt idx="133">
                  <c:v>24.418000000000006</c:v>
                </c:pt>
                <c:pt idx="134">
                  <c:v>20.011999999999944</c:v>
                </c:pt>
                <c:pt idx="135">
                  <c:v>28.118000000000052</c:v>
                </c:pt>
                <c:pt idx="136">
                  <c:v>42.255999999999972</c:v>
                </c:pt>
                <c:pt idx="138">
                  <c:v>14.176200000000001</c:v>
                </c:pt>
                <c:pt idx="139">
                  <c:v>10.767800000000001</c:v>
                </c:pt>
                <c:pt idx="140">
                  <c:v>12.344699999999996</c:v>
                </c:pt>
                <c:pt idx="141">
                  <c:v>25.825299999999999</c:v>
                </c:pt>
                <c:pt idx="142">
                  <c:v>8.8880000000000052</c:v>
                </c:pt>
                <c:pt idx="143">
                  <c:v>9.1230000000000047</c:v>
                </c:pt>
                <c:pt idx="144">
                  <c:v>10.144999999999996</c:v>
                </c:pt>
                <c:pt idx="145">
                  <c:v>10.697000000000003</c:v>
                </c:pt>
                <c:pt idx="146">
                  <c:v>7.0349999999999966</c:v>
                </c:pt>
                <c:pt idx="147">
                  <c:v>6.4230000000000018</c:v>
                </c:pt>
                <c:pt idx="148">
                  <c:v>6.8069999999999879</c:v>
                </c:pt>
                <c:pt idx="149">
                  <c:v>7.2190000000000225</c:v>
                </c:pt>
                <c:pt idx="150">
                  <c:v>6.9739999999999895</c:v>
                </c:pt>
                <c:pt idx="151">
                  <c:v>7.0349999999999966</c:v>
                </c:pt>
                <c:pt idx="152">
                  <c:v>6.921999999999997</c:v>
                </c:pt>
                <c:pt idx="153">
                  <c:v>8.0939999999999941</c:v>
                </c:pt>
                <c:pt idx="154">
                  <c:v>9.3940000000000055</c:v>
                </c:pt>
                <c:pt idx="155">
                  <c:v>9.4350000000000023</c:v>
                </c:pt>
                <c:pt idx="156">
                  <c:v>8.3149999999999977</c:v>
                </c:pt>
                <c:pt idx="157">
                  <c:v>8.4339999999999975</c:v>
                </c:pt>
                <c:pt idx="158">
                  <c:v>9.1380000000000052</c:v>
                </c:pt>
                <c:pt idx="159">
                  <c:v>14.926999999999992</c:v>
                </c:pt>
                <c:pt idx="160">
                  <c:v>16.632000000000005</c:v>
                </c:pt>
                <c:pt idx="161">
                  <c:v>9.4580000000000268</c:v>
                </c:pt>
                <c:pt idx="162">
                  <c:v>11.593999999999994</c:v>
                </c:pt>
                <c:pt idx="163">
                  <c:v>11.606999999999971</c:v>
                </c:pt>
                <c:pt idx="164">
                  <c:v>9.5760000000000218</c:v>
                </c:pt>
                <c:pt idx="165">
                  <c:v>8.8240000000000123</c:v>
                </c:pt>
                <c:pt idx="166">
                  <c:v>9.2699999999999818</c:v>
                </c:pt>
                <c:pt idx="167">
                  <c:v>10.197999999999979</c:v>
                </c:pt>
                <c:pt idx="168">
                  <c:v>8.3160000000000309</c:v>
                </c:pt>
                <c:pt idx="169">
                  <c:v>7.3580000000000041</c:v>
                </c:pt>
                <c:pt idx="170">
                  <c:v>7.950999999999965</c:v>
                </c:pt>
                <c:pt idx="171">
                  <c:v>9.6659999999999968</c:v>
                </c:pt>
                <c:pt idx="172">
                  <c:v>11.531000000000006</c:v>
                </c:pt>
                <c:pt idx="173">
                  <c:v>12.264999999999986</c:v>
                </c:pt>
                <c:pt idx="174">
                  <c:v>9.5100000000000477</c:v>
                </c:pt>
                <c:pt idx="175">
                  <c:v>9.9499999999999886</c:v>
                </c:pt>
                <c:pt idx="176">
                  <c:v>9.6949999999999932</c:v>
                </c:pt>
                <c:pt idx="177">
                  <c:v>6.7180000000000177</c:v>
                </c:pt>
                <c:pt idx="178">
                  <c:v>6.9669999999999845</c:v>
                </c:pt>
                <c:pt idx="179">
                  <c:v>6.8519999999999754</c:v>
                </c:pt>
                <c:pt idx="180">
                  <c:v>7.0769999999999982</c:v>
                </c:pt>
                <c:pt idx="181">
                  <c:v>7.6650000000000205</c:v>
                </c:pt>
                <c:pt idx="182">
                  <c:v>8.396000000000015</c:v>
                </c:pt>
                <c:pt idx="183">
                  <c:v>11.164999999999964</c:v>
                </c:pt>
                <c:pt idx="184">
                  <c:v>13.625</c:v>
                </c:pt>
                <c:pt idx="185">
                  <c:v>14.326000000000022</c:v>
                </c:pt>
                <c:pt idx="186">
                  <c:v>11.876999999999953</c:v>
                </c:pt>
                <c:pt idx="187">
                  <c:v>8.3120000000000118</c:v>
                </c:pt>
                <c:pt idx="188">
                  <c:v>12.716000000000008</c:v>
                </c:pt>
                <c:pt idx="189">
                  <c:v>13.932000000000016</c:v>
                </c:pt>
                <c:pt idx="190">
                  <c:v>9.7980000000000018</c:v>
                </c:pt>
                <c:pt idx="191">
                  <c:v>13.509999999999991</c:v>
                </c:pt>
                <c:pt idx="192">
                  <c:v>15.119000000000028</c:v>
                </c:pt>
                <c:pt idx="193">
                  <c:v>12.705000000000041</c:v>
                </c:pt>
                <c:pt idx="194">
                  <c:v>13.404999999999973</c:v>
                </c:pt>
                <c:pt idx="195">
                  <c:v>13.750999999999976</c:v>
                </c:pt>
                <c:pt idx="196">
                  <c:v>14.909999999999968</c:v>
                </c:pt>
                <c:pt idx="197">
                  <c:v>17.517000000000053</c:v>
                </c:pt>
                <c:pt idx="198">
                  <c:v>25.346000000000004</c:v>
                </c:pt>
                <c:pt idx="199">
                  <c:v>25.111999999999966</c:v>
                </c:pt>
                <c:pt idx="200">
                  <c:v>23.092999999999961</c:v>
                </c:pt>
                <c:pt idx="201">
                  <c:v>28.435000000000059</c:v>
                </c:pt>
                <c:pt idx="202">
                  <c:v>30.379999999999995</c:v>
                </c:pt>
              </c:numCache>
            </c:numRef>
          </c:xVal>
          <c:yVal>
            <c:numRef>
              <c:f>'Epidermis file sorting'!$AG$2:$AG$204</c:f>
              <c:numCache>
                <c:formatCode>General</c:formatCode>
                <c:ptCount val="203"/>
                <c:pt idx="138">
                  <c:v>38.765999999999998</c:v>
                </c:pt>
                <c:pt idx="139">
                  <c:v>52.9422</c:v>
                </c:pt>
                <c:pt idx="140">
                  <c:v>63.71</c:v>
                </c:pt>
                <c:pt idx="141">
                  <c:v>76.054699999999997</c:v>
                </c:pt>
                <c:pt idx="142">
                  <c:v>101.88</c:v>
                </c:pt>
                <c:pt idx="143">
                  <c:v>110.768</c:v>
                </c:pt>
                <c:pt idx="144">
                  <c:v>119.89100000000001</c:v>
                </c:pt>
                <c:pt idx="145">
                  <c:v>130.036</c:v>
                </c:pt>
                <c:pt idx="146">
                  <c:v>140.733</c:v>
                </c:pt>
                <c:pt idx="147">
                  <c:v>147.768</c:v>
                </c:pt>
                <c:pt idx="148">
                  <c:v>154.191</c:v>
                </c:pt>
                <c:pt idx="149">
                  <c:v>160.99799999999999</c:v>
                </c:pt>
                <c:pt idx="150">
                  <c:v>168.21700000000001</c:v>
                </c:pt>
                <c:pt idx="151">
                  <c:v>175.191</c:v>
                </c:pt>
                <c:pt idx="152">
                  <c:v>182.226</c:v>
                </c:pt>
                <c:pt idx="153">
                  <c:v>189.148</c:v>
                </c:pt>
                <c:pt idx="154">
                  <c:v>197.24199999999999</c:v>
                </c:pt>
                <c:pt idx="155">
                  <c:v>206.636</c:v>
                </c:pt>
                <c:pt idx="156">
                  <c:v>216.071</c:v>
                </c:pt>
                <c:pt idx="157">
                  <c:v>224.386</c:v>
                </c:pt>
                <c:pt idx="158">
                  <c:v>232.82</c:v>
                </c:pt>
                <c:pt idx="159">
                  <c:v>241.958</c:v>
                </c:pt>
                <c:pt idx="160">
                  <c:v>256.88499999999999</c:v>
                </c:pt>
                <c:pt idx="161">
                  <c:v>273.517</c:v>
                </c:pt>
                <c:pt idx="162">
                  <c:v>282.97500000000002</c:v>
                </c:pt>
                <c:pt idx="163">
                  <c:v>294.56900000000002</c:v>
                </c:pt>
                <c:pt idx="164">
                  <c:v>306.17599999999999</c:v>
                </c:pt>
                <c:pt idx="165">
                  <c:v>315.75200000000001</c:v>
                </c:pt>
                <c:pt idx="166">
                  <c:v>324.57600000000002</c:v>
                </c:pt>
                <c:pt idx="167">
                  <c:v>333.846</c:v>
                </c:pt>
                <c:pt idx="168">
                  <c:v>344.04399999999998</c:v>
                </c:pt>
                <c:pt idx="169">
                  <c:v>352.36</c:v>
                </c:pt>
                <c:pt idx="170">
                  <c:v>359.71800000000002</c:v>
                </c:pt>
                <c:pt idx="171">
                  <c:v>367.66899999999998</c:v>
                </c:pt>
                <c:pt idx="172">
                  <c:v>377.33499999999998</c:v>
                </c:pt>
                <c:pt idx="173">
                  <c:v>388.86599999999999</c:v>
                </c:pt>
                <c:pt idx="174">
                  <c:v>401.13099999999997</c:v>
                </c:pt>
                <c:pt idx="175">
                  <c:v>410.64100000000002</c:v>
                </c:pt>
                <c:pt idx="176">
                  <c:v>420.59100000000001</c:v>
                </c:pt>
                <c:pt idx="177">
                  <c:v>430.286</c:v>
                </c:pt>
                <c:pt idx="178">
                  <c:v>437.00400000000002</c:v>
                </c:pt>
                <c:pt idx="179">
                  <c:v>443.971</c:v>
                </c:pt>
                <c:pt idx="180">
                  <c:v>450.82299999999998</c:v>
                </c:pt>
                <c:pt idx="181">
                  <c:v>457.9</c:v>
                </c:pt>
                <c:pt idx="182">
                  <c:v>465.565</c:v>
                </c:pt>
                <c:pt idx="183">
                  <c:v>473.96100000000001</c:v>
                </c:pt>
                <c:pt idx="184">
                  <c:v>485.12599999999998</c:v>
                </c:pt>
                <c:pt idx="185">
                  <c:v>498.75099999999998</c:v>
                </c:pt>
                <c:pt idx="186">
                  <c:v>513.077</c:v>
                </c:pt>
                <c:pt idx="187">
                  <c:v>524.95399999999995</c:v>
                </c:pt>
                <c:pt idx="188">
                  <c:v>533.26599999999996</c:v>
                </c:pt>
                <c:pt idx="189">
                  <c:v>545.98199999999997</c:v>
                </c:pt>
                <c:pt idx="190">
                  <c:v>559.91399999999999</c:v>
                </c:pt>
                <c:pt idx="191">
                  <c:v>569.71199999999999</c:v>
                </c:pt>
                <c:pt idx="192">
                  <c:v>583.22199999999998</c:v>
                </c:pt>
                <c:pt idx="193">
                  <c:v>598.34100000000001</c:v>
                </c:pt>
                <c:pt idx="194">
                  <c:v>611.04600000000005</c:v>
                </c:pt>
                <c:pt idx="195">
                  <c:v>624.45100000000002</c:v>
                </c:pt>
                <c:pt idx="196">
                  <c:v>638.202</c:v>
                </c:pt>
                <c:pt idx="197">
                  <c:v>653.11199999999997</c:v>
                </c:pt>
                <c:pt idx="198">
                  <c:v>670.62900000000002</c:v>
                </c:pt>
                <c:pt idx="199">
                  <c:v>695.97500000000002</c:v>
                </c:pt>
                <c:pt idx="200">
                  <c:v>721.08699999999999</c:v>
                </c:pt>
                <c:pt idx="201">
                  <c:v>744.18</c:v>
                </c:pt>
                <c:pt idx="202">
                  <c:v>772.615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0D3-4984-ABAD-A98D1E09D1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1265984"/>
        <c:axId val="421266312"/>
      </c:scatterChart>
      <c:valAx>
        <c:axId val="421265984"/>
        <c:scaling>
          <c:orientation val="minMax"/>
          <c:max val="50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21266312"/>
        <c:crosses val="autoZero"/>
        <c:crossBetween val="midCat"/>
      </c:valAx>
      <c:valAx>
        <c:axId val="421266312"/>
        <c:scaling>
          <c:orientation val="minMax"/>
          <c:max val="8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212659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Cell file sorted'!$Q$1:$Q$198</c:f>
              <c:numCache>
                <c:formatCode>General</c:formatCode>
                <c:ptCount val="198"/>
                <c:pt idx="0">
                  <c:v>6.4819999999999993</c:v>
                </c:pt>
                <c:pt idx="1">
                  <c:v>7.1349999999999909</c:v>
                </c:pt>
                <c:pt idx="2">
                  <c:v>8.2950000000000017</c:v>
                </c:pt>
                <c:pt idx="3">
                  <c:v>10.702000000000012</c:v>
                </c:pt>
                <c:pt idx="4">
                  <c:v>10.389999999999986</c:v>
                </c:pt>
                <c:pt idx="5">
                  <c:v>10.854000000000013</c:v>
                </c:pt>
                <c:pt idx="6">
                  <c:v>8.5619999999999834</c:v>
                </c:pt>
                <c:pt idx="7">
                  <c:v>6.3720000000000141</c:v>
                </c:pt>
                <c:pt idx="8">
                  <c:v>8.7709999999999866</c:v>
                </c:pt>
                <c:pt idx="9">
                  <c:v>8.5360000000000014</c:v>
                </c:pt>
                <c:pt idx="10">
                  <c:v>7.507000000000005</c:v>
                </c:pt>
                <c:pt idx="11">
                  <c:v>6.8019999999999925</c:v>
                </c:pt>
                <c:pt idx="12">
                  <c:v>5.3329999999999984</c:v>
                </c:pt>
                <c:pt idx="13">
                  <c:v>5.9080000000000155</c:v>
                </c:pt>
                <c:pt idx="14">
                  <c:v>6.5</c:v>
                </c:pt>
                <c:pt idx="15">
                  <c:v>7.4499999999999886</c:v>
                </c:pt>
                <c:pt idx="16">
                  <c:v>7.1119999999999948</c:v>
                </c:pt>
                <c:pt idx="17">
                  <c:v>7.3190000000000168</c:v>
                </c:pt>
                <c:pt idx="18">
                  <c:v>7.9249999999999829</c:v>
                </c:pt>
                <c:pt idx="19">
                  <c:v>7.9160000000000252</c:v>
                </c:pt>
                <c:pt idx="20">
                  <c:v>8.2769999999999868</c:v>
                </c:pt>
                <c:pt idx="21">
                  <c:v>7.4409999999999741</c:v>
                </c:pt>
                <c:pt idx="22">
                  <c:v>6.8370000000000459</c:v>
                </c:pt>
                <c:pt idx="23">
                  <c:v>7.9459999999999695</c:v>
                </c:pt>
                <c:pt idx="24">
                  <c:v>8.8070000000000164</c:v>
                </c:pt>
                <c:pt idx="25">
                  <c:v>8.7839999999999918</c:v>
                </c:pt>
                <c:pt idx="26">
                  <c:v>6.7370000000000232</c:v>
                </c:pt>
                <c:pt idx="27">
                  <c:v>5.1649999999999636</c:v>
                </c:pt>
                <c:pt idx="28">
                  <c:v>5.132000000000005</c:v>
                </c:pt>
                <c:pt idx="29">
                  <c:v>4.7080000000000268</c:v>
                </c:pt>
                <c:pt idx="30">
                  <c:v>4.6669999999999732</c:v>
                </c:pt>
                <c:pt idx="31">
                  <c:v>5.1469999999999914</c:v>
                </c:pt>
                <c:pt idx="32">
                  <c:v>7.6050000000000182</c:v>
                </c:pt>
                <c:pt idx="33">
                  <c:v>9.0840000000000032</c:v>
                </c:pt>
                <c:pt idx="34">
                  <c:v>7.2110000000000127</c:v>
                </c:pt>
                <c:pt idx="35">
                  <c:v>7.4149999999999636</c:v>
                </c:pt>
                <c:pt idx="36">
                  <c:v>7.4560000000000173</c:v>
                </c:pt>
                <c:pt idx="37">
                  <c:v>7.6659999999999968</c:v>
                </c:pt>
                <c:pt idx="38">
                  <c:v>8.0790000000000077</c:v>
                </c:pt>
                <c:pt idx="39">
                  <c:v>8.285000000000025</c:v>
                </c:pt>
                <c:pt idx="40">
                  <c:v>8.0489999999999782</c:v>
                </c:pt>
                <c:pt idx="41">
                  <c:v>7.964999999999975</c:v>
                </c:pt>
                <c:pt idx="42">
                  <c:v>8.5460000000000491</c:v>
                </c:pt>
                <c:pt idx="43">
                  <c:v>11.172999999999945</c:v>
                </c:pt>
                <c:pt idx="44">
                  <c:v>8.8210000000000264</c:v>
                </c:pt>
                <c:pt idx="45">
                  <c:v>7.2169999999999845</c:v>
                </c:pt>
                <c:pt idx="46">
                  <c:v>10.265000000000043</c:v>
                </c:pt>
                <c:pt idx="47">
                  <c:v>9.6769999999999641</c:v>
                </c:pt>
                <c:pt idx="48">
                  <c:v>6.7080000000000268</c:v>
                </c:pt>
                <c:pt idx="49">
                  <c:v>8.450999999999965</c:v>
                </c:pt>
                <c:pt idx="50">
                  <c:v>11.511000000000024</c:v>
                </c:pt>
                <c:pt idx="51">
                  <c:v>11.793000000000006</c:v>
                </c:pt>
                <c:pt idx="52">
                  <c:v>9.6649999999999636</c:v>
                </c:pt>
                <c:pt idx="53">
                  <c:v>9.2810000000000628</c:v>
                </c:pt>
                <c:pt idx="54">
                  <c:v>18.241999999999962</c:v>
                </c:pt>
                <c:pt idx="55">
                  <c:v>14.067999999999984</c:v>
                </c:pt>
                <c:pt idx="56">
                  <c:v>17.548999999999978</c:v>
                </c:pt>
                <c:pt idx="57">
                  <c:v>21.368000000000052</c:v>
                </c:pt>
                <c:pt idx="58">
                  <c:v>19.783000000000015</c:v>
                </c:pt>
                <c:pt idx="59">
                  <c:v>18.740000000000009</c:v>
                </c:pt>
                <c:pt idx="60">
                  <c:v>19.567999999999984</c:v>
                </c:pt>
                <c:pt idx="61">
                  <c:v>26.959999999999923</c:v>
                </c:pt>
                <c:pt idx="62">
                  <c:v>33.94500000000005</c:v>
                </c:pt>
                <c:pt idx="63">
                  <c:v>34.350999999999999</c:v>
                </c:pt>
                <c:pt idx="64">
                  <c:v>40.33400000000006</c:v>
                </c:pt>
                <c:pt idx="65">
                  <c:v>6.777000000000001</c:v>
                </c:pt>
                <c:pt idx="66">
                  <c:v>7.3070000000000022</c:v>
                </c:pt>
                <c:pt idx="67">
                  <c:v>7.5919999999999987</c:v>
                </c:pt>
                <c:pt idx="68">
                  <c:v>7.6080000000000041</c:v>
                </c:pt>
                <c:pt idx="69">
                  <c:v>8.4089999999999918</c:v>
                </c:pt>
                <c:pt idx="70">
                  <c:v>10.800000000000011</c:v>
                </c:pt>
                <c:pt idx="71">
                  <c:v>11.221000000000004</c:v>
                </c:pt>
                <c:pt idx="72">
                  <c:v>10.75</c:v>
                </c:pt>
                <c:pt idx="73">
                  <c:v>8.5180000000000007</c:v>
                </c:pt>
                <c:pt idx="74">
                  <c:v>6.518999999999977</c:v>
                </c:pt>
                <c:pt idx="75">
                  <c:v>8.9980000000000189</c:v>
                </c:pt>
                <c:pt idx="76">
                  <c:v>8.2659999999999911</c:v>
                </c:pt>
                <c:pt idx="77">
                  <c:v>5.73599999999999</c:v>
                </c:pt>
                <c:pt idx="78">
                  <c:v>5.9920000000000186</c:v>
                </c:pt>
                <c:pt idx="79">
                  <c:v>9.2999999999999829</c:v>
                </c:pt>
                <c:pt idx="80">
                  <c:v>10.209000000000003</c:v>
                </c:pt>
                <c:pt idx="81">
                  <c:v>9.4200000000000159</c:v>
                </c:pt>
                <c:pt idx="82">
                  <c:v>13.231999999999999</c:v>
                </c:pt>
                <c:pt idx="83">
                  <c:v>10.62700000000001</c:v>
                </c:pt>
                <c:pt idx="84">
                  <c:v>6.3220000000000027</c:v>
                </c:pt>
                <c:pt idx="85">
                  <c:v>6.7090000000000032</c:v>
                </c:pt>
                <c:pt idx="86">
                  <c:v>7.5009999999999764</c:v>
                </c:pt>
                <c:pt idx="87">
                  <c:v>8.8519999999999754</c:v>
                </c:pt>
                <c:pt idx="88">
                  <c:v>9.0030000000000427</c:v>
                </c:pt>
                <c:pt idx="89">
                  <c:v>6.7409999999999854</c:v>
                </c:pt>
                <c:pt idx="90">
                  <c:v>5.0489999999999782</c:v>
                </c:pt>
                <c:pt idx="91">
                  <c:v>5.3670000000000186</c:v>
                </c:pt>
                <c:pt idx="92">
                  <c:v>5.9370000000000118</c:v>
                </c:pt>
                <c:pt idx="93">
                  <c:v>7.3059999999999832</c:v>
                </c:pt>
                <c:pt idx="94">
                  <c:v>9.5919999999999845</c:v>
                </c:pt>
                <c:pt idx="95">
                  <c:v>9.0100000000000477</c:v>
                </c:pt>
                <c:pt idx="96">
                  <c:v>6.8579999999999472</c:v>
                </c:pt>
                <c:pt idx="97">
                  <c:v>6.0850000000000364</c:v>
                </c:pt>
                <c:pt idx="98">
                  <c:v>7.8100000000000023</c:v>
                </c:pt>
                <c:pt idx="99">
                  <c:v>7.8369999999999891</c:v>
                </c:pt>
                <c:pt idx="100">
                  <c:v>8.6610000000000014</c:v>
                </c:pt>
                <c:pt idx="101">
                  <c:v>8.6220000000000141</c:v>
                </c:pt>
                <c:pt idx="102">
                  <c:v>8.2909999999999968</c:v>
                </c:pt>
                <c:pt idx="103">
                  <c:v>7.8360000000000127</c:v>
                </c:pt>
                <c:pt idx="104">
                  <c:v>8.5809999999999604</c:v>
                </c:pt>
                <c:pt idx="105">
                  <c:v>9.0970000000000368</c:v>
                </c:pt>
                <c:pt idx="106">
                  <c:v>9.8100000000000023</c:v>
                </c:pt>
                <c:pt idx="107">
                  <c:v>8.3369999999999891</c:v>
                </c:pt>
                <c:pt idx="108">
                  <c:v>11.216000000000008</c:v>
                </c:pt>
                <c:pt idx="109">
                  <c:v>10.508999999999958</c:v>
                </c:pt>
                <c:pt idx="110">
                  <c:v>9.4910000000000423</c:v>
                </c:pt>
                <c:pt idx="111">
                  <c:v>7.7759999999999536</c:v>
                </c:pt>
                <c:pt idx="112">
                  <c:v>9.1059999999999945</c:v>
                </c:pt>
                <c:pt idx="113">
                  <c:v>13.784000000000049</c:v>
                </c:pt>
                <c:pt idx="114">
                  <c:v>15.794999999999959</c:v>
                </c:pt>
                <c:pt idx="115">
                  <c:v>13.539999999999964</c:v>
                </c:pt>
                <c:pt idx="116">
                  <c:v>13.375</c:v>
                </c:pt>
                <c:pt idx="117">
                  <c:v>15.232000000000085</c:v>
                </c:pt>
                <c:pt idx="118">
                  <c:v>15.951999999999998</c:v>
                </c:pt>
                <c:pt idx="119">
                  <c:v>16.000999999999976</c:v>
                </c:pt>
                <c:pt idx="120">
                  <c:v>16.255999999999972</c:v>
                </c:pt>
                <c:pt idx="121">
                  <c:v>18.425000000000068</c:v>
                </c:pt>
                <c:pt idx="122">
                  <c:v>21.519000000000005</c:v>
                </c:pt>
                <c:pt idx="123">
                  <c:v>26.405999999999949</c:v>
                </c:pt>
                <c:pt idx="124">
                  <c:v>24.899999999999977</c:v>
                </c:pt>
                <c:pt idx="125">
                  <c:v>28.072000000000003</c:v>
                </c:pt>
                <c:pt idx="126">
                  <c:v>30.980000000000018</c:v>
                </c:pt>
                <c:pt idx="127">
                  <c:v>7.9230000000000018</c:v>
                </c:pt>
                <c:pt idx="128">
                  <c:v>7.2460000000000093</c:v>
                </c:pt>
                <c:pt idx="129">
                  <c:v>7.3449999999999989</c:v>
                </c:pt>
                <c:pt idx="130">
                  <c:v>7.7259999999999991</c:v>
                </c:pt>
                <c:pt idx="131">
                  <c:v>7.0229999999999961</c:v>
                </c:pt>
                <c:pt idx="132">
                  <c:v>7.3389999999999986</c:v>
                </c:pt>
                <c:pt idx="133">
                  <c:v>7.7460000000000093</c:v>
                </c:pt>
                <c:pt idx="134">
                  <c:v>9.1670000000000016</c:v>
                </c:pt>
                <c:pt idx="135">
                  <c:v>9.4819999999999993</c:v>
                </c:pt>
                <c:pt idx="136">
                  <c:v>8.8689999999999998</c:v>
                </c:pt>
                <c:pt idx="137">
                  <c:v>8.8870000000000005</c:v>
                </c:pt>
                <c:pt idx="138">
                  <c:v>8.9779999999999802</c:v>
                </c:pt>
                <c:pt idx="139">
                  <c:v>10.314000000000021</c:v>
                </c:pt>
                <c:pt idx="140">
                  <c:v>8.7539999999999907</c:v>
                </c:pt>
                <c:pt idx="141">
                  <c:v>5.4979999999999905</c:v>
                </c:pt>
                <c:pt idx="142">
                  <c:v>6.0200000000000102</c:v>
                </c:pt>
                <c:pt idx="143">
                  <c:v>6.5180000000000007</c:v>
                </c:pt>
                <c:pt idx="144">
                  <c:v>5.7069999999999936</c:v>
                </c:pt>
                <c:pt idx="145">
                  <c:v>7.9660000000000082</c:v>
                </c:pt>
                <c:pt idx="146">
                  <c:v>8.1940000000000168</c:v>
                </c:pt>
                <c:pt idx="147">
                  <c:v>5.6919999999999504</c:v>
                </c:pt>
                <c:pt idx="148">
                  <c:v>5.3710000000000377</c:v>
                </c:pt>
                <c:pt idx="149">
                  <c:v>4.7779999999999632</c:v>
                </c:pt>
                <c:pt idx="150">
                  <c:v>5.4790000000000418</c:v>
                </c:pt>
                <c:pt idx="151">
                  <c:v>6.1399999999999864</c:v>
                </c:pt>
                <c:pt idx="152">
                  <c:v>5.8170000000000073</c:v>
                </c:pt>
                <c:pt idx="153">
                  <c:v>6.20799999999997</c:v>
                </c:pt>
                <c:pt idx="154">
                  <c:v>8.4700000000000273</c:v>
                </c:pt>
                <c:pt idx="155">
                  <c:v>10.704999999999984</c:v>
                </c:pt>
                <c:pt idx="156">
                  <c:v>8.3079999999999927</c:v>
                </c:pt>
                <c:pt idx="157">
                  <c:v>6.1150000000000091</c:v>
                </c:pt>
                <c:pt idx="158">
                  <c:v>6.3380000000000223</c:v>
                </c:pt>
                <c:pt idx="159">
                  <c:v>6.8059999999999832</c:v>
                </c:pt>
                <c:pt idx="160">
                  <c:v>7.5430000000000064</c:v>
                </c:pt>
                <c:pt idx="161">
                  <c:v>7.6610000000000014</c:v>
                </c:pt>
                <c:pt idx="162">
                  <c:v>7.2629999999999768</c:v>
                </c:pt>
                <c:pt idx="163">
                  <c:v>7.6270000000000095</c:v>
                </c:pt>
                <c:pt idx="164">
                  <c:v>7.5520000000000209</c:v>
                </c:pt>
                <c:pt idx="165">
                  <c:v>7.3789999999999623</c:v>
                </c:pt>
                <c:pt idx="166">
                  <c:v>8.1450000000000387</c:v>
                </c:pt>
                <c:pt idx="167">
                  <c:v>8.9449999999999932</c:v>
                </c:pt>
                <c:pt idx="168">
                  <c:v>8.6139999999999759</c:v>
                </c:pt>
                <c:pt idx="169">
                  <c:v>8.7830000000000155</c:v>
                </c:pt>
                <c:pt idx="170">
                  <c:v>9.3149999999999977</c:v>
                </c:pt>
                <c:pt idx="171">
                  <c:v>9.160000000000025</c:v>
                </c:pt>
                <c:pt idx="172">
                  <c:v>9.7029999999999745</c:v>
                </c:pt>
                <c:pt idx="173">
                  <c:v>7.5529999999999973</c:v>
                </c:pt>
                <c:pt idx="174">
                  <c:v>5.6170000000000186</c:v>
                </c:pt>
                <c:pt idx="175">
                  <c:v>8.0639999999999645</c:v>
                </c:pt>
                <c:pt idx="176">
                  <c:v>10.559000000000026</c:v>
                </c:pt>
                <c:pt idx="177">
                  <c:v>9.5760000000000218</c:v>
                </c:pt>
                <c:pt idx="178">
                  <c:v>9.7829999999999586</c:v>
                </c:pt>
                <c:pt idx="179">
                  <c:v>12.783000000000072</c:v>
                </c:pt>
                <c:pt idx="180">
                  <c:v>14.567999999999984</c:v>
                </c:pt>
                <c:pt idx="181">
                  <c:v>14.41599999999994</c:v>
                </c:pt>
                <c:pt idx="182">
                  <c:v>11.574000000000069</c:v>
                </c:pt>
                <c:pt idx="183">
                  <c:v>8.9379999999999882</c:v>
                </c:pt>
                <c:pt idx="184">
                  <c:v>10.687999999999988</c:v>
                </c:pt>
                <c:pt idx="185">
                  <c:v>11.086000000000013</c:v>
                </c:pt>
                <c:pt idx="186">
                  <c:v>11.014999999999986</c:v>
                </c:pt>
                <c:pt idx="187">
                  <c:v>30.04200000000003</c:v>
                </c:pt>
                <c:pt idx="188">
                  <c:v>18.057999999999993</c:v>
                </c:pt>
                <c:pt idx="189">
                  <c:v>18.906999999999925</c:v>
                </c:pt>
                <c:pt idx="190">
                  <c:v>25.061000000000035</c:v>
                </c:pt>
                <c:pt idx="191">
                  <c:v>22.865000000000009</c:v>
                </c:pt>
                <c:pt idx="192">
                  <c:v>19.269000000000005</c:v>
                </c:pt>
                <c:pt idx="193">
                  <c:v>23.428999999999974</c:v>
                </c:pt>
                <c:pt idx="194">
                  <c:v>22.865000000000009</c:v>
                </c:pt>
                <c:pt idx="195">
                  <c:v>19.269000000000005</c:v>
                </c:pt>
                <c:pt idx="196">
                  <c:v>23.428999999999974</c:v>
                </c:pt>
                <c:pt idx="197">
                  <c:v>30.265999999999963</c:v>
                </c:pt>
              </c:numCache>
            </c:numRef>
          </c:xVal>
          <c:yVal>
            <c:numRef>
              <c:f>'Cell file sorted'!$R$1:$R$198</c:f>
              <c:numCache>
                <c:formatCode>General</c:formatCode>
                <c:ptCount val="198"/>
                <c:pt idx="0">
                  <c:v>103.489</c:v>
                </c:pt>
                <c:pt idx="1">
                  <c:v>109.971</c:v>
                </c:pt>
                <c:pt idx="2">
                  <c:v>117.10599999999999</c:v>
                </c:pt>
                <c:pt idx="3">
                  <c:v>125.401</c:v>
                </c:pt>
                <c:pt idx="4">
                  <c:v>136.10300000000001</c:v>
                </c:pt>
                <c:pt idx="5">
                  <c:v>146.49299999999999</c:v>
                </c:pt>
                <c:pt idx="6">
                  <c:v>157.34700000000001</c:v>
                </c:pt>
                <c:pt idx="7">
                  <c:v>165.90899999999999</c:v>
                </c:pt>
                <c:pt idx="8">
                  <c:v>172.28100000000001</c:v>
                </c:pt>
                <c:pt idx="9">
                  <c:v>181.05199999999999</c:v>
                </c:pt>
                <c:pt idx="10">
                  <c:v>189.58799999999999</c:v>
                </c:pt>
                <c:pt idx="11">
                  <c:v>197.095</c:v>
                </c:pt>
                <c:pt idx="12">
                  <c:v>203.89699999999999</c:v>
                </c:pt>
                <c:pt idx="13">
                  <c:v>209.23</c:v>
                </c:pt>
                <c:pt idx="14">
                  <c:v>215.13800000000001</c:v>
                </c:pt>
                <c:pt idx="15">
                  <c:v>221.63800000000001</c:v>
                </c:pt>
                <c:pt idx="16">
                  <c:v>229.08799999999999</c:v>
                </c:pt>
                <c:pt idx="17">
                  <c:v>236.2</c:v>
                </c:pt>
                <c:pt idx="18">
                  <c:v>243.51900000000001</c:v>
                </c:pt>
                <c:pt idx="19">
                  <c:v>251.44399999999999</c:v>
                </c:pt>
                <c:pt idx="20">
                  <c:v>259.36</c:v>
                </c:pt>
                <c:pt idx="21">
                  <c:v>267.637</c:v>
                </c:pt>
                <c:pt idx="22">
                  <c:v>275.07799999999997</c:v>
                </c:pt>
                <c:pt idx="23">
                  <c:v>281.91500000000002</c:v>
                </c:pt>
                <c:pt idx="24">
                  <c:v>289.86099999999999</c:v>
                </c:pt>
                <c:pt idx="25">
                  <c:v>298.66800000000001</c:v>
                </c:pt>
                <c:pt idx="26">
                  <c:v>307.452</c:v>
                </c:pt>
                <c:pt idx="27">
                  <c:v>314.18900000000002</c:v>
                </c:pt>
                <c:pt idx="28">
                  <c:v>319.35399999999998</c:v>
                </c:pt>
                <c:pt idx="29">
                  <c:v>324.48599999999999</c:v>
                </c:pt>
                <c:pt idx="30">
                  <c:v>329.19400000000002</c:v>
                </c:pt>
                <c:pt idx="31">
                  <c:v>333.86099999999999</c:v>
                </c:pt>
                <c:pt idx="32">
                  <c:v>339.00799999999998</c:v>
                </c:pt>
                <c:pt idx="33">
                  <c:v>346.613</c:v>
                </c:pt>
                <c:pt idx="34">
                  <c:v>355.697</c:v>
                </c:pt>
                <c:pt idx="35">
                  <c:v>362.90800000000002</c:v>
                </c:pt>
                <c:pt idx="36">
                  <c:v>370.32299999999998</c:v>
                </c:pt>
                <c:pt idx="37">
                  <c:v>377.779</c:v>
                </c:pt>
                <c:pt idx="38">
                  <c:v>385.44499999999999</c:v>
                </c:pt>
                <c:pt idx="39">
                  <c:v>393.524</c:v>
                </c:pt>
                <c:pt idx="40">
                  <c:v>401.80900000000003</c:v>
                </c:pt>
                <c:pt idx="41">
                  <c:v>409.858</c:v>
                </c:pt>
                <c:pt idx="42">
                  <c:v>417.82299999999998</c:v>
                </c:pt>
                <c:pt idx="43">
                  <c:v>426.36900000000003</c:v>
                </c:pt>
                <c:pt idx="44">
                  <c:v>437.54199999999997</c:v>
                </c:pt>
                <c:pt idx="45">
                  <c:v>446.363</c:v>
                </c:pt>
                <c:pt idx="46">
                  <c:v>453.58</c:v>
                </c:pt>
                <c:pt idx="47">
                  <c:v>463.84500000000003</c:v>
                </c:pt>
                <c:pt idx="48">
                  <c:v>473.52199999999999</c:v>
                </c:pt>
                <c:pt idx="49">
                  <c:v>480.23</c:v>
                </c:pt>
                <c:pt idx="50">
                  <c:v>488.68099999999998</c:v>
                </c:pt>
                <c:pt idx="51">
                  <c:v>500.19200000000001</c:v>
                </c:pt>
                <c:pt idx="52">
                  <c:v>511.98500000000001</c:v>
                </c:pt>
                <c:pt idx="53">
                  <c:v>521.65</c:v>
                </c:pt>
                <c:pt idx="54">
                  <c:v>530.93100000000004</c:v>
                </c:pt>
                <c:pt idx="55">
                  <c:v>549.173</c:v>
                </c:pt>
                <c:pt idx="56">
                  <c:v>563.24099999999999</c:v>
                </c:pt>
                <c:pt idx="57">
                  <c:v>580.79</c:v>
                </c:pt>
                <c:pt idx="58">
                  <c:v>602.15800000000002</c:v>
                </c:pt>
                <c:pt idx="59">
                  <c:v>621.94100000000003</c:v>
                </c:pt>
                <c:pt idx="60">
                  <c:v>640.68100000000004</c:v>
                </c:pt>
                <c:pt idx="61">
                  <c:v>660.24900000000002</c:v>
                </c:pt>
                <c:pt idx="62">
                  <c:v>687.20899999999995</c:v>
                </c:pt>
                <c:pt idx="63">
                  <c:v>721.154</c:v>
                </c:pt>
                <c:pt idx="64">
                  <c:v>755.5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32E-493E-8A8A-1FF5C354B741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Cell file sorted'!$Q$1:$Q$198</c:f>
              <c:numCache>
                <c:formatCode>General</c:formatCode>
                <c:ptCount val="198"/>
                <c:pt idx="0">
                  <c:v>6.4819999999999993</c:v>
                </c:pt>
                <c:pt idx="1">
                  <c:v>7.1349999999999909</c:v>
                </c:pt>
                <c:pt idx="2">
                  <c:v>8.2950000000000017</c:v>
                </c:pt>
                <c:pt idx="3">
                  <c:v>10.702000000000012</c:v>
                </c:pt>
                <c:pt idx="4">
                  <c:v>10.389999999999986</c:v>
                </c:pt>
                <c:pt idx="5">
                  <c:v>10.854000000000013</c:v>
                </c:pt>
                <c:pt idx="6">
                  <c:v>8.5619999999999834</c:v>
                </c:pt>
                <c:pt idx="7">
                  <c:v>6.3720000000000141</c:v>
                </c:pt>
                <c:pt idx="8">
                  <c:v>8.7709999999999866</c:v>
                </c:pt>
                <c:pt idx="9">
                  <c:v>8.5360000000000014</c:v>
                </c:pt>
                <c:pt idx="10">
                  <c:v>7.507000000000005</c:v>
                </c:pt>
                <c:pt idx="11">
                  <c:v>6.8019999999999925</c:v>
                </c:pt>
                <c:pt idx="12">
                  <c:v>5.3329999999999984</c:v>
                </c:pt>
                <c:pt idx="13">
                  <c:v>5.9080000000000155</c:v>
                </c:pt>
                <c:pt idx="14">
                  <c:v>6.5</c:v>
                </c:pt>
                <c:pt idx="15">
                  <c:v>7.4499999999999886</c:v>
                </c:pt>
                <c:pt idx="16">
                  <c:v>7.1119999999999948</c:v>
                </c:pt>
                <c:pt idx="17">
                  <c:v>7.3190000000000168</c:v>
                </c:pt>
                <c:pt idx="18">
                  <c:v>7.9249999999999829</c:v>
                </c:pt>
                <c:pt idx="19">
                  <c:v>7.9160000000000252</c:v>
                </c:pt>
                <c:pt idx="20">
                  <c:v>8.2769999999999868</c:v>
                </c:pt>
                <c:pt idx="21">
                  <c:v>7.4409999999999741</c:v>
                </c:pt>
                <c:pt idx="22">
                  <c:v>6.8370000000000459</c:v>
                </c:pt>
                <c:pt idx="23">
                  <c:v>7.9459999999999695</c:v>
                </c:pt>
                <c:pt idx="24">
                  <c:v>8.8070000000000164</c:v>
                </c:pt>
                <c:pt idx="25">
                  <c:v>8.7839999999999918</c:v>
                </c:pt>
                <c:pt idx="26">
                  <c:v>6.7370000000000232</c:v>
                </c:pt>
                <c:pt idx="27">
                  <c:v>5.1649999999999636</c:v>
                </c:pt>
                <c:pt idx="28">
                  <c:v>5.132000000000005</c:v>
                </c:pt>
                <c:pt idx="29">
                  <c:v>4.7080000000000268</c:v>
                </c:pt>
                <c:pt idx="30">
                  <c:v>4.6669999999999732</c:v>
                </c:pt>
                <c:pt idx="31">
                  <c:v>5.1469999999999914</c:v>
                </c:pt>
                <c:pt idx="32">
                  <c:v>7.6050000000000182</c:v>
                </c:pt>
                <c:pt idx="33">
                  <c:v>9.0840000000000032</c:v>
                </c:pt>
                <c:pt idx="34">
                  <c:v>7.2110000000000127</c:v>
                </c:pt>
                <c:pt idx="35">
                  <c:v>7.4149999999999636</c:v>
                </c:pt>
                <c:pt idx="36">
                  <c:v>7.4560000000000173</c:v>
                </c:pt>
                <c:pt idx="37">
                  <c:v>7.6659999999999968</c:v>
                </c:pt>
                <c:pt idx="38">
                  <c:v>8.0790000000000077</c:v>
                </c:pt>
                <c:pt idx="39">
                  <c:v>8.285000000000025</c:v>
                </c:pt>
                <c:pt idx="40">
                  <c:v>8.0489999999999782</c:v>
                </c:pt>
                <c:pt idx="41">
                  <c:v>7.964999999999975</c:v>
                </c:pt>
                <c:pt idx="42">
                  <c:v>8.5460000000000491</c:v>
                </c:pt>
                <c:pt idx="43">
                  <c:v>11.172999999999945</c:v>
                </c:pt>
                <c:pt idx="44">
                  <c:v>8.8210000000000264</c:v>
                </c:pt>
                <c:pt idx="45">
                  <c:v>7.2169999999999845</c:v>
                </c:pt>
                <c:pt idx="46">
                  <c:v>10.265000000000043</c:v>
                </c:pt>
                <c:pt idx="47">
                  <c:v>9.6769999999999641</c:v>
                </c:pt>
                <c:pt idx="48">
                  <c:v>6.7080000000000268</c:v>
                </c:pt>
                <c:pt idx="49">
                  <c:v>8.450999999999965</c:v>
                </c:pt>
                <c:pt idx="50">
                  <c:v>11.511000000000024</c:v>
                </c:pt>
                <c:pt idx="51">
                  <c:v>11.793000000000006</c:v>
                </c:pt>
                <c:pt idx="52">
                  <c:v>9.6649999999999636</c:v>
                </c:pt>
                <c:pt idx="53">
                  <c:v>9.2810000000000628</c:v>
                </c:pt>
                <c:pt idx="54">
                  <c:v>18.241999999999962</c:v>
                </c:pt>
                <c:pt idx="55">
                  <c:v>14.067999999999984</c:v>
                </c:pt>
                <c:pt idx="56">
                  <c:v>17.548999999999978</c:v>
                </c:pt>
                <c:pt idx="57">
                  <c:v>21.368000000000052</c:v>
                </c:pt>
                <c:pt idx="58">
                  <c:v>19.783000000000015</c:v>
                </c:pt>
                <c:pt idx="59">
                  <c:v>18.740000000000009</c:v>
                </c:pt>
                <c:pt idx="60">
                  <c:v>19.567999999999984</c:v>
                </c:pt>
                <c:pt idx="61">
                  <c:v>26.959999999999923</c:v>
                </c:pt>
                <c:pt idx="62">
                  <c:v>33.94500000000005</c:v>
                </c:pt>
                <c:pt idx="63">
                  <c:v>34.350999999999999</c:v>
                </c:pt>
                <c:pt idx="64">
                  <c:v>40.33400000000006</c:v>
                </c:pt>
                <c:pt idx="65">
                  <c:v>6.777000000000001</c:v>
                </c:pt>
                <c:pt idx="66">
                  <c:v>7.3070000000000022</c:v>
                </c:pt>
                <c:pt idx="67">
                  <c:v>7.5919999999999987</c:v>
                </c:pt>
                <c:pt idx="68">
                  <c:v>7.6080000000000041</c:v>
                </c:pt>
                <c:pt idx="69">
                  <c:v>8.4089999999999918</c:v>
                </c:pt>
                <c:pt idx="70">
                  <c:v>10.800000000000011</c:v>
                </c:pt>
                <c:pt idx="71">
                  <c:v>11.221000000000004</c:v>
                </c:pt>
                <c:pt idx="72">
                  <c:v>10.75</c:v>
                </c:pt>
                <c:pt idx="73">
                  <c:v>8.5180000000000007</c:v>
                </c:pt>
                <c:pt idx="74">
                  <c:v>6.518999999999977</c:v>
                </c:pt>
                <c:pt idx="75">
                  <c:v>8.9980000000000189</c:v>
                </c:pt>
                <c:pt idx="76">
                  <c:v>8.2659999999999911</c:v>
                </c:pt>
                <c:pt idx="77">
                  <c:v>5.73599999999999</c:v>
                </c:pt>
                <c:pt idx="78">
                  <c:v>5.9920000000000186</c:v>
                </c:pt>
                <c:pt idx="79">
                  <c:v>9.2999999999999829</c:v>
                </c:pt>
                <c:pt idx="80">
                  <c:v>10.209000000000003</c:v>
                </c:pt>
                <c:pt idx="81">
                  <c:v>9.4200000000000159</c:v>
                </c:pt>
                <c:pt idx="82">
                  <c:v>13.231999999999999</c:v>
                </c:pt>
                <c:pt idx="83">
                  <c:v>10.62700000000001</c:v>
                </c:pt>
                <c:pt idx="84">
                  <c:v>6.3220000000000027</c:v>
                </c:pt>
                <c:pt idx="85">
                  <c:v>6.7090000000000032</c:v>
                </c:pt>
                <c:pt idx="86">
                  <c:v>7.5009999999999764</c:v>
                </c:pt>
                <c:pt idx="87">
                  <c:v>8.8519999999999754</c:v>
                </c:pt>
                <c:pt idx="88">
                  <c:v>9.0030000000000427</c:v>
                </c:pt>
                <c:pt idx="89">
                  <c:v>6.7409999999999854</c:v>
                </c:pt>
                <c:pt idx="90">
                  <c:v>5.0489999999999782</c:v>
                </c:pt>
                <c:pt idx="91">
                  <c:v>5.3670000000000186</c:v>
                </c:pt>
                <c:pt idx="92">
                  <c:v>5.9370000000000118</c:v>
                </c:pt>
                <c:pt idx="93">
                  <c:v>7.3059999999999832</c:v>
                </c:pt>
                <c:pt idx="94">
                  <c:v>9.5919999999999845</c:v>
                </c:pt>
                <c:pt idx="95">
                  <c:v>9.0100000000000477</c:v>
                </c:pt>
                <c:pt idx="96">
                  <c:v>6.8579999999999472</c:v>
                </c:pt>
                <c:pt idx="97">
                  <c:v>6.0850000000000364</c:v>
                </c:pt>
                <c:pt idx="98">
                  <c:v>7.8100000000000023</c:v>
                </c:pt>
                <c:pt idx="99">
                  <c:v>7.8369999999999891</c:v>
                </c:pt>
                <c:pt idx="100">
                  <c:v>8.6610000000000014</c:v>
                </c:pt>
                <c:pt idx="101">
                  <c:v>8.6220000000000141</c:v>
                </c:pt>
                <c:pt idx="102">
                  <c:v>8.2909999999999968</c:v>
                </c:pt>
                <c:pt idx="103">
                  <c:v>7.8360000000000127</c:v>
                </c:pt>
                <c:pt idx="104">
                  <c:v>8.5809999999999604</c:v>
                </c:pt>
                <c:pt idx="105">
                  <c:v>9.0970000000000368</c:v>
                </c:pt>
                <c:pt idx="106">
                  <c:v>9.8100000000000023</c:v>
                </c:pt>
                <c:pt idx="107">
                  <c:v>8.3369999999999891</c:v>
                </c:pt>
                <c:pt idx="108">
                  <c:v>11.216000000000008</c:v>
                </c:pt>
                <c:pt idx="109">
                  <c:v>10.508999999999958</c:v>
                </c:pt>
                <c:pt idx="110">
                  <c:v>9.4910000000000423</c:v>
                </c:pt>
                <c:pt idx="111">
                  <c:v>7.7759999999999536</c:v>
                </c:pt>
                <c:pt idx="112">
                  <c:v>9.1059999999999945</c:v>
                </c:pt>
                <c:pt idx="113">
                  <c:v>13.784000000000049</c:v>
                </c:pt>
                <c:pt idx="114">
                  <c:v>15.794999999999959</c:v>
                </c:pt>
                <c:pt idx="115">
                  <c:v>13.539999999999964</c:v>
                </c:pt>
                <c:pt idx="116">
                  <c:v>13.375</c:v>
                </c:pt>
                <c:pt idx="117">
                  <c:v>15.232000000000085</c:v>
                </c:pt>
                <c:pt idx="118">
                  <c:v>15.951999999999998</c:v>
                </c:pt>
                <c:pt idx="119">
                  <c:v>16.000999999999976</c:v>
                </c:pt>
                <c:pt idx="120">
                  <c:v>16.255999999999972</c:v>
                </c:pt>
                <c:pt idx="121">
                  <c:v>18.425000000000068</c:v>
                </c:pt>
                <c:pt idx="122">
                  <c:v>21.519000000000005</c:v>
                </c:pt>
                <c:pt idx="123">
                  <c:v>26.405999999999949</c:v>
                </c:pt>
                <c:pt idx="124">
                  <c:v>24.899999999999977</c:v>
                </c:pt>
                <c:pt idx="125">
                  <c:v>28.072000000000003</c:v>
                </c:pt>
                <c:pt idx="126">
                  <c:v>30.980000000000018</c:v>
                </c:pt>
                <c:pt idx="127">
                  <c:v>7.9230000000000018</c:v>
                </c:pt>
                <c:pt idx="128">
                  <c:v>7.2460000000000093</c:v>
                </c:pt>
                <c:pt idx="129">
                  <c:v>7.3449999999999989</c:v>
                </c:pt>
                <c:pt idx="130">
                  <c:v>7.7259999999999991</c:v>
                </c:pt>
                <c:pt idx="131">
                  <c:v>7.0229999999999961</c:v>
                </c:pt>
                <c:pt idx="132">
                  <c:v>7.3389999999999986</c:v>
                </c:pt>
                <c:pt idx="133">
                  <c:v>7.7460000000000093</c:v>
                </c:pt>
                <c:pt idx="134">
                  <c:v>9.1670000000000016</c:v>
                </c:pt>
                <c:pt idx="135">
                  <c:v>9.4819999999999993</c:v>
                </c:pt>
                <c:pt idx="136">
                  <c:v>8.8689999999999998</c:v>
                </c:pt>
                <c:pt idx="137">
                  <c:v>8.8870000000000005</c:v>
                </c:pt>
                <c:pt idx="138">
                  <c:v>8.9779999999999802</c:v>
                </c:pt>
                <c:pt idx="139">
                  <c:v>10.314000000000021</c:v>
                </c:pt>
                <c:pt idx="140">
                  <c:v>8.7539999999999907</c:v>
                </c:pt>
                <c:pt idx="141">
                  <c:v>5.4979999999999905</c:v>
                </c:pt>
                <c:pt idx="142">
                  <c:v>6.0200000000000102</c:v>
                </c:pt>
                <c:pt idx="143">
                  <c:v>6.5180000000000007</c:v>
                </c:pt>
                <c:pt idx="144">
                  <c:v>5.7069999999999936</c:v>
                </c:pt>
                <c:pt idx="145">
                  <c:v>7.9660000000000082</c:v>
                </c:pt>
                <c:pt idx="146">
                  <c:v>8.1940000000000168</c:v>
                </c:pt>
                <c:pt idx="147">
                  <c:v>5.6919999999999504</c:v>
                </c:pt>
                <c:pt idx="148">
                  <c:v>5.3710000000000377</c:v>
                </c:pt>
                <c:pt idx="149">
                  <c:v>4.7779999999999632</c:v>
                </c:pt>
                <c:pt idx="150">
                  <c:v>5.4790000000000418</c:v>
                </c:pt>
                <c:pt idx="151">
                  <c:v>6.1399999999999864</c:v>
                </c:pt>
                <c:pt idx="152">
                  <c:v>5.8170000000000073</c:v>
                </c:pt>
                <c:pt idx="153">
                  <c:v>6.20799999999997</c:v>
                </c:pt>
                <c:pt idx="154">
                  <c:v>8.4700000000000273</c:v>
                </c:pt>
                <c:pt idx="155">
                  <c:v>10.704999999999984</c:v>
                </c:pt>
                <c:pt idx="156">
                  <c:v>8.3079999999999927</c:v>
                </c:pt>
                <c:pt idx="157">
                  <c:v>6.1150000000000091</c:v>
                </c:pt>
                <c:pt idx="158">
                  <c:v>6.3380000000000223</c:v>
                </c:pt>
                <c:pt idx="159">
                  <c:v>6.8059999999999832</c:v>
                </c:pt>
                <c:pt idx="160">
                  <c:v>7.5430000000000064</c:v>
                </c:pt>
                <c:pt idx="161">
                  <c:v>7.6610000000000014</c:v>
                </c:pt>
                <c:pt idx="162">
                  <c:v>7.2629999999999768</c:v>
                </c:pt>
                <c:pt idx="163">
                  <c:v>7.6270000000000095</c:v>
                </c:pt>
                <c:pt idx="164">
                  <c:v>7.5520000000000209</c:v>
                </c:pt>
                <c:pt idx="165">
                  <c:v>7.3789999999999623</c:v>
                </c:pt>
                <c:pt idx="166">
                  <c:v>8.1450000000000387</c:v>
                </c:pt>
                <c:pt idx="167">
                  <c:v>8.9449999999999932</c:v>
                </c:pt>
                <c:pt idx="168">
                  <c:v>8.6139999999999759</c:v>
                </c:pt>
                <c:pt idx="169">
                  <c:v>8.7830000000000155</c:v>
                </c:pt>
                <c:pt idx="170">
                  <c:v>9.3149999999999977</c:v>
                </c:pt>
                <c:pt idx="171">
                  <c:v>9.160000000000025</c:v>
                </c:pt>
                <c:pt idx="172">
                  <c:v>9.7029999999999745</c:v>
                </c:pt>
                <c:pt idx="173">
                  <c:v>7.5529999999999973</c:v>
                </c:pt>
                <c:pt idx="174">
                  <c:v>5.6170000000000186</c:v>
                </c:pt>
                <c:pt idx="175">
                  <c:v>8.0639999999999645</c:v>
                </c:pt>
                <c:pt idx="176">
                  <c:v>10.559000000000026</c:v>
                </c:pt>
                <c:pt idx="177">
                  <c:v>9.5760000000000218</c:v>
                </c:pt>
                <c:pt idx="178">
                  <c:v>9.7829999999999586</c:v>
                </c:pt>
                <c:pt idx="179">
                  <c:v>12.783000000000072</c:v>
                </c:pt>
                <c:pt idx="180">
                  <c:v>14.567999999999984</c:v>
                </c:pt>
                <c:pt idx="181">
                  <c:v>14.41599999999994</c:v>
                </c:pt>
                <c:pt idx="182">
                  <c:v>11.574000000000069</c:v>
                </c:pt>
                <c:pt idx="183">
                  <c:v>8.9379999999999882</c:v>
                </c:pt>
                <c:pt idx="184">
                  <c:v>10.687999999999988</c:v>
                </c:pt>
                <c:pt idx="185">
                  <c:v>11.086000000000013</c:v>
                </c:pt>
                <c:pt idx="186">
                  <c:v>11.014999999999986</c:v>
                </c:pt>
                <c:pt idx="187">
                  <c:v>30.04200000000003</c:v>
                </c:pt>
                <c:pt idx="188">
                  <c:v>18.057999999999993</c:v>
                </c:pt>
                <c:pt idx="189">
                  <c:v>18.906999999999925</c:v>
                </c:pt>
                <c:pt idx="190">
                  <c:v>25.061000000000035</c:v>
                </c:pt>
                <c:pt idx="191">
                  <c:v>22.865000000000009</c:v>
                </c:pt>
                <c:pt idx="192">
                  <c:v>19.269000000000005</c:v>
                </c:pt>
                <c:pt idx="193">
                  <c:v>23.428999999999974</c:v>
                </c:pt>
                <c:pt idx="194">
                  <c:v>22.865000000000009</c:v>
                </c:pt>
                <c:pt idx="195">
                  <c:v>19.269000000000005</c:v>
                </c:pt>
                <c:pt idx="196">
                  <c:v>23.428999999999974</c:v>
                </c:pt>
                <c:pt idx="197">
                  <c:v>30.265999999999963</c:v>
                </c:pt>
              </c:numCache>
            </c:numRef>
          </c:xVal>
          <c:yVal>
            <c:numRef>
              <c:f>'Cell file sorted'!$S$1:$S$198</c:f>
              <c:numCache>
                <c:formatCode>General</c:formatCode>
                <c:ptCount val="198"/>
                <c:pt idx="65">
                  <c:v>106.074</c:v>
                </c:pt>
                <c:pt idx="66">
                  <c:v>112.851</c:v>
                </c:pt>
                <c:pt idx="67">
                  <c:v>120.158</c:v>
                </c:pt>
                <c:pt idx="68">
                  <c:v>127.75</c:v>
                </c:pt>
                <c:pt idx="69">
                  <c:v>135.358</c:v>
                </c:pt>
                <c:pt idx="70">
                  <c:v>143.767</c:v>
                </c:pt>
                <c:pt idx="71">
                  <c:v>154.56700000000001</c:v>
                </c:pt>
                <c:pt idx="72">
                  <c:v>165.78800000000001</c:v>
                </c:pt>
                <c:pt idx="73">
                  <c:v>176.53800000000001</c:v>
                </c:pt>
                <c:pt idx="74">
                  <c:v>185.05600000000001</c:v>
                </c:pt>
                <c:pt idx="75">
                  <c:v>191.57499999999999</c:v>
                </c:pt>
                <c:pt idx="76">
                  <c:v>200.57300000000001</c:v>
                </c:pt>
                <c:pt idx="77">
                  <c:v>208.839</c:v>
                </c:pt>
                <c:pt idx="78">
                  <c:v>214.57499999999999</c:v>
                </c:pt>
                <c:pt idx="79">
                  <c:v>220.56700000000001</c:v>
                </c:pt>
                <c:pt idx="80">
                  <c:v>229.86699999999999</c:v>
                </c:pt>
                <c:pt idx="81">
                  <c:v>240.07599999999999</c:v>
                </c:pt>
                <c:pt idx="82">
                  <c:v>249.49600000000001</c:v>
                </c:pt>
                <c:pt idx="83">
                  <c:v>262.72800000000001</c:v>
                </c:pt>
                <c:pt idx="84">
                  <c:v>273.35500000000002</c:v>
                </c:pt>
                <c:pt idx="85">
                  <c:v>279.67700000000002</c:v>
                </c:pt>
                <c:pt idx="86">
                  <c:v>286.38600000000002</c:v>
                </c:pt>
                <c:pt idx="87">
                  <c:v>293.887</c:v>
                </c:pt>
                <c:pt idx="88">
                  <c:v>302.73899999999998</c:v>
                </c:pt>
                <c:pt idx="89">
                  <c:v>311.74200000000002</c:v>
                </c:pt>
                <c:pt idx="90">
                  <c:v>318.483</c:v>
                </c:pt>
                <c:pt idx="91">
                  <c:v>323.53199999999998</c:v>
                </c:pt>
                <c:pt idx="92">
                  <c:v>328.899</c:v>
                </c:pt>
                <c:pt idx="93">
                  <c:v>334.83600000000001</c:v>
                </c:pt>
                <c:pt idx="94">
                  <c:v>342.142</c:v>
                </c:pt>
                <c:pt idx="95">
                  <c:v>351.73399999999998</c:v>
                </c:pt>
                <c:pt idx="96">
                  <c:v>360.74400000000003</c:v>
                </c:pt>
                <c:pt idx="97">
                  <c:v>367.60199999999998</c:v>
                </c:pt>
                <c:pt idx="98">
                  <c:v>373.68700000000001</c:v>
                </c:pt>
                <c:pt idx="99">
                  <c:v>381.49700000000001</c:v>
                </c:pt>
                <c:pt idx="100">
                  <c:v>389.334</c:v>
                </c:pt>
                <c:pt idx="101">
                  <c:v>397.995</c:v>
                </c:pt>
                <c:pt idx="102">
                  <c:v>406.61700000000002</c:v>
                </c:pt>
                <c:pt idx="103">
                  <c:v>414.90800000000002</c:v>
                </c:pt>
                <c:pt idx="104">
                  <c:v>422.74400000000003</c:v>
                </c:pt>
                <c:pt idx="105">
                  <c:v>431.32499999999999</c:v>
                </c:pt>
                <c:pt idx="106">
                  <c:v>440.42200000000003</c:v>
                </c:pt>
                <c:pt idx="107">
                  <c:v>450.23200000000003</c:v>
                </c:pt>
                <c:pt idx="108">
                  <c:v>458.56900000000002</c:v>
                </c:pt>
                <c:pt idx="109">
                  <c:v>469.78500000000003</c:v>
                </c:pt>
                <c:pt idx="110">
                  <c:v>480.29399999999998</c:v>
                </c:pt>
                <c:pt idx="111">
                  <c:v>489.78500000000003</c:v>
                </c:pt>
                <c:pt idx="112">
                  <c:v>497.56099999999998</c:v>
                </c:pt>
                <c:pt idx="113">
                  <c:v>506.66699999999997</c:v>
                </c:pt>
                <c:pt idx="114">
                  <c:v>520.45100000000002</c:v>
                </c:pt>
                <c:pt idx="115">
                  <c:v>536.24599999999998</c:v>
                </c:pt>
                <c:pt idx="116">
                  <c:v>549.78599999999994</c:v>
                </c:pt>
                <c:pt idx="117">
                  <c:v>563.16099999999994</c:v>
                </c:pt>
                <c:pt idx="118">
                  <c:v>578.39300000000003</c:v>
                </c:pt>
                <c:pt idx="119">
                  <c:v>594.34500000000003</c:v>
                </c:pt>
                <c:pt idx="120">
                  <c:v>610.346</c:v>
                </c:pt>
                <c:pt idx="121">
                  <c:v>626.60199999999998</c:v>
                </c:pt>
                <c:pt idx="122">
                  <c:v>645.02700000000004</c:v>
                </c:pt>
                <c:pt idx="123">
                  <c:v>666.54600000000005</c:v>
                </c:pt>
                <c:pt idx="124">
                  <c:v>692.952</c:v>
                </c:pt>
                <c:pt idx="125">
                  <c:v>717.85199999999998</c:v>
                </c:pt>
                <c:pt idx="126">
                  <c:v>745.923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32E-493E-8A8A-1FF5C354B741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Cell file sorted'!$Q$1:$Q$198</c:f>
              <c:numCache>
                <c:formatCode>General</c:formatCode>
                <c:ptCount val="198"/>
                <c:pt idx="0">
                  <c:v>6.4819999999999993</c:v>
                </c:pt>
                <c:pt idx="1">
                  <c:v>7.1349999999999909</c:v>
                </c:pt>
                <c:pt idx="2">
                  <c:v>8.2950000000000017</c:v>
                </c:pt>
                <c:pt idx="3">
                  <c:v>10.702000000000012</c:v>
                </c:pt>
                <c:pt idx="4">
                  <c:v>10.389999999999986</c:v>
                </c:pt>
                <c:pt idx="5">
                  <c:v>10.854000000000013</c:v>
                </c:pt>
                <c:pt idx="6">
                  <c:v>8.5619999999999834</c:v>
                </c:pt>
                <c:pt idx="7">
                  <c:v>6.3720000000000141</c:v>
                </c:pt>
                <c:pt idx="8">
                  <c:v>8.7709999999999866</c:v>
                </c:pt>
                <c:pt idx="9">
                  <c:v>8.5360000000000014</c:v>
                </c:pt>
                <c:pt idx="10">
                  <c:v>7.507000000000005</c:v>
                </c:pt>
                <c:pt idx="11">
                  <c:v>6.8019999999999925</c:v>
                </c:pt>
                <c:pt idx="12">
                  <c:v>5.3329999999999984</c:v>
                </c:pt>
                <c:pt idx="13">
                  <c:v>5.9080000000000155</c:v>
                </c:pt>
                <c:pt idx="14">
                  <c:v>6.5</c:v>
                </c:pt>
                <c:pt idx="15">
                  <c:v>7.4499999999999886</c:v>
                </c:pt>
                <c:pt idx="16">
                  <c:v>7.1119999999999948</c:v>
                </c:pt>
                <c:pt idx="17">
                  <c:v>7.3190000000000168</c:v>
                </c:pt>
                <c:pt idx="18">
                  <c:v>7.9249999999999829</c:v>
                </c:pt>
                <c:pt idx="19">
                  <c:v>7.9160000000000252</c:v>
                </c:pt>
                <c:pt idx="20">
                  <c:v>8.2769999999999868</c:v>
                </c:pt>
                <c:pt idx="21">
                  <c:v>7.4409999999999741</c:v>
                </c:pt>
                <c:pt idx="22">
                  <c:v>6.8370000000000459</c:v>
                </c:pt>
                <c:pt idx="23">
                  <c:v>7.9459999999999695</c:v>
                </c:pt>
                <c:pt idx="24">
                  <c:v>8.8070000000000164</c:v>
                </c:pt>
                <c:pt idx="25">
                  <c:v>8.7839999999999918</c:v>
                </c:pt>
                <c:pt idx="26">
                  <c:v>6.7370000000000232</c:v>
                </c:pt>
                <c:pt idx="27">
                  <c:v>5.1649999999999636</c:v>
                </c:pt>
                <c:pt idx="28">
                  <c:v>5.132000000000005</c:v>
                </c:pt>
                <c:pt idx="29">
                  <c:v>4.7080000000000268</c:v>
                </c:pt>
                <c:pt idx="30">
                  <c:v>4.6669999999999732</c:v>
                </c:pt>
                <c:pt idx="31">
                  <c:v>5.1469999999999914</c:v>
                </c:pt>
                <c:pt idx="32">
                  <c:v>7.6050000000000182</c:v>
                </c:pt>
                <c:pt idx="33">
                  <c:v>9.0840000000000032</c:v>
                </c:pt>
                <c:pt idx="34">
                  <c:v>7.2110000000000127</c:v>
                </c:pt>
                <c:pt idx="35">
                  <c:v>7.4149999999999636</c:v>
                </c:pt>
                <c:pt idx="36">
                  <c:v>7.4560000000000173</c:v>
                </c:pt>
                <c:pt idx="37">
                  <c:v>7.6659999999999968</c:v>
                </c:pt>
                <c:pt idx="38">
                  <c:v>8.0790000000000077</c:v>
                </c:pt>
                <c:pt idx="39">
                  <c:v>8.285000000000025</c:v>
                </c:pt>
                <c:pt idx="40">
                  <c:v>8.0489999999999782</c:v>
                </c:pt>
                <c:pt idx="41">
                  <c:v>7.964999999999975</c:v>
                </c:pt>
                <c:pt idx="42">
                  <c:v>8.5460000000000491</c:v>
                </c:pt>
                <c:pt idx="43">
                  <c:v>11.172999999999945</c:v>
                </c:pt>
                <c:pt idx="44">
                  <c:v>8.8210000000000264</c:v>
                </c:pt>
                <c:pt idx="45">
                  <c:v>7.2169999999999845</c:v>
                </c:pt>
                <c:pt idx="46">
                  <c:v>10.265000000000043</c:v>
                </c:pt>
                <c:pt idx="47">
                  <c:v>9.6769999999999641</c:v>
                </c:pt>
                <c:pt idx="48">
                  <c:v>6.7080000000000268</c:v>
                </c:pt>
                <c:pt idx="49">
                  <c:v>8.450999999999965</c:v>
                </c:pt>
                <c:pt idx="50">
                  <c:v>11.511000000000024</c:v>
                </c:pt>
                <c:pt idx="51">
                  <c:v>11.793000000000006</c:v>
                </c:pt>
                <c:pt idx="52">
                  <c:v>9.6649999999999636</c:v>
                </c:pt>
                <c:pt idx="53">
                  <c:v>9.2810000000000628</c:v>
                </c:pt>
                <c:pt idx="54">
                  <c:v>18.241999999999962</c:v>
                </c:pt>
                <c:pt idx="55">
                  <c:v>14.067999999999984</c:v>
                </c:pt>
                <c:pt idx="56">
                  <c:v>17.548999999999978</c:v>
                </c:pt>
                <c:pt idx="57">
                  <c:v>21.368000000000052</c:v>
                </c:pt>
                <c:pt idx="58">
                  <c:v>19.783000000000015</c:v>
                </c:pt>
                <c:pt idx="59">
                  <c:v>18.740000000000009</c:v>
                </c:pt>
                <c:pt idx="60">
                  <c:v>19.567999999999984</c:v>
                </c:pt>
                <c:pt idx="61">
                  <c:v>26.959999999999923</c:v>
                </c:pt>
                <c:pt idx="62">
                  <c:v>33.94500000000005</c:v>
                </c:pt>
                <c:pt idx="63">
                  <c:v>34.350999999999999</c:v>
                </c:pt>
                <c:pt idx="64">
                  <c:v>40.33400000000006</c:v>
                </c:pt>
                <c:pt idx="65">
                  <c:v>6.777000000000001</c:v>
                </c:pt>
                <c:pt idx="66">
                  <c:v>7.3070000000000022</c:v>
                </c:pt>
                <c:pt idx="67">
                  <c:v>7.5919999999999987</c:v>
                </c:pt>
                <c:pt idx="68">
                  <c:v>7.6080000000000041</c:v>
                </c:pt>
                <c:pt idx="69">
                  <c:v>8.4089999999999918</c:v>
                </c:pt>
                <c:pt idx="70">
                  <c:v>10.800000000000011</c:v>
                </c:pt>
                <c:pt idx="71">
                  <c:v>11.221000000000004</c:v>
                </c:pt>
                <c:pt idx="72">
                  <c:v>10.75</c:v>
                </c:pt>
                <c:pt idx="73">
                  <c:v>8.5180000000000007</c:v>
                </c:pt>
                <c:pt idx="74">
                  <c:v>6.518999999999977</c:v>
                </c:pt>
                <c:pt idx="75">
                  <c:v>8.9980000000000189</c:v>
                </c:pt>
                <c:pt idx="76">
                  <c:v>8.2659999999999911</c:v>
                </c:pt>
                <c:pt idx="77">
                  <c:v>5.73599999999999</c:v>
                </c:pt>
                <c:pt idx="78">
                  <c:v>5.9920000000000186</c:v>
                </c:pt>
                <c:pt idx="79">
                  <c:v>9.2999999999999829</c:v>
                </c:pt>
                <c:pt idx="80">
                  <c:v>10.209000000000003</c:v>
                </c:pt>
                <c:pt idx="81">
                  <c:v>9.4200000000000159</c:v>
                </c:pt>
                <c:pt idx="82">
                  <c:v>13.231999999999999</c:v>
                </c:pt>
                <c:pt idx="83">
                  <c:v>10.62700000000001</c:v>
                </c:pt>
                <c:pt idx="84">
                  <c:v>6.3220000000000027</c:v>
                </c:pt>
                <c:pt idx="85">
                  <c:v>6.7090000000000032</c:v>
                </c:pt>
                <c:pt idx="86">
                  <c:v>7.5009999999999764</c:v>
                </c:pt>
                <c:pt idx="87">
                  <c:v>8.8519999999999754</c:v>
                </c:pt>
                <c:pt idx="88">
                  <c:v>9.0030000000000427</c:v>
                </c:pt>
                <c:pt idx="89">
                  <c:v>6.7409999999999854</c:v>
                </c:pt>
                <c:pt idx="90">
                  <c:v>5.0489999999999782</c:v>
                </c:pt>
                <c:pt idx="91">
                  <c:v>5.3670000000000186</c:v>
                </c:pt>
                <c:pt idx="92">
                  <c:v>5.9370000000000118</c:v>
                </c:pt>
                <c:pt idx="93">
                  <c:v>7.3059999999999832</c:v>
                </c:pt>
                <c:pt idx="94">
                  <c:v>9.5919999999999845</c:v>
                </c:pt>
                <c:pt idx="95">
                  <c:v>9.0100000000000477</c:v>
                </c:pt>
                <c:pt idx="96">
                  <c:v>6.8579999999999472</c:v>
                </c:pt>
                <c:pt idx="97">
                  <c:v>6.0850000000000364</c:v>
                </c:pt>
                <c:pt idx="98">
                  <c:v>7.8100000000000023</c:v>
                </c:pt>
                <c:pt idx="99">
                  <c:v>7.8369999999999891</c:v>
                </c:pt>
                <c:pt idx="100">
                  <c:v>8.6610000000000014</c:v>
                </c:pt>
                <c:pt idx="101">
                  <c:v>8.6220000000000141</c:v>
                </c:pt>
                <c:pt idx="102">
                  <c:v>8.2909999999999968</c:v>
                </c:pt>
                <c:pt idx="103">
                  <c:v>7.8360000000000127</c:v>
                </c:pt>
                <c:pt idx="104">
                  <c:v>8.5809999999999604</c:v>
                </c:pt>
                <c:pt idx="105">
                  <c:v>9.0970000000000368</c:v>
                </c:pt>
                <c:pt idx="106">
                  <c:v>9.8100000000000023</c:v>
                </c:pt>
                <c:pt idx="107">
                  <c:v>8.3369999999999891</c:v>
                </c:pt>
                <c:pt idx="108">
                  <c:v>11.216000000000008</c:v>
                </c:pt>
                <c:pt idx="109">
                  <c:v>10.508999999999958</c:v>
                </c:pt>
                <c:pt idx="110">
                  <c:v>9.4910000000000423</c:v>
                </c:pt>
                <c:pt idx="111">
                  <c:v>7.7759999999999536</c:v>
                </c:pt>
                <c:pt idx="112">
                  <c:v>9.1059999999999945</c:v>
                </c:pt>
                <c:pt idx="113">
                  <c:v>13.784000000000049</c:v>
                </c:pt>
                <c:pt idx="114">
                  <c:v>15.794999999999959</c:v>
                </c:pt>
                <c:pt idx="115">
                  <c:v>13.539999999999964</c:v>
                </c:pt>
                <c:pt idx="116">
                  <c:v>13.375</c:v>
                </c:pt>
                <c:pt idx="117">
                  <c:v>15.232000000000085</c:v>
                </c:pt>
                <c:pt idx="118">
                  <c:v>15.951999999999998</c:v>
                </c:pt>
                <c:pt idx="119">
                  <c:v>16.000999999999976</c:v>
                </c:pt>
                <c:pt idx="120">
                  <c:v>16.255999999999972</c:v>
                </c:pt>
                <c:pt idx="121">
                  <c:v>18.425000000000068</c:v>
                </c:pt>
                <c:pt idx="122">
                  <c:v>21.519000000000005</c:v>
                </c:pt>
                <c:pt idx="123">
                  <c:v>26.405999999999949</c:v>
                </c:pt>
                <c:pt idx="124">
                  <c:v>24.899999999999977</c:v>
                </c:pt>
                <c:pt idx="125">
                  <c:v>28.072000000000003</c:v>
                </c:pt>
                <c:pt idx="126">
                  <c:v>30.980000000000018</c:v>
                </c:pt>
                <c:pt idx="127">
                  <c:v>7.9230000000000018</c:v>
                </c:pt>
                <c:pt idx="128">
                  <c:v>7.2460000000000093</c:v>
                </c:pt>
                <c:pt idx="129">
                  <c:v>7.3449999999999989</c:v>
                </c:pt>
                <c:pt idx="130">
                  <c:v>7.7259999999999991</c:v>
                </c:pt>
                <c:pt idx="131">
                  <c:v>7.0229999999999961</c:v>
                </c:pt>
                <c:pt idx="132">
                  <c:v>7.3389999999999986</c:v>
                </c:pt>
                <c:pt idx="133">
                  <c:v>7.7460000000000093</c:v>
                </c:pt>
                <c:pt idx="134">
                  <c:v>9.1670000000000016</c:v>
                </c:pt>
                <c:pt idx="135">
                  <c:v>9.4819999999999993</c:v>
                </c:pt>
                <c:pt idx="136">
                  <c:v>8.8689999999999998</c:v>
                </c:pt>
                <c:pt idx="137">
                  <c:v>8.8870000000000005</c:v>
                </c:pt>
                <c:pt idx="138">
                  <c:v>8.9779999999999802</c:v>
                </c:pt>
                <c:pt idx="139">
                  <c:v>10.314000000000021</c:v>
                </c:pt>
                <c:pt idx="140">
                  <c:v>8.7539999999999907</c:v>
                </c:pt>
                <c:pt idx="141">
                  <c:v>5.4979999999999905</c:v>
                </c:pt>
                <c:pt idx="142">
                  <c:v>6.0200000000000102</c:v>
                </c:pt>
                <c:pt idx="143">
                  <c:v>6.5180000000000007</c:v>
                </c:pt>
                <c:pt idx="144">
                  <c:v>5.7069999999999936</c:v>
                </c:pt>
                <c:pt idx="145">
                  <c:v>7.9660000000000082</c:v>
                </c:pt>
                <c:pt idx="146">
                  <c:v>8.1940000000000168</c:v>
                </c:pt>
                <c:pt idx="147">
                  <c:v>5.6919999999999504</c:v>
                </c:pt>
                <c:pt idx="148">
                  <c:v>5.3710000000000377</c:v>
                </c:pt>
                <c:pt idx="149">
                  <c:v>4.7779999999999632</c:v>
                </c:pt>
                <c:pt idx="150">
                  <c:v>5.4790000000000418</c:v>
                </c:pt>
                <c:pt idx="151">
                  <c:v>6.1399999999999864</c:v>
                </c:pt>
                <c:pt idx="152">
                  <c:v>5.8170000000000073</c:v>
                </c:pt>
                <c:pt idx="153">
                  <c:v>6.20799999999997</c:v>
                </c:pt>
                <c:pt idx="154">
                  <c:v>8.4700000000000273</c:v>
                </c:pt>
                <c:pt idx="155">
                  <c:v>10.704999999999984</c:v>
                </c:pt>
                <c:pt idx="156">
                  <c:v>8.3079999999999927</c:v>
                </c:pt>
                <c:pt idx="157">
                  <c:v>6.1150000000000091</c:v>
                </c:pt>
                <c:pt idx="158">
                  <c:v>6.3380000000000223</c:v>
                </c:pt>
                <c:pt idx="159">
                  <c:v>6.8059999999999832</c:v>
                </c:pt>
                <c:pt idx="160">
                  <c:v>7.5430000000000064</c:v>
                </c:pt>
                <c:pt idx="161">
                  <c:v>7.6610000000000014</c:v>
                </c:pt>
                <c:pt idx="162">
                  <c:v>7.2629999999999768</c:v>
                </c:pt>
                <c:pt idx="163">
                  <c:v>7.6270000000000095</c:v>
                </c:pt>
                <c:pt idx="164">
                  <c:v>7.5520000000000209</c:v>
                </c:pt>
                <c:pt idx="165">
                  <c:v>7.3789999999999623</c:v>
                </c:pt>
                <c:pt idx="166">
                  <c:v>8.1450000000000387</c:v>
                </c:pt>
                <c:pt idx="167">
                  <c:v>8.9449999999999932</c:v>
                </c:pt>
                <c:pt idx="168">
                  <c:v>8.6139999999999759</c:v>
                </c:pt>
                <c:pt idx="169">
                  <c:v>8.7830000000000155</c:v>
                </c:pt>
                <c:pt idx="170">
                  <c:v>9.3149999999999977</c:v>
                </c:pt>
                <c:pt idx="171">
                  <c:v>9.160000000000025</c:v>
                </c:pt>
                <c:pt idx="172">
                  <c:v>9.7029999999999745</c:v>
                </c:pt>
                <c:pt idx="173">
                  <c:v>7.5529999999999973</c:v>
                </c:pt>
                <c:pt idx="174">
                  <c:v>5.6170000000000186</c:v>
                </c:pt>
                <c:pt idx="175">
                  <c:v>8.0639999999999645</c:v>
                </c:pt>
                <c:pt idx="176">
                  <c:v>10.559000000000026</c:v>
                </c:pt>
                <c:pt idx="177">
                  <c:v>9.5760000000000218</c:v>
                </c:pt>
                <c:pt idx="178">
                  <c:v>9.7829999999999586</c:v>
                </c:pt>
                <c:pt idx="179">
                  <c:v>12.783000000000072</c:v>
                </c:pt>
                <c:pt idx="180">
                  <c:v>14.567999999999984</c:v>
                </c:pt>
                <c:pt idx="181">
                  <c:v>14.41599999999994</c:v>
                </c:pt>
                <c:pt idx="182">
                  <c:v>11.574000000000069</c:v>
                </c:pt>
                <c:pt idx="183">
                  <c:v>8.9379999999999882</c:v>
                </c:pt>
                <c:pt idx="184">
                  <c:v>10.687999999999988</c:v>
                </c:pt>
                <c:pt idx="185">
                  <c:v>11.086000000000013</c:v>
                </c:pt>
                <c:pt idx="186">
                  <c:v>11.014999999999986</c:v>
                </c:pt>
                <c:pt idx="187">
                  <c:v>30.04200000000003</c:v>
                </c:pt>
                <c:pt idx="188">
                  <c:v>18.057999999999993</c:v>
                </c:pt>
                <c:pt idx="189">
                  <c:v>18.906999999999925</c:v>
                </c:pt>
                <c:pt idx="190">
                  <c:v>25.061000000000035</c:v>
                </c:pt>
                <c:pt idx="191">
                  <c:v>22.865000000000009</c:v>
                </c:pt>
                <c:pt idx="192">
                  <c:v>19.269000000000005</c:v>
                </c:pt>
                <c:pt idx="193">
                  <c:v>23.428999999999974</c:v>
                </c:pt>
                <c:pt idx="194">
                  <c:v>22.865000000000009</c:v>
                </c:pt>
                <c:pt idx="195">
                  <c:v>19.269000000000005</c:v>
                </c:pt>
                <c:pt idx="196">
                  <c:v>23.428999999999974</c:v>
                </c:pt>
                <c:pt idx="197">
                  <c:v>30.265999999999963</c:v>
                </c:pt>
              </c:numCache>
            </c:numRef>
          </c:xVal>
          <c:yVal>
            <c:numRef>
              <c:f>'Cell file sorted'!$T$1:$T$198</c:f>
              <c:numCache>
                <c:formatCode>General</c:formatCode>
                <c:ptCount val="198"/>
                <c:pt idx="127">
                  <c:v>106.636</c:v>
                </c:pt>
                <c:pt idx="128">
                  <c:v>114.559</c:v>
                </c:pt>
                <c:pt idx="129">
                  <c:v>121.80500000000001</c:v>
                </c:pt>
                <c:pt idx="130">
                  <c:v>129.15</c:v>
                </c:pt>
                <c:pt idx="131">
                  <c:v>136.876</c:v>
                </c:pt>
                <c:pt idx="132">
                  <c:v>143.899</c:v>
                </c:pt>
                <c:pt idx="133">
                  <c:v>151.238</c:v>
                </c:pt>
                <c:pt idx="134">
                  <c:v>158.98400000000001</c:v>
                </c:pt>
                <c:pt idx="135">
                  <c:v>168.15100000000001</c:v>
                </c:pt>
                <c:pt idx="136">
                  <c:v>177.63300000000001</c:v>
                </c:pt>
                <c:pt idx="137">
                  <c:v>186.50200000000001</c:v>
                </c:pt>
                <c:pt idx="138">
                  <c:v>195.38900000000001</c:v>
                </c:pt>
                <c:pt idx="139">
                  <c:v>204.36699999999999</c:v>
                </c:pt>
                <c:pt idx="140">
                  <c:v>214.68100000000001</c:v>
                </c:pt>
                <c:pt idx="141">
                  <c:v>223.435</c:v>
                </c:pt>
                <c:pt idx="142">
                  <c:v>228.93299999999999</c:v>
                </c:pt>
                <c:pt idx="143">
                  <c:v>234.953</c:v>
                </c:pt>
                <c:pt idx="144">
                  <c:v>241.471</c:v>
                </c:pt>
                <c:pt idx="145">
                  <c:v>247.178</c:v>
                </c:pt>
                <c:pt idx="146">
                  <c:v>255.14400000000001</c:v>
                </c:pt>
                <c:pt idx="147">
                  <c:v>263.33800000000002</c:v>
                </c:pt>
                <c:pt idx="148">
                  <c:v>269.02999999999997</c:v>
                </c:pt>
                <c:pt idx="149">
                  <c:v>274.40100000000001</c:v>
                </c:pt>
                <c:pt idx="150">
                  <c:v>279.17899999999997</c:v>
                </c:pt>
                <c:pt idx="151">
                  <c:v>284.65800000000002</c:v>
                </c:pt>
                <c:pt idx="152">
                  <c:v>290.798</c:v>
                </c:pt>
                <c:pt idx="153">
                  <c:v>296.61500000000001</c:v>
                </c:pt>
                <c:pt idx="154">
                  <c:v>302.82299999999998</c:v>
                </c:pt>
                <c:pt idx="155">
                  <c:v>311.29300000000001</c:v>
                </c:pt>
                <c:pt idx="156">
                  <c:v>321.99799999999999</c:v>
                </c:pt>
                <c:pt idx="157">
                  <c:v>330.30599999999998</c:v>
                </c:pt>
                <c:pt idx="158">
                  <c:v>336.42099999999999</c:v>
                </c:pt>
                <c:pt idx="159">
                  <c:v>342.75900000000001</c:v>
                </c:pt>
                <c:pt idx="160">
                  <c:v>349.565</c:v>
                </c:pt>
                <c:pt idx="161">
                  <c:v>357.108</c:v>
                </c:pt>
                <c:pt idx="162">
                  <c:v>364.76900000000001</c:v>
                </c:pt>
                <c:pt idx="163">
                  <c:v>372.03199999999998</c:v>
                </c:pt>
                <c:pt idx="164">
                  <c:v>379.65899999999999</c:v>
                </c:pt>
                <c:pt idx="165">
                  <c:v>387.21100000000001</c:v>
                </c:pt>
                <c:pt idx="166">
                  <c:v>394.59</c:v>
                </c:pt>
                <c:pt idx="167">
                  <c:v>402.73500000000001</c:v>
                </c:pt>
                <c:pt idx="168">
                  <c:v>411.68</c:v>
                </c:pt>
                <c:pt idx="169">
                  <c:v>420.29399999999998</c:v>
                </c:pt>
                <c:pt idx="170">
                  <c:v>429.077</c:v>
                </c:pt>
                <c:pt idx="171">
                  <c:v>438.392</c:v>
                </c:pt>
                <c:pt idx="172">
                  <c:v>447.55200000000002</c:v>
                </c:pt>
                <c:pt idx="173">
                  <c:v>457.255</c:v>
                </c:pt>
                <c:pt idx="174">
                  <c:v>464.80799999999999</c:v>
                </c:pt>
                <c:pt idx="175">
                  <c:v>470.42500000000001</c:v>
                </c:pt>
                <c:pt idx="176">
                  <c:v>478.48899999999998</c:v>
                </c:pt>
                <c:pt idx="177">
                  <c:v>489.048</c:v>
                </c:pt>
                <c:pt idx="178">
                  <c:v>498.62400000000002</c:v>
                </c:pt>
                <c:pt idx="179">
                  <c:v>508.40699999999998</c:v>
                </c:pt>
                <c:pt idx="180">
                  <c:v>521.19000000000005</c:v>
                </c:pt>
                <c:pt idx="181">
                  <c:v>535.75800000000004</c:v>
                </c:pt>
                <c:pt idx="182">
                  <c:v>550.17399999999998</c:v>
                </c:pt>
                <c:pt idx="183">
                  <c:v>561.74800000000005</c:v>
                </c:pt>
                <c:pt idx="184">
                  <c:v>570.68600000000004</c:v>
                </c:pt>
                <c:pt idx="185">
                  <c:v>581.37400000000002</c:v>
                </c:pt>
                <c:pt idx="186">
                  <c:v>592.46</c:v>
                </c:pt>
                <c:pt idx="187">
                  <c:v>603.47500000000002</c:v>
                </c:pt>
                <c:pt idx="188">
                  <c:v>633.51700000000005</c:v>
                </c:pt>
                <c:pt idx="189">
                  <c:v>651.57500000000005</c:v>
                </c:pt>
                <c:pt idx="190">
                  <c:v>670.48199999999997</c:v>
                </c:pt>
                <c:pt idx="191">
                  <c:v>695.54300000000001</c:v>
                </c:pt>
                <c:pt idx="192">
                  <c:v>718.40800000000002</c:v>
                </c:pt>
                <c:pt idx="193">
                  <c:v>737.67700000000002</c:v>
                </c:pt>
                <c:pt idx="194">
                  <c:v>695.54300000000001</c:v>
                </c:pt>
                <c:pt idx="195">
                  <c:v>718.40800000000002</c:v>
                </c:pt>
                <c:pt idx="196">
                  <c:v>737.67700000000002</c:v>
                </c:pt>
                <c:pt idx="197">
                  <c:v>761.105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32E-493E-8A8A-1FF5C354B7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5552768"/>
        <c:axId val="945546864"/>
      </c:scatterChart>
      <c:valAx>
        <c:axId val="945552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45546864"/>
        <c:crosses val="autoZero"/>
        <c:crossBetween val="midCat"/>
      </c:valAx>
      <c:valAx>
        <c:axId val="945546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455527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Cell File Sorted'!$R$2:$R$204</c:f>
              <c:numCache>
                <c:formatCode>General</c:formatCode>
                <c:ptCount val="203"/>
                <c:pt idx="0">
                  <c:v>5.8469999999999942</c:v>
                </c:pt>
                <c:pt idx="1">
                  <c:v>6.4969999999999999</c:v>
                </c:pt>
                <c:pt idx="2">
                  <c:v>6.8560000000000088</c:v>
                </c:pt>
                <c:pt idx="3">
                  <c:v>8.2949999999999875</c:v>
                </c:pt>
                <c:pt idx="4">
                  <c:v>8.1290000000000191</c:v>
                </c:pt>
                <c:pt idx="5">
                  <c:v>8.9439999999999884</c:v>
                </c:pt>
                <c:pt idx="6">
                  <c:v>8.5929999999999893</c:v>
                </c:pt>
                <c:pt idx="7">
                  <c:v>9.6810000000000116</c:v>
                </c:pt>
                <c:pt idx="8">
                  <c:v>9.2510000000000048</c:v>
                </c:pt>
                <c:pt idx="9">
                  <c:v>8.757000000000005</c:v>
                </c:pt>
                <c:pt idx="10">
                  <c:v>8.3559999999999945</c:v>
                </c:pt>
                <c:pt idx="11">
                  <c:v>9.6500000000000057</c:v>
                </c:pt>
                <c:pt idx="12">
                  <c:v>7.8729999999999905</c:v>
                </c:pt>
                <c:pt idx="13">
                  <c:v>5.2019999999999982</c:v>
                </c:pt>
                <c:pt idx="14">
                  <c:v>5.4350000000000023</c:v>
                </c:pt>
                <c:pt idx="15">
                  <c:v>6.0089999999999861</c:v>
                </c:pt>
                <c:pt idx="16">
                  <c:v>5.7060000000000173</c:v>
                </c:pt>
                <c:pt idx="17">
                  <c:v>5.0769999999999982</c:v>
                </c:pt>
                <c:pt idx="18">
                  <c:v>5.7949999999999875</c:v>
                </c:pt>
                <c:pt idx="19">
                  <c:v>6.2060000000000173</c:v>
                </c:pt>
                <c:pt idx="20">
                  <c:v>5.8859999999999673</c:v>
                </c:pt>
                <c:pt idx="21">
                  <c:v>5.2320000000000277</c:v>
                </c:pt>
                <c:pt idx="22">
                  <c:v>5.9739999999999895</c:v>
                </c:pt>
                <c:pt idx="23">
                  <c:v>6.8670000000000186</c:v>
                </c:pt>
                <c:pt idx="24">
                  <c:v>7.8770000000000095</c:v>
                </c:pt>
                <c:pt idx="25">
                  <c:v>8.9069999999999823</c:v>
                </c:pt>
                <c:pt idx="26">
                  <c:v>8.4730000000000132</c:v>
                </c:pt>
                <c:pt idx="27">
                  <c:v>8.1490000000000009</c:v>
                </c:pt>
                <c:pt idx="28">
                  <c:v>7.9420000000000073</c:v>
                </c:pt>
                <c:pt idx="29">
                  <c:v>7.9759999999999991</c:v>
                </c:pt>
                <c:pt idx="30">
                  <c:v>7.3479999999999563</c:v>
                </c:pt>
                <c:pt idx="31">
                  <c:v>13.761000000000024</c:v>
                </c:pt>
                <c:pt idx="32">
                  <c:v>8.9780000000000086</c:v>
                </c:pt>
                <c:pt idx="33">
                  <c:v>9.1129999999999995</c:v>
                </c:pt>
                <c:pt idx="34">
                  <c:v>8.1049999999999613</c:v>
                </c:pt>
                <c:pt idx="35">
                  <c:v>8.6470000000000482</c:v>
                </c:pt>
                <c:pt idx="36">
                  <c:v>7.2330000000000041</c:v>
                </c:pt>
                <c:pt idx="37">
                  <c:v>5.1499999999999773</c:v>
                </c:pt>
                <c:pt idx="38">
                  <c:v>5.0799999999999841</c:v>
                </c:pt>
                <c:pt idx="39">
                  <c:v>4.9580000000000268</c:v>
                </c:pt>
                <c:pt idx="40">
                  <c:v>4.7419999999999618</c:v>
                </c:pt>
                <c:pt idx="41">
                  <c:v>4.7530000000000427</c:v>
                </c:pt>
                <c:pt idx="42">
                  <c:v>6.8709999999999809</c:v>
                </c:pt>
                <c:pt idx="43">
                  <c:v>7.0889999999999986</c:v>
                </c:pt>
                <c:pt idx="44">
                  <c:v>5.1000000000000227</c:v>
                </c:pt>
                <c:pt idx="45">
                  <c:v>7.9969999999999573</c:v>
                </c:pt>
                <c:pt idx="46">
                  <c:v>8.9080000000000155</c:v>
                </c:pt>
                <c:pt idx="47">
                  <c:v>8.8870000000000005</c:v>
                </c:pt>
                <c:pt idx="48">
                  <c:v>8.6700000000000159</c:v>
                </c:pt>
                <c:pt idx="49">
                  <c:v>6.9850000000000136</c:v>
                </c:pt>
                <c:pt idx="50">
                  <c:v>10.525999999999954</c:v>
                </c:pt>
                <c:pt idx="51">
                  <c:v>9.6770000000000209</c:v>
                </c:pt>
                <c:pt idx="52">
                  <c:v>7.396000000000015</c:v>
                </c:pt>
                <c:pt idx="53">
                  <c:v>9.9029999999999632</c:v>
                </c:pt>
                <c:pt idx="54">
                  <c:v>9.4830000000000609</c:v>
                </c:pt>
                <c:pt idx="55">
                  <c:v>7.3399999999999181</c:v>
                </c:pt>
                <c:pt idx="56">
                  <c:v>9.0350000000000819</c:v>
                </c:pt>
                <c:pt idx="57">
                  <c:v>11.793000000000006</c:v>
                </c:pt>
                <c:pt idx="58">
                  <c:v>12.538000000000011</c:v>
                </c:pt>
                <c:pt idx="59">
                  <c:v>10.404999999999973</c:v>
                </c:pt>
                <c:pt idx="60">
                  <c:v>9.2549999999999955</c:v>
                </c:pt>
                <c:pt idx="61">
                  <c:v>13.808999999999969</c:v>
                </c:pt>
                <c:pt idx="62">
                  <c:v>16.020999999999958</c:v>
                </c:pt>
                <c:pt idx="63">
                  <c:v>14.609000000000037</c:v>
                </c:pt>
                <c:pt idx="64">
                  <c:v>18.623000000000047</c:v>
                </c:pt>
                <c:pt idx="65">
                  <c:v>17.519999999999982</c:v>
                </c:pt>
                <c:pt idx="66">
                  <c:v>31.230000000000018</c:v>
                </c:pt>
                <c:pt idx="67">
                  <c:v>35.769999999999982</c:v>
                </c:pt>
                <c:pt idx="68">
                  <c:v>33.247999999999934</c:v>
                </c:pt>
                <c:pt idx="69">
                  <c:v>30.138000000000034</c:v>
                </c:pt>
                <c:pt idx="70">
                  <c:v>12.314999999999998</c:v>
                </c:pt>
                <c:pt idx="71">
                  <c:v>12.001999999999995</c:v>
                </c:pt>
                <c:pt idx="72">
                  <c:v>7.5609999999999928</c:v>
                </c:pt>
                <c:pt idx="73">
                  <c:v>7.2490000000000236</c:v>
                </c:pt>
                <c:pt idx="74">
                  <c:v>7.3049999999999784</c:v>
                </c:pt>
                <c:pt idx="75">
                  <c:v>8.2060000000000173</c:v>
                </c:pt>
                <c:pt idx="76">
                  <c:v>7.5089999999999861</c:v>
                </c:pt>
                <c:pt idx="77">
                  <c:v>8.2650000000000148</c:v>
                </c:pt>
                <c:pt idx="78">
                  <c:v>8.0909999999999798</c:v>
                </c:pt>
                <c:pt idx="79">
                  <c:v>9.5690000000000168</c:v>
                </c:pt>
                <c:pt idx="80">
                  <c:v>8.2419999999999902</c:v>
                </c:pt>
                <c:pt idx="81">
                  <c:v>5.9200000000000159</c:v>
                </c:pt>
                <c:pt idx="82">
                  <c:v>8.0009999999999764</c:v>
                </c:pt>
                <c:pt idx="83">
                  <c:v>8.2360000000000184</c:v>
                </c:pt>
                <c:pt idx="84">
                  <c:v>6.25</c:v>
                </c:pt>
                <c:pt idx="85">
                  <c:v>8.304000000000002</c:v>
                </c:pt>
                <c:pt idx="86">
                  <c:v>9.9369999999999834</c:v>
                </c:pt>
                <c:pt idx="87">
                  <c:v>9.5190000000000055</c:v>
                </c:pt>
                <c:pt idx="88">
                  <c:v>8.9069999999999823</c:v>
                </c:pt>
                <c:pt idx="89">
                  <c:v>9.1310000000000286</c:v>
                </c:pt>
                <c:pt idx="90">
                  <c:v>9.7740000000000009</c:v>
                </c:pt>
                <c:pt idx="91">
                  <c:v>9.7930000000000064</c:v>
                </c:pt>
                <c:pt idx="92">
                  <c:v>9.8360000000000127</c:v>
                </c:pt>
                <c:pt idx="93">
                  <c:v>10.526999999999987</c:v>
                </c:pt>
                <c:pt idx="94">
                  <c:v>8.9350000000000023</c:v>
                </c:pt>
                <c:pt idx="95">
                  <c:v>18.012999999999977</c:v>
                </c:pt>
                <c:pt idx="96">
                  <c:v>15.343000000000018</c:v>
                </c:pt>
                <c:pt idx="97">
                  <c:v>8.2230000000000132</c:v>
                </c:pt>
                <c:pt idx="98">
                  <c:v>9.9339999999999691</c:v>
                </c:pt>
                <c:pt idx="99">
                  <c:v>8.8070000000000164</c:v>
                </c:pt>
                <c:pt idx="100">
                  <c:v>8.13900000000001</c:v>
                </c:pt>
                <c:pt idx="101">
                  <c:v>9.0419999999999732</c:v>
                </c:pt>
                <c:pt idx="102">
                  <c:v>7.0939999999999941</c:v>
                </c:pt>
                <c:pt idx="103">
                  <c:v>5.2230000000000132</c:v>
                </c:pt>
                <c:pt idx="104">
                  <c:v>10.708000000000027</c:v>
                </c:pt>
                <c:pt idx="105">
                  <c:v>12.190999999999974</c:v>
                </c:pt>
                <c:pt idx="106">
                  <c:v>9.6059999999999945</c:v>
                </c:pt>
                <c:pt idx="107">
                  <c:v>7.7320000000000277</c:v>
                </c:pt>
                <c:pt idx="108">
                  <c:v>5.4889999999999759</c:v>
                </c:pt>
                <c:pt idx="109">
                  <c:v>5.3530000000000086</c:v>
                </c:pt>
                <c:pt idx="110">
                  <c:v>5.1639999999999873</c:v>
                </c:pt>
                <c:pt idx="111">
                  <c:v>8.242999999999995</c:v>
                </c:pt>
                <c:pt idx="112">
                  <c:v>8.7100000000000364</c:v>
                </c:pt>
                <c:pt idx="113">
                  <c:v>6.4099999999999682</c:v>
                </c:pt>
                <c:pt idx="114">
                  <c:v>7.2660000000000196</c:v>
                </c:pt>
                <c:pt idx="115">
                  <c:v>2.5999999999999659</c:v>
                </c:pt>
                <c:pt idx="116">
                  <c:v>12.819000000000074</c:v>
                </c:pt>
                <c:pt idx="117">
                  <c:v>13.133999999999901</c:v>
                </c:pt>
                <c:pt idx="118">
                  <c:v>13.355000000000018</c:v>
                </c:pt>
                <c:pt idx="119">
                  <c:v>13.697999999999979</c:v>
                </c:pt>
                <c:pt idx="120">
                  <c:v>13.951999999999998</c:v>
                </c:pt>
                <c:pt idx="121">
                  <c:v>14.573000000000093</c:v>
                </c:pt>
                <c:pt idx="122">
                  <c:v>17.421999999999912</c:v>
                </c:pt>
                <c:pt idx="123">
                  <c:v>18.206999999999994</c:v>
                </c:pt>
                <c:pt idx="124">
                  <c:v>20.059000000000083</c:v>
                </c:pt>
                <c:pt idx="125">
                  <c:v>20.250999999999976</c:v>
                </c:pt>
                <c:pt idx="126">
                  <c:v>17.836999999999989</c:v>
                </c:pt>
                <c:pt idx="127">
                  <c:v>54.172000000000025</c:v>
                </c:pt>
                <c:pt idx="128">
                  <c:v>30.380999999999972</c:v>
                </c:pt>
                <c:pt idx="129">
                  <c:v>32.794999999999959</c:v>
                </c:pt>
                <c:pt idx="130">
                  <c:v>9.3130000000000024</c:v>
                </c:pt>
                <c:pt idx="131">
                  <c:v>10.391999999999996</c:v>
                </c:pt>
                <c:pt idx="132">
                  <c:v>11.036000000000001</c:v>
                </c:pt>
                <c:pt idx="133">
                  <c:v>10.923000000000002</c:v>
                </c:pt>
                <c:pt idx="134">
                  <c:v>8.203000000000003</c:v>
                </c:pt>
                <c:pt idx="135">
                  <c:v>6.257000000000005</c:v>
                </c:pt>
                <c:pt idx="136">
                  <c:v>5.8969999999999914</c:v>
                </c:pt>
                <c:pt idx="137">
                  <c:v>5.7959999999999923</c:v>
                </c:pt>
                <c:pt idx="138">
                  <c:v>5.2050000000000125</c:v>
                </c:pt>
                <c:pt idx="139">
                  <c:v>4.8619999999999948</c:v>
                </c:pt>
                <c:pt idx="140">
                  <c:v>5.2280000000000086</c:v>
                </c:pt>
                <c:pt idx="141">
                  <c:v>5.7959999999999923</c:v>
                </c:pt>
                <c:pt idx="142">
                  <c:v>5.2920000000000016</c:v>
                </c:pt>
                <c:pt idx="143">
                  <c:v>4.7820000000000107</c:v>
                </c:pt>
                <c:pt idx="144">
                  <c:v>5.0949999999999989</c:v>
                </c:pt>
                <c:pt idx="145">
                  <c:v>5.6349999999999909</c:v>
                </c:pt>
                <c:pt idx="146">
                  <c:v>6.6529999999999916</c:v>
                </c:pt>
                <c:pt idx="147">
                  <c:v>7.8460000000000036</c:v>
                </c:pt>
                <c:pt idx="148">
                  <c:v>7.257000000000005</c:v>
                </c:pt>
                <c:pt idx="149">
                  <c:v>7.5029999999999859</c:v>
                </c:pt>
                <c:pt idx="150">
                  <c:v>7.6910000000000025</c:v>
                </c:pt>
                <c:pt idx="151">
                  <c:v>8.5790000000000362</c:v>
                </c:pt>
                <c:pt idx="152">
                  <c:v>9.1269999999999527</c:v>
                </c:pt>
                <c:pt idx="153">
                  <c:v>7.1230000000000473</c:v>
                </c:pt>
                <c:pt idx="154">
                  <c:v>4.9959999999999809</c:v>
                </c:pt>
                <c:pt idx="155">
                  <c:v>6.7160000000000082</c:v>
                </c:pt>
                <c:pt idx="156">
                  <c:v>8.3319999999999936</c:v>
                </c:pt>
                <c:pt idx="157">
                  <c:v>8.7789999999999964</c:v>
                </c:pt>
                <c:pt idx="158">
                  <c:v>9.3020000000000209</c:v>
                </c:pt>
                <c:pt idx="159">
                  <c:v>9.6829999999999927</c:v>
                </c:pt>
                <c:pt idx="160">
                  <c:v>7.589999999999975</c:v>
                </c:pt>
                <c:pt idx="161">
                  <c:v>5.2610000000000241</c:v>
                </c:pt>
                <c:pt idx="162">
                  <c:v>5.103999999999985</c:v>
                </c:pt>
                <c:pt idx="163">
                  <c:v>5.1730000000000018</c:v>
                </c:pt>
                <c:pt idx="164">
                  <c:v>5.5980000000000132</c:v>
                </c:pt>
                <c:pt idx="165">
                  <c:v>5.8079999999999927</c:v>
                </c:pt>
                <c:pt idx="166">
                  <c:v>6.44399999999996</c:v>
                </c:pt>
                <c:pt idx="167">
                  <c:v>5.7260000000000559</c:v>
                </c:pt>
                <c:pt idx="168">
                  <c:v>5.5589999999999691</c:v>
                </c:pt>
                <c:pt idx="169">
                  <c:v>6.01400000000001</c:v>
                </c:pt>
                <c:pt idx="170">
                  <c:v>5.5339999999999918</c:v>
                </c:pt>
                <c:pt idx="171">
                  <c:v>5.617999999999995</c:v>
                </c:pt>
                <c:pt idx="172">
                  <c:v>5.8949999999999818</c:v>
                </c:pt>
                <c:pt idx="173">
                  <c:v>6.2170000000000414</c:v>
                </c:pt>
                <c:pt idx="174">
                  <c:v>6.0190000000000055</c:v>
                </c:pt>
                <c:pt idx="175">
                  <c:v>6.2330000000000041</c:v>
                </c:pt>
                <c:pt idx="176">
                  <c:v>11.871999999999957</c:v>
                </c:pt>
                <c:pt idx="177">
                  <c:v>5.8199999999999932</c:v>
                </c:pt>
                <c:pt idx="178">
                  <c:v>5.8280000000000314</c:v>
                </c:pt>
                <c:pt idx="179">
                  <c:v>6.1129999999999995</c:v>
                </c:pt>
                <c:pt idx="180">
                  <c:v>6.8319999999999936</c:v>
                </c:pt>
                <c:pt idx="181">
                  <c:v>9.2470000000000141</c:v>
                </c:pt>
                <c:pt idx="182">
                  <c:v>8.6080000000000041</c:v>
                </c:pt>
                <c:pt idx="183">
                  <c:v>5.8039999999999736</c:v>
                </c:pt>
                <c:pt idx="184">
                  <c:v>9.26400000000001</c:v>
                </c:pt>
                <c:pt idx="185">
                  <c:v>9.3179999999999836</c:v>
                </c:pt>
                <c:pt idx="186">
                  <c:v>7.4070000000000391</c:v>
                </c:pt>
                <c:pt idx="187">
                  <c:v>10.528999999999996</c:v>
                </c:pt>
                <c:pt idx="188">
                  <c:v>11.156999999999925</c:v>
                </c:pt>
                <c:pt idx="189">
                  <c:v>16.379999999999995</c:v>
                </c:pt>
                <c:pt idx="190">
                  <c:v>8.68100000000004</c:v>
                </c:pt>
                <c:pt idx="191">
                  <c:v>8.7710000000000719</c:v>
                </c:pt>
                <c:pt idx="192">
                  <c:v>10.080999999999904</c:v>
                </c:pt>
                <c:pt idx="193">
                  <c:v>10.730000000000018</c:v>
                </c:pt>
                <c:pt idx="194">
                  <c:v>12.704000000000065</c:v>
                </c:pt>
                <c:pt idx="195">
                  <c:v>14.631999999999948</c:v>
                </c:pt>
                <c:pt idx="196">
                  <c:v>17.606999999999971</c:v>
                </c:pt>
                <c:pt idx="197">
                  <c:v>17.298000000000002</c:v>
                </c:pt>
                <c:pt idx="198">
                  <c:v>16.603000000000065</c:v>
                </c:pt>
                <c:pt idx="199">
                  <c:v>21.572999999999979</c:v>
                </c:pt>
                <c:pt idx="200">
                  <c:v>30.150999999999954</c:v>
                </c:pt>
                <c:pt idx="201">
                  <c:v>46.020000000000095</c:v>
                </c:pt>
                <c:pt idx="202">
                  <c:v>30.116999999999962</c:v>
                </c:pt>
              </c:numCache>
            </c:numRef>
          </c:xVal>
          <c:yVal>
            <c:numRef>
              <c:f>'Cell File Sorted'!$S$2:$S$204</c:f>
              <c:numCache>
                <c:formatCode>General</c:formatCode>
                <c:ptCount val="203"/>
                <c:pt idx="0">
                  <c:v>106.259</c:v>
                </c:pt>
                <c:pt idx="1">
                  <c:v>112.10599999999999</c:v>
                </c:pt>
                <c:pt idx="2">
                  <c:v>118.60299999999999</c:v>
                </c:pt>
                <c:pt idx="3">
                  <c:v>125.459</c:v>
                </c:pt>
                <c:pt idx="4">
                  <c:v>133.75399999999999</c:v>
                </c:pt>
                <c:pt idx="5">
                  <c:v>141.88300000000001</c:v>
                </c:pt>
                <c:pt idx="6">
                  <c:v>150.827</c:v>
                </c:pt>
                <c:pt idx="7">
                  <c:v>159.41999999999999</c:v>
                </c:pt>
                <c:pt idx="8">
                  <c:v>169.101</c:v>
                </c:pt>
                <c:pt idx="9">
                  <c:v>178.352</c:v>
                </c:pt>
                <c:pt idx="10">
                  <c:v>187.10900000000001</c:v>
                </c:pt>
                <c:pt idx="11">
                  <c:v>195.465</c:v>
                </c:pt>
                <c:pt idx="12">
                  <c:v>205.11500000000001</c:v>
                </c:pt>
                <c:pt idx="13">
                  <c:v>212.988</c:v>
                </c:pt>
                <c:pt idx="14">
                  <c:v>218.19</c:v>
                </c:pt>
                <c:pt idx="15">
                  <c:v>223.625</c:v>
                </c:pt>
                <c:pt idx="16">
                  <c:v>229.63399999999999</c:v>
                </c:pt>
                <c:pt idx="17">
                  <c:v>235.34</c:v>
                </c:pt>
                <c:pt idx="18">
                  <c:v>240.417</c:v>
                </c:pt>
                <c:pt idx="19">
                  <c:v>246.21199999999999</c:v>
                </c:pt>
                <c:pt idx="20">
                  <c:v>252.41800000000001</c:v>
                </c:pt>
                <c:pt idx="21">
                  <c:v>258.30399999999997</c:v>
                </c:pt>
                <c:pt idx="22">
                  <c:v>263.536</c:v>
                </c:pt>
                <c:pt idx="23">
                  <c:v>269.51</c:v>
                </c:pt>
                <c:pt idx="24">
                  <c:v>276.37700000000001</c:v>
                </c:pt>
                <c:pt idx="25">
                  <c:v>284.25400000000002</c:v>
                </c:pt>
                <c:pt idx="26">
                  <c:v>293.161</c:v>
                </c:pt>
                <c:pt idx="27">
                  <c:v>301.63400000000001</c:v>
                </c:pt>
                <c:pt idx="28">
                  <c:v>309.78300000000002</c:v>
                </c:pt>
                <c:pt idx="29">
                  <c:v>317.72500000000002</c:v>
                </c:pt>
                <c:pt idx="30">
                  <c:v>325.70100000000002</c:v>
                </c:pt>
                <c:pt idx="31">
                  <c:v>333.04899999999998</c:v>
                </c:pt>
                <c:pt idx="32">
                  <c:v>346.81</c:v>
                </c:pt>
                <c:pt idx="33">
                  <c:v>355.78800000000001</c:v>
                </c:pt>
                <c:pt idx="34">
                  <c:v>364.90100000000001</c:v>
                </c:pt>
                <c:pt idx="35">
                  <c:v>373.00599999999997</c:v>
                </c:pt>
                <c:pt idx="36">
                  <c:v>381.65300000000002</c:v>
                </c:pt>
                <c:pt idx="37">
                  <c:v>388.88600000000002</c:v>
                </c:pt>
                <c:pt idx="38">
                  <c:v>394.036</c:v>
                </c:pt>
                <c:pt idx="39">
                  <c:v>399.11599999999999</c:v>
                </c:pt>
                <c:pt idx="40">
                  <c:v>404.07400000000001</c:v>
                </c:pt>
                <c:pt idx="41">
                  <c:v>408.81599999999997</c:v>
                </c:pt>
                <c:pt idx="42">
                  <c:v>413.56900000000002</c:v>
                </c:pt>
                <c:pt idx="43">
                  <c:v>420.44</c:v>
                </c:pt>
                <c:pt idx="44">
                  <c:v>427.529</c:v>
                </c:pt>
                <c:pt idx="45">
                  <c:v>432.62900000000002</c:v>
                </c:pt>
                <c:pt idx="46">
                  <c:v>440.62599999999998</c:v>
                </c:pt>
                <c:pt idx="47">
                  <c:v>449.53399999999999</c:v>
                </c:pt>
                <c:pt idx="48">
                  <c:v>458.42099999999999</c:v>
                </c:pt>
                <c:pt idx="49">
                  <c:v>467.09100000000001</c:v>
                </c:pt>
                <c:pt idx="50">
                  <c:v>474.07600000000002</c:v>
                </c:pt>
                <c:pt idx="51">
                  <c:v>484.60199999999998</c:v>
                </c:pt>
                <c:pt idx="52">
                  <c:v>494.279</c:v>
                </c:pt>
                <c:pt idx="53">
                  <c:v>501.67500000000001</c:v>
                </c:pt>
                <c:pt idx="54">
                  <c:v>511.57799999999997</c:v>
                </c:pt>
                <c:pt idx="55">
                  <c:v>521.06100000000004</c:v>
                </c:pt>
                <c:pt idx="56">
                  <c:v>528.40099999999995</c:v>
                </c:pt>
                <c:pt idx="57">
                  <c:v>537.43600000000004</c:v>
                </c:pt>
                <c:pt idx="58">
                  <c:v>549.22900000000004</c:v>
                </c:pt>
                <c:pt idx="59">
                  <c:v>561.76700000000005</c:v>
                </c:pt>
                <c:pt idx="60">
                  <c:v>572.17200000000003</c:v>
                </c:pt>
                <c:pt idx="61">
                  <c:v>581.42700000000002</c:v>
                </c:pt>
                <c:pt idx="62">
                  <c:v>595.23599999999999</c:v>
                </c:pt>
                <c:pt idx="63">
                  <c:v>611.25699999999995</c:v>
                </c:pt>
                <c:pt idx="64">
                  <c:v>625.86599999999999</c:v>
                </c:pt>
                <c:pt idx="65">
                  <c:v>644.48900000000003</c:v>
                </c:pt>
                <c:pt idx="66">
                  <c:v>662.00900000000001</c:v>
                </c:pt>
                <c:pt idx="67">
                  <c:v>693.23900000000003</c:v>
                </c:pt>
                <c:pt idx="68">
                  <c:v>729.00900000000001</c:v>
                </c:pt>
                <c:pt idx="69">
                  <c:v>762.256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723-43F1-A0D2-39A358F941C4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Cell File Sorted'!$R$2:$R$204</c:f>
              <c:numCache>
                <c:formatCode>General</c:formatCode>
                <c:ptCount val="203"/>
                <c:pt idx="0">
                  <c:v>5.8469999999999942</c:v>
                </c:pt>
                <c:pt idx="1">
                  <c:v>6.4969999999999999</c:v>
                </c:pt>
                <c:pt idx="2">
                  <c:v>6.8560000000000088</c:v>
                </c:pt>
                <c:pt idx="3">
                  <c:v>8.2949999999999875</c:v>
                </c:pt>
                <c:pt idx="4">
                  <c:v>8.1290000000000191</c:v>
                </c:pt>
                <c:pt idx="5">
                  <c:v>8.9439999999999884</c:v>
                </c:pt>
                <c:pt idx="6">
                  <c:v>8.5929999999999893</c:v>
                </c:pt>
                <c:pt idx="7">
                  <c:v>9.6810000000000116</c:v>
                </c:pt>
                <c:pt idx="8">
                  <c:v>9.2510000000000048</c:v>
                </c:pt>
                <c:pt idx="9">
                  <c:v>8.757000000000005</c:v>
                </c:pt>
                <c:pt idx="10">
                  <c:v>8.3559999999999945</c:v>
                </c:pt>
                <c:pt idx="11">
                  <c:v>9.6500000000000057</c:v>
                </c:pt>
                <c:pt idx="12">
                  <c:v>7.8729999999999905</c:v>
                </c:pt>
                <c:pt idx="13">
                  <c:v>5.2019999999999982</c:v>
                </c:pt>
                <c:pt idx="14">
                  <c:v>5.4350000000000023</c:v>
                </c:pt>
                <c:pt idx="15">
                  <c:v>6.0089999999999861</c:v>
                </c:pt>
                <c:pt idx="16">
                  <c:v>5.7060000000000173</c:v>
                </c:pt>
                <c:pt idx="17">
                  <c:v>5.0769999999999982</c:v>
                </c:pt>
                <c:pt idx="18">
                  <c:v>5.7949999999999875</c:v>
                </c:pt>
                <c:pt idx="19">
                  <c:v>6.2060000000000173</c:v>
                </c:pt>
                <c:pt idx="20">
                  <c:v>5.8859999999999673</c:v>
                </c:pt>
                <c:pt idx="21">
                  <c:v>5.2320000000000277</c:v>
                </c:pt>
                <c:pt idx="22">
                  <c:v>5.9739999999999895</c:v>
                </c:pt>
                <c:pt idx="23">
                  <c:v>6.8670000000000186</c:v>
                </c:pt>
                <c:pt idx="24">
                  <c:v>7.8770000000000095</c:v>
                </c:pt>
                <c:pt idx="25">
                  <c:v>8.9069999999999823</c:v>
                </c:pt>
                <c:pt idx="26">
                  <c:v>8.4730000000000132</c:v>
                </c:pt>
                <c:pt idx="27">
                  <c:v>8.1490000000000009</c:v>
                </c:pt>
                <c:pt idx="28">
                  <c:v>7.9420000000000073</c:v>
                </c:pt>
                <c:pt idx="29">
                  <c:v>7.9759999999999991</c:v>
                </c:pt>
                <c:pt idx="30">
                  <c:v>7.3479999999999563</c:v>
                </c:pt>
                <c:pt idx="31">
                  <c:v>13.761000000000024</c:v>
                </c:pt>
                <c:pt idx="32">
                  <c:v>8.9780000000000086</c:v>
                </c:pt>
                <c:pt idx="33">
                  <c:v>9.1129999999999995</c:v>
                </c:pt>
                <c:pt idx="34">
                  <c:v>8.1049999999999613</c:v>
                </c:pt>
                <c:pt idx="35">
                  <c:v>8.6470000000000482</c:v>
                </c:pt>
                <c:pt idx="36">
                  <c:v>7.2330000000000041</c:v>
                </c:pt>
                <c:pt idx="37">
                  <c:v>5.1499999999999773</c:v>
                </c:pt>
                <c:pt idx="38">
                  <c:v>5.0799999999999841</c:v>
                </c:pt>
                <c:pt idx="39">
                  <c:v>4.9580000000000268</c:v>
                </c:pt>
                <c:pt idx="40">
                  <c:v>4.7419999999999618</c:v>
                </c:pt>
                <c:pt idx="41">
                  <c:v>4.7530000000000427</c:v>
                </c:pt>
                <c:pt idx="42">
                  <c:v>6.8709999999999809</c:v>
                </c:pt>
                <c:pt idx="43">
                  <c:v>7.0889999999999986</c:v>
                </c:pt>
                <c:pt idx="44">
                  <c:v>5.1000000000000227</c:v>
                </c:pt>
                <c:pt idx="45">
                  <c:v>7.9969999999999573</c:v>
                </c:pt>
                <c:pt idx="46">
                  <c:v>8.9080000000000155</c:v>
                </c:pt>
                <c:pt idx="47">
                  <c:v>8.8870000000000005</c:v>
                </c:pt>
                <c:pt idx="48">
                  <c:v>8.6700000000000159</c:v>
                </c:pt>
                <c:pt idx="49">
                  <c:v>6.9850000000000136</c:v>
                </c:pt>
                <c:pt idx="50">
                  <c:v>10.525999999999954</c:v>
                </c:pt>
                <c:pt idx="51">
                  <c:v>9.6770000000000209</c:v>
                </c:pt>
                <c:pt idx="52">
                  <c:v>7.396000000000015</c:v>
                </c:pt>
                <c:pt idx="53">
                  <c:v>9.9029999999999632</c:v>
                </c:pt>
                <c:pt idx="54">
                  <c:v>9.4830000000000609</c:v>
                </c:pt>
                <c:pt idx="55">
                  <c:v>7.3399999999999181</c:v>
                </c:pt>
                <c:pt idx="56">
                  <c:v>9.0350000000000819</c:v>
                </c:pt>
                <c:pt idx="57">
                  <c:v>11.793000000000006</c:v>
                </c:pt>
                <c:pt idx="58">
                  <c:v>12.538000000000011</c:v>
                </c:pt>
                <c:pt idx="59">
                  <c:v>10.404999999999973</c:v>
                </c:pt>
                <c:pt idx="60">
                  <c:v>9.2549999999999955</c:v>
                </c:pt>
                <c:pt idx="61">
                  <c:v>13.808999999999969</c:v>
                </c:pt>
                <c:pt idx="62">
                  <c:v>16.020999999999958</c:v>
                </c:pt>
                <c:pt idx="63">
                  <c:v>14.609000000000037</c:v>
                </c:pt>
                <c:pt idx="64">
                  <c:v>18.623000000000047</c:v>
                </c:pt>
                <c:pt idx="65">
                  <c:v>17.519999999999982</c:v>
                </c:pt>
                <c:pt idx="66">
                  <c:v>31.230000000000018</c:v>
                </c:pt>
                <c:pt idx="67">
                  <c:v>35.769999999999982</c:v>
                </c:pt>
                <c:pt idx="68">
                  <c:v>33.247999999999934</c:v>
                </c:pt>
                <c:pt idx="69">
                  <c:v>30.138000000000034</c:v>
                </c:pt>
                <c:pt idx="70">
                  <c:v>12.314999999999998</c:v>
                </c:pt>
                <c:pt idx="71">
                  <c:v>12.001999999999995</c:v>
                </c:pt>
                <c:pt idx="72">
                  <c:v>7.5609999999999928</c:v>
                </c:pt>
                <c:pt idx="73">
                  <c:v>7.2490000000000236</c:v>
                </c:pt>
                <c:pt idx="74">
                  <c:v>7.3049999999999784</c:v>
                </c:pt>
                <c:pt idx="75">
                  <c:v>8.2060000000000173</c:v>
                </c:pt>
                <c:pt idx="76">
                  <c:v>7.5089999999999861</c:v>
                </c:pt>
                <c:pt idx="77">
                  <c:v>8.2650000000000148</c:v>
                </c:pt>
                <c:pt idx="78">
                  <c:v>8.0909999999999798</c:v>
                </c:pt>
                <c:pt idx="79">
                  <c:v>9.5690000000000168</c:v>
                </c:pt>
                <c:pt idx="80">
                  <c:v>8.2419999999999902</c:v>
                </c:pt>
                <c:pt idx="81">
                  <c:v>5.9200000000000159</c:v>
                </c:pt>
                <c:pt idx="82">
                  <c:v>8.0009999999999764</c:v>
                </c:pt>
                <c:pt idx="83">
                  <c:v>8.2360000000000184</c:v>
                </c:pt>
                <c:pt idx="84">
                  <c:v>6.25</c:v>
                </c:pt>
                <c:pt idx="85">
                  <c:v>8.304000000000002</c:v>
                </c:pt>
                <c:pt idx="86">
                  <c:v>9.9369999999999834</c:v>
                </c:pt>
                <c:pt idx="87">
                  <c:v>9.5190000000000055</c:v>
                </c:pt>
                <c:pt idx="88">
                  <c:v>8.9069999999999823</c:v>
                </c:pt>
                <c:pt idx="89">
                  <c:v>9.1310000000000286</c:v>
                </c:pt>
                <c:pt idx="90">
                  <c:v>9.7740000000000009</c:v>
                </c:pt>
                <c:pt idx="91">
                  <c:v>9.7930000000000064</c:v>
                </c:pt>
                <c:pt idx="92">
                  <c:v>9.8360000000000127</c:v>
                </c:pt>
                <c:pt idx="93">
                  <c:v>10.526999999999987</c:v>
                </c:pt>
                <c:pt idx="94">
                  <c:v>8.9350000000000023</c:v>
                </c:pt>
                <c:pt idx="95">
                  <c:v>18.012999999999977</c:v>
                </c:pt>
                <c:pt idx="96">
                  <c:v>15.343000000000018</c:v>
                </c:pt>
                <c:pt idx="97">
                  <c:v>8.2230000000000132</c:v>
                </c:pt>
                <c:pt idx="98">
                  <c:v>9.9339999999999691</c:v>
                </c:pt>
                <c:pt idx="99">
                  <c:v>8.8070000000000164</c:v>
                </c:pt>
                <c:pt idx="100">
                  <c:v>8.13900000000001</c:v>
                </c:pt>
                <c:pt idx="101">
                  <c:v>9.0419999999999732</c:v>
                </c:pt>
                <c:pt idx="102">
                  <c:v>7.0939999999999941</c:v>
                </c:pt>
                <c:pt idx="103">
                  <c:v>5.2230000000000132</c:v>
                </c:pt>
                <c:pt idx="104">
                  <c:v>10.708000000000027</c:v>
                </c:pt>
                <c:pt idx="105">
                  <c:v>12.190999999999974</c:v>
                </c:pt>
                <c:pt idx="106">
                  <c:v>9.6059999999999945</c:v>
                </c:pt>
                <c:pt idx="107">
                  <c:v>7.7320000000000277</c:v>
                </c:pt>
                <c:pt idx="108">
                  <c:v>5.4889999999999759</c:v>
                </c:pt>
                <c:pt idx="109">
                  <c:v>5.3530000000000086</c:v>
                </c:pt>
                <c:pt idx="110">
                  <c:v>5.1639999999999873</c:v>
                </c:pt>
                <c:pt idx="111">
                  <c:v>8.242999999999995</c:v>
                </c:pt>
                <c:pt idx="112">
                  <c:v>8.7100000000000364</c:v>
                </c:pt>
                <c:pt idx="113">
                  <c:v>6.4099999999999682</c:v>
                </c:pt>
                <c:pt idx="114">
                  <c:v>7.2660000000000196</c:v>
                </c:pt>
                <c:pt idx="115">
                  <c:v>2.5999999999999659</c:v>
                </c:pt>
                <c:pt idx="116">
                  <c:v>12.819000000000074</c:v>
                </c:pt>
                <c:pt idx="117">
                  <c:v>13.133999999999901</c:v>
                </c:pt>
                <c:pt idx="118">
                  <c:v>13.355000000000018</c:v>
                </c:pt>
                <c:pt idx="119">
                  <c:v>13.697999999999979</c:v>
                </c:pt>
                <c:pt idx="120">
                  <c:v>13.951999999999998</c:v>
                </c:pt>
                <c:pt idx="121">
                  <c:v>14.573000000000093</c:v>
                </c:pt>
                <c:pt idx="122">
                  <c:v>17.421999999999912</c:v>
                </c:pt>
                <c:pt idx="123">
                  <c:v>18.206999999999994</c:v>
                </c:pt>
                <c:pt idx="124">
                  <c:v>20.059000000000083</c:v>
                </c:pt>
                <c:pt idx="125">
                  <c:v>20.250999999999976</c:v>
                </c:pt>
                <c:pt idx="126">
                  <c:v>17.836999999999989</c:v>
                </c:pt>
                <c:pt idx="127">
                  <c:v>54.172000000000025</c:v>
                </c:pt>
                <c:pt idx="128">
                  <c:v>30.380999999999972</c:v>
                </c:pt>
                <c:pt idx="129">
                  <c:v>32.794999999999959</c:v>
                </c:pt>
                <c:pt idx="130">
                  <c:v>9.3130000000000024</c:v>
                </c:pt>
                <c:pt idx="131">
                  <c:v>10.391999999999996</c:v>
                </c:pt>
                <c:pt idx="132">
                  <c:v>11.036000000000001</c:v>
                </c:pt>
                <c:pt idx="133">
                  <c:v>10.923000000000002</c:v>
                </c:pt>
                <c:pt idx="134">
                  <c:v>8.203000000000003</c:v>
                </c:pt>
                <c:pt idx="135">
                  <c:v>6.257000000000005</c:v>
                </c:pt>
                <c:pt idx="136">
                  <c:v>5.8969999999999914</c:v>
                </c:pt>
                <c:pt idx="137">
                  <c:v>5.7959999999999923</c:v>
                </c:pt>
                <c:pt idx="138">
                  <c:v>5.2050000000000125</c:v>
                </c:pt>
                <c:pt idx="139">
                  <c:v>4.8619999999999948</c:v>
                </c:pt>
                <c:pt idx="140">
                  <c:v>5.2280000000000086</c:v>
                </c:pt>
                <c:pt idx="141">
                  <c:v>5.7959999999999923</c:v>
                </c:pt>
                <c:pt idx="142">
                  <c:v>5.2920000000000016</c:v>
                </c:pt>
                <c:pt idx="143">
                  <c:v>4.7820000000000107</c:v>
                </c:pt>
                <c:pt idx="144">
                  <c:v>5.0949999999999989</c:v>
                </c:pt>
                <c:pt idx="145">
                  <c:v>5.6349999999999909</c:v>
                </c:pt>
                <c:pt idx="146">
                  <c:v>6.6529999999999916</c:v>
                </c:pt>
                <c:pt idx="147">
                  <c:v>7.8460000000000036</c:v>
                </c:pt>
                <c:pt idx="148">
                  <c:v>7.257000000000005</c:v>
                </c:pt>
                <c:pt idx="149">
                  <c:v>7.5029999999999859</c:v>
                </c:pt>
                <c:pt idx="150">
                  <c:v>7.6910000000000025</c:v>
                </c:pt>
                <c:pt idx="151">
                  <c:v>8.5790000000000362</c:v>
                </c:pt>
                <c:pt idx="152">
                  <c:v>9.1269999999999527</c:v>
                </c:pt>
                <c:pt idx="153">
                  <c:v>7.1230000000000473</c:v>
                </c:pt>
                <c:pt idx="154">
                  <c:v>4.9959999999999809</c:v>
                </c:pt>
                <c:pt idx="155">
                  <c:v>6.7160000000000082</c:v>
                </c:pt>
                <c:pt idx="156">
                  <c:v>8.3319999999999936</c:v>
                </c:pt>
                <c:pt idx="157">
                  <c:v>8.7789999999999964</c:v>
                </c:pt>
                <c:pt idx="158">
                  <c:v>9.3020000000000209</c:v>
                </c:pt>
                <c:pt idx="159">
                  <c:v>9.6829999999999927</c:v>
                </c:pt>
                <c:pt idx="160">
                  <c:v>7.589999999999975</c:v>
                </c:pt>
                <c:pt idx="161">
                  <c:v>5.2610000000000241</c:v>
                </c:pt>
                <c:pt idx="162">
                  <c:v>5.103999999999985</c:v>
                </c:pt>
                <c:pt idx="163">
                  <c:v>5.1730000000000018</c:v>
                </c:pt>
                <c:pt idx="164">
                  <c:v>5.5980000000000132</c:v>
                </c:pt>
                <c:pt idx="165">
                  <c:v>5.8079999999999927</c:v>
                </c:pt>
                <c:pt idx="166">
                  <c:v>6.44399999999996</c:v>
                </c:pt>
                <c:pt idx="167">
                  <c:v>5.7260000000000559</c:v>
                </c:pt>
                <c:pt idx="168">
                  <c:v>5.5589999999999691</c:v>
                </c:pt>
                <c:pt idx="169">
                  <c:v>6.01400000000001</c:v>
                </c:pt>
                <c:pt idx="170">
                  <c:v>5.5339999999999918</c:v>
                </c:pt>
                <c:pt idx="171">
                  <c:v>5.617999999999995</c:v>
                </c:pt>
                <c:pt idx="172">
                  <c:v>5.8949999999999818</c:v>
                </c:pt>
                <c:pt idx="173">
                  <c:v>6.2170000000000414</c:v>
                </c:pt>
                <c:pt idx="174">
                  <c:v>6.0190000000000055</c:v>
                </c:pt>
                <c:pt idx="175">
                  <c:v>6.2330000000000041</c:v>
                </c:pt>
                <c:pt idx="176">
                  <c:v>11.871999999999957</c:v>
                </c:pt>
                <c:pt idx="177">
                  <c:v>5.8199999999999932</c:v>
                </c:pt>
                <c:pt idx="178">
                  <c:v>5.8280000000000314</c:v>
                </c:pt>
                <c:pt idx="179">
                  <c:v>6.1129999999999995</c:v>
                </c:pt>
                <c:pt idx="180">
                  <c:v>6.8319999999999936</c:v>
                </c:pt>
                <c:pt idx="181">
                  <c:v>9.2470000000000141</c:v>
                </c:pt>
                <c:pt idx="182">
                  <c:v>8.6080000000000041</c:v>
                </c:pt>
                <c:pt idx="183">
                  <c:v>5.8039999999999736</c:v>
                </c:pt>
                <c:pt idx="184">
                  <c:v>9.26400000000001</c:v>
                </c:pt>
                <c:pt idx="185">
                  <c:v>9.3179999999999836</c:v>
                </c:pt>
                <c:pt idx="186">
                  <c:v>7.4070000000000391</c:v>
                </c:pt>
                <c:pt idx="187">
                  <c:v>10.528999999999996</c:v>
                </c:pt>
                <c:pt idx="188">
                  <c:v>11.156999999999925</c:v>
                </c:pt>
                <c:pt idx="189">
                  <c:v>16.379999999999995</c:v>
                </c:pt>
                <c:pt idx="190">
                  <c:v>8.68100000000004</c:v>
                </c:pt>
                <c:pt idx="191">
                  <c:v>8.7710000000000719</c:v>
                </c:pt>
                <c:pt idx="192">
                  <c:v>10.080999999999904</c:v>
                </c:pt>
                <c:pt idx="193">
                  <c:v>10.730000000000018</c:v>
                </c:pt>
                <c:pt idx="194">
                  <c:v>12.704000000000065</c:v>
                </c:pt>
                <c:pt idx="195">
                  <c:v>14.631999999999948</c:v>
                </c:pt>
                <c:pt idx="196">
                  <c:v>17.606999999999971</c:v>
                </c:pt>
                <c:pt idx="197">
                  <c:v>17.298000000000002</c:v>
                </c:pt>
                <c:pt idx="198">
                  <c:v>16.603000000000065</c:v>
                </c:pt>
                <c:pt idx="199">
                  <c:v>21.572999999999979</c:v>
                </c:pt>
                <c:pt idx="200">
                  <c:v>30.150999999999954</c:v>
                </c:pt>
                <c:pt idx="201">
                  <c:v>46.020000000000095</c:v>
                </c:pt>
                <c:pt idx="202">
                  <c:v>30.116999999999962</c:v>
                </c:pt>
              </c:numCache>
            </c:numRef>
          </c:xVal>
          <c:yVal>
            <c:numRef>
              <c:f>'Cell File Sorted'!$T$2:$T$204</c:f>
              <c:numCache>
                <c:formatCode>General</c:formatCode>
                <c:ptCount val="203"/>
                <c:pt idx="70">
                  <c:v>101.149</c:v>
                </c:pt>
                <c:pt idx="71">
                  <c:v>113.464</c:v>
                </c:pt>
                <c:pt idx="72">
                  <c:v>125.46599999999999</c:v>
                </c:pt>
                <c:pt idx="73">
                  <c:v>133.02699999999999</c:v>
                </c:pt>
                <c:pt idx="74">
                  <c:v>140.27600000000001</c:v>
                </c:pt>
                <c:pt idx="75">
                  <c:v>147.58099999999999</c:v>
                </c:pt>
                <c:pt idx="76">
                  <c:v>155.78700000000001</c:v>
                </c:pt>
                <c:pt idx="77">
                  <c:v>163.29599999999999</c:v>
                </c:pt>
                <c:pt idx="78">
                  <c:v>171.56100000000001</c:v>
                </c:pt>
                <c:pt idx="79">
                  <c:v>179.65199999999999</c:v>
                </c:pt>
                <c:pt idx="80">
                  <c:v>189.221</c:v>
                </c:pt>
                <c:pt idx="81">
                  <c:v>197.46299999999999</c:v>
                </c:pt>
                <c:pt idx="82">
                  <c:v>203.38300000000001</c:v>
                </c:pt>
                <c:pt idx="83">
                  <c:v>211.38399999999999</c:v>
                </c:pt>
                <c:pt idx="84">
                  <c:v>219.62</c:v>
                </c:pt>
                <c:pt idx="85">
                  <c:v>225.87</c:v>
                </c:pt>
                <c:pt idx="86">
                  <c:v>234.17400000000001</c:v>
                </c:pt>
                <c:pt idx="87">
                  <c:v>244.11099999999999</c:v>
                </c:pt>
                <c:pt idx="88">
                  <c:v>253.63</c:v>
                </c:pt>
                <c:pt idx="89">
                  <c:v>262.53699999999998</c:v>
                </c:pt>
                <c:pt idx="90">
                  <c:v>271.66800000000001</c:v>
                </c:pt>
                <c:pt idx="91">
                  <c:v>281.44200000000001</c:v>
                </c:pt>
                <c:pt idx="92">
                  <c:v>291.23500000000001</c:v>
                </c:pt>
                <c:pt idx="93">
                  <c:v>301.07100000000003</c:v>
                </c:pt>
                <c:pt idx="94">
                  <c:v>311.59800000000001</c:v>
                </c:pt>
                <c:pt idx="95">
                  <c:v>320.53300000000002</c:v>
                </c:pt>
                <c:pt idx="96">
                  <c:v>338.54599999999999</c:v>
                </c:pt>
                <c:pt idx="97">
                  <c:v>353.88900000000001</c:v>
                </c:pt>
                <c:pt idx="98">
                  <c:v>362.11200000000002</c:v>
                </c:pt>
                <c:pt idx="99">
                  <c:v>372.04599999999999</c:v>
                </c:pt>
                <c:pt idx="100">
                  <c:v>380.85300000000001</c:v>
                </c:pt>
                <c:pt idx="101">
                  <c:v>388.99200000000002</c:v>
                </c:pt>
                <c:pt idx="102">
                  <c:v>398.03399999999999</c:v>
                </c:pt>
                <c:pt idx="103">
                  <c:v>405.12799999999999</c:v>
                </c:pt>
                <c:pt idx="104">
                  <c:v>410.351</c:v>
                </c:pt>
                <c:pt idx="105">
                  <c:v>421.05900000000003</c:v>
                </c:pt>
                <c:pt idx="106">
                  <c:v>433.25</c:v>
                </c:pt>
                <c:pt idx="107">
                  <c:v>442.85599999999999</c:v>
                </c:pt>
                <c:pt idx="108">
                  <c:v>450.58800000000002</c:v>
                </c:pt>
                <c:pt idx="109">
                  <c:v>456.077</c:v>
                </c:pt>
                <c:pt idx="110">
                  <c:v>461.43</c:v>
                </c:pt>
                <c:pt idx="111">
                  <c:v>466.59399999999999</c:v>
                </c:pt>
                <c:pt idx="112">
                  <c:v>474.83699999999999</c:v>
                </c:pt>
                <c:pt idx="113">
                  <c:v>483.54700000000003</c:v>
                </c:pt>
                <c:pt idx="114">
                  <c:v>489.95699999999999</c:v>
                </c:pt>
                <c:pt idx="115">
                  <c:v>497.22300000000001</c:v>
                </c:pt>
                <c:pt idx="116">
                  <c:v>499.82299999999998</c:v>
                </c:pt>
                <c:pt idx="117">
                  <c:v>512.64200000000005</c:v>
                </c:pt>
                <c:pt idx="118">
                  <c:v>525.77599999999995</c:v>
                </c:pt>
                <c:pt idx="119">
                  <c:v>539.13099999999997</c:v>
                </c:pt>
                <c:pt idx="120">
                  <c:v>552.82899999999995</c:v>
                </c:pt>
                <c:pt idx="121">
                  <c:v>566.78099999999995</c:v>
                </c:pt>
                <c:pt idx="122">
                  <c:v>581.35400000000004</c:v>
                </c:pt>
                <c:pt idx="123">
                  <c:v>598.77599999999995</c:v>
                </c:pt>
                <c:pt idx="124">
                  <c:v>616.98299999999995</c:v>
                </c:pt>
                <c:pt idx="125">
                  <c:v>637.04200000000003</c:v>
                </c:pt>
                <c:pt idx="126">
                  <c:v>657.29300000000001</c:v>
                </c:pt>
                <c:pt idx="127">
                  <c:v>675.13</c:v>
                </c:pt>
                <c:pt idx="128">
                  <c:v>729.30200000000002</c:v>
                </c:pt>
                <c:pt idx="129">
                  <c:v>759.682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723-43F1-A0D2-39A358F941C4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xVal>
            <c:numRef>
              <c:f>'Cell File Sorted'!$R$2:$R$204</c:f>
              <c:numCache>
                <c:formatCode>General</c:formatCode>
                <c:ptCount val="203"/>
                <c:pt idx="0">
                  <c:v>5.8469999999999942</c:v>
                </c:pt>
                <c:pt idx="1">
                  <c:v>6.4969999999999999</c:v>
                </c:pt>
                <c:pt idx="2">
                  <c:v>6.8560000000000088</c:v>
                </c:pt>
                <c:pt idx="3">
                  <c:v>8.2949999999999875</c:v>
                </c:pt>
                <c:pt idx="4">
                  <c:v>8.1290000000000191</c:v>
                </c:pt>
                <c:pt idx="5">
                  <c:v>8.9439999999999884</c:v>
                </c:pt>
                <c:pt idx="6">
                  <c:v>8.5929999999999893</c:v>
                </c:pt>
                <c:pt idx="7">
                  <c:v>9.6810000000000116</c:v>
                </c:pt>
                <c:pt idx="8">
                  <c:v>9.2510000000000048</c:v>
                </c:pt>
                <c:pt idx="9">
                  <c:v>8.757000000000005</c:v>
                </c:pt>
                <c:pt idx="10">
                  <c:v>8.3559999999999945</c:v>
                </c:pt>
                <c:pt idx="11">
                  <c:v>9.6500000000000057</c:v>
                </c:pt>
                <c:pt idx="12">
                  <c:v>7.8729999999999905</c:v>
                </c:pt>
                <c:pt idx="13">
                  <c:v>5.2019999999999982</c:v>
                </c:pt>
                <c:pt idx="14">
                  <c:v>5.4350000000000023</c:v>
                </c:pt>
                <c:pt idx="15">
                  <c:v>6.0089999999999861</c:v>
                </c:pt>
                <c:pt idx="16">
                  <c:v>5.7060000000000173</c:v>
                </c:pt>
                <c:pt idx="17">
                  <c:v>5.0769999999999982</c:v>
                </c:pt>
                <c:pt idx="18">
                  <c:v>5.7949999999999875</c:v>
                </c:pt>
                <c:pt idx="19">
                  <c:v>6.2060000000000173</c:v>
                </c:pt>
                <c:pt idx="20">
                  <c:v>5.8859999999999673</c:v>
                </c:pt>
                <c:pt idx="21">
                  <c:v>5.2320000000000277</c:v>
                </c:pt>
                <c:pt idx="22">
                  <c:v>5.9739999999999895</c:v>
                </c:pt>
                <c:pt idx="23">
                  <c:v>6.8670000000000186</c:v>
                </c:pt>
                <c:pt idx="24">
                  <c:v>7.8770000000000095</c:v>
                </c:pt>
                <c:pt idx="25">
                  <c:v>8.9069999999999823</c:v>
                </c:pt>
                <c:pt idx="26">
                  <c:v>8.4730000000000132</c:v>
                </c:pt>
                <c:pt idx="27">
                  <c:v>8.1490000000000009</c:v>
                </c:pt>
                <c:pt idx="28">
                  <c:v>7.9420000000000073</c:v>
                </c:pt>
                <c:pt idx="29">
                  <c:v>7.9759999999999991</c:v>
                </c:pt>
                <c:pt idx="30">
                  <c:v>7.3479999999999563</c:v>
                </c:pt>
                <c:pt idx="31">
                  <c:v>13.761000000000024</c:v>
                </c:pt>
                <c:pt idx="32">
                  <c:v>8.9780000000000086</c:v>
                </c:pt>
                <c:pt idx="33">
                  <c:v>9.1129999999999995</c:v>
                </c:pt>
                <c:pt idx="34">
                  <c:v>8.1049999999999613</c:v>
                </c:pt>
                <c:pt idx="35">
                  <c:v>8.6470000000000482</c:v>
                </c:pt>
                <c:pt idx="36">
                  <c:v>7.2330000000000041</c:v>
                </c:pt>
                <c:pt idx="37">
                  <c:v>5.1499999999999773</c:v>
                </c:pt>
                <c:pt idx="38">
                  <c:v>5.0799999999999841</c:v>
                </c:pt>
                <c:pt idx="39">
                  <c:v>4.9580000000000268</c:v>
                </c:pt>
                <c:pt idx="40">
                  <c:v>4.7419999999999618</c:v>
                </c:pt>
                <c:pt idx="41">
                  <c:v>4.7530000000000427</c:v>
                </c:pt>
                <c:pt idx="42">
                  <c:v>6.8709999999999809</c:v>
                </c:pt>
                <c:pt idx="43">
                  <c:v>7.0889999999999986</c:v>
                </c:pt>
                <c:pt idx="44">
                  <c:v>5.1000000000000227</c:v>
                </c:pt>
                <c:pt idx="45">
                  <c:v>7.9969999999999573</c:v>
                </c:pt>
                <c:pt idx="46">
                  <c:v>8.9080000000000155</c:v>
                </c:pt>
                <c:pt idx="47">
                  <c:v>8.8870000000000005</c:v>
                </c:pt>
                <c:pt idx="48">
                  <c:v>8.6700000000000159</c:v>
                </c:pt>
                <c:pt idx="49">
                  <c:v>6.9850000000000136</c:v>
                </c:pt>
                <c:pt idx="50">
                  <c:v>10.525999999999954</c:v>
                </c:pt>
                <c:pt idx="51">
                  <c:v>9.6770000000000209</c:v>
                </c:pt>
                <c:pt idx="52">
                  <c:v>7.396000000000015</c:v>
                </c:pt>
                <c:pt idx="53">
                  <c:v>9.9029999999999632</c:v>
                </c:pt>
                <c:pt idx="54">
                  <c:v>9.4830000000000609</c:v>
                </c:pt>
                <c:pt idx="55">
                  <c:v>7.3399999999999181</c:v>
                </c:pt>
                <c:pt idx="56">
                  <c:v>9.0350000000000819</c:v>
                </c:pt>
                <c:pt idx="57">
                  <c:v>11.793000000000006</c:v>
                </c:pt>
                <c:pt idx="58">
                  <c:v>12.538000000000011</c:v>
                </c:pt>
                <c:pt idx="59">
                  <c:v>10.404999999999973</c:v>
                </c:pt>
                <c:pt idx="60">
                  <c:v>9.2549999999999955</c:v>
                </c:pt>
                <c:pt idx="61">
                  <c:v>13.808999999999969</c:v>
                </c:pt>
                <c:pt idx="62">
                  <c:v>16.020999999999958</c:v>
                </c:pt>
                <c:pt idx="63">
                  <c:v>14.609000000000037</c:v>
                </c:pt>
                <c:pt idx="64">
                  <c:v>18.623000000000047</c:v>
                </c:pt>
                <c:pt idx="65">
                  <c:v>17.519999999999982</c:v>
                </c:pt>
                <c:pt idx="66">
                  <c:v>31.230000000000018</c:v>
                </c:pt>
                <c:pt idx="67">
                  <c:v>35.769999999999982</c:v>
                </c:pt>
                <c:pt idx="68">
                  <c:v>33.247999999999934</c:v>
                </c:pt>
                <c:pt idx="69">
                  <c:v>30.138000000000034</c:v>
                </c:pt>
                <c:pt idx="70">
                  <c:v>12.314999999999998</c:v>
                </c:pt>
                <c:pt idx="71">
                  <c:v>12.001999999999995</c:v>
                </c:pt>
                <c:pt idx="72">
                  <c:v>7.5609999999999928</c:v>
                </c:pt>
                <c:pt idx="73">
                  <c:v>7.2490000000000236</c:v>
                </c:pt>
                <c:pt idx="74">
                  <c:v>7.3049999999999784</c:v>
                </c:pt>
                <c:pt idx="75">
                  <c:v>8.2060000000000173</c:v>
                </c:pt>
                <c:pt idx="76">
                  <c:v>7.5089999999999861</c:v>
                </c:pt>
                <c:pt idx="77">
                  <c:v>8.2650000000000148</c:v>
                </c:pt>
                <c:pt idx="78">
                  <c:v>8.0909999999999798</c:v>
                </c:pt>
                <c:pt idx="79">
                  <c:v>9.5690000000000168</c:v>
                </c:pt>
                <c:pt idx="80">
                  <c:v>8.2419999999999902</c:v>
                </c:pt>
                <c:pt idx="81">
                  <c:v>5.9200000000000159</c:v>
                </c:pt>
                <c:pt idx="82">
                  <c:v>8.0009999999999764</c:v>
                </c:pt>
                <c:pt idx="83">
                  <c:v>8.2360000000000184</c:v>
                </c:pt>
                <c:pt idx="84">
                  <c:v>6.25</c:v>
                </c:pt>
                <c:pt idx="85">
                  <c:v>8.304000000000002</c:v>
                </c:pt>
                <c:pt idx="86">
                  <c:v>9.9369999999999834</c:v>
                </c:pt>
                <c:pt idx="87">
                  <c:v>9.5190000000000055</c:v>
                </c:pt>
                <c:pt idx="88">
                  <c:v>8.9069999999999823</c:v>
                </c:pt>
                <c:pt idx="89">
                  <c:v>9.1310000000000286</c:v>
                </c:pt>
                <c:pt idx="90">
                  <c:v>9.7740000000000009</c:v>
                </c:pt>
                <c:pt idx="91">
                  <c:v>9.7930000000000064</c:v>
                </c:pt>
                <c:pt idx="92">
                  <c:v>9.8360000000000127</c:v>
                </c:pt>
                <c:pt idx="93">
                  <c:v>10.526999999999987</c:v>
                </c:pt>
                <c:pt idx="94">
                  <c:v>8.9350000000000023</c:v>
                </c:pt>
                <c:pt idx="95">
                  <c:v>18.012999999999977</c:v>
                </c:pt>
                <c:pt idx="96">
                  <c:v>15.343000000000018</c:v>
                </c:pt>
                <c:pt idx="97">
                  <c:v>8.2230000000000132</c:v>
                </c:pt>
                <c:pt idx="98">
                  <c:v>9.9339999999999691</c:v>
                </c:pt>
                <c:pt idx="99">
                  <c:v>8.8070000000000164</c:v>
                </c:pt>
                <c:pt idx="100">
                  <c:v>8.13900000000001</c:v>
                </c:pt>
                <c:pt idx="101">
                  <c:v>9.0419999999999732</c:v>
                </c:pt>
                <c:pt idx="102">
                  <c:v>7.0939999999999941</c:v>
                </c:pt>
                <c:pt idx="103">
                  <c:v>5.2230000000000132</c:v>
                </c:pt>
                <c:pt idx="104">
                  <c:v>10.708000000000027</c:v>
                </c:pt>
                <c:pt idx="105">
                  <c:v>12.190999999999974</c:v>
                </c:pt>
                <c:pt idx="106">
                  <c:v>9.6059999999999945</c:v>
                </c:pt>
                <c:pt idx="107">
                  <c:v>7.7320000000000277</c:v>
                </c:pt>
                <c:pt idx="108">
                  <c:v>5.4889999999999759</c:v>
                </c:pt>
                <c:pt idx="109">
                  <c:v>5.3530000000000086</c:v>
                </c:pt>
                <c:pt idx="110">
                  <c:v>5.1639999999999873</c:v>
                </c:pt>
                <c:pt idx="111">
                  <c:v>8.242999999999995</c:v>
                </c:pt>
                <c:pt idx="112">
                  <c:v>8.7100000000000364</c:v>
                </c:pt>
                <c:pt idx="113">
                  <c:v>6.4099999999999682</c:v>
                </c:pt>
                <c:pt idx="114">
                  <c:v>7.2660000000000196</c:v>
                </c:pt>
                <c:pt idx="115">
                  <c:v>2.5999999999999659</c:v>
                </c:pt>
                <c:pt idx="116">
                  <c:v>12.819000000000074</c:v>
                </c:pt>
                <c:pt idx="117">
                  <c:v>13.133999999999901</c:v>
                </c:pt>
                <c:pt idx="118">
                  <c:v>13.355000000000018</c:v>
                </c:pt>
                <c:pt idx="119">
                  <c:v>13.697999999999979</c:v>
                </c:pt>
                <c:pt idx="120">
                  <c:v>13.951999999999998</c:v>
                </c:pt>
                <c:pt idx="121">
                  <c:v>14.573000000000093</c:v>
                </c:pt>
                <c:pt idx="122">
                  <c:v>17.421999999999912</c:v>
                </c:pt>
                <c:pt idx="123">
                  <c:v>18.206999999999994</c:v>
                </c:pt>
                <c:pt idx="124">
                  <c:v>20.059000000000083</c:v>
                </c:pt>
                <c:pt idx="125">
                  <c:v>20.250999999999976</c:v>
                </c:pt>
                <c:pt idx="126">
                  <c:v>17.836999999999989</c:v>
                </c:pt>
                <c:pt idx="127">
                  <c:v>54.172000000000025</c:v>
                </c:pt>
                <c:pt idx="128">
                  <c:v>30.380999999999972</c:v>
                </c:pt>
                <c:pt idx="129">
                  <c:v>32.794999999999959</c:v>
                </c:pt>
                <c:pt idx="130">
                  <c:v>9.3130000000000024</c:v>
                </c:pt>
                <c:pt idx="131">
                  <c:v>10.391999999999996</c:v>
                </c:pt>
                <c:pt idx="132">
                  <c:v>11.036000000000001</c:v>
                </c:pt>
                <c:pt idx="133">
                  <c:v>10.923000000000002</c:v>
                </c:pt>
                <c:pt idx="134">
                  <c:v>8.203000000000003</c:v>
                </c:pt>
                <c:pt idx="135">
                  <c:v>6.257000000000005</c:v>
                </c:pt>
                <c:pt idx="136">
                  <c:v>5.8969999999999914</c:v>
                </c:pt>
                <c:pt idx="137">
                  <c:v>5.7959999999999923</c:v>
                </c:pt>
                <c:pt idx="138">
                  <c:v>5.2050000000000125</c:v>
                </c:pt>
                <c:pt idx="139">
                  <c:v>4.8619999999999948</c:v>
                </c:pt>
                <c:pt idx="140">
                  <c:v>5.2280000000000086</c:v>
                </c:pt>
                <c:pt idx="141">
                  <c:v>5.7959999999999923</c:v>
                </c:pt>
                <c:pt idx="142">
                  <c:v>5.2920000000000016</c:v>
                </c:pt>
                <c:pt idx="143">
                  <c:v>4.7820000000000107</c:v>
                </c:pt>
                <c:pt idx="144">
                  <c:v>5.0949999999999989</c:v>
                </c:pt>
                <c:pt idx="145">
                  <c:v>5.6349999999999909</c:v>
                </c:pt>
                <c:pt idx="146">
                  <c:v>6.6529999999999916</c:v>
                </c:pt>
                <c:pt idx="147">
                  <c:v>7.8460000000000036</c:v>
                </c:pt>
                <c:pt idx="148">
                  <c:v>7.257000000000005</c:v>
                </c:pt>
                <c:pt idx="149">
                  <c:v>7.5029999999999859</c:v>
                </c:pt>
                <c:pt idx="150">
                  <c:v>7.6910000000000025</c:v>
                </c:pt>
                <c:pt idx="151">
                  <c:v>8.5790000000000362</c:v>
                </c:pt>
                <c:pt idx="152">
                  <c:v>9.1269999999999527</c:v>
                </c:pt>
                <c:pt idx="153">
                  <c:v>7.1230000000000473</c:v>
                </c:pt>
                <c:pt idx="154">
                  <c:v>4.9959999999999809</c:v>
                </c:pt>
                <c:pt idx="155">
                  <c:v>6.7160000000000082</c:v>
                </c:pt>
                <c:pt idx="156">
                  <c:v>8.3319999999999936</c:v>
                </c:pt>
                <c:pt idx="157">
                  <c:v>8.7789999999999964</c:v>
                </c:pt>
                <c:pt idx="158">
                  <c:v>9.3020000000000209</c:v>
                </c:pt>
                <c:pt idx="159">
                  <c:v>9.6829999999999927</c:v>
                </c:pt>
                <c:pt idx="160">
                  <c:v>7.589999999999975</c:v>
                </c:pt>
                <c:pt idx="161">
                  <c:v>5.2610000000000241</c:v>
                </c:pt>
                <c:pt idx="162">
                  <c:v>5.103999999999985</c:v>
                </c:pt>
                <c:pt idx="163">
                  <c:v>5.1730000000000018</c:v>
                </c:pt>
                <c:pt idx="164">
                  <c:v>5.5980000000000132</c:v>
                </c:pt>
                <c:pt idx="165">
                  <c:v>5.8079999999999927</c:v>
                </c:pt>
                <c:pt idx="166">
                  <c:v>6.44399999999996</c:v>
                </c:pt>
                <c:pt idx="167">
                  <c:v>5.7260000000000559</c:v>
                </c:pt>
                <c:pt idx="168">
                  <c:v>5.5589999999999691</c:v>
                </c:pt>
                <c:pt idx="169">
                  <c:v>6.01400000000001</c:v>
                </c:pt>
                <c:pt idx="170">
                  <c:v>5.5339999999999918</c:v>
                </c:pt>
                <c:pt idx="171">
                  <c:v>5.617999999999995</c:v>
                </c:pt>
                <c:pt idx="172">
                  <c:v>5.8949999999999818</c:v>
                </c:pt>
                <c:pt idx="173">
                  <c:v>6.2170000000000414</c:v>
                </c:pt>
                <c:pt idx="174">
                  <c:v>6.0190000000000055</c:v>
                </c:pt>
                <c:pt idx="175">
                  <c:v>6.2330000000000041</c:v>
                </c:pt>
                <c:pt idx="176">
                  <c:v>11.871999999999957</c:v>
                </c:pt>
                <c:pt idx="177">
                  <c:v>5.8199999999999932</c:v>
                </c:pt>
                <c:pt idx="178">
                  <c:v>5.8280000000000314</c:v>
                </c:pt>
                <c:pt idx="179">
                  <c:v>6.1129999999999995</c:v>
                </c:pt>
                <c:pt idx="180">
                  <c:v>6.8319999999999936</c:v>
                </c:pt>
                <c:pt idx="181">
                  <c:v>9.2470000000000141</c:v>
                </c:pt>
                <c:pt idx="182">
                  <c:v>8.6080000000000041</c:v>
                </c:pt>
                <c:pt idx="183">
                  <c:v>5.8039999999999736</c:v>
                </c:pt>
                <c:pt idx="184">
                  <c:v>9.26400000000001</c:v>
                </c:pt>
                <c:pt idx="185">
                  <c:v>9.3179999999999836</c:v>
                </c:pt>
                <c:pt idx="186">
                  <c:v>7.4070000000000391</c:v>
                </c:pt>
                <c:pt idx="187">
                  <c:v>10.528999999999996</c:v>
                </c:pt>
                <c:pt idx="188">
                  <c:v>11.156999999999925</c:v>
                </c:pt>
                <c:pt idx="189">
                  <c:v>16.379999999999995</c:v>
                </c:pt>
                <c:pt idx="190">
                  <c:v>8.68100000000004</c:v>
                </c:pt>
                <c:pt idx="191">
                  <c:v>8.7710000000000719</c:v>
                </c:pt>
                <c:pt idx="192">
                  <c:v>10.080999999999904</c:v>
                </c:pt>
                <c:pt idx="193">
                  <c:v>10.730000000000018</c:v>
                </c:pt>
                <c:pt idx="194">
                  <c:v>12.704000000000065</c:v>
                </c:pt>
                <c:pt idx="195">
                  <c:v>14.631999999999948</c:v>
                </c:pt>
                <c:pt idx="196">
                  <c:v>17.606999999999971</c:v>
                </c:pt>
                <c:pt idx="197">
                  <c:v>17.298000000000002</c:v>
                </c:pt>
                <c:pt idx="198">
                  <c:v>16.603000000000065</c:v>
                </c:pt>
                <c:pt idx="199">
                  <c:v>21.572999999999979</c:v>
                </c:pt>
                <c:pt idx="200">
                  <c:v>30.150999999999954</c:v>
                </c:pt>
                <c:pt idx="201">
                  <c:v>46.020000000000095</c:v>
                </c:pt>
                <c:pt idx="202">
                  <c:v>30.116999999999962</c:v>
                </c:pt>
              </c:numCache>
            </c:numRef>
          </c:xVal>
          <c:yVal>
            <c:numRef>
              <c:f>'Cell File Sorted'!$U$2:$U$204</c:f>
              <c:numCache>
                <c:formatCode>General</c:formatCode>
                <c:ptCount val="203"/>
                <c:pt idx="130">
                  <c:v>103.116</c:v>
                </c:pt>
                <c:pt idx="131">
                  <c:v>112.429</c:v>
                </c:pt>
                <c:pt idx="132">
                  <c:v>122.821</c:v>
                </c:pt>
                <c:pt idx="133">
                  <c:v>133.857</c:v>
                </c:pt>
                <c:pt idx="134">
                  <c:v>144.78</c:v>
                </c:pt>
                <c:pt idx="135">
                  <c:v>152.983</c:v>
                </c:pt>
                <c:pt idx="136">
                  <c:v>159.24</c:v>
                </c:pt>
                <c:pt idx="137">
                  <c:v>165.137</c:v>
                </c:pt>
                <c:pt idx="138">
                  <c:v>170.93299999999999</c:v>
                </c:pt>
                <c:pt idx="139">
                  <c:v>176.13800000000001</c:v>
                </c:pt>
                <c:pt idx="140">
                  <c:v>181</c:v>
                </c:pt>
                <c:pt idx="141">
                  <c:v>186.22800000000001</c:v>
                </c:pt>
                <c:pt idx="142">
                  <c:v>192.024</c:v>
                </c:pt>
                <c:pt idx="143">
                  <c:v>197.316</c:v>
                </c:pt>
                <c:pt idx="144">
                  <c:v>202.09800000000001</c:v>
                </c:pt>
                <c:pt idx="145">
                  <c:v>207.19300000000001</c:v>
                </c:pt>
                <c:pt idx="146">
                  <c:v>212.828</c:v>
                </c:pt>
                <c:pt idx="147">
                  <c:v>219.48099999999999</c:v>
                </c:pt>
                <c:pt idx="148">
                  <c:v>227.327</c:v>
                </c:pt>
                <c:pt idx="149">
                  <c:v>234.584</c:v>
                </c:pt>
                <c:pt idx="150">
                  <c:v>242.08699999999999</c:v>
                </c:pt>
                <c:pt idx="151">
                  <c:v>249.77799999999999</c:v>
                </c:pt>
                <c:pt idx="152">
                  <c:v>258.35700000000003</c:v>
                </c:pt>
                <c:pt idx="153">
                  <c:v>267.48399999999998</c:v>
                </c:pt>
                <c:pt idx="154">
                  <c:v>274.60700000000003</c:v>
                </c:pt>
                <c:pt idx="155">
                  <c:v>279.60300000000001</c:v>
                </c:pt>
                <c:pt idx="156">
                  <c:v>286.31900000000002</c:v>
                </c:pt>
                <c:pt idx="157">
                  <c:v>294.65100000000001</c:v>
                </c:pt>
                <c:pt idx="158">
                  <c:v>303.43</c:v>
                </c:pt>
                <c:pt idx="159">
                  <c:v>312.73200000000003</c:v>
                </c:pt>
                <c:pt idx="160">
                  <c:v>322.41500000000002</c:v>
                </c:pt>
                <c:pt idx="161">
                  <c:v>330.005</c:v>
                </c:pt>
                <c:pt idx="162">
                  <c:v>335.26600000000002</c:v>
                </c:pt>
                <c:pt idx="163">
                  <c:v>340.37</c:v>
                </c:pt>
                <c:pt idx="164">
                  <c:v>345.54300000000001</c:v>
                </c:pt>
                <c:pt idx="165">
                  <c:v>351.14100000000002</c:v>
                </c:pt>
                <c:pt idx="166">
                  <c:v>356.94900000000001</c:v>
                </c:pt>
                <c:pt idx="167">
                  <c:v>363.39299999999997</c:v>
                </c:pt>
                <c:pt idx="168">
                  <c:v>369.11900000000003</c:v>
                </c:pt>
                <c:pt idx="169">
                  <c:v>374.678</c:v>
                </c:pt>
                <c:pt idx="170">
                  <c:v>380.69200000000001</c:v>
                </c:pt>
                <c:pt idx="171">
                  <c:v>386.226</c:v>
                </c:pt>
                <c:pt idx="172">
                  <c:v>391.84399999999999</c:v>
                </c:pt>
                <c:pt idx="173">
                  <c:v>397.73899999999998</c:v>
                </c:pt>
                <c:pt idx="174">
                  <c:v>403.95600000000002</c:v>
                </c:pt>
                <c:pt idx="175">
                  <c:v>409.97500000000002</c:v>
                </c:pt>
                <c:pt idx="176">
                  <c:v>416.20800000000003</c:v>
                </c:pt>
                <c:pt idx="177">
                  <c:v>428.08</c:v>
                </c:pt>
                <c:pt idx="178">
                  <c:v>433.9</c:v>
                </c:pt>
                <c:pt idx="179">
                  <c:v>439.72800000000001</c:v>
                </c:pt>
                <c:pt idx="180">
                  <c:v>445.84100000000001</c:v>
                </c:pt>
                <c:pt idx="181">
                  <c:v>452.673</c:v>
                </c:pt>
                <c:pt idx="182">
                  <c:v>461.92</c:v>
                </c:pt>
                <c:pt idx="183">
                  <c:v>470.52800000000002</c:v>
                </c:pt>
                <c:pt idx="184">
                  <c:v>476.33199999999999</c:v>
                </c:pt>
                <c:pt idx="185">
                  <c:v>485.596</c:v>
                </c:pt>
                <c:pt idx="186">
                  <c:v>494.91399999999999</c:v>
                </c:pt>
                <c:pt idx="187">
                  <c:v>502.32100000000003</c:v>
                </c:pt>
                <c:pt idx="188">
                  <c:v>512.85</c:v>
                </c:pt>
                <c:pt idx="189">
                  <c:v>524.00699999999995</c:v>
                </c:pt>
                <c:pt idx="190">
                  <c:v>540.38699999999994</c:v>
                </c:pt>
                <c:pt idx="191">
                  <c:v>549.06799999999998</c:v>
                </c:pt>
                <c:pt idx="192">
                  <c:v>557.83900000000006</c:v>
                </c:pt>
                <c:pt idx="193">
                  <c:v>567.91999999999996</c:v>
                </c:pt>
                <c:pt idx="194">
                  <c:v>578.65</c:v>
                </c:pt>
                <c:pt idx="195">
                  <c:v>591.35400000000004</c:v>
                </c:pt>
                <c:pt idx="196">
                  <c:v>605.98599999999999</c:v>
                </c:pt>
                <c:pt idx="197">
                  <c:v>623.59299999999996</c:v>
                </c:pt>
                <c:pt idx="198">
                  <c:v>640.89099999999996</c:v>
                </c:pt>
                <c:pt idx="199">
                  <c:v>657.49400000000003</c:v>
                </c:pt>
                <c:pt idx="200">
                  <c:v>679.06700000000001</c:v>
                </c:pt>
                <c:pt idx="201">
                  <c:v>709.21799999999996</c:v>
                </c:pt>
                <c:pt idx="202">
                  <c:v>755.2380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723-43F1-A0D2-39A358F941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3686296"/>
        <c:axId val="663686952"/>
      </c:scatterChart>
      <c:valAx>
        <c:axId val="663686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63686952"/>
        <c:crosses val="autoZero"/>
        <c:crossBetween val="midCat"/>
      </c:valAx>
      <c:valAx>
        <c:axId val="663686952"/>
        <c:scaling>
          <c:orientation val="minMax"/>
          <c:max val="8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636862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1615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1322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7369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2475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7830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2085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5176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652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781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3088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8629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32869A-EB71-4EDC-B105-713D8EC16427}" type="datetimeFigureOut">
              <a:rPr lang="de-DE" smtClean="0"/>
              <a:t>13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F6B70-779A-48B1-869B-3000D19877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4231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20363" t="11062" r="19203" b="4106"/>
          <a:stretch/>
        </p:blipFill>
        <p:spPr>
          <a:xfrm>
            <a:off x="5768093" y="1085867"/>
            <a:ext cx="6218498" cy="490993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12307" t="11197" r="25001" b="4017"/>
          <a:stretch/>
        </p:blipFill>
        <p:spPr>
          <a:xfrm>
            <a:off x="0" y="1085867"/>
            <a:ext cx="6294112" cy="4788159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6138153" y="972767"/>
            <a:ext cx="5982511" cy="1325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Rectangle 6"/>
          <p:cNvSpPr/>
          <p:nvPr/>
        </p:nvSpPr>
        <p:spPr>
          <a:xfrm>
            <a:off x="1" y="923735"/>
            <a:ext cx="6206246" cy="1876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Rectangle 7"/>
          <p:cNvSpPr/>
          <p:nvPr/>
        </p:nvSpPr>
        <p:spPr>
          <a:xfrm>
            <a:off x="-145915" y="5853121"/>
            <a:ext cx="6524017" cy="1830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Box 8"/>
          <p:cNvSpPr txBox="1"/>
          <p:nvPr/>
        </p:nvSpPr>
        <p:spPr>
          <a:xfrm>
            <a:off x="1118681" y="4753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0" name="TextBox 9"/>
          <p:cNvSpPr txBox="1"/>
          <p:nvPr/>
        </p:nvSpPr>
        <p:spPr>
          <a:xfrm>
            <a:off x="6864485" y="4753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11" name="TextBox 10"/>
          <p:cNvSpPr txBox="1"/>
          <p:nvPr/>
        </p:nvSpPr>
        <p:spPr>
          <a:xfrm>
            <a:off x="268941" y="204395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135780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0303" t="11616" r="18788" b="4344"/>
          <a:stretch/>
        </p:blipFill>
        <p:spPr>
          <a:xfrm>
            <a:off x="249383" y="1191698"/>
            <a:ext cx="5694218" cy="441939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22576" t="11212" r="21174" b="3939"/>
          <a:stretch/>
        </p:blipFill>
        <p:spPr>
          <a:xfrm>
            <a:off x="6213767" y="1170916"/>
            <a:ext cx="5682342" cy="482138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86171" y="4753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7" name="TextBox 6"/>
          <p:cNvSpPr txBox="1"/>
          <p:nvPr/>
        </p:nvSpPr>
        <p:spPr>
          <a:xfrm>
            <a:off x="6531975" y="4753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8" name="Rectangle 7"/>
          <p:cNvSpPr/>
          <p:nvPr/>
        </p:nvSpPr>
        <p:spPr>
          <a:xfrm>
            <a:off x="5914103" y="988142"/>
            <a:ext cx="243349" cy="52946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Rectangle 8"/>
          <p:cNvSpPr/>
          <p:nvPr/>
        </p:nvSpPr>
        <p:spPr>
          <a:xfrm>
            <a:off x="6157452" y="988142"/>
            <a:ext cx="5847735" cy="1901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Rectangle 9"/>
          <p:cNvSpPr/>
          <p:nvPr/>
        </p:nvSpPr>
        <p:spPr>
          <a:xfrm>
            <a:off x="5974437" y="5977549"/>
            <a:ext cx="5847735" cy="1901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Rectangle 10"/>
          <p:cNvSpPr/>
          <p:nvPr/>
        </p:nvSpPr>
        <p:spPr>
          <a:xfrm>
            <a:off x="26782" y="1053998"/>
            <a:ext cx="243349" cy="52946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TextBox 11"/>
          <p:cNvSpPr txBox="1"/>
          <p:nvPr/>
        </p:nvSpPr>
        <p:spPr>
          <a:xfrm>
            <a:off x="268941" y="204395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7122989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19405" t="11376" r="17976" b="3968"/>
          <a:stretch/>
        </p:blipFill>
        <p:spPr>
          <a:xfrm>
            <a:off x="2699657" y="1078803"/>
            <a:ext cx="6139542" cy="466885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494384" y="5739267"/>
            <a:ext cx="6786465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TextBox 5"/>
          <p:cNvSpPr txBox="1"/>
          <p:nvPr/>
        </p:nvSpPr>
        <p:spPr>
          <a:xfrm>
            <a:off x="268941" y="204395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3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22182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12230" t="7778" r="57600" b="12857"/>
          <a:stretch/>
        </p:blipFill>
        <p:spPr>
          <a:xfrm>
            <a:off x="301039" y="159455"/>
            <a:ext cx="5920558" cy="525649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42670" t="28200" r="52215" b="51324"/>
          <a:stretch/>
        </p:blipFill>
        <p:spPr>
          <a:xfrm>
            <a:off x="2114697" y="5501811"/>
            <a:ext cx="1003747" cy="135618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42670" t="51003" r="52215" b="37983"/>
          <a:stretch/>
        </p:blipFill>
        <p:spPr>
          <a:xfrm>
            <a:off x="3410322" y="5501811"/>
            <a:ext cx="1003747" cy="72943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l="927" t="6418" r="66572" b="3921"/>
          <a:stretch/>
        </p:blipFill>
        <p:spPr>
          <a:xfrm>
            <a:off x="6704400" y="159454"/>
            <a:ext cx="5342158" cy="497401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6768" t="3095" r="70984" b="93327"/>
          <a:stretch/>
        </p:blipFill>
        <p:spPr>
          <a:xfrm>
            <a:off x="7788136" y="5482883"/>
            <a:ext cx="3400926" cy="18460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-24272" y="204395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4</a:t>
            </a:r>
            <a:endParaRPr lang="de-DE" dirty="0"/>
          </a:p>
        </p:txBody>
      </p:sp>
      <p:sp>
        <p:nvSpPr>
          <p:cNvPr id="10" name="TextBox 9"/>
          <p:cNvSpPr txBox="1"/>
          <p:nvPr/>
        </p:nvSpPr>
        <p:spPr>
          <a:xfrm>
            <a:off x="383212" y="204395"/>
            <a:ext cx="397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1" name="TextBox 10"/>
          <p:cNvSpPr txBox="1"/>
          <p:nvPr/>
        </p:nvSpPr>
        <p:spPr>
          <a:xfrm>
            <a:off x="6295162" y="159454"/>
            <a:ext cx="397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10262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1250573" y="3546005"/>
          <a:ext cx="4172370" cy="28863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1250573" y="3546006"/>
          <a:ext cx="4172370" cy="28863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/>
          </p:nvPr>
        </p:nvGraphicFramePr>
        <p:xfrm>
          <a:off x="1156872" y="3419025"/>
          <a:ext cx="4354411" cy="31546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1250573" y="3546006"/>
          <a:ext cx="4172370" cy="28863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6701850" y="7039623"/>
            <a:ext cx="4930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verage cell volume in the epidermis between 100 and 500 µm from the QC</a:t>
            </a:r>
            <a:endParaRPr lang="de-DE" sz="1200" dirty="0"/>
          </a:p>
        </p:txBody>
      </p:sp>
      <p:grpSp>
        <p:nvGrpSpPr>
          <p:cNvPr id="10" name="Group 9"/>
          <p:cNvGrpSpPr/>
          <p:nvPr/>
        </p:nvGrpSpPr>
        <p:grpSpPr>
          <a:xfrm>
            <a:off x="5567885" y="1050708"/>
            <a:ext cx="6739535" cy="2455197"/>
            <a:chOff x="1410055" y="572567"/>
            <a:chExt cx="8353425" cy="2455197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/>
            </p:nvPr>
          </p:nvGraphicFramePr>
          <p:xfrm>
            <a:off x="1410055" y="572567"/>
            <a:ext cx="8353425" cy="23500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cxnSp>
          <p:nvCxnSpPr>
            <p:cNvPr id="12" name="Straight Connector 11"/>
            <p:cNvCxnSpPr/>
            <p:nvPr/>
          </p:nvCxnSpPr>
          <p:spPr>
            <a:xfrm>
              <a:off x="1885844" y="2796932"/>
              <a:ext cx="6862273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8569222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8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711437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7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853653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6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95869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5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138085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4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280301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3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422517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2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564733" y="279693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10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764657" y="2796932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0</a:t>
              </a:r>
              <a:endParaRPr lang="de-DE" sz="900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6694057" y="3519248"/>
            <a:ext cx="2729492" cy="2655693"/>
            <a:chOff x="6403079" y="3785479"/>
            <a:chExt cx="2729492" cy="2655693"/>
          </a:xfrm>
        </p:grpSpPr>
        <p:sp>
          <p:nvSpPr>
            <p:cNvPr id="9" name="Isosceles Triangle 8"/>
            <p:cNvSpPr/>
            <p:nvPr/>
          </p:nvSpPr>
          <p:spPr>
            <a:xfrm flipV="1">
              <a:off x="6403079" y="3785479"/>
              <a:ext cx="2729492" cy="1444483"/>
            </a:xfrm>
            <a:prstGeom prst="triangle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aphicFrame>
          <p:nvGraphicFramePr>
            <p:cNvPr id="22" name="Chart 21"/>
            <p:cNvGraphicFramePr>
              <a:graphicFrameLocks/>
            </p:cNvGraphicFramePr>
            <p:nvPr>
              <p:extLst/>
            </p:nvPr>
          </p:nvGraphicFramePr>
          <p:xfrm>
            <a:off x="6993478" y="4411838"/>
            <a:ext cx="1548501" cy="20293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4" name="Rectangle 23"/>
            <p:cNvSpPr/>
            <p:nvPr/>
          </p:nvSpPr>
          <p:spPr>
            <a:xfrm>
              <a:off x="6998172" y="4344626"/>
              <a:ext cx="1538567" cy="154445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27" name="TextBox 26"/>
          <p:cNvSpPr txBox="1"/>
          <p:nvPr/>
        </p:nvSpPr>
        <p:spPr>
          <a:xfrm rot="16200000">
            <a:off x="474123" y="4660461"/>
            <a:ext cx="14319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 smtClean="0"/>
              <a:t>D</a:t>
            </a:r>
            <a:r>
              <a:rPr lang="de-DE" sz="1200" i="1" baseline="-25000" dirty="0" smtClean="0"/>
              <a:t>i</a:t>
            </a:r>
            <a:r>
              <a:rPr lang="de-DE" sz="1200" dirty="0" smtClean="0"/>
              <a:t> cell volume µm</a:t>
            </a:r>
            <a:r>
              <a:rPr lang="de-DE" sz="1200" baseline="30000" dirty="0" smtClean="0"/>
              <a:t>-3</a:t>
            </a:r>
            <a:endParaRPr lang="de-DE" sz="1200" baseline="30000" dirty="0"/>
          </a:p>
        </p:txBody>
      </p:sp>
      <p:sp>
        <p:nvSpPr>
          <p:cNvPr id="28" name="TextBox 27"/>
          <p:cNvSpPr txBox="1"/>
          <p:nvPr/>
        </p:nvSpPr>
        <p:spPr>
          <a:xfrm>
            <a:off x="3784777" y="6174941"/>
            <a:ext cx="1783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istance from QC µm</a:t>
            </a:r>
            <a:r>
              <a:rPr lang="de-DE" sz="1200" baseline="30000" dirty="0" smtClean="0"/>
              <a:t>-1</a:t>
            </a:r>
            <a:endParaRPr lang="de-DE" sz="1200" baseline="30000" dirty="0"/>
          </a:p>
        </p:txBody>
      </p:sp>
      <p:sp>
        <p:nvSpPr>
          <p:cNvPr id="29" name="TextBox 28"/>
          <p:cNvSpPr txBox="1"/>
          <p:nvPr/>
        </p:nvSpPr>
        <p:spPr>
          <a:xfrm>
            <a:off x="9979234" y="3588279"/>
            <a:ext cx="1605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Distance from QC µm</a:t>
            </a:r>
            <a:r>
              <a:rPr lang="de-DE" sz="1200" baseline="30000" dirty="0" smtClean="0"/>
              <a:t>-1</a:t>
            </a:r>
            <a:endParaRPr lang="de-DE" sz="1200" baseline="300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4767364" y="1778761"/>
            <a:ext cx="12412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Cell volume µm</a:t>
            </a:r>
            <a:r>
              <a:rPr lang="de-DE" sz="1200" baseline="30000" dirty="0" smtClean="0"/>
              <a:t>-3</a:t>
            </a:r>
            <a:endParaRPr lang="de-DE" sz="1200" baseline="30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6498471" y="4866050"/>
            <a:ext cx="12412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Cell volume µm</a:t>
            </a:r>
            <a:r>
              <a:rPr lang="de-DE" sz="1200" baseline="30000" dirty="0" smtClean="0"/>
              <a:t>-3</a:t>
            </a:r>
            <a:endParaRPr lang="de-DE" sz="1200" baseline="30000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7689129" y="4194084"/>
            <a:ext cx="4786" cy="1534556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H="1">
            <a:off x="7691510" y="5726259"/>
            <a:ext cx="9906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668393" y="578362"/>
            <a:ext cx="397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43" name="TextBox 42"/>
          <p:cNvSpPr txBox="1"/>
          <p:nvPr/>
        </p:nvSpPr>
        <p:spPr>
          <a:xfrm>
            <a:off x="8362998" y="3859131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</a:t>
            </a:r>
            <a:endParaRPr lang="de-DE" dirty="0"/>
          </a:p>
        </p:txBody>
      </p:sp>
      <p:graphicFrame>
        <p:nvGraphicFramePr>
          <p:cNvPr id="44" name="Chart 43"/>
          <p:cNvGraphicFramePr>
            <a:graphicFrameLocks/>
          </p:cNvGraphicFramePr>
          <p:nvPr>
            <p:extLst/>
          </p:nvPr>
        </p:nvGraphicFramePr>
        <p:xfrm>
          <a:off x="1353836" y="767804"/>
          <a:ext cx="2151950" cy="28135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5" name="Chart 44"/>
          <p:cNvGraphicFramePr>
            <a:graphicFrameLocks/>
          </p:cNvGraphicFramePr>
          <p:nvPr>
            <p:extLst/>
          </p:nvPr>
        </p:nvGraphicFramePr>
        <p:xfrm>
          <a:off x="1353840" y="767287"/>
          <a:ext cx="2412542" cy="28140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6" name="Chart 45"/>
          <p:cNvGraphicFramePr>
            <a:graphicFrameLocks/>
          </p:cNvGraphicFramePr>
          <p:nvPr>
            <p:extLst/>
          </p:nvPr>
        </p:nvGraphicFramePr>
        <p:xfrm>
          <a:off x="1353839" y="763028"/>
          <a:ext cx="2412543" cy="28182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49" name="TextBox 48"/>
          <p:cNvSpPr txBox="1"/>
          <p:nvPr/>
        </p:nvSpPr>
        <p:spPr>
          <a:xfrm>
            <a:off x="668393" y="3605747"/>
            <a:ext cx="287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52" name="Rectangle 51"/>
          <p:cNvSpPr/>
          <p:nvPr/>
        </p:nvSpPr>
        <p:spPr>
          <a:xfrm>
            <a:off x="1296733" y="770324"/>
            <a:ext cx="454403" cy="26140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3" name="Rectangle 52"/>
          <p:cNvSpPr/>
          <p:nvPr/>
        </p:nvSpPr>
        <p:spPr>
          <a:xfrm>
            <a:off x="289251" y="3384421"/>
            <a:ext cx="1709630" cy="152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4" name="Rectangle 63"/>
          <p:cNvSpPr/>
          <p:nvPr/>
        </p:nvSpPr>
        <p:spPr>
          <a:xfrm>
            <a:off x="1032004" y="3375235"/>
            <a:ext cx="2716200" cy="1088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51" name="Group 50"/>
          <p:cNvGrpSpPr/>
          <p:nvPr/>
        </p:nvGrpSpPr>
        <p:grpSpPr>
          <a:xfrm>
            <a:off x="1358457" y="763028"/>
            <a:ext cx="2400119" cy="2818294"/>
            <a:chOff x="1113180" y="3851835"/>
            <a:chExt cx="1784976" cy="2818294"/>
          </a:xfrm>
        </p:grpSpPr>
        <p:graphicFrame>
          <p:nvGraphicFramePr>
            <p:cNvPr id="48" name="Chart 47"/>
            <p:cNvGraphicFramePr>
              <a:graphicFrameLocks/>
            </p:cNvGraphicFramePr>
            <p:nvPr>
              <p:extLst/>
            </p:nvPr>
          </p:nvGraphicFramePr>
          <p:xfrm>
            <a:off x="1113180" y="3851835"/>
            <a:ext cx="1784976" cy="281829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50" name="Rectangle 49"/>
            <p:cNvSpPr/>
            <p:nvPr/>
          </p:nvSpPr>
          <p:spPr>
            <a:xfrm>
              <a:off x="1636152" y="6124038"/>
              <a:ext cx="412428" cy="2224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62" name="TextBox 61"/>
          <p:cNvSpPr txBox="1"/>
          <p:nvPr/>
        </p:nvSpPr>
        <p:spPr>
          <a:xfrm rot="16200000">
            <a:off x="387496" y="1790167"/>
            <a:ext cx="1605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Distance from QC µm</a:t>
            </a:r>
            <a:r>
              <a:rPr lang="de-DE" sz="1200" baseline="30000" dirty="0" smtClean="0"/>
              <a:t>-1</a:t>
            </a:r>
            <a:endParaRPr lang="de-DE" sz="1200" baseline="30000" dirty="0"/>
          </a:p>
        </p:txBody>
      </p:sp>
      <p:sp>
        <p:nvSpPr>
          <p:cNvPr id="63" name="TextBox 62"/>
          <p:cNvSpPr txBox="1"/>
          <p:nvPr/>
        </p:nvSpPr>
        <p:spPr>
          <a:xfrm>
            <a:off x="2804282" y="3419600"/>
            <a:ext cx="1509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Cell length µm</a:t>
            </a:r>
            <a:r>
              <a:rPr lang="de-DE" sz="1200" baseline="30000" dirty="0" smtClean="0"/>
              <a:t>-1</a:t>
            </a:r>
            <a:endParaRPr lang="de-DE" sz="1200" baseline="30000" dirty="0"/>
          </a:p>
        </p:txBody>
      </p:sp>
      <p:sp>
        <p:nvSpPr>
          <p:cNvPr id="65" name="TextBox 64"/>
          <p:cNvSpPr txBox="1"/>
          <p:nvPr/>
        </p:nvSpPr>
        <p:spPr>
          <a:xfrm>
            <a:off x="5249483" y="576274"/>
            <a:ext cx="397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68941" y="204395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5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4750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Widescreen</PresentationFormat>
  <Paragraphs>3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 Teale</dc:creator>
  <cp:lastModifiedBy>William Teale</cp:lastModifiedBy>
  <cp:revision>8</cp:revision>
  <dcterms:created xsi:type="dcterms:W3CDTF">2019-11-19T09:52:56Z</dcterms:created>
  <dcterms:modified xsi:type="dcterms:W3CDTF">2021-05-13T11:20:50Z</dcterms:modified>
</cp:coreProperties>
</file>